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90" r:id="rId2"/>
    <p:sldId id="279" r:id="rId3"/>
    <p:sldId id="36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340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B7318A-4BC5-4FF5-AC95-698B3C3C7B73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D65908-28E6-4184-9CCC-FC3663A77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5290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47782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860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490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0277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068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7944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052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391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9218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1591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360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55149-5375-4CBA-814F-FC61F17A2FAA}" type="datetimeFigureOut">
              <a:rPr kumimoji="1" lang="ja-JP" altLang="en-US" smtClean="0"/>
              <a:t>2024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46000-A514-4F6D-A641-AD39B648C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7388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Line 67">
            <a:extLst>
              <a:ext uri="{FF2B5EF4-FFF2-40B4-BE49-F238E27FC236}">
                <a16:creationId xmlns:a16="http://schemas.microsoft.com/office/drawing/2014/main" id="{C67BA61B-EEEF-D28D-E1BA-73795256A16D}"/>
              </a:ext>
            </a:extLst>
          </p:cNvPr>
          <p:cNvSpPr>
            <a:spLocks noChangeShapeType="1"/>
          </p:cNvSpPr>
          <p:nvPr/>
        </p:nvSpPr>
        <p:spPr bwMode="auto">
          <a:xfrm>
            <a:off x="2555875" y="2074943"/>
            <a:ext cx="0" cy="2857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" name="Line 80">
            <a:extLst>
              <a:ext uri="{FF2B5EF4-FFF2-40B4-BE49-F238E27FC236}">
                <a16:creationId xmlns:a16="http://schemas.microsoft.com/office/drawing/2014/main" id="{52204EBA-27EE-88BB-7554-B95D41DD0E5A}"/>
              </a:ext>
            </a:extLst>
          </p:cNvPr>
          <p:cNvSpPr>
            <a:spLocks noChangeShapeType="1"/>
          </p:cNvSpPr>
          <p:nvPr/>
        </p:nvSpPr>
        <p:spPr bwMode="auto">
          <a:xfrm>
            <a:off x="2555875" y="2074943"/>
            <a:ext cx="0" cy="55563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" name="Rectangle 81">
            <a:extLst>
              <a:ext uri="{FF2B5EF4-FFF2-40B4-BE49-F238E27FC236}">
                <a16:creationId xmlns:a16="http://schemas.microsoft.com/office/drawing/2014/main" id="{66B64515-D88C-004D-26D5-2CB8430027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91678" y="2152731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7.5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" name="Line 86">
            <a:extLst>
              <a:ext uri="{FF2B5EF4-FFF2-40B4-BE49-F238E27FC236}">
                <a16:creationId xmlns:a16="http://schemas.microsoft.com/office/drawing/2014/main" id="{C3EB9E91-10BE-D011-C501-0A77260DE45C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2050" y="2046368"/>
            <a:ext cx="285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" name="Line 96">
            <a:extLst>
              <a:ext uri="{FF2B5EF4-FFF2-40B4-BE49-F238E27FC236}">
                <a16:creationId xmlns:a16="http://schemas.microsoft.com/office/drawing/2014/main" id="{BFC39D21-2B36-33F3-874A-37B4FE7DFF1E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2050" y="1616156"/>
            <a:ext cx="285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" name="Line 106">
            <a:extLst>
              <a:ext uri="{FF2B5EF4-FFF2-40B4-BE49-F238E27FC236}">
                <a16:creationId xmlns:a16="http://schemas.microsoft.com/office/drawing/2014/main" id="{C3741B3F-91E7-91B1-F81C-CC7F2FC12325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2050" y="1185943"/>
            <a:ext cx="285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" name="Line 107">
            <a:extLst>
              <a:ext uri="{FF2B5EF4-FFF2-40B4-BE49-F238E27FC236}">
                <a16:creationId xmlns:a16="http://schemas.microsoft.com/office/drawing/2014/main" id="{82E342C3-5C89-AED7-8D3A-F84746909D56}"/>
              </a:ext>
            </a:extLst>
          </p:cNvPr>
          <p:cNvSpPr>
            <a:spLocks noChangeShapeType="1"/>
          </p:cNvSpPr>
          <p:nvPr/>
        </p:nvSpPr>
        <p:spPr bwMode="auto">
          <a:xfrm>
            <a:off x="1135063" y="2046368"/>
            <a:ext cx="5556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" name="Rectangle 108">
            <a:extLst>
              <a:ext uri="{FF2B5EF4-FFF2-40B4-BE49-F238E27FC236}">
                <a16:creationId xmlns:a16="http://schemas.microsoft.com/office/drawing/2014/main" id="{492EBE10-3649-24FE-67DD-C7F6084344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9020" y="199398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" name="Line 111">
            <a:extLst>
              <a:ext uri="{FF2B5EF4-FFF2-40B4-BE49-F238E27FC236}">
                <a16:creationId xmlns:a16="http://schemas.microsoft.com/office/drawing/2014/main" id="{710C371B-DE5D-2E88-9037-3067F880BD80}"/>
              </a:ext>
            </a:extLst>
          </p:cNvPr>
          <p:cNvSpPr>
            <a:spLocks noChangeShapeType="1"/>
          </p:cNvSpPr>
          <p:nvPr/>
        </p:nvSpPr>
        <p:spPr bwMode="auto">
          <a:xfrm>
            <a:off x="1135063" y="1616156"/>
            <a:ext cx="5556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" name="Rectangle 112">
            <a:extLst>
              <a:ext uri="{FF2B5EF4-FFF2-40B4-BE49-F238E27FC236}">
                <a16:creationId xmlns:a16="http://schemas.microsoft.com/office/drawing/2014/main" id="{5B1A2072-9516-2887-9CED-E2435B3A16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5045" y="1562181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" name="Line 115">
            <a:extLst>
              <a:ext uri="{FF2B5EF4-FFF2-40B4-BE49-F238E27FC236}">
                <a16:creationId xmlns:a16="http://schemas.microsoft.com/office/drawing/2014/main" id="{BF075267-73CF-4916-BA30-76BECE1860C3}"/>
              </a:ext>
            </a:extLst>
          </p:cNvPr>
          <p:cNvSpPr>
            <a:spLocks noChangeShapeType="1"/>
          </p:cNvSpPr>
          <p:nvPr/>
        </p:nvSpPr>
        <p:spPr bwMode="auto">
          <a:xfrm>
            <a:off x="1135063" y="1185943"/>
            <a:ext cx="5556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" name="Rectangle 116">
            <a:extLst>
              <a:ext uri="{FF2B5EF4-FFF2-40B4-BE49-F238E27FC236}">
                <a16:creationId xmlns:a16="http://schemas.microsoft.com/office/drawing/2014/main" id="{6FAAA39A-440A-73AD-AF52-A43410EA2B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2658" y="1133556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10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" name="Freeform 118">
            <a:extLst>
              <a:ext uri="{FF2B5EF4-FFF2-40B4-BE49-F238E27FC236}">
                <a16:creationId xmlns:a16="http://schemas.microsoft.com/office/drawing/2014/main" id="{3A68F033-4309-52DA-1D2B-ED213A99C913}"/>
              </a:ext>
            </a:extLst>
          </p:cNvPr>
          <p:cNvSpPr>
            <a:spLocks/>
          </p:cNvSpPr>
          <p:nvPr/>
        </p:nvSpPr>
        <p:spPr bwMode="auto">
          <a:xfrm>
            <a:off x="1192213" y="1793003"/>
            <a:ext cx="2987675" cy="239713"/>
          </a:xfrm>
          <a:custGeom>
            <a:avLst/>
            <a:gdLst>
              <a:gd name="T0" fmla="*/ 29 w 1882"/>
              <a:gd name="T1" fmla="*/ 150 h 151"/>
              <a:gd name="T2" fmla="*/ 59 w 1882"/>
              <a:gd name="T3" fmla="*/ 151 h 151"/>
              <a:gd name="T4" fmla="*/ 90 w 1882"/>
              <a:gd name="T5" fmla="*/ 142 h 151"/>
              <a:gd name="T6" fmla="*/ 121 w 1882"/>
              <a:gd name="T7" fmla="*/ 43 h 151"/>
              <a:gd name="T8" fmla="*/ 151 w 1882"/>
              <a:gd name="T9" fmla="*/ 91 h 151"/>
              <a:gd name="T10" fmla="*/ 181 w 1882"/>
              <a:gd name="T11" fmla="*/ 138 h 151"/>
              <a:gd name="T12" fmla="*/ 212 w 1882"/>
              <a:gd name="T13" fmla="*/ 148 h 151"/>
              <a:gd name="T14" fmla="*/ 243 w 1882"/>
              <a:gd name="T15" fmla="*/ 147 h 151"/>
              <a:gd name="T16" fmla="*/ 274 w 1882"/>
              <a:gd name="T17" fmla="*/ 148 h 151"/>
              <a:gd name="T18" fmla="*/ 304 w 1882"/>
              <a:gd name="T19" fmla="*/ 149 h 151"/>
              <a:gd name="T20" fmla="*/ 334 w 1882"/>
              <a:gd name="T21" fmla="*/ 149 h 151"/>
              <a:gd name="T22" fmla="*/ 365 w 1882"/>
              <a:gd name="T23" fmla="*/ 148 h 151"/>
              <a:gd name="T24" fmla="*/ 396 w 1882"/>
              <a:gd name="T25" fmla="*/ 146 h 151"/>
              <a:gd name="T26" fmla="*/ 427 w 1882"/>
              <a:gd name="T27" fmla="*/ 141 h 151"/>
              <a:gd name="T28" fmla="*/ 456 w 1882"/>
              <a:gd name="T29" fmla="*/ 133 h 151"/>
              <a:gd name="T30" fmla="*/ 487 w 1882"/>
              <a:gd name="T31" fmla="*/ 122 h 151"/>
              <a:gd name="T32" fmla="*/ 518 w 1882"/>
              <a:gd name="T33" fmla="*/ 110 h 151"/>
              <a:gd name="T34" fmla="*/ 549 w 1882"/>
              <a:gd name="T35" fmla="*/ 99 h 151"/>
              <a:gd name="T36" fmla="*/ 580 w 1882"/>
              <a:gd name="T37" fmla="*/ 91 h 151"/>
              <a:gd name="T38" fmla="*/ 609 w 1882"/>
              <a:gd name="T39" fmla="*/ 85 h 151"/>
              <a:gd name="T40" fmla="*/ 640 w 1882"/>
              <a:gd name="T41" fmla="*/ 81 h 151"/>
              <a:gd name="T42" fmla="*/ 671 w 1882"/>
              <a:gd name="T43" fmla="*/ 80 h 151"/>
              <a:gd name="T44" fmla="*/ 702 w 1882"/>
              <a:gd name="T45" fmla="*/ 79 h 151"/>
              <a:gd name="T46" fmla="*/ 732 w 1882"/>
              <a:gd name="T47" fmla="*/ 65 h 151"/>
              <a:gd name="T48" fmla="*/ 762 w 1882"/>
              <a:gd name="T49" fmla="*/ 68 h 151"/>
              <a:gd name="T50" fmla="*/ 793 w 1882"/>
              <a:gd name="T51" fmla="*/ 72 h 151"/>
              <a:gd name="T52" fmla="*/ 824 w 1882"/>
              <a:gd name="T53" fmla="*/ 63 h 151"/>
              <a:gd name="T54" fmla="*/ 855 w 1882"/>
              <a:gd name="T55" fmla="*/ 71 h 151"/>
              <a:gd name="T56" fmla="*/ 885 w 1882"/>
              <a:gd name="T57" fmla="*/ 71 h 151"/>
              <a:gd name="T58" fmla="*/ 915 w 1882"/>
              <a:gd name="T59" fmla="*/ 71 h 151"/>
              <a:gd name="T60" fmla="*/ 946 w 1882"/>
              <a:gd name="T61" fmla="*/ 69 h 151"/>
              <a:gd name="T62" fmla="*/ 977 w 1882"/>
              <a:gd name="T63" fmla="*/ 68 h 151"/>
              <a:gd name="T64" fmla="*/ 1007 w 1882"/>
              <a:gd name="T65" fmla="*/ 66 h 151"/>
              <a:gd name="T66" fmla="*/ 1038 w 1882"/>
              <a:gd name="T67" fmla="*/ 64 h 151"/>
              <a:gd name="T68" fmla="*/ 1068 w 1882"/>
              <a:gd name="T69" fmla="*/ 63 h 151"/>
              <a:gd name="T70" fmla="*/ 1099 w 1882"/>
              <a:gd name="T71" fmla="*/ 61 h 151"/>
              <a:gd name="T72" fmla="*/ 1130 w 1882"/>
              <a:gd name="T73" fmla="*/ 59 h 151"/>
              <a:gd name="T74" fmla="*/ 1160 w 1882"/>
              <a:gd name="T75" fmla="*/ 58 h 151"/>
              <a:gd name="T76" fmla="*/ 1191 w 1882"/>
              <a:gd name="T77" fmla="*/ 55 h 151"/>
              <a:gd name="T78" fmla="*/ 1221 w 1882"/>
              <a:gd name="T79" fmla="*/ 54 h 151"/>
              <a:gd name="T80" fmla="*/ 1252 w 1882"/>
              <a:gd name="T81" fmla="*/ 53 h 151"/>
              <a:gd name="T82" fmla="*/ 1283 w 1882"/>
              <a:gd name="T83" fmla="*/ 51 h 151"/>
              <a:gd name="T84" fmla="*/ 1313 w 1882"/>
              <a:gd name="T85" fmla="*/ 47 h 151"/>
              <a:gd name="T86" fmla="*/ 1344 w 1882"/>
              <a:gd name="T87" fmla="*/ 44 h 151"/>
              <a:gd name="T88" fmla="*/ 1375 w 1882"/>
              <a:gd name="T89" fmla="*/ 44 h 151"/>
              <a:gd name="T90" fmla="*/ 1405 w 1882"/>
              <a:gd name="T91" fmla="*/ 42 h 151"/>
              <a:gd name="T92" fmla="*/ 1435 w 1882"/>
              <a:gd name="T93" fmla="*/ 40 h 151"/>
              <a:gd name="T94" fmla="*/ 1466 w 1882"/>
              <a:gd name="T95" fmla="*/ 39 h 151"/>
              <a:gd name="T96" fmla="*/ 1497 w 1882"/>
              <a:gd name="T97" fmla="*/ 37 h 151"/>
              <a:gd name="T98" fmla="*/ 1528 w 1882"/>
              <a:gd name="T99" fmla="*/ 36 h 151"/>
              <a:gd name="T100" fmla="*/ 1558 w 1882"/>
              <a:gd name="T101" fmla="*/ 34 h 151"/>
              <a:gd name="T102" fmla="*/ 1588 w 1882"/>
              <a:gd name="T103" fmla="*/ 31 h 151"/>
              <a:gd name="T104" fmla="*/ 1619 w 1882"/>
              <a:gd name="T105" fmla="*/ 28 h 151"/>
              <a:gd name="T106" fmla="*/ 1650 w 1882"/>
              <a:gd name="T107" fmla="*/ 26 h 151"/>
              <a:gd name="T108" fmla="*/ 1681 w 1882"/>
              <a:gd name="T109" fmla="*/ 23 h 151"/>
              <a:gd name="T110" fmla="*/ 1710 w 1882"/>
              <a:gd name="T111" fmla="*/ 20 h 151"/>
              <a:gd name="T112" fmla="*/ 1741 w 1882"/>
              <a:gd name="T113" fmla="*/ 17 h 151"/>
              <a:gd name="T114" fmla="*/ 1772 w 1882"/>
              <a:gd name="T115" fmla="*/ 14 h 151"/>
              <a:gd name="T116" fmla="*/ 1803 w 1882"/>
              <a:gd name="T117" fmla="*/ 7 h 151"/>
              <a:gd name="T118" fmla="*/ 1834 w 1882"/>
              <a:gd name="T119" fmla="*/ 4 h 151"/>
              <a:gd name="T120" fmla="*/ 1863 w 1882"/>
              <a:gd name="T121" fmla="*/ 1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1882" h="151">
                <a:moveTo>
                  <a:pt x="0" y="149"/>
                </a:moveTo>
                <a:lnTo>
                  <a:pt x="2" y="149"/>
                </a:lnTo>
                <a:lnTo>
                  <a:pt x="4" y="149"/>
                </a:lnTo>
                <a:lnTo>
                  <a:pt x="6" y="149"/>
                </a:lnTo>
                <a:lnTo>
                  <a:pt x="8" y="149"/>
                </a:lnTo>
                <a:lnTo>
                  <a:pt x="10" y="150"/>
                </a:lnTo>
                <a:lnTo>
                  <a:pt x="13" y="150"/>
                </a:lnTo>
                <a:lnTo>
                  <a:pt x="15" y="150"/>
                </a:lnTo>
                <a:lnTo>
                  <a:pt x="17" y="150"/>
                </a:lnTo>
                <a:lnTo>
                  <a:pt x="19" y="150"/>
                </a:lnTo>
                <a:lnTo>
                  <a:pt x="21" y="150"/>
                </a:lnTo>
                <a:lnTo>
                  <a:pt x="22" y="150"/>
                </a:lnTo>
                <a:lnTo>
                  <a:pt x="24" y="150"/>
                </a:lnTo>
                <a:lnTo>
                  <a:pt x="26" y="150"/>
                </a:lnTo>
                <a:lnTo>
                  <a:pt x="29" y="150"/>
                </a:lnTo>
                <a:lnTo>
                  <a:pt x="31" y="151"/>
                </a:lnTo>
                <a:lnTo>
                  <a:pt x="33" y="151"/>
                </a:lnTo>
                <a:lnTo>
                  <a:pt x="35" y="151"/>
                </a:lnTo>
                <a:lnTo>
                  <a:pt x="37" y="151"/>
                </a:lnTo>
                <a:lnTo>
                  <a:pt x="39" y="151"/>
                </a:lnTo>
                <a:lnTo>
                  <a:pt x="41" y="151"/>
                </a:lnTo>
                <a:lnTo>
                  <a:pt x="43" y="151"/>
                </a:lnTo>
                <a:lnTo>
                  <a:pt x="45" y="151"/>
                </a:lnTo>
                <a:lnTo>
                  <a:pt x="47" y="151"/>
                </a:lnTo>
                <a:lnTo>
                  <a:pt x="49" y="151"/>
                </a:lnTo>
                <a:lnTo>
                  <a:pt x="51" y="151"/>
                </a:lnTo>
                <a:lnTo>
                  <a:pt x="53" y="151"/>
                </a:lnTo>
                <a:lnTo>
                  <a:pt x="55" y="151"/>
                </a:lnTo>
                <a:lnTo>
                  <a:pt x="57" y="151"/>
                </a:lnTo>
                <a:lnTo>
                  <a:pt x="59" y="151"/>
                </a:lnTo>
                <a:lnTo>
                  <a:pt x="61" y="151"/>
                </a:lnTo>
                <a:lnTo>
                  <a:pt x="64" y="151"/>
                </a:lnTo>
                <a:lnTo>
                  <a:pt x="66" y="151"/>
                </a:lnTo>
                <a:lnTo>
                  <a:pt x="68" y="150"/>
                </a:lnTo>
                <a:lnTo>
                  <a:pt x="70" y="150"/>
                </a:lnTo>
                <a:lnTo>
                  <a:pt x="72" y="150"/>
                </a:lnTo>
                <a:lnTo>
                  <a:pt x="73" y="149"/>
                </a:lnTo>
                <a:lnTo>
                  <a:pt x="75" y="149"/>
                </a:lnTo>
                <a:lnTo>
                  <a:pt x="77" y="148"/>
                </a:lnTo>
                <a:lnTo>
                  <a:pt x="79" y="148"/>
                </a:lnTo>
                <a:lnTo>
                  <a:pt x="82" y="147"/>
                </a:lnTo>
                <a:lnTo>
                  <a:pt x="84" y="146"/>
                </a:lnTo>
                <a:lnTo>
                  <a:pt x="86" y="145"/>
                </a:lnTo>
                <a:lnTo>
                  <a:pt x="88" y="144"/>
                </a:lnTo>
                <a:lnTo>
                  <a:pt x="90" y="142"/>
                </a:lnTo>
                <a:lnTo>
                  <a:pt x="92" y="140"/>
                </a:lnTo>
                <a:lnTo>
                  <a:pt x="94" y="137"/>
                </a:lnTo>
                <a:lnTo>
                  <a:pt x="96" y="133"/>
                </a:lnTo>
                <a:lnTo>
                  <a:pt x="98" y="128"/>
                </a:lnTo>
                <a:lnTo>
                  <a:pt x="100" y="122"/>
                </a:lnTo>
                <a:lnTo>
                  <a:pt x="102" y="116"/>
                </a:lnTo>
                <a:lnTo>
                  <a:pt x="104" y="107"/>
                </a:lnTo>
                <a:lnTo>
                  <a:pt x="106" y="98"/>
                </a:lnTo>
                <a:lnTo>
                  <a:pt x="108" y="88"/>
                </a:lnTo>
                <a:lnTo>
                  <a:pt x="110" y="79"/>
                </a:lnTo>
                <a:lnTo>
                  <a:pt x="112" y="70"/>
                </a:lnTo>
                <a:lnTo>
                  <a:pt x="115" y="61"/>
                </a:lnTo>
                <a:lnTo>
                  <a:pt x="117" y="54"/>
                </a:lnTo>
                <a:lnTo>
                  <a:pt x="119" y="47"/>
                </a:lnTo>
                <a:lnTo>
                  <a:pt x="121" y="43"/>
                </a:lnTo>
                <a:lnTo>
                  <a:pt x="123" y="40"/>
                </a:lnTo>
                <a:lnTo>
                  <a:pt x="124" y="39"/>
                </a:lnTo>
                <a:lnTo>
                  <a:pt x="126" y="40"/>
                </a:lnTo>
                <a:lnTo>
                  <a:pt x="128" y="40"/>
                </a:lnTo>
                <a:lnTo>
                  <a:pt x="130" y="43"/>
                </a:lnTo>
                <a:lnTo>
                  <a:pt x="133" y="46"/>
                </a:lnTo>
                <a:lnTo>
                  <a:pt x="135" y="50"/>
                </a:lnTo>
                <a:lnTo>
                  <a:pt x="137" y="55"/>
                </a:lnTo>
                <a:lnTo>
                  <a:pt x="139" y="60"/>
                </a:lnTo>
                <a:lnTo>
                  <a:pt x="141" y="65"/>
                </a:lnTo>
                <a:lnTo>
                  <a:pt x="143" y="71"/>
                </a:lnTo>
                <a:lnTo>
                  <a:pt x="145" y="76"/>
                </a:lnTo>
                <a:lnTo>
                  <a:pt x="147" y="81"/>
                </a:lnTo>
                <a:lnTo>
                  <a:pt x="149" y="86"/>
                </a:lnTo>
                <a:lnTo>
                  <a:pt x="151" y="91"/>
                </a:lnTo>
                <a:lnTo>
                  <a:pt x="153" y="96"/>
                </a:lnTo>
                <a:lnTo>
                  <a:pt x="155" y="100"/>
                </a:lnTo>
                <a:lnTo>
                  <a:pt x="157" y="105"/>
                </a:lnTo>
                <a:lnTo>
                  <a:pt x="159" y="109"/>
                </a:lnTo>
                <a:lnTo>
                  <a:pt x="161" y="113"/>
                </a:lnTo>
                <a:lnTo>
                  <a:pt x="163" y="117"/>
                </a:lnTo>
                <a:lnTo>
                  <a:pt x="165" y="119"/>
                </a:lnTo>
                <a:lnTo>
                  <a:pt x="168" y="123"/>
                </a:lnTo>
                <a:lnTo>
                  <a:pt x="170" y="126"/>
                </a:lnTo>
                <a:lnTo>
                  <a:pt x="172" y="128"/>
                </a:lnTo>
                <a:lnTo>
                  <a:pt x="174" y="131"/>
                </a:lnTo>
                <a:lnTo>
                  <a:pt x="175" y="133"/>
                </a:lnTo>
                <a:lnTo>
                  <a:pt x="177" y="135"/>
                </a:lnTo>
                <a:lnTo>
                  <a:pt x="179" y="137"/>
                </a:lnTo>
                <a:lnTo>
                  <a:pt x="181" y="138"/>
                </a:lnTo>
                <a:lnTo>
                  <a:pt x="184" y="140"/>
                </a:lnTo>
                <a:lnTo>
                  <a:pt x="186" y="141"/>
                </a:lnTo>
                <a:lnTo>
                  <a:pt x="188" y="142"/>
                </a:lnTo>
                <a:lnTo>
                  <a:pt x="190" y="143"/>
                </a:lnTo>
                <a:lnTo>
                  <a:pt x="192" y="144"/>
                </a:lnTo>
                <a:lnTo>
                  <a:pt x="194" y="145"/>
                </a:lnTo>
                <a:lnTo>
                  <a:pt x="196" y="145"/>
                </a:lnTo>
                <a:lnTo>
                  <a:pt x="198" y="146"/>
                </a:lnTo>
                <a:lnTo>
                  <a:pt x="200" y="146"/>
                </a:lnTo>
                <a:lnTo>
                  <a:pt x="202" y="147"/>
                </a:lnTo>
                <a:lnTo>
                  <a:pt x="204" y="147"/>
                </a:lnTo>
                <a:lnTo>
                  <a:pt x="206" y="147"/>
                </a:lnTo>
                <a:lnTo>
                  <a:pt x="208" y="147"/>
                </a:lnTo>
                <a:lnTo>
                  <a:pt x="210" y="148"/>
                </a:lnTo>
                <a:lnTo>
                  <a:pt x="212" y="148"/>
                </a:lnTo>
                <a:lnTo>
                  <a:pt x="214" y="148"/>
                </a:lnTo>
                <a:lnTo>
                  <a:pt x="216" y="148"/>
                </a:lnTo>
                <a:lnTo>
                  <a:pt x="219" y="148"/>
                </a:lnTo>
                <a:lnTo>
                  <a:pt x="221" y="148"/>
                </a:lnTo>
                <a:lnTo>
                  <a:pt x="223" y="148"/>
                </a:lnTo>
                <a:lnTo>
                  <a:pt x="225" y="148"/>
                </a:lnTo>
                <a:lnTo>
                  <a:pt x="226" y="147"/>
                </a:lnTo>
                <a:lnTo>
                  <a:pt x="228" y="147"/>
                </a:lnTo>
                <a:lnTo>
                  <a:pt x="230" y="147"/>
                </a:lnTo>
                <a:lnTo>
                  <a:pt x="232" y="147"/>
                </a:lnTo>
                <a:lnTo>
                  <a:pt x="235" y="147"/>
                </a:lnTo>
                <a:lnTo>
                  <a:pt x="237" y="147"/>
                </a:lnTo>
                <a:lnTo>
                  <a:pt x="239" y="147"/>
                </a:lnTo>
                <a:lnTo>
                  <a:pt x="241" y="147"/>
                </a:lnTo>
                <a:lnTo>
                  <a:pt x="243" y="147"/>
                </a:lnTo>
                <a:lnTo>
                  <a:pt x="245" y="148"/>
                </a:lnTo>
                <a:lnTo>
                  <a:pt x="247" y="148"/>
                </a:lnTo>
                <a:lnTo>
                  <a:pt x="249" y="148"/>
                </a:lnTo>
                <a:lnTo>
                  <a:pt x="251" y="148"/>
                </a:lnTo>
                <a:lnTo>
                  <a:pt x="253" y="148"/>
                </a:lnTo>
                <a:lnTo>
                  <a:pt x="255" y="148"/>
                </a:lnTo>
                <a:lnTo>
                  <a:pt x="257" y="148"/>
                </a:lnTo>
                <a:lnTo>
                  <a:pt x="259" y="148"/>
                </a:lnTo>
                <a:lnTo>
                  <a:pt x="261" y="148"/>
                </a:lnTo>
                <a:lnTo>
                  <a:pt x="263" y="148"/>
                </a:lnTo>
                <a:lnTo>
                  <a:pt x="265" y="148"/>
                </a:lnTo>
                <a:lnTo>
                  <a:pt x="267" y="148"/>
                </a:lnTo>
                <a:lnTo>
                  <a:pt x="270" y="148"/>
                </a:lnTo>
                <a:lnTo>
                  <a:pt x="272" y="148"/>
                </a:lnTo>
                <a:lnTo>
                  <a:pt x="274" y="148"/>
                </a:lnTo>
                <a:lnTo>
                  <a:pt x="276" y="148"/>
                </a:lnTo>
                <a:lnTo>
                  <a:pt x="277" y="149"/>
                </a:lnTo>
                <a:lnTo>
                  <a:pt x="279" y="149"/>
                </a:lnTo>
                <a:lnTo>
                  <a:pt x="281" y="149"/>
                </a:lnTo>
                <a:lnTo>
                  <a:pt x="283" y="149"/>
                </a:lnTo>
                <a:lnTo>
                  <a:pt x="285" y="149"/>
                </a:lnTo>
                <a:lnTo>
                  <a:pt x="288" y="149"/>
                </a:lnTo>
                <a:lnTo>
                  <a:pt x="290" y="149"/>
                </a:lnTo>
                <a:lnTo>
                  <a:pt x="292" y="149"/>
                </a:lnTo>
                <a:lnTo>
                  <a:pt x="294" y="149"/>
                </a:lnTo>
                <a:lnTo>
                  <a:pt x="296" y="149"/>
                </a:lnTo>
                <a:lnTo>
                  <a:pt x="298" y="149"/>
                </a:lnTo>
                <a:lnTo>
                  <a:pt x="300" y="149"/>
                </a:lnTo>
                <a:lnTo>
                  <a:pt x="302" y="149"/>
                </a:lnTo>
                <a:lnTo>
                  <a:pt x="304" y="149"/>
                </a:lnTo>
                <a:lnTo>
                  <a:pt x="306" y="149"/>
                </a:lnTo>
                <a:lnTo>
                  <a:pt x="308" y="149"/>
                </a:lnTo>
                <a:lnTo>
                  <a:pt x="310" y="149"/>
                </a:lnTo>
                <a:lnTo>
                  <a:pt x="312" y="149"/>
                </a:lnTo>
                <a:lnTo>
                  <a:pt x="314" y="149"/>
                </a:lnTo>
                <a:lnTo>
                  <a:pt x="316" y="149"/>
                </a:lnTo>
                <a:lnTo>
                  <a:pt x="318" y="149"/>
                </a:lnTo>
                <a:lnTo>
                  <a:pt x="321" y="149"/>
                </a:lnTo>
                <a:lnTo>
                  <a:pt x="323" y="149"/>
                </a:lnTo>
                <a:lnTo>
                  <a:pt x="325" y="149"/>
                </a:lnTo>
                <a:lnTo>
                  <a:pt x="327" y="149"/>
                </a:lnTo>
                <a:lnTo>
                  <a:pt x="328" y="149"/>
                </a:lnTo>
                <a:lnTo>
                  <a:pt x="330" y="149"/>
                </a:lnTo>
                <a:lnTo>
                  <a:pt x="332" y="149"/>
                </a:lnTo>
                <a:lnTo>
                  <a:pt x="334" y="149"/>
                </a:lnTo>
                <a:lnTo>
                  <a:pt x="336" y="149"/>
                </a:lnTo>
                <a:lnTo>
                  <a:pt x="339" y="149"/>
                </a:lnTo>
                <a:lnTo>
                  <a:pt x="341" y="149"/>
                </a:lnTo>
                <a:lnTo>
                  <a:pt x="343" y="149"/>
                </a:lnTo>
                <a:lnTo>
                  <a:pt x="345" y="149"/>
                </a:lnTo>
                <a:lnTo>
                  <a:pt x="347" y="149"/>
                </a:lnTo>
                <a:lnTo>
                  <a:pt x="349" y="149"/>
                </a:lnTo>
                <a:lnTo>
                  <a:pt x="351" y="149"/>
                </a:lnTo>
                <a:lnTo>
                  <a:pt x="353" y="149"/>
                </a:lnTo>
                <a:lnTo>
                  <a:pt x="355" y="149"/>
                </a:lnTo>
                <a:lnTo>
                  <a:pt x="357" y="148"/>
                </a:lnTo>
                <a:lnTo>
                  <a:pt x="359" y="148"/>
                </a:lnTo>
                <a:lnTo>
                  <a:pt x="361" y="148"/>
                </a:lnTo>
                <a:lnTo>
                  <a:pt x="363" y="148"/>
                </a:lnTo>
                <a:lnTo>
                  <a:pt x="365" y="148"/>
                </a:lnTo>
                <a:lnTo>
                  <a:pt x="367" y="148"/>
                </a:lnTo>
                <a:lnTo>
                  <a:pt x="369" y="148"/>
                </a:lnTo>
                <a:lnTo>
                  <a:pt x="371" y="148"/>
                </a:lnTo>
                <a:lnTo>
                  <a:pt x="374" y="148"/>
                </a:lnTo>
                <a:lnTo>
                  <a:pt x="376" y="148"/>
                </a:lnTo>
                <a:lnTo>
                  <a:pt x="378" y="147"/>
                </a:lnTo>
                <a:lnTo>
                  <a:pt x="379" y="147"/>
                </a:lnTo>
                <a:lnTo>
                  <a:pt x="381" y="147"/>
                </a:lnTo>
                <a:lnTo>
                  <a:pt x="383" y="147"/>
                </a:lnTo>
                <a:lnTo>
                  <a:pt x="385" y="147"/>
                </a:lnTo>
                <a:lnTo>
                  <a:pt x="387" y="147"/>
                </a:lnTo>
                <a:lnTo>
                  <a:pt x="390" y="146"/>
                </a:lnTo>
                <a:lnTo>
                  <a:pt x="392" y="146"/>
                </a:lnTo>
                <a:lnTo>
                  <a:pt x="394" y="146"/>
                </a:lnTo>
                <a:lnTo>
                  <a:pt x="396" y="146"/>
                </a:lnTo>
                <a:lnTo>
                  <a:pt x="398" y="146"/>
                </a:lnTo>
                <a:lnTo>
                  <a:pt x="400" y="145"/>
                </a:lnTo>
                <a:lnTo>
                  <a:pt x="402" y="145"/>
                </a:lnTo>
                <a:lnTo>
                  <a:pt x="404" y="145"/>
                </a:lnTo>
                <a:lnTo>
                  <a:pt x="405" y="145"/>
                </a:lnTo>
                <a:lnTo>
                  <a:pt x="408" y="144"/>
                </a:lnTo>
                <a:lnTo>
                  <a:pt x="410" y="144"/>
                </a:lnTo>
                <a:lnTo>
                  <a:pt x="412" y="144"/>
                </a:lnTo>
                <a:lnTo>
                  <a:pt x="414" y="143"/>
                </a:lnTo>
                <a:lnTo>
                  <a:pt x="416" y="143"/>
                </a:lnTo>
                <a:lnTo>
                  <a:pt x="418" y="143"/>
                </a:lnTo>
                <a:lnTo>
                  <a:pt x="420" y="142"/>
                </a:lnTo>
                <a:lnTo>
                  <a:pt x="422" y="142"/>
                </a:lnTo>
                <a:lnTo>
                  <a:pt x="425" y="142"/>
                </a:lnTo>
                <a:lnTo>
                  <a:pt x="427" y="141"/>
                </a:lnTo>
                <a:lnTo>
                  <a:pt x="429" y="141"/>
                </a:lnTo>
                <a:lnTo>
                  <a:pt x="430" y="140"/>
                </a:lnTo>
                <a:lnTo>
                  <a:pt x="432" y="140"/>
                </a:lnTo>
                <a:lnTo>
                  <a:pt x="434" y="139"/>
                </a:lnTo>
                <a:lnTo>
                  <a:pt x="436" y="139"/>
                </a:lnTo>
                <a:lnTo>
                  <a:pt x="438" y="138"/>
                </a:lnTo>
                <a:lnTo>
                  <a:pt x="441" y="138"/>
                </a:lnTo>
                <a:lnTo>
                  <a:pt x="443" y="137"/>
                </a:lnTo>
                <a:lnTo>
                  <a:pt x="445" y="137"/>
                </a:lnTo>
                <a:lnTo>
                  <a:pt x="447" y="136"/>
                </a:lnTo>
                <a:lnTo>
                  <a:pt x="449" y="136"/>
                </a:lnTo>
                <a:lnTo>
                  <a:pt x="451" y="135"/>
                </a:lnTo>
                <a:lnTo>
                  <a:pt x="453" y="135"/>
                </a:lnTo>
                <a:lnTo>
                  <a:pt x="455" y="134"/>
                </a:lnTo>
                <a:lnTo>
                  <a:pt x="456" y="133"/>
                </a:lnTo>
                <a:lnTo>
                  <a:pt x="459" y="133"/>
                </a:lnTo>
                <a:lnTo>
                  <a:pt x="461" y="132"/>
                </a:lnTo>
                <a:lnTo>
                  <a:pt x="463" y="131"/>
                </a:lnTo>
                <a:lnTo>
                  <a:pt x="465" y="131"/>
                </a:lnTo>
                <a:lnTo>
                  <a:pt x="467" y="130"/>
                </a:lnTo>
                <a:lnTo>
                  <a:pt x="469" y="129"/>
                </a:lnTo>
                <a:lnTo>
                  <a:pt x="471" y="128"/>
                </a:lnTo>
                <a:lnTo>
                  <a:pt x="473" y="128"/>
                </a:lnTo>
                <a:lnTo>
                  <a:pt x="476" y="127"/>
                </a:lnTo>
                <a:lnTo>
                  <a:pt x="478" y="126"/>
                </a:lnTo>
                <a:lnTo>
                  <a:pt x="480" y="125"/>
                </a:lnTo>
                <a:lnTo>
                  <a:pt x="481" y="124"/>
                </a:lnTo>
                <a:lnTo>
                  <a:pt x="483" y="124"/>
                </a:lnTo>
                <a:lnTo>
                  <a:pt x="485" y="123"/>
                </a:lnTo>
                <a:lnTo>
                  <a:pt x="487" y="122"/>
                </a:lnTo>
                <a:lnTo>
                  <a:pt x="489" y="121"/>
                </a:lnTo>
                <a:lnTo>
                  <a:pt x="491" y="120"/>
                </a:lnTo>
                <a:lnTo>
                  <a:pt x="494" y="119"/>
                </a:lnTo>
                <a:lnTo>
                  <a:pt x="496" y="119"/>
                </a:lnTo>
                <a:lnTo>
                  <a:pt x="498" y="119"/>
                </a:lnTo>
                <a:lnTo>
                  <a:pt x="500" y="118"/>
                </a:lnTo>
                <a:lnTo>
                  <a:pt x="502" y="117"/>
                </a:lnTo>
                <a:lnTo>
                  <a:pt x="504" y="116"/>
                </a:lnTo>
                <a:lnTo>
                  <a:pt x="506" y="115"/>
                </a:lnTo>
                <a:lnTo>
                  <a:pt x="507" y="114"/>
                </a:lnTo>
                <a:lnTo>
                  <a:pt x="510" y="113"/>
                </a:lnTo>
                <a:lnTo>
                  <a:pt x="512" y="112"/>
                </a:lnTo>
                <a:lnTo>
                  <a:pt x="514" y="112"/>
                </a:lnTo>
                <a:lnTo>
                  <a:pt x="516" y="111"/>
                </a:lnTo>
                <a:lnTo>
                  <a:pt x="518" y="110"/>
                </a:lnTo>
                <a:lnTo>
                  <a:pt x="520" y="109"/>
                </a:lnTo>
                <a:lnTo>
                  <a:pt x="522" y="108"/>
                </a:lnTo>
                <a:lnTo>
                  <a:pt x="524" y="107"/>
                </a:lnTo>
                <a:lnTo>
                  <a:pt x="526" y="106"/>
                </a:lnTo>
                <a:lnTo>
                  <a:pt x="529" y="105"/>
                </a:lnTo>
                <a:lnTo>
                  <a:pt x="531" y="105"/>
                </a:lnTo>
                <a:lnTo>
                  <a:pt x="532" y="104"/>
                </a:lnTo>
                <a:lnTo>
                  <a:pt x="534" y="103"/>
                </a:lnTo>
                <a:lnTo>
                  <a:pt x="536" y="102"/>
                </a:lnTo>
                <a:lnTo>
                  <a:pt x="538" y="102"/>
                </a:lnTo>
                <a:lnTo>
                  <a:pt x="540" y="101"/>
                </a:lnTo>
                <a:lnTo>
                  <a:pt x="542" y="100"/>
                </a:lnTo>
                <a:lnTo>
                  <a:pt x="545" y="100"/>
                </a:lnTo>
                <a:lnTo>
                  <a:pt x="547" y="99"/>
                </a:lnTo>
                <a:lnTo>
                  <a:pt x="549" y="99"/>
                </a:lnTo>
                <a:lnTo>
                  <a:pt x="551" y="98"/>
                </a:lnTo>
                <a:lnTo>
                  <a:pt x="553" y="98"/>
                </a:lnTo>
                <a:lnTo>
                  <a:pt x="555" y="97"/>
                </a:lnTo>
                <a:lnTo>
                  <a:pt x="557" y="97"/>
                </a:lnTo>
                <a:lnTo>
                  <a:pt x="558" y="96"/>
                </a:lnTo>
                <a:lnTo>
                  <a:pt x="561" y="96"/>
                </a:lnTo>
                <a:lnTo>
                  <a:pt x="563" y="95"/>
                </a:lnTo>
                <a:lnTo>
                  <a:pt x="565" y="95"/>
                </a:lnTo>
                <a:lnTo>
                  <a:pt x="567" y="94"/>
                </a:lnTo>
                <a:lnTo>
                  <a:pt x="569" y="94"/>
                </a:lnTo>
                <a:lnTo>
                  <a:pt x="571" y="93"/>
                </a:lnTo>
                <a:lnTo>
                  <a:pt x="573" y="93"/>
                </a:lnTo>
                <a:lnTo>
                  <a:pt x="575" y="92"/>
                </a:lnTo>
                <a:lnTo>
                  <a:pt x="577" y="91"/>
                </a:lnTo>
                <a:lnTo>
                  <a:pt x="580" y="91"/>
                </a:lnTo>
                <a:lnTo>
                  <a:pt x="582" y="90"/>
                </a:lnTo>
                <a:lnTo>
                  <a:pt x="583" y="90"/>
                </a:lnTo>
                <a:lnTo>
                  <a:pt x="585" y="90"/>
                </a:lnTo>
                <a:lnTo>
                  <a:pt x="587" y="89"/>
                </a:lnTo>
                <a:lnTo>
                  <a:pt x="589" y="89"/>
                </a:lnTo>
                <a:lnTo>
                  <a:pt x="591" y="89"/>
                </a:lnTo>
                <a:lnTo>
                  <a:pt x="593" y="89"/>
                </a:lnTo>
                <a:lnTo>
                  <a:pt x="596" y="88"/>
                </a:lnTo>
                <a:lnTo>
                  <a:pt x="598" y="88"/>
                </a:lnTo>
                <a:lnTo>
                  <a:pt x="600" y="88"/>
                </a:lnTo>
                <a:lnTo>
                  <a:pt x="602" y="87"/>
                </a:lnTo>
                <a:lnTo>
                  <a:pt x="604" y="87"/>
                </a:lnTo>
                <a:lnTo>
                  <a:pt x="606" y="86"/>
                </a:lnTo>
                <a:lnTo>
                  <a:pt x="608" y="85"/>
                </a:lnTo>
                <a:lnTo>
                  <a:pt x="609" y="85"/>
                </a:lnTo>
                <a:lnTo>
                  <a:pt x="611" y="85"/>
                </a:lnTo>
                <a:lnTo>
                  <a:pt x="614" y="84"/>
                </a:lnTo>
                <a:lnTo>
                  <a:pt x="616" y="84"/>
                </a:lnTo>
                <a:lnTo>
                  <a:pt x="618" y="83"/>
                </a:lnTo>
                <a:lnTo>
                  <a:pt x="620" y="83"/>
                </a:lnTo>
                <a:lnTo>
                  <a:pt x="622" y="82"/>
                </a:lnTo>
                <a:lnTo>
                  <a:pt x="624" y="81"/>
                </a:lnTo>
                <a:lnTo>
                  <a:pt x="626" y="81"/>
                </a:lnTo>
                <a:lnTo>
                  <a:pt x="628" y="80"/>
                </a:lnTo>
                <a:lnTo>
                  <a:pt x="631" y="80"/>
                </a:lnTo>
                <a:lnTo>
                  <a:pt x="633" y="80"/>
                </a:lnTo>
                <a:lnTo>
                  <a:pt x="634" y="80"/>
                </a:lnTo>
                <a:lnTo>
                  <a:pt x="636" y="80"/>
                </a:lnTo>
                <a:lnTo>
                  <a:pt x="638" y="80"/>
                </a:lnTo>
                <a:lnTo>
                  <a:pt x="640" y="81"/>
                </a:lnTo>
                <a:lnTo>
                  <a:pt x="642" y="81"/>
                </a:lnTo>
                <a:lnTo>
                  <a:pt x="644" y="81"/>
                </a:lnTo>
                <a:lnTo>
                  <a:pt x="646" y="81"/>
                </a:lnTo>
                <a:lnTo>
                  <a:pt x="649" y="81"/>
                </a:lnTo>
                <a:lnTo>
                  <a:pt x="651" y="81"/>
                </a:lnTo>
                <a:lnTo>
                  <a:pt x="653" y="81"/>
                </a:lnTo>
                <a:lnTo>
                  <a:pt x="655" y="81"/>
                </a:lnTo>
                <a:lnTo>
                  <a:pt x="657" y="81"/>
                </a:lnTo>
                <a:lnTo>
                  <a:pt x="659" y="81"/>
                </a:lnTo>
                <a:lnTo>
                  <a:pt x="660" y="81"/>
                </a:lnTo>
                <a:lnTo>
                  <a:pt x="662" y="81"/>
                </a:lnTo>
                <a:lnTo>
                  <a:pt x="665" y="81"/>
                </a:lnTo>
                <a:lnTo>
                  <a:pt x="667" y="81"/>
                </a:lnTo>
                <a:lnTo>
                  <a:pt x="669" y="80"/>
                </a:lnTo>
                <a:lnTo>
                  <a:pt x="671" y="80"/>
                </a:lnTo>
                <a:lnTo>
                  <a:pt x="673" y="80"/>
                </a:lnTo>
                <a:lnTo>
                  <a:pt x="675" y="80"/>
                </a:lnTo>
                <a:lnTo>
                  <a:pt x="677" y="80"/>
                </a:lnTo>
                <a:lnTo>
                  <a:pt x="679" y="80"/>
                </a:lnTo>
                <a:lnTo>
                  <a:pt x="682" y="80"/>
                </a:lnTo>
                <a:lnTo>
                  <a:pt x="684" y="79"/>
                </a:lnTo>
                <a:lnTo>
                  <a:pt x="685" y="79"/>
                </a:lnTo>
                <a:lnTo>
                  <a:pt x="687" y="79"/>
                </a:lnTo>
                <a:lnTo>
                  <a:pt x="689" y="79"/>
                </a:lnTo>
                <a:lnTo>
                  <a:pt x="691" y="79"/>
                </a:lnTo>
                <a:lnTo>
                  <a:pt x="693" y="79"/>
                </a:lnTo>
                <a:lnTo>
                  <a:pt x="695" y="79"/>
                </a:lnTo>
                <a:lnTo>
                  <a:pt x="697" y="79"/>
                </a:lnTo>
                <a:lnTo>
                  <a:pt x="700" y="79"/>
                </a:lnTo>
                <a:lnTo>
                  <a:pt x="702" y="79"/>
                </a:lnTo>
                <a:lnTo>
                  <a:pt x="704" y="79"/>
                </a:lnTo>
                <a:lnTo>
                  <a:pt x="706" y="79"/>
                </a:lnTo>
                <a:lnTo>
                  <a:pt x="708" y="79"/>
                </a:lnTo>
                <a:lnTo>
                  <a:pt x="710" y="79"/>
                </a:lnTo>
                <a:lnTo>
                  <a:pt x="711" y="78"/>
                </a:lnTo>
                <a:lnTo>
                  <a:pt x="713" y="78"/>
                </a:lnTo>
                <a:lnTo>
                  <a:pt x="716" y="77"/>
                </a:lnTo>
                <a:lnTo>
                  <a:pt x="718" y="75"/>
                </a:lnTo>
                <a:lnTo>
                  <a:pt x="720" y="73"/>
                </a:lnTo>
                <a:lnTo>
                  <a:pt x="722" y="70"/>
                </a:lnTo>
                <a:lnTo>
                  <a:pt x="724" y="67"/>
                </a:lnTo>
                <a:lnTo>
                  <a:pt x="726" y="65"/>
                </a:lnTo>
                <a:lnTo>
                  <a:pt x="728" y="64"/>
                </a:lnTo>
                <a:lnTo>
                  <a:pt x="730" y="64"/>
                </a:lnTo>
                <a:lnTo>
                  <a:pt x="732" y="65"/>
                </a:lnTo>
                <a:lnTo>
                  <a:pt x="735" y="66"/>
                </a:lnTo>
                <a:lnTo>
                  <a:pt x="736" y="68"/>
                </a:lnTo>
                <a:lnTo>
                  <a:pt x="738" y="69"/>
                </a:lnTo>
                <a:lnTo>
                  <a:pt x="740" y="71"/>
                </a:lnTo>
                <a:lnTo>
                  <a:pt x="742" y="71"/>
                </a:lnTo>
                <a:lnTo>
                  <a:pt x="744" y="72"/>
                </a:lnTo>
                <a:lnTo>
                  <a:pt x="746" y="73"/>
                </a:lnTo>
                <a:lnTo>
                  <a:pt x="748" y="73"/>
                </a:lnTo>
                <a:lnTo>
                  <a:pt x="751" y="73"/>
                </a:lnTo>
                <a:lnTo>
                  <a:pt x="753" y="72"/>
                </a:lnTo>
                <a:lnTo>
                  <a:pt x="755" y="71"/>
                </a:lnTo>
                <a:lnTo>
                  <a:pt x="757" y="70"/>
                </a:lnTo>
                <a:lnTo>
                  <a:pt x="759" y="69"/>
                </a:lnTo>
                <a:lnTo>
                  <a:pt x="761" y="69"/>
                </a:lnTo>
                <a:lnTo>
                  <a:pt x="762" y="68"/>
                </a:lnTo>
                <a:lnTo>
                  <a:pt x="764" y="68"/>
                </a:lnTo>
                <a:lnTo>
                  <a:pt x="766" y="69"/>
                </a:lnTo>
                <a:lnTo>
                  <a:pt x="769" y="70"/>
                </a:lnTo>
                <a:lnTo>
                  <a:pt x="771" y="71"/>
                </a:lnTo>
                <a:lnTo>
                  <a:pt x="773" y="71"/>
                </a:lnTo>
                <a:lnTo>
                  <a:pt x="775" y="72"/>
                </a:lnTo>
                <a:lnTo>
                  <a:pt x="777" y="72"/>
                </a:lnTo>
                <a:lnTo>
                  <a:pt x="779" y="73"/>
                </a:lnTo>
                <a:lnTo>
                  <a:pt x="781" y="73"/>
                </a:lnTo>
                <a:lnTo>
                  <a:pt x="783" y="73"/>
                </a:lnTo>
                <a:lnTo>
                  <a:pt x="786" y="73"/>
                </a:lnTo>
                <a:lnTo>
                  <a:pt x="787" y="73"/>
                </a:lnTo>
                <a:lnTo>
                  <a:pt x="789" y="73"/>
                </a:lnTo>
                <a:lnTo>
                  <a:pt x="791" y="73"/>
                </a:lnTo>
                <a:lnTo>
                  <a:pt x="793" y="72"/>
                </a:lnTo>
                <a:lnTo>
                  <a:pt x="795" y="71"/>
                </a:lnTo>
                <a:lnTo>
                  <a:pt x="797" y="68"/>
                </a:lnTo>
                <a:lnTo>
                  <a:pt x="799" y="65"/>
                </a:lnTo>
                <a:lnTo>
                  <a:pt x="802" y="62"/>
                </a:lnTo>
                <a:lnTo>
                  <a:pt x="804" y="59"/>
                </a:lnTo>
                <a:lnTo>
                  <a:pt x="806" y="57"/>
                </a:lnTo>
                <a:lnTo>
                  <a:pt x="808" y="56"/>
                </a:lnTo>
                <a:lnTo>
                  <a:pt x="810" y="57"/>
                </a:lnTo>
                <a:lnTo>
                  <a:pt x="812" y="58"/>
                </a:lnTo>
                <a:lnTo>
                  <a:pt x="813" y="60"/>
                </a:lnTo>
                <a:lnTo>
                  <a:pt x="815" y="61"/>
                </a:lnTo>
                <a:lnTo>
                  <a:pt x="817" y="62"/>
                </a:lnTo>
                <a:lnTo>
                  <a:pt x="820" y="63"/>
                </a:lnTo>
                <a:lnTo>
                  <a:pt x="822" y="63"/>
                </a:lnTo>
                <a:lnTo>
                  <a:pt x="824" y="63"/>
                </a:lnTo>
                <a:lnTo>
                  <a:pt x="826" y="63"/>
                </a:lnTo>
                <a:lnTo>
                  <a:pt x="828" y="63"/>
                </a:lnTo>
                <a:lnTo>
                  <a:pt x="830" y="62"/>
                </a:lnTo>
                <a:lnTo>
                  <a:pt x="832" y="63"/>
                </a:lnTo>
                <a:lnTo>
                  <a:pt x="834" y="63"/>
                </a:lnTo>
                <a:lnTo>
                  <a:pt x="837" y="65"/>
                </a:lnTo>
                <a:lnTo>
                  <a:pt x="838" y="66"/>
                </a:lnTo>
                <a:lnTo>
                  <a:pt x="840" y="67"/>
                </a:lnTo>
                <a:lnTo>
                  <a:pt x="842" y="68"/>
                </a:lnTo>
                <a:lnTo>
                  <a:pt x="844" y="69"/>
                </a:lnTo>
                <a:lnTo>
                  <a:pt x="846" y="69"/>
                </a:lnTo>
                <a:lnTo>
                  <a:pt x="848" y="70"/>
                </a:lnTo>
                <a:lnTo>
                  <a:pt x="850" y="70"/>
                </a:lnTo>
                <a:lnTo>
                  <a:pt x="852" y="71"/>
                </a:lnTo>
                <a:lnTo>
                  <a:pt x="855" y="71"/>
                </a:lnTo>
                <a:lnTo>
                  <a:pt x="857" y="71"/>
                </a:lnTo>
                <a:lnTo>
                  <a:pt x="859" y="72"/>
                </a:lnTo>
                <a:lnTo>
                  <a:pt x="861" y="72"/>
                </a:lnTo>
                <a:lnTo>
                  <a:pt x="863" y="72"/>
                </a:lnTo>
                <a:lnTo>
                  <a:pt x="864" y="72"/>
                </a:lnTo>
                <a:lnTo>
                  <a:pt x="866" y="72"/>
                </a:lnTo>
                <a:lnTo>
                  <a:pt x="868" y="72"/>
                </a:lnTo>
                <a:lnTo>
                  <a:pt x="871" y="72"/>
                </a:lnTo>
                <a:lnTo>
                  <a:pt x="873" y="72"/>
                </a:lnTo>
                <a:lnTo>
                  <a:pt x="875" y="72"/>
                </a:lnTo>
                <a:lnTo>
                  <a:pt x="877" y="72"/>
                </a:lnTo>
                <a:lnTo>
                  <a:pt x="879" y="72"/>
                </a:lnTo>
                <a:lnTo>
                  <a:pt x="881" y="72"/>
                </a:lnTo>
                <a:lnTo>
                  <a:pt x="883" y="72"/>
                </a:lnTo>
                <a:lnTo>
                  <a:pt x="885" y="71"/>
                </a:lnTo>
                <a:lnTo>
                  <a:pt x="887" y="71"/>
                </a:lnTo>
                <a:lnTo>
                  <a:pt x="889" y="71"/>
                </a:lnTo>
                <a:lnTo>
                  <a:pt x="891" y="71"/>
                </a:lnTo>
                <a:lnTo>
                  <a:pt x="893" y="71"/>
                </a:lnTo>
                <a:lnTo>
                  <a:pt x="895" y="71"/>
                </a:lnTo>
                <a:lnTo>
                  <a:pt x="897" y="71"/>
                </a:lnTo>
                <a:lnTo>
                  <a:pt x="899" y="71"/>
                </a:lnTo>
                <a:lnTo>
                  <a:pt x="901" y="71"/>
                </a:lnTo>
                <a:lnTo>
                  <a:pt x="903" y="71"/>
                </a:lnTo>
                <a:lnTo>
                  <a:pt x="906" y="71"/>
                </a:lnTo>
                <a:lnTo>
                  <a:pt x="908" y="71"/>
                </a:lnTo>
                <a:lnTo>
                  <a:pt x="910" y="71"/>
                </a:lnTo>
                <a:lnTo>
                  <a:pt x="912" y="71"/>
                </a:lnTo>
                <a:lnTo>
                  <a:pt x="914" y="71"/>
                </a:lnTo>
                <a:lnTo>
                  <a:pt x="915" y="71"/>
                </a:lnTo>
                <a:lnTo>
                  <a:pt x="917" y="71"/>
                </a:lnTo>
                <a:lnTo>
                  <a:pt x="919" y="70"/>
                </a:lnTo>
                <a:lnTo>
                  <a:pt x="922" y="70"/>
                </a:lnTo>
                <a:lnTo>
                  <a:pt x="924" y="70"/>
                </a:lnTo>
                <a:lnTo>
                  <a:pt x="926" y="70"/>
                </a:lnTo>
                <a:lnTo>
                  <a:pt x="928" y="70"/>
                </a:lnTo>
                <a:lnTo>
                  <a:pt x="930" y="70"/>
                </a:lnTo>
                <a:lnTo>
                  <a:pt x="932" y="70"/>
                </a:lnTo>
                <a:lnTo>
                  <a:pt x="934" y="70"/>
                </a:lnTo>
                <a:lnTo>
                  <a:pt x="936" y="70"/>
                </a:lnTo>
                <a:lnTo>
                  <a:pt x="938" y="70"/>
                </a:lnTo>
                <a:lnTo>
                  <a:pt x="940" y="70"/>
                </a:lnTo>
                <a:lnTo>
                  <a:pt x="942" y="70"/>
                </a:lnTo>
                <a:lnTo>
                  <a:pt x="944" y="69"/>
                </a:lnTo>
                <a:lnTo>
                  <a:pt x="946" y="69"/>
                </a:lnTo>
                <a:lnTo>
                  <a:pt x="948" y="69"/>
                </a:lnTo>
                <a:lnTo>
                  <a:pt x="950" y="69"/>
                </a:lnTo>
                <a:lnTo>
                  <a:pt x="952" y="69"/>
                </a:lnTo>
                <a:lnTo>
                  <a:pt x="954" y="69"/>
                </a:lnTo>
                <a:lnTo>
                  <a:pt x="957" y="69"/>
                </a:lnTo>
                <a:lnTo>
                  <a:pt x="959" y="69"/>
                </a:lnTo>
                <a:lnTo>
                  <a:pt x="961" y="69"/>
                </a:lnTo>
                <a:lnTo>
                  <a:pt x="963" y="69"/>
                </a:lnTo>
                <a:lnTo>
                  <a:pt x="965" y="68"/>
                </a:lnTo>
                <a:lnTo>
                  <a:pt x="966" y="68"/>
                </a:lnTo>
                <a:lnTo>
                  <a:pt x="968" y="68"/>
                </a:lnTo>
                <a:lnTo>
                  <a:pt x="970" y="68"/>
                </a:lnTo>
                <a:lnTo>
                  <a:pt x="972" y="68"/>
                </a:lnTo>
                <a:lnTo>
                  <a:pt x="975" y="68"/>
                </a:lnTo>
                <a:lnTo>
                  <a:pt x="977" y="68"/>
                </a:lnTo>
                <a:lnTo>
                  <a:pt x="979" y="68"/>
                </a:lnTo>
                <a:lnTo>
                  <a:pt x="981" y="68"/>
                </a:lnTo>
                <a:lnTo>
                  <a:pt x="983" y="68"/>
                </a:lnTo>
                <a:lnTo>
                  <a:pt x="985" y="67"/>
                </a:lnTo>
                <a:lnTo>
                  <a:pt x="987" y="67"/>
                </a:lnTo>
                <a:lnTo>
                  <a:pt x="989" y="67"/>
                </a:lnTo>
                <a:lnTo>
                  <a:pt x="992" y="67"/>
                </a:lnTo>
                <a:lnTo>
                  <a:pt x="993" y="67"/>
                </a:lnTo>
                <a:lnTo>
                  <a:pt x="995" y="67"/>
                </a:lnTo>
                <a:lnTo>
                  <a:pt x="997" y="67"/>
                </a:lnTo>
                <a:lnTo>
                  <a:pt x="999" y="67"/>
                </a:lnTo>
                <a:lnTo>
                  <a:pt x="1001" y="67"/>
                </a:lnTo>
                <a:lnTo>
                  <a:pt x="1003" y="66"/>
                </a:lnTo>
                <a:lnTo>
                  <a:pt x="1005" y="66"/>
                </a:lnTo>
                <a:lnTo>
                  <a:pt x="1007" y="66"/>
                </a:lnTo>
                <a:lnTo>
                  <a:pt x="1010" y="66"/>
                </a:lnTo>
                <a:lnTo>
                  <a:pt x="1012" y="66"/>
                </a:lnTo>
                <a:lnTo>
                  <a:pt x="1014" y="66"/>
                </a:lnTo>
                <a:lnTo>
                  <a:pt x="1016" y="66"/>
                </a:lnTo>
                <a:lnTo>
                  <a:pt x="1017" y="66"/>
                </a:lnTo>
                <a:lnTo>
                  <a:pt x="1019" y="65"/>
                </a:lnTo>
                <a:lnTo>
                  <a:pt x="1021" y="65"/>
                </a:lnTo>
                <a:lnTo>
                  <a:pt x="1023" y="65"/>
                </a:lnTo>
                <a:lnTo>
                  <a:pt x="1026" y="65"/>
                </a:lnTo>
                <a:lnTo>
                  <a:pt x="1028" y="65"/>
                </a:lnTo>
                <a:lnTo>
                  <a:pt x="1030" y="65"/>
                </a:lnTo>
                <a:lnTo>
                  <a:pt x="1032" y="65"/>
                </a:lnTo>
                <a:lnTo>
                  <a:pt x="1034" y="65"/>
                </a:lnTo>
                <a:lnTo>
                  <a:pt x="1036" y="65"/>
                </a:lnTo>
                <a:lnTo>
                  <a:pt x="1038" y="64"/>
                </a:lnTo>
                <a:lnTo>
                  <a:pt x="1040" y="64"/>
                </a:lnTo>
                <a:lnTo>
                  <a:pt x="1043" y="64"/>
                </a:lnTo>
                <a:lnTo>
                  <a:pt x="1044" y="64"/>
                </a:lnTo>
                <a:lnTo>
                  <a:pt x="1046" y="64"/>
                </a:lnTo>
                <a:lnTo>
                  <a:pt x="1048" y="64"/>
                </a:lnTo>
                <a:lnTo>
                  <a:pt x="1050" y="64"/>
                </a:lnTo>
                <a:lnTo>
                  <a:pt x="1052" y="64"/>
                </a:lnTo>
                <a:lnTo>
                  <a:pt x="1054" y="63"/>
                </a:lnTo>
                <a:lnTo>
                  <a:pt x="1056" y="63"/>
                </a:lnTo>
                <a:lnTo>
                  <a:pt x="1058" y="63"/>
                </a:lnTo>
                <a:lnTo>
                  <a:pt x="1061" y="63"/>
                </a:lnTo>
                <a:lnTo>
                  <a:pt x="1063" y="63"/>
                </a:lnTo>
                <a:lnTo>
                  <a:pt x="1065" y="63"/>
                </a:lnTo>
                <a:lnTo>
                  <a:pt x="1067" y="63"/>
                </a:lnTo>
                <a:lnTo>
                  <a:pt x="1068" y="63"/>
                </a:lnTo>
                <a:lnTo>
                  <a:pt x="1070" y="62"/>
                </a:lnTo>
                <a:lnTo>
                  <a:pt x="1072" y="62"/>
                </a:lnTo>
                <a:lnTo>
                  <a:pt x="1074" y="62"/>
                </a:lnTo>
                <a:lnTo>
                  <a:pt x="1077" y="62"/>
                </a:lnTo>
                <a:lnTo>
                  <a:pt x="1079" y="62"/>
                </a:lnTo>
                <a:lnTo>
                  <a:pt x="1081" y="62"/>
                </a:lnTo>
                <a:lnTo>
                  <a:pt x="1083" y="62"/>
                </a:lnTo>
                <a:lnTo>
                  <a:pt x="1085" y="62"/>
                </a:lnTo>
                <a:lnTo>
                  <a:pt x="1087" y="62"/>
                </a:lnTo>
                <a:lnTo>
                  <a:pt x="1089" y="61"/>
                </a:lnTo>
                <a:lnTo>
                  <a:pt x="1091" y="61"/>
                </a:lnTo>
                <a:lnTo>
                  <a:pt x="1093" y="61"/>
                </a:lnTo>
                <a:lnTo>
                  <a:pt x="1095" y="61"/>
                </a:lnTo>
                <a:lnTo>
                  <a:pt x="1097" y="61"/>
                </a:lnTo>
                <a:lnTo>
                  <a:pt x="1099" y="61"/>
                </a:lnTo>
                <a:lnTo>
                  <a:pt x="1101" y="61"/>
                </a:lnTo>
                <a:lnTo>
                  <a:pt x="1103" y="61"/>
                </a:lnTo>
                <a:lnTo>
                  <a:pt x="1105" y="61"/>
                </a:lnTo>
                <a:lnTo>
                  <a:pt x="1107" y="60"/>
                </a:lnTo>
                <a:lnTo>
                  <a:pt x="1109" y="60"/>
                </a:lnTo>
                <a:lnTo>
                  <a:pt x="1112" y="60"/>
                </a:lnTo>
                <a:lnTo>
                  <a:pt x="1114" y="60"/>
                </a:lnTo>
                <a:lnTo>
                  <a:pt x="1116" y="60"/>
                </a:lnTo>
                <a:lnTo>
                  <a:pt x="1118" y="60"/>
                </a:lnTo>
                <a:lnTo>
                  <a:pt x="1119" y="60"/>
                </a:lnTo>
                <a:lnTo>
                  <a:pt x="1121" y="60"/>
                </a:lnTo>
                <a:lnTo>
                  <a:pt x="1123" y="59"/>
                </a:lnTo>
                <a:lnTo>
                  <a:pt x="1125" y="59"/>
                </a:lnTo>
                <a:lnTo>
                  <a:pt x="1127" y="59"/>
                </a:lnTo>
                <a:lnTo>
                  <a:pt x="1130" y="59"/>
                </a:lnTo>
                <a:lnTo>
                  <a:pt x="1132" y="59"/>
                </a:lnTo>
                <a:lnTo>
                  <a:pt x="1134" y="59"/>
                </a:lnTo>
                <a:lnTo>
                  <a:pt x="1136" y="59"/>
                </a:lnTo>
                <a:lnTo>
                  <a:pt x="1138" y="59"/>
                </a:lnTo>
                <a:lnTo>
                  <a:pt x="1140" y="58"/>
                </a:lnTo>
                <a:lnTo>
                  <a:pt x="1142" y="58"/>
                </a:lnTo>
                <a:lnTo>
                  <a:pt x="1144" y="58"/>
                </a:lnTo>
                <a:lnTo>
                  <a:pt x="1146" y="58"/>
                </a:lnTo>
                <a:lnTo>
                  <a:pt x="1148" y="58"/>
                </a:lnTo>
                <a:lnTo>
                  <a:pt x="1150" y="58"/>
                </a:lnTo>
                <a:lnTo>
                  <a:pt x="1152" y="58"/>
                </a:lnTo>
                <a:lnTo>
                  <a:pt x="1154" y="58"/>
                </a:lnTo>
                <a:lnTo>
                  <a:pt x="1156" y="58"/>
                </a:lnTo>
                <a:lnTo>
                  <a:pt x="1158" y="58"/>
                </a:lnTo>
                <a:lnTo>
                  <a:pt x="1160" y="58"/>
                </a:lnTo>
                <a:lnTo>
                  <a:pt x="1163" y="57"/>
                </a:lnTo>
                <a:lnTo>
                  <a:pt x="1165" y="57"/>
                </a:lnTo>
                <a:lnTo>
                  <a:pt x="1167" y="57"/>
                </a:lnTo>
                <a:lnTo>
                  <a:pt x="1169" y="57"/>
                </a:lnTo>
                <a:lnTo>
                  <a:pt x="1170" y="57"/>
                </a:lnTo>
                <a:lnTo>
                  <a:pt x="1172" y="56"/>
                </a:lnTo>
                <a:lnTo>
                  <a:pt x="1174" y="56"/>
                </a:lnTo>
                <a:lnTo>
                  <a:pt x="1176" y="56"/>
                </a:lnTo>
                <a:lnTo>
                  <a:pt x="1178" y="56"/>
                </a:lnTo>
                <a:lnTo>
                  <a:pt x="1181" y="56"/>
                </a:lnTo>
                <a:lnTo>
                  <a:pt x="1183" y="55"/>
                </a:lnTo>
                <a:lnTo>
                  <a:pt x="1185" y="55"/>
                </a:lnTo>
                <a:lnTo>
                  <a:pt x="1187" y="55"/>
                </a:lnTo>
                <a:lnTo>
                  <a:pt x="1189" y="55"/>
                </a:lnTo>
                <a:lnTo>
                  <a:pt x="1191" y="55"/>
                </a:lnTo>
                <a:lnTo>
                  <a:pt x="1193" y="55"/>
                </a:lnTo>
                <a:lnTo>
                  <a:pt x="1195" y="55"/>
                </a:lnTo>
                <a:lnTo>
                  <a:pt x="1197" y="55"/>
                </a:lnTo>
                <a:lnTo>
                  <a:pt x="1199" y="54"/>
                </a:lnTo>
                <a:lnTo>
                  <a:pt x="1201" y="54"/>
                </a:lnTo>
                <a:lnTo>
                  <a:pt x="1203" y="54"/>
                </a:lnTo>
                <a:lnTo>
                  <a:pt x="1205" y="54"/>
                </a:lnTo>
                <a:lnTo>
                  <a:pt x="1207" y="54"/>
                </a:lnTo>
                <a:lnTo>
                  <a:pt x="1209" y="54"/>
                </a:lnTo>
                <a:lnTo>
                  <a:pt x="1211" y="54"/>
                </a:lnTo>
                <a:lnTo>
                  <a:pt x="1213" y="54"/>
                </a:lnTo>
                <a:lnTo>
                  <a:pt x="1216" y="54"/>
                </a:lnTo>
                <a:lnTo>
                  <a:pt x="1218" y="54"/>
                </a:lnTo>
                <a:lnTo>
                  <a:pt x="1220" y="54"/>
                </a:lnTo>
                <a:lnTo>
                  <a:pt x="1221" y="54"/>
                </a:lnTo>
                <a:lnTo>
                  <a:pt x="1223" y="53"/>
                </a:lnTo>
                <a:lnTo>
                  <a:pt x="1225" y="53"/>
                </a:lnTo>
                <a:lnTo>
                  <a:pt x="1227" y="53"/>
                </a:lnTo>
                <a:lnTo>
                  <a:pt x="1229" y="53"/>
                </a:lnTo>
                <a:lnTo>
                  <a:pt x="1232" y="53"/>
                </a:lnTo>
                <a:lnTo>
                  <a:pt x="1234" y="53"/>
                </a:lnTo>
                <a:lnTo>
                  <a:pt x="1236" y="53"/>
                </a:lnTo>
                <a:lnTo>
                  <a:pt x="1238" y="53"/>
                </a:lnTo>
                <a:lnTo>
                  <a:pt x="1240" y="53"/>
                </a:lnTo>
                <a:lnTo>
                  <a:pt x="1242" y="53"/>
                </a:lnTo>
                <a:lnTo>
                  <a:pt x="1244" y="53"/>
                </a:lnTo>
                <a:lnTo>
                  <a:pt x="1246" y="53"/>
                </a:lnTo>
                <a:lnTo>
                  <a:pt x="1248" y="53"/>
                </a:lnTo>
                <a:lnTo>
                  <a:pt x="1250" y="53"/>
                </a:lnTo>
                <a:lnTo>
                  <a:pt x="1252" y="53"/>
                </a:lnTo>
                <a:lnTo>
                  <a:pt x="1254" y="53"/>
                </a:lnTo>
                <a:lnTo>
                  <a:pt x="1256" y="52"/>
                </a:lnTo>
                <a:lnTo>
                  <a:pt x="1258" y="52"/>
                </a:lnTo>
                <a:lnTo>
                  <a:pt x="1260" y="52"/>
                </a:lnTo>
                <a:lnTo>
                  <a:pt x="1262" y="52"/>
                </a:lnTo>
                <a:lnTo>
                  <a:pt x="1264" y="52"/>
                </a:lnTo>
                <a:lnTo>
                  <a:pt x="1267" y="52"/>
                </a:lnTo>
                <a:lnTo>
                  <a:pt x="1269" y="52"/>
                </a:lnTo>
                <a:lnTo>
                  <a:pt x="1271" y="52"/>
                </a:lnTo>
                <a:lnTo>
                  <a:pt x="1272" y="52"/>
                </a:lnTo>
                <a:lnTo>
                  <a:pt x="1274" y="51"/>
                </a:lnTo>
                <a:lnTo>
                  <a:pt x="1276" y="51"/>
                </a:lnTo>
                <a:lnTo>
                  <a:pt x="1278" y="51"/>
                </a:lnTo>
                <a:lnTo>
                  <a:pt x="1280" y="51"/>
                </a:lnTo>
                <a:lnTo>
                  <a:pt x="1283" y="51"/>
                </a:lnTo>
                <a:lnTo>
                  <a:pt x="1285" y="51"/>
                </a:lnTo>
                <a:lnTo>
                  <a:pt x="1287" y="50"/>
                </a:lnTo>
                <a:lnTo>
                  <a:pt x="1289" y="50"/>
                </a:lnTo>
                <a:lnTo>
                  <a:pt x="1291" y="50"/>
                </a:lnTo>
                <a:lnTo>
                  <a:pt x="1293" y="50"/>
                </a:lnTo>
                <a:lnTo>
                  <a:pt x="1295" y="50"/>
                </a:lnTo>
                <a:lnTo>
                  <a:pt x="1297" y="49"/>
                </a:lnTo>
                <a:lnTo>
                  <a:pt x="1298" y="49"/>
                </a:lnTo>
                <a:lnTo>
                  <a:pt x="1301" y="49"/>
                </a:lnTo>
                <a:lnTo>
                  <a:pt x="1303" y="49"/>
                </a:lnTo>
                <a:lnTo>
                  <a:pt x="1305" y="48"/>
                </a:lnTo>
                <a:lnTo>
                  <a:pt x="1307" y="48"/>
                </a:lnTo>
                <a:lnTo>
                  <a:pt x="1309" y="48"/>
                </a:lnTo>
                <a:lnTo>
                  <a:pt x="1311" y="47"/>
                </a:lnTo>
                <a:lnTo>
                  <a:pt x="1313" y="47"/>
                </a:lnTo>
                <a:lnTo>
                  <a:pt x="1315" y="47"/>
                </a:lnTo>
                <a:lnTo>
                  <a:pt x="1318" y="46"/>
                </a:lnTo>
                <a:lnTo>
                  <a:pt x="1320" y="46"/>
                </a:lnTo>
                <a:lnTo>
                  <a:pt x="1322" y="46"/>
                </a:lnTo>
                <a:lnTo>
                  <a:pt x="1323" y="46"/>
                </a:lnTo>
                <a:lnTo>
                  <a:pt x="1325" y="45"/>
                </a:lnTo>
                <a:lnTo>
                  <a:pt x="1327" y="45"/>
                </a:lnTo>
                <a:lnTo>
                  <a:pt x="1329" y="45"/>
                </a:lnTo>
                <a:lnTo>
                  <a:pt x="1331" y="45"/>
                </a:lnTo>
                <a:lnTo>
                  <a:pt x="1333" y="45"/>
                </a:lnTo>
                <a:lnTo>
                  <a:pt x="1336" y="45"/>
                </a:lnTo>
                <a:lnTo>
                  <a:pt x="1338" y="45"/>
                </a:lnTo>
                <a:lnTo>
                  <a:pt x="1340" y="45"/>
                </a:lnTo>
                <a:lnTo>
                  <a:pt x="1342" y="44"/>
                </a:lnTo>
                <a:lnTo>
                  <a:pt x="1344" y="44"/>
                </a:lnTo>
                <a:lnTo>
                  <a:pt x="1346" y="44"/>
                </a:lnTo>
                <a:lnTo>
                  <a:pt x="1348" y="44"/>
                </a:lnTo>
                <a:lnTo>
                  <a:pt x="1349" y="44"/>
                </a:lnTo>
                <a:lnTo>
                  <a:pt x="1352" y="44"/>
                </a:lnTo>
                <a:lnTo>
                  <a:pt x="1354" y="44"/>
                </a:lnTo>
                <a:lnTo>
                  <a:pt x="1356" y="44"/>
                </a:lnTo>
                <a:lnTo>
                  <a:pt x="1358" y="44"/>
                </a:lnTo>
                <a:lnTo>
                  <a:pt x="1360" y="44"/>
                </a:lnTo>
                <a:lnTo>
                  <a:pt x="1362" y="44"/>
                </a:lnTo>
                <a:lnTo>
                  <a:pt x="1364" y="44"/>
                </a:lnTo>
                <a:lnTo>
                  <a:pt x="1366" y="44"/>
                </a:lnTo>
                <a:lnTo>
                  <a:pt x="1369" y="44"/>
                </a:lnTo>
                <a:lnTo>
                  <a:pt x="1371" y="44"/>
                </a:lnTo>
                <a:lnTo>
                  <a:pt x="1373" y="44"/>
                </a:lnTo>
                <a:lnTo>
                  <a:pt x="1375" y="44"/>
                </a:lnTo>
                <a:lnTo>
                  <a:pt x="1376" y="44"/>
                </a:lnTo>
                <a:lnTo>
                  <a:pt x="1378" y="44"/>
                </a:lnTo>
                <a:lnTo>
                  <a:pt x="1380" y="44"/>
                </a:lnTo>
                <a:lnTo>
                  <a:pt x="1382" y="43"/>
                </a:lnTo>
                <a:lnTo>
                  <a:pt x="1384" y="43"/>
                </a:lnTo>
                <a:lnTo>
                  <a:pt x="1387" y="43"/>
                </a:lnTo>
                <a:lnTo>
                  <a:pt x="1389" y="43"/>
                </a:lnTo>
                <a:lnTo>
                  <a:pt x="1391" y="43"/>
                </a:lnTo>
                <a:lnTo>
                  <a:pt x="1393" y="43"/>
                </a:lnTo>
                <a:lnTo>
                  <a:pt x="1395" y="43"/>
                </a:lnTo>
                <a:lnTo>
                  <a:pt x="1397" y="43"/>
                </a:lnTo>
                <a:lnTo>
                  <a:pt x="1399" y="42"/>
                </a:lnTo>
                <a:lnTo>
                  <a:pt x="1400" y="42"/>
                </a:lnTo>
                <a:lnTo>
                  <a:pt x="1403" y="42"/>
                </a:lnTo>
                <a:lnTo>
                  <a:pt x="1405" y="42"/>
                </a:lnTo>
                <a:lnTo>
                  <a:pt x="1407" y="42"/>
                </a:lnTo>
                <a:lnTo>
                  <a:pt x="1409" y="42"/>
                </a:lnTo>
                <a:lnTo>
                  <a:pt x="1411" y="42"/>
                </a:lnTo>
                <a:lnTo>
                  <a:pt x="1413" y="42"/>
                </a:lnTo>
                <a:lnTo>
                  <a:pt x="1415" y="41"/>
                </a:lnTo>
                <a:lnTo>
                  <a:pt x="1417" y="41"/>
                </a:lnTo>
                <a:lnTo>
                  <a:pt x="1419" y="41"/>
                </a:lnTo>
                <a:lnTo>
                  <a:pt x="1422" y="41"/>
                </a:lnTo>
                <a:lnTo>
                  <a:pt x="1424" y="41"/>
                </a:lnTo>
                <a:lnTo>
                  <a:pt x="1426" y="41"/>
                </a:lnTo>
                <a:lnTo>
                  <a:pt x="1427" y="41"/>
                </a:lnTo>
                <a:lnTo>
                  <a:pt x="1429" y="41"/>
                </a:lnTo>
                <a:lnTo>
                  <a:pt x="1431" y="40"/>
                </a:lnTo>
                <a:lnTo>
                  <a:pt x="1433" y="40"/>
                </a:lnTo>
                <a:lnTo>
                  <a:pt x="1435" y="40"/>
                </a:lnTo>
                <a:lnTo>
                  <a:pt x="1438" y="40"/>
                </a:lnTo>
                <a:lnTo>
                  <a:pt x="1440" y="40"/>
                </a:lnTo>
                <a:lnTo>
                  <a:pt x="1442" y="40"/>
                </a:lnTo>
                <a:lnTo>
                  <a:pt x="1444" y="40"/>
                </a:lnTo>
                <a:lnTo>
                  <a:pt x="1446" y="40"/>
                </a:lnTo>
                <a:lnTo>
                  <a:pt x="1448" y="40"/>
                </a:lnTo>
                <a:lnTo>
                  <a:pt x="1450" y="40"/>
                </a:lnTo>
                <a:lnTo>
                  <a:pt x="1451" y="40"/>
                </a:lnTo>
                <a:lnTo>
                  <a:pt x="1453" y="40"/>
                </a:lnTo>
                <a:lnTo>
                  <a:pt x="1456" y="40"/>
                </a:lnTo>
                <a:lnTo>
                  <a:pt x="1458" y="40"/>
                </a:lnTo>
                <a:lnTo>
                  <a:pt x="1460" y="40"/>
                </a:lnTo>
                <a:lnTo>
                  <a:pt x="1462" y="39"/>
                </a:lnTo>
                <a:lnTo>
                  <a:pt x="1464" y="39"/>
                </a:lnTo>
                <a:lnTo>
                  <a:pt x="1466" y="39"/>
                </a:lnTo>
                <a:lnTo>
                  <a:pt x="1468" y="39"/>
                </a:lnTo>
                <a:lnTo>
                  <a:pt x="1470" y="39"/>
                </a:lnTo>
                <a:lnTo>
                  <a:pt x="1473" y="39"/>
                </a:lnTo>
                <a:lnTo>
                  <a:pt x="1475" y="39"/>
                </a:lnTo>
                <a:lnTo>
                  <a:pt x="1477" y="38"/>
                </a:lnTo>
                <a:lnTo>
                  <a:pt x="1478" y="38"/>
                </a:lnTo>
                <a:lnTo>
                  <a:pt x="1480" y="38"/>
                </a:lnTo>
                <a:lnTo>
                  <a:pt x="1482" y="37"/>
                </a:lnTo>
                <a:lnTo>
                  <a:pt x="1484" y="37"/>
                </a:lnTo>
                <a:lnTo>
                  <a:pt x="1486" y="37"/>
                </a:lnTo>
                <a:lnTo>
                  <a:pt x="1489" y="37"/>
                </a:lnTo>
                <a:lnTo>
                  <a:pt x="1491" y="36"/>
                </a:lnTo>
                <a:lnTo>
                  <a:pt x="1493" y="37"/>
                </a:lnTo>
                <a:lnTo>
                  <a:pt x="1495" y="37"/>
                </a:lnTo>
                <a:lnTo>
                  <a:pt x="1497" y="37"/>
                </a:lnTo>
                <a:lnTo>
                  <a:pt x="1499" y="37"/>
                </a:lnTo>
                <a:lnTo>
                  <a:pt x="1501" y="37"/>
                </a:lnTo>
                <a:lnTo>
                  <a:pt x="1502" y="37"/>
                </a:lnTo>
                <a:lnTo>
                  <a:pt x="1504" y="37"/>
                </a:lnTo>
                <a:lnTo>
                  <a:pt x="1507" y="37"/>
                </a:lnTo>
                <a:lnTo>
                  <a:pt x="1509" y="37"/>
                </a:lnTo>
                <a:lnTo>
                  <a:pt x="1511" y="37"/>
                </a:lnTo>
                <a:lnTo>
                  <a:pt x="1513" y="37"/>
                </a:lnTo>
                <a:lnTo>
                  <a:pt x="1515" y="37"/>
                </a:lnTo>
                <a:lnTo>
                  <a:pt x="1517" y="36"/>
                </a:lnTo>
                <a:lnTo>
                  <a:pt x="1519" y="36"/>
                </a:lnTo>
                <a:lnTo>
                  <a:pt x="1521" y="36"/>
                </a:lnTo>
                <a:lnTo>
                  <a:pt x="1524" y="36"/>
                </a:lnTo>
                <a:lnTo>
                  <a:pt x="1526" y="36"/>
                </a:lnTo>
                <a:lnTo>
                  <a:pt x="1528" y="36"/>
                </a:lnTo>
                <a:lnTo>
                  <a:pt x="1529" y="36"/>
                </a:lnTo>
                <a:lnTo>
                  <a:pt x="1531" y="36"/>
                </a:lnTo>
                <a:lnTo>
                  <a:pt x="1533" y="35"/>
                </a:lnTo>
                <a:lnTo>
                  <a:pt x="1535" y="35"/>
                </a:lnTo>
                <a:lnTo>
                  <a:pt x="1537" y="35"/>
                </a:lnTo>
                <a:lnTo>
                  <a:pt x="1539" y="35"/>
                </a:lnTo>
                <a:lnTo>
                  <a:pt x="1542" y="35"/>
                </a:lnTo>
                <a:lnTo>
                  <a:pt x="1544" y="35"/>
                </a:lnTo>
                <a:lnTo>
                  <a:pt x="1546" y="35"/>
                </a:lnTo>
                <a:lnTo>
                  <a:pt x="1548" y="34"/>
                </a:lnTo>
                <a:lnTo>
                  <a:pt x="1550" y="34"/>
                </a:lnTo>
                <a:lnTo>
                  <a:pt x="1552" y="34"/>
                </a:lnTo>
                <a:lnTo>
                  <a:pt x="1553" y="34"/>
                </a:lnTo>
                <a:lnTo>
                  <a:pt x="1555" y="34"/>
                </a:lnTo>
                <a:lnTo>
                  <a:pt x="1558" y="34"/>
                </a:lnTo>
                <a:lnTo>
                  <a:pt x="1560" y="33"/>
                </a:lnTo>
                <a:lnTo>
                  <a:pt x="1562" y="33"/>
                </a:lnTo>
                <a:lnTo>
                  <a:pt x="1564" y="33"/>
                </a:lnTo>
                <a:lnTo>
                  <a:pt x="1566" y="33"/>
                </a:lnTo>
                <a:lnTo>
                  <a:pt x="1568" y="33"/>
                </a:lnTo>
                <a:lnTo>
                  <a:pt x="1570" y="33"/>
                </a:lnTo>
                <a:lnTo>
                  <a:pt x="1572" y="33"/>
                </a:lnTo>
                <a:lnTo>
                  <a:pt x="1574" y="32"/>
                </a:lnTo>
                <a:lnTo>
                  <a:pt x="1577" y="32"/>
                </a:lnTo>
                <a:lnTo>
                  <a:pt x="1579" y="32"/>
                </a:lnTo>
                <a:lnTo>
                  <a:pt x="1580" y="32"/>
                </a:lnTo>
                <a:lnTo>
                  <a:pt x="1582" y="32"/>
                </a:lnTo>
                <a:lnTo>
                  <a:pt x="1584" y="32"/>
                </a:lnTo>
                <a:lnTo>
                  <a:pt x="1586" y="31"/>
                </a:lnTo>
                <a:lnTo>
                  <a:pt x="1588" y="31"/>
                </a:lnTo>
                <a:lnTo>
                  <a:pt x="1590" y="31"/>
                </a:lnTo>
                <a:lnTo>
                  <a:pt x="1593" y="31"/>
                </a:lnTo>
                <a:lnTo>
                  <a:pt x="1595" y="31"/>
                </a:lnTo>
                <a:lnTo>
                  <a:pt x="1597" y="30"/>
                </a:lnTo>
                <a:lnTo>
                  <a:pt x="1599" y="30"/>
                </a:lnTo>
                <a:lnTo>
                  <a:pt x="1601" y="30"/>
                </a:lnTo>
                <a:lnTo>
                  <a:pt x="1603" y="30"/>
                </a:lnTo>
                <a:lnTo>
                  <a:pt x="1604" y="30"/>
                </a:lnTo>
                <a:lnTo>
                  <a:pt x="1606" y="29"/>
                </a:lnTo>
                <a:lnTo>
                  <a:pt x="1609" y="29"/>
                </a:lnTo>
                <a:lnTo>
                  <a:pt x="1611" y="29"/>
                </a:lnTo>
                <a:lnTo>
                  <a:pt x="1613" y="29"/>
                </a:lnTo>
                <a:lnTo>
                  <a:pt x="1615" y="29"/>
                </a:lnTo>
                <a:lnTo>
                  <a:pt x="1617" y="28"/>
                </a:lnTo>
                <a:lnTo>
                  <a:pt x="1619" y="28"/>
                </a:lnTo>
                <a:lnTo>
                  <a:pt x="1621" y="28"/>
                </a:lnTo>
                <a:lnTo>
                  <a:pt x="1623" y="28"/>
                </a:lnTo>
                <a:lnTo>
                  <a:pt x="1625" y="28"/>
                </a:lnTo>
                <a:lnTo>
                  <a:pt x="1628" y="28"/>
                </a:lnTo>
                <a:lnTo>
                  <a:pt x="1630" y="27"/>
                </a:lnTo>
                <a:lnTo>
                  <a:pt x="1631" y="27"/>
                </a:lnTo>
                <a:lnTo>
                  <a:pt x="1633" y="27"/>
                </a:lnTo>
                <a:lnTo>
                  <a:pt x="1635" y="27"/>
                </a:lnTo>
                <a:lnTo>
                  <a:pt x="1637" y="27"/>
                </a:lnTo>
                <a:lnTo>
                  <a:pt x="1639" y="27"/>
                </a:lnTo>
                <a:lnTo>
                  <a:pt x="1641" y="27"/>
                </a:lnTo>
                <a:lnTo>
                  <a:pt x="1644" y="26"/>
                </a:lnTo>
                <a:lnTo>
                  <a:pt x="1646" y="26"/>
                </a:lnTo>
                <a:lnTo>
                  <a:pt x="1648" y="26"/>
                </a:lnTo>
                <a:lnTo>
                  <a:pt x="1650" y="26"/>
                </a:lnTo>
                <a:lnTo>
                  <a:pt x="1652" y="26"/>
                </a:lnTo>
                <a:lnTo>
                  <a:pt x="1654" y="26"/>
                </a:lnTo>
                <a:lnTo>
                  <a:pt x="1655" y="25"/>
                </a:lnTo>
                <a:lnTo>
                  <a:pt x="1657" y="25"/>
                </a:lnTo>
                <a:lnTo>
                  <a:pt x="1659" y="25"/>
                </a:lnTo>
                <a:lnTo>
                  <a:pt x="1662" y="25"/>
                </a:lnTo>
                <a:lnTo>
                  <a:pt x="1664" y="25"/>
                </a:lnTo>
                <a:lnTo>
                  <a:pt x="1666" y="25"/>
                </a:lnTo>
                <a:lnTo>
                  <a:pt x="1668" y="24"/>
                </a:lnTo>
                <a:lnTo>
                  <a:pt x="1670" y="24"/>
                </a:lnTo>
                <a:lnTo>
                  <a:pt x="1672" y="24"/>
                </a:lnTo>
                <a:lnTo>
                  <a:pt x="1674" y="24"/>
                </a:lnTo>
                <a:lnTo>
                  <a:pt x="1676" y="24"/>
                </a:lnTo>
                <a:lnTo>
                  <a:pt x="1679" y="23"/>
                </a:lnTo>
                <a:lnTo>
                  <a:pt x="1681" y="23"/>
                </a:lnTo>
                <a:lnTo>
                  <a:pt x="1682" y="23"/>
                </a:lnTo>
                <a:lnTo>
                  <a:pt x="1684" y="23"/>
                </a:lnTo>
                <a:lnTo>
                  <a:pt x="1686" y="23"/>
                </a:lnTo>
                <a:lnTo>
                  <a:pt x="1688" y="22"/>
                </a:lnTo>
                <a:lnTo>
                  <a:pt x="1690" y="22"/>
                </a:lnTo>
                <a:lnTo>
                  <a:pt x="1692" y="22"/>
                </a:lnTo>
                <a:lnTo>
                  <a:pt x="1694" y="22"/>
                </a:lnTo>
                <a:lnTo>
                  <a:pt x="1697" y="22"/>
                </a:lnTo>
                <a:lnTo>
                  <a:pt x="1699" y="22"/>
                </a:lnTo>
                <a:lnTo>
                  <a:pt x="1701" y="21"/>
                </a:lnTo>
                <a:lnTo>
                  <a:pt x="1703" y="21"/>
                </a:lnTo>
                <a:lnTo>
                  <a:pt x="1705" y="21"/>
                </a:lnTo>
                <a:lnTo>
                  <a:pt x="1706" y="21"/>
                </a:lnTo>
                <a:lnTo>
                  <a:pt x="1708" y="21"/>
                </a:lnTo>
                <a:lnTo>
                  <a:pt x="1710" y="20"/>
                </a:lnTo>
                <a:lnTo>
                  <a:pt x="1713" y="20"/>
                </a:lnTo>
                <a:lnTo>
                  <a:pt x="1715" y="20"/>
                </a:lnTo>
                <a:lnTo>
                  <a:pt x="1717" y="20"/>
                </a:lnTo>
                <a:lnTo>
                  <a:pt x="1719" y="20"/>
                </a:lnTo>
                <a:lnTo>
                  <a:pt x="1721" y="19"/>
                </a:lnTo>
                <a:lnTo>
                  <a:pt x="1723" y="19"/>
                </a:lnTo>
                <a:lnTo>
                  <a:pt x="1725" y="19"/>
                </a:lnTo>
                <a:lnTo>
                  <a:pt x="1727" y="19"/>
                </a:lnTo>
                <a:lnTo>
                  <a:pt x="1730" y="19"/>
                </a:lnTo>
                <a:lnTo>
                  <a:pt x="1732" y="19"/>
                </a:lnTo>
                <a:lnTo>
                  <a:pt x="1733" y="18"/>
                </a:lnTo>
                <a:lnTo>
                  <a:pt x="1735" y="18"/>
                </a:lnTo>
                <a:lnTo>
                  <a:pt x="1737" y="18"/>
                </a:lnTo>
                <a:lnTo>
                  <a:pt x="1739" y="18"/>
                </a:lnTo>
                <a:lnTo>
                  <a:pt x="1741" y="17"/>
                </a:lnTo>
                <a:lnTo>
                  <a:pt x="1743" y="17"/>
                </a:lnTo>
                <a:lnTo>
                  <a:pt x="1745" y="17"/>
                </a:lnTo>
                <a:lnTo>
                  <a:pt x="1748" y="17"/>
                </a:lnTo>
                <a:lnTo>
                  <a:pt x="1750" y="16"/>
                </a:lnTo>
                <a:lnTo>
                  <a:pt x="1752" y="16"/>
                </a:lnTo>
                <a:lnTo>
                  <a:pt x="1754" y="16"/>
                </a:lnTo>
                <a:lnTo>
                  <a:pt x="1756" y="16"/>
                </a:lnTo>
                <a:lnTo>
                  <a:pt x="1757" y="16"/>
                </a:lnTo>
                <a:lnTo>
                  <a:pt x="1759" y="15"/>
                </a:lnTo>
                <a:lnTo>
                  <a:pt x="1761" y="15"/>
                </a:lnTo>
                <a:lnTo>
                  <a:pt x="1764" y="15"/>
                </a:lnTo>
                <a:lnTo>
                  <a:pt x="1766" y="15"/>
                </a:lnTo>
                <a:lnTo>
                  <a:pt x="1768" y="14"/>
                </a:lnTo>
                <a:lnTo>
                  <a:pt x="1770" y="14"/>
                </a:lnTo>
                <a:lnTo>
                  <a:pt x="1772" y="14"/>
                </a:lnTo>
                <a:lnTo>
                  <a:pt x="1774" y="14"/>
                </a:lnTo>
                <a:lnTo>
                  <a:pt x="1776" y="14"/>
                </a:lnTo>
                <a:lnTo>
                  <a:pt x="1778" y="14"/>
                </a:lnTo>
                <a:lnTo>
                  <a:pt x="1780" y="13"/>
                </a:lnTo>
                <a:lnTo>
                  <a:pt x="1783" y="13"/>
                </a:lnTo>
                <a:lnTo>
                  <a:pt x="1784" y="13"/>
                </a:lnTo>
                <a:lnTo>
                  <a:pt x="1786" y="13"/>
                </a:lnTo>
                <a:lnTo>
                  <a:pt x="1788" y="12"/>
                </a:lnTo>
                <a:lnTo>
                  <a:pt x="1790" y="12"/>
                </a:lnTo>
                <a:lnTo>
                  <a:pt x="1792" y="11"/>
                </a:lnTo>
                <a:lnTo>
                  <a:pt x="1794" y="10"/>
                </a:lnTo>
                <a:lnTo>
                  <a:pt x="1796" y="9"/>
                </a:lnTo>
                <a:lnTo>
                  <a:pt x="1799" y="8"/>
                </a:lnTo>
                <a:lnTo>
                  <a:pt x="1801" y="7"/>
                </a:lnTo>
                <a:lnTo>
                  <a:pt x="1803" y="7"/>
                </a:lnTo>
                <a:lnTo>
                  <a:pt x="1805" y="6"/>
                </a:lnTo>
                <a:lnTo>
                  <a:pt x="1807" y="6"/>
                </a:lnTo>
                <a:lnTo>
                  <a:pt x="1809" y="5"/>
                </a:lnTo>
                <a:lnTo>
                  <a:pt x="1810" y="5"/>
                </a:lnTo>
                <a:lnTo>
                  <a:pt x="1812" y="5"/>
                </a:lnTo>
                <a:lnTo>
                  <a:pt x="1814" y="4"/>
                </a:lnTo>
                <a:lnTo>
                  <a:pt x="1817" y="4"/>
                </a:lnTo>
                <a:lnTo>
                  <a:pt x="1819" y="4"/>
                </a:lnTo>
                <a:lnTo>
                  <a:pt x="1821" y="4"/>
                </a:lnTo>
                <a:lnTo>
                  <a:pt x="1823" y="4"/>
                </a:lnTo>
                <a:lnTo>
                  <a:pt x="1825" y="4"/>
                </a:lnTo>
                <a:lnTo>
                  <a:pt x="1827" y="4"/>
                </a:lnTo>
                <a:lnTo>
                  <a:pt x="1829" y="4"/>
                </a:lnTo>
                <a:lnTo>
                  <a:pt x="1831" y="4"/>
                </a:lnTo>
                <a:lnTo>
                  <a:pt x="1834" y="4"/>
                </a:lnTo>
                <a:lnTo>
                  <a:pt x="1835" y="4"/>
                </a:lnTo>
                <a:lnTo>
                  <a:pt x="1837" y="4"/>
                </a:lnTo>
                <a:lnTo>
                  <a:pt x="1839" y="4"/>
                </a:lnTo>
                <a:lnTo>
                  <a:pt x="1841" y="3"/>
                </a:lnTo>
                <a:lnTo>
                  <a:pt x="1843" y="3"/>
                </a:lnTo>
                <a:lnTo>
                  <a:pt x="1845" y="3"/>
                </a:lnTo>
                <a:lnTo>
                  <a:pt x="1847" y="3"/>
                </a:lnTo>
                <a:lnTo>
                  <a:pt x="1850" y="2"/>
                </a:lnTo>
                <a:lnTo>
                  <a:pt x="1852" y="2"/>
                </a:lnTo>
                <a:lnTo>
                  <a:pt x="1854" y="2"/>
                </a:lnTo>
                <a:lnTo>
                  <a:pt x="1856" y="2"/>
                </a:lnTo>
                <a:lnTo>
                  <a:pt x="1858" y="1"/>
                </a:lnTo>
                <a:lnTo>
                  <a:pt x="1860" y="1"/>
                </a:lnTo>
                <a:lnTo>
                  <a:pt x="1861" y="1"/>
                </a:lnTo>
                <a:lnTo>
                  <a:pt x="1863" y="1"/>
                </a:lnTo>
                <a:lnTo>
                  <a:pt x="1865" y="0"/>
                </a:lnTo>
                <a:lnTo>
                  <a:pt x="1868" y="0"/>
                </a:lnTo>
                <a:lnTo>
                  <a:pt x="1870" y="0"/>
                </a:lnTo>
                <a:lnTo>
                  <a:pt x="1872" y="0"/>
                </a:lnTo>
                <a:lnTo>
                  <a:pt x="1874" y="0"/>
                </a:lnTo>
                <a:lnTo>
                  <a:pt x="1876" y="0"/>
                </a:lnTo>
                <a:lnTo>
                  <a:pt x="1878" y="0"/>
                </a:lnTo>
                <a:lnTo>
                  <a:pt x="1880" y="0"/>
                </a:lnTo>
                <a:lnTo>
                  <a:pt x="18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Rectangle 120">
            <a:extLst>
              <a:ext uri="{FF2B5EF4-FFF2-40B4-BE49-F238E27FC236}">
                <a16:creationId xmlns:a16="http://schemas.microsoft.com/office/drawing/2014/main" id="{D1DC5BEF-D9D8-6354-E098-C442151238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0625" y="1182768"/>
            <a:ext cx="2976563" cy="879475"/>
          </a:xfrm>
          <a:prstGeom prst="rect">
            <a:avLst/>
          </a:prstGeom>
          <a:noFill/>
          <a:ln w="12700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Line 17">
            <a:extLst>
              <a:ext uri="{FF2B5EF4-FFF2-40B4-BE49-F238E27FC236}">
                <a16:creationId xmlns:a16="http://schemas.microsoft.com/office/drawing/2014/main" id="{24759782-02A7-EA6B-7C11-A6DB01C41BE4}"/>
              </a:ext>
            </a:extLst>
          </p:cNvPr>
          <p:cNvSpPr>
            <a:spLocks noChangeShapeType="1"/>
          </p:cNvSpPr>
          <p:nvPr/>
        </p:nvSpPr>
        <p:spPr bwMode="auto">
          <a:xfrm>
            <a:off x="4158836" y="2061060"/>
            <a:ext cx="0" cy="2857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Line 25">
            <a:extLst>
              <a:ext uri="{FF2B5EF4-FFF2-40B4-BE49-F238E27FC236}">
                <a16:creationId xmlns:a16="http://schemas.microsoft.com/office/drawing/2014/main" id="{4F145F0F-2238-C9F2-1082-5A5E3736A89C}"/>
              </a:ext>
            </a:extLst>
          </p:cNvPr>
          <p:cNvSpPr>
            <a:spLocks noChangeShapeType="1"/>
          </p:cNvSpPr>
          <p:nvPr/>
        </p:nvSpPr>
        <p:spPr bwMode="auto">
          <a:xfrm>
            <a:off x="4158836" y="2061060"/>
            <a:ext cx="0" cy="55563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Rectangle 24">
            <a:extLst>
              <a:ext uri="{FF2B5EF4-FFF2-40B4-BE49-F238E27FC236}">
                <a16:creationId xmlns:a16="http://schemas.microsoft.com/office/drawing/2014/main" id="{BB2C611F-8D9D-E10D-B543-ABCB3BDB2D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9320" y="2152731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1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4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" name="Line 17">
            <a:extLst>
              <a:ext uri="{FF2B5EF4-FFF2-40B4-BE49-F238E27FC236}">
                <a16:creationId xmlns:a16="http://schemas.microsoft.com/office/drawing/2014/main" id="{49D1BC8F-66FD-6561-1A22-856E5099CC42}"/>
              </a:ext>
            </a:extLst>
          </p:cNvPr>
          <p:cNvSpPr>
            <a:spLocks noChangeShapeType="1"/>
          </p:cNvSpPr>
          <p:nvPr/>
        </p:nvSpPr>
        <p:spPr bwMode="auto">
          <a:xfrm>
            <a:off x="1187001" y="2057888"/>
            <a:ext cx="0" cy="2857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" name="Line 25">
            <a:extLst>
              <a:ext uri="{FF2B5EF4-FFF2-40B4-BE49-F238E27FC236}">
                <a16:creationId xmlns:a16="http://schemas.microsoft.com/office/drawing/2014/main" id="{CC160163-04F5-C32E-BB84-F57AF3BDE39C}"/>
              </a:ext>
            </a:extLst>
          </p:cNvPr>
          <p:cNvSpPr>
            <a:spLocks noChangeShapeType="1"/>
          </p:cNvSpPr>
          <p:nvPr/>
        </p:nvSpPr>
        <p:spPr bwMode="auto">
          <a:xfrm>
            <a:off x="1187001" y="2057888"/>
            <a:ext cx="0" cy="55563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Rectangle 24">
            <a:extLst>
              <a:ext uri="{FF2B5EF4-FFF2-40B4-BE49-F238E27FC236}">
                <a16:creationId xmlns:a16="http://schemas.microsoft.com/office/drawing/2014/main" id="{2E21EB84-D5BB-82EB-FB12-5766AEA0C5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6534" y="213319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6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41506F5C-2B50-3B86-D1B9-AD32111186C4}"/>
              </a:ext>
            </a:extLst>
          </p:cNvPr>
          <p:cNvGrpSpPr/>
          <p:nvPr/>
        </p:nvGrpSpPr>
        <p:grpSpPr>
          <a:xfrm>
            <a:off x="4407411" y="1031030"/>
            <a:ext cx="1335787" cy="1308523"/>
            <a:chOff x="5808609" y="2796960"/>
            <a:chExt cx="1335787" cy="1619919"/>
          </a:xfrm>
        </p:grpSpPr>
        <p:sp>
          <p:nvSpPr>
            <p:cNvPr id="25" name="AutoShape 4">
              <a:extLst>
                <a:ext uri="{FF2B5EF4-FFF2-40B4-BE49-F238E27FC236}">
                  <a16:creationId xmlns:a16="http://schemas.microsoft.com/office/drawing/2014/main" id="{7B09B630-6045-290F-60B0-EAF80B51757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6058204" y="2796960"/>
              <a:ext cx="970901" cy="14935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Rectangle 6">
              <a:extLst>
                <a:ext uri="{FF2B5EF4-FFF2-40B4-BE49-F238E27FC236}">
                  <a16:creationId xmlns:a16="http://schemas.microsoft.com/office/drawing/2014/main" id="{F6DBC23D-BDF3-42BF-3F66-2062BEF329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55894" y="2796961"/>
              <a:ext cx="950828" cy="1453223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Rectangle 8">
              <a:extLst>
                <a:ext uri="{FF2B5EF4-FFF2-40B4-BE49-F238E27FC236}">
                  <a16:creationId xmlns:a16="http://schemas.microsoft.com/office/drawing/2014/main" id="{47DAAA59-4225-9CA2-16F0-2F3656BA33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6112" y="2932249"/>
              <a:ext cx="874902" cy="1245363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Line 14">
              <a:extLst>
                <a:ext uri="{FF2B5EF4-FFF2-40B4-BE49-F238E27FC236}">
                  <a16:creationId xmlns:a16="http://schemas.microsoft.com/office/drawing/2014/main" id="{127B3926-0929-7548-3D13-72A2CE81F6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16112" y="4177612"/>
              <a:ext cx="874902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Line 15">
              <a:extLst>
                <a:ext uri="{FF2B5EF4-FFF2-40B4-BE49-F238E27FC236}">
                  <a16:creationId xmlns:a16="http://schemas.microsoft.com/office/drawing/2014/main" id="{256D622C-6F70-A7B6-B554-145D3AC213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22221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Line 16">
              <a:extLst>
                <a:ext uri="{FF2B5EF4-FFF2-40B4-BE49-F238E27FC236}">
                  <a16:creationId xmlns:a16="http://schemas.microsoft.com/office/drawing/2014/main" id="{0C6F730C-F002-8520-2182-DC6F92A555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43602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Line 17">
              <a:extLst>
                <a:ext uri="{FF2B5EF4-FFF2-40B4-BE49-F238E27FC236}">
                  <a16:creationId xmlns:a16="http://schemas.microsoft.com/office/drawing/2014/main" id="{D827BA6B-EAB2-7B1B-DE6E-97773B1A02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65420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Line 18">
              <a:extLst>
                <a:ext uri="{FF2B5EF4-FFF2-40B4-BE49-F238E27FC236}">
                  <a16:creationId xmlns:a16="http://schemas.microsoft.com/office/drawing/2014/main" id="{446925B6-7852-BDDE-9CAD-C38483F361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86802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Line 19">
              <a:extLst>
                <a:ext uri="{FF2B5EF4-FFF2-40B4-BE49-F238E27FC236}">
                  <a16:creationId xmlns:a16="http://schemas.microsoft.com/office/drawing/2014/main" id="{5AA8CC47-8A0A-9654-DF09-F0F895C85B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08183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Line 20">
              <a:extLst>
                <a:ext uri="{FF2B5EF4-FFF2-40B4-BE49-F238E27FC236}">
                  <a16:creationId xmlns:a16="http://schemas.microsoft.com/office/drawing/2014/main" id="{699791F0-2E8B-B52B-8D5A-085F5009B9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29565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Line 21">
              <a:extLst>
                <a:ext uri="{FF2B5EF4-FFF2-40B4-BE49-F238E27FC236}">
                  <a16:creationId xmlns:a16="http://schemas.microsoft.com/office/drawing/2014/main" id="{BC7F8F7B-B8B4-34EB-6B78-65EDB44FD1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0947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Line 22">
              <a:extLst>
                <a:ext uri="{FF2B5EF4-FFF2-40B4-BE49-F238E27FC236}">
                  <a16:creationId xmlns:a16="http://schemas.microsoft.com/office/drawing/2014/main" id="{46A340AF-8014-FDF1-15A5-DA55807199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72765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Line 23">
              <a:extLst>
                <a:ext uri="{FF2B5EF4-FFF2-40B4-BE49-F238E27FC236}">
                  <a16:creationId xmlns:a16="http://schemas.microsoft.com/office/drawing/2014/main" id="{01E2CD2E-A8F0-9501-2E6D-72B94796E8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4146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Line 24">
              <a:extLst>
                <a:ext uri="{FF2B5EF4-FFF2-40B4-BE49-F238E27FC236}">
                  <a16:creationId xmlns:a16="http://schemas.microsoft.com/office/drawing/2014/main" id="{CE44FDFC-E292-E168-0270-647A285F28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15528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Line 25">
              <a:extLst>
                <a:ext uri="{FF2B5EF4-FFF2-40B4-BE49-F238E27FC236}">
                  <a16:creationId xmlns:a16="http://schemas.microsoft.com/office/drawing/2014/main" id="{2F7886FB-24EF-BA17-1980-F6DF885B90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6910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Line 26">
              <a:extLst>
                <a:ext uri="{FF2B5EF4-FFF2-40B4-BE49-F238E27FC236}">
                  <a16:creationId xmlns:a16="http://schemas.microsoft.com/office/drawing/2014/main" id="{F481D449-43FF-29B7-519A-B8D7A23E8C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8728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Line 27">
              <a:extLst>
                <a:ext uri="{FF2B5EF4-FFF2-40B4-BE49-F238E27FC236}">
                  <a16:creationId xmlns:a16="http://schemas.microsoft.com/office/drawing/2014/main" id="{1AB113C0-63F7-032D-E7BA-35B13AE821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80109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Line 28">
              <a:extLst>
                <a:ext uri="{FF2B5EF4-FFF2-40B4-BE49-F238E27FC236}">
                  <a16:creationId xmlns:a16="http://schemas.microsoft.com/office/drawing/2014/main" id="{52D41862-0C51-7B3D-994F-A98860AEA5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01491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Line 29">
              <a:extLst>
                <a:ext uri="{FF2B5EF4-FFF2-40B4-BE49-F238E27FC236}">
                  <a16:creationId xmlns:a16="http://schemas.microsoft.com/office/drawing/2014/main" id="{56A46DC1-73CF-D331-DABD-23777A5FE8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22873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Line 30">
              <a:extLst>
                <a:ext uri="{FF2B5EF4-FFF2-40B4-BE49-F238E27FC236}">
                  <a16:creationId xmlns:a16="http://schemas.microsoft.com/office/drawing/2014/main" id="{473E96C8-DCB7-0762-7A60-6EC25144DA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44691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Line 31">
              <a:extLst>
                <a:ext uri="{FF2B5EF4-FFF2-40B4-BE49-F238E27FC236}">
                  <a16:creationId xmlns:a16="http://schemas.microsoft.com/office/drawing/2014/main" id="{83270962-BE71-D236-BF20-1C23290904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66072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Line 32">
              <a:extLst>
                <a:ext uri="{FF2B5EF4-FFF2-40B4-BE49-F238E27FC236}">
                  <a16:creationId xmlns:a16="http://schemas.microsoft.com/office/drawing/2014/main" id="{800ED555-18EA-DB7D-D562-7C484C442C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87454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Line 33">
              <a:extLst>
                <a:ext uri="{FF2B5EF4-FFF2-40B4-BE49-F238E27FC236}">
                  <a16:creationId xmlns:a16="http://schemas.microsoft.com/office/drawing/2014/main" id="{419450D0-A425-822E-88D7-C2E354784E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08836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Line 34">
              <a:extLst>
                <a:ext uri="{FF2B5EF4-FFF2-40B4-BE49-F238E27FC236}">
                  <a16:creationId xmlns:a16="http://schemas.microsoft.com/office/drawing/2014/main" id="{7265D729-91A3-B9AC-E903-47F8B42B41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30217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Line 35">
              <a:extLst>
                <a:ext uri="{FF2B5EF4-FFF2-40B4-BE49-F238E27FC236}">
                  <a16:creationId xmlns:a16="http://schemas.microsoft.com/office/drawing/2014/main" id="{71052E63-FD5E-E69D-DD65-226EFB7CCA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2035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Line 36">
              <a:extLst>
                <a:ext uri="{FF2B5EF4-FFF2-40B4-BE49-F238E27FC236}">
                  <a16:creationId xmlns:a16="http://schemas.microsoft.com/office/drawing/2014/main" id="{2B662B03-CBBE-9536-E991-4C140A6440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73417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Line 37">
              <a:extLst>
                <a:ext uri="{FF2B5EF4-FFF2-40B4-BE49-F238E27FC236}">
                  <a16:creationId xmlns:a16="http://schemas.microsoft.com/office/drawing/2014/main" id="{50A7FC99-F355-F578-B64D-357B70792E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94798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Line 38">
              <a:extLst>
                <a:ext uri="{FF2B5EF4-FFF2-40B4-BE49-F238E27FC236}">
                  <a16:creationId xmlns:a16="http://schemas.microsoft.com/office/drawing/2014/main" id="{BE75DA1D-6F6C-D962-3300-4E729AC5B5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16180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Line 39">
              <a:extLst>
                <a:ext uri="{FF2B5EF4-FFF2-40B4-BE49-F238E27FC236}">
                  <a16:creationId xmlns:a16="http://schemas.microsoft.com/office/drawing/2014/main" id="{755ED861-A08F-AECD-D153-F6BBBC33B2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37998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" name="Line 40">
              <a:extLst>
                <a:ext uri="{FF2B5EF4-FFF2-40B4-BE49-F238E27FC236}">
                  <a16:creationId xmlns:a16="http://schemas.microsoft.com/office/drawing/2014/main" id="{758B4356-AF98-308B-1FA7-3617604858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59380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Line 41">
              <a:extLst>
                <a:ext uri="{FF2B5EF4-FFF2-40B4-BE49-F238E27FC236}">
                  <a16:creationId xmlns:a16="http://schemas.microsoft.com/office/drawing/2014/main" id="{7A8D855F-B764-0BDB-B2B9-D9D46D5CB5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80761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" name="Line 42">
              <a:extLst>
                <a:ext uri="{FF2B5EF4-FFF2-40B4-BE49-F238E27FC236}">
                  <a16:creationId xmlns:a16="http://schemas.microsoft.com/office/drawing/2014/main" id="{F159851F-6DFE-8B8D-35B7-43905E8FAF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02143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Line 43">
              <a:extLst>
                <a:ext uri="{FF2B5EF4-FFF2-40B4-BE49-F238E27FC236}">
                  <a16:creationId xmlns:a16="http://schemas.microsoft.com/office/drawing/2014/main" id="{177BB354-CE1E-056D-86BC-05A4978D76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23961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Line 44">
              <a:extLst>
                <a:ext uri="{FF2B5EF4-FFF2-40B4-BE49-F238E27FC236}">
                  <a16:creationId xmlns:a16="http://schemas.microsoft.com/office/drawing/2014/main" id="{357C8BE8-0AB3-7061-F4FA-D909177B6F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45343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Line 45">
              <a:extLst>
                <a:ext uri="{FF2B5EF4-FFF2-40B4-BE49-F238E27FC236}">
                  <a16:creationId xmlns:a16="http://schemas.microsoft.com/office/drawing/2014/main" id="{3C4CF262-04CB-67F6-9088-385B439BBB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66724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" name="Line 46">
              <a:extLst>
                <a:ext uri="{FF2B5EF4-FFF2-40B4-BE49-F238E27FC236}">
                  <a16:creationId xmlns:a16="http://schemas.microsoft.com/office/drawing/2014/main" id="{A95B74C0-4BC9-8DCD-AB31-BAA6F3AC46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88106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" name="Line 47">
              <a:extLst>
                <a:ext uri="{FF2B5EF4-FFF2-40B4-BE49-F238E27FC236}">
                  <a16:creationId xmlns:a16="http://schemas.microsoft.com/office/drawing/2014/main" id="{0B42AC51-8FB9-55D2-5F1E-57735DCDA1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09488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" name="Line 48">
              <a:extLst>
                <a:ext uri="{FF2B5EF4-FFF2-40B4-BE49-F238E27FC236}">
                  <a16:creationId xmlns:a16="http://schemas.microsoft.com/office/drawing/2014/main" id="{A8AE50AD-F4C3-66A5-4F39-ADDB92BE41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31306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Line 49">
              <a:extLst>
                <a:ext uri="{FF2B5EF4-FFF2-40B4-BE49-F238E27FC236}">
                  <a16:creationId xmlns:a16="http://schemas.microsoft.com/office/drawing/2014/main" id="{367B8083-0722-D4A9-4F9A-93E182FE65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52687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" name="Line 50">
              <a:extLst>
                <a:ext uri="{FF2B5EF4-FFF2-40B4-BE49-F238E27FC236}">
                  <a16:creationId xmlns:a16="http://schemas.microsoft.com/office/drawing/2014/main" id="{25980B9D-D828-40E9-9A7C-947FB54C94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74069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Line 51">
              <a:extLst>
                <a:ext uri="{FF2B5EF4-FFF2-40B4-BE49-F238E27FC236}">
                  <a16:creationId xmlns:a16="http://schemas.microsoft.com/office/drawing/2014/main" id="{ECFE08A2-30E4-6077-157C-89034BC946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95451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" name="Line 52">
              <a:extLst>
                <a:ext uri="{FF2B5EF4-FFF2-40B4-BE49-F238E27FC236}">
                  <a16:creationId xmlns:a16="http://schemas.microsoft.com/office/drawing/2014/main" id="{9FBD28C5-CEE6-07F6-5A26-54BE454383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17269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Line 53">
              <a:extLst>
                <a:ext uri="{FF2B5EF4-FFF2-40B4-BE49-F238E27FC236}">
                  <a16:creationId xmlns:a16="http://schemas.microsoft.com/office/drawing/2014/main" id="{FEE0DB8D-4684-AB85-13D0-67E8083580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38650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" name="Line 54">
              <a:extLst>
                <a:ext uri="{FF2B5EF4-FFF2-40B4-BE49-F238E27FC236}">
                  <a16:creationId xmlns:a16="http://schemas.microsoft.com/office/drawing/2014/main" id="{57ED6911-A275-6D6D-0824-E626C05E94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60032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" name="Line 55">
              <a:extLst>
                <a:ext uri="{FF2B5EF4-FFF2-40B4-BE49-F238E27FC236}">
                  <a16:creationId xmlns:a16="http://schemas.microsoft.com/office/drawing/2014/main" id="{DB9F6258-F897-4D06-626A-24313958B0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81413" y="4177612"/>
              <a:ext cx="436" cy="44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" name="Line 56">
              <a:extLst>
                <a:ext uri="{FF2B5EF4-FFF2-40B4-BE49-F238E27FC236}">
                  <a16:creationId xmlns:a16="http://schemas.microsoft.com/office/drawing/2014/main" id="{4524F0DB-3002-0C78-656A-FE15992415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22221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Line 57">
              <a:extLst>
                <a:ext uri="{FF2B5EF4-FFF2-40B4-BE49-F238E27FC236}">
                  <a16:creationId xmlns:a16="http://schemas.microsoft.com/office/drawing/2014/main" id="{1052C0D5-B068-B006-9556-623DCC1650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65420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" name="Line 58">
              <a:extLst>
                <a:ext uri="{FF2B5EF4-FFF2-40B4-BE49-F238E27FC236}">
                  <a16:creationId xmlns:a16="http://schemas.microsoft.com/office/drawing/2014/main" id="{1CB842B0-FE05-FF84-365D-2B34A98222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08183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Line 59">
              <a:extLst>
                <a:ext uri="{FF2B5EF4-FFF2-40B4-BE49-F238E27FC236}">
                  <a16:creationId xmlns:a16="http://schemas.microsoft.com/office/drawing/2014/main" id="{53868A3F-1D41-785D-EB6A-D144B86176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0947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" name="Line 60">
              <a:extLst>
                <a:ext uri="{FF2B5EF4-FFF2-40B4-BE49-F238E27FC236}">
                  <a16:creationId xmlns:a16="http://schemas.microsoft.com/office/drawing/2014/main" id="{E515F5CD-33B8-9B07-932F-A23EB895F7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4146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" name="Line 61">
              <a:extLst>
                <a:ext uri="{FF2B5EF4-FFF2-40B4-BE49-F238E27FC236}">
                  <a16:creationId xmlns:a16="http://schemas.microsoft.com/office/drawing/2014/main" id="{45073965-E2FC-8CB2-C30A-01A19F42CA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6910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" name="Line 62">
              <a:extLst>
                <a:ext uri="{FF2B5EF4-FFF2-40B4-BE49-F238E27FC236}">
                  <a16:creationId xmlns:a16="http://schemas.microsoft.com/office/drawing/2014/main" id="{58C36B06-A23C-F3B1-9EFE-C435250AA2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80109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" name="Line 63">
              <a:extLst>
                <a:ext uri="{FF2B5EF4-FFF2-40B4-BE49-F238E27FC236}">
                  <a16:creationId xmlns:a16="http://schemas.microsoft.com/office/drawing/2014/main" id="{25156835-6283-5801-4416-68271A40FD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22873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" name="Line 64">
              <a:extLst>
                <a:ext uri="{FF2B5EF4-FFF2-40B4-BE49-F238E27FC236}">
                  <a16:creationId xmlns:a16="http://schemas.microsoft.com/office/drawing/2014/main" id="{952F2C34-F1AC-CF17-22DF-794D9DD95A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66072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Line 65">
              <a:extLst>
                <a:ext uri="{FF2B5EF4-FFF2-40B4-BE49-F238E27FC236}">
                  <a16:creationId xmlns:a16="http://schemas.microsoft.com/office/drawing/2014/main" id="{2FA891DB-FBBF-B494-D9E0-543FCED2CC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08836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Line 66">
              <a:extLst>
                <a:ext uri="{FF2B5EF4-FFF2-40B4-BE49-F238E27FC236}">
                  <a16:creationId xmlns:a16="http://schemas.microsoft.com/office/drawing/2014/main" id="{FB0AD8E2-6172-D7F7-8CAD-AE6492ED58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2035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Line 67">
              <a:extLst>
                <a:ext uri="{FF2B5EF4-FFF2-40B4-BE49-F238E27FC236}">
                  <a16:creationId xmlns:a16="http://schemas.microsoft.com/office/drawing/2014/main" id="{67F16532-DCF8-D190-60A7-C000E9B58A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94798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Line 68">
              <a:extLst>
                <a:ext uri="{FF2B5EF4-FFF2-40B4-BE49-F238E27FC236}">
                  <a16:creationId xmlns:a16="http://schemas.microsoft.com/office/drawing/2014/main" id="{7B92FBCC-747E-20F4-D2CF-62A377D041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37998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Line 69">
              <a:extLst>
                <a:ext uri="{FF2B5EF4-FFF2-40B4-BE49-F238E27FC236}">
                  <a16:creationId xmlns:a16="http://schemas.microsoft.com/office/drawing/2014/main" id="{0E97EABB-8AE4-465C-8C17-5A631C2426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80761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Line 70">
              <a:extLst>
                <a:ext uri="{FF2B5EF4-FFF2-40B4-BE49-F238E27FC236}">
                  <a16:creationId xmlns:a16="http://schemas.microsoft.com/office/drawing/2014/main" id="{DD245A3B-50DF-4930-BFAF-7D3304BD39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23961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Line 71">
              <a:extLst>
                <a:ext uri="{FF2B5EF4-FFF2-40B4-BE49-F238E27FC236}">
                  <a16:creationId xmlns:a16="http://schemas.microsoft.com/office/drawing/2014/main" id="{89ADA1C4-A3BE-DDE4-7CBB-031AE9F407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66724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Line 72">
              <a:extLst>
                <a:ext uri="{FF2B5EF4-FFF2-40B4-BE49-F238E27FC236}">
                  <a16:creationId xmlns:a16="http://schemas.microsoft.com/office/drawing/2014/main" id="{1120ED47-36D4-1FEE-3B6C-84AAAAE4A3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09488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Line 73">
              <a:extLst>
                <a:ext uri="{FF2B5EF4-FFF2-40B4-BE49-F238E27FC236}">
                  <a16:creationId xmlns:a16="http://schemas.microsoft.com/office/drawing/2014/main" id="{7D9279C9-F17A-1000-AB5C-3F8B24BDAA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52687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Line 74">
              <a:extLst>
                <a:ext uri="{FF2B5EF4-FFF2-40B4-BE49-F238E27FC236}">
                  <a16:creationId xmlns:a16="http://schemas.microsoft.com/office/drawing/2014/main" id="{B49A1570-EC4E-020E-2829-68D9AB597D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95451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Line 75">
              <a:extLst>
                <a:ext uri="{FF2B5EF4-FFF2-40B4-BE49-F238E27FC236}">
                  <a16:creationId xmlns:a16="http://schemas.microsoft.com/office/drawing/2014/main" id="{352D1BE3-F47A-7D67-39ED-B3B82B3A1A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38650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Line 76">
              <a:extLst>
                <a:ext uri="{FF2B5EF4-FFF2-40B4-BE49-F238E27FC236}">
                  <a16:creationId xmlns:a16="http://schemas.microsoft.com/office/drawing/2014/main" id="{AC3F6D14-10FF-CC24-37D9-BFC2F2CEE2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81413" y="4177612"/>
              <a:ext cx="436" cy="98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Rectangle 77">
              <a:extLst>
                <a:ext uri="{FF2B5EF4-FFF2-40B4-BE49-F238E27FC236}">
                  <a16:creationId xmlns:a16="http://schemas.microsoft.com/office/drawing/2014/main" id="{02B449F0-9623-1FDA-0E35-DCC0F6ED7D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1239" y="4193818"/>
              <a:ext cx="19396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490.0</a:t>
              </a:r>
              <a:endParaRPr kumimoji="0" 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92" name="Rectangle 87">
              <a:extLst>
                <a:ext uri="{FF2B5EF4-FFF2-40B4-BE49-F238E27FC236}">
                  <a16:creationId xmlns:a16="http://schemas.microsoft.com/office/drawing/2014/main" id="{3CC72672-6DA1-AD81-680F-19021F5636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21054" y="4193818"/>
              <a:ext cx="19396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492.0</a:t>
              </a: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93" name="Rectangle 97">
              <a:extLst>
                <a:ext uri="{FF2B5EF4-FFF2-40B4-BE49-F238E27FC236}">
                  <a16:creationId xmlns:a16="http://schemas.microsoft.com/office/drawing/2014/main" id="{3474D4F8-131A-20D5-CC6D-CFAD307B41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50432" y="4193818"/>
              <a:ext cx="19396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494.0</a:t>
              </a: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94" name="Rectangle 98">
              <a:extLst>
                <a:ext uri="{FF2B5EF4-FFF2-40B4-BE49-F238E27FC236}">
                  <a16:creationId xmlns:a16="http://schemas.microsoft.com/office/drawing/2014/main" id="{96D116AA-ABAA-AF13-6AA7-3E46771BE6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08836" y="4324546"/>
              <a:ext cx="26449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m/z, Da</a:t>
              </a:r>
              <a:endParaRPr kumimoji="0" 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95" name="Line 99">
              <a:extLst>
                <a:ext uri="{FF2B5EF4-FFF2-40B4-BE49-F238E27FC236}">
                  <a16:creationId xmlns:a16="http://schemas.microsoft.com/office/drawing/2014/main" id="{7FE6F842-95F5-4E52-0F1E-BDB32CFCDD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16112" y="2932249"/>
              <a:ext cx="436" cy="12453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Line 100">
              <a:extLst>
                <a:ext uri="{FF2B5EF4-FFF2-40B4-BE49-F238E27FC236}">
                  <a16:creationId xmlns:a16="http://schemas.microsoft.com/office/drawing/2014/main" id="{F1BF73CB-B9C7-5D5D-43DC-0398FAD3AA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4177612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Line 101">
              <a:extLst>
                <a:ext uri="{FF2B5EF4-FFF2-40B4-BE49-F238E27FC236}">
                  <a16:creationId xmlns:a16="http://schemas.microsoft.com/office/drawing/2014/main" id="{E6611FE9-5D97-6EC6-72B7-0AD766CEB8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4160589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Line 102">
              <a:extLst>
                <a:ext uri="{FF2B5EF4-FFF2-40B4-BE49-F238E27FC236}">
                  <a16:creationId xmlns:a16="http://schemas.microsoft.com/office/drawing/2014/main" id="{D7F8410A-5CDE-53F3-B32B-4ECA649BBB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4142670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Line 132">
              <a:extLst>
                <a:ext uri="{FF2B5EF4-FFF2-40B4-BE49-F238E27FC236}">
                  <a16:creationId xmlns:a16="http://schemas.microsoft.com/office/drawing/2014/main" id="{17222601-F2D1-ECA2-2212-8AABAC4EBA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3614063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Line 133">
              <a:extLst>
                <a:ext uri="{FF2B5EF4-FFF2-40B4-BE49-F238E27FC236}">
                  <a16:creationId xmlns:a16="http://schemas.microsoft.com/office/drawing/2014/main" id="{97F5E559-EE9B-F12F-E055-1BFF4F9078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3596144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Line 134">
              <a:extLst>
                <a:ext uri="{FF2B5EF4-FFF2-40B4-BE49-F238E27FC236}">
                  <a16:creationId xmlns:a16="http://schemas.microsoft.com/office/drawing/2014/main" id="{A0DC95B1-082F-02A0-235E-7037E52083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3578225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Line 135">
              <a:extLst>
                <a:ext uri="{FF2B5EF4-FFF2-40B4-BE49-F238E27FC236}">
                  <a16:creationId xmlns:a16="http://schemas.microsoft.com/office/drawing/2014/main" id="{96EB75BC-AAA7-B725-C85C-A51046D71D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3561202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Line 136">
              <a:extLst>
                <a:ext uri="{FF2B5EF4-FFF2-40B4-BE49-F238E27FC236}">
                  <a16:creationId xmlns:a16="http://schemas.microsoft.com/office/drawing/2014/main" id="{F6CCE8EA-A851-933F-E4B6-AC05725DC1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3543283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Line 167">
              <a:extLst>
                <a:ext uri="{FF2B5EF4-FFF2-40B4-BE49-F238E27FC236}">
                  <a16:creationId xmlns:a16="http://schemas.microsoft.com/office/drawing/2014/main" id="{258248F6-9AAE-0882-3A87-591708AF57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2996757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Line 168">
              <a:extLst>
                <a:ext uri="{FF2B5EF4-FFF2-40B4-BE49-F238E27FC236}">
                  <a16:creationId xmlns:a16="http://schemas.microsoft.com/office/drawing/2014/main" id="{2498CD75-BDD8-2AAC-A40E-751E6024C3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2978838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Line 169">
              <a:extLst>
                <a:ext uri="{FF2B5EF4-FFF2-40B4-BE49-F238E27FC236}">
                  <a16:creationId xmlns:a16="http://schemas.microsoft.com/office/drawing/2014/main" id="{F57EF2FC-D339-E4B5-56EE-E579B198CF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2960919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Line 170">
              <a:extLst>
                <a:ext uri="{FF2B5EF4-FFF2-40B4-BE49-F238E27FC236}">
                  <a16:creationId xmlns:a16="http://schemas.microsoft.com/office/drawing/2014/main" id="{5A306D27-A00F-5BED-4B42-7108554F18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4366" y="2943896"/>
              <a:ext cx="1745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Line 171">
              <a:extLst>
                <a:ext uri="{FF2B5EF4-FFF2-40B4-BE49-F238E27FC236}">
                  <a16:creationId xmlns:a16="http://schemas.microsoft.com/office/drawing/2014/main" id="{935CC0E9-302B-2FAB-5D8C-8A46B6F06D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2621" y="4177612"/>
              <a:ext cx="3491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Line 178">
              <a:extLst>
                <a:ext uri="{FF2B5EF4-FFF2-40B4-BE49-F238E27FC236}">
                  <a16:creationId xmlns:a16="http://schemas.microsoft.com/office/drawing/2014/main" id="{26AA4AC3-6E3E-475C-3416-C6CCA10F60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2621" y="3561202"/>
              <a:ext cx="3491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Line 185">
              <a:extLst>
                <a:ext uri="{FF2B5EF4-FFF2-40B4-BE49-F238E27FC236}">
                  <a16:creationId xmlns:a16="http://schemas.microsoft.com/office/drawing/2014/main" id="{C6D6A92C-508B-8288-6414-A7B6BAB6A4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2621" y="2943896"/>
              <a:ext cx="3491" cy="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Rectangle 186">
              <a:extLst>
                <a:ext uri="{FF2B5EF4-FFF2-40B4-BE49-F238E27FC236}">
                  <a16:creationId xmlns:a16="http://schemas.microsoft.com/office/drawing/2014/main" id="{F5D3C551-D536-815E-04A6-280C024238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5776" y="4128708"/>
              <a:ext cx="4328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0</a:t>
              </a:r>
              <a:endParaRPr kumimoji="0" 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2" name="Rectangle 193">
              <a:extLst>
                <a:ext uri="{FF2B5EF4-FFF2-40B4-BE49-F238E27FC236}">
                  <a16:creationId xmlns:a16="http://schemas.microsoft.com/office/drawing/2014/main" id="{BF99373B-3D88-9008-9554-4F11C30C8B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9352" y="3532507"/>
              <a:ext cx="1298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350</a:t>
              </a:r>
              <a:endParaRPr kumimoji="0" 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3" name="Rectangle 200">
              <a:extLst>
                <a:ext uri="{FF2B5EF4-FFF2-40B4-BE49-F238E27FC236}">
                  <a16:creationId xmlns:a16="http://schemas.microsoft.com/office/drawing/2014/main" id="{231936B3-3D01-C332-1E72-6482495614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3002" y="2915201"/>
              <a:ext cx="1298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700</a:t>
              </a:r>
              <a:endParaRPr kumimoji="0" 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4" name="Rectangle 201">
              <a:extLst>
                <a:ext uri="{FF2B5EF4-FFF2-40B4-BE49-F238E27FC236}">
                  <a16:creationId xmlns:a16="http://schemas.microsoft.com/office/drawing/2014/main" id="{B4B310BD-2C27-854A-C399-5AC1E864D3B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576654" y="3508764"/>
              <a:ext cx="55624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Intensity, counts</a:t>
              </a:r>
              <a:endParaRPr kumimoji="0" 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5" name="Freeform 204">
              <a:extLst>
                <a:ext uri="{FF2B5EF4-FFF2-40B4-BE49-F238E27FC236}">
                  <a16:creationId xmlns:a16="http://schemas.microsoft.com/office/drawing/2014/main" id="{98E32FF3-DEA4-B66C-9E21-20828002E978}"/>
                </a:ext>
              </a:extLst>
            </p:cNvPr>
            <p:cNvSpPr>
              <a:spLocks/>
            </p:cNvSpPr>
            <p:nvPr/>
          </p:nvSpPr>
          <p:spPr bwMode="auto">
            <a:xfrm flipV="1">
              <a:off x="6157566" y="2932249"/>
              <a:ext cx="106035" cy="124536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"/>
                </a:cxn>
                <a:cxn ang="0">
                  <a:pos x="57" y="13"/>
                </a:cxn>
                <a:cxn ang="0">
                  <a:pos x="114" y="155"/>
                </a:cxn>
                <a:cxn ang="0">
                  <a:pos x="170" y="317"/>
                </a:cxn>
                <a:cxn ang="0">
                  <a:pos x="227" y="695"/>
                </a:cxn>
                <a:cxn ang="0">
                  <a:pos x="284" y="1380"/>
                </a:cxn>
                <a:cxn ang="0">
                  <a:pos x="341" y="2727"/>
                </a:cxn>
                <a:cxn ang="0">
                  <a:pos x="397" y="4994"/>
                </a:cxn>
                <a:cxn ang="0">
                  <a:pos x="454" y="9327"/>
                </a:cxn>
                <a:cxn ang="0">
                  <a:pos x="511" y="14997"/>
                </a:cxn>
                <a:cxn ang="0">
                  <a:pos x="568" y="20833"/>
                </a:cxn>
                <a:cxn ang="0">
                  <a:pos x="624" y="25463"/>
                </a:cxn>
                <a:cxn ang="0">
                  <a:pos x="681" y="25722"/>
                </a:cxn>
                <a:cxn ang="0">
                  <a:pos x="738" y="25288"/>
                </a:cxn>
                <a:cxn ang="0">
                  <a:pos x="794" y="22494"/>
                </a:cxn>
                <a:cxn ang="0">
                  <a:pos x="851" y="19446"/>
                </a:cxn>
                <a:cxn ang="0">
                  <a:pos x="908" y="15345"/>
                </a:cxn>
                <a:cxn ang="0">
                  <a:pos x="965" y="11889"/>
                </a:cxn>
                <a:cxn ang="0">
                  <a:pos x="1021" y="8715"/>
                </a:cxn>
                <a:cxn ang="0">
                  <a:pos x="1078" y="6702"/>
                </a:cxn>
                <a:cxn ang="0">
                  <a:pos x="1135" y="4508"/>
                </a:cxn>
                <a:cxn ang="0">
                  <a:pos x="1192" y="3372"/>
                </a:cxn>
                <a:cxn ang="0">
                  <a:pos x="1248" y="2449"/>
                </a:cxn>
                <a:cxn ang="0">
                  <a:pos x="1305" y="1701"/>
                </a:cxn>
                <a:cxn ang="0">
                  <a:pos x="1362" y="1062"/>
                </a:cxn>
                <a:cxn ang="0">
                  <a:pos x="1419" y="966"/>
                </a:cxn>
                <a:cxn ang="0">
                  <a:pos x="1475" y="665"/>
                </a:cxn>
                <a:cxn ang="0">
                  <a:pos x="1532" y="383"/>
                </a:cxn>
                <a:cxn ang="0">
                  <a:pos x="1589" y="254"/>
                </a:cxn>
                <a:cxn ang="0">
                  <a:pos x="1646" y="191"/>
                </a:cxn>
                <a:cxn ang="0">
                  <a:pos x="1702" y="119"/>
                </a:cxn>
                <a:cxn ang="0">
                  <a:pos x="1759" y="132"/>
                </a:cxn>
                <a:cxn ang="0">
                  <a:pos x="1816" y="66"/>
                </a:cxn>
                <a:cxn ang="0">
                  <a:pos x="1873" y="23"/>
                </a:cxn>
                <a:cxn ang="0">
                  <a:pos x="1929" y="36"/>
                </a:cxn>
                <a:cxn ang="0">
                  <a:pos x="1986" y="13"/>
                </a:cxn>
                <a:cxn ang="0">
                  <a:pos x="2043" y="16"/>
                </a:cxn>
                <a:cxn ang="0">
                  <a:pos x="2100" y="16"/>
                </a:cxn>
                <a:cxn ang="0">
                  <a:pos x="2156" y="36"/>
                </a:cxn>
                <a:cxn ang="0">
                  <a:pos x="2213" y="19"/>
                </a:cxn>
                <a:cxn ang="0">
                  <a:pos x="2270" y="36"/>
                </a:cxn>
                <a:cxn ang="0">
                  <a:pos x="2327" y="29"/>
                </a:cxn>
                <a:cxn ang="0">
                  <a:pos x="2384" y="39"/>
                </a:cxn>
                <a:cxn ang="0">
                  <a:pos x="2440" y="26"/>
                </a:cxn>
                <a:cxn ang="0">
                  <a:pos x="2497" y="46"/>
                </a:cxn>
                <a:cxn ang="0">
                  <a:pos x="2554" y="66"/>
                </a:cxn>
                <a:cxn ang="0">
                  <a:pos x="2611" y="29"/>
                </a:cxn>
                <a:cxn ang="0">
                  <a:pos x="2667" y="29"/>
                </a:cxn>
                <a:cxn ang="0">
                  <a:pos x="2724" y="33"/>
                </a:cxn>
                <a:cxn ang="0">
                  <a:pos x="2781" y="56"/>
                </a:cxn>
                <a:cxn ang="0">
                  <a:pos x="2838" y="49"/>
                </a:cxn>
                <a:cxn ang="0">
                  <a:pos x="2894" y="39"/>
                </a:cxn>
                <a:cxn ang="0">
                  <a:pos x="2951" y="13"/>
                </a:cxn>
                <a:cxn ang="0">
                  <a:pos x="3008" y="23"/>
                </a:cxn>
                <a:cxn ang="0">
                  <a:pos x="3065" y="23"/>
                </a:cxn>
                <a:cxn ang="0">
                  <a:pos x="3121" y="13"/>
                </a:cxn>
                <a:cxn ang="0">
                  <a:pos x="3178" y="19"/>
                </a:cxn>
                <a:cxn ang="0">
                  <a:pos x="3235" y="19"/>
                </a:cxn>
                <a:cxn ang="0">
                  <a:pos x="3292" y="26"/>
                </a:cxn>
                <a:cxn ang="0">
                  <a:pos x="3348" y="6"/>
                </a:cxn>
                <a:cxn ang="0">
                  <a:pos x="3348" y="0"/>
                </a:cxn>
              </a:cxnLst>
              <a:rect l="0" t="0" r="r" b="b"/>
              <a:pathLst>
                <a:path w="3348" h="25722">
                  <a:moveTo>
                    <a:pt x="0" y="0"/>
                  </a:moveTo>
                  <a:lnTo>
                    <a:pt x="0" y="6"/>
                  </a:lnTo>
                  <a:lnTo>
                    <a:pt x="57" y="13"/>
                  </a:lnTo>
                  <a:lnTo>
                    <a:pt x="114" y="155"/>
                  </a:lnTo>
                  <a:lnTo>
                    <a:pt x="170" y="317"/>
                  </a:lnTo>
                  <a:lnTo>
                    <a:pt x="227" y="695"/>
                  </a:lnTo>
                  <a:lnTo>
                    <a:pt x="284" y="1380"/>
                  </a:lnTo>
                  <a:lnTo>
                    <a:pt x="341" y="2727"/>
                  </a:lnTo>
                  <a:lnTo>
                    <a:pt x="397" y="4994"/>
                  </a:lnTo>
                  <a:lnTo>
                    <a:pt x="454" y="9327"/>
                  </a:lnTo>
                  <a:lnTo>
                    <a:pt x="511" y="14997"/>
                  </a:lnTo>
                  <a:lnTo>
                    <a:pt x="568" y="20833"/>
                  </a:lnTo>
                  <a:lnTo>
                    <a:pt x="624" y="25463"/>
                  </a:lnTo>
                  <a:lnTo>
                    <a:pt x="681" y="25722"/>
                  </a:lnTo>
                  <a:lnTo>
                    <a:pt x="738" y="25288"/>
                  </a:lnTo>
                  <a:lnTo>
                    <a:pt x="794" y="22494"/>
                  </a:lnTo>
                  <a:lnTo>
                    <a:pt x="851" y="19446"/>
                  </a:lnTo>
                  <a:lnTo>
                    <a:pt x="908" y="15345"/>
                  </a:lnTo>
                  <a:lnTo>
                    <a:pt x="965" y="11889"/>
                  </a:lnTo>
                  <a:lnTo>
                    <a:pt x="1021" y="8715"/>
                  </a:lnTo>
                  <a:lnTo>
                    <a:pt x="1078" y="6702"/>
                  </a:lnTo>
                  <a:lnTo>
                    <a:pt x="1135" y="4508"/>
                  </a:lnTo>
                  <a:lnTo>
                    <a:pt x="1192" y="3372"/>
                  </a:lnTo>
                  <a:lnTo>
                    <a:pt x="1248" y="2449"/>
                  </a:lnTo>
                  <a:lnTo>
                    <a:pt x="1305" y="1701"/>
                  </a:lnTo>
                  <a:lnTo>
                    <a:pt x="1362" y="1062"/>
                  </a:lnTo>
                  <a:lnTo>
                    <a:pt x="1419" y="966"/>
                  </a:lnTo>
                  <a:lnTo>
                    <a:pt x="1475" y="665"/>
                  </a:lnTo>
                  <a:lnTo>
                    <a:pt x="1532" y="383"/>
                  </a:lnTo>
                  <a:lnTo>
                    <a:pt x="1589" y="254"/>
                  </a:lnTo>
                  <a:lnTo>
                    <a:pt x="1646" y="191"/>
                  </a:lnTo>
                  <a:lnTo>
                    <a:pt x="1702" y="119"/>
                  </a:lnTo>
                  <a:lnTo>
                    <a:pt x="1759" y="132"/>
                  </a:lnTo>
                  <a:lnTo>
                    <a:pt x="1816" y="66"/>
                  </a:lnTo>
                  <a:lnTo>
                    <a:pt x="1873" y="23"/>
                  </a:lnTo>
                  <a:lnTo>
                    <a:pt x="1929" y="36"/>
                  </a:lnTo>
                  <a:lnTo>
                    <a:pt x="1986" y="13"/>
                  </a:lnTo>
                  <a:lnTo>
                    <a:pt x="2043" y="16"/>
                  </a:lnTo>
                  <a:lnTo>
                    <a:pt x="2100" y="16"/>
                  </a:lnTo>
                  <a:lnTo>
                    <a:pt x="2156" y="36"/>
                  </a:lnTo>
                  <a:lnTo>
                    <a:pt x="2213" y="19"/>
                  </a:lnTo>
                  <a:lnTo>
                    <a:pt x="2270" y="36"/>
                  </a:lnTo>
                  <a:lnTo>
                    <a:pt x="2327" y="29"/>
                  </a:lnTo>
                  <a:lnTo>
                    <a:pt x="2384" y="39"/>
                  </a:lnTo>
                  <a:lnTo>
                    <a:pt x="2440" y="26"/>
                  </a:lnTo>
                  <a:lnTo>
                    <a:pt x="2497" y="46"/>
                  </a:lnTo>
                  <a:lnTo>
                    <a:pt x="2554" y="66"/>
                  </a:lnTo>
                  <a:lnTo>
                    <a:pt x="2611" y="29"/>
                  </a:lnTo>
                  <a:lnTo>
                    <a:pt x="2667" y="29"/>
                  </a:lnTo>
                  <a:lnTo>
                    <a:pt x="2724" y="33"/>
                  </a:lnTo>
                  <a:lnTo>
                    <a:pt x="2781" y="56"/>
                  </a:lnTo>
                  <a:lnTo>
                    <a:pt x="2838" y="49"/>
                  </a:lnTo>
                  <a:lnTo>
                    <a:pt x="2894" y="39"/>
                  </a:lnTo>
                  <a:lnTo>
                    <a:pt x="2951" y="13"/>
                  </a:lnTo>
                  <a:lnTo>
                    <a:pt x="3008" y="23"/>
                  </a:lnTo>
                  <a:lnTo>
                    <a:pt x="3065" y="23"/>
                  </a:lnTo>
                  <a:lnTo>
                    <a:pt x="3121" y="13"/>
                  </a:lnTo>
                  <a:lnTo>
                    <a:pt x="3178" y="19"/>
                  </a:lnTo>
                  <a:lnTo>
                    <a:pt x="3235" y="19"/>
                  </a:lnTo>
                  <a:lnTo>
                    <a:pt x="3292" y="26"/>
                  </a:lnTo>
                  <a:lnTo>
                    <a:pt x="3348" y="6"/>
                  </a:lnTo>
                  <a:lnTo>
                    <a:pt x="3348" y="0"/>
                  </a:lnTo>
                </a:path>
              </a:pathLst>
            </a:cu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Line 205">
              <a:extLst>
                <a:ext uri="{FF2B5EF4-FFF2-40B4-BE49-F238E27FC236}">
                  <a16:creationId xmlns:a16="http://schemas.microsoft.com/office/drawing/2014/main" id="{C8A6EBD0-7F7B-E6A3-162A-7452C6C9CE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67528" y="4177612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Line 207">
              <a:extLst>
                <a:ext uri="{FF2B5EF4-FFF2-40B4-BE49-F238E27FC236}">
                  <a16:creationId xmlns:a16="http://schemas.microsoft.com/office/drawing/2014/main" id="{ACFDF9F8-189A-ECA7-DD9C-09311782E3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79002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Line 208">
              <a:extLst>
                <a:ext uri="{FF2B5EF4-FFF2-40B4-BE49-F238E27FC236}">
                  <a16:creationId xmlns:a16="http://schemas.microsoft.com/office/drawing/2014/main" id="{57785D5B-3672-2651-E163-0B4A2A1428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89911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Line 209">
              <a:extLst>
                <a:ext uri="{FF2B5EF4-FFF2-40B4-BE49-F238E27FC236}">
                  <a16:creationId xmlns:a16="http://schemas.microsoft.com/office/drawing/2014/main" id="{7AF83107-B0B0-9B9A-44D4-9810A0E09A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3402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0" name="Line 210">
              <a:extLst>
                <a:ext uri="{FF2B5EF4-FFF2-40B4-BE49-F238E27FC236}">
                  <a16:creationId xmlns:a16="http://schemas.microsoft.com/office/drawing/2014/main" id="{9CE917C6-22EA-406A-C70A-F1547E3772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0820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Line 211">
              <a:extLst>
                <a:ext uri="{FF2B5EF4-FFF2-40B4-BE49-F238E27FC236}">
                  <a16:creationId xmlns:a16="http://schemas.microsoft.com/office/drawing/2014/main" id="{B7B54C16-083F-FACB-EC02-30F50C0408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29620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2" name="Line 212">
              <a:extLst>
                <a:ext uri="{FF2B5EF4-FFF2-40B4-BE49-F238E27FC236}">
                  <a16:creationId xmlns:a16="http://schemas.microsoft.com/office/drawing/2014/main" id="{F7998B15-ABF6-C2C0-391F-50BE0843F3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1002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Freeform 213">
              <a:extLst>
                <a:ext uri="{FF2B5EF4-FFF2-40B4-BE49-F238E27FC236}">
                  <a16:creationId xmlns:a16="http://schemas.microsoft.com/office/drawing/2014/main" id="{0FDAEE13-7B87-258C-871A-4F6AB4D1637D}"/>
                </a:ext>
              </a:extLst>
            </p:cNvPr>
            <p:cNvSpPr>
              <a:spLocks/>
            </p:cNvSpPr>
            <p:nvPr/>
          </p:nvSpPr>
          <p:spPr bwMode="auto">
            <a:xfrm flipV="1">
              <a:off x="6379801" y="4070994"/>
              <a:ext cx="50618" cy="10661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"/>
                </a:cxn>
                <a:cxn ang="0">
                  <a:pos x="57" y="6"/>
                </a:cxn>
                <a:cxn ang="0">
                  <a:pos x="113" y="36"/>
                </a:cxn>
                <a:cxn ang="0">
                  <a:pos x="170" y="82"/>
                </a:cxn>
                <a:cxn ang="0">
                  <a:pos x="227" y="205"/>
                </a:cxn>
                <a:cxn ang="0">
                  <a:pos x="284" y="582"/>
                </a:cxn>
                <a:cxn ang="0">
                  <a:pos x="341" y="940"/>
                </a:cxn>
                <a:cxn ang="0">
                  <a:pos x="397" y="1568"/>
                </a:cxn>
                <a:cxn ang="0">
                  <a:pos x="454" y="2055"/>
                </a:cxn>
                <a:cxn ang="0">
                  <a:pos x="511" y="2211"/>
                </a:cxn>
                <a:cxn ang="0">
                  <a:pos x="568" y="2211"/>
                </a:cxn>
                <a:cxn ang="0">
                  <a:pos x="625" y="1995"/>
                </a:cxn>
                <a:cxn ang="0">
                  <a:pos x="681" y="1691"/>
                </a:cxn>
                <a:cxn ang="0">
                  <a:pos x="738" y="1396"/>
                </a:cxn>
                <a:cxn ang="0">
                  <a:pos x="795" y="940"/>
                </a:cxn>
                <a:cxn ang="0">
                  <a:pos x="852" y="807"/>
                </a:cxn>
                <a:cxn ang="0">
                  <a:pos x="909" y="605"/>
                </a:cxn>
                <a:cxn ang="0">
                  <a:pos x="965" y="440"/>
                </a:cxn>
                <a:cxn ang="0">
                  <a:pos x="1022" y="284"/>
                </a:cxn>
                <a:cxn ang="0">
                  <a:pos x="1079" y="248"/>
                </a:cxn>
                <a:cxn ang="0">
                  <a:pos x="1136" y="152"/>
                </a:cxn>
                <a:cxn ang="0">
                  <a:pos x="1193" y="102"/>
                </a:cxn>
                <a:cxn ang="0">
                  <a:pos x="1249" y="49"/>
                </a:cxn>
                <a:cxn ang="0">
                  <a:pos x="1306" y="33"/>
                </a:cxn>
                <a:cxn ang="0">
                  <a:pos x="1363" y="6"/>
                </a:cxn>
                <a:cxn ang="0">
                  <a:pos x="1420" y="36"/>
                </a:cxn>
                <a:cxn ang="0">
                  <a:pos x="1477" y="9"/>
                </a:cxn>
                <a:cxn ang="0">
                  <a:pos x="1533" y="6"/>
                </a:cxn>
                <a:cxn ang="0">
                  <a:pos x="1590" y="6"/>
                </a:cxn>
                <a:cxn ang="0">
                  <a:pos x="1590" y="0"/>
                </a:cxn>
              </a:cxnLst>
              <a:rect l="0" t="0" r="r" b="b"/>
              <a:pathLst>
                <a:path w="1590" h="2211">
                  <a:moveTo>
                    <a:pt x="0" y="0"/>
                  </a:moveTo>
                  <a:lnTo>
                    <a:pt x="0" y="6"/>
                  </a:lnTo>
                  <a:lnTo>
                    <a:pt x="57" y="6"/>
                  </a:lnTo>
                  <a:lnTo>
                    <a:pt x="113" y="36"/>
                  </a:lnTo>
                  <a:lnTo>
                    <a:pt x="170" y="82"/>
                  </a:lnTo>
                  <a:lnTo>
                    <a:pt x="227" y="205"/>
                  </a:lnTo>
                  <a:lnTo>
                    <a:pt x="284" y="582"/>
                  </a:lnTo>
                  <a:lnTo>
                    <a:pt x="341" y="940"/>
                  </a:lnTo>
                  <a:lnTo>
                    <a:pt x="397" y="1568"/>
                  </a:lnTo>
                  <a:lnTo>
                    <a:pt x="454" y="2055"/>
                  </a:lnTo>
                  <a:lnTo>
                    <a:pt x="511" y="2211"/>
                  </a:lnTo>
                  <a:lnTo>
                    <a:pt x="568" y="2211"/>
                  </a:lnTo>
                  <a:lnTo>
                    <a:pt x="625" y="1995"/>
                  </a:lnTo>
                  <a:lnTo>
                    <a:pt x="681" y="1691"/>
                  </a:lnTo>
                  <a:lnTo>
                    <a:pt x="738" y="1396"/>
                  </a:lnTo>
                  <a:lnTo>
                    <a:pt x="795" y="940"/>
                  </a:lnTo>
                  <a:lnTo>
                    <a:pt x="852" y="807"/>
                  </a:lnTo>
                  <a:lnTo>
                    <a:pt x="909" y="605"/>
                  </a:lnTo>
                  <a:lnTo>
                    <a:pt x="965" y="440"/>
                  </a:lnTo>
                  <a:lnTo>
                    <a:pt x="1022" y="284"/>
                  </a:lnTo>
                  <a:lnTo>
                    <a:pt x="1079" y="248"/>
                  </a:lnTo>
                  <a:lnTo>
                    <a:pt x="1136" y="152"/>
                  </a:lnTo>
                  <a:lnTo>
                    <a:pt x="1193" y="102"/>
                  </a:lnTo>
                  <a:lnTo>
                    <a:pt x="1249" y="49"/>
                  </a:lnTo>
                  <a:lnTo>
                    <a:pt x="1306" y="33"/>
                  </a:lnTo>
                  <a:lnTo>
                    <a:pt x="1363" y="6"/>
                  </a:lnTo>
                  <a:lnTo>
                    <a:pt x="1420" y="36"/>
                  </a:lnTo>
                  <a:lnTo>
                    <a:pt x="1477" y="9"/>
                  </a:lnTo>
                  <a:lnTo>
                    <a:pt x="1533" y="6"/>
                  </a:lnTo>
                  <a:lnTo>
                    <a:pt x="1590" y="6"/>
                  </a:lnTo>
                  <a:lnTo>
                    <a:pt x="1590" y="0"/>
                  </a:lnTo>
                </a:path>
              </a:pathLst>
            </a:cu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Line 214">
              <a:extLst>
                <a:ext uri="{FF2B5EF4-FFF2-40B4-BE49-F238E27FC236}">
                  <a16:creationId xmlns:a16="http://schemas.microsoft.com/office/drawing/2014/main" id="{F79873C0-49E7-ECFB-AC80-8473C78D12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35655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Freeform 215">
              <a:extLst>
                <a:ext uri="{FF2B5EF4-FFF2-40B4-BE49-F238E27FC236}">
                  <a16:creationId xmlns:a16="http://schemas.microsoft.com/office/drawing/2014/main" id="{3C1E0008-9929-44EE-407D-27BD31C4ACF5}"/>
                </a:ext>
              </a:extLst>
            </p:cNvPr>
            <p:cNvSpPr>
              <a:spLocks/>
            </p:cNvSpPr>
            <p:nvPr/>
          </p:nvSpPr>
          <p:spPr bwMode="auto">
            <a:xfrm flipV="1">
              <a:off x="6603218" y="4172235"/>
              <a:ext cx="23563" cy="53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"/>
                </a:cxn>
                <a:cxn ang="0">
                  <a:pos x="57" y="13"/>
                </a:cxn>
                <a:cxn ang="0">
                  <a:pos x="114" y="43"/>
                </a:cxn>
                <a:cxn ang="0">
                  <a:pos x="171" y="23"/>
                </a:cxn>
                <a:cxn ang="0">
                  <a:pos x="228" y="115"/>
                </a:cxn>
                <a:cxn ang="0">
                  <a:pos x="285" y="59"/>
                </a:cxn>
                <a:cxn ang="0">
                  <a:pos x="341" y="109"/>
                </a:cxn>
                <a:cxn ang="0">
                  <a:pos x="398" y="109"/>
                </a:cxn>
                <a:cxn ang="0">
                  <a:pos x="455" y="69"/>
                </a:cxn>
                <a:cxn ang="0">
                  <a:pos x="512" y="43"/>
                </a:cxn>
                <a:cxn ang="0">
                  <a:pos x="569" y="33"/>
                </a:cxn>
                <a:cxn ang="0">
                  <a:pos x="626" y="6"/>
                </a:cxn>
                <a:cxn ang="0">
                  <a:pos x="683" y="13"/>
                </a:cxn>
                <a:cxn ang="0">
                  <a:pos x="739" y="26"/>
                </a:cxn>
                <a:cxn ang="0">
                  <a:pos x="739" y="0"/>
                </a:cxn>
              </a:cxnLst>
              <a:rect l="0" t="0" r="r" b="b"/>
              <a:pathLst>
                <a:path w="739" h="115">
                  <a:moveTo>
                    <a:pt x="0" y="0"/>
                  </a:moveTo>
                  <a:lnTo>
                    <a:pt x="0" y="6"/>
                  </a:lnTo>
                  <a:lnTo>
                    <a:pt x="57" y="13"/>
                  </a:lnTo>
                  <a:lnTo>
                    <a:pt x="114" y="43"/>
                  </a:lnTo>
                  <a:lnTo>
                    <a:pt x="171" y="23"/>
                  </a:lnTo>
                  <a:lnTo>
                    <a:pt x="228" y="115"/>
                  </a:lnTo>
                  <a:lnTo>
                    <a:pt x="285" y="59"/>
                  </a:lnTo>
                  <a:lnTo>
                    <a:pt x="341" y="109"/>
                  </a:lnTo>
                  <a:lnTo>
                    <a:pt x="398" y="109"/>
                  </a:lnTo>
                  <a:lnTo>
                    <a:pt x="455" y="69"/>
                  </a:lnTo>
                  <a:lnTo>
                    <a:pt x="512" y="43"/>
                  </a:lnTo>
                  <a:lnTo>
                    <a:pt x="569" y="33"/>
                  </a:lnTo>
                  <a:lnTo>
                    <a:pt x="626" y="6"/>
                  </a:lnTo>
                  <a:lnTo>
                    <a:pt x="683" y="13"/>
                  </a:lnTo>
                  <a:lnTo>
                    <a:pt x="739" y="26"/>
                  </a:lnTo>
                  <a:lnTo>
                    <a:pt x="739" y="0"/>
                  </a:lnTo>
                </a:path>
              </a:pathLst>
            </a:cu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Line 216">
              <a:extLst>
                <a:ext uri="{FF2B5EF4-FFF2-40B4-BE49-F238E27FC236}">
                  <a16:creationId xmlns:a16="http://schemas.microsoft.com/office/drawing/2014/main" id="{82445290-0026-73B1-4394-4BCFF9D167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37690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Line 217">
              <a:extLst>
                <a:ext uri="{FF2B5EF4-FFF2-40B4-BE49-F238E27FC236}">
                  <a16:creationId xmlns:a16="http://schemas.microsoft.com/office/drawing/2014/main" id="{4D72BD38-BDC0-F257-70D3-7F5F9E3B0D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63798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8" name="Line 218">
              <a:extLst>
                <a:ext uri="{FF2B5EF4-FFF2-40B4-BE49-F238E27FC236}">
                  <a16:creationId xmlns:a16="http://schemas.microsoft.com/office/drawing/2014/main" id="{4DB003C0-765A-B982-F377-61D1AAAB13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27070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9" name="Line 219">
              <a:extLst>
                <a:ext uri="{FF2B5EF4-FFF2-40B4-BE49-F238E27FC236}">
                  <a16:creationId xmlns:a16="http://schemas.microsoft.com/office/drawing/2014/main" id="{C45A69BD-C9AE-8CC4-CC2C-19A1A0A3DD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30561" y="4177611"/>
              <a:ext cx="436" cy="896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" name="Rectangle 221">
              <a:extLst>
                <a:ext uri="{FF2B5EF4-FFF2-40B4-BE49-F238E27FC236}">
                  <a16:creationId xmlns:a16="http://schemas.microsoft.com/office/drawing/2014/main" id="{30C1565C-8460-D44E-C6BB-4984FBA77E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7316" y="2812141"/>
              <a:ext cx="32380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490.2685</a:t>
              </a:r>
              <a:endParaRPr kumimoji="0" 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A1D27C0E-C8D7-7ED3-2F48-0A18C3A3983A}"/>
              </a:ext>
            </a:extLst>
          </p:cNvPr>
          <p:cNvSpPr txBox="1"/>
          <p:nvPr/>
        </p:nvSpPr>
        <p:spPr>
          <a:xfrm rot="16200000">
            <a:off x="333919" y="1566993"/>
            <a:ext cx="934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20 nm (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U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3085BDBB-278C-B4B9-BE0A-964495005213}"/>
              </a:ext>
            </a:extLst>
          </p:cNvPr>
          <p:cNvSpPr txBox="1"/>
          <p:nvPr/>
        </p:nvSpPr>
        <p:spPr>
          <a:xfrm>
            <a:off x="2187233" y="2264969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4" name="グループ化 133">
            <a:extLst>
              <a:ext uri="{FF2B5EF4-FFF2-40B4-BE49-F238E27FC236}">
                <a16:creationId xmlns:a16="http://schemas.microsoft.com/office/drawing/2014/main" id="{14EA6F22-B31C-A436-3D0D-F969F580B428}"/>
              </a:ext>
            </a:extLst>
          </p:cNvPr>
          <p:cNvGrpSpPr/>
          <p:nvPr/>
        </p:nvGrpSpPr>
        <p:grpSpPr>
          <a:xfrm>
            <a:off x="904865" y="2921776"/>
            <a:ext cx="3242598" cy="970836"/>
            <a:chOff x="4326603" y="3637319"/>
            <a:chExt cx="3242598" cy="970836"/>
          </a:xfrm>
        </p:grpSpPr>
        <p:sp>
          <p:nvSpPr>
            <p:cNvPr id="135" name="Line 101">
              <a:extLst>
                <a:ext uri="{FF2B5EF4-FFF2-40B4-BE49-F238E27FC236}">
                  <a16:creationId xmlns:a16="http://schemas.microsoft.com/office/drawing/2014/main" id="{9805494C-B863-B278-ACA8-7A49FF156D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4376" y="4546600"/>
              <a:ext cx="555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" name="Rectangle 102">
              <a:extLst>
                <a:ext uri="{FF2B5EF4-FFF2-40B4-BE49-F238E27FC236}">
                  <a16:creationId xmlns:a16="http://schemas.microsoft.com/office/drawing/2014/main" id="{0EFE1350-A136-7858-2D47-EAF0A173A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32965" y="4485044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anose="020B0609070205080204" pitchFamily="49" charset="-128"/>
                  <a:cs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7" name="Line 103">
              <a:extLst>
                <a:ext uri="{FF2B5EF4-FFF2-40B4-BE49-F238E27FC236}">
                  <a16:creationId xmlns:a16="http://schemas.microsoft.com/office/drawing/2014/main" id="{BA62D161-5E79-C589-F440-6468257466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4376" y="4265613"/>
              <a:ext cx="555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" name="Rectangle 104">
              <a:extLst>
                <a:ext uri="{FF2B5EF4-FFF2-40B4-BE49-F238E27FC236}">
                  <a16:creationId xmlns:a16="http://schemas.microsoft.com/office/drawing/2014/main" id="{710C5A19-86CD-60BC-5597-0D07F2C178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8990" y="4202469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anose="020B0609070205080204" pitchFamily="49" charset="-128"/>
                  <a:cs typeface="Arial" panose="020B0604020202020204" pitchFamily="34" charset="0"/>
                </a:rPr>
                <a:t>5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9" name="Line 105">
              <a:extLst>
                <a:ext uri="{FF2B5EF4-FFF2-40B4-BE49-F238E27FC236}">
                  <a16:creationId xmlns:a16="http://schemas.microsoft.com/office/drawing/2014/main" id="{8002315D-EDB7-7C04-74AA-702BFF5A5A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4376" y="3981450"/>
              <a:ext cx="555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Rectangle 106">
              <a:extLst>
                <a:ext uri="{FF2B5EF4-FFF2-40B4-BE49-F238E27FC236}">
                  <a16:creationId xmlns:a16="http://schemas.microsoft.com/office/drawing/2014/main" id="{30C334CA-D535-47FF-38C7-8A0AEC8249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6603" y="3919894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anose="020B0609070205080204" pitchFamily="49" charset="-128"/>
                  <a:cs typeface="Arial" panose="020B06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1" name="Line 107">
              <a:extLst>
                <a:ext uri="{FF2B5EF4-FFF2-40B4-BE49-F238E27FC236}">
                  <a16:creationId xmlns:a16="http://schemas.microsoft.com/office/drawing/2014/main" id="{E523BEF0-B895-5B47-1D3E-6D7B15CE75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4376" y="3698875"/>
              <a:ext cx="555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Rectangle 108">
              <a:extLst>
                <a:ext uri="{FF2B5EF4-FFF2-40B4-BE49-F238E27FC236}">
                  <a16:creationId xmlns:a16="http://schemas.microsoft.com/office/drawing/2014/main" id="{7732E1AE-A580-4137-7ADB-327B03DBAD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6603" y="3637319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anose="020B0609070205080204" pitchFamily="49" charset="-128"/>
                  <a:cs typeface="Arial" panose="020B0604020202020204" pitchFamily="34" charset="0"/>
                </a:rPr>
                <a:t>1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3" name="Freeform 110">
              <a:extLst>
                <a:ext uri="{FF2B5EF4-FFF2-40B4-BE49-F238E27FC236}">
                  <a16:creationId xmlns:a16="http://schemas.microsoft.com/office/drawing/2014/main" id="{FA14FA86-423E-DA62-592A-D9DFBE1E1F1A}"/>
                </a:ext>
              </a:extLst>
            </p:cNvPr>
            <p:cNvSpPr>
              <a:spLocks/>
            </p:cNvSpPr>
            <p:nvPr/>
          </p:nvSpPr>
          <p:spPr bwMode="auto">
            <a:xfrm>
              <a:off x="4581526" y="4094163"/>
              <a:ext cx="2987675" cy="400050"/>
            </a:xfrm>
            <a:custGeom>
              <a:avLst/>
              <a:gdLst>
                <a:gd name="T0" fmla="*/ 27 w 1882"/>
                <a:gd name="T1" fmla="*/ 128 h 144"/>
                <a:gd name="T2" fmla="*/ 58 w 1882"/>
                <a:gd name="T3" fmla="*/ 127 h 144"/>
                <a:gd name="T4" fmla="*/ 89 w 1882"/>
                <a:gd name="T5" fmla="*/ 127 h 144"/>
                <a:gd name="T6" fmla="*/ 120 w 1882"/>
                <a:gd name="T7" fmla="*/ 128 h 144"/>
                <a:gd name="T8" fmla="*/ 149 w 1882"/>
                <a:gd name="T9" fmla="*/ 128 h 144"/>
                <a:gd name="T10" fmla="*/ 180 w 1882"/>
                <a:gd name="T11" fmla="*/ 130 h 144"/>
                <a:gd name="T12" fmla="*/ 211 w 1882"/>
                <a:gd name="T13" fmla="*/ 130 h 144"/>
                <a:gd name="T14" fmla="*/ 241 w 1882"/>
                <a:gd name="T15" fmla="*/ 131 h 144"/>
                <a:gd name="T16" fmla="*/ 272 w 1882"/>
                <a:gd name="T17" fmla="*/ 132 h 144"/>
                <a:gd name="T18" fmla="*/ 302 w 1882"/>
                <a:gd name="T19" fmla="*/ 133 h 144"/>
                <a:gd name="T20" fmla="*/ 332 w 1882"/>
                <a:gd name="T21" fmla="*/ 134 h 144"/>
                <a:gd name="T22" fmla="*/ 363 w 1882"/>
                <a:gd name="T23" fmla="*/ 135 h 144"/>
                <a:gd name="T24" fmla="*/ 394 w 1882"/>
                <a:gd name="T25" fmla="*/ 136 h 144"/>
                <a:gd name="T26" fmla="*/ 424 w 1882"/>
                <a:gd name="T27" fmla="*/ 136 h 144"/>
                <a:gd name="T28" fmla="*/ 455 w 1882"/>
                <a:gd name="T29" fmla="*/ 138 h 144"/>
                <a:gd name="T30" fmla="*/ 485 w 1882"/>
                <a:gd name="T31" fmla="*/ 139 h 144"/>
                <a:gd name="T32" fmla="*/ 515 w 1882"/>
                <a:gd name="T33" fmla="*/ 139 h 144"/>
                <a:gd name="T34" fmla="*/ 546 w 1882"/>
                <a:gd name="T35" fmla="*/ 140 h 144"/>
                <a:gd name="T36" fmla="*/ 577 w 1882"/>
                <a:gd name="T37" fmla="*/ 141 h 144"/>
                <a:gd name="T38" fmla="*/ 607 w 1882"/>
                <a:gd name="T39" fmla="*/ 142 h 144"/>
                <a:gd name="T40" fmla="*/ 637 w 1882"/>
                <a:gd name="T41" fmla="*/ 143 h 144"/>
                <a:gd name="T42" fmla="*/ 668 w 1882"/>
                <a:gd name="T43" fmla="*/ 143 h 144"/>
                <a:gd name="T44" fmla="*/ 699 w 1882"/>
                <a:gd name="T45" fmla="*/ 144 h 144"/>
                <a:gd name="T46" fmla="*/ 729 w 1882"/>
                <a:gd name="T47" fmla="*/ 144 h 144"/>
                <a:gd name="T48" fmla="*/ 760 w 1882"/>
                <a:gd name="T49" fmla="*/ 144 h 144"/>
                <a:gd name="T50" fmla="*/ 790 w 1882"/>
                <a:gd name="T51" fmla="*/ 144 h 144"/>
                <a:gd name="T52" fmla="*/ 820 w 1882"/>
                <a:gd name="T53" fmla="*/ 144 h 144"/>
                <a:gd name="T54" fmla="*/ 851 w 1882"/>
                <a:gd name="T55" fmla="*/ 144 h 144"/>
                <a:gd name="T56" fmla="*/ 882 w 1882"/>
                <a:gd name="T57" fmla="*/ 144 h 144"/>
                <a:gd name="T58" fmla="*/ 912 w 1882"/>
                <a:gd name="T59" fmla="*/ 140 h 144"/>
                <a:gd name="T60" fmla="*/ 942 w 1882"/>
                <a:gd name="T61" fmla="*/ 142 h 144"/>
                <a:gd name="T62" fmla="*/ 973 w 1882"/>
                <a:gd name="T63" fmla="*/ 136 h 144"/>
                <a:gd name="T64" fmla="*/ 1003 w 1882"/>
                <a:gd name="T65" fmla="*/ 2 h 144"/>
                <a:gd name="T66" fmla="*/ 1034 w 1882"/>
                <a:gd name="T67" fmla="*/ 99 h 144"/>
                <a:gd name="T68" fmla="*/ 1065 w 1882"/>
                <a:gd name="T69" fmla="*/ 131 h 144"/>
                <a:gd name="T70" fmla="*/ 1094 w 1882"/>
                <a:gd name="T71" fmla="*/ 140 h 144"/>
                <a:gd name="T72" fmla="*/ 1125 w 1882"/>
                <a:gd name="T73" fmla="*/ 143 h 144"/>
                <a:gd name="T74" fmla="*/ 1156 w 1882"/>
                <a:gd name="T75" fmla="*/ 143 h 144"/>
                <a:gd name="T76" fmla="*/ 1187 w 1882"/>
                <a:gd name="T77" fmla="*/ 143 h 144"/>
                <a:gd name="T78" fmla="*/ 1217 w 1882"/>
                <a:gd name="T79" fmla="*/ 143 h 144"/>
                <a:gd name="T80" fmla="*/ 1247 w 1882"/>
                <a:gd name="T81" fmla="*/ 142 h 144"/>
                <a:gd name="T82" fmla="*/ 1278 w 1882"/>
                <a:gd name="T83" fmla="*/ 142 h 144"/>
                <a:gd name="T84" fmla="*/ 1308 w 1882"/>
                <a:gd name="T85" fmla="*/ 142 h 144"/>
                <a:gd name="T86" fmla="*/ 1339 w 1882"/>
                <a:gd name="T87" fmla="*/ 142 h 144"/>
                <a:gd name="T88" fmla="*/ 1370 w 1882"/>
                <a:gd name="T89" fmla="*/ 141 h 144"/>
                <a:gd name="T90" fmla="*/ 1400 w 1882"/>
                <a:gd name="T91" fmla="*/ 140 h 144"/>
                <a:gd name="T92" fmla="*/ 1430 w 1882"/>
                <a:gd name="T93" fmla="*/ 139 h 144"/>
                <a:gd name="T94" fmla="*/ 1461 w 1882"/>
                <a:gd name="T95" fmla="*/ 139 h 144"/>
                <a:gd name="T96" fmla="*/ 1491 w 1882"/>
                <a:gd name="T97" fmla="*/ 138 h 144"/>
                <a:gd name="T98" fmla="*/ 1522 w 1882"/>
                <a:gd name="T99" fmla="*/ 136 h 144"/>
                <a:gd name="T100" fmla="*/ 1553 w 1882"/>
                <a:gd name="T101" fmla="*/ 123 h 144"/>
                <a:gd name="T102" fmla="*/ 1582 w 1882"/>
                <a:gd name="T103" fmla="*/ 130 h 144"/>
                <a:gd name="T104" fmla="*/ 1613 w 1882"/>
                <a:gd name="T105" fmla="*/ 132 h 144"/>
                <a:gd name="T106" fmla="*/ 1644 w 1882"/>
                <a:gd name="T107" fmla="*/ 133 h 144"/>
                <a:gd name="T108" fmla="*/ 1674 w 1882"/>
                <a:gd name="T109" fmla="*/ 132 h 144"/>
                <a:gd name="T110" fmla="*/ 1705 w 1882"/>
                <a:gd name="T111" fmla="*/ 132 h 144"/>
                <a:gd name="T112" fmla="*/ 1735 w 1882"/>
                <a:gd name="T113" fmla="*/ 132 h 144"/>
                <a:gd name="T114" fmla="*/ 1766 w 1882"/>
                <a:gd name="T115" fmla="*/ 131 h 144"/>
                <a:gd name="T116" fmla="*/ 1796 w 1882"/>
                <a:gd name="T117" fmla="*/ 130 h 144"/>
                <a:gd name="T118" fmla="*/ 1827 w 1882"/>
                <a:gd name="T119" fmla="*/ 130 h 144"/>
                <a:gd name="T120" fmla="*/ 1858 w 1882"/>
                <a:gd name="T121" fmla="*/ 130 h 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1882" h="144">
                  <a:moveTo>
                    <a:pt x="0" y="130"/>
                  </a:moveTo>
                  <a:lnTo>
                    <a:pt x="2" y="130"/>
                  </a:lnTo>
                  <a:lnTo>
                    <a:pt x="4" y="130"/>
                  </a:lnTo>
                  <a:lnTo>
                    <a:pt x="7" y="130"/>
                  </a:lnTo>
                  <a:lnTo>
                    <a:pt x="9" y="129"/>
                  </a:lnTo>
                  <a:lnTo>
                    <a:pt x="11" y="129"/>
                  </a:lnTo>
                  <a:lnTo>
                    <a:pt x="14" y="129"/>
                  </a:lnTo>
                  <a:lnTo>
                    <a:pt x="16" y="129"/>
                  </a:lnTo>
                  <a:lnTo>
                    <a:pt x="19" y="129"/>
                  </a:lnTo>
                  <a:lnTo>
                    <a:pt x="21" y="129"/>
                  </a:lnTo>
                  <a:lnTo>
                    <a:pt x="23" y="128"/>
                  </a:lnTo>
                  <a:lnTo>
                    <a:pt x="25" y="128"/>
                  </a:lnTo>
                  <a:lnTo>
                    <a:pt x="27" y="128"/>
                  </a:lnTo>
                  <a:lnTo>
                    <a:pt x="30" y="128"/>
                  </a:lnTo>
                  <a:lnTo>
                    <a:pt x="32" y="128"/>
                  </a:lnTo>
                  <a:lnTo>
                    <a:pt x="35" y="128"/>
                  </a:lnTo>
                  <a:lnTo>
                    <a:pt x="37" y="128"/>
                  </a:lnTo>
                  <a:lnTo>
                    <a:pt x="40" y="128"/>
                  </a:lnTo>
                  <a:lnTo>
                    <a:pt x="42" y="128"/>
                  </a:lnTo>
                  <a:lnTo>
                    <a:pt x="45" y="128"/>
                  </a:lnTo>
                  <a:lnTo>
                    <a:pt x="47" y="127"/>
                  </a:lnTo>
                  <a:lnTo>
                    <a:pt x="48" y="127"/>
                  </a:lnTo>
                  <a:lnTo>
                    <a:pt x="51" y="127"/>
                  </a:lnTo>
                  <a:lnTo>
                    <a:pt x="53" y="127"/>
                  </a:lnTo>
                  <a:lnTo>
                    <a:pt x="56" y="127"/>
                  </a:lnTo>
                  <a:lnTo>
                    <a:pt x="58" y="127"/>
                  </a:lnTo>
                  <a:lnTo>
                    <a:pt x="61" y="127"/>
                  </a:lnTo>
                  <a:lnTo>
                    <a:pt x="63" y="127"/>
                  </a:lnTo>
                  <a:lnTo>
                    <a:pt x="65" y="127"/>
                  </a:lnTo>
                  <a:lnTo>
                    <a:pt x="68" y="127"/>
                  </a:lnTo>
                  <a:lnTo>
                    <a:pt x="70" y="127"/>
                  </a:lnTo>
                  <a:lnTo>
                    <a:pt x="72" y="127"/>
                  </a:lnTo>
                  <a:lnTo>
                    <a:pt x="74" y="127"/>
                  </a:lnTo>
                  <a:lnTo>
                    <a:pt x="77" y="127"/>
                  </a:lnTo>
                  <a:lnTo>
                    <a:pt x="79" y="127"/>
                  </a:lnTo>
                  <a:lnTo>
                    <a:pt x="82" y="127"/>
                  </a:lnTo>
                  <a:lnTo>
                    <a:pt x="84" y="127"/>
                  </a:lnTo>
                  <a:lnTo>
                    <a:pt x="86" y="127"/>
                  </a:lnTo>
                  <a:lnTo>
                    <a:pt x="89" y="127"/>
                  </a:lnTo>
                  <a:lnTo>
                    <a:pt x="91" y="127"/>
                  </a:lnTo>
                  <a:lnTo>
                    <a:pt x="94" y="127"/>
                  </a:lnTo>
                  <a:lnTo>
                    <a:pt x="96" y="127"/>
                  </a:lnTo>
                  <a:lnTo>
                    <a:pt x="98" y="127"/>
                  </a:lnTo>
                  <a:lnTo>
                    <a:pt x="100" y="127"/>
                  </a:lnTo>
                  <a:lnTo>
                    <a:pt x="102" y="127"/>
                  </a:lnTo>
                  <a:lnTo>
                    <a:pt x="105" y="127"/>
                  </a:lnTo>
                  <a:lnTo>
                    <a:pt x="107" y="127"/>
                  </a:lnTo>
                  <a:lnTo>
                    <a:pt x="110" y="127"/>
                  </a:lnTo>
                  <a:lnTo>
                    <a:pt x="112" y="128"/>
                  </a:lnTo>
                  <a:lnTo>
                    <a:pt x="115" y="128"/>
                  </a:lnTo>
                  <a:lnTo>
                    <a:pt x="117" y="128"/>
                  </a:lnTo>
                  <a:lnTo>
                    <a:pt x="120" y="128"/>
                  </a:lnTo>
                  <a:lnTo>
                    <a:pt x="122" y="127"/>
                  </a:lnTo>
                  <a:lnTo>
                    <a:pt x="124" y="127"/>
                  </a:lnTo>
                  <a:lnTo>
                    <a:pt x="126" y="127"/>
                  </a:lnTo>
                  <a:lnTo>
                    <a:pt x="128" y="127"/>
                  </a:lnTo>
                  <a:lnTo>
                    <a:pt x="131" y="127"/>
                  </a:lnTo>
                  <a:lnTo>
                    <a:pt x="133" y="127"/>
                  </a:lnTo>
                  <a:lnTo>
                    <a:pt x="136" y="128"/>
                  </a:lnTo>
                  <a:lnTo>
                    <a:pt x="138" y="128"/>
                  </a:lnTo>
                  <a:lnTo>
                    <a:pt x="140" y="128"/>
                  </a:lnTo>
                  <a:lnTo>
                    <a:pt x="143" y="128"/>
                  </a:lnTo>
                  <a:lnTo>
                    <a:pt x="145" y="128"/>
                  </a:lnTo>
                  <a:lnTo>
                    <a:pt x="148" y="128"/>
                  </a:lnTo>
                  <a:lnTo>
                    <a:pt x="149" y="128"/>
                  </a:lnTo>
                  <a:lnTo>
                    <a:pt x="152" y="129"/>
                  </a:lnTo>
                  <a:lnTo>
                    <a:pt x="154" y="129"/>
                  </a:lnTo>
                  <a:lnTo>
                    <a:pt x="157" y="129"/>
                  </a:lnTo>
                  <a:lnTo>
                    <a:pt x="159" y="129"/>
                  </a:lnTo>
                  <a:lnTo>
                    <a:pt x="161" y="129"/>
                  </a:lnTo>
                  <a:lnTo>
                    <a:pt x="164" y="129"/>
                  </a:lnTo>
                  <a:lnTo>
                    <a:pt x="166" y="129"/>
                  </a:lnTo>
                  <a:lnTo>
                    <a:pt x="169" y="129"/>
                  </a:lnTo>
                  <a:lnTo>
                    <a:pt x="171" y="129"/>
                  </a:lnTo>
                  <a:lnTo>
                    <a:pt x="174" y="129"/>
                  </a:lnTo>
                  <a:lnTo>
                    <a:pt x="175" y="129"/>
                  </a:lnTo>
                  <a:lnTo>
                    <a:pt x="177" y="130"/>
                  </a:lnTo>
                  <a:lnTo>
                    <a:pt x="180" y="130"/>
                  </a:lnTo>
                  <a:lnTo>
                    <a:pt x="182" y="130"/>
                  </a:lnTo>
                  <a:lnTo>
                    <a:pt x="185" y="130"/>
                  </a:lnTo>
                  <a:lnTo>
                    <a:pt x="187" y="130"/>
                  </a:lnTo>
                  <a:lnTo>
                    <a:pt x="190" y="130"/>
                  </a:lnTo>
                  <a:lnTo>
                    <a:pt x="192" y="130"/>
                  </a:lnTo>
                  <a:lnTo>
                    <a:pt x="195" y="130"/>
                  </a:lnTo>
                  <a:lnTo>
                    <a:pt x="197" y="130"/>
                  </a:lnTo>
                  <a:lnTo>
                    <a:pt x="199" y="130"/>
                  </a:lnTo>
                  <a:lnTo>
                    <a:pt x="201" y="130"/>
                  </a:lnTo>
                  <a:lnTo>
                    <a:pt x="203" y="130"/>
                  </a:lnTo>
                  <a:lnTo>
                    <a:pt x="206" y="130"/>
                  </a:lnTo>
                  <a:lnTo>
                    <a:pt x="208" y="130"/>
                  </a:lnTo>
                  <a:lnTo>
                    <a:pt x="211" y="130"/>
                  </a:lnTo>
                  <a:lnTo>
                    <a:pt x="213" y="130"/>
                  </a:lnTo>
                  <a:lnTo>
                    <a:pt x="215" y="130"/>
                  </a:lnTo>
                  <a:lnTo>
                    <a:pt x="218" y="130"/>
                  </a:lnTo>
                  <a:lnTo>
                    <a:pt x="220" y="130"/>
                  </a:lnTo>
                  <a:lnTo>
                    <a:pt x="223" y="130"/>
                  </a:lnTo>
                  <a:lnTo>
                    <a:pt x="225" y="130"/>
                  </a:lnTo>
                  <a:lnTo>
                    <a:pt x="227" y="130"/>
                  </a:lnTo>
                  <a:lnTo>
                    <a:pt x="229" y="131"/>
                  </a:lnTo>
                  <a:lnTo>
                    <a:pt x="232" y="131"/>
                  </a:lnTo>
                  <a:lnTo>
                    <a:pt x="234" y="131"/>
                  </a:lnTo>
                  <a:lnTo>
                    <a:pt x="236" y="131"/>
                  </a:lnTo>
                  <a:lnTo>
                    <a:pt x="239" y="131"/>
                  </a:lnTo>
                  <a:lnTo>
                    <a:pt x="241" y="131"/>
                  </a:lnTo>
                  <a:lnTo>
                    <a:pt x="244" y="131"/>
                  </a:lnTo>
                  <a:lnTo>
                    <a:pt x="246" y="131"/>
                  </a:lnTo>
                  <a:lnTo>
                    <a:pt x="249" y="131"/>
                  </a:lnTo>
                  <a:lnTo>
                    <a:pt x="251" y="131"/>
                  </a:lnTo>
                  <a:lnTo>
                    <a:pt x="252" y="131"/>
                  </a:lnTo>
                  <a:lnTo>
                    <a:pt x="255" y="131"/>
                  </a:lnTo>
                  <a:lnTo>
                    <a:pt x="257" y="132"/>
                  </a:lnTo>
                  <a:lnTo>
                    <a:pt x="260" y="132"/>
                  </a:lnTo>
                  <a:lnTo>
                    <a:pt x="262" y="132"/>
                  </a:lnTo>
                  <a:lnTo>
                    <a:pt x="265" y="132"/>
                  </a:lnTo>
                  <a:lnTo>
                    <a:pt x="267" y="132"/>
                  </a:lnTo>
                  <a:lnTo>
                    <a:pt x="270" y="132"/>
                  </a:lnTo>
                  <a:lnTo>
                    <a:pt x="272" y="132"/>
                  </a:lnTo>
                  <a:lnTo>
                    <a:pt x="274" y="132"/>
                  </a:lnTo>
                  <a:lnTo>
                    <a:pt x="277" y="132"/>
                  </a:lnTo>
                  <a:lnTo>
                    <a:pt x="278" y="132"/>
                  </a:lnTo>
                  <a:lnTo>
                    <a:pt x="281" y="132"/>
                  </a:lnTo>
                  <a:lnTo>
                    <a:pt x="283" y="132"/>
                  </a:lnTo>
                  <a:lnTo>
                    <a:pt x="286" y="132"/>
                  </a:lnTo>
                  <a:lnTo>
                    <a:pt x="288" y="132"/>
                  </a:lnTo>
                  <a:lnTo>
                    <a:pt x="290" y="132"/>
                  </a:lnTo>
                  <a:lnTo>
                    <a:pt x="293" y="132"/>
                  </a:lnTo>
                  <a:lnTo>
                    <a:pt x="295" y="133"/>
                  </a:lnTo>
                  <a:lnTo>
                    <a:pt x="298" y="133"/>
                  </a:lnTo>
                  <a:lnTo>
                    <a:pt x="300" y="133"/>
                  </a:lnTo>
                  <a:lnTo>
                    <a:pt x="302" y="133"/>
                  </a:lnTo>
                  <a:lnTo>
                    <a:pt x="304" y="133"/>
                  </a:lnTo>
                  <a:lnTo>
                    <a:pt x="307" y="133"/>
                  </a:lnTo>
                  <a:lnTo>
                    <a:pt x="309" y="133"/>
                  </a:lnTo>
                  <a:lnTo>
                    <a:pt x="311" y="133"/>
                  </a:lnTo>
                  <a:lnTo>
                    <a:pt x="314" y="133"/>
                  </a:lnTo>
                  <a:lnTo>
                    <a:pt x="316" y="133"/>
                  </a:lnTo>
                  <a:lnTo>
                    <a:pt x="319" y="133"/>
                  </a:lnTo>
                  <a:lnTo>
                    <a:pt x="321" y="133"/>
                  </a:lnTo>
                  <a:lnTo>
                    <a:pt x="324" y="134"/>
                  </a:lnTo>
                  <a:lnTo>
                    <a:pt x="326" y="134"/>
                  </a:lnTo>
                  <a:lnTo>
                    <a:pt x="328" y="134"/>
                  </a:lnTo>
                  <a:lnTo>
                    <a:pt x="330" y="134"/>
                  </a:lnTo>
                  <a:lnTo>
                    <a:pt x="332" y="134"/>
                  </a:lnTo>
                  <a:lnTo>
                    <a:pt x="335" y="134"/>
                  </a:lnTo>
                  <a:lnTo>
                    <a:pt x="337" y="134"/>
                  </a:lnTo>
                  <a:lnTo>
                    <a:pt x="340" y="134"/>
                  </a:lnTo>
                  <a:lnTo>
                    <a:pt x="342" y="134"/>
                  </a:lnTo>
                  <a:lnTo>
                    <a:pt x="345" y="134"/>
                  </a:lnTo>
                  <a:lnTo>
                    <a:pt x="347" y="134"/>
                  </a:lnTo>
                  <a:lnTo>
                    <a:pt x="349" y="134"/>
                  </a:lnTo>
                  <a:lnTo>
                    <a:pt x="352" y="135"/>
                  </a:lnTo>
                  <a:lnTo>
                    <a:pt x="353" y="135"/>
                  </a:lnTo>
                  <a:lnTo>
                    <a:pt x="356" y="135"/>
                  </a:lnTo>
                  <a:lnTo>
                    <a:pt x="358" y="135"/>
                  </a:lnTo>
                  <a:lnTo>
                    <a:pt x="361" y="135"/>
                  </a:lnTo>
                  <a:lnTo>
                    <a:pt x="363" y="135"/>
                  </a:lnTo>
                  <a:lnTo>
                    <a:pt x="365" y="135"/>
                  </a:lnTo>
                  <a:lnTo>
                    <a:pt x="368" y="135"/>
                  </a:lnTo>
                  <a:lnTo>
                    <a:pt x="370" y="135"/>
                  </a:lnTo>
                  <a:lnTo>
                    <a:pt x="373" y="135"/>
                  </a:lnTo>
                  <a:lnTo>
                    <a:pt x="375" y="135"/>
                  </a:lnTo>
                  <a:lnTo>
                    <a:pt x="378" y="135"/>
                  </a:lnTo>
                  <a:lnTo>
                    <a:pt x="379" y="135"/>
                  </a:lnTo>
                  <a:lnTo>
                    <a:pt x="382" y="135"/>
                  </a:lnTo>
                  <a:lnTo>
                    <a:pt x="384" y="135"/>
                  </a:lnTo>
                  <a:lnTo>
                    <a:pt x="386" y="136"/>
                  </a:lnTo>
                  <a:lnTo>
                    <a:pt x="389" y="136"/>
                  </a:lnTo>
                  <a:lnTo>
                    <a:pt x="391" y="136"/>
                  </a:lnTo>
                  <a:lnTo>
                    <a:pt x="394" y="136"/>
                  </a:lnTo>
                  <a:lnTo>
                    <a:pt x="396" y="136"/>
                  </a:lnTo>
                  <a:lnTo>
                    <a:pt x="399" y="136"/>
                  </a:lnTo>
                  <a:lnTo>
                    <a:pt x="401" y="135"/>
                  </a:lnTo>
                  <a:lnTo>
                    <a:pt x="403" y="135"/>
                  </a:lnTo>
                  <a:lnTo>
                    <a:pt x="405" y="135"/>
                  </a:lnTo>
                  <a:lnTo>
                    <a:pt x="407" y="135"/>
                  </a:lnTo>
                  <a:lnTo>
                    <a:pt x="410" y="135"/>
                  </a:lnTo>
                  <a:lnTo>
                    <a:pt x="412" y="135"/>
                  </a:lnTo>
                  <a:lnTo>
                    <a:pt x="415" y="135"/>
                  </a:lnTo>
                  <a:lnTo>
                    <a:pt x="417" y="136"/>
                  </a:lnTo>
                  <a:lnTo>
                    <a:pt x="420" y="136"/>
                  </a:lnTo>
                  <a:lnTo>
                    <a:pt x="422" y="136"/>
                  </a:lnTo>
                  <a:lnTo>
                    <a:pt x="424" y="136"/>
                  </a:lnTo>
                  <a:lnTo>
                    <a:pt x="427" y="136"/>
                  </a:lnTo>
                  <a:lnTo>
                    <a:pt x="429" y="137"/>
                  </a:lnTo>
                  <a:lnTo>
                    <a:pt x="431" y="137"/>
                  </a:lnTo>
                  <a:lnTo>
                    <a:pt x="433" y="137"/>
                  </a:lnTo>
                  <a:lnTo>
                    <a:pt x="436" y="137"/>
                  </a:lnTo>
                  <a:lnTo>
                    <a:pt x="438" y="137"/>
                  </a:lnTo>
                  <a:lnTo>
                    <a:pt x="440" y="137"/>
                  </a:lnTo>
                  <a:lnTo>
                    <a:pt x="443" y="137"/>
                  </a:lnTo>
                  <a:lnTo>
                    <a:pt x="445" y="137"/>
                  </a:lnTo>
                  <a:lnTo>
                    <a:pt x="448" y="138"/>
                  </a:lnTo>
                  <a:lnTo>
                    <a:pt x="450" y="138"/>
                  </a:lnTo>
                  <a:lnTo>
                    <a:pt x="453" y="138"/>
                  </a:lnTo>
                  <a:lnTo>
                    <a:pt x="455" y="138"/>
                  </a:lnTo>
                  <a:lnTo>
                    <a:pt x="457" y="138"/>
                  </a:lnTo>
                  <a:lnTo>
                    <a:pt x="459" y="138"/>
                  </a:lnTo>
                  <a:lnTo>
                    <a:pt x="461" y="138"/>
                  </a:lnTo>
                  <a:lnTo>
                    <a:pt x="464" y="138"/>
                  </a:lnTo>
                  <a:lnTo>
                    <a:pt x="466" y="138"/>
                  </a:lnTo>
                  <a:lnTo>
                    <a:pt x="469" y="138"/>
                  </a:lnTo>
                  <a:lnTo>
                    <a:pt x="471" y="138"/>
                  </a:lnTo>
                  <a:lnTo>
                    <a:pt x="474" y="138"/>
                  </a:lnTo>
                  <a:lnTo>
                    <a:pt x="476" y="138"/>
                  </a:lnTo>
                  <a:lnTo>
                    <a:pt x="478" y="138"/>
                  </a:lnTo>
                  <a:lnTo>
                    <a:pt x="481" y="139"/>
                  </a:lnTo>
                  <a:lnTo>
                    <a:pt x="482" y="139"/>
                  </a:lnTo>
                  <a:lnTo>
                    <a:pt x="485" y="139"/>
                  </a:lnTo>
                  <a:lnTo>
                    <a:pt x="487" y="139"/>
                  </a:lnTo>
                  <a:lnTo>
                    <a:pt x="490" y="139"/>
                  </a:lnTo>
                  <a:lnTo>
                    <a:pt x="492" y="139"/>
                  </a:lnTo>
                  <a:lnTo>
                    <a:pt x="495" y="139"/>
                  </a:lnTo>
                  <a:lnTo>
                    <a:pt x="497" y="139"/>
                  </a:lnTo>
                  <a:lnTo>
                    <a:pt x="499" y="139"/>
                  </a:lnTo>
                  <a:lnTo>
                    <a:pt x="502" y="139"/>
                  </a:lnTo>
                  <a:lnTo>
                    <a:pt x="504" y="139"/>
                  </a:lnTo>
                  <a:lnTo>
                    <a:pt x="506" y="139"/>
                  </a:lnTo>
                  <a:lnTo>
                    <a:pt x="508" y="139"/>
                  </a:lnTo>
                  <a:lnTo>
                    <a:pt x="511" y="139"/>
                  </a:lnTo>
                  <a:lnTo>
                    <a:pt x="513" y="139"/>
                  </a:lnTo>
                  <a:lnTo>
                    <a:pt x="515" y="139"/>
                  </a:lnTo>
                  <a:lnTo>
                    <a:pt x="518" y="139"/>
                  </a:lnTo>
                  <a:lnTo>
                    <a:pt x="520" y="140"/>
                  </a:lnTo>
                  <a:lnTo>
                    <a:pt x="523" y="140"/>
                  </a:lnTo>
                  <a:lnTo>
                    <a:pt x="525" y="140"/>
                  </a:lnTo>
                  <a:lnTo>
                    <a:pt x="528" y="140"/>
                  </a:lnTo>
                  <a:lnTo>
                    <a:pt x="530" y="140"/>
                  </a:lnTo>
                  <a:lnTo>
                    <a:pt x="532" y="140"/>
                  </a:lnTo>
                  <a:lnTo>
                    <a:pt x="534" y="140"/>
                  </a:lnTo>
                  <a:lnTo>
                    <a:pt x="536" y="140"/>
                  </a:lnTo>
                  <a:lnTo>
                    <a:pt x="539" y="140"/>
                  </a:lnTo>
                  <a:lnTo>
                    <a:pt x="541" y="140"/>
                  </a:lnTo>
                  <a:lnTo>
                    <a:pt x="544" y="140"/>
                  </a:lnTo>
                  <a:lnTo>
                    <a:pt x="546" y="140"/>
                  </a:lnTo>
                  <a:lnTo>
                    <a:pt x="549" y="140"/>
                  </a:lnTo>
                  <a:lnTo>
                    <a:pt x="551" y="140"/>
                  </a:lnTo>
                  <a:lnTo>
                    <a:pt x="553" y="140"/>
                  </a:lnTo>
                  <a:lnTo>
                    <a:pt x="556" y="140"/>
                  </a:lnTo>
                  <a:lnTo>
                    <a:pt x="558" y="140"/>
                  </a:lnTo>
                  <a:lnTo>
                    <a:pt x="560" y="140"/>
                  </a:lnTo>
                  <a:lnTo>
                    <a:pt x="562" y="140"/>
                  </a:lnTo>
                  <a:lnTo>
                    <a:pt x="565" y="140"/>
                  </a:lnTo>
                  <a:lnTo>
                    <a:pt x="567" y="140"/>
                  </a:lnTo>
                  <a:lnTo>
                    <a:pt x="570" y="140"/>
                  </a:lnTo>
                  <a:lnTo>
                    <a:pt x="572" y="141"/>
                  </a:lnTo>
                  <a:lnTo>
                    <a:pt x="574" y="141"/>
                  </a:lnTo>
                  <a:lnTo>
                    <a:pt x="577" y="141"/>
                  </a:lnTo>
                  <a:lnTo>
                    <a:pt x="579" y="141"/>
                  </a:lnTo>
                  <a:lnTo>
                    <a:pt x="582" y="141"/>
                  </a:lnTo>
                  <a:lnTo>
                    <a:pt x="583" y="141"/>
                  </a:lnTo>
                  <a:lnTo>
                    <a:pt x="586" y="141"/>
                  </a:lnTo>
                  <a:lnTo>
                    <a:pt x="588" y="141"/>
                  </a:lnTo>
                  <a:lnTo>
                    <a:pt x="590" y="141"/>
                  </a:lnTo>
                  <a:lnTo>
                    <a:pt x="593" y="142"/>
                  </a:lnTo>
                  <a:lnTo>
                    <a:pt x="595" y="142"/>
                  </a:lnTo>
                  <a:lnTo>
                    <a:pt x="598" y="142"/>
                  </a:lnTo>
                  <a:lnTo>
                    <a:pt x="600" y="142"/>
                  </a:lnTo>
                  <a:lnTo>
                    <a:pt x="603" y="142"/>
                  </a:lnTo>
                  <a:lnTo>
                    <a:pt x="605" y="142"/>
                  </a:lnTo>
                  <a:lnTo>
                    <a:pt x="607" y="142"/>
                  </a:lnTo>
                  <a:lnTo>
                    <a:pt x="609" y="142"/>
                  </a:lnTo>
                  <a:lnTo>
                    <a:pt x="611" y="142"/>
                  </a:lnTo>
                  <a:lnTo>
                    <a:pt x="614" y="142"/>
                  </a:lnTo>
                  <a:lnTo>
                    <a:pt x="616" y="142"/>
                  </a:lnTo>
                  <a:lnTo>
                    <a:pt x="619" y="142"/>
                  </a:lnTo>
                  <a:lnTo>
                    <a:pt x="621" y="142"/>
                  </a:lnTo>
                  <a:lnTo>
                    <a:pt x="624" y="142"/>
                  </a:lnTo>
                  <a:lnTo>
                    <a:pt x="626" y="142"/>
                  </a:lnTo>
                  <a:lnTo>
                    <a:pt x="628" y="142"/>
                  </a:lnTo>
                  <a:lnTo>
                    <a:pt x="631" y="143"/>
                  </a:lnTo>
                  <a:lnTo>
                    <a:pt x="633" y="143"/>
                  </a:lnTo>
                  <a:lnTo>
                    <a:pt x="635" y="143"/>
                  </a:lnTo>
                  <a:lnTo>
                    <a:pt x="637" y="143"/>
                  </a:lnTo>
                  <a:lnTo>
                    <a:pt x="640" y="143"/>
                  </a:lnTo>
                  <a:lnTo>
                    <a:pt x="642" y="143"/>
                  </a:lnTo>
                  <a:lnTo>
                    <a:pt x="644" y="143"/>
                  </a:lnTo>
                  <a:lnTo>
                    <a:pt x="647" y="143"/>
                  </a:lnTo>
                  <a:lnTo>
                    <a:pt x="649" y="143"/>
                  </a:lnTo>
                  <a:lnTo>
                    <a:pt x="652" y="143"/>
                  </a:lnTo>
                  <a:lnTo>
                    <a:pt x="654" y="143"/>
                  </a:lnTo>
                  <a:lnTo>
                    <a:pt x="657" y="143"/>
                  </a:lnTo>
                  <a:lnTo>
                    <a:pt x="659" y="143"/>
                  </a:lnTo>
                  <a:lnTo>
                    <a:pt x="661" y="143"/>
                  </a:lnTo>
                  <a:lnTo>
                    <a:pt x="663" y="143"/>
                  </a:lnTo>
                  <a:lnTo>
                    <a:pt x="665" y="143"/>
                  </a:lnTo>
                  <a:lnTo>
                    <a:pt x="668" y="143"/>
                  </a:lnTo>
                  <a:lnTo>
                    <a:pt x="670" y="143"/>
                  </a:lnTo>
                  <a:lnTo>
                    <a:pt x="673" y="143"/>
                  </a:lnTo>
                  <a:lnTo>
                    <a:pt x="675" y="143"/>
                  </a:lnTo>
                  <a:lnTo>
                    <a:pt x="678" y="143"/>
                  </a:lnTo>
                  <a:lnTo>
                    <a:pt x="680" y="143"/>
                  </a:lnTo>
                  <a:lnTo>
                    <a:pt x="682" y="143"/>
                  </a:lnTo>
                  <a:lnTo>
                    <a:pt x="685" y="143"/>
                  </a:lnTo>
                  <a:lnTo>
                    <a:pt x="686" y="143"/>
                  </a:lnTo>
                  <a:lnTo>
                    <a:pt x="689" y="143"/>
                  </a:lnTo>
                  <a:lnTo>
                    <a:pt x="691" y="143"/>
                  </a:lnTo>
                  <a:lnTo>
                    <a:pt x="694" y="143"/>
                  </a:lnTo>
                  <a:lnTo>
                    <a:pt x="696" y="144"/>
                  </a:lnTo>
                  <a:lnTo>
                    <a:pt x="699" y="144"/>
                  </a:lnTo>
                  <a:lnTo>
                    <a:pt x="701" y="144"/>
                  </a:lnTo>
                  <a:lnTo>
                    <a:pt x="703" y="144"/>
                  </a:lnTo>
                  <a:lnTo>
                    <a:pt x="706" y="144"/>
                  </a:lnTo>
                  <a:lnTo>
                    <a:pt x="708" y="144"/>
                  </a:lnTo>
                  <a:lnTo>
                    <a:pt x="711" y="144"/>
                  </a:lnTo>
                  <a:lnTo>
                    <a:pt x="712" y="144"/>
                  </a:lnTo>
                  <a:lnTo>
                    <a:pt x="715" y="144"/>
                  </a:lnTo>
                  <a:lnTo>
                    <a:pt x="717" y="144"/>
                  </a:lnTo>
                  <a:lnTo>
                    <a:pt x="719" y="144"/>
                  </a:lnTo>
                  <a:lnTo>
                    <a:pt x="722" y="144"/>
                  </a:lnTo>
                  <a:lnTo>
                    <a:pt x="724" y="144"/>
                  </a:lnTo>
                  <a:lnTo>
                    <a:pt x="727" y="144"/>
                  </a:lnTo>
                  <a:lnTo>
                    <a:pt x="729" y="144"/>
                  </a:lnTo>
                  <a:lnTo>
                    <a:pt x="732" y="144"/>
                  </a:lnTo>
                  <a:lnTo>
                    <a:pt x="734" y="144"/>
                  </a:lnTo>
                  <a:lnTo>
                    <a:pt x="736" y="144"/>
                  </a:lnTo>
                  <a:lnTo>
                    <a:pt x="738" y="144"/>
                  </a:lnTo>
                  <a:lnTo>
                    <a:pt x="740" y="144"/>
                  </a:lnTo>
                  <a:lnTo>
                    <a:pt x="743" y="144"/>
                  </a:lnTo>
                  <a:lnTo>
                    <a:pt x="745" y="144"/>
                  </a:lnTo>
                  <a:lnTo>
                    <a:pt x="748" y="144"/>
                  </a:lnTo>
                  <a:lnTo>
                    <a:pt x="750" y="144"/>
                  </a:lnTo>
                  <a:lnTo>
                    <a:pt x="753" y="144"/>
                  </a:lnTo>
                  <a:lnTo>
                    <a:pt x="755" y="144"/>
                  </a:lnTo>
                  <a:lnTo>
                    <a:pt x="757" y="144"/>
                  </a:lnTo>
                  <a:lnTo>
                    <a:pt x="760" y="144"/>
                  </a:lnTo>
                  <a:lnTo>
                    <a:pt x="762" y="144"/>
                  </a:lnTo>
                  <a:lnTo>
                    <a:pt x="764" y="144"/>
                  </a:lnTo>
                  <a:lnTo>
                    <a:pt x="766" y="144"/>
                  </a:lnTo>
                  <a:lnTo>
                    <a:pt x="769" y="144"/>
                  </a:lnTo>
                  <a:lnTo>
                    <a:pt x="771" y="144"/>
                  </a:lnTo>
                  <a:lnTo>
                    <a:pt x="774" y="144"/>
                  </a:lnTo>
                  <a:lnTo>
                    <a:pt x="776" y="144"/>
                  </a:lnTo>
                  <a:lnTo>
                    <a:pt x="778" y="144"/>
                  </a:lnTo>
                  <a:lnTo>
                    <a:pt x="781" y="144"/>
                  </a:lnTo>
                  <a:lnTo>
                    <a:pt x="783" y="144"/>
                  </a:lnTo>
                  <a:lnTo>
                    <a:pt x="786" y="144"/>
                  </a:lnTo>
                  <a:lnTo>
                    <a:pt x="787" y="144"/>
                  </a:lnTo>
                  <a:lnTo>
                    <a:pt x="790" y="144"/>
                  </a:lnTo>
                  <a:lnTo>
                    <a:pt x="792" y="144"/>
                  </a:lnTo>
                  <a:lnTo>
                    <a:pt x="794" y="144"/>
                  </a:lnTo>
                  <a:lnTo>
                    <a:pt x="797" y="144"/>
                  </a:lnTo>
                  <a:lnTo>
                    <a:pt x="799" y="144"/>
                  </a:lnTo>
                  <a:lnTo>
                    <a:pt x="802" y="144"/>
                  </a:lnTo>
                  <a:lnTo>
                    <a:pt x="804" y="144"/>
                  </a:lnTo>
                  <a:lnTo>
                    <a:pt x="807" y="144"/>
                  </a:lnTo>
                  <a:lnTo>
                    <a:pt x="809" y="144"/>
                  </a:lnTo>
                  <a:lnTo>
                    <a:pt x="812" y="144"/>
                  </a:lnTo>
                  <a:lnTo>
                    <a:pt x="813" y="144"/>
                  </a:lnTo>
                  <a:lnTo>
                    <a:pt x="815" y="144"/>
                  </a:lnTo>
                  <a:lnTo>
                    <a:pt x="818" y="144"/>
                  </a:lnTo>
                  <a:lnTo>
                    <a:pt x="820" y="144"/>
                  </a:lnTo>
                  <a:lnTo>
                    <a:pt x="823" y="144"/>
                  </a:lnTo>
                  <a:lnTo>
                    <a:pt x="825" y="144"/>
                  </a:lnTo>
                  <a:lnTo>
                    <a:pt x="828" y="144"/>
                  </a:lnTo>
                  <a:lnTo>
                    <a:pt x="830" y="143"/>
                  </a:lnTo>
                  <a:lnTo>
                    <a:pt x="832" y="143"/>
                  </a:lnTo>
                  <a:lnTo>
                    <a:pt x="835" y="143"/>
                  </a:lnTo>
                  <a:lnTo>
                    <a:pt x="837" y="143"/>
                  </a:lnTo>
                  <a:lnTo>
                    <a:pt x="839" y="143"/>
                  </a:lnTo>
                  <a:lnTo>
                    <a:pt x="841" y="143"/>
                  </a:lnTo>
                  <a:lnTo>
                    <a:pt x="844" y="144"/>
                  </a:lnTo>
                  <a:lnTo>
                    <a:pt x="846" y="144"/>
                  </a:lnTo>
                  <a:lnTo>
                    <a:pt x="849" y="144"/>
                  </a:lnTo>
                  <a:lnTo>
                    <a:pt x="851" y="144"/>
                  </a:lnTo>
                  <a:lnTo>
                    <a:pt x="853" y="144"/>
                  </a:lnTo>
                  <a:lnTo>
                    <a:pt x="856" y="144"/>
                  </a:lnTo>
                  <a:lnTo>
                    <a:pt x="858" y="144"/>
                  </a:lnTo>
                  <a:lnTo>
                    <a:pt x="861" y="144"/>
                  </a:lnTo>
                  <a:lnTo>
                    <a:pt x="863" y="144"/>
                  </a:lnTo>
                  <a:lnTo>
                    <a:pt x="865" y="144"/>
                  </a:lnTo>
                  <a:lnTo>
                    <a:pt x="867" y="144"/>
                  </a:lnTo>
                  <a:lnTo>
                    <a:pt x="869" y="144"/>
                  </a:lnTo>
                  <a:lnTo>
                    <a:pt x="872" y="144"/>
                  </a:lnTo>
                  <a:lnTo>
                    <a:pt x="874" y="144"/>
                  </a:lnTo>
                  <a:lnTo>
                    <a:pt x="877" y="144"/>
                  </a:lnTo>
                  <a:lnTo>
                    <a:pt x="879" y="144"/>
                  </a:lnTo>
                  <a:lnTo>
                    <a:pt x="882" y="144"/>
                  </a:lnTo>
                  <a:lnTo>
                    <a:pt x="884" y="143"/>
                  </a:lnTo>
                  <a:lnTo>
                    <a:pt x="887" y="143"/>
                  </a:lnTo>
                  <a:lnTo>
                    <a:pt x="889" y="143"/>
                  </a:lnTo>
                  <a:lnTo>
                    <a:pt x="890" y="143"/>
                  </a:lnTo>
                  <a:lnTo>
                    <a:pt x="893" y="143"/>
                  </a:lnTo>
                  <a:lnTo>
                    <a:pt x="895" y="143"/>
                  </a:lnTo>
                  <a:lnTo>
                    <a:pt x="898" y="143"/>
                  </a:lnTo>
                  <a:lnTo>
                    <a:pt x="900" y="142"/>
                  </a:lnTo>
                  <a:lnTo>
                    <a:pt x="903" y="142"/>
                  </a:lnTo>
                  <a:lnTo>
                    <a:pt x="905" y="142"/>
                  </a:lnTo>
                  <a:lnTo>
                    <a:pt x="907" y="141"/>
                  </a:lnTo>
                  <a:lnTo>
                    <a:pt x="910" y="140"/>
                  </a:lnTo>
                  <a:lnTo>
                    <a:pt x="912" y="140"/>
                  </a:lnTo>
                  <a:lnTo>
                    <a:pt x="915" y="139"/>
                  </a:lnTo>
                  <a:lnTo>
                    <a:pt x="916" y="139"/>
                  </a:lnTo>
                  <a:lnTo>
                    <a:pt x="919" y="139"/>
                  </a:lnTo>
                  <a:lnTo>
                    <a:pt x="921" y="140"/>
                  </a:lnTo>
                  <a:lnTo>
                    <a:pt x="924" y="140"/>
                  </a:lnTo>
                  <a:lnTo>
                    <a:pt x="926" y="140"/>
                  </a:lnTo>
                  <a:lnTo>
                    <a:pt x="928" y="141"/>
                  </a:lnTo>
                  <a:lnTo>
                    <a:pt x="931" y="141"/>
                  </a:lnTo>
                  <a:lnTo>
                    <a:pt x="933" y="141"/>
                  </a:lnTo>
                  <a:lnTo>
                    <a:pt x="936" y="141"/>
                  </a:lnTo>
                  <a:lnTo>
                    <a:pt x="938" y="141"/>
                  </a:lnTo>
                  <a:lnTo>
                    <a:pt x="940" y="142"/>
                  </a:lnTo>
                  <a:lnTo>
                    <a:pt x="942" y="142"/>
                  </a:lnTo>
                  <a:lnTo>
                    <a:pt x="944" y="142"/>
                  </a:lnTo>
                  <a:lnTo>
                    <a:pt x="947" y="142"/>
                  </a:lnTo>
                  <a:lnTo>
                    <a:pt x="949" y="142"/>
                  </a:lnTo>
                  <a:lnTo>
                    <a:pt x="952" y="142"/>
                  </a:lnTo>
                  <a:lnTo>
                    <a:pt x="954" y="142"/>
                  </a:lnTo>
                  <a:lnTo>
                    <a:pt x="957" y="142"/>
                  </a:lnTo>
                  <a:lnTo>
                    <a:pt x="959" y="142"/>
                  </a:lnTo>
                  <a:lnTo>
                    <a:pt x="962" y="141"/>
                  </a:lnTo>
                  <a:lnTo>
                    <a:pt x="964" y="141"/>
                  </a:lnTo>
                  <a:lnTo>
                    <a:pt x="966" y="140"/>
                  </a:lnTo>
                  <a:lnTo>
                    <a:pt x="968" y="138"/>
                  </a:lnTo>
                  <a:lnTo>
                    <a:pt x="970" y="137"/>
                  </a:lnTo>
                  <a:lnTo>
                    <a:pt x="973" y="136"/>
                  </a:lnTo>
                  <a:lnTo>
                    <a:pt x="975" y="134"/>
                  </a:lnTo>
                  <a:lnTo>
                    <a:pt x="978" y="134"/>
                  </a:lnTo>
                  <a:lnTo>
                    <a:pt x="980" y="133"/>
                  </a:lnTo>
                  <a:lnTo>
                    <a:pt x="982" y="133"/>
                  </a:lnTo>
                  <a:lnTo>
                    <a:pt x="985" y="131"/>
                  </a:lnTo>
                  <a:lnTo>
                    <a:pt x="987" y="128"/>
                  </a:lnTo>
                  <a:lnTo>
                    <a:pt x="990" y="121"/>
                  </a:lnTo>
                  <a:lnTo>
                    <a:pt x="992" y="109"/>
                  </a:lnTo>
                  <a:lnTo>
                    <a:pt x="994" y="91"/>
                  </a:lnTo>
                  <a:lnTo>
                    <a:pt x="996" y="67"/>
                  </a:lnTo>
                  <a:lnTo>
                    <a:pt x="999" y="41"/>
                  </a:lnTo>
                  <a:lnTo>
                    <a:pt x="1001" y="16"/>
                  </a:lnTo>
                  <a:lnTo>
                    <a:pt x="1003" y="2"/>
                  </a:lnTo>
                  <a:lnTo>
                    <a:pt x="1006" y="0"/>
                  </a:lnTo>
                  <a:lnTo>
                    <a:pt x="1008" y="8"/>
                  </a:lnTo>
                  <a:lnTo>
                    <a:pt x="1011" y="23"/>
                  </a:lnTo>
                  <a:lnTo>
                    <a:pt x="1013" y="38"/>
                  </a:lnTo>
                  <a:lnTo>
                    <a:pt x="1016" y="50"/>
                  </a:lnTo>
                  <a:lnTo>
                    <a:pt x="1017" y="58"/>
                  </a:lnTo>
                  <a:lnTo>
                    <a:pt x="1019" y="64"/>
                  </a:lnTo>
                  <a:lnTo>
                    <a:pt x="1022" y="68"/>
                  </a:lnTo>
                  <a:lnTo>
                    <a:pt x="1024" y="73"/>
                  </a:lnTo>
                  <a:lnTo>
                    <a:pt x="1027" y="79"/>
                  </a:lnTo>
                  <a:lnTo>
                    <a:pt x="1029" y="86"/>
                  </a:lnTo>
                  <a:lnTo>
                    <a:pt x="1032" y="92"/>
                  </a:lnTo>
                  <a:lnTo>
                    <a:pt x="1034" y="99"/>
                  </a:lnTo>
                  <a:lnTo>
                    <a:pt x="1037" y="104"/>
                  </a:lnTo>
                  <a:lnTo>
                    <a:pt x="1039" y="109"/>
                  </a:lnTo>
                  <a:lnTo>
                    <a:pt x="1041" y="113"/>
                  </a:lnTo>
                  <a:lnTo>
                    <a:pt x="1043" y="115"/>
                  </a:lnTo>
                  <a:lnTo>
                    <a:pt x="1045" y="116"/>
                  </a:lnTo>
                  <a:lnTo>
                    <a:pt x="1048" y="117"/>
                  </a:lnTo>
                  <a:lnTo>
                    <a:pt x="1050" y="119"/>
                  </a:lnTo>
                  <a:lnTo>
                    <a:pt x="1053" y="121"/>
                  </a:lnTo>
                  <a:lnTo>
                    <a:pt x="1055" y="123"/>
                  </a:lnTo>
                  <a:lnTo>
                    <a:pt x="1057" y="126"/>
                  </a:lnTo>
                  <a:lnTo>
                    <a:pt x="1060" y="128"/>
                  </a:lnTo>
                  <a:lnTo>
                    <a:pt x="1062" y="130"/>
                  </a:lnTo>
                  <a:lnTo>
                    <a:pt x="1065" y="131"/>
                  </a:lnTo>
                  <a:lnTo>
                    <a:pt x="1067" y="131"/>
                  </a:lnTo>
                  <a:lnTo>
                    <a:pt x="1069" y="132"/>
                  </a:lnTo>
                  <a:lnTo>
                    <a:pt x="1071" y="133"/>
                  </a:lnTo>
                  <a:lnTo>
                    <a:pt x="1074" y="134"/>
                  </a:lnTo>
                  <a:lnTo>
                    <a:pt x="1076" y="135"/>
                  </a:lnTo>
                  <a:lnTo>
                    <a:pt x="1078" y="136"/>
                  </a:lnTo>
                  <a:lnTo>
                    <a:pt x="1081" y="136"/>
                  </a:lnTo>
                  <a:lnTo>
                    <a:pt x="1083" y="137"/>
                  </a:lnTo>
                  <a:lnTo>
                    <a:pt x="1086" y="138"/>
                  </a:lnTo>
                  <a:lnTo>
                    <a:pt x="1088" y="139"/>
                  </a:lnTo>
                  <a:lnTo>
                    <a:pt x="1091" y="139"/>
                  </a:lnTo>
                  <a:lnTo>
                    <a:pt x="1093" y="140"/>
                  </a:lnTo>
                  <a:lnTo>
                    <a:pt x="1094" y="140"/>
                  </a:lnTo>
                  <a:lnTo>
                    <a:pt x="1097" y="141"/>
                  </a:lnTo>
                  <a:lnTo>
                    <a:pt x="1099" y="141"/>
                  </a:lnTo>
                  <a:lnTo>
                    <a:pt x="1102" y="141"/>
                  </a:lnTo>
                  <a:lnTo>
                    <a:pt x="1104" y="142"/>
                  </a:lnTo>
                  <a:lnTo>
                    <a:pt x="1107" y="142"/>
                  </a:lnTo>
                  <a:lnTo>
                    <a:pt x="1109" y="142"/>
                  </a:lnTo>
                  <a:lnTo>
                    <a:pt x="1112" y="142"/>
                  </a:lnTo>
                  <a:lnTo>
                    <a:pt x="1114" y="142"/>
                  </a:lnTo>
                  <a:lnTo>
                    <a:pt x="1116" y="142"/>
                  </a:lnTo>
                  <a:lnTo>
                    <a:pt x="1119" y="142"/>
                  </a:lnTo>
                  <a:lnTo>
                    <a:pt x="1120" y="143"/>
                  </a:lnTo>
                  <a:lnTo>
                    <a:pt x="1123" y="143"/>
                  </a:lnTo>
                  <a:lnTo>
                    <a:pt x="1125" y="143"/>
                  </a:lnTo>
                  <a:lnTo>
                    <a:pt x="1128" y="143"/>
                  </a:lnTo>
                  <a:lnTo>
                    <a:pt x="1130" y="143"/>
                  </a:lnTo>
                  <a:lnTo>
                    <a:pt x="1132" y="143"/>
                  </a:lnTo>
                  <a:lnTo>
                    <a:pt x="1135" y="143"/>
                  </a:lnTo>
                  <a:lnTo>
                    <a:pt x="1137" y="143"/>
                  </a:lnTo>
                  <a:lnTo>
                    <a:pt x="1140" y="143"/>
                  </a:lnTo>
                  <a:lnTo>
                    <a:pt x="1142" y="143"/>
                  </a:lnTo>
                  <a:lnTo>
                    <a:pt x="1145" y="143"/>
                  </a:lnTo>
                  <a:lnTo>
                    <a:pt x="1146" y="143"/>
                  </a:lnTo>
                  <a:lnTo>
                    <a:pt x="1149" y="143"/>
                  </a:lnTo>
                  <a:lnTo>
                    <a:pt x="1151" y="143"/>
                  </a:lnTo>
                  <a:lnTo>
                    <a:pt x="1153" y="143"/>
                  </a:lnTo>
                  <a:lnTo>
                    <a:pt x="1156" y="143"/>
                  </a:lnTo>
                  <a:lnTo>
                    <a:pt x="1158" y="143"/>
                  </a:lnTo>
                  <a:lnTo>
                    <a:pt x="1161" y="143"/>
                  </a:lnTo>
                  <a:lnTo>
                    <a:pt x="1163" y="143"/>
                  </a:lnTo>
                  <a:lnTo>
                    <a:pt x="1166" y="143"/>
                  </a:lnTo>
                  <a:lnTo>
                    <a:pt x="1168" y="143"/>
                  </a:lnTo>
                  <a:lnTo>
                    <a:pt x="1170" y="143"/>
                  </a:lnTo>
                  <a:lnTo>
                    <a:pt x="1172" y="143"/>
                  </a:lnTo>
                  <a:lnTo>
                    <a:pt x="1174" y="143"/>
                  </a:lnTo>
                  <a:lnTo>
                    <a:pt x="1177" y="143"/>
                  </a:lnTo>
                  <a:lnTo>
                    <a:pt x="1179" y="143"/>
                  </a:lnTo>
                  <a:lnTo>
                    <a:pt x="1182" y="143"/>
                  </a:lnTo>
                  <a:lnTo>
                    <a:pt x="1184" y="143"/>
                  </a:lnTo>
                  <a:lnTo>
                    <a:pt x="1187" y="143"/>
                  </a:lnTo>
                  <a:lnTo>
                    <a:pt x="1189" y="143"/>
                  </a:lnTo>
                  <a:lnTo>
                    <a:pt x="1191" y="143"/>
                  </a:lnTo>
                  <a:lnTo>
                    <a:pt x="1194" y="143"/>
                  </a:lnTo>
                  <a:lnTo>
                    <a:pt x="1196" y="143"/>
                  </a:lnTo>
                  <a:lnTo>
                    <a:pt x="1198" y="143"/>
                  </a:lnTo>
                  <a:lnTo>
                    <a:pt x="1200" y="143"/>
                  </a:lnTo>
                  <a:lnTo>
                    <a:pt x="1203" y="143"/>
                  </a:lnTo>
                  <a:lnTo>
                    <a:pt x="1205" y="143"/>
                  </a:lnTo>
                  <a:lnTo>
                    <a:pt x="1207" y="143"/>
                  </a:lnTo>
                  <a:lnTo>
                    <a:pt x="1210" y="143"/>
                  </a:lnTo>
                  <a:lnTo>
                    <a:pt x="1212" y="143"/>
                  </a:lnTo>
                  <a:lnTo>
                    <a:pt x="1215" y="143"/>
                  </a:lnTo>
                  <a:lnTo>
                    <a:pt x="1217" y="143"/>
                  </a:lnTo>
                  <a:lnTo>
                    <a:pt x="1220" y="143"/>
                  </a:lnTo>
                  <a:lnTo>
                    <a:pt x="1221" y="143"/>
                  </a:lnTo>
                  <a:lnTo>
                    <a:pt x="1224" y="143"/>
                  </a:lnTo>
                  <a:lnTo>
                    <a:pt x="1226" y="142"/>
                  </a:lnTo>
                  <a:lnTo>
                    <a:pt x="1228" y="142"/>
                  </a:lnTo>
                  <a:lnTo>
                    <a:pt x="1231" y="142"/>
                  </a:lnTo>
                  <a:lnTo>
                    <a:pt x="1233" y="142"/>
                  </a:lnTo>
                  <a:lnTo>
                    <a:pt x="1236" y="142"/>
                  </a:lnTo>
                  <a:lnTo>
                    <a:pt x="1238" y="142"/>
                  </a:lnTo>
                  <a:lnTo>
                    <a:pt x="1241" y="142"/>
                  </a:lnTo>
                  <a:lnTo>
                    <a:pt x="1243" y="142"/>
                  </a:lnTo>
                  <a:lnTo>
                    <a:pt x="1245" y="142"/>
                  </a:lnTo>
                  <a:lnTo>
                    <a:pt x="1247" y="142"/>
                  </a:lnTo>
                  <a:lnTo>
                    <a:pt x="1249" y="142"/>
                  </a:lnTo>
                  <a:lnTo>
                    <a:pt x="1252" y="142"/>
                  </a:lnTo>
                  <a:lnTo>
                    <a:pt x="1254" y="142"/>
                  </a:lnTo>
                  <a:lnTo>
                    <a:pt x="1257" y="142"/>
                  </a:lnTo>
                  <a:lnTo>
                    <a:pt x="1259" y="142"/>
                  </a:lnTo>
                  <a:lnTo>
                    <a:pt x="1261" y="142"/>
                  </a:lnTo>
                  <a:lnTo>
                    <a:pt x="1264" y="142"/>
                  </a:lnTo>
                  <a:lnTo>
                    <a:pt x="1266" y="142"/>
                  </a:lnTo>
                  <a:lnTo>
                    <a:pt x="1269" y="142"/>
                  </a:lnTo>
                  <a:lnTo>
                    <a:pt x="1271" y="142"/>
                  </a:lnTo>
                  <a:lnTo>
                    <a:pt x="1273" y="142"/>
                  </a:lnTo>
                  <a:lnTo>
                    <a:pt x="1275" y="142"/>
                  </a:lnTo>
                  <a:lnTo>
                    <a:pt x="1278" y="142"/>
                  </a:lnTo>
                  <a:lnTo>
                    <a:pt x="1280" y="142"/>
                  </a:lnTo>
                  <a:lnTo>
                    <a:pt x="1282" y="142"/>
                  </a:lnTo>
                  <a:lnTo>
                    <a:pt x="1285" y="142"/>
                  </a:lnTo>
                  <a:lnTo>
                    <a:pt x="1287" y="142"/>
                  </a:lnTo>
                  <a:lnTo>
                    <a:pt x="1290" y="142"/>
                  </a:lnTo>
                  <a:lnTo>
                    <a:pt x="1292" y="142"/>
                  </a:lnTo>
                  <a:lnTo>
                    <a:pt x="1295" y="142"/>
                  </a:lnTo>
                  <a:lnTo>
                    <a:pt x="1297" y="142"/>
                  </a:lnTo>
                  <a:lnTo>
                    <a:pt x="1298" y="142"/>
                  </a:lnTo>
                  <a:lnTo>
                    <a:pt x="1301" y="142"/>
                  </a:lnTo>
                  <a:lnTo>
                    <a:pt x="1303" y="142"/>
                  </a:lnTo>
                  <a:lnTo>
                    <a:pt x="1306" y="142"/>
                  </a:lnTo>
                  <a:lnTo>
                    <a:pt x="1308" y="142"/>
                  </a:lnTo>
                  <a:lnTo>
                    <a:pt x="1311" y="142"/>
                  </a:lnTo>
                  <a:lnTo>
                    <a:pt x="1313" y="142"/>
                  </a:lnTo>
                  <a:lnTo>
                    <a:pt x="1316" y="142"/>
                  </a:lnTo>
                  <a:lnTo>
                    <a:pt x="1318" y="142"/>
                  </a:lnTo>
                  <a:lnTo>
                    <a:pt x="1320" y="142"/>
                  </a:lnTo>
                  <a:lnTo>
                    <a:pt x="1323" y="142"/>
                  </a:lnTo>
                  <a:lnTo>
                    <a:pt x="1324" y="142"/>
                  </a:lnTo>
                  <a:lnTo>
                    <a:pt x="1327" y="142"/>
                  </a:lnTo>
                  <a:lnTo>
                    <a:pt x="1329" y="142"/>
                  </a:lnTo>
                  <a:lnTo>
                    <a:pt x="1332" y="142"/>
                  </a:lnTo>
                  <a:lnTo>
                    <a:pt x="1334" y="142"/>
                  </a:lnTo>
                  <a:lnTo>
                    <a:pt x="1336" y="142"/>
                  </a:lnTo>
                  <a:lnTo>
                    <a:pt x="1339" y="142"/>
                  </a:lnTo>
                  <a:lnTo>
                    <a:pt x="1341" y="142"/>
                  </a:lnTo>
                  <a:lnTo>
                    <a:pt x="1344" y="142"/>
                  </a:lnTo>
                  <a:lnTo>
                    <a:pt x="1346" y="142"/>
                  </a:lnTo>
                  <a:lnTo>
                    <a:pt x="1349" y="142"/>
                  </a:lnTo>
                  <a:lnTo>
                    <a:pt x="1350" y="141"/>
                  </a:lnTo>
                  <a:lnTo>
                    <a:pt x="1353" y="141"/>
                  </a:lnTo>
                  <a:lnTo>
                    <a:pt x="1355" y="141"/>
                  </a:lnTo>
                  <a:lnTo>
                    <a:pt x="1357" y="141"/>
                  </a:lnTo>
                  <a:lnTo>
                    <a:pt x="1360" y="141"/>
                  </a:lnTo>
                  <a:lnTo>
                    <a:pt x="1362" y="141"/>
                  </a:lnTo>
                  <a:lnTo>
                    <a:pt x="1365" y="141"/>
                  </a:lnTo>
                  <a:lnTo>
                    <a:pt x="1367" y="141"/>
                  </a:lnTo>
                  <a:lnTo>
                    <a:pt x="1370" y="141"/>
                  </a:lnTo>
                  <a:lnTo>
                    <a:pt x="1372" y="141"/>
                  </a:lnTo>
                  <a:lnTo>
                    <a:pt x="1374" y="141"/>
                  </a:lnTo>
                  <a:lnTo>
                    <a:pt x="1376" y="141"/>
                  </a:lnTo>
                  <a:lnTo>
                    <a:pt x="1378" y="141"/>
                  </a:lnTo>
                  <a:lnTo>
                    <a:pt x="1381" y="141"/>
                  </a:lnTo>
                  <a:lnTo>
                    <a:pt x="1383" y="141"/>
                  </a:lnTo>
                  <a:lnTo>
                    <a:pt x="1386" y="141"/>
                  </a:lnTo>
                  <a:lnTo>
                    <a:pt x="1388" y="141"/>
                  </a:lnTo>
                  <a:lnTo>
                    <a:pt x="1391" y="141"/>
                  </a:lnTo>
                  <a:lnTo>
                    <a:pt x="1393" y="141"/>
                  </a:lnTo>
                  <a:lnTo>
                    <a:pt x="1395" y="140"/>
                  </a:lnTo>
                  <a:lnTo>
                    <a:pt x="1398" y="140"/>
                  </a:lnTo>
                  <a:lnTo>
                    <a:pt x="1400" y="140"/>
                  </a:lnTo>
                  <a:lnTo>
                    <a:pt x="1402" y="140"/>
                  </a:lnTo>
                  <a:lnTo>
                    <a:pt x="1404" y="140"/>
                  </a:lnTo>
                  <a:lnTo>
                    <a:pt x="1407" y="140"/>
                  </a:lnTo>
                  <a:lnTo>
                    <a:pt x="1409" y="140"/>
                  </a:lnTo>
                  <a:lnTo>
                    <a:pt x="1411" y="140"/>
                  </a:lnTo>
                  <a:lnTo>
                    <a:pt x="1414" y="140"/>
                  </a:lnTo>
                  <a:lnTo>
                    <a:pt x="1416" y="140"/>
                  </a:lnTo>
                  <a:lnTo>
                    <a:pt x="1419" y="140"/>
                  </a:lnTo>
                  <a:lnTo>
                    <a:pt x="1421" y="140"/>
                  </a:lnTo>
                  <a:lnTo>
                    <a:pt x="1424" y="140"/>
                  </a:lnTo>
                  <a:lnTo>
                    <a:pt x="1426" y="139"/>
                  </a:lnTo>
                  <a:lnTo>
                    <a:pt x="1428" y="139"/>
                  </a:lnTo>
                  <a:lnTo>
                    <a:pt x="1430" y="139"/>
                  </a:lnTo>
                  <a:lnTo>
                    <a:pt x="1432" y="139"/>
                  </a:lnTo>
                  <a:lnTo>
                    <a:pt x="1435" y="139"/>
                  </a:lnTo>
                  <a:lnTo>
                    <a:pt x="1437" y="139"/>
                  </a:lnTo>
                  <a:lnTo>
                    <a:pt x="1440" y="139"/>
                  </a:lnTo>
                  <a:lnTo>
                    <a:pt x="1442" y="139"/>
                  </a:lnTo>
                  <a:lnTo>
                    <a:pt x="1445" y="139"/>
                  </a:lnTo>
                  <a:lnTo>
                    <a:pt x="1447" y="139"/>
                  </a:lnTo>
                  <a:lnTo>
                    <a:pt x="1449" y="139"/>
                  </a:lnTo>
                  <a:lnTo>
                    <a:pt x="1451" y="139"/>
                  </a:lnTo>
                  <a:lnTo>
                    <a:pt x="1453" y="139"/>
                  </a:lnTo>
                  <a:lnTo>
                    <a:pt x="1456" y="139"/>
                  </a:lnTo>
                  <a:lnTo>
                    <a:pt x="1458" y="139"/>
                  </a:lnTo>
                  <a:lnTo>
                    <a:pt x="1461" y="139"/>
                  </a:lnTo>
                  <a:lnTo>
                    <a:pt x="1463" y="139"/>
                  </a:lnTo>
                  <a:lnTo>
                    <a:pt x="1466" y="139"/>
                  </a:lnTo>
                  <a:lnTo>
                    <a:pt x="1468" y="139"/>
                  </a:lnTo>
                  <a:lnTo>
                    <a:pt x="1470" y="139"/>
                  </a:lnTo>
                  <a:lnTo>
                    <a:pt x="1473" y="139"/>
                  </a:lnTo>
                  <a:lnTo>
                    <a:pt x="1475" y="139"/>
                  </a:lnTo>
                  <a:lnTo>
                    <a:pt x="1477" y="139"/>
                  </a:lnTo>
                  <a:lnTo>
                    <a:pt x="1479" y="138"/>
                  </a:lnTo>
                  <a:lnTo>
                    <a:pt x="1482" y="138"/>
                  </a:lnTo>
                  <a:lnTo>
                    <a:pt x="1484" y="138"/>
                  </a:lnTo>
                  <a:lnTo>
                    <a:pt x="1486" y="138"/>
                  </a:lnTo>
                  <a:lnTo>
                    <a:pt x="1489" y="138"/>
                  </a:lnTo>
                  <a:lnTo>
                    <a:pt x="1491" y="138"/>
                  </a:lnTo>
                  <a:lnTo>
                    <a:pt x="1494" y="138"/>
                  </a:lnTo>
                  <a:lnTo>
                    <a:pt x="1496" y="138"/>
                  </a:lnTo>
                  <a:lnTo>
                    <a:pt x="1499" y="138"/>
                  </a:lnTo>
                  <a:lnTo>
                    <a:pt x="1501" y="138"/>
                  </a:lnTo>
                  <a:lnTo>
                    <a:pt x="1503" y="138"/>
                  </a:lnTo>
                  <a:lnTo>
                    <a:pt x="1505" y="138"/>
                  </a:lnTo>
                  <a:lnTo>
                    <a:pt x="1507" y="137"/>
                  </a:lnTo>
                  <a:lnTo>
                    <a:pt x="1510" y="137"/>
                  </a:lnTo>
                  <a:lnTo>
                    <a:pt x="1512" y="137"/>
                  </a:lnTo>
                  <a:lnTo>
                    <a:pt x="1515" y="137"/>
                  </a:lnTo>
                  <a:lnTo>
                    <a:pt x="1517" y="137"/>
                  </a:lnTo>
                  <a:lnTo>
                    <a:pt x="1520" y="137"/>
                  </a:lnTo>
                  <a:lnTo>
                    <a:pt x="1522" y="136"/>
                  </a:lnTo>
                  <a:lnTo>
                    <a:pt x="1524" y="136"/>
                  </a:lnTo>
                  <a:lnTo>
                    <a:pt x="1527" y="135"/>
                  </a:lnTo>
                  <a:lnTo>
                    <a:pt x="1528" y="134"/>
                  </a:lnTo>
                  <a:lnTo>
                    <a:pt x="1531" y="133"/>
                  </a:lnTo>
                  <a:lnTo>
                    <a:pt x="1533" y="131"/>
                  </a:lnTo>
                  <a:lnTo>
                    <a:pt x="1536" y="130"/>
                  </a:lnTo>
                  <a:lnTo>
                    <a:pt x="1538" y="128"/>
                  </a:lnTo>
                  <a:lnTo>
                    <a:pt x="1541" y="126"/>
                  </a:lnTo>
                  <a:lnTo>
                    <a:pt x="1543" y="124"/>
                  </a:lnTo>
                  <a:lnTo>
                    <a:pt x="1545" y="123"/>
                  </a:lnTo>
                  <a:lnTo>
                    <a:pt x="1548" y="122"/>
                  </a:lnTo>
                  <a:lnTo>
                    <a:pt x="1550" y="122"/>
                  </a:lnTo>
                  <a:lnTo>
                    <a:pt x="1553" y="123"/>
                  </a:lnTo>
                  <a:lnTo>
                    <a:pt x="1554" y="124"/>
                  </a:lnTo>
                  <a:lnTo>
                    <a:pt x="1557" y="124"/>
                  </a:lnTo>
                  <a:lnTo>
                    <a:pt x="1559" y="125"/>
                  </a:lnTo>
                  <a:lnTo>
                    <a:pt x="1561" y="126"/>
                  </a:lnTo>
                  <a:lnTo>
                    <a:pt x="1564" y="127"/>
                  </a:lnTo>
                  <a:lnTo>
                    <a:pt x="1566" y="127"/>
                  </a:lnTo>
                  <a:lnTo>
                    <a:pt x="1569" y="128"/>
                  </a:lnTo>
                  <a:lnTo>
                    <a:pt x="1571" y="128"/>
                  </a:lnTo>
                  <a:lnTo>
                    <a:pt x="1574" y="128"/>
                  </a:lnTo>
                  <a:lnTo>
                    <a:pt x="1576" y="129"/>
                  </a:lnTo>
                  <a:lnTo>
                    <a:pt x="1579" y="129"/>
                  </a:lnTo>
                  <a:lnTo>
                    <a:pt x="1580" y="129"/>
                  </a:lnTo>
                  <a:lnTo>
                    <a:pt x="1582" y="130"/>
                  </a:lnTo>
                  <a:lnTo>
                    <a:pt x="1585" y="130"/>
                  </a:lnTo>
                  <a:lnTo>
                    <a:pt x="1587" y="130"/>
                  </a:lnTo>
                  <a:lnTo>
                    <a:pt x="1590" y="130"/>
                  </a:lnTo>
                  <a:lnTo>
                    <a:pt x="1592" y="130"/>
                  </a:lnTo>
                  <a:lnTo>
                    <a:pt x="1595" y="130"/>
                  </a:lnTo>
                  <a:lnTo>
                    <a:pt x="1597" y="131"/>
                  </a:lnTo>
                  <a:lnTo>
                    <a:pt x="1599" y="131"/>
                  </a:lnTo>
                  <a:lnTo>
                    <a:pt x="1602" y="131"/>
                  </a:lnTo>
                  <a:lnTo>
                    <a:pt x="1604" y="131"/>
                  </a:lnTo>
                  <a:lnTo>
                    <a:pt x="1606" y="132"/>
                  </a:lnTo>
                  <a:lnTo>
                    <a:pt x="1608" y="132"/>
                  </a:lnTo>
                  <a:lnTo>
                    <a:pt x="1611" y="132"/>
                  </a:lnTo>
                  <a:lnTo>
                    <a:pt x="1613" y="132"/>
                  </a:lnTo>
                  <a:lnTo>
                    <a:pt x="1616" y="132"/>
                  </a:lnTo>
                  <a:lnTo>
                    <a:pt x="1618" y="132"/>
                  </a:lnTo>
                  <a:lnTo>
                    <a:pt x="1620" y="132"/>
                  </a:lnTo>
                  <a:lnTo>
                    <a:pt x="1623" y="132"/>
                  </a:lnTo>
                  <a:lnTo>
                    <a:pt x="1625" y="132"/>
                  </a:lnTo>
                  <a:lnTo>
                    <a:pt x="1628" y="132"/>
                  </a:lnTo>
                  <a:lnTo>
                    <a:pt x="1630" y="132"/>
                  </a:lnTo>
                  <a:lnTo>
                    <a:pt x="1632" y="132"/>
                  </a:lnTo>
                  <a:lnTo>
                    <a:pt x="1634" y="132"/>
                  </a:lnTo>
                  <a:lnTo>
                    <a:pt x="1636" y="132"/>
                  </a:lnTo>
                  <a:lnTo>
                    <a:pt x="1639" y="133"/>
                  </a:lnTo>
                  <a:lnTo>
                    <a:pt x="1641" y="133"/>
                  </a:lnTo>
                  <a:lnTo>
                    <a:pt x="1644" y="133"/>
                  </a:lnTo>
                  <a:lnTo>
                    <a:pt x="1646" y="133"/>
                  </a:lnTo>
                  <a:lnTo>
                    <a:pt x="1649" y="133"/>
                  </a:lnTo>
                  <a:lnTo>
                    <a:pt x="1651" y="133"/>
                  </a:lnTo>
                  <a:lnTo>
                    <a:pt x="1654" y="133"/>
                  </a:lnTo>
                  <a:lnTo>
                    <a:pt x="1655" y="133"/>
                  </a:lnTo>
                  <a:lnTo>
                    <a:pt x="1657" y="133"/>
                  </a:lnTo>
                  <a:lnTo>
                    <a:pt x="1660" y="133"/>
                  </a:lnTo>
                  <a:lnTo>
                    <a:pt x="1662" y="133"/>
                  </a:lnTo>
                  <a:lnTo>
                    <a:pt x="1665" y="133"/>
                  </a:lnTo>
                  <a:lnTo>
                    <a:pt x="1667" y="133"/>
                  </a:lnTo>
                  <a:lnTo>
                    <a:pt x="1670" y="133"/>
                  </a:lnTo>
                  <a:lnTo>
                    <a:pt x="1672" y="132"/>
                  </a:lnTo>
                  <a:lnTo>
                    <a:pt x="1674" y="132"/>
                  </a:lnTo>
                  <a:lnTo>
                    <a:pt x="1677" y="132"/>
                  </a:lnTo>
                  <a:lnTo>
                    <a:pt x="1679" y="132"/>
                  </a:lnTo>
                  <a:lnTo>
                    <a:pt x="1681" y="132"/>
                  </a:lnTo>
                  <a:lnTo>
                    <a:pt x="1683" y="132"/>
                  </a:lnTo>
                  <a:lnTo>
                    <a:pt x="1686" y="132"/>
                  </a:lnTo>
                  <a:lnTo>
                    <a:pt x="1688" y="132"/>
                  </a:lnTo>
                  <a:lnTo>
                    <a:pt x="1691" y="132"/>
                  </a:lnTo>
                  <a:lnTo>
                    <a:pt x="1693" y="132"/>
                  </a:lnTo>
                  <a:lnTo>
                    <a:pt x="1695" y="132"/>
                  </a:lnTo>
                  <a:lnTo>
                    <a:pt x="1698" y="132"/>
                  </a:lnTo>
                  <a:lnTo>
                    <a:pt x="1700" y="132"/>
                  </a:lnTo>
                  <a:lnTo>
                    <a:pt x="1703" y="132"/>
                  </a:lnTo>
                  <a:lnTo>
                    <a:pt x="1705" y="132"/>
                  </a:lnTo>
                  <a:lnTo>
                    <a:pt x="1707" y="132"/>
                  </a:lnTo>
                  <a:lnTo>
                    <a:pt x="1709" y="132"/>
                  </a:lnTo>
                  <a:lnTo>
                    <a:pt x="1711" y="132"/>
                  </a:lnTo>
                  <a:lnTo>
                    <a:pt x="1714" y="132"/>
                  </a:lnTo>
                  <a:lnTo>
                    <a:pt x="1716" y="132"/>
                  </a:lnTo>
                  <a:lnTo>
                    <a:pt x="1719" y="132"/>
                  </a:lnTo>
                  <a:lnTo>
                    <a:pt x="1721" y="132"/>
                  </a:lnTo>
                  <a:lnTo>
                    <a:pt x="1724" y="132"/>
                  </a:lnTo>
                  <a:lnTo>
                    <a:pt x="1726" y="132"/>
                  </a:lnTo>
                  <a:lnTo>
                    <a:pt x="1729" y="132"/>
                  </a:lnTo>
                  <a:lnTo>
                    <a:pt x="1731" y="132"/>
                  </a:lnTo>
                  <a:lnTo>
                    <a:pt x="1732" y="132"/>
                  </a:lnTo>
                  <a:lnTo>
                    <a:pt x="1735" y="132"/>
                  </a:lnTo>
                  <a:lnTo>
                    <a:pt x="1737" y="132"/>
                  </a:lnTo>
                  <a:lnTo>
                    <a:pt x="1740" y="132"/>
                  </a:lnTo>
                  <a:lnTo>
                    <a:pt x="1742" y="131"/>
                  </a:lnTo>
                  <a:lnTo>
                    <a:pt x="1745" y="131"/>
                  </a:lnTo>
                  <a:lnTo>
                    <a:pt x="1747" y="131"/>
                  </a:lnTo>
                  <a:lnTo>
                    <a:pt x="1749" y="131"/>
                  </a:lnTo>
                  <a:lnTo>
                    <a:pt x="1752" y="131"/>
                  </a:lnTo>
                  <a:lnTo>
                    <a:pt x="1754" y="131"/>
                  </a:lnTo>
                  <a:lnTo>
                    <a:pt x="1757" y="131"/>
                  </a:lnTo>
                  <a:lnTo>
                    <a:pt x="1758" y="131"/>
                  </a:lnTo>
                  <a:lnTo>
                    <a:pt x="1761" y="131"/>
                  </a:lnTo>
                  <a:lnTo>
                    <a:pt x="1763" y="131"/>
                  </a:lnTo>
                  <a:lnTo>
                    <a:pt x="1766" y="131"/>
                  </a:lnTo>
                  <a:lnTo>
                    <a:pt x="1768" y="131"/>
                  </a:lnTo>
                  <a:lnTo>
                    <a:pt x="1770" y="131"/>
                  </a:lnTo>
                  <a:lnTo>
                    <a:pt x="1773" y="131"/>
                  </a:lnTo>
                  <a:lnTo>
                    <a:pt x="1775" y="131"/>
                  </a:lnTo>
                  <a:lnTo>
                    <a:pt x="1778" y="131"/>
                  </a:lnTo>
                  <a:lnTo>
                    <a:pt x="1780" y="131"/>
                  </a:lnTo>
                  <a:lnTo>
                    <a:pt x="1783" y="131"/>
                  </a:lnTo>
                  <a:lnTo>
                    <a:pt x="1784" y="131"/>
                  </a:lnTo>
                  <a:lnTo>
                    <a:pt x="1786" y="131"/>
                  </a:lnTo>
                  <a:lnTo>
                    <a:pt x="1789" y="131"/>
                  </a:lnTo>
                  <a:lnTo>
                    <a:pt x="1791" y="131"/>
                  </a:lnTo>
                  <a:lnTo>
                    <a:pt x="1794" y="131"/>
                  </a:lnTo>
                  <a:lnTo>
                    <a:pt x="1796" y="130"/>
                  </a:lnTo>
                  <a:lnTo>
                    <a:pt x="1799" y="130"/>
                  </a:lnTo>
                  <a:lnTo>
                    <a:pt x="1801" y="130"/>
                  </a:lnTo>
                  <a:lnTo>
                    <a:pt x="1804" y="130"/>
                  </a:lnTo>
                  <a:lnTo>
                    <a:pt x="1806" y="130"/>
                  </a:lnTo>
                  <a:lnTo>
                    <a:pt x="1808" y="130"/>
                  </a:lnTo>
                  <a:lnTo>
                    <a:pt x="1810" y="130"/>
                  </a:lnTo>
                  <a:lnTo>
                    <a:pt x="1812" y="130"/>
                  </a:lnTo>
                  <a:lnTo>
                    <a:pt x="1815" y="130"/>
                  </a:lnTo>
                  <a:lnTo>
                    <a:pt x="1817" y="130"/>
                  </a:lnTo>
                  <a:lnTo>
                    <a:pt x="1820" y="130"/>
                  </a:lnTo>
                  <a:lnTo>
                    <a:pt x="1822" y="130"/>
                  </a:lnTo>
                  <a:lnTo>
                    <a:pt x="1824" y="130"/>
                  </a:lnTo>
                  <a:lnTo>
                    <a:pt x="1827" y="130"/>
                  </a:lnTo>
                  <a:lnTo>
                    <a:pt x="1829" y="130"/>
                  </a:lnTo>
                  <a:lnTo>
                    <a:pt x="1832" y="130"/>
                  </a:lnTo>
                  <a:lnTo>
                    <a:pt x="1834" y="130"/>
                  </a:lnTo>
                  <a:lnTo>
                    <a:pt x="1836" y="130"/>
                  </a:lnTo>
                  <a:lnTo>
                    <a:pt x="1838" y="130"/>
                  </a:lnTo>
                  <a:lnTo>
                    <a:pt x="1841" y="130"/>
                  </a:lnTo>
                  <a:lnTo>
                    <a:pt x="1843" y="130"/>
                  </a:lnTo>
                  <a:lnTo>
                    <a:pt x="1845" y="130"/>
                  </a:lnTo>
                  <a:lnTo>
                    <a:pt x="1848" y="130"/>
                  </a:lnTo>
                  <a:lnTo>
                    <a:pt x="1850" y="130"/>
                  </a:lnTo>
                  <a:lnTo>
                    <a:pt x="1853" y="130"/>
                  </a:lnTo>
                  <a:lnTo>
                    <a:pt x="1855" y="130"/>
                  </a:lnTo>
                  <a:lnTo>
                    <a:pt x="1858" y="130"/>
                  </a:lnTo>
                  <a:lnTo>
                    <a:pt x="1860" y="130"/>
                  </a:lnTo>
                  <a:lnTo>
                    <a:pt x="1861" y="130"/>
                  </a:lnTo>
                  <a:lnTo>
                    <a:pt x="1864" y="130"/>
                  </a:lnTo>
                  <a:lnTo>
                    <a:pt x="1866" y="130"/>
                  </a:lnTo>
                  <a:lnTo>
                    <a:pt x="1869" y="130"/>
                  </a:lnTo>
                  <a:lnTo>
                    <a:pt x="1871" y="130"/>
                  </a:lnTo>
                  <a:lnTo>
                    <a:pt x="1874" y="130"/>
                  </a:lnTo>
                  <a:lnTo>
                    <a:pt x="1876" y="130"/>
                  </a:lnTo>
                  <a:lnTo>
                    <a:pt x="1879" y="130"/>
                  </a:lnTo>
                  <a:lnTo>
                    <a:pt x="1881" y="130"/>
                  </a:lnTo>
                  <a:lnTo>
                    <a:pt x="1882" y="129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Rectangle 112">
              <a:extLst>
                <a:ext uri="{FF2B5EF4-FFF2-40B4-BE49-F238E27FC236}">
                  <a16:creationId xmlns:a16="http://schemas.microsoft.com/office/drawing/2014/main" id="{81856AF4-BDBC-9757-73FF-6D768B2C9F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9938" y="3681413"/>
              <a:ext cx="2976563" cy="879475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45" name="Line 12">
            <a:extLst>
              <a:ext uri="{FF2B5EF4-FFF2-40B4-BE49-F238E27FC236}">
                <a16:creationId xmlns:a16="http://schemas.microsoft.com/office/drawing/2014/main" id="{EC54F6ED-11A6-C5A4-F9A5-F6CC9DABC0D3}"/>
              </a:ext>
            </a:extLst>
          </p:cNvPr>
          <p:cNvSpPr>
            <a:spLocks noChangeShapeType="1"/>
          </p:cNvSpPr>
          <p:nvPr/>
        </p:nvSpPr>
        <p:spPr bwMode="auto">
          <a:xfrm>
            <a:off x="2623991" y="3851702"/>
            <a:ext cx="0" cy="2857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" name="Line 23">
            <a:extLst>
              <a:ext uri="{FF2B5EF4-FFF2-40B4-BE49-F238E27FC236}">
                <a16:creationId xmlns:a16="http://schemas.microsoft.com/office/drawing/2014/main" id="{6B29C9C1-F73A-B03E-2CEB-047D6977430A}"/>
              </a:ext>
            </a:extLst>
          </p:cNvPr>
          <p:cNvSpPr>
            <a:spLocks noChangeShapeType="1"/>
          </p:cNvSpPr>
          <p:nvPr/>
        </p:nvSpPr>
        <p:spPr bwMode="auto">
          <a:xfrm>
            <a:off x="2623991" y="3851702"/>
            <a:ext cx="0" cy="55563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" name="Rectangle 24">
            <a:extLst>
              <a:ext uri="{FF2B5EF4-FFF2-40B4-BE49-F238E27FC236}">
                <a16:creationId xmlns:a16="http://schemas.microsoft.com/office/drawing/2014/main" id="{52839EAF-47A3-C966-F761-51EEB06975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71419" y="392790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1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8" name="Line 17">
            <a:extLst>
              <a:ext uri="{FF2B5EF4-FFF2-40B4-BE49-F238E27FC236}">
                <a16:creationId xmlns:a16="http://schemas.microsoft.com/office/drawing/2014/main" id="{2181B1FC-6D8E-0721-B428-547315418F8D}"/>
              </a:ext>
            </a:extLst>
          </p:cNvPr>
          <p:cNvSpPr>
            <a:spLocks noChangeShapeType="1"/>
          </p:cNvSpPr>
          <p:nvPr/>
        </p:nvSpPr>
        <p:spPr bwMode="auto">
          <a:xfrm>
            <a:off x="4132337" y="3852514"/>
            <a:ext cx="0" cy="2857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" name="Line 25">
            <a:extLst>
              <a:ext uri="{FF2B5EF4-FFF2-40B4-BE49-F238E27FC236}">
                <a16:creationId xmlns:a16="http://schemas.microsoft.com/office/drawing/2014/main" id="{363767FB-A1CB-2F9A-D924-1C4B04AEFBA4}"/>
              </a:ext>
            </a:extLst>
          </p:cNvPr>
          <p:cNvSpPr>
            <a:spLocks noChangeShapeType="1"/>
          </p:cNvSpPr>
          <p:nvPr/>
        </p:nvSpPr>
        <p:spPr bwMode="auto">
          <a:xfrm>
            <a:off x="4132337" y="3852514"/>
            <a:ext cx="0" cy="55563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" name="Rectangle 24">
            <a:extLst>
              <a:ext uri="{FF2B5EF4-FFF2-40B4-BE49-F238E27FC236}">
                <a16:creationId xmlns:a16="http://schemas.microsoft.com/office/drawing/2014/main" id="{3831BF31-1726-54AC-4F9B-219371E09D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2821" y="394418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1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4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1" name="Line 25">
            <a:extLst>
              <a:ext uri="{FF2B5EF4-FFF2-40B4-BE49-F238E27FC236}">
                <a16:creationId xmlns:a16="http://schemas.microsoft.com/office/drawing/2014/main" id="{4758D8A4-5792-C2A7-6B96-F0A2DB71ED3D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0145" y="3853326"/>
            <a:ext cx="0" cy="55563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2" name="Rectangle 24">
            <a:extLst>
              <a:ext uri="{FF2B5EF4-FFF2-40B4-BE49-F238E27FC236}">
                <a16:creationId xmlns:a16="http://schemas.microsoft.com/office/drawing/2014/main" id="{76C00588-C03A-D585-6694-FBF915059A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9678" y="392863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6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153" name="グループ化 152">
            <a:extLst>
              <a:ext uri="{FF2B5EF4-FFF2-40B4-BE49-F238E27FC236}">
                <a16:creationId xmlns:a16="http://schemas.microsoft.com/office/drawing/2014/main" id="{7FAA66FC-A86A-888E-BE08-0BE84D087C0A}"/>
              </a:ext>
            </a:extLst>
          </p:cNvPr>
          <p:cNvGrpSpPr/>
          <p:nvPr/>
        </p:nvGrpSpPr>
        <p:grpSpPr>
          <a:xfrm>
            <a:off x="4376746" y="2854822"/>
            <a:ext cx="1481134" cy="1264207"/>
            <a:chOff x="5610456" y="2747275"/>
            <a:chExt cx="1481134" cy="2309766"/>
          </a:xfrm>
        </p:grpSpPr>
        <p:sp>
          <p:nvSpPr>
            <p:cNvPr id="154" name="AutoShape 504">
              <a:extLst>
                <a:ext uri="{FF2B5EF4-FFF2-40B4-BE49-F238E27FC236}">
                  <a16:creationId xmlns:a16="http://schemas.microsoft.com/office/drawing/2014/main" id="{79C1C3B4-F68C-B36E-2BE5-A6BF3D83192F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5901770" y="2771998"/>
              <a:ext cx="1127432" cy="2160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" name="Rectangle 506">
              <a:extLst>
                <a:ext uri="{FF2B5EF4-FFF2-40B4-BE49-F238E27FC236}">
                  <a16:creationId xmlns:a16="http://schemas.microsoft.com/office/drawing/2014/main" id="{94B9AC50-CF85-4F01-D60C-D574638077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2391" y="2771998"/>
              <a:ext cx="1104474" cy="210185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" name="Rectangle 507">
              <a:extLst>
                <a:ext uri="{FF2B5EF4-FFF2-40B4-BE49-F238E27FC236}">
                  <a16:creationId xmlns:a16="http://schemas.microsoft.com/office/drawing/2014/main" id="{FF95259E-4707-E68A-8575-2466AB736D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2391" y="2864073"/>
              <a:ext cx="1104474" cy="2009775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" name="Rectangle 508">
              <a:extLst>
                <a:ext uri="{FF2B5EF4-FFF2-40B4-BE49-F238E27FC236}">
                  <a16:creationId xmlns:a16="http://schemas.microsoft.com/office/drawing/2014/main" id="{D72FC33E-E96E-9035-EF68-57818B50F5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2506" y="2967260"/>
              <a:ext cx="1015744" cy="1801812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" name="Rectangle 509">
              <a:extLst>
                <a:ext uri="{FF2B5EF4-FFF2-40B4-BE49-F238E27FC236}">
                  <a16:creationId xmlns:a16="http://schemas.microsoft.com/office/drawing/2014/main" id="{863E314E-5D9E-6BE8-77D9-D332102E0F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2391" y="2771998"/>
              <a:ext cx="1104474" cy="92075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9" name="Line 514">
              <a:extLst>
                <a:ext uri="{FF2B5EF4-FFF2-40B4-BE49-F238E27FC236}">
                  <a16:creationId xmlns:a16="http://schemas.microsoft.com/office/drawing/2014/main" id="{1076A30E-2094-0715-BC83-CF93F8F397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72506" y="4769073"/>
              <a:ext cx="1015744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" name="Line 515">
              <a:extLst>
                <a:ext uri="{FF2B5EF4-FFF2-40B4-BE49-F238E27FC236}">
                  <a16:creationId xmlns:a16="http://schemas.microsoft.com/office/drawing/2014/main" id="{94D7668B-121E-C389-4255-6B6971F6C9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83675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" name="Line 516">
              <a:extLst>
                <a:ext uri="{FF2B5EF4-FFF2-40B4-BE49-F238E27FC236}">
                  <a16:creationId xmlns:a16="http://schemas.microsoft.com/office/drawing/2014/main" id="{650657C8-E127-DD6F-8F23-C3E9925952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08494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" name="Line 517">
              <a:extLst>
                <a:ext uri="{FF2B5EF4-FFF2-40B4-BE49-F238E27FC236}">
                  <a16:creationId xmlns:a16="http://schemas.microsoft.com/office/drawing/2014/main" id="{72DA57E7-C867-579C-BCF8-97C950BD6B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33314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" name="Line 518">
              <a:extLst>
                <a:ext uri="{FF2B5EF4-FFF2-40B4-BE49-F238E27FC236}">
                  <a16:creationId xmlns:a16="http://schemas.microsoft.com/office/drawing/2014/main" id="{6A93CF12-0F63-CAD1-0DF3-0D2C734CE0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58134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" name="Line 519">
              <a:extLst>
                <a:ext uri="{FF2B5EF4-FFF2-40B4-BE49-F238E27FC236}">
                  <a16:creationId xmlns:a16="http://schemas.microsoft.com/office/drawing/2014/main" id="{A37E8C5B-541D-9636-A3EC-88B51D9335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2953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5" name="Line 520">
              <a:extLst>
                <a:ext uri="{FF2B5EF4-FFF2-40B4-BE49-F238E27FC236}">
                  <a16:creationId xmlns:a16="http://schemas.microsoft.com/office/drawing/2014/main" id="{76CE40DF-ED85-F254-8275-2470CFD9B6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07773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" name="Line 521">
              <a:extLst>
                <a:ext uri="{FF2B5EF4-FFF2-40B4-BE49-F238E27FC236}">
                  <a16:creationId xmlns:a16="http://schemas.microsoft.com/office/drawing/2014/main" id="{B8EDB7C1-3A1A-722F-4BC5-BB097AFE80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32593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" name="Line 522">
              <a:extLst>
                <a:ext uri="{FF2B5EF4-FFF2-40B4-BE49-F238E27FC236}">
                  <a16:creationId xmlns:a16="http://schemas.microsoft.com/office/drawing/2014/main" id="{14551703-01F7-B4DE-ABDE-6130FFDD16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57412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" name="Line 523">
              <a:extLst>
                <a:ext uri="{FF2B5EF4-FFF2-40B4-BE49-F238E27FC236}">
                  <a16:creationId xmlns:a16="http://schemas.microsoft.com/office/drawing/2014/main" id="{D47053E7-0C79-0B73-7961-6798444CDB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82232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" name="Line 524">
              <a:extLst>
                <a:ext uri="{FF2B5EF4-FFF2-40B4-BE49-F238E27FC236}">
                  <a16:creationId xmlns:a16="http://schemas.microsoft.com/office/drawing/2014/main" id="{09BF4CF7-CBB7-693B-D433-BD1994D769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07052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0" name="Line 525">
              <a:extLst>
                <a:ext uri="{FF2B5EF4-FFF2-40B4-BE49-F238E27FC236}">
                  <a16:creationId xmlns:a16="http://schemas.microsoft.com/office/drawing/2014/main" id="{3511EB1D-1980-4373-9BA9-A04703F8D1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31871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1" name="Line 526">
              <a:extLst>
                <a:ext uri="{FF2B5EF4-FFF2-40B4-BE49-F238E27FC236}">
                  <a16:creationId xmlns:a16="http://schemas.microsoft.com/office/drawing/2014/main" id="{4A9C41A7-E573-651C-0B30-B7ACAF69A5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6691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2" name="Line 527">
              <a:extLst>
                <a:ext uri="{FF2B5EF4-FFF2-40B4-BE49-F238E27FC236}">
                  <a16:creationId xmlns:a16="http://schemas.microsoft.com/office/drawing/2014/main" id="{B9015F14-A1F6-A5B4-BD5A-65923D7779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81511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3" name="Line 528">
              <a:extLst>
                <a:ext uri="{FF2B5EF4-FFF2-40B4-BE49-F238E27FC236}">
                  <a16:creationId xmlns:a16="http://schemas.microsoft.com/office/drawing/2014/main" id="{64ABAE96-EF6E-BA2C-285B-58BB0CF527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6330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4" name="Line 529">
              <a:extLst>
                <a:ext uri="{FF2B5EF4-FFF2-40B4-BE49-F238E27FC236}">
                  <a16:creationId xmlns:a16="http://schemas.microsoft.com/office/drawing/2014/main" id="{19AA39FA-7E13-3D4D-AEEA-0FF70488BC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1150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5" name="Line 530">
              <a:extLst>
                <a:ext uri="{FF2B5EF4-FFF2-40B4-BE49-F238E27FC236}">
                  <a16:creationId xmlns:a16="http://schemas.microsoft.com/office/drawing/2014/main" id="{E06373CC-A6FA-72CB-3614-303B9E07F5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5969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6" name="Line 531">
              <a:extLst>
                <a:ext uri="{FF2B5EF4-FFF2-40B4-BE49-F238E27FC236}">
                  <a16:creationId xmlns:a16="http://schemas.microsoft.com/office/drawing/2014/main" id="{3068F0EF-E541-25AB-16CA-E0B3911DE4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80789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7" name="Line 532">
              <a:extLst>
                <a:ext uri="{FF2B5EF4-FFF2-40B4-BE49-F238E27FC236}">
                  <a16:creationId xmlns:a16="http://schemas.microsoft.com/office/drawing/2014/main" id="{BBCF95EA-0330-2B33-3D98-12422B8858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05609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8" name="Line 533">
              <a:extLst>
                <a:ext uri="{FF2B5EF4-FFF2-40B4-BE49-F238E27FC236}">
                  <a16:creationId xmlns:a16="http://schemas.microsoft.com/office/drawing/2014/main" id="{4A126395-4BD2-22DE-A954-A701E6EA3A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29808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9" name="Line 534">
              <a:extLst>
                <a:ext uri="{FF2B5EF4-FFF2-40B4-BE49-F238E27FC236}">
                  <a16:creationId xmlns:a16="http://schemas.microsoft.com/office/drawing/2014/main" id="{9F836D8E-E4F3-510F-AB37-A97B55399B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54628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0" name="Line 535">
              <a:extLst>
                <a:ext uri="{FF2B5EF4-FFF2-40B4-BE49-F238E27FC236}">
                  <a16:creationId xmlns:a16="http://schemas.microsoft.com/office/drawing/2014/main" id="{4C282481-6200-3165-2023-BBA07D5ECF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9447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1" name="Line 536">
              <a:extLst>
                <a:ext uri="{FF2B5EF4-FFF2-40B4-BE49-F238E27FC236}">
                  <a16:creationId xmlns:a16="http://schemas.microsoft.com/office/drawing/2014/main" id="{09884A34-DFFB-FB45-C4C4-41E808CA6A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04267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2" name="Line 537">
              <a:extLst>
                <a:ext uri="{FF2B5EF4-FFF2-40B4-BE49-F238E27FC236}">
                  <a16:creationId xmlns:a16="http://schemas.microsoft.com/office/drawing/2014/main" id="{00985910-310D-CF0C-F7E2-F0029217B7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29087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3" name="Line 538">
              <a:extLst>
                <a:ext uri="{FF2B5EF4-FFF2-40B4-BE49-F238E27FC236}">
                  <a16:creationId xmlns:a16="http://schemas.microsoft.com/office/drawing/2014/main" id="{CFE539F7-9B7A-B4F3-B37C-3BB88677B3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3906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4" name="Line 539">
              <a:extLst>
                <a:ext uri="{FF2B5EF4-FFF2-40B4-BE49-F238E27FC236}">
                  <a16:creationId xmlns:a16="http://schemas.microsoft.com/office/drawing/2014/main" id="{17B22ACA-3AA6-DAAA-24F9-4725CE55B3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78726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5" name="Line 540">
              <a:extLst>
                <a:ext uri="{FF2B5EF4-FFF2-40B4-BE49-F238E27FC236}">
                  <a16:creationId xmlns:a16="http://schemas.microsoft.com/office/drawing/2014/main" id="{B0EC069B-C485-0692-E815-FEDE9B765A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03546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6" name="Line 541">
              <a:extLst>
                <a:ext uri="{FF2B5EF4-FFF2-40B4-BE49-F238E27FC236}">
                  <a16:creationId xmlns:a16="http://schemas.microsoft.com/office/drawing/2014/main" id="{12D4B203-C3F1-40D9-A324-3ADB8C52F3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28365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7" name="Line 542">
              <a:extLst>
                <a:ext uri="{FF2B5EF4-FFF2-40B4-BE49-F238E27FC236}">
                  <a16:creationId xmlns:a16="http://schemas.microsoft.com/office/drawing/2014/main" id="{EBABD1E9-BA7C-DC83-E75C-B66F7209A0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53185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8" name="Line 543">
              <a:extLst>
                <a:ext uri="{FF2B5EF4-FFF2-40B4-BE49-F238E27FC236}">
                  <a16:creationId xmlns:a16="http://schemas.microsoft.com/office/drawing/2014/main" id="{A02FCE1C-B1EB-BA99-76E0-7625A07BA4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78005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9" name="Line 544">
              <a:extLst>
                <a:ext uri="{FF2B5EF4-FFF2-40B4-BE49-F238E27FC236}">
                  <a16:creationId xmlns:a16="http://schemas.microsoft.com/office/drawing/2014/main" id="{E64504C0-118F-8468-31CB-00C6768DFA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02824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0" name="Line 545">
              <a:extLst>
                <a:ext uri="{FF2B5EF4-FFF2-40B4-BE49-F238E27FC236}">
                  <a16:creationId xmlns:a16="http://schemas.microsoft.com/office/drawing/2014/main" id="{B2664AC5-F924-9E96-FB74-A1069A4BD4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27644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1" name="Line 546">
              <a:extLst>
                <a:ext uri="{FF2B5EF4-FFF2-40B4-BE49-F238E27FC236}">
                  <a16:creationId xmlns:a16="http://schemas.microsoft.com/office/drawing/2014/main" id="{848E1026-9BE9-357A-7300-21A786E107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52463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2" name="Line 547">
              <a:extLst>
                <a:ext uri="{FF2B5EF4-FFF2-40B4-BE49-F238E27FC236}">
                  <a16:creationId xmlns:a16="http://schemas.microsoft.com/office/drawing/2014/main" id="{F0A824DE-EAE7-A8F2-5B60-0D09228CEE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7283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3" name="Line 548">
              <a:extLst>
                <a:ext uri="{FF2B5EF4-FFF2-40B4-BE49-F238E27FC236}">
                  <a16:creationId xmlns:a16="http://schemas.microsoft.com/office/drawing/2014/main" id="{EF5DEEB7-C96C-7D4B-7F50-AC7C75F88C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02103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4" name="Line 549">
              <a:extLst>
                <a:ext uri="{FF2B5EF4-FFF2-40B4-BE49-F238E27FC236}">
                  <a16:creationId xmlns:a16="http://schemas.microsoft.com/office/drawing/2014/main" id="{DC10AA86-6119-37EC-8DD2-8F5A31792D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26922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5" name="Line 550">
              <a:extLst>
                <a:ext uri="{FF2B5EF4-FFF2-40B4-BE49-F238E27FC236}">
                  <a16:creationId xmlns:a16="http://schemas.microsoft.com/office/drawing/2014/main" id="{39E48115-E171-2BB4-8C86-139BC6867E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51742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6" name="Line 551">
              <a:extLst>
                <a:ext uri="{FF2B5EF4-FFF2-40B4-BE49-F238E27FC236}">
                  <a16:creationId xmlns:a16="http://schemas.microsoft.com/office/drawing/2014/main" id="{82094F23-C2A3-63C0-1B5B-28807001E9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76562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7" name="Line 552">
              <a:extLst>
                <a:ext uri="{FF2B5EF4-FFF2-40B4-BE49-F238E27FC236}">
                  <a16:creationId xmlns:a16="http://schemas.microsoft.com/office/drawing/2014/main" id="{18E23266-5D76-9892-54D0-859BE9D10E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01381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8" name="Line 553">
              <a:extLst>
                <a:ext uri="{FF2B5EF4-FFF2-40B4-BE49-F238E27FC236}">
                  <a16:creationId xmlns:a16="http://schemas.microsoft.com/office/drawing/2014/main" id="{8C8BACDA-66D1-A544-8E4D-CF9E6B5BC2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26201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9" name="Line 554">
              <a:extLst>
                <a:ext uri="{FF2B5EF4-FFF2-40B4-BE49-F238E27FC236}">
                  <a16:creationId xmlns:a16="http://schemas.microsoft.com/office/drawing/2014/main" id="{8C835606-BABE-FCF2-0364-9181781FC7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51021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0" name="Line 555">
              <a:extLst>
                <a:ext uri="{FF2B5EF4-FFF2-40B4-BE49-F238E27FC236}">
                  <a16:creationId xmlns:a16="http://schemas.microsoft.com/office/drawing/2014/main" id="{D48485C2-373D-A129-8C3F-DB90D34AF9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75840" y="4769073"/>
              <a:ext cx="621" cy="79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1" name="Line 556">
              <a:extLst>
                <a:ext uri="{FF2B5EF4-FFF2-40B4-BE49-F238E27FC236}">
                  <a16:creationId xmlns:a16="http://schemas.microsoft.com/office/drawing/2014/main" id="{65DBC9B2-A140-C586-9919-33B748F22C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83675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2" name="Line 557">
              <a:extLst>
                <a:ext uri="{FF2B5EF4-FFF2-40B4-BE49-F238E27FC236}">
                  <a16:creationId xmlns:a16="http://schemas.microsoft.com/office/drawing/2014/main" id="{4971CFE1-1F87-CEAB-A770-4200F8728B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33314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3" name="Line 558">
              <a:extLst>
                <a:ext uri="{FF2B5EF4-FFF2-40B4-BE49-F238E27FC236}">
                  <a16:creationId xmlns:a16="http://schemas.microsoft.com/office/drawing/2014/main" id="{FA80CE03-62F2-5A1A-07C6-E2CA2988A2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2953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4" name="Line 559">
              <a:extLst>
                <a:ext uri="{FF2B5EF4-FFF2-40B4-BE49-F238E27FC236}">
                  <a16:creationId xmlns:a16="http://schemas.microsoft.com/office/drawing/2014/main" id="{2495277C-4C3A-9A1D-3104-785FA3B610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32593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5" name="Line 560">
              <a:extLst>
                <a:ext uri="{FF2B5EF4-FFF2-40B4-BE49-F238E27FC236}">
                  <a16:creationId xmlns:a16="http://schemas.microsoft.com/office/drawing/2014/main" id="{5ADCE9F7-ED1A-4D5C-D856-9D9888ABC8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82232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" name="Line 561">
              <a:extLst>
                <a:ext uri="{FF2B5EF4-FFF2-40B4-BE49-F238E27FC236}">
                  <a16:creationId xmlns:a16="http://schemas.microsoft.com/office/drawing/2014/main" id="{42E244F8-B681-F1D4-B82D-63DCAEC86C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31871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" name="Line 562">
              <a:extLst>
                <a:ext uri="{FF2B5EF4-FFF2-40B4-BE49-F238E27FC236}">
                  <a16:creationId xmlns:a16="http://schemas.microsoft.com/office/drawing/2014/main" id="{A3EEC535-3694-6EDD-1CB7-2D2F3D31E1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81511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" name="Line 563">
              <a:extLst>
                <a:ext uri="{FF2B5EF4-FFF2-40B4-BE49-F238E27FC236}">
                  <a16:creationId xmlns:a16="http://schemas.microsoft.com/office/drawing/2014/main" id="{E96811B2-7441-F2D4-E920-813207141B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1150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" name="Line 564">
              <a:extLst>
                <a:ext uri="{FF2B5EF4-FFF2-40B4-BE49-F238E27FC236}">
                  <a16:creationId xmlns:a16="http://schemas.microsoft.com/office/drawing/2014/main" id="{E8556694-87CF-91F8-87ED-61C5642357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80789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" name="Line 565">
              <a:extLst>
                <a:ext uri="{FF2B5EF4-FFF2-40B4-BE49-F238E27FC236}">
                  <a16:creationId xmlns:a16="http://schemas.microsoft.com/office/drawing/2014/main" id="{056D650B-2CF8-697C-26E0-F35E43783E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29808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1" name="Line 566">
              <a:extLst>
                <a:ext uri="{FF2B5EF4-FFF2-40B4-BE49-F238E27FC236}">
                  <a16:creationId xmlns:a16="http://schemas.microsoft.com/office/drawing/2014/main" id="{2A427ABF-2C30-BB4C-5223-4B0DDA180E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9447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2" name="Line 567">
              <a:extLst>
                <a:ext uri="{FF2B5EF4-FFF2-40B4-BE49-F238E27FC236}">
                  <a16:creationId xmlns:a16="http://schemas.microsoft.com/office/drawing/2014/main" id="{35DFEB29-FADB-767A-A9E2-EEA96E38CA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29087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3" name="Line 568">
              <a:extLst>
                <a:ext uri="{FF2B5EF4-FFF2-40B4-BE49-F238E27FC236}">
                  <a16:creationId xmlns:a16="http://schemas.microsoft.com/office/drawing/2014/main" id="{9902B461-1113-9A8E-700C-9695A14B0E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78726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" name="Line 569">
              <a:extLst>
                <a:ext uri="{FF2B5EF4-FFF2-40B4-BE49-F238E27FC236}">
                  <a16:creationId xmlns:a16="http://schemas.microsoft.com/office/drawing/2014/main" id="{781FFA0C-E032-0D45-0C9A-2DD393B8A7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28365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" name="Line 570">
              <a:extLst>
                <a:ext uri="{FF2B5EF4-FFF2-40B4-BE49-F238E27FC236}">
                  <a16:creationId xmlns:a16="http://schemas.microsoft.com/office/drawing/2014/main" id="{C2770ABE-3BD7-1A91-4CAA-65B5F9D1D9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78005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" name="Line 571">
              <a:extLst>
                <a:ext uri="{FF2B5EF4-FFF2-40B4-BE49-F238E27FC236}">
                  <a16:creationId xmlns:a16="http://schemas.microsoft.com/office/drawing/2014/main" id="{F5202E1C-8C85-8449-00CD-D630DC97E5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27644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" name="Line 572">
              <a:extLst>
                <a:ext uri="{FF2B5EF4-FFF2-40B4-BE49-F238E27FC236}">
                  <a16:creationId xmlns:a16="http://schemas.microsoft.com/office/drawing/2014/main" id="{0ECA8124-F775-A419-B72C-94DCBDE82D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7283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" name="Line 573">
              <a:extLst>
                <a:ext uri="{FF2B5EF4-FFF2-40B4-BE49-F238E27FC236}">
                  <a16:creationId xmlns:a16="http://schemas.microsoft.com/office/drawing/2014/main" id="{318BA65C-F7F8-2843-1D5E-CC8D7C7687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26922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" name="Line 574">
              <a:extLst>
                <a:ext uri="{FF2B5EF4-FFF2-40B4-BE49-F238E27FC236}">
                  <a16:creationId xmlns:a16="http://schemas.microsoft.com/office/drawing/2014/main" id="{E10E5EAD-D755-EA7A-8FF0-934803ADF5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76562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" name="Line 575">
              <a:extLst>
                <a:ext uri="{FF2B5EF4-FFF2-40B4-BE49-F238E27FC236}">
                  <a16:creationId xmlns:a16="http://schemas.microsoft.com/office/drawing/2014/main" id="{253CDED2-D5E9-1BE5-23A8-CC34197912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26201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1" name="Line 576">
              <a:extLst>
                <a:ext uri="{FF2B5EF4-FFF2-40B4-BE49-F238E27FC236}">
                  <a16:creationId xmlns:a16="http://schemas.microsoft.com/office/drawing/2014/main" id="{44C0DE33-FC5B-5536-29A2-AF09748907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75840" y="4769073"/>
              <a:ext cx="621" cy="14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2" name="Rectangle 577">
              <a:extLst>
                <a:ext uri="{FF2B5EF4-FFF2-40B4-BE49-F238E27FC236}">
                  <a16:creationId xmlns:a16="http://schemas.microsoft.com/office/drawing/2014/main" id="{5CC3AB40-AA40-2ADA-BC5E-169B34B9C9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31995" y="4817224"/>
              <a:ext cx="19396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714.0</a:t>
              </a:r>
              <a:endParaRPr kumimoji="0" 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3" name="Rectangle 587">
              <a:extLst>
                <a:ext uri="{FF2B5EF4-FFF2-40B4-BE49-F238E27FC236}">
                  <a16:creationId xmlns:a16="http://schemas.microsoft.com/office/drawing/2014/main" id="{CEE96059-2BC4-DAFB-7939-916FDD2475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4700" y="4817224"/>
              <a:ext cx="19396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716.0</a:t>
              </a:r>
              <a:endParaRPr kumimoji="0" 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4" name="Rectangle 598">
              <a:extLst>
                <a:ext uri="{FF2B5EF4-FFF2-40B4-BE49-F238E27FC236}">
                  <a16:creationId xmlns:a16="http://schemas.microsoft.com/office/drawing/2014/main" id="{44360579-EEAF-3C25-4A59-9644EF6482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2834" y="4964708"/>
              <a:ext cx="26449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m/z, Da</a:t>
              </a:r>
              <a:endParaRPr kumimoji="0" 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5" name="Line 599">
              <a:extLst>
                <a:ext uri="{FF2B5EF4-FFF2-40B4-BE49-F238E27FC236}">
                  <a16:creationId xmlns:a16="http://schemas.microsoft.com/office/drawing/2014/main" id="{56DFC65E-7E8B-FCC3-4B6D-78025C41AF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72506" y="2967260"/>
              <a:ext cx="621" cy="1801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6" name="Line 600">
              <a:extLst>
                <a:ext uri="{FF2B5EF4-FFF2-40B4-BE49-F238E27FC236}">
                  <a16:creationId xmlns:a16="http://schemas.microsoft.com/office/drawing/2014/main" id="{AA7F6747-BD51-A3B6-BA05-F71F8F46D3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0645" y="4769073"/>
              <a:ext cx="1862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7" name="Line 601">
              <a:extLst>
                <a:ext uri="{FF2B5EF4-FFF2-40B4-BE49-F238E27FC236}">
                  <a16:creationId xmlns:a16="http://schemas.microsoft.com/office/drawing/2014/main" id="{A4C67E4D-10E8-0720-AC07-1B712A3D43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0645" y="4740498"/>
              <a:ext cx="1862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8" name="Line 629">
              <a:extLst>
                <a:ext uri="{FF2B5EF4-FFF2-40B4-BE49-F238E27FC236}">
                  <a16:creationId xmlns:a16="http://schemas.microsoft.com/office/drawing/2014/main" id="{44370482-AA5C-AE55-4866-90ED61903C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0645" y="3905473"/>
              <a:ext cx="1862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9" name="Line 630">
              <a:extLst>
                <a:ext uri="{FF2B5EF4-FFF2-40B4-BE49-F238E27FC236}">
                  <a16:creationId xmlns:a16="http://schemas.microsoft.com/office/drawing/2014/main" id="{3E40607E-9ADC-ECB5-B4D9-91E1FADBD7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0645" y="3876898"/>
              <a:ext cx="1862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0" name="Line 631">
              <a:extLst>
                <a:ext uri="{FF2B5EF4-FFF2-40B4-BE49-F238E27FC236}">
                  <a16:creationId xmlns:a16="http://schemas.microsoft.com/office/drawing/2014/main" id="{4DBFB981-CF6D-A550-F37D-BFF90F9FA3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0645" y="3846735"/>
              <a:ext cx="1862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1" name="Line 632">
              <a:extLst>
                <a:ext uri="{FF2B5EF4-FFF2-40B4-BE49-F238E27FC236}">
                  <a16:creationId xmlns:a16="http://schemas.microsoft.com/office/drawing/2014/main" id="{685A96AB-E60B-0156-994F-E4727E9DE3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0645" y="3816573"/>
              <a:ext cx="1862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2" name="Line 659">
              <a:extLst>
                <a:ext uri="{FF2B5EF4-FFF2-40B4-BE49-F238E27FC236}">
                  <a16:creationId xmlns:a16="http://schemas.microsoft.com/office/drawing/2014/main" id="{449A0C82-F6DE-6E39-3390-E62F36BCAC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0645" y="3011710"/>
              <a:ext cx="1862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3" name="Line 660">
              <a:extLst>
                <a:ext uri="{FF2B5EF4-FFF2-40B4-BE49-F238E27FC236}">
                  <a16:creationId xmlns:a16="http://schemas.microsoft.com/office/drawing/2014/main" id="{F9D57C84-3342-797E-DAD7-B1BF9325CC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0645" y="2983135"/>
              <a:ext cx="1862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4" name="Line 661">
              <a:extLst>
                <a:ext uri="{FF2B5EF4-FFF2-40B4-BE49-F238E27FC236}">
                  <a16:creationId xmlns:a16="http://schemas.microsoft.com/office/drawing/2014/main" id="{F7CB2185-1DB6-9A29-3C7A-F44F4F7827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68163" y="4769073"/>
              <a:ext cx="4344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5" name="Line 667">
              <a:extLst>
                <a:ext uri="{FF2B5EF4-FFF2-40B4-BE49-F238E27FC236}">
                  <a16:creationId xmlns:a16="http://schemas.microsoft.com/office/drawing/2014/main" id="{AAD45F48-C2EF-CFD2-8F6E-E746B983F9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68163" y="3876898"/>
              <a:ext cx="4344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6" name="Line 673">
              <a:extLst>
                <a:ext uri="{FF2B5EF4-FFF2-40B4-BE49-F238E27FC236}">
                  <a16:creationId xmlns:a16="http://schemas.microsoft.com/office/drawing/2014/main" id="{13BFA26B-21ED-2343-F4EC-781669CA7E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68163" y="2983135"/>
              <a:ext cx="4344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7" name="Rectangle 674">
              <a:extLst>
                <a:ext uri="{FF2B5EF4-FFF2-40B4-BE49-F238E27FC236}">
                  <a16:creationId xmlns:a16="http://schemas.microsoft.com/office/drawing/2014/main" id="{A6C5B459-7784-54D6-F7DF-F2F18E6789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8444" y="4730537"/>
              <a:ext cx="4328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0</a:t>
              </a:r>
              <a:endParaRPr kumimoji="0" 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38" name="Rectangle 680">
              <a:extLst>
                <a:ext uri="{FF2B5EF4-FFF2-40B4-BE49-F238E27FC236}">
                  <a16:creationId xmlns:a16="http://schemas.microsoft.com/office/drawing/2014/main" id="{4BA11A5E-4B3D-E612-19AD-6E23D8F251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5414" y="3836774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30</a:t>
              </a:r>
              <a:endParaRPr kumimoji="0" 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39" name="Rectangle 686">
              <a:extLst>
                <a:ext uri="{FF2B5EF4-FFF2-40B4-BE49-F238E27FC236}">
                  <a16:creationId xmlns:a16="http://schemas.microsoft.com/office/drawing/2014/main" id="{73100802-8211-5CF7-902D-6858FDAB93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5414" y="2943012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60</a:t>
              </a:r>
              <a:endParaRPr kumimoji="0" 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40" name="Rectangle 687">
              <a:extLst>
                <a:ext uri="{FF2B5EF4-FFF2-40B4-BE49-F238E27FC236}">
                  <a16:creationId xmlns:a16="http://schemas.microsoft.com/office/drawing/2014/main" id="{09A942BD-A281-D208-C568-7AF4AAA505F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378501" y="3820590"/>
              <a:ext cx="55624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Intensity, counts</a:t>
              </a:r>
              <a:endParaRPr kumimoji="0" 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41" name="Line 690">
              <a:extLst>
                <a:ext uri="{FF2B5EF4-FFF2-40B4-BE49-F238E27FC236}">
                  <a16:creationId xmlns:a16="http://schemas.microsoft.com/office/drawing/2014/main" id="{818CC81A-1B22-3366-7935-1AA6DFDD09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47586" y="4762723"/>
              <a:ext cx="621" cy="6350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2" name="Freeform 691">
              <a:extLst>
                <a:ext uri="{FF2B5EF4-FFF2-40B4-BE49-F238E27FC236}">
                  <a16:creationId xmlns:a16="http://schemas.microsoft.com/office/drawing/2014/main" id="{DAF3E28D-67EE-399C-6120-F81857005FF6}"/>
                </a:ext>
              </a:extLst>
            </p:cNvPr>
            <p:cNvSpPr>
              <a:spLocks/>
            </p:cNvSpPr>
            <p:nvPr/>
          </p:nvSpPr>
          <p:spPr bwMode="auto">
            <a:xfrm flipV="1">
              <a:off x="6055031" y="3306985"/>
              <a:ext cx="47778" cy="14620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9"/>
                </a:cxn>
                <a:cxn ang="0">
                  <a:pos x="68" y="425"/>
                </a:cxn>
                <a:cxn ang="0">
                  <a:pos x="136" y="478"/>
                </a:cxn>
                <a:cxn ang="0">
                  <a:pos x="204" y="2125"/>
                </a:cxn>
                <a:cxn ang="0">
                  <a:pos x="273" y="3188"/>
                </a:cxn>
                <a:cxn ang="0">
                  <a:pos x="341" y="6589"/>
                </a:cxn>
                <a:cxn ang="0">
                  <a:pos x="409" y="12063"/>
                </a:cxn>
                <a:cxn ang="0">
                  <a:pos x="477" y="16899"/>
                </a:cxn>
                <a:cxn ang="0">
                  <a:pos x="545" y="20885"/>
                </a:cxn>
                <a:cxn ang="0">
                  <a:pos x="613" y="20354"/>
                </a:cxn>
                <a:cxn ang="0">
                  <a:pos x="681" y="16899"/>
                </a:cxn>
                <a:cxn ang="0">
                  <a:pos x="749" y="9512"/>
                </a:cxn>
                <a:cxn ang="0">
                  <a:pos x="817" y="6961"/>
                </a:cxn>
                <a:cxn ang="0">
                  <a:pos x="885" y="3720"/>
                </a:cxn>
                <a:cxn ang="0">
                  <a:pos x="954" y="850"/>
                </a:cxn>
                <a:cxn ang="0">
                  <a:pos x="1022" y="372"/>
                </a:cxn>
                <a:cxn ang="0">
                  <a:pos x="1090" y="850"/>
                </a:cxn>
                <a:cxn ang="0">
                  <a:pos x="1158" y="106"/>
                </a:cxn>
                <a:cxn ang="0">
                  <a:pos x="1226" y="106"/>
                </a:cxn>
                <a:cxn ang="0">
                  <a:pos x="1294" y="106"/>
                </a:cxn>
                <a:cxn ang="0">
                  <a:pos x="1294" y="0"/>
                </a:cxn>
              </a:cxnLst>
              <a:rect l="0" t="0" r="r" b="b"/>
              <a:pathLst>
                <a:path w="1294" h="20885">
                  <a:moveTo>
                    <a:pt x="0" y="0"/>
                  </a:moveTo>
                  <a:lnTo>
                    <a:pt x="0" y="159"/>
                  </a:lnTo>
                  <a:lnTo>
                    <a:pt x="68" y="425"/>
                  </a:lnTo>
                  <a:lnTo>
                    <a:pt x="136" y="478"/>
                  </a:lnTo>
                  <a:lnTo>
                    <a:pt x="204" y="2125"/>
                  </a:lnTo>
                  <a:lnTo>
                    <a:pt x="273" y="3188"/>
                  </a:lnTo>
                  <a:lnTo>
                    <a:pt x="341" y="6589"/>
                  </a:lnTo>
                  <a:lnTo>
                    <a:pt x="409" y="12063"/>
                  </a:lnTo>
                  <a:lnTo>
                    <a:pt x="477" y="16899"/>
                  </a:lnTo>
                  <a:lnTo>
                    <a:pt x="545" y="20885"/>
                  </a:lnTo>
                  <a:lnTo>
                    <a:pt x="613" y="20354"/>
                  </a:lnTo>
                  <a:lnTo>
                    <a:pt x="681" y="16899"/>
                  </a:lnTo>
                  <a:lnTo>
                    <a:pt x="749" y="9512"/>
                  </a:lnTo>
                  <a:lnTo>
                    <a:pt x="817" y="6961"/>
                  </a:lnTo>
                  <a:lnTo>
                    <a:pt x="885" y="3720"/>
                  </a:lnTo>
                  <a:lnTo>
                    <a:pt x="954" y="850"/>
                  </a:lnTo>
                  <a:lnTo>
                    <a:pt x="1022" y="372"/>
                  </a:lnTo>
                  <a:lnTo>
                    <a:pt x="1090" y="850"/>
                  </a:lnTo>
                  <a:lnTo>
                    <a:pt x="1158" y="106"/>
                  </a:lnTo>
                  <a:lnTo>
                    <a:pt x="1226" y="106"/>
                  </a:lnTo>
                  <a:lnTo>
                    <a:pt x="1294" y="106"/>
                  </a:lnTo>
                  <a:lnTo>
                    <a:pt x="1294" y="0"/>
                  </a:lnTo>
                </a:path>
              </a:pathLst>
            </a:cu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3" name="Line 692">
              <a:extLst>
                <a:ext uri="{FF2B5EF4-FFF2-40B4-BE49-F238E27FC236}">
                  <a16:creationId xmlns:a16="http://schemas.microsoft.com/office/drawing/2014/main" id="{B6623A59-455C-DDFA-DA68-936B7B83D7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10255" y="4762723"/>
              <a:ext cx="621" cy="6350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4" name="Line 693">
              <a:extLst>
                <a:ext uri="{FF2B5EF4-FFF2-40B4-BE49-F238E27FC236}">
                  <a16:creationId xmlns:a16="http://schemas.microsoft.com/office/drawing/2014/main" id="{11F2EE02-CEF1-D1CA-1F03-12C7D048A1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23285" y="4762723"/>
              <a:ext cx="621" cy="6350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5" name="Freeform 694">
              <a:extLst>
                <a:ext uri="{FF2B5EF4-FFF2-40B4-BE49-F238E27FC236}">
                  <a16:creationId xmlns:a16="http://schemas.microsoft.com/office/drawing/2014/main" id="{8C0A81EC-7571-6E2D-EB31-31FDC1885425}"/>
                </a:ext>
              </a:extLst>
            </p:cNvPr>
            <p:cNvSpPr>
              <a:spLocks/>
            </p:cNvSpPr>
            <p:nvPr/>
          </p:nvSpPr>
          <p:spPr bwMode="auto">
            <a:xfrm flipV="1">
              <a:off x="6128249" y="2967260"/>
              <a:ext cx="62670" cy="18018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6"/>
                </a:cxn>
                <a:cxn ang="0">
                  <a:pos x="68" y="106"/>
                </a:cxn>
                <a:cxn ang="0">
                  <a:pos x="136" y="106"/>
                </a:cxn>
                <a:cxn ang="0">
                  <a:pos x="204" y="318"/>
                </a:cxn>
                <a:cxn ang="0">
                  <a:pos x="273" y="372"/>
                </a:cxn>
                <a:cxn ang="0">
                  <a:pos x="341" y="1434"/>
                </a:cxn>
                <a:cxn ang="0">
                  <a:pos x="409" y="2019"/>
                </a:cxn>
                <a:cxn ang="0">
                  <a:pos x="477" y="2391"/>
                </a:cxn>
                <a:cxn ang="0">
                  <a:pos x="545" y="5367"/>
                </a:cxn>
                <a:cxn ang="0">
                  <a:pos x="613" y="8609"/>
                </a:cxn>
                <a:cxn ang="0">
                  <a:pos x="681" y="15624"/>
                </a:cxn>
                <a:cxn ang="0">
                  <a:pos x="749" y="23755"/>
                </a:cxn>
                <a:cxn ang="0">
                  <a:pos x="818" y="25403"/>
                </a:cxn>
                <a:cxn ang="0">
                  <a:pos x="886" y="25722"/>
                </a:cxn>
                <a:cxn ang="0">
                  <a:pos x="954" y="21098"/>
                </a:cxn>
                <a:cxn ang="0">
                  <a:pos x="1022" y="13286"/>
                </a:cxn>
                <a:cxn ang="0">
                  <a:pos x="1090" y="8024"/>
                </a:cxn>
                <a:cxn ang="0">
                  <a:pos x="1158" y="6324"/>
                </a:cxn>
                <a:cxn ang="0">
                  <a:pos x="1226" y="3348"/>
                </a:cxn>
                <a:cxn ang="0">
                  <a:pos x="1294" y="1700"/>
                </a:cxn>
                <a:cxn ang="0">
                  <a:pos x="1362" y="850"/>
                </a:cxn>
                <a:cxn ang="0">
                  <a:pos x="1431" y="106"/>
                </a:cxn>
                <a:cxn ang="0">
                  <a:pos x="1499" y="106"/>
                </a:cxn>
                <a:cxn ang="0">
                  <a:pos x="1567" y="159"/>
                </a:cxn>
                <a:cxn ang="0">
                  <a:pos x="1635" y="106"/>
                </a:cxn>
                <a:cxn ang="0">
                  <a:pos x="1703" y="106"/>
                </a:cxn>
                <a:cxn ang="0">
                  <a:pos x="1703" y="0"/>
                </a:cxn>
              </a:cxnLst>
              <a:rect l="0" t="0" r="r" b="b"/>
              <a:pathLst>
                <a:path w="1703" h="25722">
                  <a:moveTo>
                    <a:pt x="0" y="0"/>
                  </a:moveTo>
                  <a:lnTo>
                    <a:pt x="0" y="106"/>
                  </a:lnTo>
                  <a:lnTo>
                    <a:pt x="68" y="106"/>
                  </a:lnTo>
                  <a:lnTo>
                    <a:pt x="136" y="106"/>
                  </a:lnTo>
                  <a:lnTo>
                    <a:pt x="204" y="318"/>
                  </a:lnTo>
                  <a:lnTo>
                    <a:pt x="273" y="372"/>
                  </a:lnTo>
                  <a:lnTo>
                    <a:pt x="341" y="1434"/>
                  </a:lnTo>
                  <a:lnTo>
                    <a:pt x="409" y="2019"/>
                  </a:lnTo>
                  <a:lnTo>
                    <a:pt x="477" y="2391"/>
                  </a:lnTo>
                  <a:lnTo>
                    <a:pt x="545" y="5367"/>
                  </a:lnTo>
                  <a:lnTo>
                    <a:pt x="613" y="8609"/>
                  </a:lnTo>
                  <a:lnTo>
                    <a:pt x="681" y="15624"/>
                  </a:lnTo>
                  <a:lnTo>
                    <a:pt x="749" y="23755"/>
                  </a:lnTo>
                  <a:lnTo>
                    <a:pt x="818" y="25403"/>
                  </a:lnTo>
                  <a:lnTo>
                    <a:pt x="886" y="25722"/>
                  </a:lnTo>
                  <a:lnTo>
                    <a:pt x="954" y="21098"/>
                  </a:lnTo>
                  <a:lnTo>
                    <a:pt x="1022" y="13286"/>
                  </a:lnTo>
                  <a:lnTo>
                    <a:pt x="1090" y="8024"/>
                  </a:lnTo>
                  <a:lnTo>
                    <a:pt x="1158" y="6324"/>
                  </a:lnTo>
                  <a:lnTo>
                    <a:pt x="1226" y="3348"/>
                  </a:lnTo>
                  <a:lnTo>
                    <a:pt x="1294" y="1700"/>
                  </a:lnTo>
                  <a:lnTo>
                    <a:pt x="1362" y="850"/>
                  </a:lnTo>
                  <a:lnTo>
                    <a:pt x="1431" y="106"/>
                  </a:lnTo>
                  <a:lnTo>
                    <a:pt x="1499" y="106"/>
                  </a:lnTo>
                  <a:lnTo>
                    <a:pt x="1567" y="159"/>
                  </a:lnTo>
                  <a:lnTo>
                    <a:pt x="1635" y="106"/>
                  </a:lnTo>
                  <a:lnTo>
                    <a:pt x="1703" y="106"/>
                  </a:lnTo>
                  <a:lnTo>
                    <a:pt x="1703" y="0"/>
                  </a:lnTo>
                </a:path>
              </a:pathLst>
            </a:cu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6" name="Line 695">
              <a:extLst>
                <a:ext uri="{FF2B5EF4-FFF2-40B4-BE49-F238E27FC236}">
                  <a16:creationId xmlns:a16="http://schemas.microsoft.com/office/drawing/2014/main" id="{D1E502EE-0758-9F1D-C5F2-CFD61DFDAD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98365" y="4762723"/>
              <a:ext cx="621" cy="6350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7" name="Freeform 696">
              <a:extLst>
                <a:ext uri="{FF2B5EF4-FFF2-40B4-BE49-F238E27FC236}">
                  <a16:creationId xmlns:a16="http://schemas.microsoft.com/office/drawing/2014/main" id="{5180FFB1-347B-7074-4FE2-2C49B3D74042}"/>
                </a:ext>
              </a:extLst>
            </p:cNvPr>
            <p:cNvSpPr>
              <a:spLocks/>
            </p:cNvSpPr>
            <p:nvPr/>
          </p:nvSpPr>
          <p:spPr bwMode="auto">
            <a:xfrm flipV="1">
              <a:off x="6218220" y="3868960"/>
              <a:ext cx="50260" cy="9001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12"/>
                </a:cxn>
                <a:cxn ang="0">
                  <a:pos x="69" y="637"/>
                </a:cxn>
                <a:cxn ang="0">
                  <a:pos x="137" y="318"/>
                </a:cxn>
                <a:cxn ang="0">
                  <a:pos x="205" y="956"/>
                </a:cxn>
                <a:cxn ang="0">
                  <a:pos x="273" y="1806"/>
                </a:cxn>
                <a:cxn ang="0">
                  <a:pos x="341" y="2391"/>
                </a:cxn>
                <a:cxn ang="0">
                  <a:pos x="409" y="3773"/>
                </a:cxn>
                <a:cxn ang="0">
                  <a:pos x="477" y="6217"/>
                </a:cxn>
                <a:cxn ang="0">
                  <a:pos x="546" y="11372"/>
                </a:cxn>
                <a:cxn ang="0">
                  <a:pos x="614" y="12861"/>
                </a:cxn>
                <a:cxn ang="0">
                  <a:pos x="682" y="10841"/>
                </a:cxn>
                <a:cxn ang="0">
                  <a:pos x="750" y="9034"/>
                </a:cxn>
                <a:cxn ang="0">
                  <a:pos x="818" y="6430"/>
                </a:cxn>
                <a:cxn ang="0">
                  <a:pos x="886" y="3932"/>
                </a:cxn>
                <a:cxn ang="0">
                  <a:pos x="954" y="2232"/>
                </a:cxn>
                <a:cxn ang="0">
                  <a:pos x="1022" y="1169"/>
                </a:cxn>
                <a:cxn ang="0">
                  <a:pos x="1091" y="425"/>
                </a:cxn>
                <a:cxn ang="0">
                  <a:pos x="1159" y="106"/>
                </a:cxn>
                <a:cxn ang="0">
                  <a:pos x="1227" y="106"/>
                </a:cxn>
                <a:cxn ang="0">
                  <a:pos x="1295" y="106"/>
                </a:cxn>
                <a:cxn ang="0">
                  <a:pos x="1363" y="212"/>
                </a:cxn>
                <a:cxn ang="0">
                  <a:pos x="1363" y="0"/>
                </a:cxn>
              </a:cxnLst>
              <a:rect l="0" t="0" r="r" b="b"/>
              <a:pathLst>
                <a:path w="1363" h="12861">
                  <a:moveTo>
                    <a:pt x="0" y="0"/>
                  </a:moveTo>
                  <a:lnTo>
                    <a:pt x="0" y="212"/>
                  </a:lnTo>
                  <a:lnTo>
                    <a:pt x="69" y="637"/>
                  </a:lnTo>
                  <a:lnTo>
                    <a:pt x="137" y="318"/>
                  </a:lnTo>
                  <a:lnTo>
                    <a:pt x="205" y="956"/>
                  </a:lnTo>
                  <a:lnTo>
                    <a:pt x="273" y="1806"/>
                  </a:lnTo>
                  <a:lnTo>
                    <a:pt x="341" y="2391"/>
                  </a:lnTo>
                  <a:lnTo>
                    <a:pt x="409" y="3773"/>
                  </a:lnTo>
                  <a:lnTo>
                    <a:pt x="477" y="6217"/>
                  </a:lnTo>
                  <a:lnTo>
                    <a:pt x="546" y="11372"/>
                  </a:lnTo>
                  <a:lnTo>
                    <a:pt x="614" y="12861"/>
                  </a:lnTo>
                  <a:lnTo>
                    <a:pt x="682" y="10841"/>
                  </a:lnTo>
                  <a:lnTo>
                    <a:pt x="750" y="9034"/>
                  </a:lnTo>
                  <a:lnTo>
                    <a:pt x="818" y="6430"/>
                  </a:lnTo>
                  <a:lnTo>
                    <a:pt x="886" y="3932"/>
                  </a:lnTo>
                  <a:lnTo>
                    <a:pt x="954" y="2232"/>
                  </a:lnTo>
                  <a:lnTo>
                    <a:pt x="1022" y="1169"/>
                  </a:lnTo>
                  <a:lnTo>
                    <a:pt x="1091" y="425"/>
                  </a:lnTo>
                  <a:lnTo>
                    <a:pt x="1159" y="106"/>
                  </a:lnTo>
                  <a:lnTo>
                    <a:pt x="1227" y="106"/>
                  </a:lnTo>
                  <a:lnTo>
                    <a:pt x="1295" y="106"/>
                  </a:lnTo>
                  <a:lnTo>
                    <a:pt x="1363" y="212"/>
                  </a:lnTo>
                  <a:lnTo>
                    <a:pt x="1363" y="0"/>
                  </a:lnTo>
                </a:path>
              </a:pathLst>
            </a:cu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8" name="Freeform 697">
              <a:extLst>
                <a:ext uri="{FF2B5EF4-FFF2-40B4-BE49-F238E27FC236}">
                  <a16:creationId xmlns:a16="http://schemas.microsoft.com/office/drawing/2014/main" id="{25AC650F-C7E5-6D1E-3530-4585A01F17DF}"/>
                </a:ext>
              </a:extLst>
            </p:cNvPr>
            <p:cNvSpPr>
              <a:spLocks/>
            </p:cNvSpPr>
            <p:nvPr/>
          </p:nvSpPr>
          <p:spPr bwMode="auto">
            <a:xfrm flipV="1">
              <a:off x="6308812" y="4530948"/>
              <a:ext cx="27302" cy="23812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6"/>
                </a:cxn>
                <a:cxn ang="0">
                  <a:pos x="69" y="106"/>
                </a:cxn>
                <a:cxn ang="0">
                  <a:pos x="137" y="212"/>
                </a:cxn>
                <a:cxn ang="0">
                  <a:pos x="205" y="584"/>
                </a:cxn>
                <a:cxn ang="0">
                  <a:pos x="273" y="850"/>
                </a:cxn>
                <a:cxn ang="0">
                  <a:pos x="341" y="3188"/>
                </a:cxn>
                <a:cxn ang="0">
                  <a:pos x="409" y="2763"/>
                </a:cxn>
                <a:cxn ang="0">
                  <a:pos x="477" y="3401"/>
                </a:cxn>
                <a:cxn ang="0">
                  <a:pos x="546" y="2391"/>
                </a:cxn>
                <a:cxn ang="0">
                  <a:pos x="614" y="1328"/>
                </a:cxn>
                <a:cxn ang="0">
                  <a:pos x="682" y="744"/>
                </a:cxn>
                <a:cxn ang="0">
                  <a:pos x="750" y="690"/>
                </a:cxn>
                <a:cxn ang="0">
                  <a:pos x="750" y="0"/>
                </a:cxn>
              </a:cxnLst>
              <a:rect l="0" t="0" r="r" b="b"/>
              <a:pathLst>
                <a:path w="750" h="3401">
                  <a:moveTo>
                    <a:pt x="0" y="0"/>
                  </a:moveTo>
                  <a:lnTo>
                    <a:pt x="0" y="106"/>
                  </a:lnTo>
                  <a:lnTo>
                    <a:pt x="69" y="106"/>
                  </a:lnTo>
                  <a:lnTo>
                    <a:pt x="137" y="212"/>
                  </a:lnTo>
                  <a:lnTo>
                    <a:pt x="205" y="584"/>
                  </a:lnTo>
                  <a:lnTo>
                    <a:pt x="273" y="850"/>
                  </a:lnTo>
                  <a:lnTo>
                    <a:pt x="341" y="3188"/>
                  </a:lnTo>
                  <a:lnTo>
                    <a:pt x="409" y="2763"/>
                  </a:lnTo>
                  <a:lnTo>
                    <a:pt x="477" y="3401"/>
                  </a:lnTo>
                  <a:lnTo>
                    <a:pt x="546" y="2391"/>
                  </a:lnTo>
                  <a:lnTo>
                    <a:pt x="614" y="1328"/>
                  </a:lnTo>
                  <a:lnTo>
                    <a:pt x="682" y="744"/>
                  </a:lnTo>
                  <a:lnTo>
                    <a:pt x="750" y="690"/>
                  </a:lnTo>
                  <a:lnTo>
                    <a:pt x="750" y="0"/>
                  </a:lnTo>
                </a:path>
              </a:pathLst>
            </a:cu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9" name="Line 698">
              <a:extLst>
                <a:ext uri="{FF2B5EF4-FFF2-40B4-BE49-F238E27FC236}">
                  <a16:creationId xmlns:a16="http://schemas.microsoft.com/office/drawing/2014/main" id="{84894D14-0DBB-9B14-020C-37CFC24CF7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41078" y="4746848"/>
              <a:ext cx="621" cy="22225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0" name="Line 699">
              <a:extLst>
                <a:ext uri="{FF2B5EF4-FFF2-40B4-BE49-F238E27FC236}">
                  <a16:creationId xmlns:a16="http://schemas.microsoft.com/office/drawing/2014/main" id="{C2717C9F-6FA5-12FB-BB12-A8B0687B47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51006" y="4762723"/>
              <a:ext cx="621" cy="6350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1" name="Freeform 700">
              <a:extLst>
                <a:ext uri="{FF2B5EF4-FFF2-40B4-BE49-F238E27FC236}">
                  <a16:creationId xmlns:a16="http://schemas.microsoft.com/office/drawing/2014/main" id="{71E3F231-3CD4-5212-79FA-0E301AE0004D}"/>
                </a:ext>
              </a:extLst>
            </p:cNvPr>
            <p:cNvSpPr>
              <a:spLocks/>
            </p:cNvSpPr>
            <p:nvPr/>
          </p:nvSpPr>
          <p:spPr bwMode="auto">
            <a:xfrm flipV="1">
              <a:off x="6403747" y="4735735"/>
              <a:ext cx="10549" cy="3333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78"/>
                </a:cxn>
                <a:cxn ang="0">
                  <a:pos x="69" y="212"/>
                </a:cxn>
                <a:cxn ang="0">
                  <a:pos x="137" y="318"/>
                </a:cxn>
                <a:cxn ang="0">
                  <a:pos x="205" y="212"/>
                </a:cxn>
                <a:cxn ang="0">
                  <a:pos x="273" y="106"/>
                </a:cxn>
                <a:cxn ang="0">
                  <a:pos x="273" y="0"/>
                </a:cxn>
              </a:cxnLst>
              <a:rect l="0" t="0" r="r" b="b"/>
              <a:pathLst>
                <a:path w="273" h="478">
                  <a:moveTo>
                    <a:pt x="0" y="0"/>
                  </a:moveTo>
                  <a:lnTo>
                    <a:pt x="0" y="478"/>
                  </a:lnTo>
                  <a:lnTo>
                    <a:pt x="69" y="212"/>
                  </a:lnTo>
                  <a:lnTo>
                    <a:pt x="137" y="318"/>
                  </a:lnTo>
                  <a:lnTo>
                    <a:pt x="205" y="212"/>
                  </a:lnTo>
                  <a:lnTo>
                    <a:pt x="273" y="106"/>
                  </a:lnTo>
                  <a:lnTo>
                    <a:pt x="273" y="0"/>
                  </a:lnTo>
                </a:path>
              </a:pathLst>
            </a:cu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2" name="Line 701">
              <a:extLst>
                <a:ext uri="{FF2B5EF4-FFF2-40B4-BE49-F238E27FC236}">
                  <a16:creationId xmlns:a16="http://schemas.microsoft.com/office/drawing/2014/main" id="{CDC972C7-855C-79C4-0D81-9A2AEB21D9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63935" y="4762723"/>
              <a:ext cx="621" cy="6350"/>
            </a:xfrm>
            <a:prstGeom prst="line">
              <a:avLst/>
            </a:pr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3" name="Rectangle 703">
              <a:extLst>
                <a:ext uri="{FF2B5EF4-FFF2-40B4-BE49-F238E27FC236}">
                  <a16:creationId xmlns:a16="http://schemas.microsoft.com/office/drawing/2014/main" id="{3F8DC4CA-3206-BD95-8321-F12A0E582A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8438" y="2747275"/>
              <a:ext cx="32380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714.7070</a:t>
              </a:r>
              <a:endParaRPr kumimoji="0" 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54" name="Rectangle 704">
              <a:extLst>
                <a:ext uri="{FF2B5EF4-FFF2-40B4-BE49-F238E27FC236}">
                  <a16:creationId xmlns:a16="http://schemas.microsoft.com/office/drawing/2014/main" id="{DA4655D2-19BD-3F3F-8D05-8B90E463F4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23431" y="3087001"/>
              <a:ext cx="32380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714.3740</a:t>
              </a:r>
              <a:endParaRPr kumimoji="0" 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55" name="Rectangle 705">
              <a:extLst>
                <a:ext uri="{FF2B5EF4-FFF2-40B4-BE49-F238E27FC236}">
                  <a16:creationId xmlns:a16="http://schemas.microsoft.com/office/drawing/2014/main" id="{8945ADA5-9895-188E-4E3B-DF210EE4E8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9102" y="3648975"/>
              <a:ext cx="32380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715.0403</a:t>
              </a:r>
              <a:endParaRPr kumimoji="0" 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56" name="Rectangle 587">
              <a:extLst>
                <a:ext uri="{FF2B5EF4-FFF2-40B4-BE49-F238E27FC236}">
                  <a16:creationId xmlns:a16="http://schemas.microsoft.com/office/drawing/2014/main" id="{D76E2290-0D80-4F56-1EBD-F2C750056E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97626" y="4819847"/>
              <a:ext cx="19396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718.0</a:t>
              </a:r>
              <a:endParaRPr kumimoji="0" 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7AE59033-16FA-9C01-FAE6-4A8B6327D9E8}"/>
              </a:ext>
            </a:extLst>
          </p:cNvPr>
          <p:cNvSpPr txBox="1"/>
          <p:nvPr/>
        </p:nvSpPr>
        <p:spPr>
          <a:xfrm rot="16200000">
            <a:off x="272444" y="3296484"/>
            <a:ext cx="934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20 nm (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U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id="{89A38CFA-B236-B4E5-D65C-A9DA1136C11E}"/>
              </a:ext>
            </a:extLst>
          </p:cNvPr>
          <p:cNvSpPr txBox="1"/>
          <p:nvPr/>
        </p:nvSpPr>
        <p:spPr>
          <a:xfrm>
            <a:off x="2350044" y="4099984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76FE0F47-D4F2-8239-571F-D30B75CE3CEC}"/>
              </a:ext>
            </a:extLst>
          </p:cNvPr>
          <p:cNvSpPr txBox="1"/>
          <p:nvPr/>
        </p:nvSpPr>
        <p:spPr>
          <a:xfrm>
            <a:off x="635001" y="4455959"/>
            <a:ext cx="64135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: Confirmation of purity and molecular weight of synthesized peptides</a:t>
            </a:r>
          </a:p>
          <a:p>
            <a:r>
              <a:rPr lang="en-US" altLang="ja-JP" sz="1200" dirty="0">
                <a:latin typeface="Palatino Linotype" panose="02040502050505030304" pitchFamily="18" charset="0"/>
              </a:rPr>
              <a:t>(a) Chromatogram 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 each purified peptide (Upper; ANA-SA5, Lower; Aβ11-29), (b) MS analysis (Upper; ANA-SA5, Lower; Aβ11-29).</a:t>
            </a:r>
            <a:endParaRPr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6FFDBB58-A875-11F3-4A07-35665B44B877}"/>
              </a:ext>
            </a:extLst>
          </p:cNvPr>
          <p:cNvSpPr txBox="1"/>
          <p:nvPr/>
        </p:nvSpPr>
        <p:spPr>
          <a:xfrm>
            <a:off x="658944" y="86875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id="{1FC3793D-3860-F92F-AAB5-6A9CAA0FE592}"/>
              </a:ext>
            </a:extLst>
          </p:cNvPr>
          <p:cNvSpPr txBox="1"/>
          <p:nvPr/>
        </p:nvSpPr>
        <p:spPr>
          <a:xfrm>
            <a:off x="4314768" y="86875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テキスト ボックス 333">
            <a:extLst>
              <a:ext uri="{FF2B5EF4-FFF2-40B4-BE49-F238E27FC236}">
                <a16:creationId xmlns:a16="http://schemas.microsoft.com/office/drawing/2014/main" id="{1D182799-615A-8176-84F3-CF53EAA39D30}"/>
              </a:ext>
            </a:extLst>
          </p:cNvPr>
          <p:cNvSpPr txBox="1"/>
          <p:nvPr/>
        </p:nvSpPr>
        <p:spPr>
          <a:xfrm>
            <a:off x="5429824" y="1177743"/>
            <a:ext cx="16786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bserved mass: 489.2685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正方形/長方形 334">
            <a:extLst>
              <a:ext uri="{FF2B5EF4-FFF2-40B4-BE49-F238E27FC236}">
                <a16:creationId xmlns:a16="http://schemas.microsoft.com/office/drawing/2014/main" id="{0CB6905E-CC81-3BDD-93B0-407D965E2AD6}"/>
              </a:ext>
            </a:extLst>
          </p:cNvPr>
          <p:cNvSpPr/>
          <p:nvPr/>
        </p:nvSpPr>
        <p:spPr>
          <a:xfrm>
            <a:off x="5429824" y="1330547"/>
            <a:ext cx="246957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etected ion m/z: 490.2685  [M + 1H]</a:t>
            </a:r>
            <a:r>
              <a:rPr lang="en-US" altLang="ja-JP" sz="1000" baseline="45000" dirty="0">
                <a:latin typeface="Arial" panose="020B0604020202020204" pitchFamily="34" charset="0"/>
                <a:cs typeface="Arial" panose="020B0604020202020204" pitchFamily="34" charset="0"/>
              </a:rPr>
              <a:t>1+</a:t>
            </a:r>
            <a:endParaRPr lang="ja-JP" altLang="en-US" sz="1000" baseline="4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TextBox 830">
            <a:extLst>
              <a:ext uri="{FF2B5EF4-FFF2-40B4-BE49-F238E27FC236}">
                <a16:creationId xmlns:a16="http://schemas.microsoft.com/office/drawing/2014/main" id="{763F6F51-A494-AA0F-8823-7E3065438A1E}"/>
              </a:ext>
            </a:extLst>
          </p:cNvPr>
          <p:cNvSpPr txBox="1"/>
          <p:nvPr/>
        </p:nvSpPr>
        <p:spPr>
          <a:xfrm>
            <a:off x="5429824" y="1009190"/>
            <a:ext cx="15872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0" lang="en-US" altLang="ja-JP" sz="1000" dirty="0">
                <a:solidFill>
                  <a:srgbClr val="212121"/>
                </a:solidFill>
                <a:latin typeface="Arial" panose="020B0604020202020204" pitchFamily="34" charset="0"/>
                <a:ea typeface="inherit"/>
                <a:cs typeface="Arial" panose="020B0604020202020204" pitchFamily="34" charset="0"/>
              </a:rPr>
              <a:t>Calculated mass: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89.25</a:t>
            </a:r>
          </a:p>
        </p:txBody>
      </p:sp>
      <p:sp>
        <p:nvSpPr>
          <p:cNvPr id="267" name="テキスト ボックス 333">
            <a:extLst>
              <a:ext uri="{FF2B5EF4-FFF2-40B4-BE49-F238E27FC236}">
                <a16:creationId xmlns:a16="http://schemas.microsoft.com/office/drawing/2014/main" id="{70AA5AD4-77B8-B757-4F94-413D2C68F82A}"/>
              </a:ext>
            </a:extLst>
          </p:cNvPr>
          <p:cNvSpPr txBox="1"/>
          <p:nvPr/>
        </p:nvSpPr>
        <p:spPr>
          <a:xfrm>
            <a:off x="5429824" y="3007689"/>
            <a:ext cx="17844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bserved mass : 2140.1220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正方形/長方形 334">
            <a:extLst>
              <a:ext uri="{FF2B5EF4-FFF2-40B4-BE49-F238E27FC236}">
                <a16:creationId xmlns:a16="http://schemas.microsoft.com/office/drawing/2014/main" id="{29497FD2-F8EC-2BB5-E970-29740B340476}"/>
              </a:ext>
            </a:extLst>
          </p:cNvPr>
          <p:cNvSpPr/>
          <p:nvPr/>
        </p:nvSpPr>
        <p:spPr>
          <a:xfrm>
            <a:off x="5429824" y="3160493"/>
            <a:ext cx="239681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etected ion m/z: 714.3740  [M + 3H]</a:t>
            </a:r>
            <a:r>
              <a:rPr lang="en-US" altLang="ja-JP" sz="1000" baseline="45000" dirty="0">
                <a:latin typeface="Arial" panose="020B0604020202020204" pitchFamily="34" charset="0"/>
                <a:cs typeface="Arial" panose="020B0604020202020204" pitchFamily="34" charset="0"/>
              </a:rPr>
              <a:t>3+</a:t>
            </a:r>
            <a:endParaRPr lang="ja-JP" altLang="en-US" sz="1000" baseline="4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830">
            <a:extLst>
              <a:ext uri="{FF2B5EF4-FFF2-40B4-BE49-F238E27FC236}">
                <a16:creationId xmlns:a16="http://schemas.microsoft.com/office/drawing/2014/main" id="{D7F2F9F8-A651-F2DD-481D-FDAF78BC59F2}"/>
              </a:ext>
            </a:extLst>
          </p:cNvPr>
          <p:cNvSpPr txBox="1"/>
          <p:nvPr/>
        </p:nvSpPr>
        <p:spPr>
          <a:xfrm>
            <a:off x="5429824" y="2839136"/>
            <a:ext cx="16866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0" lang="en-US" altLang="ja-JP" sz="1000" dirty="0">
                <a:solidFill>
                  <a:srgbClr val="212121"/>
                </a:solidFill>
                <a:latin typeface="Arial" panose="020B0604020202020204" pitchFamily="34" charset="0"/>
                <a:ea typeface="inherit"/>
                <a:cs typeface="Arial" panose="020B0604020202020204" pitchFamily="34" charset="0"/>
              </a:rPr>
              <a:t>Calculated mass :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140.07</a:t>
            </a:r>
          </a:p>
        </p:txBody>
      </p:sp>
    </p:spTree>
    <p:extLst>
      <p:ext uri="{BB962C8B-B14F-4D97-AF65-F5344CB8AC3E}">
        <p14:creationId xmlns:p14="http://schemas.microsoft.com/office/powerpoint/2010/main" val="3087488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6">
            <a:extLst>
              <a:ext uri="{FF2B5EF4-FFF2-40B4-BE49-F238E27FC236}">
                <a16:creationId xmlns:a16="http://schemas.microsoft.com/office/drawing/2014/main" id="{4FB5AFAA-F80F-45BA-A888-0A6E339AB0BB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329232" y="873385"/>
            <a:ext cx="2700337" cy="1620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189" name="Line 191">
            <a:extLst>
              <a:ext uri="{FF2B5EF4-FFF2-40B4-BE49-F238E27FC236}">
                <a16:creationId xmlns:a16="http://schemas.microsoft.com/office/drawing/2014/main" id="{093545A4-D4EF-4AB2-A95E-1CAEFE5FDDBD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1361" y="2545535"/>
            <a:ext cx="9404" cy="128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199" name="Line 201">
            <a:extLst>
              <a:ext uri="{FF2B5EF4-FFF2-40B4-BE49-F238E27FC236}">
                <a16:creationId xmlns:a16="http://schemas.microsoft.com/office/drawing/2014/main" id="{CA7CFD2B-DCFA-44C4-B40C-0E7373FA1100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1361" y="2202410"/>
            <a:ext cx="9404" cy="128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09" name="Line 211">
            <a:extLst>
              <a:ext uri="{FF2B5EF4-FFF2-40B4-BE49-F238E27FC236}">
                <a16:creationId xmlns:a16="http://schemas.microsoft.com/office/drawing/2014/main" id="{2AA3E371-F6A6-40F9-8CB3-7A9C50BB1112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1361" y="1860569"/>
            <a:ext cx="9404" cy="128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10" name="Line 212">
            <a:extLst>
              <a:ext uri="{FF2B5EF4-FFF2-40B4-BE49-F238E27FC236}">
                <a16:creationId xmlns:a16="http://schemas.microsoft.com/office/drawing/2014/main" id="{D7946174-AD0E-49E7-A8D3-799B498F8410}"/>
              </a:ext>
            </a:extLst>
          </p:cNvPr>
          <p:cNvSpPr>
            <a:spLocks noChangeShapeType="1"/>
          </p:cNvSpPr>
          <p:nvPr/>
        </p:nvSpPr>
        <p:spPr bwMode="auto">
          <a:xfrm>
            <a:off x="4912947" y="2545535"/>
            <a:ext cx="17818" cy="128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11" name="Rectangle 213">
            <a:extLst>
              <a:ext uri="{FF2B5EF4-FFF2-40B4-BE49-F238E27FC236}">
                <a16:creationId xmlns:a16="http://schemas.microsoft.com/office/drawing/2014/main" id="{C074273F-A66C-4708-985B-8E9101B780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9415" y="2514771"/>
            <a:ext cx="35031" cy="808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70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0</a:t>
            </a:r>
            <a:endParaRPr lang="en-US" altLang="ja-JP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Line 216">
            <a:extLst>
              <a:ext uri="{FF2B5EF4-FFF2-40B4-BE49-F238E27FC236}">
                <a16:creationId xmlns:a16="http://schemas.microsoft.com/office/drawing/2014/main" id="{2FEFF652-8724-4273-87BA-EE5B66A49F73}"/>
              </a:ext>
            </a:extLst>
          </p:cNvPr>
          <p:cNvSpPr>
            <a:spLocks noChangeShapeType="1"/>
          </p:cNvSpPr>
          <p:nvPr/>
        </p:nvSpPr>
        <p:spPr bwMode="auto">
          <a:xfrm>
            <a:off x="4912947" y="2202410"/>
            <a:ext cx="17818" cy="128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15" name="Rectangle 217">
            <a:extLst>
              <a:ext uri="{FF2B5EF4-FFF2-40B4-BE49-F238E27FC236}">
                <a16:creationId xmlns:a16="http://schemas.microsoft.com/office/drawing/2014/main" id="{EE1F2CF7-937A-4150-8187-16C21E0E0A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1102" y="2172931"/>
            <a:ext cx="70061" cy="808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20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Line 220">
            <a:extLst>
              <a:ext uri="{FF2B5EF4-FFF2-40B4-BE49-F238E27FC236}">
                <a16:creationId xmlns:a16="http://schemas.microsoft.com/office/drawing/2014/main" id="{565E2581-EACF-44D0-9ABD-F317CEAD1054}"/>
              </a:ext>
            </a:extLst>
          </p:cNvPr>
          <p:cNvSpPr>
            <a:spLocks noChangeShapeType="1"/>
          </p:cNvSpPr>
          <p:nvPr/>
        </p:nvSpPr>
        <p:spPr bwMode="auto">
          <a:xfrm>
            <a:off x="4912947" y="1860569"/>
            <a:ext cx="17818" cy="128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19" name="Rectangle 221">
            <a:extLst>
              <a:ext uri="{FF2B5EF4-FFF2-40B4-BE49-F238E27FC236}">
                <a16:creationId xmlns:a16="http://schemas.microsoft.com/office/drawing/2014/main" id="{10445C3D-F374-4D6D-A0DE-666F5127F6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1102" y="1829806"/>
            <a:ext cx="70061" cy="808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40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Freeform 223">
            <a:extLst>
              <a:ext uri="{FF2B5EF4-FFF2-40B4-BE49-F238E27FC236}">
                <a16:creationId xmlns:a16="http://schemas.microsoft.com/office/drawing/2014/main" id="{C6063C24-573D-4DF6-A717-957B043E4247}"/>
              </a:ext>
            </a:extLst>
          </p:cNvPr>
          <p:cNvSpPr>
            <a:spLocks/>
          </p:cNvSpPr>
          <p:nvPr/>
        </p:nvSpPr>
        <p:spPr bwMode="auto">
          <a:xfrm>
            <a:off x="4931260" y="1910689"/>
            <a:ext cx="1695191" cy="634846"/>
          </a:xfrm>
          <a:custGeom>
            <a:avLst/>
            <a:gdLst>
              <a:gd name="T0" fmla="*/ 24 w 6851"/>
              <a:gd name="T1" fmla="*/ 212 h 988"/>
              <a:gd name="T2" fmla="*/ 52 w 6851"/>
              <a:gd name="T3" fmla="*/ 239 h 988"/>
              <a:gd name="T4" fmla="*/ 79 w 6851"/>
              <a:gd name="T5" fmla="*/ 246 h 988"/>
              <a:gd name="T6" fmla="*/ 107 w 6851"/>
              <a:gd name="T7" fmla="*/ 247 h 988"/>
              <a:gd name="T8" fmla="*/ 135 w 6851"/>
              <a:gd name="T9" fmla="*/ 247 h 988"/>
              <a:gd name="T10" fmla="*/ 162 w 6851"/>
              <a:gd name="T11" fmla="*/ 247 h 988"/>
              <a:gd name="T12" fmla="*/ 190 w 6851"/>
              <a:gd name="T13" fmla="*/ 247 h 988"/>
              <a:gd name="T14" fmla="*/ 217 w 6851"/>
              <a:gd name="T15" fmla="*/ 246 h 988"/>
              <a:gd name="T16" fmla="*/ 245 w 6851"/>
              <a:gd name="T17" fmla="*/ 245 h 988"/>
              <a:gd name="T18" fmla="*/ 272 w 6851"/>
              <a:gd name="T19" fmla="*/ 243 h 988"/>
              <a:gd name="T20" fmla="*/ 300 w 6851"/>
              <a:gd name="T21" fmla="*/ 237 h 988"/>
              <a:gd name="T22" fmla="*/ 328 w 6851"/>
              <a:gd name="T23" fmla="*/ 227 h 988"/>
              <a:gd name="T24" fmla="*/ 355 w 6851"/>
              <a:gd name="T25" fmla="*/ 214 h 988"/>
              <a:gd name="T26" fmla="*/ 383 w 6851"/>
              <a:gd name="T27" fmla="*/ 202 h 988"/>
              <a:gd name="T28" fmla="*/ 410 w 6851"/>
              <a:gd name="T29" fmla="*/ 193 h 988"/>
              <a:gd name="T30" fmla="*/ 438 w 6851"/>
              <a:gd name="T31" fmla="*/ 187 h 988"/>
              <a:gd name="T32" fmla="*/ 465 w 6851"/>
              <a:gd name="T33" fmla="*/ 184 h 988"/>
              <a:gd name="T34" fmla="*/ 493 w 6851"/>
              <a:gd name="T35" fmla="*/ 182 h 988"/>
              <a:gd name="T36" fmla="*/ 521 w 6851"/>
              <a:gd name="T37" fmla="*/ 180 h 988"/>
              <a:gd name="T38" fmla="*/ 548 w 6851"/>
              <a:gd name="T39" fmla="*/ 179 h 988"/>
              <a:gd name="T40" fmla="*/ 576 w 6851"/>
              <a:gd name="T41" fmla="*/ 179 h 988"/>
              <a:gd name="T42" fmla="*/ 603 w 6851"/>
              <a:gd name="T43" fmla="*/ 178 h 988"/>
              <a:gd name="T44" fmla="*/ 631 w 6851"/>
              <a:gd name="T45" fmla="*/ 177 h 988"/>
              <a:gd name="T46" fmla="*/ 658 w 6851"/>
              <a:gd name="T47" fmla="*/ 178 h 988"/>
              <a:gd name="T48" fmla="*/ 686 w 6851"/>
              <a:gd name="T49" fmla="*/ 178 h 988"/>
              <a:gd name="T50" fmla="*/ 714 w 6851"/>
              <a:gd name="T51" fmla="*/ 173 h 988"/>
              <a:gd name="T52" fmla="*/ 741 w 6851"/>
              <a:gd name="T53" fmla="*/ 174 h 988"/>
              <a:gd name="T54" fmla="*/ 769 w 6851"/>
              <a:gd name="T55" fmla="*/ 176 h 988"/>
              <a:gd name="T56" fmla="*/ 796 w 6851"/>
              <a:gd name="T57" fmla="*/ 176 h 988"/>
              <a:gd name="T58" fmla="*/ 824 w 6851"/>
              <a:gd name="T59" fmla="*/ 174 h 988"/>
              <a:gd name="T60" fmla="*/ 851 w 6851"/>
              <a:gd name="T61" fmla="*/ 175 h 988"/>
              <a:gd name="T62" fmla="*/ 879 w 6851"/>
              <a:gd name="T63" fmla="*/ 170 h 988"/>
              <a:gd name="T64" fmla="*/ 906 w 6851"/>
              <a:gd name="T65" fmla="*/ 172 h 988"/>
              <a:gd name="T66" fmla="*/ 934 w 6851"/>
              <a:gd name="T67" fmla="*/ 174 h 988"/>
              <a:gd name="T68" fmla="*/ 962 w 6851"/>
              <a:gd name="T69" fmla="*/ 173 h 988"/>
              <a:gd name="T70" fmla="*/ 989 w 6851"/>
              <a:gd name="T71" fmla="*/ 174 h 988"/>
              <a:gd name="T72" fmla="*/ 1017 w 6851"/>
              <a:gd name="T73" fmla="*/ 171 h 988"/>
              <a:gd name="T74" fmla="*/ 1044 w 6851"/>
              <a:gd name="T75" fmla="*/ 169 h 988"/>
              <a:gd name="T76" fmla="*/ 1072 w 6851"/>
              <a:gd name="T77" fmla="*/ 169 h 988"/>
              <a:gd name="T78" fmla="*/ 1099 w 6851"/>
              <a:gd name="T79" fmla="*/ 167 h 988"/>
              <a:gd name="T80" fmla="*/ 1127 w 6851"/>
              <a:gd name="T81" fmla="*/ 167 h 988"/>
              <a:gd name="T82" fmla="*/ 1155 w 6851"/>
              <a:gd name="T83" fmla="*/ 168 h 988"/>
              <a:gd name="T84" fmla="*/ 1182 w 6851"/>
              <a:gd name="T85" fmla="*/ 168 h 988"/>
              <a:gd name="T86" fmla="*/ 1210 w 6851"/>
              <a:gd name="T87" fmla="*/ 166 h 988"/>
              <a:gd name="T88" fmla="*/ 1237 w 6851"/>
              <a:gd name="T89" fmla="*/ 166 h 988"/>
              <a:gd name="T90" fmla="*/ 1265 w 6851"/>
              <a:gd name="T91" fmla="*/ 164 h 988"/>
              <a:gd name="T92" fmla="*/ 1292 w 6851"/>
              <a:gd name="T93" fmla="*/ 158 h 988"/>
              <a:gd name="T94" fmla="*/ 1320 w 6851"/>
              <a:gd name="T95" fmla="*/ 159 h 988"/>
              <a:gd name="T96" fmla="*/ 1348 w 6851"/>
              <a:gd name="T97" fmla="*/ 159 h 988"/>
              <a:gd name="T98" fmla="*/ 1375 w 6851"/>
              <a:gd name="T99" fmla="*/ 158 h 988"/>
              <a:gd name="T100" fmla="*/ 1403 w 6851"/>
              <a:gd name="T101" fmla="*/ 156 h 988"/>
              <a:gd name="T102" fmla="*/ 1430 w 6851"/>
              <a:gd name="T103" fmla="*/ 143 h 988"/>
              <a:gd name="T104" fmla="*/ 1458 w 6851"/>
              <a:gd name="T105" fmla="*/ 144 h 988"/>
              <a:gd name="T106" fmla="*/ 1485 w 6851"/>
              <a:gd name="T107" fmla="*/ 136 h 988"/>
              <a:gd name="T108" fmla="*/ 1513 w 6851"/>
              <a:gd name="T109" fmla="*/ 39 h 988"/>
              <a:gd name="T110" fmla="*/ 1541 w 6851"/>
              <a:gd name="T111" fmla="*/ 95 h 988"/>
              <a:gd name="T112" fmla="*/ 1568 w 6851"/>
              <a:gd name="T113" fmla="*/ 55 h 988"/>
              <a:gd name="T114" fmla="*/ 1596 w 6851"/>
              <a:gd name="T115" fmla="*/ 21 h 988"/>
              <a:gd name="T116" fmla="*/ 1623 w 6851"/>
              <a:gd name="T117" fmla="*/ 69 h 988"/>
              <a:gd name="T118" fmla="*/ 1651 w 6851"/>
              <a:gd name="T119" fmla="*/ 92 h 988"/>
              <a:gd name="T120" fmla="*/ 1678 w 6851"/>
              <a:gd name="T121" fmla="*/ 104 h 988"/>
              <a:gd name="T122" fmla="*/ 1706 w 6851"/>
              <a:gd name="T123" fmla="*/ 112 h 988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  <a:gd name="T165" fmla="*/ 0 60000 65536"/>
              <a:gd name="T166" fmla="*/ 0 60000 65536"/>
              <a:gd name="T167" fmla="*/ 0 60000 65536"/>
              <a:gd name="T168" fmla="*/ 0 60000 65536"/>
              <a:gd name="T169" fmla="*/ 0 60000 65536"/>
              <a:gd name="T170" fmla="*/ 0 60000 65536"/>
              <a:gd name="T171" fmla="*/ 0 60000 65536"/>
              <a:gd name="T172" fmla="*/ 0 60000 65536"/>
              <a:gd name="T173" fmla="*/ 0 60000 65536"/>
              <a:gd name="T174" fmla="*/ 0 60000 65536"/>
              <a:gd name="T175" fmla="*/ 0 60000 65536"/>
              <a:gd name="T176" fmla="*/ 0 60000 65536"/>
              <a:gd name="T177" fmla="*/ 0 60000 65536"/>
              <a:gd name="T178" fmla="*/ 0 60000 65536"/>
              <a:gd name="T179" fmla="*/ 0 60000 65536"/>
              <a:gd name="T180" fmla="*/ 0 60000 65536"/>
              <a:gd name="T181" fmla="*/ 0 60000 65536"/>
              <a:gd name="T182" fmla="*/ 0 60000 65536"/>
              <a:gd name="T183" fmla="*/ 0 60000 65536"/>
              <a:gd name="T184" fmla="*/ 0 60000 65536"/>
              <a:gd name="T185" fmla="*/ 0 60000 65536"/>
            </a:gdLst>
            <a:ahLst/>
            <a:cxnLst>
              <a:cxn ang="T124">
                <a:pos x="T0" y="T1"/>
              </a:cxn>
              <a:cxn ang="T125">
                <a:pos x="T2" y="T3"/>
              </a:cxn>
              <a:cxn ang="T126">
                <a:pos x="T4" y="T5"/>
              </a:cxn>
              <a:cxn ang="T127">
                <a:pos x="T6" y="T7"/>
              </a:cxn>
              <a:cxn ang="T128">
                <a:pos x="T8" y="T9"/>
              </a:cxn>
              <a:cxn ang="T129">
                <a:pos x="T10" y="T11"/>
              </a:cxn>
              <a:cxn ang="T130">
                <a:pos x="T12" y="T13"/>
              </a:cxn>
              <a:cxn ang="T131">
                <a:pos x="T14" y="T15"/>
              </a:cxn>
              <a:cxn ang="T132">
                <a:pos x="T16" y="T17"/>
              </a:cxn>
              <a:cxn ang="T133">
                <a:pos x="T18" y="T19"/>
              </a:cxn>
              <a:cxn ang="T134">
                <a:pos x="T20" y="T21"/>
              </a:cxn>
              <a:cxn ang="T135">
                <a:pos x="T22" y="T23"/>
              </a:cxn>
              <a:cxn ang="T136">
                <a:pos x="T24" y="T25"/>
              </a:cxn>
              <a:cxn ang="T137">
                <a:pos x="T26" y="T27"/>
              </a:cxn>
              <a:cxn ang="T138">
                <a:pos x="T28" y="T29"/>
              </a:cxn>
              <a:cxn ang="T139">
                <a:pos x="T30" y="T31"/>
              </a:cxn>
              <a:cxn ang="T140">
                <a:pos x="T32" y="T33"/>
              </a:cxn>
              <a:cxn ang="T141">
                <a:pos x="T34" y="T35"/>
              </a:cxn>
              <a:cxn ang="T142">
                <a:pos x="T36" y="T37"/>
              </a:cxn>
              <a:cxn ang="T143">
                <a:pos x="T38" y="T39"/>
              </a:cxn>
              <a:cxn ang="T144">
                <a:pos x="T40" y="T41"/>
              </a:cxn>
              <a:cxn ang="T145">
                <a:pos x="T42" y="T43"/>
              </a:cxn>
              <a:cxn ang="T146">
                <a:pos x="T44" y="T45"/>
              </a:cxn>
              <a:cxn ang="T147">
                <a:pos x="T46" y="T47"/>
              </a:cxn>
              <a:cxn ang="T148">
                <a:pos x="T48" y="T49"/>
              </a:cxn>
              <a:cxn ang="T149">
                <a:pos x="T50" y="T51"/>
              </a:cxn>
              <a:cxn ang="T150">
                <a:pos x="T52" y="T53"/>
              </a:cxn>
              <a:cxn ang="T151">
                <a:pos x="T54" y="T55"/>
              </a:cxn>
              <a:cxn ang="T152">
                <a:pos x="T56" y="T57"/>
              </a:cxn>
              <a:cxn ang="T153">
                <a:pos x="T58" y="T59"/>
              </a:cxn>
              <a:cxn ang="T154">
                <a:pos x="T60" y="T61"/>
              </a:cxn>
              <a:cxn ang="T155">
                <a:pos x="T62" y="T63"/>
              </a:cxn>
              <a:cxn ang="T156">
                <a:pos x="T64" y="T65"/>
              </a:cxn>
              <a:cxn ang="T157">
                <a:pos x="T66" y="T67"/>
              </a:cxn>
              <a:cxn ang="T158">
                <a:pos x="T68" y="T69"/>
              </a:cxn>
              <a:cxn ang="T159">
                <a:pos x="T70" y="T71"/>
              </a:cxn>
              <a:cxn ang="T160">
                <a:pos x="T72" y="T73"/>
              </a:cxn>
              <a:cxn ang="T161">
                <a:pos x="T74" y="T75"/>
              </a:cxn>
              <a:cxn ang="T162">
                <a:pos x="T76" y="T77"/>
              </a:cxn>
              <a:cxn ang="T163">
                <a:pos x="T78" y="T79"/>
              </a:cxn>
              <a:cxn ang="T164">
                <a:pos x="T80" y="T81"/>
              </a:cxn>
              <a:cxn ang="T165">
                <a:pos x="T82" y="T83"/>
              </a:cxn>
              <a:cxn ang="T166">
                <a:pos x="T84" y="T85"/>
              </a:cxn>
              <a:cxn ang="T167">
                <a:pos x="T86" y="T87"/>
              </a:cxn>
              <a:cxn ang="T168">
                <a:pos x="T88" y="T89"/>
              </a:cxn>
              <a:cxn ang="T169">
                <a:pos x="T90" y="T91"/>
              </a:cxn>
              <a:cxn ang="T170">
                <a:pos x="T92" y="T93"/>
              </a:cxn>
              <a:cxn ang="T171">
                <a:pos x="T94" y="T95"/>
              </a:cxn>
              <a:cxn ang="T172">
                <a:pos x="T96" y="T97"/>
              </a:cxn>
              <a:cxn ang="T173">
                <a:pos x="T98" y="T99"/>
              </a:cxn>
              <a:cxn ang="T174">
                <a:pos x="T100" y="T101"/>
              </a:cxn>
              <a:cxn ang="T175">
                <a:pos x="T102" y="T103"/>
              </a:cxn>
              <a:cxn ang="T176">
                <a:pos x="T104" y="T105"/>
              </a:cxn>
              <a:cxn ang="T177">
                <a:pos x="T106" y="T107"/>
              </a:cxn>
              <a:cxn ang="T178">
                <a:pos x="T108" y="T109"/>
              </a:cxn>
              <a:cxn ang="T179">
                <a:pos x="T110" y="T111"/>
              </a:cxn>
              <a:cxn ang="T180">
                <a:pos x="T112" y="T113"/>
              </a:cxn>
              <a:cxn ang="T181">
                <a:pos x="T114" y="T115"/>
              </a:cxn>
              <a:cxn ang="T182">
                <a:pos x="T116" y="T117"/>
              </a:cxn>
              <a:cxn ang="T183">
                <a:pos x="T118" y="T119"/>
              </a:cxn>
              <a:cxn ang="T184">
                <a:pos x="T120" y="T121"/>
              </a:cxn>
              <a:cxn ang="T185">
                <a:pos x="T122" y="T123"/>
              </a:cxn>
            </a:cxnLst>
            <a:rect l="0" t="0" r="r" b="b"/>
            <a:pathLst>
              <a:path w="6851" h="988">
                <a:moveTo>
                  <a:pt x="0" y="714"/>
                </a:moveTo>
                <a:lnTo>
                  <a:pt x="2" y="716"/>
                </a:lnTo>
                <a:lnTo>
                  <a:pt x="8" y="723"/>
                </a:lnTo>
                <a:lnTo>
                  <a:pt x="16" y="731"/>
                </a:lnTo>
                <a:lnTo>
                  <a:pt x="23" y="740"/>
                </a:lnTo>
                <a:lnTo>
                  <a:pt x="29" y="750"/>
                </a:lnTo>
                <a:lnTo>
                  <a:pt x="37" y="760"/>
                </a:lnTo>
                <a:lnTo>
                  <a:pt x="43" y="771"/>
                </a:lnTo>
                <a:lnTo>
                  <a:pt x="50" y="781"/>
                </a:lnTo>
                <a:lnTo>
                  <a:pt x="58" y="790"/>
                </a:lnTo>
                <a:lnTo>
                  <a:pt x="64" y="800"/>
                </a:lnTo>
                <a:lnTo>
                  <a:pt x="71" y="810"/>
                </a:lnTo>
                <a:lnTo>
                  <a:pt x="77" y="819"/>
                </a:lnTo>
                <a:lnTo>
                  <a:pt x="85" y="829"/>
                </a:lnTo>
                <a:lnTo>
                  <a:pt x="92" y="838"/>
                </a:lnTo>
                <a:lnTo>
                  <a:pt x="98" y="846"/>
                </a:lnTo>
                <a:lnTo>
                  <a:pt x="106" y="854"/>
                </a:lnTo>
                <a:lnTo>
                  <a:pt x="112" y="863"/>
                </a:lnTo>
                <a:lnTo>
                  <a:pt x="119" y="871"/>
                </a:lnTo>
                <a:lnTo>
                  <a:pt x="127" y="879"/>
                </a:lnTo>
                <a:lnTo>
                  <a:pt x="133" y="886"/>
                </a:lnTo>
                <a:lnTo>
                  <a:pt x="140" y="894"/>
                </a:lnTo>
                <a:lnTo>
                  <a:pt x="146" y="902"/>
                </a:lnTo>
                <a:lnTo>
                  <a:pt x="154" y="909"/>
                </a:lnTo>
                <a:lnTo>
                  <a:pt x="160" y="915"/>
                </a:lnTo>
                <a:lnTo>
                  <a:pt x="167" y="921"/>
                </a:lnTo>
                <a:lnTo>
                  <a:pt x="175" y="929"/>
                </a:lnTo>
                <a:lnTo>
                  <a:pt x="181" y="932"/>
                </a:lnTo>
                <a:lnTo>
                  <a:pt x="188" y="938"/>
                </a:lnTo>
                <a:lnTo>
                  <a:pt x="194" y="944"/>
                </a:lnTo>
                <a:lnTo>
                  <a:pt x="202" y="950"/>
                </a:lnTo>
                <a:lnTo>
                  <a:pt x="210" y="953"/>
                </a:lnTo>
                <a:lnTo>
                  <a:pt x="215" y="957"/>
                </a:lnTo>
                <a:lnTo>
                  <a:pt x="223" y="961"/>
                </a:lnTo>
                <a:lnTo>
                  <a:pt x="229" y="963"/>
                </a:lnTo>
                <a:lnTo>
                  <a:pt x="236" y="967"/>
                </a:lnTo>
                <a:lnTo>
                  <a:pt x="244" y="969"/>
                </a:lnTo>
                <a:lnTo>
                  <a:pt x="250" y="971"/>
                </a:lnTo>
                <a:lnTo>
                  <a:pt x="258" y="973"/>
                </a:lnTo>
                <a:lnTo>
                  <a:pt x="263" y="975"/>
                </a:lnTo>
                <a:lnTo>
                  <a:pt x="271" y="977"/>
                </a:lnTo>
                <a:lnTo>
                  <a:pt x="277" y="978"/>
                </a:lnTo>
                <a:lnTo>
                  <a:pt x="284" y="978"/>
                </a:lnTo>
                <a:lnTo>
                  <a:pt x="292" y="980"/>
                </a:lnTo>
                <a:lnTo>
                  <a:pt x="298" y="980"/>
                </a:lnTo>
                <a:lnTo>
                  <a:pt x="306" y="980"/>
                </a:lnTo>
                <a:lnTo>
                  <a:pt x="311" y="982"/>
                </a:lnTo>
                <a:lnTo>
                  <a:pt x="319" y="982"/>
                </a:lnTo>
                <a:lnTo>
                  <a:pt x="327" y="982"/>
                </a:lnTo>
                <a:lnTo>
                  <a:pt x="332" y="982"/>
                </a:lnTo>
                <a:lnTo>
                  <a:pt x="340" y="982"/>
                </a:lnTo>
                <a:lnTo>
                  <a:pt x="346" y="982"/>
                </a:lnTo>
                <a:lnTo>
                  <a:pt x="354" y="984"/>
                </a:lnTo>
                <a:lnTo>
                  <a:pt x="361" y="984"/>
                </a:lnTo>
                <a:lnTo>
                  <a:pt x="367" y="984"/>
                </a:lnTo>
                <a:lnTo>
                  <a:pt x="375" y="984"/>
                </a:lnTo>
                <a:lnTo>
                  <a:pt x="380" y="984"/>
                </a:lnTo>
                <a:lnTo>
                  <a:pt x="388" y="984"/>
                </a:lnTo>
                <a:lnTo>
                  <a:pt x="394" y="984"/>
                </a:lnTo>
                <a:lnTo>
                  <a:pt x="402" y="984"/>
                </a:lnTo>
                <a:lnTo>
                  <a:pt x="409" y="984"/>
                </a:lnTo>
                <a:lnTo>
                  <a:pt x="415" y="984"/>
                </a:lnTo>
                <a:lnTo>
                  <a:pt x="423" y="984"/>
                </a:lnTo>
                <a:lnTo>
                  <a:pt x="429" y="986"/>
                </a:lnTo>
                <a:lnTo>
                  <a:pt x="436" y="986"/>
                </a:lnTo>
                <a:lnTo>
                  <a:pt x="444" y="986"/>
                </a:lnTo>
                <a:lnTo>
                  <a:pt x="450" y="986"/>
                </a:lnTo>
                <a:lnTo>
                  <a:pt x="457" y="986"/>
                </a:lnTo>
                <a:lnTo>
                  <a:pt x="463" y="986"/>
                </a:lnTo>
                <a:lnTo>
                  <a:pt x="471" y="986"/>
                </a:lnTo>
                <a:lnTo>
                  <a:pt x="478" y="986"/>
                </a:lnTo>
                <a:lnTo>
                  <a:pt x="484" y="986"/>
                </a:lnTo>
                <a:lnTo>
                  <a:pt x="492" y="986"/>
                </a:lnTo>
                <a:lnTo>
                  <a:pt x="498" y="986"/>
                </a:lnTo>
                <a:lnTo>
                  <a:pt x="505" y="986"/>
                </a:lnTo>
                <a:lnTo>
                  <a:pt x="513" y="986"/>
                </a:lnTo>
                <a:lnTo>
                  <a:pt x="519" y="986"/>
                </a:lnTo>
                <a:lnTo>
                  <a:pt x="526" y="986"/>
                </a:lnTo>
                <a:lnTo>
                  <a:pt x="532" y="986"/>
                </a:lnTo>
                <a:lnTo>
                  <a:pt x="540" y="986"/>
                </a:lnTo>
                <a:lnTo>
                  <a:pt x="546" y="986"/>
                </a:lnTo>
                <a:lnTo>
                  <a:pt x="553" y="986"/>
                </a:lnTo>
                <a:lnTo>
                  <a:pt x="561" y="986"/>
                </a:lnTo>
                <a:lnTo>
                  <a:pt x="567" y="986"/>
                </a:lnTo>
                <a:lnTo>
                  <a:pt x="574" y="986"/>
                </a:lnTo>
                <a:lnTo>
                  <a:pt x="580" y="986"/>
                </a:lnTo>
                <a:lnTo>
                  <a:pt x="588" y="986"/>
                </a:lnTo>
                <a:lnTo>
                  <a:pt x="596" y="986"/>
                </a:lnTo>
                <a:lnTo>
                  <a:pt x="601" y="986"/>
                </a:lnTo>
                <a:lnTo>
                  <a:pt x="609" y="986"/>
                </a:lnTo>
                <a:lnTo>
                  <a:pt x="615" y="986"/>
                </a:lnTo>
                <a:lnTo>
                  <a:pt x="622" y="986"/>
                </a:lnTo>
                <a:lnTo>
                  <a:pt x="630" y="986"/>
                </a:lnTo>
                <a:lnTo>
                  <a:pt x="636" y="986"/>
                </a:lnTo>
                <a:lnTo>
                  <a:pt x="644" y="986"/>
                </a:lnTo>
                <a:lnTo>
                  <a:pt x="649" y="986"/>
                </a:lnTo>
                <a:lnTo>
                  <a:pt x="657" y="986"/>
                </a:lnTo>
                <a:lnTo>
                  <a:pt x="663" y="986"/>
                </a:lnTo>
                <a:lnTo>
                  <a:pt x="670" y="986"/>
                </a:lnTo>
                <a:lnTo>
                  <a:pt x="678" y="986"/>
                </a:lnTo>
                <a:lnTo>
                  <a:pt x="684" y="986"/>
                </a:lnTo>
                <a:lnTo>
                  <a:pt x="692" y="986"/>
                </a:lnTo>
                <a:lnTo>
                  <a:pt x="697" y="986"/>
                </a:lnTo>
                <a:lnTo>
                  <a:pt x="705" y="986"/>
                </a:lnTo>
                <a:lnTo>
                  <a:pt x="713" y="986"/>
                </a:lnTo>
                <a:lnTo>
                  <a:pt x="718" y="988"/>
                </a:lnTo>
                <a:lnTo>
                  <a:pt x="726" y="986"/>
                </a:lnTo>
                <a:lnTo>
                  <a:pt x="732" y="988"/>
                </a:lnTo>
                <a:lnTo>
                  <a:pt x="740" y="986"/>
                </a:lnTo>
                <a:lnTo>
                  <a:pt x="747" y="986"/>
                </a:lnTo>
                <a:lnTo>
                  <a:pt x="753" y="986"/>
                </a:lnTo>
                <a:lnTo>
                  <a:pt x="761" y="986"/>
                </a:lnTo>
                <a:lnTo>
                  <a:pt x="766" y="986"/>
                </a:lnTo>
                <a:lnTo>
                  <a:pt x="774" y="986"/>
                </a:lnTo>
                <a:lnTo>
                  <a:pt x="782" y="986"/>
                </a:lnTo>
                <a:lnTo>
                  <a:pt x="788" y="986"/>
                </a:lnTo>
                <a:lnTo>
                  <a:pt x="795" y="986"/>
                </a:lnTo>
                <a:lnTo>
                  <a:pt x="801" y="986"/>
                </a:lnTo>
                <a:lnTo>
                  <a:pt x="809" y="986"/>
                </a:lnTo>
                <a:lnTo>
                  <a:pt x="814" y="986"/>
                </a:lnTo>
                <a:lnTo>
                  <a:pt x="822" y="986"/>
                </a:lnTo>
                <a:lnTo>
                  <a:pt x="830" y="986"/>
                </a:lnTo>
                <a:lnTo>
                  <a:pt x="836" y="986"/>
                </a:lnTo>
                <a:lnTo>
                  <a:pt x="843" y="986"/>
                </a:lnTo>
                <a:lnTo>
                  <a:pt x="849" y="986"/>
                </a:lnTo>
                <a:lnTo>
                  <a:pt x="857" y="984"/>
                </a:lnTo>
                <a:lnTo>
                  <a:pt x="864" y="986"/>
                </a:lnTo>
                <a:lnTo>
                  <a:pt x="870" y="984"/>
                </a:lnTo>
                <a:lnTo>
                  <a:pt x="878" y="984"/>
                </a:lnTo>
                <a:lnTo>
                  <a:pt x="884" y="984"/>
                </a:lnTo>
                <a:lnTo>
                  <a:pt x="891" y="984"/>
                </a:lnTo>
                <a:lnTo>
                  <a:pt x="899" y="984"/>
                </a:lnTo>
                <a:lnTo>
                  <a:pt x="905" y="984"/>
                </a:lnTo>
                <a:lnTo>
                  <a:pt x="912" y="984"/>
                </a:lnTo>
                <a:lnTo>
                  <a:pt x="918" y="984"/>
                </a:lnTo>
                <a:lnTo>
                  <a:pt x="926" y="984"/>
                </a:lnTo>
                <a:lnTo>
                  <a:pt x="932" y="984"/>
                </a:lnTo>
                <a:lnTo>
                  <a:pt x="939" y="982"/>
                </a:lnTo>
                <a:lnTo>
                  <a:pt x="947" y="982"/>
                </a:lnTo>
                <a:lnTo>
                  <a:pt x="953" y="982"/>
                </a:lnTo>
                <a:lnTo>
                  <a:pt x="960" y="982"/>
                </a:lnTo>
                <a:lnTo>
                  <a:pt x="966" y="982"/>
                </a:lnTo>
                <a:lnTo>
                  <a:pt x="974" y="982"/>
                </a:lnTo>
                <a:lnTo>
                  <a:pt x="981" y="980"/>
                </a:lnTo>
                <a:lnTo>
                  <a:pt x="987" y="980"/>
                </a:lnTo>
                <a:lnTo>
                  <a:pt x="995" y="980"/>
                </a:lnTo>
                <a:lnTo>
                  <a:pt x="1001" y="978"/>
                </a:lnTo>
                <a:lnTo>
                  <a:pt x="1008" y="978"/>
                </a:lnTo>
                <a:lnTo>
                  <a:pt x="1016" y="978"/>
                </a:lnTo>
                <a:lnTo>
                  <a:pt x="1022" y="977"/>
                </a:lnTo>
                <a:lnTo>
                  <a:pt x="1029" y="977"/>
                </a:lnTo>
                <a:lnTo>
                  <a:pt x="1035" y="977"/>
                </a:lnTo>
                <a:lnTo>
                  <a:pt x="1043" y="975"/>
                </a:lnTo>
                <a:lnTo>
                  <a:pt x="1049" y="975"/>
                </a:lnTo>
                <a:lnTo>
                  <a:pt x="1056" y="973"/>
                </a:lnTo>
                <a:lnTo>
                  <a:pt x="1064" y="973"/>
                </a:lnTo>
                <a:lnTo>
                  <a:pt x="1070" y="971"/>
                </a:lnTo>
                <a:lnTo>
                  <a:pt x="1078" y="971"/>
                </a:lnTo>
                <a:lnTo>
                  <a:pt x="1083" y="969"/>
                </a:lnTo>
                <a:lnTo>
                  <a:pt x="1091" y="969"/>
                </a:lnTo>
                <a:lnTo>
                  <a:pt x="1099" y="969"/>
                </a:lnTo>
                <a:lnTo>
                  <a:pt x="1104" y="967"/>
                </a:lnTo>
                <a:lnTo>
                  <a:pt x="1112" y="967"/>
                </a:lnTo>
                <a:lnTo>
                  <a:pt x="1118" y="965"/>
                </a:lnTo>
                <a:lnTo>
                  <a:pt x="1126" y="963"/>
                </a:lnTo>
                <a:lnTo>
                  <a:pt x="1133" y="963"/>
                </a:lnTo>
                <a:lnTo>
                  <a:pt x="1139" y="961"/>
                </a:lnTo>
                <a:lnTo>
                  <a:pt x="1147" y="959"/>
                </a:lnTo>
                <a:lnTo>
                  <a:pt x="1152" y="959"/>
                </a:lnTo>
                <a:lnTo>
                  <a:pt x="1160" y="957"/>
                </a:lnTo>
                <a:lnTo>
                  <a:pt x="1168" y="955"/>
                </a:lnTo>
                <a:lnTo>
                  <a:pt x="1174" y="953"/>
                </a:lnTo>
                <a:lnTo>
                  <a:pt x="1181" y="952"/>
                </a:lnTo>
                <a:lnTo>
                  <a:pt x="1187" y="950"/>
                </a:lnTo>
                <a:lnTo>
                  <a:pt x="1195" y="950"/>
                </a:lnTo>
                <a:lnTo>
                  <a:pt x="1200" y="948"/>
                </a:lnTo>
                <a:lnTo>
                  <a:pt x="1208" y="946"/>
                </a:lnTo>
                <a:lnTo>
                  <a:pt x="1216" y="942"/>
                </a:lnTo>
                <a:lnTo>
                  <a:pt x="1222" y="940"/>
                </a:lnTo>
                <a:lnTo>
                  <a:pt x="1229" y="938"/>
                </a:lnTo>
                <a:lnTo>
                  <a:pt x="1235" y="936"/>
                </a:lnTo>
                <a:lnTo>
                  <a:pt x="1243" y="934"/>
                </a:lnTo>
                <a:lnTo>
                  <a:pt x="1250" y="930"/>
                </a:lnTo>
                <a:lnTo>
                  <a:pt x="1256" y="929"/>
                </a:lnTo>
                <a:lnTo>
                  <a:pt x="1264" y="927"/>
                </a:lnTo>
                <a:lnTo>
                  <a:pt x="1270" y="923"/>
                </a:lnTo>
                <a:lnTo>
                  <a:pt x="1277" y="921"/>
                </a:lnTo>
                <a:lnTo>
                  <a:pt x="1285" y="919"/>
                </a:lnTo>
                <a:lnTo>
                  <a:pt x="1291" y="915"/>
                </a:lnTo>
                <a:lnTo>
                  <a:pt x="1298" y="913"/>
                </a:lnTo>
                <a:lnTo>
                  <a:pt x="1304" y="909"/>
                </a:lnTo>
                <a:lnTo>
                  <a:pt x="1312" y="907"/>
                </a:lnTo>
                <a:lnTo>
                  <a:pt x="1318" y="904"/>
                </a:lnTo>
                <a:lnTo>
                  <a:pt x="1325" y="902"/>
                </a:lnTo>
                <a:lnTo>
                  <a:pt x="1333" y="898"/>
                </a:lnTo>
                <a:lnTo>
                  <a:pt x="1339" y="894"/>
                </a:lnTo>
                <a:lnTo>
                  <a:pt x="1346" y="892"/>
                </a:lnTo>
                <a:lnTo>
                  <a:pt x="1352" y="888"/>
                </a:lnTo>
                <a:lnTo>
                  <a:pt x="1360" y="884"/>
                </a:lnTo>
                <a:lnTo>
                  <a:pt x="1367" y="882"/>
                </a:lnTo>
                <a:lnTo>
                  <a:pt x="1373" y="879"/>
                </a:lnTo>
                <a:lnTo>
                  <a:pt x="1381" y="875"/>
                </a:lnTo>
                <a:lnTo>
                  <a:pt x="1387" y="871"/>
                </a:lnTo>
                <a:lnTo>
                  <a:pt x="1394" y="869"/>
                </a:lnTo>
                <a:lnTo>
                  <a:pt x="1402" y="865"/>
                </a:lnTo>
                <a:lnTo>
                  <a:pt x="1408" y="861"/>
                </a:lnTo>
                <a:lnTo>
                  <a:pt x="1415" y="859"/>
                </a:lnTo>
                <a:lnTo>
                  <a:pt x="1421" y="856"/>
                </a:lnTo>
                <a:lnTo>
                  <a:pt x="1429" y="852"/>
                </a:lnTo>
                <a:lnTo>
                  <a:pt x="1435" y="848"/>
                </a:lnTo>
                <a:lnTo>
                  <a:pt x="1442" y="844"/>
                </a:lnTo>
                <a:lnTo>
                  <a:pt x="1450" y="842"/>
                </a:lnTo>
                <a:lnTo>
                  <a:pt x="1456" y="838"/>
                </a:lnTo>
                <a:lnTo>
                  <a:pt x="1463" y="836"/>
                </a:lnTo>
                <a:lnTo>
                  <a:pt x="1469" y="833"/>
                </a:lnTo>
                <a:lnTo>
                  <a:pt x="1477" y="829"/>
                </a:lnTo>
                <a:lnTo>
                  <a:pt x="1485" y="827"/>
                </a:lnTo>
                <a:lnTo>
                  <a:pt x="1490" y="823"/>
                </a:lnTo>
                <a:lnTo>
                  <a:pt x="1498" y="819"/>
                </a:lnTo>
                <a:lnTo>
                  <a:pt x="1504" y="817"/>
                </a:lnTo>
                <a:lnTo>
                  <a:pt x="1511" y="813"/>
                </a:lnTo>
                <a:lnTo>
                  <a:pt x="1519" y="811"/>
                </a:lnTo>
                <a:lnTo>
                  <a:pt x="1525" y="808"/>
                </a:lnTo>
                <a:lnTo>
                  <a:pt x="1533" y="806"/>
                </a:lnTo>
                <a:lnTo>
                  <a:pt x="1538" y="802"/>
                </a:lnTo>
                <a:lnTo>
                  <a:pt x="1546" y="800"/>
                </a:lnTo>
                <a:lnTo>
                  <a:pt x="1554" y="798"/>
                </a:lnTo>
                <a:lnTo>
                  <a:pt x="1559" y="794"/>
                </a:lnTo>
                <a:lnTo>
                  <a:pt x="1567" y="792"/>
                </a:lnTo>
                <a:lnTo>
                  <a:pt x="1573" y="788"/>
                </a:lnTo>
                <a:lnTo>
                  <a:pt x="1581" y="787"/>
                </a:lnTo>
                <a:lnTo>
                  <a:pt x="1586" y="785"/>
                </a:lnTo>
                <a:lnTo>
                  <a:pt x="1594" y="783"/>
                </a:lnTo>
                <a:lnTo>
                  <a:pt x="1602" y="781"/>
                </a:lnTo>
                <a:lnTo>
                  <a:pt x="1607" y="779"/>
                </a:lnTo>
                <a:lnTo>
                  <a:pt x="1615" y="775"/>
                </a:lnTo>
                <a:lnTo>
                  <a:pt x="1621" y="773"/>
                </a:lnTo>
                <a:lnTo>
                  <a:pt x="1629" y="771"/>
                </a:lnTo>
                <a:lnTo>
                  <a:pt x="1636" y="771"/>
                </a:lnTo>
                <a:lnTo>
                  <a:pt x="1642" y="769"/>
                </a:lnTo>
                <a:lnTo>
                  <a:pt x="1650" y="767"/>
                </a:lnTo>
                <a:lnTo>
                  <a:pt x="1655" y="765"/>
                </a:lnTo>
                <a:lnTo>
                  <a:pt x="1663" y="765"/>
                </a:lnTo>
                <a:lnTo>
                  <a:pt x="1671" y="764"/>
                </a:lnTo>
                <a:lnTo>
                  <a:pt x="1677" y="762"/>
                </a:lnTo>
                <a:lnTo>
                  <a:pt x="1684" y="760"/>
                </a:lnTo>
                <a:lnTo>
                  <a:pt x="1690" y="760"/>
                </a:lnTo>
                <a:lnTo>
                  <a:pt x="1698" y="758"/>
                </a:lnTo>
                <a:lnTo>
                  <a:pt x="1703" y="756"/>
                </a:lnTo>
                <a:lnTo>
                  <a:pt x="1711" y="756"/>
                </a:lnTo>
                <a:lnTo>
                  <a:pt x="1719" y="754"/>
                </a:lnTo>
                <a:lnTo>
                  <a:pt x="1725" y="754"/>
                </a:lnTo>
                <a:lnTo>
                  <a:pt x="1732" y="752"/>
                </a:lnTo>
                <a:lnTo>
                  <a:pt x="1738" y="750"/>
                </a:lnTo>
                <a:lnTo>
                  <a:pt x="1746" y="750"/>
                </a:lnTo>
                <a:lnTo>
                  <a:pt x="1753" y="748"/>
                </a:lnTo>
                <a:lnTo>
                  <a:pt x="1759" y="746"/>
                </a:lnTo>
                <a:lnTo>
                  <a:pt x="1767" y="746"/>
                </a:lnTo>
                <a:lnTo>
                  <a:pt x="1773" y="744"/>
                </a:lnTo>
                <a:lnTo>
                  <a:pt x="1780" y="744"/>
                </a:lnTo>
                <a:lnTo>
                  <a:pt x="1788" y="742"/>
                </a:lnTo>
                <a:lnTo>
                  <a:pt x="1794" y="742"/>
                </a:lnTo>
                <a:lnTo>
                  <a:pt x="1801" y="740"/>
                </a:lnTo>
                <a:lnTo>
                  <a:pt x="1807" y="740"/>
                </a:lnTo>
                <a:lnTo>
                  <a:pt x="1815" y="740"/>
                </a:lnTo>
                <a:lnTo>
                  <a:pt x="1823" y="739"/>
                </a:lnTo>
                <a:lnTo>
                  <a:pt x="1828" y="739"/>
                </a:lnTo>
                <a:lnTo>
                  <a:pt x="1836" y="737"/>
                </a:lnTo>
                <a:lnTo>
                  <a:pt x="1842" y="737"/>
                </a:lnTo>
                <a:lnTo>
                  <a:pt x="1849" y="735"/>
                </a:lnTo>
                <a:lnTo>
                  <a:pt x="1855" y="735"/>
                </a:lnTo>
                <a:lnTo>
                  <a:pt x="1863" y="735"/>
                </a:lnTo>
                <a:lnTo>
                  <a:pt x="1871" y="735"/>
                </a:lnTo>
                <a:lnTo>
                  <a:pt x="1876" y="735"/>
                </a:lnTo>
                <a:lnTo>
                  <a:pt x="1884" y="733"/>
                </a:lnTo>
                <a:lnTo>
                  <a:pt x="1890" y="733"/>
                </a:lnTo>
                <a:lnTo>
                  <a:pt x="1897" y="733"/>
                </a:lnTo>
                <a:lnTo>
                  <a:pt x="1905" y="731"/>
                </a:lnTo>
                <a:lnTo>
                  <a:pt x="1911" y="731"/>
                </a:lnTo>
                <a:lnTo>
                  <a:pt x="1919" y="731"/>
                </a:lnTo>
                <a:lnTo>
                  <a:pt x="1924" y="731"/>
                </a:lnTo>
                <a:lnTo>
                  <a:pt x="1932" y="731"/>
                </a:lnTo>
                <a:lnTo>
                  <a:pt x="1940" y="729"/>
                </a:lnTo>
                <a:lnTo>
                  <a:pt x="1945" y="729"/>
                </a:lnTo>
                <a:lnTo>
                  <a:pt x="1953" y="729"/>
                </a:lnTo>
                <a:lnTo>
                  <a:pt x="1959" y="729"/>
                </a:lnTo>
                <a:lnTo>
                  <a:pt x="1967" y="727"/>
                </a:lnTo>
                <a:lnTo>
                  <a:pt x="1972" y="727"/>
                </a:lnTo>
                <a:lnTo>
                  <a:pt x="1980" y="727"/>
                </a:lnTo>
                <a:lnTo>
                  <a:pt x="1988" y="727"/>
                </a:lnTo>
                <a:lnTo>
                  <a:pt x="1993" y="725"/>
                </a:lnTo>
                <a:lnTo>
                  <a:pt x="2001" y="725"/>
                </a:lnTo>
                <a:lnTo>
                  <a:pt x="2007" y="725"/>
                </a:lnTo>
                <a:lnTo>
                  <a:pt x="2015" y="725"/>
                </a:lnTo>
                <a:lnTo>
                  <a:pt x="2022" y="725"/>
                </a:lnTo>
                <a:lnTo>
                  <a:pt x="2028" y="723"/>
                </a:lnTo>
                <a:lnTo>
                  <a:pt x="2036" y="723"/>
                </a:lnTo>
                <a:lnTo>
                  <a:pt x="2041" y="723"/>
                </a:lnTo>
                <a:lnTo>
                  <a:pt x="2049" y="723"/>
                </a:lnTo>
                <a:lnTo>
                  <a:pt x="2057" y="723"/>
                </a:lnTo>
                <a:lnTo>
                  <a:pt x="2063" y="721"/>
                </a:lnTo>
                <a:lnTo>
                  <a:pt x="2070" y="721"/>
                </a:lnTo>
                <a:lnTo>
                  <a:pt x="2076" y="719"/>
                </a:lnTo>
                <a:lnTo>
                  <a:pt x="2084" y="719"/>
                </a:lnTo>
                <a:lnTo>
                  <a:pt x="2089" y="717"/>
                </a:lnTo>
                <a:lnTo>
                  <a:pt x="2097" y="716"/>
                </a:lnTo>
                <a:lnTo>
                  <a:pt x="2105" y="714"/>
                </a:lnTo>
                <a:lnTo>
                  <a:pt x="2111" y="712"/>
                </a:lnTo>
                <a:lnTo>
                  <a:pt x="2118" y="710"/>
                </a:lnTo>
                <a:lnTo>
                  <a:pt x="2124" y="710"/>
                </a:lnTo>
                <a:lnTo>
                  <a:pt x="2132" y="710"/>
                </a:lnTo>
                <a:lnTo>
                  <a:pt x="2139" y="712"/>
                </a:lnTo>
                <a:lnTo>
                  <a:pt x="2145" y="712"/>
                </a:lnTo>
                <a:lnTo>
                  <a:pt x="2153" y="714"/>
                </a:lnTo>
                <a:lnTo>
                  <a:pt x="2159" y="714"/>
                </a:lnTo>
                <a:lnTo>
                  <a:pt x="2166" y="714"/>
                </a:lnTo>
                <a:lnTo>
                  <a:pt x="2174" y="714"/>
                </a:lnTo>
                <a:lnTo>
                  <a:pt x="2180" y="716"/>
                </a:lnTo>
                <a:lnTo>
                  <a:pt x="2187" y="716"/>
                </a:lnTo>
                <a:lnTo>
                  <a:pt x="2193" y="716"/>
                </a:lnTo>
                <a:lnTo>
                  <a:pt x="2201" y="716"/>
                </a:lnTo>
                <a:lnTo>
                  <a:pt x="2208" y="716"/>
                </a:lnTo>
                <a:lnTo>
                  <a:pt x="2214" y="716"/>
                </a:lnTo>
                <a:lnTo>
                  <a:pt x="2222" y="716"/>
                </a:lnTo>
                <a:lnTo>
                  <a:pt x="2228" y="716"/>
                </a:lnTo>
                <a:lnTo>
                  <a:pt x="2235" y="716"/>
                </a:lnTo>
                <a:lnTo>
                  <a:pt x="2241" y="716"/>
                </a:lnTo>
                <a:lnTo>
                  <a:pt x="2249" y="716"/>
                </a:lnTo>
                <a:lnTo>
                  <a:pt x="2256" y="716"/>
                </a:lnTo>
                <a:lnTo>
                  <a:pt x="2262" y="716"/>
                </a:lnTo>
                <a:lnTo>
                  <a:pt x="2270" y="716"/>
                </a:lnTo>
                <a:lnTo>
                  <a:pt x="2276" y="716"/>
                </a:lnTo>
                <a:lnTo>
                  <a:pt x="2283" y="714"/>
                </a:lnTo>
                <a:lnTo>
                  <a:pt x="2291" y="714"/>
                </a:lnTo>
                <a:lnTo>
                  <a:pt x="2297" y="714"/>
                </a:lnTo>
                <a:lnTo>
                  <a:pt x="2304" y="714"/>
                </a:lnTo>
                <a:lnTo>
                  <a:pt x="2310" y="714"/>
                </a:lnTo>
                <a:lnTo>
                  <a:pt x="2318" y="714"/>
                </a:lnTo>
                <a:lnTo>
                  <a:pt x="2326" y="714"/>
                </a:lnTo>
                <a:lnTo>
                  <a:pt x="2331" y="714"/>
                </a:lnTo>
                <a:lnTo>
                  <a:pt x="2339" y="712"/>
                </a:lnTo>
                <a:lnTo>
                  <a:pt x="2345" y="714"/>
                </a:lnTo>
                <a:lnTo>
                  <a:pt x="2352" y="714"/>
                </a:lnTo>
                <a:lnTo>
                  <a:pt x="2358" y="712"/>
                </a:lnTo>
                <a:lnTo>
                  <a:pt x="2366" y="712"/>
                </a:lnTo>
                <a:lnTo>
                  <a:pt x="2374" y="712"/>
                </a:lnTo>
                <a:lnTo>
                  <a:pt x="2379" y="712"/>
                </a:lnTo>
                <a:lnTo>
                  <a:pt x="2387" y="712"/>
                </a:lnTo>
                <a:lnTo>
                  <a:pt x="2393" y="712"/>
                </a:lnTo>
                <a:lnTo>
                  <a:pt x="2400" y="712"/>
                </a:lnTo>
                <a:lnTo>
                  <a:pt x="2408" y="710"/>
                </a:lnTo>
                <a:lnTo>
                  <a:pt x="2414" y="710"/>
                </a:lnTo>
                <a:lnTo>
                  <a:pt x="2422" y="708"/>
                </a:lnTo>
                <a:lnTo>
                  <a:pt x="2427" y="708"/>
                </a:lnTo>
                <a:lnTo>
                  <a:pt x="2435" y="708"/>
                </a:lnTo>
                <a:lnTo>
                  <a:pt x="2443" y="708"/>
                </a:lnTo>
                <a:lnTo>
                  <a:pt x="2448" y="706"/>
                </a:lnTo>
                <a:lnTo>
                  <a:pt x="2456" y="706"/>
                </a:lnTo>
                <a:lnTo>
                  <a:pt x="2462" y="704"/>
                </a:lnTo>
                <a:lnTo>
                  <a:pt x="2470" y="704"/>
                </a:lnTo>
                <a:lnTo>
                  <a:pt x="2477" y="704"/>
                </a:lnTo>
                <a:lnTo>
                  <a:pt x="2483" y="704"/>
                </a:lnTo>
                <a:lnTo>
                  <a:pt x="2491" y="704"/>
                </a:lnTo>
                <a:lnTo>
                  <a:pt x="2496" y="704"/>
                </a:lnTo>
                <a:lnTo>
                  <a:pt x="2504" y="704"/>
                </a:lnTo>
                <a:lnTo>
                  <a:pt x="2510" y="704"/>
                </a:lnTo>
                <a:lnTo>
                  <a:pt x="2518" y="704"/>
                </a:lnTo>
                <a:lnTo>
                  <a:pt x="2525" y="706"/>
                </a:lnTo>
                <a:lnTo>
                  <a:pt x="2531" y="706"/>
                </a:lnTo>
                <a:lnTo>
                  <a:pt x="2539" y="706"/>
                </a:lnTo>
                <a:lnTo>
                  <a:pt x="2544" y="708"/>
                </a:lnTo>
                <a:lnTo>
                  <a:pt x="2552" y="708"/>
                </a:lnTo>
                <a:lnTo>
                  <a:pt x="2560" y="708"/>
                </a:lnTo>
                <a:lnTo>
                  <a:pt x="2566" y="710"/>
                </a:lnTo>
                <a:lnTo>
                  <a:pt x="2573" y="710"/>
                </a:lnTo>
                <a:lnTo>
                  <a:pt x="2579" y="710"/>
                </a:lnTo>
                <a:lnTo>
                  <a:pt x="2587" y="710"/>
                </a:lnTo>
                <a:lnTo>
                  <a:pt x="2594" y="710"/>
                </a:lnTo>
                <a:lnTo>
                  <a:pt x="2600" y="710"/>
                </a:lnTo>
                <a:lnTo>
                  <a:pt x="2608" y="712"/>
                </a:lnTo>
                <a:lnTo>
                  <a:pt x="2614" y="712"/>
                </a:lnTo>
                <a:lnTo>
                  <a:pt x="2621" y="712"/>
                </a:lnTo>
                <a:lnTo>
                  <a:pt x="2627" y="712"/>
                </a:lnTo>
                <a:lnTo>
                  <a:pt x="2635" y="710"/>
                </a:lnTo>
                <a:lnTo>
                  <a:pt x="2642" y="712"/>
                </a:lnTo>
                <a:lnTo>
                  <a:pt x="2648" y="712"/>
                </a:lnTo>
                <a:lnTo>
                  <a:pt x="2656" y="712"/>
                </a:lnTo>
                <a:lnTo>
                  <a:pt x="2662" y="712"/>
                </a:lnTo>
                <a:lnTo>
                  <a:pt x="2669" y="712"/>
                </a:lnTo>
                <a:lnTo>
                  <a:pt x="2677" y="712"/>
                </a:lnTo>
                <a:lnTo>
                  <a:pt x="2683" y="712"/>
                </a:lnTo>
                <a:lnTo>
                  <a:pt x="2690" y="712"/>
                </a:lnTo>
                <a:lnTo>
                  <a:pt x="2696" y="712"/>
                </a:lnTo>
                <a:lnTo>
                  <a:pt x="2704" y="712"/>
                </a:lnTo>
                <a:lnTo>
                  <a:pt x="2712" y="712"/>
                </a:lnTo>
                <a:lnTo>
                  <a:pt x="2717" y="712"/>
                </a:lnTo>
                <a:lnTo>
                  <a:pt x="2725" y="712"/>
                </a:lnTo>
                <a:lnTo>
                  <a:pt x="2731" y="712"/>
                </a:lnTo>
                <a:lnTo>
                  <a:pt x="2738" y="712"/>
                </a:lnTo>
                <a:lnTo>
                  <a:pt x="2744" y="712"/>
                </a:lnTo>
                <a:lnTo>
                  <a:pt x="2752" y="712"/>
                </a:lnTo>
                <a:lnTo>
                  <a:pt x="2760" y="712"/>
                </a:lnTo>
                <a:lnTo>
                  <a:pt x="2765" y="710"/>
                </a:lnTo>
                <a:lnTo>
                  <a:pt x="2773" y="710"/>
                </a:lnTo>
                <a:lnTo>
                  <a:pt x="2779" y="708"/>
                </a:lnTo>
                <a:lnTo>
                  <a:pt x="2786" y="708"/>
                </a:lnTo>
                <a:lnTo>
                  <a:pt x="2794" y="706"/>
                </a:lnTo>
                <a:lnTo>
                  <a:pt x="2800" y="704"/>
                </a:lnTo>
                <a:lnTo>
                  <a:pt x="2808" y="704"/>
                </a:lnTo>
                <a:lnTo>
                  <a:pt x="2813" y="702"/>
                </a:lnTo>
                <a:lnTo>
                  <a:pt x="2821" y="700"/>
                </a:lnTo>
                <a:lnTo>
                  <a:pt x="2829" y="698"/>
                </a:lnTo>
                <a:lnTo>
                  <a:pt x="2834" y="696"/>
                </a:lnTo>
                <a:lnTo>
                  <a:pt x="2842" y="694"/>
                </a:lnTo>
                <a:lnTo>
                  <a:pt x="2848" y="693"/>
                </a:lnTo>
                <a:lnTo>
                  <a:pt x="2856" y="691"/>
                </a:lnTo>
                <a:lnTo>
                  <a:pt x="2863" y="693"/>
                </a:lnTo>
                <a:lnTo>
                  <a:pt x="2869" y="693"/>
                </a:lnTo>
                <a:lnTo>
                  <a:pt x="2877" y="694"/>
                </a:lnTo>
                <a:lnTo>
                  <a:pt x="2882" y="698"/>
                </a:lnTo>
                <a:lnTo>
                  <a:pt x="2890" y="698"/>
                </a:lnTo>
                <a:lnTo>
                  <a:pt x="2896" y="700"/>
                </a:lnTo>
                <a:lnTo>
                  <a:pt x="2904" y="700"/>
                </a:lnTo>
                <a:lnTo>
                  <a:pt x="2911" y="700"/>
                </a:lnTo>
                <a:lnTo>
                  <a:pt x="2917" y="700"/>
                </a:lnTo>
                <a:lnTo>
                  <a:pt x="2925" y="698"/>
                </a:lnTo>
                <a:lnTo>
                  <a:pt x="2930" y="696"/>
                </a:lnTo>
                <a:lnTo>
                  <a:pt x="2938" y="694"/>
                </a:lnTo>
                <a:lnTo>
                  <a:pt x="2946" y="694"/>
                </a:lnTo>
                <a:lnTo>
                  <a:pt x="2952" y="693"/>
                </a:lnTo>
                <a:lnTo>
                  <a:pt x="2959" y="694"/>
                </a:lnTo>
                <a:lnTo>
                  <a:pt x="2965" y="694"/>
                </a:lnTo>
                <a:lnTo>
                  <a:pt x="2973" y="694"/>
                </a:lnTo>
                <a:lnTo>
                  <a:pt x="2980" y="694"/>
                </a:lnTo>
                <a:lnTo>
                  <a:pt x="2986" y="693"/>
                </a:lnTo>
                <a:lnTo>
                  <a:pt x="2994" y="689"/>
                </a:lnTo>
                <a:lnTo>
                  <a:pt x="3000" y="687"/>
                </a:lnTo>
                <a:lnTo>
                  <a:pt x="3007" y="685"/>
                </a:lnTo>
                <a:lnTo>
                  <a:pt x="3013" y="685"/>
                </a:lnTo>
                <a:lnTo>
                  <a:pt x="3021" y="687"/>
                </a:lnTo>
                <a:lnTo>
                  <a:pt x="3028" y="691"/>
                </a:lnTo>
                <a:lnTo>
                  <a:pt x="3034" y="693"/>
                </a:lnTo>
                <a:lnTo>
                  <a:pt x="3042" y="694"/>
                </a:lnTo>
                <a:lnTo>
                  <a:pt x="3048" y="698"/>
                </a:lnTo>
                <a:lnTo>
                  <a:pt x="3055" y="700"/>
                </a:lnTo>
                <a:lnTo>
                  <a:pt x="3063" y="700"/>
                </a:lnTo>
                <a:lnTo>
                  <a:pt x="3069" y="702"/>
                </a:lnTo>
                <a:lnTo>
                  <a:pt x="3076" y="702"/>
                </a:lnTo>
                <a:lnTo>
                  <a:pt x="3082" y="704"/>
                </a:lnTo>
                <a:lnTo>
                  <a:pt x="3090" y="704"/>
                </a:lnTo>
                <a:lnTo>
                  <a:pt x="3097" y="706"/>
                </a:lnTo>
                <a:lnTo>
                  <a:pt x="3103" y="706"/>
                </a:lnTo>
                <a:lnTo>
                  <a:pt x="3111" y="706"/>
                </a:lnTo>
                <a:lnTo>
                  <a:pt x="3117" y="706"/>
                </a:lnTo>
                <a:lnTo>
                  <a:pt x="3124" y="706"/>
                </a:lnTo>
                <a:lnTo>
                  <a:pt x="3132" y="708"/>
                </a:lnTo>
                <a:lnTo>
                  <a:pt x="3138" y="706"/>
                </a:lnTo>
                <a:lnTo>
                  <a:pt x="3145" y="706"/>
                </a:lnTo>
                <a:lnTo>
                  <a:pt x="3151" y="706"/>
                </a:lnTo>
                <a:lnTo>
                  <a:pt x="3159" y="706"/>
                </a:lnTo>
                <a:lnTo>
                  <a:pt x="3165" y="706"/>
                </a:lnTo>
                <a:lnTo>
                  <a:pt x="3172" y="706"/>
                </a:lnTo>
                <a:lnTo>
                  <a:pt x="3180" y="704"/>
                </a:lnTo>
                <a:lnTo>
                  <a:pt x="3186" y="702"/>
                </a:lnTo>
                <a:lnTo>
                  <a:pt x="3193" y="702"/>
                </a:lnTo>
                <a:lnTo>
                  <a:pt x="3199" y="702"/>
                </a:lnTo>
                <a:lnTo>
                  <a:pt x="3207" y="702"/>
                </a:lnTo>
                <a:lnTo>
                  <a:pt x="3215" y="702"/>
                </a:lnTo>
                <a:lnTo>
                  <a:pt x="3220" y="704"/>
                </a:lnTo>
                <a:lnTo>
                  <a:pt x="3228" y="704"/>
                </a:lnTo>
                <a:lnTo>
                  <a:pt x="3234" y="704"/>
                </a:lnTo>
                <a:lnTo>
                  <a:pt x="3241" y="704"/>
                </a:lnTo>
                <a:lnTo>
                  <a:pt x="3249" y="704"/>
                </a:lnTo>
                <a:lnTo>
                  <a:pt x="3255" y="704"/>
                </a:lnTo>
                <a:lnTo>
                  <a:pt x="3263" y="702"/>
                </a:lnTo>
                <a:lnTo>
                  <a:pt x="3268" y="700"/>
                </a:lnTo>
                <a:lnTo>
                  <a:pt x="3276" y="698"/>
                </a:lnTo>
                <a:lnTo>
                  <a:pt x="3282" y="696"/>
                </a:lnTo>
                <a:lnTo>
                  <a:pt x="3289" y="693"/>
                </a:lnTo>
                <a:lnTo>
                  <a:pt x="3297" y="693"/>
                </a:lnTo>
                <a:lnTo>
                  <a:pt x="3303" y="691"/>
                </a:lnTo>
                <a:lnTo>
                  <a:pt x="3311" y="691"/>
                </a:lnTo>
                <a:lnTo>
                  <a:pt x="3316" y="693"/>
                </a:lnTo>
                <a:lnTo>
                  <a:pt x="3324" y="694"/>
                </a:lnTo>
                <a:lnTo>
                  <a:pt x="3332" y="694"/>
                </a:lnTo>
                <a:lnTo>
                  <a:pt x="3337" y="696"/>
                </a:lnTo>
                <a:lnTo>
                  <a:pt x="3345" y="696"/>
                </a:lnTo>
                <a:lnTo>
                  <a:pt x="3351" y="696"/>
                </a:lnTo>
                <a:lnTo>
                  <a:pt x="3359" y="696"/>
                </a:lnTo>
                <a:lnTo>
                  <a:pt x="3366" y="696"/>
                </a:lnTo>
                <a:lnTo>
                  <a:pt x="3372" y="696"/>
                </a:lnTo>
                <a:lnTo>
                  <a:pt x="3380" y="696"/>
                </a:lnTo>
                <a:lnTo>
                  <a:pt x="3385" y="696"/>
                </a:lnTo>
                <a:lnTo>
                  <a:pt x="3393" y="698"/>
                </a:lnTo>
                <a:lnTo>
                  <a:pt x="3399" y="698"/>
                </a:lnTo>
                <a:lnTo>
                  <a:pt x="3407" y="698"/>
                </a:lnTo>
                <a:lnTo>
                  <a:pt x="3414" y="698"/>
                </a:lnTo>
                <a:lnTo>
                  <a:pt x="3420" y="700"/>
                </a:lnTo>
                <a:lnTo>
                  <a:pt x="3428" y="700"/>
                </a:lnTo>
                <a:lnTo>
                  <a:pt x="3433" y="700"/>
                </a:lnTo>
                <a:lnTo>
                  <a:pt x="3441" y="700"/>
                </a:lnTo>
                <a:lnTo>
                  <a:pt x="3449" y="702"/>
                </a:lnTo>
                <a:lnTo>
                  <a:pt x="3455" y="700"/>
                </a:lnTo>
                <a:lnTo>
                  <a:pt x="3462" y="700"/>
                </a:lnTo>
                <a:lnTo>
                  <a:pt x="3468" y="696"/>
                </a:lnTo>
                <a:lnTo>
                  <a:pt x="3476" y="694"/>
                </a:lnTo>
                <a:lnTo>
                  <a:pt x="3483" y="691"/>
                </a:lnTo>
                <a:lnTo>
                  <a:pt x="3489" y="687"/>
                </a:lnTo>
                <a:lnTo>
                  <a:pt x="3497" y="683"/>
                </a:lnTo>
                <a:lnTo>
                  <a:pt x="3503" y="681"/>
                </a:lnTo>
                <a:lnTo>
                  <a:pt x="3510" y="679"/>
                </a:lnTo>
                <a:lnTo>
                  <a:pt x="3518" y="679"/>
                </a:lnTo>
                <a:lnTo>
                  <a:pt x="3524" y="679"/>
                </a:lnTo>
                <a:lnTo>
                  <a:pt x="3531" y="681"/>
                </a:lnTo>
                <a:lnTo>
                  <a:pt x="3537" y="683"/>
                </a:lnTo>
                <a:lnTo>
                  <a:pt x="3545" y="683"/>
                </a:lnTo>
                <a:lnTo>
                  <a:pt x="3551" y="685"/>
                </a:lnTo>
                <a:lnTo>
                  <a:pt x="3558" y="687"/>
                </a:lnTo>
                <a:lnTo>
                  <a:pt x="3566" y="687"/>
                </a:lnTo>
                <a:lnTo>
                  <a:pt x="3572" y="689"/>
                </a:lnTo>
                <a:lnTo>
                  <a:pt x="3579" y="689"/>
                </a:lnTo>
                <a:lnTo>
                  <a:pt x="3585" y="689"/>
                </a:lnTo>
                <a:lnTo>
                  <a:pt x="3593" y="689"/>
                </a:lnTo>
                <a:lnTo>
                  <a:pt x="3601" y="689"/>
                </a:lnTo>
                <a:lnTo>
                  <a:pt x="3606" y="689"/>
                </a:lnTo>
                <a:lnTo>
                  <a:pt x="3614" y="689"/>
                </a:lnTo>
                <a:lnTo>
                  <a:pt x="3620" y="687"/>
                </a:lnTo>
                <a:lnTo>
                  <a:pt x="3627" y="685"/>
                </a:lnTo>
                <a:lnTo>
                  <a:pt x="3635" y="683"/>
                </a:lnTo>
                <a:lnTo>
                  <a:pt x="3641" y="681"/>
                </a:lnTo>
                <a:lnTo>
                  <a:pt x="3649" y="681"/>
                </a:lnTo>
                <a:lnTo>
                  <a:pt x="3654" y="681"/>
                </a:lnTo>
                <a:lnTo>
                  <a:pt x="3662" y="683"/>
                </a:lnTo>
                <a:lnTo>
                  <a:pt x="3668" y="685"/>
                </a:lnTo>
                <a:lnTo>
                  <a:pt x="3675" y="685"/>
                </a:lnTo>
                <a:lnTo>
                  <a:pt x="3683" y="687"/>
                </a:lnTo>
                <a:lnTo>
                  <a:pt x="3689" y="689"/>
                </a:lnTo>
                <a:lnTo>
                  <a:pt x="3697" y="691"/>
                </a:lnTo>
                <a:lnTo>
                  <a:pt x="3702" y="693"/>
                </a:lnTo>
                <a:lnTo>
                  <a:pt x="3710" y="693"/>
                </a:lnTo>
                <a:lnTo>
                  <a:pt x="3718" y="694"/>
                </a:lnTo>
                <a:lnTo>
                  <a:pt x="3723" y="694"/>
                </a:lnTo>
                <a:lnTo>
                  <a:pt x="3731" y="694"/>
                </a:lnTo>
                <a:lnTo>
                  <a:pt x="3737" y="694"/>
                </a:lnTo>
                <a:lnTo>
                  <a:pt x="3745" y="694"/>
                </a:lnTo>
                <a:lnTo>
                  <a:pt x="3752" y="694"/>
                </a:lnTo>
                <a:lnTo>
                  <a:pt x="3758" y="694"/>
                </a:lnTo>
                <a:lnTo>
                  <a:pt x="3766" y="694"/>
                </a:lnTo>
                <a:lnTo>
                  <a:pt x="3771" y="694"/>
                </a:lnTo>
                <a:lnTo>
                  <a:pt x="3779" y="694"/>
                </a:lnTo>
                <a:lnTo>
                  <a:pt x="3785" y="694"/>
                </a:lnTo>
                <a:lnTo>
                  <a:pt x="3793" y="694"/>
                </a:lnTo>
                <a:lnTo>
                  <a:pt x="3800" y="693"/>
                </a:lnTo>
                <a:lnTo>
                  <a:pt x="3806" y="693"/>
                </a:lnTo>
                <a:lnTo>
                  <a:pt x="3814" y="693"/>
                </a:lnTo>
                <a:lnTo>
                  <a:pt x="3819" y="693"/>
                </a:lnTo>
                <a:lnTo>
                  <a:pt x="3827" y="691"/>
                </a:lnTo>
                <a:lnTo>
                  <a:pt x="3835" y="691"/>
                </a:lnTo>
                <a:lnTo>
                  <a:pt x="3841" y="691"/>
                </a:lnTo>
                <a:lnTo>
                  <a:pt x="3848" y="691"/>
                </a:lnTo>
                <a:lnTo>
                  <a:pt x="3854" y="693"/>
                </a:lnTo>
                <a:lnTo>
                  <a:pt x="3862" y="693"/>
                </a:lnTo>
                <a:lnTo>
                  <a:pt x="3869" y="693"/>
                </a:lnTo>
                <a:lnTo>
                  <a:pt x="3875" y="693"/>
                </a:lnTo>
                <a:lnTo>
                  <a:pt x="3883" y="693"/>
                </a:lnTo>
                <a:lnTo>
                  <a:pt x="3889" y="693"/>
                </a:lnTo>
                <a:lnTo>
                  <a:pt x="3896" y="694"/>
                </a:lnTo>
                <a:lnTo>
                  <a:pt x="3904" y="693"/>
                </a:lnTo>
                <a:lnTo>
                  <a:pt x="3910" y="694"/>
                </a:lnTo>
                <a:lnTo>
                  <a:pt x="3917" y="694"/>
                </a:lnTo>
                <a:lnTo>
                  <a:pt x="3923" y="694"/>
                </a:lnTo>
                <a:lnTo>
                  <a:pt x="3931" y="694"/>
                </a:lnTo>
                <a:lnTo>
                  <a:pt x="3937" y="694"/>
                </a:lnTo>
                <a:lnTo>
                  <a:pt x="3944" y="694"/>
                </a:lnTo>
                <a:lnTo>
                  <a:pt x="3952" y="694"/>
                </a:lnTo>
                <a:lnTo>
                  <a:pt x="3958" y="694"/>
                </a:lnTo>
                <a:lnTo>
                  <a:pt x="3965" y="694"/>
                </a:lnTo>
                <a:lnTo>
                  <a:pt x="3971" y="694"/>
                </a:lnTo>
                <a:lnTo>
                  <a:pt x="3979" y="694"/>
                </a:lnTo>
                <a:lnTo>
                  <a:pt x="3986" y="693"/>
                </a:lnTo>
                <a:lnTo>
                  <a:pt x="3992" y="693"/>
                </a:lnTo>
                <a:lnTo>
                  <a:pt x="4000" y="693"/>
                </a:lnTo>
                <a:lnTo>
                  <a:pt x="4006" y="693"/>
                </a:lnTo>
                <a:lnTo>
                  <a:pt x="4013" y="691"/>
                </a:lnTo>
                <a:lnTo>
                  <a:pt x="4021" y="691"/>
                </a:lnTo>
                <a:lnTo>
                  <a:pt x="4027" y="691"/>
                </a:lnTo>
                <a:lnTo>
                  <a:pt x="4034" y="689"/>
                </a:lnTo>
                <a:lnTo>
                  <a:pt x="4040" y="689"/>
                </a:lnTo>
                <a:lnTo>
                  <a:pt x="4048" y="687"/>
                </a:lnTo>
                <a:lnTo>
                  <a:pt x="4054" y="685"/>
                </a:lnTo>
                <a:lnTo>
                  <a:pt x="4061" y="683"/>
                </a:lnTo>
                <a:lnTo>
                  <a:pt x="4069" y="683"/>
                </a:lnTo>
                <a:lnTo>
                  <a:pt x="4075" y="681"/>
                </a:lnTo>
                <a:lnTo>
                  <a:pt x="4082" y="677"/>
                </a:lnTo>
                <a:lnTo>
                  <a:pt x="4088" y="675"/>
                </a:lnTo>
                <a:lnTo>
                  <a:pt x="4096" y="671"/>
                </a:lnTo>
                <a:lnTo>
                  <a:pt x="4104" y="668"/>
                </a:lnTo>
                <a:lnTo>
                  <a:pt x="4109" y="664"/>
                </a:lnTo>
                <a:lnTo>
                  <a:pt x="4117" y="662"/>
                </a:lnTo>
                <a:lnTo>
                  <a:pt x="4123" y="660"/>
                </a:lnTo>
                <a:lnTo>
                  <a:pt x="4130" y="660"/>
                </a:lnTo>
                <a:lnTo>
                  <a:pt x="4138" y="662"/>
                </a:lnTo>
                <a:lnTo>
                  <a:pt x="4144" y="664"/>
                </a:lnTo>
                <a:lnTo>
                  <a:pt x="4152" y="666"/>
                </a:lnTo>
                <a:lnTo>
                  <a:pt x="4157" y="668"/>
                </a:lnTo>
                <a:lnTo>
                  <a:pt x="4165" y="669"/>
                </a:lnTo>
                <a:lnTo>
                  <a:pt x="4173" y="671"/>
                </a:lnTo>
                <a:lnTo>
                  <a:pt x="4178" y="673"/>
                </a:lnTo>
                <a:lnTo>
                  <a:pt x="4186" y="673"/>
                </a:lnTo>
                <a:lnTo>
                  <a:pt x="4192" y="675"/>
                </a:lnTo>
                <a:lnTo>
                  <a:pt x="4200" y="675"/>
                </a:lnTo>
                <a:lnTo>
                  <a:pt x="4205" y="675"/>
                </a:lnTo>
                <a:lnTo>
                  <a:pt x="4213" y="675"/>
                </a:lnTo>
                <a:lnTo>
                  <a:pt x="4221" y="675"/>
                </a:lnTo>
                <a:lnTo>
                  <a:pt x="4226" y="677"/>
                </a:lnTo>
                <a:lnTo>
                  <a:pt x="4234" y="675"/>
                </a:lnTo>
                <a:lnTo>
                  <a:pt x="4240" y="675"/>
                </a:lnTo>
                <a:lnTo>
                  <a:pt x="4248" y="675"/>
                </a:lnTo>
                <a:lnTo>
                  <a:pt x="4255" y="675"/>
                </a:lnTo>
                <a:lnTo>
                  <a:pt x="4261" y="675"/>
                </a:lnTo>
                <a:lnTo>
                  <a:pt x="4269" y="675"/>
                </a:lnTo>
                <a:lnTo>
                  <a:pt x="4275" y="675"/>
                </a:lnTo>
                <a:lnTo>
                  <a:pt x="4282" y="675"/>
                </a:lnTo>
                <a:lnTo>
                  <a:pt x="4290" y="675"/>
                </a:lnTo>
                <a:lnTo>
                  <a:pt x="4296" y="675"/>
                </a:lnTo>
                <a:lnTo>
                  <a:pt x="4303" y="677"/>
                </a:lnTo>
                <a:lnTo>
                  <a:pt x="4309" y="677"/>
                </a:lnTo>
                <a:lnTo>
                  <a:pt x="4317" y="679"/>
                </a:lnTo>
                <a:lnTo>
                  <a:pt x="4323" y="679"/>
                </a:lnTo>
                <a:lnTo>
                  <a:pt x="4330" y="679"/>
                </a:lnTo>
                <a:lnTo>
                  <a:pt x="4338" y="679"/>
                </a:lnTo>
                <a:lnTo>
                  <a:pt x="4344" y="679"/>
                </a:lnTo>
                <a:lnTo>
                  <a:pt x="4351" y="679"/>
                </a:lnTo>
                <a:lnTo>
                  <a:pt x="4357" y="677"/>
                </a:lnTo>
                <a:lnTo>
                  <a:pt x="4365" y="675"/>
                </a:lnTo>
                <a:lnTo>
                  <a:pt x="4372" y="673"/>
                </a:lnTo>
                <a:lnTo>
                  <a:pt x="4378" y="671"/>
                </a:lnTo>
                <a:lnTo>
                  <a:pt x="4386" y="668"/>
                </a:lnTo>
                <a:lnTo>
                  <a:pt x="4392" y="666"/>
                </a:lnTo>
                <a:lnTo>
                  <a:pt x="4399" y="666"/>
                </a:lnTo>
                <a:lnTo>
                  <a:pt x="4407" y="666"/>
                </a:lnTo>
                <a:lnTo>
                  <a:pt x="4413" y="668"/>
                </a:lnTo>
                <a:lnTo>
                  <a:pt x="4420" y="668"/>
                </a:lnTo>
                <a:lnTo>
                  <a:pt x="4426" y="669"/>
                </a:lnTo>
                <a:lnTo>
                  <a:pt x="4434" y="671"/>
                </a:lnTo>
                <a:lnTo>
                  <a:pt x="4440" y="671"/>
                </a:lnTo>
                <a:lnTo>
                  <a:pt x="4447" y="673"/>
                </a:lnTo>
                <a:lnTo>
                  <a:pt x="4455" y="673"/>
                </a:lnTo>
                <a:lnTo>
                  <a:pt x="4461" y="673"/>
                </a:lnTo>
                <a:lnTo>
                  <a:pt x="4468" y="675"/>
                </a:lnTo>
                <a:lnTo>
                  <a:pt x="4474" y="673"/>
                </a:lnTo>
                <a:lnTo>
                  <a:pt x="4482" y="673"/>
                </a:lnTo>
                <a:lnTo>
                  <a:pt x="4490" y="671"/>
                </a:lnTo>
                <a:lnTo>
                  <a:pt x="4495" y="671"/>
                </a:lnTo>
                <a:lnTo>
                  <a:pt x="4503" y="669"/>
                </a:lnTo>
                <a:lnTo>
                  <a:pt x="4509" y="668"/>
                </a:lnTo>
                <a:lnTo>
                  <a:pt x="4516" y="668"/>
                </a:lnTo>
                <a:lnTo>
                  <a:pt x="4524" y="668"/>
                </a:lnTo>
                <a:lnTo>
                  <a:pt x="4530" y="668"/>
                </a:lnTo>
                <a:lnTo>
                  <a:pt x="4538" y="668"/>
                </a:lnTo>
                <a:lnTo>
                  <a:pt x="4543" y="669"/>
                </a:lnTo>
                <a:lnTo>
                  <a:pt x="4551" y="669"/>
                </a:lnTo>
                <a:lnTo>
                  <a:pt x="4559" y="669"/>
                </a:lnTo>
                <a:lnTo>
                  <a:pt x="4564" y="671"/>
                </a:lnTo>
                <a:lnTo>
                  <a:pt x="4572" y="671"/>
                </a:lnTo>
                <a:lnTo>
                  <a:pt x="4578" y="671"/>
                </a:lnTo>
                <a:lnTo>
                  <a:pt x="4586" y="673"/>
                </a:lnTo>
                <a:lnTo>
                  <a:pt x="4591" y="673"/>
                </a:lnTo>
                <a:lnTo>
                  <a:pt x="4599" y="671"/>
                </a:lnTo>
                <a:lnTo>
                  <a:pt x="4607" y="671"/>
                </a:lnTo>
                <a:lnTo>
                  <a:pt x="4612" y="671"/>
                </a:lnTo>
                <a:lnTo>
                  <a:pt x="4620" y="671"/>
                </a:lnTo>
                <a:lnTo>
                  <a:pt x="4626" y="671"/>
                </a:lnTo>
                <a:lnTo>
                  <a:pt x="4634" y="673"/>
                </a:lnTo>
                <a:lnTo>
                  <a:pt x="4641" y="673"/>
                </a:lnTo>
                <a:lnTo>
                  <a:pt x="4647" y="671"/>
                </a:lnTo>
                <a:lnTo>
                  <a:pt x="4655" y="671"/>
                </a:lnTo>
                <a:lnTo>
                  <a:pt x="4660" y="671"/>
                </a:lnTo>
                <a:lnTo>
                  <a:pt x="4668" y="671"/>
                </a:lnTo>
                <a:lnTo>
                  <a:pt x="4676" y="669"/>
                </a:lnTo>
                <a:lnTo>
                  <a:pt x="4682" y="668"/>
                </a:lnTo>
                <a:lnTo>
                  <a:pt x="4689" y="668"/>
                </a:lnTo>
                <a:lnTo>
                  <a:pt x="4695" y="668"/>
                </a:lnTo>
                <a:lnTo>
                  <a:pt x="4703" y="668"/>
                </a:lnTo>
                <a:lnTo>
                  <a:pt x="4708" y="668"/>
                </a:lnTo>
                <a:lnTo>
                  <a:pt x="4716" y="668"/>
                </a:lnTo>
                <a:lnTo>
                  <a:pt x="4724" y="668"/>
                </a:lnTo>
                <a:lnTo>
                  <a:pt x="4730" y="669"/>
                </a:lnTo>
                <a:lnTo>
                  <a:pt x="4737" y="669"/>
                </a:lnTo>
                <a:lnTo>
                  <a:pt x="4743" y="669"/>
                </a:lnTo>
                <a:lnTo>
                  <a:pt x="4751" y="669"/>
                </a:lnTo>
                <a:lnTo>
                  <a:pt x="4758" y="669"/>
                </a:lnTo>
                <a:lnTo>
                  <a:pt x="4764" y="669"/>
                </a:lnTo>
                <a:lnTo>
                  <a:pt x="4772" y="669"/>
                </a:lnTo>
                <a:lnTo>
                  <a:pt x="4778" y="668"/>
                </a:lnTo>
                <a:lnTo>
                  <a:pt x="4785" y="668"/>
                </a:lnTo>
                <a:lnTo>
                  <a:pt x="4793" y="668"/>
                </a:lnTo>
                <a:lnTo>
                  <a:pt x="4799" y="666"/>
                </a:lnTo>
                <a:lnTo>
                  <a:pt x="4806" y="666"/>
                </a:lnTo>
                <a:lnTo>
                  <a:pt x="4812" y="666"/>
                </a:lnTo>
                <a:lnTo>
                  <a:pt x="4820" y="664"/>
                </a:lnTo>
                <a:lnTo>
                  <a:pt x="4827" y="664"/>
                </a:lnTo>
                <a:lnTo>
                  <a:pt x="4833" y="664"/>
                </a:lnTo>
                <a:lnTo>
                  <a:pt x="4841" y="664"/>
                </a:lnTo>
                <a:lnTo>
                  <a:pt x="4847" y="664"/>
                </a:lnTo>
                <a:lnTo>
                  <a:pt x="4854" y="662"/>
                </a:lnTo>
                <a:lnTo>
                  <a:pt x="4860" y="662"/>
                </a:lnTo>
                <a:lnTo>
                  <a:pt x="4868" y="662"/>
                </a:lnTo>
                <a:lnTo>
                  <a:pt x="4875" y="662"/>
                </a:lnTo>
                <a:lnTo>
                  <a:pt x="4881" y="662"/>
                </a:lnTo>
                <a:lnTo>
                  <a:pt x="4889" y="662"/>
                </a:lnTo>
                <a:lnTo>
                  <a:pt x="4895" y="664"/>
                </a:lnTo>
                <a:lnTo>
                  <a:pt x="4902" y="662"/>
                </a:lnTo>
                <a:lnTo>
                  <a:pt x="4910" y="662"/>
                </a:lnTo>
                <a:lnTo>
                  <a:pt x="4916" y="662"/>
                </a:lnTo>
                <a:lnTo>
                  <a:pt x="4924" y="662"/>
                </a:lnTo>
                <a:lnTo>
                  <a:pt x="4929" y="662"/>
                </a:lnTo>
                <a:lnTo>
                  <a:pt x="4937" y="662"/>
                </a:lnTo>
                <a:lnTo>
                  <a:pt x="4945" y="662"/>
                </a:lnTo>
                <a:lnTo>
                  <a:pt x="4950" y="662"/>
                </a:lnTo>
                <a:lnTo>
                  <a:pt x="4958" y="662"/>
                </a:lnTo>
                <a:lnTo>
                  <a:pt x="4964" y="662"/>
                </a:lnTo>
                <a:lnTo>
                  <a:pt x="4972" y="662"/>
                </a:lnTo>
                <a:lnTo>
                  <a:pt x="4977" y="662"/>
                </a:lnTo>
                <a:lnTo>
                  <a:pt x="4985" y="662"/>
                </a:lnTo>
                <a:lnTo>
                  <a:pt x="4993" y="662"/>
                </a:lnTo>
                <a:lnTo>
                  <a:pt x="4998" y="660"/>
                </a:lnTo>
                <a:lnTo>
                  <a:pt x="5006" y="660"/>
                </a:lnTo>
                <a:lnTo>
                  <a:pt x="5012" y="660"/>
                </a:lnTo>
                <a:lnTo>
                  <a:pt x="5020" y="660"/>
                </a:lnTo>
                <a:lnTo>
                  <a:pt x="5027" y="658"/>
                </a:lnTo>
                <a:lnTo>
                  <a:pt x="5033" y="658"/>
                </a:lnTo>
                <a:lnTo>
                  <a:pt x="5041" y="658"/>
                </a:lnTo>
                <a:lnTo>
                  <a:pt x="5046" y="656"/>
                </a:lnTo>
                <a:lnTo>
                  <a:pt x="5054" y="656"/>
                </a:lnTo>
                <a:lnTo>
                  <a:pt x="5062" y="654"/>
                </a:lnTo>
                <a:lnTo>
                  <a:pt x="5068" y="654"/>
                </a:lnTo>
                <a:lnTo>
                  <a:pt x="5075" y="654"/>
                </a:lnTo>
                <a:lnTo>
                  <a:pt x="5081" y="652"/>
                </a:lnTo>
                <a:lnTo>
                  <a:pt x="5089" y="650"/>
                </a:lnTo>
                <a:lnTo>
                  <a:pt x="5094" y="648"/>
                </a:lnTo>
                <a:lnTo>
                  <a:pt x="5102" y="646"/>
                </a:lnTo>
                <a:lnTo>
                  <a:pt x="5110" y="643"/>
                </a:lnTo>
                <a:lnTo>
                  <a:pt x="5116" y="639"/>
                </a:lnTo>
                <a:lnTo>
                  <a:pt x="5123" y="635"/>
                </a:lnTo>
                <a:lnTo>
                  <a:pt x="5129" y="633"/>
                </a:lnTo>
                <a:lnTo>
                  <a:pt x="5137" y="629"/>
                </a:lnTo>
                <a:lnTo>
                  <a:pt x="5144" y="629"/>
                </a:lnTo>
                <a:lnTo>
                  <a:pt x="5150" y="629"/>
                </a:lnTo>
                <a:lnTo>
                  <a:pt x="5158" y="629"/>
                </a:lnTo>
                <a:lnTo>
                  <a:pt x="5164" y="629"/>
                </a:lnTo>
                <a:lnTo>
                  <a:pt x="5171" y="631"/>
                </a:lnTo>
                <a:lnTo>
                  <a:pt x="5179" y="633"/>
                </a:lnTo>
                <a:lnTo>
                  <a:pt x="5185" y="635"/>
                </a:lnTo>
                <a:lnTo>
                  <a:pt x="5192" y="635"/>
                </a:lnTo>
                <a:lnTo>
                  <a:pt x="5198" y="637"/>
                </a:lnTo>
                <a:lnTo>
                  <a:pt x="5206" y="639"/>
                </a:lnTo>
                <a:lnTo>
                  <a:pt x="5213" y="641"/>
                </a:lnTo>
                <a:lnTo>
                  <a:pt x="5219" y="643"/>
                </a:lnTo>
                <a:lnTo>
                  <a:pt x="5227" y="643"/>
                </a:lnTo>
                <a:lnTo>
                  <a:pt x="5233" y="645"/>
                </a:lnTo>
                <a:lnTo>
                  <a:pt x="5240" y="645"/>
                </a:lnTo>
                <a:lnTo>
                  <a:pt x="5246" y="645"/>
                </a:lnTo>
                <a:lnTo>
                  <a:pt x="5254" y="643"/>
                </a:lnTo>
                <a:lnTo>
                  <a:pt x="5261" y="641"/>
                </a:lnTo>
                <a:lnTo>
                  <a:pt x="5267" y="639"/>
                </a:lnTo>
                <a:lnTo>
                  <a:pt x="5275" y="637"/>
                </a:lnTo>
                <a:lnTo>
                  <a:pt x="5281" y="635"/>
                </a:lnTo>
                <a:lnTo>
                  <a:pt x="5288" y="633"/>
                </a:lnTo>
                <a:lnTo>
                  <a:pt x="5296" y="633"/>
                </a:lnTo>
                <a:lnTo>
                  <a:pt x="5302" y="633"/>
                </a:lnTo>
                <a:lnTo>
                  <a:pt x="5309" y="633"/>
                </a:lnTo>
                <a:lnTo>
                  <a:pt x="5315" y="633"/>
                </a:lnTo>
                <a:lnTo>
                  <a:pt x="5323" y="635"/>
                </a:lnTo>
                <a:lnTo>
                  <a:pt x="5331" y="635"/>
                </a:lnTo>
                <a:lnTo>
                  <a:pt x="5336" y="637"/>
                </a:lnTo>
                <a:lnTo>
                  <a:pt x="5344" y="637"/>
                </a:lnTo>
                <a:lnTo>
                  <a:pt x="5350" y="637"/>
                </a:lnTo>
                <a:lnTo>
                  <a:pt x="5357" y="635"/>
                </a:lnTo>
                <a:lnTo>
                  <a:pt x="5363" y="635"/>
                </a:lnTo>
                <a:lnTo>
                  <a:pt x="5371" y="633"/>
                </a:lnTo>
                <a:lnTo>
                  <a:pt x="5379" y="633"/>
                </a:lnTo>
                <a:lnTo>
                  <a:pt x="5384" y="633"/>
                </a:lnTo>
                <a:lnTo>
                  <a:pt x="5392" y="633"/>
                </a:lnTo>
                <a:lnTo>
                  <a:pt x="5398" y="633"/>
                </a:lnTo>
                <a:lnTo>
                  <a:pt x="5405" y="633"/>
                </a:lnTo>
                <a:lnTo>
                  <a:pt x="5413" y="633"/>
                </a:lnTo>
                <a:lnTo>
                  <a:pt x="5419" y="633"/>
                </a:lnTo>
                <a:lnTo>
                  <a:pt x="5427" y="635"/>
                </a:lnTo>
                <a:lnTo>
                  <a:pt x="5432" y="635"/>
                </a:lnTo>
                <a:lnTo>
                  <a:pt x="5440" y="633"/>
                </a:lnTo>
                <a:lnTo>
                  <a:pt x="5448" y="633"/>
                </a:lnTo>
                <a:lnTo>
                  <a:pt x="5453" y="633"/>
                </a:lnTo>
                <a:lnTo>
                  <a:pt x="5461" y="633"/>
                </a:lnTo>
                <a:lnTo>
                  <a:pt x="5467" y="633"/>
                </a:lnTo>
                <a:lnTo>
                  <a:pt x="5475" y="633"/>
                </a:lnTo>
                <a:lnTo>
                  <a:pt x="5480" y="633"/>
                </a:lnTo>
                <a:lnTo>
                  <a:pt x="5488" y="631"/>
                </a:lnTo>
                <a:lnTo>
                  <a:pt x="5496" y="631"/>
                </a:lnTo>
                <a:lnTo>
                  <a:pt x="5501" y="629"/>
                </a:lnTo>
                <a:lnTo>
                  <a:pt x="5509" y="629"/>
                </a:lnTo>
                <a:lnTo>
                  <a:pt x="5515" y="629"/>
                </a:lnTo>
                <a:lnTo>
                  <a:pt x="5523" y="627"/>
                </a:lnTo>
                <a:lnTo>
                  <a:pt x="5530" y="627"/>
                </a:lnTo>
                <a:lnTo>
                  <a:pt x="5536" y="625"/>
                </a:lnTo>
                <a:lnTo>
                  <a:pt x="5544" y="625"/>
                </a:lnTo>
                <a:lnTo>
                  <a:pt x="5549" y="623"/>
                </a:lnTo>
                <a:lnTo>
                  <a:pt x="5557" y="623"/>
                </a:lnTo>
                <a:lnTo>
                  <a:pt x="5565" y="621"/>
                </a:lnTo>
                <a:lnTo>
                  <a:pt x="5571" y="621"/>
                </a:lnTo>
                <a:lnTo>
                  <a:pt x="5578" y="621"/>
                </a:lnTo>
                <a:lnTo>
                  <a:pt x="5584" y="623"/>
                </a:lnTo>
                <a:lnTo>
                  <a:pt x="5592" y="623"/>
                </a:lnTo>
                <a:lnTo>
                  <a:pt x="5599" y="623"/>
                </a:lnTo>
                <a:lnTo>
                  <a:pt x="5605" y="623"/>
                </a:lnTo>
                <a:lnTo>
                  <a:pt x="5613" y="623"/>
                </a:lnTo>
                <a:lnTo>
                  <a:pt x="5619" y="623"/>
                </a:lnTo>
                <a:lnTo>
                  <a:pt x="5626" y="621"/>
                </a:lnTo>
                <a:lnTo>
                  <a:pt x="5632" y="621"/>
                </a:lnTo>
                <a:lnTo>
                  <a:pt x="5640" y="620"/>
                </a:lnTo>
                <a:lnTo>
                  <a:pt x="5647" y="618"/>
                </a:lnTo>
                <a:lnTo>
                  <a:pt x="5653" y="616"/>
                </a:lnTo>
                <a:lnTo>
                  <a:pt x="5661" y="612"/>
                </a:lnTo>
                <a:lnTo>
                  <a:pt x="5667" y="606"/>
                </a:lnTo>
                <a:lnTo>
                  <a:pt x="5674" y="600"/>
                </a:lnTo>
                <a:lnTo>
                  <a:pt x="5682" y="595"/>
                </a:lnTo>
                <a:lnTo>
                  <a:pt x="5688" y="591"/>
                </a:lnTo>
                <a:lnTo>
                  <a:pt x="5695" y="585"/>
                </a:lnTo>
                <a:lnTo>
                  <a:pt x="5701" y="579"/>
                </a:lnTo>
                <a:lnTo>
                  <a:pt x="5709" y="575"/>
                </a:lnTo>
                <a:lnTo>
                  <a:pt x="5717" y="572"/>
                </a:lnTo>
                <a:lnTo>
                  <a:pt x="5722" y="570"/>
                </a:lnTo>
                <a:lnTo>
                  <a:pt x="5730" y="568"/>
                </a:lnTo>
                <a:lnTo>
                  <a:pt x="5736" y="566"/>
                </a:lnTo>
                <a:lnTo>
                  <a:pt x="5743" y="566"/>
                </a:lnTo>
                <a:lnTo>
                  <a:pt x="5749" y="566"/>
                </a:lnTo>
                <a:lnTo>
                  <a:pt x="5757" y="564"/>
                </a:lnTo>
                <a:lnTo>
                  <a:pt x="5765" y="564"/>
                </a:lnTo>
                <a:lnTo>
                  <a:pt x="5770" y="564"/>
                </a:lnTo>
                <a:lnTo>
                  <a:pt x="5778" y="564"/>
                </a:lnTo>
                <a:lnTo>
                  <a:pt x="5784" y="566"/>
                </a:lnTo>
                <a:lnTo>
                  <a:pt x="5791" y="566"/>
                </a:lnTo>
                <a:lnTo>
                  <a:pt x="5799" y="566"/>
                </a:lnTo>
                <a:lnTo>
                  <a:pt x="5805" y="568"/>
                </a:lnTo>
                <a:lnTo>
                  <a:pt x="5813" y="570"/>
                </a:lnTo>
                <a:lnTo>
                  <a:pt x="5818" y="570"/>
                </a:lnTo>
                <a:lnTo>
                  <a:pt x="5826" y="572"/>
                </a:lnTo>
                <a:lnTo>
                  <a:pt x="5834" y="574"/>
                </a:lnTo>
                <a:lnTo>
                  <a:pt x="5839" y="574"/>
                </a:lnTo>
                <a:lnTo>
                  <a:pt x="5847" y="575"/>
                </a:lnTo>
                <a:lnTo>
                  <a:pt x="5853" y="575"/>
                </a:lnTo>
                <a:lnTo>
                  <a:pt x="5861" y="577"/>
                </a:lnTo>
                <a:lnTo>
                  <a:pt x="5868" y="577"/>
                </a:lnTo>
                <a:lnTo>
                  <a:pt x="5874" y="577"/>
                </a:lnTo>
                <a:lnTo>
                  <a:pt x="5882" y="577"/>
                </a:lnTo>
                <a:lnTo>
                  <a:pt x="5887" y="577"/>
                </a:lnTo>
                <a:lnTo>
                  <a:pt x="5895" y="577"/>
                </a:lnTo>
                <a:lnTo>
                  <a:pt x="5901" y="577"/>
                </a:lnTo>
                <a:lnTo>
                  <a:pt x="5909" y="577"/>
                </a:lnTo>
                <a:lnTo>
                  <a:pt x="5916" y="575"/>
                </a:lnTo>
                <a:lnTo>
                  <a:pt x="5922" y="574"/>
                </a:lnTo>
                <a:lnTo>
                  <a:pt x="5930" y="570"/>
                </a:lnTo>
                <a:lnTo>
                  <a:pt x="5935" y="560"/>
                </a:lnTo>
                <a:lnTo>
                  <a:pt x="5943" y="543"/>
                </a:lnTo>
                <a:lnTo>
                  <a:pt x="5951" y="512"/>
                </a:lnTo>
                <a:lnTo>
                  <a:pt x="5957" y="464"/>
                </a:lnTo>
                <a:lnTo>
                  <a:pt x="5964" y="397"/>
                </a:lnTo>
                <a:lnTo>
                  <a:pt x="5970" y="314"/>
                </a:lnTo>
                <a:lnTo>
                  <a:pt x="5978" y="226"/>
                </a:lnTo>
                <a:lnTo>
                  <a:pt x="5985" y="140"/>
                </a:lnTo>
                <a:lnTo>
                  <a:pt x="5991" y="71"/>
                </a:lnTo>
                <a:lnTo>
                  <a:pt x="5999" y="23"/>
                </a:lnTo>
                <a:lnTo>
                  <a:pt x="6005" y="0"/>
                </a:lnTo>
                <a:lnTo>
                  <a:pt x="6012" y="0"/>
                </a:lnTo>
                <a:lnTo>
                  <a:pt x="6018" y="13"/>
                </a:lnTo>
                <a:lnTo>
                  <a:pt x="6026" y="36"/>
                </a:lnTo>
                <a:lnTo>
                  <a:pt x="6033" y="67"/>
                </a:lnTo>
                <a:lnTo>
                  <a:pt x="6039" y="98"/>
                </a:lnTo>
                <a:lnTo>
                  <a:pt x="6047" y="126"/>
                </a:lnTo>
                <a:lnTo>
                  <a:pt x="6053" y="155"/>
                </a:lnTo>
                <a:lnTo>
                  <a:pt x="6060" y="180"/>
                </a:lnTo>
                <a:lnTo>
                  <a:pt x="6068" y="205"/>
                </a:lnTo>
                <a:lnTo>
                  <a:pt x="6074" y="226"/>
                </a:lnTo>
                <a:lnTo>
                  <a:pt x="6081" y="247"/>
                </a:lnTo>
                <a:lnTo>
                  <a:pt x="6087" y="265"/>
                </a:lnTo>
                <a:lnTo>
                  <a:pt x="6095" y="282"/>
                </a:lnTo>
                <a:lnTo>
                  <a:pt x="6102" y="297"/>
                </a:lnTo>
                <a:lnTo>
                  <a:pt x="6108" y="311"/>
                </a:lnTo>
                <a:lnTo>
                  <a:pt x="6116" y="322"/>
                </a:lnTo>
                <a:lnTo>
                  <a:pt x="6122" y="332"/>
                </a:lnTo>
                <a:lnTo>
                  <a:pt x="6129" y="341"/>
                </a:lnTo>
                <a:lnTo>
                  <a:pt x="6135" y="351"/>
                </a:lnTo>
                <a:lnTo>
                  <a:pt x="6143" y="359"/>
                </a:lnTo>
                <a:lnTo>
                  <a:pt x="6150" y="366"/>
                </a:lnTo>
                <a:lnTo>
                  <a:pt x="6156" y="372"/>
                </a:lnTo>
                <a:lnTo>
                  <a:pt x="6164" y="378"/>
                </a:lnTo>
                <a:lnTo>
                  <a:pt x="6170" y="384"/>
                </a:lnTo>
                <a:lnTo>
                  <a:pt x="6177" y="387"/>
                </a:lnTo>
                <a:lnTo>
                  <a:pt x="6185" y="391"/>
                </a:lnTo>
                <a:lnTo>
                  <a:pt x="6191" y="393"/>
                </a:lnTo>
                <a:lnTo>
                  <a:pt x="6198" y="393"/>
                </a:lnTo>
                <a:lnTo>
                  <a:pt x="6204" y="393"/>
                </a:lnTo>
                <a:lnTo>
                  <a:pt x="6212" y="391"/>
                </a:lnTo>
                <a:lnTo>
                  <a:pt x="6220" y="385"/>
                </a:lnTo>
                <a:lnTo>
                  <a:pt x="6225" y="380"/>
                </a:lnTo>
                <a:lnTo>
                  <a:pt x="6233" y="366"/>
                </a:lnTo>
                <a:lnTo>
                  <a:pt x="6239" y="351"/>
                </a:lnTo>
                <a:lnTo>
                  <a:pt x="6246" y="332"/>
                </a:lnTo>
                <a:lnTo>
                  <a:pt x="6254" y="307"/>
                </a:lnTo>
                <a:lnTo>
                  <a:pt x="6260" y="280"/>
                </a:lnTo>
                <a:lnTo>
                  <a:pt x="6268" y="251"/>
                </a:lnTo>
                <a:lnTo>
                  <a:pt x="6273" y="219"/>
                </a:lnTo>
                <a:lnTo>
                  <a:pt x="6281" y="188"/>
                </a:lnTo>
                <a:lnTo>
                  <a:pt x="6287" y="157"/>
                </a:lnTo>
                <a:lnTo>
                  <a:pt x="6294" y="130"/>
                </a:lnTo>
                <a:lnTo>
                  <a:pt x="6302" y="107"/>
                </a:lnTo>
                <a:lnTo>
                  <a:pt x="6308" y="86"/>
                </a:lnTo>
                <a:lnTo>
                  <a:pt x="6316" y="71"/>
                </a:lnTo>
                <a:lnTo>
                  <a:pt x="6321" y="57"/>
                </a:lnTo>
                <a:lnTo>
                  <a:pt x="6329" y="50"/>
                </a:lnTo>
                <a:lnTo>
                  <a:pt x="6337" y="44"/>
                </a:lnTo>
                <a:lnTo>
                  <a:pt x="6342" y="42"/>
                </a:lnTo>
                <a:lnTo>
                  <a:pt x="6350" y="42"/>
                </a:lnTo>
                <a:lnTo>
                  <a:pt x="6356" y="48"/>
                </a:lnTo>
                <a:lnTo>
                  <a:pt x="6364" y="53"/>
                </a:lnTo>
                <a:lnTo>
                  <a:pt x="6371" y="61"/>
                </a:lnTo>
                <a:lnTo>
                  <a:pt x="6377" y="71"/>
                </a:lnTo>
                <a:lnTo>
                  <a:pt x="6385" y="82"/>
                </a:lnTo>
                <a:lnTo>
                  <a:pt x="6390" y="94"/>
                </a:lnTo>
                <a:lnTo>
                  <a:pt x="6398" y="107"/>
                </a:lnTo>
                <a:lnTo>
                  <a:pt x="6404" y="123"/>
                </a:lnTo>
                <a:lnTo>
                  <a:pt x="6412" y="136"/>
                </a:lnTo>
                <a:lnTo>
                  <a:pt x="6419" y="151"/>
                </a:lnTo>
                <a:lnTo>
                  <a:pt x="6425" y="165"/>
                </a:lnTo>
                <a:lnTo>
                  <a:pt x="6433" y="180"/>
                </a:lnTo>
                <a:lnTo>
                  <a:pt x="6438" y="192"/>
                </a:lnTo>
                <a:lnTo>
                  <a:pt x="6446" y="205"/>
                </a:lnTo>
                <a:lnTo>
                  <a:pt x="6454" y="217"/>
                </a:lnTo>
                <a:lnTo>
                  <a:pt x="6460" y="228"/>
                </a:lnTo>
                <a:lnTo>
                  <a:pt x="6467" y="240"/>
                </a:lnTo>
                <a:lnTo>
                  <a:pt x="6473" y="249"/>
                </a:lnTo>
                <a:lnTo>
                  <a:pt x="6481" y="257"/>
                </a:lnTo>
                <a:lnTo>
                  <a:pt x="6488" y="266"/>
                </a:lnTo>
                <a:lnTo>
                  <a:pt x="6494" y="274"/>
                </a:lnTo>
                <a:lnTo>
                  <a:pt x="6502" y="282"/>
                </a:lnTo>
                <a:lnTo>
                  <a:pt x="6508" y="290"/>
                </a:lnTo>
                <a:lnTo>
                  <a:pt x="6515" y="297"/>
                </a:lnTo>
                <a:lnTo>
                  <a:pt x="6523" y="303"/>
                </a:lnTo>
                <a:lnTo>
                  <a:pt x="6529" y="311"/>
                </a:lnTo>
                <a:lnTo>
                  <a:pt x="6536" y="316"/>
                </a:lnTo>
                <a:lnTo>
                  <a:pt x="6542" y="322"/>
                </a:lnTo>
                <a:lnTo>
                  <a:pt x="6550" y="328"/>
                </a:lnTo>
                <a:lnTo>
                  <a:pt x="6556" y="334"/>
                </a:lnTo>
                <a:lnTo>
                  <a:pt x="6563" y="339"/>
                </a:lnTo>
                <a:lnTo>
                  <a:pt x="6571" y="343"/>
                </a:lnTo>
                <a:lnTo>
                  <a:pt x="6577" y="349"/>
                </a:lnTo>
                <a:lnTo>
                  <a:pt x="6584" y="353"/>
                </a:lnTo>
                <a:lnTo>
                  <a:pt x="6590" y="359"/>
                </a:lnTo>
                <a:lnTo>
                  <a:pt x="6598" y="362"/>
                </a:lnTo>
                <a:lnTo>
                  <a:pt x="6606" y="366"/>
                </a:lnTo>
                <a:lnTo>
                  <a:pt x="6611" y="370"/>
                </a:lnTo>
                <a:lnTo>
                  <a:pt x="6619" y="374"/>
                </a:lnTo>
                <a:lnTo>
                  <a:pt x="6625" y="378"/>
                </a:lnTo>
                <a:lnTo>
                  <a:pt x="6632" y="382"/>
                </a:lnTo>
                <a:lnTo>
                  <a:pt x="6640" y="385"/>
                </a:lnTo>
                <a:lnTo>
                  <a:pt x="6646" y="387"/>
                </a:lnTo>
                <a:lnTo>
                  <a:pt x="6654" y="391"/>
                </a:lnTo>
                <a:lnTo>
                  <a:pt x="6659" y="393"/>
                </a:lnTo>
                <a:lnTo>
                  <a:pt x="6667" y="397"/>
                </a:lnTo>
                <a:lnTo>
                  <a:pt x="6673" y="399"/>
                </a:lnTo>
                <a:lnTo>
                  <a:pt x="6680" y="403"/>
                </a:lnTo>
                <a:lnTo>
                  <a:pt x="6688" y="407"/>
                </a:lnTo>
                <a:lnTo>
                  <a:pt x="6694" y="408"/>
                </a:lnTo>
                <a:lnTo>
                  <a:pt x="6702" y="410"/>
                </a:lnTo>
                <a:lnTo>
                  <a:pt x="6707" y="414"/>
                </a:lnTo>
                <a:lnTo>
                  <a:pt x="6715" y="416"/>
                </a:lnTo>
                <a:lnTo>
                  <a:pt x="6723" y="418"/>
                </a:lnTo>
                <a:lnTo>
                  <a:pt x="6728" y="422"/>
                </a:lnTo>
                <a:lnTo>
                  <a:pt x="6736" y="424"/>
                </a:lnTo>
                <a:lnTo>
                  <a:pt x="6742" y="426"/>
                </a:lnTo>
                <a:lnTo>
                  <a:pt x="6750" y="428"/>
                </a:lnTo>
                <a:lnTo>
                  <a:pt x="6757" y="430"/>
                </a:lnTo>
                <a:lnTo>
                  <a:pt x="6763" y="432"/>
                </a:lnTo>
                <a:lnTo>
                  <a:pt x="6771" y="433"/>
                </a:lnTo>
                <a:lnTo>
                  <a:pt x="6776" y="435"/>
                </a:lnTo>
                <a:lnTo>
                  <a:pt x="6784" y="437"/>
                </a:lnTo>
                <a:lnTo>
                  <a:pt x="6790" y="439"/>
                </a:lnTo>
                <a:lnTo>
                  <a:pt x="6798" y="441"/>
                </a:lnTo>
                <a:lnTo>
                  <a:pt x="6805" y="443"/>
                </a:lnTo>
                <a:lnTo>
                  <a:pt x="6811" y="443"/>
                </a:lnTo>
                <a:lnTo>
                  <a:pt x="6819" y="445"/>
                </a:lnTo>
                <a:lnTo>
                  <a:pt x="6824" y="447"/>
                </a:lnTo>
                <a:lnTo>
                  <a:pt x="6832" y="449"/>
                </a:lnTo>
                <a:lnTo>
                  <a:pt x="6840" y="449"/>
                </a:lnTo>
                <a:lnTo>
                  <a:pt x="6846" y="451"/>
                </a:lnTo>
                <a:lnTo>
                  <a:pt x="6851" y="453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23" name="Rectangle 225">
            <a:extLst>
              <a:ext uri="{FF2B5EF4-FFF2-40B4-BE49-F238E27FC236}">
                <a16:creationId xmlns:a16="http://schemas.microsoft.com/office/drawing/2014/main" id="{DED53552-F886-442D-8A94-174D3E8ABC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0765" y="1851573"/>
            <a:ext cx="1696181" cy="717093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ja-JP" altLang="en-US" sz="700">
              <a:latin typeface="Arial" panose="020B0604020202020204" pitchFamily="34" charset="0"/>
            </a:endParaRPr>
          </a:p>
        </p:txBody>
      </p:sp>
      <p:sp>
        <p:nvSpPr>
          <p:cNvPr id="814" name="テキスト ボックス 1269">
            <a:extLst>
              <a:ext uri="{FF2B5EF4-FFF2-40B4-BE49-F238E27FC236}">
                <a16:creationId xmlns:a16="http://schemas.microsoft.com/office/drawing/2014/main" id="{A6E4187C-1A35-4AF0-A897-6C0909F04B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51328" y="2380221"/>
            <a:ext cx="284990" cy="1502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 day</a:t>
            </a:r>
            <a:endParaRPr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71" name="グループ化 970">
            <a:extLst>
              <a:ext uri="{FF2B5EF4-FFF2-40B4-BE49-F238E27FC236}">
                <a16:creationId xmlns:a16="http://schemas.microsoft.com/office/drawing/2014/main" id="{35715E01-5472-4475-8A8C-893C38475CF7}"/>
              </a:ext>
            </a:extLst>
          </p:cNvPr>
          <p:cNvGrpSpPr/>
          <p:nvPr/>
        </p:nvGrpSpPr>
        <p:grpSpPr>
          <a:xfrm>
            <a:off x="4921360" y="2821593"/>
            <a:ext cx="1700551" cy="713858"/>
            <a:chOff x="-1329598" y="3730860"/>
            <a:chExt cx="2403026" cy="955045"/>
          </a:xfrm>
        </p:grpSpPr>
        <p:sp>
          <p:nvSpPr>
            <p:cNvPr id="429" name="Freeform 737">
              <a:extLst>
                <a:ext uri="{FF2B5EF4-FFF2-40B4-BE49-F238E27FC236}">
                  <a16:creationId xmlns:a16="http://schemas.microsoft.com/office/drawing/2014/main" id="{E16251F2-37FD-4FA9-854C-10B3187D19B0}"/>
                </a:ext>
              </a:extLst>
            </p:cNvPr>
            <p:cNvSpPr>
              <a:spLocks/>
            </p:cNvSpPr>
            <p:nvPr/>
          </p:nvSpPr>
          <p:spPr bwMode="auto">
            <a:xfrm>
              <a:off x="-1328897" y="3775361"/>
              <a:ext cx="2401624" cy="854064"/>
            </a:xfrm>
            <a:custGeom>
              <a:avLst/>
              <a:gdLst>
                <a:gd name="T0" fmla="*/ 24 w 6851"/>
                <a:gd name="T1" fmla="*/ 227 h 998"/>
                <a:gd name="T2" fmla="*/ 52 w 6851"/>
                <a:gd name="T3" fmla="*/ 244 h 998"/>
                <a:gd name="T4" fmla="*/ 79 w 6851"/>
                <a:gd name="T5" fmla="*/ 249 h 998"/>
                <a:gd name="T6" fmla="*/ 107 w 6851"/>
                <a:gd name="T7" fmla="*/ 249 h 998"/>
                <a:gd name="T8" fmla="*/ 135 w 6851"/>
                <a:gd name="T9" fmla="*/ 249 h 998"/>
                <a:gd name="T10" fmla="*/ 162 w 6851"/>
                <a:gd name="T11" fmla="*/ 249 h 998"/>
                <a:gd name="T12" fmla="*/ 190 w 6851"/>
                <a:gd name="T13" fmla="*/ 250 h 998"/>
                <a:gd name="T14" fmla="*/ 217 w 6851"/>
                <a:gd name="T15" fmla="*/ 249 h 998"/>
                <a:gd name="T16" fmla="*/ 245 w 6851"/>
                <a:gd name="T17" fmla="*/ 249 h 998"/>
                <a:gd name="T18" fmla="*/ 272 w 6851"/>
                <a:gd name="T19" fmla="*/ 246 h 998"/>
                <a:gd name="T20" fmla="*/ 300 w 6851"/>
                <a:gd name="T21" fmla="*/ 241 h 998"/>
                <a:gd name="T22" fmla="*/ 328 w 6851"/>
                <a:gd name="T23" fmla="*/ 232 h 998"/>
                <a:gd name="T24" fmla="*/ 355 w 6851"/>
                <a:gd name="T25" fmla="*/ 220 h 998"/>
                <a:gd name="T26" fmla="*/ 383 w 6851"/>
                <a:gd name="T27" fmla="*/ 208 h 998"/>
                <a:gd name="T28" fmla="*/ 410 w 6851"/>
                <a:gd name="T29" fmla="*/ 199 h 998"/>
                <a:gd name="T30" fmla="*/ 438 w 6851"/>
                <a:gd name="T31" fmla="*/ 193 h 998"/>
                <a:gd name="T32" fmla="*/ 465 w 6851"/>
                <a:gd name="T33" fmla="*/ 190 h 998"/>
                <a:gd name="T34" fmla="*/ 493 w 6851"/>
                <a:gd name="T35" fmla="*/ 188 h 998"/>
                <a:gd name="T36" fmla="*/ 521 w 6851"/>
                <a:gd name="T37" fmla="*/ 185 h 998"/>
                <a:gd name="T38" fmla="*/ 548 w 6851"/>
                <a:gd name="T39" fmla="*/ 182 h 998"/>
                <a:gd name="T40" fmla="*/ 576 w 6851"/>
                <a:gd name="T41" fmla="*/ 182 h 998"/>
                <a:gd name="T42" fmla="*/ 603 w 6851"/>
                <a:gd name="T43" fmla="*/ 178 h 998"/>
                <a:gd name="T44" fmla="*/ 631 w 6851"/>
                <a:gd name="T45" fmla="*/ 178 h 998"/>
                <a:gd name="T46" fmla="*/ 658 w 6851"/>
                <a:gd name="T47" fmla="*/ 178 h 998"/>
                <a:gd name="T48" fmla="*/ 686 w 6851"/>
                <a:gd name="T49" fmla="*/ 178 h 998"/>
                <a:gd name="T50" fmla="*/ 714 w 6851"/>
                <a:gd name="T51" fmla="*/ 160 h 998"/>
                <a:gd name="T52" fmla="*/ 741 w 6851"/>
                <a:gd name="T53" fmla="*/ 157 h 998"/>
                <a:gd name="T54" fmla="*/ 769 w 6851"/>
                <a:gd name="T55" fmla="*/ 164 h 998"/>
                <a:gd name="T56" fmla="*/ 796 w 6851"/>
                <a:gd name="T57" fmla="*/ 172 h 998"/>
                <a:gd name="T58" fmla="*/ 824 w 6851"/>
                <a:gd name="T59" fmla="*/ 167 h 998"/>
                <a:gd name="T60" fmla="*/ 851 w 6851"/>
                <a:gd name="T61" fmla="*/ 171 h 998"/>
                <a:gd name="T62" fmla="*/ 879 w 6851"/>
                <a:gd name="T63" fmla="*/ 169 h 998"/>
                <a:gd name="T64" fmla="*/ 906 w 6851"/>
                <a:gd name="T65" fmla="*/ 168 h 998"/>
                <a:gd name="T66" fmla="*/ 934 w 6851"/>
                <a:gd name="T67" fmla="*/ 167 h 998"/>
                <a:gd name="T68" fmla="*/ 962 w 6851"/>
                <a:gd name="T69" fmla="*/ 164 h 998"/>
                <a:gd name="T70" fmla="*/ 989 w 6851"/>
                <a:gd name="T71" fmla="*/ 164 h 998"/>
                <a:gd name="T72" fmla="*/ 1017 w 6851"/>
                <a:gd name="T73" fmla="*/ 162 h 998"/>
                <a:gd name="T74" fmla="*/ 1044 w 6851"/>
                <a:gd name="T75" fmla="*/ 160 h 998"/>
                <a:gd name="T76" fmla="*/ 1072 w 6851"/>
                <a:gd name="T77" fmla="*/ 156 h 998"/>
                <a:gd name="T78" fmla="*/ 1099 w 6851"/>
                <a:gd name="T79" fmla="*/ 151 h 998"/>
                <a:gd name="T80" fmla="*/ 1127 w 6851"/>
                <a:gd name="T81" fmla="*/ 153 h 998"/>
                <a:gd name="T82" fmla="*/ 1155 w 6851"/>
                <a:gd name="T83" fmla="*/ 149 h 998"/>
                <a:gd name="T84" fmla="*/ 1182 w 6851"/>
                <a:gd name="T85" fmla="*/ 147 h 998"/>
                <a:gd name="T86" fmla="*/ 1210 w 6851"/>
                <a:gd name="T87" fmla="*/ 150 h 998"/>
                <a:gd name="T88" fmla="*/ 1237 w 6851"/>
                <a:gd name="T89" fmla="*/ 150 h 998"/>
                <a:gd name="T90" fmla="*/ 1265 w 6851"/>
                <a:gd name="T91" fmla="*/ 147 h 998"/>
                <a:gd name="T92" fmla="*/ 1292 w 6851"/>
                <a:gd name="T93" fmla="*/ 136 h 998"/>
                <a:gd name="T94" fmla="*/ 1320 w 6851"/>
                <a:gd name="T95" fmla="*/ 140 h 998"/>
                <a:gd name="T96" fmla="*/ 1348 w 6851"/>
                <a:gd name="T97" fmla="*/ 137 h 998"/>
                <a:gd name="T98" fmla="*/ 1375 w 6851"/>
                <a:gd name="T99" fmla="*/ 136 h 998"/>
                <a:gd name="T100" fmla="*/ 1403 w 6851"/>
                <a:gd name="T101" fmla="*/ 131 h 998"/>
                <a:gd name="T102" fmla="*/ 1430 w 6851"/>
                <a:gd name="T103" fmla="*/ 127 h 998"/>
                <a:gd name="T104" fmla="*/ 1458 w 6851"/>
                <a:gd name="T105" fmla="*/ 123 h 998"/>
                <a:gd name="T106" fmla="*/ 1485 w 6851"/>
                <a:gd name="T107" fmla="*/ 122 h 998"/>
                <a:gd name="T108" fmla="*/ 1513 w 6851"/>
                <a:gd name="T109" fmla="*/ 54 h 998"/>
                <a:gd name="T110" fmla="*/ 1541 w 6851"/>
                <a:gd name="T111" fmla="*/ 84 h 998"/>
                <a:gd name="T112" fmla="*/ 1568 w 6851"/>
                <a:gd name="T113" fmla="*/ 67 h 998"/>
                <a:gd name="T114" fmla="*/ 1596 w 6851"/>
                <a:gd name="T115" fmla="*/ 4 h 998"/>
                <a:gd name="T116" fmla="*/ 1623 w 6851"/>
                <a:gd name="T117" fmla="*/ 48 h 998"/>
                <a:gd name="T118" fmla="*/ 1651 w 6851"/>
                <a:gd name="T119" fmla="*/ 71 h 998"/>
                <a:gd name="T120" fmla="*/ 1678 w 6851"/>
                <a:gd name="T121" fmla="*/ 81 h 998"/>
                <a:gd name="T122" fmla="*/ 1706 w 6851"/>
                <a:gd name="T123" fmla="*/ 87 h 998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60000 65536"/>
                <a:gd name="T181" fmla="*/ 0 60000 65536"/>
                <a:gd name="T182" fmla="*/ 0 60000 65536"/>
                <a:gd name="T183" fmla="*/ 0 60000 65536"/>
                <a:gd name="T184" fmla="*/ 0 60000 65536"/>
                <a:gd name="T185" fmla="*/ 0 60000 65536"/>
              </a:gdLst>
              <a:ahLst/>
              <a:cxnLst>
                <a:cxn ang="T124">
                  <a:pos x="T0" y="T1"/>
                </a:cxn>
                <a:cxn ang="T125">
                  <a:pos x="T2" y="T3"/>
                </a:cxn>
                <a:cxn ang="T126">
                  <a:pos x="T4" y="T5"/>
                </a:cxn>
                <a:cxn ang="T127">
                  <a:pos x="T6" y="T7"/>
                </a:cxn>
                <a:cxn ang="T128">
                  <a:pos x="T8" y="T9"/>
                </a:cxn>
                <a:cxn ang="T129">
                  <a:pos x="T10" y="T11"/>
                </a:cxn>
                <a:cxn ang="T130">
                  <a:pos x="T12" y="T13"/>
                </a:cxn>
                <a:cxn ang="T131">
                  <a:pos x="T14" y="T15"/>
                </a:cxn>
                <a:cxn ang="T132">
                  <a:pos x="T16" y="T17"/>
                </a:cxn>
                <a:cxn ang="T133">
                  <a:pos x="T18" y="T19"/>
                </a:cxn>
                <a:cxn ang="T134">
                  <a:pos x="T20" y="T21"/>
                </a:cxn>
                <a:cxn ang="T135">
                  <a:pos x="T22" y="T23"/>
                </a:cxn>
                <a:cxn ang="T136">
                  <a:pos x="T24" y="T25"/>
                </a:cxn>
                <a:cxn ang="T137">
                  <a:pos x="T26" y="T27"/>
                </a:cxn>
                <a:cxn ang="T138">
                  <a:pos x="T28" y="T29"/>
                </a:cxn>
                <a:cxn ang="T139">
                  <a:pos x="T30" y="T31"/>
                </a:cxn>
                <a:cxn ang="T140">
                  <a:pos x="T32" y="T33"/>
                </a:cxn>
                <a:cxn ang="T141">
                  <a:pos x="T34" y="T35"/>
                </a:cxn>
                <a:cxn ang="T142">
                  <a:pos x="T36" y="T37"/>
                </a:cxn>
                <a:cxn ang="T143">
                  <a:pos x="T38" y="T39"/>
                </a:cxn>
                <a:cxn ang="T144">
                  <a:pos x="T40" y="T41"/>
                </a:cxn>
                <a:cxn ang="T145">
                  <a:pos x="T42" y="T43"/>
                </a:cxn>
                <a:cxn ang="T146">
                  <a:pos x="T44" y="T45"/>
                </a:cxn>
                <a:cxn ang="T147">
                  <a:pos x="T46" y="T47"/>
                </a:cxn>
                <a:cxn ang="T148">
                  <a:pos x="T48" y="T49"/>
                </a:cxn>
                <a:cxn ang="T149">
                  <a:pos x="T50" y="T51"/>
                </a:cxn>
                <a:cxn ang="T150">
                  <a:pos x="T52" y="T53"/>
                </a:cxn>
                <a:cxn ang="T151">
                  <a:pos x="T54" y="T55"/>
                </a:cxn>
                <a:cxn ang="T152">
                  <a:pos x="T56" y="T57"/>
                </a:cxn>
                <a:cxn ang="T153">
                  <a:pos x="T58" y="T59"/>
                </a:cxn>
                <a:cxn ang="T154">
                  <a:pos x="T60" y="T61"/>
                </a:cxn>
                <a:cxn ang="T155">
                  <a:pos x="T62" y="T63"/>
                </a:cxn>
                <a:cxn ang="T156">
                  <a:pos x="T64" y="T65"/>
                </a:cxn>
                <a:cxn ang="T157">
                  <a:pos x="T66" y="T67"/>
                </a:cxn>
                <a:cxn ang="T158">
                  <a:pos x="T68" y="T69"/>
                </a:cxn>
                <a:cxn ang="T159">
                  <a:pos x="T70" y="T71"/>
                </a:cxn>
                <a:cxn ang="T160">
                  <a:pos x="T72" y="T73"/>
                </a:cxn>
                <a:cxn ang="T161">
                  <a:pos x="T74" y="T75"/>
                </a:cxn>
                <a:cxn ang="T162">
                  <a:pos x="T76" y="T77"/>
                </a:cxn>
                <a:cxn ang="T163">
                  <a:pos x="T78" y="T79"/>
                </a:cxn>
                <a:cxn ang="T164">
                  <a:pos x="T80" y="T81"/>
                </a:cxn>
                <a:cxn ang="T165">
                  <a:pos x="T82" y="T83"/>
                </a:cxn>
                <a:cxn ang="T166">
                  <a:pos x="T84" y="T85"/>
                </a:cxn>
                <a:cxn ang="T167">
                  <a:pos x="T86" y="T87"/>
                </a:cxn>
                <a:cxn ang="T168">
                  <a:pos x="T88" y="T89"/>
                </a:cxn>
                <a:cxn ang="T169">
                  <a:pos x="T90" y="T91"/>
                </a:cxn>
                <a:cxn ang="T170">
                  <a:pos x="T92" y="T93"/>
                </a:cxn>
                <a:cxn ang="T171">
                  <a:pos x="T94" y="T95"/>
                </a:cxn>
                <a:cxn ang="T172">
                  <a:pos x="T96" y="T97"/>
                </a:cxn>
                <a:cxn ang="T173">
                  <a:pos x="T98" y="T99"/>
                </a:cxn>
                <a:cxn ang="T174">
                  <a:pos x="T100" y="T101"/>
                </a:cxn>
                <a:cxn ang="T175">
                  <a:pos x="T102" y="T103"/>
                </a:cxn>
                <a:cxn ang="T176">
                  <a:pos x="T104" y="T105"/>
                </a:cxn>
                <a:cxn ang="T177">
                  <a:pos x="T106" y="T107"/>
                </a:cxn>
                <a:cxn ang="T178">
                  <a:pos x="T108" y="T109"/>
                </a:cxn>
                <a:cxn ang="T179">
                  <a:pos x="T110" y="T111"/>
                </a:cxn>
                <a:cxn ang="T180">
                  <a:pos x="T112" y="T113"/>
                </a:cxn>
                <a:cxn ang="T181">
                  <a:pos x="T114" y="T115"/>
                </a:cxn>
                <a:cxn ang="T182">
                  <a:pos x="T116" y="T117"/>
                </a:cxn>
                <a:cxn ang="T183">
                  <a:pos x="T118" y="T119"/>
                </a:cxn>
                <a:cxn ang="T184">
                  <a:pos x="T120" y="T121"/>
                </a:cxn>
                <a:cxn ang="T185">
                  <a:pos x="T122" y="T123"/>
                </a:cxn>
              </a:cxnLst>
              <a:rect l="0" t="0" r="r" b="b"/>
              <a:pathLst>
                <a:path w="6851" h="998">
                  <a:moveTo>
                    <a:pt x="0" y="781"/>
                  </a:moveTo>
                  <a:lnTo>
                    <a:pt x="2" y="787"/>
                  </a:lnTo>
                  <a:lnTo>
                    <a:pt x="8" y="806"/>
                  </a:lnTo>
                  <a:lnTo>
                    <a:pt x="16" y="820"/>
                  </a:lnTo>
                  <a:lnTo>
                    <a:pt x="23" y="833"/>
                  </a:lnTo>
                  <a:lnTo>
                    <a:pt x="29" y="845"/>
                  </a:lnTo>
                  <a:lnTo>
                    <a:pt x="37" y="854"/>
                  </a:lnTo>
                  <a:lnTo>
                    <a:pt x="43" y="862"/>
                  </a:lnTo>
                  <a:lnTo>
                    <a:pt x="50" y="870"/>
                  </a:lnTo>
                  <a:lnTo>
                    <a:pt x="58" y="876"/>
                  </a:lnTo>
                  <a:lnTo>
                    <a:pt x="64" y="881"/>
                  </a:lnTo>
                  <a:lnTo>
                    <a:pt x="71" y="887"/>
                  </a:lnTo>
                  <a:lnTo>
                    <a:pt x="77" y="893"/>
                  </a:lnTo>
                  <a:lnTo>
                    <a:pt x="85" y="899"/>
                  </a:lnTo>
                  <a:lnTo>
                    <a:pt x="92" y="902"/>
                  </a:lnTo>
                  <a:lnTo>
                    <a:pt x="98" y="908"/>
                  </a:lnTo>
                  <a:lnTo>
                    <a:pt x="106" y="912"/>
                  </a:lnTo>
                  <a:lnTo>
                    <a:pt x="112" y="918"/>
                  </a:lnTo>
                  <a:lnTo>
                    <a:pt x="119" y="923"/>
                  </a:lnTo>
                  <a:lnTo>
                    <a:pt x="127" y="927"/>
                  </a:lnTo>
                  <a:lnTo>
                    <a:pt x="133" y="933"/>
                  </a:lnTo>
                  <a:lnTo>
                    <a:pt x="140" y="937"/>
                  </a:lnTo>
                  <a:lnTo>
                    <a:pt x="146" y="941"/>
                  </a:lnTo>
                  <a:lnTo>
                    <a:pt x="154" y="947"/>
                  </a:lnTo>
                  <a:lnTo>
                    <a:pt x="160" y="950"/>
                  </a:lnTo>
                  <a:lnTo>
                    <a:pt x="167" y="954"/>
                  </a:lnTo>
                  <a:lnTo>
                    <a:pt x="175" y="958"/>
                  </a:lnTo>
                  <a:lnTo>
                    <a:pt x="181" y="962"/>
                  </a:lnTo>
                  <a:lnTo>
                    <a:pt x="188" y="966"/>
                  </a:lnTo>
                  <a:lnTo>
                    <a:pt x="194" y="970"/>
                  </a:lnTo>
                  <a:lnTo>
                    <a:pt x="202" y="971"/>
                  </a:lnTo>
                  <a:lnTo>
                    <a:pt x="210" y="975"/>
                  </a:lnTo>
                  <a:lnTo>
                    <a:pt x="215" y="977"/>
                  </a:lnTo>
                  <a:lnTo>
                    <a:pt x="223" y="979"/>
                  </a:lnTo>
                  <a:lnTo>
                    <a:pt x="229" y="981"/>
                  </a:lnTo>
                  <a:lnTo>
                    <a:pt x="236" y="983"/>
                  </a:lnTo>
                  <a:lnTo>
                    <a:pt x="244" y="985"/>
                  </a:lnTo>
                  <a:lnTo>
                    <a:pt x="250" y="987"/>
                  </a:lnTo>
                  <a:lnTo>
                    <a:pt x="258" y="989"/>
                  </a:lnTo>
                  <a:lnTo>
                    <a:pt x="263" y="989"/>
                  </a:lnTo>
                  <a:lnTo>
                    <a:pt x="271" y="989"/>
                  </a:lnTo>
                  <a:lnTo>
                    <a:pt x="277" y="991"/>
                  </a:lnTo>
                  <a:lnTo>
                    <a:pt x="284" y="991"/>
                  </a:lnTo>
                  <a:lnTo>
                    <a:pt x="292" y="993"/>
                  </a:lnTo>
                  <a:lnTo>
                    <a:pt x="298" y="993"/>
                  </a:lnTo>
                  <a:lnTo>
                    <a:pt x="306" y="993"/>
                  </a:lnTo>
                  <a:lnTo>
                    <a:pt x="311" y="993"/>
                  </a:lnTo>
                  <a:lnTo>
                    <a:pt x="319" y="993"/>
                  </a:lnTo>
                  <a:lnTo>
                    <a:pt x="327" y="993"/>
                  </a:lnTo>
                  <a:lnTo>
                    <a:pt x="332" y="994"/>
                  </a:lnTo>
                  <a:lnTo>
                    <a:pt x="340" y="994"/>
                  </a:lnTo>
                  <a:lnTo>
                    <a:pt x="346" y="994"/>
                  </a:lnTo>
                  <a:lnTo>
                    <a:pt x="354" y="994"/>
                  </a:lnTo>
                  <a:lnTo>
                    <a:pt x="361" y="994"/>
                  </a:lnTo>
                  <a:lnTo>
                    <a:pt x="367" y="994"/>
                  </a:lnTo>
                  <a:lnTo>
                    <a:pt x="375" y="994"/>
                  </a:lnTo>
                  <a:lnTo>
                    <a:pt x="380" y="994"/>
                  </a:lnTo>
                  <a:lnTo>
                    <a:pt x="388" y="994"/>
                  </a:lnTo>
                  <a:lnTo>
                    <a:pt x="394" y="994"/>
                  </a:lnTo>
                  <a:lnTo>
                    <a:pt x="402" y="994"/>
                  </a:lnTo>
                  <a:lnTo>
                    <a:pt x="409" y="994"/>
                  </a:lnTo>
                  <a:lnTo>
                    <a:pt x="415" y="994"/>
                  </a:lnTo>
                  <a:lnTo>
                    <a:pt x="423" y="994"/>
                  </a:lnTo>
                  <a:lnTo>
                    <a:pt x="429" y="996"/>
                  </a:lnTo>
                  <a:lnTo>
                    <a:pt x="436" y="996"/>
                  </a:lnTo>
                  <a:lnTo>
                    <a:pt x="444" y="996"/>
                  </a:lnTo>
                  <a:lnTo>
                    <a:pt x="450" y="996"/>
                  </a:lnTo>
                  <a:lnTo>
                    <a:pt x="457" y="996"/>
                  </a:lnTo>
                  <a:lnTo>
                    <a:pt x="463" y="996"/>
                  </a:lnTo>
                  <a:lnTo>
                    <a:pt x="471" y="996"/>
                  </a:lnTo>
                  <a:lnTo>
                    <a:pt x="478" y="996"/>
                  </a:lnTo>
                  <a:lnTo>
                    <a:pt x="484" y="996"/>
                  </a:lnTo>
                  <a:lnTo>
                    <a:pt x="492" y="996"/>
                  </a:lnTo>
                  <a:lnTo>
                    <a:pt x="498" y="996"/>
                  </a:lnTo>
                  <a:lnTo>
                    <a:pt x="505" y="996"/>
                  </a:lnTo>
                  <a:lnTo>
                    <a:pt x="513" y="996"/>
                  </a:lnTo>
                  <a:lnTo>
                    <a:pt x="519" y="996"/>
                  </a:lnTo>
                  <a:lnTo>
                    <a:pt x="526" y="996"/>
                  </a:lnTo>
                  <a:lnTo>
                    <a:pt x="532" y="996"/>
                  </a:lnTo>
                  <a:lnTo>
                    <a:pt x="540" y="996"/>
                  </a:lnTo>
                  <a:lnTo>
                    <a:pt x="546" y="996"/>
                  </a:lnTo>
                  <a:lnTo>
                    <a:pt x="553" y="996"/>
                  </a:lnTo>
                  <a:lnTo>
                    <a:pt x="561" y="996"/>
                  </a:lnTo>
                  <a:lnTo>
                    <a:pt x="567" y="996"/>
                  </a:lnTo>
                  <a:lnTo>
                    <a:pt x="574" y="996"/>
                  </a:lnTo>
                  <a:lnTo>
                    <a:pt x="580" y="996"/>
                  </a:lnTo>
                  <a:lnTo>
                    <a:pt x="588" y="996"/>
                  </a:lnTo>
                  <a:lnTo>
                    <a:pt x="596" y="996"/>
                  </a:lnTo>
                  <a:lnTo>
                    <a:pt x="601" y="996"/>
                  </a:lnTo>
                  <a:lnTo>
                    <a:pt x="609" y="996"/>
                  </a:lnTo>
                  <a:lnTo>
                    <a:pt x="615" y="996"/>
                  </a:lnTo>
                  <a:lnTo>
                    <a:pt x="622" y="996"/>
                  </a:lnTo>
                  <a:lnTo>
                    <a:pt x="630" y="996"/>
                  </a:lnTo>
                  <a:lnTo>
                    <a:pt x="636" y="996"/>
                  </a:lnTo>
                  <a:lnTo>
                    <a:pt x="644" y="996"/>
                  </a:lnTo>
                  <a:lnTo>
                    <a:pt x="649" y="996"/>
                  </a:lnTo>
                  <a:lnTo>
                    <a:pt x="657" y="996"/>
                  </a:lnTo>
                  <a:lnTo>
                    <a:pt x="663" y="996"/>
                  </a:lnTo>
                  <a:lnTo>
                    <a:pt x="670" y="996"/>
                  </a:lnTo>
                  <a:lnTo>
                    <a:pt x="678" y="996"/>
                  </a:lnTo>
                  <a:lnTo>
                    <a:pt x="684" y="996"/>
                  </a:lnTo>
                  <a:lnTo>
                    <a:pt x="692" y="996"/>
                  </a:lnTo>
                  <a:lnTo>
                    <a:pt x="697" y="998"/>
                  </a:lnTo>
                  <a:lnTo>
                    <a:pt x="705" y="998"/>
                  </a:lnTo>
                  <a:lnTo>
                    <a:pt x="713" y="998"/>
                  </a:lnTo>
                  <a:lnTo>
                    <a:pt x="718" y="996"/>
                  </a:lnTo>
                  <a:lnTo>
                    <a:pt x="726" y="998"/>
                  </a:lnTo>
                  <a:lnTo>
                    <a:pt x="732" y="998"/>
                  </a:lnTo>
                  <a:lnTo>
                    <a:pt x="740" y="998"/>
                  </a:lnTo>
                  <a:lnTo>
                    <a:pt x="747" y="998"/>
                  </a:lnTo>
                  <a:lnTo>
                    <a:pt x="753" y="998"/>
                  </a:lnTo>
                  <a:lnTo>
                    <a:pt x="761" y="998"/>
                  </a:lnTo>
                  <a:lnTo>
                    <a:pt x="766" y="998"/>
                  </a:lnTo>
                  <a:lnTo>
                    <a:pt x="774" y="998"/>
                  </a:lnTo>
                  <a:lnTo>
                    <a:pt x="782" y="998"/>
                  </a:lnTo>
                  <a:lnTo>
                    <a:pt x="788" y="998"/>
                  </a:lnTo>
                  <a:lnTo>
                    <a:pt x="795" y="996"/>
                  </a:lnTo>
                  <a:lnTo>
                    <a:pt x="801" y="996"/>
                  </a:lnTo>
                  <a:lnTo>
                    <a:pt x="809" y="996"/>
                  </a:lnTo>
                  <a:lnTo>
                    <a:pt x="814" y="996"/>
                  </a:lnTo>
                  <a:lnTo>
                    <a:pt x="822" y="996"/>
                  </a:lnTo>
                  <a:lnTo>
                    <a:pt x="830" y="996"/>
                  </a:lnTo>
                  <a:lnTo>
                    <a:pt x="836" y="996"/>
                  </a:lnTo>
                  <a:lnTo>
                    <a:pt x="843" y="996"/>
                  </a:lnTo>
                  <a:lnTo>
                    <a:pt x="849" y="996"/>
                  </a:lnTo>
                  <a:lnTo>
                    <a:pt x="857" y="996"/>
                  </a:lnTo>
                  <a:lnTo>
                    <a:pt x="864" y="996"/>
                  </a:lnTo>
                  <a:lnTo>
                    <a:pt x="870" y="996"/>
                  </a:lnTo>
                  <a:lnTo>
                    <a:pt x="878" y="996"/>
                  </a:lnTo>
                  <a:lnTo>
                    <a:pt x="884" y="996"/>
                  </a:lnTo>
                  <a:lnTo>
                    <a:pt x="891" y="996"/>
                  </a:lnTo>
                  <a:lnTo>
                    <a:pt x="899" y="996"/>
                  </a:lnTo>
                  <a:lnTo>
                    <a:pt x="905" y="994"/>
                  </a:lnTo>
                  <a:lnTo>
                    <a:pt x="912" y="994"/>
                  </a:lnTo>
                  <a:lnTo>
                    <a:pt x="918" y="994"/>
                  </a:lnTo>
                  <a:lnTo>
                    <a:pt x="926" y="994"/>
                  </a:lnTo>
                  <a:lnTo>
                    <a:pt x="932" y="994"/>
                  </a:lnTo>
                  <a:lnTo>
                    <a:pt x="939" y="994"/>
                  </a:lnTo>
                  <a:lnTo>
                    <a:pt x="947" y="994"/>
                  </a:lnTo>
                  <a:lnTo>
                    <a:pt x="953" y="994"/>
                  </a:lnTo>
                  <a:lnTo>
                    <a:pt x="960" y="993"/>
                  </a:lnTo>
                  <a:lnTo>
                    <a:pt x="966" y="993"/>
                  </a:lnTo>
                  <a:lnTo>
                    <a:pt x="974" y="993"/>
                  </a:lnTo>
                  <a:lnTo>
                    <a:pt x="981" y="993"/>
                  </a:lnTo>
                  <a:lnTo>
                    <a:pt x="987" y="993"/>
                  </a:lnTo>
                  <a:lnTo>
                    <a:pt x="995" y="991"/>
                  </a:lnTo>
                  <a:lnTo>
                    <a:pt x="1001" y="991"/>
                  </a:lnTo>
                  <a:lnTo>
                    <a:pt x="1008" y="991"/>
                  </a:lnTo>
                  <a:lnTo>
                    <a:pt x="1016" y="989"/>
                  </a:lnTo>
                  <a:lnTo>
                    <a:pt x="1022" y="989"/>
                  </a:lnTo>
                  <a:lnTo>
                    <a:pt x="1029" y="989"/>
                  </a:lnTo>
                  <a:lnTo>
                    <a:pt x="1035" y="987"/>
                  </a:lnTo>
                  <a:lnTo>
                    <a:pt x="1043" y="987"/>
                  </a:lnTo>
                  <a:lnTo>
                    <a:pt x="1049" y="987"/>
                  </a:lnTo>
                  <a:lnTo>
                    <a:pt x="1056" y="985"/>
                  </a:lnTo>
                  <a:lnTo>
                    <a:pt x="1064" y="985"/>
                  </a:lnTo>
                  <a:lnTo>
                    <a:pt x="1070" y="983"/>
                  </a:lnTo>
                  <a:lnTo>
                    <a:pt x="1078" y="983"/>
                  </a:lnTo>
                  <a:lnTo>
                    <a:pt x="1083" y="981"/>
                  </a:lnTo>
                  <a:lnTo>
                    <a:pt x="1091" y="981"/>
                  </a:lnTo>
                  <a:lnTo>
                    <a:pt x="1099" y="979"/>
                  </a:lnTo>
                  <a:lnTo>
                    <a:pt x="1104" y="979"/>
                  </a:lnTo>
                  <a:lnTo>
                    <a:pt x="1112" y="979"/>
                  </a:lnTo>
                  <a:lnTo>
                    <a:pt x="1118" y="977"/>
                  </a:lnTo>
                  <a:lnTo>
                    <a:pt x="1126" y="975"/>
                  </a:lnTo>
                  <a:lnTo>
                    <a:pt x="1133" y="975"/>
                  </a:lnTo>
                  <a:lnTo>
                    <a:pt x="1139" y="973"/>
                  </a:lnTo>
                  <a:lnTo>
                    <a:pt x="1147" y="973"/>
                  </a:lnTo>
                  <a:lnTo>
                    <a:pt x="1152" y="971"/>
                  </a:lnTo>
                  <a:lnTo>
                    <a:pt x="1160" y="971"/>
                  </a:lnTo>
                  <a:lnTo>
                    <a:pt x="1168" y="970"/>
                  </a:lnTo>
                  <a:lnTo>
                    <a:pt x="1174" y="968"/>
                  </a:lnTo>
                  <a:lnTo>
                    <a:pt x="1181" y="966"/>
                  </a:lnTo>
                  <a:lnTo>
                    <a:pt x="1187" y="966"/>
                  </a:lnTo>
                  <a:lnTo>
                    <a:pt x="1195" y="964"/>
                  </a:lnTo>
                  <a:lnTo>
                    <a:pt x="1200" y="962"/>
                  </a:lnTo>
                  <a:lnTo>
                    <a:pt x="1208" y="960"/>
                  </a:lnTo>
                  <a:lnTo>
                    <a:pt x="1216" y="958"/>
                  </a:lnTo>
                  <a:lnTo>
                    <a:pt x="1222" y="958"/>
                  </a:lnTo>
                  <a:lnTo>
                    <a:pt x="1229" y="954"/>
                  </a:lnTo>
                  <a:lnTo>
                    <a:pt x="1235" y="952"/>
                  </a:lnTo>
                  <a:lnTo>
                    <a:pt x="1243" y="950"/>
                  </a:lnTo>
                  <a:lnTo>
                    <a:pt x="1250" y="948"/>
                  </a:lnTo>
                  <a:lnTo>
                    <a:pt x="1256" y="947"/>
                  </a:lnTo>
                  <a:lnTo>
                    <a:pt x="1264" y="945"/>
                  </a:lnTo>
                  <a:lnTo>
                    <a:pt x="1270" y="941"/>
                  </a:lnTo>
                  <a:lnTo>
                    <a:pt x="1277" y="939"/>
                  </a:lnTo>
                  <a:lnTo>
                    <a:pt x="1285" y="937"/>
                  </a:lnTo>
                  <a:lnTo>
                    <a:pt x="1291" y="935"/>
                  </a:lnTo>
                  <a:lnTo>
                    <a:pt x="1298" y="931"/>
                  </a:lnTo>
                  <a:lnTo>
                    <a:pt x="1304" y="929"/>
                  </a:lnTo>
                  <a:lnTo>
                    <a:pt x="1312" y="925"/>
                  </a:lnTo>
                  <a:lnTo>
                    <a:pt x="1318" y="923"/>
                  </a:lnTo>
                  <a:lnTo>
                    <a:pt x="1325" y="922"/>
                  </a:lnTo>
                  <a:lnTo>
                    <a:pt x="1333" y="918"/>
                  </a:lnTo>
                  <a:lnTo>
                    <a:pt x="1339" y="916"/>
                  </a:lnTo>
                  <a:lnTo>
                    <a:pt x="1346" y="912"/>
                  </a:lnTo>
                  <a:lnTo>
                    <a:pt x="1352" y="910"/>
                  </a:lnTo>
                  <a:lnTo>
                    <a:pt x="1360" y="906"/>
                  </a:lnTo>
                  <a:lnTo>
                    <a:pt x="1367" y="904"/>
                  </a:lnTo>
                  <a:lnTo>
                    <a:pt x="1373" y="900"/>
                  </a:lnTo>
                  <a:lnTo>
                    <a:pt x="1381" y="899"/>
                  </a:lnTo>
                  <a:lnTo>
                    <a:pt x="1387" y="895"/>
                  </a:lnTo>
                  <a:lnTo>
                    <a:pt x="1394" y="893"/>
                  </a:lnTo>
                  <a:lnTo>
                    <a:pt x="1402" y="889"/>
                  </a:lnTo>
                  <a:lnTo>
                    <a:pt x="1408" y="887"/>
                  </a:lnTo>
                  <a:lnTo>
                    <a:pt x="1415" y="883"/>
                  </a:lnTo>
                  <a:lnTo>
                    <a:pt x="1421" y="879"/>
                  </a:lnTo>
                  <a:lnTo>
                    <a:pt x="1429" y="877"/>
                  </a:lnTo>
                  <a:lnTo>
                    <a:pt x="1435" y="874"/>
                  </a:lnTo>
                  <a:lnTo>
                    <a:pt x="1442" y="870"/>
                  </a:lnTo>
                  <a:lnTo>
                    <a:pt x="1450" y="868"/>
                  </a:lnTo>
                  <a:lnTo>
                    <a:pt x="1456" y="864"/>
                  </a:lnTo>
                  <a:lnTo>
                    <a:pt x="1463" y="862"/>
                  </a:lnTo>
                  <a:lnTo>
                    <a:pt x="1469" y="858"/>
                  </a:lnTo>
                  <a:lnTo>
                    <a:pt x="1477" y="854"/>
                  </a:lnTo>
                  <a:lnTo>
                    <a:pt x="1485" y="852"/>
                  </a:lnTo>
                  <a:lnTo>
                    <a:pt x="1490" y="849"/>
                  </a:lnTo>
                  <a:lnTo>
                    <a:pt x="1498" y="847"/>
                  </a:lnTo>
                  <a:lnTo>
                    <a:pt x="1504" y="843"/>
                  </a:lnTo>
                  <a:lnTo>
                    <a:pt x="1511" y="841"/>
                  </a:lnTo>
                  <a:lnTo>
                    <a:pt x="1519" y="837"/>
                  </a:lnTo>
                  <a:lnTo>
                    <a:pt x="1525" y="835"/>
                  </a:lnTo>
                  <a:lnTo>
                    <a:pt x="1533" y="831"/>
                  </a:lnTo>
                  <a:lnTo>
                    <a:pt x="1538" y="829"/>
                  </a:lnTo>
                  <a:lnTo>
                    <a:pt x="1546" y="826"/>
                  </a:lnTo>
                  <a:lnTo>
                    <a:pt x="1554" y="824"/>
                  </a:lnTo>
                  <a:lnTo>
                    <a:pt x="1559" y="822"/>
                  </a:lnTo>
                  <a:lnTo>
                    <a:pt x="1567" y="820"/>
                  </a:lnTo>
                  <a:lnTo>
                    <a:pt x="1573" y="818"/>
                  </a:lnTo>
                  <a:lnTo>
                    <a:pt x="1581" y="814"/>
                  </a:lnTo>
                  <a:lnTo>
                    <a:pt x="1586" y="812"/>
                  </a:lnTo>
                  <a:lnTo>
                    <a:pt x="1594" y="810"/>
                  </a:lnTo>
                  <a:lnTo>
                    <a:pt x="1602" y="808"/>
                  </a:lnTo>
                  <a:lnTo>
                    <a:pt x="1607" y="805"/>
                  </a:lnTo>
                  <a:lnTo>
                    <a:pt x="1615" y="803"/>
                  </a:lnTo>
                  <a:lnTo>
                    <a:pt x="1621" y="801"/>
                  </a:lnTo>
                  <a:lnTo>
                    <a:pt x="1629" y="799"/>
                  </a:lnTo>
                  <a:lnTo>
                    <a:pt x="1636" y="797"/>
                  </a:lnTo>
                  <a:lnTo>
                    <a:pt x="1642" y="795"/>
                  </a:lnTo>
                  <a:lnTo>
                    <a:pt x="1650" y="793"/>
                  </a:lnTo>
                  <a:lnTo>
                    <a:pt x="1655" y="791"/>
                  </a:lnTo>
                  <a:lnTo>
                    <a:pt x="1663" y="789"/>
                  </a:lnTo>
                  <a:lnTo>
                    <a:pt x="1671" y="787"/>
                  </a:lnTo>
                  <a:lnTo>
                    <a:pt x="1677" y="787"/>
                  </a:lnTo>
                  <a:lnTo>
                    <a:pt x="1684" y="785"/>
                  </a:lnTo>
                  <a:lnTo>
                    <a:pt x="1690" y="783"/>
                  </a:lnTo>
                  <a:lnTo>
                    <a:pt x="1698" y="783"/>
                  </a:lnTo>
                  <a:lnTo>
                    <a:pt x="1703" y="781"/>
                  </a:lnTo>
                  <a:lnTo>
                    <a:pt x="1711" y="780"/>
                  </a:lnTo>
                  <a:lnTo>
                    <a:pt x="1719" y="780"/>
                  </a:lnTo>
                  <a:lnTo>
                    <a:pt x="1725" y="778"/>
                  </a:lnTo>
                  <a:lnTo>
                    <a:pt x="1732" y="776"/>
                  </a:lnTo>
                  <a:lnTo>
                    <a:pt x="1738" y="776"/>
                  </a:lnTo>
                  <a:lnTo>
                    <a:pt x="1746" y="774"/>
                  </a:lnTo>
                  <a:lnTo>
                    <a:pt x="1753" y="772"/>
                  </a:lnTo>
                  <a:lnTo>
                    <a:pt x="1759" y="772"/>
                  </a:lnTo>
                  <a:lnTo>
                    <a:pt x="1767" y="770"/>
                  </a:lnTo>
                  <a:lnTo>
                    <a:pt x="1773" y="768"/>
                  </a:lnTo>
                  <a:lnTo>
                    <a:pt x="1780" y="768"/>
                  </a:lnTo>
                  <a:lnTo>
                    <a:pt x="1788" y="766"/>
                  </a:lnTo>
                  <a:lnTo>
                    <a:pt x="1794" y="766"/>
                  </a:lnTo>
                  <a:lnTo>
                    <a:pt x="1801" y="764"/>
                  </a:lnTo>
                  <a:lnTo>
                    <a:pt x="1807" y="764"/>
                  </a:lnTo>
                  <a:lnTo>
                    <a:pt x="1815" y="762"/>
                  </a:lnTo>
                  <a:lnTo>
                    <a:pt x="1823" y="762"/>
                  </a:lnTo>
                  <a:lnTo>
                    <a:pt x="1828" y="760"/>
                  </a:lnTo>
                  <a:lnTo>
                    <a:pt x="1836" y="760"/>
                  </a:lnTo>
                  <a:lnTo>
                    <a:pt x="1842" y="760"/>
                  </a:lnTo>
                  <a:lnTo>
                    <a:pt x="1849" y="758"/>
                  </a:lnTo>
                  <a:lnTo>
                    <a:pt x="1855" y="758"/>
                  </a:lnTo>
                  <a:lnTo>
                    <a:pt x="1863" y="757"/>
                  </a:lnTo>
                  <a:lnTo>
                    <a:pt x="1871" y="757"/>
                  </a:lnTo>
                  <a:lnTo>
                    <a:pt x="1876" y="757"/>
                  </a:lnTo>
                  <a:lnTo>
                    <a:pt x="1884" y="757"/>
                  </a:lnTo>
                  <a:lnTo>
                    <a:pt x="1890" y="755"/>
                  </a:lnTo>
                  <a:lnTo>
                    <a:pt x="1897" y="755"/>
                  </a:lnTo>
                  <a:lnTo>
                    <a:pt x="1905" y="753"/>
                  </a:lnTo>
                  <a:lnTo>
                    <a:pt x="1911" y="753"/>
                  </a:lnTo>
                  <a:lnTo>
                    <a:pt x="1919" y="753"/>
                  </a:lnTo>
                  <a:lnTo>
                    <a:pt x="1924" y="753"/>
                  </a:lnTo>
                  <a:lnTo>
                    <a:pt x="1932" y="751"/>
                  </a:lnTo>
                  <a:lnTo>
                    <a:pt x="1940" y="751"/>
                  </a:lnTo>
                  <a:lnTo>
                    <a:pt x="1945" y="751"/>
                  </a:lnTo>
                  <a:lnTo>
                    <a:pt x="1953" y="749"/>
                  </a:lnTo>
                  <a:lnTo>
                    <a:pt x="1959" y="749"/>
                  </a:lnTo>
                  <a:lnTo>
                    <a:pt x="1967" y="749"/>
                  </a:lnTo>
                  <a:lnTo>
                    <a:pt x="1972" y="749"/>
                  </a:lnTo>
                  <a:lnTo>
                    <a:pt x="1980" y="747"/>
                  </a:lnTo>
                  <a:lnTo>
                    <a:pt x="1988" y="747"/>
                  </a:lnTo>
                  <a:lnTo>
                    <a:pt x="1993" y="747"/>
                  </a:lnTo>
                  <a:lnTo>
                    <a:pt x="2001" y="745"/>
                  </a:lnTo>
                  <a:lnTo>
                    <a:pt x="2007" y="745"/>
                  </a:lnTo>
                  <a:lnTo>
                    <a:pt x="2015" y="745"/>
                  </a:lnTo>
                  <a:lnTo>
                    <a:pt x="2022" y="745"/>
                  </a:lnTo>
                  <a:lnTo>
                    <a:pt x="2028" y="743"/>
                  </a:lnTo>
                  <a:lnTo>
                    <a:pt x="2036" y="743"/>
                  </a:lnTo>
                  <a:lnTo>
                    <a:pt x="2041" y="743"/>
                  </a:lnTo>
                  <a:lnTo>
                    <a:pt x="2049" y="741"/>
                  </a:lnTo>
                  <a:lnTo>
                    <a:pt x="2057" y="741"/>
                  </a:lnTo>
                  <a:lnTo>
                    <a:pt x="2063" y="741"/>
                  </a:lnTo>
                  <a:lnTo>
                    <a:pt x="2070" y="741"/>
                  </a:lnTo>
                  <a:lnTo>
                    <a:pt x="2076" y="739"/>
                  </a:lnTo>
                  <a:lnTo>
                    <a:pt x="2084" y="739"/>
                  </a:lnTo>
                  <a:lnTo>
                    <a:pt x="2089" y="737"/>
                  </a:lnTo>
                  <a:lnTo>
                    <a:pt x="2097" y="735"/>
                  </a:lnTo>
                  <a:lnTo>
                    <a:pt x="2105" y="734"/>
                  </a:lnTo>
                  <a:lnTo>
                    <a:pt x="2111" y="732"/>
                  </a:lnTo>
                  <a:lnTo>
                    <a:pt x="2118" y="730"/>
                  </a:lnTo>
                  <a:lnTo>
                    <a:pt x="2124" y="728"/>
                  </a:lnTo>
                  <a:lnTo>
                    <a:pt x="2132" y="726"/>
                  </a:lnTo>
                  <a:lnTo>
                    <a:pt x="2139" y="726"/>
                  </a:lnTo>
                  <a:lnTo>
                    <a:pt x="2145" y="724"/>
                  </a:lnTo>
                  <a:lnTo>
                    <a:pt x="2153" y="726"/>
                  </a:lnTo>
                  <a:lnTo>
                    <a:pt x="2159" y="726"/>
                  </a:lnTo>
                  <a:lnTo>
                    <a:pt x="2166" y="726"/>
                  </a:lnTo>
                  <a:lnTo>
                    <a:pt x="2174" y="728"/>
                  </a:lnTo>
                  <a:lnTo>
                    <a:pt x="2180" y="728"/>
                  </a:lnTo>
                  <a:lnTo>
                    <a:pt x="2187" y="728"/>
                  </a:lnTo>
                  <a:lnTo>
                    <a:pt x="2193" y="728"/>
                  </a:lnTo>
                  <a:lnTo>
                    <a:pt x="2201" y="730"/>
                  </a:lnTo>
                  <a:lnTo>
                    <a:pt x="2208" y="730"/>
                  </a:lnTo>
                  <a:lnTo>
                    <a:pt x="2214" y="730"/>
                  </a:lnTo>
                  <a:lnTo>
                    <a:pt x="2222" y="730"/>
                  </a:lnTo>
                  <a:lnTo>
                    <a:pt x="2228" y="730"/>
                  </a:lnTo>
                  <a:lnTo>
                    <a:pt x="2235" y="730"/>
                  </a:lnTo>
                  <a:lnTo>
                    <a:pt x="2241" y="730"/>
                  </a:lnTo>
                  <a:lnTo>
                    <a:pt x="2249" y="730"/>
                  </a:lnTo>
                  <a:lnTo>
                    <a:pt x="2256" y="730"/>
                  </a:lnTo>
                  <a:lnTo>
                    <a:pt x="2262" y="730"/>
                  </a:lnTo>
                  <a:lnTo>
                    <a:pt x="2270" y="730"/>
                  </a:lnTo>
                  <a:lnTo>
                    <a:pt x="2276" y="728"/>
                  </a:lnTo>
                  <a:lnTo>
                    <a:pt x="2283" y="728"/>
                  </a:lnTo>
                  <a:lnTo>
                    <a:pt x="2291" y="728"/>
                  </a:lnTo>
                  <a:lnTo>
                    <a:pt x="2297" y="726"/>
                  </a:lnTo>
                  <a:lnTo>
                    <a:pt x="2304" y="726"/>
                  </a:lnTo>
                  <a:lnTo>
                    <a:pt x="2310" y="724"/>
                  </a:lnTo>
                  <a:lnTo>
                    <a:pt x="2318" y="724"/>
                  </a:lnTo>
                  <a:lnTo>
                    <a:pt x="2326" y="724"/>
                  </a:lnTo>
                  <a:lnTo>
                    <a:pt x="2331" y="722"/>
                  </a:lnTo>
                  <a:lnTo>
                    <a:pt x="2339" y="722"/>
                  </a:lnTo>
                  <a:lnTo>
                    <a:pt x="2345" y="722"/>
                  </a:lnTo>
                  <a:lnTo>
                    <a:pt x="2352" y="722"/>
                  </a:lnTo>
                  <a:lnTo>
                    <a:pt x="2358" y="722"/>
                  </a:lnTo>
                  <a:lnTo>
                    <a:pt x="2366" y="722"/>
                  </a:lnTo>
                  <a:lnTo>
                    <a:pt x="2374" y="722"/>
                  </a:lnTo>
                  <a:lnTo>
                    <a:pt x="2379" y="720"/>
                  </a:lnTo>
                  <a:lnTo>
                    <a:pt x="2387" y="718"/>
                  </a:lnTo>
                  <a:lnTo>
                    <a:pt x="2393" y="718"/>
                  </a:lnTo>
                  <a:lnTo>
                    <a:pt x="2400" y="716"/>
                  </a:lnTo>
                  <a:lnTo>
                    <a:pt x="2408" y="714"/>
                  </a:lnTo>
                  <a:lnTo>
                    <a:pt x="2414" y="712"/>
                  </a:lnTo>
                  <a:lnTo>
                    <a:pt x="2422" y="712"/>
                  </a:lnTo>
                  <a:lnTo>
                    <a:pt x="2427" y="710"/>
                  </a:lnTo>
                  <a:lnTo>
                    <a:pt x="2435" y="712"/>
                  </a:lnTo>
                  <a:lnTo>
                    <a:pt x="2443" y="712"/>
                  </a:lnTo>
                  <a:lnTo>
                    <a:pt x="2448" y="712"/>
                  </a:lnTo>
                  <a:lnTo>
                    <a:pt x="2456" y="712"/>
                  </a:lnTo>
                  <a:lnTo>
                    <a:pt x="2462" y="712"/>
                  </a:lnTo>
                  <a:lnTo>
                    <a:pt x="2470" y="712"/>
                  </a:lnTo>
                  <a:lnTo>
                    <a:pt x="2477" y="714"/>
                  </a:lnTo>
                  <a:lnTo>
                    <a:pt x="2483" y="712"/>
                  </a:lnTo>
                  <a:lnTo>
                    <a:pt x="2491" y="712"/>
                  </a:lnTo>
                  <a:lnTo>
                    <a:pt x="2496" y="712"/>
                  </a:lnTo>
                  <a:lnTo>
                    <a:pt x="2504" y="712"/>
                  </a:lnTo>
                  <a:lnTo>
                    <a:pt x="2510" y="710"/>
                  </a:lnTo>
                  <a:lnTo>
                    <a:pt x="2518" y="710"/>
                  </a:lnTo>
                  <a:lnTo>
                    <a:pt x="2525" y="709"/>
                  </a:lnTo>
                  <a:lnTo>
                    <a:pt x="2531" y="709"/>
                  </a:lnTo>
                  <a:lnTo>
                    <a:pt x="2539" y="707"/>
                  </a:lnTo>
                  <a:lnTo>
                    <a:pt x="2544" y="707"/>
                  </a:lnTo>
                  <a:lnTo>
                    <a:pt x="2552" y="707"/>
                  </a:lnTo>
                  <a:lnTo>
                    <a:pt x="2560" y="709"/>
                  </a:lnTo>
                  <a:lnTo>
                    <a:pt x="2566" y="709"/>
                  </a:lnTo>
                  <a:lnTo>
                    <a:pt x="2573" y="709"/>
                  </a:lnTo>
                  <a:lnTo>
                    <a:pt x="2579" y="710"/>
                  </a:lnTo>
                  <a:lnTo>
                    <a:pt x="2587" y="710"/>
                  </a:lnTo>
                  <a:lnTo>
                    <a:pt x="2594" y="712"/>
                  </a:lnTo>
                  <a:lnTo>
                    <a:pt x="2600" y="712"/>
                  </a:lnTo>
                  <a:lnTo>
                    <a:pt x="2608" y="712"/>
                  </a:lnTo>
                  <a:lnTo>
                    <a:pt x="2614" y="712"/>
                  </a:lnTo>
                  <a:lnTo>
                    <a:pt x="2621" y="714"/>
                  </a:lnTo>
                  <a:lnTo>
                    <a:pt x="2627" y="712"/>
                  </a:lnTo>
                  <a:lnTo>
                    <a:pt x="2635" y="712"/>
                  </a:lnTo>
                  <a:lnTo>
                    <a:pt x="2642" y="712"/>
                  </a:lnTo>
                  <a:lnTo>
                    <a:pt x="2648" y="712"/>
                  </a:lnTo>
                  <a:lnTo>
                    <a:pt x="2656" y="712"/>
                  </a:lnTo>
                  <a:lnTo>
                    <a:pt x="2662" y="712"/>
                  </a:lnTo>
                  <a:lnTo>
                    <a:pt x="2669" y="710"/>
                  </a:lnTo>
                  <a:lnTo>
                    <a:pt x="2677" y="710"/>
                  </a:lnTo>
                  <a:lnTo>
                    <a:pt x="2683" y="712"/>
                  </a:lnTo>
                  <a:lnTo>
                    <a:pt x="2690" y="712"/>
                  </a:lnTo>
                  <a:lnTo>
                    <a:pt x="2696" y="712"/>
                  </a:lnTo>
                  <a:lnTo>
                    <a:pt x="2704" y="712"/>
                  </a:lnTo>
                  <a:lnTo>
                    <a:pt x="2712" y="712"/>
                  </a:lnTo>
                  <a:lnTo>
                    <a:pt x="2717" y="712"/>
                  </a:lnTo>
                  <a:lnTo>
                    <a:pt x="2725" y="712"/>
                  </a:lnTo>
                  <a:lnTo>
                    <a:pt x="2731" y="712"/>
                  </a:lnTo>
                  <a:lnTo>
                    <a:pt x="2738" y="712"/>
                  </a:lnTo>
                  <a:lnTo>
                    <a:pt x="2744" y="710"/>
                  </a:lnTo>
                  <a:lnTo>
                    <a:pt x="2752" y="710"/>
                  </a:lnTo>
                  <a:lnTo>
                    <a:pt x="2760" y="710"/>
                  </a:lnTo>
                  <a:lnTo>
                    <a:pt x="2765" y="709"/>
                  </a:lnTo>
                  <a:lnTo>
                    <a:pt x="2773" y="707"/>
                  </a:lnTo>
                  <a:lnTo>
                    <a:pt x="2779" y="705"/>
                  </a:lnTo>
                  <a:lnTo>
                    <a:pt x="2786" y="703"/>
                  </a:lnTo>
                  <a:lnTo>
                    <a:pt x="2794" y="699"/>
                  </a:lnTo>
                  <a:lnTo>
                    <a:pt x="2800" y="695"/>
                  </a:lnTo>
                  <a:lnTo>
                    <a:pt x="2808" y="689"/>
                  </a:lnTo>
                  <a:lnTo>
                    <a:pt x="2813" y="684"/>
                  </a:lnTo>
                  <a:lnTo>
                    <a:pt x="2821" y="678"/>
                  </a:lnTo>
                  <a:lnTo>
                    <a:pt x="2829" y="672"/>
                  </a:lnTo>
                  <a:lnTo>
                    <a:pt x="2834" y="666"/>
                  </a:lnTo>
                  <a:lnTo>
                    <a:pt x="2842" y="657"/>
                  </a:lnTo>
                  <a:lnTo>
                    <a:pt x="2848" y="649"/>
                  </a:lnTo>
                  <a:lnTo>
                    <a:pt x="2856" y="639"/>
                  </a:lnTo>
                  <a:lnTo>
                    <a:pt x="2863" y="632"/>
                  </a:lnTo>
                  <a:lnTo>
                    <a:pt x="2869" y="630"/>
                  </a:lnTo>
                  <a:lnTo>
                    <a:pt x="2877" y="632"/>
                  </a:lnTo>
                  <a:lnTo>
                    <a:pt x="2882" y="636"/>
                  </a:lnTo>
                  <a:lnTo>
                    <a:pt x="2890" y="643"/>
                  </a:lnTo>
                  <a:lnTo>
                    <a:pt x="2896" y="649"/>
                  </a:lnTo>
                  <a:lnTo>
                    <a:pt x="2904" y="655"/>
                  </a:lnTo>
                  <a:lnTo>
                    <a:pt x="2911" y="657"/>
                  </a:lnTo>
                  <a:lnTo>
                    <a:pt x="2917" y="657"/>
                  </a:lnTo>
                  <a:lnTo>
                    <a:pt x="2925" y="653"/>
                  </a:lnTo>
                  <a:lnTo>
                    <a:pt x="2930" y="645"/>
                  </a:lnTo>
                  <a:lnTo>
                    <a:pt x="2938" y="634"/>
                  </a:lnTo>
                  <a:lnTo>
                    <a:pt x="2946" y="626"/>
                  </a:lnTo>
                  <a:lnTo>
                    <a:pt x="2952" y="622"/>
                  </a:lnTo>
                  <a:lnTo>
                    <a:pt x="2959" y="622"/>
                  </a:lnTo>
                  <a:lnTo>
                    <a:pt x="2965" y="628"/>
                  </a:lnTo>
                  <a:lnTo>
                    <a:pt x="2973" y="632"/>
                  </a:lnTo>
                  <a:lnTo>
                    <a:pt x="2980" y="636"/>
                  </a:lnTo>
                  <a:lnTo>
                    <a:pt x="2986" y="636"/>
                  </a:lnTo>
                  <a:lnTo>
                    <a:pt x="2994" y="628"/>
                  </a:lnTo>
                  <a:lnTo>
                    <a:pt x="3000" y="615"/>
                  </a:lnTo>
                  <a:lnTo>
                    <a:pt x="3007" y="601"/>
                  </a:lnTo>
                  <a:lnTo>
                    <a:pt x="3013" y="588"/>
                  </a:lnTo>
                  <a:lnTo>
                    <a:pt x="3021" y="582"/>
                  </a:lnTo>
                  <a:lnTo>
                    <a:pt x="3028" y="584"/>
                  </a:lnTo>
                  <a:lnTo>
                    <a:pt x="3034" y="591"/>
                  </a:lnTo>
                  <a:lnTo>
                    <a:pt x="3042" y="603"/>
                  </a:lnTo>
                  <a:lnTo>
                    <a:pt x="3048" y="615"/>
                  </a:lnTo>
                  <a:lnTo>
                    <a:pt x="3055" y="628"/>
                  </a:lnTo>
                  <a:lnTo>
                    <a:pt x="3063" y="638"/>
                  </a:lnTo>
                  <a:lnTo>
                    <a:pt x="3069" y="647"/>
                  </a:lnTo>
                  <a:lnTo>
                    <a:pt x="3076" y="655"/>
                  </a:lnTo>
                  <a:lnTo>
                    <a:pt x="3082" y="661"/>
                  </a:lnTo>
                  <a:lnTo>
                    <a:pt x="3090" y="666"/>
                  </a:lnTo>
                  <a:lnTo>
                    <a:pt x="3097" y="670"/>
                  </a:lnTo>
                  <a:lnTo>
                    <a:pt x="3103" y="676"/>
                  </a:lnTo>
                  <a:lnTo>
                    <a:pt x="3111" y="678"/>
                  </a:lnTo>
                  <a:lnTo>
                    <a:pt x="3117" y="682"/>
                  </a:lnTo>
                  <a:lnTo>
                    <a:pt x="3124" y="684"/>
                  </a:lnTo>
                  <a:lnTo>
                    <a:pt x="3132" y="686"/>
                  </a:lnTo>
                  <a:lnTo>
                    <a:pt x="3138" y="687"/>
                  </a:lnTo>
                  <a:lnTo>
                    <a:pt x="3145" y="687"/>
                  </a:lnTo>
                  <a:lnTo>
                    <a:pt x="3151" y="689"/>
                  </a:lnTo>
                  <a:lnTo>
                    <a:pt x="3159" y="689"/>
                  </a:lnTo>
                  <a:lnTo>
                    <a:pt x="3165" y="689"/>
                  </a:lnTo>
                  <a:lnTo>
                    <a:pt x="3172" y="687"/>
                  </a:lnTo>
                  <a:lnTo>
                    <a:pt x="3180" y="687"/>
                  </a:lnTo>
                  <a:lnTo>
                    <a:pt x="3186" y="687"/>
                  </a:lnTo>
                  <a:lnTo>
                    <a:pt x="3193" y="686"/>
                  </a:lnTo>
                  <a:lnTo>
                    <a:pt x="3199" y="684"/>
                  </a:lnTo>
                  <a:lnTo>
                    <a:pt x="3207" y="684"/>
                  </a:lnTo>
                  <a:lnTo>
                    <a:pt x="3215" y="682"/>
                  </a:lnTo>
                  <a:lnTo>
                    <a:pt x="3220" y="682"/>
                  </a:lnTo>
                  <a:lnTo>
                    <a:pt x="3228" y="684"/>
                  </a:lnTo>
                  <a:lnTo>
                    <a:pt x="3234" y="684"/>
                  </a:lnTo>
                  <a:lnTo>
                    <a:pt x="3241" y="684"/>
                  </a:lnTo>
                  <a:lnTo>
                    <a:pt x="3249" y="684"/>
                  </a:lnTo>
                  <a:lnTo>
                    <a:pt x="3255" y="682"/>
                  </a:lnTo>
                  <a:lnTo>
                    <a:pt x="3263" y="680"/>
                  </a:lnTo>
                  <a:lnTo>
                    <a:pt x="3268" y="678"/>
                  </a:lnTo>
                  <a:lnTo>
                    <a:pt x="3276" y="674"/>
                  </a:lnTo>
                  <a:lnTo>
                    <a:pt x="3282" y="670"/>
                  </a:lnTo>
                  <a:lnTo>
                    <a:pt x="3289" y="668"/>
                  </a:lnTo>
                  <a:lnTo>
                    <a:pt x="3297" y="666"/>
                  </a:lnTo>
                  <a:lnTo>
                    <a:pt x="3303" y="668"/>
                  </a:lnTo>
                  <a:lnTo>
                    <a:pt x="3311" y="668"/>
                  </a:lnTo>
                  <a:lnTo>
                    <a:pt x="3316" y="670"/>
                  </a:lnTo>
                  <a:lnTo>
                    <a:pt x="3324" y="672"/>
                  </a:lnTo>
                  <a:lnTo>
                    <a:pt x="3332" y="674"/>
                  </a:lnTo>
                  <a:lnTo>
                    <a:pt x="3337" y="676"/>
                  </a:lnTo>
                  <a:lnTo>
                    <a:pt x="3345" y="678"/>
                  </a:lnTo>
                  <a:lnTo>
                    <a:pt x="3351" y="680"/>
                  </a:lnTo>
                  <a:lnTo>
                    <a:pt x="3359" y="682"/>
                  </a:lnTo>
                  <a:lnTo>
                    <a:pt x="3366" y="682"/>
                  </a:lnTo>
                  <a:lnTo>
                    <a:pt x="3372" y="682"/>
                  </a:lnTo>
                  <a:lnTo>
                    <a:pt x="3380" y="682"/>
                  </a:lnTo>
                  <a:lnTo>
                    <a:pt x="3385" y="682"/>
                  </a:lnTo>
                  <a:lnTo>
                    <a:pt x="3393" y="682"/>
                  </a:lnTo>
                  <a:lnTo>
                    <a:pt x="3399" y="682"/>
                  </a:lnTo>
                  <a:lnTo>
                    <a:pt x="3407" y="682"/>
                  </a:lnTo>
                  <a:lnTo>
                    <a:pt x="3414" y="682"/>
                  </a:lnTo>
                  <a:lnTo>
                    <a:pt x="3420" y="680"/>
                  </a:lnTo>
                  <a:lnTo>
                    <a:pt x="3428" y="680"/>
                  </a:lnTo>
                  <a:lnTo>
                    <a:pt x="3433" y="678"/>
                  </a:lnTo>
                  <a:lnTo>
                    <a:pt x="3441" y="678"/>
                  </a:lnTo>
                  <a:lnTo>
                    <a:pt x="3449" y="678"/>
                  </a:lnTo>
                  <a:lnTo>
                    <a:pt x="3455" y="678"/>
                  </a:lnTo>
                  <a:lnTo>
                    <a:pt x="3462" y="676"/>
                  </a:lnTo>
                  <a:lnTo>
                    <a:pt x="3468" y="676"/>
                  </a:lnTo>
                  <a:lnTo>
                    <a:pt x="3476" y="676"/>
                  </a:lnTo>
                  <a:lnTo>
                    <a:pt x="3483" y="676"/>
                  </a:lnTo>
                  <a:lnTo>
                    <a:pt x="3489" y="676"/>
                  </a:lnTo>
                  <a:lnTo>
                    <a:pt x="3497" y="676"/>
                  </a:lnTo>
                  <a:lnTo>
                    <a:pt x="3503" y="676"/>
                  </a:lnTo>
                  <a:lnTo>
                    <a:pt x="3510" y="676"/>
                  </a:lnTo>
                  <a:lnTo>
                    <a:pt x="3518" y="676"/>
                  </a:lnTo>
                  <a:lnTo>
                    <a:pt x="3524" y="676"/>
                  </a:lnTo>
                  <a:lnTo>
                    <a:pt x="3531" y="676"/>
                  </a:lnTo>
                  <a:lnTo>
                    <a:pt x="3537" y="676"/>
                  </a:lnTo>
                  <a:lnTo>
                    <a:pt x="3545" y="676"/>
                  </a:lnTo>
                  <a:lnTo>
                    <a:pt x="3551" y="674"/>
                  </a:lnTo>
                  <a:lnTo>
                    <a:pt x="3558" y="674"/>
                  </a:lnTo>
                  <a:lnTo>
                    <a:pt x="3566" y="674"/>
                  </a:lnTo>
                  <a:lnTo>
                    <a:pt x="3572" y="674"/>
                  </a:lnTo>
                  <a:lnTo>
                    <a:pt x="3579" y="674"/>
                  </a:lnTo>
                  <a:lnTo>
                    <a:pt x="3585" y="674"/>
                  </a:lnTo>
                  <a:lnTo>
                    <a:pt x="3593" y="674"/>
                  </a:lnTo>
                  <a:lnTo>
                    <a:pt x="3601" y="672"/>
                  </a:lnTo>
                  <a:lnTo>
                    <a:pt x="3606" y="672"/>
                  </a:lnTo>
                  <a:lnTo>
                    <a:pt x="3614" y="672"/>
                  </a:lnTo>
                  <a:lnTo>
                    <a:pt x="3620" y="672"/>
                  </a:lnTo>
                  <a:lnTo>
                    <a:pt x="3627" y="670"/>
                  </a:lnTo>
                  <a:lnTo>
                    <a:pt x="3635" y="668"/>
                  </a:lnTo>
                  <a:lnTo>
                    <a:pt x="3641" y="666"/>
                  </a:lnTo>
                  <a:lnTo>
                    <a:pt x="3649" y="662"/>
                  </a:lnTo>
                  <a:lnTo>
                    <a:pt x="3654" y="661"/>
                  </a:lnTo>
                  <a:lnTo>
                    <a:pt x="3662" y="661"/>
                  </a:lnTo>
                  <a:lnTo>
                    <a:pt x="3668" y="661"/>
                  </a:lnTo>
                  <a:lnTo>
                    <a:pt x="3675" y="661"/>
                  </a:lnTo>
                  <a:lnTo>
                    <a:pt x="3683" y="661"/>
                  </a:lnTo>
                  <a:lnTo>
                    <a:pt x="3689" y="662"/>
                  </a:lnTo>
                  <a:lnTo>
                    <a:pt x="3697" y="664"/>
                  </a:lnTo>
                  <a:lnTo>
                    <a:pt x="3702" y="664"/>
                  </a:lnTo>
                  <a:lnTo>
                    <a:pt x="3710" y="666"/>
                  </a:lnTo>
                  <a:lnTo>
                    <a:pt x="3718" y="666"/>
                  </a:lnTo>
                  <a:lnTo>
                    <a:pt x="3723" y="666"/>
                  </a:lnTo>
                  <a:lnTo>
                    <a:pt x="3731" y="666"/>
                  </a:lnTo>
                  <a:lnTo>
                    <a:pt x="3737" y="666"/>
                  </a:lnTo>
                  <a:lnTo>
                    <a:pt x="3745" y="666"/>
                  </a:lnTo>
                  <a:lnTo>
                    <a:pt x="3752" y="664"/>
                  </a:lnTo>
                  <a:lnTo>
                    <a:pt x="3758" y="662"/>
                  </a:lnTo>
                  <a:lnTo>
                    <a:pt x="3766" y="662"/>
                  </a:lnTo>
                  <a:lnTo>
                    <a:pt x="3771" y="661"/>
                  </a:lnTo>
                  <a:lnTo>
                    <a:pt x="3779" y="659"/>
                  </a:lnTo>
                  <a:lnTo>
                    <a:pt x="3785" y="659"/>
                  </a:lnTo>
                  <a:lnTo>
                    <a:pt x="3793" y="657"/>
                  </a:lnTo>
                  <a:lnTo>
                    <a:pt x="3800" y="657"/>
                  </a:lnTo>
                  <a:lnTo>
                    <a:pt x="3806" y="657"/>
                  </a:lnTo>
                  <a:lnTo>
                    <a:pt x="3814" y="657"/>
                  </a:lnTo>
                  <a:lnTo>
                    <a:pt x="3819" y="657"/>
                  </a:lnTo>
                  <a:lnTo>
                    <a:pt x="3827" y="655"/>
                  </a:lnTo>
                  <a:lnTo>
                    <a:pt x="3835" y="655"/>
                  </a:lnTo>
                  <a:lnTo>
                    <a:pt x="3841" y="655"/>
                  </a:lnTo>
                  <a:lnTo>
                    <a:pt x="3848" y="655"/>
                  </a:lnTo>
                  <a:lnTo>
                    <a:pt x="3854" y="655"/>
                  </a:lnTo>
                  <a:lnTo>
                    <a:pt x="3862" y="657"/>
                  </a:lnTo>
                  <a:lnTo>
                    <a:pt x="3869" y="657"/>
                  </a:lnTo>
                  <a:lnTo>
                    <a:pt x="3875" y="657"/>
                  </a:lnTo>
                  <a:lnTo>
                    <a:pt x="3883" y="657"/>
                  </a:lnTo>
                  <a:lnTo>
                    <a:pt x="3889" y="657"/>
                  </a:lnTo>
                  <a:lnTo>
                    <a:pt x="3896" y="657"/>
                  </a:lnTo>
                  <a:lnTo>
                    <a:pt x="3904" y="655"/>
                  </a:lnTo>
                  <a:lnTo>
                    <a:pt x="3910" y="655"/>
                  </a:lnTo>
                  <a:lnTo>
                    <a:pt x="3917" y="655"/>
                  </a:lnTo>
                  <a:lnTo>
                    <a:pt x="3923" y="655"/>
                  </a:lnTo>
                  <a:lnTo>
                    <a:pt x="3931" y="655"/>
                  </a:lnTo>
                  <a:lnTo>
                    <a:pt x="3937" y="655"/>
                  </a:lnTo>
                  <a:lnTo>
                    <a:pt x="3944" y="655"/>
                  </a:lnTo>
                  <a:lnTo>
                    <a:pt x="3952" y="655"/>
                  </a:lnTo>
                  <a:lnTo>
                    <a:pt x="3958" y="655"/>
                  </a:lnTo>
                  <a:lnTo>
                    <a:pt x="3965" y="655"/>
                  </a:lnTo>
                  <a:lnTo>
                    <a:pt x="3971" y="657"/>
                  </a:lnTo>
                  <a:lnTo>
                    <a:pt x="3979" y="655"/>
                  </a:lnTo>
                  <a:lnTo>
                    <a:pt x="3986" y="657"/>
                  </a:lnTo>
                  <a:lnTo>
                    <a:pt x="3992" y="657"/>
                  </a:lnTo>
                  <a:lnTo>
                    <a:pt x="4000" y="657"/>
                  </a:lnTo>
                  <a:lnTo>
                    <a:pt x="4006" y="655"/>
                  </a:lnTo>
                  <a:lnTo>
                    <a:pt x="4013" y="655"/>
                  </a:lnTo>
                  <a:lnTo>
                    <a:pt x="4021" y="655"/>
                  </a:lnTo>
                  <a:lnTo>
                    <a:pt x="4027" y="655"/>
                  </a:lnTo>
                  <a:lnTo>
                    <a:pt x="4034" y="653"/>
                  </a:lnTo>
                  <a:lnTo>
                    <a:pt x="4040" y="653"/>
                  </a:lnTo>
                  <a:lnTo>
                    <a:pt x="4048" y="651"/>
                  </a:lnTo>
                  <a:lnTo>
                    <a:pt x="4054" y="649"/>
                  </a:lnTo>
                  <a:lnTo>
                    <a:pt x="4061" y="647"/>
                  </a:lnTo>
                  <a:lnTo>
                    <a:pt x="4069" y="645"/>
                  </a:lnTo>
                  <a:lnTo>
                    <a:pt x="4075" y="643"/>
                  </a:lnTo>
                  <a:lnTo>
                    <a:pt x="4082" y="643"/>
                  </a:lnTo>
                  <a:lnTo>
                    <a:pt x="4088" y="641"/>
                  </a:lnTo>
                  <a:lnTo>
                    <a:pt x="4096" y="641"/>
                  </a:lnTo>
                  <a:lnTo>
                    <a:pt x="4104" y="641"/>
                  </a:lnTo>
                  <a:lnTo>
                    <a:pt x="4109" y="641"/>
                  </a:lnTo>
                  <a:lnTo>
                    <a:pt x="4117" y="639"/>
                  </a:lnTo>
                  <a:lnTo>
                    <a:pt x="4123" y="639"/>
                  </a:lnTo>
                  <a:lnTo>
                    <a:pt x="4130" y="639"/>
                  </a:lnTo>
                  <a:lnTo>
                    <a:pt x="4138" y="638"/>
                  </a:lnTo>
                  <a:lnTo>
                    <a:pt x="4144" y="638"/>
                  </a:lnTo>
                  <a:lnTo>
                    <a:pt x="4152" y="638"/>
                  </a:lnTo>
                  <a:lnTo>
                    <a:pt x="4157" y="638"/>
                  </a:lnTo>
                  <a:lnTo>
                    <a:pt x="4165" y="638"/>
                  </a:lnTo>
                  <a:lnTo>
                    <a:pt x="4173" y="638"/>
                  </a:lnTo>
                  <a:lnTo>
                    <a:pt x="4178" y="638"/>
                  </a:lnTo>
                  <a:lnTo>
                    <a:pt x="4186" y="636"/>
                  </a:lnTo>
                  <a:lnTo>
                    <a:pt x="4192" y="636"/>
                  </a:lnTo>
                  <a:lnTo>
                    <a:pt x="4200" y="636"/>
                  </a:lnTo>
                  <a:lnTo>
                    <a:pt x="4205" y="636"/>
                  </a:lnTo>
                  <a:lnTo>
                    <a:pt x="4213" y="636"/>
                  </a:lnTo>
                  <a:lnTo>
                    <a:pt x="4221" y="636"/>
                  </a:lnTo>
                  <a:lnTo>
                    <a:pt x="4226" y="636"/>
                  </a:lnTo>
                  <a:lnTo>
                    <a:pt x="4234" y="634"/>
                  </a:lnTo>
                  <a:lnTo>
                    <a:pt x="4240" y="634"/>
                  </a:lnTo>
                  <a:lnTo>
                    <a:pt x="4248" y="632"/>
                  </a:lnTo>
                  <a:lnTo>
                    <a:pt x="4255" y="632"/>
                  </a:lnTo>
                  <a:lnTo>
                    <a:pt x="4261" y="630"/>
                  </a:lnTo>
                  <a:lnTo>
                    <a:pt x="4269" y="628"/>
                  </a:lnTo>
                  <a:lnTo>
                    <a:pt x="4275" y="626"/>
                  </a:lnTo>
                  <a:lnTo>
                    <a:pt x="4282" y="626"/>
                  </a:lnTo>
                  <a:lnTo>
                    <a:pt x="4290" y="624"/>
                  </a:lnTo>
                  <a:lnTo>
                    <a:pt x="4296" y="624"/>
                  </a:lnTo>
                  <a:lnTo>
                    <a:pt x="4303" y="624"/>
                  </a:lnTo>
                  <a:lnTo>
                    <a:pt x="4309" y="624"/>
                  </a:lnTo>
                  <a:lnTo>
                    <a:pt x="4317" y="626"/>
                  </a:lnTo>
                  <a:lnTo>
                    <a:pt x="4323" y="626"/>
                  </a:lnTo>
                  <a:lnTo>
                    <a:pt x="4330" y="626"/>
                  </a:lnTo>
                  <a:lnTo>
                    <a:pt x="4338" y="628"/>
                  </a:lnTo>
                  <a:lnTo>
                    <a:pt x="4344" y="628"/>
                  </a:lnTo>
                  <a:lnTo>
                    <a:pt x="4351" y="628"/>
                  </a:lnTo>
                  <a:lnTo>
                    <a:pt x="4357" y="626"/>
                  </a:lnTo>
                  <a:lnTo>
                    <a:pt x="4365" y="624"/>
                  </a:lnTo>
                  <a:lnTo>
                    <a:pt x="4372" y="620"/>
                  </a:lnTo>
                  <a:lnTo>
                    <a:pt x="4378" y="615"/>
                  </a:lnTo>
                  <a:lnTo>
                    <a:pt x="4386" y="611"/>
                  </a:lnTo>
                  <a:lnTo>
                    <a:pt x="4392" y="607"/>
                  </a:lnTo>
                  <a:lnTo>
                    <a:pt x="4399" y="603"/>
                  </a:lnTo>
                  <a:lnTo>
                    <a:pt x="4407" y="603"/>
                  </a:lnTo>
                  <a:lnTo>
                    <a:pt x="4413" y="603"/>
                  </a:lnTo>
                  <a:lnTo>
                    <a:pt x="4420" y="605"/>
                  </a:lnTo>
                  <a:lnTo>
                    <a:pt x="4426" y="609"/>
                  </a:lnTo>
                  <a:lnTo>
                    <a:pt x="4434" y="611"/>
                  </a:lnTo>
                  <a:lnTo>
                    <a:pt x="4440" y="613"/>
                  </a:lnTo>
                  <a:lnTo>
                    <a:pt x="4447" y="615"/>
                  </a:lnTo>
                  <a:lnTo>
                    <a:pt x="4455" y="615"/>
                  </a:lnTo>
                  <a:lnTo>
                    <a:pt x="4461" y="616"/>
                  </a:lnTo>
                  <a:lnTo>
                    <a:pt x="4468" y="616"/>
                  </a:lnTo>
                  <a:lnTo>
                    <a:pt x="4474" y="616"/>
                  </a:lnTo>
                  <a:lnTo>
                    <a:pt x="4482" y="616"/>
                  </a:lnTo>
                  <a:lnTo>
                    <a:pt x="4490" y="615"/>
                  </a:lnTo>
                  <a:lnTo>
                    <a:pt x="4495" y="613"/>
                  </a:lnTo>
                  <a:lnTo>
                    <a:pt x="4503" y="611"/>
                  </a:lnTo>
                  <a:lnTo>
                    <a:pt x="4509" y="611"/>
                  </a:lnTo>
                  <a:lnTo>
                    <a:pt x="4516" y="609"/>
                  </a:lnTo>
                  <a:lnTo>
                    <a:pt x="4524" y="607"/>
                  </a:lnTo>
                  <a:lnTo>
                    <a:pt x="4530" y="609"/>
                  </a:lnTo>
                  <a:lnTo>
                    <a:pt x="4538" y="609"/>
                  </a:lnTo>
                  <a:lnTo>
                    <a:pt x="4543" y="611"/>
                  </a:lnTo>
                  <a:lnTo>
                    <a:pt x="4551" y="611"/>
                  </a:lnTo>
                  <a:lnTo>
                    <a:pt x="4559" y="613"/>
                  </a:lnTo>
                  <a:lnTo>
                    <a:pt x="4564" y="613"/>
                  </a:lnTo>
                  <a:lnTo>
                    <a:pt x="4572" y="613"/>
                  </a:lnTo>
                  <a:lnTo>
                    <a:pt x="4578" y="611"/>
                  </a:lnTo>
                  <a:lnTo>
                    <a:pt x="4586" y="609"/>
                  </a:lnTo>
                  <a:lnTo>
                    <a:pt x="4591" y="607"/>
                  </a:lnTo>
                  <a:lnTo>
                    <a:pt x="4599" y="605"/>
                  </a:lnTo>
                  <a:lnTo>
                    <a:pt x="4607" y="601"/>
                  </a:lnTo>
                  <a:lnTo>
                    <a:pt x="4612" y="597"/>
                  </a:lnTo>
                  <a:lnTo>
                    <a:pt x="4620" y="593"/>
                  </a:lnTo>
                  <a:lnTo>
                    <a:pt x="4626" y="591"/>
                  </a:lnTo>
                  <a:lnTo>
                    <a:pt x="4634" y="593"/>
                  </a:lnTo>
                  <a:lnTo>
                    <a:pt x="4641" y="593"/>
                  </a:lnTo>
                  <a:lnTo>
                    <a:pt x="4647" y="595"/>
                  </a:lnTo>
                  <a:lnTo>
                    <a:pt x="4655" y="595"/>
                  </a:lnTo>
                  <a:lnTo>
                    <a:pt x="4660" y="595"/>
                  </a:lnTo>
                  <a:lnTo>
                    <a:pt x="4668" y="593"/>
                  </a:lnTo>
                  <a:lnTo>
                    <a:pt x="4676" y="588"/>
                  </a:lnTo>
                  <a:lnTo>
                    <a:pt x="4682" y="582"/>
                  </a:lnTo>
                  <a:lnTo>
                    <a:pt x="4689" y="578"/>
                  </a:lnTo>
                  <a:lnTo>
                    <a:pt x="4695" y="574"/>
                  </a:lnTo>
                  <a:lnTo>
                    <a:pt x="4703" y="574"/>
                  </a:lnTo>
                  <a:lnTo>
                    <a:pt x="4708" y="576"/>
                  </a:lnTo>
                  <a:lnTo>
                    <a:pt x="4716" y="580"/>
                  </a:lnTo>
                  <a:lnTo>
                    <a:pt x="4724" y="584"/>
                  </a:lnTo>
                  <a:lnTo>
                    <a:pt x="4730" y="588"/>
                  </a:lnTo>
                  <a:lnTo>
                    <a:pt x="4737" y="590"/>
                  </a:lnTo>
                  <a:lnTo>
                    <a:pt x="4743" y="593"/>
                  </a:lnTo>
                  <a:lnTo>
                    <a:pt x="4751" y="595"/>
                  </a:lnTo>
                  <a:lnTo>
                    <a:pt x="4758" y="597"/>
                  </a:lnTo>
                  <a:lnTo>
                    <a:pt x="4764" y="599"/>
                  </a:lnTo>
                  <a:lnTo>
                    <a:pt x="4772" y="599"/>
                  </a:lnTo>
                  <a:lnTo>
                    <a:pt x="4778" y="601"/>
                  </a:lnTo>
                  <a:lnTo>
                    <a:pt x="4785" y="601"/>
                  </a:lnTo>
                  <a:lnTo>
                    <a:pt x="4793" y="601"/>
                  </a:lnTo>
                  <a:lnTo>
                    <a:pt x="4799" y="599"/>
                  </a:lnTo>
                  <a:lnTo>
                    <a:pt x="4806" y="599"/>
                  </a:lnTo>
                  <a:lnTo>
                    <a:pt x="4812" y="597"/>
                  </a:lnTo>
                  <a:lnTo>
                    <a:pt x="4820" y="597"/>
                  </a:lnTo>
                  <a:lnTo>
                    <a:pt x="4827" y="597"/>
                  </a:lnTo>
                  <a:lnTo>
                    <a:pt x="4833" y="597"/>
                  </a:lnTo>
                  <a:lnTo>
                    <a:pt x="4841" y="597"/>
                  </a:lnTo>
                  <a:lnTo>
                    <a:pt x="4847" y="597"/>
                  </a:lnTo>
                  <a:lnTo>
                    <a:pt x="4854" y="597"/>
                  </a:lnTo>
                  <a:lnTo>
                    <a:pt x="4860" y="597"/>
                  </a:lnTo>
                  <a:lnTo>
                    <a:pt x="4868" y="597"/>
                  </a:lnTo>
                  <a:lnTo>
                    <a:pt x="4875" y="597"/>
                  </a:lnTo>
                  <a:lnTo>
                    <a:pt x="4881" y="597"/>
                  </a:lnTo>
                  <a:lnTo>
                    <a:pt x="4889" y="597"/>
                  </a:lnTo>
                  <a:lnTo>
                    <a:pt x="4895" y="597"/>
                  </a:lnTo>
                  <a:lnTo>
                    <a:pt x="4902" y="597"/>
                  </a:lnTo>
                  <a:lnTo>
                    <a:pt x="4910" y="597"/>
                  </a:lnTo>
                  <a:lnTo>
                    <a:pt x="4916" y="597"/>
                  </a:lnTo>
                  <a:lnTo>
                    <a:pt x="4924" y="597"/>
                  </a:lnTo>
                  <a:lnTo>
                    <a:pt x="4929" y="597"/>
                  </a:lnTo>
                  <a:lnTo>
                    <a:pt x="4937" y="597"/>
                  </a:lnTo>
                  <a:lnTo>
                    <a:pt x="4945" y="597"/>
                  </a:lnTo>
                  <a:lnTo>
                    <a:pt x="4950" y="597"/>
                  </a:lnTo>
                  <a:lnTo>
                    <a:pt x="4958" y="597"/>
                  </a:lnTo>
                  <a:lnTo>
                    <a:pt x="4964" y="597"/>
                  </a:lnTo>
                  <a:lnTo>
                    <a:pt x="4972" y="597"/>
                  </a:lnTo>
                  <a:lnTo>
                    <a:pt x="4977" y="597"/>
                  </a:lnTo>
                  <a:lnTo>
                    <a:pt x="4985" y="595"/>
                  </a:lnTo>
                  <a:lnTo>
                    <a:pt x="4993" y="595"/>
                  </a:lnTo>
                  <a:lnTo>
                    <a:pt x="4998" y="595"/>
                  </a:lnTo>
                  <a:lnTo>
                    <a:pt x="5006" y="595"/>
                  </a:lnTo>
                  <a:lnTo>
                    <a:pt x="5012" y="595"/>
                  </a:lnTo>
                  <a:lnTo>
                    <a:pt x="5020" y="593"/>
                  </a:lnTo>
                  <a:lnTo>
                    <a:pt x="5027" y="593"/>
                  </a:lnTo>
                  <a:lnTo>
                    <a:pt x="5033" y="591"/>
                  </a:lnTo>
                  <a:lnTo>
                    <a:pt x="5041" y="590"/>
                  </a:lnTo>
                  <a:lnTo>
                    <a:pt x="5046" y="590"/>
                  </a:lnTo>
                  <a:lnTo>
                    <a:pt x="5054" y="590"/>
                  </a:lnTo>
                  <a:lnTo>
                    <a:pt x="5062" y="588"/>
                  </a:lnTo>
                  <a:lnTo>
                    <a:pt x="5068" y="588"/>
                  </a:lnTo>
                  <a:lnTo>
                    <a:pt x="5075" y="586"/>
                  </a:lnTo>
                  <a:lnTo>
                    <a:pt x="5081" y="586"/>
                  </a:lnTo>
                  <a:lnTo>
                    <a:pt x="5089" y="584"/>
                  </a:lnTo>
                  <a:lnTo>
                    <a:pt x="5094" y="582"/>
                  </a:lnTo>
                  <a:lnTo>
                    <a:pt x="5102" y="578"/>
                  </a:lnTo>
                  <a:lnTo>
                    <a:pt x="5110" y="572"/>
                  </a:lnTo>
                  <a:lnTo>
                    <a:pt x="5116" y="567"/>
                  </a:lnTo>
                  <a:lnTo>
                    <a:pt x="5123" y="561"/>
                  </a:lnTo>
                  <a:lnTo>
                    <a:pt x="5129" y="553"/>
                  </a:lnTo>
                  <a:lnTo>
                    <a:pt x="5137" y="547"/>
                  </a:lnTo>
                  <a:lnTo>
                    <a:pt x="5144" y="544"/>
                  </a:lnTo>
                  <a:lnTo>
                    <a:pt x="5150" y="544"/>
                  </a:lnTo>
                  <a:lnTo>
                    <a:pt x="5158" y="542"/>
                  </a:lnTo>
                  <a:lnTo>
                    <a:pt x="5164" y="544"/>
                  </a:lnTo>
                  <a:lnTo>
                    <a:pt x="5171" y="544"/>
                  </a:lnTo>
                  <a:lnTo>
                    <a:pt x="5179" y="544"/>
                  </a:lnTo>
                  <a:lnTo>
                    <a:pt x="5185" y="545"/>
                  </a:lnTo>
                  <a:lnTo>
                    <a:pt x="5192" y="547"/>
                  </a:lnTo>
                  <a:lnTo>
                    <a:pt x="5198" y="547"/>
                  </a:lnTo>
                  <a:lnTo>
                    <a:pt x="5206" y="549"/>
                  </a:lnTo>
                  <a:lnTo>
                    <a:pt x="5213" y="551"/>
                  </a:lnTo>
                  <a:lnTo>
                    <a:pt x="5219" y="553"/>
                  </a:lnTo>
                  <a:lnTo>
                    <a:pt x="5227" y="555"/>
                  </a:lnTo>
                  <a:lnTo>
                    <a:pt x="5233" y="557"/>
                  </a:lnTo>
                  <a:lnTo>
                    <a:pt x="5240" y="557"/>
                  </a:lnTo>
                  <a:lnTo>
                    <a:pt x="5246" y="559"/>
                  </a:lnTo>
                  <a:lnTo>
                    <a:pt x="5254" y="561"/>
                  </a:lnTo>
                  <a:lnTo>
                    <a:pt x="5261" y="561"/>
                  </a:lnTo>
                  <a:lnTo>
                    <a:pt x="5267" y="561"/>
                  </a:lnTo>
                  <a:lnTo>
                    <a:pt x="5275" y="561"/>
                  </a:lnTo>
                  <a:lnTo>
                    <a:pt x="5281" y="559"/>
                  </a:lnTo>
                  <a:lnTo>
                    <a:pt x="5288" y="559"/>
                  </a:lnTo>
                  <a:lnTo>
                    <a:pt x="5296" y="557"/>
                  </a:lnTo>
                  <a:lnTo>
                    <a:pt x="5302" y="557"/>
                  </a:lnTo>
                  <a:lnTo>
                    <a:pt x="5309" y="557"/>
                  </a:lnTo>
                  <a:lnTo>
                    <a:pt x="5315" y="557"/>
                  </a:lnTo>
                  <a:lnTo>
                    <a:pt x="5323" y="557"/>
                  </a:lnTo>
                  <a:lnTo>
                    <a:pt x="5331" y="557"/>
                  </a:lnTo>
                  <a:lnTo>
                    <a:pt x="5336" y="557"/>
                  </a:lnTo>
                  <a:lnTo>
                    <a:pt x="5344" y="557"/>
                  </a:lnTo>
                  <a:lnTo>
                    <a:pt x="5350" y="557"/>
                  </a:lnTo>
                  <a:lnTo>
                    <a:pt x="5357" y="557"/>
                  </a:lnTo>
                  <a:lnTo>
                    <a:pt x="5363" y="555"/>
                  </a:lnTo>
                  <a:lnTo>
                    <a:pt x="5371" y="555"/>
                  </a:lnTo>
                  <a:lnTo>
                    <a:pt x="5379" y="551"/>
                  </a:lnTo>
                  <a:lnTo>
                    <a:pt x="5384" y="549"/>
                  </a:lnTo>
                  <a:lnTo>
                    <a:pt x="5392" y="547"/>
                  </a:lnTo>
                  <a:lnTo>
                    <a:pt x="5398" y="545"/>
                  </a:lnTo>
                  <a:lnTo>
                    <a:pt x="5405" y="544"/>
                  </a:lnTo>
                  <a:lnTo>
                    <a:pt x="5413" y="544"/>
                  </a:lnTo>
                  <a:lnTo>
                    <a:pt x="5419" y="544"/>
                  </a:lnTo>
                  <a:lnTo>
                    <a:pt x="5427" y="544"/>
                  </a:lnTo>
                  <a:lnTo>
                    <a:pt x="5432" y="544"/>
                  </a:lnTo>
                  <a:lnTo>
                    <a:pt x="5440" y="544"/>
                  </a:lnTo>
                  <a:lnTo>
                    <a:pt x="5448" y="545"/>
                  </a:lnTo>
                  <a:lnTo>
                    <a:pt x="5453" y="545"/>
                  </a:lnTo>
                  <a:lnTo>
                    <a:pt x="5461" y="545"/>
                  </a:lnTo>
                  <a:lnTo>
                    <a:pt x="5467" y="545"/>
                  </a:lnTo>
                  <a:lnTo>
                    <a:pt x="5475" y="545"/>
                  </a:lnTo>
                  <a:lnTo>
                    <a:pt x="5480" y="544"/>
                  </a:lnTo>
                  <a:lnTo>
                    <a:pt x="5488" y="544"/>
                  </a:lnTo>
                  <a:lnTo>
                    <a:pt x="5496" y="542"/>
                  </a:lnTo>
                  <a:lnTo>
                    <a:pt x="5501" y="542"/>
                  </a:lnTo>
                  <a:lnTo>
                    <a:pt x="5509" y="540"/>
                  </a:lnTo>
                  <a:lnTo>
                    <a:pt x="5515" y="538"/>
                  </a:lnTo>
                  <a:lnTo>
                    <a:pt x="5523" y="538"/>
                  </a:lnTo>
                  <a:lnTo>
                    <a:pt x="5530" y="536"/>
                  </a:lnTo>
                  <a:lnTo>
                    <a:pt x="5536" y="534"/>
                  </a:lnTo>
                  <a:lnTo>
                    <a:pt x="5544" y="532"/>
                  </a:lnTo>
                  <a:lnTo>
                    <a:pt x="5549" y="530"/>
                  </a:lnTo>
                  <a:lnTo>
                    <a:pt x="5557" y="528"/>
                  </a:lnTo>
                  <a:lnTo>
                    <a:pt x="5565" y="526"/>
                  </a:lnTo>
                  <a:lnTo>
                    <a:pt x="5571" y="524"/>
                  </a:lnTo>
                  <a:lnTo>
                    <a:pt x="5578" y="522"/>
                  </a:lnTo>
                  <a:lnTo>
                    <a:pt x="5584" y="522"/>
                  </a:lnTo>
                  <a:lnTo>
                    <a:pt x="5592" y="522"/>
                  </a:lnTo>
                  <a:lnTo>
                    <a:pt x="5599" y="522"/>
                  </a:lnTo>
                  <a:lnTo>
                    <a:pt x="5605" y="522"/>
                  </a:lnTo>
                  <a:lnTo>
                    <a:pt x="5613" y="522"/>
                  </a:lnTo>
                  <a:lnTo>
                    <a:pt x="5619" y="522"/>
                  </a:lnTo>
                  <a:lnTo>
                    <a:pt x="5626" y="522"/>
                  </a:lnTo>
                  <a:lnTo>
                    <a:pt x="5632" y="522"/>
                  </a:lnTo>
                  <a:lnTo>
                    <a:pt x="5640" y="522"/>
                  </a:lnTo>
                  <a:lnTo>
                    <a:pt x="5647" y="520"/>
                  </a:lnTo>
                  <a:lnTo>
                    <a:pt x="5653" y="520"/>
                  </a:lnTo>
                  <a:lnTo>
                    <a:pt x="5661" y="520"/>
                  </a:lnTo>
                  <a:lnTo>
                    <a:pt x="5667" y="519"/>
                  </a:lnTo>
                  <a:lnTo>
                    <a:pt x="5674" y="517"/>
                  </a:lnTo>
                  <a:lnTo>
                    <a:pt x="5682" y="515"/>
                  </a:lnTo>
                  <a:lnTo>
                    <a:pt x="5688" y="513"/>
                  </a:lnTo>
                  <a:lnTo>
                    <a:pt x="5695" y="511"/>
                  </a:lnTo>
                  <a:lnTo>
                    <a:pt x="5701" y="509"/>
                  </a:lnTo>
                  <a:lnTo>
                    <a:pt x="5709" y="507"/>
                  </a:lnTo>
                  <a:lnTo>
                    <a:pt x="5717" y="507"/>
                  </a:lnTo>
                  <a:lnTo>
                    <a:pt x="5722" y="505"/>
                  </a:lnTo>
                  <a:lnTo>
                    <a:pt x="5730" y="503"/>
                  </a:lnTo>
                  <a:lnTo>
                    <a:pt x="5736" y="503"/>
                  </a:lnTo>
                  <a:lnTo>
                    <a:pt x="5743" y="501"/>
                  </a:lnTo>
                  <a:lnTo>
                    <a:pt x="5749" y="501"/>
                  </a:lnTo>
                  <a:lnTo>
                    <a:pt x="5757" y="499"/>
                  </a:lnTo>
                  <a:lnTo>
                    <a:pt x="5765" y="497"/>
                  </a:lnTo>
                  <a:lnTo>
                    <a:pt x="5770" y="497"/>
                  </a:lnTo>
                  <a:lnTo>
                    <a:pt x="5778" y="497"/>
                  </a:lnTo>
                  <a:lnTo>
                    <a:pt x="5784" y="496"/>
                  </a:lnTo>
                  <a:lnTo>
                    <a:pt x="5791" y="496"/>
                  </a:lnTo>
                  <a:lnTo>
                    <a:pt x="5799" y="494"/>
                  </a:lnTo>
                  <a:lnTo>
                    <a:pt x="5805" y="494"/>
                  </a:lnTo>
                  <a:lnTo>
                    <a:pt x="5813" y="494"/>
                  </a:lnTo>
                  <a:lnTo>
                    <a:pt x="5818" y="494"/>
                  </a:lnTo>
                  <a:lnTo>
                    <a:pt x="5826" y="492"/>
                  </a:lnTo>
                  <a:lnTo>
                    <a:pt x="5834" y="492"/>
                  </a:lnTo>
                  <a:lnTo>
                    <a:pt x="5839" y="492"/>
                  </a:lnTo>
                  <a:lnTo>
                    <a:pt x="5847" y="492"/>
                  </a:lnTo>
                  <a:lnTo>
                    <a:pt x="5853" y="492"/>
                  </a:lnTo>
                  <a:lnTo>
                    <a:pt x="5861" y="494"/>
                  </a:lnTo>
                  <a:lnTo>
                    <a:pt x="5868" y="494"/>
                  </a:lnTo>
                  <a:lnTo>
                    <a:pt x="5874" y="494"/>
                  </a:lnTo>
                  <a:lnTo>
                    <a:pt x="5882" y="494"/>
                  </a:lnTo>
                  <a:lnTo>
                    <a:pt x="5887" y="494"/>
                  </a:lnTo>
                  <a:lnTo>
                    <a:pt x="5895" y="494"/>
                  </a:lnTo>
                  <a:lnTo>
                    <a:pt x="5901" y="494"/>
                  </a:lnTo>
                  <a:lnTo>
                    <a:pt x="5909" y="494"/>
                  </a:lnTo>
                  <a:lnTo>
                    <a:pt x="5916" y="494"/>
                  </a:lnTo>
                  <a:lnTo>
                    <a:pt x="5922" y="494"/>
                  </a:lnTo>
                  <a:lnTo>
                    <a:pt x="5930" y="492"/>
                  </a:lnTo>
                  <a:lnTo>
                    <a:pt x="5935" y="490"/>
                  </a:lnTo>
                  <a:lnTo>
                    <a:pt x="5943" y="488"/>
                  </a:lnTo>
                  <a:lnTo>
                    <a:pt x="5951" y="482"/>
                  </a:lnTo>
                  <a:lnTo>
                    <a:pt x="5957" y="473"/>
                  </a:lnTo>
                  <a:lnTo>
                    <a:pt x="5964" y="455"/>
                  </a:lnTo>
                  <a:lnTo>
                    <a:pt x="5970" y="428"/>
                  </a:lnTo>
                  <a:lnTo>
                    <a:pt x="5978" y="394"/>
                  </a:lnTo>
                  <a:lnTo>
                    <a:pt x="5985" y="352"/>
                  </a:lnTo>
                  <a:lnTo>
                    <a:pt x="5991" y="307"/>
                  </a:lnTo>
                  <a:lnTo>
                    <a:pt x="5999" y="263"/>
                  </a:lnTo>
                  <a:lnTo>
                    <a:pt x="6005" y="227"/>
                  </a:lnTo>
                  <a:lnTo>
                    <a:pt x="6012" y="202"/>
                  </a:lnTo>
                  <a:lnTo>
                    <a:pt x="6018" y="187"/>
                  </a:lnTo>
                  <a:lnTo>
                    <a:pt x="6026" y="183"/>
                  </a:lnTo>
                  <a:lnTo>
                    <a:pt x="6033" y="185"/>
                  </a:lnTo>
                  <a:lnTo>
                    <a:pt x="6039" y="192"/>
                  </a:lnTo>
                  <a:lnTo>
                    <a:pt x="6047" y="202"/>
                  </a:lnTo>
                  <a:lnTo>
                    <a:pt x="6053" y="215"/>
                  </a:lnTo>
                  <a:lnTo>
                    <a:pt x="6060" y="229"/>
                  </a:lnTo>
                  <a:lnTo>
                    <a:pt x="6068" y="240"/>
                  </a:lnTo>
                  <a:lnTo>
                    <a:pt x="6074" y="254"/>
                  </a:lnTo>
                  <a:lnTo>
                    <a:pt x="6081" y="263"/>
                  </a:lnTo>
                  <a:lnTo>
                    <a:pt x="6087" y="275"/>
                  </a:lnTo>
                  <a:lnTo>
                    <a:pt x="6095" y="284"/>
                  </a:lnTo>
                  <a:lnTo>
                    <a:pt x="6102" y="294"/>
                  </a:lnTo>
                  <a:lnTo>
                    <a:pt x="6108" y="300"/>
                  </a:lnTo>
                  <a:lnTo>
                    <a:pt x="6116" y="306"/>
                  </a:lnTo>
                  <a:lnTo>
                    <a:pt x="6122" y="311"/>
                  </a:lnTo>
                  <a:lnTo>
                    <a:pt x="6129" y="315"/>
                  </a:lnTo>
                  <a:lnTo>
                    <a:pt x="6135" y="319"/>
                  </a:lnTo>
                  <a:lnTo>
                    <a:pt x="6143" y="323"/>
                  </a:lnTo>
                  <a:lnTo>
                    <a:pt x="6150" y="327"/>
                  </a:lnTo>
                  <a:lnTo>
                    <a:pt x="6156" y="331"/>
                  </a:lnTo>
                  <a:lnTo>
                    <a:pt x="6164" y="336"/>
                  </a:lnTo>
                  <a:lnTo>
                    <a:pt x="6170" y="340"/>
                  </a:lnTo>
                  <a:lnTo>
                    <a:pt x="6177" y="344"/>
                  </a:lnTo>
                  <a:lnTo>
                    <a:pt x="6185" y="346"/>
                  </a:lnTo>
                  <a:lnTo>
                    <a:pt x="6191" y="350"/>
                  </a:lnTo>
                  <a:lnTo>
                    <a:pt x="6198" y="350"/>
                  </a:lnTo>
                  <a:lnTo>
                    <a:pt x="6204" y="352"/>
                  </a:lnTo>
                  <a:lnTo>
                    <a:pt x="6212" y="352"/>
                  </a:lnTo>
                  <a:lnTo>
                    <a:pt x="6220" y="352"/>
                  </a:lnTo>
                  <a:lnTo>
                    <a:pt x="6225" y="350"/>
                  </a:lnTo>
                  <a:lnTo>
                    <a:pt x="6233" y="348"/>
                  </a:lnTo>
                  <a:lnTo>
                    <a:pt x="6239" y="342"/>
                  </a:lnTo>
                  <a:lnTo>
                    <a:pt x="6246" y="334"/>
                  </a:lnTo>
                  <a:lnTo>
                    <a:pt x="6254" y="323"/>
                  </a:lnTo>
                  <a:lnTo>
                    <a:pt x="6260" y="309"/>
                  </a:lnTo>
                  <a:lnTo>
                    <a:pt x="6268" y="290"/>
                  </a:lnTo>
                  <a:lnTo>
                    <a:pt x="6273" y="267"/>
                  </a:lnTo>
                  <a:lnTo>
                    <a:pt x="6281" y="240"/>
                  </a:lnTo>
                  <a:lnTo>
                    <a:pt x="6287" y="212"/>
                  </a:lnTo>
                  <a:lnTo>
                    <a:pt x="6294" y="181"/>
                  </a:lnTo>
                  <a:lnTo>
                    <a:pt x="6302" y="148"/>
                  </a:lnTo>
                  <a:lnTo>
                    <a:pt x="6308" y="119"/>
                  </a:lnTo>
                  <a:lnTo>
                    <a:pt x="6316" y="91"/>
                  </a:lnTo>
                  <a:lnTo>
                    <a:pt x="6321" y="68"/>
                  </a:lnTo>
                  <a:lnTo>
                    <a:pt x="6329" y="47"/>
                  </a:lnTo>
                  <a:lnTo>
                    <a:pt x="6337" y="29"/>
                  </a:lnTo>
                  <a:lnTo>
                    <a:pt x="6342" y="16"/>
                  </a:lnTo>
                  <a:lnTo>
                    <a:pt x="6350" y="8"/>
                  </a:lnTo>
                  <a:lnTo>
                    <a:pt x="6356" y="2"/>
                  </a:lnTo>
                  <a:lnTo>
                    <a:pt x="6364" y="0"/>
                  </a:lnTo>
                  <a:lnTo>
                    <a:pt x="6371" y="2"/>
                  </a:lnTo>
                  <a:lnTo>
                    <a:pt x="6377" y="6"/>
                  </a:lnTo>
                  <a:lnTo>
                    <a:pt x="6385" y="14"/>
                  </a:lnTo>
                  <a:lnTo>
                    <a:pt x="6390" y="22"/>
                  </a:lnTo>
                  <a:lnTo>
                    <a:pt x="6398" y="31"/>
                  </a:lnTo>
                  <a:lnTo>
                    <a:pt x="6404" y="43"/>
                  </a:lnTo>
                  <a:lnTo>
                    <a:pt x="6412" y="54"/>
                  </a:lnTo>
                  <a:lnTo>
                    <a:pt x="6419" y="66"/>
                  </a:lnTo>
                  <a:lnTo>
                    <a:pt x="6425" y="77"/>
                  </a:lnTo>
                  <a:lnTo>
                    <a:pt x="6433" y="91"/>
                  </a:lnTo>
                  <a:lnTo>
                    <a:pt x="6438" y="104"/>
                  </a:lnTo>
                  <a:lnTo>
                    <a:pt x="6446" y="116"/>
                  </a:lnTo>
                  <a:lnTo>
                    <a:pt x="6454" y="129"/>
                  </a:lnTo>
                  <a:lnTo>
                    <a:pt x="6460" y="141"/>
                  </a:lnTo>
                  <a:lnTo>
                    <a:pt x="6467" y="152"/>
                  </a:lnTo>
                  <a:lnTo>
                    <a:pt x="6473" y="164"/>
                  </a:lnTo>
                  <a:lnTo>
                    <a:pt x="6481" y="173"/>
                  </a:lnTo>
                  <a:lnTo>
                    <a:pt x="6488" y="183"/>
                  </a:lnTo>
                  <a:lnTo>
                    <a:pt x="6494" y="192"/>
                  </a:lnTo>
                  <a:lnTo>
                    <a:pt x="6502" y="200"/>
                  </a:lnTo>
                  <a:lnTo>
                    <a:pt x="6508" y="208"/>
                  </a:lnTo>
                  <a:lnTo>
                    <a:pt x="6515" y="215"/>
                  </a:lnTo>
                  <a:lnTo>
                    <a:pt x="6523" y="223"/>
                  </a:lnTo>
                  <a:lnTo>
                    <a:pt x="6529" y="229"/>
                  </a:lnTo>
                  <a:lnTo>
                    <a:pt x="6536" y="235"/>
                  </a:lnTo>
                  <a:lnTo>
                    <a:pt x="6542" y="240"/>
                  </a:lnTo>
                  <a:lnTo>
                    <a:pt x="6550" y="246"/>
                  </a:lnTo>
                  <a:lnTo>
                    <a:pt x="6556" y="252"/>
                  </a:lnTo>
                  <a:lnTo>
                    <a:pt x="6563" y="256"/>
                  </a:lnTo>
                  <a:lnTo>
                    <a:pt x="6571" y="261"/>
                  </a:lnTo>
                  <a:lnTo>
                    <a:pt x="6577" y="265"/>
                  </a:lnTo>
                  <a:lnTo>
                    <a:pt x="6584" y="269"/>
                  </a:lnTo>
                  <a:lnTo>
                    <a:pt x="6590" y="275"/>
                  </a:lnTo>
                  <a:lnTo>
                    <a:pt x="6598" y="279"/>
                  </a:lnTo>
                  <a:lnTo>
                    <a:pt x="6606" y="281"/>
                  </a:lnTo>
                  <a:lnTo>
                    <a:pt x="6611" y="284"/>
                  </a:lnTo>
                  <a:lnTo>
                    <a:pt x="6619" y="288"/>
                  </a:lnTo>
                  <a:lnTo>
                    <a:pt x="6625" y="292"/>
                  </a:lnTo>
                  <a:lnTo>
                    <a:pt x="6632" y="294"/>
                  </a:lnTo>
                  <a:lnTo>
                    <a:pt x="6640" y="298"/>
                  </a:lnTo>
                  <a:lnTo>
                    <a:pt x="6646" y="300"/>
                  </a:lnTo>
                  <a:lnTo>
                    <a:pt x="6654" y="304"/>
                  </a:lnTo>
                  <a:lnTo>
                    <a:pt x="6659" y="306"/>
                  </a:lnTo>
                  <a:lnTo>
                    <a:pt x="6667" y="307"/>
                  </a:lnTo>
                  <a:lnTo>
                    <a:pt x="6673" y="311"/>
                  </a:lnTo>
                  <a:lnTo>
                    <a:pt x="6680" y="313"/>
                  </a:lnTo>
                  <a:lnTo>
                    <a:pt x="6688" y="315"/>
                  </a:lnTo>
                  <a:lnTo>
                    <a:pt x="6694" y="317"/>
                  </a:lnTo>
                  <a:lnTo>
                    <a:pt x="6702" y="319"/>
                  </a:lnTo>
                  <a:lnTo>
                    <a:pt x="6707" y="321"/>
                  </a:lnTo>
                  <a:lnTo>
                    <a:pt x="6715" y="323"/>
                  </a:lnTo>
                  <a:lnTo>
                    <a:pt x="6723" y="325"/>
                  </a:lnTo>
                  <a:lnTo>
                    <a:pt x="6728" y="327"/>
                  </a:lnTo>
                  <a:lnTo>
                    <a:pt x="6736" y="329"/>
                  </a:lnTo>
                  <a:lnTo>
                    <a:pt x="6742" y="331"/>
                  </a:lnTo>
                  <a:lnTo>
                    <a:pt x="6750" y="332"/>
                  </a:lnTo>
                  <a:lnTo>
                    <a:pt x="6757" y="332"/>
                  </a:lnTo>
                  <a:lnTo>
                    <a:pt x="6763" y="334"/>
                  </a:lnTo>
                  <a:lnTo>
                    <a:pt x="6771" y="336"/>
                  </a:lnTo>
                  <a:lnTo>
                    <a:pt x="6776" y="338"/>
                  </a:lnTo>
                  <a:lnTo>
                    <a:pt x="6784" y="340"/>
                  </a:lnTo>
                  <a:lnTo>
                    <a:pt x="6790" y="342"/>
                  </a:lnTo>
                  <a:lnTo>
                    <a:pt x="6798" y="342"/>
                  </a:lnTo>
                  <a:lnTo>
                    <a:pt x="6805" y="344"/>
                  </a:lnTo>
                  <a:lnTo>
                    <a:pt x="6811" y="346"/>
                  </a:lnTo>
                  <a:lnTo>
                    <a:pt x="6819" y="346"/>
                  </a:lnTo>
                  <a:lnTo>
                    <a:pt x="6824" y="348"/>
                  </a:lnTo>
                  <a:lnTo>
                    <a:pt x="6832" y="350"/>
                  </a:lnTo>
                  <a:lnTo>
                    <a:pt x="6840" y="350"/>
                  </a:lnTo>
                  <a:lnTo>
                    <a:pt x="6846" y="352"/>
                  </a:lnTo>
                  <a:lnTo>
                    <a:pt x="6851" y="35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431" name="Rectangle 739">
              <a:extLst>
                <a:ext uri="{FF2B5EF4-FFF2-40B4-BE49-F238E27FC236}">
                  <a16:creationId xmlns:a16="http://schemas.microsoft.com/office/drawing/2014/main" id="{CF6A578B-30E6-4885-8FC2-DE4639C8EE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329598" y="3730860"/>
              <a:ext cx="2403026" cy="955045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endParaRPr lang="ja-JP" altLang="en-US" sz="700">
                <a:latin typeface="Arial" panose="020B0604020202020204" pitchFamily="34" charset="0"/>
              </a:endParaRPr>
            </a:p>
          </p:txBody>
        </p:sp>
        <p:sp>
          <p:nvSpPr>
            <p:cNvPr id="816" name="テキスト ボックス 1271">
              <a:extLst>
                <a:ext uri="{FF2B5EF4-FFF2-40B4-BE49-F238E27FC236}">
                  <a16:creationId xmlns:a16="http://schemas.microsoft.com/office/drawing/2014/main" id="{8FDA6FB3-2A31-4C40-A8FF-9AD3154A25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976" y="4399932"/>
              <a:ext cx="449162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 days</a:t>
              </a:r>
              <a:endParaRPr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8" name="Freeform 109">
            <a:extLst>
              <a:ext uri="{FF2B5EF4-FFF2-40B4-BE49-F238E27FC236}">
                <a16:creationId xmlns:a16="http://schemas.microsoft.com/office/drawing/2014/main" id="{0C05753D-5972-48A4-A99B-4C565695A284}"/>
              </a:ext>
            </a:extLst>
          </p:cNvPr>
          <p:cNvSpPr>
            <a:spLocks/>
          </p:cNvSpPr>
          <p:nvPr/>
        </p:nvSpPr>
        <p:spPr bwMode="auto">
          <a:xfrm>
            <a:off x="4925106" y="1068357"/>
            <a:ext cx="1705645" cy="493537"/>
          </a:xfrm>
          <a:custGeom>
            <a:avLst/>
            <a:gdLst>
              <a:gd name="T0" fmla="*/ 24 w 6851"/>
              <a:gd name="T1" fmla="*/ 158 h 766"/>
              <a:gd name="T2" fmla="*/ 52 w 6851"/>
              <a:gd name="T3" fmla="*/ 182 h 766"/>
              <a:gd name="T4" fmla="*/ 79 w 6851"/>
              <a:gd name="T5" fmla="*/ 190 h 766"/>
              <a:gd name="T6" fmla="*/ 107 w 6851"/>
              <a:gd name="T7" fmla="*/ 191 h 766"/>
              <a:gd name="T8" fmla="*/ 135 w 6851"/>
              <a:gd name="T9" fmla="*/ 192 h 766"/>
              <a:gd name="T10" fmla="*/ 162 w 6851"/>
              <a:gd name="T11" fmla="*/ 192 h 766"/>
              <a:gd name="T12" fmla="*/ 190 w 6851"/>
              <a:gd name="T13" fmla="*/ 192 h 766"/>
              <a:gd name="T14" fmla="*/ 217 w 6851"/>
              <a:gd name="T15" fmla="*/ 192 h 766"/>
              <a:gd name="T16" fmla="*/ 245 w 6851"/>
              <a:gd name="T17" fmla="*/ 191 h 766"/>
              <a:gd name="T18" fmla="*/ 272 w 6851"/>
              <a:gd name="T19" fmla="*/ 190 h 766"/>
              <a:gd name="T20" fmla="*/ 300 w 6851"/>
              <a:gd name="T21" fmla="*/ 188 h 766"/>
              <a:gd name="T22" fmla="*/ 328 w 6851"/>
              <a:gd name="T23" fmla="*/ 183 h 766"/>
              <a:gd name="T24" fmla="*/ 355 w 6851"/>
              <a:gd name="T25" fmla="*/ 175 h 766"/>
              <a:gd name="T26" fmla="*/ 383 w 6851"/>
              <a:gd name="T27" fmla="*/ 166 h 766"/>
              <a:gd name="T28" fmla="*/ 410 w 6851"/>
              <a:gd name="T29" fmla="*/ 159 h 766"/>
              <a:gd name="T30" fmla="*/ 438 w 6851"/>
              <a:gd name="T31" fmla="*/ 155 h 766"/>
              <a:gd name="T32" fmla="*/ 465 w 6851"/>
              <a:gd name="T33" fmla="*/ 153 h 766"/>
              <a:gd name="T34" fmla="*/ 493 w 6851"/>
              <a:gd name="T35" fmla="*/ 152 h 766"/>
              <a:gd name="T36" fmla="*/ 521 w 6851"/>
              <a:gd name="T37" fmla="*/ 151 h 766"/>
              <a:gd name="T38" fmla="*/ 548 w 6851"/>
              <a:gd name="T39" fmla="*/ 149 h 766"/>
              <a:gd name="T40" fmla="*/ 576 w 6851"/>
              <a:gd name="T41" fmla="*/ 148 h 766"/>
              <a:gd name="T42" fmla="*/ 603 w 6851"/>
              <a:gd name="T43" fmla="*/ 147 h 766"/>
              <a:gd name="T44" fmla="*/ 631 w 6851"/>
              <a:gd name="T45" fmla="*/ 146 h 766"/>
              <a:gd name="T46" fmla="*/ 658 w 6851"/>
              <a:gd name="T47" fmla="*/ 146 h 766"/>
              <a:gd name="T48" fmla="*/ 686 w 6851"/>
              <a:gd name="T49" fmla="*/ 145 h 766"/>
              <a:gd name="T50" fmla="*/ 714 w 6851"/>
              <a:gd name="T51" fmla="*/ 144 h 766"/>
              <a:gd name="T52" fmla="*/ 741 w 6851"/>
              <a:gd name="T53" fmla="*/ 144 h 766"/>
              <a:gd name="T54" fmla="*/ 769 w 6851"/>
              <a:gd name="T55" fmla="*/ 143 h 766"/>
              <a:gd name="T56" fmla="*/ 796 w 6851"/>
              <a:gd name="T57" fmla="*/ 141 h 766"/>
              <a:gd name="T58" fmla="*/ 824 w 6851"/>
              <a:gd name="T59" fmla="*/ 141 h 766"/>
              <a:gd name="T60" fmla="*/ 851 w 6851"/>
              <a:gd name="T61" fmla="*/ 140 h 766"/>
              <a:gd name="T62" fmla="*/ 879 w 6851"/>
              <a:gd name="T63" fmla="*/ 139 h 766"/>
              <a:gd name="T64" fmla="*/ 906 w 6851"/>
              <a:gd name="T65" fmla="*/ 137 h 766"/>
              <a:gd name="T66" fmla="*/ 934 w 6851"/>
              <a:gd name="T67" fmla="*/ 136 h 766"/>
              <a:gd name="T68" fmla="*/ 962 w 6851"/>
              <a:gd name="T69" fmla="*/ 135 h 766"/>
              <a:gd name="T70" fmla="*/ 989 w 6851"/>
              <a:gd name="T71" fmla="*/ 134 h 766"/>
              <a:gd name="T72" fmla="*/ 1017 w 6851"/>
              <a:gd name="T73" fmla="*/ 132 h 766"/>
              <a:gd name="T74" fmla="*/ 1044 w 6851"/>
              <a:gd name="T75" fmla="*/ 131 h 766"/>
              <a:gd name="T76" fmla="*/ 1072 w 6851"/>
              <a:gd name="T77" fmla="*/ 130 h 766"/>
              <a:gd name="T78" fmla="*/ 1099 w 6851"/>
              <a:gd name="T79" fmla="*/ 129 h 766"/>
              <a:gd name="T80" fmla="*/ 1127 w 6851"/>
              <a:gd name="T81" fmla="*/ 128 h 766"/>
              <a:gd name="T82" fmla="*/ 1155 w 6851"/>
              <a:gd name="T83" fmla="*/ 127 h 766"/>
              <a:gd name="T84" fmla="*/ 1182 w 6851"/>
              <a:gd name="T85" fmla="*/ 122 h 766"/>
              <a:gd name="T86" fmla="*/ 1210 w 6851"/>
              <a:gd name="T87" fmla="*/ 124 h 766"/>
              <a:gd name="T88" fmla="*/ 1237 w 6851"/>
              <a:gd name="T89" fmla="*/ 122 h 766"/>
              <a:gd name="T90" fmla="*/ 1265 w 6851"/>
              <a:gd name="T91" fmla="*/ 120 h 766"/>
              <a:gd name="T92" fmla="*/ 1292 w 6851"/>
              <a:gd name="T93" fmla="*/ 117 h 766"/>
              <a:gd name="T94" fmla="*/ 1320 w 6851"/>
              <a:gd name="T95" fmla="*/ 115 h 766"/>
              <a:gd name="T96" fmla="*/ 1348 w 6851"/>
              <a:gd name="T97" fmla="*/ 113 h 766"/>
              <a:gd name="T98" fmla="*/ 1375 w 6851"/>
              <a:gd name="T99" fmla="*/ 111 h 766"/>
              <a:gd name="T100" fmla="*/ 1403 w 6851"/>
              <a:gd name="T101" fmla="*/ 110 h 766"/>
              <a:gd name="T102" fmla="*/ 1430 w 6851"/>
              <a:gd name="T103" fmla="*/ 106 h 766"/>
              <a:gd name="T104" fmla="*/ 1458 w 6851"/>
              <a:gd name="T105" fmla="*/ 105 h 766"/>
              <a:gd name="T106" fmla="*/ 1485 w 6851"/>
              <a:gd name="T107" fmla="*/ 104 h 766"/>
              <a:gd name="T108" fmla="*/ 1513 w 6851"/>
              <a:gd name="T109" fmla="*/ 7 h 766"/>
              <a:gd name="T110" fmla="*/ 1541 w 6851"/>
              <a:gd name="T111" fmla="*/ 65 h 766"/>
              <a:gd name="T112" fmla="*/ 1568 w 6851"/>
              <a:gd name="T113" fmla="*/ 67 h 766"/>
              <a:gd name="T114" fmla="*/ 1596 w 6851"/>
              <a:gd name="T115" fmla="*/ 27 h 766"/>
              <a:gd name="T116" fmla="*/ 1623 w 6851"/>
              <a:gd name="T117" fmla="*/ 52 h 766"/>
              <a:gd name="T118" fmla="*/ 1651 w 6851"/>
              <a:gd name="T119" fmla="*/ 67 h 766"/>
              <a:gd name="T120" fmla="*/ 1678 w 6851"/>
              <a:gd name="T121" fmla="*/ 74 h 766"/>
              <a:gd name="T122" fmla="*/ 1706 w 6851"/>
              <a:gd name="T123" fmla="*/ 79 h 76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  <a:gd name="T165" fmla="*/ 0 60000 65536"/>
              <a:gd name="T166" fmla="*/ 0 60000 65536"/>
              <a:gd name="T167" fmla="*/ 0 60000 65536"/>
              <a:gd name="T168" fmla="*/ 0 60000 65536"/>
              <a:gd name="T169" fmla="*/ 0 60000 65536"/>
              <a:gd name="T170" fmla="*/ 0 60000 65536"/>
              <a:gd name="T171" fmla="*/ 0 60000 65536"/>
              <a:gd name="T172" fmla="*/ 0 60000 65536"/>
              <a:gd name="T173" fmla="*/ 0 60000 65536"/>
              <a:gd name="T174" fmla="*/ 0 60000 65536"/>
              <a:gd name="T175" fmla="*/ 0 60000 65536"/>
              <a:gd name="T176" fmla="*/ 0 60000 65536"/>
              <a:gd name="T177" fmla="*/ 0 60000 65536"/>
              <a:gd name="T178" fmla="*/ 0 60000 65536"/>
              <a:gd name="T179" fmla="*/ 0 60000 65536"/>
              <a:gd name="T180" fmla="*/ 0 60000 65536"/>
              <a:gd name="T181" fmla="*/ 0 60000 65536"/>
              <a:gd name="T182" fmla="*/ 0 60000 65536"/>
              <a:gd name="T183" fmla="*/ 0 60000 65536"/>
              <a:gd name="T184" fmla="*/ 0 60000 65536"/>
              <a:gd name="T185" fmla="*/ 0 60000 65536"/>
            </a:gdLst>
            <a:ahLst/>
            <a:cxnLst>
              <a:cxn ang="T124">
                <a:pos x="T0" y="T1"/>
              </a:cxn>
              <a:cxn ang="T125">
                <a:pos x="T2" y="T3"/>
              </a:cxn>
              <a:cxn ang="T126">
                <a:pos x="T4" y="T5"/>
              </a:cxn>
              <a:cxn ang="T127">
                <a:pos x="T6" y="T7"/>
              </a:cxn>
              <a:cxn ang="T128">
                <a:pos x="T8" y="T9"/>
              </a:cxn>
              <a:cxn ang="T129">
                <a:pos x="T10" y="T11"/>
              </a:cxn>
              <a:cxn ang="T130">
                <a:pos x="T12" y="T13"/>
              </a:cxn>
              <a:cxn ang="T131">
                <a:pos x="T14" y="T15"/>
              </a:cxn>
              <a:cxn ang="T132">
                <a:pos x="T16" y="T17"/>
              </a:cxn>
              <a:cxn ang="T133">
                <a:pos x="T18" y="T19"/>
              </a:cxn>
              <a:cxn ang="T134">
                <a:pos x="T20" y="T21"/>
              </a:cxn>
              <a:cxn ang="T135">
                <a:pos x="T22" y="T23"/>
              </a:cxn>
              <a:cxn ang="T136">
                <a:pos x="T24" y="T25"/>
              </a:cxn>
              <a:cxn ang="T137">
                <a:pos x="T26" y="T27"/>
              </a:cxn>
              <a:cxn ang="T138">
                <a:pos x="T28" y="T29"/>
              </a:cxn>
              <a:cxn ang="T139">
                <a:pos x="T30" y="T31"/>
              </a:cxn>
              <a:cxn ang="T140">
                <a:pos x="T32" y="T33"/>
              </a:cxn>
              <a:cxn ang="T141">
                <a:pos x="T34" y="T35"/>
              </a:cxn>
              <a:cxn ang="T142">
                <a:pos x="T36" y="T37"/>
              </a:cxn>
              <a:cxn ang="T143">
                <a:pos x="T38" y="T39"/>
              </a:cxn>
              <a:cxn ang="T144">
                <a:pos x="T40" y="T41"/>
              </a:cxn>
              <a:cxn ang="T145">
                <a:pos x="T42" y="T43"/>
              </a:cxn>
              <a:cxn ang="T146">
                <a:pos x="T44" y="T45"/>
              </a:cxn>
              <a:cxn ang="T147">
                <a:pos x="T46" y="T47"/>
              </a:cxn>
              <a:cxn ang="T148">
                <a:pos x="T48" y="T49"/>
              </a:cxn>
              <a:cxn ang="T149">
                <a:pos x="T50" y="T51"/>
              </a:cxn>
              <a:cxn ang="T150">
                <a:pos x="T52" y="T53"/>
              </a:cxn>
              <a:cxn ang="T151">
                <a:pos x="T54" y="T55"/>
              </a:cxn>
              <a:cxn ang="T152">
                <a:pos x="T56" y="T57"/>
              </a:cxn>
              <a:cxn ang="T153">
                <a:pos x="T58" y="T59"/>
              </a:cxn>
              <a:cxn ang="T154">
                <a:pos x="T60" y="T61"/>
              </a:cxn>
              <a:cxn ang="T155">
                <a:pos x="T62" y="T63"/>
              </a:cxn>
              <a:cxn ang="T156">
                <a:pos x="T64" y="T65"/>
              </a:cxn>
              <a:cxn ang="T157">
                <a:pos x="T66" y="T67"/>
              </a:cxn>
              <a:cxn ang="T158">
                <a:pos x="T68" y="T69"/>
              </a:cxn>
              <a:cxn ang="T159">
                <a:pos x="T70" y="T71"/>
              </a:cxn>
              <a:cxn ang="T160">
                <a:pos x="T72" y="T73"/>
              </a:cxn>
              <a:cxn ang="T161">
                <a:pos x="T74" y="T75"/>
              </a:cxn>
              <a:cxn ang="T162">
                <a:pos x="T76" y="T77"/>
              </a:cxn>
              <a:cxn ang="T163">
                <a:pos x="T78" y="T79"/>
              </a:cxn>
              <a:cxn ang="T164">
                <a:pos x="T80" y="T81"/>
              </a:cxn>
              <a:cxn ang="T165">
                <a:pos x="T82" y="T83"/>
              </a:cxn>
              <a:cxn ang="T166">
                <a:pos x="T84" y="T85"/>
              </a:cxn>
              <a:cxn ang="T167">
                <a:pos x="T86" y="T87"/>
              </a:cxn>
              <a:cxn ang="T168">
                <a:pos x="T88" y="T89"/>
              </a:cxn>
              <a:cxn ang="T169">
                <a:pos x="T90" y="T91"/>
              </a:cxn>
              <a:cxn ang="T170">
                <a:pos x="T92" y="T93"/>
              </a:cxn>
              <a:cxn ang="T171">
                <a:pos x="T94" y="T95"/>
              </a:cxn>
              <a:cxn ang="T172">
                <a:pos x="T96" y="T97"/>
              </a:cxn>
              <a:cxn ang="T173">
                <a:pos x="T98" y="T99"/>
              </a:cxn>
              <a:cxn ang="T174">
                <a:pos x="T100" y="T101"/>
              </a:cxn>
              <a:cxn ang="T175">
                <a:pos x="T102" y="T103"/>
              </a:cxn>
              <a:cxn ang="T176">
                <a:pos x="T104" y="T105"/>
              </a:cxn>
              <a:cxn ang="T177">
                <a:pos x="T106" y="T107"/>
              </a:cxn>
              <a:cxn ang="T178">
                <a:pos x="T108" y="T109"/>
              </a:cxn>
              <a:cxn ang="T179">
                <a:pos x="T110" y="T111"/>
              </a:cxn>
              <a:cxn ang="T180">
                <a:pos x="T112" y="T113"/>
              </a:cxn>
              <a:cxn ang="T181">
                <a:pos x="T114" y="T115"/>
              </a:cxn>
              <a:cxn ang="T182">
                <a:pos x="T116" y="T117"/>
              </a:cxn>
              <a:cxn ang="T183">
                <a:pos x="T118" y="T119"/>
              </a:cxn>
              <a:cxn ang="T184">
                <a:pos x="T120" y="T121"/>
              </a:cxn>
              <a:cxn ang="T185">
                <a:pos x="T122" y="T123"/>
              </a:cxn>
            </a:cxnLst>
            <a:rect l="0" t="0" r="r" b="b"/>
            <a:pathLst>
              <a:path w="6851" h="766">
                <a:moveTo>
                  <a:pt x="0" y="620"/>
                </a:moveTo>
                <a:lnTo>
                  <a:pt x="2" y="622"/>
                </a:lnTo>
                <a:lnTo>
                  <a:pt x="8" y="620"/>
                </a:lnTo>
                <a:lnTo>
                  <a:pt x="16" y="618"/>
                </a:lnTo>
                <a:lnTo>
                  <a:pt x="23" y="614"/>
                </a:lnTo>
                <a:lnTo>
                  <a:pt x="29" y="609"/>
                </a:lnTo>
                <a:lnTo>
                  <a:pt x="37" y="607"/>
                </a:lnTo>
                <a:lnTo>
                  <a:pt x="43" y="603"/>
                </a:lnTo>
                <a:lnTo>
                  <a:pt x="50" y="603"/>
                </a:lnTo>
                <a:lnTo>
                  <a:pt x="58" y="603"/>
                </a:lnTo>
                <a:lnTo>
                  <a:pt x="64" y="605"/>
                </a:lnTo>
                <a:lnTo>
                  <a:pt x="71" y="607"/>
                </a:lnTo>
                <a:lnTo>
                  <a:pt x="77" y="612"/>
                </a:lnTo>
                <a:lnTo>
                  <a:pt x="85" y="618"/>
                </a:lnTo>
                <a:lnTo>
                  <a:pt x="92" y="624"/>
                </a:lnTo>
                <a:lnTo>
                  <a:pt x="98" y="630"/>
                </a:lnTo>
                <a:lnTo>
                  <a:pt x="106" y="637"/>
                </a:lnTo>
                <a:lnTo>
                  <a:pt x="112" y="643"/>
                </a:lnTo>
                <a:lnTo>
                  <a:pt x="119" y="651"/>
                </a:lnTo>
                <a:lnTo>
                  <a:pt x="127" y="658"/>
                </a:lnTo>
                <a:lnTo>
                  <a:pt x="133" y="666"/>
                </a:lnTo>
                <a:lnTo>
                  <a:pt x="140" y="672"/>
                </a:lnTo>
                <a:lnTo>
                  <a:pt x="146" y="680"/>
                </a:lnTo>
                <a:lnTo>
                  <a:pt x="154" y="685"/>
                </a:lnTo>
                <a:lnTo>
                  <a:pt x="160" y="693"/>
                </a:lnTo>
                <a:lnTo>
                  <a:pt x="167" y="699"/>
                </a:lnTo>
                <a:lnTo>
                  <a:pt x="175" y="704"/>
                </a:lnTo>
                <a:lnTo>
                  <a:pt x="181" y="710"/>
                </a:lnTo>
                <a:lnTo>
                  <a:pt x="188" y="714"/>
                </a:lnTo>
                <a:lnTo>
                  <a:pt x="194" y="720"/>
                </a:lnTo>
                <a:lnTo>
                  <a:pt x="202" y="724"/>
                </a:lnTo>
                <a:lnTo>
                  <a:pt x="210" y="727"/>
                </a:lnTo>
                <a:lnTo>
                  <a:pt x="215" y="731"/>
                </a:lnTo>
                <a:lnTo>
                  <a:pt x="223" y="735"/>
                </a:lnTo>
                <a:lnTo>
                  <a:pt x="229" y="739"/>
                </a:lnTo>
                <a:lnTo>
                  <a:pt x="236" y="743"/>
                </a:lnTo>
                <a:lnTo>
                  <a:pt x="244" y="745"/>
                </a:lnTo>
                <a:lnTo>
                  <a:pt x="250" y="747"/>
                </a:lnTo>
                <a:lnTo>
                  <a:pt x="258" y="751"/>
                </a:lnTo>
                <a:lnTo>
                  <a:pt x="263" y="752"/>
                </a:lnTo>
                <a:lnTo>
                  <a:pt x="271" y="754"/>
                </a:lnTo>
                <a:lnTo>
                  <a:pt x="277" y="754"/>
                </a:lnTo>
                <a:lnTo>
                  <a:pt x="284" y="756"/>
                </a:lnTo>
                <a:lnTo>
                  <a:pt x="292" y="758"/>
                </a:lnTo>
                <a:lnTo>
                  <a:pt x="298" y="758"/>
                </a:lnTo>
                <a:lnTo>
                  <a:pt x="306" y="760"/>
                </a:lnTo>
                <a:lnTo>
                  <a:pt x="311" y="760"/>
                </a:lnTo>
                <a:lnTo>
                  <a:pt x="319" y="760"/>
                </a:lnTo>
                <a:lnTo>
                  <a:pt x="327" y="762"/>
                </a:lnTo>
                <a:lnTo>
                  <a:pt x="332" y="762"/>
                </a:lnTo>
                <a:lnTo>
                  <a:pt x="340" y="762"/>
                </a:lnTo>
                <a:lnTo>
                  <a:pt x="346" y="762"/>
                </a:lnTo>
                <a:lnTo>
                  <a:pt x="354" y="762"/>
                </a:lnTo>
                <a:lnTo>
                  <a:pt x="361" y="764"/>
                </a:lnTo>
                <a:lnTo>
                  <a:pt x="367" y="764"/>
                </a:lnTo>
                <a:lnTo>
                  <a:pt x="375" y="764"/>
                </a:lnTo>
                <a:lnTo>
                  <a:pt x="380" y="764"/>
                </a:lnTo>
                <a:lnTo>
                  <a:pt x="388" y="764"/>
                </a:lnTo>
                <a:lnTo>
                  <a:pt x="394" y="764"/>
                </a:lnTo>
                <a:lnTo>
                  <a:pt x="402" y="764"/>
                </a:lnTo>
                <a:lnTo>
                  <a:pt x="409" y="764"/>
                </a:lnTo>
                <a:lnTo>
                  <a:pt x="415" y="764"/>
                </a:lnTo>
                <a:lnTo>
                  <a:pt x="423" y="764"/>
                </a:lnTo>
                <a:lnTo>
                  <a:pt x="429" y="764"/>
                </a:lnTo>
                <a:lnTo>
                  <a:pt x="436" y="764"/>
                </a:lnTo>
                <a:lnTo>
                  <a:pt x="444" y="764"/>
                </a:lnTo>
                <a:lnTo>
                  <a:pt x="450" y="764"/>
                </a:lnTo>
                <a:lnTo>
                  <a:pt x="457" y="764"/>
                </a:lnTo>
                <a:lnTo>
                  <a:pt x="463" y="764"/>
                </a:lnTo>
                <a:lnTo>
                  <a:pt x="471" y="764"/>
                </a:lnTo>
                <a:lnTo>
                  <a:pt x="478" y="764"/>
                </a:lnTo>
                <a:lnTo>
                  <a:pt x="484" y="764"/>
                </a:lnTo>
                <a:lnTo>
                  <a:pt x="492" y="764"/>
                </a:lnTo>
                <a:lnTo>
                  <a:pt x="498" y="766"/>
                </a:lnTo>
                <a:lnTo>
                  <a:pt x="505" y="766"/>
                </a:lnTo>
                <a:lnTo>
                  <a:pt x="513" y="766"/>
                </a:lnTo>
                <a:lnTo>
                  <a:pt x="519" y="766"/>
                </a:lnTo>
                <a:lnTo>
                  <a:pt x="526" y="766"/>
                </a:lnTo>
                <a:lnTo>
                  <a:pt x="532" y="766"/>
                </a:lnTo>
                <a:lnTo>
                  <a:pt x="540" y="766"/>
                </a:lnTo>
                <a:lnTo>
                  <a:pt x="546" y="766"/>
                </a:lnTo>
                <a:lnTo>
                  <a:pt x="553" y="766"/>
                </a:lnTo>
                <a:lnTo>
                  <a:pt x="561" y="766"/>
                </a:lnTo>
                <a:lnTo>
                  <a:pt x="567" y="766"/>
                </a:lnTo>
                <a:lnTo>
                  <a:pt x="574" y="766"/>
                </a:lnTo>
                <a:lnTo>
                  <a:pt x="580" y="766"/>
                </a:lnTo>
                <a:lnTo>
                  <a:pt x="588" y="766"/>
                </a:lnTo>
                <a:lnTo>
                  <a:pt x="596" y="766"/>
                </a:lnTo>
                <a:lnTo>
                  <a:pt x="601" y="766"/>
                </a:lnTo>
                <a:lnTo>
                  <a:pt x="609" y="766"/>
                </a:lnTo>
                <a:lnTo>
                  <a:pt x="615" y="766"/>
                </a:lnTo>
                <a:lnTo>
                  <a:pt x="622" y="766"/>
                </a:lnTo>
                <a:lnTo>
                  <a:pt x="630" y="766"/>
                </a:lnTo>
                <a:lnTo>
                  <a:pt x="636" y="766"/>
                </a:lnTo>
                <a:lnTo>
                  <a:pt x="644" y="766"/>
                </a:lnTo>
                <a:lnTo>
                  <a:pt x="649" y="766"/>
                </a:lnTo>
                <a:lnTo>
                  <a:pt x="657" y="766"/>
                </a:lnTo>
                <a:lnTo>
                  <a:pt x="663" y="766"/>
                </a:lnTo>
                <a:lnTo>
                  <a:pt x="670" y="766"/>
                </a:lnTo>
                <a:lnTo>
                  <a:pt x="678" y="766"/>
                </a:lnTo>
                <a:lnTo>
                  <a:pt x="684" y="766"/>
                </a:lnTo>
                <a:lnTo>
                  <a:pt x="692" y="766"/>
                </a:lnTo>
                <a:lnTo>
                  <a:pt x="697" y="766"/>
                </a:lnTo>
                <a:lnTo>
                  <a:pt x="705" y="766"/>
                </a:lnTo>
                <a:lnTo>
                  <a:pt x="713" y="766"/>
                </a:lnTo>
                <a:lnTo>
                  <a:pt x="718" y="766"/>
                </a:lnTo>
                <a:lnTo>
                  <a:pt x="726" y="766"/>
                </a:lnTo>
                <a:lnTo>
                  <a:pt x="732" y="766"/>
                </a:lnTo>
                <a:lnTo>
                  <a:pt x="740" y="766"/>
                </a:lnTo>
                <a:lnTo>
                  <a:pt x="747" y="766"/>
                </a:lnTo>
                <a:lnTo>
                  <a:pt x="753" y="766"/>
                </a:lnTo>
                <a:lnTo>
                  <a:pt x="761" y="766"/>
                </a:lnTo>
                <a:lnTo>
                  <a:pt x="766" y="766"/>
                </a:lnTo>
                <a:lnTo>
                  <a:pt x="774" y="766"/>
                </a:lnTo>
                <a:lnTo>
                  <a:pt x="782" y="766"/>
                </a:lnTo>
                <a:lnTo>
                  <a:pt x="788" y="766"/>
                </a:lnTo>
                <a:lnTo>
                  <a:pt x="795" y="766"/>
                </a:lnTo>
                <a:lnTo>
                  <a:pt x="801" y="766"/>
                </a:lnTo>
                <a:lnTo>
                  <a:pt x="809" y="766"/>
                </a:lnTo>
                <a:lnTo>
                  <a:pt x="814" y="766"/>
                </a:lnTo>
                <a:lnTo>
                  <a:pt x="822" y="766"/>
                </a:lnTo>
                <a:lnTo>
                  <a:pt x="830" y="766"/>
                </a:lnTo>
                <a:lnTo>
                  <a:pt x="836" y="766"/>
                </a:lnTo>
                <a:lnTo>
                  <a:pt x="843" y="766"/>
                </a:lnTo>
                <a:lnTo>
                  <a:pt x="849" y="766"/>
                </a:lnTo>
                <a:lnTo>
                  <a:pt x="857" y="766"/>
                </a:lnTo>
                <a:lnTo>
                  <a:pt x="864" y="766"/>
                </a:lnTo>
                <a:lnTo>
                  <a:pt x="870" y="766"/>
                </a:lnTo>
                <a:lnTo>
                  <a:pt x="878" y="766"/>
                </a:lnTo>
                <a:lnTo>
                  <a:pt x="884" y="766"/>
                </a:lnTo>
                <a:lnTo>
                  <a:pt x="891" y="766"/>
                </a:lnTo>
                <a:lnTo>
                  <a:pt x="899" y="766"/>
                </a:lnTo>
                <a:lnTo>
                  <a:pt x="905" y="766"/>
                </a:lnTo>
                <a:lnTo>
                  <a:pt x="912" y="766"/>
                </a:lnTo>
                <a:lnTo>
                  <a:pt x="918" y="766"/>
                </a:lnTo>
                <a:lnTo>
                  <a:pt x="926" y="766"/>
                </a:lnTo>
                <a:lnTo>
                  <a:pt x="932" y="764"/>
                </a:lnTo>
                <a:lnTo>
                  <a:pt x="939" y="764"/>
                </a:lnTo>
                <a:lnTo>
                  <a:pt x="947" y="764"/>
                </a:lnTo>
                <a:lnTo>
                  <a:pt x="953" y="764"/>
                </a:lnTo>
                <a:lnTo>
                  <a:pt x="960" y="764"/>
                </a:lnTo>
                <a:lnTo>
                  <a:pt x="966" y="764"/>
                </a:lnTo>
                <a:lnTo>
                  <a:pt x="974" y="764"/>
                </a:lnTo>
                <a:lnTo>
                  <a:pt x="981" y="764"/>
                </a:lnTo>
                <a:lnTo>
                  <a:pt x="987" y="764"/>
                </a:lnTo>
                <a:lnTo>
                  <a:pt x="995" y="764"/>
                </a:lnTo>
                <a:lnTo>
                  <a:pt x="1001" y="764"/>
                </a:lnTo>
                <a:lnTo>
                  <a:pt x="1008" y="764"/>
                </a:lnTo>
                <a:lnTo>
                  <a:pt x="1016" y="762"/>
                </a:lnTo>
                <a:lnTo>
                  <a:pt x="1022" y="762"/>
                </a:lnTo>
                <a:lnTo>
                  <a:pt x="1029" y="762"/>
                </a:lnTo>
                <a:lnTo>
                  <a:pt x="1035" y="762"/>
                </a:lnTo>
                <a:lnTo>
                  <a:pt x="1043" y="762"/>
                </a:lnTo>
                <a:lnTo>
                  <a:pt x="1049" y="762"/>
                </a:lnTo>
                <a:lnTo>
                  <a:pt x="1056" y="762"/>
                </a:lnTo>
                <a:lnTo>
                  <a:pt x="1064" y="760"/>
                </a:lnTo>
                <a:lnTo>
                  <a:pt x="1070" y="760"/>
                </a:lnTo>
                <a:lnTo>
                  <a:pt x="1078" y="760"/>
                </a:lnTo>
                <a:lnTo>
                  <a:pt x="1083" y="760"/>
                </a:lnTo>
                <a:lnTo>
                  <a:pt x="1091" y="760"/>
                </a:lnTo>
                <a:lnTo>
                  <a:pt x="1099" y="758"/>
                </a:lnTo>
                <a:lnTo>
                  <a:pt x="1104" y="758"/>
                </a:lnTo>
                <a:lnTo>
                  <a:pt x="1112" y="758"/>
                </a:lnTo>
                <a:lnTo>
                  <a:pt x="1118" y="758"/>
                </a:lnTo>
                <a:lnTo>
                  <a:pt x="1126" y="758"/>
                </a:lnTo>
                <a:lnTo>
                  <a:pt x="1133" y="756"/>
                </a:lnTo>
                <a:lnTo>
                  <a:pt x="1139" y="756"/>
                </a:lnTo>
                <a:lnTo>
                  <a:pt x="1147" y="756"/>
                </a:lnTo>
                <a:lnTo>
                  <a:pt x="1152" y="754"/>
                </a:lnTo>
                <a:lnTo>
                  <a:pt x="1160" y="754"/>
                </a:lnTo>
                <a:lnTo>
                  <a:pt x="1168" y="752"/>
                </a:lnTo>
                <a:lnTo>
                  <a:pt x="1174" y="752"/>
                </a:lnTo>
                <a:lnTo>
                  <a:pt x="1181" y="752"/>
                </a:lnTo>
                <a:lnTo>
                  <a:pt x="1187" y="751"/>
                </a:lnTo>
                <a:lnTo>
                  <a:pt x="1195" y="751"/>
                </a:lnTo>
                <a:lnTo>
                  <a:pt x="1200" y="751"/>
                </a:lnTo>
                <a:lnTo>
                  <a:pt x="1208" y="749"/>
                </a:lnTo>
                <a:lnTo>
                  <a:pt x="1216" y="749"/>
                </a:lnTo>
                <a:lnTo>
                  <a:pt x="1222" y="747"/>
                </a:lnTo>
                <a:lnTo>
                  <a:pt x="1229" y="747"/>
                </a:lnTo>
                <a:lnTo>
                  <a:pt x="1235" y="745"/>
                </a:lnTo>
                <a:lnTo>
                  <a:pt x="1243" y="745"/>
                </a:lnTo>
                <a:lnTo>
                  <a:pt x="1250" y="743"/>
                </a:lnTo>
                <a:lnTo>
                  <a:pt x="1256" y="743"/>
                </a:lnTo>
                <a:lnTo>
                  <a:pt x="1264" y="741"/>
                </a:lnTo>
                <a:lnTo>
                  <a:pt x="1270" y="739"/>
                </a:lnTo>
                <a:lnTo>
                  <a:pt x="1277" y="739"/>
                </a:lnTo>
                <a:lnTo>
                  <a:pt x="1285" y="737"/>
                </a:lnTo>
                <a:lnTo>
                  <a:pt x="1291" y="735"/>
                </a:lnTo>
                <a:lnTo>
                  <a:pt x="1298" y="733"/>
                </a:lnTo>
                <a:lnTo>
                  <a:pt x="1304" y="733"/>
                </a:lnTo>
                <a:lnTo>
                  <a:pt x="1312" y="731"/>
                </a:lnTo>
                <a:lnTo>
                  <a:pt x="1318" y="729"/>
                </a:lnTo>
                <a:lnTo>
                  <a:pt x="1325" y="727"/>
                </a:lnTo>
                <a:lnTo>
                  <a:pt x="1333" y="726"/>
                </a:lnTo>
                <a:lnTo>
                  <a:pt x="1339" y="724"/>
                </a:lnTo>
                <a:lnTo>
                  <a:pt x="1346" y="722"/>
                </a:lnTo>
                <a:lnTo>
                  <a:pt x="1352" y="720"/>
                </a:lnTo>
                <a:lnTo>
                  <a:pt x="1360" y="718"/>
                </a:lnTo>
                <a:lnTo>
                  <a:pt x="1367" y="716"/>
                </a:lnTo>
                <a:lnTo>
                  <a:pt x="1373" y="714"/>
                </a:lnTo>
                <a:lnTo>
                  <a:pt x="1381" y="712"/>
                </a:lnTo>
                <a:lnTo>
                  <a:pt x="1387" y="710"/>
                </a:lnTo>
                <a:lnTo>
                  <a:pt x="1394" y="708"/>
                </a:lnTo>
                <a:lnTo>
                  <a:pt x="1402" y="706"/>
                </a:lnTo>
                <a:lnTo>
                  <a:pt x="1408" y="703"/>
                </a:lnTo>
                <a:lnTo>
                  <a:pt x="1415" y="701"/>
                </a:lnTo>
                <a:lnTo>
                  <a:pt x="1421" y="699"/>
                </a:lnTo>
                <a:lnTo>
                  <a:pt x="1429" y="697"/>
                </a:lnTo>
                <a:lnTo>
                  <a:pt x="1435" y="695"/>
                </a:lnTo>
                <a:lnTo>
                  <a:pt x="1442" y="693"/>
                </a:lnTo>
                <a:lnTo>
                  <a:pt x="1450" y="689"/>
                </a:lnTo>
                <a:lnTo>
                  <a:pt x="1456" y="687"/>
                </a:lnTo>
                <a:lnTo>
                  <a:pt x="1463" y="685"/>
                </a:lnTo>
                <a:lnTo>
                  <a:pt x="1469" y="683"/>
                </a:lnTo>
                <a:lnTo>
                  <a:pt x="1477" y="681"/>
                </a:lnTo>
                <a:lnTo>
                  <a:pt x="1485" y="678"/>
                </a:lnTo>
                <a:lnTo>
                  <a:pt x="1490" y="676"/>
                </a:lnTo>
                <a:lnTo>
                  <a:pt x="1498" y="674"/>
                </a:lnTo>
                <a:lnTo>
                  <a:pt x="1504" y="672"/>
                </a:lnTo>
                <a:lnTo>
                  <a:pt x="1511" y="670"/>
                </a:lnTo>
                <a:lnTo>
                  <a:pt x="1519" y="668"/>
                </a:lnTo>
                <a:lnTo>
                  <a:pt x="1525" y="666"/>
                </a:lnTo>
                <a:lnTo>
                  <a:pt x="1533" y="664"/>
                </a:lnTo>
                <a:lnTo>
                  <a:pt x="1538" y="662"/>
                </a:lnTo>
                <a:lnTo>
                  <a:pt x="1546" y="660"/>
                </a:lnTo>
                <a:lnTo>
                  <a:pt x="1554" y="658"/>
                </a:lnTo>
                <a:lnTo>
                  <a:pt x="1559" y="655"/>
                </a:lnTo>
                <a:lnTo>
                  <a:pt x="1567" y="655"/>
                </a:lnTo>
                <a:lnTo>
                  <a:pt x="1573" y="653"/>
                </a:lnTo>
                <a:lnTo>
                  <a:pt x="1581" y="651"/>
                </a:lnTo>
                <a:lnTo>
                  <a:pt x="1586" y="649"/>
                </a:lnTo>
                <a:lnTo>
                  <a:pt x="1594" y="647"/>
                </a:lnTo>
                <a:lnTo>
                  <a:pt x="1602" y="645"/>
                </a:lnTo>
                <a:lnTo>
                  <a:pt x="1607" y="643"/>
                </a:lnTo>
                <a:lnTo>
                  <a:pt x="1615" y="641"/>
                </a:lnTo>
                <a:lnTo>
                  <a:pt x="1621" y="641"/>
                </a:lnTo>
                <a:lnTo>
                  <a:pt x="1629" y="639"/>
                </a:lnTo>
                <a:lnTo>
                  <a:pt x="1636" y="637"/>
                </a:lnTo>
                <a:lnTo>
                  <a:pt x="1642" y="635"/>
                </a:lnTo>
                <a:lnTo>
                  <a:pt x="1650" y="633"/>
                </a:lnTo>
                <a:lnTo>
                  <a:pt x="1655" y="633"/>
                </a:lnTo>
                <a:lnTo>
                  <a:pt x="1663" y="632"/>
                </a:lnTo>
                <a:lnTo>
                  <a:pt x="1671" y="632"/>
                </a:lnTo>
                <a:lnTo>
                  <a:pt x="1677" y="630"/>
                </a:lnTo>
                <a:lnTo>
                  <a:pt x="1684" y="628"/>
                </a:lnTo>
                <a:lnTo>
                  <a:pt x="1690" y="628"/>
                </a:lnTo>
                <a:lnTo>
                  <a:pt x="1698" y="626"/>
                </a:lnTo>
                <a:lnTo>
                  <a:pt x="1703" y="626"/>
                </a:lnTo>
                <a:lnTo>
                  <a:pt x="1711" y="624"/>
                </a:lnTo>
                <a:lnTo>
                  <a:pt x="1719" y="624"/>
                </a:lnTo>
                <a:lnTo>
                  <a:pt x="1725" y="622"/>
                </a:lnTo>
                <a:lnTo>
                  <a:pt x="1732" y="622"/>
                </a:lnTo>
                <a:lnTo>
                  <a:pt x="1738" y="620"/>
                </a:lnTo>
                <a:lnTo>
                  <a:pt x="1746" y="620"/>
                </a:lnTo>
                <a:lnTo>
                  <a:pt x="1753" y="620"/>
                </a:lnTo>
                <a:lnTo>
                  <a:pt x="1759" y="618"/>
                </a:lnTo>
                <a:lnTo>
                  <a:pt x="1767" y="618"/>
                </a:lnTo>
                <a:lnTo>
                  <a:pt x="1773" y="618"/>
                </a:lnTo>
                <a:lnTo>
                  <a:pt x="1780" y="616"/>
                </a:lnTo>
                <a:lnTo>
                  <a:pt x="1788" y="616"/>
                </a:lnTo>
                <a:lnTo>
                  <a:pt x="1794" y="616"/>
                </a:lnTo>
                <a:lnTo>
                  <a:pt x="1801" y="614"/>
                </a:lnTo>
                <a:lnTo>
                  <a:pt x="1807" y="614"/>
                </a:lnTo>
                <a:lnTo>
                  <a:pt x="1815" y="614"/>
                </a:lnTo>
                <a:lnTo>
                  <a:pt x="1823" y="614"/>
                </a:lnTo>
                <a:lnTo>
                  <a:pt x="1828" y="612"/>
                </a:lnTo>
                <a:lnTo>
                  <a:pt x="1836" y="612"/>
                </a:lnTo>
                <a:lnTo>
                  <a:pt x="1842" y="612"/>
                </a:lnTo>
                <a:lnTo>
                  <a:pt x="1849" y="610"/>
                </a:lnTo>
                <a:lnTo>
                  <a:pt x="1855" y="610"/>
                </a:lnTo>
                <a:lnTo>
                  <a:pt x="1863" y="610"/>
                </a:lnTo>
                <a:lnTo>
                  <a:pt x="1871" y="610"/>
                </a:lnTo>
                <a:lnTo>
                  <a:pt x="1876" y="610"/>
                </a:lnTo>
                <a:lnTo>
                  <a:pt x="1884" y="609"/>
                </a:lnTo>
                <a:lnTo>
                  <a:pt x="1890" y="609"/>
                </a:lnTo>
                <a:lnTo>
                  <a:pt x="1897" y="609"/>
                </a:lnTo>
                <a:lnTo>
                  <a:pt x="1905" y="609"/>
                </a:lnTo>
                <a:lnTo>
                  <a:pt x="1911" y="607"/>
                </a:lnTo>
                <a:lnTo>
                  <a:pt x="1919" y="607"/>
                </a:lnTo>
                <a:lnTo>
                  <a:pt x="1924" y="607"/>
                </a:lnTo>
                <a:lnTo>
                  <a:pt x="1932" y="607"/>
                </a:lnTo>
                <a:lnTo>
                  <a:pt x="1940" y="607"/>
                </a:lnTo>
                <a:lnTo>
                  <a:pt x="1945" y="607"/>
                </a:lnTo>
                <a:lnTo>
                  <a:pt x="1953" y="605"/>
                </a:lnTo>
                <a:lnTo>
                  <a:pt x="1959" y="605"/>
                </a:lnTo>
                <a:lnTo>
                  <a:pt x="1967" y="605"/>
                </a:lnTo>
                <a:lnTo>
                  <a:pt x="1972" y="605"/>
                </a:lnTo>
                <a:lnTo>
                  <a:pt x="1980" y="605"/>
                </a:lnTo>
                <a:lnTo>
                  <a:pt x="1988" y="603"/>
                </a:lnTo>
                <a:lnTo>
                  <a:pt x="1993" y="603"/>
                </a:lnTo>
                <a:lnTo>
                  <a:pt x="2001" y="603"/>
                </a:lnTo>
                <a:lnTo>
                  <a:pt x="2007" y="603"/>
                </a:lnTo>
                <a:lnTo>
                  <a:pt x="2015" y="603"/>
                </a:lnTo>
                <a:lnTo>
                  <a:pt x="2022" y="603"/>
                </a:lnTo>
                <a:lnTo>
                  <a:pt x="2028" y="603"/>
                </a:lnTo>
                <a:lnTo>
                  <a:pt x="2036" y="603"/>
                </a:lnTo>
                <a:lnTo>
                  <a:pt x="2041" y="601"/>
                </a:lnTo>
                <a:lnTo>
                  <a:pt x="2049" y="601"/>
                </a:lnTo>
                <a:lnTo>
                  <a:pt x="2057" y="601"/>
                </a:lnTo>
                <a:lnTo>
                  <a:pt x="2063" y="601"/>
                </a:lnTo>
                <a:lnTo>
                  <a:pt x="2070" y="601"/>
                </a:lnTo>
                <a:lnTo>
                  <a:pt x="2076" y="601"/>
                </a:lnTo>
                <a:lnTo>
                  <a:pt x="2084" y="601"/>
                </a:lnTo>
                <a:lnTo>
                  <a:pt x="2089" y="601"/>
                </a:lnTo>
                <a:lnTo>
                  <a:pt x="2097" y="599"/>
                </a:lnTo>
                <a:lnTo>
                  <a:pt x="2105" y="599"/>
                </a:lnTo>
                <a:lnTo>
                  <a:pt x="2111" y="599"/>
                </a:lnTo>
                <a:lnTo>
                  <a:pt x="2118" y="599"/>
                </a:lnTo>
                <a:lnTo>
                  <a:pt x="2124" y="599"/>
                </a:lnTo>
                <a:lnTo>
                  <a:pt x="2132" y="597"/>
                </a:lnTo>
                <a:lnTo>
                  <a:pt x="2139" y="597"/>
                </a:lnTo>
                <a:lnTo>
                  <a:pt x="2145" y="597"/>
                </a:lnTo>
                <a:lnTo>
                  <a:pt x="2153" y="595"/>
                </a:lnTo>
                <a:lnTo>
                  <a:pt x="2159" y="595"/>
                </a:lnTo>
                <a:lnTo>
                  <a:pt x="2166" y="595"/>
                </a:lnTo>
                <a:lnTo>
                  <a:pt x="2174" y="593"/>
                </a:lnTo>
                <a:lnTo>
                  <a:pt x="2180" y="593"/>
                </a:lnTo>
                <a:lnTo>
                  <a:pt x="2187" y="593"/>
                </a:lnTo>
                <a:lnTo>
                  <a:pt x="2193" y="595"/>
                </a:lnTo>
                <a:lnTo>
                  <a:pt x="2201" y="593"/>
                </a:lnTo>
                <a:lnTo>
                  <a:pt x="2208" y="593"/>
                </a:lnTo>
                <a:lnTo>
                  <a:pt x="2214" y="593"/>
                </a:lnTo>
                <a:lnTo>
                  <a:pt x="2222" y="593"/>
                </a:lnTo>
                <a:lnTo>
                  <a:pt x="2228" y="593"/>
                </a:lnTo>
                <a:lnTo>
                  <a:pt x="2235" y="593"/>
                </a:lnTo>
                <a:lnTo>
                  <a:pt x="2241" y="593"/>
                </a:lnTo>
                <a:lnTo>
                  <a:pt x="2249" y="593"/>
                </a:lnTo>
                <a:lnTo>
                  <a:pt x="2256" y="593"/>
                </a:lnTo>
                <a:lnTo>
                  <a:pt x="2262" y="593"/>
                </a:lnTo>
                <a:lnTo>
                  <a:pt x="2270" y="593"/>
                </a:lnTo>
                <a:lnTo>
                  <a:pt x="2276" y="593"/>
                </a:lnTo>
                <a:lnTo>
                  <a:pt x="2283" y="593"/>
                </a:lnTo>
                <a:lnTo>
                  <a:pt x="2291" y="593"/>
                </a:lnTo>
                <a:lnTo>
                  <a:pt x="2297" y="591"/>
                </a:lnTo>
                <a:lnTo>
                  <a:pt x="2304" y="591"/>
                </a:lnTo>
                <a:lnTo>
                  <a:pt x="2310" y="591"/>
                </a:lnTo>
                <a:lnTo>
                  <a:pt x="2318" y="591"/>
                </a:lnTo>
                <a:lnTo>
                  <a:pt x="2326" y="591"/>
                </a:lnTo>
                <a:lnTo>
                  <a:pt x="2331" y="591"/>
                </a:lnTo>
                <a:lnTo>
                  <a:pt x="2339" y="591"/>
                </a:lnTo>
                <a:lnTo>
                  <a:pt x="2345" y="591"/>
                </a:lnTo>
                <a:lnTo>
                  <a:pt x="2352" y="589"/>
                </a:lnTo>
                <a:lnTo>
                  <a:pt x="2358" y="589"/>
                </a:lnTo>
                <a:lnTo>
                  <a:pt x="2366" y="589"/>
                </a:lnTo>
                <a:lnTo>
                  <a:pt x="2374" y="589"/>
                </a:lnTo>
                <a:lnTo>
                  <a:pt x="2379" y="589"/>
                </a:lnTo>
                <a:lnTo>
                  <a:pt x="2387" y="589"/>
                </a:lnTo>
                <a:lnTo>
                  <a:pt x="2393" y="589"/>
                </a:lnTo>
                <a:lnTo>
                  <a:pt x="2400" y="589"/>
                </a:lnTo>
                <a:lnTo>
                  <a:pt x="2408" y="589"/>
                </a:lnTo>
                <a:lnTo>
                  <a:pt x="2414" y="587"/>
                </a:lnTo>
                <a:lnTo>
                  <a:pt x="2422" y="587"/>
                </a:lnTo>
                <a:lnTo>
                  <a:pt x="2427" y="587"/>
                </a:lnTo>
                <a:lnTo>
                  <a:pt x="2435" y="587"/>
                </a:lnTo>
                <a:lnTo>
                  <a:pt x="2443" y="587"/>
                </a:lnTo>
                <a:lnTo>
                  <a:pt x="2448" y="587"/>
                </a:lnTo>
                <a:lnTo>
                  <a:pt x="2456" y="587"/>
                </a:lnTo>
                <a:lnTo>
                  <a:pt x="2462" y="585"/>
                </a:lnTo>
                <a:lnTo>
                  <a:pt x="2470" y="585"/>
                </a:lnTo>
                <a:lnTo>
                  <a:pt x="2477" y="585"/>
                </a:lnTo>
                <a:lnTo>
                  <a:pt x="2483" y="585"/>
                </a:lnTo>
                <a:lnTo>
                  <a:pt x="2491" y="585"/>
                </a:lnTo>
                <a:lnTo>
                  <a:pt x="2496" y="585"/>
                </a:lnTo>
                <a:lnTo>
                  <a:pt x="2504" y="585"/>
                </a:lnTo>
                <a:lnTo>
                  <a:pt x="2510" y="585"/>
                </a:lnTo>
                <a:lnTo>
                  <a:pt x="2518" y="585"/>
                </a:lnTo>
                <a:lnTo>
                  <a:pt x="2525" y="584"/>
                </a:lnTo>
                <a:lnTo>
                  <a:pt x="2531" y="584"/>
                </a:lnTo>
                <a:lnTo>
                  <a:pt x="2539" y="584"/>
                </a:lnTo>
                <a:lnTo>
                  <a:pt x="2544" y="584"/>
                </a:lnTo>
                <a:lnTo>
                  <a:pt x="2552" y="584"/>
                </a:lnTo>
                <a:lnTo>
                  <a:pt x="2560" y="584"/>
                </a:lnTo>
                <a:lnTo>
                  <a:pt x="2566" y="584"/>
                </a:lnTo>
                <a:lnTo>
                  <a:pt x="2573" y="584"/>
                </a:lnTo>
                <a:lnTo>
                  <a:pt x="2579" y="584"/>
                </a:lnTo>
                <a:lnTo>
                  <a:pt x="2587" y="582"/>
                </a:lnTo>
                <a:lnTo>
                  <a:pt x="2594" y="584"/>
                </a:lnTo>
                <a:lnTo>
                  <a:pt x="2600" y="584"/>
                </a:lnTo>
                <a:lnTo>
                  <a:pt x="2608" y="584"/>
                </a:lnTo>
                <a:lnTo>
                  <a:pt x="2614" y="582"/>
                </a:lnTo>
                <a:lnTo>
                  <a:pt x="2621" y="582"/>
                </a:lnTo>
                <a:lnTo>
                  <a:pt x="2627" y="582"/>
                </a:lnTo>
                <a:lnTo>
                  <a:pt x="2635" y="582"/>
                </a:lnTo>
                <a:lnTo>
                  <a:pt x="2642" y="582"/>
                </a:lnTo>
                <a:lnTo>
                  <a:pt x="2648" y="582"/>
                </a:lnTo>
                <a:lnTo>
                  <a:pt x="2656" y="582"/>
                </a:lnTo>
                <a:lnTo>
                  <a:pt x="2662" y="582"/>
                </a:lnTo>
                <a:lnTo>
                  <a:pt x="2669" y="582"/>
                </a:lnTo>
                <a:lnTo>
                  <a:pt x="2677" y="582"/>
                </a:lnTo>
                <a:lnTo>
                  <a:pt x="2683" y="582"/>
                </a:lnTo>
                <a:lnTo>
                  <a:pt x="2690" y="582"/>
                </a:lnTo>
                <a:lnTo>
                  <a:pt x="2696" y="582"/>
                </a:lnTo>
                <a:lnTo>
                  <a:pt x="2704" y="582"/>
                </a:lnTo>
                <a:lnTo>
                  <a:pt x="2712" y="582"/>
                </a:lnTo>
                <a:lnTo>
                  <a:pt x="2717" y="582"/>
                </a:lnTo>
                <a:lnTo>
                  <a:pt x="2725" y="582"/>
                </a:lnTo>
                <a:lnTo>
                  <a:pt x="2731" y="580"/>
                </a:lnTo>
                <a:lnTo>
                  <a:pt x="2738" y="580"/>
                </a:lnTo>
                <a:lnTo>
                  <a:pt x="2744" y="580"/>
                </a:lnTo>
                <a:lnTo>
                  <a:pt x="2752" y="580"/>
                </a:lnTo>
                <a:lnTo>
                  <a:pt x="2760" y="580"/>
                </a:lnTo>
                <a:lnTo>
                  <a:pt x="2765" y="580"/>
                </a:lnTo>
                <a:lnTo>
                  <a:pt x="2773" y="580"/>
                </a:lnTo>
                <a:lnTo>
                  <a:pt x="2779" y="580"/>
                </a:lnTo>
                <a:lnTo>
                  <a:pt x="2786" y="578"/>
                </a:lnTo>
                <a:lnTo>
                  <a:pt x="2794" y="578"/>
                </a:lnTo>
                <a:lnTo>
                  <a:pt x="2800" y="578"/>
                </a:lnTo>
                <a:lnTo>
                  <a:pt x="2808" y="578"/>
                </a:lnTo>
                <a:lnTo>
                  <a:pt x="2813" y="578"/>
                </a:lnTo>
                <a:lnTo>
                  <a:pt x="2821" y="578"/>
                </a:lnTo>
                <a:lnTo>
                  <a:pt x="2829" y="576"/>
                </a:lnTo>
                <a:lnTo>
                  <a:pt x="2834" y="576"/>
                </a:lnTo>
                <a:lnTo>
                  <a:pt x="2842" y="576"/>
                </a:lnTo>
                <a:lnTo>
                  <a:pt x="2848" y="576"/>
                </a:lnTo>
                <a:lnTo>
                  <a:pt x="2856" y="576"/>
                </a:lnTo>
                <a:lnTo>
                  <a:pt x="2863" y="576"/>
                </a:lnTo>
                <a:lnTo>
                  <a:pt x="2869" y="576"/>
                </a:lnTo>
                <a:lnTo>
                  <a:pt x="2877" y="576"/>
                </a:lnTo>
                <a:lnTo>
                  <a:pt x="2882" y="576"/>
                </a:lnTo>
                <a:lnTo>
                  <a:pt x="2890" y="576"/>
                </a:lnTo>
                <a:lnTo>
                  <a:pt x="2896" y="576"/>
                </a:lnTo>
                <a:lnTo>
                  <a:pt x="2904" y="576"/>
                </a:lnTo>
                <a:lnTo>
                  <a:pt x="2911" y="576"/>
                </a:lnTo>
                <a:lnTo>
                  <a:pt x="2917" y="576"/>
                </a:lnTo>
                <a:lnTo>
                  <a:pt x="2925" y="576"/>
                </a:lnTo>
                <a:lnTo>
                  <a:pt x="2930" y="576"/>
                </a:lnTo>
                <a:lnTo>
                  <a:pt x="2938" y="576"/>
                </a:lnTo>
                <a:lnTo>
                  <a:pt x="2946" y="574"/>
                </a:lnTo>
                <a:lnTo>
                  <a:pt x="2952" y="574"/>
                </a:lnTo>
                <a:lnTo>
                  <a:pt x="2959" y="574"/>
                </a:lnTo>
                <a:lnTo>
                  <a:pt x="2965" y="574"/>
                </a:lnTo>
                <a:lnTo>
                  <a:pt x="2973" y="574"/>
                </a:lnTo>
                <a:lnTo>
                  <a:pt x="2980" y="574"/>
                </a:lnTo>
                <a:lnTo>
                  <a:pt x="2986" y="574"/>
                </a:lnTo>
                <a:lnTo>
                  <a:pt x="2994" y="574"/>
                </a:lnTo>
                <a:lnTo>
                  <a:pt x="3000" y="574"/>
                </a:lnTo>
                <a:lnTo>
                  <a:pt x="3007" y="574"/>
                </a:lnTo>
                <a:lnTo>
                  <a:pt x="3013" y="574"/>
                </a:lnTo>
                <a:lnTo>
                  <a:pt x="3021" y="572"/>
                </a:lnTo>
                <a:lnTo>
                  <a:pt x="3028" y="572"/>
                </a:lnTo>
                <a:lnTo>
                  <a:pt x="3034" y="572"/>
                </a:lnTo>
                <a:lnTo>
                  <a:pt x="3042" y="572"/>
                </a:lnTo>
                <a:lnTo>
                  <a:pt x="3048" y="572"/>
                </a:lnTo>
                <a:lnTo>
                  <a:pt x="3055" y="572"/>
                </a:lnTo>
                <a:lnTo>
                  <a:pt x="3063" y="572"/>
                </a:lnTo>
                <a:lnTo>
                  <a:pt x="3069" y="572"/>
                </a:lnTo>
                <a:lnTo>
                  <a:pt x="3076" y="572"/>
                </a:lnTo>
                <a:lnTo>
                  <a:pt x="3082" y="570"/>
                </a:lnTo>
                <a:lnTo>
                  <a:pt x="3090" y="570"/>
                </a:lnTo>
                <a:lnTo>
                  <a:pt x="3097" y="570"/>
                </a:lnTo>
                <a:lnTo>
                  <a:pt x="3103" y="570"/>
                </a:lnTo>
                <a:lnTo>
                  <a:pt x="3111" y="570"/>
                </a:lnTo>
                <a:lnTo>
                  <a:pt x="3117" y="570"/>
                </a:lnTo>
                <a:lnTo>
                  <a:pt x="3124" y="570"/>
                </a:lnTo>
                <a:lnTo>
                  <a:pt x="3132" y="568"/>
                </a:lnTo>
                <a:lnTo>
                  <a:pt x="3138" y="568"/>
                </a:lnTo>
                <a:lnTo>
                  <a:pt x="3145" y="568"/>
                </a:lnTo>
                <a:lnTo>
                  <a:pt x="3151" y="568"/>
                </a:lnTo>
                <a:lnTo>
                  <a:pt x="3159" y="568"/>
                </a:lnTo>
                <a:lnTo>
                  <a:pt x="3165" y="566"/>
                </a:lnTo>
                <a:lnTo>
                  <a:pt x="3172" y="566"/>
                </a:lnTo>
                <a:lnTo>
                  <a:pt x="3180" y="566"/>
                </a:lnTo>
                <a:lnTo>
                  <a:pt x="3186" y="564"/>
                </a:lnTo>
                <a:lnTo>
                  <a:pt x="3193" y="564"/>
                </a:lnTo>
                <a:lnTo>
                  <a:pt x="3199" y="562"/>
                </a:lnTo>
                <a:lnTo>
                  <a:pt x="3207" y="561"/>
                </a:lnTo>
                <a:lnTo>
                  <a:pt x="3215" y="561"/>
                </a:lnTo>
                <a:lnTo>
                  <a:pt x="3220" y="561"/>
                </a:lnTo>
                <a:lnTo>
                  <a:pt x="3228" y="561"/>
                </a:lnTo>
                <a:lnTo>
                  <a:pt x="3234" y="561"/>
                </a:lnTo>
                <a:lnTo>
                  <a:pt x="3241" y="561"/>
                </a:lnTo>
                <a:lnTo>
                  <a:pt x="3249" y="561"/>
                </a:lnTo>
                <a:lnTo>
                  <a:pt x="3255" y="561"/>
                </a:lnTo>
                <a:lnTo>
                  <a:pt x="3263" y="562"/>
                </a:lnTo>
                <a:lnTo>
                  <a:pt x="3268" y="562"/>
                </a:lnTo>
                <a:lnTo>
                  <a:pt x="3276" y="562"/>
                </a:lnTo>
                <a:lnTo>
                  <a:pt x="3282" y="562"/>
                </a:lnTo>
                <a:lnTo>
                  <a:pt x="3289" y="562"/>
                </a:lnTo>
                <a:lnTo>
                  <a:pt x="3297" y="561"/>
                </a:lnTo>
                <a:lnTo>
                  <a:pt x="3303" y="561"/>
                </a:lnTo>
                <a:lnTo>
                  <a:pt x="3311" y="561"/>
                </a:lnTo>
                <a:lnTo>
                  <a:pt x="3316" y="561"/>
                </a:lnTo>
                <a:lnTo>
                  <a:pt x="3324" y="561"/>
                </a:lnTo>
                <a:lnTo>
                  <a:pt x="3332" y="561"/>
                </a:lnTo>
                <a:lnTo>
                  <a:pt x="3337" y="561"/>
                </a:lnTo>
                <a:lnTo>
                  <a:pt x="3345" y="561"/>
                </a:lnTo>
                <a:lnTo>
                  <a:pt x="3351" y="561"/>
                </a:lnTo>
                <a:lnTo>
                  <a:pt x="3359" y="559"/>
                </a:lnTo>
                <a:lnTo>
                  <a:pt x="3366" y="559"/>
                </a:lnTo>
                <a:lnTo>
                  <a:pt x="3372" y="559"/>
                </a:lnTo>
                <a:lnTo>
                  <a:pt x="3380" y="559"/>
                </a:lnTo>
                <a:lnTo>
                  <a:pt x="3385" y="559"/>
                </a:lnTo>
                <a:lnTo>
                  <a:pt x="3393" y="557"/>
                </a:lnTo>
                <a:lnTo>
                  <a:pt x="3399" y="557"/>
                </a:lnTo>
                <a:lnTo>
                  <a:pt x="3407" y="557"/>
                </a:lnTo>
                <a:lnTo>
                  <a:pt x="3414" y="557"/>
                </a:lnTo>
                <a:lnTo>
                  <a:pt x="3420" y="555"/>
                </a:lnTo>
                <a:lnTo>
                  <a:pt x="3428" y="555"/>
                </a:lnTo>
                <a:lnTo>
                  <a:pt x="3433" y="555"/>
                </a:lnTo>
                <a:lnTo>
                  <a:pt x="3441" y="555"/>
                </a:lnTo>
                <a:lnTo>
                  <a:pt x="3449" y="555"/>
                </a:lnTo>
                <a:lnTo>
                  <a:pt x="3455" y="555"/>
                </a:lnTo>
                <a:lnTo>
                  <a:pt x="3462" y="555"/>
                </a:lnTo>
                <a:lnTo>
                  <a:pt x="3468" y="555"/>
                </a:lnTo>
                <a:lnTo>
                  <a:pt x="3476" y="555"/>
                </a:lnTo>
                <a:lnTo>
                  <a:pt x="3483" y="555"/>
                </a:lnTo>
                <a:lnTo>
                  <a:pt x="3489" y="555"/>
                </a:lnTo>
                <a:lnTo>
                  <a:pt x="3497" y="555"/>
                </a:lnTo>
                <a:lnTo>
                  <a:pt x="3503" y="555"/>
                </a:lnTo>
                <a:lnTo>
                  <a:pt x="3510" y="555"/>
                </a:lnTo>
                <a:lnTo>
                  <a:pt x="3518" y="555"/>
                </a:lnTo>
                <a:lnTo>
                  <a:pt x="3524" y="555"/>
                </a:lnTo>
                <a:lnTo>
                  <a:pt x="3531" y="553"/>
                </a:lnTo>
                <a:lnTo>
                  <a:pt x="3537" y="553"/>
                </a:lnTo>
                <a:lnTo>
                  <a:pt x="3545" y="553"/>
                </a:lnTo>
                <a:lnTo>
                  <a:pt x="3551" y="553"/>
                </a:lnTo>
                <a:lnTo>
                  <a:pt x="3558" y="553"/>
                </a:lnTo>
                <a:lnTo>
                  <a:pt x="3566" y="551"/>
                </a:lnTo>
                <a:lnTo>
                  <a:pt x="3572" y="551"/>
                </a:lnTo>
                <a:lnTo>
                  <a:pt x="3579" y="551"/>
                </a:lnTo>
                <a:lnTo>
                  <a:pt x="3585" y="551"/>
                </a:lnTo>
                <a:lnTo>
                  <a:pt x="3593" y="549"/>
                </a:lnTo>
                <a:lnTo>
                  <a:pt x="3601" y="549"/>
                </a:lnTo>
                <a:lnTo>
                  <a:pt x="3606" y="549"/>
                </a:lnTo>
                <a:lnTo>
                  <a:pt x="3614" y="549"/>
                </a:lnTo>
                <a:lnTo>
                  <a:pt x="3620" y="547"/>
                </a:lnTo>
                <a:lnTo>
                  <a:pt x="3627" y="547"/>
                </a:lnTo>
                <a:lnTo>
                  <a:pt x="3635" y="547"/>
                </a:lnTo>
                <a:lnTo>
                  <a:pt x="3641" y="545"/>
                </a:lnTo>
                <a:lnTo>
                  <a:pt x="3649" y="545"/>
                </a:lnTo>
                <a:lnTo>
                  <a:pt x="3654" y="543"/>
                </a:lnTo>
                <a:lnTo>
                  <a:pt x="3662" y="543"/>
                </a:lnTo>
                <a:lnTo>
                  <a:pt x="3668" y="541"/>
                </a:lnTo>
                <a:lnTo>
                  <a:pt x="3675" y="541"/>
                </a:lnTo>
                <a:lnTo>
                  <a:pt x="3683" y="541"/>
                </a:lnTo>
                <a:lnTo>
                  <a:pt x="3689" y="541"/>
                </a:lnTo>
                <a:lnTo>
                  <a:pt x="3697" y="541"/>
                </a:lnTo>
                <a:lnTo>
                  <a:pt x="3702" y="541"/>
                </a:lnTo>
                <a:lnTo>
                  <a:pt x="3710" y="541"/>
                </a:lnTo>
                <a:lnTo>
                  <a:pt x="3718" y="541"/>
                </a:lnTo>
                <a:lnTo>
                  <a:pt x="3723" y="541"/>
                </a:lnTo>
                <a:lnTo>
                  <a:pt x="3731" y="541"/>
                </a:lnTo>
                <a:lnTo>
                  <a:pt x="3737" y="541"/>
                </a:lnTo>
                <a:lnTo>
                  <a:pt x="3745" y="541"/>
                </a:lnTo>
                <a:lnTo>
                  <a:pt x="3752" y="541"/>
                </a:lnTo>
                <a:lnTo>
                  <a:pt x="3758" y="541"/>
                </a:lnTo>
                <a:lnTo>
                  <a:pt x="3766" y="541"/>
                </a:lnTo>
                <a:lnTo>
                  <a:pt x="3771" y="541"/>
                </a:lnTo>
                <a:lnTo>
                  <a:pt x="3779" y="541"/>
                </a:lnTo>
                <a:lnTo>
                  <a:pt x="3785" y="541"/>
                </a:lnTo>
                <a:lnTo>
                  <a:pt x="3793" y="541"/>
                </a:lnTo>
                <a:lnTo>
                  <a:pt x="3800" y="539"/>
                </a:lnTo>
                <a:lnTo>
                  <a:pt x="3806" y="539"/>
                </a:lnTo>
                <a:lnTo>
                  <a:pt x="3814" y="539"/>
                </a:lnTo>
                <a:lnTo>
                  <a:pt x="3819" y="539"/>
                </a:lnTo>
                <a:lnTo>
                  <a:pt x="3827" y="539"/>
                </a:lnTo>
                <a:lnTo>
                  <a:pt x="3835" y="539"/>
                </a:lnTo>
                <a:lnTo>
                  <a:pt x="3841" y="539"/>
                </a:lnTo>
                <a:lnTo>
                  <a:pt x="3848" y="539"/>
                </a:lnTo>
                <a:lnTo>
                  <a:pt x="3854" y="539"/>
                </a:lnTo>
                <a:lnTo>
                  <a:pt x="3862" y="538"/>
                </a:lnTo>
                <a:lnTo>
                  <a:pt x="3869" y="538"/>
                </a:lnTo>
                <a:lnTo>
                  <a:pt x="3875" y="538"/>
                </a:lnTo>
                <a:lnTo>
                  <a:pt x="3883" y="538"/>
                </a:lnTo>
                <a:lnTo>
                  <a:pt x="3889" y="538"/>
                </a:lnTo>
                <a:lnTo>
                  <a:pt x="3896" y="536"/>
                </a:lnTo>
                <a:lnTo>
                  <a:pt x="3904" y="536"/>
                </a:lnTo>
                <a:lnTo>
                  <a:pt x="3910" y="536"/>
                </a:lnTo>
                <a:lnTo>
                  <a:pt x="3917" y="536"/>
                </a:lnTo>
                <a:lnTo>
                  <a:pt x="3923" y="536"/>
                </a:lnTo>
                <a:lnTo>
                  <a:pt x="3931" y="536"/>
                </a:lnTo>
                <a:lnTo>
                  <a:pt x="3937" y="536"/>
                </a:lnTo>
                <a:lnTo>
                  <a:pt x="3944" y="536"/>
                </a:lnTo>
                <a:lnTo>
                  <a:pt x="3952" y="534"/>
                </a:lnTo>
                <a:lnTo>
                  <a:pt x="3958" y="534"/>
                </a:lnTo>
                <a:lnTo>
                  <a:pt x="3965" y="534"/>
                </a:lnTo>
                <a:lnTo>
                  <a:pt x="3971" y="534"/>
                </a:lnTo>
                <a:lnTo>
                  <a:pt x="3979" y="534"/>
                </a:lnTo>
                <a:lnTo>
                  <a:pt x="3986" y="534"/>
                </a:lnTo>
                <a:lnTo>
                  <a:pt x="3992" y="534"/>
                </a:lnTo>
                <a:lnTo>
                  <a:pt x="4000" y="532"/>
                </a:lnTo>
                <a:lnTo>
                  <a:pt x="4006" y="532"/>
                </a:lnTo>
                <a:lnTo>
                  <a:pt x="4013" y="532"/>
                </a:lnTo>
                <a:lnTo>
                  <a:pt x="4021" y="532"/>
                </a:lnTo>
                <a:lnTo>
                  <a:pt x="4027" y="530"/>
                </a:lnTo>
                <a:lnTo>
                  <a:pt x="4034" y="530"/>
                </a:lnTo>
                <a:lnTo>
                  <a:pt x="4040" y="530"/>
                </a:lnTo>
                <a:lnTo>
                  <a:pt x="4048" y="530"/>
                </a:lnTo>
                <a:lnTo>
                  <a:pt x="4054" y="528"/>
                </a:lnTo>
                <a:lnTo>
                  <a:pt x="4061" y="528"/>
                </a:lnTo>
                <a:lnTo>
                  <a:pt x="4069" y="528"/>
                </a:lnTo>
                <a:lnTo>
                  <a:pt x="4075" y="528"/>
                </a:lnTo>
                <a:lnTo>
                  <a:pt x="4082" y="526"/>
                </a:lnTo>
                <a:lnTo>
                  <a:pt x="4088" y="526"/>
                </a:lnTo>
                <a:lnTo>
                  <a:pt x="4096" y="526"/>
                </a:lnTo>
                <a:lnTo>
                  <a:pt x="4104" y="526"/>
                </a:lnTo>
                <a:lnTo>
                  <a:pt x="4109" y="526"/>
                </a:lnTo>
                <a:lnTo>
                  <a:pt x="4117" y="526"/>
                </a:lnTo>
                <a:lnTo>
                  <a:pt x="4123" y="526"/>
                </a:lnTo>
                <a:lnTo>
                  <a:pt x="4130" y="524"/>
                </a:lnTo>
                <a:lnTo>
                  <a:pt x="4138" y="524"/>
                </a:lnTo>
                <a:lnTo>
                  <a:pt x="4144" y="524"/>
                </a:lnTo>
                <a:lnTo>
                  <a:pt x="4152" y="524"/>
                </a:lnTo>
                <a:lnTo>
                  <a:pt x="4157" y="524"/>
                </a:lnTo>
                <a:lnTo>
                  <a:pt x="4165" y="522"/>
                </a:lnTo>
                <a:lnTo>
                  <a:pt x="4173" y="522"/>
                </a:lnTo>
                <a:lnTo>
                  <a:pt x="4178" y="522"/>
                </a:lnTo>
                <a:lnTo>
                  <a:pt x="4186" y="522"/>
                </a:lnTo>
                <a:lnTo>
                  <a:pt x="4192" y="522"/>
                </a:lnTo>
                <a:lnTo>
                  <a:pt x="4200" y="520"/>
                </a:lnTo>
                <a:lnTo>
                  <a:pt x="4205" y="520"/>
                </a:lnTo>
                <a:lnTo>
                  <a:pt x="4213" y="520"/>
                </a:lnTo>
                <a:lnTo>
                  <a:pt x="4221" y="520"/>
                </a:lnTo>
                <a:lnTo>
                  <a:pt x="4226" y="520"/>
                </a:lnTo>
                <a:lnTo>
                  <a:pt x="4234" y="520"/>
                </a:lnTo>
                <a:lnTo>
                  <a:pt x="4240" y="520"/>
                </a:lnTo>
                <a:lnTo>
                  <a:pt x="4248" y="520"/>
                </a:lnTo>
                <a:lnTo>
                  <a:pt x="4255" y="520"/>
                </a:lnTo>
                <a:lnTo>
                  <a:pt x="4261" y="518"/>
                </a:lnTo>
                <a:lnTo>
                  <a:pt x="4269" y="518"/>
                </a:lnTo>
                <a:lnTo>
                  <a:pt x="4275" y="518"/>
                </a:lnTo>
                <a:lnTo>
                  <a:pt x="4282" y="518"/>
                </a:lnTo>
                <a:lnTo>
                  <a:pt x="4290" y="518"/>
                </a:lnTo>
                <a:lnTo>
                  <a:pt x="4296" y="520"/>
                </a:lnTo>
                <a:lnTo>
                  <a:pt x="4303" y="520"/>
                </a:lnTo>
                <a:lnTo>
                  <a:pt x="4309" y="518"/>
                </a:lnTo>
                <a:lnTo>
                  <a:pt x="4317" y="520"/>
                </a:lnTo>
                <a:lnTo>
                  <a:pt x="4323" y="520"/>
                </a:lnTo>
                <a:lnTo>
                  <a:pt x="4330" y="520"/>
                </a:lnTo>
                <a:lnTo>
                  <a:pt x="4338" y="518"/>
                </a:lnTo>
                <a:lnTo>
                  <a:pt x="4344" y="518"/>
                </a:lnTo>
                <a:lnTo>
                  <a:pt x="4351" y="518"/>
                </a:lnTo>
                <a:lnTo>
                  <a:pt x="4357" y="518"/>
                </a:lnTo>
                <a:lnTo>
                  <a:pt x="4365" y="518"/>
                </a:lnTo>
                <a:lnTo>
                  <a:pt x="4372" y="518"/>
                </a:lnTo>
                <a:lnTo>
                  <a:pt x="4378" y="518"/>
                </a:lnTo>
                <a:lnTo>
                  <a:pt x="4386" y="518"/>
                </a:lnTo>
                <a:lnTo>
                  <a:pt x="4392" y="516"/>
                </a:lnTo>
                <a:lnTo>
                  <a:pt x="4399" y="516"/>
                </a:lnTo>
                <a:lnTo>
                  <a:pt x="4407" y="516"/>
                </a:lnTo>
                <a:lnTo>
                  <a:pt x="4413" y="516"/>
                </a:lnTo>
                <a:lnTo>
                  <a:pt x="4420" y="514"/>
                </a:lnTo>
                <a:lnTo>
                  <a:pt x="4426" y="514"/>
                </a:lnTo>
                <a:lnTo>
                  <a:pt x="4434" y="514"/>
                </a:lnTo>
                <a:lnTo>
                  <a:pt x="4440" y="514"/>
                </a:lnTo>
                <a:lnTo>
                  <a:pt x="4447" y="514"/>
                </a:lnTo>
                <a:lnTo>
                  <a:pt x="4455" y="514"/>
                </a:lnTo>
                <a:lnTo>
                  <a:pt x="4461" y="513"/>
                </a:lnTo>
                <a:lnTo>
                  <a:pt x="4468" y="513"/>
                </a:lnTo>
                <a:lnTo>
                  <a:pt x="4474" y="513"/>
                </a:lnTo>
                <a:lnTo>
                  <a:pt x="4482" y="513"/>
                </a:lnTo>
                <a:lnTo>
                  <a:pt x="4490" y="513"/>
                </a:lnTo>
                <a:lnTo>
                  <a:pt x="4495" y="513"/>
                </a:lnTo>
                <a:lnTo>
                  <a:pt x="4503" y="513"/>
                </a:lnTo>
                <a:lnTo>
                  <a:pt x="4509" y="511"/>
                </a:lnTo>
                <a:lnTo>
                  <a:pt x="4516" y="511"/>
                </a:lnTo>
                <a:lnTo>
                  <a:pt x="4524" y="511"/>
                </a:lnTo>
                <a:lnTo>
                  <a:pt x="4530" y="511"/>
                </a:lnTo>
                <a:lnTo>
                  <a:pt x="4538" y="511"/>
                </a:lnTo>
                <a:lnTo>
                  <a:pt x="4543" y="511"/>
                </a:lnTo>
                <a:lnTo>
                  <a:pt x="4551" y="509"/>
                </a:lnTo>
                <a:lnTo>
                  <a:pt x="4559" y="509"/>
                </a:lnTo>
                <a:lnTo>
                  <a:pt x="4564" y="507"/>
                </a:lnTo>
                <a:lnTo>
                  <a:pt x="4572" y="507"/>
                </a:lnTo>
                <a:lnTo>
                  <a:pt x="4578" y="507"/>
                </a:lnTo>
                <a:lnTo>
                  <a:pt x="4586" y="507"/>
                </a:lnTo>
                <a:lnTo>
                  <a:pt x="4591" y="507"/>
                </a:lnTo>
                <a:lnTo>
                  <a:pt x="4599" y="507"/>
                </a:lnTo>
                <a:lnTo>
                  <a:pt x="4607" y="507"/>
                </a:lnTo>
                <a:lnTo>
                  <a:pt x="4612" y="507"/>
                </a:lnTo>
                <a:lnTo>
                  <a:pt x="4620" y="507"/>
                </a:lnTo>
                <a:lnTo>
                  <a:pt x="4626" y="505"/>
                </a:lnTo>
                <a:lnTo>
                  <a:pt x="4634" y="505"/>
                </a:lnTo>
                <a:lnTo>
                  <a:pt x="4641" y="505"/>
                </a:lnTo>
                <a:lnTo>
                  <a:pt x="4647" y="505"/>
                </a:lnTo>
                <a:lnTo>
                  <a:pt x="4655" y="505"/>
                </a:lnTo>
                <a:lnTo>
                  <a:pt x="4660" y="505"/>
                </a:lnTo>
                <a:lnTo>
                  <a:pt x="4668" y="503"/>
                </a:lnTo>
                <a:lnTo>
                  <a:pt x="4676" y="503"/>
                </a:lnTo>
                <a:lnTo>
                  <a:pt x="4682" y="501"/>
                </a:lnTo>
                <a:lnTo>
                  <a:pt x="4689" y="499"/>
                </a:lnTo>
                <a:lnTo>
                  <a:pt x="4695" y="497"/>
                </a:lnTo>
                <a:lnTo>
                  <a:pt x="4703" y="493"/>
                </a:lnTo>
                <a:lnTo>
                  <a:pt x="4708" y="491"/>
                </a:lnTo>
                <a:lnTo>
                  <a:pt x="4716" y="490"/>
                </a:lnTo>
                <a:lnTo>
                  <a:pt x="4724" y="488"/>
                </a:lnTo>
                <a:lnTo>
                  <a:pt x="4730" y="488"/>
                </a:lnTo>
                <a:lnTo>
                  <a:pt x="4737" y="490"/>
                </a:lnTo>
                <a:lnTo>
                  <a:pt x="4743" y="490"/>
                </a:lnTo>
                <a:lnTo>
                  <a:pt x="4751" y="491"/>
                </a:lnTo>
                <a:lnTo>
                  <a:pt x="4758" y="493"/>
                </a:lnTo>
                <a:lnTo>
                  <a:pt x="4764" y="493"/>
                </a:lnTo>
                <a:lnTo>
                  <a:pt x="4772" y="495"/>
                </a:lnTo>
                <a:lnTo>
                  <a:pt x="4778" y="495"/>
                </a:lnTo>
                <a:lnTo>
                  <a:pt x="4785" y="495"/>
                </a:lnTo>
                <a:lnTo>
                  <a:pt x="4793" y="495"/>
                </a:lnTo>
                <a:lnTo>
                  <a:pt x="4799" y="495"/>
                </a:lnTo>
                <a:lnTo>
                  <a:pt x="4806" y="495"/>
                </a:lnTo>
                <a:lnTo>
                  <a:pt x="4812" y="495"/>
                </a:lnTo>
                <a:lnTo>
                  <a:pt x="4820" y="495"/>
                </a:lnTo>
                <a:lnTo>
                  <a:pt x="4827" y="495"/>
                </a:lnTo>
                <a:lnTo>
                  <a:pt x="4833" y="495"/>
                </a:lnTo>
                <a:lnTo>
                  <a:pt x="4841" y="493"/>
                </a:lnTo>
                <a:lnTo>
                  <a:pt x="4847" y="493"/>
                </a:lnTo>
                <a:lnTo>
                  <a:pt x="4854" y="493"/>
                </a:lnTo>
                <a:lnTo>
                  <a:pt x="4860" y="493"/>
                </a:lnTo>
                <a:lnTo>
                  <a:pt x="4868" y="493"/>
                </a:lnTo>
                <a:lnTo>
                  <a:pt x="4875" y="491"/>
                </a:lnTo>
                <a:lnTo>
                  <a:pt x="4881" y="491"/>
                </a:lnTo>
                <a:lnTo>
                  <a:pt x="4889" y="491"/>
                </a:lnTo>
                <a:lnTo>
                  <a:pt x="4895" y="491"/>
                </a:lnTo>
                <a:lnTo>
                  <a:pt x="4902" y="490"/>
                </a:lnTo>
                <a:lnTo>
                  <a:pt x="4910" y="490"/>
                </a:lnTo>
                <a:lnTo>
                  <a:pt x="4916" y="490"/>
                </a:lnTo>
                <a:lnTo>
                  <a:pt x="4924" y="488"/>
                </a:lnTo>
                <a:lnTo>
                  <a:pt x="4929" y="488"/>
                </a:lnTo>
                <a:lnTo>
                  <a:pt x="4937" y="488"/>
                </a:lnTo>
                <a:lnTo>
                  <a:pt x="4945" y="486"/>
                </a:lnTo>
                <a:lnTo>
                  <a:pt x="4950" y="486"/>
                </a:lnTo>
                <a:lnTo>
                  <a:pt x="4958" y="486"/>
                </a:lnTo>
                <a:lnTo>
                  <a:pt x="4964" y="486"/>
                </a:lnTo>
                <a:lnTo>
                  <a:pt x="4972" y="486"/>
                </a:lnTo>
                <a:lnTo>
                  <a:pt x="4977" y="484"/>
                </a:lnTo>
                <a:lnTo>
                  <a:pt x="4985" y="484"/>
                </a:lnTo>
                <a:lnTo>
                  <a:pt x="4993" y="484"/>
                </a:lnTo>
                <a:lnTo>
                  <a:pt x="4998" y="484"/>
                </a:lnTo>
                <a:lnTo>
                  <a:pt x="5006" y="482"/>
                </a:lnTo>
                <a:lnTo>
                  <a:pt x="5012" y="482"/>
                </a:lnTo>
                <a:lnTo>
                  <a:pt x="5020" y="482"/>
                </a:lnTo>
                <a:lnTo>
                  <a:pt x="5027" y="482"/>
                </a:lnTo>
                <a:lnTo>
                  <a:pt x="5033" y="480"/>
                </a:lnTo>
                <a:lnTo>
                  <a:pt x="5041" y="480"/>
                </a:lnTo>
                <a:lnTo>
                  <a:pt x="5046" y="480"/>
                </a:lnTo>
                <a:lnTo>
                  <a:pt x="5054" y="478"/>
                </a:lnTo>
                <a:lnTo>
                  <a:pt x="5062" y="478"/>
                </a:lnTo>
                <a:lnTo>
                  <a:pt x="5068" y="478"/>
                </a:lnTo>
                <a:lnTo>
                  <a:pt x="5075" y="478"/>
                </a:lnTo>
                <a:lnTo>
                  <a:pt x="5081" y="476"/>
                </a:lnTo>
                <a:lnTo>
                  <a:pt x="5089" y="476"/>
                </a:lnTo>
                <a:lnTo>
                  <a:pt x="5094" y="476"/>
                </a:lnTo>
                <a:lnTo>
                  <a:pt x="5102" y="474"/>
                </a:lnTo>
                <a:lnTo>
                  <a:pt x="5110" y="474"/>
                </a:lnTo>
                <a:lnTo>
                  <a:pt x="5116" y="474"/>
                </a:lnTo>
                <a:lnTo>
                  <a:pt x="5123" y="474"/>
                </a:lnTo>
                <a:lnTo>
                  <a:pt x="5129" y="472"/>
                </a:lnTo>
                <a:lnTo>
                  <a:pt x="5137" y="472"/>
                </a:lnTo>
                <a:lnTo>
                  <a:pt x="5144" y="472"/>
                </a:lnTo>
                <a:lnTo>
                  <a:pt x="5150" y="470"/>
                </a:lnTo>
                <a:lnTo>
                  <a:pt x="5158" y="470"/>
                </a:lnTo>
                <a:lnTo>
                  <a:pt x="5164" y="468"/>
                </a:lnTo>
                <a:lnTo>
                  <a:pt x="5171" y="468"/>
                </a:lnTo>
                <a:lnTo>
                  <a:pt x="5179" y="467"/>
                </a:lnTo>
                <a:lnTo>
                  <a:pt x="5185" y="467"/>
                </a:lnTo>
                <a:lnTo>
                  <a:pt x="5192" y="467"/>
                </a:lnTo>
                <a:lnTo>
                  <a:pt x="5198" y="465"/>
                </a:lnTo>
                <a:lnTo>
                  <a:pt x="5206" y="465"/>
                </a:lnTo>
                <a:lnTo>
                  <a:pt x="5213" y="465"/>
                </a:lnTo>
                <a:lnTo>
                  <a:pt x="5219" y="465"/>
                </a:lnTo>
                <a:lnTo>
                  <a:pt x="5227" y="465"/>
                </a:lnTo>
                <a:lnTo>
                  <a:pt x="5233" y="463"/>
                </a:lnTo>
                <a:lnTo>
                  <a:pt x="5240" y="463"/>
                </a:lnTo>
                <a:lnTo>
                  <a:pt x="5246" y="463"/>
                </a:lnTo>
                <a:lnTo>
                  <a:pt x="5254" y="463"/>
                </a:lnTo>
                <a:lnTo>
                  <a:pt x="5261" y="461"/>
                </a:lnTo>
                <a:lnTo>
                  <a:pt x="5267" y="461"/>
                </a:lnTo>
                <a:lnTo>
                  <a:pt x="5275" y="461"/>
                </a:lnTo>
                <a:lnTo>
                  <a:pt x="5281" y="459"/>
                </a:lnTo>
                <a:lnTo>
                  <a:pt x="5288" y="459"/>
                </a:lnTo>
                <a:lnTo>
                  <a:pt x="5296" y="457"/>
                </a:lnTo>
                <a:lnTo>
                  <a:pt x="5302" y="457"/>
                </a:lnTo>
                <a:lnTo>
                  <a:pt x="5309" y="457"/>
                </a:lnTo>
                <a:lnTo>
                  <a:pt x="5315" y="457"/>
                </a:lnTo>
                <a:lnTo>
                  <a:pt x="5323" y="455"/>
                </a:lnTo>
                <a:lnTo>
                  <a:pt x="5331" y="455"/>
                </a:lnTo>
                <a:lnTo>
                  <a:pt x="5336" y="455"/>
                </a:lnTo>
                <a:lnTo>
                  <a:pt x="5344" y="455"/>
                </a:lnTo>
                <a:lnTo>
                  <a:pt x="5350" y="453"/>
                </a:lnTo>
                <a:lnTo>
                  <a:pt x="5357" y="453"/>
                </a:lnTo>
                <a:lnTo>
                  <a:pt x="5363" y="453"/>
                </a:lnTo>
                <a:lnTo>
                  <a:pt x="5371" y="453"/>
                </a:lnTo>
                <a:lnTo>
                  <a:pt x="5379" y="451"/>
                </a:lnTo>
                <a:lnTo>
                  <a:pt x="5384" y="451"/>
                </a:lnTo>
                <a:lnTo>
                  <a:pt x="5392" y="451"/>
                </a:lnTo>
                <a:lnTo>
                  <a:pt x="5398" y="451"/>
                </a:lnTo>
                <a:lnTo>
                  <a:pt x="5405" y="449"/>
                </a:lnTo>
                <a:lnTo>
                  <a:pt x="5413" y="449"/>
                </a:lnTo>
                <a:lnTo>
                  <a:pt x="5419" y="449"/>
                </a:lnTo>
                <a:lnTo>
                  <a:pt x="5427" y="449"/>
                </a:lnTo>
                <a:lnTo>
                  <a:pt x="5432" y="447"/>
                </a:lnTo>
                <a:lnTo>
                  <a:pt x="5440" y="447"/>
                </a:lnTo>
                <a:lnTo>
                  <a:pt x="5448" y="447"/>
                </a:lnTo>
                <a:lnTo>
                  <a:pt x="5453" y="447"/>
                </a:lnTo>
                <a:lnTo>
                  <a:pt x="5461" y="447"/>
                </a:lnTo>
                <a:lnTo>
                  <a:pt x="5467" y="445"/>
                </a:lnTo>
                <a:lnTo>
                  <a:pt x="5475" y="445"/>
                </a:lnTo>
                <a:lnTo>
                  <a:pt x="5480" y="445"/>
                </a:lnTo>
                <a:lnTo>
                  <a:pt x="5488" y="445"/>
                </a:lnTo>
                <a:lnTo>
                  <a:pt x="5496" y="443"/>
                </a:lnTo>
                <a:lnTo>
                  <a:pt x="5501" y="443"/>
                </a:lnTo>
                <a:lnTo>
                  <a:pt x="5509" y="443"/>
                </a:lnTo>
                <a:lnTo>
                  <a:pt x="5515" y="442"/>
                </a:lnTo>
                <a:lnTo>
                  <a:pt x="5523" y="442"/>
                </a:lnTo>
                <a:lnTo>
                  <a:pt x="5530" y="442"/>
                </a:lnTo>
                <a:lnTo>
                  <a:pt x="5536" y="442"/>
                </a:lnTo>
                <a:lnTo>
                  <a:pt x="5544" y="442"/>
                </a:lnTo>
                <a:lnTo>
                  <a:pt x="5549" y="442"/>
                </a:lnTo>
                <a:lnTo>
                  <a:pt x="5557" y="442"/>
                </a:lnTo>
                <a:lnTo>
                  <a:pt x="5565" y="442"/>
                </a:lnTo>
                <a:lnTo>
                  <a:pt x="5571" y="442"/>
                </a:lnTo>
                <a:lnTo>
                  <a:pt x="5578" y="440"/>
                </a:lnTo>
                <a:lnTo>
                  <a:pt x="5584" y="440"/>
                </a:lnTo>
                <a:lnTo>
                  <a:pt x="5592" y="440"/>
                </a:lnTo>
                <a:lnTo>
                  <a:pt x="5599" y="440"/>
                </a:lnTo>
                <a:lnTo>
                  <a:pt x="5605" y="440"/>
                </a:lnTo>
                <a:lnTo>
                  <a:pt x="5613" y="438"/>
                </a:lnTo>
                <a:lnTo>
                  <a:pt x="5619" y="438"/>
                </a:lnTo>
                <a:lnTo>
                  <a:pt x="5626" y="438"/>
                </a:lnTo>
                <a:lnTo>
                  <a:pt x="5632" y="438"/>
                </a:lnTo>
                <a:lnTo>
                  <a:pt x="5640" y="438"/>
                </a:lnTo>
                <a:lnTo>
                  <a:pt x="5647" y="436"/>
                </a:lnTo>
                <a:lnTo>
                  <a:pt x="5653" y="436"/>
                </a:lnTo>
                <a:lnTo>
                  <a:pt x="5661" y="436"/>
                </a:lnTo>
                <a:lnTo>
                  <a:pt x="5667" y="436"/>
                </a:lnTo>
                <a:lnTo>
                  <a:pt x="5674" y="434"/>
                </a:lnTo>
                <a:lnTo>
                  <a:pt x="5682" y="434"/>
                </a:lnTo>
                <a:lnTo>
                  <a:pt x="5688" y="432"/>
                </a:lnTo>
                <a:lnTo>
                  <a:pt x="5695" y="430"/>
                </a:lnTo>
                <a:lnTo>
                  <a:pt x="5701" y="430"/>
                </a:lnTo>
                <a:lnTo>
                  <a:pt x="5709" y="428"/>
                </a:lnTo>
                <a:lnTo>
                  <a:pt x="5717" y="426"/>
                </a:lnTo>
                <a:lnTo>
                  <a:pt x="5722" y="424"/>
                </a:lnTo>
                <a:lnTo>
                  <a:pt x="5730" y="422"/>
                </a:lnTo>
                <a:lnTo>
                  <a:pt x="5736" y="422"/>
                </a:lnTo>
                <a:lnTo>
                  <a:pt x="5743" y="420"/>
                </a:lnTo>
                <a:lnTo>
                  <a:pt x="5749" y="420"/>
                </a:lnTo>
                <a:lnTo>
                  <a:pt x="5757" y="419"/>
                </a:lnTo>
                <a:lnTo>
                  <a:pt x="5765" y="419"/>
                </a:lnTo>
                <a:lnTo>
                  <a:pt x="5770" y="419"/>
                </a:lnTo>
                <a:lnTo>
                  <a:pt x="5778" y="419"/>
                </a:lnTo>
                <a:lnTo>
                  <a:pt x="5784" y="417"/>
                </a:lnTo>
                <a:lnTo>
                  <a:pt x="5791" y="417"/>
                </a:lnTo>
                <a:lnTo>
                  <a:pt x="5799" y="417"/>
                </a:lnTo>
                <a:lnTo>
                  <a:pt x="5805" y="417"/>
                </a:lnTo>
                <a:lnTo>
                  <a:pt x="5813" y="417"/>
                </a:lnTo>
                <a:lnTo>
                  <a:pt x="5818" y="417"/>
                </a:lnTo>
                <a:lnTo>
                  <a:pt x="5826" y="417"/>
                </a:lnTo>
                <a:lnTo>
                  <a:pt x="5834" y="417"/>
                </a:lnTo>
                <a:lnTo>
                  <a:pt x="5839" y="417"/>
                </a:lnTo>
                <a:lnTo>
                  <a:pt x="5847" y="417"/>
                </a:lnTo>
                <a:lnTo>
                  <a:pt x="5853" y="419"/>
                </a:lnTo>
                <a:lnTo>
                  <a:pt x="5861" y="419"/>
                </a:lnTo>
                <a:lnTo>
                  <a:pt x="5868" y="419"/>
                </a:lnTo>
                <a:lnTo>
                  <a:pt x="5874" y="419"/>
                </a:lnTo>
                <a:lnTo>
                  <a:pt x="5882" y="419"/>
                </a:lnTo>
                <a:lnTo>
                  <a:pt x="5887" y="419"/>
                </a:lnTo>
                <a:lnTo>
                  <a:pt x="5895" y="419"/>
                </a:lnTo>
                <a:lnTo>
                  <a:pt x="5901" y="419"/>
                </a:lnTo>
                <a:lnTo>
                  <a:pt x="5909" y="419"/>
                </a:lnTo>
                <a:lnTo>
                  <a:pt x="5916" y="417"/>
                </a:lnTo>
                <a:lnTo>
                  <a:pt x="5922" y="417"/>
                </a:lnTo>
                <a:lnTo>
                  <a:pt x="5930" y="417"/>
                </a:lnTo>
                <a:lnTo>
                  <a:pt x="5935" y="417"/>
                </a:lnTo>
                <a:lnTo>
                  <a:pt x="5943" y="415"/>
                </a:lnTo>
                <a:lnTo>
                  <a:pt x="5951" y="413"/>
                </a:lnTo>
                <a:lnTo>
                  <a:pt x="5957" y="411"/>
                </a:lnTo>
                <a:lnTo>
                  <a:pt x="5964" y="405"/>
                </a:lnTo>
                <a:lnTo>
                  <a:pt x="5970" y="394"/>
                </a:lnTo>
                <a:lnTo>
                  <a:pt x="5978" y="374"/>
                </a:lnTo>
                <a:lnTo>
                  <a:pt x="5985" y="342"/>
                </a:lnTo>
                <a:lnTo>
                  <a:pt x="5991" y="298"/>
                </a:lnTo>
                <a:lnTo>
                  <a:pt x="5999" y="242"/>
                </a:lnTo>
                <a:lnTo>
                  <a:pt x="6005" y="179"/>
                </a:lnTo>
                <a:lnTo>
                  <a:pt x="6012" y="115"/>
                </a:lnTo>
                <a:lnTo>
                  <a:pt x="6018" y="64"/>
                </a:lnTo>
                <a:lnTo>
                  <a:pt x="6026" y="25"/>
                </a:lnTo>
                <a:lnTo>
                  <a:pt x="6033" y="4"/>
                </a:lnTo>
                <a:lnTo>
                  <a:pt x="6039" y="0"/>
                </a:lnTo>
                <a:lnTo>
                  <a:pt x="6047" y="10"/>
                </a:lnTo>
                <a:lnTo>
                  <a:pt x="6053" y="27"/>
                </a:lnTo>
                <a:lnTo>
                  <a:pt x="6060" y="48"/>
                </a:lnTo>
                <a:lnTo>
                  <a:pt x="6068" y="71"/>
                </a:lnTo>
                <a:lnTo>
                  <a:pt x="6074" y="94"/>
                </a:lnTo>
                <a:lnTo>
                  <a:pt x="6081" y="115"/>
                </a:lnTo>
                <a:lnTo>
                  <a:pt x="6087" y="135"/>
                </a:lnTo>
                <a:lnTo>
                  <a:pt x="6095" y="152"/>
                </a:lnTo>
                <a:lnTo>
                  <a:pt x="6102" y="169"/>
                </a:lnTo>
                <a:lnTo>
                  <a:pt x="6108" y="182"/>
                </a:lnTo>
                <a:lnTo>
                  <a:pt x="6116" y="196"/>
                </a:lnTo>
                <a:lnTo>
                  <a:pt x="6122" y="209"/>
                </a:lnTo>
                <a:lnTo>
                  <a:pt x="6129" y="221"/>
                </a:lnTo>
                <a:lnTo>
                  <a:pt x="6135" y="230"/>
                </a:lnTo>
                <a:lnTo>
                  <a:pt x="6143" y="238"/>
                </a:lnTo>
                <a:lnTo>
                  <a:pt x="6150" y="246"/>
                </a:lnTo>
                <a:lnTo>
                  <a:pt x="6156" y="253"/>
                </a:lnTo>
                <a:lnTo>
                  <a:pt x="6164" y="259"/>
                </a:lnTo>
                <a:lnTo>
                  <a:pt x="6170" y="265"/>
                </a:lnTo>
                <a:lnTo>
                  <a:pt x="6177" y="271"/>
                </a:lnTo>
                <a:lnTo>
                  <a:pt x="6185" y="275"/>
                </a:lnTo>
                <a:lnTo>
                  <a:pt x="6191" y="278"/>
                </a:lnTo>
                <a:lnTo>
                  <a:pt x="6198" y="282"/>
                </a:lnTo>
                <a:lnTo>
                  <a:pt x="6204" y="286"/>
                </a:lnTo>
                <a:lnTo>
                  <a:pt x="6212" y="288"/>
                </a:lnTo>
                <a:lnTo>
                  <a:pt x="6220" y="290"/>
                </a:lnTo>
                <a:lnTo>
                  <a:pt x="6225" y="292"/>
                </a:lnTo>
                <a:lnTo>
                  <a:pt x="6233" y="292"/>
                </a:lnTo>
                <a:lnTo>
                  <a:pt x="6239" y="292"/>
                </a:lnTo>
                <a:lnTo>
                  <a:pt x="6246" y="290"/>
                </a:lnTo>
                <a:lnTo>
                  <a:pt x="6254" y="288"/>
                </a:lnTo>
                <a:lnTo>
                  <a:pt x="6260" y="282"/>
                </a:lnTo>
                <a:lnTo>
                  <a:pt x="6268" y="277"/>
                </a:lnTo>
                <a:lnTo>
                  <a:pt x="6273" y="267"/>
                </a:lnTo>
                <a:lnTo>
                  <a:pt x="6281" y="255"/>
                </a:lnTo>
                <a:lnTo>
                  <a:pt x="6287" y="242"/>
                </a:lnTo>
                <a:lnTo>
                  <a:pt x="6294" y="229"/>
                </a:lnTo>
                <a:lnTo>
                  <a:pt x="6302" y="211"/>
                </a:lnTo>
                <a:lnTo>
                  <a:pt x="6308" y="196"/>
                </a:lnTo>
                <a:lnTo>
                  <a:pt x="6316" y="179"/>
                </a:lnTo>
                <a:lnTo>
                  <a:pt x="6321" y="163"/>
                </a:lnTo>
                <a:lnTo>
                  <a:pt x="6329" y="150"/>
                </a:lnTo>
                <a:lnTo>
                  <a:pt x="6337" y="138"/>
                </a:lnTo>
                <a:lnTo>
                  <a:pt x="6342" y="129"/>
                </a:lnTo>
                <a:lnTo>
                  <a:pt x="6350" y="121"/>
                </a:lnTo>
                <a:lnTo>
                  <a:pt x="6356" y="113"/>
                </a:lnTo>
                <a:lnTo>
                  <a:pt x="6364" y="110"/>
                </a:lnTo>
                <a:lnTo>
                  <a:pt x="6371" y="108"/>
                </a:lnTo>
                <a:lnTo>
                  <a:pt x="6377" y="106"/>
                </a:lnTo>
                <a:lnTo>
                  <a:pt x="6385" y="108"/>
                </a:lnTo>
                <a:lnTo>
                  <a:pt x="6390" y="110"/>
                </a:lnTo>
                <a:lnTo>
                  <a:pt x="6398" y="113"/>
                </a:lnTo>
                <a:lnTo>
                  <a:pt x="6404" y="117"/>
                </a:lnTo>
                <a:lnTo>
                  <a:pt x="6412" y="123"/>
                </a:lnTo>
                <a:lnTo>
                  <a:pt x="6419" y="131"/>
                </a:lnTo>
                <a:lnTo>
                  <a:pt x="6425" y="136"/>
                </a:lnTo>
                <a:lnTo>
                  <a:pt x="6433" y="144"/>
                </a:lnTo>
                <a:lnTo>
                  <a:pt x="6438" y="152"/>
                </a:lnTo>
                <a:lnTo>
                  <a:pt x="6446" y="159"/>
                </a:lnTo>
                <a:lnTo>
                  <a:pt x="6454" y="167"/>
                </a:lnTo>
                <a:lnTo>
                  <a:pt x="6460" y="175"/>
                </a:lnTo>
                <a:lnTo>
                  <a:pt x="6467" y="182"/>
                </a:lnTo>
                <a:lnTo>
                  <a:pt x="6473" y="190"/>
                </a:lnTo>
                <a:lnTo>
                  <a:pt x="6481" y="196"/>
                </a:lnTo>
                <a:lnTo>
                  <a:pt x="6488" y="202"/>
                </a:lnTo>
                <a:lnTo>
                  <a:pt x="6494" y="207"/>
                </a:lnTo>
                <a:lnTo>
                  <a:pt x="6502" y="213"/>
                </a:lnTo>
                <a:lnTo>
                  <a:pt x="6508" y="219"/>
                </a:lnTo>
                <a:lnTo>
                  <a:pt x="6515" y="223"/>
                </a:lnTo>
                <a:lnTo>
                  <a:pt x="6523" y="227"/>
                </a:lnTo>
                <a:lnTo>
                  <a:pt x="6529" y="232"/>
                </a:lnTo>
                <a:lnTo>
                  <a:pt x="6536" y="236"/>
                </a:lnTo>
                <a:lnTo>
                  <a:pt x="6542" y="240"/>
                </a:lnTo>
                <a:lnTo>
                  <a:pt x="6550" y="244"/>
                </a:lnTo>
                <a:lnTo>
                  <a:pt x="6556" y="246"/>
                </a:lnTo>
                <a:lnTo>
                  <a:pt x="6563" y="250"/>
                </a:lnTo>
                <a:lnTo>
                  <a:pt x="6571" y="253"/>
                </a:lnTo>
                <a:lnTo>
                  <a:pt x="6577" y="255"/>
                </a:lnTo>
                <a:lnTo>
                  <a:pt x="6584" y="259"/>
                </a:lnTo>
                <a:lnTo>
                  <a:pt x="6590" y="261"/>
                </a:lnTo>
                <a:lnTo>
                  <a:pt x="6598" y="265"/>
                </a:lnTo>
                <a:lnTo>
                  <a:pt x="6606" y="267"/>
                </a:lnTo>
                <a:lnTo>
                  <a:pt x="6611" y="269"/>
                </a:lnTo>
                <a:lnTo>
                  <a:pt x="6619" y="271"/>
                </a:lnTo>
                <a:lnTo>
                  <a:pt x="6625" y="275"/>
                </a:lnTo>
                <a:lnTo>
                  <a:pt x="6632" y="277"/>
                </a:lnTo>
                <a:lnTo>
                  <a:pt x="6640" y="278"/>
                </a:lnTo>
                <a:lnTo>
                  <a:pt x="6646" y="280"/>
                </a:lnTo>
                <a:lnTo>
                  <a:pt x="6654" y="282"/>
                </a:lnTo>
                <a:lnTo>
                  <a:pt x="6659" y="282"/>
                </a:lnTo>
                <a:lnTo>
                  <a:pt x="6667" y="284"/>
                </a:lnTo>
                <a:lnTo>
                  <a:pt x="6673" y="286"/>
                </a:lnTo>
                <a:lnTo>
                  <a:pt x="6680" y="288"/>
                </a:lnTo>
                <a:lnTo>
                  <a:pt x="6688" y="290"/>
                </a:lnTo>
                <a:lnTo>
                  <a:pt x="6694" y="292"/>
                </a:lnTo>
                <a:lnTo>
                  <a:pt x="6702" y="294"/>
                </a:lnTo>
                <a:lnTo>
                  <a:pt x="6707" y="294"/>
                </a:lnTo>
                <a:lnTo>
                  <a:pt x="6715" y="296"/>
                </a:lnTo>
                <a:lnTo>
                  <a:pt x="6723" y="298"/>
                </a:lnTo>
                <a:lnTo>
                  <a:pt x="6728" y="298"/>
                </a:lnTo>
                <a:lnTo>
                  <a:pt x="6736" y="300"/>
                </a:lnTo>
                <a:lnTo>
                  <a:pt x="6742" y="301"/>
                </a:lnTo>
                <a:lnTo>
                  <a:pt x="6750" y="301"/>
                </a:lnTo>
                <a:lnTo>
                  <a:pt x="6757" y="303"/>
                </a:lnTo>
                <a:lnTo>
                  <a:pt x="6763" y="303"/>
                </a:lnTo>
                <a:lnTo>
                  <a:pt x="6771" y="305"/>
                </a:lnTo>
                <a:lnTo>
                  <a:pt x="6776" y="307"/>
                </a:lnTo>
                <a:lnTo>
                  <a:pt x="6784" y="307"/>
                </a:lnTo>
                <a:lnTo>
                  <a:pt x="6790" y="309"/>
                </a:lnTo>
                <a:lnTo>
                  <a:pt x="6798" y="309"/>
                </a:lnTo>
                <a:lnTo>
                  <a:pt x="6805" y="311"/>
                </a:lnTo>
                <a:lnTo>
                  <a:pt x="6811" y="311"/>
                </a:lnTo>
                <a:lnTo>
                  <a:pt x="6819" y="311"/>
                </a:lnTo>
                <a:lnTo>
                  <a:pt x="6824" y="313"/>
                </a:lnTo>
                <a:lnTo>
                  <a:pt x="6832" y="313"/>
                </a:lnTo>
                <a:lnTo>
                  <a:pt x="6840" y="315"/>
                </a:lnTo>
                <a:lnTo>
                  <a:pt x="6846" y="315"/>
                </a:lnTo>
                <a:lnTo>
                  <a:pt x="6851" y="315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110" name="Rectangle 111">
            <a:extLst>
              <a:ext uri="{FF2B5EF4-FFF2-40B4-BE49-F238E27FC236}">
                <a16:creationId xmlns:a16="http://schemas.microsoft.com/office/drawing/2014/main" id="{E07C0093-1E06-4B94-A073-7996714F3F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4607" y="863468"/>
            <a:ext cx="1706642" cy="719043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ja-JP" altLang="en-US" sz="700">
              <a:latin typeface="Arial" panose="020B0604020202020204" pitchFamily="34" charset="0"/>
            </a:endParaRPr>
          </a:p>
        </p:txBody>
      </p:sp>
      <p:sp>
        <p:nvSpPr>
          <p:cNvPr id="813" name="テキスト ボックス 1268">
            <a:extLst>
              <a:ext uri="{FF2B5EF4-FFF2-40B4-BE49-F238E27FC236}">
                <a16:creationId xmlns:a16="http://schemas.microsoft.com/office/drawing/2014/main" id="{1A484ECA-5053-443B-BDDD-A308837819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77879" y="1412725"/>
            <a:ext cx="286748" cy="1506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 day</a:t>
            </a:r>
            <a:endParaRPr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2" name="テキスト ボックス 1279">
            <a:extLst>
              <a:ext uri="{FF2B5EF4-FFF2-40B4-BE49-F238E27FC236}">
                <a16:creationId xmlns:a16="http://schemas.microsoft.com/office/drawing/2014/main" id="{AD8D759B-91F1-4A4B-A518-E9D80123EC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46930" y="1303731"/>
            <a:ext cx="352982" cy="1506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A5</a:t>
            </a:r>
            <a:endParaRPr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3" name="テキスト ボックス 1280">
            <a:extLst>
              <a:ext uri="{FF2B5EF4-FFF2-40B4-BE49-F238E27FC236}">
                <a16:creationId xmlns:a16="http://schemas.microsoft.com/office/drawing/2014/main" id="{C031D772-2976-46F7-A3DE-84DDB8F336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51808" y="905616"/>
            <a:ext cx="279926" cy="1506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7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ja-JP" sz="7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ja-JP" sz="70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81" name="グループ化 980">
            <a:extLst>
              <a:ext uri="{FF2B5EF4-FFF2-40B4-BE49-F238E27FC236}">
                <a16:creationId xmlns:a16="http://schemas.microsoft.com/office/drawing/2014/main" id="{50052CAE-7765-4FF2-AB95-281DA5C74C8A}"/>
              </a:ext>
            </a:extLst>
          </p:cNvPr>
          <p:cNvGrpSpPr/>
          <p:nvPr/>
        </p:nvGrpSpPr>
        <p:grpSpPr>
          <a:xfrm>
            <a:off x="4799621" y="2802019"/>
            <a:ext cx="119663" cy="765848"/>
            <a:chOff x="2196643" y="3006161"/>
            <a:chExt cx="119663" cy="765848"/>
          </a:xfrm>
        </p:grpSpPr>
        <p:sp>
          <p:nvSpPr>
            <p:cNvPr id="972" name="Line 191">
              <a:extLst>
                <a:ext uri="{FF2B5EF4-FFF2-40B4-BE49-F238E27FC236}">
                  <a16:creationId xmlns:a16="http://schemas.microsoft.com/office/drawing/2014/main" id="{E2499782-A892-4D3A-8BE5-FF5AD92A1B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6902" y="3721890"/>
              <a:ext cx="9404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73" name="Line 201">
              <a:extLst>
                <a:ext uri="{FF2B5EF4-FFF2-40B4-BE49-F238E27FC236}">
                  <a16:creationId xmlns:a16="http://schemas.microsoft.com/office/drawing/2014/main" id="{66CEB7B8-AC15-4BFB-8533-F3EACEAC48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6902" y="3378765"/>
              <a:ext cx="9404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74" name="Line 211">
              <a:extLst>
                <a:ext uri="{FF2B5EF4-FFF2-40B4-BE49-F238E27FC236}">
                  <a16:creationId xmlns:a16="http://schemas.microsoft.com/office/drawing/2014/main" id="{56B8033B-411C-411A-85D0-BB5A3C1DD8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6902" y="3036924"/>
              <a:ext cx="9404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75" name="Line 212">
              <a:extLst>
                <a:ext uri="{FF2B5EF4-FFF2-40B4-BE49-F238E27FC236}">
                  <a16:creationId xmlns:a16="http://schemas.microsoft.com/office/drawing/2014/main" id="{4ED1D0EA-19BA-4A89-977C-A36954F18D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98488" y="3721890"/>
              <a:ext cx="17818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76" name="Rectangle 213">
              <a:extLst>
                <a:ext uri="{FF2B5EF4-FFF2-40B4-BE49-F238E27FC236}">
                  <a16:creationId xmlns:a16="http://schemas.microsoft.com/office/drawing/2014/main" id="{97D34C33-20B0-40E8-9E77-B0BFD6EC0E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4956" y="3691126"/>
              <a:ext cx="35031" cy="808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70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0</a:t>
              </a:r>
              <a:endParaRPr lang="en-US" altLang="ja-JP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7" name="Line 216">
              <a:extLst>
                <a:ext uri="{FF2B5EF4-FFF2-40B4-BE49-F238E27FC236}">
                  <a16:creationId xmlns:a16="http://schemas.microsoft.com/office/drawing/2014/main" id="{5F360512-C96A-4D4F-9D54-5FA72EC0CC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98488" y="3378765"/>
              <a:ext cx="17818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78" name="Rectangle 217">
              <a:extLst>
                <a:ext uri="{FF2B5EF4-FFF2-40B4-BE49-F238E27FC236}">
                  <a16:creationId xmlns:a16="http://schemas.microsoft.com/office/drawing/2014/main" id="{0E517352-BADF-4433-B24B-7962722D4A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6643" y="3349286"/>
              <a:ext cx="70061" cy="808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70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20</a:t>
              </a:r>
              <a:endParaRPr lang="en-US" altLang="ja-JP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9" name="Line 220">
              <a:extLst>
                <a:ext uri="{FF2B5EF4-FFF2-40B4-BE49-F238E27FC236}">
                  <a16:creationId xmlns:a16="http://schemas.microsoft.com/office/drawing/2014/main" id="{4140BCD9-C059-4047-AE37-F96043871D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98488" y="3036924"/>
              <a:ext cx="17818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80" name="Rectangle 221">
              <a:extLst>
                <a:ext uri="{FF2B5EF4-FFF2-40B4-BE49-F238E27FC236}">
                  <a16:creationId xmlns:a16="http://schemas.microsoft.com/office/drawing/2014/main" id="{CCE87600-0AC9-4A83-8E5C-2F165BF7ED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6643" y="3006161"/>
              <a:ext cx="70061" cy="808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40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2" name="Line 499">
            <a:extLst>
              <a:ext uri="{FF2B5EF4-FFF2-40B4-BE49-F238E27FC236}">
                <a16:creationId xmlns:a16="http://schemas.microsoft.com/office/drawing/2014/main" id="{10FBA51D-4331-42FF-8341-1842B3836F3F}"/>
              </a:ext>
            </a:extLst>
          </p:cNvPr>
          <p:cNvSpPr>
            <a:spLocks noChangeShapeType="1"/>
          </p:cNvSpPr>
          <p:nvPr/>
        </p:nvSpPr>
        <p:spPr bwMode="auto">
          <a:xfrm>
            <a:off x="5022963" y="4536058"/>
            <a:ext cx="498" cy="2287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57" name="Line 524">
            <a:extLst>
              <a:ext uri="{FF2B5EF4-FFF2-40B4-BE49-F238E27FC236}">
                <a16:creationId xmlns:a16="http://schemas.microsoft.com/office/drawing/2014/main" id="{9CA3BAF0-CF4F-4825-A638-C236EF8E1EAA}"/>
              </a:ext>
            </a:extLst>
          </p:cNvPr>
          <p:cNvSpPr>
            <a:spLocks noChangeShapeType="1"/>
          </p:cNvSpPr>
          <p:nvPr/>
        </p:nvSpPr>
        <p:spPr bwMode="auto">
          <a:xfrm>
            <a:off x="5826758" y="4536058"/>
            <a:ext cx="498" cy="2287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82" name="Line 549">
            <a:extLst>
              <a:ext uri="{FF2B5EF4-FFF2-40B4-BE49-F238E27FC236}">
                <a16:creationId xmlns:a16="http://schemas.microsoft.com/office/drawing/2014/main" id="{C72C791E-122C-457F-ABAD-5BC25912D4CE}"/>
              </a:ext>
            </a:extLst>
          </p:cNvPr>
          <p:cNvSpPr>
            <a:spLocks noChangeShapeType="1"/>
          </p:cNvSpPr>
          <p:nvPr/>
        </p:nvSpPr>
        <p:spPr bwMode="auto">
          <a:xfrm>
            <a:off x="6631549" y="4536058"/>
            <a:ext cx="498" cy="2287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83" name="Line 550">
            <a:extLst>
              <a:ext uri="{FF2B5EF4-FFF2-40B4-BE49-F238E27FC236}">
                <a16:creationId xmlns:a16="http://schemas.microsoft.com/office/drawing/2014/main" id="{63E1D11A-2B3B-45F6-B447-5ACCEB90A715}"/>
              </a:ext>
            </a:extLst>
          </p:cNvPr>
          <p:cNvSpPr>
            <a:spLocks noChangeShapeType="1"/>
          </p:cNvSpPr>
          <p:nvPr/>
        </p:nvSpPr>
        <p:spPr bwMode="auto">
          <a:xfrm>
            <a:off x="5022963" y="4536058"/>
            <a:ext cx="498" cy="4447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84" name="Rectangle 551">
            <a:extLst>
              <a:ext uri="{FF2B5EF4-FFF2-40B4-BE49-F238E27FC236}">
                <a16:creationId xmlns:a16="http://schemas.microsoft.com/office/drawing/2014/main" id="{1F1715AF-B2C9-4DAF-984A-A8B5803DE0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98062" y="4581806"/>
            <a:ext cx="35248" cy="799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4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3" name="Line 560">
            <a:extLst>
              <a:ext uri="{FF2B5EF4-FFF2-40B4-BE49-F238E27FC236}">
                <a16:creationId xmlns:a16="http://schemas.microsoft.com/office/drawing/2014/main" id="{CC1BE659-06AF-40A2-BFEE-3E1B8B5C8816}"/>
              </a:ext>
            </a:extLst>
          </p:cNvPr>
          <p:cNvSpPr>
            <a:spLocks noChangeShapeType="1"/>
          </p:cNvSpPr>
          <p:nvPr/>
        </p:nvSpPr>
        <p:spPr bwMode="auto">
          <a:xfrm>
            <a:off x="5826758" y="4536058"/>
            <a:ext cx="498" cy="4447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94" name="Rectangle 561">
            <a:extLst>
              <a:ext uri="{FF2B5EF4-FFF2-40B4-BE49-F238E27FC236}">
                <a16:creationId xmlns:a16="http://schemas.microsoft.com/office/drawing/2014/main" id="{291BC01D-C724-453B-9B65-8CD41FA414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1858" y="4581806"/>
            <a:ext cx="35248" cy="799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9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3" name="Line 570">
            <a:extLst>
              <a:ext uri="{FF2B5EF4-FFF2-40B4-BE49-F238E27FC236}">
                <a16:creationId xmlns:a16="http://schemas.microsoft.com/office/drawing/2014/main" id="{53C464F4-E509-4000-8B81-EA3FE671F33A}"/>
              </a:ext>
            </a:extLst>
          </p:cNvPr>
          <p:cNvSpPr>
            <a:spLocks noChangeShapeType="1"/>
          </p:cNvSpPr>
          <p:nvPr/>
        </p:nvSpPr>
        <p:spPr bwMode="auto">
          <a:xfrm>
            <a:off x="6631549" y="4536058"/>
            <a:ext cx="498" cy="4447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619" name="Freeform 586">
            <a:extLst>
              <a:ext uri="{FF2B5EF4-FFF2-40B4-BE49-F238E27FC236}">
                <a16:creationId xmlns:a16="http://schemas.microsoft.com/office/drawing/2014/main" id="{E4A04833-EDA1-4A0F-8E5B-5EC8227E3985}"/>
              </a:ext>
            </a:extLst>
          </p:cNvPr>
          <p:cNvSpPr>
            <a:spLocks/>
          </p:cNvSpPr>
          <p:nvPr/>
        </p:nvSpPr>
        <p:spPr bwMode="auto">
          <a:xfrm>
            <a:off x="4926349" y="3946419"/>
            <a:ext cx="1705698" cy="565494"/>
          </a:xfrm>
          <a:custGeom>
            <a:avLst/>
            <a:gdLst>
              <a:gd name="T0" fmla="*/ 24 w 6851"/>
              <a:gd name="T1" fmla="*/ 202 h 890"/>
              <a:gd name="T2" fmla="*/ 52 w 6851"/>
              <a:gd name="T3" fmla="*/ 218 h 890"/>
              <a:gd name="T4" fmla="*/ 79 w 6851"/>
              <a:gd name="T5" fmla="*/ 222 h 890"/>
              <a:gd name="T6" fmla="*/ 107 w 6851"/>
              <a:gd name="T7" fmla="*/ 222 h 890"/>
              <a:gd name="T8" fmla="*/ 135 w 6851"/>
              <a:gd name="T9" fmla="*/ 223 h 890"/>
              <a:gd name="T10" fmla="*/ 162 w 6851"/>
              <a:gd name="T11" fmla="*/ 223 h 890"/>
              <a:gd name="T12" fmla="*/ 190 w 6851"/>
              <a:gd name="T13" fmla="*/ 223 h 890"/>
              <a:gd name="T14" fmla="*/ 217 w 6851"/>
              <a:gd name="T15" fmla="*/ 223 h 890"/>
              <a:gd name="T16" fmla="*/ 245 w 6851"/>
              <a:gd name="T17" fmla="*/ 222 h 890"/>
              <a:gd name="T18" fmla="*/ 272 w 6851"/>
              <a:gd name="T19" fmla="*/ 221 h 890"/>
              <a:gd name="T20" fmla="*/ 300 w 6851"/>
              <a:gd name="T21" fmla="*/ 218 h 890"/>
              <a:gd name="T22" fmla="*/ 328 w 6851"/>
              <a:gd name="T23" fmla="*/ 211 h 890"/>
              <a:gd name="T24" fmla="*/ 355 w 6851"/>
              <a:gd name="T25" fmla="*/ 199 h 890"/>
              <a:gd name="T26" fmla="*/ 383 w 6851"/>
              <a:gd name="T27" fmla="*/ 184 h 890"/>
              <a:gd name="T28" fmla="*/ 410 w 6851"/>
              <a:gd name="T29" fmla="*/ 171 h 890"/>
              <a:gd name="T30" fmla="*/ 438 w 6851"/>
              <a:gd name="T31" fmla="*/ 163 h 890"/>
              <a:gd name="T32" fmla="*/ 465 w 6851"/>
              <a:gd name="T33" fmla="*/ 160 h 890"/>
              <a:gd name="T34" fmla="*/ 493 w 6851"/>
              <a:gd name="T35" fmla="*/ 158 h 890"/>
              <a:gd name="T36" fmla="*/ 521 w 6851"/>
              <a:gd name="T37" fmla="*/ 157 h 890"/>
              <a:gd name="T38" fmla="*/ 548 w 6851"/>
              <a:gd name="T39" fmla="*/ 154 h 890"/>
              <a:gd name="T40" fmla="*/ 576 w 6851"/>
              <a:gd name="T41" fmla="*/ 155 h 890"/>
              <a:gd name="T42" fmla="*/ 603 w 6851"/>
              <a:gd name="T43" fmla="*/ 150 h 890"/>
              <a:gd name="T44" fmla="*/ 631 w 6851"/>
              <a:gd name="T45" fmla="*/ 151 h 890"/>
              <a:gd name="T46" fmla="*/ 658 w 6851"/>
              <a:gd name="T47" fmla="*/ 152 h 890"/>
              <a:gd name="T48" fmla="*/ 686 w 6851"/>
              <a:gd name="T49" fmla="*/ 152 h 890"/>
              <a:gd name="T50" fmla="*/ 714 w 6851"/>
              <a:gd name="T51" fmla="*/ 130 h 890"/>
              <a:gd name="T52" fmla="*/ 741 w 6851"/>
              <a:gd name="T53" fmla="*/ 134 h 890"/>
              <a:gd name="T54" fmla="*/ 769 w 6851"/>
              <a:gd name="T55" fmla="*/ 141 h 890"/>
              <a:gd name="T56" fmla="*/ 796 w 6851"/>
              <a:gd name="T57" fmla="*/ 145 h 890"/>
              <a:gd name="T58" fmla="*/ 824 w 6851"/>
              <a:gd name="T59" fmla="*/ 143 h 890"/>
              <a:gd name="T60" fmla="*/ 851 w 6851"/>
              <a:gd name="T61" fmla="*/ 147 h 890"/>
              <a:gd name="T62" fmla="*/ 879 w 6851"/>
              <a:gd name="T63" fmla="*/ 144 h 890"/>
              <a:gd name="T64" fmla="*/ 906 w 6851"/>
              <a:gd name="T65" fmla="*/ 142 h 890"/>
              <a:gd name="T66" fmla="*/ 934 w 6851"/>
              <a:gd name="T67" fmla="*/ 143 h 890"/>
              <a:gd name="T68" fmla="*/ 962 w 6851"/>
              <a:gd name="T69" fmla="*/ 141 h 890"/>
              <a:gd name="T70" fmla="*/ 989 w 6851"/>
              <a:gd name="T71" fmla="*/ 140 h 890"/>
              <a:gd name="T72" fmla="*/ 1017 w 6851"/>
              <a:gd name="T73" fmla="*/ 135 h 890"/>
              <a:gd name="T74" fmla="*/ 1044 w 6851"/>
              <a:gd name="T75" fmla="*/ 136 h 890"/>
              <a:gd name="T76" fmla="*/ 1072 w 6851"/>
              <a:gd name="T77" fmla="*/ 134 h 890"/>
              <a:gd name="T78" fmla="*/ 1099 w 6851"/>
              <a:gd name="T79" fmla="*/ 128 h 890"/>
              <a:gd name="T80" fmla="*/ 1127 w 6851"/>
              <a:gd name="T81" fmla="*/ 130 h 890"/>
              <a:gd name="T82" fmla="*/ 1155 w 6851"/>
              <a:gd name="T83" fmla="*/ 131 h 890"/>
              <a:gd name="T84" fmla="*/ 1182 w 6851"/>
              <a:gd name="T85" fmla="*/ 129 h 890"/>
              <a:gd name="T86" fmla="*/ 1210 w 6851"/>
              <a:gd name="T87" fmla="*/ 128 h 890"/>
              <a:gd name="T88" fmla="*/ 1237 w 6851"/>
              <a:gd name="T89" fmla="*/ 127 h 890"/>
              <a:gd name="T90" fmla="*/ 1265 w 6851"/>
              <a:gd name="T91" fmla="*/ 125 h 890"/>
              <a:gd name="T92" fmla="*/ 1292 w 6851"/>
              <a:gd name="T93" fmla="*/ 117 h 890"/>
              <a:gd name="T94" fmla="*/ 1320 w 6851"/>
              <a:gd name="T95" fmla="*/ 120 h 890"/>
              <a:gd name="T96" fmla="*/ 1348 w 6851"/>
              <a:gd name="T97" fmla="*/ 116 h 890"/>
              <a:gd name="T98" fmla="*/ 1375 w 6851"/>
              <a:gd name="T99" fmla="*/ 116 h 890"/>
              <a:gd name="T100" fmla="*/ 1403 w 6851"/>
              <a:gd name="T101" fmla="*/ 114 h 890"/>
              <a:gd name="T102" fmla="*/ 1430 w 6851"/>
              <a:gd name="T103" fmla="*/ 109 h 890"/>
              <a:gd name="T104" fmla="*/ 1458 w 6851"/>
              <a:gd name="T105" fmla="*/ 107 h 890"/>
              <a:gd name="T106" fmla="*/ 1485 w 6851"/>
              <a:gd name="T107" fmla="*/ 94 h 890"/>
              <a:gd name="T108" fmla="*/ 1513 w 6851"/>
              <a:gd name="T109" fmla="*/ 77 h 890"/>
              <a:gd name="T110" fmla="*/ 1541 w 6851"/>
              <a:gd name="T111" fmla="*/ 80 h 890"/>
              <a:gd name="T112" fmla="*/ 1568 w 6851"/>
              <a:gd name="T113" fmla="*/ 24 h 890"/>
              <a:gd name="T114" fmla="*/ 1596 w 6851"/>
              <a:gd name="T115" fmla="*/ 20 h 890"/>
              <a:gd name="T116" fmla="*/ 1623 w 6851"/>
              <a:gd name="T117" fmla="*/ 54 h 890"/>
              <a:gd name="T118" fmla="*/ 1651 w 6851"/>
              <a:gd name="T119" fmla="*/ 67 h 890"/>
              <a:gd name="T120" fmla="*/ 1678 w 6851"/>
              <a:gd name="T121" fmla="*/ 73 h 890"/>
              <a:gd name="T122" fmla="*/ 1706 w 6851"/>
              <a:gd name="T123" fmla="*/ 76 h 890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  <a:gd name="T165" fmla="*/ 0 60000 65536"/>
              <a:gd name="T166" fmla="*/ 0 60000 65536"/>
              <a:gd name="T167" fmla="*/ 0 60000 65536"/>
              <a:gd name="T168" fmla="*/ 0 60000 65536"/>
              <a:gd name="T169" fmla="*/ 0 60000 65536"/>
              <a:gd name="T170" fmla="*/ 0 60000 65536"/>
              <a:gd name="T171" fmla="*/ 0 60000 65536"/>
              <a:gd name="T172" fmla="*/ 0 60000 65536"/>
              <a:gd name="T173" fmla="*/ 0 60000 65536"/>
              <a:gd name="T174" fmla="*/ 0 60000 65536"/>
              <a:gd name="T175" fmla="*/ 0 60000 65536"/>
              <a:gd name="T176" fmla="*/ 0 60000 65536"/>
              <a:gd name="T177" fmla="*/ 0 60000 65536"/>
              <a:gd name="T178" fmla="*/ 0 60000 65536"/>
              <a:gd name="T179" fmla="*/ 0 60000 65536"/>
              <a:gd name="T180" fmla="*/ 0 60000 65536"/>
              <a:gd name="T181" fmla="*/ 0 60000 65536"/>
              <a:gd name="T182" fmla="*/ 0 60000 65536"/>
              <a:gd name="T183" fmla="*/ 0 60000 65536"/>
              <a:gd name="T184" fmla="*/ 0 60000 65536"/>
              <a:gd name="T185" fmla="*/ 0 60000 65536"/>
            </a:gdLst>
            <a:ahLst/>
            <a:cxnLst>
              <a:cxn ang="T124">
                <a:pos x="T0" y="T1"/>
              </a:cxn>
              <a:cxn ang="T125">
                <a:pos x="T2" y="T3"/>
              </a:cxn>
              <a:cxn ang="T126">
                <a:pos x="T4" y="T5"/>
              </a:cxn>
              <a:cxn ang="T127">
                <a:pos x="T6" y="T7"/>
              </a:cxn>
              <a:cxn ang="T128">
                <a:pos x="T8" y="T9"/>
              </a:cxn>
              <a:cxn ang="T129">
                <a:pos x="T10" y="T11"/>
              </a:cxn>
              <a:cxn ang="T130">
                <a:pos x="T12" y="T13"/>
              </a:cxn>
              <a:cxn ang="T131">
                <a:pos x="T14" y="T15"/>
              </a:cxn>
              <a:cxn ang="T132">
                <a:pos x="T16" y="T17"/>
              </a:cxn>
              <a:cxn ang="T133">
                <a:pos x="T18" y="T19"/>
              </a:cxn>
              <a:cxn ang="T134">
                <a:pos x="T20" y="T21"/>
              </a:cxn>
              <a:cxn ang="T135">
                <a:pos x="T22" y="T23"/>
              </a:cxn>
              <a:cxn ang="T136">
                <a:pos x="T24" y="T25"/>
              </a:cxn>
              <a:cxn ang="T137">
                <a:pos x="T26" y="T27"/>
              </a:cxn>
              <a:cxn ang="T138">
                <a:pos x="T28" y="T29"/>
              </a:cxn>
              <a:cxn ang="T139">
                <a:pos x="T30" y="T31"/>
              </a:cxn>
              <a:cxn ang="T140">
                <a:pos x="T32" y="T33"/>
              </a:cxn>
              <a:cxn ang="T141">
                <a:pos x="T34" y="T35"/>
              </a:cxn>
              <a:cxn ang="T142">
                <a:pos x="T36" y="T37"/>
              </a:cxn>
              <a:cxn ang="T143">
                <a:pos x="T38" y="T39"/>
              </a:cxn>
              <a:cxn ang="T144">
                <a:pos x="T40" y="T41"/>
              </a:cxn>
              <a:cxn ang="T145">
                <a:pos x="T42" y="T43"/>
              </a:cxn>
              <a:cxn ang="T146">
                <a:pos x="T44" y="T45"/>
              </a:cxn>
              <a:cxn ang="T147">
                <a:pos x="T46" y="T47"/>
              </a:cxn>
              <a:cxn ang="T148">
                <a:pos x="T48" y="T49"/>
              </a:cxn>
              <a:cxn ang="T149">
                <a:pos x="T50" y="T51"/>
              </a:cxn>
              <a:cxn ang="T150">
                <a:pos x="T52" y="T53"/>
              </a:cxn>
              <a:cxn ang="T151">
                <a:pos x="T54" y="T55"/>
              </a:cxn>
              <a:cxn ang="T152">
                <a:pos x="T56" y="T57"/>
              </a:cxn>
              <a:cxn ang="T153">
                <a:pos x="T58" y="T59"/>
              </a:cxn>
              <a:cxn ang="T154">
                <a:pos x="T60" y="T61"/>
              </a:cxn>
              <a:cxn ang="T155">
                <a:pos x="T62" y="T63"/>
              </a:cxn>
              <a:cxn ang="T156">
                <a:pos x="T64" y="T65"/>
              </a:cxn>
              <a:cxn ang="T157">
                <a:pos x="T66" y="T67"/>
              </a:cxn>
              <a:cxn ang="T158">
                <a:pos x="T68" y="T69"/>
              </a:cxn>
              <a:cxn ang="T159">
                <a:pos x="T70" y="T71"/>
              </a:cxn>
              <a:cxn ang="T160">
                <a:pos x="T72" y="T73"/>
              </a:cxn>
              <a:cxn ang="T161">
                <a:pos x="T74" y="T75"/>
              </a:cxn>
              <a:cxn ang="T162">
                <a:pos x="T76" y="T77"/>
              </a:cxn>
              <a:cxn ang="T163">
                <a:pos x="T78" y="T79"/>
              </a:cxn>
              <a:cxn ang="T164">
                <a:pos x="T80" y="T81"/>
              </a:cxn>
              <a:cxn ang="T165">
                <a:pos x="T82" y="T83"/>
              </a:cxn>
              <a:cxn ang="T166">
                <a:pos x="T84" y="T85"/>
              </a:cxn>
              <a:cxn ang="T167">
                <a:pos x="T86" y="T87"/>
              </a:cxn>
              <a:cxn ang="T168">
                <a:pos x="T88" y="T89"/>
              </a:cxn>
              <a:cxn ang="T169">
                <a:pos x="T90" y="T91"/>
              </a:cxn>
              <a:cxn ang="T170">
                <a:pos x="T92" y="T93"/>
              </a:cxn>
              <a:cxn ang="T171">
                <a:pos x="T94" y="T95"/>
              </a:cxn>
              <a:cxn ang="T172">
                <a:pos x="T96" y="T97"/>
              </a:cxn>
              <a:cxn ang="T173">
                <a:pos x="T98" y="T99"/>
              </a:cxn>
              <a:cxn ang="T174">
                <a:pos x="T100" y="T101"/>
              </a:cxn>
              <a:cxn ang="T175">
                <a:pos x="T102" y="T103"/>
              </a:cxn>
              <a:cxn ang="T176">
                <a:pos x="T104" y="T105"/>
              </a:cxn>
              <a:cxn ang="T177">
                <a:pos x="T106" y="T107"/>
              </a:cxn>
              <a:cxn ang="T178">
                <a:pos x="T108" y="T109"/>
              </a:cxn>
              <a:cxn ang="T179">
                <a:pos x="T110" y="T111"/>
              </a:cxn>
              <a:cxn ang="T180">
                <a:pos x="T112" y="T113"/>
              </a:cxn>
              <a:cxn ang="T181">
                <a:pos x="T114" y="T115"/>
              </a:cxn>
              <a:cxn ang="T182">
                <a:pos x="T116" y="T117"/>
              </a:cxn>
              <a:cxn ang="T183">
                <a:pos x="T118" y="T119"/>
              </a:cxn>
              <a:cxn ang="T184">
                <a:pos x="T120" y="T121"/>
              </a:cxn>
              <a:cxn ang="T185">
                <a:pos x="T122" y="T123"/>
              </a:cxn>
            </a:cxnLst>
            <a:rect l="0" t="0" r="r" b="b"/>
            <a:pathLst>
              <a:path w="6851" h="890">
                <a:moveTo>
                  <a:pt x="0" y="650"/>
                </a:moveTo>
                <a:lnTo>
                  <a:pt x="2" y="658"/>
                </a:lnTo>
                <a:lnTo>
                  <a:pt x="8" y="683"/>
                </a:lnTo>
                <a:lnTo>
                  <a:pt x="16" y="702"/>
                </a:lnTo>
                <a:lnTo>
                  <a:pt x="23" y="717"/>
                </a:lnTo>
                <a:lnTo>
                  <a:pt x="29" y="731"/>
                </a:lnTo>
                <a:lnTo>
                  <a:pt x="37" y="742"/>
                </a:lnTo>
                <a:lnTo>
                  <a:pt x="43" y="754"/>
                </a:lnTo>
                <a:lnTo>
                  <a:pt x="50" y="762"/>
                </a:lnTo>
                <a:lnTo>
                  <a:pt x="58" y="769"/>
                </a:lnTo>
                <a:lnTo>
                  <a:pt x="64" y="777"/>
                </a:lnTo>
                <a:lnTo>
                  <a:pt x="71" y="783"/>
                </a:lnTo>
                <a:lnTo>
                  <a:pt x="77" y="788"/>
                </a:lnTo>
                <a:lnTo>
                  <a:pt x="85" y="794"/>
                </a:lnTo>
                <a:lnTo>
                  <a:pt x="92" y="800"/>
                </a:lnTo>
                <a:lnTo>
                  <a:pt x="98" y="806"/>
                </a:lnTo>
                <a:lnTo>
                  <a:pt x="106" y="810"/>
                </a:lnTo>
                <a:lnTo>
                  <a:pt x="112" y="815"/>
                </a:lnTo>
                <a:lnTo>
                  <a:pt x="119" y="821"/>
                </a:lnTo>
                <a:lnTo>
                  <a:pt x="127" y="827"/>
                </a:lnTo>
                <a:lnTo>
                  <a:pt x="133" y="831"/>
                </a:lnTo>
                <a:lnTo>
                  <a:pt x="140" y="836"/>
                </a:lnTo>
                <a:lnTo>
                  <a:pt x="146" y="840"/>
                </a:lnTo>
                <a:lnTo>
                  <a:pt x="154" y="844"/>
                </a:lnTo>
                <a:lnTo>
                  <a:pt x="160" y="848"/>
                </a:lnTo>
                <a:lnTo>
                  <a:pt x="167" y="852"/>
                </a:lnTo>
                <a:lnTo>
                  <a:pt x="175" y="856"/>
                </a:lnTo>
                <a:lnTo>
                  <a:pt x="181" y="859"/>
                </a:lnTo>
                <a:lnTo>
                  <a:pt x="188" y="863"/>
                </a:lnTo>
                <a:lnTo>
                  <a:pt x="194" y="865"/>
                </a:lnTo>
                <a:lnTo>
                  <a:pt x="202" y="867"/>
                </a:lnTo>
                <a:lnTo>
                  <a:pt x="210" y="871"/>
                </a:lnTo>
                <a:lnTo>
                  <a:pt x="215" y="873"/>
                </a:lnTo>
                <a:lnTo>
                  <a:pt x="223" y="875"/>
                </a:lnTo>
                <a:lnTo>
                  <a:pt x="229" y="877"/>
                </a:lnTo>
                <a:lnTo>
                  <a:pt x="236" y="877"/>
                </a:lnTo>
                <a:lnTo>
                  <a:pt x="244" y="879"/>
                </a:lnTo>
                <a:lnTo>
                  <a:pt x="250" y="881"/>
                </a:lnTo>
                <a:lnTo>
                  <a:pt x="258" y="881"/>
                </a:lnTo>
                <a:lnTo>
                  <a:pt x="263" y="882"/>
                </a:lnTo>
                <a:lnTo>
                  <a:pt x="271" y="882"/>
                </a:lnTo>
                <a:lnTo>
                  <a:pt x="277" y="882"/>
                </a:lnTo>
                <a:lnTo>
                  <a:pt x="284" y="884"/>
                </a:lnTo>
                <a:lnTo>
                  <a:pt x="292" y="884"/>
                </a:lnTo>
                <a:lnTo>
                  <a:pt x="298" y="884"/>
                </a:lnTo>
                <a:lnTo>
                  <a:pt x="306" y="884"/>
                </a:lnTo>
                <a:lnTo>
                  <a:pt x="311" y="884"/>
                </a:lnTo>
                <a:lnTo>
                  <a:pt x="319" y="886"/>
                </a:lnTo>
                <a:lnTo>
                  <a:pt x="327" y="886"/>
                </a:lnTo>
                <a:lnTo>
                  <a:pt x="332" y="886"/>
                </a:lnTo>
                <a:lnTo>
                  <a:pt x="340" y="886"/>
                </a:lnTo>
                <a:lnTo>
                  <a:pt x="346" y="886"/>
                </a:lnTo>
                <a:lnTo>
                  <a:pt x="354" y="886"/>
                </a:lnTo>
                <a:lnTo>
                  <a:pt x="361" y="886"/>
                </a:lnTo>
                <a:lnTo>
                  <a:pt x="367" y="886"/>
                </a:lnTo>
                <a:lnTo>
                  <a:pt x="375" y="886"/>
                </a:lnTo>
                <a:lnTo>
                  <a:pt x="380" y="886"/>
                </a:lnTo>
                <a:lnTo>
                  <a:pt x="388" y="886"/>
                </a:lnTo>
                <a:lnTo>
                  <a:pt x="394" y="886"/>
                </a:lnTo>
                <a:lnTo>
                  <a:pt x="402" y="886"/>
                </a:lnTo>
                <a:lnTo>
                  <a:pt x="409" y="886"/>
                </a:lnTo>
                <a:lnTo>
                  <a:pt x="415" y="888"/>
                </a:lnTo>
                <a:lnTo>
                  <a:pt x="423" y="888"/>
                </a:lnTo>
                <a:lnTo>
                  <a:pt x="429" y="886"/>
                </a:lnTo>
                <a:lnTo>
                  <a:pt x="436" y="886"/>
                </a:lnTo>
                <a:lnTo>
                  <a:pt x="444" y="888"/>
                </a:lnTo>
                <a:lnTo>
                  <a:pt x="450" y="888"/>
                </a:lnTo>
                <a:lnTo>
                  <a:pt x="457" y="888"/>
                </a:lnTo>
                <a:lnTo>
                  <a:pt x="463" y="888"/>
                </a:lnTo>
                <a:lnTo>
                  <a:pt x="471" y="888"/>
                </a:lnTo>
                <a:lnTo>
                  <a:pt x="478" y="888"/>
                </a:lnTo>
                <a:lnTo>
                  <a:pt x="484" y="888"/>
                </a:lnTo>
                <a:lnTo>
                  <a:pt x="492" y="888"/>
                </a:lnTo>
                <a:lnTo>
                  <a:pt x="498" y="888"/>
                </a:lnTo>
                <a:lnTo>
                  <a:pt x="505" y="888"/>
                </a:lnTo>
                <a:lnTo>
                  <a:pt x="513" y="888"/>
                </a:lnTo>
                <a:lnTo>
                  <a:pt x="519" y="888"/>
                </a:lnTo>
                <a:lnTo>
                  <a:pt x="526" y="888"/>
                </a:lnTo>
                <a:lnTo>
                  <a:pt x="532" y="888"/>
                </a:lnTo>
                <a:lnTo>
                  <a:pt x="540" y="890"/>
                </a:lnTo>
                <a:lnTo>
                  <a:pt x="546" y="890"/>
                </a:lnTo>
                <a:lnTo>
                  <a:pt x="553" y="888"/>
                </a:lnTo>
                <a:lnTo>
                  <a:pt x="561" y="888"/>
                </a:lnTo>
                <a:lnTo>
                  <a:pt x="567" y="890"/>
                </a:lnTo>
                <a:lnTo>
                  <a:pt x="574" y="890"/>
                </a:lnTo>
                <a:lnTo>
                  <a:pt x="580" y="890"/>
                </a:lnTo>
                <a:lnTo>
                  <a:pt x="588" y="890"/>
                </a:lnTo>
                <a:lnTo>
                  <a:pt x="596" y="890"/>
                </a:lnTo>
                <a:lnTo>
                  <a:pt x="601" y="890"/>
                </a:lnTo>
                <a:lnTo>
                  <a:pt x="609" y="890"/>
                </a:lnTo>
                <a:lnTo>
                  <a:pt x="615" y="890"/>
                </a:lnTo>
                <a:lnTo>
                  <a:pt x="622" y="890"/>
                </a:lnTo>
                <a:lnTo>
                  <a:pt x="630" y="890"/>
                </a:lnTo>
                <a:lnTo>
                  <a:pt x="636" y="890"/>
                </a:lnTo>
                <a:lnTo>
                  <a:pt x="644" y="890"/>
                </a:lnTo>
                <a:lnTo>
                  <a:pt x="649" y="890"/>
                </a:lnTo>
                <a:lnTo>
                  <a:pt x="657" y="890"/>
                </a:lnTo>
                <a:lnTo>
                  <a:pt x="663" y="890"/>
                </a:lnTo>
                <a:lnTo>
                  <a:pt x="670" y="890"/>
                </a:lnTo>
                <a:lnTo>
                  <a:pt x="678" y="890"/>
                </a:lnTo>
                <a:lnTo>
                  <a:pt x="684" y="890"/>
                </a:lnTo>
                <a:lnTo>
                  <a:pt x="692" y="890"/>
                </a:lnTo>
                <a:lnTo>
                  <a:pt x="697" y="890"/>
                </a:lnTo>
                <a:lnTo>
                  <a:pt x="705" y="890"/>
                </a:lnTo>
                <a:lnTo>
                  <a:pt x="713" y="890"/>
                </a:lnTo>
                <a:lnTo>
                  <a:pt x="718" y="890"/>
                </a:lnTo>
                <a:lnTo>
                  <a:pt x="726" y="890"/>
                </a:lnTo>
                <a:lnTo>
                  <a:pt x="732" y="890"/>
                </a:lnTo>
                <a:lnTo>
                  <a:pt x="740" y="890"/>
                </a:lnTo>
                <a:lnTo>
                  <a:pt x="747" y="890"/>
                </a:lnTo>
                <a:lnTo>
                  <a:pt x="753" y="890"/>
                </a:lnTo>
                <a:lnTo>
                  <a:pt x="761" y="890"/>
                </a:lnTo>
                <a:lnTo>
                  <a:pt x="766" y="890"/>
                </a:lnTo>
                <a:lnTo>
                  <a:pt x="774" y="890"/>
                </a:lnTo>
                <a:lnTo>
                  <a:pt x="782" y="890"/>
                </a:lnTo>
                <a:lnTo>
                  <a:pt x="788" y="890"/>
                </a:lnTo>
                <a:lnTo>
                  <a:pt x="795" y="890"/>
                </a:lnTo>
                <a:lnTo>
                  <a:pt x="801" y="890"/>
                </a:lnTo>
                <a:lnTo>
                  <a:pt x="809" y="890"/>
                </a:lnTo>
                <a:lnTo>
                  <a:pt x="814" y="890"/>
                </a:lnTo>
                <a:lnTo>
                  <a:pt x="822" y="890"/>
                </a:lnTo>
                <a:lnTo>
                  <a:pt x="830" y="890"/>
                </a:lnTo>
                <a:lnTo>
                  <a:pt x="836" y="890"/>
                </a:lnTo>
                <a:lnTo>
                  <a:pt x="843" y="890"/>
                </a:lnTo>
                <a:lnTo>
                  <a:pt x="849" y="890"/>
                </a:lnTo>
                <a:lnTo>
                  <a:pt x="857" y="890"/>
                </a:lnTo>
                <a:lnTo>
                  <a:pt x="864" y="890"/>
                </a:lnTo>
                <a:lnTo>
                  <a:pt x="870" y="890"/>
                </a:lnTo>
                <a:lnTo>
                  <a:pt x="878" y="890"/>
                </a:lnTo>
                <a:lnTo>
                  <a:pt x="884" y="890"/>
                </a:lnTo>
                <a:lnTo>
                  <a:pt x="891" y="890"/>
                </a:lnTo>
                <a:lnTo>
                  <a:pt x="899" y="890"/>
                </a:lnTo>
                <a:lnTo>
                  <a:pt x="905" y="890"/>
                </a:lnTo>
                <a:lnTo>
                  <a:pt x="912" y="890"/>
                </a:lnTo>
                <a:lnTo>
                  <a:pt x="918" y="890"/>
                </a:lnTo>
                <a:lnTo>
                  <a:pt x="926" y="890"/>
                </a:lnTo>
                <a:lnTo>
                  <a:pt x="932" y="890"/>
                </a:lnTo>
                <a:lnTo>
                  <a:pt x="939" y="890"/>
                </a:lnTo>
                <a:lnTo>
                  <a:pt x="947" y="888"/>
                </a:lnTo>
                <a:lnTo>
                  <a:pt x="953" y="888"/>
                </a:lnTo>
                <a:lnTo>
                  <a:pt x="960" y="888"/>
                </a:lnTo>
                <a:lnTo>
                  <a:pt x="966" y="888"/>
                </a:lnTo>
                <a:lnTo>
                  <a:pt x="974" y="888"/>
                </a:lnTo>
                <a:lnTo>
                  <a:pt x="981" y="888"/>
                </a:lnTo>
                <a:lnTo>
                  <a:pt x="987" y="888"/>
                </a:lnTo>
                <a:lnTo>
                  <a:pt x="995" y="888"/>
                </a:lnTo>
                <a:lnTo>
                  <a:pt x="1001" y="886"/>
                </a:lnTo>
                <a:lnTo>
                  <a:pt x="1008" y="886"/>
                </a:lnTo>
                <a:lnTo>
                  <a:pt x="1016" y="886"/>
                </a:lnTo>
                <a:lnTo>
                  <a:pt x="1022" y="886"/>
                </a:lnTo>
                <a:lnTo>
                  <a:pt x="1029" y="886"/>
                </a:lnTo>
                <a:lnTo>
                  <a:pt x="1035" y="884"/>
                </a:lnTo>
                <a:lnTo>
                  <a:pt x="1043" y="884"/>
                </a:lnTo>
                <a:lnTo>
                  <a:pt x="1049" y="884"/>
                </a:lnTo>
                <a:lnTo>
                  <a:pt x="1056" y="884"/>
                </a:lnTo>
                <a:lnTo>
                  <a:pt x="1064" y="882"/>
                </a:lnTo>
                <a:lnTo>
                  <a:pt x="1070" y="882"/>
                </a:lnTo>
                <a:lnTo>
                  <a:pt x="1078" y="882"/>
                </a:lnTo>
                <a:lnTo>
                  <a:pt x="1083" y="882"/>
                </a:lnTo>
                <a:lnTo>
                  <a:pt x="1091" y="881"/>
                </a:lnTo>
                <a:lnTo>
                  <a:pt x="1099" y="881"/>
                </a:lnTo>
                <a:lnTo>
                  <a:pt x="1104" y="881"/>
                </a:lnTo>
                <a:lnTo>
                  <a:pt x="1112" y="881"/>
                </a:lnTo>
                <a:lnTo>
                  <a:pt x="1118" y="879"/>
                </a:lnTo>
                <a:lnTo>
                  <a:pt x="1126" y="879"/>
                </a:lnTo>
                <a:lnTo>
                  <a:pt x="1133" y="879"/>
                </a:lnTo>
                <a:lnTo>
                  <a:pt x="1139" y="879"/>
                </a:lnTo>
                <a:lnTo>
                  <a:pt x="1147" y="877"/>
                </a:lnTo>
                <a:lnTo>
                  <a:pt x="1152" y="877"/>
                </a:lnTo>
                <a:lnTo>
                  <a:pt x="1160" y="877"/>
                </a:lnTo>
                <a:lnTo>
                  <a:pt x="1168" y="875"/>
                </a:lnTo>
                <a:lnTo>
                  <a:pt x="1174" y="875"/>
                </a:lnTo>
                <a:lnTo>
                  <a:pt x="1181" y="875"/>
                </a:lnTo>
                <a:lnTo>
                  <a:pt x="1187" y="873"/>
                </a:lnTo>
                <a:lnTo>
                  <a:pt x="1195" y="873"/>
                </a:lnTo>
                <a:lnTo>
                  <a:pt x="1200" y="871"/>
                </a:lnTo>
                <a:lnTo>
                  <a:pt x="1208" y="871"/>
                </a:lnTo>
                <a:lnTo>
                  <a:pt x="1216" y="869"/>
                </a:lnTo>
                <a:lnTo>
                  <a:pt x="1222" y="867"/>
                </a:lnTo>
                <a:lnTo>
                  <a:pt x="1229" y="867"/>
                </a:lnTo>
                <a:lnTo>
                  <a:pt x="1235" y="865"/>
                </a:lnTo>
                <a:lnTo>
                  <a:pt x="1243" y="863"/>
                </a:lnTo>
                <a:lnTo>
                  <a:pt x="1250" y="861"/>
                </a:lnTo>
                <a:lnTo>
                  <a:pt x="1256" y="859"/>
                </a:lnTo>
                <a:lnTo>
                  <a:pt x="1264" y="857"/>
                </a:lnTo>
                <a:lnTo>
                  <a:pt x="1270" y="856"/>
                </a:lnTo>
                <a:lnTo>
                  <a:pt x="1277" y="854"/>
                </a:lnTo>
                <a:lnTo>
                  <a:pt x="1285" y="852"/>
                </a:lnTo>
                <a:lnTo>
                  <a:pt x="1291" y="850"/>
                </a:lnTo>
                <a:lnTo>
                  <a:pt x="1298" y="846"/>
                </a:lnTo>
                <a:lnTo>
                  <a:pt x="1304" y="844"/>
                </a:lnTo>
                <a:lnTo>
                  <a:pt x="1312" y="842"/>
                </a:lnTo>
                <a:lnTo>
                  <a:pt x="1318" y="840"/>
                </a:lnTo>
                <a:lnTo>
                  <a:pt x="1325" y="836"/>
                </a:lnTo>
                <a:lnTo>
                  <a:pt x="1333" y="834"/>
                </a:lnTo>
                <a:lnTo>
                  <a:pt x="1339" y="833"/>
                </a:lnTo>
                <a:lnTo>
                  <a:pt x="1346" y="829"/>
                </a:lnTo>
                <a:lnTo>
                  <a:pt x="1352" y="825"/>
                </a:lnTo>
                <a:lnTo>
                  <a:pt x="1360" y="823"/>
                </a:lnTo>
                <a:lnTo>
                  <a:pt x="1367" y="819"/>
                </a:lnTo>
                <a:lnTo>
                  <a:pt x="1373" y="817"/>
                </a:lnTo>
                <a:lnTo>
                  <a:pt x="1381" y="813"/>
                </a:lnTo>
                <a:lnTo>
                  <a:pt x="1387" y="811"/>
                </a:lnTo>
                <a:lnTo>
                  <a:pt x="1394" y="808"/>
                </a:lnTo>
                <a:lnTo>
                  <a:pt x="1402" y="804"/>
                </a:lnTo>
                <a:lnTo>
                  <a:pt x="1408" y="800"/>
                </a:lnTo>
                <a:lnTo>
                  <a:pt x="1415" y="798"/>
                </a:lnTo>
                <a:lnTo>
                  <a:pt x="1421" y="794"/>
                </a:lnTo>
                <a:lnTo>
                  <a:pt x="1429" y="790"/>
                </a:lnTo>
                <a:lnTo>
                  <a:pt x="1435" y="786"/>
                </a:lnTo>
                <a:lnTo>
                  <a:pt x="1442" y="783"/>
                </a:lnTo>
                <a:lnTo>
                  <a:pt x="1450" y="779"/>
                </a:lnTo>
                <a:lnTo>
                  <a:pt x="1456" y="775"/>
                </a:lnTo>
                <a:lnTo>
                  <a:pt x="1463" y="771"/>
                </a:lnTo>
                <a:lnTo>
                  <a:pt x="1469" y="767"/>
                </a:lnTo>
                <a:lnTo>
                  <a:pt x="1477" y="763"/>
                </a:lnTo>
                <a:lnTo>
                  <a:pt x="1485" y="760"/>
                </a:lnTo>
                <a:lnTo>
                  <a:pt x="1490" y="754"/>
                </a:lnTo>
                <a:lnTo>
                  <a:pt x="1498" y="750"/>
                </a:lnTo>
                <a:lnTo>
                  <a:pt x="1504" y="748"/>
                </a:lnTo>
                <a:lnTo>
                  <a:pt x="1511" y="742"/>
                </a:lnTo>
                <a:lnTo>
                  <a:pt x="1519" y="739"/>
                </a:lnTo>
                <a:lnTo>
                  <a:pt x="1525" y="735"/>
                </a:lnTo>
                <a:lnTo>
                  <a:pt x="1533" y="733"/>
                </a:lnTo>
                <a:lnTo>
                  <a:pt x="1538" y="729"/>
                </a:lnTo>
                <a:lnTo>
                  <a:pt x="1546" y="725"/>
                </a:lnTo>
                <a:lnTo>
                  <a:pt x="1554" y="721"/>
                </a:lnTo>
                <a:lnTo>
                  <a:pt x="1559" y="717"/>
                </a:lnTo>
                <a:lnTo>
                  <a:pt x="1567" y="715"/>
                </a:lnTo>
                <a:lnTo>
                  <a:pt x="1573" y="712"/>
                </a:lnTo>
                <a:lnTo>
                  <a:pt x="1581" y="708"/>
                </a:lnTo>
                <a:lnTo>
                  <a:pt x="1586" y="704"/>
                </a:lnTo>
                <a:lnTo>
                  <a:pt x="1594" y="702"/>
                </a:lnTo>
                <a:lnTo>
                  <a:pt x="1602" y="698"/>
                </a:lnTo>
                <a:lnTo>
                  <a:pt x="1607" y="696"/>
                </a:lnTo>
                <a:lnTo>
                  <a:pt x="1615" y="692"/>
                </a:lnTo>
                <a:lnTo>
                  <a:pt x="1621" y="691"/>
                </a:lnTo>
                <a:lnTo>
                  <a:pt x="1629" y="687"/>
                </a:lnTo>
                <a:lnTo>
                  <a:pt x="1636" y="685"/>
                </a:lnTo>
                <a:lnTo>
                  <a:pt x="1642" y="683"/>
                </a:lnTo>
                <a:lnTo>
                  <a:pt x="1650" y="679"/>
                </a:lnTo>
                <a:lnTo>
                  <a:pt x="1655" y="677"/>
                </a:lnTo>
                <a:lnTo>
                  <a:pt x="1663" y="673"/>
                </a:lnTo>
                <a:lnTo>
                  <a:pt x="1671" y="671"/>
                </a:lnTo>
                <a:lnTo>
                  <a:pt x="1677" y="669"/>
                </a:lnTo>
                <a:lnTo>
                  <a:pt x="1684" y="668"/>
                </a:lnTo>
                <a:lnTo>
                  <a:pt x="1690" y="666"/>
                </a:lnTo>
                <a:lnTo>
                  <a:pt x="1698" y="664"/>
                </a:lnTo>
                <a:lnTo>
                  <a:pt x="1703" y="662"/>
                </a:lnTo>
                <a:lnTo>
                  <a:pt x="1711" y="660"/>
                </a:lnTo>
                <a:lnTo>
                  <a:pt x="1719" y="658"/>
                </a:lnTo>
                <a:lnTo>
                  <a:pt x="1725" y="656"/>
                </a:lnTo>
                <a:lnTo>
                  <a:pt x="1732" y="656"/>
                </a:lnTo>
                <a:lnTo>
                  <a:pt x="1738" y="654"/>
                </a:lnTo>
                <a:lnTo>
                  <a:pt x="1746" y="654"/>
                </a:lnTo>
                <a:lnTo>
                  <a:pt x="1753" y="652"/>
                </a:lnTo>
                <a:lnTo>
                  <a:pt x="1759" y="650"/>
                </a:lnTo>
                <a:lnTo>
                  <a:pt x="1767" y="650"/>
                </a:lnTo>
                <a:lnTo>
                  <a:pt x="1773" y="648"/>
                </a:lnTo>
                <a:lnTo>
                  <a:pt x="1780" y="646"/>
                </a:lnTo>
                <a:lnTo>
                  <a:pt x="1788" y="646"/>
                </a:lnTo>
                <a:lnTo>
                  <a:pt x="1794" y="644"/>
                </a:lnTo>
                <a:lnTo>
                  <a:pt x="1801" y="644"/>
                </a:lnTo>
                <a:lnTo>
                  <a:pt x="1807" y="643"/>
                </a:lnTo>
                <a:lnTo>
                  <a:pt x="1815" y="643"/>
                </a:lnTo>
                <a:lnTo>
                  <a:pt x="1823" y="641"/>
                </a:lnTo>
                <a:lnTo>
                  <a:pt x="1828" y="641"/>
                </a:lnTo>
                <a:lnTo>
                  <a:pt x="1836" y="639"/>
                </a:lnTo>
                <a:lnTo>
                  <a:pt x="1842" y="639"/>
                </a:lnTo>
                <a:lnTo>
                  <a:pt x="1849" y="639"/>
                </a:lnTo>
                <a:lnTo>
                  <a:pt x="1855" y="637"/>
                </a:lnTo>
                <a:lnTo>
                  <a:pt x="1863" y="637"/>
                </a:lnTo>
                <a:lnTo>
                  <a:pt x="1871" y="637"/>
                </a:lnTo>
                <a:lnTo>
                  <a:pt x="1876" y="635"/>
                </a:lnTo>
                <a:lnTo>
                  <a:pt x="1884" y="635"/>
                </a:lnTo>
                <a:lnTo>
                  <a:pt x="1890" y="635"/>
                </a:lnTo>
                <a:lnTo>
                  <a:pt x="1897" y="635"/>
                </a:lnTo>
                <a:lnTo>
                  <a:pt x="1905" y="633"/>
                </a:lnTo>
                <a:lnTo>
                  <a:pt x="1911" y="633"/>
                </a:lnTo>
                <a:lnTo>
                  <a:pt x="1919" y="633"/>
                </a:lnTo>
                <a:lnTo>
                  <a:pt x="1924" y="633"/>
                </a:lnTo>
                <a:lnTo>
                  <a:pt x="1932" y="633"/>
                </a:lnTo>
                <a:lnTo>
                  <a:pt x="1940" y="631"/>
                </a:lnTo>
                <a:lnTo>
                  <a:pt x="1945" y="631"/>
                </a:lnTo>
                <a:lnTo>
                  <a:pt x="1953" y="631"/>
                </a:lnTo>
                <a:lnTo>
                  <a:pt x="1959" y="631"/>
                </a:lnTo>
                <a:lnTo>
                  <a:pt x="1967" y="629"/>
                </a:lnTo>
                <a:lnTo>
                  <a:pt x="1972" y="629"/>
                </a:lnTo>
                <a:lnTo>
                  <a:pt x="1980" y="629"/>
                </a:lnTo>
                <a:lnTo>
                  <a:pt x="1988" y="629"/>
                </a:lnTo>
                <a:lnTo>
                  <a:pt x="1993" y="629"/>
                </a:lnTo>
                <a:lnTo>
                  <a:pt x="2001" y="629"/>
                </a:lnTo>
                <a:lnTo>
                  <a:pt x="2007" y="629"/>
                </a:lnTo>
                <a:lnTo>
                  <a:pt x="2015" y="627"/>
                </a:lnTo>
                <a:lnTo>
                  <a:pt x="2022" y="627"/>
                </a:lnTo>
                <a:lnTo>
                  <a:pt x="2028" y="627"/>
                </a:lnTo>
                <a:lnTo>
                  <a:pt x="2036" y="627"/>
                </a:lnTo>
                <a:lnTo>
                  <a:pt x="2041" y="627"/>
                </a:lnTo>
                <a:lnTo>
                  <a:pt x="2049" y="627"/>
                </a:lnTo>
                <a:lnTo>
                  <a:pt x="2057" y="627"/>
                </a:lnTo>
                <a:lnTo>
                  <a:pt x="2063" y="627"/>
                </a:lnTo>
                <a:lnTo>
                  <a:pt x="2070" y="627"/>
                </a:lnTo>
                <a:lnTo>
                  <a:pt x="2076" y="625"/>
                </a:lnTo>
                <a:lnTo>
                  <a:pt x="2084" y="625"/>
                </a:lnTo>
                <a:lnTo>
                  <a:pt x="2089" y="625"/>
                </a:lnTo>
                <a:lnTo>
                  <a:pt x="2097" y="623"/>
                </a:lnTo>
                <a:lnTo>
                  <a:pt x="2105" y="623"/>
                </a:lnTo>
                <a:lnTo>
                  <a:pt x="2111" y="621"/>
                </a:lnTo>
                <a:lnTo>
                  <a:pt x="2118" y="620"/>
                </a:lnTo>
                <a:lnTo>
                  <a:pt x="2124" y="616"/>
                </a:lnTo>
                <a:lnTo>
                  <a:pt x="2132" y="614"/>
                </a:lnTo>
                <a:lnTo>
                  <a:pt x="2139" y="612"/>
                </a:lnTo>
                <a:lnTo>
                  <a:pt x="2145" y="610"/>
                </a:lnTo>
                <a:lnTo>
                  <a:pt x="2153" y="610"/>
                </a:lnTo>
                <a:lnTo>
                  <a:pt x="2159" y="610"/>
                </a:lnTo>
                <a:lnTo>
                  <a:pt x="2166" y="610"/>
                </a:lnTo>
                <a:lnTo>
                  <a:pt x="2174" y="612"/>
                </a:lnTo>
                <a:lnTo>
                  <a:pt x="2180" y="612"/>
                </a:lnTo>
                <a:lnTo>
                  <a:pt x="2187" y="614"/>
                </a:lnTo>
                <a:lnTo>
                  <a:pt x="2193" y="614"/>
                </a:lnTo>
                <a:lnTo>
                  <a:pt x="2201" y="616"/>
                </a:lnTo>
                <a:lnTo>
                  <a:pt x="2208" y="616"/>
                </a:lnTo>
                <a:lnTo>
                  <a:pt x="2214" y="618"/>
                </a:lnTo>
                <a:lnTo>
                  <a:pt x="2222" y="618"/>
                </a:lnTo>
                <a:lnTo>
                  <a:pt x="2228" y="618"/>
                </a:lnTo>
                <a:lnTo>
                  <a:pt x="2235" y="618"/>
                </a:lnTo>
                <a:lnTo>
                  <a:pt x="2241" y="618"/>
                </a:lnTo>
                <a:lnTo>
                  <a:pt x="2249" y="618"/>
                </a:lnTo>
                <a:lnTo>
                  <a:pt x="2256" y="620"/>
                </a:lnTo>
                <a:lnTo>
                  <a:pt x="2262" y="620"/>
                </a:lnTo>
                <a:lnTo>
                  <a:pt x="2270" y="620"/>
                </a:lnTo>
                <a:lnTo>
                  <a:pt x="2276" y="620"/>
                </a:lnTo>
                <a:lnTo>
                  <a:pt x="2283" y="620"/>
                </a:lnTo>
                <a:lnTo>
                  <a:pt x="2291" y="618"/>
                </a:lnTo>
                <a:lnTo>
                  <a:pt x="2297" y="618"/>
                </a:lnTo>
                <a:lnTo>
                  <a:pt x="2304" y="618"/>
                </a:lnTo>
                <a:lnTo>
                  <a:pt x="2310" y="616"/>
                </a:lnTo>
                <a:lnTo>
                  <a:pt x="2318" y="616"/>
                </a:lnTo>
                <a:lnTo>
                  <a:pt x="2326" y="616"/>
                </a:lnTo>
                <a:lnTo>
                  <a:pt x="2331" y="614"/>
                </a:lnTo>
                <a:lnTo>
                  <a:pt x="2339" y="614"/>
                </a:lnTo>
                <a:lnTo>
                  <a:pt x="2345" y="614"/>
                </a:lnTo>
                <a:lnTo>
                  <a:pt x="2352" y="614"/>
                </a:lnTo>
                <a:lnTo>
                  <a:pt x="2358" y="614"/>
                </a:lnTo>
                <a:lnTo>
                  <a:pt x="2366" y="614"/>
                </a:lnTo>
                <a:lnTo>
                  <a:pt x="2374" y="612"/>
                </a:lnTo>
                <a:lnTo>
                  <a:pt x="2379" y="610"/>
                </a:lnTo>
                <a:lnTo>
                  <a:pt x="2387" y="606"/>
                </a:lnTo>
                <a:lnTo>
                  <a:pt x="2393" y="604"/>
                </a:lnTo>
                <a:lnTo>
                  <a:pt x="2400" y="602"/>
                </a:lnTo>
                <a:lnTo>
                  <a:pt x="2408" y="600"/>
                </a:lnTo>
                <a:lnTo>
                  <a:pt x="2414" y="598"/>
                </a:lnTo>
                <a:lnTo>
                  <a:pt x="2422" y="598"/>
                </a:lnTo>
                <a:lnTo>
                  <a:pt x="2427" y="598"/>
                </a:lnTo>
                <a:lnTo>
                  <a:pt x="2435" y="598"/>
                </a:lnTo>
                <a:lnTo>
                  <a:pt x="2443" y="600"/>
                </a:lnTo>
                <a:lnTo>
                  <a:pt x="2448" y="602"/>
                </a:lnTo>
                <a:lnTo>
                  <a:pt x="2456" y="604"/>
                </a:lnTo>
                <a:lnTo>
                  <a:pt x="2462" y="606"/>
                </a:lnTo>
                <a:lnTo>
                  <a:pt x="2470" y="606"/>
                </a:lnTo>
                <a:lnTo>
                  <a:pt x="2477" y="608"/>
                </a:lnTo>
                <a:lnTo>
                  <a:pt x="2483" y="608"/>
                </a:lnTo>
                <a:lnTo>
                  <a:pt x="2491" y="610"/>
                </a:lnTo>
                <a:lnTo>
                  <a:pt x="2496" y="610"/>
                </a:lnTo>
                <a:lnTo>
                  <a:pt x="2504" y="610"/>
                </a:lnTo>
                <a:lnTo>
                  <a:pt x="2510" y="608"/>
                </a:lnTo>
                <a:lnTo>
                  <a:pt x="2518" y="606"/>
                </a:lnTo>
                <a:lnTo>
                  <a:pt x="2525" y="604"/>
                </a:lnTo>
                <a:lnTo>
                  <a:pt x="2531" y="602"/>
                </a:lnTo>
                <a:lnTo>
                  <a:pt x="2539" y="600"/>
                </a:lnTo>
                <a:lnTo>
                  <a:pt x="2544" y="598"/>
                </a:lnTo>
                <a:lnTo>
                  <a:pt x="2552" y="598"/>
                </a:lnTo>
                <a:lnTo>
                  <a:pt x="2560" y="598"/>
                </a:lnTo>
                <a:lnTo>
                  <a:pt x="2566" y="598"/>
                </a:lnTo>
                <a:lnTo>
                  <a:pt x="2573" y="600"/>
                </a:lnTo>
                <a:lnTo>
                  <a:pt x="2579" y="602"/>
                </a:lnTo>
                <a:lnTo>
                  <a:pt x="2587" y="602"/>
                </a:lnTo>
                <a:lnTo>
                  <a:pt x="2594" y="604"/>
                </a:lnTo>
                <a:lnTo>
                  <a:pt x="2600" y="604"/>
                </a:lnTo>
                <a:lnTo>
                  <a:pt x="2608" y="606"/>
                </a:lnTo>
                <a:lnTo>
                  <a:pt x="2614" y="606"/>
                </a:lnTo>
                <a:lnTo>
                  <a:pt x="2621" y="608"/>
                </a:lnTo>
                <a:lnTo>
                  <a:pt x="2627" y="608"/>
                </a:lnTo>
                <a:lnTo>
                  <a:pt x="2635" y="608"/>
                </a:lnTo>
                <a:lnTo>
                  <a:pt x="2642" y="608"/>
                </a:lnTo>
                <a:lnTo>
                  <a:pt x="2648" y="606"/>
                </a:lnTo>
                <a:lnTo>
                  <a:pt x="2656" y="606"/>
                </a:lnTo>
                <a:lnTo>
                  <a:pt x="2662" y="606"/>
                </a:lnTo>
                <a:lnTo>
                  <a:pt x="2669" y="606"/>
                </a:lnTo>
                <a:lnTo>
                  <a:pt x="2677" y="606"/>
                </a:lnTo>
                <a:lnTo>
                  <a:pt x="2683" y="606"/>
                </a:lnTo>
                <a:lnTo>
                  <a:pt x="2690" y="606"/>
                </a:lnTo>
                <a:lnTo>
                  <a:pt x="2696" y="608"/>
                </a:lnTo>
                <a:lnTo>
                  <a:pt x="2704" y="608"/>
                </a:lnTo>
                <a:lnTo>
                  <a:pt x="2712" y="608"/>
                </a:lnTo>
                <a:lnTo>
                  <a:pt x="2717" y="608"/>
                </a:lnTo>
                <a:lnTo>
                  <a:pt x="2725" y="608"/>
                </a:lnTo>
                <a:lnTo>
                  <a:pt x="2731" y="608"/>
                </a:lnTo>
                <a:lnTo>
                  <a:pt x="2738" y="606"/>
                </a:lnTo>
                <a:lnTo>
                  <a:pt x="2744" y="606"/>
                </a:lnTo>
                <a:lnTo>
                  <a:pt x="2752" y="604"/>
                </a:lnTo>
                <a:lnTo>
                  <a:pt x="2760" y="602"/>
                </a:lnTo>
                <a:lnTo>
                  <a:pt x="2765" y="598"/>
                </a:lnTo>
                <a:lnTo>
                  <a:pt x="2773" y="595"/>
                </a:lnTo>
                <a:lnTo>
                  <a:pt x="2779" y="589"/>
                </a:lnTo>
                <a:lnTo>
                  <a:pt x="2786" y="583"/>
                </a:lnTo>
                <a:lnTo>
                  <a:pt x="2794" y="575"/>
                </a:lnTo>
                <a:lnTo>
                  <a:pt x="2800" y="570"/>
                </a:lnTo>
                <a:lnTo>
                  <a:pt x="2808" y="564"/>
                </a:lnTo>
                <a:lnTo>
                  <a:pt x="2813" y="560"/>
                </a:lnTo>
                <a:lnTo>
                  <a:pt x="2821" y="552"/>
                </a:lnTo>
                <a:lnTo>
                  <a:pt x="2829" y="545"/>
                </a:lnTo>
                <a:lnTo>
                  <a:pt x="2834" y="535"/>
                </a:lnTo>
                <a:lnTo>
                  <a:pt x="2842" y="525"/>
                </a:lnTo>
                <a:lnTo>
                  <a:pt x="2848" y="520"/>
                </a:lnTo>
                <a:lnTo>
                  <a:pt x="2856" y="518"/>
                </a:lnTo>
                <a:lnTo>
                  <a:pt x="2863" y="520"/>
                </a:lnTo>
                <a:lnTo>
                  <a:pt x="2869" y="527"/>
                </a:lnTo>
                <a:lnTo>
                  <a:pt x="2877" y="535"/>
                </a:lnTo>
                <a:lnTo>
                  <a:pt x="2882" y="541"/>
                </a:lnTo>
                <a:lnTo>
                  <a:pt x="2890" y="545"/>
                </a:lnTo>
                <a:lnTo>
                  <a:pt x="2896" y="545"/>
                </a:lnTo>
                <a:lnTo>
                  <a:pt x="2904" y="539"/>
                </a:lnTo>
                <a:lnTo>
                  <a:pt x="2911" y="531"/>
                </a:lnTo>
                <a:lnTo>
                  <a:pt x="2917" y="520"/>
                </a:lnTo>
                <a:lnTo>
                  <a:pt x="2925" y="512"/>
                </a:lnTo>
                <a:lnTo>
                  <a:pt x="2930" y="510"/>
                </a:lnTo>
                <a:lnTo>
                  <a:pt x="2938" y="510"/>
                </a:lnTo>
                <a:lnTo>
                  <a:pt x="2946" y="518"/>
                </a:lnTo>
                <a:lnTo>
                  <a:pt x="2952" y="525"/>
                </a:lnTo>
                <a:lnTo>
                  <a:pt x="2959" y="531"/>
                </a:lnTo>
                <a:lnTo>
                  <a:pt x="2965" y="533"/>
                </a:lnTo>
                <a:lnTo>
                  <a:pt x="2973" y="531"/>
                </a:lnTo>
                <a:lnTo>
                  <a:pt x="2980" y="520"/>
                </a:lnTo>
                <a:lnTo>
                  <a:pt x="2986" y="504"/>
                </a:lnTo>
                <a:lnTo>
                  <a:pt x="2994" y="489"/>
                </a:lnTo>
                <a:lnTo>
                  <a:pt x="3000" y="476"/>
                </a:lnTo>
                <a:lnTo>
                  <a:pt x="3007" y="468"/>
                </a:lnTo>
                <a:lnTo>
                  <a:pt x="3013" y="470"/>
                </a:lnTo>
                <a:lnTo>
                  <a:pt x="3021" y="479"/>
                </a:lnTo>
                <a:lnTo>
                  <a:pt x="3028" y="493"/>
                </a:lnTo>
                <a:lnTo>
                  <a:pt x="3034" y="506"/>
                </a:lnTo>
                <a:lnTo>
                  <a:pt x="3042" y="520"/>
                </a:lnTo>
                <a:lnTo>
                  <a:pt x="3048" y="531"/>
                </a:lnTo>
                <a:lnTo>
                  <a:pt x="3055" y="541"/>
                </a:lnTo>
                <a:lnTo>
                  <a:pt x="3063" y="549"/>
                </a:lnTo>
                <a:lnTo>
                  <a:pt x="3069" y="556"/>
                </a:lnTo>
                <a:lnTo>
                  <a:pt x="3076" y="562"/>
                </a:lnTo>
                <a:lnTo>
                  <a:pt x="3082" y="568"/>
                </a:lnTo>
                <a:lnTo>
                  <a:pt x="3090" y="573"/>
                </a:lnTo>
                <a:lnTo>
                  <a:pt x="3097" y="575"/>
                </a:lnTo>
                <a:lnTo>
                  <a:pt x="3103" y="579"/>
                </a:lnTo>
                <a:lnTo>
                  <a:pt x="3111" y="581"/>
                </a:lnTo>
                <a:lnTo>
                  <a:pt x="3117" y="585"/>
                </a:lnTo>
                <a:lnTo>
                  <a:pt x="3124" y="585"/>
                </a:lnTo>
                <a:lnTo>
                  <a:pt x="3132" y="587"/>
                </a:lnTo>
                <a:lnTo>
                  <a:pt x="3138" y="587"/>
                </a:lnTo>
                <a:lnTo>
                  <a:pt x="3145" y="587"/>
                </a:lnTo>
                <a:lnTo>
                  <a:pt x="3151" y="587"/>
                </a:lnTo>
                <a:lnTo>
                  <a:pt x="3159" y="585"/>
                </a:lnTo>
                <a:lnTo>
                  <a:pt x="3165" y="583"/>
                </a:lnTo>
                <a:lnTo>
                  <a:pt x="3172" y="581"/>
                </a:lnTo>
                <a:lnTo>
                  <a:pt x="3180" y="581"/>
                </a:lnTo>
                <a:lnTo>
                  <a:pt x="3186" y="579"/>
                </a:lnTo>
                <a:lnTo>
                  <a:pt x="3193" y="579"/>
                </a:lnTo>
                <a:lnTo>
                  <a:pt x="3199" y="579"/>
                </a:lnTo>
                <a:lnTo>
                  <a:pt x="3207" y="579"/>
                </a:lnTo>
                <a:lnTo>
                  <a:pt x="3215" y="579"/>
                </a:lnTo>
                <a:lnTo>
                  <a:pt x="3220" y="579"/>
                </a:lnTo>
                <a:lnTo>
                  <a:pt x="3228" y="577"/>
                </a:lnTo>
                <a:lnTo>
                  <a:pt x="3234" y="577"/>
                </a:lnTo>
                <a:lnTo>
                  <a:pt x="3241" y="573"/>
                </a:lnTo>
                <a:lnTo>
                  <a:pt x="3249" y="570"/>
                </a:lnTo>
                <a:lnTo>
                  <a:pt x="3255" y="568"/>
                </a:lnTo>
                <a:lnTo>
                  <a:pt x="3263" y="566"/>
                </a:lnTo>
                <a:lnTo>
                  <a:pt x="3268" y="566"/>
                </a:lnTo>
                <a:lnTo>
                  <a:pt x="3276" y="566"/>
                </a:lnTo>
                <a:lnTo>
                  <a:pt x="3282" y="568"/>
                </a:lnTo>
                <a:lnTo>
                  <a:pt x="3289" y="570"/>
                </a:lnTo>
                <a:lnTo>
                  <a:pt x="3297" y="572"/>
                </a:lnTo>
                <a:lnTo>
                  <a:pt x="3303" y="573"/>
                </a:lnTo>
                <a:lnTo>
                  <a:pt x="3311" y="575"/>
                </a:lnTo>
                <a:lnTo>
                  <a:pt x="3316" y="577"/>
                </a:lnTo>
                <a:lnTo>
                  <a:pt x="3324" y="579"/>
                </a:lnTo>
                <a:lnTo>
                  <a:pt x="3332" y="581"/>
                </a:lnTo>
                <a:lnTo>
                  <a:pt x="3337" y="581"/>
                </a:lnTo>
                <a:lnTo>
                  <a:pt x="3345" y="583"/>
                </a:lnTo>
                <a:lnTo>
                  <a:pt x="3351" y="585"/>
                </a:lnTo>
                <a:lnTo>
                  <a:pt x="3359" y="585"/>
                </a:lnTo>
                <a:lnTo>
                  <a:pt x="3366" y="585"/>
                </a:lnTo>
                <a:lnTo>
                  <a:pt x="3372" y="585"/>
                </a:lnTo>
                <a:lnTo>
                  <a:pt x="3380" y="585"/>
                </a:lnTo>
                <a:lnTo>
                  <a:pt x="3385" y="585"/>
                </a:lnTo>
                <a:lnTo>
                  <a:pt x="3393" y="585"/>
                </a:lnTo>
                <a:lnTo>
                  <a:pt x="3399" y="587"/>
                </a:lnTo>
                <a:lnTo>
                  <a:pt x="3407" y="585"/>
                </a:lnTo>
                <a:lnTo>
                  <a:pt x="3414" y="585"/>
                </a:lnTo>
                <a:lnTo>
                  <a:pt x="3420" y="585"/>
                </a:lnTo>
                <a:lnTo>
                  <a:pt x="3428" y="585"/>
                </a:lnTo>
                <a:lnTo>
                  <a:pt x="3433" y="583"/>
                </a:lnTo>
                <a:lnTo>
                  <a:pt x="3441" y="583"/>
                </a:lnTo>
                <a:lnTo>
                  <a:pt x="3449" y="581"/>
                </a:lnTo>
                <a:lnTo>
                  <a:pt x="3455" y="579"/>
                </a:lnTo>
                <a:lnTo>
                  <a:pt x="3462" y="579"/>
                </a:lnTo>
                <a:lnTo>
                  <a:pt x="3468" y="577"/>
                </a:lnTo>
                <a:lnTo>
                  <a:pt x="3476" y="577"/>
                </a:lnTo>
                <a:lnTo>
                  <a:pt x="3483" y="575"/>
                </a:lnTo>
                <a:lnTo>
                  <a:pt x="3489" y="575"/>
                </a:lnTo>
                <a:lnTo>
                  <a:pt x="3497" y="575"/>
                </a:lnTo>
                <a:lnTo>
                  <a:pt x="3503" y="575"/>
                </a:lnTo>
                <a:lnTo>
                  <a:pt x="3510" y="575"/>
                </a:lnTo>
                <a:lnTo>
                  <a:pt x="3518" y="575"/>
                </a:lnTo>
                <a:lnTo>
                  <a:pt x="3524" y="575"/>
                </a:lnTo>
                <a:lnTo>
                  <a:pt x="3531" y="575"/>
                </a:lnTo>
                <a:lnTo>
                  <a:pt x="3537" y="575"/>
                </a:lnTo>
                <a:lnTo>
                  <a:pt x="3545" y="575"/>
                </a:lnTo>
                <a:lnTo>
                  <a:pt x="3551" y="575"/>
                </a:lnTo>
                <a:lnTo>
                  <a:pt x="3558" y="575"/>
                </a:lnTo>
                <a:lnTo>
                  <a:pt x="3566" y="575"/>
                </a:lnTo>
                <a:lnTo>
                  <a:pt x="3572" y="575"/>
                </a:lnTo>
                <a:lnTo>
                  <a:pt x="3579" y="575"/>
                </a:lnTo>
                <a:lnTo>
                  <a:pt x="3585" y="575"/>
                </a:lnTo>
                <a:lnTo>
                  <a:pt x="3593" y="575"/>
                </a:lnTo>
                <a:lnTo>
                  <a:pt x="3601" y="573"/>
                </a:lnTo>
                <a:lnTo>
                  <a:pt x="3606" y="573"/>
                </a:lnTo>
                <a:lnTo>
                  <a:pt x="3614" y="572"/>
                </a:lnTo>
                <a:lnTo>
                  <a:pt x="3620" y="570"/>
                </a:lnTo>
                <a:lnTo>
                  <a:pt x="3627" y="568"/>
                </a:lnTo>
                <a:lnTo>
                  <a:pt x="3635" y="566"/>
                </a:lnTo>
                <a:lnTo>
                  <a:pt x="3641" y="564"/>
                </a:lnTo>
                <a:lnTo>
                  <a:pt x="3649" y="564"/>
                </a:lnTo>
                <a:lnTo>
                  <a:pt x="3654" y="564"/>
                </a:lnTo>
                <a:lnTo>
                  <a:pt x="3662" y="564"/>
                </a:lnTo>
                <a:lnTo>
                  <a:pt x="3668" y="566"/>
                </a:lnTo>
                <a:lnTo>
                  <a:pt x="3675" y="568"/>
                </a:lnTo>
                <a:lnTo>
                  <a:pt x="3683" y="570"/>
                </a:lnTo>
                <a:lnTo>
                  <a:pt x="3689" y="570"/>
                </a:lnTo>
                <a:lnTo>
                  <a:pt x="3697" y="572"/>
                </a:lnTo>
                <a:lnTo>
                  <a:pt x="3702" y="572"/>
                </a:lnTo>
                <a:lnTo>
                  <a:pt x="3710" y="572"/>
                </a:lnTo>
                <a:lnTo>
                  <a:pt x="3718" y="573"/>
                </a:lnTo>
                <a:lnTo>
                  <a:pt x="3723" y="572"/>
                </a:lnTo>
                <a:lnTo>
                  <a:pt x="3731" y="572"/>
                </a:lnTo>
                <a:lnTo>
                  <a:pt x="3737" y="570"/>
                </a:lnTo>
                <a:lnTo>
                  <a:pt x="3745" y="570"/>
                </a:lnTo>
                <a:lnTo>
                  <a:pt x="3752" y="568"/>
                </a:lnTo>
                <a:lnTo>
                  <a:pt x="3758" y="566"/>
                </a:lnTo>
                <a:lnTo>
                  <a:pt x="3766" y="566"/>
                </a:lnTo>
                <a:lnTo>
                  <a:pt x="3771" y="564"/>
                </a:lnTo>
                <a:lnTo>
                  <a:pt x="3779" y="564"/>
                </a:lnTo>
                <a:lnTo>
                  <a:pt x="3785" y="564"/>
                </a:lnTo>
                <a:lnTo>
                  <a:pt x="3793" y="564"/>
                </a:lnTo>
                <a:lnTo>
                  <a:pt x="3800" y="562"/>
                </a:lnTo>
                <a:lnTo>
                  <a:pt x="3806" y="562"/>
                </a:lnTo>
                <a:lnTo>
                  <a:pt x="3814" y="562"/>
                </a:lnTo>
                <a:lnTo>
                  <a:pt x="3819" y="562"/>
                </a:lnTo>
                <a:lnTo>
                  <a:pt x="3827" y="562"/>
                </a:lnTo>
                <a:lnTo>
                  <a:pt x="3835" y="562"/>
                </a:lnTo>
                <a:lnTo>
                  <a:pt x="3841" y="562"/>
                </a:lnTo>
                <a:lnTo>
                  <a:pt x="3848" y="562"/>
                </a:lnTo>
                <a:lnTo>
                  <a:pt x="3854" y="562"/>
                </a:lnTo>
                <a:lnTo>
                  <a:pt x="3862" y="562"/>
                </a:lnTo>
                <a:lnTo>
                  <a:pt x="3869" y="562"/>
                </a:lnTo>
                <a:lnTo>
                  <a:pt x="3875" y="562"/>
                </a:lnTo>
                <a:lnTo>
                  <a:pt x="3883" y="562"/>
                </a:lnTo>
                <a:lnTo>
                  <a:pt x="3889" y="562"/>
                </a:lnTo>
                <a:lnTo>
                  <a:pt x="3896" y="560"/>
                </a:lnTo>
                <a:lnTo>
                  <a:pt x="3904" y="560"/>
                </a:lnTo>
                <a:lnTo>
                  <a:pt x="3910" y="560"/>
                </a:lnTo>
                <a:lnTo>
                  <a:pt x="3917" y="560"/>
                </a:lnTo>
                <a:lnTo>
                  <a:pt x="3923" y="560"/>
                </a:lnTo>
                <a:lnTo>
                  <a:pt x="3931" y="558"/>
                </a:lnTo>
                <a:lnTo>
                  <a:pt x="3937" y="558"/>
                </a:lnTo>
                <a:lnTo>
                  <a:pt x="3944" y="558"/>
                </a:lnTo>
                <a:lnTo>
                  <a:pt x="3952" y="558"/>
                </a:lnTo>
                <a:lnTo>
                  <a:pt x="3958" y="558"/>
                </a:lnTo>
                <a:lnTo>
                  <a:pt x="3965" y="558"/>
                </a:lnTo>
                <a:lnTo>
                  <a:pt x="3971" y="558"/>
                </a:lnTo>
                <a:lnTo>
                  <a:pt x="3979" y="558"/>
                </a:lnTo>
                <a:lnTo>
                  <a:pt x="3986" y="558"/>
                </a:lnTo>
                <a:lnTo>
                  <a:pt x="3992" y="556"/>
                </a:lnTo>
                <a:lnTo>
                  <a:pt x="4000" y="556"/>
                </a:lnTo>
                <a:lnTo>
                  <a:pt x="4006" y="556"/>
                </a:lnTo>
                <a:lnTo>
                  <a:pt x="4013" y="554"/>
                </a:lnTo>
                <a:lnTo>
                  <a:pt x="4021" y="552"/>
                </a:lnTo>
                <a:lnTo>
                  <a:pt x="4027" y="552"/>
                </a:lnTo>
                <a:lnTo>
                  <a:pt x="4034" y="550"/>
                </a:lnTo>
                <a:lnTo>
                  <a:pt x="4040" y="549"/>
                </a:lnTo>
                <a:lnTo>
                  <a:pt x="4048" y="547"/>
                </a:lnTo>
                <a:lnTo>
                  <a:pt x="4054" y="543"/>
                </a:lnTo>
                <a:lnTo>
                  <a:pt x="4061" y="541"/>
                </a:lnTo>
                <a:lnTo>
                  <a:pt x="4069" y="539"/>
                </a:lnTo>
                <a:lnTo>
                  <a:pt x="4075" y="537"/>
                </a:lnTo>
                <a:lnTo>
                  <a:pt x="4082" y="535"/>
                </a:lnTo>
                <a:lnTo>
                  <a:pt x="4088" y="533"/>
                </a:lnTo>
                <a:lnTo>
                  <a:pt x="4096" y="533"/>
                </a:lnTo>
                <a:lnTo>
                  <a:pt x="4104" y="533"/>
                </a:lnTo>
                <a:lnTo>
                  <a:pt x="4109" y="533"/>
                </a:lnTo>
                <a:lnTo>
                  <a:pt x="4117" y="535"/>
                </a:lnTo>
                <a:lnTo>
                  <a:pt x="4123" y="537"/>
                </a:lnTo>
                <a:lnTo>
                  <a:pt x="4130" y="537"/>
                </a:lnTo>
                <a:lnTo>
                  <a:pt x="4138" y="539"/>
                </a:lnTo>
                <a:lnTo>
                  <a:pt x="4144" y="541"/>
                </a:lnTo>
                <a:lnTo>
                  <a:pt x="4152" y="541"/>
                </a:lnTo>
                <a:lnTo>
                  <a:pt x="4157" y="543"/>
                </a:lnTo>
                <a:lnTo>
                  <a:pt x="4165" y="543"/>
                </a:lnTo>
                <a:lnTo>
                  <a:pt x="4173" y="543"/>
                </a:lnTo>
                <a:lnTo>
                  <a:pt x="4178" y="543"/>
                </a:lnTo>
                <a:lnTo>
                  <a:pt x="4186" y="543"/>
                </a:lnTo>
                <a:lnTo>
                  <a:pt x="4192" y="543"/>
                </a:lnTo>
                <a:lnTo>
                  <a:pt x="4200" y="543"/>
                </a:lnTo>
                <a:lnTo>
                  <a:pt x="4205" y="543"/>
                </a:lnTo>
                <a:lnTo>
                  <a:pt x="4213" y="543"/>
                </a:lnTo>
                <a:lnTo>
                  <a:pt x="4221" y="541"/>
                </a:lnTo>
                <a:lnTo>
                  <a:pt x="4226" y="541"/>
                </a:lnTo>
                <a:lnTo>
                  <a:pt x="4234" y="539"/>
                </a:lnTo>
                <a:lnTo>
                  <a:pt x="4240" y="537"/>
                </a:lnTo>
                <a:lnTo>
                  <a:pt x="4248" y="537"/>
                </a:lnTo>
                <a:lnTo>
                  <a:pt x="4255" y="535"/>
                </a:lnTo>
                <a:lnTo>
                  <a:pt x="4261" y="535"/>
                </a:lnTo>
                <a:lnTo>
                  <a:pt x="4269" y="535"/>
                </a:lnTo>
                <a:lnTo>
                  <a:pt x="4275" y="535"/>
                </a:lnTo>
                <a:lnTo>
                  <a:pt x="4282" y="535"/>
                </a:lnTo>
                <a:lnTo>
                  <a:pt x="4290" y="535"/>
                </a:lnTo>
                <a:lnTo>
                  <a:pt x="4296" y="535"/>
                </a:lnTo>
                <a:lnTo>
                  <a:pt x="4303" y="535"/>
                </a:lnTo>
                <a:lnTo>
                  <a:pt x="4309" y="537"/>
                </a:lnTo>
                <a:lnTo>
                  <a:pt x="4317" y="537"/>
                </a:lnTo>
                <a:lnTo>
                  <a:pt x="4323" y="537"/>
                </a:lnTo>
                <a:lnTo>
                  <a:pt x="4330" y="537"/>
                </a:lnTo>
                <a:lnTo>
                  <a:pt x="4338" y="535"/>
                </a:lnTo>
                <a:lnTo>
                  <a:pt x="4344" y="533"/>
                </a:lnTo>
                <a:lnTo>
                  <a:pt x="4351" y="529"/>
                </a:lnTo>
                <a:lnTo>
                  <a:pt x="4357" y="524"/>
                </a:lnTo>
                <a:lnTo>
                  <a:pt x="4365" y="518"/>
                </a:lnTo>
                <a:lnTo>
                  <a:pt x="4372" y="512"/>
                </a:lnTo>
                <a:lnTo>
                  <a:pt x="4378" y="510"/>
                </a:lnTo>
                <a:lnTo>
                  <a:pt x="4386" y="508"/>
                </a:lnTo>
                <a:lnTo>
                  <a:pt x="4392" y="510"/>
                </a:lnTo>
                <a:lnTo>
                  <a:pt x="4399" y="512"/>
                </a:lnTo>
                <a:lnTo>
                  <a:pt x="4407" y="516"/>
                </a:lnTo>
                <a:lnTo>
                  <a:pt x="4413" y="518"/>
                </a:lnTo>
                <a:lnTo>
                  <a:pt x="4420" y="522"/>
                </a:lnTo>
                <a:lnTo>
                  <a:pt x="4426" y="524"/>
                </a:lnTo>
                <a:lnTo>
                  <a:pt x="4434" y="524"/>
                </a:lnTo>
                <a:lnTo>
                  <a:pt x="4440" y="524"/>
                </a:lnTo>
                <a:lnTo>
                  <a:pt x="4447" y="524"/>
                </a:lnTo>
                <a:lnTo>
                  <a:pt x="4455" y="524"/>
                </a:lnTo>
                <a:lnTo>
                  <a:pt x="4461" y="522"/>
                </a:lnTo>
                <a:lnTo>
                  <a:pt x="4468" y="522"/>
                </a:lnTo>
                <a:lnTo>
                  <a:pt x="4474" y="520"/>
                </a:lnTo>
                <a:lnTo>
                  <a:pt x="4482" y="518"/>
                </a:lnTo>
                <a:lnTo>
                  <a:pt x="4490" y="518"/>
                </a:lnTo>
                <a:lnTo>
                  <a:pt x="4495" y="518"/>
                </a:lnTo>
                <a:lnTo>
                  <a:pt x="4503" y="518"/>
                </a:lnTo>
                <a:lnTo>
                  <a:pt x="4509" y="518"/>
                </a:lnTo>
                <a:lnTo>
                  <a:pt x="4516" y="520"/>
                </a:lnTo>
                <a:lnTo>
                  <a:pt x="4524" y="520"/>
                </a:lnTo>
                <a:lnTo>
                  <a:pt x="4530" y="520"/>
                </a:lnTo>
                <a:lnTo>
                  <a:pt x="4538" y="522"/>
                </a:lnTo>
                <a:lnTo>
                  <a:pt x="4543" y="522"/>
                </a:lnTo>
                <a:lnTo>
                  <a:pt x="4551" y="524"/>
                </a:lnTo>
                <a:lnTo>
                  <a:pt x="4559" y="524"/>
                </a:lnTo>
                <a:lnTo>
                  <a:pt x="4564" y="524"/>
                </a:lnTo>
                <a:lnTo>
                  <a:pt x="4572" y="524"/>
                </a:lnTo>
                <a:lnTo>
                  <a:pt x="4578" y="524"/>
                </a:lnTo>
                <a:lnTo>
                  <a:pt x="4586" y="524"/>
                </a:lnTo>
                <a:lnTo>
                  <a:pt x="4591" y="524"/>
                </a:lnTo>
                <a:lnTo>
                  <a:pt x="4599" y="524"/>
                </a:lnTo>
                <a:lnTo>
                  <a:pt x="4607" y="524"/>
                </a:lnTo>
                <a:lnTo>
                  <a:pt x="4612" y="524"/>
                </a:lnTo>
                <a:lnTo>
                  <a:pt x="4620" y="522"/>
                </a:lnTo>
                <a:lnTo>
                  <a:pt x="4626" y="520"/>
                </a:lnTo>
                <a:lnTo>
                  <a:pt x="4634" y="516"/>
                </a:lnTo>
                <a:lnTo>
                  <a:pt x="4641" y="508"/>
                </a:lnTo>
                <a:lnTo>
                  <a:pt x="4647" y="501"/>
                </a:lnTo>
                <a:lnTo>
                  <a:pt x="4655" y="495"/>
                </a:lnTo>
                <a:lnTo>
                  <a:pt x="4660" y="489"/>
                </a:lnTo>
                <a:lnTo>
                  <a:pt x="4668" y="487"/>
                </a:lnTo>
                <a:lnTo>
                  <a:pt x="4676" y="487"/>
                </a:lnTo>
                <a:lnTo>
                  <a:pt x="4682" y="491"/>
                </a:lnTo>
                <a:lnTo>
                  <a:pt x="4689" y="495"/>
                </a:lnTo>
                <a:lnTo>
                  <a:pt x="4695" y="499"/>
                </a:lnTo>
                <a:lnTo>
                  <a:pt x="4703" y="502"/>
                </a:lnTo>
                <a:lnTo>
                  <a:pt x="4708" y="506"/>
                </a:lnTo>
                <a:lnTo>
                  <a:pt x="4716" y="508"/>
                </a:lnTo>
                <a:lnTo>
                  <a:pt x="4724" y="512"/>
                </a:lnTo>
                <a:lnTo>
                  <a:pt x="4730" y="514"/>
                </a:lnTo>
                <a:lnTo>
                  <a:pt x="4737" y="514"/>
                </a:lnTo>
                <a:lnTo>
                  <a:pt x="4743" y="516"/>
                </a:lnTo>
                <a:lnTo>
                  <a:pt x="4751" y="516"/>
                </a:lnTo>
                <a:lnTo>
                  <a:pt x="4758" y="516"/>
                </a:lnTo>
                <a:lnTo>
                  <a:pt x="4764" y="516"/>
                </a:lnTo>
                <a:lnTo>
                  <a:pt x="4772" y="516"/>
                </a:lnTo>
                <a:lnTo>
                  <a:pt x="4778" y="514"/>
                </a:lnTo>
                <a:lnTo>
                  <a:pt x="4785" y="514"/>
                </a:lnTo>
                <a:lnTo>
                  <a:pt x="4793" y="512"/>
                </a:lnTo>
                <a:lnTo>
                  <a:pt x="4799" y="512"/>
                </a:lnTo>
                <a:lnTo>
                  <a:pt x="4806" y="510"/>
                </a:lnTo>
                <a:lnTo>
                  <a:pt x="4812" y="510"/>
                </a:lnTo>
                <a:lnTo>
                  <a:pt x="4820" y="510"/>
                </a:lnTo>
                <a:lnTo>
                  <a:pt x="4827" y="510"/>
                </a:lnTo>
                <a:lnTo>
                  <a:pt x="4833" y="510"/>
                </a:lnTo>
                <a:lnTo>
                  <a:pt x="4841" y="510"/>
                </a:lnTo>
                <a:lnTo>
                  <a:pt x="4847" y="512"/>
                </a:lnTo>
                <a:lnTo>
                  <a:pt x="4854" y="512"/>
                </a:lnTo>
                <a:lnTo>
                  <a:pt x="4860" y="510"/>
                </a:lnTo>
                <a:lnTo>
                  <a:pt x="4868" y="512"/>
                </a:lnTo>
                <a:lnTo>
                  <a:pt x="4875" y="512"/>
                </a:lnTo>
                <a:lnTo>
                  <a:pt x="4881" y="510"/>
                </a:lnTo>
                <a:lnTo>
                  <a:pt x="4889" y="512"/>
                </a:lnTo>
                <a:lnTo>
                  <a:pt x="4895" y="512"/>
                </a:lnTo>
                <a:lnTo>
                  <a:pt x="4902" y="512"/>
                </a:lnTo>
                <a:lnTo>
                  <a:pt x="4910" y="512"/>
                </a:lnTo>
                <a:lnTo>
                  <a:pt x="4916" y="512"/>
                </a:lnTo>
                <a:lnTo>
                  <a:pt x="4924" y="510"/>
                </a:lnTo>
                <a:lnTo>
                  <a:pt x="4929" y="510"/>
                </a:lnTo>
                <a:lnTo>
                  <a:pt x="4937" y="510"/>
                </a:lnTo>
                <a:lnTo>
                  <a:pt x="4945" y="508"/>
                </a:lnTo>
                <a:lnTo>
                  <a:pt x="4950" y="508"/>
                </a:lnTo>
                <a:lnTo>
                  <a:pt x="4958" y="508"/>
                </a:lnTo>
                <a:lnTo>
                  <a:pt x="4964" y="508"/>
                </a:lnTo>
                <a:lnTo>
                  <a:pt x="4972" y="506"/>
                </a:lnTo>
                <a:lnTo>
                  <a:pt x="4977" y="506"/>
                </a:lnTo>
                <a:lnTo>
                  <a:pt x="4985" y="506"/>
                </a:lnTo>
                <a:lnTo>
                  <a:pt x="4993" y="506"/>
                </a:lnTo>
                <a:lnTo>
                  <a:pt x="4998" y="504"/>
                </a:lnTo>
                <a:lnTo>
                  <a:pt x="5006" y="504"/>
                </a:lnTo>
                <a:lnTo>
                  <a:pt x="5012" y="504"/>
                </a:lnTo>
                <a:lnTo>
                  <a:pt x="5020" y="502"/>
                </a:lnTo>
                <a:lnTo>
                  <a:pt x="5027" y="502"/>
                </a:lnTo>
                <a:lnTo>
                  <a:pt x="5033" y="501"/>
                </a:lnTo>
                <a:lnTo>
                  <a:pt x="5041" y="501"/>
                </a:lnTo>
                <a:lnTo>
                  <a:pt x="5046" y="501"/>
                </a:lnTo>
                <a:lnTo>
                  <a:pt x="5054" y="499"/>
                </a:lnTo>
                <a:lnTo>
                  <a:pt x="5062" y="497"/>
                </a:lnTo>
                <a:lnTo>
                  <a:pt x="5068" y="495"/>
                </a:lnTo>
                <a:lnTo>
                  <a:pt x="5075" y="491"/>
                </a:lnTo>
                <a:lnTo>
                  <a:pt x="5081" y="487"/>
                </a:lnTo>
                <a:lnTo>
                  <a:pt x="5089" y="479"/>
                </a:lnTo>
                <a:lnTo>
                  <a:pt x="5094" y="472"/>
                </a:lnTo>
                <a:lnTo>
                  <a:pt x="5102" y="466"/>
                </a:lnTo>
                <a:lnTo>
                  <a:pt x="5110" y="458"/>
                </a:lnTo>
                <a:lnTo>
                  <a:pt x="5116" y="456"/>
                </a:lnTo>
                <a:lnTo>
                  <a:pt x="5123" y="454"/>
                </a:lnTo>
                <a:lnTo>
                  <a:pt x="5129" y="454"/>
                </a:lnTo>
                <a:lnTo>
                  <a:pt x="5137" y="456"/>
                </a:lnTo>
                <a:lnTo>
                  <a:pt x="5144" y="458"/>
                </a:lnTo>
                <a:lnTo>
                  <a:pt x="5150" y="460"/>
                </a:lnTo>
                <a:lnTo>
                  <a:pt x="5158" y="462"/>
                </a:lnTo>
                <a:lnTo>
                  <a:pt x="5164" y="464"/>
                </a:lnTo>
                <a:lnTo>
                  <a:pt x="5171" y="466"/>
                </a:lnTo>
                <a:lnTo>
                  <a:pt x="5179" y="468"/>
                </a:lnTo>
                <a:lnTo>
                  <a:pt x="5185" y="470"/>
                </a:lnTo>
                <a:lnTo>
                  <a:pt x="5192" y="470"/>
                </a:lnTo>
                <a:lnTo>
                  <a:pt x="5198" y="472"/>
                </a:lnTo>
                <a:lnTo>
                  <a:pt x="5206" y="474"/>
                </a:lnTo>
                <a:lnTo>
                  <a:pt x="5213" y="476"/>
                </a:lnTo>
                <a:lnTo>
                  <a:pt x="5219" y="478"/>
                </a:lnTo>
                <a:lnTo>
                  <a:pt x="5227" y="478"/>
                </a:lnTo>
                <a:lnTo>
                  <a:pt x="5233" y="479"/>
                </a:lnTo>
                <a:lnTo>
                  <a:pt x="5240" y="479"/>
                </a:lnTo>
                <a:lnTo>
                  <a:pt x="5246" y="479"/>
                </a:lnTo>
                <a:lnTo>
                  <a:pt x="5254" y="479"/>
                </a:lnTo>
                <a:lnTo>
                  <a:pt x="5261" y="479"/>
                </a:lnTo>
                <a:lnTo>
                  <a:pt x="5267" y="479"/>
                </a:lnTo>
                <a:lnTo>
                  <a:pt x="5275" y="479"/>
                </a:lnTo>
                <a:lnTo>
                  <a:pt x="5281" y="479"/>
                </a:lnTo>
                <a:lnTo>
                  <a:pt x="5288" y="479"/>
                </a:lnTo>
                <a:lnTo>
                  <a:pt x="5296" y="479"/>
                </a:lnTo>
                <a:lnTo>
                  <a:pt x="5302" y="479"/>
                </a:lnTo>
                <a:lnTo>
                  <a:pt x="5309" y="479"/>
                </a:lnTo>
                <a:lnTo>
                  <a:pt x="5315" y="479"/>
                </a:lnTo>
                <a:lnTo>
                  <a:pt x="5323" y="479"/>
                </a:lnTo>
                <a:lnTo>
                  <a:pt x="5331" y="479"/>
                </a:lnTo>
                <a:lnTo>
                  <a:pt x="5336" y="478"/>
                </a:lnTo>
                <a:lnTo>
                  <a:pt x="5344" y="476"/>
                </a:lnTo>
                <a:lnTo>
                  <a:pt x="5350" y="474"/>
                </a:lnTo>
                <a:lnTo>
                  <a:pt x="5357" y="472"/>
                </a:lnTo>
                <a:lnTo>
                  <a:pt x="5363" y="470"/>
                </a:lnTo>
                <a:lnTo>
                  <a:pt x="5371" y="468"/>
                </a:lnTo>
                <a:lnTo>
                  <a:pt x="5379" y="466"/>
                </a:lnTo>
                <a:lnTo>
                  <a:pt x="5384" y="464"/>
                </a:lnTo>
                <a:lnTo>
                  <a:pt x="5392" y="464"/>
                </a:lnTo>
                <a:lnTo>
                  <a:pt x="5398" y="464"/>
                </a:lnTo>
                <a:lnTo>
                  <a:pt x="5405" y="466"/>
                </a:lnTo>
                <a:lnTo>
                  <a:pt x="5413" y="466"/>
                </a:lnTo>
                <a:lnTo>
                  <a:pt x="5419" y="466"/>
                </a:lnTo>
                <a:lnTo>
                  <a:pt x="5427" y="466"/>
                </a:lnTo>
                <a:lnTo>
                  <a:pt x="5432" y="466"/>
                </a:lnTo>
                <a:lnTo>
                  <a:pt x="5440" y="468"/>
                </a:lnTo>
                <a:lnTo>
                  <a:pt x="5448" y="468"/>
                </a:lnTo>
                <a:lnTo>
                  <a:pt x="5453" y="468"/>
                </a:lnTo>
                <a:lnTo>
                  <a:pt x="5461" y="468"/>
                </a:lnTo>
                <a:lnTo>
                  <a:pt x="5467" y="468"/>
                </a:lnTo>
                <a:lnTo>
                  <a:pt x="5475" y="466"/>
                </a:lnTo>
                <a:lnTo>
                  <a:pt x="5480" y="466"/>
                </a:lnTo>
                <a:lnTo>
                  <a:pt x="5488" y="466"/>
                </a:lnTo>
                <a:lnTo>
                  <a:pt x="5496" y="466"/>
                </a:lnTo>
                <a:lnTo>
                  <a:pt x="5501" y="464"/>
                </a:lnTo>
                <a:lnTo>
                  <a:pt x="5509" y="462"/>
                </a:lnTo>
                <a:lnTo>
                  <a:pt x="5515" y="462"/>
                </a:lnTo>
                <a:lnTo>
                  <a:pt x="5523" y="460"/>
                </a:lnTo>
                <a:lnTo>
                  <a:pt x="5530" y="458"/>
                </a:lnTo>
                <a:lnTo>
                  <a:pt x="5536" y="456"/>
                </a:lnTo>
                <a:lnTo>
                  <a:pt x="5544" y="456"/>
                </a:lnTo>
                <a:lnTo>
                  <a:pt x="5549" y="454"/>
                </a:lnTo>
                <a:lnTo>
                  <a:pt x="5557" y="454"/>
                </a:lnTo>
                <a:lnTo>
                  <a:pt x="5565" y="454"/>
                </a:lnTo>
                <a:lnTo>
                  <a:pt x="5571" y="454"/>
                </a:lnTo>
                <a:lnTo>
                  <a:pt x="5578" y="454"/>
                </a:lnTo>
                <a:lnTo>
                  <a:pt x="5584" y="454"/>
                </a:lnTo>
                <a:lnTo>
                  <a:pt x="5592" y="454"/>
                </a:lnTo>
                <a:lnTo>
                  <a:pt x="5599" y="454"/>
                </a:lnTo>
                <a:lnTo>
                  <a:pt x="5605" y="454"/>
                </a:lnTo>
                <a:lnTo>
                  <a:pt x="5613" y="453"/>
                </a:lnTo>
                <a:lnTo>
                  <a:pt x="5619" y="453"/>
                </a:lnTo>
                <a:lnTo>
                  <a:pt x="5626" y="451"/>
                </a:lnTo>
                <a:lnTo>
                  <a:pt x="5632" y="449"/>
                </a:lnTo>
                <a:lnTo>
                  <a:pt x="5640" y="449"/>
                </a:lnTo>
                <a:lnTo>
                  <a:pt x="5647" y="447"/>
                </a:lnTo>
                <a:lnTo>
                  <a:pt x="5653" y="445"/>
                </a:lnTo>
                <a:lnTo>
                  <a:pt x="5661" y="445"/>
                </a:lnTo>
                <a:lnTo>
                  <a:pt x="5667" y="443"/>
                </a:lnTo>
                <a:lnTo>
                  <a:pt x="5674" y="443"/>
                </a:lnTo>
                <a:lnTo>
                  <a:pt x="5682" y="441"/>
                </a:lnTo>
                <a:lnTo>
                  <a:pt x="5688" y="441"/>
                </a:lnTo>
                <a:lnTo>
                  <a:pt x="5695" y="439"/>
                </a:lnTo>
                <a:lnTo>
                  <a:pt x="5701" y="437"/>
                </a:lnTo>
                <a:lnTo>
                  <a:pt x="5709" y="435"/>
                </a:lnTo>
                <a:lnTo>
                  <a:pt x="5717" y="435"/>
                </a:lnTo>
                <a:lnTo>
                  <a:pt x="5722" y="433"/>
                </a:lnTo>
                <a:lnTo>
                  <a:pt x="5730" y="431"/>
                </a:lnTo>
                <a:lnTo>
                  <a:pt x="5736" y="431"/>
                </a:lnTo>
                <a:lnTo>
                  <a:pt x="5743" y="430"/>
                </a:lnTo>
                <a:lnTo>
                  <a:pt x="5749" y="428"/>
                </a:lnTo>
                <a:lnTo>
                  <a:pt x="5757" y="428"/>
                </a:lnTo>
                <a:lnTo>
                  <a:pt x="5765" y="426"/>
                </a:lnTo>
                <a:lnTo>
                  <a:pt x="5770" y="426"/>
                </a:lnTo>
                <a:lnTo>
                  <a:pt x="5778" y="426"/>
                </a:lnTo>
                <a:lnTo>
                  <a:pt x="5784" y="426"/>
                </a:lnTo>
                <a:lnTo>
                  <a:pt x="5791" y="426"/>
                </a:lnTo>
                <a:lnTo>
                  <a:pt x="5799" y="426"/>
                </a:lnTo>
                <a:lnTo>
                  <a:pt x="5805" y="426"/>
                </a:lnTo>
                <a:lnTo>
                  <a:pt x="5813" y="426"/>
                </a:lnTo>
                <a:lnTo>
                  <a:pt x="5818" y="426"/>
                </a:lnTo>
                <a:lnTo>
                  <a:pt x="5826" y="426"/>
                </a:lnTo>
                <a:lnTo>
                  <a:pt x="5834" y="426"/>
                </a:lnTo>
                <a:lnTo>
                  <a:pt x="5839" y="426"/>
                </a:lnTo>
                <a:lnTo>
                  <a:pt x="5847" y="426"/>
                </a:lnTo>
                <a:lnTo>
                  <a:pt x="5853" y="426"/>
                </a:lnTo>
                <a:lnTo>
                  <a:pt x="5861" y="426"/>
                </a:lnTo>
                <a:lnTo>
                  <a:pt x="5868" y="426"/>
                </a:lnTo>
                <a:lnTo>
                  <a:pt x="5874" y="426"/>
                </a:lnTo>
                <a:lnTo>
                  <a:pt x="5882" y="426"/>
                </a:lnTo>
                <a:lnTo>
                  <a:pt x="5887" y="426"/>
                </a:lnTo>
                <a:lnTo>
                  <a:pt x="5895" y="424"/>
                </a:lnTo>
                <a:lnTo>
                  <a:pt x="5901" y="424"/>
                </a:lnTo>
                <a:lnTo>
                  <a:pt x="5909" y="422"/>
                </a:lnTo>
                <a:lnTo>
                  <a:pt x="5916" y="418"/>
                </a:lnTo>
                <a:lnTo>
                  <a:pt x="5922" y="412"/>
                </a:lnTo>
                <a:lnTo>
                  <a:pt x="5930" y="405"/>
                </a:lnTo>
                <a:lnTo>
                  <a:pt x="5935" y="391"/>
                </a:lnTo>
                <a:lnTo>
                  <a:pt x="5943" y="376"/>
                </a:lnTo>
                <a:lnTo>
                  <a:pt x="5951" y="359"/>
                </a:lnTo>
                <a:lnTo>
                  <a:pt x="5957" y="341"/>
                </a:lnTo>
                <a:lnTo>
                  <a:pt x="5964" y="322"/>
                </a:lnTo>
                <a:lnTo>
                  <a:pt x="5970" y="309"/>
                </a:lnTo>
                <a:lnTo>
                  <a:pt x="5978" y="297"/>
                </a:lnTo>
                <a:lnTo>
                  <a:pt x="5985" y="289"/>
                </a:lnTo>
                <a:lnTo>
                  <a:pt x="5991" y="284"/>
                </a:lnTo>
                <a:lnTo>
                  <a:pt x="5999" y="284"/>
                </a:lnTo>
                <a:lnTo>
                  <a:pt x="6005" y="284"/>
                </a:lnTo>
                <a:lnTo>
                  <a:pt x="6012" y="286"/>
                </a:lnTo>
                <a:lnTo>
                  <a:pt x="6018" y="288"/>
                </a:lnTo>
                <a:lnTo>
                  <a:pt x="6026" y="291"/>
                </a:lnTo>
                <a:lnTo>
                  <a:pt x="6033" y="295"/>
                </a:lnTo>
                <a:lnTo>
                  <a:pt x="6039" y="299"/>
                </a:lnTo>
                <a:lnTo>
                  <a:pt x="6047" y="303"/>
                </a:lnTo>
                <a:lnTo>
                  <a:pt x="6053" y="305"/>
                </a:lnTo>
                <a:lnTo>
                  <a:pt x="6060" y="309"/>
                </a:lnTo>
                <a:lnTo>
                  <a:pt x="6068" y="311"/>
                </a:lnTo>
                <a:lnTo>
                  <a:pt x="6074" y="312"/>
                </a:lnTo>
                <a:lnTo>
                  <a:pt x="6081" y="312"/>
                </a:lnTo>
                <a:lnTo>
                  <a:pt x="6087" y="312"/>
                </a:lnTo>
                <a:lnTo>
                  <a:pt x="6095" y="312"/>
                </a:lnTo>
                <a:lnTo>
                  <a:pt x="6102" y="311"/>
                </a:lnTo>
                <a:lnTo>
                  <a:pt x="6108" y="311"/>
                </a:lnTo>
                <a:lnTo>
                  <a:pt x="6116" y="311"/>
                </a:lnTo>
                <a:lnTo>
                  <a:pt x="6122" y="312"/>
                </a:lnTo>
                <a:lnTo>
                  <a:pt x="6129" y="314"/>
                </a:lnTo>
                <a:lnTo>
                  <a:pt x="6135" y="316"/>
                </a:lnTo>
                <a:lnTo>
                  <a:pt x="6143" y="318"/>
                </a:lnTo>
                <a:lnTo>
                  <a:pt x="6150" y="320"/>
                </a:lnTo>
                <a:lnTo>
                  <a:pt x="6156" y="320"/>
                </a:lnTo>
                <a:lnTo>
                  <a:pt x="6164" y="320"/>
                </a:lnTo>
                <a:lnTo>
                  <a:pt x="6170" y="322"/>
                </a:lnTo>
                <a:lnTo>
                  <a:pt x="6177" y="320"/>
                </a:lnTo>
                <a:lnTo>
                  <a:pt x="6185" y="320"/>
                </a:lnTo>
                <a:lnTo>
                  <a:pt x="6191" y="318"/>
                </a:lnTo>
                <a:lnTo>
                  <a:pt x="6198" y="314"/>
                </a:lnTo>
                <a:lnTo>
                  <a:pt x="6204" y="311"/>
                </a:lnTo>
                <a:lnTo>
                  <a:pt x="6212" y="303"/>
                </a:lnTo>
                <a:lnTo>
                  <a:pt x="6220" y="291"/>
                </a:lnTo>
                <a:lnTo>
                  <a:pt x="6225" y="278"/>
                </a:lnTo>
                <a:lnTo>
                  <a:pt x="6233" y="261"/>
                </a:lnTo>
                <a:lnTo>
                  <a:pt x="6239" y="240"/>
                </a:lnTo>
                <a:lnTo>
                  <a:pt x="6246" y="213"/>
                </a:lnTo>
                <a:lnTo>
                  <a:pt x="6254" y="184"/>
                </a:lnTo>
                <a:lnTo>
                  <a:pt x="6260" y="155"/>
                </a:lnTo>
                <a:lnTo>
                  <a:pt x="6268" y="124"/>
                </a:lnTo>
                <a:lnTo>
                  <a:pt x="6273" y="96"/>
                </a:lnTo>
                <a:lnTo>
                  <a:pt x="6281" y="71"/>
                </a:lnTo>
                <a:lnTo>
                  <a:pt x="6287" y="48"/>
                </a:lnTo>
                <a:lnTo>
                  <a:pt x="6294" y="30"/>
                </a:lnTo>
                <a:lnTo>
                  <a:pt x="6302" y="17"/>
                </a:lnTo>
                <a:lnTo>
                  <a:pt x="6308" y="7"/>
                </a:lnTo>
                <a:lnTo>
                  <a:pt x="6316" y="2"/>
                </a:lnTo>
                <a:lnTo>
                  <a:pt x="6321" y="0"/>
                </a:lnTo>
                <a:lnTo>
                  <a:pt x="6329" y="2"/>
                </a:lnTo>
                <a:lnTo>
                  <a:pt x="6337" y="7"/>
                </a:lnTo>
                <a:lnTo>
                  <a:pt x="6342" y="15"/>
                </a:lnTo>
                <a:lnTo>
                  <a:pt x="6350" y="25"/>
                </a:lnTo>
                <a:lnTo>
                  <a:pt x="6356" y="34"/>
                </a:lnTo>
                <a:lnTo>
                  <a:pt x="6364" y="46"/>
                </a:lnTo>
                <a:lnTo>
                  <a:pt x="6371" y="57"/>
                </a:lnTo>
                <a:lnTo>
                  <a:pt x="6377" y="69"/>
                </a:lnTo>
                <a:lnTo>
                  <a:pt x="6385" y="80"/>
                </a:lnTo>
                <a:lnTo>
                  <a:pt x="6390" y="92"/>
                </a:lnTo>
                <a:lnTo>
                  <a:pt x="6398" y="103"/>
                </a:lnTo>
                <a:lnTo>
                  <a:pt x="6404" y="115"/>
                </a:lnTo>
                <a:lnTo>
                  <a:pt x="6412" y="124"/>
                </a:lnTo>
                <a:lnTo>
                  <a:pt x="6419" y="136"/>
                </a:lnTo>
                <a:lnTo>
                  <a:pt x="6425" y="146"/>
                </a:lnTo>
                <a:lnTo>
                  <a:pt x="6433" y="153"/>
                </a:lnTo>
                <a:lnTo>
                  <a:pt x="6438" y="163"/>
                </a:lnTo>
                <a:lnTo>
                  <a:pt x="6446" y="170"/>
                </a:lnTo>
                <a:lnTo>
                  <a:pt x="6454" y="178"/>
                </a:lnTo>
                <a:lnTo>
                  <a:pt x="6460" y="186"/>
                </a:lnTo>
                <a:lnTo>
                  <a:pt x="6467" y="192"/>
                </a:lnTo>
                <a:lnTo>
                  <a:pt x="6473" y="197"/>
                </a:lnTo>
                <a:lnTo>
                  <a:pt x="6481" y="205"/>
                </a:lnTo>
                <a:lnTo>
                  <a:pt x="6488" y="209"/>
                </a:lnTo>
                <a:lnTo>
                  <a:pt x="6494" y="215"/>
                </a:lnTo>
                <a:lnTo>
                  <a:pt x="6502" y="218"/>
                </a:lnTo>
                <a:lnTo>
                  <a:pt x="6508" y="224"/>
                </a:lnTo>
                <a:lnTo>
                  <a:pt x="6515" y="228"/>
                </a:lnTo>
                <a:lnTo>
                  <a:pt x="6523" y="232"/>
                </a:lnTo>
                <a:lnTo>
                  <a:pt x="6529" y="236"/>
                </a:lnTo>
                <a:lnTo>
                  <a:pt x="6536" y="240"/>
                </a:lnTo>
                <a:lnTo>
                  <a:pt x="6542" y="243"/>
                </a:lnTo>
                <a:lnTo>
                  <a:pt x="6550" y="245"/>
                </a:lnTo>
                <a:lnTo>
                  <a:pt x="6556" y="249"/>
                </a:lnTo>
                <a:lnTo>
                  <a:pt x="6563" y="251"/>
                </a:lnTo>
                <a:lnTo>
                  <a:pt x="6571" y="255"/>
                </a:lnTo>
                <a:lnTo>
                  <a:pt x="6577" y="257"/>
                </a:lnTo>
                <a:lnTo>
                  <a:pt x="6584" y="259"/>
                </a:lnTo>
                <a:lnTo>
                  <a:pt x="6590" y="263"/>
                </a:lnTo>
                <a:lnTo>
                  <a:pt x="6598" y="265"/>
                </a:lnTo>
                <a:lnTo>
                  <a:pt x="6606" y="266"/>
                </a:lnTo>
                <a:lnTo>
                  <a:pt x="6611" y="268"/>
                </a:lnTo>
                <a:lnTo>
                  <a:pt x="6619" y="270"/>
                </a:lnTo>
                <a:lnTo>
                  <a:pt x="6625" y="272"/>
                </a:lnTo>
                <a:lnTo>
                  <a:pt x="6632" y="274"/>
                </a:lnTo>
                <a:lnTo>
                  <a:pt x="6640" y="276"/>
                </a:lnTo>
                <a:lnTo>
                  <a:pt x="6646" y="278"/>
                </a:lnTo>
                <a:lnTo>
                  <a:pt x="6654" y="280"/>
                </a:lnTo>
                <a:lnTo>
                  <a:pt x="6659" y="282"/>
                </a:lnTo>
                <a:lnTo>
                  <a:pt x="6667" y="282"/>
                </a:lnTo>
                <a:lnTo>
                  <a:pt x="6673" y="284"/>
                </a:lnTo>
                <a:lnTo>
                  <a:pt x="6680" y="286"/>
                </a:lnTo>
                <a:lnTo>
                  <a:pt x="6688" y="286"/>
                </a:lnTo>
                <a:lnTo>
                  <a:pt x="6694" y="286"/>
                </a:lnTo>
                <a:lnTo>
                  <a:pt x="6702" y="288"/>
                </a:lnTo>
                <a:lnTo>
                  <a:pt x="6707" y="289"/>
                </a:lnTo>
                <a:lnTo>
                  <a:pt x="6715" y="289"/>
                </a:lnTo>
                <a:lnTo>
                  <a:pt x="6723" y="291"/>
                </a:lnTo>
                <a:lnTo>
                  <a:pt x="6728" y="291"/>
                </a:lnTo>
                <a:lnTo>
                  <a:pt x="6736" y="293"/>
                </a:lnTo>
                <a:lnTo>
                  <a:pt x="6742" y="293"/>
                </a:lnTo>
                <a:lnTo>
                  <a:pt x="6750" y="295"/>
                </a:lnTo>
                <a:lnTo>
                  <a:pt x="6757" y="295"/>
                </a:lnTo>
                <a:lnTo>
                  <a:pt x="6763" y="297"/>
                </a:lnTo>
                <a:lnTo>
                  <a:pt x="6771" y="297"/>
                </a:lnTo>
                <a:lnTo>
                  <a:pt x="6776" y="299"/>
                </a:lnTo>
                <a:lnTo>
                  <a:pt x="6784" y="299"/>
                </a:lnTo>
                <a:lnTo>
                  <a:pt x="6790" y="299"/>
                </a:lnTo>
                <a:lnTo>
                  <a:pt x="6798" y="301"/>
                </a:lnTo>
                <a:lnTo>
                  <a:pt x="6805" y="301"/>
                </a:lnTo>
                <a:lnTo>
                  <a:pt x="6811" y="303"/>
                </a:lnTo>
                <a:lnTo>
                  <a:pt x="6819" y="303"/>
                </a:lnTo>
                <a:lnTo>
                  <a:pt x="6824" y="303"/>
                </a:lnTo>
                <a:lnTo>
                  <a:pt x="6832" y="303"/>
                </a:lnTo>
                <a:lnTo>
                  <a:pt x="6840" y="305"/>
                </a:lnTo>
                <a:lnTo>
                  <a:pt x="6846" y="305"/>
                </a:lnTo>
                <a:lnTo>
                  <a:pt x="6851" y="305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621" name="Rectangle 588">
            <a:extLst>
              <a:ext uri="{FF2B5EF4-FFF2-40B4-BE49-F238E27FC236}">
                <a16:creationId xmlns:a16="http://schemas.microsoft.com/office/drawing/2014/main" id="{4723225C-4D50-44F5-A8F8-244D4BDAE5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5851" y="3826966"/>
            <a:ext cx="1706694" cy="709092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ja-JP" altLang="en-US" sz="700">
              <a:latin typeface="Arial" panose="020B0604020202020204" pitchFamily="34" charset="0"/>
            </a:endParaRPr>
          </a:p>
        </p:txBody>
      </p:sp>
      <p:sp>
        <p:nvSpPr>
          <p:cNvPr id="818" name="テキスト ボックス 1273">
            <a:extLst>
              <a:ext uri="{FF2B5EF4-FFF2-40B4-BE49-F238E27FC236}">
                <a16:creationId xmlns:a16="http://schemas.microsoft.com/office/drawing/2014/main" id="{662BB83F-3C5B-45E7-B053-9B342469A6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8276" y="4346518"/>
            <a:ext cx="318593" cy="1485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 days</a:t>
            </a:r>
            <a:endParaRPr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2" name="Rectangle 551">
            <a:extLst>
              <a:ext uri="{FF2B5EF4-FFF2-40B4-BE49-F238E27FC236}">
                <a16:creationId xmlns:a16="http://schemas.microsoft.com/office/drawing/2014/main" id="{C63C3589-86CA-438B-9598-ADDF2AD2D0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1030" y="4578998"/>
            <a:ext cx="70495" cy="799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4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84" name="グループ化 983">
            <a:extLst>
              <a:ext uri="{FF2B5EF4-FFF2-40B4-BE49-F238E27FC236}">
                <a16:creationId xmlns:a16="http://schemas.microsoft.com/office/drawing/2014/main" id="{2448CF49-4CFD-408B-A5C6-0030A51AE1CE}"/>
              </a:ext>
            </a:extLst>
          </p:cNvPr>
          <p:cNvGrpSpPr/>
          <p:nvPr/>
        </p:nvGrpSpPr>
        <p:grpSpPr>
          <a:xfrm>
            <a:off x="4808265" y="3800987"/>
            <a:ext cx="119663" cy="765848"/>
            <a:chOff x="2196643" y="3006161"/>
            <a:chExt cx="119663" cy="765848"/>
          </a:xfrm>
        </p:grpSpPr>
        <p:sp>
          <p:nvSpPr>
            <p:cNvPr id="985" name="Line 191">
              <a:extLst>
                <a:ext uri="{FF2B5EF4-FFF2-40B4-BE49-F238E27FC236}">
                  <a16:creationId xmlns:a16="http://schemas.microsoft.com/office/drawing/2014/main" id="{526F0433-776A-41DC-A844-BE7AA4896A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6902" y="3721890"/>
              <a:ext cx="9404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86" name="Line 201">
              <a:extLst>
                <a:ext uri="{FF2B5EF4-FFF2-40B4-BE49-F238E27FC236}">
                  <a16:creationId xmlns:a16="http://schemas.microsoft.com/office/drawing/2014/main" id="{E646810D-D03C-4EE4-A3BE-6991EF2944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6902" y="3378765"/>
              <a:ext cx="9404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87" name="Line 211">
              <a:extLst>
                <a:ext uri="{FF2B5EF4-FFF2-40B4-BE49-F238E27FC236}">
                  <a16:creationId xmlns:a16="http://schemas.microsoft.com/office/drawing/2014/main" id="{7DCC6C61-221D-4F6F-B739-4D04FC8846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6902" y="3036924"/>
              <a:ext cx="9404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88" name="Line 212">
              <a:extLst>
                <a:ext uri="{FF2B5EF4-FFF2-40B4-BE49-F238E27FC236}">
                  <a16:creationId xmlns:a16="http://schemas.microsoft.com/office/drawing/2014/main" id="{A5343BE4-E605-4A51-AFA1-ED543895A7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98488" y="3721890"/>
              <a:ext cx="17818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89" name="Rectangle 213">
              <a:extLst>
                <a:ext uri="{FF2B5EF4-FFF2-40B4-BE49-F238E27FC236}">
                  <a16:creationId xmlns:a16="http://schemas.microsoft.com/office/drawing/2014/main" id="{D365F579-293D-48D4-82C7-697DF42921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4956" y="3691126"/>
              <a:ext cx="35031" cy="808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70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0</a:t>
              </a:r>
              <a:endParaRPr lang="en-US" altLang="ja-JP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0" name="Line 216">
              <a:extLst>
                <a:ext uri="{FF2B5EF4-FFF2-40B4-BE49-F238E27FC236}">
                  <a16:creationId xmlns:a16="http://schemas.microsoft.com/office/drawing/2014/main" id="{08437D5B-8198-454D-B39C-62506BCA12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98488" y="3378765"/>
              <a:ext cx="17818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91" name="Rectangle 217">
              <a:extLst>
                <a:ext uri="{FF2B5EF4-FFF2-40B4-BE49-F238E27FC236}">
                  <a16:creationId xmlns:a16="http://schemas.microsoft.com/office/drawing/2014/main" id="{5A249AA8-F2D3-4097-A637-9A53A48595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6643" y="3349286"/>
              <a:ext cx="70061" cy="808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70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20</a:t>
              </a:r>
              <a:endParaRPr lang="en-US" altLang="ja-JP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2" name="Line 220">
              <a:extLst>
                <a:ext uri="{FF2B5EF4-FFF2-40B4-BE49-F238E27FC236}">
                  <a16:creationId xmlns:a16="http://schemas.microsoft.com/office/drawing/2014/main" id="{FD03A143-D7F7-4806-BFA4-86F066284C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98488" y="3036924"/>
              <a:ext cx="17818" cy="12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93" name="Rectangle 221">
              <a:extLst>
                <a:ext uri="{FF2B5EF4-FFF2-40B4-BE49-F238E27FC236}">
                  <a16:creationId xmlns:a16="http://schemas.microsoft.com/office/drawing/2014/main" id="{39CA0261-74D7-4037-8EF7-9EFF2ED509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6643" y="3006161"/>
              <a:ext cx="70061" cy="808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40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08" name="グループ化 1007">
            <a:extLst>
              <a:ext uri="{FF2B5EF4-FFF2-40B4-BE49-F238E27FC236}">
                <a16:creationId xmlns:a16="http://schemas.microsoft.com/office/drawing/2014/main" id="{428F0D25-2B1D-4D90-8FC4-4E87C104875F}"/>
              </a:ext>
            </a:extLst>
          </p:cNvPr>
          <p:cNvGrpSpPr/>
          <p:nvPr/>
        </p:nvGrpSpPr>
        <p:grpSpPr>
          <a:xfrm>
            <a:off x="4798433" y="835619"/>
            <a:ext cx="119984" cy="738684"/>
            <a:chOff x="2023341" y="3842311"/>
            <a:chExt cx="119984" cy="738684"/>
          </a:xfrm>
        </p:grpSpPr>
        <p:sp>
          <p:nvSpPr>
            <p:cNvPr id="997" name="Line 436">
              <a:extLst>
                <a:ext uri="{FF2B5EF4-FFF2-40B4-BE49-F238E27FC236}">
                  <a16:creationId xmlns:a16="http://schemas.microsoft.com/office/drawing/2014/main" id="{A2FD6798-E9D3-498A-B884-39796D784F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3827" y="3901593"/>
              <a:ext cx="9498" cy="104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98" name="Line 451">
              <a:extLst>
                <a:ext uri="{FF2B5EF4-FFF2-40B4-BE49-F238E27FC236}">
                  <a16:creationId xmlns:a16="http://schemas.microsoft.com/office/drawing/2014/main" id="{46A7D0EA-204C-45E1-B58E-79C4BCEDC7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5328" y="3901593"/>
              <a:ext cx="17997" cy="104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999" name="Line 436">
              <a:extLst>
                <a:ext uri="{FF2B5EF4-FFF2-40B4-BE49-F238E27FC236}">
                  <a16:creationId xmlns:a16="http://schemas.microsoft.com/office/drawing/2014/main" id="{3A72243B-9C94-415E-90B5-AADC66E439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3827" y="4125370"/>
              <a:ext cx="9498" cy="104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1000" name="Line 451">
              <a:extLst>
                <a:ext uri="{FF2B5EF4-FFF2-40B4-BE49-F238E27FC236}">
                  <a16:creationId xmlns:a16="http://schemas.microsoft.com/office/drawing/2014/main" id="{44567161-CCB2-4683-9D7A-34CC68AB96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5328" y="4125370"/>
              <a:ext cx="17997" cy="104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1001" name="Line 436">
              <a:extLst>
                <a:ext uri="{FF2B5EF4-FFF2-40B4-BE49-F238E27FC236}">
                  <a16:creationId xmlns:a16="http://schemas.microsoft.com/office/drawing/2014/main" id="{925CCFF0-E455-4D71-B419-0063E56BD3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3827" y="4570752"/>
              <a:ext cx="9498" cy="104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1002" name="Line 451">
              <a:extLst>
                <a:ext uri="{FF2B5EF4-FFF2-40B4-BE49-F238E27FC236}">
                  <a16:creationId xmlns:a16="http://schemas.microsoft.com/office/drawing/2014/main" id="{0EDE9765-2AB3-4665-91FA-95AD54A1F9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5328" y="4570752"/>
              <a:ext cx="17997" cy="104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1003" name="Rectangle 450">
              <a:extLst>
                <a:ext uri="{FF2B5EF4-FFF2-40B4-BE49-F238E27FC236}">
                  <a16:creationId xmlns:a16="http://schemas.microsoft.com/office/drawing/2014/main" id="{4E16D012-D45E-4CAD-92AB-5F61F794A4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7490" y="4507307"/>
              <a:ext cx="29034" cy="73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70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0</a:t>
              </a:r>
              <a:endParaRPr lang="en-US" altLang="ja-JP" sz="70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1004" name="Rectangle 452">
              <a:extLst>
                <a:ext uri="{FF2B5EF4-FFF2-40B4-BE49-F238E27FC236}">
                  <a16:creationId xmlns:a16="http://schemas.microsoft.com/office/drawing/2014/main" id="{1226FB0D-1552-443B-B19E-ACA6F69D9B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3864" y="3842311"/>
              <a:ext cx="58067" cy="73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75</a:t>
              </a:r>
              <a:endParaRPr lang="en-US" altLang="ja-JP" sz="7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1005" name="Line 451">
              <a:extLst>
                <a:ext uri="{FF2B5EF4-FFF2-40B4-BE49-F238E27FC236}">
                  <a16:creationId xmlns:a16="http://schemas.microsoft.com/office/drawing/2014/main" id="{C400ED57-BDA5-4786-809E-A96DF924CB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5328" y="4379563"/>
              <a:ext cx="17997" cy="104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1006" name="Rectangle 452">
              <a:extLst>
                <a:ext uri="{FF2B5EF4-FFF2-40B4-BE49-F238E27FC236}">
                  <a16:creationId xmlns:a16="http://schemas.microsoft.com/office/drawing/2014/main" id="{FBEC15FA-7CEC-4912-A6E1-5A51B32B38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3341" y="4075500"/>
              <a:ext cx="58067" cy="73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50</a:t>
              </a:r>
              <a:endParaRPr lang="en-US" altLang="ja-JP" sz="7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1007" name="Rectangle 452">
              <a:extLst>
                <a:ext uri="{FF2B5EF4-FFF2-40B4-BE49-F238E27FC236}">
                  <a16:creationId xmlns:a16="http://schemas.microsoft.com/office/drawing/2014/main" id="{938AB114-76AD-4530-AD1D-7BB3F598F8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8220" y="4320670"/>
              <a:ext cx="58067" cy="73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25</a:t>
              </a:r>
              <a:endParaRPr lang="en-US" altLang="ja-JP" sz="7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</p:grpSp>
      <p:sp>
        <p:nvSpPr>
          <p:cNvPr id="1019" name="テキスト ボックス 1018">
            <a:extLst>
              <a:ext uri="{FF2B5EF4-FFF2-40B4-BE49-F238E27FC236}">
                <a16:creationId xmlns:a16="http://schemas.microsoft.com/office/drawing/2014/main" id="{9DE1D377-EBCA-4255-8B4C-630DB88E78D5}"/>
              </a:ext>
            </a:extLst>
          </p:cNvPr>
          <p:cNvSpPr txBox="1"/>
          <p:nvPr/>
        </p:nvSpPr>
        <p:spPr>
          <a:xfrm rot="16200000">
            <a:off x="4378478" y="4233075"/>
            <a:ext cx="506377" cy="131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mAU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(220 nm)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0" name="Rectangle 483">
            <a:extLst>
              <a:ext uri="{FF2B5EF4-FFF2-40B4-BE49-F238E27FC236}">
                <a16:creationId xmlns:a16="http://schemas.microsoft.com/office/drawing/2014/main" id="{9597E48C-553E-4E07-BAF2-A6D136C06B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57747" y="4704470"/>
            <a:ext cx="298259" cy="70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7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Time (min.)</a:t>
            </a:r>
            <a:endParaRPr lang="ja-JP" altLang="ja-JP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28" name="テキスト ボックス 1027">
            <a:extLst>
              <a:ext uri="{FF2B5EF4-FFF2-40B4-BE49-F238E27FC236}">
                <a16:creationId xmlns:a16="http://schemas.microsoft.com/office/drawing/2014/main" id="{806B13B9-6A05-40D2-A1FD-252164ECD0FF}"/>
              </a:ext>
            </a:extLst>
          </p:cNvPr>
          <p:cNvSpPr txBox="1"/>
          <p:nvPr/>
        </p:nvSpPr>
        <p:spPr>
          <a:xfrm>
            <a:off x="4381823" y="808951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0) 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29" name="テキスト ボックス 1028">
            <a:extLst>
              <a:ext uri="{FF2B5EF4-FFF2-40B4-BE49-F238E27FC236}">
                <a16:creationId xmlns:a16="http://schemas.microsoft.com/office/drawing/2014/main" id="{A7D0CC14-31DC-4AC6-82EA-CF4130666227}"/>
              </a:ext>
            </a:extLst>
          </p:cNvPr>
          <p:cNvSpPr txBox="1"/>
          <p:nvPr/>
        </p:nvSpPr>
        <p:spPr>
          <a:xfrm>
            <a:off x="4373356" y="1812828"/>
            <a:ext cx="3037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1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30" name="テキスト ボックス 1029">
            <a:extLst>
              <a:ext uri="{FF2B5EF4-FFF2-40B4-BE49-F238E27FC236}">
                <a16:creationId xmlns:a16="http://schemas.microsoft.com/office/drawing/2014/main" id="{5A674C08-D6C7-4AD6-9469-5CF50B6443D5}"/>
              </a:ext>
            </a:extLst>
          </p:cNvPr>
          <p:cNvSpPr txBox="1"/>
          <p:nvPr/>
        </p:nvSpPr>
        <p:spPr>
          <a:xfrm>
            <a:off x="4382770" y="3787906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5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31" name="テキスト ボックス 1030">
            <a:extLst>
              <a:ext uri="{FF2B5EF4-FFF2-40B4-BE49-F238E27FC236}">
                <a16:creationId xmlns:a16="http://schemas.microsoft.com/office/drawing/2014/main" id="{34F127F4-CE81-417E-AD70-A34265AFDC91}"/>
              </a:ext>
            </a:extLst>
          </p:cNvPr>
          <p:cNvSpPr txBox="1"/>
          <p:nvPr/>
        </p:nvSpPr>
        <p:spPr>
          <a:xfrm>
            <a:off x="4328784" y="617559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day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32" name="テキスト ボックス 1031">
            <a:extLst>
              <a:ext uri="{FF2B5EF4-FFF2-40B4-BE49-F238E27FC236}">
                <a16:creationId xmlns:a16="http://schemas.microsoft.com/office/drawing/2014/main" id="{89BF90A4-DED8-4668-A45D-6B2050772890}"/>
              </a:ext>
            </a:extLst>
          </p:cNvPr>
          <p:cNvSpPr txBox="1"/>
          <p:nvPr/>
        </p:nvSpPr>
        <p:spPr>
          <a:xfrm>
            <a:off x="4381823" y="2785171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3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50A2189E-95E3-B3B5-E60E-8453B8EB9538}"/>
              </a:ext>
            </a:extLst>
          </p:cNvPr>
          <p:cNvGrpSpPr/>
          <p:nvPr/>
        </p:nvGrpSpPr>
        <p:grpSpPr>
          <a:xfrm>
            <a:off x="2186455" y="859764"/>
            <a:ext cx="1696136" cy="719532"/>
            <a:chOff x="2150945" y="859764"/>
            <a:chExt cx="1731646" cy="896592"/>
          </a:xfrm>
        </p:grpSpPr>
        <p:sp>
          <p:nvSpPr>
            <p:cNvPr id="84" name="Freeform 334">
              <a:extLst>
                <a:ext uri="{FF2B5EF4-FFF2-40B4-BE49-F238E27FC236}">
                  <a16:creationId xmlns:a16="http://schemas.microsoft.com/office/drawing/2014/main" id="{2C644859-E2D8-4E09-BD5A-BC7AE9C6E17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1632" y="962592"/>
              <a:ext cx="1730959" cy="638619"/>
            </a:xfrm>
            <a:custGeom>
              <a:avLst/>
              <a:gdLst>
                <a:gd name="T0" fmla="*/ 35 w 2520"/>
                <a:gd name="T1" fmla="*/ 351 h 354"/>
                <a:gd name="T2" fmla="*/ 76 w 2520"/>
                <a:gd name="T3" fmla="*/ 347 h 354"/>
                <a:gd name="T4" fmla="*/ 116 w 2520"/>
                <a:gd name="T5" fmla="*/ 345 h 354"/>
                <a:gd name="T6" fmla="*/ 156 w 2520"/>
                <a:gd name="T7" fmla="*/ 344 h 354"/>
                <a:gd name="T8" fmla="*/ 197 w 2520"/>
                <a:gd name="T9" fmla="*/ 341 h 354"/>
                <a:gd name="T10" fmla="*/ 237 w 2520"/>
                <a:gd name="T11" fmla="*/ 341 h 354"/>
                <a:gd name="T12" fmla="*/ 277 w 2520"/>
                <a:gd name="T13" fmla="*/ 340 h 354"/>
                <a:gd name="T14" fmla="*/ 317 w 2520"/>
                <a:gd name="T15" fmla="*/ 340 h 354"/>
                <a:gd name="T16" fmla="*/ 357 w 2520"/>
                <a:gd name="T17" fmla="*/ 339 h 354"/>
                <a:gd name="T18" fmla="*/ 397 w 2520"/>
                <a:gd name="T19" fmla="*/ 340 h 354"/>
                <a:gd name="T20" fmla="*/ 438 w 2520"/>
                <a:gd name="T21" fmla="*/ 341 h 354"/>
                <a:gd name="T22" fmla="*/ 478 w 2520"/>
                <a:gd name="T23" fmla="*/ 341 h 354"/>
                <a:gd name="T24" fmla="*/ 518 w 2520"/>
                <a:gd name="T25" fmla="*/ 342 h 354"/>
                <a:gd name="T26" fmla="*/ 559 w 2520"/>
                <a:gd name="T27" fmla="*/ 343 h 354"/>
                <a:gd name="T28" fmla="*/ 599 w 2520"/>
                <a:gd name="T29" fmla="*/ 344 h 354"/>
                <a:gd name="T30" fmla="*/ 639 w 2520"/>
                <a:gd name="T31" fmla="*/ 344 h 354"/>
                <a:gd name="T32" fmla="*/ 680 w 2520"/>
                <a:gd name="T33" fmla="*/ 344 h 354"/>
                <a:gd name="T34" fmla="*/ 720 w 2520"/>
                <a:gd name="T35" fmla="*/ 345 h 354"/>
                <a:gd name="T36" fmla="*/ 760 w 2520"/>
                <a:gd name="T37" fmla="*/ 345 h 354"/>
                <a:gd name="T38" fmla="*/ 801 w 2520"/>
                <a:gd name="T39" fmla="*/ 345 h 354"/>
                <a:gd name="T40" fmla="*/ 841 w 2520"/>
                <a:gd name="T41" fmla="*/ 345 h 354"/>
                <a:gd name="T42" fmla="*/ 881 w 2520"/>
                <a:gd name="T43" fmla="*/ 345 h 354"/>
                <a:gd name="T44" fmla="*/ 922 w 2520"/>
                <a:gd name="T45" fmla="*/ 345 h 354"/>
                <a:gd name="T46" fmla="*/ 962 w 2520"/>
                <a:gd name="T47" fmla="*/ 344 h 354"/>
                <a:gd name="T48" fmla="*/ 1002 w 2520"/>
                <a:gd name="T49" fmla="*/ 345 h 354"/>
                <a:gd name="T50" fmla="*/ 1043 w 2520"/>
                <a:gd name="T51" fmla="*/ 346 h 354"/>
                <a:gd name="T52" fmla="*/ 1083 w 2520"/>
                <a:gd name="T53" fmla="*/ 346 h 354"/>
                <a:gd name="T54" fmla="*/ 1123 w 2520"/>
                <a:gd name="T55" fmla="*/ 345 h 354"/>
                <a:gd name="T56" fmla="*/ 1164 w 2520"/>
                <a:gd name="T57" fmla="*/ 342 h 354"/>
                <a:gd name="T58" fmla="*/ 1204 w 2520"/>
                <a:gd name="T59" fmla="*/ 330 h 354"/>
                <a:gd name="T60" fmla="*/ 1244 w 2520"/>
                <a:gd name="T61" fmla="*/ 340 h 354"/>
                <a:gd name="T62" fmla="*/ 1285 w 2520"/>
                <a:gd name="T63" fmla="*/ 343 h 354"/>
                <a:gd name="T64" fmla="*/ 1325 w 2520"/>
                <a:gd name="T65" fmla="*/ 343 h 354"/>
                <a:gd name="T66" fmla="*/ 1365 w 2520"/>
                <a:gd name="T67" fmla="*/ 344 h 354"/>
                <a:gd name="T68" fmla="*/ 1406 w 2520"/>
                <a:gd name="T69" fmla="*/ 343 h 354"/>
                <a:gd name="T70" fmla="*/ 1446 w 2520"/>
                <a:gd name="T71" fmla="*/ 343 h 354"/>
                <a:gd name="T72" fmla="*/ 1486 w 2520"/>
                <a:gd name="T73" fmla="*/ 343 h 354"/>
                <a:gd name="T74" fmla="*/ 1527 w 2520"/>
                <a:gd name="T75" fmla="*/ 343 h 354"/>
                <a:gd name="T76" fmla="*/ 1567 w 2520"/>
                <a:gd name="T77" fmla="*/ 342 h 354"/>
                <a:gd name="T78" fmla="*/ 1606 w 2520"/>
                <a:gd name="T79" fmla="*/ 341 h 354"/>
                <a:gd name="T80" fmla="*/ 1647 w 2520"/>
                <a:gd name="T81" fmla="*/ 339 h 354"/>
                <a:gd name="T82" fmla="*/ 1687 w 2520"/>
                <a:gd name="T83" fmla="*/ 339 h 354"/>
                <a:gd name="T84" fmla="*/ 1727 w 2520"/>
                <a:gd name="T85" fmla="*/ 339 h 354"/>
                <a:gd name="T86" fmla="*/ 1768 w 2520"/>
                <a:gd name="T87" fmla="*/ 338 h 354"/>
                <a:gd name="T88" fmla="*/ 1808 w 2520"/>
                <a:gd name="T89" fmla="*/ 337 h 354"/>
                <a:gd name="T90" fmla="*/ 1848 w 2520"/>
                <a:gd name="T91" fmla="*/ 337 h 354"/>
                <a:gd name="T92" fmla="*/ 1889 w 2520"/>
                <a:gd name="T93" fmla="*/ 336 h 354"/>
                <a:gd name="T94" fmla="*/ 1929 w 2520"/>
                <a:gd name="T95" fmla="*/ 335 h 354"/>
                <a:gd name="T96" fmla="*/ 1969 w 2520"/>
                <a:gd name="T97" fmla="*/ 323 h 354"/>
                <a:gd name="T98" fmla="*/ 2010 w 2520"/>
                <a:gd name="T99" fmla="*/ 314 h 354"/>
                <a:gd name="T100" fmla="*/ 2050 w 2520"/>
                <a:gd name="T101" fmla="*/ 319 h 354"/>
                <a:gd name="T102" fmla="*/ 2090 w 2520"/>
                <a:gd name="T103" fmla="*/ 320 h 354"/>
                <a:gd name="T104" fmla="*/ 2131 w 2520"/>
                <a:gd name="T105" fmla="*/ 61 h 354"/>
                <a:gd name="T106" fmla="*/ 2171 w 2520"/>
                <a:gd name="T107" fmla="*/ 132 h 354"/>
                <a:gd name="T108" fmla="*/ 2211 w 2520"/>
                <a:gd name="T109" fmla="*/ 227 h 354"/>
                <a:gd name="T110" fmla="*/ 2252 w 2520"/>
                <a:gd name="T111" fmla="*/ 258 h 354"/>
                <a:gd name="T112" fmla="*/ 2292 w 2520"/>
                <a:gd name="T113" fmla="*/ 193 h 354"/>
                <a:gd name="T114" fmla="*/ 2332 w 2520"/>
                <a:gd name="T115" fmla="*/ 74 h 354"/>
                <a:gd name="T116" fmla="*/ 2373 w 2520"/>
                <a:gd name="T117" fmla="*/ 154 h 354"/>
                <a:gd name="T118" fmla="*/ 2413 w 2520"/>
                <a:gd name="T119" fmla="*/ 200 h 354"/>
                <a:gd name="T120" fmla="*/ 2453 w 2520"/>
                <a:gd name="T121" fmla="*/ 228 h 354"/>
                <a:gd name="T122" fmla="*/ 2494 w 2520"/>
                <a:gd name="T123" fmla="*/ 247 h 3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520" h="354">
                  <a:moveTo>
                    <a:pt x="0" y="354"/>
                  </a:moveTo>
                  <a:lnTo>
                    <a:pt x="2" y="353"/>
                  </a:lnTo>
                  <a:lnTo>
                    <a:pt x="5" y="353"/>
                  </a:lnTo>
                  <a:lnTo>
                    <a:pt x="8" y="352"/>
                  </a:lnTo>
                  <a:lnTo>
                    <a:pt x="11" y="352"/>
                  </a:lnTo>
                  <a:lnTo>
                    <a:pt x="15" y="352"/>
                  </a:lnTo>
                  <a:lnTo>
                    <a:pt x="18" y="352"/>
                  </a:lnTo>
                  <a:lnTo>
                    <a:pt x="22" y="352"/>
                  </a:lnTo>
                  <a:lnTo>
                    <a:pt x="25" y="352"/>
                  </a:lnTo>
                  <a:lnTo>
                    <a:pt x="29" y="351"/>
                  </a:lnTo>
                  <a:lnTo>
                    <a:pt x="31" y="351"/>
                  </a:lnTo>
                  <a:lnTo>
                    <a:pt x="35" y="351"/>
                  </a:lnTo>
                  <a:lnTo>
                    <a:pt x="38" y="350"/>
                  </a:lnTo>
                  <a:lnTo>
                    <a:pt x="42" y="350"/>
                  </a:lnTo>
                  <a:lnTo>
                    <a:pt x="45" y="350"/>
                  </a:lnTo>
                  <a:lnTo>
                    <a:pt x="49" y="349"/>
                  </a:lnTo>
                  <a:lnTo>
                    <a:pt x="52" y="349"/>
                  </a:lnTo>
                  <a:lnTo>
                    <a:pt x="55" y="349"/>
                  </a:lnTo>
                  <a:lnTo>
                    <a:pt x="58" y="348"/>
                  </a:lnTo>
                  <a:lnTo>
                    <a:pt x="62" y="348"/>
                  </a:lnTo>
                  <a:lnTo>
                    <a:pt x="65" y="348"/>
                  </a:lnTo>
                  <a:lnTo>
                    <a:pt x="69" y="348"/>
                  </a:lnTo>
                  <a:lnTo>
                    <a:pt x="72" y="348"/>
                  </a:lnTo>
                  <a:lnTo>
                    <a:pt x="76" y="347"/>
                  </a:lnTo>
                  <a:lnTo>
                    <a:pt x="78" y="347"/>
                  </a:lnTo>
                  <a:lnTo>
                    <a:pt x="82" y="347"/>
                  </a:lnTo>
                  <a:lnTo>
                    <a:pt x="85" y="347"/>
                  </a:lnTo>
                  <a:lnTo>
                    <a:pt x="89" y="346"/>
                  </a:lnTo>
                  <a:lnTo>
                    <a:pt x="92" y="346"/>
                  </a:lnTo>
                  <a:lnTo>
                    <a:pt x="96" y="346"/>
                  </a:lnTo>
                  <a:lnTo>
                    <a:pt x="99" y="346"/>
                  </a:lnTo>
                  <a:lnTo>
                    <a:pt x="102" y="346"/>
                  </a:lnTo>
                  <a:lnTo>
                    <a:pt x="105" y="346"/>
                  </a:lnTo>
                  <a:lnTo>
                    <a:pt x="109" y="346"/>
                  </a:lnTo>
                  <a:lnTo>
                    <a:pt x="112" y="345"/>
                  </a:lnTo>
                  <a:lnTo>
                    <a:pt x="116" y="345"/>
                  </a:lnTo>
                  <a:lnTo>
                    <a:pt x="119" y="345"/>
                  </a:lnTo>
                  <a:lnTo>
                    <a:pt x="123" y="345"/>
                  </a:lnTo>
                  <a:lnTo>
                    <a:pt x="126" y="345"/>
                  </a:lnTo>
                  <a:lnTo>
                    <a:pt x="129" y="345"/>
                  </a:lnTo>
                  <a:lnTo>
                    <a:pt x="132" y="345"/>
                  </a:lnTo>
                  <a:lnTo>
                    <a:pt x="136" y="344"/>
                  </a:lnTo>
                  <a:lnTo>
                    <a:pt x="139" y="344"/>
                  </a:lnTo>
                  <a:lnTo>
                    <a:pt x="143" y="344"/>
                  </a:lnTo>
                  <a:lnTo>
                    <a:pt x="146" y="344"/>
                  </a:lnTo>
                  <a:lnTo>
                    <a:pt x="150" y="344"/>
                  </a:lnTo>
                  <a:lnTo>
                    <a:pt x="152" y="344"/>
                  </a:lnTo>
                  <a:lnTo>
                    <a:pt x="156" y="344"/>
                  </a:lnTo>
                  <a:lnTo>
                    <a:pt x="159" y="344"/>
                  </a:lnTo>
                  <a:lnTo>
                    <a:pt x="163" y="344"/>
                  </a:lnTo>
                  <a:lnTo>
                    <a:pt x="166" y="343"/>
                  </a:lnTo>
                  <a:lnTo>
                    <a:pt x="170" y="343"/>
                  </a:lnTo>
                  <a:lnTo>
                    <a:pt x="173" y="343"/>
                  </a:lnTo>
                  <a:lnTo>
                    <a:pt x="176" y="343"/>
                  </a:lnTo>
                  <a:lnTo>
                    <a:pt x="179" y="343"/>
                  </a:lnTo>
                  <a:lnTo>
                    <a:pt x="183" y="342"/>
                  </a:lnTo>
                  <a:lnTo>
                    <a:pt x="186" y="342"/>
                  </a:lnTo>
                  <a:lnTo>
                    <a:pt x="190" y="342"/>
                  </a:lnTo>
                  <a:lnTo>
                    <a:pt x="193" y="341"/>
                  </a:lnTo>
                  <a:lnTo>
                    <a:pt x="197" y="341"/>
                  </a:lnTo>
                  <a:lnTo>
                    <a:pt x="199" y="341"/>
                  </a:lnTo>
                  <a:lnTo>
                    <a:pt x="203" y="341"/>
                  </a:lnTo>
                  <a:lnTo>
                    <a:pt x="206" y="341"/>
                  </a:lnTo>
                  <a:lnTo>
                    <a:pt x="210" y="341"/>
                  </a:lnTo>
                  <a:lnTo>
                    <a:pt x="213" y="341"/>
                  </a:lnTo>
                  <a:lnTo>
                    <a:pt x="217" y="341"/>
                  </a:lnTo>
                  <a:lnTo>
                    <a:pt x="220" y="341"/>
                  </a:lnTo>
                  <a:lnTo>
                    <a:pt x="223" y="341"/>
                  </a:lnTo>
                  <a:lnTo>
                    <a:pt x="226" y="341"/>
                  </a:lnTo>
                  <a:lnTo>
                    <a:pt x="230" y="341"/>
                  </a:lnTo>
                  <a:lnTo>
                    <a:pt x="233" y="341"/>
                  </a:lnTo>
                  <a:lnTo>
                    <a:pt x="237" y="341"/>
                  </a:lnTo>
                  <a:lnTo>
                    <a:pt x="240" y="341"/>
                  </a:lnTo>
                  <a:lnTo>
                    <a:pt x="244" y="341"/>
                  </a:lnTo>
                  <a:lnTo>
                    <a:pt x="247" y="341"/>
                  </a:lnTo>
                  <a:lnTo>
                    <a:pt x="250" y="341"/>
                  </a:lnTo>
                  <a:lnTo>
                    <a:pt x="253" y="341"/>
                  </a:lnTo>
                  <a:lnTo>
                    <a:pt x="257" y="341"/>
                  </a:lnTo>
                  <a:lnTo>
                    <a:pt x="260" y="341"/>
                  </a:lnTo>
                  <a:lnTo>
                    <a:pt x="264" y="341"/>
                  </a:lnTo>
                  <a:lnTo>
                    <a:pt x="267" y="341"/>
                  </a:lnTo>
                  <a:lnTo>
                    <a:pt x="271" y="341"/>
                  </a:lnTo>
                  <a:lnTo>
                    <a:pt x="273" y="341"/>
                  </a:lnTo>
                  <a:lnTo>
                    <a:pt x="277" y="340"/>
                  </a:lnTo>
                  <a:lnTo>
                    <a:pt x="280" y="341"/>
                  </a:lnTo>
                  <a:lnTo>
                    <a:pt x="284" y="341"/>
                  </a:lnTo>
                  <a:lnTo>
                    <a:pt x="287" y="340"/>
                  </a:lnTo>
                  <a:lnTo>
                    <a:pt x="291" y="340"/>
                  </a:lnTo>
                  <a:lnTo>
                    <a:pt x="294" y="341"/>
                  </a:lnTo>
                  <a:lnTo>
                    <a:pt x="297" y="341"/>
                  </a:lnTo>
                  <a:lnTo>
                    <a:pt x="300" y="341"/>
                  </a:lnTo>
                  <a:lnTo>
                    <a:pt x="304" y="340"/>
                  </a:lnTo>
                  <a:lnTo>
                    <a:pt x="307" y="340"/>
                  </a:lnTo>
                  <a:lnTo>
                    <a:pt x="311" y="340"/>
                  </a:lnTo>
                  <a:lnTo>
                    <a:pt x="314" y="340"/>
                  </a:lnTo>
                  <a:lnTo>
                    <a:pt x="317" y="340"/>
                  </a:lnTo>
                  <a:lnTo>
                    <a:pt x="320" y="340"/>
                  </a:lnTo>
                  <a:lnTo>
                    <a:pt x="323" y="340"/>
                  </a:lnTo>
                  <a:lnTo>
                    <a:pt x="327" y="340"/>
                  </a:lnTo>
                  <a:lnTo>
                    <a:pt x="330" y="340"/>
                  </a:lnTo>
                  <a:lnTo>
                    <a:pt x="334" y="340"/>
                  </a:lnTo>
                  <a:lnTo>
                    <a:pt x="337" y="340"/>
                  </a:lnTo>
                  <a:lnTo>
                    <a:pt x="341" y="340"/>
                  </a:lnTo>
                  <a:lnTo>
                    <a:pt x="344" y="339"/>
                  </a:lnTo>
                  <a:lnTo>
                    <a:pt x="347" y="339"/>
                  </a:lnTo>
                  <a:lnTo>
                    <a:pt x="350" y="339"/>
                  </a:lnTo>
                  <a:lnTo>
                    <a:pt x="354" y="339"/>
                  </a:lnTo>
                  <a:lnTo>
                    <a:pt x="357" y="339"/>
                  </a:lnTo>
                  <a:lnTo>
                    <a:pt x="361" y="339"/>
                  </a:lnTo>
                  <a:lnTo>
                    <a:pt x="364" y="339"/>
                  </a:lnTo>
                  <a:lnTo>
                    <a:pt x="368" y="339"/>
                  </a:lnTo>
                  <a:lnTo>
                    <a:pt x="370" y="339"/>
                  </a:lnTo>
                  <a:lnTo>
                    <a:pt x="374" y="339"/>
                  </a:lnTo>
                  <a:lnTo>
                    <a:pt x="377" y="340"/>
                  </a:lnTo>
                  <a:lnTo>
                    <a:pt x="381" y="340"/>
                  </a:lnTo>
                  <a:lnTo>
                    <a:pt x="384" y="340"/>
                  </a:lnTo>
                  <a:lnTo>
                    <a:pt x="388" y="340"/>
                  </a:lnTo>
                  <a:lnTo>
                    <a:pt x="391" y="340"/>
                  </a:lnTo>
                  <a:lnTo>
                    <a:pt x="394" y="340"/>
                  </a:lnTo>
                  <a:lnTo>
                    <a:pt x="397" y="340"/>
                  </a:lnTo>
                  <a:lnTo>
                    <a:pt x="401" y="340"/>
                  </a:lnTo>
                  <a:lnTo>
                    <a:pt x="404" y="340"/>
                  </a:lnTo>
                  <a:lnTo>
                    <a:pt x="408" y="340"/>
                  </a:lnTo>
                  <a:lnTo>
                    <a:pt x="411" y="340"/>
                  </a:lnTo>
                  <a:lnTo>
                    <a:pt x="415" y="341"/>
                  </a:lnTo>
                  <a:lnTo>
                    <a:pt x="417" y="341"/>
                  </a:lnTo>
                  <a:lnTo>
                    <a:pt x="421" y="341"/>
                  </a:lnTo>
                  <a:lnTo>
                    <a:pt x="424" y="341"/>
                  </a:lnTo>
                  <a:lnTo>
                    <a:pt x="428" y="341"/>
                  </a:lnTo>
                  <a:lnTo>
                    <a:pt x="431" y="341"/>
                  </a:lnTo>
                  <a:lnTo>
                    <a:pt x="435" y="341"/>
                  </a:lnTo>
                  <a:lnTo>
                    <a:pt x="438" y="341"/>
                  </a:lnTo>
                  <a:lnTo>
                    <a:pt x="441" y="341"/>
                  </a:lnTo>
                  <a:lnTo>
                    <a:pt x="444" y="341"/>
                  </a:lnTo>
                  <a:lnTo>
                    <a:pt x="448" y="341"/>
                  </a:lnTo>
                  <a:lnTo>
                    <a:pt x="451" y="341"/>
                  </a:lnTo>
                  <a:lnTo>
                    <a:pt x="455" y="341"/>
                  </a:lnTo>
                  <a:lnTo>
                    <a:pt x="458" y="341"/>
                  </a:lnTo>
                  <a:lnTo>
                    <a:pt x="462" y="341"/>
                  </a:lnTo>
                  <a:lnTo>
                    <a:pt x="465" y="341"/>
                  </a:lnTo>
                  <a:lnTo>
                    <a:pt x="468" y="341"/>
                  </a:lnTo>
                  <a:lnTo>
                    <a:pt x="471" y="341"/>
                  </a:lnTo>
                  <a:lnTo>
                    <a:pt x="475" y="341"/>
                  </a:lnTo>
                  <a:lnTo>
                    <a:pt x="478" y="341"/>
                  </a:lnTo>
                  <a:lnTo>
                    <a:pt x="482" y="341"/>
                  </a:lnTo>
                  <a:lnTo>
                    <a:pt x="485" y="342"/>
                  </a:lnTo>
                  <a:lnTo>
                    <a:pt x="489" y="342"/>
                  </a:lnTo>
                  <a:lnTo>
                    <a:pt x="491" y="342"/>
                  </a:lnTo>
                  <a:lnTo>
                    <a:pt x="495" y="342"/>
                  </a:lnTo>
                  <a:lnTo>
                    <a:pt x="498" y="342"/>
                  </a:lnTo>
                  <a:lnTo>
                    <a:pt x="502" y="342"/>
                  </a:lnTo>
                  <a:lnTo>
                    <a:pt x="505" y="342"/>
                  </a:lnTo>
                  <a:lnTo>
                    <a:pt x="509" y="342"/>
                  </a:lnTo>
                  <a:lnTo>
                    <a:pt x="512" y="342"/>
                  </a:lnTo>
                  <a:lnTo>
                    <a:pt x="515" y="342"/>
                  </a:lnTo>
                  <a:lnTo>
                    <a:pt x="518" y="342"/>
                  </a:lnTo>
                  <a:lnTo>
                    <a:pt x="522" y="342"/>
                  </a:lnTo>
                  <a:lnTo>
                    <a:pt x="525" y="342"/>
                  </a:lnTo>
                  <a:lnTo>
                    <a:pt x="529" y="342"/>
                  </a:lnTo>
                  <a:lnTo>
                    <a:pt x="532" y="342"/>
                  </a:lnTo>
                  <a:lnTo>
                    <a:pt x="536" y="342"/>
                  </a:lnTo>
                  <a:lnTo>
                    <a:pt x="538" y="342"/>
                  </a:lnTo>
                  <a:lnTo>
                    <a:pt x="542" y="342"/>
                  </a:lnTo>
                  <a:lnTo>
                    <a:pt x="545" y="342"/>
                  </a:lnTo>
                  <a:lnTo>
                    <a:pt x="549" y="342"/>
                  </a:lnTo>
                  <a:lnTo>
                    <a:pt x="552" y="343"/>
                  </a:lnTo>
                  <a:lnTo>
                    <a:pt x="556" y="343"/>
                  </a:lnTo>
                  <a:lnTo>
                    <a:pt x="559" y="343"/>
                  </a:lnTo>
                  <a:lnTo>
                    <a:pt x="563" y="343"/>
                  </a:lnTo>
                  <a:lnTo>
                    <a:pt x="565" y="343"/>
                  </a:lnTo>
                  <a:lnTo>
                    <a:pt x="569" y="343"/>
                  </a:lnTo>
                  <a:lnTo>
                    <a:pt x="572" y="343"/>
                  </a:lnTo>
                  <a:lnTo>
                    <a:pt x="576" y="343"/>
                  </a:lnTo>
                  <a:lnTo>
                    <a:pt x="579" y="343"/>
                  </a:lnTo>
                  <a:lnTo>
                    <a:pt x="583" y="343"/>
                  </a:lnTo>
                  <a:lnTo>
                    <a:pt x="586" y="343"/>
                  </a:lnTo>
                  <a:lnTo>
                    <a:pt x="589" y="343"/>
                  </a:lnTo>
                  <a:lnTo>
                    <a:pt x="592" y="343"/>
                  </a:lnTo>
                  <a:lnTo>
                    <a:pt x="596" y="343"/>
                  </a:lnTo>
                  <a:lnTo>
                    <a:pt x="599" y="344"/>
                  </a:lnTo>
                  <a:lnTo>
                    <a:pt x="603" y="344"/>
                  </a:lnTo>
                  <a:lnTo>
                    <a:pt x="606" y="344"/>
                  </a:lnTo>
                  <a:lnTo>
                    <a:pt x="610" y="344"/>
                  </a:lnTo>
                  <a:lnTo>
                    <a:pt x="612" y="344"/>
                  </a:lnTo>
                  <a:lnTo>
                    <a:pt x="616" y="344"/>
                  </a:lnTo>
                  <a:lnTo>
                    <a:pt x="619" y="344"/>
                  </a:lnTo>
                  <a:lnTo>
                    <a:pt x="623" y="344"/>
                  </a:lnTo>
                  <a:lnTo>
                    <a:pt x="626" y="344"/>
                  </a:lnTo>
                  <a:lnTo>
                    <a:pt x="630" y="344"/>
                  </a:lnTo>
                  <a:lnTo>
                    <a:pt x="633" y="344"/>
                  </a:lnTo>
                  <a:lnTo>
                    <a:pt x="636" y="344"/>
                  </a:lnTo>
                  <a:lnTo>
                    <a:pt x="639" y="344"/>
                  </a:lnTo>
                  <a:lnTo>
                    <a:pt x="643" y="344"/>
                  </a:lnTo>
                  <a:lnTo>
                    <a:pt x="646" y="344"/>
                  </a:lnTo>
                  <a:lnTo>
                    <a:pt x="650" y="344"/>
                  </a:lnTo>
                  <a:lnTo>
                    <a:pt x="653" y="344"/>
                  </a:lnTo>
                  <a:lnTo>
                    <a:pt x="657" y="344"/>
                  </a:lnTo>
                  <a:lnTo>
                    <a:pt x="659" y="344"/>
                  </a:lnTo>
                  <a:lnTo>
                    <a:pt x="663" y="344"/>
                  </a:lnTo>
                  <a:lnTo>
                    <a:pt x="666" y="344"/>
                  </a:lnTo>
                  <a:lnTo>
                    <a:pt x="670" y="344"/>
                  </a:lnTo>
                  <a:lnTo>
                    <a:pt x="673" y="344"/>
                  </a:lnTo>
                  <a:lnTo>
                    <a:pt x="677" y="344"/>
                  </a:lnTo>
                  <a:lnTo>
                    <a:pt x="680" y="344"/>
                  </a:lnTo>
                  <a:lnTo>
                    <a:pt x="684" y="345"/>
                  </a:lnTo>
                  <a:lnTo>
                    <a:pt x="686" y="345"/>
                  </a:lnTo>
                  <a:lnTo>
                    <a:pt x="690" y="345"/>
                  </a:lnTo>
                  <a:lnTo>
                    <a:pt x="693" y="344"/>
                  </a:lnTo>
                  <a:lnTo>
                    <a:pt x="697" y="344"/>
                  </a:lnTo>
                  <a:lnTo>
                    <a:pt x="700" y="345"/>
                  </a:lnTo>
                  <a:lnTo>
                    <a:pt x="704" y="345"/>
                  </a:lnTo>
                  <a:lnTo>
                    <a:pt x="707" y="345"/>
                  </a:lnTo>
                  <a:lnTo>
                    <a:pt x="710" y="345"/>
                  </a:lnTo>
                  <a:lnTo>
                    <a:pt x="713" y="345"/>
                  </a:lnTo>
                  <a:lnTo>
                    <a:pt x="717" y="345"/>
                  </a:lnTo>
                  <a:lnTo>
                    <a:pt x="720" y="345"/>
                  </a:lnTo>
                  <a:lnTo>
                    <a:pt x="724" y="345"/>
                  </a:lnTo>
                  <a:lnTo>
                    <a:pt x="727" y="345"/>
                  </a:lnTo>
                  <a:lnTo>
                    <a:pt x="731" y="345"/>
                  </a:lnTo>
                  <a:lnTo>
                    <a:pt x="733" y="345"/>
                  </a:lnTo>
                  <a:lnTo>
                    <a:pt x="737" y="345"/>
                  </a:lnTo>
                  <a:lnTo>
                    <a:pt x="740" y="345"/>
                  </a:lnTo>
                  <a:lnTo>
                    <a:pt x="744" y="345"/>
                  </a:lnTo>
                  <a:lnTo>
                    <a:pt x="747" y="345"/>
                  </a:lnTo>
                  <a:lnTo>
                    <a:pt x="751" y="345"/>
                  </a:lnTo>
                  <a:lnTo>
                    <a:pt x="754" y="345"/>
                  </a:lnTo>
                  <a:lnTo>
                    <a:pt x="757" y="345"/>
                  </a:lnTo>
                  <a:lnTo>
                    <a:pt x="760" y="345"/>
                  </a:lnTo>
                  <a:lnTo>
                    <a:pt x="764" y="345"/>
                  </a:lnTo>
                  <a:lnTo>
                    <a:pt x="767" y="345"/>
                  </a:lnTo>
                  <a:lnTo>
                    <a:pt x="771" y="345"/>
                  </a:lnTo>
                  <a:lnTo>
                    <a:pt x="774" y="345"/>
                  </a:lnTo>
                  <a:lnTo>
                    <a:pt x="778" y="345"/>
                  </a:lnTo>
                  <a:lnTo>
                    <a:pt x="780" y="345"/>
                  </a:lnTo>
                  <a:lnTo>
                    <a:pt x="784" y="345"/>
                  </a:lnTo>
                  <a:lnTo>
                    <a:pt x="787" y="345"/>
                  </a:lnTo>
                  <a:lnTo>
                    <a:pt x="791" y="345"/>
                  </a:lnTo>
                  <a:lnTo>
                    <a:pt x="794" y="345"/>
                  </a:lnTo>
                  <a:lnTo>
                    <a:pt x="798" y="345"/>
                  </a:lnTo>
                  <a:lnTo>
                    <a:pt x="801" y="345"/>
                  </a:lnTo>
                  <a:lnTo>
                    <a:pt x="805" y="345"/>
                  </a:lnTo>
                  <a:lnTo>
                    <a:pt x="807" y="345"/>
                  </a:lnTo>
                  <a:lnTo>
                    <a:pt x="811" y="345"/>
                  </a:lnTo>
                  <a:lnTo>
                    <a:pt x="814" y="345"/>
                  </a:lnTo>
                  <a:lnTo>
                    <a:pt x="818" y="345"/>
                  </a:lnTo>
                  <a:lnTo>
                    <a:pt x="821" y="345"/>
                  </a:lnTo>
                  <a:lnTo>
                    <a:pt x="825" y="345"/>
                  </a:lnTo>
                  <a:lnTo>
                    <a:pt x="828" y="345"/>
                  </a:lnTo>
                  <a:lnTo>
                    <a:pt x="831" y="345"/>
                  </a:lnTo>
                  <a:lnTo>
                    <a:pt x="834" y="345"/>
                  </a:lnTo>
                  <a:lnTo>
                    <a:pt x="838" y="345"/>
                  </a:lnTo>
                  <a:lnTo>
                    <a:pt x="841" y="345"/>
                  </a:lnTo>
                  <a:lnTo>
                    <a:pt x="845" y="345"/>
                  </a:lnTo>
                  <a:lnTo>
                    <a:pt x="848" y="346"/>
                  </a:lnTo>
                  <a:lnTo>
                    <a:pt x="852" y="346"/>
                  </a:lnTo>
                  <a:lnTo>
                    <a:pt x="854" y="346"/>
                  </a:lnTo>
                  <a:lnTo>
                    <a:pt x="858" y="346"/>
                  </a:lnTo>
                  <a:lnTo>
                    <a:pt x="861" y="346"/>
                  </a:lnTo>
                  <a:lnTo>
                    <a:pt x="865" y="345"/>
                  </a:lnTo>
                  <a:lnTo>
                    <a:pt x="868" y="346"/>
                  </a:lnTo>
                  <a:lnTo>
                    <a:pt x="872" y="346"/>
                  </a:lnTo>
                  <a:lnTo>
                    <a:pt x="875" y="345"/>
                  </a:lnTo>
                  <a:lnTo>
                    <a:pt x="878" y="345"/>
                  </a:lnTo>
                  <a:lnTo>
                    <a:pt x="881" y="345"/>
                  </a:lnTo>
                  <a:lnTo>
                    <a:pt x="885" y="345"/>
                  </a:lnTo>
                  <a:lnTo>
                    <a:pt x="888" y="345"/>
                  </a:lnTo>
                  <a:lnTo>
                    <a:pt x="892" y="345"/>
                  </a:lnTo>
                  <a:lnTo>
                    <a:pt x="895" y="345"/>
                  </a:lnTo>
                  <a:lnTo>
                    <a:pt x="899" y="345"/>
                  </a:lnTo>
                  <a:lnTo>
                    <a:pt x="902" y="345"/>
                  </a:lnTo>
                  <a:lnTo>
                    <a:pt x="905" y="345"/>
                  </a:lnTo>
                  <a:lnTo>
                    <a:pt x="908" y="345"/>
                  </a:lnTo>
                  <a:lnTo>
                    <a:pt x="912" y="345"/>
                  </a:lnTo>
                  <a:lnTo>
                    <a:pt x="915" y="345"/>
                  </a:lnTo>
                  <a:lnTo>
                    <a:pt x="919" y="345"/>
                  </a:lnTo>
                  <a:lnTo>
                    <a:pt x="922" y="345"/>
                  </a:lnTo>
                  <a:lnTo>
                    <a:pt x="926" y="346"/>
                  </a:lnTo>
                  <a:lnTo>
                    <a:pt x="928" y="345"/>
                  </a:lnTo>
                  <a:lnTo>
                    <a:pt x="932" y="345"/>
                  </a:lnTo>
                  <a:lnTo>
                    <a:pt x="935" y="345"/>
                  </a:lnTo>
                  <a:lnTo>
                    <a:pt x="939" y="345"/>
                  </a:lnTo>
                  <a:lnTo>
                    <a:pt x="942" y="345"/>
                  </a:lnTo>
                  <a:lnTo>
                    <a:pt x="945" y="344"/>
                  </a:lnTo>
                  <a:lnTo>
                    <a:pt x="949" y="344"/>
                  </a:lnTo>
                  <a:lnTo>
                    <a:pt x="951" y="344"/>
                  </a:lnTo>
                  <a:lnTo>
                    <a:pt x="955" y="344"/>
                  </a:lnTo>
                  <a:lnTo>
                    <a:pt x="958" y="344"/>
                  </a:lnTo>
                  <a:lnTo>
                    <a:pt x="962" y="344"/>
                  </a:lnTo>
                  <a:lnTo>
                    <a:pt x="965" y="344"/>
                  </a:lnTo>
                  <a:lnTo>
                    <a:pt x="969" y="344"/>
                  </a:lnTo>
                  <a:lnTo>
                    <a:pt x="972" y="344"/>
                  </a:lnTo>
                  <a:lnTo>
                    <a:pt x="975" y="345"/>
                  </a:lnTo>
                  <a:lnTo>
                    <a:pt x="978" y="345"/>
                  </a:lnTo>
                  <a:lnTo>
                    <a:pt x="982" y="345"/>
                  </a:lnTo>
                  <a:lnTo>
                    <a:pt x="985" y="345"/>
                  </a:lnTo>
                  <a:lnTo>
                    <a:pt x="989" y="345"/>
                  </a:lnTo>
                  <a:lnTo>
                    <a:pt x="992" y="345"/>
                  </a:lnTo>
                  <a:lnTo>
                    <a:pt x="996" y="345"/>
                  </a:lnTo>
                  <a:lnTo>
                    <a:pt x="998" y="345"/>
                  </a:lnTo>
                  <a:lnTo>
                    <a:pt x="1002" y="345"/>
                  </a:lnTo>
                  <a:lnTo>
                    <a:pt x="1005" y="346"/>
                  </a:lnTo>
                  <a:lnTo>
                    <a:pt x="1009" y="346"/>
                  </a:lnTo>
                  <a:lnTo>
                    <a:pt x="1012" y="346"/>
                  </a:lnTo>
                  <a:lnTo>
                    <a:pt x="1016" y="346"/>
                  </a:lnTo>
                  <a:lnTo>
                    <a:pt x="1019" y="346"/>
                  </a:lnTo>
                  <a:lnTo>
                    <a:pt x="1023" y="345"/>
                  </a:lnTo>
                  <a:lnTo>
                    <a:pt x="1025" y="346"/>
                  </a:lnTo>
                  <a:lnTo>
                    <a:pt x="1029" y="346"/>
                  </a:lnTo>
                  <a:lnTo>
                    <a:pt x="1032" y="346"/>
                  </a:lnTo>
                  <a:lnTo>
                    <a:pt x="1036" y="346"/>
                  </a:lnTo>
                  <a:lnTo>
                    <a:pt x="1039" y="346"/>
                  </a:lnTo>
                  <a:lnTo>
                    <a:pt x="1043" y="346"/>
                  </a:lnTo>
                  <a:lnTo>
                    <a:pt x="1046" y="346"/>
                  </a:lnTo>
                  <a:lnTo>
                    <a:pt x="1049" y="346"/>
                  </a:lnTo>
                  <a:lnTo>
                    <a:pt x="1052" y="346"/>
                  </a:lnTo>
                  <a:lnTo>
                    <a:pt x="1056" y="346"/>
                  </a:lnTo>
                  <a:lnTo>
                    <a:pt x="1059" y="346"/>
                  </a:lnTo>
                  <a:lnTo>
                    <a:pt x="1063" y="346"/>
                  </a:lnTo>
                  <a:lnTo>
                    <a:pt x="1066" y="346"/>
                  </a:lnTo>
                  <a:lnTo>
                    <a:pt x="1070" y="346"/>
                  </a:lnTo>
                  <a:lnTo>
                    <a:pt x="1072" y="346"/>
                  </a:lnTo>
                  <a:lnTo>
                    <a:pt x="1076" y="346"/>
                  </a:lnTo>
                  <a:lnTo>
                    <a:pt x="1079" y="346"/>
                  </a:lnTo>
                  <a:lnTo>
                    <a:pt x="1083" y="346"/>
                  </a:lnTo>
                  <a:lnTo>
                    <a:pt x="1086" y="345"/>
                  </a:lnTo>
                  <a:lnTo>
                    <a:pt x="1090" y="345"/>
                  </a:lnTo>
                  <a:lnTo>
                    <a:pt x="1093" y="345"/>
                  </a:lnTo>
                  <a:lnTo>
                    <a:pt x="1096" y="345"/>
                  </a:lnTo>
                  <a:lnTo>
                    <a:pt x="1099" y="345"/>
                  </a:lnTo>
                  <a:lnTo>
                    <a:pt x="1103" y="345"/>
                  </a:lnTo>
                  <a:lnTo>
                    <a:pt x="1106" y="345"/>
                  </a:lnTo>
                  <a:lnTo>
                    <a:pt x="1110" y="345"/>
                  </a:lnTo>
                  <a:lnTo>
                    <a:pt x="1113" y="345"/>
                  </a:lnTo>
                  <a:lnTo>
                    <a:pt x="1117" y="345"/>
                  </a:lnTo>
                  <a:lnTo>
                    <a:pt x="1120" y="345"/>
                  </a:lnTo>
                  <a:lnTo>
                    <a:pt x="1123" y="345"/>
                  </a:lnTo>
                  <a:lnTo>
                    <a:pt x="1126" y="345"/>
                  </a:lnTo>
                  <a:lnTo>
                    <a:pt x="1130" y="344"/>
                  </a:lnTo>
                  <a:lnTo>
                    <a:pt x="1133" y="344"/>
                  </a:lnTo>
                  <a:lnTo>
                    <a:pt x="1137" y="344"/>
                  </a:lnTo>
                  <a:lnTo>
                    <a:pt x="1140" y="343"/>
                  </a:lnTo>
                  <a:lnTo>
                    <a:pt x="1144" y="343"/>
                  </a:lnTo>
                  <a:lnTo>
                    <a:pt x="1146" y="343"/>
                  </a:lnTo>
                  <a:lnTo>
                    <a:pt x="1150" y="343"/>
                  </a:lnTo>
                  <a:lnTo>
                    <a:pt x="1153" y="342"/>
                  </a:lnTo>
                  <a:lnTo>
                    <a:pt x="1157" y="342"/>
                  </a:lnTo>
                  <a:lnTo>
                    <a:pt x="1160" y="342"/>
                  </a:lnTo>
                  <a:lnTo>
                    <a:pt x="1164" y="342"/>
                  </a:lnTo>
                  <a:lnTo>
                    <a:pt x="1167" y="341"/>
                  </a:lnTo>
                  <a:lnTo>
                    <a:pt x="1170" y="341"/>
                  </a:lnTo>
                  <a:lnTo>
                    <a:pt x="1173" y="341"/>
                  </a:lnTo>
                  <a:lnTo>
                    <a:pt x="1177" y="340"/>
                  </a:lnTo>
                  <a:lnTo>
                    <a:pt x="1180" y="340"/>
                  </a:lnTo>
                  <a:lnTo>
                    <a:pt x="1184" y="339"/>
                  </a:lnTo>
                  <a:lnTo>
                    <a:pt x="1187" y="338"/>
                  </a:lnTo>
                  <a:lnTo>
                    <a:pt x="1191" y="337"/>
                  </a:lnTo>
                  <a:lnTo>
                    <a:pt x="1193" y="335"/>
                  </a:lnTo>
                  <a:lnTo>
                    <a:pt x="1197" y="333"/>
                  </a:lnTo>
                  <a:lnTo>
                    <a:pt x="1200" y="331"/>
                  </a:lnTo>
                  <a:lnTo>
                    <a:pt x="1204" y="330"/>
                  </a:lnTo>
                  <a:lnTo>
                    <a:pt x="1207" y="330"/>
                  </a:lnTo>
                  <a:lnTo>
                    <a:pt x="1211" y="330"/>
                  </a:lnTo>
                  <a:lnTo>
                    <a:pt x="1214" y="331"/>
                  </a:lnTo>
                  <a:lnTo>
                    <a:pt x="1217" y="332"/>
                  </a:lnTo>
                  <a:lnTo>
                    <a:pt x="1220" y="334"/>
                  </a:lnTo>
                  <a:lnTo>
                    <a:pt x="1224" y="335"/>
                  </a:lnTo>
                  <a:lnTo>
                    <a:pt x="1227" y="336"/>
                  </a:lnTo>
                  <a:lnTo>
                    <a:pt x="1231" y="337"/>
                  </a:lnTo>
                  <a:lnTo>
                    <a:pt x="1234" y="338"/>
                  </a:lnTo>
                  <a:lnTo>
                    <a:pt x="1238" y="339"/>
                  </a:lnTo>
                  <a:lnTo>
                    <a:pt x="1241" y="339"/>
                  </a:lnTo>
                  <a:lnTo>
                    <a:pt x="1244" y="340"/>
                  </a:lnTo>
                  <a:lnTo>
                    <a:pt x="1247" y="341"/>
                  </a:lnTo>
                  <a:lnTo>
                    <a:pt x="1251" y="341"/>
                  </a:lnTo>
                  <a:lnTo>
                    <a:pt x="1254" y="342"/>
                  </a:lnTo>
                  <a:lnTo>
                    <a:pt x="1258" y="342"/>
                  </a:lnTo>
                  <a:lnTo>
                    <a:pt x="1261" y="342"/>
                  </a:lnTo>
                  <a:lnTo>
                    <a:pt x="1265" y="342"/>
                  </a:lnTo>
                  <a:lnTo>
                    <a:pt x="1267" y="343"/>
                  </a:lnTo>
                  <a:lnTo>
                    <a:pt x="1271" y="343"/>
                  </a:lnTo>
                  <a:lnTo>
                    <a:pt x="1274" y="343"/>
                  </a:lnTo>
                  <a:lnTo>
                    <a:pt x="1278" y="343"/>
                  </a:lnTo>
                  <a:lnTo>
                    <a:pt x="1281" y="343"/>
                  </a:lnTo>
                  <a:lnTo>
                    <a:pt x="1285" y="343"/>
                  </a:lnTo>
                  <a:lnTo>
                    <a:pt x="1288" y="343"/>
                  </a:lnTo>
                  <a:lnTo>
                    <a:pt x="1291" y="343"/>
                  </a:lnTo>
                  <a:lnTo>
                    <a:pt x="1294" y="343"/>
                  </a:lnTo>
                  <a:lnTo>
                    <a:pt x="1298" y="343"/>
                  </a:lnTo>
                  <a:lnTo>
                    <a:pt x="1301" y="343"/>
                  </a:lnTo>
                  <a:lnTo>
                    <a:pt x="1305" y="343"/>
                  </a:lnTo>
                  <a:lnTo>
                    <a:pt x="1308" y="343"/>
                  </a:lnTo>
                  <a:lnTo>
                    <a:pt x="1312" y="343"/>
                  </a:lnTo>
                  <a:lnTo>
                    <a:pt x="1314" y="343"/>
                  </a:lnTo>
                  <a:lnTo>
                    <a:pt x="1318" y="343"/>
                  </a:lnTo>
                  <a:lnTo>
                    <a:pt x="1321" y="343"/>
                  </a:lnTo>
                  <a:lnTo>
                    <a:pt x="1325" y="343"/>
                  </a:lnTo>
                  <a:lnTo>
                    <a:pt x="1328" y="343"/>
                  </a:lnTo>
                  <a:lnTo>
                    <a:pt x="1332" y="343"/>
                  </a:lnTo>
                  <a:lnTo>
                    <a:pt x="1335" y="343"/>
                  </a:lnTo>
                  <a:lnTo>
                    <a:pt x="1338" y="343"/>
                  </a:lnTo>
                  <a:lnTo>
                    <a:pt x="1341" y="343"/>
                  </a:lnTo>
                  <a:lnTo>
                    <a:pt x="1345" y="343"/>
                  </a:lnTo>
                  <a:lnTo>
                    <a:pt x="1348" y="343"/>
                  </a:lnTo>
                  <a:lnTo>
                    <a:pt x="1352" y="343"/>
                  </a:lnTo>
                  <a:lnTo>
                    <a:pt x="1355" y="343"/>
                  </a:lnTo>
                  <a:lnTo>
                    <a:pt x="1359" y="343"/>
                  </a:lnTo>
                  <a:lnTo>
                    <a:pt x="1362" y="343"/>
                  </a:lnTo>
                  <a:lnTo>
                    <a:pt x="1365" y="344"/>
                  </a:lnTo>
                  <a:lnTo>
                    <a:pt x="1368" y="344"/>
                  </a:lnTo>
                  <a:lnTo>
                    <a:pt x="1372" y="344"/>
                  </a:lnTo>
                  <a:lnTo>
                    <a:pt x="1375" y="344"/>
                  </a:lnTo>
                  <a:lnTo>
                    <a:pt x="1379" y="344"/>
                  </a:lnTo>
                  <a:lnTo>
                    <a:pt x="1382" y="344"/>
                  </a:lnTo>
                  <a:lnTo>
                    <a:pt x="1386" y="344"/>
                  </a:lnTo>
                  <a:lnTo>
                    <a:pt x="1388" y="344"/>
                  </a:lnTo>
                  <a:lnTo>
                    <a:pt x="1392" y="343"/>
                  </a:lnTo>
                  <a:lnTo>
                    <a:pt x="1395" y="343"/>
                  </a:lnTo>
                  <a:lnTo>
                    <a:pt x="1399" y="343"/>
                  </a:lnTo>
                  <a:lnTo>
                    <a:pt x="1402" y="343"/>
                  </a:lnTo>
                  <a:lnTo>
                    <a:pt x="1406" y="343"/>
                  </a:lnTo>
                  <a:lnTo>
                    <a:pt x="1409" y="343"/>
                  </a:lnTo>
                  <a:lnTo>
                    <a:pt x="1412" y="343"/>
                  </a:lnTo>
                  <a:lnTo>
                    <a:pt x="1415" y="343"/>
                  </a:lnTo>
                  <a:lnTo>
                    <a:pt x="1419" y="343"/>
                  </a:lnTo>
                  <a:lnTo>
                    <a:pt x="1422" y="343"/>
                  </a:lnTo>
                  <a:lnTo>
                    <a:pt x="1426" y="343"/>
                  </a:lnTo>
                  <a:lnTo>
                    <a:pt x="1429" y="343"/>
                  </a:lnTo>
                  <a:lnTo>
                    <a:pt x="1433" y="343"/>
                  </a:lnTo>
                  <a:lnTo>
                    <a:pt x="1435" y="343"/>
                  </a:lnTo>
                  <a:lnTo>
                    <a:pt x="1439" y="343"/>
                  </a:lnTo>
                  <a:lnTo>
                    <a:pt x="1442" y="343"/>
                  </a:lnTo>
                  <a:lnTo>
                    <a:pt x="1446" y="343"/>
                  </a:lnTo>
                  <a:lnTo>
                    <a:pt x="1449" y="343"/>
                  </a:lnTo>
                  <a:lnTo>
                    <a:pt x="1453" y="343"/>
                  </a:lnTo>
                  <a:lnTo>
                    <a:pt x="1456" y="343"/>
                  </a:lnTo>
                  <a:lnTo>
                    <a:pt x="1459" y="343"/>
                  </a:lnTo>
                  <a:lnTo>
                    <a:pt x="1462" y="343"/>
                  </a:lnTo>
                  <a:lnTo>
                    <a:pt x="1466" y="343"/>
                  </a:lnTo>
                  <a:lnTo>
                    <a:pt x="1469" y="343"/>
                  </a:lnTo>
                  <a:lnTo>
                    <a:pt x="1473" y="343"/>
                  </a:lnTo>
                  <a:lnTo>
                    <a:pt x="1476" y="343"/>
                  </a:lnTo>
                  <a:lnTo>
                    <a:pt x="1480" y="343"/>
                  </a:lnTo>
                  <a:lnTo>
                    <a:pt x="1483" y="343"/>
                  </a:lnTo>
                  <a:lnTo>
                    <a:pt x="1486" y="343"/>
                  </a:lnTo>
                  <a:lnTo>
                    <a:pt x="1489" y="343"/>
                  </a:lnTo>
                  <a:lnTo>
                    <a:pt x="1493" y="343"/>
                  </a:lnTo>
                  <a:lnTo>
                    <a:pt x="1496" y="343"/>
                  </a:lnTo>
                  <a:lnTo>
                    <a:pt x="1500" y="343"/>
                  </a:lnTo>
                  <a:lnTo>
                    <a:pt x="1503" y="343"/>
                  </a:lnTo>
                  <a:lnTo>
                    <a:pt x="1507" y="343"/>
                  </a:lnTo>
                  <a:lnTo>
                    <a:pt x="1509" y="343"/>
                  </a:lnTo>
                  <a:lnTo>
                    <a:pt x="1513" y="343"/>
                  </a:lnTo>
                  <a:lnTo>
                    <a:pt x="1516" y="343"/>
                  </a:lnTo>
                  <a:lnTo>
                    <a:pt x="1520" y="343"/>
                  </a:lnTo>
                  <a:lnTo>
                    <a:pt x="1523" y="343"/>
                  </a:lnTo>
                  <a:lnTo>
                    <a:pt x="1527" y="343"/>
                  </a:lnTo>
                  <a:lnTo>
                    <a:pt x="1530" y="343"/>
                  </a:lnTo>
                  <a:lnTo>
                    <a:pt x="1533" y="342"/>
                  </a:lnTo>
                  <a:lnTo>
                    <a:pt x="1536" y="343"/>
                  </a:lnTo>
                  <a:lnTo>
                    <a:pt x="1540" y="343"/>
                  </a:lnTo>
                  <a:lnTo>
                    <a:pt x="1543" y="342"/>
                  </a:lnTo>
                  <a:lnTo>
                    <a:pt x="1547" y="342"/>
                  </a:lnTo>
                  <a:lnTo>
                    <a:pt x="1550" y="342"/>
                  </a:lnTo>
                  <a:lnTo>
                    <a:pt x="1554" y="342"/>
                  </a:lnTo>
                  <a:lnTo>
                    <a:pt x="1556" y="342"/>
                  </a:lnTo>
                  <a:lnTo>
                    <a:pt x="1560" y="342"/>
                  </a:lnTo>
                  <a:lnTo>
                    <a:pt x="1563" y="342"/>
                  </a:lnTo>
                  <a:lnTo>
                    <a:pt x="1567" y="342"/>
                  </a:lnTo>
                  <a:lnTo>
                    <a:pt x="1570" y="342"/>
                  </a:lnTo>
                  <a:lnTo>
                    <a:pt x="1574" y="342"/>
                  </a:lnTo>
                  <a:lnTo>
                    <a:pt x="1577" y="342"/>
                  </a:lnTo>
                  <a:lnTo>
                    <a:pt x="1580" y="342"/>
                  </a:lnTo>
                  <a:lnTo>
                    <a:pt x="1583" y="342"/>
                  </a:lnTo>
                  <a:lnTo>
                    <a:pt x="1586" y="342"/>
                  </a:lnTo>
                  <a:lnTo>
                    <a:pt x="1590" y="342"/>
                  </a:lnTo>
                  <a:lnTo>
                    <a:pt x="1593" y="342"/>
                  </a:lnTo>
                  <a:lnTo>
                    <a:pt x="1597" y="341"/>
                  </a:lnTo>
                  <a:lnTo>
                    <a:pt x="1600" y="341"/>
                  </a:lnTo>
                  <a:lnTo>
                    <a:pt x="1604" y="341"/>
                  </a:lnTo>
                  <a:lnTo>
                    <a:pt x="1606" y="341"/>
                  </a:lnTo>
                  <a:lnTo>
                    <a:pt x="1610" y="341"/>
                  </a:lnTo>
                  <a:lnTo>
                    <a:pt x="1613" y="341"/>
                  </a:lnTo>
                  <a:lnTo>
                    <a:pt x="1617" y="341"/>
                  </a:lnTo>
                  <a:lnTo>
                    <a:pt x="1620" y="341"/>
                  </a:lnTo>
                  <a:lnTo>
                    <a:pt x="1624" y="341"/>
                  </a:lnTo>
                  <a:lnTo>
                    <a:pt x="1627" y="340"/>
                  </a:lnTo>
                  <a:lnTo>
                    <a:pt x="1630" y="340"/>
                  </a:lnTo>
                  <a:lnTo>
                    <a:pt x="1633" y="340"/>
                  </a:lnTo>
                  <a:lnTo>
                    <a:pt x="1637" y="340"/>
                  </a:lnTo>
                  <a:lnTo>
                    <a:pt x="1640" y="340"/>
                  </a:lnTo>
                  <a:lnTo>
                    <a:pt x="1644" y="340"/>
                  </a:lnTo>
                  <a:lnTo>
                    <a:pt x="1647" y="339"/>
                  </a:lnTo>
                  <a:lnTo>
                    <a:pt x="1651" y="339"/>
                  </a:lnTo>
                  <a:lnTo>
                    <a:pt x="1653" y="339"/>
                  </a:lnTo>
                  <a:lnTo>
                    <a:pt x="1657" y="339"/>
                  </a:lnTo>
                  <a:lnTo>
                    <a:pt x="1660" y="339"/>
                  </a:lnTo>
                  <a:lnTo>
                    <a:pt x="1664" y="339"/>
                  </a:lnTo>
                  <a:lnTo>
                    <a:pt x="1667" y="339"/>
                  </a:lnTo>
                  <a:lnTo>
                    <a:pt x="1671" y="339"/>
                  </a:lnTo>
                  <a:lnTo>
                    <a:pt x="1674" y="339"/>
                  </a:lnTo>
                  <a:lnTo>
                    <a:pt x="1677" y="339"/>
                  </a:lnTo>
                  <a:lnTo>
                    <a:pt x="1680" y="339"/>
                  </a:lnTo>
                  <a:lnTo>
                    <a:pt x="1684" y="339"/>
                  </a:lnTo>
                  <a:lnTo>
                    <a:pt x="1687" y="339"/>
                  </a:lnTo>
                  <a:lnTo>
                    <a:pt x="1691" y="339"/>
                  </a:lnTo>
                  <a:lnTo>
                    <a:pt x="1694" y="339"/>
                  </a:lnTo>
                  <a:lnTo>
                    <a:pt x="1698" y="339"/>
                  </a:lnTo>
                  <a:lnTo>
                    <a:pt x="1701" y="339"/>
                  </a:lnTo>
                  <a:lnTo>
                    <a:pt x="1704" y="338"/>
                  </a:lnTo>
                  <a:lnTo>
                    <a:pt x="1707" y="339"/>
                  </a:lnTo>
                  <a:lnTo>
                    <a:pt x="1711" y="339"/>
                  </a:lnTo>
                  <a:lnTo>
                    <a:pt x="1714" y="339"/>
                  </a:lnTo>
                  <a:lnTo>
                    <a:pt x="1718" y="339"/>
                  </a:lnTo>
                  <a:lnTo>
                    <a:pt x="1721" y="339"/>
                  </a:lnTo>
                  <a:lnTo>
                    <a:pt x="1725" y="339"/>
                  </a:lnTo>
                  <a:lnTo>
                    <a:pt x="1727" y="339"/>
                  </a:lnTo>
                  <a:lnTo>
                    <a:pt x="1731" y="339"/>
                  </a:lnTo>
                  <a:lnTo>
                    <a:pt x="1734" y="339"/>
                  </a:lnTo>
                  <a:lnTo>
                    <a:pt x="1738" y="339"/>
                  </a:lnTo>
                  <a:lnTo>
                    <a:pt x="1741" y="339"/>
                  </a:lnTo>
                  <a:lnTo>
                    <a:pt x="1745" y="339"/>
                  </a:lnTo>
                  <a:lnTo>
                    <a:pt x="1748" y="339"/>
                  </a:lnTo>
                  <a:lnTo>
                    <a:pt x="1751" y="339"/>
                  </a:lnTo>
                  <a:lnTo>
                    <a:pt x="1754" y="339"/>
                  </a:lnTo>
                  <a:lnTo>
                    <a:pt x="1758" y="339"/>
                  </a:lnTo>
                  <a:lnTo>
                    <a:pt x="1761" y="339"/>
                  </a:lnTo>
                  <a:lnTo>
                    <a:pt x="1765" y="339"/>
                  </a:lnTo>
                  <a:lnTo>
                    <a:pt x="1768" y="338"/>
                  </a:lnTo>
                  <a:lnTo>
                    <a:pt x="1772" y="338"/>
                  </a:lnTo>
                  <a:lnTo>
                    <a:pt x="1774" y="338"/>
                  </a:lnTo>
                  <a:lnTo>
                    <a:pt x="1778" y="338"/>
                  </a:lnTo>
                  <a:lnTo>
                    <a:pt x="1781" y="338"/>
                  </a:lnTo>
                  <a:lnTo>
                    <a:pt x="1785" y="338"/>
                  </a:lnTo>
                  <a:lnTo>
                    <a:pt x="1788" y="338"/>
                  </a:lnTo>
                  <a:lnTo>
                    <a:pt x="1792" y="338"/>
                  </a:lnTo>
                  <a:lnTo>
                    <a:pt x="1795" y="338"/>
                  </a:lnTo>
                  <a:lnTo>
                    <a:pt x="1798" y="337"/>
                  </a:lnTo>
                  <a:lnTo>
                    <a:pt x="1801" y="337"/>
                  </a:lnTo>
                  <a:lnTo>
                    <a:pt x="1805" y="337"/>
                  </a:lnTo>
                  <a:lnTo>
                    <a:pt x="1808" y="337"/>
                  </a:lnTo>
                  <a:lnTo>
                    <a:pt x="1812" y="337"/>
                  </a:lnTo>
                  <a:lnTo>
                    <a:pt x="1815" y="337"/>
                  </a:lnTo>
                  <a:lnTo>
                    <a:pt x="1819" y="337"/>
                  </a:lnTo>
                  <a:lnTo>
                    <a:pt x="1822" y="337"/>
                  </a:lnTo>
                  <a:lnTo>
                    <a:pt x="1825" y="337"/>
                  </a:lnTo>
                  <a:lnTo>
                    <a:pt x="1828" y="337"/>
                  </a:lnTo>
                  <a:lnTo>
                    <a:pt x="1832" y="337"/>
                  </a:lnTo>
                  <a:lnTo>
                    <a:pt x="1835" y="337"/>
                  </a:lnTo>
                  <a:lnTo>
                    <a:pt x="1839" y="337"/>
                  </a:lnTo>
                  <a:lnTo>
                    <a:pt x="1842" y="337"/>
                  </a:lnTo>
                  <a:lnTo>
                    <a:pt x="1846" y="337"/>
                  </a:lnTo>
                  <a:lnTo>
                    <a:pt x="1848" y="337"/>
                  </a:lnTo>
                  <a:lnTo>
                    <a:pt x="1852" y="337"/>
                  </a:lnTo>
                  <a:lnTo>
                    <a:pt x="1855" y="337"/>
                  </a:lnTo>
                  <a:lnTo>
                    <a:pt x="1859" y="337"/>
                  </a:lnTo>
                  <a:lnTo>
                    <a:pt x="1862" y="337"/>
                  </a:lnTo>
                  <a:lnTo>
                    <a:pt x="1866" y="337"/>
                  </a:lnTo>
                  <a:lnTo>
                    <a:pt x="1869" y="337"/>
                  </a:lnTo>
                  <a:lnTo>
                    <a:pt x="1872" y="337"/>
                  </a:lnTo>
                  <a:lnTo>
                    <a:pt x="1875" y="336"/>
                  </a:lnTo>
                  <a:lnTo>
                    <a:pt x="1879" y="336"/>
                  </a:lnTo>
                  <a:lnTo>
                    <a:pt x="1882" y="336"/>
                  </a:lnTo>
                  <a:lnTo>
                    <a:pt x="1886" y="336"/>
                  </a:lnTo>
                  <a:lnTo>
                    <a:pt x="1889" y="336"/>
                  </a:lnTo>
                  <a:lnTo>
                    <a:pt x="1893" y="336"/>
                  </a:lnTo>
                  <a:lnTo>
                    <a:pt x="1895" y="336"/>
                  </a:lnTo>
                  <a:lnTo>
                    <a:pt x="1899" y="336"/>
                  </a:lnTo>
                  <a:lnTo>
                    <a:pt x="1902" y="336"/>
                  </a:lnTo>
                  <a:lnTo>
                    <a:pt x="1906" y="336"/>
                  </a:lnTo>
                  <a:lnTo>
                    <a:pt x="1909" y="336"/>
                  </a:lnTo>
                  <a:lnTo>
                    <a:pt x="1913" y="336"/>
                  </a:lnTo>
                  <a:lnTo>
                    <a:pt x="1916" y="335"/>
                  </a:lnTo>
                  <a:lnTo>
                    <a:pt x="1919" y="335"/>
                  </a:lnTo>
                  <a:lnTo>
                    <a:pt x="1922" y="335"/>
                  </a:lnTo>
                  <a:lnTo>
                    <a:pt x="1926" y="335"/>
                  </a:lnTo>
                  <a:lnTo>
                    <a:pt x="1929" y="335"/>
                  </a:lnTo>
                  <a:lnTo>
                    <a:pt x="1933" y="335"/>
                  </a:lnTo>
                  <a:lnTo>
                    <a:pt x="1936" y="334"/>
                  </a:lnTo>
                  <a:lnTo>
                    <a:pt x="1940" y="334"/>
                  </a:lnTo>
                  <a:lnTo>
                    <a:pt x="1943" y="334"/>
                  </a:lnTo>
                  <a:lnTo>
                    <a:pt x="1946" y="333"/>
                  </a:lnTo>
                  <a:lnTo>
                    <a:pt x="1949" y="333"/>
                  </a:lnTo>
                  <a:lnTo>
                    <a:pt x="1953" y="332"/>
                  </a:lnTo>
                  <a:lnTo>
                    <a:pt x="1956" y="331"/>
                  </a:lnTo>
                  <a:lnTo>
                    <a:pt x="1960" y="330"/>
                  </a:lnTo>
                  <a:lnTo>
                    <a:pt x="1963" y="328"/>
                  </a:lnTo>
                  <a:lnTo>
                    <a:pt x="1967" y="326"/>
                  </a:lnTo>
                  <a:lnTo>
                    <a:pt x="1969" y="323"/>
                  </a:lnTo>
                  <a:lnTo>
                    <a:pt x="1973" y="320"/>
                  </a:lnTo>
                  <a:lnTo>
                    <a:pt x="1976" y="318"/>
                  </a:lnTo>
                  <a:lnTo>
                    <a:pt x="1980" y="316"/>
                  </a:lnTo>
                  <a:lnTo>
                    <a:pt x="1983" y="314"/>
                  </a:lnTo>
                  <a:lnTo>
                    <a:pt x="1987" y="312"/>
                  </a:lnTo>
                  <a:lnTo>
                    <a:pt x="1990" y="311"/>
                  </a:lnTo>
                  <a:lnTo>
                    <a:pt x="1993" y="311"/>
                  </a:lnTo>
                  <a:lnTo>
                    <a:pt x="1996" y="311"/>
                  </a:lnTo>
                  <a:lnTo>
                    <a:pt x="2000" y="312"/>
                  </a:lnTo>
                  <a:lnTo>
                    <a:pt x="2003" y="312"/>
                  </a:lnTo>
                  <a:lnTo>
                    <a:pt x="2007" y="313"/>
                  </a:lnTo>
                  <a:lnTo>
                    <a:pt x="2010" y="314"/>
                  </a:lnTo>
                  <a:lnTo>
                    <a:pt x="2014" y="314"/>
                  </a:lnTo>
                  <a:lnTo>
                    <a:pt x="2016" y="315"/>
                  </a:lnTo>
                  <a:lnTo>
                    <a:pt x="2020" y="316"/>
                  </a:lnTo>
                  <a:lnTo>
                    <a:pt x="2023" y="316"/>
                  </a:lnTo>
                  <a:lnTo>
                    <a:pt x="2027" y="317"/>
                  </a:lnTo>
                  <a:lnTo>
                    <a:pt x="2030" y="317"/>
                  </a:lnTo>
                  <a:lnTo>
                    <a:pt x="2034" y="317"/>
                  </a:lnTo>
                  <a:lnTo>
                    <a:pt x="2037" y="317"/>
                  </a:lnTo>
                  <a:lnTo>
                    <a:pt x="2040" y="317"/>
                  </a:lnTo>
                  <a:lnTo>
                    <a:pt x="2043" y="318"/>
                  </a:lnTo>
                  <a:lnTo>
                    <a:pt x="2047" y="318"/>
                  </a:lnTo>
                  <a:lnTo>
                    <a:pt x="2050" y="319"/>
                  </a:lnTo>
                  <a:lnTo>
                    <a:pt x="2054" y="319"/>
                  </a:lnTo>
                  <a:lnTo>
                    <a:pt x="2057" y="319"/>
                  </a:lnTo>
                  <a:lnTo>
                    <a:pt x="2061" y="319"/>
                  </a:lnTo>
                  <a:lnTo>
                    <a:pt x="2064" y="320"/>
                  </a:lnTo>
                  <a:lnTo>
                    <a:pt x="2067" y="320"/>
                  </a:lnTo>
                  <a:lnTo>
                    <a:pt x="2070" y="320"/>
                  </a:lnTo>
                  <a:lnTo>
                    <a:pt x="2074" y="320"/>
                  </a:lnTo>
                  <a:lnTo>
                    <a:pt x="2077" y="321"/>
                  </a:lnTo>
                  <a:lnTo>
                    <a:pt x="2081" y="321"/>
                  </a:lnTo>
                  <a:lnTo>
                    <a:pt x="2084" y="321"/>
                  </a:lnTo>
                  <a:lnTo>
                    <a:pt x="2088" y="321"/>
                  </a:lnTo>
                  <a:lnTo>
                    <a:pt x="2090" y="320"/>
                  </a:lnTo>
                  <a:lnTo>
                    <a:pt x="2094" y="320"/>
                  </a:lnTo>
                  <a:lnTo>
                    <a:pt x="2097" y="319"/>
                  </a:lnTo>
                  <a:lnTo>
                    <a:pt x="2101" y="317"/>
                  </a:lnTo>
                  <a:lnTo>
                    <a:pt x="2104" y="313"/>
                  </a:lnTo>
                  <a:lnTo>
                    <a:pt x="2108" y="305"/>
                  </a:lnTo>
                  <a:lnTo>
                    <a:pt x="2111" y="291"/>
                  </a:lnTo>
                  <a:lnTo>
                    <a:pt x="2114" y="269"/>
                  </a:lnTo>
                  <a:lnTo>
                    <a:pt x="2117" y="238"/>
                  </a:lnTo>
                  <a:lnTo>
                    <a:pt x="2121" y="198"/>
                  </a:lnTo>
                  <a:lnTo>
                    <a:pt x="2124" y="151"/>
                  </a:lnTo>
                  <a:lnTo>
                    <a:pt x="2128" y="104"/>
                  </a:lnTo>
                  <a:lnTo>
                    <a:pt x="2131" y="61"/>
                  </a:lnTo>
                  <a:lnTo>
                    <a:pt x="2135" y="28"/>
                  </a:lnTo>
                  <a:lnTo>
                    <a:pt x="2137" y="7"/>
                  </a:lnTo>
                  <a:lnTo>
                    <a:pt x="2141" y="0"/>
                  </a:lnTo>
                  <a:lnTo>
                    <a:pt x="2144" y="3"/>
                  </a:lnTo>
                  <a:lnTo>
                    <a:pt x="2148" y="15"/>
                  </a:lnTo>
                  <a:lnTo>
                    <a:pt x="2151" y="32"/>
                  </a:lnTo>
                  <a:lnTo>
                    <a:pt x="2155" y="50"/>
                  </a:lnTo>
                  <a:lnTo>
                    <a:pt x="2158" y="69"/>
                  </a:lnTo>
                  <a:lnTo>
                    <a:pt x="2161" y="87"/>
                  </a:lnTo>
                  <a:lnTo>
                    <a:pt x="2164" y="104"/>
                  </a:lnTo>
                  <a:lnTo>
                    <a:pt x="2168" y="118"/>
                  </a:lnTo>
                  <a:lnTo>
                    <a:pt x="2171" y="132"/>
                  </a:lnTo>
                  <a:lnTo>
                    <a:pt x="2175" y="144"/>
                  </a:lnTo>
                  <a:lnTo>
                    <a:pt x="2178" y="156"/>
                  </a:lnTo>
                  <a:lnTo>
                    <a:pt x="2182" y="167"/>
                  </a:lnTo>
                  <a:lnTo>
                    <a:pt x="2185" y="176"/>
                  </a:lnTo>
                  <a:lnTo>
                    <a:pt x="2188" y="185"/>
                  </a:lnTo>
                  <a:lnTo>
                    <a:pt x="2191" y="193"/>
                  </a:lnTo>
                  <a:lnTo>
                    <a:pt x="2195" y="200"/>
                  </a:lnTo>
                  <a:lnTo>
                    <a:pt x="2198" y="207"/>
                  </a:lnTo>
                  <a:lnTo>
                    <a:pt x="2202" y="212"/>
                  </a:lnTo>
                  <a:lnTo>
                    <a:pt x="2205" y="217"/>
                  </a:lnTo>
                  <a:lnTo>
                    <a:pt x="2208" y="222"/>
                  </a:lnTo>
                  <a:lnTo>
                    <a:pt x="2211" y="227"/>
                  </a:lnTo>
                  <a:lnTo>
                    <a:pt x="2214" y="231"/>
                  </a:lnTo>
                  <a:lnTo>
                    <a:pt x="2218" y="235"/>
                  </a:lnTo>
                  <a:lnTo>
                    <a:pt x="2221" y="239"/>
                  </a:lnTo>
                  <a:lnTo>
                    <a:pt x="2225" y="242"/>
                  </a:lnTo>
                  <a:lnTo>
                    <a:pt x="2228" y="245"/>
                  </a:lnTo>
                  <a:lnTo>
                    <a:pt x="2232" y="247"/>
                  </a:lnTo>
                  <a:lnTo>
                    <a:pt x="2234" y="250"/>
                  </a:lnTo>
                  <a:lnTo>
                    <a:pt x="2238" y="252"/>
                  </a:lnTo>
                  <a:lnTo>
                    <a:pt x="2241" y="254"/>
                  </a:lnTo>
                  <a:lnTo>
                    <a:pt x="2245" y="255"/>
                  </a:lnTo>
                  <a:lnTo>
                    <a:pt x="2248" y="257"/>
                  </a:lnTo>
                  <a:lnTo>
                    <a:pt x="2252" y="258"/>
                  </a:lnTo>
                  <a:lnTo>
                    <a:pt x="2255" y="258"/>
                  </a:lnTo>
                  <a:lnTo>
                    <a:pt x="2258" y="258"/>
                  </a:lnTo>
                  <a:lnTo>
                    <a:pt x="2261" y="257"/>
                  </a:lnTo>
                  <a:lnTo>
                    <a:pt x="2265" y="256"/>
                  </a:lnTo>
                  <a:lnTo>
                    <a:pt x="2268" y="254"/>
                  </a:lnTo>
                  <a:lnTo>
                    <a:pt x="2272" y="250"/>
                  </a:lnTo>
                  <a:lnTo>
                    <a:pt x="2275" y="245"/>
                  </a:lnTo>
                  <a:lnTo>
                    <a:pt x="2279" y="238"/>
                  </a:lnTo>
                  <a:lnTo>
                    <a:pt x="2282" y="229"/>
                  </a:lnTo>
                  <a:lnTo>
                    <a:pt x="2285" y="218"/>
                  </a:lnTo>
                  <a:lnTo>
                    <a:pt x="2288" y="207"/>
                  </a:lnTo>
                  <a:lnTo>
                    <a:pt x="2292" y="193"/>
                  </a:lnTo>
                  <a:lnTo>
                    <a:pt x="2295" y="178"/>
                  </a:lnTo>
                  <a:lnTo>
                    <a:pt x="2299" y="163"/>
                  </a:lnTo>
                  <a:lnTo>
                    <a:pt x="2302" y="147"/>
                  </a:lnTo>
                  <a:lnTo>
                    <a:pt x="2306" y="133"/>
                  </a:lnTo>
                  <a:lnTo>
                    <a:pt x="2308" y="118"/>
                  </a:lnTo>
                  <a:lnTo>
                    <a:pt x="2312" y="105"/>
                  </a:lnTo>
                  <a:lnTo>
                    <a:pt x="2315" y="93"/>
                  </a:lnTo>
                  <a:lnTo>
                    <a:pt x="2319" y="83"/>
                  </a:lnTo>
                  <a:lnTo>
                    <a:pt x="2322" y="76"/>
                  </a:lnTo>
                  <a:lnTo>
                    <a:pt x="2326" y="73"/>
                  </a:lnTo>
                  <a:lnTo>
                    <a:pt x="2329" y="72"/>
                  </a:lnTo>
                  <a:lnTo>
                    <a:pt x="2332" y="74"/>
                  </a:lnTo>
                  <a:lnTo>
                    <a:pt x="2335" y="78"/>
                  </a:lnTo>
                  <a:lnTo>
                    <a:pt x="2339" y="84"/>
                  </a:lnTo>
                  <a:lnTo>
                    <a:pt x="2342" y="91"/>
                  </a:lnTo>
                  <a:lnTo>
                    <a:pt x="2346" y="99"/>
                  </a:lnTo>
                  <a:lnTo>
                    <a:pt x="2349" y="106"/>
                  </a:lnTo>
                  <a:lnTo>
                    <a:pt x="2353" y="114"/>
                  </a:lnTo>
                  <a:lnTo>
                    <a:pt x="2355" y="122"/>
                  </a:lnTo>
                  <a:lnTo>
                    <a:pt x="2359" y="129"/>
                  </a:lnTo>
                  <a:lnTo>
                    <a:pt x="2362" y="136"/>
                  </a:lnTo>
                  <a:lnTo>
                    <a:pt x="2366" y="142"/>
                  </a:lnTo>
                  <a:lnTo>
                    <a:pt x="2369" y="148"/>
                  </a:lnTo>
                  <a:lnTo>
                    <a:pt x="2373" y="154"/>
                  </a:lnTo>
                  <a:lnTo>
                    <a:pt x="2376" y="159"/>
                  </a:lnTo>
                  <a:lnTo>
                    <a:pt x="2379" y="164"/>
                  </a:lnTo>
                  <a:lnTo>
                    <a:pt x="2382" y="169"/>
                  </a:lnTo>
                  <a:lnTo>
                    <a:pt x="2386" y="173"/>
                  </a:lnTo>
                  <a:lnTo>
                    <a:pt x="2389" y="176"/>
                  </a:lnTo>
                  <a:lnTo>
                    <a:pt x="2393" y="180"/>
                  </a:lnTo>
                  <a:lnTo>
                    <a:pt x="2396" y="184"/>
                  </a:lnTo>
                  <a:lnTo>
                    <a:pt x="2400" y="187"/>
                  </a:lnTo>
                  <a:lnTo>
                    <a:pt x="2403" y="191"/>
                  </a:lnTo>
                  <a:lnTo>
                    <a:pt x="2406" y="194"/>
                  </a:lnTo>
                  <a:lnTo>
                    <a:pt x="2409" y="197"/>
                  </a:lnTo>
                  <a:lnTo>
                    <a:pt x="2413" y="200"/>
                  </a:lnTo>
                  <a:lnTo>
                    <a:pt x="2416" y="203"/>
                  </a:lnTo>
                  <a:lnTo>
                    <a:pt x="2420" y="206"/>
                  </a:lnTo>
                  <a:lnTo>
                    <a:pt x="2423" y="208"/>
                  </a:lnTo>
                  <a:lnTo>
                    <a:pt x="2427" y="211"/>
                  </a:lnTo>
                  <a:lnTo>
                    <a:pt x="2429" y="212"/>
                  </a:lnTo>
                  <a:lnTo>
                    <a:pt x="2433" y="215"/>
                  </a:lnTo>
                  <a:lnTo>
                    <a:pt x="2436" y="217"/>
                  </a:lnTo>
                  <a:lnTo>
                    <a:pt x="2440" y="219"/>
                  </a:lnTo>
                  <a:lnTo>
                    <a:pt x="2443" y="221"/>
                  </a:lnTo>
                  <a:lnTo>
                    <a:pt x="2447" y="224"/>
                  </a:lnTo>
                  <a:lnTo>
                    <a:pt x="2450" y="226"/>
                  </a:lnTo>
                  <a:lnTo>
                    <a:pt x="2453" y="228"/>
                  </a:lnTo>
                  <a:lnTo>
                    <a:pt x="2456" y="229"/>
                  </a:lnTo>
                  <a:lnTo>
                    <a:pt x="2460" y="231"/>
                  </a:lnTo>
                  <a:lnTo>
                    <a:pt x="2463" y="233"/>
                  </a:lnTo>
                  <a:lnTo>
                    <a:pt x="2467" y="235"/>
                  </a:lnTo>
                  <a:lnTo>
                    <a:pt x="2470" y="237"/>
                  </a:lnTo>
                  <a:lnTo>
                    <a:pt x="2474" y="238"/>
                  </a:lnTo>
                  <a:lnTo>
                    <a:pt x="2476" y="240"/>
                  </a:lnTo>
                  <a:lnTo>
                    <a:pt x="2480" y="241"/>
                  </a:lnTo>
                  <a:lnTo>
                    <a:pt x="2483" y="243"/>
                  </a:lnTo>
                  <a:lnTo>
                    <a:pt x="2487" y="244"/>
                  </a:lnTo>
                  <a:lnTo>
                    <a:pt x="2490" y="246"/>
                  </a:lnTo>
                  <a:lnTo>
                    <a:pt x="2494" y="247"/>
                  </a:lnTo>
                  <a:lnTo>
                    <a:pt x="2497" y="247"/>
                  </a:lnTo>
                  <a:lnTo>
                    <a:pt x="2500" y="249"/>
                  </a:lnTo>
                  <a:lnTo>
                    <a:pt x="2503" y="250"/>
                  </a:lnTo>
                  <a:lnTo>
                    <a:pt x="2507" y="251"/>
                  </a:lnTo>
                  <a:lnTo>
                    <a:pt x="2510" y="252"/>
                  </a:lnTo>
                  <a:lnTo>
                    <a:pt x="2514" y="253"/>
                  </a:lnTo>
                  <a:lnTo>
                    <a:pt x="2517" y="255"/>
                  </a:lnTo>
                  <a:lnTo>
                    <a:pt x="2520" y="256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Rectangle 336">
              <a:extLst>
                <a:ext uri="{FF2B5EF4-FFF2-40B4-BE49-F238E27FC236}">
                  <a16:creationId xmlns:a16="http://schemas.microsoft.com/office/drawing/2014/main" id="{8BE5E1BD-6964-AA41-A4CA-C4E8698824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0945" y="859764"/>
              <a:ext cx="1726838" cy="89659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03" name="グループ化 102">
            <a:extLst>
              <a:ext uri="{FF2B5EF4-FFF2-40B4-BE49-F238E27FC236}">
                <a16:creationId xmlns:a16="http://schemas.microsoft.com/office/drawing/2014/main" id="{27D20254-308F-EEB8-9D66-6FF54A0BEA0B}"/>
              </a:ext>
            </a:extLst>
          </p:cNvPr>
          <p:cNvGrpSpPr/>
          <p:nvPr/>
        </p:nvGrpSpPr>
        <p:grpSpPr>
          <a:xfrm>
            <a:off x="2184657" y="2822814"/>
            <a:ext cx="1713864" cy="723125"/>
            <a:chOff x="2112886" y="3284756"/>
            <a:chExt cx="1731646" cy="896592"/>
          </a:xfrm>
        </p:grpSpPr>
        <p:sp>
          <p:nvSpPr>
            <p:cNvPr id="544" name="Freeform 1094">
              <a:extLst>
                <a:ext uri="{FF2B5EF4-FFF2-40B4-BE49-F238E27FC236}">
                  <a16:creationId xmlns:a16="http://schemas.microsoft.com/office/drawing/2014/main" id="{CD098136-84C4-29A4-20EE-2543AFA422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3573" y="3696070"/>
              <a:ext cx="1730959" cy="328330"/>
            </a:xfrm>
            <a:custGeom>
              <a:avLst/>
              <a:gdLst>
                <a:gd name="T0" fmla="*/ 35 w 2520"/>
                <a:gd name="T1" fmla="*/ 179 h 182"/>
                <a:gd name="T2" fmla="*/ 76 w 2520"/>
                <a:gd name="T3" fmla="*/ 175 h 182"/>
                <a:gd name="T4" fmla="*/ 116 w 2520"/>
                <a:gd name="T5" fmla="*/ 173 h 182"/>
                <a:gd name="T6" fmla="*/ 156 w 2520"/>
                <a:gd name="T7" fmla="*/ 172 h 182"/>
                <a:gd name="T8" fmla="*/ 197 w 2520"/>
                <a:gd name="T9" fmla="*/ 170 h 182"/>
                <a:gd name="T10" fmla="*/ 237 w 2520"/>
                <a:gd name="T11" fmla="*/ 169 h 182"/>
                <a:gd name="T12" fmla="*/ 277 w 2520"/>
                <a:gd name="T13" fmla="*/ 168 h 182"/>
                <a:gd name="T14" fmla="*/ 317 w 2520"/>
                <a:gd name="T15" fmla="*/ 168 h 182"/>
                <a:gd name="T16" fmla="*/ 357 w 2520"/>
                <a:gd name="T17" fmla="*/ 168 h 182"/>
                <a:gd name="T18" fmla="*/ 397 w 2520"/>
                <a:gd name="T19" fmla="*/ 169 h 182"/>
                <a:gd name="T20" fmla="*/ 438 w 2520"/>
                <a:gd name="T21" fmla="*/ 169 h 182"/>
                <a:gd name="T22" fmla="*/ 478 w 2520"/>
                <a:gd name="T23" fmla="*/ 169 h 182"/>
                <a:gd name="T24" fmla="*/ 518 w 2520"/>
                <a:gd name="T25" fmla="*/ 171 h 182"/>
                <a:gd name="T26" fmla="*/ 559 w 2520"/>
                <a:gd name="T27" fmla="*/ 171 h 182"/>
                <a:gd name="T28" fmla="*/ 599 w 2520"/>
                <a:gd name="T29" fmla="*/ 172 h 182"/>
                <a:gd name="T30" fmla="*/ 639 w 2520"/>
                <a:gd name="T31" fmla="*/ 172 h 182"/>
                <a:gd name="T32" fmla="*/ 680 w 2520"/>
                <a:gd name="T33" fmla="*/ 173 h 182"/>
                <a:gd name="T34" fmla="*/ 720 w 2520"/>
                <a:gd name="T35" fmla="*/ 173 h 182"/>
                <a:gd name="T36" fmla="*/ 760 w 2520"/>
                <a:gd name="T37" fmla="*/ 167 h 182"/>
                <a:gd name="T38" fmla="*/ 801 w 2520"/>
                <a:gd name="T39" fmla="*/ 172 h 182"/>
                <a:gd name="T40" fmla="*/ 841 w 2520"/>
                <a:gd name="T41" fmla="*/ 173 h 182"/>
                <a:gd name="T42" fmla="*/ 881 w 2520"/>
                <a:gd name="T43" fmla="*/ 173 h 182"/>
                <a:gd name="T44" fmla="*/ 922 w 2520"/>
                <a:gd name="T45" fmla="*/ 174 h 182"/>
                <a:gd name="T46" fmla="*/ 962 w 2520"/>
                <a:gd name="T47" fmla="*/ 173 h 182"/>
                <a:gd name="T48" fmla="*/ 1002 w 2520"/>
                <a:gd name="T49" fmla="*/ 174 h 182"/>
                <a:gd name="T50" fmla="*/ 1043 w 2520"/>
                <a:gd name="T51" fmla="*/ 174 h 182"/>
                <a:gd name="T52" fmla="*/ 1083 w 2520"/>
                <a:gd name="T53" fmla="*/ 174 h 182"/>
                <a:gd name="T54" fmla="*/ 1123 w 2520"/>
                <a:gd name="T55" fmla="*/ 173 h 182"/>
                <a:gd name="T56" fmla="*/ 1164 w 2520"/>
                <a:gd name="T57" fmla="*/ 169 h 182"/>
                <a:gd name="T58" fmla="*/ 1204 w 2520"/>
                <a:gd name="T59" fmla="*/ 166 h 182"/>
                <a:gd name="T60" fmla="*/ 1244 w 2520"/>
                <a:gd name="T61" fmla="*/ 171 h 182"/>
                <a:gd name="T62" fmla="*/ 1285 w 2520"/>
                <a:gd name="T63" fmla="*/ 173 h 182"/>
                <a:gd name="T64" fmla="*/ 1325 w 2520"/>
                <a:gd name="T65" fmla="*/ 173 h 182"/>
                <a:gd name="T66" fmla="*/ 1365 w 2520"/>
                <a:gd name="T67" fmla="*/ 172 h 182"/>
                <a:gd name="T68" fmla="*/ 1406 w 2520"/>
                <a:gd name="T69" fmla="*/ 173 h 182"/>
                <a:gd name="T70" fmla="*/ 1446 w 2520"/>
                <a:gd name="T71" fmla="*/ 172 h 182"/>
                <a:gd name="T72" fmla="*/ 1486 w 2520"/>
                <a:gd name="T73" fmla="*/ 172 h 182"/>
                <a:gd name="T74" fmla="*/ 1527 w 2520"/>
                <a:gd name="T75" fmla="*/ 173 h 182"/>
                <a:gd name="T76" fmla="*/ 1567 w 2520"/>
                <a:gd name="T77" fmla="*/ 172 h 182"/>
                <a:gd name="T78" fmla="*/ 1606 w 2520"/>
                <a:gd name="T79" fmla="*/ 171 h 182"/>
                <a:gd name="T80" fmla="*/ 1647 w 2520"/>
                <a:gd name="T81" fmla="*/ 169 h 182"/>
                <a:gd name="T82" fmla="*/ 1687 w 2520"/>
                <a:gd name="T83" fmla="*/ 169 h 182"/>
                <a:gd name="T84" fmla="*/ 1727 w 2520"/>
                <a:gd name="T85" fmla="*/ 169 h 182"/>
                <a:gd name="T86" fmla="*/ 1768 w 2520"/>
                <a:gd name="T87" fmla="*/ 168 h 182"/>
                <a:gd name="T88" fmla="*/ 1808 w 2520"/>
                <a:gd name="T89" fmla="*/ 167 h 182"/>
                <a:gd name="T90" fmla="*/ 1848 w 2520"/>
                <a:gd name="T91" fmla="*/ 165 h 182"/>
                <a:gd name="T92" fmla="*/ 1889 w 2520"/>
                <a:gd name="T93" fmla="*/ 164 h 182"/>
                <a:gd name="T94" fmla="*/ 1929 w 2520"/>
                <a:gd name="T95" fmla="*/ 162 h 182"/>
                <a:gd name="T96" fmla="*/ 1969 w 2520"/>
                <a:gd name="T97" fmla="*/ 155 h 182"/>
                <a:gd name="T98" fmla="*/ 2010 w 2520"/>
                <a:gd name="T99" fmla="*/ 146 h 182"/>
                <a:gd name="T100" fmla="*/ 2050 w 2520"/>
                <a:gd name="T101" fmla="*/ 151 h 182"/>
                <a:gd name="T102" fmla="*/ 2090 w 2520"/>
                <a:gd name="T103" fmla="*/ 153 h 182"/>
                <a:gd name="T104" fmla="*/ 2131 w 2520"/>
                <a:gd name="T105" fmla="*/ 59 h 182"/>
                <a:gd name="T106" fmla="*/ 2171 w 2520"/>
                <a:gd name="T107" fmla="*/ 62 h 182"/>
                <a:gd name="T108" fmla="*/ 2211 w 2520"/>
                <a:gd name="T109" fmla="*/ 105 h 182"/>
                <a:gd name="T110" fmla="*/ 2252 w 2520"/>
                <a:gd name="T111" fmla="*/ 117 h 182"/>
                <a:gd name="T112" fmla="*/ 2292 w 2520"/>
                <a:gd name="T113" fmla="*/ 67 h 182"/>
                <a:gd name="T114" fmla="*/ 2332 w 2520"/>
                <a:gd name="T115" fmla="*/ 1 h 182"/>
                <a:gd name="T116" fmla="*/ 2373 w 2520"/>
                <a:gd name="T117" fmla="*/ 44 h 182"/>
                <a:gd name="T118" fmla="*/ 2413 w 2520"/>
                <a:gd name="T119" fmla="*/ 74 h 182"/>
                <a:gd name="T120" fmla="*/ 2453 w 2520"/>
                <a:gd name="T121" fmla="*/ 91 h 182"/>
                <a:gd name="T122" fmla="*/ 2494 w 2520"/>
                <a:gd name="T123" fmla="*/ 104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520" h="182">
                  <a:moveTo>
                    <a:pt x="0" y="182"/>
                  </a:moveTo>
                  <a:lnTo>
                    <a:pt x="2" y="181"/>
                  </a:lnTo>
                  <a:lnTo>
                    <a:pt x="5" y="181"/>
                  </a:lnTo>
                  <a:lnTo>
                    <a:pt x="8" y="181"/>
                  </a:lnTo>
                  <a:lnTo>
                    <a:pt x="11" y="181"/>
                  </a:lnTo>
                  <a:lnTo>
                    <a:pt x="15" y="180"/>
                  </a:lnTo>
                  <a:lnTo>
                    <a:pt x="18" y="180"/>
                  </a:lnTo>
                  <a:lnTo>
                    <a:pt x="22" y="180"/>
                  </a:lnTo>
                  <a:lnTo>
                    <a:pt x="25" y="179"/>
                  </a:lnTo>
                  <a:lnTo>
                    <a:pt x="29" y="179"/>
                  </a:lnTo>
                  <a:lnTo>
                    <a:pt x="31" y="179"/>
                  </a:lnTo>
                  <a:lnTo>
                    <a:pt x="35" y="179"/>
                  </a:lnTo>
                  <a:lnTo>
                    <a:pt x="38" y="178"/>
                  </a:lnTo>
                  <a:lnTo>
                    <a:pt x="42" y="178"/>
                  </a:lnTo>
                  <a:lnTo>
                    <a:pt x="45" y="178"/>
                  </a:lnTo>
                  <a:lnTo>
                    <a:pt x="49" y="177"/>
                  </a:lnTo>
                  <a:lnTo>
                    <a:pt x="52" y="177"/>
                  </a:lnTo>
                  <a:lnTo>
                    <a:pt x="55" y="177"/>
                  </a:lnTo>
                  <a:lnTo>
                    <a:pt x="58" y="176"/>
                  </a:lnTo>
                  <a:lnTo>
                    <a:pt x="62" y="176"/>
                  </a:lnTo>
                  <a:lnTo>
                    <a:pt x="65" y="176"/>
                  </a:lnTo>
                  <a:lnTo>
                    <a:pt x="69" y="176"/>
                  </a:lnTo>
                  <a:lnTo>
                    <a:pt x="72" y="176"/>
                  </a:lnTo>
                  <a:lnTo>
                    <a:pt x="76" y="175"/>
                  </a:lnTo>
                  <a:lnTo>
                    <a:pt x="78" y="175"/>
                  </a:lnTo>
                  <a:lnTo>
                    <a:pt x="82" y="175"/>
                  </a:lnTo>
                  <a:lnTo>
                    <a:pt x="85" y="175"/>
                  </a:lnTo>
                  <a:lnTo>
                    <a:pt x="89" y="175"/>
                  </a:lnTo>
                  <a:lnTo>
                    <a:pt x="92" y="175"/>
                  </a:lnTo>
                  <a:lnTo>
                    <a:pt x="96" y="174"/>
                  </a:lnTo>
                  <a:lnTo>
                    <a:pt x="99" y="174"/>
                  </a:lnTo>
                  <a:lnTo>
                    <a:pt x="102" y="174"/>
                  </a:lnTo>
                  <a:lnTo>
                    <a:pt x="105" y="174"/>
                  </a:lnTo>
                  <a:lnTo>
                    <a:pt x="109" y="174"/>
                  </a:lnTo>
                  <a:lnTo>
                    <a:pt x="112" y="173"/>
                  </a:lnTo>
                  <a:lnTo>
                    <a:pt x="116" y="173"/>
                  </a:lnTo>
                  <a:lnTo>
                    <a:pt x="119" y="173"/>
                  </a:lnTo>
                  <a:lnTo>
                    <a:pt x="123" y="173"/>
                  </a:lnTo>
                  <a:lnTo>
                    <a:pt x="126" y="173"/>
                  </a:lnTo>
                  <a:lnTo>
                    <a:pt x="129" y="173"/>
                  </a:lnTo>
                  <a:lnTo>
                    <a:pt x="132" y="173"/>
                  </a:lnTo>
                  <a:lnTo>
                    <a:pt x="136" y="172"/>
                  </a:lnTo>
                  <a:lnTo>
                    <a:pt x="139" y="172"/>
                  </a:lnTo>
                  <a:lnTo>
                    <a:pt x="143" y="172"/>
                  </a:lnTo>
                  <a:lnTo>
                    <a:pt x="146" y="172"/>
                  </a:lnTo>
                  <a:lnTo>
                    <a:pt x="150" y="172"/>
                  </a:lnTo>
                  <a:lnTo>
                    <a:pt x="152" y="172"/>
                  </a:lnTo>
                  <a:lnTo>
                    <a:pt x="156" y="172"/>
                  </a:lnTo>
                  <a:lnTo>
                    <a:pt x="159" y="172"/>
                  </a:lnTo>
                  <a:lnTo>
                    <a:pt x="163" y="172"/>
                  </a:lnTo>
                  <a:lnTo>
                    <a:pt x="166" y="172"/>
                  </a:lnTo>
                  <a:lnTo>
                    <a:pt x="170" y="172"/>
                  </a:lnTo>
                  <a:lnTo>
                    <a:pt x="173" y="171"/>
                  </a:lnTo>
                  <a:lnTo>
                    <a:pt x="176" y="171"/>
                  </a:lnTo>
                  <a:lnTo>
                    <a:pt x="179" y="171"/>
                  </a:lnTo>
                  <a:lnTo>
                    <a:pt x="183" y="171"/>
                  </a:lnTo>
                  <a:lnTo>
                    <a:pt x="186" y="171"/>
                  </a:lnTo>
                  <a:lnTo>
                    <a:pt x="190" y="171"/>
                  </a:lnTo>
                  <a:lnTo>
                    <a:pt x="193" y="170"/>
                  </a:lnTo>
                  <a:lnTo>
                    <a:pt x="197" y="170"/>
                  </a:lnTo>
                  <a:lnTo>
                    <a:pt x="199" y="170"/>
                  </a:lnTo>
                  <a:lnTo>
                    <a:pt x="203" y="170"/>
                  </a:lnTo>
                  <a:lnTo>
                    <a:pt x="206" y="170"/>
                  </a:lnTo>
                  <a:lnTo>
                    <a:pt x="210" y="170"/>
                  </a:lnTo>
                  <a:lnTo>
                    <a:pt x="213" y="170"/>
                  </a:lnTo>
                  <a:lnTo>
                    <a:pt x="217" y="170"/>
                  </a:lnTo>
                  <a:lnTo>
                    <a:pt x="220" y="170"/>
                  </a:lnTo>
                  <a:lnTo>
                    <a:pt x="223" y="170"/>
                  </a:lnTo>
                  <a:lnTo>
                    <a:pt x="226" y="169"/>
                  </a:lnTo>
                  <a:lnTo>
                    <a:pt x="230" y="169"/>
                  </a:lnTo>
                  <a:lnTo>
                    <a:pt x="233" y="169"/>
                  </a:lnTo>
                  <a:lnTo>
                    <a:pt x="237" y="169"/>
                  </a:lnTo>
                  <a:lnTo>
                    <a:pt x="240" y="169"/>
                  </a:lnTo>
                  <a:lnTo>
                    <a:pt x="244" y="168"/>
                  </a:lnTo>
                  <a:lnTo>
                    <a:pt x="247" y="168"/>
                  </a:lnTo>
                  <a:lnTo>
                    <a:pt x="250" y="168"/>
                  </a:lnTo>
                  <a:lnTo>
                    <a:pt x="253" y="168"/>
                  </a:lnTo>
                  <a:lnTo>
                    <a:pt x="257" y="168"/>
                  </a:lnTo>
                  <a:lnTo>
                    <a:pt x="260" y="168"/>
                  </a:lnTo>
                  <a:lnTo>
                    <a:pt x="264" y="168"/>
                  </a:lnTo>
                  <a:lnTo>
                    <a:pt x="267" y="168"/>
                  </a:lnTo>
                  <a:lnTo>
                    <a:pt x="271" y="168"/>
                  </a:lnTo>
                  <a:lnTo>
                    <a:pt x="273" y="168"/>
                  </a:lnTo>
                  <a:lnTo>
                    <a:pt x="277" y="168"/>
                  </a:lnTo>
                  <a:lnTo>
                    <a:pt x="280" y="168"/>
                  </a:lnTo>
                  <a:lnTo>
                    <a:pt x="284" y="168"/>
                  </a:lnTo>
                  <a:lnTo>
                    <a:pt x="287" y="168"/>
                  </a:lnTo>
                  <a:lnTo>
                    <a:pt x="291" y="168"/>
                  </a:lnTo>
                  <a:lnTo>
                    <a:pt x="294" y="168"/>
                  </a:lnTo>
                  <a:lnTo>
                    <a:pt x="297" y="167"/>
                  </a:lnTo>
                  <a:lnTo>
                    <a:pt x="300" y="168"/>
                  </a:lnTo>
                  <a:lnTo>
                    <a:pt x="304" y="168"/>
                  </a:lnTo>
                  <a:lnTo>
                    <a:pt x="307" y="167"/>
                  </a:lnTo>
                  <a:lnTo>
                    <a:pt x="311" y="168"/>
                  </a:lnTo>
                  <a:lnTo>
                    <a:pt x="314" y="168"/>
                  </a:lnTo>
                  <a:lnTo>
                    <a:pt x="317" y="168"/>
                  </a:lnTo>
                  <a:lnTo>
                    <a:pt x="320" y="168"/>
                  </a:lnTo>
                  <a:lnTo>
                    <a:pt x="323" y="168"/>
                  </a:lnTo>
                  <a:lnTo>
                    <a:pt x="327" y="168"/>
                  </a:lnTo>
                  <a:lnTo>
                    <a:pt x="330" y="168"/>
                  </a:lnTo>
                  <a:lnTo>
                    <a:pt x="334" y="168"/>
                  </a:lnTo>
                  <a:lnTo>
                    <a:pt x="337" y="168"/>
                  </a:lnTo>
                  <a:lnTo>
                    <a:pt x="341" y="168"/>
                  </a:lnTo>
                  <a:lnTo>
                    <a:pt x="344" y="168"/>
                  </a:lnTo>
                  <a:lnTo>
                    <a:pt x="347" y="168"/>
                  </a:lnTo>
                  <a:lnTo>
                    <a:pt x="350" y="168"/>
                  </a:lnTo>
                  <a:lnTo>
                    <a:pt x="354" y="168"/>
                  </a:lnTo>
                  <a:lnTo>
                    <a:pt x="357" y="168"/>
                  </a:lnTo>
                  <a:lnTo>
                    <a:pt x="361" y="168"/>
                  </a:lnTo>
                  <a:lnTo>
                    <a:pt x="364" y="168"/>
                  </a:lnTo>
                  <a:lnTo>
                    <a:pt x="368" y="168"/>
                  </a:lnTo>
                  <a:lnTo>
                    <a:pt x="370" y="168"/>
                  </a:lnTo>
                  <a:lnTo>
                    <a:pt x="374" y="168"/>
                  </a:lnTo>
                  <a:lnTo>
                    <a:pt x="377" y="168"/>
                  </a:lnTo>
                  <a:lnTo>
                    <a:pt x="381" y="169"/>
                  </a:lnTo>
                  <a:lnTo>
                    <a:pt x="384" y="169"/>
                  </a:lnTo>
                  <a:lnTo>
                    <a:pt x="388" y="169"/>
                  </a:lnTo>
                  <a:lnTo>
                    <a:pt x="391" y="169"/>
                  </a:lnTo>
                  <a:lnTo>
                    <a:pt x="394" y="169"/>
                  </a:lnTo>
                  <a:lnTo>
                    <a:pt x="397" y="169"/>
                  </a:lnTo>
                  <a:lnTo>
                    <a:pt x="401" y="169"/>
                  </a:lnTo>
                  <a:lnTo>
                    <a:pt x="404" y="169"/>
                  </a:lnTo>
                  <a:lnTo>
                    <a:pt x="408" y="169"/>
                  </a:lnTo>
                  <a:lnTo>
                    <a:pt x="411" y="169"/>
                  </a:lnTo>
                  <a:lnTo>
                    <a:pt x="415" y="169"/>
                  </a:lnTo>
                  <a:lnTo>
                    <a:pt x="417" y="169"/>
                  </a:lnTo>
                  <a:lnTo>
                    <a:pt x="421" y="169"/>
                  </a:lnTo>
                  <a:lnTo>
                    <a:pt x="424" y="169"/>
                  </a:lnTo>
                  <a:lnTo>
                    <a:pt x="428" y="169"/>
                  </a:lnTo>
                  <a:lnTo>
                    <a:pt x="431" y="169"/>
                  </a:lnTo>
                  <a:lnTo>
                    <a:pt x="435" y="169"/>
                  </a:lnTo>
                  <a:lnTo>
                    <a:pt x="438" y="169"/>
                  </a:lnTo>
                  <a:lnTo>
                    <a:pt x="441" y="169"/>
                  </a:lnTo>
                  <a:lnTo>
                    <a:pt x="444" y="169"/>
                  </a:lnTo>
                  <a:lnTo>
                    <a:pt x="448" y="169"/>
                  </a:lnTo>
                  <a:lnTo>
                    <a:pt x="451" y="169"/>
                  </a:lnTo>
                  <a:lnTo>
                    <a:pt x="455" y="169"/>
                  </a:lnTo>
                  <a:lnTo>
                    <a:pt x="458" y="169"/>
                  </a:lnTo>
                  <a:lnTo>
                    <a:pt x="462" y="169"/>
                  </a:lnTo>
                  <a:lnTo>
                    <a:pt x="465" y="169"/>
                  </a:lnTo>
                  <a:lnTo>
                    <a:pt x="468" y="169"/>
                  </a:lnTo>
                  <a:lnTo>
                    <a:pt x="471" y="169"/>
                  </a:lnTo>
                  <a:lnTo>
                    <a:pt x="475" y="169"/>
                  </a:lnTo>
                  <a:lnTo>
                    <a:pt x="478" y="169"/>
                  </a:lnTo>
                  <a:lnTo>
                    <a:pt x="482" y="169"/>
                  </a:lnTo>
                  <a:lnTo>
                    <a:pt x="485" y="169"/>
                  </a:lnTo>
                  <a:lnTo>
                    <a:pt x="489" y="170"/>
                  </a:lnTo>
                  <a:lnTo>
                    <a:pt x="491" y="170"/>
                  </a:lnTo>
                  <a:lnTo>
                    <a:pt x="495" y="170"/>
                  </a:lnTo>
                  <a:lnTo>
                    <a:pt x="498" y="170"/>
                  </a:lnTo>
                  <a:lnTo>
                    <a:pt x="502" y="170"/>
                  </a:lnTo>
                  <a:lnTo>
                    <a:pt x="505" y="170"/>
                  </a:lnTo>
                  <a:lnTo>
                    <a:pt x="509" y="170"/>
                  </a:lnTo>
                  <a:lnTo>
                    <a:pt x="512" y="170"/>
                  </a:lnTo>
                  <a:lnTo>
                    <a:pt x="515" y="170"/>
                  </a:lnTo>
                  <a:lnTo>
                    <a:pt x="518" y="171"/>
                  </a:lnTo>
                  <a:lnTo>
                    <a:pt x="522" y="171"/>
                  </a:lnTo>
                  <a:lnTo>
                    <a:pt x="525" y="171"/>
                  </a:lnTo>
                  <a:lnTo>
                    <a:pt x="529" y="171"/>
                  </a:lnTo>
                  <a:lnTo>
                    <a:pt x="532" y="171"/>
                  </a:lnTo>
                  <a:lnTo>
                    <a:pt x="536" y="171"/>
                  </a:lnTo>
                  <a:lnTo>
                    <a:pt x="538" y="171"/>
                  </a:lnTo>
                  <a:lnTo>
                    <a:pt x="542" y="171"/>
                  </a:lnTo>
                  <a:lnTo>
                    <a:pt x="545" y="171"/>
                  </a:lnTo>
                  <a:lnTo>
                    <a:pt x="549" y="171"/>
                  </a:lnTo>
                  <a:lnTo>
                    <a:pt x="552" y="171"/>
                  </a:lnTo>
                  <a:lnTo>
                    <a:pt x="556" y="171"/>
                  </a:lnTo>
                  <a:lnTo>
                    <a:pt x="559" y="171"/>
                  </a:lnTo>
                  <a:lnTo>
                    <a:pt x="563" y="171"/>
                  </a:lnTo>
                  <a:lnTo>
                    <a:pt x="565" y="171"/>
                  </a:lnTo>
                  <a:lnTo>
                    <a:pt x="569" y="171"/>
                  </a:lnTo>
                  <a:lnTo>
                    <a:pt x="572" y="171"/>
                  </a:lnTo>
                  <a:lnTo>
                    <a:pt x="576" y="171"/>
                  </a:lnTo>
                  <a:lnTo>
                    <a:pt x="579" y="171"/>
                  </a:lnTo>
                  <a:lnTo>
                    <a:pt x="583" y="171"/>
                  </a:lnTo>
                  <a:lnTo>
                    <a:pt x="586" y="172"/>
                  </a:lnTo>
                  <a:lnTo>
                    <a:pt x="589" y="172"/>
                  </a:lnTo>
                  <a:lnTo>
                    <a:pt x="592" y="172"/>
                  </a:lnTo>
                  <a:lnTo>
                    <a:pt x="596" y="172"/>
                  </a:lnTo>
                  <a:lnTo>
                    <a:pt x="599" y="172"/>
                  </a:lnTo>
                  <a:lnTo>
                    <a:pt x="603" y="172"/>
                  </a:lnTo>
                  <a:lnTo>
                    <a:pt x="606" y="172"/>
                  </a:lnTo>
                  <a:lnTo>
                    <a:pt x="610" y="172"/>
                  </a:lnTo>
                  <a:lnTo>
                    <a:pt x="612" y="172"/>
                  </a:lnTo>
                  <a:lnTo>
                    <a:pt x="616" y="172"/>
                  </a:lnTo>
                  <a:lnTo>
                    <a:pt x="619" y="172"/>
                  </a:lnTo>
                  <a:lnTo>
                    <a:pt x="623" y="172"/>
                  </a:lnTo>
                  <a:lnTo>
                    <a:pt x="626" y="172"/>
                  </a:lnTo>
                  <a:lnTo>
                    <a:pt x="630" y="172"/>
                  </a:lnTo>
                  <a:lnTo>
                    <a:pt x="633" y="172"/>
                  </a:lnTo>
                  <a:lnTo>
                    <a:pt x="636" y="172"/>
                  </a:lnTo>
                  <a:lnTo>
                    <a:pt x="639" y="172"/>
                  </a:lnTo>
                  <a:lnTo>
                    <a:pt x="643" y="172"/>
                  </a:lnTo>
                  <a:lnTo>
                    <a:pt x="646" y="172"/>
                  </a:lnTo>
                  <a:lnTo>
                    <a:pt x="650" y="172"/>
                  </a:lnTo>
                  <a:lnTo>
                    <a:pt x="653" y="172"/>
                  </a:lnTo>
                  <a:lnTo>
                    <a:pt x="657" y="173"/>
                  </a:lnTo>
                  <a:lnTo>
                    <a:pt x="659" y="173"/>
                  </a:lnTo>
                  <a:lnTo>
                    <a:pt x="663" y="173"/>
                  </a:lnTo>
                  <a:lnTo>
                    <a:pt x="666" y="173"/>
                  </a:lnTo>
                  <a:lnTo>
                    <a:pt x="670" y="173"/>
                  </a:lnTo>
                  <a:lnTo>
                    <a:pt x="673" y="173"/>
                  </a:lnTo>
                  <a:lnTo>
                    <a:pt x="677" y="173"/>
                  </a:lnTo>
                  <a:lnTo>
                    <a:pt x="680" y="173"/>
                  </a:lnTo>
                  <a:lnTo>
                    <a:pt x="684" y="173"/>
                  </a:lnTo>
                  <a:lnTo>
                    <a:pt x="686" y="173"/>
                  </a:lnTo>
                  <a:lnTo>
                    <a:pt x="690" y="173"/>
                  </a:lnTo>
                  <a:lnTo>
                    <a:pt x="693" y="173"/>
                  </a:lnTo>
                  <a:lnTo>
                    <a:pt x="697" y="173"/>
                  </a:lnTo>
                  <a:lnTo>
                    <a:pt x="700" y="173"/>
                  </a:lnTo>
                  <a:lnTo>
                    <a:pt x="704" y="173"/>
                  </a:lnTo>
                  <a:lnTo>
                    <a:pt x="707" y="173"/>
                  </a:lnTo>
                  <a:lnTo>
                    <a:pt x="710" y="173"/>
                  </a:lnTo>
                  <a:lnTo>
                    <a:pt x="713" y="173"/>
                  </a:lnTo>
                  <a:lnTo>
                    <a:pt x="717" y="173"/>
                  </a:lnTo>
                  <a:lnTo>
                    <a:pt x="720" y="173"/>
                  </a:lnTo>
                  <a:lnTo>
                    <a:pt x="724" y="173"/>
                  </a:lnTo>
                  <a:lnTo>
                    <a:pt x="727" y="173"/>
                  </a:lnTo>
                  <a:lnTo>
                    <a:pt x="731" y="172"/>
                  </a:lnTo>
                  <a:lnTo>
                    <a:pt x="733" y="172"/>
                  </a:lnTo>
                  <a:lnTo>
                    <a:pt x="737" y="171"/>
                  </a:lnTo>
                  <a:lnTo>
                    <a:pt x="740" y="170"/>
                  </a:lnTo>
                  <a:lnTo>
                    <a:pt x="744" y="169"/>
                  </a:lnTo>
                  <a:lnTo>
                    <a:pt x="747" y="168"/>
                  </a:lnTo>
                  <a:lnTo>
                    <a:pt x="751" y="167"/>
                  </a:lnTo>
                  <a:lnTo>
                    <a:pt x="754" y="167"/>
                  </a:lnTo>
                  <a:lnTo>
                    <a:pt x="757" y="167"/>
                  </a:lnTo>
                  <a:lnTo>
                    <a:pt x="760" y="167"/>
                  </a:lnTo>
                  <a:lnTo>
                    <a:pt x="764" y="168"/>
                  </a:lnTo>
                  <a:lnTo>
                    <a:pt x="767" y="169"/>
                  </a:lnTo>
                  <a:lnTo>
                    <a:pt x="771" y="169"/>
                  </a:lnTo>
                  <a:lnTo>
                    <a:pt x="774" y="170"/>
                  </a:lnTo>
                  <a:lnTo>
                    <a:pt x="778" y="170"/>
                  </a:lnTo>
                  <a:lnTo>
                    <a:pt x="780" y="171"/>
                  </a:lnTo>
                  <a:lnTo>
                    <a:pt x="784" y="171"/>
                  </a:lnTo>
                  <a:lnTo>
                    <a:pt x="787" y="171"/>
                  </a:lnTo>
                  <a:lnTo>
                    <a:pt x="791" y="171"/>
                  </a:lnTo>
                  <a:lnTo>
                    <a:pt x="794" y="172"/>
                  </a:lnTo>
                  <a:lnTo>
                    <a:pt x="798" y="172"/>
                  </a:lnTo>
                  <a:lnTo>
                    <a:pt x="801" y="172"/>
                  </a:lnTo>
                  <a:lnTo>
                    <a:pt x="805" y="172"/>
                  </a:lnTo>
                  <a:lnTo>
                    <a:pt x="807" y="172"/>
                  </a:lnTo>
                  <a:lnTo>
                    <a:pt x="811" y="172"/>
                  </a:lnTo>
                  <a:lnTo>
                    <a:pt x="814" y="172"/>
                  </a:lnTo>
                  <a:lnTo>
                    <a:pt x="818" y="172"/>
                  </a:lnTo>
                  <a:lnTo>
                    <a:pt x="821" y="173"/>
                  </a:lnTo>
                  <a:lnTo>
                    <a:pt x="825" y="173"/>
                  </a:lnTo>
                  <a:lnTo>
                    <a:pt x="828" y="173"/>
                  </a:lnTo>
                  <a:lnTo>
                    <a:pt x="831" y="173"/>
                  </a:lnTo>
                  <a:lnTo>
                    <a:pt x="834" y="173"/>
                  </a:lnTo>
                  <a:lnTo>
                    <a:pt x="838" y="173"/>
                  </a:lnTo>
                  <a:lnTo>
                    <a:pt x="841" y="173"/>
                  </a:lnTo>
                  <a:lnTo>
                    <a:pt x="845" y="173"/>
                  </a:lnTo>
                  <a:lnTo>
                    <a:pt x="848" y="173"/>
                  </a:lnTo>
                  <a:lnTo>
                    <a:pt x="852" y="173"/>
                  </a:lnTo>
                  <a:lnTo>
                    <a:pt x="854" y="173"/>
                  </a:lnTo>
                  <a:lnTo>
                    <a:pt x="858" y="173"/>
                  </a:lnTo>
                  <a:lnTo>
                    <a:pt x="861" y="173"/>
                  </a:lnTo>
                  <a:lnTo>
                    <a:pt x="865" y="173"/>
                  </a:lnTo>
                  <a:lnTo>
                    <a:pt x="868" y="173"/>
                  </a:lnTo>
                  <a:lnTo>
                    <a:pt x="872" y="173"/>
                  </a:lnTo>
                  <a:lnTo>
                    <a:pt x="875" y="173"/>
                  </a:lnTo>
                  <a:lnTo>
                    <a:pt x="878" y="173"/>
                  </a:lnTo>
                  <a:lnTo>
                    <a:pt x="881" y="173"/>
                  </a:lnTo>
                  <a:lnTo>
                    <a:pt x="885" y="173"/>
                  </a:lnTo>
                  <a:lnTo>
                    <a:pt x="888" y="173"/>
                  </a:lnTo>
                  <a:lnTo>
                    <a:pt x="892" y="173"/>
                  </a:lnTo>
                  <a:lnTo>
                    <a:pt x="895" y="173"/>
                  </a:lnTo>
                  <a:lnTo>
                    <a:pt x="899" y="173"/>
                  </a:lnTo>
                  <a:lnTo>
                    <a:pt x="902" y="173"/>
                  </a:lnTo>
                  <a:lnTo>
                    <a:pt x="905" y="173"/>
                  </a:lnTo>
                  <a:lnTo>
                    <a:pt x="908" y="173"/>
                  </a:lnTo>
                  <a:lnTo>
                    <a:pt x="912" y="173"/>
                  </a:lnTo>
                  <a:lnTo>
                    <a:pt x="915" y="173"/>
                  </a:lnTo>
                  <a:lnTo>
                    <a:pt x="919" y="173"/>
                  </a:lnTo>
                  <a:lnTo>
                    <a:pt x="922" y="174"/>
                  </a:lnTo>
                  <a:lnTo>
                    <a:pt x="926" y="174"/>
                  </a:lnTo>
                  <a:lnTo>
                    <a:pt x="928" y="174"/>
                  </a:lnTo>
                  <a:lnTo>
                    <a:pt x="932" y="174"/>
                  </a:lnTo>
                  <a:lnTo>
                    <a:pt x="935" y="173"/>
                  </a:lnTo>
                  <a:lnTo>
                    <a:pt x="939" y="173"/>
                  </a:lnTo>
                  <a:lnTo>
                    <a:pt x="942" y="173"/>
                  </a:lnTo>
                  <a:lnTo>
                    <a:pt x="945" y="173"/>
                  </a:lnTo>
                  <a:lnTo>
                    <a:pt x="949" y="173"/>
                  </a:lnTo>
                  <a:lnTo>
                    <a:pt x="951" y="173"/>
                  </a:lnTo>
                  <a:lnTo>
                    <a:pt x="955" y="173"/>
                  </a:lnTo>
                  <a:lnTo>
                    <a:pt x="958" y="173"/>
                  </a:lnTo>
                  <a:lnTo>
                    <a:pt x="962" y="173"/>
                  </a:lnTo>
                  <a:lnTo>
                    <a:pt x="965" y="173"/>
                  </a:lnTo>
                  <a:lnTo>
                    <a:pt x="969" y="174"/>
                  </a:lnTo>
                  <a:lnTo>
                    <a:pt x="972" y="174"/>
                  </a:lnTo>
                  <a:lnTo>
                    <a:pt x="975" y="174"/>
                  </a:lnTo>
                  <a:lnTo>
                    <a:pt x="978" y="174"/>
                  </a:lnTo>
                  <a:lnTo>
                    <a:pt x="982" y="174"/>
                  </a:lnTo>
                  <a:lnTo>
                    <a:pt x="985" y="174"/>
                  </a:lnTo>
                  <a:lnTo>
                    <a:pt x="989" y="174"/>
                  </a:lnTo>
                  <a:lnTo>
                    <a:pt x="992" y="174"/>
                  </a:lnTo>
                  <a:lnTo>
                    <a:pt x="996" y="174"/>
                  </a:lnTo>
                  <a:lnTo>
                    <a:pt x="998" y="174"/>
                  </a:lnTo>
                  <a:lnTo>
                    <a:pt x="1002" y="174"/>
                  </a:lnTo>
                  <a:lnTo>
                    <a:pt x="1005" y="174"/>
                  </a:lnTo>
                  <a:lnTo>
                    <a:pt x="1009" y="174"/>
                  </a:lnTo>
                  <a:lnTo>
                    <a:pt x="1012" y="174"/>
                  </a:lnTo>
                  <a:lnTo>
                    <a:pt x="1016" y="174"/>
                  </a:lnTo>
                  <a:lnTo>
                    <a:pt x="1019" y="174"/>
                  </a:lnTo>
                  <a:lnTo>
                    <a:pt x="1023" y="174"/>
                  </a:lnTo>
                  <a:lnTo>
                    <a:pt x="1025" y="174"/>
                  </a:lnTo>
                  <a:lnTo>
                    <a:pt x="1029" y="174"/>
                  </a:lnTo>
                  <a:lnTo>
                    <a:pt x="1032" y="174"/>
                  </a:lnTo>
                  <a:lnTo>
                    <a:pt x="1036" y="174"/>
                  </a:lnTo>
                  <a:lnTo>
                    <a:pt x="1039" y="174"/>
                  </a:lnTo>
                  <a:lnTo>
                    <a:pt x="1043" y="174"/>
                  </a:lnTo>
                  <a:lnTo>
                    <a:pt x="1046" y="174"/>
                  </a:lnTo>
                  <a:lnTo>
                    <a:pt x="1049" y="174"/>
                  </a:lnTo>
                  <a:lnTo>
                    <a:pt x="1052" y="174"/>
                  </a:lnTo>
                  <a:lnTo>
                    <a:pt x="1056" y="174"/>
                  </a:lnTo>
                  <a:lnTo>
                    <a:pt x="1059" y="174"/>
                  </a:lnTo>
                  <a:lnTo>
                    <a:pt x="1063" y="174"/>
                  </a:lnTo>
                  <a:lnTo>
                    <a:pt x="1066" y="174"/>
                  </a:lnTo>
                  <a:lnTo>
                    <a:pt x="1070" y="174"/>
                  </a:lnTo>
                  <a:lnTo>
                    <a:pt x="1072" y="174"/>
                  </a:lnTo>
                  <a:lnTo>
                    <a:pt x="1076" y="174"/>
                  </a:lnTo>
                  <a:lnTo>
                    <a:pt x="1079" y="174"/>
                  </a:lnTo>
                  <a:lnTo>
                    <a:pt x="1083" y="174"/>
                  </a:lnTo>
                  <a:lnTo>
                    <a:pt x="1086" y="174"/>
                  </a:lnTo>
                  <a:lnTo>
                    <a:pt x="1090" y="174"/>
                  </a:lnTo>
                  <a:lnTo>
                    <a:pt x="1093" y="174"/>
                  </a:lnTo>
                  <a:lnTo>
                    <a:pt x="1096" y="174"/>
                  </a:lnTo>
                  <a:lnTo>
                    <a:pt x="1099" y="174"/>
                  </a:lnTo>
                  <a:lnTo>
                    <a:pt x="1103" y="174"/>
                  </a:lnTo>
                  <a:lnTo>
                    <a:pt x="1106" y="174"/>
                  </a:lnTo>
                  <a:lnTo>
                    <a:pt x="1110" y="173"/>
                  </a:lnTo>
                  <a:lnTo>
                    <a:pt x="1113" y="173"/>
                  </a:lnTo>
                  <a:lnTo>
                    <a:pt x="1117" y="173"/>
                  </a:lnTo>
                  <a:lnTo>
                    <a:pt x="1120" y="173"/>
                  </a:lnTo>
                  <a:lnTo>
                    <a:pt x="1123" y="173"/>
                  </a:lnTo>
                  <a:lnTo>
                    <a:pt x="1126" y="172"/>
                  </a:lnTo>
                  <a:lnTo>
                    <a:pt x="1130" y="172"/>
                  </a:lnTo>
                  <a:lnTo>
                    <a:pt x="1133" y="172"/>
                  </a:lnTo>
                  <a:lnTo>
                    <a:pt x="1137" y="171"/>
                  </a:lnTo>
                  <a:lnTo>
                    <a:pt x="1140" y="171"/>
                  </a:lnTo>
                  <a:lnTo>
                    <a:pt x="1144" y="170"/>
                  </a:lnTo>
                  <a:lnTo>
                    <a:pt x="1146" y="170"/>
                  </a:lnTo>
                  <a:lnTo>
                    <a:pt x="1150" y="170"/>
                  </a:lnTo>
                  <a:lnTo>
                    <a:pt x="1153" y="170"/>
                  </a:lnTo>
                  <a:lnTo>
                    <a:pt x="1157" y="169"/>
                  </a:lnTo>
                  <a:lnTo>
                    <a:pt x="1160" y="169"/>
                  </a:lnTo>
                  <a:lnTo>
                    <a:pt x="1164" y="169"/>
                  </a:lnTo>
                  <a:lnTo>
                    <a:pt x="1167" y="169"/>
                  </a:lnTo>
                  <a:lnTo>
                    <a:pt x="1170" y="169"/>
                  </a:lnTo>
                  <a:lnTo>
                    <a:pt x="1173" y="169"/>
                  </a:lnTo>
                  <a:lnTo>
                    <a:pt x="1177" y="169"/>
                  </a:lnTo>
                  <a:lnTo>
                    <a:pt x="1180" y="168"/>
                  </a:lnTo>
                  <a:lnTo>
                    <a:pt x="1184" y="168"/>
                  </a:lnTo>
                  <a:lnTo>
                    <a:pt x="1187" y="168"/>
                  </a:lnTo>
                  <a:lnTo>
                    <a:pt x="1191" y="167"/>
                  </a:lnTo>
                  <a:lnTo>
                    <a:pt x="1193" y="167"/>
                  </a:lnTo>
                  <a:lnTo>
                    <a:pt x="1197" y="166"/>
                  </a:lnTo>
                  <a:lnTo>
                    <a:pt x="1200" y="166"/>
                  </a:lnTo>
                  <a:lnTo>
                    <a:pt x="1204" y="166"/>
                  </a:lnTo>
                  <a:lnTo>
                    <a:pt x="1207" y="166"/>
                  </a:lnTo>
                  <a:lnTo>
                    <a:pt x="1211" y="166"/>
                  </a:lnTo>
                  <a:lnTo>
                    <a:pt x="1214" y="166"/>
                  </a:lnTo>
                  <a:lnTo>
                    <a:pt x="1217" y="167"/>
                  </a:lnTo>
                  <a:lnTo>
                    <a:pt x="1220" y="167"/>
                  </a:lnTo>
                  <a:lnTo>
                    <a:pt x="1224" y="168"/>
                  </a:lnTo>
                  <a:lnTo>
                    <a:pt x="1227" y="168"/>
                  </a:lnTo>
                  <a:lnTo>
                    <a:pt x="1231" y="169"/>
                  </a:lnTo>
                  <a:lnTo>
                    <a:pt x="1234" y="169"/>
                  </a:lnTo>
                  <a:lnTo>
                    <a:pt x="1238" y="170"/>
                  </a:lnTo>
                  <a:lnTo>
                    <a:pt x="1241" y="170"/>
                  </a:lnTo>
                  <a:lnTo>
                    <a:pt x="1244" y="171"/>
                  </a:lnTo>
                  <a:lnTo>
                    <a:pt x="1247" y="171"/>
                  </a:lnTo>
                  <a:lnTo>
                    <a:pt x="1251" y="172"/>
                  </a:lnTo>
                  <a:lnTo>
                    <a:pt x="1254" y="172"/>
                  </a:lnTo>
                  <a:lnTo>
                    <a:pt x="1258" y="172"/>
                  </a:lnTo>
                  <a:lnTo>
                    <a:pt x="1261" y="173"/>
                  </a:lnTo>
                  <a:lnTo>
                    <a:pt x="1265" y="173"/>
                  </a:lnTo>
                  <a:lnTo>
                    <a:pt x="1267" y="173"/>
                  </a:lnTo>
                  <a:lnTo>
                    <a:pt x="1271" y="173"/>
                  </a:lnTo>
                  <a:lnTo>
                    <a:pt x="1274" y="173"/>
                  </a:lnTo>
                  <a:lnTo>
                    <a:pt x="1278" y="173"/>
                  </a:lnTo>
                  <a:lnTo>
                    <a:pt x="1281" y="173"/>
                  </a:lnTo>
                  <a:lnTo>
                    <a:pt x="1285" y="173"/>
                  </a:lnTo>
                  <a:lnTo>
                    <a:pt x="1288" y="173"/>
                  </a:lnTo>
                  <a:lnTo>
                    <a:pt x="1291" y="173"/>
                  </a:lnTo>
                  <a:lnTo>
                    <a:pt x="1294" y="173"/>
                  </a:lnTo>
                  <a:lnTo>
                    <a:pt x="1298" y="173"/>
                  </a:lnTo>
                  <a:lnTo>
                    <a:pt x="1301" y="173"/>
                  </a:lnTo>
                  <a:lnTo>
                    <a:pt x="1305" y="173"/>
                  </a:lnTo>
                  <a:lnTo>
                    <a:pt x="1308" y="173"/>
                  </a:lnTo>
                  <a:lnTo>
                    <a:pt x="1312" y="173"/>
                  </a:lnTo>
                  <a:lnTo>
                    <a:pt x="1314" y="173"/>
                  </a:lnTo>
                  <a:lnTo>
                    <a:pt x="1318" y="173"/>
                  </a:lnTo>
                  <a:lnTo>
                    <a:pt x="1321" y="173"/>
                  </a:lnTo>
                  <a:lnTo>
                    <a:pt x="1325" y="173"/>
                  </a:lnTo>
                  <a:lnTo>
                    <a:pt x="1328" y="173"/>
                  </a:lnTo>
                  <a:lnTo>
                    <a:pt x="1332" y="173"/>
                  </a:lnTo>
                  <a:lnTo>
                    <a:pt x="1335" y="173"/>
                  </a:lnTo>
                  <a:lnTo>
                    <a:pt x="1338" y="173"/>
                  </a:lnTo>
                  <a:lnTo>
                    <a:pt x="1341" y="173"/>
                  </a:lnTo>
                  <a:lnTo>
                    <a:pt x="1345" y="173"/>
                  </a:lnTo>
                  <a:lnTo>
                    <a:pt x="1348" y="173"/>
                  </a:lnTo>
                  <a:lnTo>
                    <a:pt x="1352" y="173"/>
                  </a:lnTo>
                  <a:lnTo>
                    <a:pt x="1355" y="173"/>
                  </a:lnTo>
                  <a:lnTo>
                    <a:pt x="1359" y="172"/>
                  </a:lnTo>
                  <a:lnTo>
                    <a:pt x="1362" y="172"/>
                  </a:lnTo>
                  <a:lnTo>
                    <a:pt x="1365" y="172"/>
                  </a:lnTo>
                  <a:lnTo>
                    <a:pt x="1368" y="172"/>
                  </a:lnTo>
                  <a:lnTo>
                    <a:pt x="1372" y="172"/>
                  </a:lnTo>
                  <a:lnTo>
                    <a:pt x="1375" y="172"/>
                  </a:lnTo>
                  <a:lnTo>
                    <a:pt x="1379" y="172"/>
                  </a:lnTo>
                  <a:lnTo>
                    <a:pt x="1382" y="173"/>
                  </a:lnTo>
                  <a:lnTo>
                    <a:pt x="1386" y="173"/>
                  </a:lnTo>
                  <a:lnTo>
                    <a:pt x="1388" y="173"/>
                  </a:lnTo>
                  <a:lnTo>
                    <a:pt x="1392" y="173"/>
                  </a:lnTo>
                  <a:lnTo>
                    <a:pt x="1395" y="172"/>
                  </a:lnTo>
                  <a:lnTo>
                    <a:pt x="1399" y="173"/>
                  </a:lnTo>
                  <a:lnTo>
                    <a:pt x="1402" y="172"/>
                  </a:lnTo>
                  <a:lnTo>
                    <a:pt x="1406" y="173"/>
                  </a:lnTo>
                  <a:lnTo>
                    <a:pt x="1409" y="173"/>
                  </a:lnTo>
                  <a:lnTo>
                    <a:pt x="1412" y="172"/>
                  </a:lnTo>
                  <a:lnTo>
                    <a:pt x="1415" y="172"/>
                  </a:lnTo>
                  <a:lnTo>
                    <a:pt x="1419" y="172"/>
                  </a:lnTo>
                  <a:lnTo>
                    <a:pt x="1422" y="172"/>
                  </a:lnTo>
                  <a:lnTo>
                    <a:pt x="1426" y="172"/>
                  </a:lnTo>
                  <a:lnTo>
                    <a:pt x="1429" y="172"/>
                  </a:lnTo>
                  <a:lnTo>
                    <a:pt x="1433" y="173"/>
                  </a:lnTo>
                  <a:lnTo>
                    <a:pt x="1435" y="172"/>
                  </a:lnTo>
                  <a:lnTo>
                    <a:pt x="1439" y="172"/>
                  </a:lnTo>
                  <a:lnTo>
                    <a:pt x="1442" y="172"/>
                  </a:lnTo>
                  <a:lnTo>
                    <a:pt x="1446" y="172"/>
                  </a:lnTo>
                  <a:lnTo>
                    <a:pt x="1449" y="172"/>
                  </a:lnTo>
                  <a:lnTo>
                    <a:pt x="1453" y="172"/>
                  </a:lnTo>
                  <a:lnTo>
                    <a:pt x="1456" y="172"/>
                  </a:lnTo>
                  <a:lnTo>
                    <a:pt x="1459" y="172"/>
                  </a:lnTo>
                  <a:lnTo>
                    <a:pt x="1462" y="172"/>
                  </a:lnTo>
                  <a:lnTo>
                    <a:pt x="1466" y="172"/>
                  </a:lnTo>
                  <a:lnTo>
                    <a:pt x="1469" y="172"/>
                  </a:lnTo>
                  <a:lnTo>
                    <a:pt x="1473" y="172"/>
                  </a:lnTo>
                  <a:lnTo>
                    <a:pt x="1476" y="172"/>
                  </a:lnTo>
                  <a:lnTo>
                    <a:pt x="1480" y="172"/>
                  </a:lnTo>
                  <a:lnTo>
                    <a:pt x="1483" y="172"/>
                  </a:lnTo>
                  <a:lnTo>
                    <a:pt x="1486" y="172"/>
                  </a:lnTo>
                  <a:lnTo>
                    <a:pt x="1489" y="172"/>
                  </a:lnTo>
                  <a:lnTo>
                    <a:pt x="1493" y="173"/>
                  </a:lnTo>
                  <a:lnTo>
                    <a:pt x="1496" y="172"/>
                  </a:lnTo>
                  <a:lnTo>
                    <a:pt x="1500" y="172"/>
                  </a:lnTo>
                  <a:lnTo>
                    <a:pt x="1503" y="173"/>
                  </a:lnTo>
                  <a:lnTo>
                    <a:pt x="1507" y="173"/>
                  </a:lnTo>
                  <a:lnTo>
                    <a:pt x="1509" y="173"/>
                  </a:lnTo>
                  <a:lnTo>
                    <a:pt x="1513" y="173"/>
                  </a:lnTo>
                  <a:lnTo>
                    <a:pt x="1516" y="173"/>
                  </a:lnTo>
                  <a:lnTo>
                    <a:pt x="1520" y="173"/>
                  </a:lnTo>
                  <a:lnTo>
                    <a:pt x="1523" y="173"/>
                  </a:lnTo>
                  <a:lnTo>
                    <a:pt x="1527" y="173"/>
                  </a:lnTo>
                  <a:lnTo>
                    <a:pt x="1530" y="172"/>
                  </a:lnTo>
                  <a:lnTo>
                    <a:pt x="1533" y="172"/>
                  </a:lnTo>
                  <a:lnTo>
                    <a:pt x="1536" y="172"/>
                  </a:lnTo>
                  <a:lnTo>
                    <a:pt x="1540" y="172"/>
                  </a:lnTo>
                  <a:lnTo>
                    <a:pt x="1543" y="172"/>
                  </a:lnTo>
                  <a:lnTo>
                    <a:pt x="1547" y="172"/>
                  </a:lnTo>
                  <a:lnTo>
                    <a:pt x="1550" y="172"/>
                  </a:lnTo>
                  <a:lnTo>
                    <a:pt x="1554" y="172"/>
                  </a:lnTo>
                  <a:lnTo>
                    <a:pt x="1556" y="172"/>
                  </a:lnTo>
                  <a:lnTo>
                    <a:pt x="1560" y="172"/>
                  </a:lnTo>
                  <a:lnTo>
                    <a:pt x="1563" y="172"/>
                  </a:lnTo>
                  <a:lnTo>
                    <a:pt x="1567" y="172"/>
                  </a:lnTo>
                  <a:lnTo>
                    <a:pt x="1570" y="172"/>
                  </a:lnTo>
                  <a:lnTo>
                    <a:pt x="1574" y="171"/>
                  </a:lnTo>
                  <a:lnTo>
                    <a:pt x="1577" y="172"/>
                  </a:lnTo>
                  <a:lnTo>
                    <a:pt x="1580" y="172"/>
                  </a:lnTo>
                  <a:lnTo>
                    <a:pt x="1583" y="172"/>
                  </a:lnTo>
                  <a:lnTo>
                    <a:pt x="1586" y="172"/>
                  </a:lnTo>
                  <a:lnTo>
                    <a:pt x="1590" y="172"/>
                  </a:lnTo>
                  <a:lnTo>
                    <a:pt x="1593" y="172"/>
                  </a:lnTo>
                  <a:lnTo>
                    <a:pt x="1597" y="171"/>
                  </a:lnTo>
                  <a:lnTo>
                    <a:pt x="1600" y="171"/>
                  </a:lnTo>
                  <a:lnTo>
                    <a:pt x="1604" y="171"/>
                  </a:lnTo>
                  <a:lnTo>
                    <a:pt x="1606" y="171"/>
                  </a:lnTo>
                  <a:lnTo>
                    <a:pt x="1610" y="171"/>
                  </a:lnTo>
                  <a:lnTo>
                    <a:pt x="1613" y="171"/>
                  </a:lnTo>
                  <a:lnTo>
                    <a:pt x="1617" y="171"/>
                  </a:lnTo>
                  <a:lnTo>
                    <a:pt x="1620" y="171"/>
                  </a:lnTo>
                  <a:lnTo>
                    <a:pt x="1624" y="171"/>
                  </a:lnTo>
                  <a:lnTo>
                    <a:pt x="1627" y="171"/>
                  </a:lnTo>
                  <a:lnTo>
                    <a:pt x="1630" y="170"/>
                  </a:lnTo>
                  <a:lnTo>
                    <a:pt x="1633" y="170"/>
                  </a:lnTo>
                  <a:lnTo>
                    <a:pt x="1637" y="170"/>
                  </a:lnTo>
                  <a:lnTo>
                    <a:pt x="1640" y="170"/>
                  </a:lnTo>
                  <a:lnTo>
                    <a:pt x="1644" y="169"/>
                  </a:lnTo>
                  <a:lnTo>
                    <a:pt x="1647" y="169"/>
                  </a:lnTo>
                  <a:lnTo>
                    <a:pt x="1651" y="169"/>
                  </a:lnTo>
                  <a:lnTo>
                    <a:pt x="1653" y="169"/>
                  </a:lnTo>
                  <a:lnTo>
                    <a:pt x="1657" y="168"/>
                  </a:lnTo>
                  <a:lnTo>
                    <a:pt x="1660" y="168"/>
                  </a:lnTo>
                  <a:lnTo>
                    <a:pt x="1664" y="168"/>
                  </a:lnTo>
                  <a:lnTo>
                    <a:pt x="1667" y="168"/>
                  </a:lnTo>
                  <a:lnTo>
                    <a:pt x="1671" y="168"/>
                  </a:lnTo>
                  <a:lnTo>
                    <a:pt x="1674" y="168"/>
                  </a:lnTo>
                  <a:lnTo>
                    <a:pt x="1677" y="168"/>
                  </a:lnTo>
                  <a:lnTo>
                    <a:pt x="1680" y="168"/>
                  </a:lnTo>
                  <a:lnTo>
                    <a:pt x="1684" y="169"/>
                  </a:lnTo>
                  <a:lnTo>
                    <a:pt x="1687" y="169"/>
                  </a:lnTo>
                  <a:lnTo>
                    <a:pt x="1691" y="169"/>
                  </a:lnTo>
                  <a:lnTo>
                    <a:pt x="1694" y="169"/>
                  </a:lnTo>
                  <a:lnTo>
                    <a:pt x="1698" y="169"/>
                  </a:lnTo>
                  <a:lnTo>
                    <a:pt x="1701" y="169"/>
                  </a:lnTo>
                  <a:lnTo>
                    <a:pt x="1704" y="169"/>
                  </a:lnTo>
                  <a:lnTo>
                    <a:pt x="1707" y="169"/>
                  </a:lnTo>
                  <a:lnTo>
                    <a:pt x="1711" y="169"/>
                  </a:lnTo>
                  <a:lnTo>
                    <a:pt x="1714" y="169"/>
                  </a:lnTo>
                  <a:lnTo>
                    <a:pt x="1718" y="169"/>
                  </a:lnTo>
                  <a:lnTo>
                    <a:pt x="1721" y="169"/>
                  </a:lnTo>
                  <a:lnTo>
                    <a:pt x="1725" y="169"/>
                  </a:lnTo>
                  <a:lnTo>
                    <a:pt x="1727" y="169"/>
                  </a:lnTo>
                  <a:lnTo>
                    <a:pt x="1731" y="169"/>
                  </a:lnTo>
                  <a:lnTo>
                    <a:pt x="1734" y="169"/>
                  </a:lnTo>
                  <a:lnTo>
                    <a:pt x="1738" y="169"/>
                  </a:lnTo>
                  <a:lnTo>
                    <a:pt x="1741" y="169"/>
                  </a:lnTo>
                  <a:lnTo>
                    <a:pt x="1745" y="169"/>
                  </a:lnTo>
                  <a:lnTo>
                    <a:pt x="1748" y="169"/>
                  </a:lnTo>
                  <a:lnTo>
                    <a:pt x="1751" y="169"/>
                  </a:lnTo>
                  <a:lnTo>
                    <a:pt x="1754" y="169"/>
                  </a:lnTo>
                  <a:lnTo>
                    <a:pt x="1758" y="168"/>
                  </a:lnTo>
                  <a:lnTo>
                    <a:pt x="1761" y="168"/>
                  </a:lnTo>
                  <a:lnTo>
                    <a:pt x="1765" y="168"/>
                  </a:lnTo>
                  <a:lnTo>
                    <a:pt x="1768" y="168"/>
                  </a:lnTo>
                  <a:lnTo>
                    <a:pt x="1772" y="168"/>
                  </a:lnTo>
                  <a:lnTo>
                    <a:pt x="1774" y="168"/>
                  </a:lnTo>
                  <a:lnTo>
                    <a:pt x="1778" y="168"/>
                  </a:lnTo>
                  <a:lnTo>
                    <a:pt x="1781" y="168"/>
                  </a:lnTo>
                  <a:lnTo>
                    <a:pt x="1785" y="168"/>
                  </a:lnTo>
                  <a:lnTo>
                    <a:pt x="1788" y="167"/>
                  </a:lnTo>
                  <a:lnTo>
                    <a:pt x="1792" y="167"/>
                  </a:lnTo>
                  <a:lnTo>
                    <a:pt x="1795" y="167"/>
                  </a:lnTo>
                  <a:lnTo>
                    <a:pt x="1798" y="167"/>
                  </a:lnTo>
                  <a:lnTo>
                    <a:pt x="1801" y="167"/>
                  </a:lnTo>
                  <a:lnTo>
                    <a:pt x="1805" y="167"/>
                  </a:lnTo>
                  <a:lnTo>
                    <a:pt x="1808" y="167"/>
                  </a:lnTo>
                  <a:lnTo>
                    <a:pt x="1812" y="166"/>
                  </a:lnTo>
                  <a:lnTo>
                    <a:pt x="1815" y="166"/>
                  </a:lnTo>
                  <a:lnTo>
                    <a:pt x="1819" y="166"/>
                  </a:lnTo>
                  <a:lnTo>
                    <a:pt x="1822" y="166"/>
                  </a:lnTo>
                  <a:lnTo>
                    <a:pt x="1825" y="166"/>
                  </a:lnTo>
                  <a:lnTo>
                    <a:pt x="1828" y="166"/>
                  </a:lnTo>
                  <a:lnTo>
                    <a:pt x="1832" y="166"/>
                  </a:lnTo>
                  <a:lnTo>
                    <a:pt x="1835" y="165"/>
                  </a:lnTo>
                  <a:lnTo>
                    <a:pt x="1839" y="165"/>
                  </a:lnTo>
                  <a:lnTo>
                    <a:pt x="1842" y="165"/>
                  </a:lnTo>
                  <a:lnTo>
                    <a:pt x="1846" y="165"/>
                  </a:lnTo>
                  <a:lnTo>
                    <a:pt x="1848" y="165"/>
                  </a:lnTo>
                  <a:lnTo>
                    <a:pt x="1852" y="165"/>
                  </a:lnTo>
                  <a:lnTo>
                    <a:pt x="1855" y="165"/>
                  </a:lnTo>
                  <a:lnTo>
                    <a:pt x="1859" y="165"/>
                  </a:lnTo>
                  <a:lnTo>
                    <a:pt x="1862" y="165"/>
                  </a:lnTo>
                  <a:lnTo>
                    <a:pt x="1866" y="165"/>
                  </a:lnTo>
                  <a:lnTo>
                    <a:pt x="1869" y="165"/>
                  </a:lnTo>
                  <a:lnTo>
                    <a:pt x="1872" y="165"/>
                  </a:lnTo>
                  <a:lnTo>
                    <a:pt x="1875" y="164"/>
                  </a:lnTo>
                  <a:lnTo>
                    <a:pt x="1879" y="164"/>
                  </a:lnTo>
                  <a:lnTo>
                    <a:pt x="1882" y="164"/>
                  </a:lnTo>
                  <a:lnTo>
                    <a:pt x="1886" y="164"/>
                  </a:lnTo>
                  <a:lnTo>
                    <a:pt x="1889" y="164"/>
                  </a:lnTo>
                  <a:lnTo>
                    <a:pt x="1893" y="164"/>
                  </a:lnTo>
                  <a:lnTo>
                    <a:pt x="1895" y="164"/>
                  </a:lnTo>
                  <a:lnTo>
                    <a:pt x="1899" y="164"/>
                  </a:lnTo>
                  <a:lnTo>
                    <a:pt x="1902" y="164"/>
                  </a:lnTo>
                  <a:lnTo>
                    <a:pt x="1906" y="164"/>
                  </a:lnTo>
                  <a:lnTo>
                    <a:pt x="1909" y="164"/>
                  </a:lnTo>
                  <a:lnTo>
                    <a:pt x="1913" y="163"/>
                  </a:lnTo>
                  <a:lnTo>
                    <a:pt x="1916" y="163"/>
                  </a:lnTo>
                  <a:lnTo>
                    <a:pt x="1919" y="163"/>
                  </a:lnTo>
                  <a:lnTo>
                    <a:pt x="1922" y="163"/>
                  </a:lnTo>
                  <a:lnTo>
                    <a:pt x="1926" y="163"/>
                  </a:lnTo>
                  <a:lnTo>
                    <a:pt x="1929" y="162"/>
                  </a:lnTo>
                  <a:lnTo>
                    <a:pt x="1933" y="162"/>
                  </a:lnTo>
                  <a:lnTo>
                    <a:pt x="1936" y="162"/>
                  </a:lnTo>
                  <a:lnTo>
                    <a:pt x="1940" y="162"/>
                  </a:lnTo>
                  <a:lnTo>
                    <a:pt x="1943" y="161"/>
                  </a:lnTo>
                  <a:lnTo>
                    <a:pt x="1946" y="161"/>
                  </a:lnTo>
                  <a:lnTo>
                    <a:pt x="1949" y="161"/>
                  </a:lnTo>
                  <a:lnTo>
                    <a:pt x="1953" y="160"/>
                  </a:lnTo>
                  <a:lnTo>
                    <a:pt x="1956" y="160"/>
                  </a:lnTo>
                  <a:lnTo>
                    <a:pt x="1960" y="159"/>
                  </a:lnTo>
                  <a:lnTo>
                    <a:pt x="1963" y="157"/>
                  </a:lnTo>
                  <a:lnTo>
                    <a:pt x="1967" y="156"/>
                  </a:lnTo>
                  <a:lnTo>
                    <a:pt x="1969" y="155"/>
                  </a:lnTo>
                  <a:lnTo>
                    <a:pt x="1973" y="153"/>
                  </a:lnTo>
                  <a:lnTo>
                    <a:pt x="1976" y="152"/>
                  </a:lnTo>
                  <a:lnTo>
                    <a:pt x="1980" y="150"/>
                  </a:lnTo>
                  <a:lnTo>
                    <a:pt x="1983" y="148"/>
                  </a:lnTo>
                  <a:lnTo>
                    <a:pt x="1987" y="147"/>
                  </a:lnTo>
                  <a:lnTo>
                    <a:pt x="1990" y="146"/>
                  </a:lnTo>
                  <a:lnTo>
                    <a:pt x="1993" y="146"/>
                  </a:lnTo>
                  <a:lnTo>
                    <a:pt x="1996" y="146"/>
                  </a:lnTo>
                  <a:lnTo>
                    <a:pt x="2000" y="146"/>
                  </a:lnTo>
                  <a:lnTo>
                    <a:pt x="2003" y="146"/>
                  </a:lnTo>
                  <a:lnTo>
                    <a:pt x="2007" y="146"/>
                  </a:lnTo>
                  <a:lnTo>
                    <a:pt x="2010" y="146"/>
                  </a:lnTo>
                  <a:lnTo>
                    <a:pt x="2014" y="146"/>
                  </a:lnTo>
                  <a:lnTo>
                    <a:pt x="2016" y="147"/>
                  </a:lnTo>
                  <a:lnTo>
                    <a:pt x="2020" y="147"/>
                  </a:lnTo>
                  <a:lnTo>
                    <a:pt x="2023" y="147"/>
                  </a:lnTo>
                  <a:lnTo>
                    <a:pt x="2027" y="148"/>
                  </a:lnTo>
                  <a:lnTo>
                    <a:pt x="2030" y="148"/>
                  </a:lnTo>
                  <a:lnTo>
                    <a:pt x="2034" y="149"/>
                  </a:lnTo>
                  <a:lnTo>
                    <a:pt x="2037" y="149"/>
                  </a:lnTo>
                  <a:lnTo>
                    <a:pt x="2040" y="150"/>
                  </a:lnTo>
                  <a:lnTo>
                    <a:pt x="2043" y="150"/>
                  </a:lnTo>
                  <a:lnTo>
                    <a:pt x="2047" y="151"/>
                  </a:lnTo>
                  <a:lnTo>
                    <a:pt x="2050" y="151"/>
                  </a:lnTo>
                  <a:lnTo>
                    <a:pt x="2054" y="151"/>
                  </a:lnTo>
                  <a:lnTo>
                    <a:pt x="2057" y="152"/>
                  </a:lnTo>
                  <a:lnTo>
                    <a:pt x="2061" y="152"/>
                  </a:lnTo>
                  <a:lnTo>
                    <a:pt x="2064" y="152"/>
                  </a:lnTo>
                  <a:lnTo>
                    <a:pt x="2067" y="152"/>
                  </a:lnTo>
                  <a:lnTo>
                    <a:pt x="2070" y="152"/>
                  </a:lnTo>
                  <a:lnTo>
                    <a:pt x="2074" y="153"/>
                  </a:lnTo>
                  <a:lnTo>
                    <a:pt x="2077" y="153"/>
                  </a:lnTo>
                  <a:lnTo>
                    <a:pt x="2081" y="153"/>
                  </a:lnTo>
                  <a:lnTo>
                    <a:pt x="2084" y="153"/>
                  </a:lnTo>
                  <a:lnTo>
                    <a:pt x="2088" y="153"/>
                  </a:lnTo>
                  <a:lnTo>
                    <a:pt x="2090" y="153"/>
                  </a:lnTo>
                  <a:lnTo>
                    <a:pt x="2094" y="153"/>
                  </a:lnTo>
                  <a:lnTo>
                    <a:pt x="2097" y="153"/>
                  </a:lnTo>
                  <a:lnTo>
                    <a:pt x="2101" y="152"/>
                  </a:lnTo>
                  <a:lnTo>
                    <a:pt x="2104" y="151"/>
                  </a:lnTo>
                  <a:lnTo>
                    <a:pt x="2108" y="149"/>
                  </a:lnTo>
                  <a:lnTo>
                    <a:pt x="2111" y="146"/>
                  </a:lnTo>
                  <a:lnTo>
                    <a:pt x="2114" y="140"/>
                  </a:lnTo>
                  <a:lnTo>
                    <a:pt x="2117" y="129"/>
                  </a:lnTo>
                  <a:lnTo>
                    <a:pt x="2121" y="115"/>
                  </a:lnTo>
                  <a:lnTo>
                    <a:pt x="2124" y="98"/>
                  </a:lnTo>
                  <a:lnTo>
                    <a:pt x="2128" y="78"/>
                  </a:lnTo>
                  <a:lnTo>
                    <a:pt x="2131" y="59"/>
                  </a:lnTo>
                  <a:lnTo>
                    <a:pt x="2135" y="42"/>
                  </a:lnTo>
                  <a:lnTo>
                    <a:pt x="2137" y="30"/>
                  </a:lnTo>
                  <a:lnTo>
                    <a:pt x="2141" y="22"/>
                  </a:lnTo>
                  <a:lnTo>
                    <a:pt x="2144" y="19"/>
                  </a:lnTo>
                  <a:lnTo>
                    <a:pt x="2148" y="20"/>
                  </a:lnTo>
                  <a:lnTo>
                    <a:pt x="2151" y="24"/>
                  </a:lnTo>
                  <a:lnTo>
                    <a:pt x="2155" y="30"/>
                  </a:lnTo>
                  <a:lnTo>
                    <a:pt x="2158" y="36"/>
                  </a:lnTo>
                  <a:lnTo>
                    <a:pt x="2161" y="42"/>
                  </a:lnTo>
                  <a:lnTo>
                    <a:pt x="2164" y="49"/>
                  </a:lnTo>
                  <a:lnTo>
                    <a:pt x="2168" y="55"/>
                  </a:lnTo>
                  <a:lnTo>
                    <a:pt x="2171" y="62"/>
                  </a:lnTo>
                  <a:lnTo>
                    <a:pt x="2175" y="68"/>
                  </a:lnTo>
                  <a:lnTo>
                    <a:pt x="2178" y="73"/>
                  </a:lnTo>
                  <a:lnTo>
                    <a:pt x="2182" y="77"/>
                  </a:lnTo>
                  <a:lnTo>
                    <a:pt x="2185" y="81"/>
                  </a:lnTo>
                  <a:lnTo>
                    <a:pt x="2188" y="86"/>
                  </a:lnTo>
                  <a:lnTo>
                    <a:pt x="2191" y="89"/>
                  </a:lnTo>
                  <a:lnTo>
                    <a:pt x="2195" y="93"/>
                  </a:lnTo>
                  <a:lnTo>
                    <a:pt x="2198" y="96"/>
                  </a:lnTo>
                  <a:lnTo>
                    <a:pt x="2202" y="98"/>
                  </a:lnTo>
                  <a:lnTo>
                    <a:pt x="2205" y="101"/>
                  </a:lnTo>
                  <a:lnTo>
                    <a:pt x="2208" y="103"/>
                  </a:lnTo>
                  <a:lnTo>
                    <a:pt x="2211" y="105"/>
                  </a:lnTo>
                  <a:lnTo>
                    <a:pt x="2214" y="107"/>
                  </a:lnTo>
                  <a:lnTo>
                    <a:pt x="2218" y="109"/>
                  </a:lnTo>
                  <a:lnTo>
                    <a:pt x="2221" y="111"/>
                  </a:lnTo>
                  <a:lnTo>
                    <a:pt x="2225" y="111"/>
                  </a:lnTo>
                  <a:lnTo>
                    <a:pt x="2228" y="113"/>
                  </a:lnTo>
                  <a:lnTo>
                    <a:pt x="2232" y="114"/>
                  </a:lnTo>
                  <a:lnTo>
                    <a:pt x="2234" y="115"/>
                  </a:lnTo>
                  <a:lnTo>
                    <a:pt x="2238" y="116"/>
                  </a:lnTo>
                  <a:lnTo>
                    <a:pt x="2241" y="116"/>
                  </a:lnTo>
                  <a:lnTo>
                    <a:pt x="2245" y="117"/>
                  </a:lnTo>
                  <a:lnTo>
                    <a:pt x="2248" y="117"/>
                  </a:lnTo>
                  <a:lnTo>
                    <a:pt x="2252" y="117"/>
                  </a:lnTo>
                  <a:lnTo>
                    <a:pt x="2255" y="117"/>
                  </a:lnTo>
                  <a:lnTo>
                    <a:pt x="2258" y="116"/>
                  </a:lnTo>
                  <a:lnTo>
                    <a:pt x="2261" y="116"/>
                  </a:lnTo>
                  <a:lnTo>
                    <a:pt x="2265" y="114"/>
                  </a:lnTo>
                  <a:lnTo>
                    <a:pt x="2268" y="112"/>
                  </a:lnTo>
                  <a:lnTo>
                    <a:pt x="2272" y="110"/>
                  </a:lnTo>
                  <a:lnTo>
                    <a:pt x="2275" y="106"/>
                  </a:lnTo>
                  <a:lnTo>
                    <a:pt x="2279" y="100"/>
                  </a:lnTo>
                  <a:lnTo>
                    <a:pt x="2282" y="93"/>
                  </a:lnTo>
                  <a:lnTo>
                    <a:pt x="2285" y="85"/>
                  </a:lnTo>
                  <a:lnTo>
                    <a:pt x="2288" y="76"/>
                  </a:lnTo>
                  <a:lnTo>
                    <a:pt x="2292" y="67"/>
                  </a:lnTo>
                  <a:lnTo>
                    <a:pt x="2295" y="57"/>
                  </a:lnTo>
                  <a:lnTo>
                    <a:pt x="2299" y="47"/>
                  </a:lnTo>
                  <a:lnTo>
                    <a:pt x="2302" y="38"/>
                  </a:lnTo>
                  <a:lnTo>
                    <a:pt x="2306" y="29"/>
                  </a:lnTo>
                  <a:lnTo>
                    <a:pt x="2308" y="22"/>
                  </a:lnTo>
                  <a:lnTo>
                    <a:pt x="2312" y="15"/>
                  </a:lnTo>
                  <a:lnTo>
                    <a:pt x="2315" y="9"/>
                  </a:lnTo>
                  <a:lnTo>
                    <a:pt x="2319" y="5"/>
                  </a:lnTo>
                  <a:lnTo>
                    <a:pt x="2322" y="2"/>
                  </a:lnTo>
                  <a:lnTo>
                    <a:pt x="2326" y="0"/>
                  </a:lnTo>
                  <a:lnTo>
                    <a:pt x="2329" y="0"/>
                  </a:lnTo>
                  <a:lnTo>
                    <a:pt x="2332" y="1"/>
                  </a:lnTo>
                  <a:lnTo>
                    <a:pt x="2335" y="2"/>
                  </a:lnTo>
                  <a:lnTo>
                    <a:pt x="2339" y="5"/>
                  </a:lnTo>
                  <a:lnTo>
                    <a:pt x="2342" y="8"/>
                  </a:lnTo>
                  <a:lnTo>
                    <a:pt x="2346" y="12"/>
                  </a:lnTo>
                  <a:lnTo>
                    <a:pt x="2349" y="16"/>
                  </a:lnTo>
                  <a:lnTo>
                    <a:pt x="2353" y="21"/>
                  </a:lnTo>
                  <a:lnTo>
                    <a:pt x="2355" y="25"/>
                  </a:lnTo>
                  <a:lnTo>
                    <a:pt x="2359" y="30"/>
                  </a:lnTo>
                  <a:lnTo>
                    <a:pt x="2362" y="34"/>
                  </a:lnTo>
                  <a:lnTo>
                    <a:pt x="2366" y="38"/>
                  </a:lnTo>
                  <a:lnTo>
                    <a:pt x="2369" y="41"/>
                  </a:lnTo>
                  <a:lnTo>
                    <a:pt x="2373" y="44"/>
                  </a:lnTo>
                  <a:lnTo>
                    <a:pt x="2376" y="48"/>
                  </a:lnTo>
                  <a:lnTo>
                    <a:pt x="2379" y="51"/>
                  </a:lnTo>
                  <a:lnTo>
                    <a:pt x="2382" y="53"/>
                  </a:lnTo>
                  <a:lnTo>
                    <a:pt x="2386" y="56"/>
                  </a:lnTo>
                  <a:lnTo>
                    <a:pt x="2389" y="59"/>
                  </a:lnTo>
                  <a:lnTo>
                    <a:pt x="2393" y="61"/>
                  </a:lnTo>
                  <a:lnTo>
                    <a:pt x="2396" y="63"/>
                  </a:lnTo>
                  <a:lnTo>
                    <a:pt x="2400" y="66"/>
                  </a:lnTo>
                  <a:lnTo>
                    <a:pt x="2403" y="68"/>
                  </a:lnTo>
                  <a:lnTo>
                    <a:pt x="2406" y="70"/>
                  </a:lnTo>
                  <a:lnTo>
                    <a:pt x="2409" y="72"/>
                  </a:lnTo>
                  <a:lnTo>
                    <a:pt x="2413" y="74"/>
                  </a:lnTo>
                  <a:lnTo>
                    <a:pt x="2416" y="75"/>
                  </a:lnTo>
                  <a:lnTo>
                    <a:pt x="2420" y="76"/>
                  </a:lnTo>
                  <a:lnTo>
                    <a:pt x="2423" y="78"/>
                  </a:lnTo>
                  <a:lnTo>
                    <a:pt x="2427" y="80"/>
                  </a:lnTo>
                  <a:lnTo>
                    <a:pt x="2429" y="82"/>
                  </a:lnTo>
                  <a:lnTo>
                    <a:pt x="2433" y="83"/>
                  </a:lnTo>
                  <a:lnTo>
                    <a:pt x="2436" y="85"/>
                  </a:lnTo>
                  <a:lnTo>
                    <a:pt x="2440" y="86"/>
                  </a:lnTo>
                  <a:lnTo>
                    <a:pt x="2443" y="87"/>
                  </a:lnTo>
                  <a:lnTo>
                    <a:pt x="2447" y="89"/>
                  </a:lnTo>
                  <a:lnTo>
                    <a:pt x="2450" y="90"/>
                  </a:lnTo>
                  <a:lnTo>
                    <a:pt x="2453" y="91"/>
                  </a:lnTo>
                  <a:lnTo>
                    <a:pt x="2456" y="93"/>
                  </a:lnTo>
                  <a:lnTo>
                    <a:pt x="2460" y="94"/>
                  </a:lnTo>
                  <a:lnTo>
                    <a:pt x="2463" y="95"/>
                  </a:lnTo>
                  <a:lnTo>
                    <a:pt x="2467" y="96"/>
                  </a:lnTo>
                  <a:lnTo>
                    <a:pt x="2470" y="97"/>
                  </a:lnTo>
                  <a:lnTo>
                    <a:pt x="2474" y="98"/>
                  </a:lnTo>
                  <a:lnTo>
                    <a:pt x="2476" y="99"/>
                  </a:lnTo>
                  <a:lnTo>
                    <a:pt x="2480" y="100"/>
                  </a:lnTo>
                  <a:lnTo>
                    <a:pt x="2483" y="101"/>
                  </a:lnTo>
                  <a:lnTo>
                    <a:pt x="2487" y="102"/>
                  </a:lnTo>
                  <a:lnTo>
                    <a:pt x="2490" y="103"/>
                  </a:lnTo>
                  <a:lnTo>
                    <a:pt x="2494" y="104"/>
                  </a:lnTo>
                  <a:lnTo>
                    <a:pt x="2497" y="104"/>
                  </a:lnTo>
                  <a:lnTo>
                    <a:pt x="2500" y="105"/>
                  </a:lnTo>
                  <a:lnTo>
                    <a:pt x="2503" y="106"/>
                  </a:lnTo>
                  <a:lnTo>
                    <a:pt x="2507" y="107"/>
                  </a:lnTo>
                  <a:lnTo>
                    <a:pt x="2510" y="108"/>
                  </a:lnTo>
                  <a:lnTo>
                    <a:pt x="2514" y="108"/>
                  </a:lnTo>
                  <a:lnTo>
                    <a:pt x="2517" y="109"/>
                  </a:lnTo>
                  <a:lnTo>
                    <a:pt x="2520" y="11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6" name="Rectangle 1096">
              <a:extLst>
                <a:ext uri="{FF2B5EF4-FFF2-40B4-BE49-F238E27FC236}">
                  <a16:creationId xmlns:a16="http://schemas.microsoft.com/office/drawing/2014/main" id="{0F698FFC-507F-3DE0-BAFC-31B5FEFDFF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886" y="3284756"/>
              <a:ext cx="1726838" cy="89659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5F39153E-E126-4670-1D19-E9424C612871}"/>
              </a:ext>
            </a:extLst>
          </p:cNvPr>
          <p:cNvGrpSpPr/>
          <p:nvPr/>
        </p:nvGrpSpPr>
        <p:grpSpPr>
          <a:xfrm>
            <a:off x="2193782" y="3809516"/>
            <a:ext cx="1704739" cy="726541"/>
            <a:chOff x="2163029" y="4480893"/>
            <a:chExt cx="1731646" cy="896592"/>
          </a:xfrm>
        </p:grpSpPr>
        <p:sp>
          <p:nvSpPr>
            <p:cNvPr id="853" name="Freeform 250">
              <a:extLst>
                <a:ext uri="{FF2B5EF4-FFF2-40B4-BE49-F238E27FC236}">
                  <a16:creationId xmlns:a16="http://schemas.microsoft.com/office/drawing/2014/main" id="{F8D37BD3-32EC-A3D6-378D-F510D28CF3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63716" y="4666706"/>
              <a:ext cx="1730959" cy="544811"/>
            </a:xfrm>
            <a:custGeom>
              <a:avLst/>
              <a:gdLst>
                <a:gd name="T0" fmla="*/ 35 w 2520"/>
                <a:gd name="T1" fmla="*/ 295 h 302"/>
                <a:gd name="T2" fmla="*/ 76 w 2520"/>
                <a:gd name="T3" fmla="*/ 290 h 302"/>
                <a:gd name="T4" fmla="*/ 116 w 2520"/>
                <a:gd name="T5" fmla="*/ 286 h 302"/>
                <a:gd name="T6" fmla="*/ 156 w 2520"/>
                <a:gd name="T7" fmla="*/ 283 h 302"/>
                <a:gd name="T8" fmla="*/ 197 w 2520"/>
                <a:gd name="T9" fmla="*/ 279 h 302"/>
                <a:gd name="T10" fmla="*/ 237 w 2520"/>
                <a:gd name="T11" fmla="*/ 276 h 302"/>
                <a:gd name="T12" fmla="*/ 277 w 2520"/>
                <a:gd name="T13" fmla="*/ 272 h 302"/>
                <a:gd name="T14" fmla="*/ 317 w 2520"/>
                <a:gd name="T15" fmla="*/ 271 h 302"/>
                <a:gd name="T16" fmla="*/ 357 w 2520"/>
                <a:gd name="T17" fmla="*/ 269 h 302"/>
                <a:gd name="T18" fmla="*/ 397 w 2520"/>
                <a:gd name="T19" fmla="*/ 269 h 302"/>
                <a:gd name="T20" fmla="*/ 438 w 2520"/>
                <a:gd name="T21" fmla="*/ 267 h 302"/>
                <a:gd name="T22" fmla="*/ 478 w 2520"/>
                <a:gd name="T23" fmla="*/ 265 h 302"/>
                <a:gd name="T24" fmla="*/ 518 w 2520"/>
                <a:gd name="T25" fmla="*/ 265 h 302"/>
                <a:gd name="T26" fmla="*/ 559 w 2520"/>
                <a:gd name="T27" fmla="*/ 264 h 302"/>
                <a:gd name="T28" fmla="*/ 599 w 2520"/>
                <a:gd name="T29" fmla="*/ 263 h 302"/>
                <a:gd name="T30" fmla="*/ 639 w 2520"/>
                <a:gd name="T31" fmla="*/ 262 h 302"/>
                <a:gd name="T32" fmla="*/ 680 w 2520"/>
                <a:gd name="T33" fmla="*/ 261 h 302"/>
                <a:gd name="T34" fmla="*/ 720 w 2520"/>
                <a:gd name="T35" fmla="*/ 259 h 302"/>
                <a:gd name="T36" fmla="*/ 760 w 2520"/>
                <a:gd name="T37" fmla="*/ 251 h 302"/>
                <a:gd name="T38" fmla="*/ 801 w 2520"/>
                <a:gd name="T39" fmla="*/ 254 h 302"/>
                <a:gd name="T40" fmla="*/ 841 w 2520"/>
                <a:gd name="T41" fmla="*/ 254 h 302"/>
                <a:gd name="T42" fmla="*/ 881 w 2520"/>
                <a:gd name="T43" fmla="*/ 252 h 302"/>
                <a:gd name="T44" fmla="*/ 922 w 2520"/>
                <a:gd name="T45" fmla="*/ 250 h 302"/>
                <a:gd name="T46" fmla="*/ 962 w 2520"/>
                <a:gd name="T47" fmla="*/ 249 h 302"/>
                <a:gd name="T48" fmla="*/ 1002 w 2520"/>
                <a:gd name="T49" fmla="*/ 248 h 302"/>
                <a:gd name="T50" fmla="*/ 1043 w 2520"/>
                <a:gd name="T51" fmla="*/ 246 h 302"/>
                <a:gd name="T52" fmla="*/ 1083 w 2520"/>
                <a:gd name="T53" fmla="*/ 244 h 302"/>
                <a:gd name="T54" fmla="*/ 1123 w 2520"/>
                <a:gd name="T55" fmla="*/ 240 h 302"/>
                <a:gd name="T56" fmla="*/ 1164 w 2520"/>
                <a:gd name="T57" fmla="*/ 236 h 302"/>
                <a:gd name="T58" fmla="*/ 1204 w 2520"/>
                <a:gd name="T59" fmla="*/ 211 h 302"/>
                <a:gd name="T60" fmla="*/ 1244 w 2520"/>
                <a:gd name="T61" fmla="*/ 231 h 302"/>
                <a:gd name="T62" fmla="*/ 1285 w 2520"/>
                <a:gd name="T63" fmla="*/ 235 h 302"/>
                <a:gd name="T64" fmla="*/ 1325 w 2520"/>
                <a:gd name="T65" fmla="*/ 234 h 302"/>
                <a:gd name="T66" fmla="*/ 1365 w 2520"/>
                <a:gd name="T67" fmla="*/ 232 h 302"/>
                <a:gd name="T68" fmla="*/ 1406 w 2520"/>
                <a:gd name="T69" fmla="*/ 229 h 302"/>
                <a:gd name="T70" fmla="*/ 1446 w 2520"/>
                <a:gd name="T71" fmla="*/ 227 h 302"/>
                <a:gd name="T72" fmla="*/ 1486 w 2520"/>
                <a:gd name="T73" fmla="*/ 226 h 302"/>
                <a:gd name="T74" fmla="*/ 1527 w 2520"/>
                <a:gd name="T75" fmla="*/ 224 h 302"/>
                <a:gd name="T76" fmla="*/ 1567 w 2520"/>
                <a:gd name="T77" fmla="*/ 221 h 302"/>
                <a:gd name="T78" fmla="*/ 1606 w 2520"/>
                <a:gd name="T79" fmla="*/ 218 h 302"/>
                <a:gd name="T80" fmla="*/ 1647 w 2520"/>
                <a:gd name="T81" fmla="*/ 214 h 302"/>
                <a:gd name="T82" fmla="*/ 1687 w 2520"/>
                <a:gd name="T83" fmla="*/ 210 h 302"/>
                <a:gd name="T84" fmla="*/ 1727 w 2520"/>
                <a:gd name="T85" fmla="*/ 210 h 302"/>
                <a:gd name="T86" fmla="*/ 1768 w 2520"/>
                <a:gd name="T87" fmla="*/ 208 h 302"/>
                <a:gd name="T88" fmla="*/ 1808 w 2520"/>
                <a:gd name="T89" fmla="*/ 204 h 302"/>
                <a:gd name="T90" fmla="*/ 1848 w 2520"/>
                <a:gd name="T91" fmla="*/ 201 h 302"/>
                <a:gd name="T92" fmla="*/ 1889 w 2520"/>
                <a:gd name="T93" fmla="*/ 199 h 302"/>
                <a:gd name="T94" fmla="*/ 1929 w 2520"/>
                <a:gd name="T95" fmla="*/ 195 h 302"/>
                <a:gd name="T96" fmla="*/ 1969 w 2520"/>
                <a:gd name="T97" fmla="*/ 187 h 302"/>
                <a:gd name="T98" fmla="*/ 2010 w 2520"/>
                <a:gd name="T99" fmla="*/ 176 h 302"/>
                <a:gd name="T100" fmla="*/ 2050 w 2520"/>
                <a:gd name="T101" fmla="*/ 179 h 302"/>
                <a:gd name="T102" fmla="*/ 2090 w 2520"/>
                <a:gd name="T103" fmla="*/ 178 h 302"/>
                <a:gd name="T104" fmla="*/ 2131 w 2520"/>
                <a:gd name="T105" fmla="*/ 144 h 302"/>
                <a:gd name="T106" fmla="*/ 2171 w 2520"/>
                <a:gd name="T107" fmla="*/ 70 h 302"/>
                <a:gd name="T108" fmla="*/ 2211 w 2520"/>
                <a:gd name="T109" fmla="*/ 116 h 302"/>
                <a:gd name="T110" fmla="*/ 2252 w 2520"/>
                <a:gd name="T111" fmla="*/ 130 h 302"/>
                <a:gd name="T112" fmla="*/ 2292 w 2520"/>
                <a:gd name="T113" fmla="*/ 110 h 302"/>
                <a:gd name="T114" fmla="*/ 2332 w 2520"/>
                <a:gd name="T115" fmla="*/ 8 h 302"/>
                <a:gd name="T116" fmla="*/ 2373 w 2520"/>
                <a:gd name="T117" fmla="*/ 27 h 302"/>
                <a:gd name="T118" fmla="*/ 2413 w 2520"/>
                <a:gd name="T119" fmla="*/ 63 h 302"/>
                <a:gd name="T120" fmla="*/ 2453 w 2520"/>
                <a:gd name="T121" fmla="*/ 85 h 302"/>
                <a:gd name="T122" fmla="*/ 2494 w 2520"/>
                <a:gd name="T123" fmla="*/ 97 h 3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520" h="302">
                  <a:moveTo>
                    <a:pt x="0" y="302"/>
                  </a:moveTo>
                  <a:lnTo>
                    <a:pt x="2" y="301"/>
                  </a:lnTo>
                  <a:lnTo>
                    <a:pt x="5" y="300"/>
                  </a:lnTo>
                  <a:lnTo>
                    <a:pt x="8" y="300"/>
                  </a:lnTo>
                  <a:lnTo>
                    <a:pt x="11" y="299"/>
                  </a:lnTo>
                  <a:lnTo>
                    <a:pt x="15" y="299"/>
                  </a:lnTo>
                  <a:lnTo>
                    <a:pt x="18" y="298"/>
                  </a:lnTo>
                  <a:lnTo>
                    <a:pt x="22" y="297"/>
                  </a:lnTo>
                  <a:lnTo>
                    <a:pt x="25" y="297"/>
                  </a:lnTo>
                  <a:lnTo>
                    <a:pt x="29" y="296"/>
                  </a:lnTo>
                  <a:lnTo>
                    <a:pt x="31" y="296"/>
                  </a:lnTo>
                  <a:lnTo>
                    <a:pt x="35" y="295"/>
                  </a:lnTo>
                  <a:lnTo>
                    <a:pt x="38" y="295"/>
                  </a:lnTo>
                  <a:lnTo>
                    <a:pt x="42" y="294"/>
                  </a:lnTo>
                  <a:lnTo>
                    <a:pt x="45" y="294"/>
                  </a:lnTo>
                  <a:lnTo>
                    <a:pt x="49" y="294"/>
                  </a:lnTo>
                  <a:lnTo>
                    <a:pt x="52" y="293"/>
                  </a:lnTo>
                  <a:lnTo>
                    <a:pt x="55" y="293"/>
                  </a:lnTo>
                  <a:lnTo>
                    <a:pt x="58" y="292"/>
                  </a:lnTo>
                  <a:lnTo>
                    <a:pt x="62" y="291"/>
                  </a:lnTo>
                  <a:lnTo>
                    <a:pt x="65" y="291"/>
                  </a:lnTo>
                  <a:lnTo>
                    <a:pt x="69" y="291"/>
                  </a:lnTo>
                  <a:lnTo>
                    <a:pt x="72" y="290"/>
                  </a:lnTo>
                  <a:lnTo>
                    <a:pt x="76" y="290"/>
                  </a:lnTo>
                  <a:lnTo>
                    <a:pt x="78" y="290"/>
                  </a:lnTo>
                  <a:lnTo>
                    <a:pt x="82" y="289"/>
                  </a:lnTo>
                  <a:lnTo>
                    <a:pt x="85" y="289"/>
                  </a:lnTo>
                  <a:lnTo>
                    <a:pt x="89" y="289"/>
                  </a:lnTo>
                  <a:lnTo>
                    <a:pt x="92" y="288"/>
                  </a:lnTo>
                  <a:lnTo>
                    <a:pt x="96" y="288"/>
                  </a:lnTo>
                  <a:lnTo>
                    <a:pt x="99" y="287"/>
                  </a:lnTo>
                  <a:lnTo>
                    <a:pt x="102" y="287"/>
                  </a:lnTo>
                  <a:lnTo>
                    <a:pt x="105" y="287"/>
                  </a:lnTo>
                  <a:lnTo>
                    <a:pt x="109" y="286"/>
                  </a:lnTo>
                  <a:lnTo>
                    <a:pt x="112" y="286"/>
                  </a:lnTo>
                  <a:lnTo>
                    <a:pt x="116" y="286"/>
                  </a:lnTo>
                  <a:lnTo>
                    <a:pt x="119" y="285"/>
                  </a:lnTo>
                  <a:lnTo>
                    <a:pt x="123" y="285"/>
                  </a:lnTo>
                  <a:lnTo>
                    <a:pt x="126" y="285"/>
                  </a:lnTo>
                  <a:lnTo>
                    <a:pt x="129" y="284"/>
                  </a:lnTo>
                  <a:lnTo>
                    <a:pt x="132" y="284"/>
                  </a:lnTo>
                  <a:lnTo>
                    <a:pt x="136" y="284"/>
                  </a:lnTo>
                  <a:lnTo>
                    <a:pt x="139" y="284"/>
                  </a:lnTo>
                  <a:lnTo>
                    <a:pt x="143" y="284"/>
                  </a:lnTo>
                  <a:lnTo>
                    <a:pt x="146" y="283"/>
                  </a:lnTo>
                  <a:lnTo>
                    <a:pt x="150" y="283"/>
                  </a:lnTo>
                  <a:lnTo>
                    <a:pt x="152" y="283"/>
                  </a:lnTo>
                  <a:lnTo>
                    <a:pt x="156" y="283"/>
                  </a:lnTo>
                  <a:lnTo>
                    <a:pt x="159" y="282"/>
                  </a:lnTo>
                  <a:lnTo>
                    <a:pt x="163" y="282"/>
                  </a:lnTo>
                  <a:lnTo>
                    <a:pt x="166" y="282"/>
                  </a:lnTo>
                  <a:lnTo>
                    <a:pt x="170" y="282"/>
                  </a:lnTo>
                  <a:lnTo>
                    <a:pt x="173" y="281"/>
                  </a:lnTo>
                  <a:lnTo>
                    <a:pt x="176" y="281"/>
                  </a:lnTo>
                  <a:lnTo>
                    <a:pt x="179" y="281"/>
                  </a:lnTo>
                  <a:lnTo>
                    <a:pt x="183" y="281"/>
                  </a:lnTo>
                  <a:lnTo>
                    <a:pt x="186" y="280"/>
                  </a:lnTo>
                  <a:lnTo>
                    <a:pt x="190" y="280"/>
                  </a:lnTo>
                  <a:lnTo>
                    <a:pt x="193" y="279"/>
                  </a:lnTo>
                  <a:lnTo>
                    <a:pt x="197" y="279"/>
                  </a:lnTo>
                  <a:lnTo>
                    <a:pt x="199" y="279"/>
                  </a:lnTo>
                  <a:lnTo>
                    <a:pt x="203" y="279"/>
                  </a:lnTo>
                  <a:lnTo>
                    <a:pt x="206" y="278"/>
                  </a:lnTo>
                  <a:lnTo>
                    <a:pt x="210" y="278"/>
                  </a:lnTo>
                  <a:lnTo>
                    <a:pt x="213" y="278"/>
                  </a:lnTo>
                  <a:lnTo>
                    <a:pt x="217" y="278"/>
                  </a:lnTo>
                  <a:lnTo>
                    <a:pt x="220" y="278"/>
                  </a:lnTo>
                  <a:lnTo>
                    <a:pt x="223" y="277"/>
                  </a:lnTo>
                  <a:lnTo>
                    <a:pt x="226" y="277"/>
                  </a:lnTo>
                  <a:lnTo>
                    <a:pt x="230" y="277"/>
                  </a:lnTo>
                  <a:lnTo>
                    <a:pt x="233" y="276"/>
                  </a:lnTo>
                  <a:lnTo>
                    <a:pt x="237" y="276"/>
                  </a:lnTo>
                  <a:lnTo>
                    <a:pt x="240" y="276"/>
                  </a:lnTo>
                  <a:lnTo>
                    <a:pt x="244" y="275"/>
                  </a:lnTo>
                  <a:lnTo>
                    <a:pt x="247" y="275"/>
                  </a:lnTo>
                  <a:lnTo>
                    <a:pt x="250" y="274"/>
                  </a:lnTo>
                  <a:lnTo>
                    <a:pt x="253" y="274"/>
                  </a:lnTo>
                  <a:lnTo>
                    <a:pt x="257" y="274"/>
                  </a:lnTo>
                  <a:lnTo>
                    <a:pt x="260" y="273"/>
                  </a:lnTo>
                  <a:lnTo>
                    <a:pt x="264" y="273"/>
                  </a:lnTo>
                  <a:lnTo>
                    <a:pt x="267" y="273"/>
                  </a:lnTo>
                  <a:lnTo>
                    <a:pt x="271" y="272"/>
                  </a:lnTo>
                  <a:lnTo>
                    <a:pt x="273" y="272"/>
                  </a:lnTo>
                  <a:lnTo>
                    <a:pt x="277" y="272"/>
                  </a:lnTo>
                  <a:lnTo>
                    <a:pt x="280" y="272"/>
                  </a:lnTo>
                  <a:lnTo>
                    <a:pt x="284" y="271"/>
                  </a:lnTo>
                  <a:lnTo>
                    <a:pt x="287" y="271"/>
                  </a:lnTo>
                  <a:lnTo>
                    <a:pt x="291" y="271"/>
                  </a:lnTo>
                  <a:lnTo>
                    <a:pt x="294" y="271"/>
                  </a:lnTo>
                  <a:lnTo>
                    <a:pt x="297" y="271"/>
                  </a:lnTo>
                  <a:lnTo>
                    <a:pt x="300" y="271"/>
                  </a:lnTo>
                  <a:lnTo>
                    <a:pt x="304" y="271"/>
                  </a:lnTo>
                  <a:lnTo>
                    <a:pt x="307" y="271"/>
                  </a:lnTo>
                  <a:lnTo>
                    <a:pt x="311" y="271"/>
                  </a:lnTo>
                  <a:lnTo>
                    <a:pt x="314" y="271"/>
                  </a:lnTo>
                  <a:lnTo>
                    <a:pt x="317" y="271"/>
                  </a:lnTo>
                  <a:lnTo>
                    <a:pt x="320" y="271"/>
                  </a:lnTo>
                  <a:lnTo>
                    <a:pt x="323" y="271"/>
                  </a:lnTo>
                  <a:lnTo>
                    <a:pt x="327" y="271"/>
                  </a:lnTo>
                  <a:lnTo>
                    <a:pt x="330" y="271"/>
                  </a:lnTo>
                  <a:lnTo>
                    <a:pt x="334" y="271"/>
                  </a:lnTo>
                  <a:lnTo>
                    <a:pt x="337" y="271"/>
                  </a:lnTo>
                  <a:lnTo>
                    <a:pt x="341" y="271"/>
                  </a:lnTo>
                  <a:lnTo>
                    <a:pt x="344" y="271"/>
                  </a:lnTo>
                  <a:lnTo>
                    <a:pt x="347" y="270"/>
                  </a:lnTo>
                  <a:lnTo>
                    <a:pt x="350" y="270"/>
                  </a:lnTo>
                  <a:lnTo>
                    <a:pt x="354" y="270"/>
                  </a:lnTo>
                  <a:lnTo>
                    <a:pt x="357" y="269"/>
                  </a:lnTo>
                  <a:lnTo>
                    <a:pt x="361" y="269"/>
                  </a:lnTo>
                  <a:lnTo>
                    <a:pt x="364" y="269"/>
                  </a:lnTo>
                  <a:lnTo>
                    <a:pt x="368" y="269"/>
                  </a:lnTo>
                  <a:lnTo>
                    <a:pt x="370" y="269"/>
                  </a:lnTo>
                  <a:lnTo>
                    <a:pt x="374" y="268"/>
                  </a:lnTo>
                  <a:lnTo>
                    <a:pt x="377" y="268"/>
                  </a:lnTo>
                  <a:lnTo>
                    <a:pt x="381" y="269"/>
                  </a:lnTo>
                  <a:lnTo>
                    <a:pt x="384" y="269"/>
                  </a:lnTo>
                  <a:lnTo>
                    <a:pt x="388" y="269"/>
                  </a:lnTo>
                  <a:lnTo>
                    <a:pt x="391" y="269"/>
                  </a:lnTo>
                  <a:lnTo>
                    <a:pt x="394" y="268"/>
                  </a:lnTo>
                  <a:lnTo>
                    <a:pt x="397" y="269"/>
                  </a:lnTo>
                  <a:lnTo>
                    <a:pt x="401" y="268"/>
                  </a:lnTo>
                  <a:lnTo>
                    <a:pt x="404" y="268"/>
                  </a:lnTo>
                  <a:lnTo>
                    <a:pt x="408" y="268"/>
                  </a:lnTo>
                  <a:lnTo>
                    <a:pt x="411" y="268"/>
                  </a:lnTo>
                  <a:lnTo>
                    <a:pt x="415" y="268"/>
                  </a:lnTo>
                  <a:lnTo>
                    <a:pt x="417" y="268"/>
                  </a:lnTo>
                  <a:lnTo>
                    <a:pt x="421" y="268"/>
                  </a:lnTo>
                  <a:lnTo>
                    <a:pt x="424" y="268"/>
                  </a:lnTo>
                  <a:lnTo>
                    <a:pt x="428" y="268"/>
                  </a:lnTo>
                  <a:lnTo>
                    <a:pt x="431" y="268"/>
                  </a:lnTo>
                  <a:lnTo>
                    <a:pt x="435" y="268"/>
                  </a:lnTo>
                  <a:lnTo>
                    <a:pt x="438" y="267"/>
                  </a:lnTo>
                  <a:lnTo>
                    <a:pt x="441" y="267"/>
                  </a:lnTo>
                  <a:lnTo>
                    <a:pt x="444" y="267"/>
                  </a:lnTo>
                  <a:lnTo>
                    <a:pt x="448" y="267"/>
                  </a:lnTo>
                  <a:lnTo>
                    <a:pt x="451" y="267"/>
                  </a:lnTo>
                  <a:lnTo>
                    <a:pt x="455" y="266"/>
                  </a:lnTo>
                  <a:lnTo>
                    <a:pt x="458" y="266"/>
                  </a:lnTo>
                  <a:lnTo>
                    <a:pt x="462" y="266"/>
                  </a:lnTo>
                  <a:lnTo>
                    <a:pt x="465" y="265"/>
                  </a:lnTo>
                  <a:lnTo>
                    <a:pt x="468" y="265"/>
                  </a:lnTo>
                  <a:lnTo>
                    <a:pt x="471" y="265"/>
                  </a:lnTo>
                  <a:lnTo>
                    <a:pt x="475" y="265"/>
                  </a:lnTo>
                  <a:lnTo>
                    <a:pt x="478" y="265"/>
                  </a:lnTo>
                  <a:lnTo>
                    <a:pt x="482" y="265"/>
                  </a:lnTo>
                  <a:lnTo>
                    <a:pt x="485" y="265"/>
                  </a:lnTo>
                  <a:lnTo>
                    <a:pt x="489" y="265"/>
                  </a:lnTo>
                  <a:lnTo>
                    <a:pt x="491" y="265"/>
                  </a:lnTo>
                  <a:lnTo>
                    <a:pt x="495" y="265"/>
                  </a:lnTo>
                  <a:lnTo>
                    <a:pt x="498" y="265"/>
                  </a:lnTo>
                  <a:lnTo>
                    <a:pt x="502" y="265"/>
                  </a:lnTo>
                  <a:lnTo>
                    <a:pt x="505" y="265"/>
                  </a:lnTo>
                  <a:lnTo>
                    <a:pt x="509" y="265"/>
                  </a:lnTo>
                  <a:lnTo>
                    <a:pt x="512" y="265"/>
                  </a:lnTo>
                  <a:lnTo>
                    <a:pt x="515" y="265"/>
                  </a:lnTo>
                  <a:lnTo>
                    <a:pt x="518" y="265"/>
                  </a:lnTo>
                  <a:lnTo>
                    <a:pt x="522" y="265"/>
                  </a:lnTo>
                  <a:lnTo>
                    <a:pt x="525" y="265"/>
                  </a:lnTo>
                  <a:lnTo>
                    <a:pt x="529" y="265"/>
                  </a:lnTo>
                  <a:lnTo>
                    <a:pt x="532" y="265"/>
                  </a:lnTo>
                  <a:lnTo>
                    <a:pt x="536" y="265"/>
                  </a:lnTo>
                  <a:lnTo>
                    <a:pt x="538" y="265"/>
                  </a:lnTo>
                  <a:lnTo>
                    <a:pt x="542" y="264"/>
                  </a:lnTo>
                  <a:lnTo>
                    <a:pt x="545" y="264"/>
                  </a:lnTo>
                  <a:lnTo>
                    <a:pt x="549" y="264"/>
                  </a:lnTo>
                  <a:lnTo>
                    <a:pt x="552" y="264"/>
                  </a:lnTo>
                  <a:lnTo>
                    <a:pt x="556" y="264"/>
                  </a:lnTo>
                  <a:lnTo>
                    <a:pt x="559" y="264"/>
                  </a:lnTo>
                  <a:lnTo>
                    <a:pt x="563" y="264"/>
                  </a:lnTo>
                  <a:lnTo>
                    <a:pt x="565" y="264"/>
                  </a:lnTo>
                  <a:lnTo>
                    <a:pt x="569" y="264"/>
                  </a:lnTo>
                  <a:lnTo>
                    <a:pt x="572" y="264"/>
                  </a:lnTo>
                  <a:lnTo>
                    <a:pt x="576" y="263"/>
                  </a:lnTo>
                  <a:lnTo>
                    <a:pt x="579" y="263"/>
                  </a:lnTo>
                  <a:lnTo>
                    <a:pt x="583" y="263"/>
                  </a:lnTo>
                  <a:lnTo>
                    <a:pt x="586" y="263"/>
                  </a:lnTo>
                  <a:lnTo>
                    <a:pt x="589" y="263"/>
                  </a:lnTo>
                  <a:lnTo>
                    <a:pt x="592" y="263"/>
                  </a:lnTo>
                  <a:lnTo>
                    <a:pt x="596" y="263"/>
                  </a:lnTo>
                  <a:lnTo>
                    <a:pt x="599" y="263"/>
                  </a:lnTo>
                  <a:lnTo>
                    <a:pt x="603" y="263"/>
                  </a:lnTo>
                  <a:lnTo>
                    <a:pt x="606" y="263"/>
                  </a:lnTo>
                  <a:lnTo>
                    <a:pt x="610" y="262"/>
                  </a:lnTo>
                  <a:lnTo>
                    <a:pt x="612" y="262"/>
                  </a:lnTo>
                  <a:lnTo>
                    <a:pt x="616" y="262"/>
                  </a:lnTo>
                  <a:lnTo>
                    <a:pt x="619" y="262"/>
                  </a:lnTo>
                  <a:lnTo>
                    <a:pt x="623" y="262"/>
                  </a:lnTo>
                  <a:lnTo>
                    <a:pt x="626" y="261"/>
                  </a:lnTo>
                  <a:lnTo>
                    <a:pt x="630" y="261"/>
                  </a:lnTo>
                  <a:lnTo>
                    <a:pt x="633" y="261"/>
                  </a:lnTo>
                  <a:lnTo>
                    <a:pt x="636" y="262"/>
                  </a:lnTo>
                  <a:lnTo>
                    <a:pt x="639" y="262"/>
                  </a:lnTo>
                  <a:lnTo>
                    <a:pt x="643" y="262"/>
                  </a:lnTo>
                  <a:lnTo>
                    <a:pt x="646" y="262"/>
                  </a:lnTo>
                  <a:lnTo>
                    <a:pt x="650" y="261"/>
                  </a:lnTo>
                  <a:lnTo>
                    <a:pt x="653" y="261"/>
                  </a:lnTo>
                  <a:lnTo>
                    <a:pt x="657" y="261"/>
                  </a:lnTo>
                  <a:lnTo>
                    <a:pt x="659" y="261"/>
                  </a:lnTo>
                  <a:lnTo>
                    <a:pt x="663" y="261"/>
                  </a:lnTo>
                  <a:lnTo>
                    <a:pt x="666" y="261"/>
                  </a:lnTo>
                  <a:lnTo>
                    <a:pt x="670" y="261"/>
                  </a:lnTo>
                  <a:lnTo>
                    <a:pt x="673" y="261"/>
                  </a:lnTo>
                  <a:lnTo>
                    <a:pt x="677" y="261"/>
                  </a:lnTo>
                  <a:lnTo>
                    <a:pt x="680" y="261"/>
                  </a:lnTo>
                  <a:lnTo>
                    <a:pt x="684" y="261"/>
                  </a:lnTo>
                  <a:lnTo>
                    <a:pt x="686" y="261"/>
                  </a:lnTo>
                  <a:lnTo>
                    <a:pt x="690" y="260"/>
                  </a:lnTo>
                  <a:lnTo>
                    <a:pt x="693" y="260"/>
                  </a:lnTo>
                  <a:lnTo>
                    <a:pt x="697" y="260"/>
                  </a:lnTo>
                  <a:lnTo>
                    <a:pt x="700" y="260"/>
                  </a:lnTo>
                  <a:lnTo>
                    <a:pt x="704" y="260"/>
                  </a:lnTo>
                  <a:lnTo>
                    <a:pt x="707" y="260"/>
                  </a:lnTo>
                  <a:lnTo>
                    <a:pt x="710" y="260"/>
                  </a:lnTo>
                  <a:lnTo>
                    <a:pt x="713" y="260"/>
                  </a:lnTo>
                  <a:lnTo>
                    <a:pt x="717" y="259"/>
                  </a:lnTo>
                  <a:lnTo>
                    <a:pt x="720" y="259"/>
                  </a:lnTo>
                  <a:lnTo>
                    <a:pt x="724" y="259"/>
                  </a:lnTo>
                  <a:lnTo>
                    <a:pt x="727" y="258"/>
                  </a:lnTo>
                  <a:lnTo>
                    <a:pt x="731" y="258"/>
                  </a:lnTo>
                  <a:lnTo>
                    <a:pt x="733" y="256"/>
                  </a:lnTo>
                  <a:lnTo>
                    <a:pt x="737" y="255"/>
                  </a:lnTo>
                  <a:lnTo>
                    <a:pt x="740" y="254"/>
                  </a:lnTo>
                  <a:lnTo>
                    <a:pt x="744" y="252"/>
                  </a:lnTo>
                  <a:lnTo>
                    <a:pt x="747" y="251"/>
                  </a:lnTo>
                  <a:lnTo>
                    <a:pt x="751" y="251"/>
                  </a:lnTo>
                  <a:lnTo>
                    <a:pt x="754" y="251"/>
                  </a:lnTo>
                  <a:lnTo>
                    <a:pt x="757" y="251"/>
                  </a:lnTo>
                  <a:lnTo>
                    <a:pt x="760" y="251"/>
                  </a:lnTo>
                  <a:lnTo>
                    <a:pt x="764" y="252"/>
                  </a:lnTo>
                  <a:lnTo>
                    <a:pt x="767" y="252"/>
                  </a:lnTo>
                  <a:lnTo>
                    <a:pt x="771" y="253"/>
                  </a:lnTo>
                  <a:lnTo>
                    <a:pt x="774" y="253"/>
                  </a:lnTo>
                  <a:lnTo>
                    <a:pt x="778" y="253"/>
                  </a:lnTo>
                  <a:lnTo>
                    <a:pt x="780" y="254"/>
                  </a:lnTo>
                  <a:lnTo>
                    <a:pt x="784" y="254"/>
                  </a:lnTo>
                  <a:lnTo>
                    <a:pt x="787" y="254"/>
                  </a:lnTo>
                  <a:lnTo>
                    <a:pt x="791" y="254"/>
                  </a:lnTo>
                  <a:lnTo>
                    <a:pt x="794" y="254"/>
                  </a:lnTo>
                  <a:lnTo>
                    <a:pt x="798" y="254"/>
                  </a:lnTo>
                  <a:lnTo>
                    <a:pt x="801" y="254"/>
                  </a:lnTo>
                  <a:lnTo>
                    <a:pt x="805" y="254"/>
                  </a:lnTo>
                  <a:lnTo>
                    <a:pt x="807" y="254"/>
                  </a:lnTo>
                  <a:lnTo>
                    <a:pt x="811" y="254"/>
                  </a:lnTo>
                  <a:lnTo>
                    <a:pt x="814" y="254"/>
                  </a:lnTo>
                  <a:lnTo>
                    <a:pt x="818" y="254"/>
                  </a:lnTo>
                  <a:lnTo>
                    <a:pt x="821" y="254"/>
                  </a:lnTo>
                  <a:lnTo>
                    <a:pt x="825" y="254"/>
                  </a:lnTo>
                  <a:lnTo>
                    <a:pt x="828" y="254"/>
                  </a:lnTo>
                  <a:lnTo>
                    <a:pt x="831" y="254"/>
                  </a:lnTo>
                  <a:lnTo>
                    <a:pt x="834" y="254"/>
                  </a:lnTo>
                  <a:lnTo>
                    <a:pt x="838" y="254"/>
                  </a:lnTo>
                  <a:lnTo>
                    <a:pt x="841" y="254"/>
                  </a:lnTo>
                  <a:lnTo>
                    <a:pt x="845" y="253"/>
                  </a:lnTo>
                  <a:lnTo>
                    <a:pt x="848" y="254"/>
                  </a:lnTo>
                  <a:lnTo>
                    <a:pt x="852" y="253"/>
                  </a:lnTo>
                  <a:lnTo>
                    <a:pt x="854" y="253"/>
                  </a:lnTo>
                  <a:lnTo>
                    <a:pt x="858" y="253"/>
                  </a:lnTo>
                  <a:lnTo>
                    <a:pt x="861" y="253"/>
                  </a:lnTo>
                  <a:lnTo>
                    <a:pt x="865" y="253"/>
                  </a:lnTo>
                  <a:lnTo>
                    <a:pt x="868" y="253"/>
                  </a:lnTo>
                  <a:lnTo>
                    <a:pt x="872" y="253"/>
                  </a:lnTo>
                  <a:lnTo>
                    <a:pt x="875" y="253"/>
                  </a:lnTo>
                  <a:lnTo>
                    <a:pt x="878" y="252"/>
                  </a:lnTo>
                  <a:lnTo>
                    <a:pt x="881" y="252"/>
                  </a:lnTo>
                  <a:lnTo>
                    <a:pt x="885" y="251"/>
                  </a:lnTo>
                  <a:lnTo>
                    <a:pt x="888" y="251"/>
                  </a:lnTo>
                  <a:lnTo>
                    <a:pt x="892" y="250"/>
                  </a:lnTo>
                  <a:lnTo>
                    <a:pt x="895" y="250"/>
                  </a:lnTo>
                  <a:lnTo>
                    <a:pt x="899" y="250"/>
                  </a:lnTo>
                  <a:lnTo>
                    <a:pt x="902" y="250"/>
                  </a:lnTo>
                  <a:lnTo>
                    <a:pt x="905" y="250"/>
                  </a:lnTo>
                  <a:lnTo>
                    <a:pt x="908" y="250"/>
                  </a:lnTo>
                  <a:lnTo>
                    <a:pt x="912" y="250"/>
                  </a:lnTo>
                  <a:lnTo>
                    <a:pt x="915" y="250"/>
                  </a:lnTo>
                  <a:lnTo>
                    <a:pt x="919" y="250"/>
                  </a:lnTo>
                  <a:lnTo>
                    <a:pt x="922" y="250"/>
                  </a:lnTo>
                  <a:lnTo>
                    <a:pt x="926" y="250"/>
                  </a:lnTo>
                  <a:lnTo>
                    <a:pt x="928" y="250"/>
                  </a:lnTo>
                  <a:lnTo>
                    <a:pt x="932" y="250"/>
                  </a:lnTo>
                  <a:lnTo>
                    <a:pt x="935" y="250"/>
                  </a:lnTo>
                  <a:lnTo>
                    <a:pt x="939" y="250"/>
                  </a:lnTo>
                  <a:lnTo>
                    <a:pt x="942" y="250"/>
                  </a:lnTo>
                  <a:lnTo>
                    <a:pt x="945" y="249"/>
                  </a:lnTo>
                  <a:lnTo>
                    <a:pt x="949" y="249"/>
                  </a:lnTo>
                  <a:lnTo>
                    <a:pt x="951" y="249"/>
                  </a:lnTo>
                  <a:lnTo>
                    <a:pt x="955" y="249"/>
                  </a:lnTo>
                  <a:lnTo>
                    <a:pt x="958" y="249"/>
                  </a:lnTo>
                  <a:lnTo>
                    <a:pt x="962" y="249"/>
                  </a:lnTo>
                  <a:lnTo>
                    <a:pt x="965" y="249"/>
                  </a:lnTo>
                  <a:lnTo>
                    <a:pt x="969" y="249"/>
                  </a:lnTo>
                  <a:lnTo>
                    <a:pt x="972" y="249"/>
                  </a:lnTo>
                  <a:lnTo>
                    <a:pt x="975" y="249"/>
                  </a:lnTo>
                  <a:lnTo>
                    <a:pt x="978" y="248"/>
                  </a:lnTo>
                  <a:lnTo>
                    <a:pt x="982" y="248"/>
                  </a:lnTo>
                  <a:lnTo>
                    <a:pt x="985" y="248"/>
                  </a:lnTo>
                  <a:lnTo>
                    <a:pt x="989" y="248"/>
                  </a:lnTo>
                  <a:lnTo>
                    <a:pt x="992" y="248"/>
                  </a:lnTo>
                  <a:lnTo>
                    <a:pt x="996" y="248"/>
                  </a:lnTo>
                  <a:lnTo>
                    <a:pt x="998" y="248"/>
                  </a:lnTo>
                  <a:lnTo>
                    <a:pt x="1002" y="248"/>
                  </a:lnTo>
                  <a:lnTo>
                    <a:pt x="1005" y="248"/>
                  </a:lnTo>
                  <a:lnTo>
                    <a:pt x="1009" y="248"/>
                  </a:lnTo>
                  <a:lnTo>
                    <a:pt x="1012" y="248"/>
                  </a:lnTo>
                  <a:lnTo>
                    <a:pt x="1016" y="247"/>
                  </a:lnTo>
                  <a:lnTo>
                    <a:pt x="1019" y="247"/>
                  </a:lnTo>
                  <a:lnTo>
                    <a:pt x="1023" y="247"/>
                  </a:lnTo>
                  <a:lnTo>
                    <a:pt x="1025" y="247"/>
                  </a:lnTo>
                  <a:lnTo>
                    <a:pt x="1029" y="247"/>
                  </a:lnTo>
                  <a:lnTo>
                    <a:pt x="1032" y="246"/>
                  </a:lnTo>
                  <a:lnTo>
                    <a:pt x="1036" y="246"/>
                  </a:lnTo>
                  <a:lnTo>
                    <a:pt x="1039" y="246"/>
                  </a:lnTo>
                  <a:lnTo>
                    <a:pt x="1043" y="246"/>
                  </a:lnTo>
                  <a:lnTo>
                    <a:pt x="1046" y="246"/>
                  </a:lnTo>
                  <a:lnTo>
                    <a:pt x="1049" y="246"/>
                  </a:lnTo>
                  <a:lnTo>
                    <a:pt x="1052" y="245"/>
                  </a:lnTo>
                  <a:lnTo>
                    <a:pt x="1056" y="245"/>
                  </a:lnTo>
                  <a:lnTo>
                    <a:pt x="1059" y="245"/>
                  </a:lnTo>
                  <a:lnTo>
                    <a:pt x="1063" y="245"/>
                  </a:lnTo>
                  <a:lnTo>
                    <a:pt x="1066" y="245"/>
                  </a:lnTo>
                  <a:lnTo>
                    <a:pt x="1070" y="245"/>
                  </a:lnTo>
                  <a:lnTo>
                    <a:pt x="1072" y="245"/>
                  </a:lnTo>
                  <a:lnTo>
                    <a:pt x="1076" y="244"/>
                  </a:lnTo>
                  <a:lnTo>
                    <a:pt x="1079" y="244"/>
                  </a:lnTo>
                  <a:lnTo>
                    <a:pt x="1083" y="244"/>
                  </a:lnTo>
                  <a:lnTo>
                    <a:pt x="1086" y="243"/>
                  </a:lnTo>
                  <a:lnTo>
                    <a:pt x="1090" y="243"/>
                  </a:lnTo>
                  <a:lnTo>
                    <a:pt x="1093" y="243"/>
                  </a:lnTo>
                  <a:lnTo>
                    <a:pt x="1096" y="243"/>
                  </a:lnTo>
                  <a:lnTo>
                    <a:pt x="1099" y="243"/>
                  </a:lnTo>
                  <a:lnTo>
                    <a:pt x="1103" y="242"/>
                  </a:lnTo>
                  <a:lnTo>
                    <a:pt x="1106" y="242"/>
                  </a:lnTo>
                  <a:lnTo>
                    <a:pt x="1110" y="241"/>
                  </a:lnTo>
                  <a:lnTo>
                    <a:pt x="1113" y="241"/>
                  </a:lnTo>
                  <a:lnTo>
                    <a:pt x="1117" y="241"/>
                  </a:lnTo>
                  <a:lnTo>
                    <a:pt x="1120" y="240"/>
                  </a:lnTo>
                  <a:lnTo>
                    <a:pt x="1123" y="240"/>
                  </a:lnTo>
                  <a:lnTo>
                    <a:pt x="1126" y="239"/>
                  </a:lnTo>
                  <a:lnTo>
                    <a:pt x="1130" y="239"/>
                  </a:lnTo>
                  <a:lnTo>
                    <a:pt x="1133" y="239"/>
                  </a:lnTo>
                  <a:lnTo>
                    <a:pt x="1137" y="238"/>
                  </a:lnTo>
                  <a:lnTo>
                    <a:pt x="1140" y="238"/>
                  </a:lnTo>
                  <a:lnTo>
                    <a:pt x="1144" y="238"/>
                  </a:lnTo>
                  <a:lnTo>
                    <a:pt x="1146" y="237"/>
                  </a:lnTo>
                  <a:lnTo>
                    <a:pt x="1150" y="237"/>
                  </a:lnTo>
                  <a:lnTo>
                    <a:pt x="1153" y="236"/>
                  </a:lnTo>
                  <a:lnTo>
                    <a:pt x="1157" y="236"/>
                  </a:lnTo>
                  <a:lnTo>
                    <a:pt x="1160" y="236"/>
                  </a:lnTo>
                  <a:lnTo>
                    <a:pt x="1164" y="236"/>
                  </a:lnTo>
                  <a:lnTo>
                    <a:pt x="1167" y="236"/>
                  </a:lnTo>
                  <a:lnTo>
                    <a:pt x="1170" y="235"/>
                  </a:lnTo>
                  <a:lnTo>
                    <a:pt x="1173" y="235"/>
                  </a:lnTo>
                  <a:lnTo>
                    <a:pt x="1177" y="234"/>
                  </a:lnTo>
                  <a:lnTo>
                    <a:pt x="1180" y="232"/>
                  </a:lnTo>
                  <a:lnTo>
                    <a:pt x="1184" y="230"/>
                  </a:lnTo>
                  <a:lnTo>
                    <a:pt x="1187" y="227"/>
                  </a:lnTo>
                  <a:lnTo>
                    <a:pt x="1191" y="224"/>
                  </a:lnTo>
                  <a:lnTo>
                    <a:pt x="1193" y="220"/>
                  </a:lnTo>
                  <a:lnTo>
                    <a:pt x="1197" y="216"/>
                  </a:lnTo>
                  <a:lnTo>
                    <a:pt x="1200" y="212"/>
                  </a:lnTo>
                  <a:lnTo>
                    <a:pt x="1204" y="211"/>
                  </a:lnTo>
                  <a:lnTo>
                    <a:pt x="1207" y="211"/>
                  </a:lnTo>
                  <a:lnTo>
                    <a:pt x="1211" y="212"/>
                  </a:lnTo>
                  <a:lnTo>
                    <a:pt x="1214" y="214"/>
                  </a:lnTo>
                  <a:lnTo>
                    <a:pt x="1217" y="217"/>
                  </a:lnTo>
                  <a:lnTo>
                    <a:pt x="1220" y="220"/>
                  </a:lnTo>
                  <a:lnTo>
                    <a:pt x="1224" y="222"/>
                  </a:lnTo>
                  <a:lnTo>
                    <a:pt x="1227" y="224"/>
                  </a:lnTo>
                  <a:lnTo>
                    <a:pt x="1231" y="226"/>
                  </a:lnTo>
                  <a:lnTo>
                    <a:pt x="1234" y="227"/>
                  </a:lnTo>
                  <a:lnTo>
                    <a:pt x="1238" y="229"/>
                  </a:lnTo>
                  <a:lnTo>
                    <a:pt x="1241" y="230"/>
                  </a:lnTo>
                  <a:lnTo>
                    <a:pt x="1244" y="231"/>
                  </a:lnTo>
                  <a:lnTo>
                    <a:pt x="1247" y="232"/>
                  </a:lnTo>
                  <a:lnTo>
                    <a:pt x="1251" y="233"/>
                  </a:lnTo>
                  <a:lnTo>
                    <a:pt x="1254" y="233"/>
                  </a:lnTo>
                  <a:lnTo>
                    <a:pt x="1258" y="234"/>
                  </a:lnTo>
                  <a:lnTo>
                    <a:pt x="1261" y="234"/>
                  </a:lnTo>
                  <a:lnTo>
                    <a:pt x="1265" y="235"/>
                  </a:lnTo>
                  <a:lnTo>
                    <a:pt x="1267" y="235"/>
                  </a:lnTo>
                  <a:lnTo>
                    <a:pt x="1271" y="235"/>
                  </a:lnTo>
                  <a:lnTo>
                    <a:pt x="1274" y="235"/>
                  </a:lnTo>
                  <a:lnTo>
                    <a:pt x="1278" y="235"/>
                  </a:lnTo>
                  <a:lnTo>
                    <a:pt x="1281" y="235"/>
                  </a:lnTo>
                  <a:lnTo>
                    <a:pt x="1285" y="235"/>
                  </a:lnTo>
                  <a:lnTo>
                    <a:pt x="1288" y="235"/>
                  </a:lnTo>
                  <a:lnTo>
                    <a:pt x="1291" y="235"/>
                  </a:lnTo>
                  <a:lnTo>
                    <a:pt x="1294" y="235"/>
                  </a:lnTo>
                  <a:lnTo>
                    <a:pt x="1298" y="235"/>
                  </a:lnTo>
                  <a:lnTo>
                    <a:pt x="1301" y="235"/>
                  </a:lnTo>
                  <a:lnTo>
                    <a:pt x="1305" y="235"/>
                  </a:lnTo>
                  <a:lnTo>
                    <a:pt x="1308" y="235"/>
                  </a:lnTo>
                  <a:lnTo>
                    <a:pt x="1312" y="234"/>
                  </a:lnTo>
                  <a:lnTo>
                    <a:pt x="1314" y="234"/>
                  </a:lnTo>
                  <a:lnTo>
                    <a:pt x="1318" y="234"/>
                  </a:lnTo>
                  <a:lnTo>
                    <a:pt x="1321" y="234"/>
                  </a:lnTo>
                  <a:lnTo>
                    <a:pt x="1325" y="234"/>
                  </a:lnTo>
                  <a:lnTo>
                    <a:pt x="1328" y="233"/>
                  </a:lnTo>
                  <a:lnTo>
                    <a:pt x="1332" y="233"/>
                  </a:lnTo>
                  <a:lnTo>
                    <a:pt x="1335" y="233"/>
                  </a:lnTo>
                  <a:lnTo>
                    <a:pt x="1338" y="233"/>
                  </a:lnTo>
                  <a:lnTo>
                    <a:pt x="1341" y="233"/>
                  </a:lnTo>
                  <a:lnTo>
                    <a:pt x="1345" y="233"/>
                  </a:lnTo>
                  <a:lnTo>
                    <a:pt x="1348" y="233"/>
                  </a:lnTo>
                  <a:lnTo>
                    <a:pt x="1352" y="232"/>
                  </a:lnTo>
                  <a:lnTo>
                    <a:pt x="1355" y="232"/>
                  </a:lnTo>
                  <a:lnTo>
                    <a:pt x="1359" y="232"/>
                  </a:lnTo>
                  <a:lnTo>
                    <a:pt x="1362" y="232"/>
                  </a:lnTo>
                  <a:lnTo>
                    <a:pt x="1365" y="232"/>
                  </a:lnTo>
                  <a:lnTo>
                    <a:pt x="1368" y="231"/>
                  </a:lnTo>
                  <a:lnTo>
                    <a:pt x="1372" y="231"/>
                  </a:lnTo>
                  <a:lnTo>
                    <a:pt x="1375" y="231"/>
                  </a:lnTo>
                  <a:lnTo>
                    <a:pt x="1379" y="231"/>
                  </a:lnTo>
                  <a:lnTo>
                    <a:pt x="1382" y="231"/>
                  </a:lnTo>
                  <a:lnTo>
                    <a:pt x="1386" y="231"/>
                  </a:lnTo>
                  <a:lnTo>
                    <a:pt x="1388" y="230"/>
                  </a:lnTo>
                  <a:lnTo>
                    <a:pt x="1392" y="230"/>
                  </a:lnTo>
                  <a:lnTo>
                    <a:pt x="1395" y="230"/>
                  </a:lnTo>
                  <a:lnTo>
                    <a:pt x="1399" y="230"/>
                  </a:lnTo>
                  <a:lnTo>
                    <a:pt x="1402" y="230"/>
                  </a:lnTo>
                  <a:lnTo>
                    <a:pt x="1406" y="229"/>
                  </a:lnTo>
                  <a:lnTo>
                    <a:pt x="1409" y="229"/>
                  </a:lnTo>
                  <a:lnTo>
                    <a:pt x="1412" y="229"/>
                  </a:lnTo>
                  <a:lnTo>
                    <a:pt x="1415" y="229"/>
                  </a:lnTo>
                  <a:lnTo>
                    <a:pt x="1419" y="228"/>
                  </a:lnTo>
                  <a:lnTo>
                    <a:pt x="1422" y="228"/>
                  </a:lnTo>
                  <a:lnTo>
                    <a:pt x="1426" y="228"/>
                  </a:lnTo>
                  <a:lnTo>
                    <a:pt x="1429" y="228"/>
                  </a:lnTo>
                  <a:lnTo>
                    <a:pt x="1433" y="228"/>
                  </a:lnTo>
                  <a:lnTo>
                    <a:pt x="1435" y="228"/>
                  </a:lnTo>
                  <a:lnTo>
                    <a:pt x="1439" y="228"/>
                  </a:lnTo>
                  <a:lnTo>
                    <a:pt x="1442" y="227"/>
                  </a:lnTo>
                  <a:lnTo>
                    <a:pt x="1446" y="227"/>
                  </a:lnTo>
                  <a:lnTo>
                    <a:pt x="1449" y="227"/>
                  </a:lnTo>
                  <a:lnTo>
                    <a:pt x="1453" y="227"/>
                  </a:lnTo>
                  <a:lnTo>
                    <a:pt x="1456" y="226"/>
                  </a:lnTo>
                  <a:lnTo>
                    <a:pt x="1459" y="226"/>
                  </a:lnTo>
                  <a:lnTo>
                    <a:pt x="1462" y="226"/>
                  </a:lnTo>
                  <a:lnTo>
                    <a:pt x="1466" y="226"/>
                  </a:lnTo>
                  <a:lnTo>
                    <a:pt x="1469" y="226"/>
                  </a:lnTo>
                  <a:lnTo>
                    <a:pt x="1473" y="225"/>
                  </a:lnTo>
                  <a:lnTo>
                    <a:pt x="1476" y="225"/>
                  </a:lnTo>
                  <a:lnTo>
                    <a:pt x="1480" y="225"/>
                  </a:lnTo>
                  <a:lnTo>
                    <a:pt x="1483" y="225"/>
                  </a:lnTo>
                  <a:lnTo>
                    <a:pt x="1486" y="226"/>
                  </a:lnTo>
                  <a:lnTo>
                    <a:pt x="1489" y="225"/>
                  </a:lnTo>
                  <a:lnTo>
                    <a:pt x="1493" y="225"/>
                  </a:lnTo>
                  <a:lnTo>
                    <a:pt x="1496" y="225"/>
                  </a:lnTo>
                  <a:lnTo>
                    <a:pt x="1500" y="225"/>
                  </a:lnTo>
                  <a:lnTo>
                    <a:pt x="1503" y="225"/>
                  </a:lnTo>
                  <a:lnTo>
                    <a:pt x="1507" y="225"/>
                  </a:lnTo>
                  <a:lnTo>
                    <a:pt x="1509" y="225"/>
                  </a:lnTo>
                  <a:lnTo>
                    <a:pt x="1513" y="225"/>
                  </a:lnTo>
                  <a:lnTo>
                    <a:pt x="1516" y="225"/>
                  </a:lnTo>
                  <a:lnTo>
                    <a:pt x="1520" y="224"/>
                  </a:lnTo>
                  <a:lnTo>
                    <a:pt x="1523" y="224"/>
                  </a:lnTo>
                  <a:lnTo>
                    <a:pt x="1527" y="224"/>
                  </a:lnTo>
                  <a:lnTo>
                    <a:pt x="1530" y="224"/>
                  </a:lnTo>
                  <a:lnTo>
                    <a:pt x="1533" y="224"/>
                  </a:lnTo>
                  <a:lnTo>
                    <a:pt x="1536" y="223"/>
                  </a:lnTo>
                  <a:lnTo>
                    <a:pt x="1540" y="223"/>
                  </a:lnTo>
                  <a:lnTo>
                    <a:pt x="1543" y="223"/>
                  </a:lnTo>
                  <a:lnTo>
                    <a:pt x="1547" y="222"/>
                  </a:lnTo>
                  <a:lnTo>
                    <a:pt x="1550" y="222"/>
                  </a:lnTo>
                  <a:lnTo>
                    <a:pt x="1554" y="222"/>
                  </a:lnTo>
                  <a:lnTo>
                    <a:pt x="1556" y="222"/>
                  </a:lnTo>
                  <a:lnTo>
                    <a:pt x="1560" y="221"/>
                  </a:lnTo>
                  <a:lnTo>
                    <a:pt x="1563" y="221"/>
                  </a:lnTo>
                  <a:lnTo>
                    <a:pt x="1567" y="221"/>
                  </a:lnTo>
                  <a:lnTo>
                    <a:pt x="1570" y="221"/>
                  </a:lnTo>
                  <a:lnTo>
                    <a:pt x="1574" y="221"/>
                  </a:lnTo>
                  <a:lnTo>
                    <a:pt x="1577" y="220"/>
                  </a:lnTo>
                  <a:lnTo>
                    <a:pt x="1580" y="220"/>
                  </a:lnTo>
                  <a:lnTo>
                    <a:pt x="1583" y="220"/>
                  </a:lnTo>
                  <a:lnTo>
                    <a:pt x="1586" y="220"/>
                  </a:lnTo>
                  <a:lnTo>
                    <a:pt x="1590" y="220"/>
                  </a:lnTo>
                  <a:lnTo>
                    <a:pt x="1593" y="219"/>
                  </a:lnTo>
                  <a:lnTo>
                    <a:pt x="1597" y="219"/>
                  </a:lnTo>
                  <a:lnTo>
                    <a:pt x="1600" y="219"/>
                  </a:lnTo>
                  <a:lnTo>
                    <a:pt x="1604" y="219"/>
                  </a:lnTo>
                  <a:lnTo>
                    <a:pt x="1606" y="218"/>
                  </a:lnTo>
                  <a:lnTo>
                    <a:pt x="1610" y="218"/>
                  </a:lnTo>
                  <a:lnTo>
                    <a:pt x="1613" y="218"/>
                  </a:lnTo>
                  <a:lnTo>
                    <a:pt x="1617" y="218"/>
                  </a:lnTo>
                  <a:lnTo>
                    <a:pt x="1620" y="217"/>
                  </a:lnTo>
                  <a:lnTo>
                    <a:pt x="1624" y="217"/>
                  </a:lnTo>
                  <a:lnTo>
                    <a:pt x="1627" y="217"/>
                  </a:lnTo>
                  <a:lnTo>
                    <a:pt x="1630" y="216"/>
                  </a:lnTo>
                  <a:lnTo>
                    <a:pt x="1633" y="216"/>
                  </a:lnTo>
                  <a:lnTo>
                    <a:pt x="1637" y="216"/>
                  </a:lnTo>
                  <a:lnTo>
                    <a:pt x="1640" y="215"/>
                  </a:lnTo>
                  <a:lnTo>
                    <a:pt x="1644" y="215"/>
                  </a:lnTo>
                  <a:lnTo>
                    <a:pt x="1647" y="214"/>
                  </a:lnTo>
                  <a:lnTo>
                    <a:pt x="1651" y="214"/>
                  </a:lnTo>
                  <a:lnTo>
                    <a:pt x="1653" y="213"/>
                  </a:lnTo>
                  <a:lnTo>
                    <a:pt x="1657" y="213"/>
                  </a:lnTo>
                  <a:lnTo>
                    <a:pt x="1660" y="212"/>
                  </a:lnTo>
                  <a:lnTo>
                    <a:pt x="1664" y="211"/>
                  </a:lnTo>
                  <a:lnTo>
                    <a:pt x="1667" y="211"/>
                  </a:lnTo>
                  <a:lnTo>
                    <a:pt x="1671" y="210"/>
                  </a:lnTo>
                  <a:lnTo>
                    <a:pt x="1674" y="210"/>
                  </a:lnTo>
                  <a:lnTo>
                    <a:pt x="1677" y="210"/>
                  </a:lnTo>
                  <a:lnTo>
                    <a:pt x="1680" y="210"/>
                  </a:lnTo>
                  <a:lnTo>
                    <a:pt x="1684" y="210"/>
                  </a:lnTo>
                  <a:lnTo>
                    <a:pt x="1687" y="210"/>
                  </a:lnTo>
                  <a:lnTo>
                    <a:pt x="1691" y="211"/>
                  </a:lnTo>
                  <a:lnTo>
                    <a:pt x="1694" y="211"/>
                  </a:lnTo>
                  <a:lnTo>
                    <a:pt x="1698" y="211"/>
                  </a:lnTo>
                  <a:lnTo>
                    <a:pt x="1701" y="211"/>
                  </a:lnTo>
                  <a:lnTo>
                    <a:pt x="1704" y="211"/>
                  </a:lnTo>
                  <a:lnTo>
                    <a:pt x="1707" y="211"/>
                  </a:lnTo>
                  <a:lnTo>
                    <a:pt x="1711" y="211"/>
                  </a:lnTo>
                  <a:lnTo>
                    <a:pt x="1714" y="211"/>
                  </a:lnTo>
                  <a:lnTo>
                    <a:pt x="1718" y="211"/>
                  </a:lnTo>
                  <a:lnTo>
                    <a:pt x="1721" y="211"/>
                  </a:lnTo>
                  <a:lnTo>
                    <a:pt x="1725" y="210"/>
                  </a:lnTo>
                  <a:lnTo>
                    <a:pt x="1727" y="210"/>
                  </a:lnTo>
                  <a:lnTo>
                    <a:pt x="1731" y="210"/>
                  </a:lnTo>
                  <a:lnTo>
                    <a:pt x="1734" y="210"/>
                  </a:lnTo>
                  <a:lnTo>
                    <a:pt x="1738" y="210"/>
                  </a:lnTo>
                  <a:lnTo>
                    <a:pt x="1741" y="209"/>
                  </a:lnTo>
                  <a:lnTo>
                    <a:pt x="1745" y="209"/>
                  </a:lnTo>
                  <a:lnTo>
                    <a:pt x="1748" y="209"/>
                  </a:lnTo>
                  <a:lnTo>
                    <a:pt x="1751" y="209"/>
                  </a:lnTo>
                  <a:lnTo>
                    <a:pt x="1754" y="209"/>
                  </a:lnTo>
                  <a:lnTo>
                    <a:pt x="1758" y="209"/>
                  </a:lnTo>
                  <a:lnTo>
                    <a:pt x="1761" y="208"/>
                  </a:lnTo>
                  <a:lnTo>
                    <a:pt x="1765" y="208"/>
                  </a:lnTo>
                  <a:lnTo>
                    <a:pt x="1768" y="208"/>
                  </a:lnTo>
                  <a:lnTo>
                    <a:pt x="1772" y="208"/>
                  </a:lnTo>
                  <a:lnTo>
                    <a:pt x="1774" y="207"/>
                  </a:lnTo>
                  <a:lnTo>
                    <a:pt x="1778" y="207"/>
                  </a:lnTo>
                  <a:lnTo>
                    <a:pt x="1781" y="207"/>
                  </a:lnTo>
                  <a:lnTo>
                    <a:pt x="1785" y="206"/>
                  </a:lnTo>
                  <a:lnTo>
                    <a:pt x="1788" y="206"/>
                  </a:lnTo>
                  <a:lnTo>
                    <a:pt x="1792" y="206"/>
                  </a:lnTo>
                  <a:lnTo>
                    <a:pt x="1795" y="205"/>
                  </a:lnTo>
                  <a:lnTo>
                    <a:pt x="1798" y="205"/>
                  </a:lnTo>
                  <a:lnTo>
                    <a:pt x="1801" y="205"/>
                  </a:lnTo>
                  <a:lnTo>
                    <a:pt x="1805" y="205"/>
                  </a:lnTo>
                  <a:lnTo>
                    <a:pt x="1808" y="204"/>
                  </a:lnTo>
                  <a:lnTo>
                    <a:pt x="1812" y="204"/>
                  </a:lnTo>
                  <a:lnTo>
                    <a:pt x="1815" y="204"/>
                  </a:lnTo>
                  <a:lnTo>
                    <a:pt x="1819" y="203"/>
                  </a:lnTo>
                  <a:lnTo>
                    <a:pt x="1822" y="203"/>
                  </a:lnTo>
                  <a:lnTo>
                    <a:pt x="1825" y="203"/>
                  </a:lnTo>
                  <a:lnTo>
                    <a:pt x="1828" y="203"/>
                  </a:lnTo>
                  <a:lnTo>
                    <a:pt x="1832" y="202"/>
                  </a:lnTo>
                  <a:lnTo>
                    <a:pt x="1835" y="202"/>
                  </a:lnTo>
                  <a:lnTo>
                    <a:pt x="1839" y="202"/>
                  </a:lnTo>
                  <a:lnTo>
                    <a:pt x="1842" y="201"/>
                  </a:lnTo>
                  <a:lnTo>
                    <a:pt x="1846" y="201"/>
                  </a:lnTo>
                  <a:lnTo>
                    <a:pt x="1848" y="201"/>
                  </a:lnTo>
                  <a:lnTo>
                    <a:pt x="1852" y="201"/>
                  </a:lnTo>
                  <a:lnTo>
                    <a:pt x="1855" y="201"/>
                  </a:lnTo>
                  <a:lnTo>
                    <a:pt x="1859" y="201"/>
                  </a:lnTo>
                  <a:lnTo>
                    <a:pt x="1862" y="201"/>
                  </a:lnTo>
                  <a:lnTo>
                    <a:pt x="1866" y="200"/>
                  </a:lnTo>
                  <a:lnTo>
                    <a:pt x="1869" y="200"/>
                  </a:lnTo>
                  <a:lnTo>
                    <a:pt x="1872" y="200"/>
                  </a:lnTo>
                  <a:lnTo>
                    <a:pt x="1875" y="200"/>
                  </a:lnTo>
                  <a:lnTo>
                    <a:pt x="1879" y="199"/>
                  </a:lnTo>
                  <a:lnTo>
                    <a:pt x="1882" y="199"/>
                  </a:lnTo>
                  <a:lnTo>
                    <a:pt x="1886" y="199"/>
                  </a:lnTo>
                  <a:lnTo>
                    <a:pt x="1889" y="199"/>
                  </a:lnTo>
                  <a:lnTo>
                    <a:pt x="1893" y="198"/>
                  </a:lnTo>
                  <a:lnTo>
                    <a:pt x="1895" y="198"/>
                  </a:lnTo>
                  <a:lnTo>
                    <a:pt x="1899" y="198"/>
                  </a:lnTo>
                  <a:lnTo>
                    <a:pt x="1902" y="198"/>
                  </a:lnTo>
                  <a:lnTo>
                    <a:pt x="1906" y="198"/>
                  </a:lnTo>
                  <a:lnTo>
                    <a:pt x="1909" y="197"/>
                  </a:lnTo>
                  <a:lnTo>
                    <a:pt x="1913" y="197"/>
                  </a:lnTo>
                  <a:lnTo>
                    <a:pt x="1916" y="197"/>
                  </a:lnTo>
                  <a:lnTo>
                    <a:pt x="1919" y="196"/>
                  </a:lnTo>
                  <a:lnTo>
                    <a:pt x="1922" y="196"/>
                  </a:lnTo>
                  <a:lnTo>
                    <a:pt x="1926" y="196"/>
                  </a:lnTo>
                  <a:lnTo>
                    <a:pt x="1929" y="195"/>
                  </a:lnTo>
                  <a:lnTo>
                    <a:pt x="1933" y="195"/>
                  </a:lnTo>
                  <a:lnTo>
                    <a:pt x="1936" y="194"/>
                  </a:lnTo>
                  <a:lnTo>
                    <a:pt x="1940" y="194"/>
                  </a:lnTo>
                  <a:lnTo>
                    <a:pt x="1943" y="193"/>
                  </a:lnTo>
                  <a:lnTo>
                    <a:pt x="1946" y="193"/>
                  </a:lnTo>
                  <a:lnTo>
                    <a:pt x="1949" y="192"/>
                  </a:lnTo>
                  <a:lnTo>
                    <a:pt x="1953" y="192"/>
                  </a:lnTo>
                  <a:lnTo>
                    <a:pt x="1956" y="191"/>
                  </a:lnTo>
                  <a:lnTo>
                    <a:pt x="1960" y="190"/>
                  </a:lnTo>
                  <a:lnTo>
                    <a:pt x="1963" y="189"/>
                  </a:lnTo>
                  <a:lnTo>
                    <a:pt x="1967" y="188"/>
                  </a:lnTo>
                  <a:lnTo>
                    <a:pt x="1969" y="187"/>
                  </a:lnTo>
                  <a:lnTo>
                    <a:pt x="1973" y="185"/>
                  </a:lnTo>
                  <a:lnTo>
                    <a:pt x="1976" y="184"/>
                  </a:lnTo>
                  <a:lnTo>
                    <a:pt x="1980" y="183"/>
                  </a:lnTo>
                  <a:lnTo>
                    <a:pt x="1983" y="182"/>
                  </a:lnTo>
                  <a:lnTo>
                    <a:pt x="1987" y="181"/>
                  </a:lnTo>
                  <a:lnTo>
                    <a:pt x="1990" y="179"/>
                  </a:lnTo>
                  <a:lnTo>
                    <a:pt x="1993" y="178"/>
                  </a:lnTo>
                  <a:lnTo>
                    <a:pt x="1996" y="178"/>
                  </a:lnTo>
                  <a:lnTo>
                    <a:pt x="2000" y="177"/>
                  </a:lnTo>
                  <a:lnTo>
                    <a:pt x="2003" y="176"/>
                  </a:lnTo>
                  <a:lnTo>
                    <a:pt x="2007" y="176"/>
                  </a:lnTo>
                  <a:lnTo>
                    <a:pt x="2010" y="176"/>
                  </a:lnTo>
                  <a:lnTo>
                    <a:pt x="2014" y="176"/>
                  </a:lnTo>
                  <a:lnTo>
                    <a:pt x="2016" y="176"/>
                  </a:lnTo>
                  <a:lnTo>
                    <a:pt x="2020" y="177"/>
                  </a:lnTo>
                  <a:lnTo>
                    <a:pt x="2023" y="177"/>
                  </a:lnTo>
                  <a:lnTo>
                    <a:pt x="2027" y="177"/>
                  </a:lnTo>
                  <a:lnTo>
                    <a:pt x="2030" y="178"/>
                  </a:lnTo>
                  <a:lnTo>
                    <a:pt x="2034" y="178"/>
                  </a:lnTo>
                  <a:lnTo>
                    <a:pt x="2037" y="178"/>
                  </a:lnTo>
                  <a:lnTo>
                    <a:pt x="2040" y="178"/>
                  </a:lnTo>
                  <a:lnTo>
                    <a:pt x="2043" y="178"/>
                  </a:lnTo>
                  <a:lnTo>
                    <a:pt x="2047" y="179"/>
                  </a:lnTo>
                  <a:lnTo>
                    <a:pt x="2050" y="179"/>
                  </a:lnTo>
                  <a:lnTo>
                    <a:pt x="2054" y="179"/>
                  </a:lnTo>
                  <a:lnTo>
                    <a:pt x="2057" y="179"/>
                  </a:lnTo>
                  <a:lnTo>
                    <a:pt x="2061" y="179"/>
                  </a:lnTo>
                  <a:lnTo>
                    <a:pt x="2064" y="179"/>
                  </a:lnTo>
                  <a:lnTo>
                    <a:pt x="2067" y="179"/>
                  </a:lnTo>
                  <a:lnTo>
                    <a:pt x="2070" y="179"/>
                  </a:lnTo>
                  <a:lnTo>
                    <a:pt x="2074" y="179"/>
                  </a:lnTo>
                  <a:lnTo>
                    <a:pt x="2077" y="179"/>
                  </a:lnTo>
                  <a:lnTo>
                    <a:pt x="2081" y="179"/>
                  </a:lnTo>
                  <a:lnTo>
                    <a:pt x="2084" y="179"/>
                  </a:lnTo>
                  <a:lnTo>
                    <a:pt x="2088" y="179"/>
                  </a:lnTo>
                  <a:lnTo>
                    <a:pt x="2090" y="178"/>
                  </a:lnTo>
                  <a:lnTo>
                    <a:pt x="2094" y="178"/>
                  </a:lnTo>
                  <a:lnTo>
                    <a:pt x="2097" y="178"/>
                  </a:lnTo>
                  <a:lnTo>
                    <a:pt x="2101" y="178"/>
                  </a:lnTo>
                  <a:lnTo>
                    <a:pt x="2104" y="178"/>
                  </a:lnTo>
                  <a:lnTo>
                    <a:pt x="2108" y="177"/>
                  </a:lnTo>
                  <a:lnTo>
                    <a:pt x="2111" y="177"/>
                  </a:lnTo>
                  <a:lnTo>
                    <a:pt x="2114" y="175"/>
                  </a:lnTo>
                  <a:lnTo>
                    <a:pt x="2117" y="173"/>
                  </a:lnTo>
                  <a:lnTo>
                    <a:pt x="2121" y="170"/>
                  </a:lnTo>
                  <a:lnTo>
                    <a:pt x="2124" y="165"/>
                  </a:lnTo>
                  <a:lnTo>
                    <a:pt x="2128" y="156"/>
                  </a:lnTo>
                  <a:lnTo>
                    <a:pt x="2131" y="144"/>
                  </a:lnTo>
                  <a:lnTo>
                    <a:pt x="2135" y="130"/>
                  </a:lnTo>
                  <a:lnTo>
                    <a:pt x="2137" y="113"/>
                  </a:lnTo>
                  <a:lnTo>
                    <a:pt x="2141" y="96"/>
                  </a:lnTo>
                  <a:lnTo>
                    <a:pt x="2144" y="82"/>
                  </a:lnTo>
                  <a:lnTo>
                    <a:pt x="2148" y="69"/>
                  </a:lnTo>
                  <a:lnTo>
                    <a:pt x="2151" y="60"/>
                  </a:lnTo>
                  <a:lnTo>
                    <a:pt x="2155" y="57"/>
                  </a:lnTo>
                  <a:lnTo>
                    <a:pt x="2158" y="56"/>
                  </a:lnTo>
                  <a:lnTo>
                    <a:pt x="2161" y="58"/>
                  </a:lnTo>
                  <a:lnTo>
                    <a:pt x="2164" y="60"/>
                  </a:lnTo>
                  <a:lnTo>
                    <a:pt x="2168" y="65"/>
                  </a:lnTo>
                  <a:lnTo>
                    <a:pt x="2171" y="70"/>
                  </a:lnTo>
                  <a:lnTo>
                    <a:pt x="2175" y="75"/>
                  </a:lnTo>
                  <a:lnTo>
                    <a:pt x="2178" y="80"/>
                  </a:lnTo>
                  <a:lnTo>
                    <a:pt x="2182" y="85"/>
                  </a:lnTo>
                  <a:lnTo>
                    <a:pt x="2185" y="90"/>
                  </a:lnTo>
                  <a:lnTo>
                    <a:pt x="2188" y="95"/>
                  </a:lnTo>
                  <a:lnTo>
                    <a:pt x="2191" y="98"/>
                  </a:lnTo>
                  <a:lnTo>
                    <a:pt x="2195" y="102"/>
                  </a:lnTo>
                  <a:lnTo>
                    <a:pt x="2198" y="105"/>
                  </a:lnTo>
                  <a:lnTo>
                    <a:pt x="2202" y="109"/>
                  </a:lnTo>
                  <a:lnTo>
                    <a:pt x="2205" y="111"/>
                  </a:lnTo>
                  <a:lnTo>
                    <a:pt x="2208" y="114"/>
                  </a:lnTo>
                  <a:lnTo>
                    <a:pt x="2211" y="116"/>
                  </a:lnTo>
                  <a:lnTo>
                    <a:pt x="2214" y="118"/>
                  </a:lnTo>
                  <a:lnTo>
                    <a:pt x="2218" y="120"/>
                  </a:lnTo>
                  <a:lnTo>
                    <a:pt x="2221" y="122"/>
                  </a:lnTo>
                  <a:lnTo>
                    <a:pt x="2225" y="124"/>
                  </a:lnTo>
                  <a:lnTo>
                    <a:pt x="2228" y="125"/>
                  </a:lnTo>
                  <a:lnTo>
                    <a:pt x="2232" y="127"/>
                  </a:lnTo>
                  <a:lnTo>
                    <a:pt x="2234" y="128"/>
                  </a:lnTo>
                  <a:lnTo>
                    <a:pt x="2238" y="129"/>
                  </a:lnTo>
                  <a:lnTo>
                    <a:pt x="2241" y="130"/>
                  </a:lnTo>
                  <a:lnTo>
                    <a:pt x="2245" y="130"/>
                  </a:lnTo>
                  <a:lnTo>
                    <a:pt x="2248" y="130"/>
                  </a:lnTo>
                  <a:lnTo>
                    <a:pt x="2252" y="130"/>
                  </a:lnTo>
                  <a:lnTo>
                    <a:pt x="2255" y="131"/>
                  </a:lnTo>
                  <a:lnTo>
                    <a:pt x="2258" y="131"/>
                  </a:lnTo>
                  <a:lnTo>
                    <a:pt x="2261" y="131"/>
                  </a:lnTo>
                  <a:lnTo>
                    <a:pt x="2265" y="130"/>
                  </a:lnTo>
                  <a:lnTo>
                    <a:pt x="2268" y="130"/>
                  </a:lnTo>
                  <a:lnTo>
                    <a:pt x="2272" y="130"/>
                  </a:lnTo>
                  <a:lnTo>
                    <a:pt x="2275" y="129"/>
                  </a:lnTo>
                  <a:lnTo>
                    <a:pt x="2279" y="127"/>
                  </a:lnTo>
                  <a:lnTo>
                    <a:pt x="2282" y="124"/>
                  </a:lnTo>
                  <a:lnTo>
                    <a:pt x="2285" y="121"/>
                  </a:lnTo>
                  <a:lnTo>
                    <a:pt x="2288" y="116"/>
                  </a:lnTo>
                  <a:lnTo>
                    <a:pt x="2292" y="110"/>
                  </a:lnTo>
                  <a:lnTo>
                    <a:pt x="2295" y="102"/>
                  </a:lnTo>
                  <a:lnTo>
                    <a:pt x="2299" y="94"/>
                  </a:lnTo>
                  <a:lnTo>
                    <a:pt x="2302" y="84"/>
                  </a:lnTo>
                  <a:lnTo>
                    <a:pt x="2306" y="74"/>
                  </a:lnTo>
                  <a:lnTo>
                    <a:pt x="2308" y="63"/>
                  </a:lnTo>
                  <a:lnTo>
                    <a:pt x="2312" y="53"/>
                  </a:lnTo>
                  <a:lnTo>
                    <a:pt x="2315" y="43"/>
                  </a:lnTo>
                  <a:lnTo>
                    <a:pt x="2319" y="34"/>
                  </a:lnTo>
                  <a:lnTo>
                    <a:pt x="2322" y="25"/>
                  </a:lnTo>
                  <a:lnTo>
                    <a:pt x="2326" y="19"/>
                  </a:lnTo>
                  <a:lnTo>
                    <a:pt x="2329" y="13"/>
                  </a:lnTo>
                  <a:lnTo>
                    <a:pt x="2332" y="8"/>
                  </a:lnTo>
                  <a:lnTo>
                    <a:pt x="2335" y="4"/>
                  </a:lnTo>
                  <a:lnTo>
                    <a:pt x="2339" y="1"/>
                  </a:lnTo>
                  <a:lnTo>
                    <a:pt x="2342" y="0"/>
                  </a:lnTo>
                  <a:lnTo>
                    <a:pt x="2346" y="1"/>
                  </a:lnTo>
                  <a:lnTo>
                    <a:pt x="2349" y="2"/>
                  </a:lnTo>
                  <a:lnTo>
                    <a:pt x="2353" y="4"/>
                  </a:lnTo>
                  <a:lnTo>
                    <a:pt x="2355" y="7"/>
                  </a:lnTo>
                  <a:lnTo>
                    <a:pt x="2359" y="11"/>
                  </a:lnTo>
                  <a:lnTo>
                    <a:pt x="2362" y="15"/>
                  </a:lnTo>
                  <a:lnTo>
                    <a:pt x="2366" y="20"/>
                  </a:lnTo>
                  <a:lnTo>
                    <a:pt x="2369" y="24"/>
                  </a:lnTo>
                  <a:lnTo>
                    <a:pt x="2373" y="27"/>
                  </a:lnTo>
                  <a:lnTo>
                    <a:pt x="2376" y="32"/>
                  </a:lnTo>
                  <a:lnTo>
                    <a:pt x="2379" y="36"/>
                  </a:lnTo>
                  <a:lnTo>
                    <a:pt x="2382" y="39"/>
                  </a:lnTo>
                  <a:lnTo>
                    <a:pt x="2386" y="43"/>
                  </a:lnTo>
                  <a:lnTo>
                    <a:pt x="2389" y="46"/>
                  </a:lnTo>
                  <a:lnTo>
                    <a:pt x="2393" y="49"/>
                  </a:lnTo>
                  <a:lnTo>
                    <a:pt x="2396" y="52"/>
                  </a:lnTo>
                  <a:lnTo>
                    <a:pt x="2400" y="55"/>
                  </a:lnTo>
                  <a:lnTo>
                    <a:pt x="2403" y="57"/>
                  </a:lnTo>
                  <a:lnTo>
                    <a:pt x="2406" y="60"/>
                  </a:lnTo>
                  <a:lnTo>
                    <a:pt x="2409" y="61"/>
                  </a:lnTo>
                  <a:lnTo>
                    <a:pt x="2413" y="63"/>
                  </a:lnTo>
                  <a:lnTo>
                    <a:pt x="2416" y="66"/>
                  </a:lnTo>
                  <a:lnTo>
                    <a:pt x="2420" y="68"/>
                  </a:lnTo>
                  <a:lnTo>
                    <a:pt x="2423" y="70"/>
                  </a:lnTo>
                  <a:lnTo>
                    <a:pt x="2427" y="71"/>
                  </a:lnTo>
                  <a:lnTo>
                    <a:pt x="2429" y="73"/>
                  </a:lnTo>
                  <a:lnTo>
                    <a:pt x="2433" y="75"/>
                  </a:lnTo>
                  <a:lnTo>
                    <a:pt x="2436" y="77"/>
                  </a:lnTo>
                  <a:lnTo>
                    <a:pt x="2440" y="79"/>
                  </a:lnTo>
                  <a:lnTo>
                    <a:pt x="2443" y="80"/>
                  </a:lnTo>
                  <a:lnTo>
                    <a:pt x="2447" y="82"/>
                  </a:lnTo>
                  <a:lnTo>
                    <a:pt x="2450" y="83"/>
                  </a:lnTo>
                  <a:lnTo>
                    <a:pt x="2453" y="85"/>
                  </a:lnTo>
                  <a:lnTo>
                    <a:pt x="2456" y="86"/>
                  </a:lnTo>
                  <a:lnTo>
                    <a:pt x="2460" y="87"/>
                  </a:lnTo>
                  <a:lnTo>
                    <a:pt x="2463" y="89"/>
                  </a:lnTo>
                  <a:lnTo>
                    <a:pt x="2467" y="90"/>
                  </a:lnTo>
                  <a:lnTo>
                    <a:pt x="2470" y="91"/>
                  </a:lnTo>
                  <a:lnTo>
                    <a:pt x="2474" y="92"/>
                  </a:lnTo>
                  <a:lnTo>
                    <a:pt x="2476" y="93"/>
                  </a:lnTo>
                  <a:lnTo>
                    <a:pt x="2480" y="94"/>
                  </a:lnTo>
                  <a:lnTo>
                    <a:pt x="2483" y="95"/>
                  </a:lnTo>
                  <a:lnTo>
                    <a:pt x="2487" y="95"/>
                  </a:lnTo>
                  <a:lnTo>
                    <a:pt x="2490" y="96"/>
                  </a:lnTo>
                  <a:lnTo>
                    <a:pt x="2494" y="97"/>
                  </a:lnTo>
                  <a:lnTo>
                    <a:pt x="2497" y="97"/>
                  </a:lnTo>
                  <a:lnTo>
                    <a:pt x="2500" y="98"/>
                  </a:lnTo>
                  <a:lnTo>
                    <a:pt x="2503" y="99"/>
                  </a:lnTo>
                  <a:lnTo>
                    <a:pt x="2507" y="100"/>
                  </a:lnTo>
                  <a:lnTo>
                    <a:pt x="2510" y="100"/>
                  </a:lnTo>
                  <a:lnTo>
                    <a:pt x="2514" y="101"/>
                  </a:lnTo>
                  <a:lnTo>
                    <a:pt x="2517" y="102"/>
                  </a:lnTo>
                  <a:lnTo>
                    <a:pt x="2520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5" name="Rectangle 252">
              <a:extLst>
                <a:ext uri="{FF2B5EF4-FFF2-40B4-BE49-F238E27FC236}">
                  <a16:creationId xmlns:a16="http://schemas.microsoft.com/office/drawing/2014/main" id="{CB86C768-2A15-5F42-AC37-71C4B77E5A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3029" y="4480893"/>
              <a:ext cx="1726838" cy="89659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962" name="テキスト ボックス 961">
            <a:extLst>
              <a:ext uri="{FF2B5EF4-FFF2-40B4-BE49-F238E27FC236}">
                <a16:creationId xmlns:a16="http://schemas.microsoft.com/office/drawing/2014/main" id="{6B0CABA7-EADF-7684-8490-FFE0EE4A47F7}"/>
              </a:ext>
            </a:extLst>
          </p:cNvPr>
          <p:cNvSpPr txBox="1"/>
          <p:nvPr/>
        </p:nvSpPr>
        <p:spPr>
          <a:xfrm>
            <a:off x="1688146" y="833367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0) 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63" name="テキスト ボックス 962">
            <a:extLst>
              <a:ext uri="{FF2B5EF4-FFF2-40B4-BE49-F238E27FC236}">
                <a16:creationId xmlns:a16="http://schemas.microsoft.com/office/drawing/2014/main" id="{39C631CD-952F-FE06-E5F2-9F035AE0ECE6}"/>
              </a:ext>
            </a:extLst>
          </p:cNvPr>
          <p:cNvSpPr txBox="1"/>
          <p:nvPr/>
        </p:nvSpPr>
        <p:spPr>
          <a:xfrm>
            <a:off x="1679679" y="1814384"/>
            <a:ext cx="3037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1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64" name="テキスト ボックス 963">
            <a:extLst>
              <a:ext uri="{FF2B5EF4-FFF2-40B4-BE49-F238E27FC236}">
                <a16:creationId xmlns:a16="http://schemas.microsoft.com/office/drawing/2014/main" id="{40AAC153-1F9E-15AB-166A-20CB21D30999}"/>
              </a:ext>
            </a:extLst>
          </p:cNvPr>
          <p:cNvSpPr txBox="1"/>
          <p:nvPr/>
        </p:nvSpPr>
        <p:spPr>
          <a:xfrm>
            <a:off x="1689093" y="3781842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5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65" name="テキスト ボックス 964">
            <a:extLst>
              <a:ext uri="{FF2B5EF4-FFF2-40B4-BE49-F238E27FC236}">
                <a16:creationId xmlns:a16="http://schemas.microsoft.com/office/drawing/2014/main" id="{C7D8DC4E-E846-5072-6660-542E63E4AF5A}"/>
              </a:ext>
            </a:extLst>
          </p:cNvPr>
          <p:cNvSpPr txBox="1"/>
          <p:nvPr/>
        </p:nvSpPr>
        <p:spPr>
          <a:xfrm>
            <a:off x="1688146" y="2809587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3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ACD372C7-4965-1D25-098F-3E79464F15F0}"/>
              </a:ext>
            </a:extLst>
          </p:cNvPr>
          <p:cNvGrpSpPr/>
          <p:nvPr/>
        </p:nvGrpSpPr>
        <p:grpSpPr>
          <a:xfrm>
            <a:off x="2188885" y="1861211"/>
            <a:ext cx="1691795" cy="707455"/>
            <a:chOff x="2142642" y="2074266"/>
            <a:chExt cx="1731646" cy="896592"/>
          </a:xfrm>
        </p:grpSpPr>
        <p:sp>
          <p:nvSpPr>
            <p:cNvPr id="394" name="Freeform 168">
              <a:extLst>
                <a:ext uri="{FF2B5EF4-FFF2-40B4-BE49-F238E27FC236}">
                  <a16:creationId xmlns:a16="http://schemas.microsoft.com/office/drawing/2014/main" id="{C95465E7-8CA6-A824-B50D-12B50BF1E3F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3329" y="2218587"/>
              <a:ext cx="1730959" cy="593519"/>
            </a:xfrm>
            <a:custGeom>
              <a:avLst/>
              <a:gdLst>
                <a:gd name="T0" fmla="*/ 35 w 2520"/>
                <a:gd name="T1" fmla="*/ 278 h 281"/>
                <a:gd name="T2" fmla="*/ 76 w 2520"/>
                <a:gd name="T3" fmla="*/ 275 h 281"/>
                <a:gd name="T4" fmla="*/ 116 w 2520"/>
                <a:gd name="T5" fmla="*/ 273 h 281"/>
                <a:gd name="T6" fmla="*/ 156 w 2520"/>
                <a:gd name="T7" fmla="*/ 272 h 281"/>
                <a:gd name="T8" fmla="*/ 197 w 2520"/>
                <a:gd name="T9" fmla="*/ 271 h 281"/>
                <a:gd name="T10" fmla="*/ 237 w 2520"/>
                <a:gd name="T11" fmla="*/ 270 h 281"/>
                <a:gd name="T12" fmla="*/ 277 w 2520"/>
                <a:gd name="T13" fmla="*/ 268 h 281"/>
                <a:gd name="T14" fmla="*/ 317 w 2520"/>
                <a:gd name="T15" fmla="*/ 268 h 281"/>
                <a:gd name="T16" fmla="*/ 357 w 2520"/>
                <a:gd name="T17" fmla="*/ 269 h 281"/>
                <a:gd name="T18" fmla="*/ 397 w 2520"/>
                <a:gd name="T19" fmla="*/ 269 h 281"/>
                <a:gd name="T20" fmla="*/ 438 w 2520"/>
                <a:gd name="T21" fmla="*/ 270 h 281"/>
                <a:gd name="T22" fmla="*/ 478 w 2520"/>
                <a:gd name="T23" fmla="*/ 270 h 281"/>
                <a:gd name="T24" fmla="*/ 518 w 2520"/>
                <a:gd name="T25" fmla="*/ 271 h 281"/>
                <a:gd name="T26" fmla="*/ 559 w 2520"/>
                <a:gd name="T27" fmla="*/ 272 h 281"/>
                <a:gd name="T28" fmla="*/ 599 w 2520"/>
                <a:gd name="T29" fmla="*/ 273 h 281"/>
                <a:gd name="T30" fmla="*/ 639 w 2520"/>
                <a:gd name="T31" fmla="*/ 273 h 281"/>
                <a:gd name="T32" fmla="*/ 680 w 2520"/>
                <a:gd name="T33" fmla="*/ 274 h 281"/>
                <a:gd name="T34" fmla="*/ 720 w 2520"/>
                <a:gd name="T35" fmla="*/ 274 h 281"/>
                <a:gd name="T36" fmla="*/ 760 w 2520"/>
                <a:gd name="T37" fmla="*/ 269 h 281"/>
                <a:gd name="T38" fmla="*/ 801 w 2520"/>
                <a:gd name="T39" fmla="*/ 274 h 281"/>
                <a:gd name="T40" fmla="*/ 841 w 2520"/>
                <a:gd name="T41" fmla="*/ 274 h 281"/>
                <a:gd name="T42" fmla="*/ 881 w 2520"/>
                <a:gd name="T43" fmla="*/ 275 h 281"/>
                <a:gd name="T44" fmla="*/ 922 w 2520"/>
                <a:gd name="T45" fmla="*/ 276 h 281"/>
                <a:gd name="T46" fmla="*/ 962 w 2520"/>
                <a:gd name="T47" fmla="*/ 275 h 281"/>
                <a:gd name="T48" fmla="*/ 1002 w 2520"/>
                <a:gd name="T49" fmla="*/ 274 h 281"/>
                <a:gd name="T50" fmla="*/ 1043 w 2520"/>
                <a:gd name="T51" fmla="*/ 272 h 281"/>
                <a:gd name="T52" fmla="*/ 1083 w 2520"/>
                <a:gd name="T53" fmla="*/ 271 h 281"/>
                <a:gd name="T54" fmla="*/ 1123 w 2520"/>
                <a:gd name="T55" fmla="*/ 272 h 281"/>
                <a:gd name="T56" fmla="*/ 1164 w 2520"/>
                <a:gd name="T57" fmla="*/ 272 h 281"/>
                <a:gd name="T58" fmla="*/ 1204 w 2520"/>
                <a:gd name="T59" fmla="*/ 272 h 281"/>
                <a:gd name="T60" fmla="*/ 1244 w 2520"/>
                <a:gd name="T61" fmla="*/ 274 h 281"/>
                <a:gd name="T62" fmla="*/ 1285 w 2520"/>
                <a:gd name="T63" fmla="*/ 276 h 281"/>
                <a:gd name="T64" fmla="*/ 1325 w 2520"/>
                <a:gd name="T65" fmla="*/ 274 h 281"/>
                <a:gd name="T66" fmla="*/ 1365 w 2520"/>
                <a:gd name="T67" fmla="*/ 275 h 281"/>
                <a:gd name="T68" fmla="*/ 1406 w 2520"/>
                <a:gd name="T69" fmla="*/ 275 h 281"/>
                <a:gd name="T70" fmla="*/ 1446 w 2520"/>
                <a:gd name="T71" fmla="*/ 273 h 281"/>
                <a:gd name="T72" fmla="*/ 1486 w 2520"/>
                <a:gd name="T73" fmla="*/ 273 h 281"/>
                <a:gd name="T74" fmla="*/ 1527 w 2520"/>
                <a:gd name="T75" fmla="*/ 275 h 281"/>
                <a:gd name="T76" fmla="*/ 1567 w 2520"/>
                <a:gd name="T77" fmla="*/ 274 h 281"/>
                <a:gd name="T78" fmla="*/ 1606 w 2520"/>
                <a:gd name="T79" fmla="*/ 273 h 281"/>
                <a:gd name="T80" fmla="*/ 1647 w 2520"/>
                <a:gd name="T81" fmla="*/ 272 h 281"/>
                <a:gd name="T82" fmla="*/ 1687 w 2520"/>
                <a:gd name="T83" fmla="*/ 271 h 281"/>
                <a:gd name="T84" fmla="*/ 1727 w 2520"/>
                <a:gd name="T85" fmla="*/ 271 h 281"/>
                <a:gd name="T86" fmla="*/ 1768 w 2520"/>
                <a:gd name="T87" fmla="*/ 270 h 281"/>
                <a:gd name="T88" fmla="*/ 1808 w 2520"/>
                <a:gd name="T89" fmla="*/ 269 h 281"/>
                <a:gd name="T90" fmla="*/ 1848 w 2520"/>
                <a:gd name="T91" fmla="*/ 267 h 281"/>
                <a:gd name="T92" fmla="*/ 1889 w 2520"/>
                <a:gd name="T93" fmla="*/ 265 h 281"/>
                <a:gd name="T94" fmla="*/ 1929 w 2520"/>
                <a:gd name="T95" fmla="*/ 259 h 281"/>
                <a:gd name="T96" fmla="*/ 1969 w 2520"/>
                <a:gd name="T97" fmla="*/ 256 h 281"/>
                <a:gd name="T98" fmla="*/ 2010 w 2520"/>
                <a:gd name="T99" fmla="*/ 252 h 281"/>
                <a:gd name="T100" fmla="*/ 2050 w 2520"/>
                <a:gd name="T101" fmla="*/ 255 h 281"/>
                <a:gd name="T102" fmla="*/ 2090 w 2520"/>
                <a:gd name="T103" fmla="*/ 255 h 281"/>
                <a:gd name="T104" fmla="*/ 2131 w 2520"/>
                <a:gd name="T105" fmla="*/ 45 h 281"/>
                <a:gd name="T106" fmla="*/ 2171 w 2520"/>
                <a:gd name="T107" fmla="*/ 101 h 281"/>
                <a:gd name="T108" fmla="*/ 2211 w 2520"/>
                <a:gd name="T109" fmla="*/ 176 h 281"/>
                <a:gd name="T110" fmla="*/ 2252 w 2520"/>
                <a:gd name="T111" fmla="*/ 197 h 281"/>
                <a:gd name="T112" fmla="*/ 2292 w 2520"/>
                <a:gd name="T113" fmla="*/ 132 h 281"/>
                <a:gd name="T114" fmla="*/ 2332 w 2520"/>
                <a:gd name="T115" fmla="*/ 70 h 281"/>
                <a:gd name="T116" fmla="*/ 2373 w 2520"/>
                <a:gd name="T117" fmla="*/ 127 h 281"/>
                <a:gd name="T118" fmla="*/ 2413 w 2520"/>
                <a:gd name="T119" fmla="*/ 160 h 281"/>
                <a:gd name="T120" fmla="*/ 2453 w 2520"/>
                <a:gd name="T121" fmla="*/ 181 h 281"/>
                <a:gd name="T122" fmla="*/ 2494 w 2520"/>
                <a:gd name="T123" fmla="*/ 196 h 2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520" h="281">
                  <a:moveTo>
                    <a:pt x="0" y="281"/>
                  </a:moveTo>
                  <a:lnTo>
                    <a:pt x="2" y="281"/>
                  </a:lnTo>
                  <a:lnTo>
                    <a:pt x="5" y="281"/>
                  </a:lnTo>
                  <a:lnTo>
                    <a:pt x="8" y="280"/>
                  </a:lnTo>
                  <a:lnTo>
                    <a:pt x="11" y="280"/>
                  </a:lnTo>
                  <a:lnTo>
                    <a:pt x="15" y="280"/>
                  </a:lnTo>
                  <a:lnTo>
                    <a:pt x="18" y="279"/>
                  </a:lnTo>
                  <a:lnTo>
                    <a:pt x="22" y="279"/>
                  </a:lnTo>
                  <a:lnTo>
                    <a:pt x="25" y="279"/>
                  </a:lnTo>
                  <a:lnTo>
                    <a:pt x="29" y="278"/>
                  </a:lnTo>
                  <a:lnTo>
                    <a:pt x="31" y="278"/>
                  </a:lnTo>
                  <a:lnTo>
                    <a:pt x="35" y="278"/>
                  </a:lnTo>
                  <a:lnTo>
                    <a:pt x="38" y="277"/>
                  </a:lnTo>
                  <a:lnTo>
                    <a:pt x="42" y="277"/>
                  </a:lnTo>
                  <a:lnTo>
                    <a:pt x="45" y="277"/>
                  </a:lnTo>
                  <a:lnTo>
                    <a:pt x="49" y="276"/>
                  </a:lnTo>
                  <a:lnTo>
                    <a:pt x="52" y="276"/>
                  </a:lnTo>
                  <a:lnTo>
                    <a:pt x="55" y="276"/>
                  </a:lnTo>
                  <a:lnTo>
                    <a:pt x="58" y="276"/>
                  </a:lnTo>
                  <a:lnTo>
                    <a:pt x="62" y="276"/>
                  </a:lnTo>
                  <a:lnTo>
                    <a:pt x="65" y="275"/>
                  </a:lnTo>
                  <a:lnTo>
                    <a:pt x="69" y="275"/>
                  </a:lnTo>
                  <a:lnTo>
                    <a:pt x="72" y="275"/>
                  </a:lnTo>
                  <a:lnTo>
                    <a:pt x="76" y="275"/>
                  </a:lnTo>
                  <a:lnTo>
                    <a:pt x="78" y="274"/>
                  </a:lnTo>
                  <a:lnTo>
                    <a:pt x="82" y="274"/>
                  </a:lnTo>
                  <a:lnTo>
                    <a:pt x="85" y="274"/>
                  </a:lnTo>
                  <a:lnTo>
                    <a:pt x="89" y="274"/>
                  </a:lnTo>
                  <a:lnTo>
                    <a:pt x="92" y="274"/>
                  </a:lnTo>
                  <a:lnTo>
                    <a:pt x="96" y="274"/>
                  </a:lnTo>
                  <a:lnTo>
                    <a:pt x="99" y="274"/>
                  </a:lnTo>
                  <a:lnTo>
                    <a:pt x="102" y="273"/>
                  </a:lnTo>
                  <a:lnTo>
                    <a:pt x="105" y="273"/>
                  </a:lnTo>
                  <a:lnTo>
                    <a:pt x="109" y="273"/>
                  </a:lnTo>
                  <a:lnTo>
                    <a:pt x="112" y="273"/>
                  </a:lnTo>
                  <a:lnTo>
                    <a:pt x="116" y="273"/>
                  </a:lnTo>
                  <a:lnTo>
                    <a:pt x="119" y="273"/>
                  </a:lnTo>
                  <a:lnTo>
                    <a:pt x="123" y="272"/>
                  </a:lnTo>
                  <a:lnTo>
                    <a:pt x="126" y="272"/>
                  </a:lnTo>
                  <a:lnTo>
                    <a:pt x="129" y="272"/>
                  </a:lnTo>
                  <a:lnTo>
                    <a:pt x="132" y="272"/>
                  </a:lnTo>
                  <a:lnTo>
                    <a:pt x="136" y="272"/>
                  </a:lnTo>
                  <a:lnTo>
                    <a:pt x="139" y="272"/>
                  </a:lnTo>
                  <a:lnTo>
                    <a:pt x="143" y="272"/>
                  </a:lnTo>
                  <a:lnTo>
                    <a:pt x="146" y="272"/>
                  </a:lnTo>
                  <a:lnTo>
                    <a:pt x="150" y="272"/>
                  </a:lnTo>
                  <a:lnTo>
                    <a:pt x="152" y="272"/>
                  </a:lnTo>
                  <a:lnTo>
                    <a:pt x="156" y="272"/>
                  </a:lnTo>
                  <a:lnTo>
                    <a:pt x="159" y="272"/>
                  </a:lnTo>
                  <a:lnTo>
                    <a:pt x="163" y="272"/>
                  </a:lnTo>
                  <a:lnTo>
                    <a:pt x="166" y="272"/>
                  </a:lnTo>
                  <a:lnTo>
                    <a:pt x="170" y="271"/>
                  </a:lnTo>
                  <a:lnTo>
                    <a:pt x="173" y="271"/>
                  </a:lnTo>
                  <a:lnTo>
                    <a:pt x="176" y="271"/>
                  </a:lnTo>
                  <a:lnTo>
                    <a:pt x="179" y="271"/>
                  </a:lnTo>
                  <a:lnTo>
                    <a:pt x="183" y="271"/>
                  </a:lnTo>
                  <a:lnTo>
                    <a:pt x="186" y="271"/>
                  </a:lnTo>
                  <a:lnTo>
                    <a:pt x="190" y="271"/>
                  </a:lnTo>
                  <a:lnTo>
                    <a:pt x="193" y="271"/>
                  </a:lnTo>
                  <a:lnTo>
                    <a:pt x="197" y="271"/>
                  </a:lnTo>
                  <a:lnTo>
                    <a:pt x="199" y="271"/>
                  </a:lnTo>
                  <a:lnTo>
                    <a:pt x="203" y="271"/>
                  </a:lnTo>
                  <a:lnTo>
                    <a:pt x="206" y="270"/>
                  </a:lnTo>
                  <a:lnTo>
                    <a:pt x="210" y="270"/>
                  </a:lnTo>
                  <a:lnTo>
                    <a:pt x="213" y="270"/>
                  </a:lnTo>
                  <a:lnTo>
                    <a:pt x="217" y="270"/>
                  </a:lnTo>
                  <a:lnTo>
                    <a:pt x="220" y="270"/>
                  </a:lnTo>
                  <a:lnTo>
                    <a:pt x="223" y="270"/>
                  </a:lnTo>
                  <a:lnTo>
                    <a:pt x="226" y="270"/>
                  </a:lnTo>
                  <a:lnTo>
                    <a:pt x="230" y="270"/>
                  </a:lnTo>
                  <a:lnTo>
                    <a:pt x="233" y="270"/>
                  </a:lnTo>
                  <a:lnTo>
                    <a:pt x="237" y="270"/>
                  </a:lnTo>
                  <a:lnTo>
                    <a:pt x="240" y="269"/>
                  </a:lnTo>
                  <a:lnTo>
                    <a:pt x="244" y="269"/>
                  </a:lnTo>
                  <a:lnTo>
                    <a:pt x="247" y="269"/>
                  </a:lnTo>
                  <a:lnTo>
                    <a:pt x="250" y="268"/>
                  </a:lnTo>
                  <a:lnTo>
                    <a:pt x="253" y="268"/>
                  </a:lnTo>
                  <a:lnTo>
                    <a:pt x="257" y="268"/>
                  </a:lnTo>
                  <a:lnTo>
                    <a:pt x="260" y="268"/>
                  </a:lnTo>
                  <a:lnTo>
                    <a:pt x="264" y="268"/>
                  </a:lnTo>
                  <a:lnTo>
                    <a:pt x="267" y="268"/>
                  </a:lnTo>
                  <a:lnTo>
                    <a:pt x="271" y="268"/>
                  </a:lnTo>
                  <a:lnTo>
                    <a:pt x="273" y="268"/>
                  </a:lnTo>
                  <a:lnTo>
                    <a:pt x="277" y="268"/>
                  </a:lnTo>
                  <a:lnTo>
                    <a:pt x="280" y="268"/>
                  </a:lnTo>
                  <a:lnTo>
                    <a:pt x="284" y="268"/>
                  </a:lnTo>
                  <a:lnTo>
                    <a:pt x="287" y="268"/>
                  </a:lnTo>
                  <a:lnTo>
                    <a:pt x="291" y="268"/>
                  </a:lnTo>
                  <a:lnTo>
                    <a:pt x="294" y="268"/>
                  </a:lnTo>
                  <a:lnTo>
                    <a:pt x="297" y="268"/>
                  </a:lnTo>
                  <a:lnTo>
                    <a:pt x="300" y="268"/>
                  </a:lnTo>
                  <a:lnTo>
                    <a:pt x="304" y="268"/>
                  </a:lnTo>
                  <a:lnTo>
                    <a:pt x="307" y="268"/>
                  </a:lnTo>
                  <a:lnTo>
                    <a:pt x="311" y="268"/>
                  </a:lnTo>
                  <a:lnTo>
                    <a:pt x="314" y="268"/>
                  </a:lnTo>
                  <a:lnTo>
                    <a:pt x="317" y="268"/>
                  </a:lnTo>
                  <a:lnTo>
                    <a:pt x="320" y="268"/>
                  </a:lnTo>
                  <a:lnTo>
                    <a:pt x="323" y="268"/>
                  </a:lnTo>
                  <a:lnTo>
                    <a:pt x="327" y="269"/>
                  </a:lnTo>
                  <a:lnTo>
                    <a:pt x="330" y="269"/>
                  </a:lnTo>
                  <a:lnTo>
                    <a:pt x="334" y="269"/>
                  </a:lnTo>
                  <a:lnTo>
                    <a:pt x="337" y="269"/>
                  </a:lnTo>
                  <a:lnTo>
                    <a:pt x="341" y="269"/>
                  </a:lnTo>
                  <a:lnTo>
                    <a:pt x="344" y="269"/>
                  </a:lnTo>
                  <a:lnTo>
                    <a:pt x="347" y="269"/>
                  </a:lnTo>
                  <a:lnTo>
                    <a:pt x="350" y="269"/>
                  </a:lnTo>
                  <a:lnTo>
                    <a:pt x="354" y="269"/>
                  </a:lnTo>
                  <a:lnTo>
                    <a:pt x="357" y="269"/>
                  </a:lnTo>
                  <a:lnTo>
                    <a:pt x="361" y="269"/>
                  </a:lnTo>
                  <a:lnTo>
                    <a:pt x="364" y="269"/>
                  </a:lnTo>
                  <a:lnTo>
                    <a:pt x="368" y="269"/>
                  </a:lnTo>
                  <a:lnTo>
                    <a:pt x="370" y="269"/>
                  </a:lnTo>
                  <a:lnTo>
                    <a:pt x="374" y="268"/>
                  </a:lnTo>
                  <a:lnTo>
                    <a:pt x="377" y="269"/>
                  </a:lnTo>
                  <a:lnTo>
                    <a:pt x="381" y="269"/>
                  </a:lnTo>
                  <a:lnTo>
                    <a:pt x="384" y="269"/>
                  </a:lnTo>
                  <a:lnTo>
                    <a:pt x="388" y="269"/>
                  </a:lnTo>
                  <a:lnTo>
                    <a:pt x="391" y="269"/>
                  </a:lnTo>
                  <a:lnTo>
                    <a:pt x="394" y="269"/>
                  </a:lnTo>
                  <a:lnTo>
                    <a:pt x="397" y="269"/>
                  </a:lnTo>
                  <a:lnTo>
                    <a:pt x="401" y="269"/>
                  </a:lnTo>
                  <a:lnTo>
                    <a:pt x="404" y="269"/>
                  </a:lnTo>
                  <a:lnTo>
                    <a:pt x="408" y="269"/>
                  </a:lnTo>
                  <a:lnTo>
                    <a:pt x="411" y="270"/>
                  </a:lnTo>
                  <a:lnTo>
                    <a:pt x="415" y="270"/>
                  </a:lnTo>
                  <a:lnTo>
                    <a:pt x="417" y="270"/>
                  </a:lnTo>
                  <a:lnTo>
                    <a:pt x="421" y="270"/>
                  </a:lnTo>
                  <a:lnTo>
                    <a:pt x="424" y="270"/>
                  </a:lnTo>
                  <a:lnTo>
                    <a:pt x="428" y="270"/>
                  </a:lnTo>
                  <a:lnTo>
                    <a:pt x="431" y="270"/>
                  </a:lnTo>
                  <a:lnTo>
                    <a:pt x="435" y="270"/>
                  </a:lnTo>
                  <a:lnTo>
                    <a:pt x="438" y="270"/>
                  </a:lnTo>
                  <a:lnTo>
                    <a:pt x="441" y="270"/>
                  </a:lnTo>
                  <a:lnTo>
                    <a:pt x="444" y="270"/>
                  </a:lnTo>
                  <a:lnTo>
                    <a:pt x="448" y="270"/>
                  </a:lnTo>
                  <a:lnTo>
                    <a:pt x="451" y="270"/>
                  </a:lnTo>
                  <a:lnTo>
                    <a:pt x="455" y="270"/>
                  </a:lnTo>
                  <a:lnTo>
                    <a:pt x="458" y="270"/>
                  </a:lnTo>
                  <a:lnTo>
                    <a:pt x="462" y="270"/>
                  </a:lnTo>
                  <a:lnTo>
                    <a:pt x="465" y="270"/>
                  </a:lnTo>
                  <a:lnTo>
                    <a:pt x="468" y="270"/>
                  </a:lnTo>
                  <a:lnTo>
                    <a:pt x="471" y="270"/>
                  </a:lnTo>
                  <a:lnTo>
                    <a:pt x="475" y="270"/>
                  </a:lnTo>
                  <a:lnTo>
                    <a:pt x="478" y="270"/>
                  </a:lnTo>
                  <a:lnTo>
                    <a:pt x="482" y="270"/>
                  </a:lnTo>
                  <a:lnTo>
                    <a:pt x="485" y="270"/>
                  </a:lnTo>
                  <a:lnTo>
                    <a:pt x="489" y="271"/>
                  </a:lnTo>
                  <a:lnTo>
                    <a:pt x="491" y="271"/>
                  </a:lnTo>
                  <a:lnTo>
                    <a:pt x="495" y="271"/>
                  </a:lnTo>
                  <a:lnTo>
                    <a:pt x="498" y="271"/>
                  </a:lnTo>
                  <a:lnTo>
                    <a:pt x="502" y="271"/>
                  </a:lnTo>
                  <a:lnTo>
                    <a:pt x="505" y="271"/>
                  </a:lnTo>
                  <a:lnTo>
                    <a:pt x="509" y="271"/>
                  </a:lnTo>
                  <a:lnTo>
                    <a:pt x="512" y="271"/>
                  </a:lnTo>
                  <a:lnTo>
                    <a:pt x="515" y="272"/>
                  </a:lnTo>
                  <a:lnTo>
                    <a:pt x="518" y="271"/>
                  </a:lnTo>
                  <a:lnTo>
                    <a:pt x="522" y="271"/>
                  </a:lnTo>
                  <a:lnTo>
                    <a:pt x="525" y="272"/>
                  </a:lnTo>
                  <a:lnTo>
                    <a:pt x="529" y="272"/>
                  </a:lnTo>
                  <a:lnTo>
                    <a:pt x="532" y="272"/>
                  </a:lnTo>
                  <a:lnTo>
                    <a:pt x="536" y="272"/>
                  </a:lnTo>
                  <a:lnTo>
                    <a:pt x="538" y="272"/>
                  </a:lnTo>
                  <a:lnTo>
                    <a:pt x="542" y="272"/>
                  </a:lnTo>
                  <a:lnTo>
                    <a:pt x="545" y="272"/>
                  </a:lnTo>
                  <a:lnTo>
                    <a:pt x="549" y="272"/>
                  </a:lnTo>
                  <a:lnTo>
                    <a:pt x="552" y="272"/>
                  </a:lnTo>
                  <a:lnTo>
                    <a:pt x="556" y="272"/>
                  </a:lnTo>
                  <a:lnTo>
                    <a:pt x="559" y="272"/>
                  </a:lnTo>
                  <a:lnTo>
                    <a:pt x="563" y="272"/>
                  </a:lnTo>
                  <a:lnTo>
                    <a:pt x="565" y="272"/>
                  </a:lnTo>
                  <a:lnTo>
                    <a:pt x="569" y="272"/>
                  </a:lnTo>
                  <a:lnTo>
                    <a:pt x="572" y="272"/>
                  </a:lnTo>
                  <a:lnTo>
                    <a:pt x="576" y="272"/>
                  </a:lnTo>
                  <a:lnTo>
                    <a:pt x="579" y="272"/>
                  </a:lnTo>
                  <a:lnTo>
                    <a:pt x="583" y="272"/>
                  </a:lnTo>
                  <a:lnTo>
                    <a:pt x="586" y="272"/>
                  </a:lnTo>
                  <a:lnTo>
                    <a:pt x="589" y="273"/>
                  </a:lnTo>
                  <a:lnTo>
                    <a:pt x="592" y="273"/>
                  </a:lnTo>
                  <a:lnTo>
                    <a:pt x="596" y="273"/>
                  </a:lnTo>
                  <a:lnTo>
                    <a:pt x="599" y="273"/>
                  </a:lnTo>
                  <a:lnTo>
                    <a:pt x="603" y="273"/>
                  </a:lnTo>
                  <a:lnTo>
                    <a:pt x="606" y="273"/>
                  </a:lnTo>
                  <a:lnTo>
                    <a:pt x="610" y="273"/>
                  </a:lnTo>
                  <a:lnTo>
                    <a:pt x="612" y="273"/>
                  </a:lnTo>
                  <a:lnTo>
                    <a:pt x="616" y="273"/>
                  </a:lnTo>
                  <a:lnTo>
                    <a:pt x="619" y="273"/>
                  </a:lnTo>
                  <a:lnTo>
                    <a:pt x="623" y="273"/>
                  </a:lnTo>
                  <a:lnTo>
                    <a:pt x="626" y="273"/>
                  </a:lnTo>
                  <a:lnTo>
                    <a:pt x="630" y="273"/>
                  </a:lnTo>
                  <a:lnTo>
                    <a:pt x="633" y="273"/>
                  </a:lnTo>
                  <a:lnTo>
                    <a:pt x="636" y="273"/>
                  </a:lnTo>
                  <a:lnTo>
                    <a:pt x="639" y="273"/>
                  </a:lnTo>
                  <a:lnTo>
                    <a:pt x="643" y="273"/>
                  </a:lnTo>
                  <a:lnTo>
                    <a:pt x="646" y="273"/>
                  </a:lnTo>
                  <a:lnTo>
                    <a:pt x="650" y="274"/>
                  </a:lnTo>
                  <a:lnTo>
                    <a:pt x="653" y="274"/>
                  </a:lnTo>
                  <a:lnTo>
                    <a:pt x="657" y="274"/>
                  </a:lnTo>
                  <a:lnTo>
                    <a:pt x="659" y="274"/>
                  </a:lnTo>
                  <a:lnTo>
                    <a:pt x="663" y="274"/>
                  </a:lnTo>
                  <a:lnTo>
                    <a:pt x="666" y="274"/>
                  </a:lnTo>
                  <a:lnTo>
                    <a:pt x="670" y="274"/>
                  </a:lnTo>
                  <a:lnTo>
                    <a:pt x="673" y="274"/>
                  </a:lnTo>
                  <a:lnTo>
                    <a:pt x="677" y="274"/>
                  </a:lnTo>
                  <a:lnTo>
                    <a:pt x="680" y="274"/>
                  </a:lnTo>
                  <a:lnTo>
                    <a:pt x="684" y="274"/>
                  </a:lnTo>
                  <a:lnTo>
                    <a:pt x="686" y="274"/>
                  </a:lnTo>
                  <a:lnTo>
                    <a:pt x="690" y="274"/>
                  </a:lnTo>
                  <a:lnTo>
                    <a:pt x="693" y="274"/>
                  </a:lnTo>
                  <a:lnTo>
                    <a:pt x="697" y="274"/>
                  </a:lnTo>
                  <a:lnTo>
                    <a:pt x="700" y="274"/>
                  </a:lnTo>
                  <a:lnTo>
                    <a:pt x="704" y="274"/>
                  </a:lnTo>
                  <a:lnTo>
                    <a:pt x="707" y="274"/>
                  </a:lnTo>
                  <a:lnTo>
                    <a:pt x="710" y="274"/>
                  </a:lnTo>
                  <a:lnTo>
                    <a:pt x="713" y="274"/>
                  </a:lnTo>
                  <a:lnTo>
                    <a:pt x="717" y="274"/>
                  </a:lnTo>
                  <a:lnTo>
                    <a:pt x="720" y="274"/>
                  </a:lnTo>
                  <a:lnTo>
                    <a:pt x="724" y="274"/>
                  </a:lnTo>
                  <a:lnTo>
                    <a:pt x="727" y="274"/>
                  </a:lnTo>
                  <a:lnTo>
                    <a:pt x="731" y="274"/>
                  </a:lnTo>
                  <a:lnTo>
                    <a:pt x="733" y="274"/>
                  </a:lnTo>
                  <a:lnTo>
                    <a:pt x="737" y="273"/>
                  </a:lnTo>
                  <a:lnTo>
                    <a:pt x="740" y="272"/>
                  </a:lnTo>
                  <a:lnTo>
                    <a:pt x="744" y="271"/>
                  </a:lnTo>
                  <a:lnTo>
                    <a:pt x="747" y="270"/>
                  </a:lnTo>
                  <a:lnTo>
                    <a:pt x="751" y="270"/>
                  </a:lnTo>
                  <a:lnTo>
                    <a:pt x="754" y="269"/>
                  </a:lnTo>
                  <a:lnTo>
                    <a:pt x="757" y="269"/>
                  </a:lnTo>
                  <a:lnTo>
                    <a:pt x="760" y="269"/>
                  </a:lnTo>
                  <a:lnTo>
                    <a:pt x="764" y="270"/>
                  </a:lnTo>
                  <a:lnTo>
                    <a:pt x="767" y="270"/>
                  </a:lnTo>
                  <a:lnTo>
                    <a:pt x="771" y="271"/>
                  </a:lnTo>
                  <a:lnTo>
                    <a:pt x="774" y="271"/>
                  </a:lnTo>
                  <a:lnTo>
                    <a:pt x="778" y="271"/>
                  </a:lnTo>
                  <a:lnTo>
                    <a:pt x="780" y="272"/>
                  </a:lnTo>
                  <a:lnTo>
                    <a:pt x="784" y="272"/>
                  </a:lnTo>
                  <a:lnTo>
                    <a:pt x="787" y="273"/>
                  </a:lnTo>
                  <a:lnTo>
                    <a:pt x="791" y="273"/>
                  </a:lnTo>
                  <a:lnTo>
                    <a:pt x="794" y="273"/>
                  </a:lnTo>
                  <a:lnTo>
                    <a:pt x="798" y="273"/>
                  </a:lnTo>
                  <a:lnTo>
                    <a:pt x="801" y="274"/>
                  </a:lnTo>
                  <a:lnTo>
                    <a:pt x="805" y="274"/>
                  </a:lnTo>
                  <a:lnTo>
                    <a:pt x="807" y="274"/>
                  </a:lnTo>
                  <a:lnTo>
                    <a:pt x="811" y="274"/>
                  </a:lnTo>
                  <a:lnTo>
                    <a:pt x="814" y="274"/>
                  </a:lnTo>
                  <a:lnTo>
                    <a:pt x="818" y="274"/>
                  </a:lnTo>
                  <a:lnTo>
                    <a:pt x="821" y="274"/>
                  </a:lnTo>
                  <a:lnTo>
                    <a:pt x="825" y="274"/>
                  </a:lnTo>
                  <a:lnTo>
                    <a:pt x="828" y="274"/>
                  </a:lnTo>
                  <a:lnTo>
                    <a:pt x="831" y="274"/>
                  </a:lnTo>
                  <a:lnTo>
                    <a:pt x="834" y="274"/>
                  </a:lnTo>
                  <a:lnTo>
                    <a:pt x="838" y="274"/>
                  </a:lnTo>
                  <a:lnTo>
                    <a:pt x="841" y="274"/>
                  </a:lnTo>
                  <a:lnTo>
                    <a:pt x="845" y="275"/>
                  </a:lnTo>
                  <a:lnTo>
                    <a:pt x="848" y="274"/>
                  </a:lnTo>
                  <a:lnTo>
                    <a:pt x="852" y="275"/>
                  </a:lnTo>
                  <a:lnTo>
                    <a:pt x="854" y="275"/>
                  </a:lnTo>
                  <a:lnTo>
                    <a:pt x="858" y="275"/>
                  </a:lnTo>
                  <a:lnTo>
                    <a:pt x="861" y="275"/>
                  </a:lnTo>
                  <a:lnTo>
                    <a:pt x="865" y="275"/>
                  </a:lnTo>
                  <a:lnTo>
                    <a:pt x="868" y="275"/>
                  </a:lnTo>
                  <a:lnTo>
                    <a:pt x="872" y="275"/>
                  </a:lnTo>
                  <a:lnTo>
                    <a:pt x="875" y="275"/>
                  </a:lnTo>
                  <a:lnTo>
                    <a:pt x="878" y="275"/>
                  </a:lnTo>
                  <a:lnTo>
                    <a:pt x="881" y="275"/>
                  </a:lnTo>
                  <a:lnTo>
                    <a:pt x="885" y="275"/>
                  </a:lnTo>
                  <a:lnTo>
                    <a:pt x="888" y="275"/>
                  </a:lnTo>
                  <a:lnTo>
                    <a:pt x="892" y="275"/>
                  </a:lnTo>
                  <a:lnTo>
                    <a:pt x="895" y="275"/>
                  </a:lnTo>
                  <a:lnTo>
                    <a:pt x="899" y="275"/>
                  </a:lnTo>
                  <a:lnTo>
                    <a:pt x="902" y="275"/>
                  </a:lnTo>
                  <a:lnTo>
                    <a:pt x="905" y="275"/>
                  </a:lnTo>
                  <a:lnTo>
                    <a:pt x="908" y="275"/>
                  </a:lnTo>
                  <a:lnTo>
                    <a:pt x="912" y="275"/>
                  </a:lnTo>
                  <a:lnTo>
                    <a:pt x="915" y="276"/>
                  </a:lnTo>
                  <a:lnTo>
                    <a:pt x="919" y="276"/>
                  </a:lnTo>
                  <a:lnTo>
                    <a:pt x="922" y="276"/>
                  </a:lnTo>
                  <a:lnTo>
                    <a:pt x="926" y="276"/>
                  </a:lnTo>
                  <a:lnTo>
                    <a:pt x="928" y="276"/>
                  </a:lnTo>
                  <a:lnTo>
                    <a:pt x="932" y="276"/>
                  </a:lnTo>
                  <a:lnTo>
                    <a:pt x="935" y="276"/>
                  </a:lnTo>
                  <a:lnTo>
                    <a:pt x="939" y="276"/>
                  </a:lnTo>
                  <a:lnTo>
                    <a:pt x="942" y="275"/>
                  </a:lnTo>
                  <a:lnTo>
                    <a:pt x="945" y="276"/>
                  </a:lnTo>
                  <a:lnTo>
                    <a:pt x="949" y="275"/>
                  </a:lnTo>
                  <a:lnTo>
                    <a:pt x="951" y="275"/>
                  </a:lnTo>
                  <a:lnTo>
                    <a:pt x="955" y="275"/>
                  </a:lnTo>
                  <a:lnTo>
                    <a:pt x="958" y="275"/>
                  </a:lnTo>
                  <a:lnTo>
                    <a:pt x="962" y="275"/>
                  </a:lnTo>
                  <a:lnTo>
                    <a:pt x="965" y="275"/>
                  </a:lnTo>
                  <a:lnTo>
                    <a:pt x="969" y="275"/>
                  </a:lnTo>
                  <a:lnTo>
                    <a:pt x="972" y="275"/>
                  </a:lnTo>
                  <a:lnTo>
                    <a:pt x="975" y="275"/>
                  </a:lnTo>
                  <a:lnTo>
                    <a:pt x="978" y="275"/>
                  </a:lnTo>
                  <a:lnTo>
                    <a:pt x="982" y="275"/>
                  </a:lnTo>
                  <a:lnTo>
                    <a:pt x="985" y="275"/>
                  </a:lnTo>
                  <a:lnTo>
                    <a:pt x="989" y="275"/>
                  </a:lnTo>
                  <a:lnTo>
                    <a:pt x="992" y="275"/>
                  </a:lnTo>
                  <a:lnTo>
                    <a:pt x="996" y="275"/>
                  </a:lnTo>
                  <a:lnTo>
                    <a:pt x="998" y="274"/>
                  </a:lnTo>
                  <a:lnTo>
                    <a:pt x="1002" y="274"/>
                  </a:lnTo>
                  <a:lnTo>
                    <a:pt x="1005" y="274"/>
                  </a:lnTo>
                  <a:lnTo>
                    <a:pt x="1009" y="274"/>
                  </a:lnTo>
                  <a:lnTo>
                    <a:pt x="1012" y="274"/>
                  </a:lnTo>
                  <a:lnTo>
                    <a:pt x="1016" y="273"/>
                  </a:lnTo>
                  <a:lnTo>
                    <a:pt x="1019" y="273"/>
                  </a:lnTo>
                  <a:lnTo>
                    <a:pt x="1023" y="273"/>
                  </a:lnTo>
                  <a:lnTo>
                    <a:pt x="1025" y="273"/>
                  </a:lnTo>
                  <a:lnTo>
                    <a:pt x="1029" y="273"/>
                  </a:lnTo>
                  <a:lnTo>
                    <a:pt x="1032" y="273"/>
                  </a:lnTo>
                  <a:lnTo>
                    <a:pt x="1036" y="272"/>
                  </a:lnTo>
                  <a:lnTo>
                    <a:pt x="1039" y="272"/>
                  </a:lnTo>
                  <a:lnTo>
                    <a:pt x="1043" y="272"/>
                  </a:lnTo>
                  <a:lnTo>
                    <a:pt x="1046" y="272"/>
                  </a:lnTo>
                  <a:lnTo>
                    <a:pt x="1049" y="272"/>
                  </a:lnTo>
                  <a:lnTo>
                    <a:pt x="1052" y="272"/>
                  </a:lnTo>
                  <a:lnTo>
                    <a:pt x="1056" y="272"/>
                  </a:lnTo>
                  <a:lnTo>
                    <a:pt x="1059" y="272"/>
                  </a:lnTo>
                  <a:lnTo>
                    <a:pt x="1063" y="272"/>
                  </a:lnTo>
                  <a:lnTo>
                    <a:pt x="1066" y="271"/>
                  </a:lnTo>
                  <a:lnTo>
                    <a:pt x="1070" y="271"/>
                  </a:lnTo>
                  <a:lnTo>
                    <a:pt x="1072" y="271"/>
                  </a:lnTo>
                  <a:lnTo>
                    <a:pt x="1076" y="271"/>
                  </a:lnTo>
                  <a:lnTo>
                    <a:pt x="1079" y="271"/>
                  </a:lnTo>
                  <a:lnTo>
                    <a:pt x="1083" y="271"/>
                  </a:lnTo>
                  <a:lnTo>
                    <a:pt x="1086" y="271"/>
                  </a:lnTo>
                  <a:lnTo>
                    <a:pt x="1090" y="271"/>
                  </a:lnTo>
                  <a:lnTo>
                    <a:pt x="1093" y="271"/>
                  </a:lnTo>
                  <a:lnTo>
                    <a:pt x="1096" y="271"/>
                  </a:lnTo>
                  <a:lnTo>
                    <a:pt x="1099" y="271"/>
                  </a:lnTo>
                  <a:lnTo>
                    <a:pt x="1103" y="271"/>
                  </a:lnTo>
                  <a:lnTo>
                    <a:pt x="1106" y="271"/>
                  </a:lnTo>
                  <a:lnTo>
                    <a:pt x="1110" y="272"/>
                  </a:lnTo>
                  <a:lnTo>
                    <a:pt x="1113" y="272"/>
                  </a:lnTo>
                  <a:lnTo>
                    <a:pt x="1117" y="272"/>
                  </a:lnTo>
                  <a:lnTo>
                    <a:pt x="1120" y="272"/>
                  </a:lnTo>
                  <a:lnTo>
                    <a:pt x="1123" y="272"/>
                  </a:lnTo>
                  <a:lnTo>
                    <a:pt x="1126" y="272"/>
                  </a:lnTo>
                  <a:lnTo>
                    <a:pt x="1130" y="272"/>
                  </a:lnTo>
                  <a:lnTo>
                    <a:pt x="1133" y="272"/>
                  </a:lnTo>
                  <a:lnTo>
                    <a:pt x="1137" y="272"/>
                  </a:lnTo>
                  <a:lnTo>
                    <a:pt x="1140" y="272"/>
                  </a:lnTo>
                  <a:lnTo>
                    <a:pt x="1144" y="272"/>
                  </a:lnTo>
                  <a:lnTo>
                    <a:pt x="1146" y="272"/>
                  </a:lnTo>
                  <a:lnTo>
                    <a:pt x="1150" y="272"/>
                  </a:lnTo>
                  <a:lnTo>
                    <a:pt x="1153" y="272"/>
                  </a:lnTo>
                  <a:lnTo>
                    <a:pt x="1157" y="272"/>
                  </a:lnTo>
                  <a:lnTo>
                    <a:pt x="1160" y="272"/>
                  </a:lnTo>
                  <a:lnTo>
                    <a:pt x="1164" y="272"/>
                  </a:lnTo>
                  <a:lnTo>
                    <a:pt x="1167" y="272"/>
                  </a:lnTo>
                  <a:lnTo>
                    <a:pt x="1170" y="272"/>
                  </a:lnTo>
                  <a:lnTo>
                    <a:pt x="1173" y="272"/>
                  </a:lnTo>
                  <a:lnTo>
                    <a:pt x="1177" y="272"/>
                  </a:lnTo>
                  <a:lnTo>
                    <a:pt x="1180" y="272"/>
                  </a:lnTo>
                  <a:lnTo>
                    <a:pt x="1184" y="272"/>
                  </a:lnTo>
                  <a:lnTo>
                    <a:pt x="1187" y="272"/>
                  </a:lnTo>
                  <a:lnTo>
                    <a:pt x="1191" y="272"/>
                  </a:lnTo>
                  <a:lnTo>
                    <a:pt x="1193" y="272"/>
                  </a:lnTo>
                  <a:lnTo>
                    <a:pt x="1197" y="272"/>
                  </a:lnTo>
                  <a:lnTo>
                    <a:pt x="1200" y="272"/>
                  </a:lnTo>
                  <a:lnTo>
                    <a:pt x="1204" y="272"/>
                  </a:lnTo>
                  <a:lnTo>
                    <a:pt x="1207" y="271"/>
                  </a:lnTo>
                  <a:lnTo>
                    <a:pt x="1211" y="272"/>
                  </a:lnTo>
                  <a:lnTo>
                    <a:pt x="1214" y="271"/>
                  </a:lnTo>
                  <a:lnTo>
                    <a:pt x="1217" y="272"/>
                  </a:lnTo>
                  <a:lnTo>
                    <a:pt x="1220" y="272"/>
                  </a:lnTo>
                  <a:lnTo>
                    <a:pt x="1224" y="272"/>
                  </a:lnTo>
                  <a:lnTo>
                    <a:pt x="1227" y="272"/>
                  </a:lnTo>
                  <a:lnTo>
                    <a:pt x="1231" y="272"/>
                  </a:lnTo>
                  <a:lnTo>
                    <a:pt x="1234" y="273"/>
                  </a:lnTo>
                  <a:lnTo>
                    <a:pt x="1238" y="273"/>
                  </a:lnTo>
                  <a:lnTo>
                    <a:pt x="1241" y="273"/>
                  </a:lnTo>
                  <a:lnTo>
                    <a:pt x="1244" y="274"/>
                  </a:lnTo>
                  <a:lnTo>
                    <a:pt x="1247" y="274"/>
                  </a:lnTo>
                  <a:lnTo>
                    <a:pt x="1251" y="274"/>
                  </a:lnTo>
                  <a:lnTo>
                    <a:pt x="1254" y="275"/>
                  </a:lnTo>
                  <a:lnTo>
                    <a:pt x="1258" y="275"/>
                  </a:lnTo>
                  <a:lnTo>
                    <a:pt x="1261" y="275"/>
                  </a:lnTo>
                  <a:lnTo>
                    <a:pt x="1265" y="275"/>
                  </a:lnTo>
                  <a:lnTo>
                    <a:pt x="1267" y="275"/>
                  </a:lnTo>
                  <a:lnTo>
                    <a:pt x="1271" y="275"/>
                  </a:lnTo>
                  <a:lnTo>
                    <a:pt x="1274" y="276"/>
                  </a:lnTo>
                  <a:lnTo>
                    <a:pt x="1278" y="275"/>
                  </a:lnTo>
                  <a:lnTo>
                    <a:pt x="1281" y="275"/>
                  </a:lnTo>
                  <a:lnTo>
                    <a:pt x="1285" y="276"/>
                  </a:lnTo>
                  <a:lnTo>
                    <a:pt x="1288" y="276"/>
                  </a:lnTo>
                  <a:lnTo>
                    <a:pt x="1291" y="276"/>
                  </a:lnTo>
                  <a:lnTo>
                    <a:pt x="1294" y="275"/>
                  </a:lnTo>
                  <a:lnTo>
                    <a:pt x="1298" y="275"/>
                  </a:lnTo>
                  <a:lnTo>
                    <a:pt x="1301" y="275"/>
                  </a:lnTo>
                  <a:lnTo>
                    <a:pt x="1305" y="275"/>
                  </a:lnTo>
                  <a:lnTo>
                    <a:pt x="1308" y="275"/>
                  </a:lnTo>
                  <a:lnTo>
                    <a:pt x="1312" y="275"/>
                  </a:lnTo>
                  <a:lnTo>
                    <a:pt x="1314" y="275"/>
                  </a:lnTo>
                  <a:lnTo>
                    <a:pt x="1318" y="275"/>
                  </a:lnTo>
                  <a:lnTo>
                    <a:pt x="1321" y="274"/>
                  </a:lnTo>
                  <a:lnTo>
                    <a:pt x="1325" y="274"/>
                  </a:lnTo>
                  <a:lnTo>
                    <a:pt x="1328" y="274"/>
                  </a:lnTo>
                  <a:lnTo>
                    <a:pt x="1332" y="274"/>
                  </a:lnTo>
                  <a:lnTo>
                    <a:pt x="1335" y="274"/>
                  </a:lnTo>
                  <a:lnTo>
                    <a:pt x="1338" y="274"/>
                  </a:lnTo>
                  <a:lnTo>
                    <a:pt x="1341" y="274"/>
                  </a:lnTo>
                  <a:lnTo>
                    <a:pt x="1345" y="275"/>
                  </a:lnTo>
                  <a:lnTo>
                    <a:pt x="1348" y="275"/>
                  </a:lnTo>
                  <a:lnTo>
                    <a:pt x="1352" y="275"/>
                  </a:lnTo>
                  <a:lnTo>
                    <a:pt x="1355" y="275"/>
                  </a:lnTo>
                  <a:lnTo>
                    <a:pt x="1359" y="275"/>
                  </a:lnTo>
                  <a:lnTo>
                    <a:pt x="1362" y="275"/>
                  </a:lnTo>
                  <a:lnTo>
                    <a:pt x="1365" y="275"/>
                  </a:lnTo>
                  <a:lnTo>
                    <a:pt x="1368" y="275"/>
                  </a:lnTo>
                  <a:lnTo>
                    <a:pt x="1372" y="275"/>
                  </a:lnTo>
                  <a:lnTo>
                    <a:pt x="1375" y="275"/>
                  </a:lnTo>
                  <a:lnTo>
                    <a:pt x="1379" y="275"/>
                  </a:lnTo>
                  <a:lnTo>
                    <a:pt x="1382" y="275"/>
                  </a:lnTo>
                  <a:lnTo>
                    <a:pt x="1386" y="275"/>
                  </a:lnTo>
                  <a:lnTo>
                    <a:pt x="1388" y="275"/>
                  </a:lnTo>
                  <a:lnTo>
                    <a:pt x="1392" y="275"/>
                  </a:lnTo>
                  <a:lnTo>
                    <a:pt x="1395" y="275"/>
                  </a:lnTo>
                  <a:lnTo>
                    <a:pt x="1399" y="275"/>
                  </a:lnTo>
                  <a:lnTo>
                    <a:pt x="1402" y="275"/>
                  </a:lnTo>
                  <a:lnTo>
                    <a:pt x="1406" y="275"/>
                  </a:lnTo>
                  <a:lnTo>
                    <a:pt x="1409" y="275"/>
                  </a:lnTo>
                  <a:lnTo>
                    <a:pt x="1412" y="275"/>
                  </a:lnTo>
                  <a:lnTo>
                    <a:pt x="1415" y="275"/>
                  </a:lnTo>
                  <a:lnTo>
                    <a:pt x="1419" y="275"/>
                  </a:lnTo>
                  <a:lnTo>
                    <a:pt x="1422" y="275"/>
                  </a:lnTo>
                  <a:lnTo>
                    <a:pt x="1426" y="275"/>
                  </a:lnTo>
                  <a:lnTo>
                    <a:pt x="1429" y="275"/>
                  </a:lnTo>
                  <a:lnTo>
                    <a:pt x="1433" y="275"/>
                  </a:lnTo>
                  <a:lnTo>
                    <a:pt x="1435" y="274"/>
                  </a:lnTo>
                  <a:lnTo>
                    <a:pt x="1439" y="274"/>
                  </a:lnTo>
                  <a:lnTo>
                    <a:pt x="1442" y="273"/>
                  </a:lnTo>
                  <a:lnTo>
                    <a:pt x="1446" y="273"/>
                  </a:lnTo>
                  <a:lnTo>
                    <a:pt x="1449" y="272"/>
                  </a:lnTo>
                  <a:lnTo>
                    <a:pt x="1453" y="272"/>
                  </a:lnTo>
                  <a:lnTo>
                    <a:pt x="1456" y="271"/>
                  </a:lnTo>
                  <a:lnTo>
                    <a:pt x="1459" y="271"/>
                  </a:lnTo>
                  <a:lnTo>
                    <a:pt x="1462" y="271"/>
                  </a:lnTo>
                  <a:lnTo>
                    <a:pt x="1466" y="271"/>
                  </a:lnTo>
                  <a:lnTo>
                    <a:pt x="1469" y="272"/>
                  </a:lnTo>
                  <a:lnTo>
                    <a:pt x="1473" y="272"/>
                  </a:lnTo>
                  <a:lnTo>
                    <a:pt x="1476" y="272"/>
                  </a:lnTo>
                  <a:lnTo>
                    <a:pt x="1480" y="273"/>
                  </a:lnTo>
                  <a:lnTo>
                    <a:pt x="1483" y="273"/>
                  </a:lnTo>
                  <a:lnTo>
                    <a:pt x="1486" y="273"/>
                  </a:lnTo>
                  <a:lnTo>
                    <a:pt x="1489" y="274"/>
                  </a:lnTo>
                  <a:lnTo>
                    <a:pt x="1493" y="274"/>
                  </a:lnTo>
                  <a:lnTo>
                    <a:pt x="1496" y="274"/>
                  </a:lnTo>
                  <a:lnTo>
                    <a:pt x="1500" y="274"/>
                  </a:lnTo>
                  <a:lnTo>
                    <a:pt x="1503" y="274"/>
                  </a:lnTo>
                  <a:lnTo>
                    <a:pt x="1507" y="274"/>
                  </a:lnTo>
                  <a:lnTo>
                    <a:pt x="1509" y="274"/>
                  </a:lnTo>
                  <a:lnTo>
                    <a:pt x="1513" y="275"/>
                  </a:lnTo>
                  <a:lnTo>
                    <a:pt x="1516" y="275"/>
                  </a:lnTo>
                  <a:lnTo>
                    <a:pt x="1520" y="275"/>
                  </a:lnTo>
                  <a:lnTo>
                    <a:pt x="1523" y="274"/>
                  </a:lnTo>
                  <a:lnTo>
                    <a:pt x="1527" y="275"/>
                  </a:lnTo>
                  <a:lnTo>
                    <a:pt x="1530" y="274"/>
                  </a:lnTo>
                  <a:lnTo>
                    <a:pt x="1533" y="274"/>
                  </a:lnTo>
                  <a:lnTo>
                    <a:pt x="1536" y="274"/>
                  </a:lnTo>
                  <a:lnTo>
                    <a:pt x="1540" y="274"/>
                  </a:lnTo>
                  <a:lnTo>
                    <a:pt x="1543" y="274"/>
                  </a:lnTo>
                  <a:lnTo>
                    <a:pt x="1547" y="274"/>
                  </a:lnTo>
                  <a:lnTo>
                    <a:pt x="1550" y="274"/>
                  </a:lnTo>
                  <a:lnTo>
                    <a:pt x="1554" y="274"/>
                  </a:lnTo>
                  <a:lnTo>
                    <a:pt x="1556" y="274"/>
                  </a:lnTo>
                  <a:lnTo>
                    <a:pt x="1560" y="274"/>
                  </a:lnTo>
                  <a:lnTo>
                    <a:pt x="1563" y="274"/>
                  </a:lnTo>
                  <a:lnTo>
                    <a:pt x="1567" y="274"/>
                  </a:lnTo>
                  <a:lnTo>
                    <a:pt x="1570" y="274"/>
                  </a:lnTo>
                  <a:lnTo>
                    <a:pt x="1574" y="274"/>
                  </a:lnTo>
                  <a:lnTo>
                    <a:pt x="1577" y="274"/>
                  </a:lnTo>
                  <a:lnTo>
                    <a:pt x="1580" y="274"/>
                  </a:lnTo>
                  <a:lnTo>
                    <a:pt x="1583" y="274"/>
                  </a:lnTo>
                  <a:lnTo>
                    <a:pt x="1586" y="274"/>
                  </a:lnTo>
                  <a:lnTo>
                    <a:pt x="1590" y="274"/>
                  </a:lnTo>
                  <a:lnTo>
                    <a:pt x="1593" y="274"/>
                  </a:lnTo>
                  <a:lnTo>
                    <a:pt x="1597" y="273"/>
                  </a:lnTo>
                  <a:lnTo>
                    <a:pt x="1600" y="274"/>
                  </a:lnTo>
                  <a:lnTo>
                    <a:pt x="1604" y="273"/>
                  </a:lnTo>
                  <a:lnTo>
                    <a:pt x="1606" y="273"/>
                  </a:lnTo>
                  <a:lnTo>
                    <a:pt x="1610" y="273"/>
                  </a:lnTo>
                  <a:lnTo>
                    <a:pt x="1613" y="273"/>
                  </a:lnTo>
                  <a:lnTo>
                    <a:pt x="1617" y="273"/>
                  </a:lnTo>
                  <a:lnTo>
                    <a:pt x="1620" y="273"/>
                  </a:lnTo>
                  <a:lnTo>
                    <a:pt x="1624" y="273"/>
                  </a:lnTo>
                  <a:lnTo>
                    <a:pt x="1627" y="273"/>
                  </a:lnTo>
                  <a:lnTo>
                    <a:pt x="1630" y="273"/>
                  </a:lnTo>
                  <a:lnTo>
                    <a:pt x="1633" y="273"/>
                  </a:lnTo>
                  <a:lnTo>
                    <a:pt x="1637" y="273"/>
                  </a:lnTo>
                  <a:lnTo>
                    <a:pt x="1640" y="272"/>
                  </a:lnTo>
                  <a:lnTo>
                    <a:pt x="1644" y="272"/>
                  </a:lnTo>
                  <a:lnTo>
                    <a:pt x="1647" y="272"/>
                  </a:lnTo>
                  <a:lnTo>
                    <a:pt x="1651" y="272"/>
                  </a:lnTo>
                  <a:lnTo>
                    <a:pt x="1653" y="272"/>
                  </a:lnTo>
                  <a:lnTo>
                    <a:pt x="1657" y="271"/>
                  </a:lnTo>
                  <a:lnTo>
                    <a:pt x="1660" y="271"/>
                  </a:lnTo>
                  <a:lnTo>
                    <a:pt x="1664" y="271"/>
                  </a:lnTo>
                  <a:lnTo>
                    <a:pt x="1667" y="271"/>
                  </a:lnTo>
                  <a:lnTo>
                    <a:pt x="1671" y="271"/>
                  </a:lnTo>
                  <a:lnTo>
                    <a:pt x="1674" y="271"/>
                  </a:lnTo>
                  <a:lnTo>
                    <a:pt x="1677" y="271"/>
                  </a:lnTo>
                  <a:lnTo>
                    <a:pt x="1680" y="271"/>
                  </a:lnTo>
                  <a:lnTo>
                    <a:pt x="1684" y="271"/>
                  </a:lnTo>
                  <a:lnTo>
                    <a:pt x="1687" y="271"/>
                  </a:lnTo>
                  <a:lnTo>
                    <a:pt x="1691" y="271"/>
                  </a:lnTo>
                  <a:lnTo>
                    <a:pt x="1694" y="271"/>
                  </a:lnTo>
                  <a:lnTo>
                    <a:pt x="1698" y="271"/>
                  </a:lnTo>
                  <a:lnTo>
                    <a:pt x="1701" y="272"/>
                  </a:lnTo>
                  <a:lnTo>
                    <a:pt x="1704" y="272"/>
                  </a:lnTo>
                  <a:lnTo>
                    <a:pt x="1707" y="272"/>
                  </a:lnTo>
                  <a:lnTo>
                    <a:pt x="1711" y="272"/>
                  </a:lnTo>
                  <a:lnTo>
                    <a:pt x="1714" y="271"/>
                  </a:lnTo>
                  <a:lnTo>
                    <a:pt x="1718" y="271"/>
                  </a:lnTo>
                  <a:lnTo>
                    <a:pt x="1721" y="271"/>
                  </a:lnTo>
                  <a:lnTo>
                    <a:pt x="1725" y="271"/>
                  </a:lnTo>
                  <a:lnTo>
                    <a:pt x="1727" y="271"/>
                  </a:lnTo>
                  <a:lnTo>
                    <a:pt x="1731" y="271"/>
                  </a:lnTo>
                  <a:lnTo>
                    <a:pt x="1734" y="271"/>
                  </a:lnTo>
                  <a:lnTo>
                    <a:pt x="1738" y="271"/>
                  </a:lnTo>
                  <a:lnTo>
                    <a:pt x="1741" y="271"/>
                  </a:lnTo>
                  <a:lnTo>
                    <a:pt x="1745" y="271"/>
                  </a:lnTo>
                  <a:lnTo>
                    <a:pt x="1748" y="271"/>
                  </a:lnTo>
                  <a:lnTo>
                    <a:pt x="1751" y="271"/>
                  </a:lnTo>
                  <a:lnTo>
                    <a:pt x="1754" y="271"/>
                  </a:lnTo>
                  <a:lnTo>
                    <a:pt x="1758" y="271"/>
                  </a:lnTo>
                  <a:lnTo>
                    <a:pt x="1761" y="271"/>
                  </a:lnTo>
                  <a:lnTo>
                    <a:pt x="1765" y="270"/>
                  </a:lnTo>
                  <a:lnTo>
                    <a:pt x="1768" y="270"/>
                  </a:lnTo>
                  <a:lnTo>
                    <a:pt x="1772" y="270"/>
                  </a:lnTo>
                  <a:lnTo>
                    <a:pt x="1774" y="270"/>
                  </a:lnTo>
                  <a:lnTo>
                    <a:pt x="1778" y="270"/>
                  </a:lnTo>
                  <a:lnTo>
                    <a:pt x="1781" y="270"/>
                  </a:lnTo>
                  <a:lnTo>
                    <a:pt x="1785" y="270"/>
                  </a:lnTo>
                  <a:lnTo>
                    <a:pt x="1788" y="270"/>
                  </a:lnTo>
                  <a:lnTo>
                    <a:pt x="1792" y="270"/>
                  </a:lnTo>
                  <a:lnTo>
                    <a:pt x="1795" y="270"/>
                  </a:lnTo>
                  <a:lnTo>
                    <a:pt x="1798" y="270"/>
                  </a:lnTo>
                  <a:lnTo>
                    <a:pt x="1801" y="269"/>
                  </a:lnTo>
                  <a:lnTo>
                    <a:pt x="1805" y="269"/>
                  </a:lnTo>
                  <a:lnTo>
                    <a:pt x="1808" y="269"/>
                  </a:lnTo>
                  <a:lnTo>
                    <a:pt x="1812" y="269"/>
                  </a:lnTo>
                  <a:lnTo>
                    <a:pt x="1815" y="269"/>
                  </a:lnTo>
                  <a:lnTo>
                    <a:pt x="1819" y="269"/>
                  </a:lnTo>
                  <a:lnTo>
                    <a:pt x="1822" y="269"/>
                  </a:lnTo>
                  <a:lnTo>
                    <a:pt x="1825" y="268"/>
                  </a:lnTo>
                  <a:lnTo>
                    <a:pt x="1828" y="268"/>
                  </a:lnTo>
                  <a:lnTo>
                    <a:pt x="1832" y="268"/>
                  </a:lnTo>
                  <a:lnTo>
                    <a:pt x="1835" y="268"/>
                  </a:lnTo>
                  <a:lnTo>
                    <a:pt x="1839" y="268"/>
                  </a:lnTo>
                  <a:lnTo>
                    <a:pt x="1842" y="268"/>
                  </a:lnTo>
                  <a:lnTo>
                    <a:pt x="1846" y="267"/>
                  </a:lnTo>
                  <a:lnTo>
                    <a:pt x="1848" y="267"/>
                  </a:lnTo>
                  <a:lnTo>
                    <a:pt x="1852" y="267"/>
                  </a:lnTo>
                  <a:lnTo>
                    <a:pt x="1855" y="267"/>
                  </a:lnTo>
                  <a:lnTo>
                    <a:pt x="1859" y="267"/>
                  </a:lnTo>
                  <a:lnTo>
                    <a:pt x="1862" y="266"/>
                  </a:lnTo>
                  <a:lnTo>
                    <a:pt x="1866" y="266"/>
                  </a:lnTo>
                  <a:lnTo>
                    <a:pt x="1869" y="266"/>
                  </a:lnTo>
                  <a:lnTo>
                    <a:pt x="1872" y="266"/>
                  </a:lnTo>
                  <a:lnTo>
                    <a:pt x="1875" y="266"/>
                  </a:lnTo>
                  <a:lnTo>
                    <a:pt x="1879" y="265"/>
                  </a:lnTo>
                  <a:lnTo>
                    <a:pt x="1882" y="265"/>
                  </a:lnTo>
                  <a:lnTo>
                    <a:pt x="1886" y="265"/>
                  </a:lnTo>
                  <a:lnTo>
                    <a:pt x="1889" y="265"/>
                  </a:lnTo>
                  <a:lnTo>
                    <a:pt x="1893" y="264"/>
                  </a:lnTo>
                  <a:lnTo>
                    <a:pt x="1895" y="264"/>
                  </a:lnTo>
                  <a:lnTo>
                    <a:pt x="1899" y="263"/>
                  </a:lnTo>
                  <a:lnTo>
                    <a:pt x="1902" y="263"/>
                  </a:lnTo>
                  <a:lnTo>
                    <a:pt x="1906" y="263"/>
                  </a:lnTo>
                  <a:lnTo>
                    <a:pt x="1909" y="262"/>
                  </a:lnTo>
                  <a:lnTo>
                    <a:pt x="1913" y="262"/>
                  </a:lnTo>
                  <a:lnTo>
                    <a:pt x="1916" y="261"/>
                  </a:lnTo>
                  <a:lnTo>
                    <a:pt x="1919" y="261"/>
                  </a:lnTo>
                  <a:lnTo>
                    <a:pt x="1922" y="260"/>
                  </a:lnTo>
                  <a:lnTo>
                    <a:pt x="1926" y="259"/>
                  </a:lnTo>
                  <a:lnTo>
                    <a:pt x="1929" y="259"/>
                  </a:lnTo>
                  <a:lnTo>
                    <a:pt x="1933" y="258"/>
                  </a:lnTo>
                  <a:lnTo>
                    <a:pt x="1936" y="258"/>
                  </a:lnTo>
                  <a:lnTo>
                    <a:pt x="1940" y="258"/>
                  </a:lnTo>
                  <a:lnTo>
                    <a:pt x="1943" y="257"/>
                  </a:lnTo>
                  <a:lnTo>
                    <a:pt x="1946" y="257"/>
                  </a:lnTo>
                  <a:lnTo>
                    <a:pt x="1949" y="257"/>
                  </a:lnTo>
                  <a:lnTo>
                    <a:pt x="1953" y="257"/>
                  </a:lnTo>
                  <a:lnTo>
                    <a:pt x="1956" y="257"/>
                  </a:lnTo>
                  <a:lnTo>
                    <a:pt x="1960" y="257"/>
                  </a:lnTo>
                  <a:lnTo>
                    <a:pt x="1963" y="256"/>
                  </a:lnTo>
                  <a:lnTo>
                    <a:pt x="1967" y="256"/>
                  </a:lnTo>
                  <a:lnTo>
                    <a:pt x="1969" y="256"/>
                  </a:lnTo>
                  <a:lnTo>
                    <a:pt x="1973" y="255"/>
                  </a:lnTo>
                  <a:lnTo>
                    <a:pt x="1976" y="254"/>
                  </a:lnTo>
                  <a:lnTo>
                    <a:pt x="1980" y="254"/>
                  </a:lnTo>
                  <a:lnTo>
                    <a:pt x="1983" y="253"/>
                  </a:lnTo>
                  <a:lnTo>
                    <a:pt x="1987" y="252"/>
                  </a:lnTo>
                  <a:lnTo>
                    <a:pt x="1990" y="252"/>
                  </a:lnTo>
                  <a:lnTo>
                    <a:pt x="1993" y="252"/>
                  </a:lnTo>
                  <a:lnTo>
                    <a:pt x="1996" y="252"/>
                  </a:lnTo>
                  <a:lnTo>
                    <a:pt x="2000" y="252"/>
                  </a:lnTo>
                  <a:lnTo>
                    <a:pt x="2003" y="252"/>
                  </a:lnTo>
                  <a:lnTo>
                    <a:pt x="2007" y="252"/>
                  </a:lnTo>
                  <a:lnTo>
                    <a:pt x="2010" y="252"/>
                  </a:lnTo>
                  <a:lnTo>
                    <a:pt x="2014" y="253"/>
                  </a:lnTo>
                  <a:lnTo>
                    <a:pt x="2016" y="253"/>
                  </a:lnTo>
                  <a:lnTo>
                    <a:pt x="2020" y="253"/>
                  </a:lnTo>
                  <a:lnTo>
                    <a:pt x="2023" y="254"/>
                  </a:lnTo>
                  <a:lnTo>
                    <a:pt x="2027" y="254"/>
                  </a:lnTo>
                  <a:lnTo>
                    <a:pt x="2030" y="254"/>
                  </a:lnTo>
                  <a:lnTo>
                    <a:pt x="2034" y="254"/>
                  </a:lnTo>
                  <a:lnTo>
                    <a:pt x="2037" y="255"/>
                  </a:lnTo>
                  <a:lnTo>
                    <a:pt x="2040" y="255"/>
                  </a:lnTo>
                  <a:lnTo>
                    <a:pt x="2043" y="255"/>
                  </a:lnTo>
                  <a:lnTo>
                    <a:pt x="2047" y="255"/>
                  </a:lnTo>
                  <a:lnTo>
                    <a:pt x="2050" y="255"/>
                  </a:lnTo>
                  <a:lnTo>
                    <a:pt x="2054" y="255"/>
                  </a:lnTo>
                  <a:lnTo>
                    <a:pt x="2057" y="255"/>
                  </a:lnTo>
                  <a:lnTo>
                    <a:pt x="2061" y="255"/>
                  </a:lnTo>
                  <a:lnTo>
                    <a:pt x="2064" y="256"/>
                  </a:lnTo>
                  <a:lnTo>
                    <a:pt x="2067" y="256"/>
                  </a:lnTo>
                  <a:lnTo>
                    <a:pt x="2070" y="256"/>
                  </a:lnTo>
                  <a:lnTo>
                    <a:pt x="2074" y="256"/>
                  </a:lnTo>
                  <a:lnTo>
                    <a:pt x="2077" y="256"/>
                  </a:lnTo>
                  <a:lnTo>
                    <a:pt x="2081" y="256"/>
                  </a:lnTo>
                  <a:lnTo>
                    <a:pt x="2084" y="256"/>
                  </a:lnTo>
                  <a:lnTo>
                    <a:pt x="2088" y="256"/>
                  </a:lnTo>
                  <a:lnTo>
                    <a:pt x="2090" y="255"/>
                  </a:lnTo>
                  <a:lnTo>
                    <a:pt x="2094" y="255"/>
                  </a:lnTo>
                  <a:lnTo>
                    <a:pt x="2097" y="254"/>
                  </a:lnTo>
                  <a:lnTo>
                    <a:pt x="2101" y="252"/>
                  </a:lnTo>
                  <a:lnTo>
                    <a:pt x="2104" y="248"/>
                  </a:lnTo>
                  <a:lnTo>
                    <a:pt x="2108" y="243"/>
                  </a:lnTo>
                  <a:lnTo>
                    <a:pt x="2111" y="231"/>
                  </a:lnTo>
                  <a:lnTo>
                    <a:pt x="2114" y="213"/>
                  </a:lnTo>
                  <a:lnTo>
                    <a:pt x="2117" y="188"/>
                  </a:lnTo>
                  <a:lnTo>
                    <a:pt x="2121" y="155"/>
                  </a:lnTo>
                  <a:lnTo>
                    <a:pt x="2124" y="117"/>
                  </a:lnTo>
                  <a:lnTo>
                    <a:pt x="2128" y="79"/>
                  </a:lnTo>
                  <a:lnTo>
                    <a:pt x="2131" y="45"/>
                  </a:lnTo>
                  <a:lnTo>
                    <a:pt x="2135" y="20"/>
                  </a:lnTo>
                  <a:lnTo>
                    <a:pt x="2137" y="5"/>
                  </a:lnTo>
                  <a:lnTo>
                    <a:pt x="2141" y="0"/>
                  </a:lnTo>
                  <a:lnTo>
                    <a:pt x="2144" y="4"/>
                  </a:lnTo>
                  <a:lnTo>
                    <a:pt x="2148" y="13"/>
                  </a:lnTo>
                  <a:lnTo>
                    <a:pt x="2151" y="26"/>
                  </a:lnTo>
                  <a:lnTo>
                    <a:pt x="2155" y="38"/>
                  </a:lnTo>
                  <a:lnTo>
                    <a:pt x="2158" y="53"/>
                  </a:lnTo>
                  <a:lnTo>
                    <a:pt x="2161" y="66"/>
                  </a:lnTo>
                  <a:lnTo>
                    <a:pt x="2164" y="78"/>
                  </a:lnTo>
                  <a:lnTo>
                    <a:pt x="2168" y="90"/>
                  </a:lnTo>
                  <a:lnTo>
                    <a:pt x="2171" y="101"/>
                  </a:lnTo>
                  <a:lnTo>
                    <a:pt x="2175" y="110"/>
                  </a:lnTo>
                  <a:lnTo>
                    <a:pt x="2178" y="119"/>
                  </a:lnTo>
                  <a:lnTo>
                    <a:pt x="2182" y="128"/>
                  </a:lnTo>
                  <a:lnTo>
                    <a:pt x="2185" y="136"/>
                  </a:lnTo>
                  <a:lnTo>
                    <a:pt x="2188" y="142"/>
                  </a:lnTo>
                  <a:lnTo>
                    <a:pt x="2191" y="148"/>
                  </a:lnTo>
                  <a:lnTo>
                    <a:pt x="2195" y="154"/>
                  </a:lnTo>
                  <a:lnTo>
                    <a:pt x="2198" y="159"/>
                  </a:lnTo>
                  <a:lnTo>
                    <a:pt x="2202" y="164"/>
                  </a:lnTo>
                  <a:lnTo>
                    <a:pt x="2205" y="168"/>
                  </a:lnTo>
                  <a:lnTo>
                    <a:pt x="2208" y="172"/>
                  </a:lnTo>
                  <a:lnTo>
                    <a:pt x="2211" y="176"/>
                  </a:lnTo>
                  <a:lnTo>
                    <a:pt x="2214" y="178"/>
                  </a:lnTo>
                  <a:lnTo>
                    <a:pt x="2218" y="181"/>
                  </a:lnTo>
                  <a:lnTo>
                    <a:pt x="2221" y="184"/>
                  </a:lnTo>
                  <a:lnTo>
                    <a:pt x="2225" y="187"/>
                  </a:lnTo>
                  <a:lnTo>
                    <a:pt x="2228" y="189"/>
                  </a:lnTo>
                  <a:lnTo>
                    <a:pt x="2232" y="191"/>
                  </a:lnTo>
                  <a:lnTo>
                    <a:pt x="2234" y="192"/>
                  </a:lnTo>
                  <a:lnTo>
                    <a:pt x="2238" y="194"/>
                  </a:lnTo>
                  <a:lnTo>
                    <a:pt x="2241" y="195"/>
                  </a:lnTo>
                  <a:lnTo>
                    <a:pt x="2245" y="196"/>
                  </a:lnTo>
                  <a:lnTo>
                    <a:pt x="2248" y="196"/>
                  </a:lnTo>
                  <a:lnTo>
                    <a:pt x="2252" y="197"/>
                  </a:lnTo>
                  <a:lnTo>
                    <a:pt x="2255" y="196"/>
                  </a:lnTo>
                  <a:lnTo>
                    <a:pt x="2258" y="196"/>
                  </a:lnTo>
                  <a:lnTo>
                    <a:pt x="2261" y="194"/>
                  </a:lnTo>
                  <a:lnTo>
                    <a:pt x="2265" y="192"/>
                  </a:lnTo>
                  <a:lnTo>
                    <a:pt x="2268" y="189"/>
                  </a:lnTo>
                  <a:lnTo>
                    <a:pt x="2272" y="185"/>
                  </a:lnTo>
                  <a:lnTo>
                    <a:pt x="2275" y="179"/>
                  </a:lnTo>
                  <a:lnTo>
                    <a:pt x="2279" y="172"/>
                  </a:lnTo>
                  <a:lnTo>
                    <a:pt x="2282" y="163"/>
                  </a:lnTo>
                  <a:lnTo>
                    <a:pt x="2285" y="153"/>
                  </a:lnTo>
                  <a:lnTo>
                    <a:pt x="2288" y="142"/>
                  </a:lnTo>
                  <a:lnTo>
                    <a:pt x="2292" y="132"/>
                  </a:lnTo>
                  <a:lnTo>
                    <a:pt x="2295" y="121"/>
                  </a:lnTo>
                  <a:lnTo>
                    <a:pt x="2299" y="110"/>
                  </a:lnTo>
                  <a:lnTo>
                    <a:pt x="2302" y="101"/>
                  </a:lnTo>
                  <a:lnTo>
                    <a:pt x="2306" y="92"/>
                  </a:lnTo>
                  <a:lnTo>
                    <a:pt x="2308" y="84"/>
                  </a:lnTo>
                  <a:lnTo>
                    <a:pt x="2312" y="77"/>
                  </a:lnTo>
                  <a:lnTo>
                    <a:pt x="2315" y="72"/>
                  </a:lnTo>
                  <a:lnTo>
                    <a:pt x="2319" y="69"/>
                  </a:lnTo>
                  <a:lnTo>
                    <a:pt x="2322" y="67"/>
                  </a:lnTo>
                  <a:lnTo>
                    <a:pt x="2326" y="67"/>
                  </a:lnTo>
                  <a:lnTo>
                    <a:pt x="2329" y="68"/>
                  </a:lnTo>
                  <a:lnTo>
                    <a:pt x="2332" y="70"/>
                  </a:lnTo>
                  <a:lnTo>
                    <a:pt x="2335" y="73"/>
                  </a:lnTo>
                  <a:lnTo>
                    <a:pt x="2339" y="78"/>
                  </a:lnTo>
                  <a:lnTo>
                    <a:pt x="2342" y="83"/>
                  </a:lnTo>
                  <a:lnTo>
                    <a:pt x="2346" y="89"/>
                  </a:lnTo>
                  <a:lnTo>
                    <a:pt x="2349" y="94"/>
                  </a:lnTo>
                  <a:lnTo>
                    <a:pt x="2353" y="100"/>
                  </a:lnTo>
                  <a:lnTo>
                    <a:pt x="2355" y="105"/>
                  </a:lnTo>
                  <a:lnTo>
                    <a:pt x="2359" y="109"/>
                  </a:lnTo>
                  <a:lnTo>
                    <a:pt x="2362" y="114"/>
                  </a:lnTo>
                  <a:lnTo>
                    <a:pt x="2366" y="119"/>
                  </a:lnTo>
                  <a:lnTo>
                    <a:pt x="2369" y="123"/>
                  </a:lnTo>
                  <a:lnTo>
                    <a:pt x="2373" y="127"/>
                  </a:lnTo>
                  <a:lnTo>
                    <a:pt x="2376" y="131"/>
                  </a:lnTo>
                  <a:lnTo>
                    <a:pt x="2379" y="134"/>
                  </a:lnTo>
                  <a:lnTo>
                    <a:pt x="2382" y="138"/>
                  </a:lnTo>
                  <a:lnTo>
                    <a:pt x="2386" y="141"/>
                  </a:lnTo>
                  <a:lnTo>
                    <a:pt x="2389" y="143"/>
                  </a:lnTo>
                  <a:lnTo>
                    <a:pt x="2393" y="145"/>
                  </a:lnTo>
                  <a:lnTo>
                    <a:pt x="2396" y="148"/>
                  </a:lnTo>
                  <a:lnTo>
                    <a:pt x="2400" y="151"/>
                  </a:lnTo>
                  <a:lnTo>
                    <a:pt x="2403" y="153"/>
                  </a:lnTo>
                  <a:lnTo>
                    <a:pt x="2406" y="156"/>
                  </a:lnTo>
                  <a:lnTo>
                    <a:pt x="2409" y="158"/>
                  </a:lnTo>
                  <a:lnTo>
                    <a:pt x="2413" y="160"/>
                  </a:lnTo>
                  <a:lnTo>
                    <a:pt x="2416" y="163"/>
                  </a:lnTo>
                  <a:lnTo>
                    <a:pt x="2420" y="165"/>
                  </a:lnTo>
                  <a:lnTo>
                    <a:pt x="2423" y="167"/>
                  </a:lnTo>
                  <a:lnTo>
                    <a:pt x="2427" y="169"/>
                  </a:lnTo>
                  <a:lnTo>
                    <a:pt x="2429" y="171"/>
                  </a:lnTo>
                  <a:lnTo>
                    <a:pt x="2433" y="173"/>
                  </a:lnTo>
                  <a:lnTo>
                    <a:pt x="2436" y="174"/>
                  </a:lnTo>
                  <a:lnTo>
                    <a:pt x="2440" y="176"/>
                  </a:lnTo>
                  <a:lnTo>
                    <a:pt x="2443" y="177"/>
                  </a:lnTo>
                  <a:lnTo>
                    <a:pt x="2447" y="178"/>
                  </a:lnTo>
                  <a:lnTo>
                    <a:pt x="2450" y="180"/>
                  </a:lnTo>
                  <a:lnTo>
                    <a:pt x="2453" y="181"/>
                  </a:lnTo>
                  <a:lnTo>
                    <a:pt x="2456" y="183"/>
                  </a:lnTo>
                  <a:lnTo>
                    <a:pt x="2460" y="184"/>
                  </a:lnTo>
                  <a:lnTo>
                    <a:pt x="2463" y="185"/>
                  </a:lnTo>
                  <a:lnTo>
                    <a:pt x="2467" y="187"/>
                  </a:lnTo>
                  <a:lnTo>
                    <a:pt x="2470" y="188"/>
                  </a:lnTo>
                  <a:lnTo>
                    <a:pt x="2474" y="189"/>
                  </a:lnTo>
                  <a:lnTo>
                    <a:pt x="2476" y="190"/>
                  </a:lnTo>
                  <a:lnTo>
                    <a:pt x="2480" y="191"/>
                  </a:lnTo>
                  <a:lnTo>
                    <a:pt x="2483" y="193"/>
                  </a:lnTo>
                  <a:lnTo>
                    <a:pt x="2487" y="194"/>
                  </a:lnTo>
                  <a:lnTo>
                    <a:pt x="2490" y="195"/>
                  </a:lnTo>
                  <a:lnTo>
                    <a:pt x="2494" y="196"/>
                  </a:lnTo>
                  <a:lnTo>
                    <a:pt x="2497" y="197"/>
                  </a:lnTo>
                  <a:lnTo>
                    <a:pt x="2500" y="198"/>
                  </a:lnTo>
                  <a:lnTo>
                    <a:pt x="2503" y="199"/>
                  </a:lnTo>
                  <a:lnTo>
                    <a:pt x="2507" y="200"/>
                  </a:lnTo>
                  <a:lnTo>
                    <a:pt x="2510" y="200"/>
                  </a:lnTo>
                  <a:lnTo>
                    <a:pt x="2514" y="201"/>
                  </a:lnTo>
                  <a:lnTo>
                    <a:pt x="2517" y="202"/>
                  </a:lnTo>
                  <a:lnTo>
                    <a:pt x="2520" y="203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" name="Rectangle 170">
              <a:extLst>
                <a:ext uri="{FF2B5EF4-FFF2-40B4-BE49-F238E27FC236}">
                  <a16:creationId xmlns:a16="http://schemas.microsoft.com/office/drawing/2014/main" id="{3DE23557-C899-5A00-AA29-1FADF92EE7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2642" y="2074266"/>
              <a:ext cx="1726838" cy="89659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05" name="Line 148">
            <a:extLst>
              <a:ext uri="{FF2B5EF4-FFF2-40B4-BE49-F238E27FC236}">
                <a16:creationId xmlns:a16="http://schemas.microsoft.com/office/drawing/2014/main" id="{A92D4256-9E98-C728-E52D-F52D976032D6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3273" y="2552606"/>
            <a:ext cx="1215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" name="Line 153">
            <a:extLst>
              <a:ext uri="{FF2B5EF4-FFF2-40B4-BE49-F238E27FC236}">
                <a16:creationId xmlns:a16="http://schemas.microsoft.com/office/drawing/2014/main" id="{38CF63CD-32A1-73DE-D04A-08CED3526350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3273" y="2217754"/>
            <a:ext cx="1215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" name="Line 158">
            <a:extLst>
              <a:ext uri="{FF2B5EF4-FFF2-40B4-BE49-F238E27FC236}">
                <a16:creationId xmlns:a16="http://schemas.microsoft.com/office/drawing/2014/main" id="{6D44FA0B-2402-A9B6-67DF-DE66321712B3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3273" y="1881454"/>
            <a:ext cx="1215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" name="Line 159">
            <a:extLst>
              <a:ext uri="{FF2B5EF4-FFF2-40B4-BE49-F238E27FC236}">
                <a16:creationId xmlns:a16="http://schemas.microsoft.com/office/drawing/2014/main" id="{6786A8F3-B21F-DF27-9D88-B8C6322D37C5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1791" y="2552606"/>
            <a:ext cx="23639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" name="Line 161">
            <a:extLst>
              <a:ext uri="{FF2B5EF4-FFF2-40B4-BE49-F238E27FC236}">
                <a16:creationId xmlns:a16="http://schemas.microsoft.com/office/drawing/2014/main" id="{09A5C831-03EB-C4A1-7A8F-FE730B9B2E18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1791" y="2217754"/>
            <a:ext cx="23639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" name="Line 163">
            <a:extLst>
              <a:ext uri="{FF2B5EF4-FFF2-40B4-BE49-F238E27FC236}">
                <a16:creationId xmlns:a16="http://schemas.microsoft.com/office/drawing/2014/main" id="{39ACB15C-3504-3A28-087C-A67E2D01C8EC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1791" y="1881454"/>
            <a:ext cx="23639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" name="Rectangle 341">
            <a:extLst>
              <a:ext uri="{FF2B5EF4-FFF2-40B4-BE49-F238E27FC236}">
                <a16:creationId xmlns:a16="http://schemas.microsoft.com/office/drawing/2014/main" id="{A9A545AB-8BC5-5D28-1846-5823A49F01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0695" y="2167154"/>
            <a:ext cx="43181" cy="97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25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ectangle 343">
            <a:extLst>
              <a:ext uri="{FF2B5EF4-FFF2-40B4-BE49-F238E27FC236}">
                <a16:creationId xmlns:a16="http://schemas.microsoft.com/office/drawing/2014/main" id="{12DB320F-F9B2-2E04-E343-46F16CD52B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7992" y="1835391"/>
            <a:ext cx="105362" cy="1007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6" name="Rectangle 341">
            <a:extLst>
              <a:ext uri="{FF2B5EF4-FFF2-40B4-BE49-F238E27FC236}">
                <a16:creationId xmlns:a16="http://schemas.microsoft.com/office/drawing/2014/main" id="{51420E04-EAB7-4813-69C8-71C5BEC8D9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6918" y="2502994"/>
            <a:ext cx="21590" cy="97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0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7" name="グループ化 126">
            <a:extLst>
              <a:ext uri="{FF2B5EF4-FFF2-40B4-BE49-F238E27FC236}">
                <a16:creationId xmlns:a16="http://schemas.microsoft.com/office/drawing/2014/main" id="{696693E7-CD3C-744C-4218-6C3D43745C40}"/>
              </a:ext>
            </a:extLst>
          </p:cNvPr>
          <p:cNvGrpSpPr/>
          <p:nvPr/>
        </p:nvGrpSpPr>
        <p:grpSpPr>
          <a:xfrm>
            <a:off x="2052512" y="837031"/>
            <a:ext cx="137438" cy="765315"/>
            <a:chOff x="2200392" y="1987791"/>
            <a:chExt cx="137438" cy="765315"/>
          </a:xfrm>
        </p:grpSpPr>
        <p:sp>
          <p:nvSpPr>
            <p:cNvPr id="118" name="Line 148">
              <a:extLst>
                <a:ext uri="{FF2B5EF4-FFF2-40B4-BE49-F238E27FC236}">
                  <a16:creationId xmlns:a16="http://schemas.microsoft.com/office/drawing/2014/main" id="{80AF551C-672B-A848-1864-0E4B90B863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5673" y="2705006"/>
              <a:ext cx="1215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Line 153">
              <a:extLst>
                <a:ext uri="{FF2B5EF4-FFF2-40B4-BE49-F238E27FC236}">
                  <a16:creationId xmlns:a16="http://schemas.microsoft.com/office/drawing/2014/main" id="{3959A264-FAF4-34D3-3590-1D6530BA6B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5673" y="2370154"/>
              <a:ext cx="1215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Line 158">
              <a:extLst>
                <a:ext uri="{FF2B5EF4-FFF2-40B4-BE49-F238E27FC236}">
                  <a16:creationId xmlns:a16="http://schemas.microsoft.com/office/drawing/2014/main" id="{276C85A0-2AAF-5BB1-2C9D-E717F38036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5673" y="2033854"/>
              <a:ext cx="1215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Line 159">
              <a:extLst>
                <a:ext uri="{FF2B5EF4-FFF2-40B4-BE49-F238E27FC236}">
                  <a16:creationId xmlns:a16="http://schemas.microsoft.com/office/drawing/2014/main" id="{2619745C-C50A-4071-62AE-BA92A31CBC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191" y="2705006"/>
              <a:ext cx="236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" name="Line 161">
              <a:extLst>
                <a:ext uri="{FF2B5EF4-FFF2-40B4-BE49-F238E27FC236}">
                  <a16:creationId xmlns:a16="http://schemas.microsoft.com/office/drawing/2014/main" id="{5D397FB9-77EE-F2F9-0A2A-EE27C07C20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191" y="2370154"/>
              <a:ext cx="236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" name="Line 163">
              <a:extLst>
                <a:ext uri="{FF2B5EF4-FFF2-40B4-BE49-F238E27FC236}">
                  <a16:creationId xmlns:a16="http://schemas.microsoft.com/office/drawing/2014/main" id="{3C5893D6-9C9F-F87F-9EF5-3E75A03DF0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191" y="2033854"/>
              <a:ext cx="236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" name="Rectangle 341">
              <a:extLst>
                <a:ext uri="{FF2B5EF4-FFF2-40B4-BE49-F238E27FC236}">
                  <a16:creationId xmlns:a16="http://schemas.microsoft.com/office/drawing/2014/main" id="{5BDA61C6-60FA-8EB9-4599-588C94F507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3095" y="2319554"/>
              <a:ext cx="43181" cy="97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25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Rectangle 343">
              <a:extLst>
                <a:ext uri="{FF2B5EF4-FFF2-40B4-BE49-F238E27FC236}">
                  <a16:creationId xmlns:a16="http://schemas.microsoft.com/office/drawing/2014/main" id="{1D482C89-0069-B048-4CE2-D2233C2C90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0392" y="1987791"/>
              <a:ext cx="105362" cy="1007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26" name="Rectangle 341">
              <a:extLst>
                <a:ext uri="{FF2B5EF4-FFF2-40B4-BE49-F238E27FC236}">
                  <a16:creationId xmlns:a16="http://schemas.microsoft.com/office/drawing/2014/main" id="{E3401165-9A97-80D8-BEB8-D2869AE22E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318" y="2655394"/>
              <a:ext cx="21590" cy="97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0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7" name="グループ化 546">
            <a:extLst>
              <a:ext uri="{FF2B5EF4-FFF2-40B4-BE49-F238E27FC236}">
                <a16:creationId xmlns:a16="http://schemas.microsoft.com/office/drawing/2014/main" id="{5149C138-CBEF-1FD5-4090-EB57D40015FA}"/>
              </a:ext>
            </a:extLst>
          </p:cNvPr>
          <p:cNvGrpSpPr/>
          <p:nvPr/>
        </p:nvGrpSpPr>
        <p:grpSpPr>
          <a:xfrm>
            <a:off x="2048260" y="2809075"/>
            <a:ext cx="137438" cy="765315"/>
            <a:chOff x="2200392" y="1987791"/>
            <a:chExt cx="137438" cy="765315"/>
          </a:xfrm>
        </p:grpSpPr>
        <p:sp>
          <p:nvSpPr>
            <p:cNvPr id="548" name="Line 148">
              <a:extLst>
                <a:ext uri="{FF2B5EF4-FFF2-40B4-BE49-F238E27FC236}">
                  <a16:creationId xmlns:a16="http://schemas.microsoft.com/office/drawing/2014/main" id="{1FA90DAA-C621-B78D-6482-FAEFFD3BF7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5673" y="2705006"/>
              <a:ext cx="1215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9" name="Line 153">
              <a:extLst>
                <a:ext uri="{FF2B5EF4-FFF2-40B4-BE49-F238E27FC236}">
                  <a16:creationId xmlns:a16="http://schemas.microsoft.com/office/drawing/2014/main" id="{6F488A77-9565-8513-9457-2CC22B7565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5673" y="2370154"/>
              <a:ext cx="1215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0" name="Line 158">
              <a:extLst>
                <a:ext uri="{FF2B5EF4-FFF2-40B4-BE49-F238E27FC236}">
                  <a16:creationId xmlns:a16="http://schemas.microsoft.com/office/drawing/2014/main" id="{F7665B6A-9B34-FAFB-C50C-CCE91EA381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5673" y="2033854"/>
              <a:ext cx="1215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1" name="Line 159">
              <a:extLst>
                <a:ext uri="{FF2B5EF4-FFF2-40B4-BE49-F238E27FC236}">
                  <a16:creationId xmlns:a16="http://schemas.microsoft.com/office/drawing/2014/main" id="{4BE66C85-19A7-B134-4D7F-94EA566DE1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191" y="2705006"/>
              <a:ext cx="236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2" name="Line 161">
              <a:extLst>
                <a:ext uri="{FF2B5EF4-FFF2-40B4-BE49-F238E27FC236}">
                  <a16:creationId xmlns:a16="http://schemas.microsoft.com/office/drawing/2014/main" id="{80B5A360-4F16-61E3-00A4-F4501619DE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191" y="2370154"/>
              <a:ext cx="236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3" name="Line 163">
              <a:extLst>
                <a:ext uri="{FF2B5EF4-FFF2-40B4-BE49-F238E27FC236}">
                  <a16:creationId xmlns:a16="http://schemas.microsoft.com/office/drawing/2014/main" id="{7DBF2F21-969F-1EF1-5593-CACEB13AE4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191" y="2033854"/>
              <a:ext cx="236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4" name="Rectangle 341">
              <a:extLst>
                <a:ext uri="{FF2B5EF4-FFF2-40B4-BE49-F238E27FC236}">
                  <a16:creationId xmlns:a16="http://schemas.microsoft.com/office/drawing/2014/main" id="{09A8672E-F70D-3FB8-09EC-3F40AB1EA0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3095" y="2319554"/>
              <a:ext cx="43181" cy="97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25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5" name="Rectangle 343">
              <a:extLst>
                <a:ext uri="{FF2B5EF4-FFF2-40B4-BE49-F238E27FC236}">
                  <a16:creationId xmlns:a16="http://schemas.microsoft.com/office/drawing/2014/main" id="{D09A3E23-355F-4E94-7CAB-5C60A4D3D7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0392" y="1987791"/>
              <a:ext cx="105362" cy="1007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56" name="Rectangle 341">
              <a:extLst>
                <a:ext uri="{FF2B5EF4-FFF2-40B4-BE49-F238E27FC236}">
                  <a16:creationId xmlns:a16="http://schemas.microsoft.com/office/drawing/2014/main" id="{173369AA-31CC-1221-7158-A90DA054E6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318" y="2655394"/>
              <a:ext cx="21590" cy="97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0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8" name="グループ化 557">
            <a:extLst>
              <a:ext uri="{FF2B5EF4-FFF2-40B4-BE49-F238E27FC236}">
                <a16:creationId xmlns:a16="http://schemas.microsoft.com/office/drawing/2014/main" id="{CA83D348-606F-1D29-A660-070DD3E35503}"/>
              </a:ext>
            </a:extLst>
          </p:cNvPr>
          <p:cNvGrpSpPr/>
          <p:nvPr/>
        </p:nvGrpSpPr>
        <p:grpSpPr>
          <a:xfrm>
            <a:off x="2051666" y="3795429"/>
            <a:ext cx="137438" cy="765315"/>
            <a:chOff x="2200392" y="1987791"/>
            <a:chExt cx="137438" cy="765315"/>
          </a:xfrm>
        </p:grpSpPr>
        <p:sp>
          <p:nvSpPr>
            <p:cNvPr id="559" name="Line 148">
              <a:extLst>
                <a:ext uri="{FF2B5EF4-FFF2-40B4-BE49-F238E27FC236}">
                  <a16:creationId xmlns:a16="http://schemas.microsoft.com/office/drawing/2014/main" id="{6E575CCF-8E62-A330-E53C-52DA549CB2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5673" y="2705006"/>
              <a:ext cx="1215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0" name="Line 153">
              <a:extLst>
                <a:ext uri="{FF2B5EF4-FFF2-40B4-BE49-F238E27FC236}">
                  <a16:creationId xmlns:a16="http://schemas.microsoft.com/office/drawing/2014/main" id="{0AEC3780-1C9B-BDEE-DFDC-78A72E497F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5673" y="2370154"/>
              <a:ext cx="1215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1" name="Line 158">
              <a:extLst>
                <a:ext uri="{FF2B5EF4-FFF2-40B4-BE49-F238E27FC236}">
                  <a16:creationId xmlns:a16="http://schemas.microsoft.com/office/drawing/2014/main" id="{4F96D123-3625-4662-EF74-EF09EA5249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5673" y="2033854"/>
              <a:ext cx="1215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2" name="Line 159">
              <a:extLst>
                <a:ext uri="{FF2B5EF4-FFF2-40B4-BE49-F238E27FC236}">
                  <a16:creationId xmlns:a16="http://schemas.microsoft.com/office/drawing/2014/main" id="{6FC1E8E5-E3EE-4A48-B241-788888B2CD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191" y="2705006"/>
              <a:ext cx="236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3" name="Line 161">
              <a:extLst>
                <a:ext uri="{FF2B5EF4-FFF2-40B4-BE49-F238E27FC236}">
                  <a16:creationId xmlns:a16="http://schemas.microsoft.com/office/drawing/2014/main" id="{28981B0D-B54B-6D6A-C8AE-5056258F53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191" y="2370154"/>
              <a:ext cx="236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4" name="Line 163">
              <a:extLst>
                <a:ext uri="{FF2B5EF4-FFF2-40B4-BE49-F238E27FC236}">
                  <a16:creationId xmlns:a16="http://schemas.microsoft.com/office/drawing/2014/main" id="{21D8D12C-BD29-EDBE-5C7D-1D70947358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191" y="2033854"/>
              <a:ext cx="236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5" name="Rectangle 341">
              <a:extLst>
                <a:ext uri="{FF2B5EF4-FFF2-40B4-BE49-F238E27FC236}">
                  <a16:creationId xmlns:a16="http://schemas.microsoft.com/office/drawing/2014/main" id="{94FFE7D6-CFDC-4053-E80C-29FAD1EA0E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3095" y="2319554"/>
              <a:ext cx="43181" cy="97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25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6" name="Rectangle 343">
              <a:extLst>
                <a:ext uri="{FF2B5EF4-FFF2-40B4-BE49-F238E27FC236}">
                  <a16:creationId xmlns:a16="http://schemas.microsoft.com/office/drawing/2014/main" id="{893E4C3F-7D6F-83C1-F775-642CDEE54C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0392" y="1987791"/>
              <a:ext cx="105362" cy="1007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67" name="Rectangle 341">
              <a:extLst>
                <a:ext uri="{FF2B5EF4-FFF2-40B4-BE49-F238E27FC236}">
                  <a16:creationId xmlns:a16="http://schemas.microsoft.com/office/drawing/2014/main" id="{35A2D82E-C0AA-0AA3-B96D-7B61CD1F09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318" y="2655394"/>
              <a:ext cx="21590" cy="97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0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8" name="テキスト ボックス 567">
            <a:extLst>
              <a:ext uri="{FF2B5EF4-FFF2-40B4-BE49-F238E27FC236}">
                <a16:creationId xmlns:a16="http://schemas.microsoft.com/office/drawing/2014/main" id="{04A0048B-6649-81D7-415B-B33282814175}"/>
              </a:ext>
            </a:extLst>
          </p:cNvPr>
          <p:cNvSpPr txBox="1"/>
          <p:nvPr/>
        </p:nvSpPr>
        <p:spPr>
          <a:xfrm>
            <a:off x="1636650" y="617559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day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69" name="テキスト ボックス 568">
            <a:extLst>
              <a:ext uri="{FF2B5EF4-FFF2-40B4-BE49-F238E27FC236}">
                <a16:creationId xmlns:a16="http://schemas.microsoft.com/office/drawing/2014/main" id="{D3ADE286-424F-3460-5361-4C31047060E5}"/>
              </a:ext>
            </a:extLst>
          </p:cNvPr>
          <p:cNvSpPr txBox="1"/>
          <p:nvPr/>
        </p:nvSpPr>
        <p:spPr>
          <a:xfrm rot="16200000">
            <a:off x="1672830" y="4220515"/>
            <a:ext cx="506377" cy="131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mAU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(220 nm)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0" name="Line 761">
            <a:extLst>
              <a:ext uri="{FF2B5EF4-FFF2-40B4-BE49-F238E27FC236}">
                <a16:creationId xmlns:a16="http://schemas.microsoft.com/office/drawing/2014/main" id="{119D4053-8C8C-605E-EA33-90C59293C02D}"/>
              </a:ext>
            </a:extLst>
          </p:cNvPr>
          <p:cNvSpPr>
            <a:spLocks noChangeShapeType="1"/>
          </p:cNvSpPr>
          <p:nvPr/>
        </p:nvSpPr>
        <p:spPr bwMode="auto">
          <a:xfrm>
            <a:off x="2195121" y="4530183"/>
            <a:ext cx="496" cy="453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71" name="Rectangle 762">
            <a:extLst>
              <a:ext uri="{FF2B5EF4-FFF2-40B4-BE49-F238E27FC236}">
                <a16:creationId xmlns:a16="http://schemas.microsoft.com/office/drawing/2014/main" id="{38869040-1B31-F89E-3AD4-73766E1B05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82353" y="4576801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6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572" name="Line 769">
            <a:extLst>
              <a:ext uri="{FF2B5EF4-FFF2-40B4-BE49-F238E27FC236}">
                <a16:creationId xmlns:a16="http://schemas.microsoft.com/office/drawing/2014/main" id="{017FCF49-F874-EE71-958B-8E86A5C91AA8}"/>
              </a:ext>
            </a:extLst>
          </p:cNvPr>
          <p:cNvSpPr>
            <a:spLocks noChangeShapeType="1"/>
          </p:cNvSpPr>
          <p:nvPr/>
        </p:nvSpPr>
        <p:spPr bwMode="auto">
          <a:xfrm>
            <a:off x="3039032" y="4530183"/>
            <a:ext cx="496" cy="453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73" name="Rectangle 770">
            <a:extLst>
              <a:ext uri="{FF2B5EF4-FFF2-40B4-BE49-F238E27FC236}">
                <a16:creationId xmlns:a16="http://schemas.microsoft.com/office/drawing/2014/main" id="{6C85C621-7318-B3A2-8579-69D4EC9350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931" y="4576427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10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574" name="Rectangle 780">
            <a:extLst>
              <a:ext uri="{FF2B5EF4-FFF2-40B4-BE49-F238E27FC236}">
                <a16:creationId xmlns:a16="http://schemas.microsoft.com/office/drawing/2014/main" id="{7AD65C53-6006-78C1-BAD8-29271504BC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43722" y="4577314"/>
            <a:ext cx="65837" cy="81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14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575" name="Line 781">
            <a:extLst>
              <a:ext uri="{FF2B5EF4-FFF2-40B4-BE49-F238E27FC236}">
                <a16:creationId xmlns:a16="http://schemas.microsoft.com/office/drawing/2014/main" id="{99624B37-3F09-2475-2F5D-E80DBF7E255B}"/>
              </a:ext>
            </a:extLst>
          </p:cNvPr>
          <p:cNvSpPr>
            <a:spLocks noChangeShapeType="1"/>
          </p:cNvSpPr>
          <p:nvPr/>
        </p:nvSpPr>
        <p:spPr bwMode="auto">
          <a:xfrm>
            <a:off x="3882942" y="4530183"/>
            <a:ext cx="496" cy="453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960" name="Rectangle 770">
            <a:extLst>
              <a:ext uri="{FF2B5EF4-FFF2-40B4-BE49-F238E27FC236}">
                <a16:creationId xmlns:a16="http://schemas.microsoft.com/office/drawing/2014/main" id="{B3D4BDD3-255A-062A-0A78-BB1EAAD6C4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8821" y="4691636"/>
            <a:ext cx="4296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Time (min)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4BD6740-8B50-D0D1-138D-4881419641E0}"/>
              </a:ext>
            </a:extLst>
          </p:cNvPr>
          <p:cNvSpPr txBox="1"/>
          <p:nvPr/>
        </p:nvSpPr>
        <p:spPr>
          <a:xfrm>
            <a:off x="590551" y="4923472"/>
            <a:ext cx="704849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: Time course analysis of the cleavage activity of ANA-SA5 against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β42 using HPLC.</a:t>
            </a:r>
          </a:p>
          <a:p>
            <a:r>
              <a:rPr lang="en-US" altLang="ja-JP" sz="1200" dirty="0">
                <a:latin typeface="Palatino Linotype" panose="02040502050505030304" pitchFamily="18" charset="0"/>
              </a:rPr>
              <a:t>Ten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μL</a:t>
            </a:r>
            <a:r>
              <a:rPr lang="en-US" altLang="ja-JP" sz="1200" dirty="0">
                <a:latin typeface="Palatino Linotype" panose="02040502050505030304" pitchFamily="18" charset="0"/>
              </a:rPr>
              <a:t> of the reaction mixture was analyzed using an analytical HPLC. (a)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β42  alone, (b)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β42 co-incubated with ANA-SA5.</a:t>
            </a:r>
            <a:endParaRPr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409C7A6-67AB-EABF-30D6-4291893FD4EE}"/>
              </a:ext>
            </a:extLst>
          </p:cNvPr>
          <p:cNvSpPr txBox="1"/>
          <p:nvPr/>
        </p:nvSpPr>
        <p:spPr>
          <a:xfrm>
            <a:off x="1662722" y="41499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2B7B304-409E-59ED-0A4C-12966F024D79}"/>
              </a:ext>
            </a:extLst>
          </p:cNvPr>
          <p:cNvSpPr txBox="1"/>
          <p:nvPr/>
        </p:nvSpPr>
        <p:spPr>
          <a:xfrm>
            <a:off x="4335394" y="41499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60935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3" name="AutoShape 705">
            <a:extLst>
              <a:ext uri="{FF2B5EF4-FFF2-40B4-BE49-F238E27FC236}">
                <a16:creationId xmlns:a16="http://schemas.microsoft.com/office/drawing/2014/main" id="{21DEF357-3561-40FB-9FF4-21E9D8BC54F9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-1106558" y="4862130"/>
            <a:ext cx="2879725" cy="1619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04" name="Line 424">
            <a:extLst>
              <a:ext uri="{FF2B5EF4-FFF2-40B4-BE49-F238E27FC236}">
                <a16:creationId xmlns:a16="http://schemas.microsoft.com/office/drawing/2014/main" id="{B92818B6-07E7-9C35-51E1-2FD5A8E5BFD4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1838" y="1532637"/>
            <a:ext cx="17857" cy="1319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05" name="Rectangle 425">
            <a:extLst>
              <a:ext uri="{FF2B5EF4-FFF2-40B4-BE49-F238E27FC236}">
                <a16:creationId xmlns:a16="http://schemas.microsoft.com/office/drawing/2014/main" id="{8363E105-4664-0838-E282-A7BFFDA930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6692" y="1486107"/>
            <a:ext cx="23156" cy="1000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0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1" name="Line 428">
            <a:extLst>
              <a:ext uri="{FF2B5EF4-FFF2-40B4-BE49-F238E27FC236}">
                <a16:creationId xmlns:a16="http://schemas.microsoft.com/office/drawing/2014/main" id="{39B1BD4B-22FC-7461-E804-CEDA783EDDBA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1837" y="915804"/>
            <a:ext cx="17857" cy="1319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02" name="Rectangle 429">
            <a:extLst>
              <a:ext uri="{FF2B5EF4-FFF2-40B4-BE49-F238E27FC236}">
                <a16:creationId xmlns:a16="http://schemas.microsoft.com/office/drawing/2014/main" id="{FBA2AF0E-96B5-3C5C-E914-BB4650DC64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04006" y="851692"/>
            <a:ext cx="69465" cy="1000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50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Rectangle 433">
            <a:extLst>
              <a:ext uri="{FF2B5EF4-FFF2-40B4-BE49-F238E27FC236}">
                <a16:creationId xmlns:a16="http://schemas.microsoft.com/office/drawing/2014/main" id="{60A430C1-512F-ED7D-0727-B50F9B3095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84950" y="870817"/>
            <a:ext cx="1699878" cy="712731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94" name="Freeform 431">
            <a:extLst>
              <a:ext uri="{FF2B5EF4-FFF2-40B4-BE49-F238E27FC236}">
                <a16:creationId xmlns:a16="http://schemas.microsoft.com/office/drawing/2014/main" id="{55631DCD-3230-CB98-B396-0855E1503EA9}"/>
              </a:ext>
            </a:extLst>
          </p:cNvPr>
          <p:cNvSpPr>
            <a:spLocks/>
          </p:cNvSpPr>
          <p:nvPr/>
        </p:nvSpPr>
        <p:spPr bwMode="auto">
          <a:xfrm>
            <a:off x="2185445" y="989953"/>
            <a:ext cx="1698886" cy="521000"/>
          </a:xfrm>
          <a:custGeom>
            <a:avLst/>
            <a:gdLst>
              <a:gd name="T0" fmla="*/ 96 w 6851"/>
              <a:gd name="T1" fmla="*/ 451 h 457"/>
              <a:gd name="T2" fmla="*/ 206 w 6851"/>
              <a:gd name="T3" fmla="*/ 447 h 457"/>
              <a:gd name="T4" fmla="*/ 315 w 6851"/>
              <a:gd name="T5" fmla="*/ 445 h 457"/>
              <a:gd name="T6" fmla="*/ 425 w 6851"/>
              <a:gd name="T7" fmla="*/ 445 h 457"/>
              <a:gd name="T8" fmla="*/ 534 w 6851"/>
              <a:gd name="T9" fmla="*/ 445 h 457"/>
              <a:gd name="T10" fmla="*/ 644 w 6851"/>
              <a:gd name="T11" fmla="*/ 447 h 457"/>
              <a:gd name="T12" fmla="*/ 753 w 6851"/>
              <a:gd name="T13" fmla="*/ 447 h 457"/>
              <a:gd name="T14" fmla="*/ 862 w 6851"/>
              <a:gd name="T15" fmla="*/ 447 h 457"/>
              <a:gd name="T16" fmla="*/ 974 w 6851"/>
              <a:gd name="T17" fmla="*/ 447 h 457"/>
              <a:gd name="T18" fmla="*/ 1083 w 6851"/>
              <a:gd name="T19" fmla="*/ 447 h 457"/>
              <a:gd name="T20" fmla="*/ 1193 w 6851"/>
              <a:gd name="T21" fmla="*/ 447 h 457"/>
              <a:gd name="T22" fmla="*/ 1302 w 6851"/>
              <a:gd name="T23" fmla="*/ 449 h 457"/>
              <a:gd name="T24" fmla="*/ 1412 w 6851"/>
              <a:gd name="T25" fmla="*/ 449 h 457"/>
              <a:gd name="T26" fmla="*/ 1521 w 6851"/>
              <a:gd name="T27" fmla="*/ 449 h 457"/>
              <a:gd name="T28" fmla="*/ 1630 w 6851"/>
              <a:gd name="T29" fmla="*/ 449 h 457"/>
              <a:gd name="T30" fmla="*/ 1740 w 6851"/>
              <a:gd name="T31" fmla="*/ 449 h 457"/>
              <a:gd name="T32" fmla="*/ 1849 w 6851"/>
              <a:gd name="T33" fmla="*/ 449 h 457"/>
              <a:gd name="T34" fmla="*/ 1959 w 6851"/>
              <a:gd name="T35" fmla="*/ 449 h 457"/>
              <a:gd name="T36" fmla="*/ 2068 w 6851"/>
              <a:gd name="T37" fmla="*/ 449 h 457"/>
              <a:gd name="T38" fmla="*/ 2178 w 6851"/>
              <a:gd name="T39" fmla="*/ 447 h 457"/>
              <a:gd name="T40" fmla="*/ 2287 w 6851"/>
              <a:gd name="T41" fmla="*/ 447 h 457"/>
              <a:gd name="T42" fmla="*/ 2397 w 6851"/>
              <a:gd name="T43" fmla="*/ 447 h 457"/>
              <a:gd name="T44" fmla="*/ 2508 w 6851"/>
              <a:gd name="T45" fmla="*/ 447 h 457"/>
              <a:gd name="T46" fmla="*/ 2617 w 6851"/>
              <a:gd name="T47" fmla="*/ 445 h 457"/>
              <a:gd name="T48" fmla="*/ 2727 w 6851"/>
              <a:gd name="T49" fmla="*/ 447 h 457"/>
              <a:gd name="T50" fmla="*/ 2836 w 6851"/>
              <a:gd name="T51" fmla="*/ 447 h 457"/>
              <a:gd name="T52" fmla="*/ 2946 w 6851"/>
              <a:gd name="T53" fmla="*/ 445 h 457"/>
              <a:gd name="T54" fmla="*/ 3055 w 6851"/>
              <a:gd name="T55" fmla="*/ 447 h 457"/>
              <a:gd name="T56" fmla="*/ 3165 w 6851"/>
              <a:gd name="T57" fmla="*/ 445 h 457"/>
              <a:gd name="T58" fmla="*/ 3274 w 6851"/>
              <a:gd name="T59" fmla="*/ 445 h 457"/>
              <a:gd name="T60" fmla="*/ 3384 w 6851"/>
              <a:gd name="T61" fmla="*/ 445 h 457"/>
              <a:gd name="T62" fmla="*/ 3493 w 6851"/>
              <a:gd name="T63" fmla="*/ 445 h 457"/>
              <a:gd name="T64" fmla="*/ 3602 w 6851"/>
              <a:gd name="T65" fmla="*/ 445 h 457"/>
              <a:gd name="T66" fmla="*/ 3712 w 6851"/>
              <a:gd name="T67" fmla="*/ 444 h 457"/>
              <a:gd name="T68" fmla="*/ 3821 w 6851"/>
              <a:gd name="T69" fmla="*/ 444 h 457"/>
              <a:gd name="T70" fmla="*/ 3931 w 6851"/>
              <a:gd name="T71" fmla="*/ 442 h 457"/>
              <a:gd name="T72" fmla="*/ 4042 w 6851"/>
              <a:gd name="T73" fmla="*/ 442 h 457"/>
              <a:gd name="T74" fmla="*/ 4152 w 6851"/>
              <a:gd name="T75" fmla="*/ 442 h 457"/>
              <a:gd name="T76" fmla="*/ 4261 w 6851"/>
              <a:gd name="T77" fmla="*/ 440 h 457"/>
              <a:gd name="T78" fmla="*/ 4371 w 6851"/>
              <a:gd name="T79" fmla="*/ 440 h 457"/>
              <a:gd name="T80" fmla="*/ 4480 w 6851"/>
              <a:gd name="T81" fmla="*/ 440 h 457"/>
              <a:gd name="T82" fmla="*/ 4589 w 6851"/>
              <a:gd name="T83" fmla="*/ 442 h 457"/>
              <a:gd name="T84" fmla="*/ 4699 w 6851"/>
              <a:gd name="T85" fmla="*/ 442 h 457"/>
              <a:gd name="T86" fmla="*/ 4808 w 6851"/>
              <a:gd name="T87" fmla="*/ 440 h 457"/>
              <a:gd name="T88" fmla="*/ 4918 w 6851"/>
              <a:gd name="T89" fmla="*/ 440 h 457"/>
              <a:gd name="T90" fmla="*/ 5027 w 6851"/>
              <a:gd name="T91" fmla="*/ 438 h 457"/>
              <a:gd name="T92" fmla="*/ 5137 w 6851"/>
              <a:gd name="T93" fmla="*/ 438 h 457"/>
              <a:gd name="T94" fmla="*/ 5246 w 6851"/>
              <a:gd name="T95" fmla="*/ 436 h 457"/>
              <a:gd name="T96" fmla="*/ 5356 w 6851"/>
              <a:gd name="T97" fmla="*/ 436 h 457"/>
              <a:gd name="T98" fmla="*/ 5465 w 6851"/>
              <a:gd name="T99" fmla="*/ 436 h 457"/>
              <a:gd name="T100" fmla="*/ 5576 w 6851"/>
              <a:gd name="T101" fmla="*/ 434 h 457"/>
              <a:gd name="T102" fmla="*/ 5686 w 6851"/>
              <a:gd name="T103" fmla="*/ 434 h 457"/>
              <a:gd name="T104" fmla="*/ 5795 w 6851"/>
              <a:gd name="T105" fmla="*/ 434 h 457"/>
              <a:gd name="T106" fmla="*/ 5905 w 6851"/>
              <a:gd name="T107" fmla="*/ 434 h 457"/>
              <a:gd name="T108" fmla="*/ 6014 w 6851"/>
              <a:gd name="T109" fmla="*/ 432 h 457"/>
              <a:gd name="T110" fmla="*/ 6124 w 6851"/>
              <a:gd name="T111" fmla="*/ 422 h 457"/>
              <a:gd name="T112" fmla="*/ 6233 w 6851"/>
              <a:gd name="T113" fmla="*/ 179 h 457"/>
              <a:gd name="T114" fmla="*/ 6342 w 6851"/>
              <a:gd name="T115" fmla="*/ 39 h 457"/>
              <a:gd name="T116" fmla="*/ 6452 w 6851"/>
              <a:gd name="T117" fmla="*/ 198 h 457"/>
              <a:gd name="T118" fmla="*/ 6561 w 6851"/>
              <a:gd name="T119" fmla="*/ 271 h 457"/>
              <a:gd name="T120" fmla="*/ 6671 w 6851"/>
              <a:gd name="T121" fmla="*/ 313 h 457"/>
              <a:gd name="T122" fmla="*/ 6780 w 6851"/>
              <a:gd name="T123" fmla="*/ 342 h 4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6851" h="457">
                <a:moveTo>
                  <a:pt x="0" y="457"/>
                </a:moveTo>
                <a:lnTo>
                  <a:pt x="4" y="457"/>
                </a:lnTo>
                <a:lnTo>
                  <a:pt x="14" y="457"/>
                </a:lnTo>
                <a:lnTo>
                  <a:pt x="23" y="455"/>
                </a:lnTo>
                <a:lnTo>
                  <a:pt x="33" y="455"/>
                </a:lnTo>
                <a:lnTo>
                  <a:pt x="41" y="455"/>
                </a:lnTo>
                <a:lnTo>
                  <a:pt x="50" y="453"/>
                </a:lnTo>
                <a:lnTo>
                  <a:pt x="60" y="453"/>
                </a:lnTo>
                <a:lnTo>
                  <a:pt x="69" y="453"/>
                </a:lnTo>
                <a:lnTo>
                  <a:pt x="77" y="451"/>
                </a:lnTo>
                <a:lnTo>
                  <a:pt x="87" y="451"/>
                </a:lnTo>
                <a:lnTo>
                  <a:pt x="96" y="451"/>
                </a:lnTo>
                <a:lnTo>
                  <a:pt x="106" y="451"/>
                </a:lnTo>
                <a:lnTo>
                  <a:pt x="114" y="451"/>
                </a:lnTo>
                <a:lnTo>
                  <a:pt x="123" y="449"/>
                </a:lnTo>
                <a:lnTo>
                  <a:pt x="133" y="449"/>
                </a:lnTo>
                <a:lnTo>
                  <a:pt x="142" y="449"/>
                </a:lnTo>
                <a:lnTo>
                  <a:pt x="150" y="449"/>
                </a:lnTo>
                <a:lnTo>
                  <a:pt x="160" y="449"/>
                </a:lnTo>
                <a:lnTo>
                  <a:pt x="169" y="447"/>
                </a:lnTo>
                <a:lnTo>
                  <a:pt x="179" y="447"/>
                </a:lnTo>
                <a:lnTo>
                  <a:pt x="187" y="447"/>
                </a:lnTo>
                <a:lnTo>
                  <a:pt x="196" y="447"/>
                </a:lnTo>
                <a:lnTo>
                  <a:pt x="206" y="447"/>
                </a:lnTo>
                <a:lnTo>
                  <a:pt x="215" y="447"/>
                </a:lnTo>
                <a:lnTo>
                  <a:pt x="225" y="447"/>
                </a:lnTo>
                <a:lnTo>
                  <a:pt x="233" y="447"/>
                </a:lnTo>
                <a:lnTo>
                  <a:pt x="242" y="447"/>
                </a:lnTo>
                <a:lnTo>
                  <a:pt x="252" y="447"/>
                </a:lnTo>
                <a:lnTo>
                  <a:pt x="261" y="447"/>
                </a:lnTo>
                <a:lnTo>
                  <a:pt x="269" y="445"/>
                </a:lnTo>
                <a:lnTo>
                  <a:pt x="279" y="445"/>
                </a:lnTo>
                <a:lnTo>
                  <a:pt x="288" y="445"/>
                </a:lnTo>
                <a:lnTo>
                  <a:pt x="298" y="445"/>
                </a:lnTo>
                <a:lnTo>
                  <a:pt x="306" y="445"/>
                </a:lnTo>
                <a:lnTo>
                  <a:pt x="315" y="445"/>
                </a:lnTo>
                <a:lnTo>
                  <a:pt x="325" y="445"/>
                </a:lnTo>
                <a:lnTo>
                  <a:pt x="334" y="445"/>
                </a:lnTo>
                <a:lnTo>
                  <a:pt x="342" y="445"/>
                </a:lnTo>
                <a:lnTo>
                  <a:pt x="352" y="445"/>
                </a:lnTo>
                <a:lnTo>
                  <a:pt x="361" y="445"/>
                </a:lnTo>
                <a:lnTo>
                  <a:pt x="371" y="445"/>
                </a:lnTo>
                <a:lnTo>
                  <a:pt x="379" y="445"/>
                </a:lnTo>
                <a:lnTo>
                  <a:pt x="388" y="445"/>
                </a:lnTo>
                <a:lnTo>
                  <a:pt x="398" y="445"/>
                </a:lnTo>
                <a:lnTo>
                  <a:pt x="407" y="445"/>
                </a:lnTo>
                <a:lnTo>
                  <a:pt x="415" y="445"/>
                </a:lnTo>
                <a:lnTo>
                  <a:pt x="425" y="445"/>
                </a:lnTo>
                <a:lnTo>
                  <a:pt x="434" y="445"/>
                </a:lnTo>
                <a:lnTo>
                  <a:pt x="444" y="445"/>
                </a:lnTo>
                <a:lnTo>
                  <a:pt x="452" y="445"/>
                </a:lnTo>
                <a:lnTo>
                  <a:pt x="461" y="445"/>
                </a:lnTo>
                <a:lnTo>
                  <a:pt x="471" y="445"/>
                </a:lnTo>
                <a:lnTo>
                  <a:pt x="480" y="445"/>
                </a:lnTo>
                <a:lnTo>
                  <a:pt x="488" y="445"/>
                </a:lnTo>
                <a:lnTo>
                  <a:pt x="498" y="445"/>
                </a:lnTo>
                <a:lnTo>
                  <a:pt x="507" y="445"/>
                </a:lnTo>
                <a:lnTo>
                  <a:pt x="517" y="445"/>
                </a:lnTo>
                <a:lnTo>
                  <a:pt x="525" y="445"/>
                </a:lnTo>
                <a:lnTo>
                  <a:pt x="534" y="445"/>
                </a:lnTo>
                <a:lnTo>
                  <a:pt x="544" y="445"/>
                </a:lnTo>
                <a:lnTo>
                  <a:pt x="553" y="445"/>
                </a:lnTo>
                <a:lnTo>
                  <a:pt x="561" y="445"/>
                </a:lnTo>
                <a:lnTo>
                  <a:pt x="571" y="445"/>
                </a:lnTo>
                <a:lnTo>
                  <a:pt x="580" y="447"/>
                </a:lnTo>
                <a:lnTo>
                  <a:pt x="590" y="447"/>
                </a:lnTo>
                <a:lnTo>
                  <a:pt x="599" y="447"/>
                </a:lnTo>
                <a:lnTo>
                  <a:pt x="607" y="447"/>
                </a:lnTo>
                <a:lnTo>
                  <a:pt x="617" y="447"/>
                </a:lnTo>
                <a:lnTo>
                  <a:pt x="626" y="447"/>
                </a:lnTo>
                <a:lnTo>
                  <a:pt x="636" y="447"/>
                </a:lnTo>
                <a:lnTo>
                  <a:pt x="644" y="447"/>
                </a:lnTo>
                <a:lnTo>
                  <a:pt x="653" y="447"/>
                </a:lnTo>
                <a:lnTo>
                  <a:pt x="663" y="447"/>
                </a:lnTo>
                <a:lnTo>
                  <a:pt x="672" y="447"/>
                </a:lnTo>
                <a:lnTo>
                  <a:pt x="680" y="447"/>
                </a:lnTo>
                <a:lnTo>
                  <a:pt x="690" y="447"/>
                </a:lnTo>
                <a:lnTo>
                  <a:pt x="699" y="447"/>
                </a:lnTo>
                <a:lnTo>
                  <a:pt x="709" y="447"/>
                </a:lnTo>
                <a:lnTo>
                  <a:pt x="717" y="447"/>
                </a:lnTo>
                <a:lnTo>
                  <a:pt x="726" y="447"/>
                </a:lnTo>
                <a:lnTo>
                  <a:pt x="736" y="447"/>
                </a:lnTo>
                <a:lnTo>
                  <a:pt x="745" y="447"/>
                </a:lnTo>
                <a:lnTo>
                  <a:pt x="753" y="447"/>
                </a:lnTo>
                <a:lnTo>
                  <a:pt x="763" y="447"/>
                </a:lnTo>
                <a:lnTo>
                  <a:pt x="772" y="447"/>
                </a:lnTo>
                <a:lnTo>
                  <a:pt x="782" y="447"/>
                </a:lnTo>
                <a:lnTo>
                  <a:pt x="789" y="447"/>
                </a:lnTo>
                <a:lnTo>
                  <a:pt x="799" y="447"/>
                </a:lnTo>
                <a:lnTo>
                  <a:pt x="809" y="447"/>
                </a:lnTo>
                <a:lnTo>
                  <a:pt x="818" y="447"/>
                </a:lnTo>
                <a:lnTo>
                  <a:pt x="826" y="447"/>
                </a:lnTo>
                <a:lnTo>
                  <a:pt x="836" y="447"/>
                </a:lnTo>
                <a:lnTo>
                  <a:pt x="845" y="447"/>
                </a:lnTo>
                <a:lnTo>
                  <a:pt x="855" y="447"/>
                </a:lnTo>
                <a:lnTo>
                  <a:pt x="862" y="447"/>
                </a:lnTo>
                <a:lnTo>
                  <a:pt x="872" y="447"/>
                </a:lnTo>
                <a:lnTo>
                  <a:pt x="882" y="447"/>
                </a:lnTo>
                <a:lnTo>
                  <a:pt x="891" y="447"/>
                </a:lnTo>
                <a:lnTo>
                  <a:pt x="899" y="447"/>
                </a:lnTo>
                <a:lnTo>
                  <a:pt x="909" y="447"/>
                </a:lnTo>
                <a:lnTo>
                  <a:pt x="918" y="447"/>
                </a:lnTo>
                <a:lnTo>
                  <a:pt x="928" y="447"/>
                </a:lnTo>
                <a:lnTo>
                  <a:pt x="935" y="447"/>
                </a:lnTo>
                <a:lnTo>
                  <a:pt x="945" y="447"/>
                </a:lnTo>
                <a:lnTo>
                  <a:pt x="955" y="447"/>
                </a:lnTo>
                <a:lnTo>
                  <a:pt x="964" y="447"/>
                </a:lnTo>
                <a:lnTo>
                  <a:pt x="974" y="447"/>
                </a:lnTo>
                <a:lnTo>
                  <a:pt x="981" y="447"/>
                </a:lnTo>
                <a:lnTo>
                  <a:pt x="991" y="447"/>
                </a:lnTo>
                <a:lnTo>
                  <a:pt x="1001" y="447"/>
                </a:lnTo>
                <a:lnTo>
                  <a:pt x="1010" y="447"/>
                </a:lnTo>
                <a:lnTo>
                  <a:pt x="1018" y="447"/>
                </a:lnTo>
                <a:lnTo>
                  <a:pt x="1028" y="447"/>
                </a:lnTo>
                <a:lnTo>
                  <a:pt x="1037" y="447"/>
                </a:lnTo>
                <a:lnTo>
                  <a:pt x="1047" y="447"/>
                </a:lnTo>
                <a:lnTo>
                  <a:pt x="1054" y="447"/>
                </a:lnTo>
                <a:lnTo>
                  <a:pt x="1064" y="447"/>
                </a:lnTo>
                <a:lnTo>
                  <a:pt x="1074" y="447"/>
                </a:lnTo>
                <a:lnTo>
                  <a:pt x="1083" y="447"/>
                </a:lnTo>
                <a:lnTo>
                  <a:pt x="1091" y="447"/>
                </a:lnTo>
                <a:lnTo>
                  <a:pt x="1101" y="447"/>
                </a:lnTo>
                <a:lnTo>
                  <a:pt x="1110" y="447"/>
                </a:lnTo>
                <a:lnTo>
                  <a:pt x="1120" y="447"/>
                </a:lnTo>
                <a:lnTo>
                  <a:pt x="1127" y="447"/>
                </a:lnTo>
                <a:lnTo>
                  <a:pt x="1137" y="447"/>
                </a:lnTo>
                <a:lnTo>
                  <a:pt x="1147" y="447"/>
                </a:lnTo>
                <a:lnTo>
                  <a:pt x="1156" y="447"/>
                </a:lnTo>
                <a:lnTo>
                  <a:pt x="1164" y="447"/>
                </a:lnTo>
                <a:lnTo>
                  <a:pt x="1174" y="447"/>
                </a:lnTo>
                <a:lnTo>
                  <a:pt x="1183" y="447"/>
                </a:lnTo>
                <a:lnTo>
                  <a:pt x="1193" y="447"/>
                </a:lnTo>
                <a:lnTo>
                  <a:pt x="1200" y="447"/>
                </a:lnTo>
                <a:lnTo>
                  <a:pt x="1210" y="447"/>
                </a:lnTo>
                <a:lnTo>
                  <a:pt x="1220" y="447"/>
                </a:lnTo>
                <a:lnTo>
                  <a:pt x="1229" y="449"/>
                </a:lnTo>
                <a:lnTo>
                  <a:pt x="1237" y="449"/>
                </a:lnTo>
                <a:lnTo>
                  <a:pt x="1246" y="449"/>
                </a:lnTo>
                <a:lnTo>
                  <a:pt x="1256" y="449"/>
                </a:lnTo>
                <a:lnTo>
                  <a:pt x="1266" y="449"/>
                </a:lnTo>
                <a:lnTo>
                  <a:pt x="1273" y="449"/>
                </a:lnTo>
                <a:lnTo>
                  <a:pt x="1283" y="449"/>
                </a:lnTo>
                <a:lnTo>
                  <a:pt x="1293" y="449"/>
                </a:lnTo>
                <a:lnTo>
                  <a:pt x="1302" y="449"/>
                </a:lnTo>
                <a:lnTo>
                  <a:pt x="1310" y="447"/>
                </a:lnTo>
                <a:lnTo>
                  <a:pt x="1319" y="449"/>
                </a:lnTo>
                <a:lnTo>
                  <a:pt x="1329" y="449"/>
                </a:lnTo>
                <a:lnTo>
                  <a:pt x="1339" y="447"/>
                </a:lnTo>
                <a:lnTo>
                  <a:pt x="1348" y="447"/>
                </a:lnTo>
                <a:lnTo>
                  <a:pt x="1356" y="449"/>
                </a:lnTo>
                <a:lnTo>
                  <a:pt x="1366" y="449"/>
                </a:lnTo>
                <a:lnTo>
                  <a:pt x="1375" y="449"/>
                </a:lnTo>
                <a:lnTo>
                  <a:pt x="1385" y="449"/>
                </a:lnTo>
                <a:lnTo>
                  <a:pt x="1392" y="449"/>
                </a:lnTo>
                <a:lnTo>
                  <a:pt x="1402" y="449"/>
                </a:lnTo>
                <a:lnTo>
                  <a:pt x="1412" y="449"/>
                </a:lnTo>
                <a:lnTo>
                  <a:pt x="1421" y="449"/>
                </a:lnTo>
                <a:lnTo>
                  <a:pt x="1429" y="449"/>
                </a:lnTo>
                <a:lnTo>
                  <a:pt x="1438" y="449"/>
                </a:lnTo>
                <a:lnTo>
                  <a:pt x="1448" y="449"/>
                </a:lnTo>
                <a:lnTo>
                  <a:pt x="1458" y="449"/>
                </a:lnTo>
                <a:lnTo>
                  <a:pt x="1465" y="449"/>
                </a:lnTo>
                <a:lnTo>
                  <a:pt x="1475" y="449"/>
                </a:lnTo>
                <a:lnTo>
                  <a:pt x="1485" y="449"/>
                </a:lnTo>
                <a:lnTo>
                  <a:pt x="1494" y="449"/>
                </a:lnTo>
                <a:lnTo>
                  <a:pt x="1502" y="449"/>
                </a:lnTo>
                <a:lnTo>
                  <a:pt x="1511" y="449"/>
                </a:lnTo>
                <a:lnTo>
                  <a:pt x="1521" y="449"/>
                </a:lnTo>
                <a:lnTo>
                  <a:pt x="1531" y="449"/>
                </a:lnTo>
                <a:lnTo>
                  <a:pt x="1538" y="449"/>
                </a:lnTo>
                <a:lnTo>
                  <a:pt x="1548" y="449"/>
                </a:lnTo>
                <a:lnTo>
                  <a:pt x="1558" y="449"/>
                </a:lnTo>
                <a:lnTo>
                  <a:pt x="1567" y="449"/>
                </a:lnTo>
                <a:lnTo>
                  <a:pt x="1575" y="449"/>
                </a:lnTo>
                <a:lnTo>
                  <a:pt x="1584" y="449"/>
                </a:lnTo>
                <a:lnTo>
                  <a:pt x="1594" y="449"/>
                </a:lnTo>
                <a:lnTo>
                  <a:pt x="1604" y="449"/>
                </a:lnTo>
                <a:lnTo>
                  <a:pt x="1611" y="449"/>
                </a:lnTo>
                <a:lnTo>
                  <a:pt x="1621" y="449"/>
                </a:lnTo>
                <a:lnTo>
                  <a:pt x="1630" y="449"/>
                </a:lnTo>
                <a:lnTo>
                  <a:pt x="1640" y="449"/>
                </a:lnTo>
                <a:lnTo>
                  <a:pt x="1648" y="449"/>
                </a:lnTo>
                <a:lnTo>
                  <a:pt x="1657" y="449"/>
                </a:lnTo>
                <a:lnTo>
                  <a:pt x="1667" y="449"/>
                </a:lnTo>
                <a:lnTo>
                  <a:pt x="1677" y="449"/>
                </a:lnTo>
                <a:lnTo>
                  <a:pt x="1684" y="449"/>
                </a:lnTo>
                <a:lnTo>
                  <a:pt x="1694" y="449"/>
                </a:lnTo>
                <a:lnTo>
                  <a:pt x="1703" y="449"/>
                </a:lnTo>
                <a:lnTo>
                  <a:pt x="1713" y="449"/>
                </a:lnTo>
                <a:lnTo>
                  <a:pt x="1723" y="449"/>
                </a:lnTo>
                <a:lnTo>
                  <a:pt x="1730" y="449"/>
                </a:lnTo>
                <a:lnTo>
                  <a:pt x="1740" y="449"/>
                </a:lnTo>
                <a:lnTo>
                  <a:pt x="1750" y="449"/>
                </a:lnTo>
                <a:lnTo>
                  <a:pt x="1759" y="449"/>
                </a:lnTo>
                <a:lnTo>
                  <a:pt x="1767" y="449"/>
                </a:lnTo>
                <a:lnTo>
                  <a:pt x="1776" y="449"/>
                </a:lnTo>
                <a:lnTo>
                  <a:pt x="1786" y="449"/>
                </a:lnTo>
                <a:lnTo>
                  <a:pt x="1796" y="449"/>
                </a:lnTo>
                <a:lnTo>
                  <a:pt x="1803" y="449"/>
                </a:lnTo>
                <a:lnTo>
                  <a:pt x="1813" y="449"/>
                </a:lnTo>
                <a:lnTo>
                  <a:pt x="1823" y="449"/>
                </a:lnTo>
                <a:lnTo>
                  <a:pt x="1832" y="449"/>
                </a:lnTo>
                <a:lnTo>
                  <a:pt x="1840" y="449"/>
                </a:lnTo>
                <a:lnTo>
                  <a:pt x="1849" y="449"/>
                </a:lnTo>
                <a:lnTo>
                  <a:pt x="1859" y="449"/>
                </a:lnTo>
                <a:lnTo>
                  <a:pt x="1869" y="449"/>
                </a:lnTo>
                <a:lnTo>
                  <a:pt x="1876" y="449"/>
                </a:lnTo>
                <a:lnTo>
                  <a:pt x="1886" y="449"/>
                </a:lnTo>
                <a:lnTo>
                  <a:pt x="1895" y="449"/>
                </a:lnTo>
                <a:lnTo>
                  <a:pt x="1905" y="449"/>
                </a:lnTo>
                <a:lnTo>
                  <a:pt x="1913" y="449"/>
                </a:lnTo>
                <a:lnTo>
                  <a:pt x="1922" y="449"/>
                </a:lnTo>
                <a:lnTo>
                  <a:pt x="1932" y="449"/>
                </a:lnTo>
                <a:lnTo>
                  <a:pt x="1942" y="449"/>
                </a:lnTo>
                <a:lnTo>
                  <a:pt x="1949" y="449"/>
                </a:lnTo>
                <a:lnTo>
                  <a:pt x="1959" y="449"/>
                </a:lnTo>
                <a:lnTo>
                  <a:pt x="1968" y="449"/>
                </a:lnTo>
                <a:lnTo>
                  <a:pt x="1978" y="449"/>
                </a:lnTo>
                <a:lnTo>
                  <a:pt x="1986" y="449"/>
                </a:lnTo>
                <a:lnTo>
                  <a:pt x="1995" y="449"/>
                </a:lnTo>
                <a:lnTo>
                  <a:pt x="2005" y="449"/>
                </a:lnTo>
                <a:lnTo>
                  <a:pt x="2015" y="449"/>
                </a:lnTo>
                <a:lnTo>
                  <a:pt x="2022" y="449"/>
                </a:lnTo>
                <a:lnTo>
                  <a:pt x="2032" y="449"/>
                </a:lnTo>
                <a:lnTo>
                  <a:pt x="2041" y="449"/>
                </a:lnTo>
                <a:lnTo>
                  <a:pt x="2051" y="449"/>
                </a:lnTo>
                <a:lnTo>
                  <a:pt x="2059" y="449"/>
                </a:lnTo>
                <a:lnTo>
                  <a:pt x="2068" y="449"/>
                </a:lnTo>
                <a:lnTo>
                  <a:pt x="2078" y="449"/>
                </a:lnTo>
                <a:lnTo>
                  <a:pt x="2087" y="449"/>
                </a:lnTo>
                <a:lnTo>
                  <a:pt x="2097" y="449"/>
                </a:lnTo>
                <a:lnTo>
                  <a:pt x="2105" y="449"/>
                </a:lnTo>
                <a:lnTo>
                  <a:pt x="2114" y="449"/>
                </a:lnTo>
                <a:lnTo>
                  <a:pt x="2124" y="447"/>
                </a:lnTo>
                <a:lnTo>
                  <a:pt x="2134" y="449"/>
                </a:lnTo>
                <a:lnTo>
                  <a:pt x="2141" y="447"/>
                </a:lnTo>
                <a:lnTo>
                  <a:pt x="2151" y="447"/>
                </a:lnTo>
                <a:lnTo>
                  <a:pt x="2160" y="447"/>
                </a:lnTo>
                <a:lnTo>
                  <a:pt x="2170" y="447"/>
                </a:lnTo>
                <a:lnTo>
                  <a:pt x="2178" y="447"/>
                </a:lnTo>
                <a:lnTo>
                  <a:pt x="2187" y="447"/>
                </a:lnTo>
                <a:lnTo>
                  <a:pt x="2197" y="447"/>
                </a:lnTo>
                <a:lnTo>
                  <a:pt x="2207" y="447"/>
                </a:lnTo>
                <a:lnTo>
                  <a:pt x="2214" y="447"/>
                </a:lnTo>
                <a:lnTo>
                  <a:pt x="2224" y="447"/>
                </a:lnTo>
                <a:lnTo>
                  <a:pt x="2233" y="447"/>
                </a:lnTo>
                <a:lnTo>
                  <a:pt x="2243" y="447"/>
                </a:lnTo>
                <a:lnTo>
                  <a:pt x="2251" y="447"/>
                </a:lnTo>
                <a:lnTo>
                  <a:pt x="2260" y="447"/>
                </a:lnTo>
                <a:lnTo>
                  <a:pt x="2270" y="447"/>
                </a:lnTo>
                <a:lnTo>
                  <a:pt x="2279" y="447"/>
                </a:lnTo>
                <a:lnTo>
                  <a:pt x="2287" y="447"/>
                </a:lnTo>
                <a:lnTo>
                  <a:pt x="2297" y="447"/>
                </a:lnTo>
                <a:lnTo>
                  <a:pt x="2306" y="447"/>
                </a:lnTo>
                <a:lnTo>
                  <a:pt x="2316" y="447"/>
                </a:lnTo>
                <a:lnTo>
                  <a:pt x="2324" y="447"/>
                </a:lnTo>
                <a:lnTo>
                  <a:pt x="2333" y="447"/>
                </a:lnTo>
                <a:lnTo>
                  <a:pt x="2343" y="447"/>
                </a:lnTo>
                <a:lnTo>
                  <a:pt x="2352" y="447"/>
                </a:lnTo>
                <a:lnTo>
                  <a:pt x="2360" y="447"/>
                </a:lnTo>
                <a:lnTo>
                  <a:pt x="2370" y="447"/>
                </a:lnTo>
                <a:lnTo>
                  <a:pt x="2379" y="447"/>
                </a:lnTo>
                <a:lnTo>
                  <a:pt x="2389" y="447"/>
                </a:lnTo>
                <a:lnTo>
                  <a:pt x="2397" y="447"/>
                </a:lnTo>
                <a:lnTo>
                  <a:pt x="2406" y="447"/>
                </a:lnTo>
                <a:lnTo>
                  <a:pt x="2416" y="447"/>
                </a:lnTo>
                <a:lnTo>
                  <a:pt x="2425" y="447"/>
                </a:lnTo>
                <a:lnTo>
                  <a:pt x="2433" y="447"/>
                </a:lnTo>
                <a:lnTo>
                  <a:pt x="2443" y="447"/>
                </a:lnTo>
                <a:lnTo>
                  <a:pt x="2452" y="447"/>
                </a:lnTo>
                <a:lnTo>
                  <a:pt x="2462" y="447"/>
                </a:lnTo>
                <a:lnTo>
                  <a:pt x="2470" y="447"/>
                </a:lnTo>
                <a:lnTo>
                  <a:pt x="2479" y="447"/>
                </a:lnTo>
                <a:lnTo>
                  <a:pt x="2489" y="447"/>
                </a:lnTo>
                <a:lnTo>
                  <a:pt x="2498" y="447"/>
                </a:lnTo>
                <a:lnTo>
                  <a:pt x="2508" y="447"/>
                </a:lnTo>
                <a:lnTo>
                  <a:pt x="2516" y="447"/>
                </a:lnTo>
                <a:lnTo>
                  <a:pt x="2525" y="447"/>
                </a:lnTo>
                <a:lnTo>
                  <a:pt x="2535" y="447"/>
                </a:lnTo>
                <a:lnTo>
                  <a:pt x="2544" y="447"/>
                </a:lnTo>
                <a:lnTo>
                  <a:pt x="2552" y="447"/>
                </a:lnTo>
                <a:lnTo>
                  <a:pt x="2562" y="447"/>
                </a:lnTo>
                <a:lnTo>
                  <a:pt x="2571" y="447"/>
                </a:lnTo>
                <a:lnTo>
                  <a:pt x="2581" y="447"/>
                </a:lnTo>
                <a:lnTo>
                  <a:pt x="2589" y="445"/>
                </a:lnTo>
                <a:lnTo>
                  <a:pt x="2598" y="445"/>
                </a:lnTo>
                <a:lnTo>
                  <a:pt x="2608" y="445"/>
                </a:lnTo>
                <a:lnTo>
                  <a:pt x="2617" y="445"/>
                </a:lnTo>
                <a:lnTo>
                  <a:pt x="2625" y="445"/>
                </a:lnTo>
                <a:lnTo>
                  <a:pt x="2635" y="445"/>
                </a:lnTo>
                <a:lnTo>
                  <a:pt x="2644" y="445"/>
                </a:lnTo>
                <a:lnTo>
                  <a:pt x="2654" y="445"/>
                </a:lnTo>
                <a:lnTo>
                  <a:pt x="2662" y="445"/>
                </a:lnTo>
                <a:lnTo>
                  <a:pt x="2671" y="445"/>
                </a:lnTo>
                <a:lnTo>
                  <a:pt x="2681" y="447"/>
                </a:lnTo>
                <a:lnTo>
                  <a:pt x="2690" y="447"/>
                </a:lnTo>
                <a:lnTo>
                  <a:pt x="2698" y="447"/>
                </a:lnTo>
                <a:lnTo>
                  <a:pt x="2708" y="447"/>
                </a:lnTo>
                <a:lnTo>
                  <a:pt x="2717" y="447"/>
                </a:lnTo>
                <a:lnTo>
                  <a:pt x="2727" y="447"/>
                </a:lnTo>
                <a:lnTo>
                  <a:pt x="2735" y="447"/>
                </a:lnTo>
                <a:lnTo>
                  <a:pt x="2744" y="447"/>
                </a:lnTo>
                <a:lnTo>
                  <a:pt x="2754" y="447"/>
                </a:lnTo>
                <a:lnTo>
                  <a:pt x="2763" y="447"/>
                </a:lnTo>
                <a:lnTo>
                  <a:pt x="2771" y="447"/>
                </a:lnTo>
                <a:lnTo>
                  <a:pt x="2781" y="447"/>
                </a:lnTo>
                <a:lnTo>
                  <a:pt x="2790" y="447"/>
                </a:lnTo>
                <a:lnTo>
                  <a:pt x="2800" y="447"/>
                </a:lnTo>
                <a:lnTo>
                  <a:pt x="2808" y="447"/>
                </a:lnTo>
                <a:lnTo>
                  <a:pt x="2817" y="447"/>
                </a:lnTo>
                <a:lnTo>
                  <a:pt x="2827" y="447"/>
                </a:lnTo>
                <a:lnTo>
                  <a:pt x="2836" y="447"/>
                </a:lnTo>
                <a:lnTo>
                  <a:pt x="2844" y="447"/>
                </a:lnTo>
                <a:lnTo>
                  <a:pt x="2854" y="447"/>
                </a:lnTo>
                <a:lnTo>
                  <a:pt x="2863" y="447"/>
                </a:lnTo>
                <a:lnTo>
                  <a:pt x="2873" y="447"/>
                </a:lnTo>
                <a:lnTo>
                  <a:pt x="2882" y="447"/>
                </a:lnTo>
                <a:lnTo>
                  <a:pt x="2890" y="447"/>
                </a:lnTo>
                <a:lnTo>
                  <a:pt x="2900" y="445"/>
                </a:lnTo>
                <a:lnTo>
                  <a:pt x="2909" y="445"/>
                </a:lnTo>
                <a:lnTo>
                  <a:pt x="2919" y="445"/>
                </a:lnTo>
                <a:lnTo>
                  <a:pt x="2927" y="445"/>
                </a:lnTo>
                <a:lnTo>
                  <a:pt x="2936" y="445"/>
                </a:lnTo>
                <a:lnTo>
                  <a:pt x="2946" y="445"/>
                </a:lnTo>
                <a:lnTo>
                  <a:pt x="2955" y="445"/>
                </a:lnTo>
                <a:lnTo>
                  <a:pt x="2963" y="447"/>
                </a:lnTo>
                <a:lnTo>
                  <a:pt x="2973" y="447"/>
                </a:lnTo>
                <a:lnTo>
                  <a:pt x="2982" y="447"/>
                </a:lnTo>
                <a:lnTo>
                  <a:pt x="2992" y="447"/>
                </a:lnTo>
                <a:lnTo>
                  <a:pt x="3000" y="447"/>
                </a:lnTo>
                <a:lnTo>
                  <a:pt x="3009" y="447"/>
                </a:lnTo>
                <a:lnTo>
                  <a:pt x="3019" y="447"/>
                </a:lnTo>
                <a:lnTo>
                  <a:pt x="3028" y="447"/>
                </a:lnTo>
                <a:lnTo>
                  <a:pt x="3036" y="447"/>
                </a:lnTo>
                <a:lnTo>
                  <a:pt x="3046" y="447"/>
                </a:lnTo>
                <a:lnTo>
                  <a:pt x="3055" y="447"/>
                </a:lnTo>
                <a:lnTo>
                  <a:pt x="3065" y="447"/>
                </a:lnTo>
                <a:lnTo>
                  <a:pt x="3073" y="447"/>
                </a:lnTo>
                <a:lnTo>
                  <a:pt x="3082" y="447"/>
                </a:lnTo>
                <a:lnTo>
                  <a:pt x="3092" y="447"/>
                </a:lnTo>
                <a:lnTo>
                  <a:pt x="3101" y="447"/>
                </a:lnTo>
                <a:lnTo>
                  <a:pt x="3109" y="447"/>
                </a:lnTo>
                <a:lnTo>
                  <a:pt x="3119" y="447"/>
                </a:lnTo>
                <a:lnTo>
                  <a:pt x="3128" y="447"/>
                </a:lnTo>
                <a:lnTo>
                  <a:pt x="3138" y="447"/>
                </a:lnTo>
                <a:lnTo>
                  <a:pt x="3145" y="447"/>
                </a:lnTo>
                <a:lnTo>
                  <a:pt x="3155" y="445"/>
                </a:lnTo>
                <a:lnTo>
                  <a:pt x="3165" y="445"/>
                </a:lnTo>
                <a:lnTo>
                  <a:pt x="3174" y="445"/>
                </a:lnTo>
                <a:lnTo>
                  <a:pt x="3182" y="445"/>
                </a:lnTo>
                <a:lnTo>
                  <a:pt x="3192" y="445"/>
                </a:lnTo>
                <a:lnTo>
                  <a:pt x="3201" y="445"/>
                </a:lnTo>
                <a:lnTo>
                  <a:pt x="3211" y="445"/>
                </a:lnTo>
                <a:lnTo>
                  <a:pt x="3218" y="445"/>
                </a:lnTo>
                <a:lnTo>
                  <a:pt x="3228" y="445"/>
                </a:lnTo>
                <a:lnTo>
                  <a:pt x="3238" y="445"/>
                </a:lnTo>
                <a:lnTo>
                  <a:pt x="3247" y="445"/>
                </a:lnTo>
                <a:lnTo>
                  <a:pt x="3257" y="445"/>
                </a:lnTo>
                <a:lnTo>
                  <a:pt x="3265" y="445"/>
                </a:lnTo>
                <a:lnTo>
                  <a:pt x="3274" y="445"/>
                </a:lnTo>
                <a:lnTo>
                  <a:pt x="3284" y="445"/>
                </a:lnTo>
                <a:lnTo>
                  <a:pt x="3293" y="445"/>
                </a:lnTo>
                <a:lnTo>
                  <a:pt x="3301" y="445"/>
                </a:lnTo>
                <a:lnTo>
                  <a:pt x="3311" y="445"/>
                </a:lnTo>
                <a:lnTo>
                  <a:pt x="3320" y="445"/>
                </a:lnTo>
                <a:lnTo>
                  <a:pt x="3330" y="445"/>
                </a:lnTo>
                <a:lnTo>
                  <a:pt x="3337" y="445"/>
                </a:lnTo>
                <a:lnTo>
                  <a:pt x="3347" y="445"/>
                </a:lnTo>
                <a:lnTo>
                  <a:pt x="3357" y="445"/>
                </a:lnTo>
                <a:lnTo>
                  <a:pt x="3366" y="445"/>
                </a:lnTo>
                <a:lnTo>
                  <a:pt x="3374" y="445"/>
                </a:lnTo>
                <a:lnTo>
                  <a:pt x="3384" y="445"/>
                </a:lnTo>
                <a:lnTo>
                  <a:pt x="3393" y="445"/>
                </a:lnTo>
                <a:lnTo>
                  <a:pt x="3403" y="445"/>
                </a:lnTo>
                <a:lnTo>
                  <a:pt x="3410" y="445"/>
                </a:lnTo>
                <a:lnTo>
                  <a:pt x="3420" y="445"/>
                </a:lnTo>
                <a:lnTo>
                  <a:pt x="3430" y="445"/>
                </a:lnTo>
                <a:lnTo>
                  <a:pt x="3439" y="445"/>
                </a:lnTo>
                <a:lnTo>
                  <a:pt x="3447" y="445"/>
                </a:lnTo>
                <a:lnTo>
                  <a:pt x="3457" y="445"/>
                </a:lnTo>
                <a:lnTo>
                  <a:pt x="3466" y="445"/>
                </a:lnTo>
                <a:lnTo>
                  <a:pt x="3476" y="445"/>
                </a:lnTo>
                <a:lnTo>
                  <a:pt x="3483" y="445"/>
                </a:lnTo>
                <a:lnTo>
                  <a:pt x="3493" y="445"/>
                </a:lnTo>
                <a:lnTo>
                  <a:pt x="3503" y="445"/>
                </a:lnTo>
                <a:lnTo>
                  <a:pt x="3512" y="445"/>
                </a:lnTo>
                <a:lnTo>
                  <a:pt x="3520" y="445"/>
                </a:lnTo>
                <a:lnTo>
                  <a:pt x="3529" y="445"/>
                </a:lnTo>
                <a:lnTo>
                  <a:pt x="3539" y="445"/>
                </a:lnTo>
                <a:lnTo>
                  <a:pt x="3549" y="445"/>
                </a:lnTo>
                <a:lnTo>
                  <a:pt x="3556" y="445"/>
                </a:lnTo>
                <a:lnTo>
                  <a:pt x="3566" y="445"/>
                </a:lnTo>
                <a:lnTo>
                  <a:pt x="3576" y="445"/>
                </a:lnTo>
                <a:lnTo>
                  <a:pt x="3585" y="445"/>
                </a:lnTo>
                <a:lnTo>
                  <a:pt x="3593" y="445"/>
                </a:lnTo>
                <a:lnTo>
                  <a:pt x="3602" y="445"/>
                </a:lnTo>
                <a:lnTo>
                  <a:pt x="3612" y="444"/>
                </a:lnTo>
                <a:lnTo>
                  <a:pt x="3622" y="444"/>
                </a:lnTo>
                <a:lnTo>
                  <a:pt x="3631" y="444"/>
                </a:lnTo>
                <a:lnTo>
                  <a:pt x="3639" y="444"/>
                </a:lnTo>
                <a:lnTo>
                  <a:pt x="3649" y="444"/>
                </a:lnTo>
                <a:lnTo>
                  <a:pt x="3658" y="444"/>
                </a:lnTo>
                <a:lnTo>
                  <a:pt x="3668" y="444"/>
                </a:lnTo>
                <a:lnTo>
                  <a:pt x="3675" y="444"/>
                </a:lnTo>
                <a:lnTo>
                  <a:pt x="3685" y="444"/>
                </a:lnTo>
                <a:lnTo>
                  <a:pt x="3695" y="444"/>
                </a:lnTo>
                <a:lnTo>
                  <a:pt x="3704" y="444"/>
                </a:lnTo>
                <a:lnTo>
                  <a:pt x="3712" y="444"/>
                </a:lnTo>
                <a:lnTo>
                  <a:pt x="3722" y="444"/>
                </a:lnTo>
                <a:lnTo>
                  <a:pt x="3731" y="444"/>
                </a:lnTo>
                <a:lnTo>
                  <a:pt x="3741" y="444"/>
                </a:lnTo>
                <a:lnTo>
                  <a:pt x="3748" y="444"/>
                </a:lnTo>
                <a:lnTo>
                  <a:pt x="3758" y="444"/>
                </a:lnTo>
                <a:lnTo>
                  <a:pt x="3768" y="444"/>
                </a:lnTo>
                <a:lnTo>
                  <a:pt x="3777" y="444"/>
                </a:lnTo>
                <a:lnTo>
                  <a:pt x="3785" y="444"/>
                </a:lnTo>
                <a:lnTo>
                  <a:pt x="3794" y="444"/>
                </a:lnTo>
                <a:lnTo>
                  <a:pt x="3804" y="444"/>
                </a:lnTo>
                <a:lnTo>
                  <a:pt x="3814" y="444"/>
                </a:lnTo>
                <a:lnTo>
                  <a:pt x="3821" y="444"/>
                </a:lnTo>
                <a:lnTo>
                  <a:pt x="3831" y="444"/>
                </a:lnTo>
                <a:lnTo>
                  <a:pt x="3841" y="444"/>
                </a:lnTo>
                <a:lnTo>
                  <a:pt x="3850" y="444"/>
                </a:lnTo>
                <a:lnTo>
                  <a:pt x="3858" y="444"/>
                </a:lnTo>
                <a:lnTo>
                  <a:pt x="3867" y="444"/>
                </a:lnTo>
                <a:lnTo>
                  <a:pt x="3877" y="442"/>
                </a:lnTo>
                <a:lnTo>
                  <a:pt x="3887" y="442"/>
                </a:lnTo>
                <a:lnTo>
                  <a:pt x="3894" y="442"/>
                </a:lnTo>
                <a:lnTo>
                  <a:pt x="3904" y="442"/>
                </a:lnTo>
                <a:lnTo>
                  <a:pt x="3914" y="442"/>
                </a:lnTo>
                <a:lnTo>
                  <a:pt x="3923" y="442"/>
                </a:lnTo>
                <a:lnTo>
                  <a:pt x="3931" y="442"/>
                </a:lnTo>
                <a:lnTo>
                  <a:pt x="3940" y="440"/>
                </a:lnTo>
                <a:lnTo>
                  <a:pt x="3950" y="440"/>
                </a:lnTo>
                <a:lnTo>
                  <a:pt x="3960" y="440"/>
                </a:lnTo>
                <a:lnTo>
                  <a:pt x="3967" y="440"/>
                </a:lnTo>
                <a:lnTo>
                  <a:pt x="3977" y="440"/>
                </a:lnTo>
                <a:lnTo>
                  <a:pt x="3986" y="440"/>
                </a:lnTo>
                <a:lnTo>
                  <a:pt x="3996" y="440"/>
                </a:lnTo>
                <a:lnTo>
                  <a:pt x="4006" y="440"/>
                </a:lnTo>
                <a:lnTo>
                  <a:pt x="4013" y="440"/>
                </a:lnTo>
                <a:lnTo>
                  <a:pt x="4023" y="442"/>
                </a:lnTo>
                <a:lnTo>
                  <a:pt x="4033" y="442"/>
                </a:lnTo>
                <a:lnTo>
                  <a:pt x="4042" y="442"/>
                </a:lnTo>
                <a:lnTo>
                  <a:pt x="4050" y="442"/>
                </a:lnTo>
                <a:lnTo>
                  <a:pt x="4059" y="442"/>
                </a:lnTo>
                <a:lnTo>
                  <a:pt x="4069" y="442"/>
                </a:lnTo>
                <a:lnTo>
                  <a:pt x="4079" y="442"/>
                </a:lnTo>
                <a:lnTo>
                  <a:pt x="4086" y="442"/>
                </a:lnTo>
                <a:lnTo>
                  <a:pt x="4096" y="442"/>
                </a:lnTo>
                <a:lnTo>
                  <a:pt x="4106" y="442"/>
                </a:lnTo>
                <a:lnTo>
                  <a:pt x="4115" y="442"/>
                </a:lnTo>
                <a:lnTo>
                  <a:pt x="4123" y="442"/>
                </a:lnTo>
                <a:lnTo>
                  <a:pt x="4132" y="442"/>
                </a:lnTo>
                <a:lnTo>
                  <a:pt x="4142" y="442"/>
                </a:lnTo>
                <a:lnTo>
                  <a:pt x="4152" y="442"/>
                </a:lnTo>
                <a:lnTo>
                  <a:pt x="4159" y="442"/>
                </a:lnTo>
                <a:lnTo>
                  <a:pt x="4169" y="442"/>
                </a:lnTo>
                <a:lnTo>
                  <a:pt x="4178" y="442"/>
                </a:lnTo>
                <a:lnTo>
                  <a:pt x="4188" y="442"/>
                </a:lnTo>
                <a:lnTo>
                  <a:pt x="4196" y="442"/>
                </a:lnTo>
                <a:lnTo>
                  <a:pt x="4205" y="442"/>
                </a:lnTo>
                <a:lnTo>
                  <a:pt x="4215" y="442"/>
                </a:lnTo>
                <a:lnTo>
                  <a:pt x="4225" y="442"/>
                </a:lnTo>
                <a:lnTo>
                  <a:pt x="4232" y="440"/>
                </a:lnTo>
                <a:lnTo>
                  <a:pt x="4242" y="440"/>
                </a:lnTo>
                <a:lnTo>
                  <a:pt x="4251" y="440"/>
                </a:lnTo>
                <a:lnTo>
                  <a:pt x="4261" y="440"/>
                </a:lnTo>
                <a:lnTo>
                  <a:pt x="4269" y="440"/>
                </a:lnTo>
                <a:lnTo>
                  <a:pt x="4278" y="440"/>
                </a:lnTo>
                <a:lnTo>
                  <a:pt x="4288" y="440"/>
                </a:lnTo>
                <a:lnTo>
                  <a:pt x="4298" y="440"/>
                </a:lnTo>
                <a:lnTo>
                  <a:pt x="4305" y="440"/>
                </a:lnTo>
                <a:lnTo>
                  <a:pt x="4315" y="440"/>
                </a:lnTo>
                <a:lnTo>
                  <a:pt x="4324" y="440"/>
                </a:lnTo>
                <a:lnTo>
                  <a:pt x="4334" y="440"/>
                </a:lnTo>
                <a:lnTo>
                  <a:pt x="4342" y="440"/>
                </a:lnTo>
                <a:lnTo>
                  <a:pt x="4351" y="440"/>
                </a:lnTo>
                <a:lnTo>
                  <a:pt x="4361" y="440"/>
                </a:lnTo>
                <a:lnTo>
                  <a:pt x="4371" y="440"/>
                </a:lnTo>
                <a:lnTo>
                  <a:pt x="4380" y="440"/>
                </a:lnTo>
                <a:lnTo>
                  <a:pt x="4388" y="440"/>
                </a:lnTo>
                <a:lnTo>
                  <a:pt x="4397" y="440"/>
                </a:lnTo>
                <a:lnTo>
                  <a:pt x="4407" y="440"/>
                </a:lnTo>
                <a:lnTo>
                  <a:pt x="4417" y="440"/>
                </a:lnTo>
                <a:lnTo>
                  <a:pt x="4424" y="440"/>
                </a:lnTo>
                <a:lnTo>
                  <a:pt x="4434" y="440"/>
                </a:lnTo>
                <a:lnTo>
                  <a:pt x="4443" y="440"/>
                </a:lnTo>
                <a:lnTo>
                  <a:pt x="4453" y="440"/>
                </a:lnTo>
                <a:lnTo>
                  <a:pt x="4461" y="440"/>
                </a:lnTo>
                <a:lnTo>
                  <a:pt x="4470" y="440"/>
                </a:lnTo>
                <a:lnTo>
                  <a:pt x="4480" y="440"/>
                </a:lnTo>
                <a:lnTo>
                  <a:pt x="4490" y="440"/>
                </a:lnTo>
                <a:lnTo>
                  <a:pt x="4497" y="440"/>
                </a:lnTo>
                <a:lnTo>
                  <a:pt x="4507" y="440"/>
                </a:lnTo>
                <a:lnTo>
                  <a:pt x="4516" y="440"/>
                </a:lnTo>
                <a:lnTo>
                  <a:pt x="4526" y="440"/>
                </a:lnTo>
                <a:lnTo>
                  <a:pt x="4534" y="440"/>
                </a:lnTo>
                <a:lnTo>
                  <a:pt x="4543" y="440"/>
                </a:lnTo>
                <a:lnTo>
                  <a:pt x="4553" y="442"/>
                </a:lnTo>
                <a:lnTo>
                  <a:pt x="4563" y="442"/>
                </a:lnTo>
                <a:lnTo>
                  <a:pt x="4570" y="442"/>
                </a:lnTo>
                <a:lnTo>
                  <a:pt x="4580" y="442"/>
                </a:lnTo>
                <a:lnTo>
                  <a:pt x="4589" y="442"/>
                </a:lnTo>
                <a:lnTo>
                  <a:pt x="4599" y="442"/>
                </a:lnTo>
                <a:lnTo>
                  <a:pt x="4607" y="442"/>
                </a:lnTo>
                <a:lnTo>
                  <a:pt x="4616" y="442"/>
                </a:lnTo>
                <a:lnTo>
                  <a:pt x="4626" y="442"/>
                </a:lnTo>
                <a:lnTo>
                  <a:pt x="4635" y="442"/>
                </a:lnTo>
                <a:lnTo>
                  <a:pt x="4643" y="442"/>
                </a:lnTo>
                <a:lnTo>
                  <a:pt x="4653" y="442"/>
                </a:lnTo>
                <a:lnTo>
                  <a:pt x="4662" y="442"/>
                </a:lnTo>
                <a:lnTo>
                  <a:pt x="4672" y="442"/>
                </a:lnTo>
                <a:lnTo>
                  <a:pt x="4680" y="442"/>
                </a:lnTo>
                <a:lnTo>
                  <a:pt x="4689" y="442"/>
                </a:lnTo>
                <a:lnTo>
                  <a:pt x="4699" y="442"/>
                </a:lnTo>
                <a:lnTo>
                  <a:pt x="4708" y="442"/>
                </a:lnTo>
                <a:lnTo>
                  <a:pt x="4716" y="442"/>
                </a:lnTo>
                <a:lnTo>
                  <a:pt x="4726" y="442"/>
                </a:lnTo>
                <a:lnTo>
                  <a:pt x="4735" y="442"/>
                </a:lnTo>
                <a:lnTo>
                  <a:pt x="4745" y="442"/>
                </a:lnTo>
                <a:lnTo>
                  <a:pt x="4753" y="442"/>
                </a:lnTo>
                <a:lnTo>
                  <a:pt x="4762" y="442"/>
                </a:lnTo>
                <a:lnTo>
                  <a:pt x="4772" y="442"/>
                </a:lnTo>
                <a:lnTo>
                  <a:pt x="4781" y="440"/>
                </a:lnTo>
                <a:lnTo>
                  <a:pt x="4791" y="440"/>
                </a:lnTo>
                <a:lnTo>
                  <a:pt x="4799" y="440"/>
                </a:lnTo>
                <a:lnTo>
                  <a:pt x="4808" y="440"/>
                </a:lnTo>
                <a:lnTo>
                  <a:pt x="4818" y="440"/>
                </a:lnTo>
                <a:lnTo>
                  <a:pt x="4827" y="440"/>
                </a:lnTo>
                <a:lnTo>
                  <a:pt x="4835" y="440"/>
                </a:lnTo>
                <a:lnTo>
                  <a:pt x="4845" y="440"/>
                </a:lnTo>
                <a:lnTo>
                  <a:pt x="4854" y="440"/>
                </a:lnTo>
                <a:lnTo>
                  <a:pt x="4864" y="440"/>
                </a:lnTo>
                <a:lnTo>
                  <a:pt x="4872" y="440"/>
                </a:lnTo>
                <a:lnTo>
                  <a:pt x="4881" y="440"/>
                </a:lnTo>
                <a:lnTo>
                  <a:pt x="4891" y="440"/>
                </a:lnTo>
                <a:lnTo>
                  <a:pt x="4900" y="440"/>
                </a:lnTo>
                <a:lnTo>
                  <a:pt x="4908" y="440"/>
                </a:lnTo>
                <a:lnTo>
                  <a:pt x="4918" y="440"/>
                </a:lnTo>
                <a:lnTo>
                  <a:pt x="4927" y="438"/>
                </a:lnTo>
                <a:lnTo>
                  <a:pt x="4937" y="438"/>
                </a:lnTo>
                <a:lnTo>
                  <a:pt x="4945" y="438"/>
                </a:lnTo>
                <a:lnTo>
                  <a:pt x="4954" y="438"/>
                </a:lnTo>
                <a:lnTo>
                  <a:pt x="4964" y="438"/>
                </a:lnTo>
                <a:lnTo>
                  <a:pt x="4973" y="438"/>
                </a:lnTo>
                <a:lnTo>
                  <a:pt x="4981" y="438"/>
                </a:lnTo>
                <a:lnTo>
                  <a:pt x="4991" y="438"/>
                </a:lnTo>
                <a:lnTo>
                  <a:pt x="5000" y="438"/>
                </a:lnTo>
                <a:lnTo>
                  <a:pt x="5010" y="438"/>
                </a:lnTo>
                <a:lnTo>
                  <a:pt x="5018" y="438"/>
                </a:lnTo>
                <a:lnTo>
                  <a:pt x="5027" y="438"/>
                </a:lnTo>
                <a:lnTo>
                  <a:pt x="5037" y="438"/>
                </a:lnTo>
                <a:lnTo>
                  <a:pt x="5046" y="438"/>
                </a:lnTo>
                <a:lnTo>
                  <a:pt x="5054" y="438"/>
                </a:lnTo>
                <a:lnTo>
                  <a:pt x="5064" y="438"/>
                </a:lnTo>
                <a:lnTo>
                  <a:pt x="5073" y="438"/>
                </a:lnTo>
                <a:lnTo>
                  <a:pt x="5083" y="438"/>
                </a:lnTo>
                <a:lnTo>
                  <a:pt x="5091" y="438"/>
                </a:lnTo>
                <a:lnTo>
                  <a:pt x="5100" y="438"/>
                </a:lnTo>
                <a:lnTo>
                  <a:pt x="5110" y="438"/>
                </a:lnTo>
                <a:lnTo>
                  <a:pt x="5119" y="438"/>
                </a:lnTo>
                <a:lnTo>
                  <a:pt x="5127" y="438"/>
                </a:lnTo>
                <a:lnTo>
                  <a:pt x="5137" y="438"/>
                </a:lnTo>
                <a:lnTo>
                  <a:pt x="5146" y="438"/>
                </a:lnTo>
                <a:lnTo>
                  <a:pt x="5156" y="438"/>
                </a:lnTo>
                <a:lnTo>
                  <a:pt x="5165" y="438"/>
                </a:lnTo>
                <a:lnTo>
                  <a:pt x="5173" y="436"/>
                </a:lnTo>
                <a:lnTo>
                  <a:pt x="5183" y="436"/>
                </a:lnTo>
                <a:lnTo>
                  <a:pt x="5192" y="436"/>
                </a:lnTo>
                <a:lnTo>
                  <a:pt x="5202" y="436"/>
                </a:lnTo>
                <a:lnTo>
                  <a:pt x="5210" y="436"/>
                </a:lnTo>
                <a:lnTo>
                  <a:pt x="5219" y="436"/>
                </a:lnTo>
                <a:lnTo>
                  <a:pt x="5229" y="436"/>
                </a:lnTo>
                <a:lnTo>
                  <a:pt x="5238" y="436"/>
                </a:lnTo>
                <a:lnTo>
                  <a:pt x="5246" y="436"/>
                </a:lnTo>
                <a:lnTo>
                  <a:pt x="5256" y="436"/>
                </a:lnTo>
                <a:lnTo>
                  <a:pt x="5265" y="436"/>
                </a:lnTo>
                <a:lnTo>
                  <a:pt x="5275" y="436"/>
                </a:lnTo>
                <a:lnTo>
                  <a:pt x="5283" y="436"/>
                </a:lnTo>
                <a:lnTo>
                  <a:pt x="5292" y="436"/>
                </a:lnTo>
                <a:lnTo>
                  <a:pt x="5302" y="436"/>
                </a:lnTo>
                <a:lnTo>
                  <a:pt x="5311" y="436"/>
                </a:lnTo>
                <a:lnTo>
                  <a:pt x="5319" y="436"/>
                </a:lnTo>
                <a:lnTo>
                  <a:pt x="5329" y="436"/>
                </a:lnTo>
                <a:lnTo>
                  <a:pt x="5338" y="436"/>
                </a:lnTo>
                <a:lnTo>
                  <a:pt x="5348" y="436"/>
                </a:lnTo>
                <a:lnTo>
                  <a:pt x="5356" y="436"/>
                </a:lnTo>
                <a:lnTo>
                  <a:pt x="5365" y="436"/>
                </a:lnTo>
                <a:lnTo>
                  <a:pt x="5375" y="436"/>
                </a:lnTo>
                <a:lnTo>
                  <a:pt x="5384" y="436"/>
                </a:lnTo>
                <a:lnTo>
                  <a:pt x="5392" y="436"/>
                </a:lnTo>
                <a:lnTo>
                  <a:pt x="5402" y="436"/>
                </a:lnTo>
                <a:lnTo>
                  <a:pt x="5411" y="436"/>
                </a:lnTo>
                <a:lnTo>
                  <a:pt x="5421" y="436"/>
                </a:lnTo>
                <a:lnTo>
                  <a:pt x="5428" y="436"/>
                </a:lnTo>
                <a:lnTo>
                  <a:pt x="5438" y="436"/>
                </a:lnTo>
                <a:lnTo>
                  <a:pt x="5448" y="436"/>
                </a:lnTo>
                <a:lnTo>
                  <a:pt x="5457" y="436"/>
                </a:lnTo>
                <a:lnTo>
                  <a:pt x="5465" y="436"/>
                </a:lnTo>
                <a:lnTo>
                  <a:pt x="5475" y="434"/>
                </a:lnTo>
                <a:lnTo>
                  <a:pt x="5484" y="434"/>
                </a:lnTo>
                <a:lnTo>
                  <a:pt x="5494" y="434"/>
                </a:lnTo>
                <a:lnTo>
                  <a:pt x="5501" y="434"/>
                </a:lnTo>
                <a:lnTo>
                  <a:pt x="5511" y="434"/>
                </a:lnTo>
                <a:lnTo>
                  <a:pt x="5521" y="434"/>
                </a:lnTo>
                <a:lnTo>
                  <a:pt x="5530" y="434"/>
                </a:lnTo>
                <a:lnTo>
                  <a:pt x="5540" y="434"/>
                </a:lnTo>
                <a:lnTo>
                  <a:pt x="5548" y="434"/>
                </a:lnTo>
                <a:lnTo>
                  <a:pt x="5557" y="434"/>
                </a:lnTo>
                <a:lnTo>
                  <a:pt x="5567" y="434"/>
                </a:lnTo>
                <a:lnTo>
                  <a:pt x="5576" y="434"/>
                </a:lnTo>
                <a:lnTo>
                  <a:pt x="5584" y="434"/>
                </a:lnTo>
                <a:lnTo>
                  <a:pt x="5594" y="434"/>
                </a:lnTo>
                <a:lnTo>
                  <a:pt x="5603" y="434"/>
                </a:lnTo>
                <a:lnTo>
                  <a:pt x="5613" y="434"/>
                </a:lnTo>
                <a:lnTo>
                  <a:pt x="5621" y="434"/>
                </a:lnTo>
                <a:lnTo>
                  <a:pt x="5630" y="434"/>
                </a:lnTo>
                <a:lnTo>
                  <a:pt x="5640" y="434"/>
                </a:lnTo>
                <a:lnTo>
                  <a:pt x="5649" y="434"/>
                </a:lnTo>
                <a:lnTo>
                  <a:pt x="5657" y="434"/>
                </a:lnTo>
                <a:lnTo>
                  <a:pt x="5667" y="434"/>
                </a:lnTo>
                <a:lnTo>
                  <a:pt x="5676" y="434"/>
                </a:lnTo>
                <a:lnTo>
                  <a:pt x="5686" y="434"/>
                </a:lnTo>
                <a:lnTo>
                  <a:pt x="5693" y="434"/>
                </a:lnTo>
                <a:lnTo>
                  <a:pt x="5703" y="434"/>
                </a:lnTo>
                <a:lnTo>
                  <a:pt x="5713" y="434"/>
                </a:lnTo>
                <a:lnTo>
                  <a:pt x="5722" y="434"/>
                </a:lnTo>
                <a:lnTo>
                  <a:pt x="5730" y="434"/>
                </a:lnTo>
                <a:lnTo>
                  <a:pt x="5740" y="434"/>
                </a:lnTo>
                <a:lnTo>
                  <a:pt x="5749" y="434"/>
                </a:lnTo>
                <a:lnTo>
                  <a:pt x="5759" y="434"/>
                </a:lnTo>
                <a:lnTo>
                  <a:pt x="5766" y="434"/>
                </a:lnTo>
                <a:lnTo>
                  <a:pt x="5776" y="434"/>
                </a:lnTo>
                <a:lnTo>
                  <a:pt x="5786" y="434"/>
                </a:lnTo>
                <a:lnTo>
                  <a:pt x="5795" y="434"/>
                </a:lnTo>
                <a:lnTo>
                  <a:pt x="5803" y="434"/>
                </a:lnTo>
                <a:lnTo>
                  <a:pt x="5813" y="434"/>
                </a:lnTo>
                <a:lnTo>
                  <a:pt x="5822" y="434"/>
                </a:lnTo>
                <a:lnTo>
                  <a:pt x="5832" y="434"/>
                </a:lnTo>
                <a:lnTo>
                  <a:pt x="5839" y="434"/>
                </a:lnTo>
                <a:lnTo>
                  <a:pt x="5849" y="434"/>
                </a:lnTo>
                <a:lnTo>
                  <a:pt x="5859" y="434"/>
                </a:lnTo>
                <a:lnTo>
                  <a:pt x="5868" y="434"/>
                </a:lnTo>
                <a:lnTo>
                  <a:pt x="5876" y="434"/>
                </a:lnTo>
                <a:lnTo>
                  <a:pt x="5885" y="434"/>
                </a:lnTo>
                <a:lnTo>
                  <a:pt x="5895" y="434"/>
                </a:lnTo>
                <a:lnTo>
                  <a:pt x="5905" y="434"/>
                </a:lnTo>
                <a:lnTo>
                  <a:pt x="5914" y="434"/>
                </a:lnTo>
                <a:lnTo>
                  <a:pt x="5922" y="434"/>
                </a:lnTo>
                <a:lnTo>
                  <a:pt x="5932" y="434"/>
                </a:lnTo>
                <a:lnTo>
                  <a:pt x="5941" y="434"/>
                </a:lnTo>
                <a:lnTo>
                  <a:pt x="5951" y="434"/>
                </a:lnTo>
                <a:lnTo>
                  <a:pt x="5958" y="434"/>
                </a:lnTo>
                <a:lnTo>
                  <a:pt x="5968" y="434"/>
                </a:lnTo>
                <a:lnTo>
                  <a:pt x="5978" y="432"/>
                </a:lnTo>
                <a:lnTo>
                  <a:pt x="5987" y="432"/>
                </a:lnTo>
                <a:lnTo>
                  <a:pt x="5995" y="432"/>
                </a:lnTo>
                <a:lnTo>
                  <a:pt x="6005" y="432"/>
                </a:lnTo>
                <a:lnTo>
                  <a:pt x="6014" y="432"/>
                </a:lnTo>
                <a:lnTo>
                  <a:pt x="6024" y="432"/>
                </a:lnTo>
                <a:lnTo>
                  <a:pt x="6031" y="432"/>
                </a:lnTo>
                <a:lnTo>
                  <a:pt x="6041" y="432"/>
                </a:lnTo>
                <a:lnTo>
                  <a:pt x="6051" y="430"/>
                </a:lnTo>
                <a:lnTo>
                  <a:pt x="6060" y="430"/>
                </a:lnTo>
                <a:lnTo>
                  <a:pt x="6068" y="430"/>
                </a:lnTo>
                <a:lnTo>
                  <a:pt x="6077" y="428"/>
                </a:lnTo>
                <a:lnTo>
                  <a:pt x="6087" y="428"/>
                </a:lnTo>
                <a:lnTo>
                  <a:pt x="6097" y="426"/>
                </a:lnTo>
                <a:lnTo>
                  <a:pt x="6104" y="426"/>
                </a:lnTo>
                <a:lnTo>
                  <a:pt x="6114" y="424"/>
                </a:lnTo>
                <a:lnTo>
                  <a:pt x="6124" y="422"/>
                </a:lnTo>
                <a:lnTo>
                  <a:pt x="6133" y="419"/>
                </a:lnTo>
                <a:lnTo>
                  <a:pt x="6141" y="415"/>
                </a:lnTo>
                <a:lnTo>
                  <a:pt x="6150" y="407"/>
                </a:lnTo>
                <a:lnTo>
                  <a:pt x="6160" y="398"/>
                </a:lnTo>
                <a:lnTo>
                  <a:pt x="6170" y="386"/>
                </a:lnTo>
                <a:lnTo>
                  <a:pt x="6177" y="369"/>
                </a:lnTo>
                <a:lnTo>
                  <a:pt x="6187" y="348"/>
                </a:lnTo>
                <a:lnTo>
                  <a:pt x="6197" y="321"/>
                </a:lnTo>
                <a:lnTo>
                  <a:pt x="6206" y="290"/>
                </a:lnTo>
                <a:lnTo>
                  <a:pt x="6214" y="255"/>
                </a:lnTo>
                <a:lnTo>
                  <a:pt x="6223" y="219"/>
                </a:lnTo>
                <a:lnTo>
                  <a:pt x="6233" y="179"/>
                </a:lnTo>
                <a:lnTo>
                  <a:pt x="6243" y="138"/>
                </a:lnTo>
                <a:lnTo>
                  <a:pt x="6250" y="100"/>
                </a:lnTo>
                <a:lnTo>
                  <a:pt x="6260" y="65"/>
                </a:lnTo>
                <a:lnTo>
                  <a:pt x="6270" y="39"/>
                </a:lnTo>
                <a:lnTo>
                  <a:pt x="6279" y="19"/>
                </a:lnTo>
                <a:lnTo>
                  <a:pt x="6289" y="6"/>
                </a:lnTo>
                <a:lnTo>
                  <a:pt x="6296" y="0"/>
                </a:lnTo>
                <a:lnTo>
                  <a:pt x="6306" y="0"/>
                </a:lnTo>
                <a:lnTo>
                  <a:pt x="6316" y="6"/>
                </a:lnTo>
                <a:lnTo>
                  <a:pt x="6325" y="14"/>
                </a:lnTo>
                <a:lnTo>
                  <a:pt x="6333" y="25"/>
                </a:lnTo>
                <a:lnTo>
                  <a:pt x="6342" y="39"/>
                </a:lnTo>
                <a:lnTo>
                  <a:pt x="6352" y="54"/>
                </a:lnTo>
                <a:lnTo>
                  <a:pt x="6362" y="69"/>
                </a:lnTo>
                <a:lnTo>
                  <a:pt x="6369" y="85"/>
                </a:lnTo>
                <a:lnTo>
                  <a:pt x="6379" y="100"/>
                </a:lnTo>
                <a:lnTo>
                  <a:pt x="6389" y="115"/>
                </a:lnTo>
                <a:lnTo>
                  <a:pt x="6398" y="129"/>
                </a:lnTo>
                <a:lnTo>
                  <a:pt x="6406" y="142"/>
                </a:lnTo>
                <a:lnTo>
                  <a:pt x="6415" y="156"/>
                </a:lnTo>
                <a:lnTo>
                  <a:pt x="6425" y="167"/>
                </a:lnTo>
                <a:lnTo>
                  <a:pt x="6435" y="179"/>
                </a:lnTo>
                <a:lnTo>
                  <a:pt x="6442" y="188"/>
                </a:lnTo>
                <a:lnTo>
                  <a:pt x="6452" y="198"/>
                </a:lnTo>
                <a:lnTo>
                  <a:pt x="6462" y="206"/>
                </a:lnTo>
                <a:lnTo>
                  <a:pt x="6471" y="213"/>
                </a:lnTo>
                <a:lnTo>
                  <a:pt x="6479" y="221"/>
                </a:lnTo>
                <a:lnTo>
                  <a:pt x="6488" y="229"/>
                </a:lnTo>
                <a:lnTo>
                  <a:pt x="6498" y="234"/>
                </a:lnTo>
                <a:lnTo>
                  <a:pt x="6508" y="240"/>
                </a:lnTo>
                <a:lnTo>
                  <a:pt x="6515" y="246"/>
                </a:lnTo>
                <a:lnTo>
                  <a:pt x="6525" y="252"/>
                </a:lnTo>
                <a:lnTo>
                  <a:pt x="6534" y="257"/>
                </a:lnTo>
                <a:lnTo>
                  <a:pt x="6544" y="261"/>
                </a:lnTo>
                <a:lnTo>
                  <a:pt x="6552" y="267"/>
                </a:lnTo>
                <a:lnTo>
                  <a:pt x="6561" y="271"/>
                </a:lnTo>
                <a:lnTo>
                  <a:pt x="6571" y="275"/>
                </a:lnTo>
                <a:lnTo>
                  <a:pt x="6581" y="279"/>
                </a:lnTo>
                <a:lnTo>
                  <a:pt x="6588" y="282"/>
                </a:lnTo>
                <a:lnTo>
                  <a:pt x="6598" y="286"/>
                </a:lnTo>
                <a:lnTo>
                  <a:pt x="6607" y="290"/>
                </a:lnTo>
                <a:lnTo>
                  <a:pt x="6617" y="294"/>
                </a:lnTo>
                <a:lnTo>
                  <a:pt x="6625" y="298"/>
                </a:lnTo>
                <a:lnTo>
                  <a:pt x="6634" y="302"/>
                </a:lnTo>
                <a:lnTo>
                  <a:pt x="6644" y="303"/>
                </a:lnTo>
                <a:lnTo>
                  <a:pt x="6654" y="307"/>
                </a:lnTo>
                <a:lnTo>
                  <a:pt x="6663" y="309"/>
                </a:lnTo>
                <a:lnTo>
                  <a:pt x="6671" y="313"/>
                </a:lnTo>
                <a:lnTo>
                  <a:pt x="6680" y="315"/>
                </a:lnTo>
                <a:lnTo>
                  <a:pt x="6690" y="319"/>
                </a:lnTo>
                <a:lnTo>
                  <a:pt x="6700" y="321"/>
                </a:lnTo>
                <a:lnTo>
                  <a:pt x="6707" y="323"/>
                </a:lnTo>
                <a:lnTo>
                  <a:pt x="6717" y="326"/>
                </a:lnTo>
                <a:lnTo>
                  <a:pt x="6726" y="328"/>
                </a:lnTo>
                <a:lnTo>
                  <a:pt x="6736" y="330"/>
                </a:lnTo>
                <a:lnTo>
                  <a:pt x="6744" y="332"/>
                </a:lnTo>
                <a:lnTo>
                  <a:pt x="6753" y="334"/>
                </a:lnTo>
                <a:lnTo>
                  <a:pt x="6763" y="338"/>
                </a:lnTo>
                <a:lnTo>
                  <a:pt x="6773" y="340"/>
                </a:lnTo>
                <a:lnTo>
                  <a:pt x="6780" y="342"/>
                </a:lnTo>
                <a:lnTo>
                  <a:pt x="6790" y="344"/>
                </a:lnTo>
                <a:lnTo>
                  <a:pt x="6799" y="346"/>
                </a:lnTo>
                <a:lnTo>
                  <a:pt x="6809" y="348"/>
                </a:lnTo>
                <a:lnTo>
                  <a:pt x="6817" y="350"/>
                </a:lnTo>
                <a:lnTo>
                  <a:pt x="6826" y="350"/>
                </a:lnTo>
                <a:lnTo>
                  <a:pt x="6836" y="351"/>
                </a:lnTo>
                <a:lnTo>
                  <a:pt x="6846" y="353"/>
                </a:lnTo>
                <a:lnTo>
                  <a:pt x="6851" y="355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99" name="Line 426">
            <a:extLst>
              <a:ext uri="{FF2B5EF4-FFF2-40B4-BE49-F238E27FC236}">
                <a16:creationId xmlns:a16="http://schemas.microsoft.com/office/drawing/2014/main" id="{AE0D3202-A3D5-7AF5-FED4-EF0EB4973EED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1838" y="1317595"/>
            <a:ext cx="17857" cy="1319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00" name="Rectangle 452">
            <a:extLst>
              <a:ext uri="{FF2B5EF4-FFF2-40B4-BE49-F238E27FC236}">
                <a16:creationId xmlns:a16="http://schemas.microsoft.com/office/drawing/2014/main" id="{09FDD64A-6F85-9656-4C3A-B28E6EAF84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2563" y="1278772"/>
            <a:ext cx="46309" cy="1000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50</a:t>
            </a:r>
            <a:endParaRPr lang="en-US" altLang="ja-JP" sz="7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497" name="Rectangle 427">
            <a:extLst>
              <a:ext uri="{FF2B5EF4-FFF2-40B4-BE49-F238E27FC236}">
                <a16:creationId xmlns:a16="http://schemas.microsoft.com/office/drawing/2014/main" id="{BC1A4A9B-E81D-D24D-2FE4-5760969643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04008" y="1075544"/>
            <a:ext cx="69463" cy="1000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00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Line 426">
            <a:extLst>
              <a:ext uri="{FF2B5EF4-FFF2-40B4-BE49-F238E27FC236}">
                <a16:creationId xmlns:a16="http://schemas.microsoft.com/office/drawing/2014/main" id="{BA904729-957E-1A3B-E7AE-94593F38775F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1837" y="1121522"/>
            <a:ext cx="17857" cy="1319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07" name="Line 148">
            <a:extLst>
              <a:ext uri="{FF2B5EF4-FFF2-40B4-BE49-F238E27FC236}">
                <a16:creationId xmlns:a16="http://schemas.microsoft.com/office/drawing/2014/main" id="{EF6E65F8-CF53-27EE-D577-B4C0BB7BD650}"/>
              </a:ext>
            </a:extLst>
          </p:cNvPr>
          <p:cNvSpPr>
            <a:spLocks noChangeShapeType="1"/>
          </p:cNvSpPr>
          <p:nvPr/>
        </p:nvSpPr>
        <p:spPr bwMode="auto">
          <a:xfrm>
            <a:off x="2184223" y="2552606"/>
            <a:ext cx="12079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9" name="Line 153">
            <a:extLst>
              <a:ext uri="{FF2B5EF4-FFF2-40B4-BE49-F238E27FC236}">
                <a16:creationId xmlns:a16="http://schemas.microsoft.com/office/drawing/2014/main" id="{25DB778F-3E0B-F2EC-EF1D-533E711BC81B}"/>
              </a:ext>
            </a:extLst>
          </p:cNvPr>
          <p:cNvSpPr>
            <a:spLocks noChangeShapeType="1"/>
          </p:cNvSpPr>
          <p:nvPr/>
        </p:nvSpPr>
        <p:spPr bwMode="auto">
          <a:xfrm>
            <a:off x="2184223" y="2217754"/>
            <a:ext cx="12079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0" name="Line 158">
            <a:extLst>
              <a:ext uri="{FF2B5EF4-FFF2-40B4-BE49-F238E27FC236}">
                <a16:creationId xmlns:a16="http://schemas.microsoft.com/office/drawing/2014/main" id="{4E7AE294-F447-46C7-5DD7-AE86206342F4}"/>
              </a:ext>
            </a:extLst>
          </p:cNvPr>
          <p:cNvSpPr>
            <a:spLocks noChangeShapeType="1"/>
          </p:cNvSpPr>
          <p:nvPr/>
        </p:nvSpPr>
        <p:spPr bwMode="auto">
          <a:xfrm>
            <a:off x="2184223" y="1881454"/>
            <a:ext cx="12079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1" name="Line 159">
            <a:extLst>
              <a:ext uri="{FF2B5EF4-FFF2-40B4-BE49-F238E27FC236}">
                <a16:creationId xmlns:a16="http://schemas.microsoft.com/office/drawing/2014/main" id="{9D31A036-ED13-E1C0-C791-27A1C409CD7D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2815" y="2552606"/>
            <a:ext cx="2348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2" name="Line 161">
            <a:extLst>
              <a:ext uri="{FF2B5EF4-FFF2-40B4-BE49-F238E27FC236}">
                <a16:creationId xmlns:a16="http://schemas.microsoft.com/office/drawing/2014/main" id="{02C92AFA-E154-8AA0-910A-4D3B16707C2C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2815" y="2217754"/>
            <a:ext cx="2348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3" name="Line 163">
            <a:extLst>
              <a:ext uri="{FF2B5EF4-FFF2-40B4-BE49-F238E27FC236}">
                <a16:creationId xmlns:a16="http://schemas.microsoft.com/office/drawing/2014/main" id="{7A1FDC2F-BF18-230D-D896-247C0A89B31E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2815" y="1881454"/>
            <a:ext cx="2348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4" name="Freeform 166">
            <a:extLst>
              <a:ext uri="{FF2B5EF4-FFF2-40B4-BE49-F238E27FC236}">
                <a16:creationId xmlns:a16="http://schemas.microsoft.com/office/drawing/2014/main" id="{644E2325-A2FF-EA0E-E4B4-7AB7A49A8A1D}"/>
              </a:ext>
            </a:extLst>
          </p:cNvPr>
          <p:cNvSpPr>
            <a:spLocks/>
          </p:cNvSpPr>
          <p:nvPr/>
        </p:nvSpPr>
        <p:spPr bwMode="auto">
          <a:xfrm>
            <a:off x="2196973" y="1848114"/>
            <a:ext cx="1540049" cy="585627"/>
          </a:xfrm>
          <a:custGeom>
            <a:avLst/>
            <a:gdLst>
              <a:gd name="T0" fmla="*/ 32 w 2295"/>
              <a:gd name="T1" fmla="*/ 396 h 404"/>
              <a:gd name="T2" fmla="*/ 69 w 2295"/>
              <a:gd name="T3" fmla="*/ 369 h 404"/>
              <a:gd name="T4" fmla="*/ 106 w 2295"/>
              <a:gd name="T5" fmla="*/ 328 h 404"/>
              <a:gd name="T6" fmla="*/ 143 w 2295"/>
              <a:gd name="T7" fmla="*/ 374 h 404"/>
              <a:gd name="T8" fmla="*/ 181 w 2295"/>
              <a:gd name="T9" fmla="*/ 379 h 404"/>
              <a:gd name="T10" fmla="*/ 217 w 2295"/>
              <a:gd name="T11" fmla="*/ 378 h 404"/>
              <a:gd name="T12" fmla="*/ 255 w 2295"/>
              <a:gd name="T13" fmla="*/ 382 h 404"/>
              <a:gd name="T14" fmla="*/ 292 w 2295"/>
              <a:gd name="T15" fmla="*/ 381 h 404"/>
              <a:gd name="T16" fmla="*/ 329 w 2295"/>
              <a:gd name="T17" fmla="*/ 378 h 404"/>
              <a:gd name="T18" fmla="*/ 366 w 2295"/>
              <a:gd name="T19" fmla="*/ 380 h 404"/>
              <a:gd name="T20" fmla="*/ 403 w 2295"/>
              <a:gd name="T21" fmla="*/ 379 h 404"/>
              <a:gd name="T22" fmla="*/ 440 w 2295"/>
              <a:gd name="T23" fmla="*/ 379 h 404"/>
              <a:gd name="T24" fmla="*/ 477 w 2295"/>
              <a:gd name="T25" fmla="*/ 380 h 404"/>
              <a:gd name="T26" fmla="*/ 515 w 2295"/>
              <a:gd name="T27" fmla="*/ 380 h 404"/>
              <a:gd name="T28" fmla="*/ 551 w 2295"/>
              <a:gd name="T29" fmla="*/ 376 h 404"/>
              <a:gd name="T30" fmla="*/ 589 w 2295"/>
              <a:gd name="T31" fmla="*/ 377 h 404"/>
              <a:gd name="T32" fmla="*/ 625 w 2295"/>
              <a:gd name="T33" fmla="*/ 375 h 404"/>
              <a:gd name="T34" fmla="*/ 663 w 2295"/>
              <a:gd name="T35" fmla="*/ 372 h 404"/>
              <a:gd name="T36" fmla="*/ 699 w 2295"/>
              <a:gd name="T37" fmla="*/ 367 h 404"/>
              <a:gd name="T38" fmla="*/ 737 w 2295"/>
              <a:gd name="T39" fmla="*/ 356 h 404"/>
              <a:gd name="T40" fmla="*/ 773 w 2295"/>
              <a:gd name="T41" fmla="*/ 371 h 404"/>
              <a:gd name="T42" fmla="*/ 811 w 2295"/>
              <a:gd name="T43" fmla="*/ 373 h 404"/>
              <a:gd name="T44" fmla="*/ 848 w 2295"/>
              <a:gd name="T45" fmla="*/ 366 h 404"/>
              <a:gd name="T46" fmla="*/ 885 w 2295"/>
              <a:gd name="T47" fmla="*/ 367 h 404"/>
              <a:gd name="T48" fmla="*/ 922 w 2295"/>
              <a:gd name="T49" fmla="*/ 364 h 404"/>
              <a:gd name="T50" fmla="*/ 959 w 2295"/>
              <a:gd name="T51" fmla="*/ 361 h 404"/>
              <a:gd name="T52" fmla="*/ 997 w 2295"/>
              <a:gd name="T53" fmla="*/ 365 h 404"/>
              <a:gd name="T54" fmla="*/ 1033 w 2295"/>
              <a:gd name="T55" fmla="*/ 313 h 404"/>
              <a:gd name="T56" fmla="*/ 1071 w 2295"/>
              <a:gd name="T57" fmla="*/ 348 h 404"/>
              <a:gd name="T58" fmla="*/ 1108 w 2295"/>
              <a:gd name="T59" fmla="*/ 360 h 404"/>
              <a:gd name="T60" fmla="*/ 1145 w 2295"/>
              <a:gd name="T61" fmla="*/ 362 h 404"/>
              <a:gd name="T62" fmla="*/ 1182 w 2295"/>
              <a:gd name="T63" fmla="*/ 305 h 404"/>
              <a:gd name="T64" fmla="*/ 1219 w 2295"/>
              <a:gd name="T65" fmla="*/ 303 h 404"/>
              <a:gd name="T66" fmla="*/ 1256 w 2295"/>
              <a:gd name="T67" fmla="*/ 290 h 404"/>
              <a:gd name="T68" fmla="*/ 1293 w 2295"/>
              <a:gd name="T69" fmla="*/ 323 h 404"/>
              <a:gd name="T70" fmla="*/ 1330 w 2295"/>
              <a:gd name="T71" fmla="*/ 302 h 404"/>
              <a:gd name="T72" fmla="*/ 1367 w 2295"/>
              <a:gd name="T73" fmla="*/ 304 h 404"/>
              <a:gd name="T74" fmla="*/ 1404 w 2295"/>
              <a:gd name="T75" fmla="*/ 297 h 404"/>
              <a:gd name="T76" fmla="*/ 1442 w 2295"/>
              <a:gd name="T77" fmla="*/ 322 h 404"/>
              <a:gd name="T78" fmla="*/ 1478 w 2295"/>
              <a:gd name="T79" fmla="*/ 338 h 404"/>
              <a:gd name="T80" fmla="*/ 1516 w 2295"/>
              <a:gd name="T81" fmla="*/ 319 h 404"/>
              <a:gd name="T82" fmla="*/ 1552 w 2295"/>
              <a:gd name="T83" fmla="*/ 336 h 404"/>
              <a:gd name="T84" fmla="*/ 1590 w 2295"/>
              <a:gd name="T85" fmla="*/ 328 h 404"/>
              <a:gd name="T86" fmla="*/ 1626 w 2295"/>
              <a:gd name="T87" fmla="*/ 335 h 404"/>
              <a:gd name="T88" fmla="*/ 1664 w 2295"/>
              <a:gd name="T89" fmla="*/ 323 h 404"/>
              <a:gd name="T90" fmla="*/ 1701 w 2295"/>
              <a:gd name="T91" fmla="*/ 319 h 404"/>
              <a:gd name="T92" fmla="*/ 1738 w 2295"/>
              <a:gd name="T93" fmla="*/ 323 h 404"/>
              <a:gd name="T94" fmla="*/ 1776 w 2295"/>
              <a:gd name="T95" fmla="*/ 327 h 404"/>
              <a:gd name="T96" fmla="*/ 1812 w 2295"/>
              <a:gd name="T97" fmla="*/ 328 h 404"/>
              <a:gd name="T98" fmla="*/ 1850 w 2295"/>
              <a:gd name="T99" fmla="*/ 330 h 404"/>
              <a:gd name="T100" fmla="*/ 1886 w 2295"/>
              <a:gd name="T101" fmla="*/ 327 h 404"/>
              <a:gd name="T102" fmla="*/ 1924 w 2295"/>
              <a:gd name="T103" fmla="*/ 322 h 404"/>
              <a:gd name="T104" fmla="*/ 1960 w 2295"/>
              <a:gd name="T105" fmla="*/ 319 h 404"/>
              <a:gd name="T106" fmla="*/ 1998 w 2295"/>
              <a:gd name="T107" fmla="*/ 318 h 404"/>
              <a:gd name="T108" fmla="*/ 2034 w 2295"/>
              <a:gd name="T109" fmla="*/ 313 h 404"/>
              <a:gd name="T110" fmla="*/ 2072 w 2295"/>
              <a:gd name="T111" fmla="*/ 309 h 404"/>
              <a:gd name="T112" fmla="*/ 2109 w 2295"/>
              <a:gd name="T113" fmla="*/ 308 h 404"/>
              <a:gd name="T114" fmla="*/ 2146 w 2295"/>
              <a:gd name="T115" fmla="*/ 315 h 404"/>
              <a:gd name="T116" fmla="*/ 2183 w 2295"/>
              <a:gd name="T117" fmla="*/ 316 h 404"/>
              <a:gd name="T118" fmla="*/ 2220 w 2295"/>
              <a:gd name="T119" fmla="*/ 312 h 404"/>
              <a:gd name="T120" fmla="*/ 2257 w 2295"/>
              <a:gd name="T121" fmla="*/ 296 h 404"/>
              <a:gd name="T122" fmla="*/ 2294 w 2295"/>
              <a:gd name="T123" fmla="*/ 20 h 4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2295" h="404">
                <a:moveTo>
                  <a:pt x="0" y="404"/>
                </a:moveTo>
                <a:lnTo>
                  <a:pt x="2" y="403"/>
                </a:lnTo>
                <a:lnTo>
                  <a:pt x="5" y="402"/>
                </a:lnTo>
                <a:lnTo>
                  <a:pt x="9" y="401"/>
                </a:lnTo>
                <a:lnTo>
                  <a:pt x="12" y="400"/>
                </a:lnTo>
                <a:lnTo>
                  <a:pt x="16" y="399"/>
                </a:lnTo>
                <a:lnTo>
                  <a:pt x="18" y="399"/>
                </a:lnTo>
                <a:lnTo>
                  <a:pt x="22" y="398"/>
                </a:lnTo>
                <a:lnTo>
                  <a:pt x="25" y="397"/>
                </a:lnTo>
                <a:lnTo>
                  <a:pt x="29" y="396"/>
                </a:lnTo>
                <a:lnTo>
                  <a:pt x="32" y="396"/>
                </a:lnTo>
                <a:lnTo>
                  <a:pt x="36" y="395"/>
                </a:lnTo>
                <a:lnTo>
                  <a:pt x="39" y="394"/>
                </a:lnTo>
                <a:lnTo>
                  <a:pt x="42" y="393"/>
                </a:lnTo>
                <a:lnTo>
                  <a:pt x="45" y="393"/>
                </a:lnTo>
                <a:lnTo>
                  <a:pt x="49" y="392"/>
                </a:lnTo>
                <a:lnTo>
                  <a:pt x="52" y="390"/>
                </a:lnTo>
                <a:lnTo>
                  <a:pt x="56" y="388"/>
                </a:lnTo>
                <a:lnTo>
                  <a:pt x="59" y="385"/>
                </a:lnTo>
                <a:lnTo>
                  <a:pt x="63" y="381"/>
                </a:lnTo>
                <a:lnTo>
                  <a:pt x="66" y="375"/>
                </a:lnTo>
                <a:lnTo>
                  <a:pt x="69" y="369"/>
                </a:lnTo>
                <a:lnTo>
                  <a:pt x="72" y="360"/>
                </a:lnTo>
                <a:lnTo>
                  <a:pt x="76" y="351"/>
                </a:lnTo>
                <a:lnTo>
                  <a:pt x="79" y="341"/>
                </a:lnTo>
                <a:lnTo>
                  <a:pt x="83" y="332"/>
                </a:lnTo>
                <a:lnTo>
                  <a:pt x="86" y="324"/>
                </a:lnTo>
                <a:lnTo>
                  <a:pt x="90" y="318"/>
                </a:lnTo>
                <a:lnTo>
                  <a:pt x="92" y="315"/>
                </a:lnTo>
                <a:lnTo>
                  <a:pt x="96" y="315"/>
                </a:lnTo>
                <a:lnTo>
                  <a:pt x="99" y="317"/>
                </a:lnTo>
                <a:lnTo>
                  <a:pt x="103" y="322"/>
                </a:lnTo>
                <a:lnTo>
                  <a:pt x="106" y="328"/>
                </a:lnTo>
                <a:lnTo>
                  <a:pt x="110" y="335"/>
                </a:lnTo>
                <a:lnTo>
                  <a:pt x="113" y="341"/>
                </a:lnTo>
                <a:lnTo>
                  <a:pt x="117" y="348"/>
                </a:lnTo>
                <a:lnTo>
                  <a:pt x="119" y="354"/>
                </a:lnTo>
                <a:lnTo>
                  <a:pt x="123" y="359"/>
                </a:lnTo>
                <a:lnTo>
                  <a:pt x="126" y="364"/>
                </a:lnTo>
                <a:lnTo>
                  <a:pt x="130" y="368"/>
                </a:lnTo>
                <a:lnTo>
                  <a:pt x="133" y="370"/>
                </a:lnTo>
                <a:lnTo>
                  <a:pt x="137" y="372"/>
                </a:lnTo>
                <a:lnTo>
                  <a:pt x="140" y="373"/>
                </a:lnTo>
                <a:lnTo>
                  <a:pt x="143" y="374"/>
                </a:lnTo>
                <a:lnTo>
                  <a:pt x="146" y="375"/>
                </a:lnTo>
                <a:lnTo>
                  <a:pt x="150" y="376"/>
                </a:lnTo>
                <a:lnTo>
                  <a:pt x="153" y="376"/>
                </a:lnTo>
                <a:lnTo>
                  <a:pt x="157" y="377"/>
                </a:lnTo>
                <a:lnTo>
                  <a:pt x="161" y="377"/>
                </a:lnTo>
                <a:lnTo>
                  <a:pt x="164" y="377"/>
                </a:lnTo>
                <a:lnTo>
                  <a:pt x="167" y="378"/>
                </a:lnTo>
                <a:lnTo>
                  <a:pt x="170" y="378"/>
                </a:lnTo>
                <a:lnTo>
                  <a:pt x="174" y="378"/>
                </a:lnTo>
                <a:lnTo>
                  <a:pt x="177" y="379"/>
                </a:lnTo>
                <a:lnTo>
                  <a:pt x="181" y="379"/>
                </a:lnTo>
                <a:lnTo>
                  <a:pt x="184" y="379"/>
                </a:lnTo>
                <a:lnTo>
                  <a:pt x="188" y="380"/>
                </a:lnTo>
                <a:lnTo>
                  <a:pt x="191" y="380"/>
                </a:lnTo>
                <a:lnTo>
                  <a:pt x="194" y="380"/>
                </a:lnTo>
                <a:lnTo>
                  <a:pt x="197" y="380"/>
                </a:lnTo>
                <a:lnTo>
                  <a:pt x="201" y="381"/>
                </a:lnTo>
                <a:lnTo>
                  <a:pt x="204" y="381"/>
                </a:lnTo>
                <a:lnTo>
                  <a:pt x="208" y="380"/>
                </a:lnTo>
                <a:lnTo>
                  <a:pt x="211" y="380"/>
                </a:lnTo>
                <a:lnTo>
                  <a:pt x="215" y="379"/>
                </a:lnTo>
                <a:lnTo>
                  <a:pt x="217" y="378"/>
                </a:lnTo>
                <a:lnTo>
                  <a:pt x="221" y="377"/>
                </a:lnTo>
                <a:lnTo>
                  <a:pt x="224" y="377"/>
                </a:lnTo>
                <a:lnTo>
                  <a:pt x="228" y="377"/>
                </a:lnTo>
                <a:lnTo>
                  <a:pt x="231" y="378"/>
                </a:lnTo>
                <a:lnTo>
                  <a:pt x="235" y="378"/>
                </a:lnTo>
                <a:lnTo>
                  <a:pt x="238" y="379"/>
                </a:lnTo>
                <a:lnTo>
                  <a:pt x="242" y="379"/>
                </a:lnTo>
                <a:lnTo>
                  <a:pt x="244" y="380"/>
                </a:lnTo>
                <a:lnTo>
                  <a:pt x="248" y="381"/>
                </a:lnTo>
                <a:lnTo>
                  <a:pt x="251" y="381"/>
                </a:lnTo>
                <a:lnTo>
                  <a:pt x="255" y="382"/>
                </a:lnTo>
                <a:lnTo>
                  <a:pt x="258" y="382"/>
                </a:lnTo>
                <a:lnTo>
                  <a:pt x="262" y="382"/>
                </a:lnTo>
                <a:lnTo>
                  <a:pt x="265" y="382"/>
                </a:lnTo>
                <a:lnTo>
                  <a:pt x="268" y="382"/>
                </a:lnTo>
                <a:lnTo>
                  <a:pt x="271" y="382"/>
                </a:lnTo>
                <a:lnTo>
                  <a:pt x="275" y="381"/>
                </a:lnTo>
                <a:lnTo>
                  <a:pt x="278" y="381"/>
                </a:lnTo>
                <a:lnTo>
                  <a:pt x="282" y="381"/>
                </a:lnTo>
                <a:lnTo>
                  <a:pt x="285" y="381"/>
                </a:lnTo>
                <a:lnTo>
                  <a:pt x="289" y="381"/>
                </a:lnTo>
                <a:lnTo>
                  <a:pt x="292" y="381"/>
                </a:lnTo>
                <a:lnTo>
                  <a:pt x="295" y="381"/>
                </a:lnTo>
                <a:lnTo>
                  <a:pt x="298" y="380"/>
                </a:lnTo>
                <a:lnTo>
                  <a:pt x="302" y="380"/>
                </a:lnTo>
                <a:lnTo>
                  <a:pt x="305" y="380"/>
                </a:lnTo>
                <a:lnTo>
                  <a:pt x="309" y="379"/>
                </a:lnTo>
                <a:lnTo>
                  <a:pt x="312" y="379"/>
                </a:lnTo>
                <a:lnTo>
                  <a:pt x="316" y="378"/>
                </a:lnTo>
                <a:lnTo>
                  <a:pt x="318" y="378"/>
                </a:lnTo>
                <a:lnTo>
                  <a:pt x="322" y="378"/>
                </a:lnTo>
                <a:lnTo>
                  <a:pt x="325" y="378"/>
                </a:lnTo>
                <a:lnTo>
                  <a:pt x="329" y="378"/>
                </a:lnTo>
                <a:lnTo>
                  <a:pt x="332" y="378"/>
                </a:lnTo>
                <a:lnTo>
                  <a:pt x="336" y="379"/>
                </a:lnTo>
                <a:lnTo>
                  <a:pt x="339" y="379"/>
                </a:lnTo>
                <a:lnTo>
                  <a:pt x="343" y="379"/>
                </a:lnTo>
                <a:lnTo>
                  <a:pt x="345" y="379"/>
                </a:lnTo>
                <a:lnTo>
                  <a:pt x="349" y="380"/>
                </a:lnTo>
                <a:lnTo>
                  <a:pt x="352" y="380"/>
                </a:lnTo>
                <a:lnTo>
                  <a:pt x="356" y="380"/>
                </a:lnTo>
                <a:lnTo>
                  <a:pt x="359" y="380"/>
                </a:lnTo>
                <a:lnTo>
                  <a:pt x="363" y="380"/>
                </a:lnTo>
                <a:lnTo>
                  <a:pt x="366" y="380"/>
                </a:lnTo>
                <a:lnTo>
                  <a:pt x="369" y="380"/>
                </a:lnTo>
                <a:lnTo>
                  <a:pt x="372" y="381"/>
                </a:lnTo>
                <a:lnTo>
                  <a:pt x="376" y="381"/>
                </a:lnTo>
                <a:lnTo>
                  <a:pt x="379" y="381"/>
                </a:lnTo>
                <a:lnTo>
                  <a:pt x="383" y="381"/>
                </a:lnTo>
                <a:lnTo>
                  <a:pt x="386" y="380"/>
                </a:lnTo>
                <a:lnTo>
                  <a:pt x="390" y="380"/>
                </a:lnTo>
                <a:lnTo>
                  <a:pt x="393" y="380"/>
                </a:lnTo>
                <a:lnTo>
                  <a:pt x="396" y="380"/>
                </a:lnTo>
                <a:lnTo>
                  <a:pt x="399" y="380"/>
                </a:lnTo>
                <a:lnTo>
                  <a:pt x="403" y="379"/>
                </a:lnTo>
                <a:lnTo>
                  <a:pt x="406" y="379"/>
                </a:lnTo>
                <a:lnTo>
                  <a:pt x="410" y="379"/>
                </a:lnTo>
                <a:lnTo>
                  <a:pt x="413" y="379"/>
                </a:lnTo>
                <a:lnTo>
                  <a:pt x="417" y="379"/>
                </a:lnTo>
                <a:lnTo>
                  <a:pt x="419" y="379"/>
                </a:lnTo>
                <a:lnTo>
                  <a:pt x="423" y="379"/>
                </a:lnTo>
                <a:lnTo>
                  <a:pt x="426" y="379"/>
                </a:lnTo>
                <a:lnTo>
                  <a:pt x="430" y="379"/>
                </a:lnTo>
                <a:lnTo>
                  <a:pt x="433" y="379"/>
                </a:lnTo>
                <a:lnTo>
                  <a:pt x="437" y="379"/>
                </a:lnTo>
                <a:lnTo>
                  <a:pt x="440" y="379"/>
                </a:lnTo>
                <a:lnTo>
                  <a:pt x="444" y="379"/>
                </a:lnTo>
                <a:lnTo>
                  <a:pt x="446" y="379"/>
                </a:lnTo>
                <a:lnTo>
                  <a:pt x="450" y="380"/>
                </a:lnTo>
                <a:lnTo>
                  <a:pt x="453" y="380"/>
                </a:lnTo>
                <a:lnTo>
                  <a:pt x="457" y="380"/>
                </a:lnTo>
                <a:lnTo>
                  <a:pt x="460" y="380"/>
                </a:lnTo>
                <a:lnTo>
                  <a:pt x="464" y="380"/>
                </a:lnTo>
                <a:lnTo>
                  <a:pt x="467" y="380"/>
                </a:lnTo>
                <a:lnTo>
                  <a:pt x="470" y="380"/>
                </a:lnTo>
                <a:lnTo>
                  <a:pt x="473" y="380"/>
                </a:lnTo>
                <a:lnTo>
                  <a:pt x="477" y="380"/>
                </a:lnTo>
                <a:lnTo>
                  <a:pt x="481" y="380"/>
                </a:lnTo>
                <a:lnTo>
                  <a:pt x="484" y="380"/>
                </a:lnTo>
                <a:lnTo>
                  <a:pt x="488" y="380"/>
                </a:lnTo>
                <a:lnTo>
                  <a:pt x="491" y="380"/>
                </a:lnTo>
                <a:lnTo>
                  <a:pt x="494" y="380"/>
                </a:lnTo>
                <a:lnTo>
                  <a:pt x="497" y="381"/>
                </a:lnTo>
                <a:lnTo>
                  <a:pt x="501" y="380"/>
                </a:lnTo>
                <a:lnTo>
                  <a:pt x="504" y="380"/>
                </a:lnTo>
                <a:lnTo>
                  <a:pt x="508" y="380"/>
                </a:lnTo>
                <a:lnTo>
                  <a:pt x="511" y="380"/>
                </a:lnTo>
                <a:lnTo>
                  <a:pt x="515" y="380"/>
                </a:lnTo>
                <a:lnTo>
                  <a:pt x="518" y="380"/>
                </a:lnTo>
                <a:lnTo>
                  <a:pt x="521" y="379"/>
                </a:lnTo>
                <a:lnTo>
                  <a:pt x="524" y="379"/>
                </a:lnTo>
                <a:lnTo>
                  <a:pt x="528" y="378"/>
                </a:lnTo>
                <a:lnTo>
                  <a:pt x="531" y="378"/>
                </a:lnTo>
                <a:lnTo>
                  <a:pt x="535" y="378"/>
                </a:lnTo>
                <a:lnTo>
                  <a:pt x="538" y="377"/>
                </a:lnTo>
                <a:lnTo>
                  <a:pt x="542" y="377"/>
                </a:lnTo>
                <a:lnTo>
                  <a:pt x="544" y="377"/>
                </a:lnTo>
                <a:lnTo>
                  <a:pt x="548" y="376"/>
                </a:lnTo>
                <a:lnTo>
                  <a:pt x="551" y="376"/>
                </a:lnTo>
                <a:lnTo>
                  <a:pt x="555" y="376"/>
                </a:lnTo>
                <a:lnTo>
                  <a:pt x="558" y="376"/>
                </a:lnTo>
                <a:lnTo>
                  <a:pt x="562" y="376"/>
                </a:lnTo>
                <a:lnTo>
                  <a:pt x="565" y="376"/>
                </a:lnTo>
                <a:lnTo>
                  <a:pt x="569" y="376"/>
                </a:lnTo>
                <a:lnTo>
                  <a:pt x="571" y="376"/>
                </a:lnTo>
                <a:lnTo>
                  <a:pt x="575" y="377"/>
                </a:lnTo>
                <a:lnTo>
                  <a:pt x="578" y="377"/>
                </a:lnTo>
                <a:lnTo>
                  <a:pt x="582" y="377"/>
                </a:lnTo>
                <a:lnTo>
                  <a:pt x="585" y="377"/>
                </a:lnTo>
                <a:lnTo>
                  <a:pt x="589" y="377"/>
                </a:lnTo>
                <a:lnTo>
                  <a:pt x="592" y="377"/>
                </a:lnTo>
                <a:lnTo>
                  <a:pt x="595" y="377"/>
                </a:lnTo>
                <a:lnTo>
                  <a:pt x="598" y="377"/>
                </a:lnTo>
                <a:lnTo>
                  <a:pt x="602" y="377"/>
                </a:lnTo>
                <a:lnTo>
                  <a:pt x="605" y="377"/>
                </a:lnTo>
                <a:lnTo>
                  <a:pt x="609" y="377"/>
                </a:lnTo>
                <a:lnTo>
                  <a:pt x="612" y="377"/>
                </a:lnTo>
                <a:lnTo>
                  <a:pt x="616" y="377"/>
                </a:lnTo>
                <a:lnTo>
                  <a:pt x="619" y="376"/>
                </a:lnTo>
                <a:lnTo>
                  <a:pt x="622" y="375"/>
                </a:lnTo>
                <a:lnTo>
                  <a:pt x="625" y="375"/>
                </a:lnTo>
                <a:lnTo>
                  <a:pt x="629" y="374"/>
                </a:lnTo>
                <a:lnTo>
                  <a:pt x="632" y="373"/>
                </a:lnTo>
                <a:lnTo>
                  <a:pt x="636" y="373"/>
                </a:lnTo>
                <a:lnTo>
                  <a:pt x="639" y="372"/>
                </a:lnTo>
                <a:lnTo>
                  <a:pt x="643" y="372"/>
                </a:lnTo>
                <a:lnTo>
                  <a:pt x="645" y="371"/>
                </a:lnTo>
                <a:lnTo>
                  <a:pt x="649" y="371"/>
                </a:lnTo>
                <a:lnTo>
                  <a:pt x="652" y="371"/>
                </a:lnTo>
                <a:lnTo>
                  <a:pt x="656" y="371"/>
                </a:lnTo>
                <a:lnTo>
                  <a:pt x="659" y="371"/>
                </a:lnTo>
                <a:lnTo>
                  <a:pt x="663" y="372"/>
                </a:lnTo>
                <a:lnTo>
                  <a:pt x="666" y="372"/>
                </a:lnTo>
                <a:lnTo>
                  <a:pt x="670" y="373"/>
                </a:lnTo>
                <a:lnTo>
                  <a:pt x="672" y="373"/>
                </a:lnTo>
                <a:lnTo>
                  <a:pt x="676" y="373"/>
                </a:lnTo>
                <a:lnTo>
                  <a:pt x="679" y="373"/>
                </a:lnTo>
                <a:lnTo>
                  <a:pt x="683" y="373"/>
                </a:lnTo>
                <a:lnTo>
                  <a:pt x="686" y="373"/>
                </a:lnTo>
                <a:lnTo>
                  <a:pt x="690" y="372"/>
                </a:lnTo>
                <a:lnTo>
                  <a:pt x="693" y="371"/>
                </a:lnTo>
                <a:lnTo>
                  <a:pt x="696" y="369"/>
                </a:lnTo>
                <a:lnTo>
                  <a:pt x="699" y="367"/>
                </a:lnTo>
                <a:lnTo>
                  <a:pt x="703" y="364"/>
                </a:lnTo>
                <a:lnTo>
                  <a:pt x="706" y="362"/>
                </a:lnTo>
                <a:lnTo>
                  <a:pt x="710" y="361"/>
                </a:lnTo>
                <a:lnTo>
                  <a:pt x="713" y="361"/>
                </a:lnTo>
                <a:lnTo>
                  <a:pt x="717" y="361"/>
                </a:lnTo>
                <a:lnTo>
                  <a:pt x="720" y="360"/>
                </a:lnTo>
                <a:lnTo>
                  <a:pt x="723" y="360"/>
                </a:lnTo>
                <a:lnTo>
                  <a:pt x="726" y="359"/>
                </a:lnTo>
                <a:lnTo>
                  <a:pt x="730" y="358"/>
                </a:lnTo>
                <a:lnTo>
                  <a:pt x="733" y="357"/>
                </a:lnTo>
                <a:lnTo>
                  <a:pt x="737" y="356"/>
                </a:lnTo>
                <a:lnTo>
                  <a:pt x="740" y="356"/>
                </a:lnTo>
                <a:lnTo>
                  <a:pt x="744" y="357"/>
                </a:lnTo>
                <a:lnTo>
                  <a:pt x="746" y="359"/>
                </a:lnTo>
                <a:lnTo>
                  <a:pt x="750" y="361"/>
                </a:lnTo>
                <a:lnTo>
                  <a:pt x="753" y="363"/>
                </a:lnTo>
                <a:lnTo>
                  <a:pt x="757" y="365"/>
                </a:lnTo>
                <a:lnTo>
                  <a:pt x="760" y="367"/>
                </a:lnTo>
                <a:lnTo>
                  <a:pt x="764" y="368"/>
                </a:lnTo>
                <a:lnTo>
                  <a:pt x="767" y="369"/>
                </a:lnTo>
                <a:lnTo>
                  <a:pt x="771" y="370"/>
                </a:lnTo>
                <a:lnTo>
                  <a:pt x="773" y="371"/>
                </a:lnTo>
                <a:lnTo>
                  <a:pt x="777" y="371"/>
                </a:lnTo>
                <a:lnTo>
                  <a:pt x="780" y="372"/>
                </a:lnTo>
                <a:lnTo>
                  <a:pt x="784" y="372"/>
                </a:lnTo>
                <a:lnTo>
                  <a:pt x="787" y="372"/>
                </a:lnTo>
                <a:lnTo>
                  <a:pt x="791" y="372"/>
                </a:lnTo>
                <a:lnTo>
                  <a:pt x="795" y="373"/>
                </a:lnTo>
                <a:lnTo>
                  <a:pt x="797" y="373"/>
                </a:lnTo>
                <a:lnTo>
                  <a:pt x="801" y="373"/>
                </a:lnTo>
                <a:lnTo>
                  <a:pt x="804" y="373"/>
                </a:lnTo>
                <a:lnTo>
                  <a:pt x="808" y="373"/>
                </a:lnTo>
                <a:lnTo>
                  <a:pt x="811" y="373"/>
                </a:lnTo>
                <a:lnTo>
                  <a:pt x="815" y="372"/>
                </a:lnTo>
                <a:lnTo>
                  <a:pt x="818" y="372"/>
                </a:lnTo>
                <a:lnTo>
                  <a:pt x="821" y="371"/>
                </a:lnTo>
                <a:lnTo>
                  <a:pt x="824" y="369"/>
                </a:lnTo>
                <a:lnTo>
                  <a:pt x="828" y="368"/>
                </a:lnTo>
                <a:lnTo>
                  <a:pt x="831" y="368"/>
                </a:lnTo>
                <a:lnTo>
                  <a:pt x="835" y="367"/>
                </a:lnTo>
                <a:lnTo>
                  <a:pt x="838" y="366"/>
                </a:lnTo>
                <a:lnTo>
                  <a:pt x="842" y="366"/>
                </a:lnTo>
                <a:lnTo>
                  <a:pt x="845" y="366"/>
                </a:lnTo>
                <a:lnTo>
                  <a:pt x="848" y="366"/>
                </a:lnTo>
                <a:lnTo>
                  <a:pt x="851" y="365"/>
                </a:lnTo>
                <a:lnTo>
                  <a:pt x="855" y="365"/>
                </a:lnTo>
                <a:lnTo>
                  <a:pt x="858" y="365"/>
                </a:lnTo>
                <a:lnTo>
                  <a:pt x="862" y="365"/>
                </a:lnTo>
                <a:lnTo>
                  <a:pt x="865" y="365"/>
                </a:lnTo>
                <a:lnTo>
                  <a:pt x="869" y="365"/>
                </a:lnTo>
                <a:lnTo>
                  <a:pt x="871" y="365"/>
                </a:lnTo>
                <a:lnTo>
                  <a:pt x="875" y="366"/>
                </a:lnTo>
                <a:lnTo>
                  <a:pt x="878" y="366"/>
                </a:lnTo>
                <a:lnTo>
                  <a:pt x="882" y="366"/>
                </a:lnTo>
                <a:lnTo>
                  <a:pt x="885" y="367"/>
                </a:lnTo>
                <a:lnTo>
                  <a:pt x="889" y="367"/>
                </a:lnTo>
                <a:lnTo>
                  <a:pt x="892" y="367"/>
                </a:lnTo>
                <a:lnTo>
                  <a:pt x="896" y="367"/>
                </a:lnTo>
                <a:lnTo>
                  <a:pt x="898" y="367"/>
                </a:lnTo>
                <a:lnTo>
                  <a:pt x="902" y="367"/>
                </a:lnTo>
                <a:lnTo>
                  <a:pt x="905" y="366"/>
                </a:lnTo>
                <a:lnTo>
                  <a:pt x="909" y="366"/>
                </a:lnTo>
                <a:lnTo>
                  <a:pt x="912" y="365"/>
                </a:lnTo>
                <a:lnTo>
                  <a:pt x="916" y="365"/>
                </a:lnTo>
                <a:lnTo>
                  <a:pt x="919" y="364"/>
                </a:lnTo>
                <a:lnTo>
                  <a:pt x="922" y="364"/>
                </a:lnTo>
                <a:lnTo>
                  <a:pt x="925" y="365"/>
                </a:lnTo>
                <a:lnTo>
                  <a:pt x="929" y="365"/>
                </a:lnTo>
                <a:lnTo>
                  <a:pt x="932" y="365"/>
                </a:lnTo>
                <a:lnTo>
                  <a:pt x="936" y="366"/>
                </a:lnTo>
                <a:lnTo>
                  <a:pt x="939" y="366"/>
                </a:lnTo>
                <a:lnTo>
                  <a:pt x="943" y="365"/>
                </a:lnTo>
                <a:lnTo>
                  <a:pt x="946" y="365"/>
                </a:lnTo>
                <a:lnTo>
                  <a:pt x="949" y="364"/>
                </a:lnTo>
                <a:lnTo>
                  <a:pt x="952" y="363"/>
                </a:lnTo>
                <a:lnTo>
                  <a:pt x="956" y="362"/>
                </a:lnTo>
                <a:lnTo>
                  <a:pt x="959" y="361"/>
                </a:lnTo>
                <a:lnTo>
                  <a:pt x="963" y="361"/>
                </a:lnTo>
                <a:lnTo>
                  <a:pt x="966" y="361"/>
                </a:lnTo>
                <a:lnTo>
                  <a:pt x="970" y="362"/>
                </a:lnTo>
                <a:lnTo>
                  <a:pt x="972" y="363"/>
                </a:lnTo>
                <a:lnTo>
                  <a:pt x="976" y="364"/>
                </a:lnTo>
                <a:lnTo>
                  <a:pt x="979" y="364"/>
                </a:lnTo>
                <a:lnTo>
                  <a:pt x="983" y="365"/>
                </a:lnTo>
                <a:lnTo>
                  <a:pt x="986" y="366"/>
                </a:lnTo>
                <a:lnTo>
                  <a:pt x="990" y="366"/>
                </a:lnTo>
                <a:lnTo>
                  <a:pt x="993" y="366"/>
                </a:lnTo>
                <a:lnTo>
                  <a:pt x="997" y="365"/>
                </a:lnTo>
                <a:lnTo>
                  <a:pt x="999" y="365"/>
                </a:lnTo>
                <a:lnTo>
                  <a:pt x="1003" y="362"/>
                </a:lnTo>
                <a:lnTo>
                  <a:pt x="1006" y="359"/>
                </a:lnTo>
                <a:lnTo>
                  <a:pt x="1010" y="355"/>
                </a:lnTo>
                <a:lnTo>
                  <a:pt x="1013" y="349"/>
                </a:lnTo>
                <a:lnTo>
                  <a:pt x="1017" y="342"/>
                </a:lnTo>
                <a:lnTo>
                  <a:pt x="1020" y="335"/>
                </a:lnTo>
                <a:lnTo>
                  <a:pt x="1023" y="328"/>
                </a:lnTo>
                <a:lnTo>
                  <a:pt x="1026" y="321"/>
                </a:lnTo>
                <a:lnTo>
                  <a:pt x="1030" y="316"/>
                </a:lnTo>
                <a:lnTo>
                  <a:pt x="1033" y="313"/>
                </a:lnTo>
                <a:lnTo>
                  <a:pt x="1037" y="313"/>
                </a:lnTo>
                <a:lnTo>
                  <a:pt x="1040" y="315"/>
                </a:lnTo>
                <a:lnTo>
                  <a:pt x="1044" y="319"/>
                </a:lnTo>
                <a:lnTo>
                  <a:pt x="1047" y="324"/>
                </a:lnTo>
                <a:lnTo>
                  <a:pt x="1050" y="329"/>
                </a:lnTo>
                <a:lnTo>
                  <a:pt x="1053" y="333"/>
                </a:lnTo>
                <a:lnTo>
                  <a:pt x="1057" y="337"/>
                </a:lnTo>
                <a:lnTo>
                  <a:pt x="1060" y="340"/>
                </a:lnTo>
                <a:lnTo>
                  <a:pt x="1064" y="343"/>
                </a:lnTo>
                <a:lnTo>
                  <a:pt x="1067" y="346"/>
                </a:lnTo>
                <a:lnTo>
                  <a:pt x="1071" y="348"/>
                </a:lnTo>
                <a:lnTo>
                  <a:pt x="1073" y="350"/>
                </a:lnTo>
                <a:lnTo>
                  <a:pt x="1077" y="352"/>
                </a:lnTo>
                <a:lnTo>
                  <a:pt x="1080" y="354"/>
                </a:lnTo>
                <a:lnTo>
                  <a:pt x="1084" y="355"/>
                </a:lnTo>
                <a:lnTo>
                  <a:pt x="1087" y="356"/>
                </a:lnTo>
                <a:lnTo>
                  <a:pt x="1091" y="357"/>
                </a:lnTo>
                <a:lnTo>
                  <a:pt x="1094" y="358"/>
                </a:lnTo>
                <a:lnTo>
                  <a:pt x="1098" y="359"/>
                </a:lnTo>
                <a:lnTo>
                  <a:pt x="1100" y="360"/>
                </a:lnTo>
                <a:lnTo>
                  <a:pt x="1104" y="360"/>
                </a:lnTo>
                <a:lnTo>
                  <a:pt x="1108" y="360"/>
                </a:lnTo>
                <a:lnTo>
                  <a:pt x="1111" y="361"/>
                </a:lnTo>
                <a:lnTo>
                  <a:pt x="1115" y="361"/>
                </a:lnTo>
                <a:lnTo>
                  <a:pt x="1118" y="361"/>
                </a:lnTo>
                <a:lnTo>
                  <a:pt x="1122" y="361"/>
                </a:lnTo>
                <a:lnTo>
                  <a:pt x="1124" y="361"/>
                </a:lnTo>
                <a:lnTo>
                  <a:pt x="1128" y="361"/>
                </a:lnTo>
                <a:lnTo>
                  <a:pt x="1131" y="362"/>
                </a:lnTo>
                <a:lnTo>
                  <a:pt x="1135" y="362"/>
                </a:lnTo>
                <a:lnTo>
                  <a:pt x="1138" y="362"/>
                </a:lnTo>
                <a:lnTo>
                  <a:pt x="1142" y="362"/>
                </a:lnTo>
                <a:lnTo>
                  <a:pt x="1145" y="362"/>
                </a:lnTo>
                <a:lnTo>
                  <a:pt x="1148" y="362"/>
                </a:lnTo>
                <a:lnTo>
                  <a:pt x="1151" y="361"/>
                </a:lnTo>
                <a:lnTo>
                  <a:pt x="1155" y="361"/>
                </a:lnTo>
                <a:lnTo>
                  <a:pt x="1158" y="359"/>
                </a:lnTo>
                <a:lnTo>
                  <a:pt x="1162" y="357"/>
                </a:lnTo>
                <a:lnTo>
                  <a:pt x="1165" y="352"/>
                </a:lnTo>
                <a:lnTo>
                  <a:pt x="1169" y="345"/>
                </a:lnTo>
                <a:lnTo>
                  <a:pt x="1172" y="337"/>
                </a:lnTo>
                <a:lnTo>
                  <a:pt x="1175" y="326"/>
                </a:lnTo>
                <a:lnTo>
                  <a:pt x="1178" y="315"/>
                </a:lnTo>
                <a:lnTo>
                  <a:pt x="1182" y="305"/>
                </a:lnTo>
                <a:lnTo>
                  <a:pt x="1185" y="300"/>
                </a:lnTo>
                <a:lnTo>
                  <a:pt x="1189" y="299"/>
                </a:lnTo>
                <a:lnTo>
                  <a:pt x="1192" y="301"/>
                </a:lnTo>
                <a:lnTo>
                  <a:pt x="1196" y="304"/>
                </a:lnTo>
                <a:lnTo>
                  <a:pt x="1198" y="309"/>
                </a:lnTo>
                <a:lnTo>
                  <a:pt x="1202" y="313"/>
                </a:lnTo>
                <a:lnTo>
                  <a:pt x="1205" y="314"/>
                </a:lnTo>
                <a:lnTo>
                  <a:pt x="1209" y="314"/>
                </a:lnTo>
                <a:lnTo>
                  <a:pt x="1212" y="312"/>
                </a:lnTo>
                <a:lnTo>
                  <a:pt x="1216" y="308"/>
                </a:lnTo>
                <a:lnTo>
                  <a:pt x="1219" y="303"/>
                </a:lnTo>
                <a:lnTo>
                  <a:pt x="1223" y="295"/>
                </a:lnTo>
                <a:lnTo>
                  <a:pt x="1225" y="288"/>
                </a:lnTo>
                <a:lnTo>
                  <a:pt x="1229" y="280"/>
                </a:lnTo>
                <a:lnTo>
                  <a:pt x="1232" y="274"/>
                </a:lnTo>
                <a:lnTo>
                  <a:pt x="1236" y="269"/>
                </a:lnTo>
                <a:lnTo>
                  <a:pt x="1239" y="267"/>
                </a:lnTo>
                <a:lnTo>
                  <a:pt x="1243" y="267"/>
                </a:lnTo>
                <a:lnTo>
                  <a:pt x="1246" y="269"/>
                </a:lnTo>
                <a:lnTo>
                  <a:pt x="1249" y="274"/>
                </a:lnTo>
                <a:lnTo>
                  <a:pt x="1252" y="281"/>
                </a:lnTo>
                <a:lnTo>
                  <a:pt x="1256" y="290"/>
                </a:lnTo>
                <a:lnTo>
                  <a:pt x="1259" y="298"/>
                </a:lnTo>
                <a:lnTo>
                  <a:pt x="1263" y="305"/>
                </a:lnTo>
                <a:lnTo>
                  <a:pt x="1266" y="312"/>
                </a:lnTo>
                <a:lnTo>
                  <a:pt x="1270" y="317"/>
                </a:lnTo>
                <a:lnTo>
                  <a:pt x="1273" y="321"/>
                </a:lnTo>
                <a:lnTo>
                  <a:pt x="1276" y="323"/>
                </a:lnTo>
                <a:lnTo>
                  <a:pt x="1279" y="324"/>
                </a:lnTo>
                <a:lnTo>
                  <a:pt x="1283" y="323"/>
                </a:lnTo>
                <a:lnTo>
                  <a:pt x="1286" y="323"/>
                </a:lnTo>
                <a:lnTo>
                  <a:pt x="1290" y="323"/>
                </a:lnTo>
                <a:lnTo>
                  <a:pt x="1293" y="323"/>
                </a:lnTo>
                <a:lnTo>
                  <a:pt x="1297" y="325"/>
                </a:lnTo>
                <a:lnTo>
                  <a:pt x="1299" y="327"/>
                </a:lnTo>
                <a:lnTo>
                  <a:pt x="1303" y="330"/>
                </a:lnTo>
                <a:lnTo>
                  <a:pt x="1306" y="333"/>
                </a:lnTo>
                <a:lnTo>
                  <a:pt x="1310" y="336"/>
                </a:lnTo>
                <a:lnTo>
                  <a:pt x="1313" y="338"/>
                </a:lnTo>
                <a:lnTo>
                  <a:pt x="1317" y="338"/>
                </a:lnTo>
                <a:lnTo>
                  <a:pt x="1320" y="335"/>
                </a:lnTo>
                <a:lnTo>
                  <a:pt x="1324" y="329"/>
                </a:lnTo>
                <a:lnTo>
                  <a:pt x="1326" y="317"/>
                </a:lnTo>
                <a:lnTo>
                  <a:pt x="1330" y="302"/>
                </a:lnTo>
                <a:lnTo>
                  <a:pt x="1333" y="285"/>
                </a:lnTo>
                <a:lnTo>
                  <a:pt x="1337" y="270"/>
                </a:lnTo>
                <a:lnTo>
                  <a:pt x="1340" y="262"/>
                </a:lnTo>
                <a:lnTo>
                  <a:pt x="1344" y="260"/>
                </a:lnTo>
                <a:lnTo>
                  <a:pt x="1347" y="264"/>
                </a:lnTo>
                <a:lnTo>
                  <a:pt x="1350" y="272"/>
                </a:lnTo>
                <a:lnTo>
                  <a:pt x="1353" y="281"/>
                </a:lnTo>
                <a:lnTo>
                  <a:pt x="1357" y="291"/>
                </a:lnTo>
                <a:lnTo>
                  <a:pt x="1360" y="298"/>
                </a:lnTo>
                <a:lnTo>
                  <a:pt x="1364" y="303"/>
                </a:lnTo>
                <a:lnTo>
                  <a:pt x="1367" y="304"/>
                </a:lnTo>
                <a:lnTo>
                  <a:pt x="1371" y="304"/>
                </a:lnTo>
                <a:lnTo>
                  <a:pt x="1374" y="303"/>
                </a:lnTo>
                <a:lnTo>
                  <a:pt x="1377" y="303"/>
                </a:lnTo>
                <a:lnTo>
                  <a:pt x="1380" y="302"/>
                </a:lnTo>
                <a:lnTo>
                  <a:pt x="1384" y="302"/>
                </a:lnTo>
                <a:lnTo>
                  <a:pt x="1387" y="303"/>
                </a:lnTo>
                <a:lnTo>
                  <a:pt x="1391" y="303"/>
                </a:lnTo>
                <a:lnTo>
                  <a:pt x="1394" y="301"/>
                </a:lnTo>
                <a:lnTo>
                  <a:pt x="1398" y="299"/>
                </a:lnTo>
                <a:lnTo>
                  <a:pt x="1400" y="298"/>
                </a:lnTo>
                <a:lnTo>
                  <a:pt x="1404" y="297"/>
                </a:lnTo>
                <a:lnTo>
                  <a:pt x="1407" y="299"/>
                </a:lnTo>
                <a:lnTo>
                  <a:pt x="1411" y="302"/>
                </a:lnTo>
                <a:lnTo>
                  <a:pt x="1414" y="305"/>
                </a:lnTo>
                <a:lnTo>
                  <a:pt x="1418" y="309"/>
                </a:lnTo>
                <a:lnTo>
                  <a:pt x="1421" y="313"/>
                </a:lnTo>
                <a:lnTo>
                  <a:pt x="1425" y="316"/>
                </a:lnTo>
                <a:lnTo>
                  <a:pt x="1428" y="318"/>
                </a:lnTo>
                <a:lnTo>
                  <a:pt x="1431" y="320"/>
                </a:lnTo>
                <a:lnTo>
                  <a:pt x="1435" y="321"/>
                </a:lnTo>
                <a:lnTo>
                  <a:pt x="1438" y="322"/>
                </a:lnTo>
                <a:lnTo>
                  <a:pt x="1442" y="322"/>
                </a:lnTo>
                <a:lnTo>
                  <a:pt x="1445" y="323"/>
                </a:lnTo>
                <a:lnTo>
                  <a:pt x="1449" y="324"/>
                </a:lnTo>
                <a:lnTo>
                  <a:pt x="1451" y="326"/>
                </a:lnTo>
                <a:lnTo>
                  <a:pt x="1455" y="328"/>
                </a:lnTo>
                <a:lnTo>
                  <a:pt x="1458" y="330"/>
                </a:lnTo>
                <a:lnTo>
                  <a:pt x="1462" y="332"/>
                </a:lnTo>
                <a:lnTo>
                  <a:pt x="1465" y="334"/>
                </a:lnTo>
                <a:lnTo>
                  <a:pt x="1469" y="336"/>
                </a:lnTo>
                <a:lnTo>
                  <a:pt x="1472" y="338"/>
                </a:lnTo>
                <a:lnTo>
                  <a:pt x="1475" y="338"/>
                </a:lnTo>
                <a:lnTo>
                  <a:pt x="1478" y="338"/>
                </a:lnTo>
                <a:lnTo>
                  <a:pt x="1482" y="339"/>
                </a:lnTo>
                <a:lnTo>
                  <a:pt x="1485" y="338"/>
                </a:lnTo>
                <a:lnTo>
                  <a:pt x="1489" y="337"/>
                </a:lnTo>
                <a:lnTo>
                  <a:pt x="1492" y="334"/>
                </a:lnTo>
                <a:lnTo>
                  <a:pt x="1496" y="330"/>
                </a:lnTo>
                <a:lnTo>
                  <a:pt x="1499" y="325"/>
                </a:lnTo>
                <a:lnTo>
                  <a:pt x="1502" y="321"/>
                </a:lnTo>
                <a:lnTo>
                  <a:pt x="1505" y="318"/>
                </a:lnTo>
                <a:lnTo>
                  <a:pt x="1509" y="317"/>
                </a:lnTo>
                <a:lnTo>
                  <a:pt x="1512" y="317"/>
                </a:lnTo>
                <a:lnTo>
                  <a:pt x="1516" y="319"/>
                </a:lnTo>
                <a:lnTo>
                  <a:pt x="1519" y="322"/>
                </a:lnTo>
                <a:lnTo>
                  <a:pt x="1523" y="324"/>
                </a:lnTo>
                <a:lnTo>
                  <a:pt x="1525" y="327"/>
                </a:lnTo>
                <a:lnTo>
                  <a:pt x="1529" y="329"/>
                </a:lnTo>
                <a:lnTo>
                  <a:pt x="1532" y="331"/>
                </a:lnTo>
                <a:lnTo>
                  <a:pt x="1536" y="333"/>
                </a:lnTo>
                <a:lnTo>
                  <a:pt x="1539" y="334"/>
                </a:lnTo>
                <a:lnTo>
                  <a:pt x="1543" y="335"/>
                </a:lnTo>
                <a:lnTo>
                  <a:pt x="1546" y="336"/>
                </a:lnTo>
                <a:lnTo>
                  <a:pt x="1550" y="336"/>
                </a:lnTo>
                <a:lnTo>
                  <a:pt x="1552" y="336"/>
                </a:lnTo>
                <a:lnTo>
                  <a:pt x="1556" y="335"/>
                </a:lnTo>
                <a:lnTo>
                  <a:pt x="1559" y="333"/>
                </a:lnTo>
                <a:lnTo>
                  <a:pt x="1563" y="330"/>
                </a:lnTo>
                <a:lnTo>
                  <a:pt x="1566" y="328"/>
                </a:lnTo>
                <a:lnTo>
                  <a:pt x="1570" y="325"/>
                </a:lnTo>
                <a:lnTo>
                  <a:pt x="1573" y="324"/>
                </a:lnTo>
                <a:lnTo>
                  <a:pt x="1576" y="324"/>
                </a:lnTo>
                <a:lnTo>
                  <a:pt x="1579" y="324"/>
                </a:lnTo>
                <a:lnTo>
                  <a:pt x="1583" y="326"/>
                </a:lnTo>
                <a:lnTo>
                  <a:pt x="1586" y="327"/>
                </a:lnTo>
                <a:lnTo>
                  <a:pt x="1590" y="328"/>
                </a:lnTo>
                <a:lnTo>
                  <a:pt x="1593" y="330"/>
                </a:lnTo>
                <a:lnTo>
                  <a:pt x="1597" y="331"/>
                </a:lnTo>
                <a:lnTo>
                  <a:pt x="1600" y="332"/>
                </a:lnTo>
                <a:lnTo>
                  <a:pt x="1603" y="333"/>
                </a:lnTo>
                <a:lnTo>
                  <a:pt x="1606" y="334"/>
                </a:lnTo>
                <a:lnTo>
                  <a:pt x="1610" y="335"/>
                </a:lnTo>
                <a:lnTo>
                  <a:pt x="1613" y="335"/>
                </a:lnTo>
                <a:lnTo>
                  <a:pt x="1617" y="335"/>
                </a:lnTo>
                <a:lnTo>
                  <a:pt x="1620" y="335"/>
                </a:lnTo>
                <a:lnTo>
                  <a:pt x="1624" y="335"/>
                </a:lnTo>
                <a:lnTo>
                  <a:pt x="1626" y="335"/>
                </a:lnTo>
                <a:lnTo>
                  <a:pt x="1630" y="335"/>
                </a:lnTo>
                <a:lnTo>
                  <a:pt x="1633" y="336"/>
                </a:lnTo>
                <a:lnTo>
                  <a:pt x="1637" y="336"/>
                </a:lnTo>
                <a:lnTo>
                  <a:pt x="1640" y="335"/>
                </a:lnTo>
                <a:lnTo>
                  <a:pt x="1644" y="335"/>
                </a:lnTo>
                <a:lnTo>
                  <a:pt x="1647" y="334"/>
                </a:lnTo>
                <a:lnTo>
                  <a:pt x="1651" y="332"/>
                </a:lnTo>
                <a:lnTo>
                  <a:pt x="1653" y="330"/>
                </a:lnTo>
                <a:lnTo>
                  <a:pt x="1657" y="328"/>
                </a:lnTo>
                <a:lnTo>
                  <a:pt x="1660" y="326"/>
                </a:lnTo>
                <a:lnTo>
                  <a:pt x="1664" y="323"/>
                </a:lnTo>
                <a:lnTo>
                  <a:pt x="1667" y="320"/>
                </a:lnTo>
                <a:lnTo>
                  <a:pt x="1671" y="317"/>
                </a:lnTo>
                <a:lnTo>
                  <a:pt x="1674" y="315"/>
                </a:lnTo>
                <a:lnTo>
                  <a:pt x="1677" y="313"/>
                </a:lnTo>
                <a:lnTo>
                  <a:pt x="1680" y="312"/>
                </a:lnTo>
                <a:lnTo>
                  <a:pt x="1684" y="312"/>
                </a:lnTo>
                <a:lnTo>
                  <a:pt x="1687" y="313"/>
                </a:lnTo>
                <a:lnTo>
                  <a:pt x="1691" y="314"/>
                </a:lnTo>
                <a:lnTo>
                  <a:pt x="1694" y="316"/>
                </a:lnTo>
                <a:lnTo>
                  <a:pt x="1698" y="317"/>
                </a:lnTo>
                <a:lnTo>
                  <a:pt x="1701" y="319"/>
                </a:lnTo>
                <a:lnTo>
                  <a:pt x="1704" y="321"/>
                </a:lnTo>
                <a:lnTo>
                  <a:pt x="1707" y="322"/>
                </a:lnTo>
                <a:lnTo>
                  <a:pt x="1711" y="322"/>
                </a:lnTo>
                <a:lnTo>
                  <a:pt x="1714" y="322"/>
                </a:lnTo>
                <a:lnTo>
                  <a:pt x="1718" y="322"/>
                </a:lnTo>
                <a:lnTo>
                  <a:pt x="1721" y="321"/>
                </a:lnTo>
                <a:lnTo>
                  <a:pt x="1725" y="321"/>
                </a:lnTo>
                <a:lnTo>
                  <a:pt x="1727" y="321"/>
                </a:lnTo>
                <a:lnTo>
                  <a:pt x="1731" y="322"/>
                </a:lnTo>
                <a:lnTo>
                  <a:pt x="1734" y="322"/>
                </a:lnTo>
                <a:lnTo>
                  <a:pt x="1738" y="323"/>
                </a:lnTo>
                <a:lnTo>
                  <a:pt x="1742" y="325"/>
                </a:lnTo>
                <a:lnTo>
                  <a:pt x="1745" y="326"/>
                </a:lnTo>
                <a:lnTo>
                  <a:pt x="1749" y="327"/>
                </a:lnTo>
                <a:lnTo>
                  <a:pt x="1752" y="328"/>
                </a:lnTo>
                <a:lnTo>
                  <a:pt x="1755" y="328"/>
                </a:lnTo>
                <a:lnTo>
                  <a:pt x="1758" y="329"/>
                </a:lnTo>
                <a:lnTo>
                  <a:pt x="1762" y="329"/>
                </a:lnTo>
                <a:lnTo>
                  <a:pt x="1765" y="329"/>
                </a:lnTo>
                <a:lnTo>
                  <a:pt x="1769" y="329"/>
                </a:lnTo>
                <a:lnTo>
                  <a:pt x="1772" y="328"/>
                </a:lnTo>
                <a:lnTo>
                  <a:pt x="1776" y="327"/>
                </a:lnTo>
                <a:lnTo>
                  <a:pt x="1778" y="326"/>
                </a:lnTo>
                <a:lnTo>
                  <a:pt x="1782" y="325"/>
                </a:lnTo>
                <a:lnTo>
                  <a:pt x="1785" y="325"/>
                </a:lnTo>
                <a:lnTo>
                  <a:pt x="1789" y="325"/>
                </a:lnTo>
                <a:lnTo>
                  <a:pt x="1792" y="325"/>
                </a:lnTo>
                <a:lnTo>
                  <a:pt x="1796" y="326"/>
                </a:lnTo>
                <a:lnTo>
                  <a:pt x="1799" y="326"/>
                </a:lnTo>
                <a:lnTo>
                  <a:pt x="1802" y="327"/>
                </a:lnTo>
                <a:lnTo>
                  <a:pt x="1805" y="328"/>
                </a:lnTo>
                <a:lnTo>
                  <a:pt x="1809" y="328"/>
                </a:lnTo>
                <a:lnTo>
                  <a:pt x="1812" y="328"/>
                </a:lnTo>
                <a:lnTo>
                  <a:pt x="1816" y="329"/>
                </a:lnTo>
                <a:lnTo>
                  <a:pt x="1819" y="329"/>
                </a:lnTo>
                <a:lnTo>
                  <a:pt x="1823" y="329"/>
                </a:lnTo>
                <a:lnTo>
                  <a:pt x="1826" y="329"/>
                </a:lnTo>
                <a:lnTo>
                  <a:pt x="1829" y="330"/>
                </a:lnTo>
                <a:lnTo>
                  <a:pt x="1832" y="330"/>
                </a:lnTo>
                <a:lnTo>
                  <a:pt x="1836" y="330"/>
                </a:lnTo>
                <a:lnTo>
                  <a:pt x="1839" y="330"/>
                </a:lnTo>
                <a:lnTo>
                  <a:pt x="1843" y="330"/>
                </a:lnTo>
                <a:lnTo>
                  <a:pt x="1846" y="330"/>
                </a:lnTo>
                <a:lnTo>
                  <a:pt x="1850" y="330"/>
                </a:lnTo>
                <a:lnTo>
                  <a:pt x="1852" y="329"/>
                </a:lnTo>
                <a:lnTo>
                  <a:pt x="1856" y="329"/>
                </a:lnTo>
                <a:lnTo>
                  <a:pt x="1859" y="328"/>
                </a:lnTo>
                <a:lnTo>
                  <a:pt x="1863" y="328"/>
                </a:lnTo>
                <a:lnTo>
                  <a:pt x="1866" y="328"/>
                </a:lnTo>
                <a:lnTo>
                  <a:pt x="1870" y="328"/>
                </a:lnTo>
                <a:lnTo>
                  <a:pt x="1873" y="328"/>
                </a:lnTo>
                <a:lnTo>
                  <a:pt x="1877" y="327"/>
                </a:lnTo>
                <a:lnTo>
                  <a:pt x="1879" y="327"/>
                </a:lnTo>
                <a:lnTo>
                  <a:pt x="1883" y="327"/>
                </a:lnTo>
                <a:lnTo>
                  <a:pt x="1886" y="327"/>
                </a:lnTo>
                <a:lnTo>
                  <a:pt x="1890" y="327"/>
                </a:lnTo>
                <a:lnTo>
                  <a:pt x="1893" y="327"/>
                </a:lnTo>
                <a:lnTo>
                  <a:pt x="1897" y="326"/>
                </a:lnTo>
                <a:lnTo>
                  <a:pt x="1900" y="326"/>
                </a:lnTo>
                <a:lnTo>
                  <a:pt x="1903" y="325"/>
                </a:lnTo>
                <a:lnTo>
                  <a:pt x="1906" y="325"/>
                </a:lnTo>
                <a:lnTo>
                  <a:pt x="1910" y="324"/>
                </a:lnTo>
                <a:lnTo>
                  <a:pt x="1913" y="323"/>
                </a:lnTo>
                <a:lnTo>
                  <a:pt x="1917" y="323"/>
                </a:lnTo>
                <a:lnTo>
                  <a:pt x="1920" y="322"/>
                </a:lnTo>
                <a:lnTo>
                  <a:pt x="1924" y="322"/>
                </a:lnTo>
                <a:lnTo>
                  <a:pt x="1927" y="321"/>
                </a:lnTo>
                <a:lnTo>
                  <a:pt x="1930" y="321"/>
                </a:lnTo>
                <a:lnTo>
                  <a:pt x="1933" y="321"/>
                </a:lnTo>
                <a:lnTo>
                  <a:pt x="1937" y="321"/>
                </a:lnTo>
                <a:lnTo>
                  <a:pt x="1940" y="321"/>
                </a:lnTo>
                <a:lnTo>
                  <a:pt x="1944" y="320"/>
                </a:lnTo>
                <a:lnTo>
                  <a:pt x="1947" y="320"/>
                </a:lnTo>
                <a:lnTo>
                  <a:pt x="1951" y="320"/>
                </a:lnTo>
                <a:lnTo>
                  <a:pt x="1953" y="319"/>
                </a:lnTo>
                <a:lnTo>
                  <a:pt x="1957" y="319"/>
                </a:lnTo>
                <a:lnTo>
                  <a:pt x="1960" y="319"/>
                </a:lnTo>
                <a:lnTo>
                  <a:pt x="1964" y="319"/>
                </a:lnTo>
                <a:lnTo>
                  <a:pt x="1967" y="319"/>
                </a:lnTo>
                <a:lnTo>
                  <a:pt x="1971" y="319"/>
                </a:lnTo>
                <a:lnTo>
                  <a:pt x="1974" y="319"/>
                </a:lnTo>
                <a:lnTo>
                  <a:pt x="1978" y="319"/>
                </a:lnTo>
                <a:lnTo>
                  <a:pt x="1980" y="319"/>
                </a:lnTo>
                <a:lnTo>
                  <a:pt x="1984" y="319"/>
                </a:lnTo>
                <a:lnTo>
                  <a:pt x="1987" y="319"/>
                </a:lnTo>
                <a:lnTo>
                  <a:pt x="1991" y="319"/>
                </a:lnTo>
                <a:lnTo>
                  <a:pt x="1994" y="318"/>
                </a:lnTo>
                <a:lnTo>
                  <a:pt x="1998" y="318"/>
                </a:lnTo>
                <a:lnTo>
                  <a:pt x="2001" y="317"/>
                </a:lnTo>
                <a:lnTo>
                  <a:pt x="2004" y="316"/>
                </a:lnTo>
                <a:lnTo>
                  <a:pt x="2007" y="315"/>
                </a:lnTo>
                <a:lnTo>
                  <a:pt x="2011" y="314"/>
                </a:lnTo>
                <a:lnTo>
                  <a:pt x="2014" y="313"/>
                </a:lnTo>
                <a:lnTo>
                  <a:pt x="2018" y="312"/>
                </a:lnTo>
                <a:lnTo>
                  <a:pt x="2021" y="312"/>
                </a:lnTo>
                <a:lnTo>
                  <a:pt x="2025" y="312"/>
                </a:lnTo>
                <a:lnTo>
                  <a:pt x="2028" y="312"/>
                </a:lnTo>
                <a:lnTo>
                  <a:pt x="2031" y="312"/>
                </a:lnTo>
                <a:lnTo>
                  <a:pt x="2034" y="313"/>
                </a:lnTo>
                <a:lnTo>
                  <a:pt x="2038" y="314"/>
                </a:lnTo>
                <a:lnTo>
                  <a:pt x="2041" y="314"/>
                </a:lnTo>
                <a:lnTo>
                  <a:pt x="2045" y="315"/>
                </a:lnTo>
                <a:lnTo>
                  <a:pt x="2048" y="315"/>
                </a:lnTo>
                <a:lnTo>
                  <a:pt x="2052" y="314"/>
                </a:lnTo>
                <a:lnTo>
                  <a:pt x="2055" y="314"/>
                </a:lnTo>
                <a:lnTo>
                  <a:pt x="2058" y="313"/>
                </a:lnTo>
                <a:lnTo>
                  <a:pt x="2062" y="313"/>
                </a:lnTo>
                <a:lnTo>
                  <a:pt x="2065" y="311"/>
                </a:lnTo>
                <a:lnTo>
                  <a:pt x="2069" y="310"/>
                </a:lnTo>
                <a:lnTo>
                  <a:pt x="2072" y="309"/>
                </a:lnTo>
                <a:lnTo>
                  <a:pt x="2076" y="307"/>
                </a:lnTo>
                <a:lnTo>
                  <a:pt x="2079" y="305"/>
                </a:lnTo>
                <a:lnTo>
                  <a:pt x="2082" y="303"/>
                </a:lnTo>
                <a:lnTo>
                  <a:pt x="2085" y="303"/>
                </a:lnTo>
                <a:lnTo>
                  <a:pt x="2089" y="302"/>
                </a:lnTo>
                <a:lnTo>
                  <a:pt x="2092" y="302"/>
                </a:lnTo>
                <a:lnTo>
                  <a:pt x="2096" y="302"/>
                </a:lnTo>
                <a:lnTo>
                  <a:pt x="2099" y="303"/>
                </a:lnTo>
                <a:lnTo>
                  <a:pt x="2103" y="304"/>
                </a:lnTo>
                <a:lnTo>
                  <a:pt x="2105" y="306"/>
                </a:lnTo>
                <a:lnTo>
                  <a:pt x="2109" y="308"/>
                </a:lnTo>
                <a:lnTo>
                  <a:pt x="2112" y="310"/>
                </a:lnTo>
                <a:lnTo>
                  <a:pt x="2116" y="311"/>
                </a:lnTo>
                <a:lnTo>
                  <a:pt x="2119" y="313"/>
                </a:lnTo>
                <a:lnTo>
                  <a:pt x="2123" y="314"/>
                </a:lnTo>
                <a:lnTo>
                  <a:pt x="2126" y="315"/>
                </a:lnTo>
                <a:lnTo>
                  <a:pt x="2129" y="316"/>
                </a:lnTo>
                <a:lnTo>
                  <a:pt x="2132" y="316"/>
                </a:lnTo>
                <a:lnTo>
                  <a:pt x="2136" y="316"/>
                </a:lnTo>
                <a:lnTo>
                  <a:pt x="2139" y="315"/>
                </a:lnTo>
                <a:lnTo>
                  <a:pt x="2143" y="315"/>
                </a:lnTo>
                <a:lnTo>
                  <a:pt x="2146" y="315"/>
                </a:lnTo>
                <a:lnTo>
                  <a:pt x="2150" y="315"/>
                </a:lnTo>
                <a:lnTo>
                  <a:pt x="2153" y="315"/>
                </a:lnTo>
                <a:lnTo>
                  <a:pt x="2156" y="315"/>
                </a:lnTo>
                <a:lnTo>
                  <a:pt x="2159" y="316"/>
                </a:lnTo>
                <a:lnTo>
                  <a:pt x="2163" y="316"/>
                </a:lnTo>
                <a:lnTo>
                  <a:pt x="2166" y="316"/>
                </a:lnTo>
                <a:lnTo>
                  <a:pt x="2170" y="316"/>
                </a:lnTo>
                <a:lnTo>
                  <a:pt x="2173" y="317"/>
                </a:lnTo>
                <a:lnTo>
                  <a:pt x="2177" y="317"/>
                </a:lnTo>
                <a:lnTo>
                  <a:pt x="2179" y="316"/>
                </a:lnTo>
                <a:lnTo>
                  <a:pt x="2183" y="316"/>
                </a:lnTo>
                <a:lnTo>
                  <a:pt x="2186" y="316"/>
                </a:lnTo>
                <a:lnTo>
                  <a:pt x="2190" y="316"/>
                </a:lnTo>
                <a:lnTo>
                  <a:pt x="2193" y="315"/>
                </a:lnTo>
                <a:lnTo>
                  <a:pt x="2197" y="315"/>
                </a:lnTo>
                <a:lnTo>
                  <a:pt x="2200" y="315"/>
                </a:lnTo>
                <a:lnTo>
                  <a:pt x="2204" y="314"/>
                </a:lnTo>
                <a:lnTo>
                  <a:pt x="2206" y="314"/>
                </a:lnTo>
                <a:lnTo>
                  <a:pt x="2210" y="313"/>
                </a:lnTo>
                <a:lnTo>
                  <a:pt x="2213" y="313"/>
                </a:lnTo>
                <a:lnTo>
                  <a:pt x="2217" y="312"/>
                </a:lnTo>
                <a:lnTo>
                  <a:pt x="2220" y="312"/>
                </a:lnTo>
                <a:lnTo>
                  <a:pt x="2224" y="311"/>
                </a:lnTo>
                <a:lnTo>
                  <a:pt x="2227" y="310"/>
                </a:lnTo>
                <a:lnTo>
                  <a:pt x="2230" y="310"/>
                </a:lnTo>
                <a:lnTo>
                  <a:pt x="2233" y="309"/>
                </a:lnTo>
                <a:lnTo>
                  <a:pt x="2237" y="309"/>
                </a:lnTo>
                <a:lnTo>
                  <a:pt x="2240" y="308"/>
                </a:lnTo>
                <a:lnTo>
                  <a:pt x="2244" y="306"/>
                </a:lnTo>
                <a:lnTo>
                  <a:pt x="2247" y="304"/>
                </a:lnTo>
                <a:lnTo>
                  <a:pt x="2251" y="303"/>
                </a:lnTo>
                <a:lnTo>
                  <a:pt x="2254" y="300"/>
                </a:lnTo>
                <a:lnTo>
                  <a:pt x="2257" y="296"/>
                </a:lnTo>
                <a:lnTo>
                  <a:pt x="2260" y="292"/>
                </a:lnTo>
                <a:lnTo>
                  <a:pt x="2264" y="287"/>
                </a:lnTo>
                <a:lnTo>
                  <a:pt x="2267" y="280"/>
                </a:lnTo>
                <a:lnTo>
                  <a:pt x="2271" y="272"/>
                </a:lnTo>
                <a:lnTo>
                  <a:pt x="2274" y="262"/>
                </a:lnTo>
                <a:lnTo>
                  <a:pt x="2278" y="246"/>
                </a:lnTo>
                <a:lnTo>
                  <a:pt x="2280" y="223"/>
                </a:lnTo>
                <a:lnTo>
                  <a:pt x="2284" y="191"/>
                </a:lnTo>
                <a:lnTo>
                  <a:pt x="2287" y="147"/>
                </a:lnTo>
                <a:lnTo>
                  <a:pt x="2291" y="90"/>
                </a:lnTo>
                <a:lnTo>
                  <a:pt x="2294" y="20"/>
                </a:lnTo>
                <a:lnTo>
                  <a:pt x="229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5" name="Freeform 167">
            <a:extLst>
              <a:ext uri="{FF2B5EF4-FFF2-40B4-BE49-F238E27FC236}">
                <a16:creationId xmlns:a16="http://schemas.microsoft.com/office/drawing/2014/main" id="{49081771-368E-1CB4-29F7-D980A064C4F4}"/>
              </a:ext>
            </a:extLst>
          </p:cNvPr>
          <p:cNvSpPr>
            <a:spLocks/>
          </p:cNvSpPr>
          <p:nvPr/>
        </p:nvSpPr>
        <p:spPr bwMode="auto">
          <a:xfrm>
            <a:off x="3871230" y="1848114"/>
            <a:ext cx="23487" cy="94223"/>
          </a:xfrm>
          <a:custGeom>
            <a:avLst/>
            <a:gdLst>
              <a:gd name="T0" fmla="*/ 0 w 35"/>
              <a:gd name="T1" fmla="*/ 0 h 65"/>
              <a:gd name="T2" fmla="*/ 2 w 35"/>
              <a:gd name="T3" fmla="*/ 3 h 65"/>
              <a:gd name="T4" fmla="*/ 5 w 35"/>
              <a:gd name="T5" fmla="*/ 11 h 65"/>
              <a:gd name="T6" fmla="*/ 9 w 35"/>
              <a:gd name="T7" fmla="*/ 18 h 65"/>
              <a:gd name="T8" fmla="*/ 11 w 35"/>
              <a:gd name="T9" fmla="*/ 24 h 65"/>
              <a:gd name="T10" fmla="*/ 15 w 35"/>
              <a:gd name="T11" fmla="*/ 31 h 65"/>
              <a:gd name="T12" fmla="*/ 18 w 35"/>
              <a:gd name="T13" fmla="*/ 37 h 65"/>
              <a:gd name="T14" fmla="*/ 22 w 35"/>
              <a:gd name="T15" fmla="*/ 44 h 65"/>
              <a:gd name="T16" fmla="*/ 25 w 35"/>
              <a:gd name="T17" fmla="*/ 50 h 65"/>
              <a:gd name="T18" fmla="*/ 29 w 35"/>
              <a:gd name="T19" fmla="*/ 56 h 65"/>
              <a:gd name="T20" fmla="*/ 32 w 35"/>
              <a:gd name="T21" fmla="*/ 60 h 65"/>
              <a:gd name="T22" fmla="*/ 35 w 35"/>
              <a:gd name="T23" fmla="*/ 65 h 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35" h="65">
                <a:moveTo>
                  <a:pt x="0" y="0"/>
                </a:moveTo>
                <a:lnTo>
                  <a:pt x="2" y="3"/>
                </a:lnTo>
                <a:lnTo>
                  <a:pt x="5" y="11"/>
                </a:lnTo>
                <a:lnTo>
                  <a:pt x="9" y="18"/>
                </a:lnTo>
                <a:lnTo>
                  <a:pt x="11" y="24"/>
                </a:lnTo>
                <a:lnTo>
                  <a:pt x="15" y="31"/>
                </a:lnTo>
                <a:lnTo>
                  <a:pt x="18" y="37"/>
                </a:lnTo>
                <a:lnTo>
                  <a:pt x="22" y="44"/>
                </a:lnTo>
                <a:lnTo>
                  <a:pt x="25" y="50"/>
                </a:lnTo>
                <a:lnTo>
                  <a:pt x="29" y="56"/>
                </a:lnTo>
                <a:lnTo>
                  <a:pt x="32" y="60"/>
                </a:lnTo>
                <a:lnTo>
                  <a:pt x="35" y="65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6" name="Rectangle 169">
            <a:extLst>
              <a:ext uri="{FF2B5EF4-FFF2-40B4-BE49-F238E27FC236}">
                <a16:creationId xmlns:a16="http://schemas.microsoft.com/office/drawing/2014/main" id="{AE39FE53-671F-3D52-C7F1-FEB3C9EA18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96302" y="1846664"/>
            <a:ext cx="1693047" cy="720437"/>
          </a:xfrm>
          <a:prstGeom prst="rect">
            <a:avLst/>
          </a:prstGeom>
          <a:noFill/>
          <a:ln w="12700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7" name="Rectangle 341">
            <a:extLst>
              <a:ext uri="{FF2B5EF4-FFF2-40B4-BE49-F238E27FC236}">
                <a16:creationId xmlns:a16="http://schemas.microsoft.com/office/drawing/2014/main" id="{CB11A929-0EB5-A84B-D299-90C41FC405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2432" y="2167154"/>
            <a:ext cx="42904" cy="97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25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8" name="Rectangle 343">
            <a:extLst>
              <a:ext uri="{FF2B5EF4-FFF2-40B4-BE49-F238E27FC236}">
                <a16:creationId xmlns:a16="http://schemas.microsoft.com/office/drawing/2014/main" id="{CA2AB24D-7044-EF59-3788-74EDD091DD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9746" y="1835391"/>
            <a:ext cx="104686" cy="1007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19" name="Rectangle 341">
            <a:extLst>
              <a:ext uri="{FF2B5EF4-FFF2-40B4-BE49-F238E27FC236}">
                <a16:creationId xmlns:a16="http://schemas.microsoft.com/office/drawing/2014/main" id="{B1F3FD0F-C51A-BD62-5BBB-E7C180ACF7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8294" y="2502994"/>
            <a:ext cx="21452" cy="97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0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0" name="グループ化 43">
            <a:extLst>
              <a:ext uri="{FF2B5EF4-FFF2-40B4-BE49-F238E27FC236}">
                <a16:creationId xmlns:a16="http://schemas.microsoft.com/office/drawing/2014/main" id="{6690F11B-FEAE-FB58-2813-AECD2A6E3E59}"/>
              </a:ext>
            </a:extLst>
          </p:cNvPr>
          <p:cNvGrpSpPr/>
          <p:nvPr/>
        </p:nvGrpSpPr>
        <p:grpSpPr>
          <a:xfrm>
            <a:off x="2077506" y="2831739"/>
            <a:ext cx="1809205" cy="721772"/>
            <a:chOff x="3935547" y="4049008"/>
            <a:chExt cx="1724847" cy="805937"/>
          </a:xfrm>
        </p:grpSpPr>
        <p:sp>
          <p:nvSpPr>
            <p:cNvPr id="521" name="Line 404">
              <a:extLst>
                <a:ext uri="{FF2B5EF4-FFF2-40B4-BE49-F238E27FC236}">
                  <a16:creationId xmlns:a16="http://schemas.microsoft.com/office/drawing/2014/main" id="{8620ADCD-6967-4AFB-4115-CEF9990180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7536" y="4809421"/>
              <a:ext cx="1153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2" name="Line 409">
              <a:extLst>
                <a:ext uri="{FF2B5EF4-FFF2-40B4-BE49-F238E27FC236}">
                  <a16:creationId xmlns:a16="http://schemas.microsoft.com/office/drawing/2014/main" id="{7EF868BD-4EB9-E327-2617-FABC90E8BF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7536" y="4455408"/>
              <a:ext cx="1153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3" name="Line 414">
              <a:extLst>
                <a:ext uri="{FF2B5EF4-FFF2-40B4-BE49-F238E27FC236}">
                  <a16:creationId xmlns:a16="http://schemas.microsoft.com/office/drawing/2014/main" id="{75B833CD-4ED0-FDC8-0C66-C4CAB23EA8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7536" y="4099808"/>
              <a:ext cx="1153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4" name="Line 415">
              <a:extLst>
                <a:ext uri="{FF2B5EF4-FFF2-40B4-BE49-F238E27FC236}">
                  <a16:creationId xmlns:a16="http://schemas.microsoft.com/office/drawing/2014/main" id="{FD4170A3-D0DF-A655-B949-F0A524F940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16646" y="4809421"/>
              <a:ext cx="224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5" name="Line 417">
              <a:extLst>
                <a:ext uri="{FF2B5EF4-FFF2-40B4-BE49-F238E27FC236}">
                  <a16:creationId xmlns:a16="http://schemas.microsoft.com/office/drawing/2014/main" id="{6C4551A8-A7C5-C25C-B925-876A89108A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16646" y="4455408"/>
              <a:ext cx="224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6" name="Line 419">
              <a:extLst>
                <a:ext uri="{FF2B5EF4-FFF2-40B4-BE49-F238E27FC236}">
                  <a16:creationId xmlns:a16="http://schemas.microsoft.com/office/drawing/2014/main" id="{FCD2C44E-E215-8897-D736-A69A520D57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16646" y="4099808"/>
              <a:ext cx="224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7" name="Freeform 422">
              <a:extLst>
                <a:ext uri="{FF2B5EF4-FFF2-40B4-BE49-F238E27FC236}">
                  <a16:creationId xmlns:a16="http://schemas.microsoft.com/office/drawing/2014/main" id="{C6618273-9630-7DE9-3C75-F43D178C4DCC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9707" y="4050596"/>
              <a:ext cx="1477195" cy="633413"/>
            </a:xfrm>
            <a:custGeom>
              <a:avLst/>
              <a:gdLst>
                <a:gd name="T0" fmla="*/ 32 w 2306"/>
                <a:gd name="T1" fmla="*/ 382 h 399"/>
                <a:gd name="T2" fmla="*/ 69 w 2306"/>
                <a:gd name="T3" fmla="*/ 335 h 399"/>
                <a:gd name="T4" fmla="*/ 106 w 2306"/>
                <a:gd name="T5" fmla="*/ 376 h 399"/>
                <a:gd name="T6" fmla="*/ 143 w 2306"/>
                <a:gd name="T7" fmla="*/ 380 h 399"/>
                <a:gd name="T8" fmla="*/ 181 w 2306"/>
                <a:gd name="T9" fmla="*/ 379 h 399"/>
                <a:gd name="T10" fmla="*/ 217 w 2306"/>
                <a:gd name="T11" fmla="*/ 376 h 399"/>
                <a:gd name="T12" fmla="*/ 255 w 2306"/>
                <a:gd name="T13" fmla="*/ 378 h 399"/>
                <a:gd name="T14" fmla="*/ 292 w 2306"/>
                <a:gd name="T15" fmla="*/ 373 h 399"/>
                <a:gd name="T16" fmla="*/ 329 w 2306"/>
                <a:gd name="T17" fmla="*/ 373 h 399"/>
                <a:gd name="T18" fmla="*/ 366 w 2306"/>
                <a:gd name="T19" fmla="*/ 374 h 399"/>
                <a:gd name="T20" fmla="*/ 403 w 2306"/>
                <a:gd name="T21" fmla="*/ 371 h 399"/>
                <a:gd name="T22" fmla="*/ 440 w 2306"/>
                <a:gd name="T23" fmla="*/ 373 h 399"/>
                <a:gd name="T24" fmla="*/ 477 w 2306"/>
                <a:gd name="T25" fmla="*/ 374 h 399"/>
                <a:gd name="T26" fmla="*/ 515 w 2306"/>
                <a:gd name="T27" fmla="*/ 373 h 399"/>
                <a:gd name="T28" fmla="*/ 551 w 2306"/>
                <a:gd name="T29" fmla="*/ 367 h 399"/>
                <a:gd name="T30" fmla="*/ 589 w 2306"/>
                <a:gd name="T31" fmla="*/ 371 h 399"/>
                <a:gd name="T32" fmla="*/ 625 w 2306"/>
                <a:gd name="T33" fmla="*/ 368 h 399"/>
                <a:gd name="T34" fmla="*/ 663 w 2306"/>
                <a:gd name="T35" fmla="*/ 367 h 399"/>
                <a:gd name="T36" fmla="*/ 699 w 2306"/>
                <a:gd name="T37" fmla="*/ 358 h 399"/>
                <a:gd name="T38" fmla="*/ 737 w 2306"/>
                <a:gd name="T39" fmla="*/ 337 h 399"/>
                <a:gd name="T40" fmla="*/ 773 w 2306"/>
                <a:gd name="T41" fmla="*/ 365 h 399"/>
                <a:gd name="T42" fmla="*/ 811 w 2306"/>
                <a:gd name="T43" fmla="*/ 368 h 399"/>
                <a:gd name="T44" fmla="*/ 848 w 2306"/>
                <a:gd name="T45" fmla="*/ 361 h 399"/>
                <a:gd name="T46" fmla="*/ 885 w 2306"/>
                <a:gd name="T47" fmla="*/ 364 h 399"/>
                <a:gd name="T48" fmla="*/ 922 w 2306"/>
                <a:gd name="T49" fmla="*/ 359 h 399"/>
                <a:gd name="T50" fmla="*/ 959 w 2306"/>
                <a:gd name="T51" fmla="*/ 356 h 399"/>
                <a:gd name="T52" fmla="*/ 997 w 2306"/>
                <a:gd name="T53" fmla="*/ 358 h 399"/>
                <a:gd name="T54" fmla="*/ 1033 w 2306"/>
                <a:gd name="T55" fmla="*/ 322 h 399"/>
                <a:gd name="T56" fmla="*/ 1071 w 2306"/>
                <a:gd name="T57" fmla="*/ 352 h 399"/>
                <a:gd name="T58" fmla="*/ 1108 w 2306"/>
                <a:gd name="T59" fmla="*/ 355 h 399"/>
                <a:gd name="T60" fmla="*/ 1145 w 2306"/>
                <a:gd name="T61" fmla="*/ 355 h 399"/>
                <a:gd name="T62" fmla="*/ 1182 w 2306"/>
                <a:gd name="T63" fmla="*/ 292 h 399"/>
                <a:gd name="T64" fmla="*/ 1219 w 2306"/>
                <a:gd name="T65" fmla="*/ 272 h 399"/>
                <a:gd name="T66" fmla="*/ 1256 w 2306"/>
                <a:gd name="T67" fmla="*/ 277 h 399"/>
                <a:gd name="T68" fmla="*/ 1293 w 2306"/>
                <a:gd name="T69" fmla="*/ 323 h 399"/>
                <a:gd name="T70" fmla="*/ 1330 w 2306"/>
                <a:gd name="T71" fmla="*/ 303 h 399"/>
                <a:gd name="T72" fmla="*/ 1367 w 2306"/>
                <a:gd name="T73" fmla="*/ 302 h 399"/>
                <a:gd name="T74" fmla="*/ 1404 w 2306"/>
                <a:gd name="T75" fmla="*/ 301 h 399"/>
                <a:gd name="T76" fmla="*/ 1442 w 2306"/>
                <a:gd name="T77" fmla="*/ 320 h 399"/>
                <a:gd name="T78" fmla="*/ 1478 w 2306"/>
                <a:gd name="T79" fmla="*/ 336 h 399"/>
                <a:gd name="T80" fmla="*/ 1516 w 2306"/>
                <a:gd name="T81" fmla="*/ 324 h 399"/>
                <a:gd name="T82" fmla="*/ 1552 w 2306"/>
                <a:gd name="T83" fmla="*/ 333 h 399"/>
                <a:gd name="T84" fmla="*/ 1590 w 2306"/>
                <a:gd name="T85" fmla="*/ 327 h 399"/>
                <a:gd name="T86" fmla="*/ 1626 w 2306"/>
                <a:gd name="T87" fmla="*/ 335 h 399"/>
                <a:gd name="T88" fmla="*/ 1664 w 2306"/>
                <a:gd name="T89" fmla="*/ 317 h 399"/>
                <a:gd name="T90" fmla="*/ 1701 w 2306"/>
                <a:gd name="T91" fmla="*/ 318 h 399"/>
                <a:gd name="T92" fmla="*/ 1738 w 2306"/>
                <a:gd name="T93" fmla="*/ 319 h 399"/>
                <a:gd name="T94" fmla="*/ 1776 w 2306"/>
                <a:gd name="T95" fmla="*/ 322 h 399"/>
                <a:gd name="T96" fmla="*/ 1812 w 2306"/>
                <a:gd name="T97" fmla="*/ 326 h 399"/>
                <a:gd name="T98" fmla="*/ 1850 w 2306"/>
                <a:gd name="T99" fmla="*/ 325 h 399"/>
                <a:gd name="T100" fmla="*/ 1886 w 2306"/>
                <a:gd name="T101" fmla="*/ 324 h 399"/>
                <a:gd name="T102" fmla="*/ 1924 w 2306"/>
                <a:gd name="T103" fmla="*/ 316 h 399"/>
                <a:gd name="T104" fmla="*/ 1960 w 2306"/>
                <a:gd name="T105" fmla="*/ 316 h 399"/>
                <a:gd name="T106" fmla="*/ 1998 w 2306"/>
                <a:gd name="T107" fmla="*/ 312 h 399"/>
                <a:gd name="T108" fmla="*/ 2034 w 2306"/>
                <a:gd name="T109" fmla="*/ 305 h 399"/>
                <a:gd name="T110" fmla="*/ 2072 w 2306"/>
                <a:gd name="T111" fmla="*/ 298 h 399"/>
                <a:gd name="T112" fmla="*/ 2109 w 2306"/>
                <a:gd name="T113" fmla="*/ 301 h 399"/>
                <a:gd name="T114" fmla="*/ 2146 w 2306"/>
                <a:gd name="T115" fmla="*/ 309 h 399"/>
                <a:gd name="T116" fmla="*/ 2183 w 2306"/>
                <a:gd name="T117" fmla="*/ 310 h 399"/>
                <a:gd name="T118" fmla="*/ 2220 w 2306"/>
                <a:gd name="T119" fmla="*/ 304 h 399"/>
                <a:gd name="T120" fmla="*/ 2257 w 2306"/>
                <a:gd name="T121" fmla="*/ 295 h 399"/>
                <a:gd name="T122" fmla="*/ 2294 w 2306"/>
                <a:gd name="T123" fmla="*/ 190 h 3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306" h="399">
                  <a:moveTo>
                    <a:pt x="0" y="399"/>
                  </a:moveTo>
                  <a:lnTo>
                    <a:pt x="2" y="398"/>
                  </a:lnTo>
                  <a:lnTo>
                    <a:pt x="5" y="398"/>
                  </a:lnTo>
                  <a:lnTo>
                    <a:pt x="9" y="397"/>
                  </a:lnTo>
                  <a:lnTo>
                    <a:pt x="12" y="396"/>
                  </a:lnTo>
                  <a:lnTo>
                    <a:pt x="16" y="396"/>
                  </a:lnTo>
                  <a:lnTo>
                    <a:pt x="18" y="394"/>
                  </a:lnTo>
                  <a:lnTo>
                    <a:pt x="22" y="393"/>
                  </a:lnTo>
                  <a:lnTo>
                    <a:pt x="25" y="390"/>
                  </a:lnTo>
                  <a:lnTo>
                    <a:pt x="29" y="387"/>
                  </a:lnTo>
                  <a:lnTo>
                    <a:pt x="32" y="382"/>
                  </a:lnTo>
                  <a:lnTo>
                    <a:pt x="36" y="376"/>
                  </a:lnTo>
                  <a:lnTo>
                    <a:pt x="39" y="369"/>
                  </a:lnTo>
                  <a:lnTo>
                    <a:pt x="42" y="361"/>
                  </a:lnTo>
                  <a:lnTo>
                    <a:pt x="45" y="352"/>
                  </a:lnTo>
                  <a:lnTo>
                    <a:pt x="49" y="344"/>
                  </a:lnTo>
                  <a:lnTo>
                    <a:pt x="52" y="338"/>
                  </a:lnTo>
                  <a:lnTo>
                    <a:pt x="56" y="333"/>
                  </a:lnTo>
                  <a:lnTo>
                    <a:pt x="59" y="330"/>
                  </a:lnTo>
                  <a:lnTo>
                    <a:pt x="63" y="330"/>
                  </a:lnTo>
                  <a:lnTo>
                    <a:pt x="66" y="332"/>
                  </a:lnTo>
                  <a:lnTo>
                    <a:pt x="69" y="335"/>
                  </a:lnTo>
                  <a:lnTo>
                    <a:pt x="72" y="339"/>
                  </a:lnTo>
                  <a:lnTo>
                    <a:pt x="76" y="345"/>
                  </a:lnTo>
                  <a:lnTo>
                    <a:pt x="79" y="350"/>
                  </a:lnTo>
                  <a:lnTo>
                    <a:pt x="83" y="356"/>
                  </a:lnTo>
                  <a:lnTo>
                    <a:pt x="86" y="361"/>
                  </a:lnTo>
                  <a:lnTo>
                    <a:pt x="90" y="366"/>
                  </a:lnTo>
                  <a:lnTo>
                    <a:pt x="92" y="369"/>
                  </a:lnTo>
                  <a:lnTo>
                    <a:pt x="96" y="372"/>
                  </a:lnTo>
                  <a:lnTo>
                    <a:pt x="99" y="374"/>
                  </a:lnTo>
                  <a:lnTo>
                    <a:pt x="103" y="375"/>
                  </a:lnTo>
                  <a:lnTo>
                    <a:pt x="106" y="376"/>
                  </a:lnTo>
                  <a:lnTo>
                    <a:pt x="110" y="377"/>
                  </a:lnTo>
                  <a:lnTo>
                    <a:pt x="113" y="378"/>
                  </a:lnTo>
                  <a:lnTo>
                    <a:pt x="117" y="378"/>
                  </a:lnTo>
                  <a:lnTo>
                    <a:pt x="119" y="378"/>
                  </a:lnTo>
                  <a:lnTo>
                    <a:pt x="123" y="379"/>
                  </a:lnTo>
                  <a:lnTo>
                    <a:pt x="126" y="379"/>
                  </a:lnTo>
                  <a:lnTo>
                    <a:pt x="130" y="379"/>
                  </a:lnTo>
                  <a:lnTo>
                    <a:pt x="133" y="379"/>
                  </a:lnTo>
                  <a:lnTo>
                    <a:pt x="137" y="380"/>
                  </a:lnTo>
                  <a:lnTo>
                    <a:pt x="140" y="380"/>
                  </a:lnTo>
                  <a:lnTo>
                    <a:pt x="143" y="380"/>
                  </a:lnTo>
                  <a:lnTo>
                    <a:pt x="146" y="380"/>
                  </a:lnTo>
                  <a:lnTo>
                    <a:pt x="150" y="380"/>
                  </a:lnTo>
                  <a:lnTo>
                    <a:pt x="153" y="379"/>
                  </a:lnTo>
                  <a:lnTo>
                    <a:pt x="157" y="379"/>
                  </a:lnTo>
                  <a:lnTo>
                    <a:pt x="161" y="379"/>
                  </a:lnTo>
                  <a:lnTo>
                    <a:pt x="164" y="379"/>
                  </a:lnTo>
                  <a:lnTo>
                    <a:pt x="167" y="379"/>
                  </a:lnTo>
                  <a:lnTo>
                    <a:pt x="170" y="379"/>
                  </a:lnTo>
                  <a:lnTo>
                    <a:pt x="174" y="379"/>
                  </a:lnTo>
                  <a:lnTo>
                    <a:pt x="177" y="379"/>
                  </a:lnTo>
                  <a:lnTo>
                    <a:pt x="181" y="379"/>
                  </a:lnTo>
                  <a:lnTo>
                    <a:pt x="184" y="378"/>
                  </a:lnTo>
                  <a:lnTo>
                    <a:pt x="188" y="378"/>
                  </a:lnTo>
                  <a:lnTo>
                    <a:pt x="191" y="377"/>
                  </a:lnTo>
                  <a:lnTo>
                    <a:pt x="194" y="377"/>
                  </a:lnTo>
                  <a:lnTo>
                    <a:pt x="197" y="376"/>
                  </a:lnTo>
                  <a:lnTo>
                    <a:pt x="201" y="375"/>
                  </a:lnTo>
                  <a:lnTo>
                    <a:pt x="204" y="375"/>
                  </a:lnTo>
                  <a:lnTo>
                    <a:pt x="208" y="375"/>
                  </a:lnTo>
                  <a:lnTo>
                    <a:pt x="211" y="375"/>
                  </a:lnTo>
                  <a:lnTo>
                    <a:pt x="215" y="375"/>
                  </a:lnTo>
                  <a:lnTo>
                    <a:pt x="217" y="376"/>
                  </a:lnTo>
                  <a:lnTo>
                    <a:pt x="221" y="376"/>
                  </a:lnTo>
                  <a:lnTo>
                    <a:pt x="224" y="377"/>
                  </a:lnTo>
                  <a:lnTo>
                    <a:pt x="228" y="377"/>
                  </a:lnTo>
                  <a:lnTo>
                    <a:pt x="231" y="378"/>
                  </a:lnTo>
                  <a:lnTo>
                    <a:pt x="235" y="378"/>
                  </a:lnTo>
                  <a:lnTo>
                    <a:pt x="238" y="378"/>
                  </a:lnTo>
                  <a:lnTo>
                    <a:pt x="242" y="378"/>
                  </a:lnTo>
                  <a:lnTo>
                    <a:pt x="244" y="378"/>
                  </a:lnTo>
                  <a:lnTo>
                    <a:pt x="248" y="378"/>
                  </a:lnTo>
                  <a:lnTo>
                    <a:pt x="251" y="378"/>
                  </a:lnTo>
                  <a:lnTo>
                    <a:pt x="255" y="378"/>
                  </a:lnTo>
                  <a:lnTo>
                    <a:pt x="258" y="377"/>
                  </a:lnTo>
                  <a:lnTo>
                    <a:pt x="262" y="376"/>
                  </a:lnTo>
                  <a:lnTo>
                    <a:pt x="265" y="376"/>
                  </a:lnTo>
                  <a:lnTo>
                    <a:pt x="268" y="375"/>
                  </a:lnTo>
                  <a:lnTo>
                    <a:pt x="271" y="375"/>
                  </a:lnTo>
                  <a:lnTo>
                    <a:pt x="275" y="374"/>
                  </a:lnTo>
                  <a:lnTo>
                    <a:pt x="278" y="374"/>
                  </a:lnTo>
                  <a:lnTo>
                    <a:pt x="282" y="373"/>
                  </a:lnTo>
                  <a:lnTo>
                    <a:pt x="285" y="373"/>
                  </a:lnTo>
                  <a:lnTo>
                    <a:pt x="289" y="373"/>
                  </a:lnTo>
                  <a:lnTo>
                    <a:pt x="292" y="373"/>
                  </a:lnTo>
                  <a:lnTo>
                    <a:pt x="295" y="373"/>
                  </a:lnTo>
                  <a:lnTo>
                    <a:pt x="298" y="373"/>
                  </a:lnTo>
                  <a:lnTo>
                    <a:pt x="302" y="373"/>
                  </a:lnTo>
                  <a:lnTo>
                    <a:pt x="305" y="372"/>
                  </a:lnTo>
                  <a:lnTo>
                    <a:pt x="309" y="372"/>
                  </a:lnTo>
                  <a:lnTo>
                    <a:pt x="312" y="372"/>
                  </a:lnTo>
                  <a:lnTo>
                    <a:pt x="316" y="373"/>
                  </a:lnTo>
                  <a:lnTo>
                    <a:pt x="318" y="373"/>
                  </a:lnTo>
                  <a:lnTo>
                    <a:pt x="322" y="373"/>
                  </a:lnTo>
                  <a:lnTo>
                    <a:pt x="325" y="373"/>
                  </a:lnTo>
                  <a:lnTo>
                    <a:pt x="329" y="373"/>
                  </a:lnTo>
                  <a:lnTo>
                    <a:pt x="332" y="373"/>
                  </a:lnTo>
                  <a:lnTo>
                    <a:pt x="336" y="373"/>
                  </a:lnTo>
                  <a:lnTo>
                    <a:pt x="339" y="374"/>
                  </a:lnTo>
                  <a:lnTo>
                    <a:pt x="343" y="374"/>
                  </a:lnTo>
                  <a:lnTo>
                    <a:pt x="345" y="374"/>
                  </a:lnTo>
                  <a:lnTo>
                    <a:pt x="349" y="374"/>
                  </a:lnTo>
                  <a:lnTo>
                    <a:pt x="352" y="374"/>
                  </a:lnTo>
                  <a:lnTo>
                    <a:pt x="356" y="374"/>
                  </a:lnTo>
                  <a:lnTo>
                    <a:pt x="359" y="374"/>
                  </a:lnTo>
                  <a:lnTo>
                    <a:pt x="363" y="374"/>
                  </a:lnTo>
                  <a:lnTo>
                    <a:pt x="366" y="374"/>
                  </a:lnTo>
                  <a:lnTo>
                    <a:pt x="369" y="374"/>
                  </a:lnTo>
                  <a:lnTo>
                    <a:pt x="372" y="374"/>
                  </a:lnTo>
                  <a:lnTo>
                    <a:pt x="376" y="373"/>
                  </a:lnTo>
                  <a:lnTo>
                    <a:pt x="379" y="373"/>
                  </a:lnTo>
                  <a:lnTo>
                    <a:pt x="383" y="373"/>
                  </a:lnTo>
                  <a:lnTo>
                    <a:pt x="386" y="373"/>
                  </a:lnTo>
                  <a:lnTo>
                    <a:pt x="390" y="373"/>
                  </a:lnTo>
                  <a:lnTo>
                    <a:pt x="393" y="373"/>
                  </a:lnTo>
                  <a:lnTo>
                    <a:pt x="396" y="372"/>
                  </a:lnTo>
                  <a:lnTo>
                    <a:pt x="399" y="372"/>
                  </a:lnTo>
                  <a:lnTo>
                    <a:pt x="403" y="371"/>
                  </a:lnTo>
                  <a:lnTo>
                    <a:pt x="406" y="371"/>
                  </a:lnTo>
                  <a:lnTo>
                    <a:pt x="410" y="371"/>
                  </a:lnTo>
                  <a:lnTo>
                    <a:pt x="413" y="371"/>
                  </a:lnTo>
                  <a:lnTo>
                    <a:pt x="417" y="371"/>
                  </a:lnTo>
                  <a:lnTo>
                    <a:pt x="419" y="372"/>
                  </a:lnTo>
                  <a:lnTo>
                    <a:pt x="423" y="372"/>
                  </a:lnTo>
                  <a:lnTo>
                    <a:pt x="426" y="372"/>
                  </a:lnTo>
                  <a:lnTo>
                    <a:pt x="430" y="373"/>
                  </a:lnTo>
                  <a:lnTo>
                    <a:pt x="433" y="373"/>
                  </a:lnTo>
                  <a:lnTo>
                    <a:pt x="437" y="373"/>
                  </a:lnTo>
                  <a:lnTo>
                    <a:pt x="440" y="373"/>
                  </a:lnTo>
                  <a:lnTo>
                    <a:pt x="444" y="373"/>
                  </a:lnTo>
                  <a:lnTo>
                    <a:pt x="446" y="373"/>
                  </a:lnTo>
                  <a:lnTo>
                    <a:pt x="450" y="373"/>
                  </a:lnTo>
                  <a:lnTo>
                    <a:pt x="453" y="373"/>
                  </a:lnTo>
                  <a:lnTo>
                    <a:pt x="457" y="373"/>
                  </a:lnTo>
                  <a:lnTo>
                    <a:pt x="460" y="373"/>
                  </a:lnTo>
                  <a:lnTo>
                    <a:pt x="464" y="373"/>
                  </a:lnTo>
                  <a:lnTo>
                    <a:pt x="467" y="374"/>
                  </a:lnTo>
                  <a:lnTo>
                    <a:pt x="470" y="374"/>
                  </a:lnTo>
                  <a:lnTo>
                    <a:pt x="473" y="374"/>
                  </a:lnTo>
                  <a:lnTo>
                    <a:pt x="477" y="374"/>
                  </a:lnTo>
                  <a:lnTo>
                    <a:pt x="481" y="374"/>
                  </a:lnTo>
                  <a:lnTo>
                    <a:pt x="484" y="374"/>
                  </a:lnTo>
                  <a:lnTo>
                    <a:pt x="488" y="374"/>
                  </a:lnTo>
                  <a:lnTo>
                    <a:pt x="491" y="374"/>
                  </a:lnTo>
                  <a:lnTo>
                    <a:pt x="494" y="374"/>
                  </a:lnTo>
                  <a:lnTo>
                    <a:pt x="497" y="374"/>
                  </a:lnTo>
                  <a:lnTo>
                    <a:pt x="501" y="373"/>
                  </a:lnTo>
                  <a:lnTo>
                    <a:pt x="504" y="373"/>
                  </a:lnTo>
                  <a:lnTo>
                    <a:pt x="508" y="373"/>
                  </a:lnTo>
                  <a:lnTo>
                    <a:pt x="511" y="373"/>
                  </a:lnTo>
                  <a:lnTo>
                    <a:pt x="515" y="373"/>
                  </a:lnTo>
                  <a:lnTo>
                    <a:pt x="518" y="373"/>
                  </a:lnTo>
                  <a:lnTo>
                    <a:pt x="521" y="372"/>
                  </a:lnTo>
                  <a:lnTo>
                    <a:pt x="524" y="372"/>
                  </a:lnTo>
                  <a:lnTo>
                    <a:pt x="528" y="371"/>
                  </a:lnTo>
                  <a:lnTo>
                    <a:pt x="531" y="370"/>
                  </a:lnTo>
                  <a:lnTo>
                    <a:pt x="535" y="369"/>
                  </a:lnTo>
                  <a:lnTo>
                    <a:pt x="538" y="369"/>
                  </a:lnTo>
                  <a:lnTo>
                    <a:pt x="542" y="368"/>
                  </a:lnTo>
                  <a:lnTo>
                    <a:pt x="544" y="367"/>
                  </a:lnTo>
                  <a:lnTo>
                    <a:pt x="548" y="367"/>
                  </a:lnTo>
                  <a:lnTo>
                    <a:pt x="551" y="367"/>
                  </a:lnTo>
                  <a:lnTo>
                    <a:pt x="555" y="367"/>
                  </a:lnTo>
                  <a:lnTo>
                    <a:pt x="558" y="368"/>
                  </a:lnTo>
                  <a:lnTo>
                    <a:pt x="562" y="368"/>
                  </a:lnTo>
                  <a:lnTo>
                    <a:pt x="565" y="369"/>
                  </a:lnTo>
                  <a:lnTo>
                    <a:pt x="569" y="370"/>
                  </a:lnTo>
                  <a:lnTo>
                    <a:pt x="571" y="370"/>
                  </a:lnTo>
                  <a:lnTo>
                    <a:pt x="575" y="370"/>
                  </a:lnTo>
                  <a:lnTo>
                    <a:pt x="578" y="370"/>
                  </a:lnTo>
                  <a:lnTo>
                    <a:pt x="582" y="370"/>
                  </a:lnTo>
                  <a:lnTo>
                    <a:pt x="585" y="370"/>
                  </a:lnTo>
                  <a:lnTo>
                    <a:pt x="589" y="371"/>
                  </a:lnTo>
                  <a:lnTo>
                    <a:pt x="592" y="371"/>
                  </a:lnTo>
                  <a:lnTo>
                    <a:pt x="595" y="371"/>
                  </a:lnTo>
                  <a:lnTo>
                    <a:pt x="598" y="371"/>
                  </a:lnTo>
                  <a:lnTo>
                    <a:pt x="602" y="371"/>
                  </a:lnTo>
                  <a:lnTo>
                    <a:pt x="605" y="371"/>
                  </a:lnTo>
                  <a:lnTo>
                    <a:pt x="609" y="371"/>
                  </a:lnTo>
                  <a:lnTo>
                    <a:pt x="612" y="371"/>
                  </a:lnTo>
                  <a:lnTo>
                    <a:pt x="616" y="370"/>
                  </a:lnTo>
                  <a:lnTo>
                    <a:pt x="619" y="370"/>
                  </a:lnTo>
                  <a:lnTo>
                    <a:pt x="622" y="369"/>
                  </a:lnTo>
                  <a:lnTo>
                    <a:pt x="625" y="368"/>
                  </a:lnTo>
                  <a:lnTo>
                    <a:pt x="629" y="367"/>
                  </a:lnTo>
                  <a:lnTo>
                    <a:pt x="632" y="366"/>
                  </a:lnTo>
                  <a:lnTo>
                    <a:pt x="636" y="366"/>
                  </a:lnTo>
                  <a:lnTo>
                    <a:pt x="639" y="366"/>
                  </a:lnTo>
                  <a:lnTo>
                    <a:pt x="643" y="366"/>
                  </a:lnTo>
                  <a:lnTo>
                    <a:pt x="645" y="366"/>
                  </a:lnTo>
                  <a:lnTo>
                    <a:pt x="649" y="366"/>
                  </a:lnTo>
                  <a:lnTo>
                    <a:pt x="652" y="366"/>
                  </a:lnTo>
                  <a:lnTo>
                    <a:pt x="656" y="367"/>
                  </a:lnTo>
                  <a:lnTo>
                    <a:pt x="659" y="367"/>
                  </a:lnTo>
                  <a:lnTo>
                    <a:pt x="663" y="367"/>
                  </a:lnTo>
                  <a:lnTo>
                    <a:pt x="666" y="367"/>
                  </a:lnTo>
                  <a:lnTo>
                    <a:pt x="670" y="368"/>
                  </a:lnTo>
                  <a:lnTo>
                    <a:pt x="672" y="368"/>
                  </a:lnTo>
                  <a:lnTo>
                    <a:pt x="676" y="368"/>
                  </a:lnTo>
                  <a:lnTo>
                    <a:pt x="679" y="368"/>
                  </a:lnTo>
                  <a:lnTo>
                    <a:pt x="683" y="368"/>
                  </a:lnTo>
                  <a:lnTo>
                    <a:pt x="686" y="367"/>
                  </a:lnTo>
                  <a:lnTo>
                    <a:pt x="690" y="366"/>
                  </a:lnTo>
                  <a:lnTo>
                    <a:pt x="693" y="364"/>
                  </a:lnTo>
                  <a:lnTo>
                    <a:pt x="696" y="361"/>
                  </a:lnTo>
                  <a:lnTo>
                    <a:pt x="699" y="358"/>
                  </a:lnTo>
                  <a:lnTo>
                    <a:pt x="703" y="355"/>
                  </a:lnTo>
                  <a:lnTo>
                    <a:pt x="706" y="352"/>
                  </a:lnTo>
                  <a:lnTo>
                    <a:pt x="710" y="349"/>
                  </a:lnTo>
                  <a:lnTo>
                    <a:pt x="713" y="347"/>
                  </a:lnTo>
                  <a:lnTo>
                    <a:pt x="717" y="344"/>
                  </a:lnTo>
                  <a:lnTo>
                    <a:pt x="720" y="342"/>
                  </a:lnTo>
                  <a:lnTo>
                    <a:pt x="723" y="339"/>
                  </a:lnTo>
                  <a:lnTo>
                    <a:pt x="726" y="338"/>
                  </a:lnTo>
                  <a:lnTo>
                    <a:pt x="730" y="336"/>
                  </a:lnTo>
                  <a:lnTo>
                    <a:pt x="733" y="336"/>
                  </a:lnTo>
                  <a:lnTo>
                    <a:pt x="737" y="337"/>
                  </a:lnTo>
                  <a:lnTo>
                    <a:pt x="740" y="338"/>
                  </a:lnTo>
                  <a:lnTo>
                    <a:pt x="744" y="341"/>
                  </a:lnTo>
                  <a:lnTo>
                    <a:pt x="746" y="345"/>
                  </a:lnTo>
                  <a:lnTo>
                    <a:pt x="750" y="349"/>
                  </a:lnTo>
                  <a:lnTo>
                    <a:pt x="753" y="353"/>
                  </a:lnTo>
                  <a:lnTo>
                    <a:pt x="757" y="356"/>
                  </a:lnTo>
                  <a:lnTo>
                    <a:pt x="760" y="359"/>
                  </a:lnTo>
                  <a:lnTo>
                    <a:pt x="764" y="361"/>
                  </a:lnTo>
                  <a:lnTo>
                    <a:pt x="767" y="363"/>
                  </a:lnTo>
                  <a:lnTo>
                    <a:pt x="771" y="364"/>
                  </a:lnTo>
                  <a:lnTo>
                    <a:pt x="773" y="365"/>
                  </a:lnTo>
                  <a:lnTo>
                    <a:pt x="777" y="366"/>
                  </a:lnTo>
                  <a:lnTo>
                    <a:pt x="780" y="366"/>
                  </a:lnTo>
                  <a:lnTo>
                    <a:pt x="784" y="366"/>
                  </a:lnTo>
                  <a:lnTo>
                    <a:pt x="787" y="367"/>
                  </a:lnTo>
                  <a:lnTo>
                    <a:pt x="791" y="367"/>
                  </a:lnTo>
                  <a:lnTo>
                    <a:pt x="795" y="367"/>
                  </a:lnTo>
                  <a:lnTo>
                    <a:pt x="797" y="368"/>
                  </a:lnTo>
                  <a:lnTo>
                    <a:pt x="801" y="368"/>
                  </a:lnTo>
                  <a:lnTo>
                    <a:pt x="804" y="368"/>
                  </a:lnTo>
                  <a:lnTo>
                    <a:pt x="808" y="368"/>
                  </a:lnTo>
                  <a:lnTo>
                    <a:pt x="811" y="368"/>
                  </a:lnTo>
                  <a:lnTo>
                    <a:pt x="815" y="367"/>
                  </a:lnTo>
                  <a:lnTo>
                    <a:pt x="818" y="366"/>
                  </a:lnTo>
                  <a:lnTo>
                    <a:pt x="821" y="365"/>
                  </a:lnTo>
                  <a:lnTo>
                    <a:pt x="824" y="363"/>
                  </a:lnTo>
                  <a:lnTo>
                    <a:pt x="828" y="361"/>
                  </a:lnTo>
                  <a:lnTo>
                    <a:pt x="831" y="360"/>
                  </a:lnTo>
                  <a:lnTo>
                    <a:pt x="835" y="360"/>
                  </a:lnTo>
                  <a:lnTo>
                    <a:pt x="838" y="360"/>
                  </a:lnTo>
                  <a:lnTo>
                    <a:pt x="842" y="360"/>
                  </a:lnTo>
                  <a:lnTo>
                    <a:pt x="845" y="361"/>
                  </a:lnTo>
                  <a:lnTo>
                    <a:pt x="848" y="361"/>
                  </a:lnTo>
                  <a:lnTo>
                    <a:pt x="851" y="362"/>
                  </a:lnTo>
                  <a:lnTo>
                    <a:pt x="855" y="363"/>
                  </a:lnTo>
                  <a:lnTo>
                    <a:pt x="858" y="363"/>
                  </a:lnTo>
                  <a:lnTo>
                    <a:pt x="862" y="363"/>
                  </a:lnTo>
                  <a:lnTo>
                    <a:pt x="865" y="363"/>
                  </a:lnTo>
                  <a:lnTo>
                    <a:pt x="869" y="363"/>
                  </a:lnTo>
                  <a:lnTo>
                    <a:pt x="871" y="363"/>
                  </a:lnTo>
                  <a:lnTo>
                    <a:pt x="875" y="363"/>
                  </a:lnTo>
                  <a:lnTo>
                    <a:pt x="878" y="363"/>
                  </a:lnTo>
                  <a:lnTo>
                    <a:pt x="882" y="364"/>
                  </a:lnTo>
                  <a:lnTo>
                    <a:pt x="885" y="364"/>
                  </a:lnTo>
                  <a:lnTo>
                    <a:pt x="889" y="364"/>
                  </a:lnTo>
                  <a:lnTo>
                    <a:pt x="892" y="364"/>
                  </a:lnTo>
                  <a:lnTo>
                    <a:pt x="896" y="364"/>
                  </a:lnTo>
                  <a:lnTo>
                    <a:pt x="898" y="363"/>
                  </a:lnTo>
                  <a:lnTo>
                    <a:pt x="902" y="363"/>
                  </a:lnTo>
                  <a:lnTo>
                    <a:pt x="905" y="362"/>
                  </a:lnTo>
                  <a:lnTo>
                    <a:pt x="909" y="361"/>
                  </a:lnTo>
                  <a:lnTo>
                    <a:pt x="912" y="360"/>
                  </a:lnTo>
                  <a:lnTo>
                    <a:pt x="916" y="359"/>
                  </a:lnTo>
                  <a:lnTo>
                    <a:pt x="919" y="359"/>
                  </a:lnTo>
                  <a:lnTo>
                    <a:pt x="922" y="359"/>
                  </a:lnTo>
                  <a:lnTo>
                    <a:pt x="925" y="360"/>
                  </a:lnTo>
                  <a:lnTo>
                    <a:pt x="929" y="360"/>
                  </a:lnTo>
                  <a:lnTo>
                    <a:pt x="932" y="361"/>
                  </a:lnTo>
                  <a:lnTo>
                    <a:pt x="936" y="361"/>
                  </a:lnTo>
                  <a:lnTo>
                    <a:pt x="939" y="361"/>
                  </a:lnTo>
                  <a:lnTo>
                    <a:pt x="943" y="361"/>
                  </a:lnTo>
                  <a:lnTo>
                    <a:pt x="946" y="360"/>
                  </a:lnTo>
                  <a:lnTo>
                    <a:pt x="949" y="360"/>
                  </a:lnTo>
                  <a:lnTo>
                    <a:pt x="952" y="358"/>
                  </a:lnTo>
                  <a:lnTo>
                    <a:pt x="956" y="357"/>
                  </a:lnTo>
                  <a:lnTo>
                    <a:pt x="959" y="356"/>
                  </a:lnTo>
                  <a:lnTo>
                    <a:pt x="963" y="355"/>
                  </a:lnTo>
                  <a:lnTo>
                    <a:pt x="966" y="355"/>
                  </a:lnTo>
                  <a:lnTo>
                    <a:pt x="970" y="356"/>
                  </a:lnTo>
                  <a:lnTo>
                    <a:pt x="972" y="357"/>
                  </a:lnTo>
                  <a:lnTo>
                    <a:pt x="976" y="358"/>
                  </a:lnTo>
                  <a:lnTo>
                    <a:pt x="979" y="359"/>
                  </a:lnTo>
                  <a:lnTo>
                    <a:pt x="983" y="360"/>
                  </a:lnTo>
                  <a:lnTo>
                    <a:pt x="986" y="360"/>
                  </a:lnTo>
                  <a:lnTo>
                    <a:pt x="990" y="360"/>
                  </a:lnTo>
                  <a:lnTo>
                    <a:pt x="993" y="359"/>
                  </a:lnTo>
                  <a:lnTo>
                    <a:pt x="997" y="358"/>
                  </a:lnTo>
                  <a:lnTo>
                    <a:pt x="999" y="355"/>
                  </a:lnTo>
                  <a:lnTo>
                    <a:pt x="1003" y="352"/>
                  </a:lnTo>
                  <a:lnTo>
                    <a:pt x="1006" y="347"/>
                  </a:lnTo>
                  <a:lnTo>
                    <a:pt x="1010" y="341"/>
                  </a:lnTo>
                  <a:lnTo>
                    <a:pt x="1013" y="335"/>
                  </a:lnTo>
                  <a:lnTo>
                    <a:pt x="1017" y="328"/>
                  </a:lnTo>
                  <a:lnTo>
                    <a:pt x="1020" y="323"/>
                  </a:lnTo>
                  <a:lnTo>
                    <a:pt x="1023" y="319"/>
                  </a:lnTo>
                  <a:lnTo>
                    <a:pt x="1026" y="318"/>
                  </a:lnTo>
                  <a:lnTo>
                    <a:pt x="1030" y="319"/>
                  </a:lnTo>
                  <a:lnTo>
                    <a:pt x="1033" y="322"/>
                  </a:lnTo>
                  <a:lnTo>
                    <a:pt x="1037" y="326"/>
                  </a:lnTo>
                  <a:lnTo>
                    <a:pt x="1040" y="331"/>
                  </a:lnTo>
                  <a:lnTo>
                    <a:pt x="1044" y="335"/>
                  </a:lnTo>
                  <a:lnTo>
                    <a:pt x="1047" y="338"/>
                  </a:lnTo>
                  <a:lnTo>
                    <a:pt x="1050" y="342"/>
                  </a:lnTo>
                  <a:lnTo>
                    <a:pt x="1053" y="345"/>
                  </a:lnTo>
                  <a:lnTo>
                    <a:pt x="1057" y="347"/>
                  </a:lnTo>
                  <a:lnTo>
                    <a:pt x="1060" y="349"/>
                  </a:lnTo>
                  <a:lnTo>
                    <a:pt x="1064" y="350"/>
                  </a:lnTo>
                  <a:lnTo>
                    <a:pt x="1067" y="351"/>
                  </a:lnTo>
                  <a:lnTo>
                    <a:pt x="1071" y="352"/>
                  </a:lnTo>
                  <a:lnTo>
                    <a:pt x="1073" y="353"/>
                  </a:lnTo>
                  <a:lnTo>
                    <a:pt x="1077" y="354"/>
                  </a:lnTo>
                  <a:lnTo>
                    <a:pt x="1080" y="354"/>
                  </a:lnTo>
                  <a:lnTo>
                    <a:pt x="1084" y="355"/>
                  </a:lnTo>
                  <a:lnTo>
                    <a:pt x="1087" y="355"/>
                  </a:lnTo>
                  <a:lnTo>
                    <a:pt x="1091" y="355"/>
                  </a:lnTo>
                  <a:lnTo>
                    <a:pt x="1094" y="355"/>
                  </a:lnTo>
                  <a:lnTo>
                    <a:pt x="1098" y="355"/>
                  </a:lnTo>
                  <a:lnTo>
                    <a:pt x="1100" y="355"/>
                  </a:lnTo>
                  <a:lnTo>
                    <a:pt x="1104" y="355"/>
                  </a:lnTo>
                  <a:lnTo>
                    <a:pt x="1108" y="355"/>
                  </a:lnTo>
                  <a:lnTo>
                    <a:pt x="1111" y="355"/>
                  </a:lnTo>
                  <a:lnTo>
                    <a:pt x="1115" y="355"/>
                  </a:lnTo>
                  <a:lnTo>
                    <a:pt x="1118" y="355"/>
                  </a:lnTo>
                  <a:lnTo>
                    <a:pt x="1122" y="355"/>
                  </a:lnTo>
                  <a:lnTo>
                    <a:pt x="1124" y="355"/>
                  </a:lnTo>
                  <a:lnTo>
                    <a:pt x="1128" y="355"/>
                  </a:lnTo>
                  <a:lnTo>
                    <a:pt x="1131" y="355"/>
                  </a:lnTo>
                  <a:lnTo>
                    <a:pt x="1135" y="355"/>
                  </a:lnTo>
                  <a:lnTo>
                    <a:pt x="1138" y="355"/>
                  </a:lnTo>
                  <a:lnTo>
                    <a:pt x="1142" y="356"/>
                  </a:lnTo>
                  <a:lnTo>
                    <a:pt x="1145" y="355"/>
                  </a:lnTo>
                  <a:lnTo>
                    <a:pt x="1148" y="355"/>
                  </a:lnTo>
                  <a:lnTo>
                    <a:pt x="1151" y="355"/>
                  </a:lnTo>
                  <a:lnTo>
                    <a:pt x="1155" y="354"/>
                  </a:lnTo>
                  <a:lnTo>
                    <a:pt x="1158" y="352"/>
                  </a:lnTo>
                  <a:lnTo>
                    <a:pt x="1162" y="348"/>
                  </a:lnTo>
                  <a:lnTo>
                    <a:pt x="1165" y="342"/>
                  </a:lnTo>
                  <a:lnTo>
                    <a:pt x="1169" y="334"/>
                  </a:lnTo>
                  <a:lnTo>
                    <a:pt x="1172" y="323"/>
                  </a:lnTo>
                  <a:lnTo>
                    <a:pt x="1175" y="311"/>
                  </a:lnTo>
                  <a:lnTo>
                    <a:pt x="1178" y="300"/>
                  </a:lnTo>
                  <a:lnTo>
                    <a:pt x="1182" y="292"/>
                  </a:lnTo>
                  <a:lnTo>
                    <a:pt x="1185" y="288"/>
                  </a:lnTo>
                  <a:lnTo>
                    <a:pt x="1189" y="288"/>
                  </a:lnTo>
                  <a:lnTo>
                    <a:pt x="1192" y="291"/>
                  </a:lnTo>
                  <a:lnTo>
                    <a:pt x="1196" y="296"/>
                  </a:lnTo>
                  <a:lnTo>
                    <a:pt x="1198" y="299"/>
                  </a:lnTo>
                  <a:lnTo>
                    <a:pt x="1202" y="301"/>
                  </a:lnTo>
                  <a:lnTo>
                    <a:pt x="1205" y="300"/>
                  </a:lnTo>
                  <a:lnTo>
                    <a:pt x="1209" y="296"/>
                  </a:lnTo>
                  <a:lnTo>
                    <a:pt x="1212" y="289"/>
                  </a:lnTo>
                  <a:lnTo>
                    <a:pt x="1216" y="281"/>
                  </a:lnTo>
                  <a:lnTo>
                    <a:pt x="1219" y="272"/>
                  </a:lnTo>
                  <a:lnTo>
                    <a:pt x="1223" y="263"/>
                  </a:lnTo>
                  <a:lnTo>
                    <a:pt x="1225" y="253"/>
                  </a:lnTo>
                  <a:lnTo>
                    <a:pt x="1229" y="245"/>
                  </a:lnTo>
                  <a:lnTo>
                    <a:pt x="1232" y="239"/>
                  </a:lnTo>
                  <a:lnTo>
                    <a:pt x="1236" y="235"/>
                  </a:lnTo>
                  <a:lnTo>
                    <a:pt x="1239" y="236"/>
                  </a:lnTo>
                  <a:lnTo>
                    <a:pt x="1243" y="239"/>
                  </a:lnTo>
                  <a:lnTo>
                    <a:pt x="1246" y="247"/>
                  </a:lnTo>
                  <a:lnTo>
                    <a:pt x="1249" y="256"/>
                  </a:lnTo>
                  <a:lnTo>
                    <a:pt x="1252" y="267"/>
                  </a:lnTo>
                  <a:lnTo>
                    <a:pt x="1256" y="277"/>
                  </a:lnTo>
                  <a:lnTo>
                    <a:pt x="1259" y="288"/>
                  </a:lnTo>
                  <a:lnTo>
                    <a:pt x="1263" y="297"/>
                  </a:lnTo>
                  <a:lnTo>
                    <a:pt x="1266" y="304"/>
                  </a:lnTo>
                  <a:lnTo>
                    <a:pt x="1270" y="310"/>
                  </a:lnTo>
                  <a:lnTo>
                    <a:pt x="1273" y="314"/>
                  </a:lnTo>
                  <a:lnTo>
                    <a:pt x="1276" y="316"/>
                  </a:lnTo>
                  <a:lnTo>
                    <a:pt x="1279" y="318"/>
                  </a:lnTo>
                  <a:lnTo>
                    <a:pt x="1283" y="319"/>
                  </a:lnTo>
                  <a:lnTo>
                    <a:pt x="1286" y="320"/>
                  </a:lnTo>
                  <a:lnTo>
                    <a:pt x="1290" y="321"/>
                  </a:lnTo>
                  <a:lnTo>
                    <a:pt x="1293" y="323"/>
                  </a:lnTo>
                  <a:lnTo>
                    <a:pt x="1297" y="326"/>
                  </a:lnTo>
                  <a:lnTo>
                    <a:pt x="1299" y="329"/>
                  </a:lnTo>
                  <a:lnTo>
                    <a:pt x="1303" y="332"/>
                  </a:lnTo>
                  <a:lnTo>
                    <a:pt x="1306" y="334"/>
                  </a:lnTo>
                  <a:lnTo>
                    <a:pt x="1310" y="336"/>
                  </a:lnTo>
                  <a:lnTo>
                    <a:pt x="1313" y="337"/>
                  </a:lnTo>
                  <a:lnTo>
                    <a:pt x="1317" y="336"/>
                  </a:lnTo>
                  <a:lnTo>
                    <a:pt x="1320" y="333"/>
                  </a:lnTo>
                  <a:lnTo>
                    <a:pt x="1324" y="326"/>
                  </a:lnTo>
                  <a:lnTo>
                    <a:pt x="1326" y="316"/>
                  </a:lnTo>
                  <a:lnTo>
                    <a:pt x="1330" y="303"/>
                  </a:lnTo>
                  <a:lnTo>
                    <a:pt x="1333" y="290"/>
                  </a:lnTo>
                  <a:lnTo>
                    <a:pt x="1337" y="279"/>
                  </a:lnTo>
                  <a:lnTo>
                    <a:pt x="1340" y="273"/>
                  </a:lnTo>
                  <a:lnTo>
                    <a:pt x="1344" y="272"/>
                  </a:lnTo>
                  <a:lnTo>
                    <a:pt x="1347" y="277"/>
                  </a:lnTo>
                  <a:lnTo>
                    <a:pt x="1350" y="283"/>
                  </a:lnTo>
                  <a:lnTo>
                    <a:pt x="1353" y="291"/>
                  </a:lnTo>
                  <a:lnTo>
                    <a:pt x="1357" y="297"/>
                  </a:lnTo>
                  <a:lnTo>
                    <a:pt x="1360" y="301"/>
                  </a:lnTo>
                  <a:lnTo>
                    <a:pt x="1364" y="302"/>
                  </a:lnTo>
                  <a:lnTo>
                    <a:pt x="1367" y="302"/>
                  </a:lnTo>
                  <a:lnTo>
                    <a:pt x="1371" y="299"/>
                  </a:lnTo>
                  <a:lnTo>
                    <a:pt x="1374" y="297"/>
                  </a:lnTo>
                  <a:lnTo>
                    <a:pt x="1377" y="297"/>
                  </a:lnTo>
                  <a:lnTo>
                    <a:pt x="1380" y="297"/>
                  </a:lnTo>
                  <a:lnTo>
                    <a:pt x="1384" y="299"/>
                  </a:lnTo>
                  <a:lnTo>
                    <a:pt x="1387" y="302"/>
                  </a:lnTo>
                  <a:lnTo>
                    <a:pt x="1391" y="303"/>
                  </a:lnTo>
                  <a:lnTo>
                    <a:pt x="1394" y="303"/>
                  </a:lnTo>
                  <a:lnTo>
                    <a:pt x="1398" y="302"/>
                  </a:lnTo>
                  <a:lnTo>
                    <a:pt x="1400" y="301"/>
                  </a:lnTo>
                  <a:lnTo>
                    <a:pt x="1404" y="301"/>
                  </a:lnTo>
                  <a:lnTo>
                    <a:pt x="1407" y="302"/>
                  </a:lnTo>
                  <a:lnTo>
                    <a:pt x="1411" y="303"/>
                  </a:lnTo>
                  <a:lnTo>
                    <a:pt x="1414" y="306"/>
                  </a:lnTo>
                  <a:lnTo>
                    <a:pt x="1418" y="308"/>
                  </a:lnTo>
                  <a:lnTo>
                    <a:pt x="1421" y="311"/>
                  </a:lnTo>
                  <a:lnTo>
                    <a:pt x="1425" y="313"/>
                  </a:lnTo>
                  <a:lnTo>
                    <a:pt x="1428" y="315"/>
                  </a:lnTo>
                  <a:lnTo>
                    <a:pt x="1431" y="316"/>
                  </a:lnTo>
                  <a:lnTo>
                    <a:pt x="1435" y="317"/>
                  </a:lnTo>
                  <a:lnTo>
                    <a:pt x="1438" y="318"/>
                  </a:lnTo>
                  <a:lnTo>
                    <a:pt x="1442" y="320"/>
                  </a:lnTo>
                  <a:lnTo>
                    <a:pt x="1445" y="321"/>
                  </a:lnTo>
                  <a:lnTo>
                    <a:pt x="1449" y="322"/>
                  </a:lnTo>
                  <a:lnTo>
                    <a:pt x="1451" y="324"/>
                  </a:lnTo>
                  <a:lnTo>
                    <a:pt x="1455" y="326"/>
                  </a:lnTo>
                  <a:lnTo>
                    <a:pt x="1458" y="328"/>
                  </a:lnTo>
                  <a:lnTo>
                    <a:pt x="1462" y="330"/>
                  </a:lnTo>
                  <a:lnTo>
                    <a:pt x="1465" y="331"/>
                  </a:lnTo>
                  <a:lnTo>
                    <a:pt x="1469" y="333"/>
                  </a:lnTo>
                  <a:lnTo>
                    <a:pt x="1472" y="334"/>
                  </a:lnTo>
                  <a:lnTo>
                    <a:pt x="1475" y="335"/>
                  </a:lnTo>
                  <a:lnTo>
                    <a:pt x="1478" y="336"/>
                  </a:lnTo>
                  <a:lnTo>
                    <a:pt x="1482" y="336"/>
                  </a:lnTo>
                  <a:lnTo>
                    <a:pt x="1485" y="336"/>
                  </a:lnTo>
                  <a:lnTo>
                    <a:pt x="1489" y="335"/>
                  </a:lnTo>
                  <a:lnTo>
                    <a:pt x="1492" y="333"/>
                  </a:lnTo>
                  <a:lnTo>
                    <a:pt x="1496" y="330"/>
                  </a:lnTo>
                  <a:lnTo>
                    <a:pt x="1499" y="327"/>
                  </a:lnTo>
                  <a:lnTo>
                    <a:pt x="1502" y="324"/>
                  </a:lnTo>
                  <a:lnTo>
                    <a:pt x="1505" y="322"/>
                  </a:lnTo>
                  <a:lnTo>
                    <a:pt x="1509" y="322"/>
                  </a:lnTo>
                  <a:lnTo>
                    <a:pt x="1512" y="322"/>
                  </a:lnTo>
                  <a:lnTo>
                    <a:pt x="1516" y="324"/>
                  </a:lnTo>
                  <a:lnTo>
                    <a:pt x="1519" y="325"/>
                  </a:lnTo>
                  <a:lnTo>
                    <a:pt x="1523" y="327"/>
                  </a:lnTo>
                  <a:lnTo>
                    <a:pt x="1525" y="329"/>
                  </a:lnTo>
                  <a:lnTo>
                    <a:pt x="1529" y="331"/>
                  </a:lnTo>
                  <a:lnTo>
                    <a:pt x="1532" y="332"/>
                  </a:lnTo>
                  <a:lnTo>
                    <a:pt x="1536" y="333"/>
                  </a:lnTo>
                  <a:lnTo>
                    <a:pt x="1539" y="333"/>
                  </a:lnTo>
                  <a:lnTo>
                    <a:pt x="1543" y="334"/>
                  </a:lnTo>
                  <a:lnTo>
                    <a:pt x="1546" y="334"/>
                  </a:lnTo>
                  <a:lnTo>
                    <a:pt x="1550" y="334"/>
                  </a:lnTo>
                  <a:lnTo>
                    <a:pt x="1552" y="333"/>
                  </a:lnTo>
                  <a:lnTo>
                    <a:pt x="1556" y="332"/>
                  </a:lnTo>
                  <a:lnTo>
                    <a:pt x="1559" y="330"/>
                  </a:lnTo>
                  <a:lnTo>
                    <a:pt x="1563" y="327"/>
                  </a:lnTo>
                  <a:lnTo>
                    <a:pt x="1566" y="325"/>
                  </a:lnTo>
                  <a:lnTo>
                    <a:pt x="1570" y="323"/>
                  </a:lnTo>
                  <a:lnTo>
                    <a:pt x="1573" y="322"/>
                  </a:lnTo>
                  <a:lnTo>
                    <a:pt x="1576" y="322"/>
                  </a:lnTo>
                  <a:lnTo>
                    <a:pt x="1579" y="323"/>
                  </a:lnTo>
                  <a:lnTo>
                    <a:pt x="1583" y="324"/>
                  </a:lnTo>
                  <a:lnTo>
                    <a:pt x="1586" y="326"/>
                  </a:lnTo>
                  <a:lnTo>
                    <a:pt x="1590" y="327"/>
                  </a:lnTo>
                  <a:lnTo>
                    <a:pt x="1593" y="329"/>
                  </a:lnTo>
                  <a:lnTo>
                    <a:pt x="1597" y="331"/>
                  </a:lnTo>
                  <a:lnTo>
                    <a:pt x="1600" y="332"/>
                  </a:lnTo>
                  <a:lnTo>
                    <a:pt x="1603" y="333"/>
                  </a:lnTo>
                  <a:lnTo>
                    <a:pt x="1606" y="334"/>
                  </a:lnTo>
                  <a:lnTo>
                    <a:pt x="1610" y="335"/>
                  </a:lnTo>
                  <a:lnTo>
                    <a:pt x="1613" y="335"/>
                  </a:lnTo>
                  <a:lnTo>
                    <a:pt x="1617" y="336"/>
                  </a:lnTo>
                  <a:lnTo>
                    <a:pt x="1620" y="336"/>
                  </a:lnTo>
                  <a:lnTo>
                    <a:pt x="1624" y="335"/>
                  </a:lnTo>
                  <a:lnTo>
                    <a:pt x="1626" y="335"/>
                  </a:lnTo>
                  <a:lnTo>
                    <a:pt x="1630" y="335"/>
                  </a:lnTo>
                  <a:lnTo>
                    <a:pt x="1633" y="335"/>
                  </a:lnTo>
                  <a:lnTo>
                    <a:pt x="1637" y="335"/>
                  </a:lnTo>
                  <a:lnTo>
                    <a:pt x="1640" y="334"/>
                  </a:lnTo>
                  <a:lnTo>
                    <a:pt x="1644" y="333"/>
                  </a:lnTo>
                  <a:lnTo>
                    <a:pt x="1647" y="331"/>
                  </a:lnTo>
                  <a:lnTo>
                    <a:pt x="1651" y="329"/>
                  </a:lnTo>
                  <a:lnTo>
                    <a:pt x="1653" y="326"/>
                  </a:lnTo>
                  <a:lnTo>
                    <a:pt x="1657" y="323"/>
                  </a:lnTo>
                  <a:lnTo>
                    <a:pt x="1660" y="320"/>
                  </a:lnTo>
                  <a:lnTo>
                    <a:pt x="1664" y="317"/>
                  </a:lnTo>
                  <a:lnTo>
                    <a:pt x="1667" y="315"/>
                  </a:lnTo>
                  <a:lnTo>
                    <a:pt x="1671" y="313"/>
                  </a:lnTo>
                  <a:lnTo>
                    <a:pt x="1674" y="311"/>
                  </a:lnTo>
                  <a:lnTo>
                    <a:pt x="1677" y="311"/>
                  </a:lnTo>
                  <a:lnTo>
                    <a:pt x="1680" y="311"/>
                  </a:lnTo>
                  <a:lnTo>
                    <a:pt x="1684" y="311"/>
                  </a:lnTo>
                  <a:lnTo>
                    <a:pt x="1687" y="312"/>
                  </a:lnTo>
                  <a:lnTo>
                    <a:pt x="1691" y="314"/>
                  </a:lnTo>
                  <a:lnTo>
                    <a:pt x="1694" y="315"/>
                  </a:lnTo>
                  <a:lnTo>
                    <a:pt x="1698" y="317"/>
                  </a:lnTo>
                  <a:lnTo>
                    <a:pt x="1701" y="318"/>
                  </a:lnTo>
                  <a:lnTo>
                    <a:pt x="1704" y="319"/>
                  </a:lnTo>
                  <a:lnTo>
                    <a:pt x="1707" y="319"/>
                  </a:lnTo>
                  <a:lnTo>
                    <a:pt x="1711" y="320"/>
                  </a:lnTo>
                  <a:lnTo>
                    <a:pt x="1714" y="320"/>
                  </a:lnTo>
                  <a:lnTo>
                    <a:pt x="1718" y="319"/>
                  </a:lnTo>
                  <a:lnTo>
                    <a:pt x="1721" y="318"/>
                  </a:lnTo>
                  <a:lnTo>
                    <a:pt x="1725" y="318"/>
                  </a:lnTo>
                  <a:lnTo>
                    <a:pt x="1727" y="317"/>
                  </a:lnTo>
                  <a:lnTo>
                    <a:pt x="1731" y="318"/>
                  </a:lnTo>
                  <a:lnTo>
                    <a:pt x="1734" y="318"/>
                  </a:lnTo>
                  <a:lnTo>
                    <a:pt x="1738" y="319"/>
                  </a:lnTo>
                  <a:lnTo>
                    <a:pt x="1742" y="320"/>
                  </a:lnTo>
                  <a:lnTo>
                    <a:pt x="1745" y="321"/>
                  </a:lnTo>
                  <a:lnTo>
                    <a:pt x="1749" y="322"/>
                  </a:lnTo>
                  <a:lnTo>
                    <a:pt x="1752" y="323"/>
                  </a:lnTo>
                  <a:lnTo>
                    <a:pt x="1755" y="323"/>
                  </a:lnTo>
                  <a:lnTo>
                    <a:pt x="1758" y="324"/>
                  </a:lnTo>
                  <a:lnTo>
                    <a:pt x="1762" y="324"/>
                  </a:lnTo>
                  <a:lnTo>
                    <a:pt x="1765" y="324"/>
                  </a:lnTo>
                  <a:lnTo>
                    <a:pt x="1769" y="324"/>
                  </a:lnTo>
                  <a:lnTo>
                    <a:pt x="1772" y="323"/>
                  </a:lnTo>
                  <a:lnTo>
                    <a:pt x="1776" y="322"/>
                  </a:lnTo>
                  <a:lnTo>
                    <a:pt x="1778" y="322"/>
                  </a:lnTo>
                  <a:lnTo>
                    <a:pt x="1782" y="321"/>
                  </a:lnTo>
                  <a:lnTo>
                    <a:pt x="1785" y="322"/>
                  </a:lnTo>
                  <a:lnTo>
                    <a:pt x="1789" y="322"/>
                  </a:lnTo>
                  <a:lnTo>
                    <a:pt x="1792" y="323"/>
                  </a:lnTo>
                  <a:lnTo>
                    <a:pt x="1796" y="323"/>
                  </a:lnTo>
                  <a:lnTo>
                    <a:pt x="1799" y="324"/>
                  </a:lnTo>
                  <a:lnTo>
                    <a:pt x="1802" y="325"/>
                  </a:lnTo>
                  <a:lnTo>
                    <a:pt x="1805" y="325"/>
                  </a:lnTo>
                  <a:lnTo>
                    <a:pt x="1809" y="325"/>
                  </a:lnTo>
                  <a:lnTo>
                    <a:pt x="1812" y="326"/>
                  </a:lnTo>
                  <a:lnTo>
                    <a:pt x="1816" y="326"/>
                  </a:lnTo>
                  <a:lnTo>
                    <a:pt x="1819" y="326"/>
                  </a:lnTo>
                  <a:lnTo>
                    <a:pt x="1823" y="326"/>
                  </a:lnTo>
                  <a:lnTo>
                    <a:pt x="1826" y="326"/>
                  </a:lnTo>
                  <a:lnTo>
                    <a:pt x="1829" y="326"/>
                  </a:lnTo>
                  <a:lnTo>
                    <a:pt x="1832" y="326"/>
                  </a:lnTo>
                  <a:lnTo>
                    <a:pt x="1836" y="325"/>
                  </a:lnTo>
                  <a:lnTo>
                    <a:pt x="1839" y="325"/>
                  </a:lnTo>
                  <a:lnTo>
                    <a:pt x="1843" y="325"/>
                  </a:lnTo>
                  <a:lnTo>
                    <a:pt x="1846" y="325"/>
                  </a:lnTo>
                  <a:lnTo>
                    <a:pt x="1850" y="325"/>
                  </a:lnTo>
                  <a:lnTo>
                    <a:pt x="1852" y="325"/>
                  </a:lnTo>
                  <a:lnTo>
                    <a:pt x="1856" y="325"/>
                  </a:lnTo>
                  <a:lnTo>
                    <a:pt x="1859" y="324"/>
                  </a:lnTo>
                  <a:lnTo>
                    <a:pt x="1863" y="324"/>
                  </a:lnTo>
                  <a:lnTo>
                    <a:pt x="1866" y="324"/>
                  </a:lnTo>
                  <a:lnTo>
                    <a:pt x="1870" y="324"/>
                  </a:lnTo>
                  <a:lnTo>
                    <a:pt x="1873" y="324"/>
                  </a:lnTo>
                  <a:lnTo>
                    <a:pt x="1877" y="324"/>
                  </a:lnTo>
                  <a:lnTo>
                    <a:pt x="1879" y="324"/>
                  </a:lnTo>
                  <a:lnTo>
                    <a:pt x="1883" y="324"/>
                  </a:lnTo>
                  <a:lnTo>
                    <a:pt x="1886" y="324"/>
                  </a:lnTo>
                  <a:lnTo>
                    <a:pt x="1890" y="324"/>
                  </a:lnTo>
                  <a:lnTo>
                    <a:pt x="1893" y="324"/>
                  </a:lnTo>
                  <a:lnTo>
                    <a:pt x="1897" y="323"/>
                  </a:lnTo>
                  <a:lnTo>
                    <a:pt x="1900" y="322"/>
                  </a:lnTo>
                  <a:lnTo>
                    <a:pt x="1903" y="322"/>
                  </a:lnTo>
                  <a:lnTo>
                    <a:pt x="1906" y="321"/>
                  </a:lnTo>
                  <a:lnTo>
                    <a:pt x="1910" y="320"/>
                  </a:lnTo>
                  <a:lnTo>
                    <a:pt x="1913" y="319"/>
                  </a:lnTo>
                  <a:lnTo>
                    <a:pt x="1917" y="318"/>
                  </a:lnTo>
                  <a:lnTo>
                    <a:pt x="1920" y="317"/>
                  </a:lnTo>
                  <a:lnTo>
                    <a:pt x="1924" y="316"/>
                  </a:lnTo>
                  <a:lnTo>
                    <a:pt x="1927" y="316"/>
                  </a:lnTo>
                  <a:lnTo>
                    <a:pt x="1930" y="316"/>
                  </a:lnTo>
                  <a:lnTo>
                    <a:pt x="1933" y="316"/>
                  </a:lnTo>
                  <a:lnTo>
                    <a:pt x="1937" y="317"/>
                  </a:lnTo>
                  <a:lnTo>
                    <a:pt x="1940" y="317"/>
                  </a:lnTo>
                  <a:lnTo>
                    <a:pt x="1944" y="317"/>
                  </a:lnTo>
                  <a:lnTo>
                    <a:pt x="1947" y="317"/>
                  </a:lnTo>
                  <a:lnTo>
                    <a:pt x="1951" y="317"/>
                  </a:lnTo>
                  <a:lnTo>
                    <a:pt x="1953" y="317"/>
                  </a:lnTo>
                  <a:lnTo>
                    <a:pt x="1957" y="317"/>
                  </a:lnTo>
                  <a:lnTo>
                    <a:pt x="1960" y="316"/>
                  </a:lnTo>
                  <a:lnTo>
                    <a:pt x="1964" y="316"/>
                  </a:lnTo>
                  <a:lnTo>
                    <a:pt x="1967" y="316"/>
                  </a:lnTo>
                  <a:lnTo>
                    <a:pt x="1971" y="315"/>
                  </a:lnTo>
                  <a:lnTo>
                    <a:pt x="1974" y="315"/>
                  </a:lnTo>
                  <a:lnTo>
                    <a:pt x="1978" y="315"/>
                  </a:lnTo>
                  <a:lnTo>
                    <a:pt x="1980" y="315"/>
                  </a:lnTo>
                  <a:lnTo>
                    <a:pt x="1984" y="314"/>
                  </a:lnTo>
                  <a:lnTo>
                    <a:pt x="1987" y="314"/>
                  </a:lnTo>
                  <a:lnTo>
                    <a:pt x="1991" y="313"/>
                  </a:lnTo>
                  <a:lnTo>
                    <a:pt x="1994" y="313"/>
                  </a:lnTo>
                  <a:lnTo>
                    <a:pt x="1998" y="312"/>
                  </a:lnTo>
                  <a:lnTo>
                    <a:pt x="2001" y="311"/>
                  </a:lnTo>
                  <a:lnTo>
                    <a:pt x="2004" y="309"/>
                  </a:lnTo>
                  <a:lnTo>
                    <a:pt x="2007" y="308"/>
                  </a:lnTo>
                  <a:lnTo>
                    <a:pt x="2011" y="307"/>
                  </a:lnTo>
                  <a:lnTo>
                    <a:pt x="2014" y="306"/>
                  </a:lnTo>
                  <a:lnTo>
                    <a:pt x="2018" y="305"/>
                  </a:lnTo>
                  <a:lnTo>
                    <a:pt x="2021" y="305"/>
                  </a:lnTo>
                  <a:lnTo>
                    <a:pt x="2025" y="304"/>
                  </a:lnTo>
                  <a:lnTo>
                    <a:pt x="2028" y="305"/>
                  </a:lnTo>
                  <a:lnTo>
                    <a:pt x="2031" y="305"/>
                  </a:lnTo>
                  <a:lnTo>
                    <a:pt x="2034" y="305"/>
                  </a:lnTo>
                  <a:lnTo>
                    <a:pt x="2038" y="306"/>
                  </a:lnTo>
                  <a:lnTo>
                    <a:pt x="2041" y="306"/>
                  </a:lnTo>
                  <a:lnTo>
                    <a:pt x="2045" y="306"/>
                  </a:lnTo>
                  <a:lnTo>
                    <a:pt x="2048" y="306"/>
                  </a:lnTo>
                  <a:lnTo>
                    <a:pt x="2052" y="306"/>
                  </a:lnTo>
                  <a:lnTo>
                    <a:pt x="2055" y="305"/>
                  </a:lnTo>
                  <a:lnTo>
                    <a:pt x="2058" y="304"/>
                  </a:lnTo>
                  <a:lnTo>
                    <a:pt x="2062" y="303"/>
                  </a:lnTo>
                  <a:lnTo>
                    <a:pt x="2065" y="302"/>
                  </a:lnTo>
                  <a:lnTo>
                    <a:pt x="2069" y="300"/>
                  </a:lnTo>
                  <a:lnTo>
                    <a:pt x="2072" y="298"/>
                  </a:lnTo>
                  <a:lnTo>
                    <a:pt x="2076" y="296"/>
                  </a:lnTo>
                  <a:lnTo>
                    <a:pt x="2079" y="293"/>
                  </a:lnTo>
                  <a:lnTo>
                    <a:pt x="2082" y="292"/>
                  </a:lnTo>
                  <a:lnTo>
                    <a:pt x="2085" y="290"/>
                  </a:lnTo>
                  <a:lnTo>
                    <a:pt x="2089" y="290"/>
                  </a:lnTo>
                  <a:lnTo>
                    <a:pt x="2092" y="290"/>
                  </a:lnTo>
                  <a:lnTo>
                    <a:pt x="2096" y="291"/>
                  </a:lnTo>
                  <a:lnTo>
                    <a:pt x="2099" y="293"/>
                  </a:lnTo>
                  <a:lnTo>
                    <a:pt x="2103" y="296"/>
                  </a:lnTo>
                  <a:lnTo>
                    <a:pt x="2105" y="298"/>
                  </a:lnTo>
                  <a:lnTo>
                    <a:pt x="2109" y="301"/>
                  </a:lnTo>
                  <a:lnTo>
                    <a:pt x="2112" y="303"/>
                  </a:lnTo>
                  <a:lnTo>
                    <a:pt x="2116" y="305"/>
                  </a:lnTo>
                  <a:lnTo>
                    <a:pt x="2119" y="307"/>
                  </a:lnTo>
                  <a:lnTo>
                    <a:pt x="2123" y="309"/>
                  </a:lnTo>
                  <a:lnTo>
                    <a:pt x="2126" y="310"/>
                  </a:lnTo>
                  <a:lnTo>
                    <a:pt x="2129" y="311"/>
                  </a:lnTo>
                  <a:lnTo>
                    <a:pt x="2132" y="311"/>
                  </a:lnTo>
                  <a:lnTo>
                    <a:pt x="2136" y="311"/>
                  </a:lnTo>
                  <a:lnTo>
                    <a:pt x="2139" y="310"/>
                  </a:lnTo>
                  <a:lnTo>
                    <a:pt x="2143" y="310"/>
                  </a:lnTo>
                  <a:lnTo>
                    <a:pt x="2146" y="309"/>
                  </a:lnTo>
                  <a:lnTo>
                    <a:pt x="2150" y="309"/>
                  </a:lnTo>
                  <a:lnTo>
                    <a:pt x="2153" y="309"/>
                  </a:lnTo>
                  <a:lnTo>
                    <a:pt x="2156" y="309"/>
                  </a:lnTo>
                  <a:lnTo>
                    <a:pt x="2159" y="309"/>
                  </a:lnTo>
                  <a:lnTo>
                    <a:pt x="2163" y="309"/>
                  </a:lnTo>
                  <a:lnTo>
                    <a:pt x="2166" y="309"/>
                  </a:lnTo>
                  <a:lnTo>
                    <a:pt x="2170" y="310"/>
                  </a:lnTo>
                  <a:lnTo>
                    <a:pt x="2173" y="310"/>
                  </a:lnTo>
                  <a:lnTo>
                    <a:pt x="2177" y="310"/>
                  </a:lnTo>
                  <a:lnTo>
                    <a:pt x="2179" y="310"/>
                  </a:lnTo>
                  <a:lnTo>
                    <a:pt x="2183" y="310"/>
                  </a:lnTo>
                  <a:lnTo>
                    <a:pt x="2186" y="310"/>
                  </a:lnTo>
                  <a:lnTo>
                    <a:pt x="2190" y="309"/>
                  </a:lnTo>
                  <a:lnTo>
                    <a:pt x="2193" y="309"/>
                  </a:lnTo>
                  <a:lnTo>
                    <a:pt x="2197" y="309"/>
                  </a:lnTo>
                  <a:lnTo>
                    <a:pt x="2200" y="308"/>
                  </a:lnTo>
                  <a:lnTo>
                    <a:pt x="2204" y="308"/>
                  </a:lnTo>
                  <a:lnTo>
                    <a:pt x="2206" y="307"/>
                  </a:lnTo>
                  <a:lnTo>
                    <a:pt x="2210" y="307"/>
                  </a:lnTo>
                  <a:lnTo>
                    <a:pt x="2213" y="306"/>
                  </a:lnTo>
                  <a:lnTo>
                    <a:pt x="2217" y="305"/>
                  </a:lnTo>
                  <a:lnTo>
                    <a:pt x="2220" y="304"/>
                  </a:lnTo>
                  <a:lnTo>
                    <a:pt x="2224" y="304"/>
                  </a:lnTo>
                  <a:lnTo>
                    <a:pt x="2227" y="303"/>
                  </a:lnTo>
                  <a:lnTo>
                    <a:pt x="2230" y="303"/>
                  </a:lnTo>
                  <a:lnTo>
                    <a:pt x="2233" y="303"/>
                  </a:lnTo>
                  <a:lnTo>
                    <a:pt x="2237" y="303"/>
                  </a:lnTo>
                  <a:lnTo>
                    <a:pt x="2240" y="302"/>
                  </a:lnTo>
                  <a:lnTo>
                    <a:pt x="2244" y="302"/>
                  </a:lnTo>
                  <a:lnTo>
                    <a:pt x="2247" y="301"/>
                  </a:lnTo>
                  <a:lnTo>
                    <a:pt x="2251" y="299"/>
                  </a:lnTo>
                  <a:lnTo>
                    <a:pt x="2254" y="297"/>
                  </a:lnTo>
                  <a:lnTo>
                    <a:pt x="2257" y="295"/>
                  </a:lnTo>
                  <a:lnTo>
                    <a:pt x="2260" y="293"/>
                  </a:lnTo>
                  <a:lnTo>
                    <a:pt x="2264" y="290"/>
                  </a:lnTo>
                  <a:lnTo>
                    <a:pt x="2267" y="286"/>
                  </a:lnTo>
                  <a:lnTo>
                    <a:pt x="2271" y="283"/>
                  </a:lnTo>
                  <a:lnTo>
                    <a:pt x="2274" y="278"/>
                  </a:lnTo>
                  <a:lnTo>
                    <a:pt x="2278" y="273"/>
                  </a:lnTo>
                  <a:lnTo>
                    <a:pt x="2280" y="266"/>
                  </a:lnTo>
                  <a:lnTo>
                    <a:pt x="2284" y="256"/>
                  </a:lnTo>
                  <a:lnTo>
                    <a:pt x="2287" y="241"/>
                  </a:lnTo>
                  <a:lnTo>
                    <a:pt x="2291" y="220"/>
                  </a:lnTo>
                  <a:lnTo>
                    <a:pt x="2294" y="190"/>
                  </a:lnTo>
                  <a:lnTo>
                    <a:pt x="2298" y="151"/>
                  </a:lnTo>
                  <a:lnTo>
                    <a:pt x="2301" y="100"/>
                  </a:lnTo>
                  <a:lnTo>
                    <a:pt x="2305" y="41"/>
                  </a:lnTo>
                  <a:lnTo>
                    <a:pt x="2306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8" name="Freeform 423">
              <a:extLst>
                <a:ext uri="{FF2B5EF4-FFF2-40B4-BE49-F238E27FC236}">
                  <a16:creationId xmlns:a16="http://schemas.microsoft.com/office/drawing/2014/main" id="{CB8CD6C5-E066-F854-C7EC-C3485C1C7E90}"/>
                </a:ext>
              </a:extLst>
            </p:cNvPr>
            <p:cNvSpPr>
              <a:spLocks/>
            </p:cNvSpPr>
            <p:nvPr/>
          </p:nvSpPr>
          <p:spPr bwMode="auto">
            <a:xfrm>
              <a:off x="5635411" y="4050596"/>
              <a:ext cx="24983" cy="107950"/>
            </a:xfrm>
            <a:custGeom>
              <a:avLst/>
              <a:gdLst>
                <a:gd name="T0" fmla="*/ 0 w 39"/>
                <a:gd name="T1" fmla="*/ 0 h 68"/>
                <a:gd name="T2" fmla="*/ 2 w 39"/>
                <a:gd name="T3" fmla="*/ 3 h 68"/>
                <a:gd name="T4" fmla="*/ 6 w 39"/>
                <a:gd name="T5" fmla="*/ 10 h 68"/>
                <a:gd name="T6" fmla="*/ 9 w 39"/>
                <a:gd name="T7" fmla="*/ 17 h 68"/>
                <a:gd name="T8" fmla="*/ 13 w 39"/>
                <a:gd name="T9" fmla="*/ 23 h 68"/>
                <a:gd name="T10" fmla="*/ 15 w 39"/>
                <a:gd name="T11" fmla="*/ 30 h 68"/>
                <a:gd name="T12" fmla="*/ 19 w 39"/>
                <a:gd name="T13" fmla="*/ 36 h 68"/>
                <a:gd name="T14" fmla="*/ 22 w 39"/>
                <a:gd name="T15" fmla="*/ 42 h 68"/>
                <a:gd name="T16" fmla="*/ 26 w 39"/>
                <a:gd name="T17" fmla="*/ 48 h 68"/>
                <a:gd name="T18" fmla="*/ 29 w 39"/>
                <a:gd name="T19" fmla="*/ 54 h 68"/>
                <a:gd name="T20" fmla="*/ 33 w 39"/>
                <a:gd name="T21" fmla="*/ 59 h 68"/>
                <a:gd name="T22" fmla="*/ 36 w 39"/>
                <a:gd name="T23" fmla="*/ 64 h 68"/>
                <a:gd name="T24" fmla="*/ 39 w 39"/>
                <a:gd name="T2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39" h="68">
                  <a:moveTo>
                    <a:pt x="0" y="0"/>
                  </a:moveTo>
                  <a:lnTo>
                    <a:pt x="2" y="3"/>
                  </a:lnTo>
                  <a:lnTo>
                    <a:pt x="6" y="10"/>
                  </a:lnTo>
                  <a:lnTo>
                    <a:pt x="9" y="17"/>
                  </a:lnTo>
                  <a:lnTo>
                    <a:pt x="13" y="23"/>
                  </a:lnTo>
                  <a:lnTo>
                    <a:pt x="15" y="30"/>
                  </a:lnTo>
                  <a:lnTo>
                    <a:pt x="19" y="36"/>
                  </a:lnTo>
                  <a:lnTo>
                    <a:pt x="22" y="42"/>
                  </a:lnTo>
                  <a:lnTo>
                    <a:pt x="26" y="48"/>
                  </a:lnTo>
                  <a:lnTo>
                    <a:pt x="29" y="54"/>
                  </a:lnTo>
                  <a:lnTo>
                    <a:pt x="33" y="59"/>
                  </a:lnTo>
                  <a:lnTo>
                    <a:pt x="36" y="64"/>
                  </a:lnTo>
                  <a:lnTo>
                    <a:pt x="39" y="68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9" name="Rectangle 425">
              <a:extLst>
                <a:ext uri="{FF2B5EF4-FFF2-40B4-BE49-F238E27FC236}">
                  <a16:creationId xmlns:a16="http://schemas.microsoft.com/office/drawing/2014/main" id="{A8D7BB0E-EB04-254E-9561-22B792450A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9067" y="4049008"/>
              <a:ext cx="1616202" cy="788988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0" name="Rectangle 341">
              <a:extLst>
                <a:ext uri="{FF2B5EF4-FFF2-40B4-BE49-F238E27FC236}">
                  <a16:creationId xmlns:a16="http://schemas.microsoft.com/office/drawing/2014/main" id="{D6B36811-80DC-4B3F-F743-49EDD0BFD5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7712" y="4403895"/>
              <a:ext cx="41017" cy="918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25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" name="Rectangle 343">
              <a:extLst>
                <a:ext uri="{FF2B5EF4-FFF2-40B4-BE49-F238E27FC236}">
                  <a16:creationId xmlns:a16="http://schemas.microsoft.com/office/drawing/2014/main" id="{1AFCD659-0941-943E-2ADD-74CC08066B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5547" y="4054065"/>
              <a:ext cx="100081" cy="94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32" name="Rectangle 341">
              <a:extLst>
                <a:ext uri="{FF2B5EF4-FFF2-40B4-BE49-F238E27FC236}">
                  <a16:creationId xmlns:a16="http://schemas.microsoft.com/office/drawing/2014/main" id="{54C1890C-2714-165C-B16A-6A2B9DE200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0831" y="4763050"/>
              <a:ext cx="20508" cy="918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0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EE21BD3F-A450-99E2-7900-6DE90EA20BE1}"/>
              </a:ext>
            </a:extLst>
          </p:cNvPr>
          <p:cNvSpPr txBox="1"/>
          <p:nvPr/>
        </p:nvSpPr>
        <p:spPr>
          <a:xfrm>
            <a:off x="1653649" y="815477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0) 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207CAF84-CA4C-2A3F-56CB-B222FC8972C9}"/>
              </a:ext>
            </a:extLst>
          </p:cNvPr>
          <p:cNvSpPr txBox="1"/>
          <p:nvPr/>
        </p:nvSpPr>
        <p:spPr>
          <a:xfrm>
            <a:off x="1654596" y="3763952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5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0522B41A-437F-1CA0-47B9-9ACBED35D4A6}"/>
              </a:ext>
            </a:extLst>
          </p:cNvPr>
          <p:cNvSpPr txBox="1"/>
          <p:nvPr/>
        </p:nvSpPr>
        <p:spPr>
          <a:xfrm>
            <a:off x="1600610" y="624085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day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5CEC6BC7-5CBA-1FB6-AECE-0A02DEA207B4}"/>
              </a:ext>
            </a:extLst>
          </p:cNvPr>
          <p:cNvSpPr txBox="1"/>
          <p:nvPr/>
        </p:nvSpPr>
        <p:spPr>
          <a:xfrm>
            <a:off x="1653649" y="2791697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3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CE06E2EB-3642-897A-482B-1B8D50A80341}"/>
              </a:ext>
            </a:extLst>
          </p:cNvPr>
          <p:cNvSpPr txBox="1"/>
          <p:nvPr/>
        </p:nvSpPr>
        <p:spPr>
          <a:xfrm>
            <a:off x="1645182" y="1796494"/>
            <a:ext cx="3037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1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Line 710">
            <a:extLst>
              <a:ext uri="{FF2B5EF4-FFF2-40B4-BE49-F238E27FC236}">
                <a16:creationId xmlns:a16="http://schemas.microsoft.com/office/drawing/2014/main" id="{952A9C74-61EE-4BD3-516D-C684583A12F6}"/>
              </a:ext>
            </a:extLst>
          </p:cNvPr>
          <p:cNvSpPr>
            <a:spLocks noChangeShapeType="1"/>
          </p:cNvSpPr>
          <p:nvPr/>
        </p:nvSpPr>
        <p:spPr bwMode="auto">
          <a:xfrm>
            <a:off x="5026420" y="4529296"/>
            <a:ext cx="496" cy="23309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8" name="Line 760">
            <a:extLst>
              <a:ext uri="{FF2B5EF4-FFF2-40B4-BE49-F238E27FC236}">
                <a16:creationId xmlns:a16="http://schemas.microsoft.com/office/drawing/2014/main" id="{00526503-DFB3-278F-E947-21BAB4B18485}"/>
              </a:ext>
            </a:extLst>
          </p:cNvPr>
          <p:cNvSpPr>
            <a:spLocks noChangeShapeType="1"/>
          </p:cNvSpPr>
          <p:nvPr/>
        </p:nvSpPr>
        <p:spPr bwMode="auto">
          <a:xfrm>
            <a:off x="6628517" y="4529296"/>
            <a:ext cx="496" cy="23309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9" name="Line 761">
            <a:extLst>
              <a:ext uri="{FF2B5EF4-FFF2-40B4-BE49-F238E27FC236}">
                <a16:creationId xmlns:a16="http://schemas.microsoft.com/office/drawing/2014/main" id="{BF01FD06-B0C1-601F-8B72-D4625C3F379B}"/>
              </a:ext>
            </a:extLst>
          </p:cNvPr>
          <p:cNvSpPr>
            <a:spLocks noChangeShapeType="1"/>
          </p:cNvSpPr>
          <p:nvPr/>
        </p:nvSpPr>
        <p:spPr bwMode="auto">
          <a:xfrm>
            <a:off x="5026420" y="4529296"/>
            <a:ext cx="496" cy="453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10" name="Rectangle 762">
            <a:extLst>
              <a:ext uri="{FF2B5EF4-FFF2-40B4-BE49-F238E27FC236}">
                <a16:creationId xmlns:a16="http://schemas.microsoft.com/office/drawing/2014/main" id="{1BE9AFC9-EE9A-36A0-C302-D1EFFE9612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13652" y="4575914"/>
            <a:ext cx="32919" cy="81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4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13" name="Rectangle 780">
            <a:extLst>
              <a:ext uri="{FF2B5EF4-FFF2-40B4-BE49-F238E27FC236}">
                <a16:creationId xmlns:a16="http://schemas.microsoft.com/office/drawing/2014/main" id="{B9FAA561-F7E9-5F30-3D90-E0705D3B2D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9297" y="4576427"/>
            <a:ext cx="65837" cy="81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14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14" name="Line 781">
            <a:extLst>
              <a:ext uri="{FF2B5EF4-FFF2-40B4-BE49-F238E27FC236}">
                <a16:creationId xmlns:a16="http://schemas.microsoft.com/office/drawing/2014/main" id="{A45F11A0-2284-3BDA-49C1-CBC172EE6066}"/>
              </a:ext>
            </a:extLst>
          </p:cNvPr>
          <p:cNvSpPr>
            <a:spLocks noChangeShapeType="1"/>
          </p:cNvSpPr>
          <p:nvPr/>
        </p:nvSpPr>
        <p:spPr bwMode="auto">
          <a:xfrm>
            <a:off x="6628517" y="4529296"/>
            <a:ext cx="496" cy="453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15" name="Line 783">
            <a:extLst>
              <a:ext uri="{FF2B5EF4-FFF2-40B4-BE49-F238E27FC236}">
                <a16:creationId xmlns:a16="http://schemas.microsoft.com/office/drawing/2014/main" id="{281BA0F9-DF25-CAFF-1B4E-B608CB0F0ED3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0275" y="4490448"/>
            <a:ext cx="9424" cy="129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16" name="Line 788">
            <a:extLst>
              <a:ext uri="{FF2B5EF4-FFF2-40B4-BE49-F238E27FC236}">
                <a16:creationId xmlns:a16="http://schemas.microsoft.com/office/drawing/2014/main" id="{4AC42D11-DC4C-C215-44BE-51773550E600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0275" y="4153760"/>
            <a:ext cx="9424" cy="129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17" name="Line 793">
            <a:extLst>
              <a:ext uri="{FF2B5EF4-FFF2-40B4-BE49-F238E27FC236}">
                <a16:creationId xmlns:a16="http://schemas.microsoft.com/office/drawing/2014/main" id="{752EBC4C-5EDC-F75D-B200-3B1CB1803A4D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0275" y="3817073"/>
            <a:ext cx="9424" cy="129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18" name="Line 794">
            <a:extLst>
              <a:ext uri="{FF2B5EF4-FFF2-40B4-BE49-F238E27FC236}">
                <a16:creationId xmlns:a16="http://schemas.microsoft.com/office/drawing/2014/main" id="{FED7511B-893C-56FC-CD22-74FE3216B258}"/>
              </a:ext>
            </a:extLst>
          </p:cNvPr>
          <p:cNvSpPr>
            <a:spLocks noChangeShapeType="1"/>
          </p:cNvSpPr>
          <p:nvPr/>
        </p:nvSpPr>
        <p:spPr bwMode="auto">
          <a:xfrm>
            <a:off x="4911842" y="4490448"/>
            <a:ext cx="17856" cy="129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19" name="Rectangle 795">
            <a:extLst>
              <a:ext uri="{FF2B5EF4-FFF2-40B4-BE49-F238E27FC236}">
                <a16:creationId xmlns:a16="http://schemas.microsoft.com/office/drawing/2014/main" id="{CD56003B-9A3B-7A1A-C7D6-AA6F38E030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1696" y="4436706"/>
            <a:ext cx="32919" cy="81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0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20" name="Line 796">
            <a:extLst>
              <a:ext uri="{FF2B5EF4-FFF2-40B4-BE49-F238E27FC236}">
                <a16:creationId xmlns:a16="http://schemas.microsoft.com/office/drawing/2014/main" id="{12946BB1-FD2D-ABCF-9680-9B78A811BF63}"/>
              </a:ext>
            </a:extLst>
          </p:cNvPr>
          <p:cNvSpPr>
            <a:spLocks noChangeShapeType="1"/>
          </p:cNvSpPr>
          <p:nvPr/>
        </p:nvSpPr>
        <p:spPr bwMode="auto">
          <a:xfrm>
            <a:off x="4911842" y="4153760"/>
            <a:ext cx="17856" cy="129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1" name="Rectangle 797">
            <a:extLst>
              <a:ext uri="{FF2B5EF4-FFF2-40B4-BE49-F238E27FC236}">
                <a16:creationId xmlns:a16="http://schemas.microsoft.com/office/drawing/2014/main" id="{9FDD5FFC-D4F0-DD5E-9AB5-3195FD4D34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6697" y="4096548"/>
            <a:ext cx="65837" cy="81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25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22" name="Line 798">
            <a:extLst>
              <a:ext uri="{FF2B5EF4-FFF2-40B4-BE49-F238E27FC236}">
                <a16:creationId xmlns:a16="http://schemas.microsoft.com/office/drawing/2014/main" id="{11A69548-944D-7AB2-A72E-D99A45917E04}"/>
              </a:ext>
            </a:extLst>
          </p:cNvPr>
          <p:cNvSpPr>
            <a:spLocks noChangeShapeType="1"/>
          </p:cNvSpPr>
          <p:nvPr/>
        </p:nvSpPr>
        <p:spPr bwMode="auto">
          <a:xfrm>
            <a:off x="4911842" y="3817073"/>
            <a:ext cx="17856" cy="129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3" name="Rectangle 799">
            <a:extLst>
              <a:ext uri="{FF2B5EF4-FFF2-40B4-BE49-F238E27FC236}">
                <a16:creationId xmlns:a16="http://schemas.microsoft.com/office/drawing/2014/main" id="{3C23F886-ED98-1CAF-1F4A-D0CC90D1A0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1805" y="3763738"/>
            <a:ext cx="65837" cy="81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50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24" name="Freeform 801">
            <a:extLst>
              <a:ext uri="{FF2B5EF4-FFF2-40B4-BE49-F238E27FC236}">
                <a16:creationId xmlns:a16="http://schemas.microsoft.com/office/drawing/2014/main" id="{6D3374EC-6A48-F3A5-C9FA-02C45A7F04FC}"/>
              </a:ext>
            </a:extLst>
          </p:cNvPr>
          <p:cNvSpPr>
            <a:spLocks/>
          </p:cNvSpPr>
          <p:nvPr/>
        </p:nvSpPr>
        <p:spPr bwMode="auto">
          <a:xfrm>
            <a:off x="4930195" y="3808009"/>
            <a:ext cx="1098156" cy="669488"/>
          </a:xfrm>
          <a:custGeom>
            <a:avLst/>
            <a:gdLst>
              <a:gd name="T0" fmla="*/ 1 w 4428"/>
              <a:gd name="T1" fmla="*/ 9 h 1034"/>
              <a:gd name="T2" fmla="*/ 2 w 4428"/>
              <a:gd name="T3" fmla="*/ 7 h 1034"/>
              <a:gd name="T4" fmla="*/ 2 w 4428"/>
              <a:gd name="T5" fmla="*/ 4 h 1034"/>
              <a:gd name="T6" fmla="*/ 3 w 4428"/>
              <a:gd name="T7" fmla="*/ 5 h 1034"/>
              <a:gd name="T8" fmla="*/ 3 w 4428"/>
              <a:gd name="T9" fmla="*/ 7 h 1034"/>
              <a:gd name="T10" fmla="*/ 4 w 4428"/>
              <a:gd name="T11" fmla="*/ 8 h 1034"/>
              <a:gd name="T12" fmla="*/ 5 w 4428"/>
              <a:gd name="T13" fmla="*/ 9 h 1034"/>
              <a:gd name="T14" fmla="*/ 5 w 4428"/>
              <a:gd name="T15" fmla="*/ 8 h 1034"/>
              <a:gd name="T16" fmla="*/ 6 w 4428"/>
              <a:gd name="T17" fmla="*/ 8 h 1034"/>
              <a:gd name="T18" fmla="*/ 6 w 4428"/>
              <a:gd name="T19" fmla="*/ 8 h 1034"/>
              <a:gd name="T20" fmla="*/ 7 w 4428"/>
              <a:gd name="T21" fmla="*/ 9 h 1034"/>
              <a:gd name="T22" fmla="*/ 8 w 4428"/>
              <a:gd name="T23" fmla="*/ 9 h 1034"/>
              <a:gd name="T24" fmla="*/ 8 w 4428"/>
              <a:gd name="T25" fmla="*/ 8 h 1034"/>
              <a:gd name="T26" fmla="*/ 9 w 4428"/>
              <a:gd name="T27" fmla="*/ 8 h 1034"/>
              <a:gd name="T28" fmla="*/ 9 w 4428"/>
              <a:gd name="T29" fmla="*/ 8 h 1034"/>
              <a:gd name="T30" fmla="*/ 10 w 4428"/>
              <a:gd name="T31" fmla="*/ 8 h 1034"/>
              <a:gd name="T32" fmla="*/ 10 w 4428"/>
              <a:gd name="T33" fmla="*/ 8 h 1034"/>
              <a:gd name="T34" fmla="*/ 11 w 4428"/>
              <a:gd name="T35" fmla="*/ 7 h 1034"/>
              <a:gd name="T36" fmla="*/ 12 w 4428"/>
              <a:gd name="T37" fmla="*/ 7 h 1034"/>
              <a:gd name="T38" fmla="*/ 12 w 4428"/>
              <a:gd name="T39" fmla="*/ 7 h 1034"/>
              <a:gd name="T40" fmla="*/ 13 w 4428"/>
              <a:gd name="T41" fmla="*/ 7 h 1034"/>
              <a:gd name="T42" fmla="*/ 13 w 4428"/>
              <a:gd name="T43" fmla="*/ 7 h 1034"/>
              <a:gd name="T44" fmla="*/ 14 w 4428"/>
              <a:gd name="T45" fmla="*/ 7 h 1034"/>
              <a:gd name="T46" fmla="*/ 15 w 4428"/>
              <a:gd name="T47" fmla="*/ 5 h 1034"/>
              <a:gd name="T48" fmla="*/ 15 w 4428"/>
              <a:gd name="T49" fmla="*/ 3 h 1034"/>
              <a:gd name="T50" fmla="*/ 16 w 4428"/>
              <a:gd name="T51" fmla="*/ 6 h 1034"/>
              <a:gd name="T52" fmla="*/ 16 w 4428"/>
              <a:gd name="T53" fmla="*/ 6 h 1034"/>
              <a:gd name="T54" fmla="*/ 17 w 4428"/>
              <a:gd name="T55" fmla="*/ 6 h 1034"/>
              <a:gd name="T56" fmla="*/ 18 w 4428"/>
              <a:gd name="T57" fmla="*/ 6 h 1034"/>
              <a:gd name="T58" fmla="*/ 18 w 4428"/>
              <a:gd name="T59" fmla="*/ 6 h 1034"/>
              <a:gd name="T60" fmla="*/ 19 w 4428"/>
              <a:gd name="T61" fmla="*/ 6 h 1034"/>
              <a:gd name="T62" fmla="*/ 19 w 4428"/>
              <a:gd name="T63" fmla="*/ 6 h 1034"/>
              <a:gd name="T64" fmla="*/ 20 w 4428"/>
              <a:gd name="T65" fmla="*/ 5 h 1034"/>
              <a:gd name="T66" fmla="*/ 21 w 4428"/>
              <a:gd name="T67" fmla="*/ 6 h 1034"/>
              <a:gd name="T68" fmla="*/ 21 w 4428"/>
              <a:gd name="T69" fmla="*/ 6 h 1034"/>
              <a:gd name="T70" fmla="*/ 22 w 4428"/>
              <a:gd name="T71" fmla="*/ 6 h 1034"/>
              <a:gd name="T72" fmla="*/ 22 w 4428"/>
              <a:gd name="T73" fmla="*/ 6 h 1034"/>
              <a:gd name="T74" fmla="*/ 23 w 4428"/>
              <a:gd name="T75" fmla="*/ 6 h 1034"/>
              <a:gd name="T76" fmla="*/ 24 w 4428"/>
              <a:gd name="T77" fmla="*/ 6 h 1034"/>
              <a:gd name="T78" fmla="*/ 24 w 4428"/>
              <a:gd name="T79" fmla="*/ 6 h 1034"/>
              <a:gd name="T80" fmla="*/ 25 w 4428"/>
              <a:gd name="T81" fmla="*/ 6 h 1034"/>
              <a:gd name="T82" fmla="*/ 25 w 4428"/>
              <a:gd name="T83" fmla="*/ 6 h 1034"/>
              <a:gd name="T84" fmla="*/ 26 w 4428"/>
              <a:gd name="T85" fmla="*/ 6 h 1034"/>
              <a:gd name="T86" fmla="*/ 26 w 4428"/>
              <a:gd name="T87" fmla="*/ 6 h 1034"/>
              <a:gd name="T88" fmla="*/ 27 w 4428"/>
              <a:gd name="T89" fmla="*/ 6 h 1034"/>
              <a:gd name="T90" fmla="*/ 28 w 4428"/>
              <a:gd name="T91" fmla="*/ 6 h 1034"/>
              <a:gd name="T92" fmla="*/ 28 w 4428"/>
              <a:gd name="T93" fmla="*/ 6 h 1034"/>
              <a:gd name="T94" fmla="*/ 29 w 4428"/>
              <a:gd name="T95" fmla="*/ 6 h 1034"/>
              <a:gd name="T96" fmla="*/ 29 w 4428"/>
              <a:gd name="T97" fmla="*/ 6 h 1034"/>
              <a:gd name="T98" fmla="*/ 30 w 4428"/>
              <a:gd name="T99" fmla="*/ 6 h 1034"/>
              <a:gd name="T100" fmla="*/ 31 w 4428"/>
              <a:gd name="T101" fmla="*/ 3 h 1034"/>
              <a:gd name="T102" fmla="*/ 31 w 4428"/>
              <a:gd name="T103" fmla="*/ 5 h 1034"/>
              <a:gd name="T104" fmla="*/ 32 w 4428"/>
              <a:gd name="T105" fmla="*/ 6 h 1034"/>
              <a:gd name="T106" fmla="*/ 32 w 4428"/>
              <a:gd name="T107" fmla="*/ 6 h 1034"/>
              <a:gd name="T108" fmla="*/ 33 w 4428"/>
              <a:gd name="T109" fmla="*/ 4 h 1034"/>
              <a:gd name="T110" fmla="*/ 34 w 4428"/>
              <a:gd name="T111" fmla="*/ 5 h 1034"/>
              <a:gd name="T112" fmla="*/ 34 w 4428"/>
              <a:gd name="T113" fmla="*/ 5 h 1034"/>
              <a:gd name="T114" fmla="*/ 35 w 4428"/>
              <a:gd name="T115" fmla="*/ 4 h 1034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  <a:gd name="T165" fmla="*/ 0 60000 65536"/>
              <a:gd name="T166" fmla="*/ 0 60000 65536"/>
              <a:gd name="T167" fmla="*/ 0 60000 65536"/>
              <a:gd name="T168" fmla="*/ 0 60000 65536"/>
              <a:gd name="T169" fmla="*/ 0 60000 65536"/>
              <a:gd name="T170" fmla="*/ 0 60000 65536"/>
              <a:gd name="T171" fmla="*/ 0 60000 65536"/>
              <a:gd name="T172" fmla="*/ 0 60000 65536"/>
              <a:gd name="T173" fmla="*/ 0 60000 65536"/>
            </a:gdLst>
            <a:ahLst/>
            <a:cxnLst>
              <a:cxn ang="T116">
                <a:pos x="T0" y="T1"/>
              </a:cxn>
              <a:cxn ang="T117">
                <a:pos x="T2" y="T3"/>
              </a:cxn>
              <a:cxn ang="T118">
                <a:pos x="T4" y="T5"/>
              </a:cxn>
              <a:cxn ang="T119">
                <a:pos x="T6" y="T7"/>
              </a:cxn>
              <a:cxn ang="T120">
                <a:pos x="T8" y="T9"/>
              </a:cxn>
              <a:cxn ang="T121">
                <a:pos x="T10" y="T11"/>
              </a:cxn>
              <a:cxn ang="T122">
                <a:pos x="T12" y="T13"/>
              </a:cxn>
              <a:cxn ang="T123">
                <a:pos x="T14" y="T15"/>
              </a:cxn>
              <a:cxn ang="T124">
                <a:pos x="T16" y="T17"/>
              </a:cxn>
              <a:cxn ang="T125">
                <a:pos x="T18" y="T19"/>
              </a:cxn>
              <a:cxn ang="T126">
                <a:pos x="T20" y="T21"/>
              </a:cxn>
              <a:cxn ang="T127">
                <a:pos x="T22" y="T23"/>
              </a:cxn>
              <a:cxn ang="T128">
                <a:pos x="T24" y="T25"/>
              </a:cxn>
              <a:cxn ang="T129">
                <a:pos x="T26" y="T27"/>
              </a:cxn>
              <a:cxn ang="T130">
                <a:pos x="T28" y="T29"/>
              </a:cxn>
              <a:cxn ang="T131">
                <a:pos x="T30" y="T31"/>
              </a:cxn>
              <a:cxn ang="T132">
                <a:pos x="T32" y="T33"/>
              </a:cxn>
              <a:cxn ang="T133">
                <a:pos x="T34" y="T35"/>
              </a:cxn>
              <a:cxn ang="T134">
                <a:pos x="T36" y="T37"/>
              </a:cxn>
              <a:cxn ang="T135">
                <a:pos x="T38" y="T39"/>
              </a:cxn>
              <a:cxn ang="T136">
                <a:pos x="T40" y="T41"/>
              </a:cxn>
              <a:cxn ang="T137">
                <a:pos x="T42" y="T43"/>
              </a:cxn>
              <a:cxn ang="T138">
                <a:pos x="T44" y="T45"/>
              </a:cxn>
              <a:cxn ang="T139">
                <a:pos x="T46" y="T47"/>
              </a:cxn>
              <a:cxn ang="T140">
                <a:pos x="T48" y="T49"/>
              </a:cxn>
              <a:cxn ang="T141">
                <a:pos x="T50" y="T51"/>
              </a:cxn>
              <a:cxn ang="T142">
                <a:pos x="T52" y="T53"/>
              </a:cxn>
              <a:cxn ang="T143">
                <a:pos x="T54" y="T55"/>
              </a:cxn>
              <a:cxn ang="T144">
                <a:pos x="T56" y="T57"/>
              </a:cxn>
              <a:cxn ang="T145">
                <a:pos x="T58" y="T59"/>
              </a:cxn>
              <a:cxn ang="T146">
                <a:pos x="T60" y="T61"/>
              </a:cxn>
              <a:cxn ang="T147">
                <a:pos x="T62" y="T63"/>
              </a:cxn>
              <a:cxn ang="T148">
                <a:pos x="T64" y="T65"/>
              </a:cxn>
              <a:cxn ang="T149">
                <a:pos x="T66" y="T67"/>
              </a:cxn>
              <a:cxn ang="T150">
                <a:pos x="T68" y="T69"/>
              </a:cxn>
              <a:cxn ang="T151">
                <a:pos x="T70" y="T71"/>
              </a:cxn>
              <a:cxn ang="T152">
                <a:pos x="T72" y="T73"/>
              </a:cxn>
              <a:cxn ang="T153">
                <a:pos x="T74" y="T75"/>
              </a:cxn>
              <a:cxn ang="T154">
                <a:pos x="T76" y="T77"/>
              </a:cxn>
              <a:cxn ang="T155">
                <a:pos x="T78" y="T79"/>
              </a:cxn>
              <a:cxn ang="T156">
                <a:pos x="T80" y="T81"/>
              </a:cxn>
              <a:cxn ang="T157">
                <a:pos x="T82" y="T83"/>
              </a:cxn>
              <a:cxn ang="T158">
                <a:pos x="T84" y="T85"/>
              </a:cxn>
              <a:cxn ang="T159">
                <a:pos x="T86" y="T87"/>
              </a:cxn>
              <a:cxn ang="T160">
                <a:pos x="T88" y="T89"/>
              </a:cxn>
              <a:cxn ang="T161">
                <a:pos x="T90" y="T91"/>
              </a:cxn>
              <a:cxn ang="T162">
                <a:pos x="T92" y="T93"/>
              </a:cxn>
              <a:cxn ang="T163">
                <a:pos x="T94" y="T95"/>
              </a:cxn>
              <a:cxn ang="T164">
                <a:pos x="T96" y="T97"/>
              </a:cxn>
              <a:cxn ang="T165">
                <a:pos x="T98" y="T99"/>
              </a:cxn>
              <a:cxn ang="T166">
                <a:pos x="T100" y="T101"/>
              </a:cxn>
              <a:cxn ang="T167">
                <a:pos x="T102" y="T103"/>
              </a:cxn>
              <a:cxn ang="T168">
                <a:pos x="T104" y="T105"/>
              </a:cxn>
              <a:cxn ang="T169">
                <a:pos x="T106" y="T107"/>
              </a:cxn>
              <a:cxn ang="T170">
                <a:pos x="T108" y="T109"/>
              </a:cxn>
              <a:cxn ang="T171">
                <a:pos x="T110" y="T111"/>
              </a:cxn>
              <a:cxn ang="T172">
                <a:pos x="T112" y="T113"/>
              </a:cxn>
              <a:cxn ang="T173">
                <a:pos x="T114" y="T115"/>
              </a:cxn>
            </a:cxnLst>
            <a:rect l="0" t="0" r="r" b="b"/>
            <a:pathLst>
              <a:path w="4428" h="1034">
                <a:moveTo>
                  <a:pt x="0" y="1015"/>
                </a:moveTo>
                <a:lnTo>
                  <a:pt x="2" y="1017"/>
                </a:lnTo>
                <a:lnTo>
                  <a:pt x="8" y="1019"/>
                </a:lnTo>
                <a:lnTo>
                  <a:pt x="16" y="1022"/>
                </a:lnTo>
                <a:lnTo>
                  <a:pt x="23" y="1024"/>
                </a:lnTo>
                <a:lnTo>
                  <a:pt x="29" y="1026"/>
                </a:lnTo>
                <a:lnTo>
                  <a:pt x="37" y="1028"/>
                </a:lnTo>
                <a:lnTo>
                  <a:pt x="43" y="1028"/>
                </a:lnTo>
                <a:lnTo>
                  <a:pt x="50" y="1030"/>
                </a:lnTo>
                <a:lnTo>
                  <a:pt x="58" y="1028"/>
                </a:lnTo>
                <a:lnTo>
                  <a:pt x="64" y="1028"/>
                </a:lnTo>
                <a:lnTo>
                  <a:pt x="71" y="1026"/>
                </a:lnTo>
                <a:lnTo>
                  <a:pt x="77" y="1022"/>
                </a:lnTo>
                <a:lnTo>
                  <a:pt x="85" y="1019"/>
                </a:lnTo>
                <a:lnTo>
                  <a:pt x="92" y="1011"/>
                </a:lnTo>
                <a:lnTo>
                  <a:pt x="98" y="1003"/>
                </a:lnTo>
                <a:lnTo>
                  <a:pt x="106" y="990"/>
                </a:lnTo>
                <a:lnTo>
                  <a:pt x="112" y="972"/>
                </a:lnTo>
                <a:lnTo>
                  <a:pt x="119" y="951"/>
                </a:lnTo>
                <a:lnTo>
                  <a:pt x="127" y="925"/>
                </a:lnTo>
                <a:lnTo>
                  <a:pt x="133" y="890"/>
                </a:lnTo>
                <a:lnTo>
                  <a:pt x="140" y="850"/>
                </a:lnTo>
                <a:lnTo>
                  <a:pt x="146" y="804"/>
                </a:lnTo>
                <a:lnTo>
                  <a:pt x="154" y="754"/>
                </a:lnTo>
                <a:lnTo>
                  <a:pt x="160" y="700"/>
                </a:lnTo>
                <a:lnTo>
                  <a:pt x="167" y="646"/>
                </a:lnTo>
                <a:lnTo>
                  <a:pt x="175" y="593"/>
                </a:lnTo>
                <a:lnTo>
                  <a:pt x="181" y="543"/>
                </a:lnTo>
                <a:lnTo>
                  <a:pt x="188" y="497"/>
                </a:lnTo>
                <a:lnTo>
                  <a:pt x="194" y="458"/>
                </a:lnTo>
                <a:lnTo>
                  <a:pt x="202" y="429"/>
                </a:lnTo>
                <a:lnTo>
                  <a:pt x="210" y="408"/>
                </a:lnTo>
                <a:lnTo>
                  <a:pt x="215" y="395"/>
                </a:lnTo>
                <a:lnTo>
                  <a:pt x="223" y="391"/>
                </a:lnTo>
                <a:lnTo>
                  <a:pt x="229" y="395"/>
                </a:lnTo>
                <a:lnTo>
                  <a:pt x="236" y="406"/>
                </a:lnTo>
                <a:lnTo>
                  <a:pt x="244" y="422"/>
                </a:lnTo>
                <a:lnTo>
                  <a:pt x="250" y="443"/>
                </a:lnTo>
                <a:lnTo>
                  <a:pt x="258" y="466"/>
                </a:lnTo>
                <a:lnTo>
                  <a:pt x="263" y="493"/>
                </a:lnTo>
                <a:lnTo>
                  <a:pt x="271" y="520"/>
                </a:lnTo>
                <a:lnTo>
                  <a:pt x="277" y="550"/>
                </a:lnTo>
                <a:lnTo>
                  <a:pt x="284" y="579"/>
                </a:lnTo>
                <a:lnTo>
                  <a:pt x="292" y="610"/>
                </a:lnTo>
                <a:lnTo>
                  <a:pt x="298" y="640"/>
                </a:lnTo>
                <a:lnTo>
                  <a:pt x="306" y="671"/>
                </a:lnTo>
                <a:lnTo>
                  <a:pt x="311" y="700"/>
                </a:lnTo>
                <a:lnTo>
                  <a:pt x="319" y="729"/>
                </a:lnTo>
                <a:lnTo>
                  <a:pt x="327" y="756"/>
                </a:lnTo>
                <a:lnTo>
                  <a:pt x="332" y="783"/>
                </a:lnTo>
                <a:lnTo>
                  <a:pt x="340" y="807"/>
                </a:lnTo>
                <a:lnTo>
                  <a:pt x="346" y="830"/>
                </a:lnTo>
                <a:lnTo>
                  <a:pt x="354" y="852"/>
                </a:lnTo>
                <a:lnTo>
                  <a:pt x="361" y="873"/>
                </a:lnTo>
                <a:lnTo>
                  <a:pt x="367" y="892"/>
                </a:lnTo>
                <a:lnTo>
                  <a:pt x="375" y="909"/>
                </a:lnTo>
                <a:lnTo>
                  <a:pt x="380" y="925"/>
                </a:lnTo>
                <a:lnTo>
                  <a:pt x="388" y="938"/>
                </a:lnTo>
                <a:lnTo>
                  <a:pt x="394" y="951"/>
                </a:lnTo>
                <a:lnTo>
                  <a:pt x="402" y="963"/>
                </a:lnTo>
                <a:lnTo>
                  <a:pt x="409" y="974"/>
                </a:lnTo>
                <a:lnTo>
                  <a:pt x="415" y="982"/>
                </a:lnTo>
                <a:lnTo>
                  <a:pt x="423" y="992"/>
                </a:lnTo>
                <a:lnTo>
                  <a:pt x="429" y="997"/>
                </a:lnTo>
                <a:lnTo>
                  <a:pt x="436" y="1005"/>
                </a:lnTo>
                <a:lnTo>
                  <a:pt x="444" y="1009"/>
                </a:lnTo>
                <a:lnTo>
                  <a:pt x="450" y="1015"/>
                </a:lnTo>
                <a:lnTo>
                  <a:pt x="457" y="1019"/>
                </a:lnTo>
                <a:lnTo>
                  <a:pt x="463" y="1020"/>
                </a:lnTo>
                <a:lnTo>
                  <a:pt x="471" y="1022"/>
                </a:lnTo>
                <a:lnTo>
                  <a:pt x="478" y="1024"/>
                </a:lnTo>
                <a:lnTo>
                  <a:pt x="484" y="1026"/>
                </a:lnTo>
                <a:lnTo>
                  <a:pt x="492" y="1028"/>
                </a:lnTo>
                <a:lnTo>
                  <a:pt x="498" y="1028"/>
                </a:lnTo>
                <a:lnTo>
                  <a:pt x="505" y="1028"/>
                </a:lnTo>
                <a:lnTo>
                  <a:pt x="513" y="1026"/>
                </a:lnTo>
                <a:lnTo>
                  <a:pt x="519" y="1026"/>
                </a:lnTo>
                <a:lnTo>
                  <a:pt x="526" y="1024"/>
                </a:lnTo>
                <a:lnTo>
                  <a:pt x="532" y="1022"/>
                </a:lnTo>
                <a:lnTo>
                  <a:pt x="540" y="1020"/>
                </a:lnTo>
                <a:lnTo>
                  <a:pt x="546" y="1017"/>
                </a:lnTo>
                <a:lnTo>
                  <a:pt x="553" y="1015"/>
                </a:lnTo>
                <a:lnTo>
                  <a:pt x="561" y="1011"/>
                </a:lnTo>
                <a:lnTo>
                  <a:pt x="567" y="1009"/>
                </a:lnTo>
                <a:lnTo>
                  <a:pt x="574" y="1005"/>
                </a:lnTo>
                <a:lnTo>
                  <a:pt x="580" y="1003"/>
                </a:lnTo>
                <a:lnTo>
                  <a:pt x="588" y="1001"/>
                </a:lnTo>
                <a:lnTo>
                  <a:pt x="596" y="997"/>
                </a:lnTo>
                <a:lnTo>
                  <a:pt x="601" y="996"/>
                </a:lnTo>
                <a:lnTo>
                  <a:pt x="609" y="996"/>
                </a:lnTo>
                <a:lnTo>
                  <a:pt x="615" y="994"/>
                </a:lnTo>
                <a:lnTo>
                  <a:pt x="622" y="994"/>
                </a:lnTo>
                <a:lnTo>
                  <a:pt x="630" y="994"/>
                </a:lnTo>
                <a:lnTo>
                  <a:pt x="636" y="994"/>
                </a:lnTo>
                <a:lnTo>
                  <a:pt x="644" y="994"/>
                </a:lnTo>
                <a:lnTo>
                  <a:pt x="649" y="996"/>
                </a:lnTo>
                <a:lnTo>
                  <a:pt x="657" y="997"/>
                </a:lnTo>
                <a:lnTo>
                  <a:pt x="663" y="999"/>
                </a:lnTo>
                <a:lnTo>
                  <a:pt x="670" y="999"/>
                </a:lnTo>
                <a:lnTo>
                  <a:pt x="678" y="1003"/>
                </a:lnTo>
                <a:lnTo>
                  <a:pt x="684" y="1005"/>
                </a:lnTo>
                <a:lnTo>
                  <a:pt x="692" y="1007"/>
                </a:lnTo>
                <a:lnTo>
                  <a:pt x="697" y="1009"/>
                </a:lnTo>
                <a:lnTo>
                  <a:pt x="705" y="1011"/>
                </a:lnTo>
                <a:lnTo>
                  <a:pt x="713" y="1013"/>
                </a:lnTo>
                <a:lnTo>
                  <a:pt x="718" y="1015"/>
                </a:lnTo>
                <a:lnTo>
                  <a:pt x="726" y="1017"/>
                </a:lnTo>
                <a:lnTo>
                  <a:pt x="732" y="1017"/>
                </a:lnTo>
                <a:lnTo>
                  <a:pt x="740" y="1019"/>
                </a:lnTo>
                <a:lnTo>
                  <a:pt x="747" y="1020"/>
                </a:lnTo>
                <a:lnTo>
                  <a:pt x="753" y="1020"/>
                </a:lnTo>
                <a:lnTo>
                  <a:pt x="761" y="1022"/>
                </a:lnTo>
                <a:lnTo>
                  <a:pt x="766" y="1022"/>
                </a:lnTo>
                <a:lnTo>
                  <a:pt x="774" y="1024"/>
                </a:lnTo>
                <a:lnTo>
                  <a:pt x="782" y="1024"/>
                </a:lnTo>
                <a:lnTo>
                  <a:pt x="788" y="1026"/>
                </a:lnTo>
                <a:lnTo>
                  <a:pt x="795" y="1026"/>
                </a:lnTo>
                <a:lnTo>
                  <a:pt x="801" y="1026"/>
                </a:lnTo>
                <a:lnTo>
                  <a:pt x="809" y="1028"/>
                </a:lnTo>
                <a:lnTo>
                  <a:pt x="814" y="1028"/>
                </a:lnTo>
                <a:lnTo>
                  <a:pt x="822" y="1028"/>
                </a:lnTo>
                <a:lnTo>
                  <a:pt x="830" y="1030"/>
                </a:lnTo>
                <a:lnTo>
                  <a:pt x="836" y="1030"/>
                </a:lnTo>
                <a:lnTo>
                  <a:pt x="843" y="1032"/>
                </a:lnTo>
                <a:lnTo>
                  <a:pt x="849" y="1032"/>
                </a:lnTo>
                <a:lnTo>
                  <a:pt x="857" y="1032"/>
                </a:lnTo>
                <a:lnTo>
                  <a:pt x="864" y="1034"/>
                </a:lnTo>
                <a:lnTo>
                  <a:pt x="870" y="1034"/>
                </a:lnTo>
                <a:lnTo>
                  <a:pt x="878" y="1034"/>
                </a:lnTo>
                <a:lnTo>
                  <a:pt x="884" y="1034"/>
                </a:lnTo>
                <a:lnTo>
                  <a:pt x="891" y="1034"/>
                </a:lnTo>
                <a:lnTo>
                  <a:pt x="899" y="1034"/>
                </a:lnTo>
                <a:lnTo>
                  <a:pt x="905" y="1034"/>
                </a:lnTo>
                <a:lnTo>
                  <a:pt x="912" y="1034"/>
                </a:lnTo>
                <a:lnTo>
                  <a:pt x="918" y="1032"/>
                </a:lnTo>
                <a:lnTo>
                  <a:pt x="926" y="1032"/>
                </a:lnTo>
                <a:lnTo>
                  <a:pt x="932" y="1030"/>
                </a:lnTo>
                <a:lnTo>
                  <a:pt x="939" y="1028"/>
                </a:lnTo>
                <a:lnTo>
                  <a:pt x="947" y="1026"/>
                </a:lnTo>
                <a:lnTo>
                  <a:pt x="953" y="1022"/>
                </a:lnTo>
                <a:lnTo>
                  <a:pt x="960" y="1020"/>
                </a:lnTo>
                <a:lnTo>
                  <a:pt x="966" y="1019"/>
                </a:lnTo>
                <a:lnTo>
                  <a:pt x="974" y="1015"/>
                </a:lnTo>
                <a:lnTo>
                  <a:pt x="981" y="1011"/>
                </a:lnTo>
                <a:lnTo>
                  <a:pt x="987" y="1009"/>
                </a:lnTo>
                <a:lnTo>
                  <a:pt x="995" y="1007"/>
                </a:lnTo>
                <a:lnTo>
                  <a:pt x="1001" y="1005"/>
                </a:lnTo>
                <a:lnTo>
                  <a:pt x="1008" y="1003"/>
                </a:lnTo>
                <a:lnTo>
                  <a:pt x="1016" y="1001"/>
                </a:lnTo>
                <a:lnTo>
                  <a:pt x="1022" y="999"/>
                </a:lnTo>
                <a:lnTo>
                  <a:pt x="1029" y="999"/>
                </a:lnTo>
                <a:lnTo>
                  <a:pt x="1035" y="1001"/>
                </a:lnTo>
                <a:lnTo>
                  <a:pt x="1043" y="1001"/>
                </a:lnTo>
                <a:lnTo>
                  <a:pt x="1049" y="1001"/>
                </a:lnTo>
                <a:lnTo>
                  <a:pt x="1056" y="1003"/>
                </a:lnTo>
                <a:lnTo>
                  <a:pt x="1064" y="1005"/>
                </a:lnTo>
                <a:lnTo>
                  <a:pt x="1070" y="1005"/>
                </a:lnTo>
                <a:lnTo>
                  <a:pt x="1078" y="1007"/>
                </a:lnTo>
                <a:lnTo>
                  <a:pt x="1083" y="1009"/>
                </a:lnTo>
                <a:lnTo>
                  <a:pt x="1091" y="1011"/>
                </a:lnTo>
                <a:lnTo>
                  <a:pt x="1099" y="1013"/>
                </a:lnTo>
                <a:lnTo>
                  <a:pt x="1104" y="1013"/>
                </a:lnTo>
                <a:lnTo>
                  <a:pt x="1112" y="1015"/>
                </a:lnTo>
                <a:lnTo>
                  <a:pt x="1118" y="1015"/>
                </a:lnTo>
                <a:lnTo>
                  <a:pt x="1126" y="1017"/>
                </a:lnTo>
                <a:lnTo>
                  <a:pt x="1133" y="1017"/>
                </a:lnTo>
                <a:lnTo>
                  <a:pt x="1139" y="1017"/>
                </a:lnTo>
                <a:lnTo>
                  <a:pt x="1147" y="1017"/>
                </a:lnTo>
                <a:lnTo>
                  <a:pt x="1152" y="1017"/>
                </a:lnTo>
                <a:lnTo>
                  <a:pt x="1160" y="1017"/>
                </a:lnTo>
                <a:lnTo>
                  <a:pt x="1168" y="1017"/>
                </a:lnTo>
                <a:lnTo>
                  <a:pt x="1174" y="1015"/>
                </a:lnTo>
                <a:lnTo>
                  <a:pt x="1181" y="1015"/>
                </a:lnTo>
                <a:lnTo>
                  <a:pt x="1187" y="1013"/>
                </a:lnTo>
                <a:lnTo>
                  <a:pt x="1195" y="1013"/>
                </a:lnTo>
                <a:lnTo>
                  <a:pt x="1200" y="1011"/>
                </a:lnTo>
                <a:lnTo>
                  <a:pt x="1208" y="1009"/>
                </a:lnTo>
                <a:lnTo>
                  <a:pt x="1216" y="1007"/>
                </a:lnTo>
                <a:lnTo>
                  <a:pt x="1222" y="1003"/>
                </a:lnTo>
                <a:lnTo>
                  <a:pt x="1229" y="1001"/>
                </a:lnTo>
                <a:lnTo>
                  <a:pt x="1235" y="997"/>
                </a:lnTo>
                <a:lnTo>
                  <a:pt x="1243" y="994"/>
                </a:lnTo>
                <a:lnTo>
                  <a:pt x="1250" y="990"/>
                </a:lnTo>
                <a:lnTo>
                  <a:pt x="1256" y="984"/>
                </a:lnTo>
                <a:lnTo>
                  <a:pt x="1264" y="980"/>
                </a:lnTo>
                <a:lnTo>
                  <a:pt x="1270" y="974"/>
                </a:lnTo>
                <a:lnTo>
                  <a:pt x="1277" y="967"/>
                </a:lnTo>
                <a:lnTo>
                  <a:pt x="1285" y="961"/>
                </a:lnTo>
                <a:lnTo>
                  <a:pt x="1291" y="953"/>
                </a:lnTo>
                <a:lnTo>
                  <a:pt x="1298" y="946"/>
                </a:lnTo>
                <a:lnTo>
                  <a:pt x="1304" y="938"/>
                </a:lnTo>
                <a:lnTo>
                  <a:pt x="1312" y="930"/>
                </a:lnTo>
                <a:lnTo>
                  <a:pt x="1318" y="921"/>
                </a:lnTo>
                <a:lnTo>
                  <a:pt x="1325" y="913"/>
                </a:lnTo>
                <a:lnTo>
                  <a:pt x="1333" y="905"/>
                </a:lnTo>
                <a:lnTo>
                  <a:pt x="1339" y="898"/>
                </a:lnTo>
                <a:lnTo>
                  <a:pt x="1346" y="892"/>
                </a:lnTo>
                <a:lnTo>
                  <a:pt x="1352" y="886"/>
                </a:lnTo>
                <a:lnTo>
                  <a:pt x="1360" y="882"/>
                </a:lnTo>
                <a:lnTo>
                  <a:pt x="1367" y="878"/>
                </a:lnTo>
                <a:lnTo>
                  <a:pt x="1373" y="877"/>
                </a:lnTo>
                <a:lnTo>
                  <a:pt x="1381" y="875"/>
                </a:lnTo>
                <a:lnTo>
                  <a:pt x="1387" y="875"/>
                </a:lnTo>
                <a:lnTo>
                  <a:pt x="1394" y="875"/>
                </a:lnTo>
                <a:lnTo>
                  <a:pt x="1402" y="875"/>
                </a:lnTo>
                <a:lnTo>
                  <a:pt x="1408" y="877"/>
                </a:lnTo>
                <a:lnTo>
                  <a:pt x="1415" y="878"/>
                </a:lnTo>
                <a:lnTo>
                  <a:pt x="1421" y="880"/>
                </a:lnTo>
                <a:lnTo>
                  <a:pt x="1429" y="880"/>
                </a:lnTo>
                <a:lnTo>
                  <a:pt x="1435" y="882"/>
                </a:lnTo>
                <a:lnTo>
                  <a:pt x="1442" y="882"/>
                </a:lnTo>
                <a:lnTo>
                  <a:pt x="1450" y="882"/>
                </a:lnTo>
                <a:lnTo>
                  <a:pt x="1456" y="882"/>
                </a:lnTo>
                <a:lnTo>
                  <a:pt x="1463" y="882"/>
                </a:lnTo>
                <a:lnTo>
                  <a:pt x="1469" y="880"/>
                </a:lnTo>
                <a:lnTo>
                  <a:pt x="1477" y="880"/>
                </a:lnTo>
                <a:lnTo>
                  <a:pt x="1485" y="878"/>
                </a:lnTo>
                <a:lnTo>
                  <a:pt x="1490" y="877"/>
                </a:lnTo>
                <a:lnTo>
                  <a:pt x="1498" y="875"/>
                </a:lnTo>
                <a:lnTo>
                  <a:pt x="1504" y="871"/>
                </a:lnTo>
                <a:lnTo>
                  <a:pt x="1511" y="869"/>
                </a:lnTo>
                <a:lnTo>
                  <a:pt x="1519" y="865"/>
                </a:lnTo>
                <a:lnTo>
                  <a:pt x="1525" y="861"/>
                </a:lnTo>
                <a:lnTo>
                  <a:pt x="1533" y="859"/>
                </a:lnTo>
                <a:lnTo>
                  <a:pt x="1538" y="855"/>
                </a:lnTo>
                <a:lnTo>
                  <a:pt x="1546" y="854"/>
                </a:lnTo>
                <a:lnTo>
                  <a:pt x="1554" y="850"/>
                </a:lnTo>
                <a:lnTo>
                  <a:pt x="1559" y="846"/>
                </a:lnTo>
                <a:lnTo>
                  <a:pt x="1567" y="844"/>
                </a:lnTo>
                <a:lnTo>
                  <a:pt x="1573" y="842"/>
                </a:lnTo>
                <a:lnTo>
                  <a:pt x="1581" y="838"/>
                </a:lnTo>
                <a:lnTo>
                  <a:pt x="1586" y="836"/>
                </a:lnTo>
                <a:lnTo>
                  <a:pt x="1594" y="832"/>
                </a:lnTo>
                <a:lnTo>
                  <a:pt x="1602" y="830"/>
                </a:lnTo>
                <a:lnTo>
                  <a:pt x="1607" y="827"/>
                </a:lnTo>
                <a:lnTo>
                  <a:pt x="1615" y="825"/>
                </a:lnTo>
                <a:lnTo>
                  <a:pt x="1621" y="821"/>
                </a:lnTo>
                <a:lnTo>
                  <a:pt x="1629" y="819"/>
                </a:lnTo>
                <a:lnTo>
                  <a:pt x="1636" y="815"/>
                </a:lnTo>
                <a:lnTo>
                  <a:pt x="1642" y="813"/>
                </a:lnTo>
                <a:lnTo>
                  <a:pt x="1650" y="811"/>
                </a:lnTo>
                <a:lnTo>
                  <a:pt x="1655" y="809"/>
                </a:lnTo>
                <a:lnTo>
                  <a:pt x="1663" y="809"/>
                </a:lnTo>
                <a:lnTo>
                  <a:pt x="1671" y="809"/>
                </a:lnTo>
                <a:lnTo>
                  <a:pt x="1677" y="809"/>
                </a:lnTo>
                <a:lnTo>
                  <a:pt x="1684" y="809"/>
                </a:lnTo>
                <a:lnTo>
                  <a:pt x="1690" y="809"/>
                </a:lnTo>
                <a:lnTo>
                  <a:pt x="1698" y="809"/>
                </a:lnTo>
                <a:lnTo>
                  <a:pt x="1703" y="807"/>
                </a:lnTo>
                <a:lnTo>
                  <a:pt x="1711" y="806"/>
                </a:lnTo>
                <a:lnTo>
                  <a:pt x="1719" y="804"/>
                </a:lnTo>
                <a:lnTo>
                  <a:pt x="1725" y="802"/>
                </a:lnTo>
                <a:lnTo>
                  <a:pt x="1732" y="800"/>
                </a:lnTo>
                <a:lnTo>
                  <a:pt x="1738" y="800"/>
                </a:lnTo>
                <a:lnTo>
                  <a:pt x="1746" y="798"/>
                </a:lnTo>
                <a:lnTo>
                  <a:pt x="1753" y="796"/>
                </a:lnTo>
                <a:lnTo>
                  <a:pt x="1759" y="794"/>
                </a:lnTo>
                <a:lnTo>
                  <a:pt x="1767" y="790"/>
                </a:lnTo>
                <a:lnTo>
                  <a:pt x="1773" y="781"/>
                </a:lnTo>
                <a:lnTo>
                  <a:pt x="1780" y="765"/>
                </a:lnTo>
                <a:lnTo>
                  <a:pt x="1788" y="740"/>
                </a:lnTo>
                <a:lnTo>
                  <a:pt x="1794" y="700"/>
                </a:lnTo>
                <a:lnTo>
                  <a:pt x="1801" y="648"/>
                </a:lnTo>
                <a:lnTo>
                  <a:pt x="1807" y="583"/>
                </a:lnTo>
                <a:lnTo>
                  <a:pt x="1815" y="512"/>
                </a:lnTo>
                <a:lnTo>
                  <a:pt x="1823" y="437"/>
                </a:lnTo>
                <a:lnTo>
                  <a:pt x="1828" y="366"/>
                </a:lnTo>
                <a:lnTo>
                  <a:pt x="1836" y="307"/>
                </a:lnTo>
                <a:lnTo>
                  <a:pt x="1842" y="262"/>
                </a:lnTo>
                <a:lnTo>
                  <a:pt x="1849" y="239"/>
                </a:lnTo>
                <a:lnTo>
                  <a:pt x="1855" y="234"/>
                </a:lnTo>
                <a:lnTo>
                  <a:pt x="1863" y="247"/>
                </a:lnTo>
                <a:lnTo>
                  <a:pt x="1871" y="276"/>
                </a:lnTo>
                <a:lnTo>
                  <a:pt x="1876" y="316"/>
                </a:lnTo>
                <a:lnTo>
                  <a:pt x="1884" y="364"/>
                </a:lnTo>
                <a:lnTo>
                  <a:pt x="1890" y="416"/>
                </a:lnTo>
                <a:lnTo>
                  <a:pt x="1897" y="470"/>
                </a:lnTo>
                <a:lnTo>
                  <a:pt x="1905" y="522"/>
                </a:lnTo>
                <a:lnTo>
                  <a:pt x="1911" y="568"/>
                </a:lnTo>
                <a:lnTo>
                  <a:pt x="1919" y="608"/>
                </a:lnTo>
                <a:lnTo>
                  <a:pt x="1924" y="640"/>
                </a:lnTo>
                <a:lnTo>
                  <a:pt x="1932" y="667"/>
                </a:lnTo>
                <a:lnTo>
                  <a:pt x="1940" y="687"/>
                </a:lnTo>
                <a:lnTo>
                  <a:pt x="1945" y="700"/>
                </a:lnTo>
                <a:lnTo>
                  <a:pt x="1953" y="708"/>
                </a:lnTo>
                <a:lnTo>
                  <a:pt x="1959" y="711"/>
                </a:lnTo>
                <a:lnTo>
                  <a:pt x="1967" y="711"/>
                </a:lnTo>
                <a:lnTo>
                  <a:pt x="1972" y="710"/>
                </a:lnTo>
                <a:lnTo>
                  <a:pt x="1980" y="706"/>
                </a:lnTo>
                <a:lnTo>
                  <a:pt x="1988" y="702"/>
                </a:lnTo>
                <a:lnTo>
                  <a:pt x="1993" y="700"/>
                </a:lnTo>
                <a:lnTo>
                  <a:pt x="2001" y="702"/>
                </a:lnTo>
                <a:lnTo>
                  <a:pt x="2007" y="704"/>
                </a:lnTo>
                <a:lnTo>
                  <a:pt x="2015" y="708"/>
                </a:lnTo>
                <a:lnTo>
                  <a:pt x="2022" y="713"/>
                </a:lnTo>
                <a:lnTo>
                  <a:pt x="2028" y="719"/>
                </a:lnTo>
                <a:lnTo>
                  <a:pt x="2036" y="725"/>
                </a:lnTo>
                <a:lnTo>
                  <a:pt x="2041" y="731"/>
                </a:lnTo>
                <a:lnTo>
                  <a:pt x="2049" y="735"/>
                </a:lnTo>
                <a:lnTo>
                  <a:pt x="2057" y="738"/>
                </a:lnTo>
                <a:lnTo>
                  <a:pt x="2063" y="742"/>
                </a:lnTo>
                <a:lnTo>
                  <a:pt x="2070" y="746"/>
                </a:lnTo>
                <a:lnTo>
                  <a:pt x="2076" y="746"/>
                </a:lnTo>
                <a:lnTo>
                  <a:pt x="2084" y="748"/>
                </a:lnTo>
                <a:lnTo>
                  <a:pt x="2089" y="748"/>
                </a:lnTo>
                <a:lnTo>
                  <a:pt x="2097" y="746"/>
                </a:lnTo>
                <a:lnTo>
                  <a:pt x="2105" y="744"/>
                </a:lnTo>
                <a:lnTo>
                  <a:pt x="2111" y="740"/>
                </a:lnTo>
                <a:lnTo>
                  <a:pt x="2118" y="735"/>
                </a:lnTo>
                <a:lnTo>
                  <a:pt x="2124" y="731"/>
                </a:lnTo>
                <a:lnTo>
                  <a:pt x="2132" y="725"/>
                </a:lnTo>
                <a:lnTo>
                  <a:pt x="2139" y="721"/>
                </a:lnTo>
                <a:lnTo>
                  <a:pt x="2145" y="719"/>
                </a:lnTo>
                <a:lnTo>
                  <a:pt x="2153" y="719"/>
                </a:lnTo>
                <a:lnTo>
                  <a:pt x="2159" y="721"/>
                </a:lnTo>
                <a:lnTo>
                  <a:pt x="2166" y="723"/>
                </a:lnTo>
                <a:lnTo>
                  <a:pt x="2174" y="723"/>
                </a:lnTo>
                <a:lnTo>
                  <a:pt x="2180" y="721"/>
                </a:lnTo>
                <a:lnTo>
                  <a:pt x="2187" y="717"/>
                </a:lnTo>
                <a:lnTo>
                  <a:pt x="2193" y="710"/>
                </a:lnTo>
                <a:lnTo>
                  <a:pt x="2201" y="702"/>
                </a:lnTo>
                <a:lnTo>
                  <a:pt x="2208" y="694"/>
                </a:lnTo>
                <a:lnTo>
                  <a:pt x="2214" y="692"/>
                </a:lnTo>
                <a:lnTo>
                  <a:pt x="2222" y="694"/>
                </a:lnTo>
                <a:lnTo>
                  <a:pt x="2228" y="700"/>
                </a:lnTo>
                <a:lnTo>
                  <a:pt x="2235" y="706"/>
                </a:lnTo>
                <a:lnTo>
                  <a:pt x="2241" y="713"/>
                </a:lnTo>
                <a:lnTo>
                  <a:pt x="2249" y="719"/>
                </a:lnTo>
                <a:lnTo>
                  <a:pt x="2256" y="723"/>
                </a:lnTo>
                <a:lnTo>
                  <a:pt x="2262" y="725"/>
                </a:lnTo>
                <a:lnTo>
                  <a:pt x="2270" y="721"/>
                </a:lnTo>
                <a:lnTo>
                  <a:pt x="2276" y="715"/>
                </a:lnTo>
                <a:lnTo>
                  <a:pt x="2283" y="706"/>
                </a:lnTo>
                <a:lnTo>
                  <a:pt x="2291" y="694"/>
                </a:lnTo>
                <a:lnTo>
                  <a:pt x="2297" y="679"/>
                </a:lnTo>
                <a:lnTo>
                  <a:pt x="2304" y="665"/>
                </a:lnTo>
                <a:lnTo>
                  <a:pt x="2310" y="656"/>
                </a:lnTo>
                <a:lnTo>
                  <a:pt x="2318" y="650"/>
                </a:lnTo>
                <a:lnTo>
                  <a:pt x="2326" y="650"/>
                </a:lnTo>
                <a:lnTo>
                  <a:pt x="2331" y="654"/>
                </a:lnTo>
                <a:lnTo>
                  <a:pt x="2339" y="660"/>
                </a:lnTo>
                <a:lnTo>
                  <a:pt x="2345" y="669"/>
                </a:lnTo>
                <a:lnTo>
                  <a:pt x="2352" y="681"/>
                </a:lnTo>
                <a:lnTo>
                  <a:pt x="2358" y="692"/>
                </a:lnTo>
                <a:lnTo>
                  <a:pt x="2366" y="702"/>
                </a:lnTo>
                <a:lnTo>
                  <a:pt x="2374" y="711"/>
                </a:lnTo>
                <a:lnTo>
                  <a:pt x="2379" y="719"/>
                </a:lnTo>
                <a:lnTo>
                  <a:pt x="2387" y="725"/>
                </a:lnTo>
                <a:lnTo>
                  <a:pt x="2393" y="729"/>
                </a:lnTo>
                <a:lnTo>
                  <a:pt x="2400" y="733"/>
                </a:lnTo>
                <a:lnTo>
                  <a:pt x="2408" y="735"/>
                </a:lnTo>
                <a:lnTo>
                  <a:pt x="2414" y="736"/>
                </a:lnTo>
                <a:lnTo>
                  <a:pt x="2422" y="733"/>
                </a:lnTo>
                <a:lnTo>
                  <a:pt x="2427" y="727"/>
                </a:lnTo>
                <a:lnTo>
                  <a:pt x="2435" y="713"/>
                </a:lnTo>
                <a:lnTo>
                  <a:pt x="2443" y="690"/>
                </a:lnTo>
                <a:lnTo>
                  <a:pt x="2448" y="658"/>
                </a:lnTo>
                <a:lnTo>
                  <a:pt x="2456" y="623"/>
                </a:lnTo>
                <a:lnTo>
                  <a:pt x="2462" y="589"/>
                </a:lnTo>
                <a:lnTo>
                  <a:pt x="2470" y="566"/>
                </a:lnTo>
                <a:lnTo>
                  <a:pt x="2477" y="560"/>
                </a:lnTo>
                <a:lnTo>
                  <a:pt x="2483" y="566"/>
                </a:lnTo>
                <a:lnTo>
                  <a:pt x="2491" y="581"/>
                </a:lnTo>
                <a:lnTo>
                  <a:pt x="2496" y="600"/>
                </a:lnTo>
                <a:lnTo>
                  <a:pt x="2504" y="619"/>
                </a:lnTo>
                <a:lnTo>
                  <a:pt x="2510" y="637"/>
                </a:lnTo>
                <a:lnTo>
                  <a:pt x="2518" y="652"/>
                </a:lnTo>
                <a:lnTo>
                  <a:pt x="2525" y="665"/>
                </a:lnTo>
                <a:lnTo>
                  <a:pt x="2531" y="677"/>
                </a:lnTo>
                <a:lnTo>
                  <a:pt x="2539" y="690"/>
                </a:lnTo>
                <a:lnTo>
                  <a:pt x="2544" y="702"/>
                </a:lnTo>
                <a:lnTo>
                  <a:pt x="2552" y="711"/>
                </a:lnTo>
                <a:lnTo>
                  <a:pt x="2560" y="719"/>
                </a:lnTo>
                <a:lnTo>
                  <a:pt x="2566" y="725"/>
                </a:lnTo>
                <a:lnTo>
                  <a:pt x="2573" y="731"/>
                </a:lnTo>
                <a:lnTo>
                  <a:pt x="2579" y="735"/>
                </a:lnTo>
                <a:lnTo>
                  <a:pt x="2587" y="736"/>
                </a:lnTo>
                <a:lnTo>
                  <a:pt x="2594" y="740"/>
                </a:lnTo>
                <a:lnTo>
                  <a:pt x="2600" y="742"/>
                </a:lnTo>
                <a:lnTo>
                  <a:pt x="2608" y="742"/>
                </a:lnTo>
                <a:lnTo>
                  <a:pt x="2614" y="744"/>
                </a:lnTo>
                <a:lnTo>
                  <a:pt x="2621" y="746"/>
                </a:lnTo>
                <a:lnTo>
                  <a:pt x="2627" y="746"/>
                </a:lnTo>
                <a:lnTo>
                  <a:pt x="2635" y="748"/>
                </a:lnTo>
                <a:lnTo>
                  <a:pt x="2642" y="748"/>
                </a:lnTo>
                <a:lnTo>
                  <a:pt x="2648" y="750"/>
                </a:lnTo>
                <a:lnTo>
                  <a:pt x="2656" y="750"/>
                </a:lnTo>
                <a:lnTo>
                  <a:pt x="2662" y="752"/>
                </a:lnTo>
                <a:lnTo>
                  <a:pt x="2669" y="752"/>
                </a:lnTo>
                <a:lnTo>
                  <a:pt x="2677" y="754"/>
                </a:lnTo>
                <a:lnTo>
                  <a:pt x="2683" y="754"/>
                </a:lnTo>
                <a:lnTo>
                  <a:pt x="2690" y="756"/>
                </a:lnTo>
                <a:lnTo>
                  <a:pt x="2696" y="756"/>
                </a:lnTo>
                <a:lnTo>
                  <a:pt x="2704" y="756"/>
                </a:lnTo>
                <a:lnTo>
                  <a:pt x="2712" y="756"/>
                </a:lnTo>
                <a:lnTo>
                  <a:pt x="2717" y="756"/>
                </a:lnTo>
                <a:lnTo>
                  <a:pt x="2725" y="756"/>
                </a:lnTo>
                <a:lnTo>
                  <a:pt x="2731" y="756"/>
                </a:lnTo>
                <a:lnTo>
                  <a:pt x="2738" y="756"/>
                </a:lnTo>
                <a:lnTo>
                  <a:pt x="2744" y="756"/>
                </a:lnTo>
                <a:lnTo>
                  <a:pt x="2752" y="756"/>
                </a:lnTo>
                <a:lnTo>
                  <a:pt x="2760" y="754"/>
                </a:lnTo>
                <a:lnTo>
                  <a:pt x="2765" y="754"/>
                </a:lnTo>
                <a:lnTo>
                  <a:pt x="2773" y="752"/>
                </a:lnTo>
                <a:lnTo>
                  <a:pt x="2779" y="750"/>
                </a:lnTo>
                <a:lnTo>
                  <a:pt x="2786" y="750"/>
                </a:lnTo>
                <a:lnTo>
                  <a:pt x="2794" y="750"/>
                </a:lnTo>
                <a:lnTo>
                  <a:pt x="2800" y="748"/>
                </a:lnTo>
                <a:lnTo>
                  <a:pt x="2808" y="748"/>
                </a:lnTo>
                <a:lnTo>
                  <a:pt x="2813" y="748"/>
                </a:lnTo>
                <a:lnTo>
                  <a:pt x="2821" y="748"/>
                </a:lnTo>
                <a:lnTo>
                  <a:pt x="2829" y="746"/>
                </a:lnTo>
                <a:lnTo>
                  <a:pt x="2834" y="744"/>
                </a:lnTo>
                <a:lnTo>
                  <a:pt x="2842" y="744"/>
                </a:lnTo>
                <a:lnTo>
                  <a:pt x="2848" y="742"/>
                </a:lnTo>
                <a:lnTo>
                  <a:pt x="2856" y="742"/>
                </a:lnTo>
                <a:lnTo>
                  <a:pt x="2863" y="742"/>
                </a:lnTo>
                <a:lnTo>
                  <a:pt x="2869" y="740"/>
                </a:lnTo>
                <a:lnTo>
                  <a:pt x="2877" y="740"/>
                </a:lnTo>
                <a:lnTo>
                  <a:pt x="2882" y="740"/>
                </a:lnTo>
                <a:lnTo>
                  <a:pt x="2890" y="740"/>
                </a:lnTo>
                <a:lnTo>
                  <a:pt x="2896" y="740"/>
                </a:lnTo>
                <a:lnTo>
                  <a:pt x="2904" y="740"/>
                </a:lnTo>
                <a:lnTo>
                  <a:pt x="2911" y="740"/>
                </a:lnTo>
                <a:lnTo>
                  <a:pt x="2917" y="740"/>
                </a:lnTo>
                <a:lnTo>
                  <a:pt x="2925" y="738"/>
                </a:lnTo>
                <a:lnTo>
                  <a:pt x="2930" y="738"/>
                </a:lnTo>
                <a:lnTo>
                  <a:pt x="2938" y="738"/>
                </a:lnTo>
                <a:lnTo>
                  <a:pt x="2946" y="738"/>
                </a:lnTo>
                <a:lnTo>
                  <a:pt x="2952" y="738"/>
                </a:lnTo>
                <a:lnTo>
                  <a:pt x="2959" y="738"/>
                </a:lnTo>
                <a:lnTo>
                  <a:pt x="2965" y="738"/>
                </a:lnTo>
                <a:lnTo>
                  <a:pt x="2973" y="740"/>
                </a:lnTo>
                <a:lnTo>
                  <a:pt x="2980" y="738"/>
                </a:lnTo>
                <a:lnTo>
                  <a:pt x="2986" y="738"/>
                </a:lnTo>
                <a:lnTo>
                  <a:pt x="2994" y="736"/>
                </a:lnTo>
                <a:lnTo>
                  <a:pt x="3000" y="733"/>
                </a:lnTo>
                <a:lnTo>
                  <a:pt x="3007" y="727"/>
                </a:lnTo>
                <a:lnTo>
                  <a:pt x="3013" y="721"/>
                </a:lnTo>
                <a:lnTo>
                  <a:pt x="3021" y="717"/>
                </a:lnTo>
                <a:lnTo>
                  <a:pt x="3028" y="713"/>
                </a:lnTo>
                <a:lnTo>
                  <a:pt x="3034" y="711"/>
                </a:lnTo>
                <a:lnTo>
                  <a:pt x="3042" y="713"/>
                </a:lnTo>
                <a:lnTo>
                  <a:pt x="3048" y="713"/>
                </a:lnTo>
                <a:lnTo>
                  <a:pt x="3055" y="717"/>
                </a:lnTo>
                <a:lnTo>
                  <a:pt x="3063" y="719"/>
                </a:lnTo>
                <a:lnTo>
                  <a:pt x="3069" y="721"/>
                </a:lnTo>
                <a:lnTo>
                  <a:pt x="3076" y="723"/>
                </a:lnTo>
                <a:lnTo>
                  <a:pt x="3082" y="725"/>
                </a:lnTo>
                <a:lnTo>
                  <a:pt x="3090" y="725"/>
                </a:lnTo>
                <a:lnTo>
                  <a:pt x="3097" y="725"/>
                </a:lnTo>
                <a:lnTo>
                  <a:pt x="3103" y="723"/>
                </a:lnTo>
                <a:lnTo>
                  <a:pt x="3111" y="721"/>
                </a:lnTo>
                <a:lnTo>
                  <a:pt x="3117" y="717"/>
                </a:lnTo>
                <a:lnTo>
                  <a:pt x="3124" y="708"/>
                </a:lnTo>
                <a:lnTo>
                  <a:pt x="3132" y="698"/>
                </a:lnTo>
                <a:lnTo>
                  <a:pt x="3138" y="685"/>
                </a:lnTo>
                <a:lnTo>
                  <a:pt x="3145" y="671"/>
                </a:lnTo>
                <a:lnTo>
                  <a:pt x="3151" y="658"/>
                </a:lnTo>
                <a:lnTo>
                  <a:pt x="3159" y="650"/>
                </a:lnTo>
                <a:lnTo>
                  <a:pt x="3165" y="648"/>
                </a:lnTo>
                <a:lnTo>
                  <a:pt x="3172" y="652"/>
                </a:lnTo>
                <a:lnTo>
                  <a:pt x="3180" y="660"/>
                </a:lnTo>
                <a:lnTo>
                  <a:pt x="3186" y="667"/>
                </a:lnTo>
                <a:lnTo>
                  <a:pt x="3193" y="677"/>
                </a:lnTo>
                <a:lnTo>
                  <a:pt x="3199" y="683"/>
                </a:lnTo>
                <a:lnTo>
                  <a:pt x="3207" y="687"/>
                </a:lnTo>
                <a:lnTo>
                  <a:pt x="3215" y="690"/>
                </a:lnTo>
                <a:lnTo>
                  <a:pt x="3220" y="692"/>
                </a:lnTo>
                <a:lnTo>
                  <a:pt x="3228" y="692"/>
                </a:lnTo>
                <a:lnTo>
                  <a:pt x="3234" y="694"/>
                </a:lnTo>
                <a:lnTo>
                  <a:pt x="3241" y="696"/>
                </a:lnTo>
                <a:lnTo>
                  <a:pt x="3249" y="700"/>
                </a:lnTo>
                <a:lnTo>
                  <a:pt x="3255" y="704"/>
                </a:lnTo>
                <a:lnTo>
                  <a:pt x="3263" y="708"/>
                </a:lnTo>
                <a:lnTo>
                  <a:pt x="3268" y="711"/>
                </a:lnTo>
                <a:lnTo>
                  <a:pt x="3276" y="715"/>
                </a:lnTo>
                <a:lnTo>
                  <a:pt x="3282" y="717"/>
                </a:lnTo>
                <a:lnTo>
                  <a:pt x="3289" y="719"/>
                </a:lnTo>
                <a:lnTo>
                  <a:pt x="3297" y="721"/>
                </a:lnTo>
                <a:lnTo>
                  <a:pt x="3303" y="723"/>
                </a:lnTo>
                <a:lnTo>
                  <a:pt x="3311" y="725"/>
                </a:lnTo>
                <a:lnTo>
                  <a:pt x="3316" y="725"/>
                </a:lnTo>
                <a:lnTo>
                  <a:pt x="3324" y="727"/>
                </a:lnTo>
                <a:lnTo>
                  <a:pt x="3332" y="727"/>
                </a:lnTo>
                <a:lnTo>
                  <a:pt x="3337" y="729"/>
                </a:lnTo>
                <a:lnTo>
                  <a:pt x="3345" y="729"/>
                </a:lnTo>
                <a:lnTo>
                  <a:pt x="3351" y="731"/>
                </a:lnTo>
                <a:lnTo>
                  <a:pt x="3359" y="731"/>
                </a:lnTo>
                <a:lnTo>
                  <a:pt x="3366" y="731"/>
                </a:lnTo>
                <a:lnTo>
                  <a:pt x="3372" y="731"/>
                </a:lnTo>
                <a:lnTo>
                  <a:pt x="3380" y="731"/>
                </a:lnTo>
                <a:lnTo>
                  <a:pt x="3385" y="731"/>
                </a:lnTo>
                <a:lnTo>
                  <a:pt x="3393" y="731"/>
                </a:lnTo>
                <a:lnTo>
                  <a:pt x="3399" y="731"/>
                </a:lnTo>
                <a:lnTo>
                  <a:pt x="3407" y="731"/>
                </a:lnTo>
                <a:lnTo>
                  <a:pt x="3414" y="729"/>
                </a:lnTo>
                <a:lnTo>
                  <a:pt x="3420" y="731"/>
                </a:lnTo>
                <a:lnTo>
                  <a:pt x="3428" y="731"/>
                </a:lnTo>
                <a:lnTo>
                  <a:pt x="3433" y="731"/>
                </a:lnTo>
                <a:lnTo>
                  <a:pt x="3441" y="729"/>
                </a:lnTo>
                <a:lnTo>
                  <a:pt x="3449" y="729"/>
                </a:lnTo>
                <a:lnTo>
                  <a:pt x="3455" y="729"/>
                </a:lnTo>
                <a:lnTo>
                  <a:pt x="3462" y="729"/>
                </a:lnTo>
                <a:lnTo>
                  <a:pt x="3468" y="727"/>
                </a:lnTo>
                <a:lnTo>
                  <a:pt x="3476" y="727"/>
                </a:lnTo>
                <a:lnTo>
                  <a:pt x="3483" y="725"/>
                </a:lnTo>
                <a:lnTo>
                  <a:pt x="3489" y="723"/>
                </a:lnTo>
                <a:lnTo>
                  <a:pt x="3497" y="723"/>
                </a:lnTo>
                <a:lnTo>
                  <a:pt x="3503" y="721"/>
                </a:lnTo>
                <a:lnTo>
                  <a:pt x="3510" y="719"/>
                </a:lnTo>
                <a:lnTo>
                  <a:pt x="3518" y="719"/>
                </a:lnTo>
                <a:lnTo>
                  <a:pt x="3524" y="717"/>
                </a:lnTo>
                <a:lnTo>
                  <a:pt x="3531" y="717"/>
                </a:lnTo>
                <a:lnTo>
                  <a:pt x="3537" y="715"/>
                </a:lnTo>
                <a:lnTo>
                  <a:pt x="3545" y="715"/>
                </a:lnTo>
                <a:lnTo>
                  <a:pt x="3551" y="713"/>
                </a:lnTo>
                <a:lnTo>
                  <a:pt x="3558" y="711"/>
                </a:lnTo>
                <a:lnTo>
                  <a:pt x="3566" y="710"/>
                </a:lnTo>
                <a:lnTo>
                  <a:pt x="3572" y="706"/>
                </a:lnTo>
                <a:lnTo>
                  <a:pt x="3579" y="704"/>
                </a:lnTo>
                <a:lnTo>
                  <a:pt x="3585" y="702"/>
                </a:lnTo>
                <a:lnTo>
                  <a:pt x="3593" y="700"/>
                </a:lnTo>
                <a:lnTo>
                  <a:pt x="3601" y="700"/>
                </a:lnTo>
                <a:lnTo>
                  <a:pt x="3606" y="700"/>
                </a:lnTo>
                <a:lnTo>
                  <a:pt x="3614" y="700"/>
                </a:lnTo>
                <a:lnTo>
                  <a:pt x="3620" y="702"/>
                </a:lnTo>
                <a:lnTo>
                  <a:pt x="3627" y="702"/>
                </a:lnTo>
                <a:lnTo>
                  <a:pt x="3635" y="704"/>
                </a:lnTo>
                <a:lnTo>
                  <a:pt x="3641" y="704"/>
                </a:lnTo>
                <a:lnTo>
                  <a:pt x="3649" y="706"/>
                </a:lnTo>
                <a:lnTo>
                  <a:pt x="3654" y="706"/>
                </a:lnTo>
                <a:lnTo>
                  <a:pt x="3662" y="708"/>
                </a:lnTo>
                <a:lnTo>
                  <a:pt x="3668" y="708"/>
                </a:lnTo>
                <a:lnTo>
                  <a:pt x="3675" y="710"/>
                </a:lnTo>
                <a:lnTo>
                  <a:pt x="3683" y="710"/>
                </a:lnTo>
                <a:lnTo>
                  <a:pt x="3689" y="710"/>
                </a:lnTo>
                <a:lnTo>
                  <a:pt x="3697" y="710"/>
                </a:lnTo>
                <a:lnTo>
                  <a:pt x="3702" y="710"/>
                </a:lnTo>
                <a:lnTo>
                  <a:pt x="3710" y="708"/>
                </a:lnTo>
                <a:lnTo>
                  <a:pt x="3718" y="708"/>
                </a:lnTo>
                <a:lnTo>
                  <a:pt x="3723" y="706"/>
                </a:lnTo>
                <a:lnTo>
                  <a:pt x="3731" y="706"/>
                </a:lnTo>
                <a:lnTo>
                  <a:pt x="3737" y="704"/>
                </a:lnTo>
                <a:lnTo>
                  <a:pt x="3745" y="702"/>
                </a:lnTo>
                <a:lnTo>
                  <a:pt x="3752" y="702"/>
                </a:lnTo>
                <a:lnTo>
                  <a:pt x="3758" y="698"/>
                </a:lnTo>
                <a:lnTo>
                  <a:pt x="3766" y="692"/>
                </a:lnTo>
                <a:lnTo>
                  <a:pt x="3771" y="683"/>
                </a:lnTo>
                <a:lnTo>
                  <a:pt x="3779" y="669"/>
                </a:lnTo>
                <a:lnTo>
                  <a:pt x="3785" y="646"/>
                </a:lnTo>
                <a:lnTo>
                  <a:pt x="3793" y="614"/>
                </a:lnTo>
                <a:lnTo>
                  <a:pt x="3800" y="573"/>
                </a:lnTo>
                <a:lnTo>
                  <a:pt x="3806" y="523"/>
                </a:lnTo>
                <a:lnTo>
                  <a:pt x="3814" y="472"/>
                </a:lnTo>
                <a:lnTo>
                  <a:pt x="3819" y="422"/>
                </a:lnTo>
                <a:lnTo>
                  <a:pt x="3827" y="380"/>
                </a:lnTo>
                <a:lnTo>
                  <a:pt x="3835" y="353"/>
                </a:lnTo>
                <a:lnTo>
                  <a:pt x="3841" y="341"/>
                </a:lnTo>
                <a:lnTo>
                  <a:pt x="3848" y="347"/>
                </a:lnTo>
                <a:lnTo>
                  <a:pt x="3854" y="366"/>
                </a:lnTo>
                <a:lnTo>
                  <a:pt x="3862" y="393"/>
                </a:lnTo>
                <a:lnTo>
                  <a:pt x="3869" y="424"/>
                </a:lnTo>
                <a:lnTo>
                  <a:pt x="3875" y="454"/>
                </a:lnTo>
                <a:lnTo>
                  <a:pt x="3883" y="485"/>
                </a:lnTo>
                <a:lnTo>
                  <a:pt x="3889" y="514"/>
                </a:lnTo>
                <a:lnTo>
                  <a:pt x="3896" y="539"/>
                </a:lnTo>
                <a:lnTo>
                  <a:pt x="3904" y="562"/>
                </a:lnTo>
                <a:lnTo>
                  <a:pt x="3910" y="585"/>
                </a:lnTo>
                <a:lnTo>
                  <a:pt x="3917" y="602"/>
                </a:lnTo>
                <a:lnTo>
                  <a:pt x="3923" y="619"/>
                </a:lnTo>
                <a:lnTo>
                  <a:pt x="3931" y="633"/>
                </a:lnTo>
                <a:lnTo>
                  <a:pt x="3937" y="644"/>
                </a:lnTo>
                <a:lnTo>
                  <a:pt x="3944" y="654"/>
                </a:lnTo>
                <a:lnTo>
                  <a:pt x="3952" y="662"/>
                </a:lnTo>
                <a:lnTo>
                  <a:pt x="3958" y="669"/>
                </a:lnTo>
                <a:lnTo>
                  <a:pt x="3965" y="673"/>
                </a:lnTo>
                <a:lnTo>
                  <a:pt x="3971" y="677"/>
                </a:lnTo>
                <a:lnTo>
                  <a:pt x="3979" y="681"/>
                </a:lnTo>
                <a:lnTo>
                  <a:pt x="3986" y="683"/>
                </a:lnTo>
                <a:lnTo>
                  <a:pt x="3992" y="687"/>
                </a:lnTo>
                <a:lnTo>
                  <a:pt x="4000" y="688"/>
                </a:lnTo>
                <a:lnTo>
                  <a:pt x="4006" y="688"/>
                </a:lnTo>
                <a:lnTo>
                  <a:pt x="4013" y="688"/>
                </a:lnTo>
                <a:lnTo>
                  <a:pt x="4021" y="690"/>
                </a:lnTo>
                <a:lnTo>
                  <a:pt x="4027" y="688"/>
                </a:lnTo>
                <a:lnTo>
                  <a:pt x="4034" y="688"/>
                </a:lnTo>
                <a:lnTo>
                  <a:pt x="4040" y="687"/>
                </a:lnTo>
                <a:lnTo>
                  <a:pt x="4048" y="685"/>
                </a:lnTo>
                <a:lnTo>
                  <a:pt x="4054" y="681"/>
                </a:lnTo>
                <a:lnTo>
                  <a:pt x="4061" y="677"/>
                </a:lnTo>
                <a:lnTo>
                  <a:pt x="4069" y="669"/>
                </a:lnTo>
                <a:lnTo>
                  <a:pt x="4075" y="660"/>
                </a:lnTo>
                <a:lnTo>
                  <a:pt x="4082" y="644"/>
                </a:lnTo>
                <a:lnTo>
                  <a:pt x="4088" y="621"/>
                </a:lnTo>
                <a:lnTo>
                  <a:pt x="4096" y="587"/>
                </a:lnTo>
                <a:lnTo>
                  <a:pt x="4104" y="537"/>
                </a:lnTo>
                <a:lnTo>
                  <a:pt x="4109" y="477"/>
                </a:lnTo>
                <a:lnTo>
                  <a:pt x="4117" y="414"/>
                </a:lnTo>
                <a:lnTo>
                  <a:pt x="4123" y="360"/>
                </a:lnTo>
                <a:lnTo>
                  <a:pt x="4130" y="328"/>
                </a:lnTo>
                <a:lnTo>
                  <a:pt x="4138" y="320"/>
                </a:lnTo>
                <a:lnTo>
                  <a:pt x="4144" y="335"/>
                </a:lnTo>
                <a:lnTo>
                  <a:pt x="4152" y="366"/>
                </a:lnTo>
                <a:lnTo>
                  <a:pt x="4157" y="404"/>
                </a:lnTo>
                <a:lnTo>
                  <a:pt x="4165" y="443"/>
                </a:lnTo>
                <a:lnTo>
                  <a:pt x="4173" y="477"/>
                </a:lnTo>
                <a:lnTo>
                  <a:pt x="4178" y="506"/>
                </a:lnTo>
                <a:lnTo>
                  <a:pt x="4186" y="531"/>
                </a:lnTo>
                <a:lnTo>
                  <a:pt x="4192" y="552"/>
                </a:lnTo>
                <a:lnTo>
                  <a:pt x="4200" y="569"/>
                </a:lnTo>
                <a:lnTo>
                  <a:pt x="4205" y="583"/>
                </a:lnTo>
                <a:lnTo>
                  <a:pt x="4213" y="594"/>
                </a:lnTo>
                <a:lnTo>
                  <a:pt x="4221" y="602"/>
                </a:lnTo>
                <a:lnTo>
                  <a:pt x="4226" y="608"/>
                </a:lnTo>
                <a:lnTo>
                  <a:pt x="4234" y="612"/>
                </a:lnTo>
                <a:lnTo>
                  <a:pt x="4240" y="617"/>
                </a:lnTo>
                <a:lnTo>
                  <a:pt x="4248" y="619"/>
                </a:lnTo>
                <a:lnTo>
                  <a:pt x="4255" y="621"/>
                </a:lnTo>
                <a:lnTo>
                  <a:pt x="4261" y="621"/>
                </a:lnTo>
                <a:lnTo>
                  <a:pt x="4269" y="621"/>
                </a:lnTo>
                <a:lnTo>
                  <a:pt x="4275" y="619"/>
                </a:lnTo>
                <a:lnTo>
                  <a:pt x="4282" y="616"/>
                </a:lnTo>
                <a:lnTo>
                  <a:pt x="4290" y="608"/>
                </a:lnTo>
                <a:lnTo>
                  <a:pt x="4296" y="598"/>
                </a:lnTo>
                <a:lnTo>
                  <a:pt x="4303" y="585"/>
                </a:lnTo>
                <a:lnTo>
                  <a:pt x="4309" y="573"/>
                </a:lnTo>
                <a:lnTo>
                  <a:pt x="4317" y="562"/>
                </a:lnTo>
                <a:lnTo>
                  <a:pt x="4323" y="556"/>
                </a:lnTo>
                <a:lnTo>
                  <a:pt x="4330" y="554"/>
                </a:lnTo>
                <a:lnTo>
                  <a:pt x="4338" y="554"/>
                </a:lnTo>
                <a:lnTo>
                  <a:pt x="4344" y="554"/>
                </a:lnTo>
                <a:lnTo>
                  <a:pt x="4351" y="554"/>
                </a:lnTo>
                <a:lnTo>
                  <a:pt x="4357" y="550"/>
                </a:lnTo>
                <a:lnTo>
                  <a:pt x="4365" y="541"/>
                </a:lnTo>
                <a:lnTo>
                  <a:pt x="4372" y="527"/>
                </a:lnTo>
                <a:lnTo>
                  <a:pt x="4378" y="510"/>
                </a:lnTo>
                <a:lnTo>
                  <a:pt x="4386" y="485"/>
                </a:lnTo>
                <a:lnTo>
                  <a:pt x="4392" y="452"/>
                </a:lnTo>
                <a:lnTo>
                  <a:pt x="4399" y="403"/>
                </a:lnTo>
                <a:lnTo>
                  <a:pt x="4407" y="332"/>
                </a:lnTo>
                <a:lnTo>
                  <a:pt x="4413" y="234"/>
                </a:lnTo>
                <a:lnTo>
                  <a:pt x="4420" y="119"/>
                </a:lnTo>
                <a:lnTo>
                  <a:pt x="4426" y="3"/>
                </a:lnTo>
                <a:lnTo>
                  <a:pt x="4428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5" name="Freeform 802">
            <a:extLst>
              <a:ext uri="{FF2B5EF4-FFF2-40B4-BE49-F238E27FC236}">
                <a16:creationId xmlns:a16="http://schemas.microsoft.com/office/drawing/2014/main" id="{FAF59E0D-DDCF-6684-2F8B-578C638E31FA}"/>
              </a:ext>
            </a:extLst>
          </p:cNvPr>
          <p:cNvSpPr>
            <a:spLocks/>
          </p:cNvSpPr>
          <p:nvPr/>
        </p:nvSpPr>
        <p:spPr bwMode="auto">
          <a:xfrm>
            <a:off x="6035791" y="3808009"/>
            <a:ext cx="465749" cy="335392"/>
          </a:xfrm>
          <a:custGeom>
            <a:avLst/>
            <a:gdLst>
              <a:gd name="T0" fmla="*/ 1 w 1878"/>
              <a:gd name="T1" fmla="*/ 2 h 518"/>
              <a:gd name="T2" fmla="*/ 1 w 1878"/>
              <a:gd name="T3" fmla="*/ 3 h 518"/>
              <a:gd name="T4" fmla="*/ 1 w 1878"/>
              <a:gd name="T5" fmla="*/ 3 h 518"/>
              <a:gd name="T6" fmla="*/ 1 w 1878"/>
              <a:gd name="T7" fmla="*/ 3 h 518"/>
              <a:gd name="T8" fmla="*/ 2 w 1878"/>
              <a:gd name="T9" fmla="*/ 3 h 518"/>
              <a:gd name="T10" fmla="*/ 2 w 1878"/>
              <a:gd name="T11" fmla="*/ 4 h 518"/>
              <a:gd name="T12" fmla="*/ 2 w 1878"/>
              <a:gd name="T13" fmla="*/ 4 h 518"/>
              <a:gd name="T14" fmla="*/ 3 w 1878"/>
              <a:gd name="T15" fmla="*/ 5 h 518"/>
              <a:gd name="T16" fmla="*/ 3 w 1878"/>
              <a:gd name="T17" fmla="*/ 4 h 518"/>
              <a:gd name="T18" fmla="*/ 3 w 1878"/>
              <a:gd name="T19" fmla="*/ 3 h 518"/>
              <a:gd name="T20" fmla="*/ 3 w 1878"/>
              <a:gd name="T21" fmla="*/ 4 h 518"/>
              <a:gd name="T22" fmla="*/ 4 w 1878"/>
              <a:gd name="T23" fmla="*/ 4 h 518"/>
              <a:gd name="T24" fmla="*/ 4 w 1878"/>
              <a:gd name="T25" fmla="*/ 4 h 518"/>
              <a:gd name="T26" fmla="*/ 4 w 1878"/>
              <a:gd name="T27" fmla="*/ 4 h 518"/>
              <a:gd name="T28" fmla="*/ 4 w 1878"/>
              <a:gd name="T29" fmla="*/ 4 h 518"/>
              <a:gd name="T30" fmla="*/ 5 w 1878"/>
              <a:gd name="T31" fmla="*/ 4 h 518"/>
              <a:gd name="T32" fmla="*/ 5 w 1878"/>
              <a:gd name="T33" fmla="*/ 4 h 518"/>
              <a:gd name="T34" fmla="*/ 5 w 1878"/>
              <a:gd name="T35" fmla="*/ 4 h 518"/>
              <a:gd name="T36" fmla="*/ 6 w 1878"/>
              <a:gd name="T37" fmla="*/ 3 h 518"/>
              <a:gd name="T38" fmla="*/ 6 w 1878"/>
              <a:gd name="T39" fmla="*/ 3 h 518"/>
              <a:gd name="T40" fmla="*/ 6 w 1878"/>
              <a:gd name="T41" fmla="*/ 3 h 518"/>
              <a:gd name="T42" fmla="*/ 6 w 1878"/>
              <a:gd name="T43" fmla="*/ 3 h 518"/>
              <a:gd name="T44" fmla="*/ 7 w 1878"/>
              <a:gd name="T45" fmla="*/ 3 h 518"/>
              <a:gd name="T46" fmla="*/ 7 w 1878"/>
              <a:gd name="T47" fmla="*/ 3 h 518"/>
              <a:gd name="T48" fmla="*/ 7 w 1878"/>
              <a:gd name="T49" fmla="*/ 3 h 518"/>
              <a:gd name="T50" fmla="*/ 7 w 1878"/>
              <a:gd name="T51" fmla="*/ 3 h 518"/>
              <a:gd name="T52" fmla="*/ 8 w 1878"/>
              <a:gd name="T53" fmla="*/ 3 h 518"/>
              <a:gd name="T54" fmla="*/ 8 w 1878"/>
              <a:gd name="T55" fmla="*/ 3 h 518"/>
              <a:gd name="T56" fmla="*/ 8 w 1878"/>
              <a:gd name="T57" fmla="*/ 3 h 518"/>
              <a:gd name="T58" fmla="*/ 8 w 1878"/>
              <a:gd name="T59" fmla="*/ 3 h 518"/>
              <a:gd name="T60" fmla="*/ 9 w 1878"/>
              <a:gd name="T61" fmla="*/ 3 h 518"/>
              <a:gd name="T62" fmla="*/ 9 w 1878"/>
              <a:gd name="T63" fmla="*/ 4 h 518"/>
              <a:gd name="T64" fmla="*/ 9 w 1878"/>
              <a:gd name="T65" fmla="*/ 4 h 518"/>
              <a:gd name="T66" fmla="*/ 10 w 1878"/>
              <a:gd name="T67" fmla="*/ 4 h 518"/>
              <a:gd name="T68" fmla="*/ 10 w 1878"/>
              <a:gd name="T69" fmla="*/ 4 h 518"/>
              <a:gd name="T70" fmla="*/ 10 w 1878"/>
              <a:gd name="T71" fmla="*/ 3 h 518"/>
              <a:gd name="T72" fmla="*/ 10 w 1878"/>
              <a:gd name="T73" fmla="*/ 3 h 518"/>
              <a:gd name="T74" fmla="*/ 11 w 1878"/>
              <a:gd name="T75" fmla="*/ 3 h 518"/>
              <a:gd name="T76" fmla="*/ 11 w 1878"/>
              <a:gd name="T77" fmla="*/ 3 h 518"/>
              <a:gd name="T78" fmla="*/ 11 w 1878"/>
              <a:gd name="T79" fmla="*/ 3 h 518"/>
              <a:gd name="T80" fmla="*/ 11 w 1878"/>
              <a:gd name="T81" fmla="*/ 3 h 518"/>
              <a:gd name="T82" fmla="*/ 12 w 1878"/>
              <a:gd name="T83" fmla="*/ 3 h 518"/>
              <a:gd name="T84" fmla="*/ 12 w 1878"/>
              <a:gd name="T85" fmla="*/ 3 h 518"/>
              <a:gd name="T86" fmla="*/ 12 w 1878"/>
              <a:gd name="T87" fmla="*/ 3 h 518"/>
              <a:gd name="T88" fmla="*/ 13 w 1878"/>
              <a:gd name="T89" fmla="*/ 3 h 518"/>
              <a:gd name="T90" fmla="*/ 13 w 1878"/>
              <a:gd name="T91" fmla="*/ 3 h 518"/>
              <a:gd name="T92" fmla="*/ 13 w 1878"/>
              <a:gd name="T93" fmla="*/ 3 h 518"/>
              <a:gd name="T94" fmla="*/ 13 w 1878"/>
              <a:gd name="T95" fmla="*/ 3 h 518"/>
              <a:gd name="T96" fmla="*/ 14 w 1878"/>
              <a:gd name="T97" fmla="*/ 3 h 518"/>
              <a:gd name="T98" fmla="*/ 14 w 1878"/>
              <a:gd name="T99" fmla="*/ 3 h 518"/>
              <a:gd name="T100" fmla="*/ 14 w 1878"/>
              <a:gd name="T101" fmla="*/ 3 h 518"/>
              <a:gd name="T102" fmla="*/ 14 w 1878"/>
              <a:gd name="T103" fmla="*/ 3 h 518"/>
              <a:gd name="T104" fmla="*/ 15 w 1878"/>
              <a:gd name="T105" fmla="*/ 3 h 518"/>
              <a:gd name="T106" fmla="*/ 15 w 1878"/>
              <a:gd name="T107" fmla="*/ 3 h 518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</a:gdLst>
            <a:ahLst/>
            <a:cxnLst>
              <a:cxn ang="T108">
                <a:pos x="T0" y="T1"/>
              </a:cxn>
              <a:cxn ang="T109">
                <a:pos x="T2" y="T3"/>
              </a:cxn>
              <a:cxn ang="T110">
                <a:pos x="T4" y="T5"/>
              </a:cxn>
              <a:cxn ang="T111">
                <a:pos x="T6" y="T7"/>
              </a:cxn>
              <a:cxn ang="T112">
                <a:pos x="T8" y="T9"/>
              </a:cxn>
              <a:cxn ang="T113">
                <a:pos x="T10" y="T11"/>
              </a:cxn>
              <a:cxn ang="T114">
                <a:pos x="T12" y="T13"/>
              </a:cxn>
              <a:cxn ang="T115">
                <a:pos x="T14" y="T15"/>
              </a:cxn>
              <a:cxn ang="T116">
                <a:pos x="T16" y="T17"/>
              </a:cxn>
              <a:cxn ang="T117">
                <a:pos x="T18" y="T19"/>
              </a:cxn>
              <a:cxn ang="T118">
                <a:pos x="T20" y="T21"/>
              </a:cxn>
              <a:cxn ang="T119">
                <a:pos x="T22" y="T23"/>
              </a:cxn>
              <a:cxn ang="T120">
                <a:pos x="T24" y="T25"/>
              </a:cxn>
              <a:cxn ang="T121">
                <a:pos x="T26" y="T27"/>
              </a:cxn>
              <a:cxn ang="T122">
                <a:pos x="T28" y="T29"/>
              </a:cxn>
              <a:cxn ang="T123">
                <a:pos x="T30" y="T31"/>
              </a:cxn>
              <a:cxn ang="T124">
                <a:pos x="T32" y="T33"/>
              </a:cxn>
              <a:cxn ang="T125">
                <a:pos x="T34" y="T35"/>
              </a:cxn>
              <a:cxn ang="T126">
                <a:pos x="T36" y="T37"/>
              </a:cxn>
              <a:cxn ang="T127">
                <a:pos x="T38" y="T39"/>
              </a:cxn>
              <a:cxn ang="T128">
                <a:pos x="T40" y="T41"/>
              </a:cxn>
              <a:cxn ang="T129">
                <a:pos x="T42" y="T43"/>
              </a:cxn>
              <a:cxn ang="T130">
                <a:pos x="T44" y="T45"/>
              </a:cxn>
              <a:cxn ang="T131">
                <a:pos x="T46" y="T47"/>
              </a:cxn>
              <a:cxn ang="T132">
                <a:pos x="T48" y="T49"/>
              </a:cxn>
              <a:cxn ang="T133">
                <a:pos x="T50" y="T51"/>
              </a:cxn>
              <a:cxn ang="T134">
                <a:pos x="T52" y="T53"/>
              </a:cxn>
              <a:cxn ang="T135">
                <a:pos x="T54" y="T55"/>
              </a:cxn>
              <a:cxn ang="T136">
                <a:pos x="T56" y="T57"/>
              </a:cxn>
              <a:cxn ang="T137">
                <a:pos x="T58" y="T59"/>
              </a:cxn>
              <a:cxn ang="T138">
                <a:pos x="T60" y="T61"/>
              </a:cxn>
              <a:cxn ang="T139">
                <a:pos x="T62" y="T63"/>
              </a:cxn>
              <a:cxn ang="T140">
                <a:pos x="T64" y="T65"/>
              </a:cxn>
              <a:cxn ang="T141">
                <a:pos x="T66" y="T67"/>
              </a:cxn>
              <a:cxn ang="T142">
                <a:pos x="T68" y="T69"/>
              </a:cxn>
              <a:cxn ang="T143">
                <a:pos x="T70" y="T71"/>
              </a:cxn>
              <a:cxn ang="T144">
                <a:pos x="T72" y="T73"/>
              </a:cxn>
              <a:cxn ang="T145">
                <a:pos x="T74" y="T75"/>
              </a:cxn>
              <a:cxn ang="T146">
                <a:pos x="T76" y="T77"/>
              </a:cxn>
              <a:cxn ang="T147">
                <a:pos x="T78" y="T79"/>
              </a:cxn>
              <a:cxn ang="T148">
                <a:pos x="T80" y="T81"/>
              </a:cxn>
              <a:cxn ang="T149">
                <a:pos x="T82" y="T83"/>
              </a:cxn>
              <a:cxn ang="T150">
                <a:pos x="T84" y="T85"/>
              </a:cxn>
              <a:cxn ang="T151">
                <a:pos x="T86" y="T87"/>
              </a:cxn>
              <a:cxn ang="T152">
                <a:pos x="T88" y="T89"/>
              </a:cxn>
              <a:cxn ang="T153">
                <a:pos x="T90" y="T91"/>
              </a:cxn>
              <a:cxn ang="T154">
                <a:pos x="T92" y="T93"/>
              </a:cxn>
              <a:cxn ang="T155">
                <a:pos x="T94" y="T95"/>
              </a:cxn>
              <a:cxn ang="T156">
                <a:pos x="T96" y="T97"/>
              </a:cxn>
              <a:cxn ang="T157">
                <a:pos x="T98" y="T99"/>
              </a:cxn>
              <a:cxn ang="T158">
                <a:pos x="T100" y="T101"/>
              </a:cxn>
              <a:cxn ang="T159">
                <a:pos x="T102" y="T103"/>
              </a:cxn>
              <a:cxn ang="T160">
                <a:pos x="T104" y="T105"/>
              </a:cxn>
              <a:cxn ang="T161">
                <a:pos x="T106" y="T107"/>
              </a:cxn>
            </a:cxnLst>
            <a:rect l="0" t="0" r="r" b="b"/>
            <a:pathLst>
              <a:path w="1878" h="518">
                <a:moveTo>
                  <a:pt x="0" y="0"/>
                </a:moveTo>
                <a:lnTo>
                  <a:pt x="2" y="15"/>
                </a:lnTo>
                <a:lnTo>
                  <a:pt x="9" y="92"/>
                </a:lnTo>
                <a:lnTo>
                  <a:pt x="15" y="157"/>
                </a:lnTo>
                <a:lnTo>
                  <a:pt x="23" y="205"/>
                </a:lnTo>
                <a:lnTo>
                  <a:pt x="31" y="236"/>
                </a:lnTo>
                <a:lnTo>
                  <a:pt x="36" y="257"/>
                </a:lnTo>
                <a:lnTo>
                  <a:pt x="44" y="274"/>
                </a:lnTo>
                <a:lnTo>
                  <a:pt x="50" y="293"/>
                </a:lnTo>
                <a:lnTo>
                  <a:pt x="57" y="314"/>
                </a:lnTo>
                <a:lnTo>
                  <a:pt x="65" y="335"/>
                </a:lnTo>
                <a:lnTo>
                  <a:pt x="71" y="351"/>
                </a:lnTo>
                <a:lnTo>
                  <a:pt x="79" y="355"/>
                </a:lnTo>
                <a:lnTo>
                  <a:pt x="84" y="343"/>
                </a:lnTo>
                <a:lnTo>
                  <a:pt x="92" y="324"/>
                </a:lnTo>
                <a:lnTo>
                  <a:pt x="100" y="301"/>
                </a:lnTo>
                <a:lnTo>
                  <a:pt x="105" y="287"/>
                </a:lnTo>
                <a:lnTo>
                  <a:pt x="113" y="287"/>
                </a:lnTo>
                <a:lnTo>
                  <a:pt x="119" y="299"/>
                </a:lnTo>
                <a:lnTo>
                  <a:pt x="127" y="316"/>
                </a:lnTo>
                <a:lnTo>
                  <a:pt x="132" y="337"/>
                </a:lnTo>
                <a:lnTo>
                  <a:pt x="140" y="353"/>
                </a:lnTo>
                <a:lnTo>
                  <a:pt x="148" y="362"/>
                </a:lnTo>
                <a:lnTo>
                  <a:pt x="153" y="370"/>
                </a:lnTo>
                <a:lnTo>
                  <a:pt x="161" y="376"/>
                </a:lnTo>
                <a:lnTo>
                  <a:pt x="167" y="378"/>
                </a:lnTo>
                <a:lnTo>
                  <a:pt x="175" y="381"/>
                </a:lnTo>
                <a:lnTo>
                  <a:pt x="182" y="387"/>
                </a:lnTo>
                <a:lnTo>
                  <a:pt x="188" y="397"/>
                </a:lnTo>
                <a:lnTo>
                  <a:pt x="196" y="408"/>
                </a:lnTo>
                <a:lnTo>
                  <a:pt x="201" y="426"/>
                </a:lnTo>
                <a:lnTo>
                  <a:pt x="209" y="443"/>
                </a:lnTo>
                <a:lnTo>
                  <a:pt x="217" y="462"/>
                </a:lnTo>
                <a:lnTo>
                  <a:pt x="223" y="477"/>
                </a:lnTo>
                <a:lnTo>
                  <a:pt x="230" y="489"/>
                </a:lnTo>
                <a:lnTo>
                  <a:pt x="236" y="500"/>
                </a:lnTo>
                <a:lnTo>
                  <a:pt x="244" y="508"/>
                </a:lnTo>
                <a:lnTo>
                  <a:pt x="249" y="514"/>
                </a:lnTo>
                <a:lnTo>
                  <a:pt x="257" y="518"/>
                </a:lnTo>
                <a:lnTo>
                  <a:pt x="265" y="516"/>
                </a:lnTo>
                <a:lnTo>
                  <a:pt x="271" y="508"/>
                </a:lnTo>
                <a:lnTo>
                  <a:pt x="278" y="495"/>
                </a:lnTo>
                <a:lnTo>
                  <a:pt x="284" y="472"/>
                </a:lnTo>
                <a:lnTo>
                  <a:pt x="292" y="439"/>
                </a:lnTo>
                <a:lnTo>
                  <a:pt x="299" y="404"/>
                </a:lnTo>
                <a:lnTo>
                  <a:pt x="305" y="374"/>
                </a:lnTo>
                <a:lnTo>
                  <a:pt x="313" y="353"/>
                </a:lnTo>
                <a:lnTo>
                  <a:pt x="319" y="347"/>
                </a:lnTo>
                <a:lnTo>
                  <a:pt x="326" y="353"/>
                </a:lnTo>
                <a:lnTo>
                  <a:pt x="334" y="368"/>
                </a:lnTo>
                <a:lnTo>
                  <a:pt x="340" y="387"/>
                </a:lnTo>
                <a:lnTo>
                  <a:pt x="347" y="410"/>
                </a:lnTo>
                <a:lnTo>
                  <a:pt x="353" y="429"/>
                </a:lnTo>
                <a:lnTo>
                  <a:pt x="361" y="447"/>
                </a:lnTo>
                <a:lnTo>
                  <a:pt x="368" y="462"/>
                </a:lnTo>
                <a:lnTo>
                  <a:pt x="374" y="474"/>
                </a:lnTo>
                <a:lnTo>
                  <a:pt x="382" y="485"/>
                </a:lnTo>
                <a:lnTo>
                  <a:pt x="388" y="493"/>
                </a:lnTo>
                <a:lnTo>
                  <a:pt x="395" y="498"/>
                </a:lnTo>
                <a:lnTo>
                  <a:pt x="401" y="502"/>
                </a:lnTo>
                <a:lnTo>
                  <a:pt x="409" y="504"/>
                </a:lnTo>
                <a:lnTo>
                  <a:pt x="416" y="502"/>
                </a:lnTo>
                <a:lnTo>
                  <a:pt x="422" y="498"/>
                </a:lnTo>
                <a:lnTo>
                  <a:pt x="430" y="493"/>
                </a:lnTo>
                <a:lnTo>
                  <a:pt x="436" y="481"/>
                </a:lnTo>
                <a:lnTo>
                  <a:pt x="443" y="472"/>
                </a:lnTo>
                <a:lnTo>
                  <a:pt x="451" y="462"/>
                </a:lnTo>
                <a:lnTo>
                  <a:pt x="457" y="454"/>
                </a:lnTo>
                <a:lnTo>
                  <a:pt x="465" y="451"/>
                </a:lnTo>
                <a:lnTo>
                  <a:pt x="470" y="451"/>
                </a:lnTo>
                <a:lnTo>
                  <a:pt x="478" y="452"/>
                </a:lnTo>
                <a:lnTo>
                  <a:pt x="486" y="454"/>
                </a:lnTo>
                <a:lnTo>
                  <a:pt x="491" y="458"/>
                </a:lnTo>
                <a:lnTo>
                  <a:pt x="499" y="460"/>
                </a:lnTo>
                <a:lnTo>
                  <a:pt x="505" y="460"/>
                </a:lnTo>
                <a:lnTo>
                  <a:pt x="513" y="462"/>
                </a:lnTo>
                <a:lnTo>
                  <a:pt x="518" y="464"/>
                </a:lnTo>
                <a:lnTo>
                  <a:pt x="526" y="462"/>
                </a:lnTo>
                <a:lnTo>
                  <a:pt x="534" y="462"/>
                </a:lnTo>
                <a:lnTo>
                  <a:pt x="539" y="458"/>
                </a:lnTo>
                <a:lnTo>
                  <a:pt x="547" y="454"/>
                </a:lnTo>
                <a:lnTo>
                  <a:pt x="553" y="451"/>
                </a:lnTo>
                <a:lnTo>
                  <a:pt x="561" y="449"/>
                </a:lnTo>
                <a:lnTo>
                  <a:pt x="568" y="445"/>
                </a:lnTo>
                <a:lnTo>
                  <a:pt x="574" y="445"/>
                </a:lnTo>
                <a:lnTo>
                  <a:pt x="582" y="443"/>
                </a:lnTo>
                <a:lnTo>
                  <a:pt x="587" y="441"/>
                </a:lnTo>
                <a:lnTo>
                  <a:pt x="595" y="435"/>
                </a:lnTo>
                <a:lnTo>
                  <a:pt x="603" y="429"/>
                </a:lnTo>
                <a:lnTo>
                  <a:pt x="609" y="418"/>
                </a:lnTo>
                <a:lnTo>
                  <a:pt x="616" y="404"/>
                </a:lnTo>
                <a:lnTo>
                  <a:pt x="622" y="385"/>
                </a:lnTo>
                <a:lnTo>
                  <a:pt x="630" y="362"/>
                </a:lnTo>
                <a:lnTo>
                  <a:pt x="635" y="337"/>
                </a:lnTo>
                <a:lnTo>
                  <a:pt x="643" y="312"/>
                </a:lnTo>
                <a:lnTo>
                  <a:pt x="651" y="289"/>
                </a:lnTo>
                <a:lnTo>
                  <a:pt x="657" y="272"/>
                </a:lnTo>
                <a:lnTo>
                  <a:pt x="664" y="264"/>
                </a:lnTo>
                <a:lnTo>
                  <a:pt x="670" y="266"/>
                </a:lnTo>
                <a:lnTo>
                  <a:pt x="678" y="276"/>
                </a:lnTo>
                <a:lnTo>
                  <a:pt x="685" y="289"/>
                </a:lnTo>
                <a:lnTo>
                  <a:pt x="691" y="303"/>
                </a:lnTo>
                <a:lnTo>
                  <a:pt x="699" y="312"/>
                </a:lnTo>
                <a:lnTo>
                  <a:pt x="705" y="318"/>
                </a:lnTo>
                <a:lnTo>
                  <a:pt x="712" y="320"/>
                </a:lnTo>
                <a:lnTo>
                  <a:pt x="720" y="320"/>
                </a:lnTo>
                <a:lnTo>
                  <a:pt x="726" y="314"/>
                </a:lnTo>
                <a:lnTo>
                  <a:pt x="733" y="309"/>
                </a:lnTo>
                <a:lnTo>
                  <a:pt x="739" y="301"/>
                </a:lnTo>
                <a:lnTo>
                  <a:pt x="747" y="293"/>
                </a:lnTo>
                <a:lnTo>
                  <a:pt x="754" y="285"/>
                </a:lnTo>
                <a:lnTo>
                  <a:pt x="760" y="284"/>
                </a:lnTo>
                <a:lnTo>
                  <a:pt x="768" y="285"/>
                </a:lnTo>
                <a:lnTo>
                  <a:pt x="774" y="293"/>
                </a:lnTo>
                <a:lnTo>
                  <a:pt x="781" y="303"/>
                </a:lnTo>
                <a:lnTo>
                  <a:pt x="787" y="312"/>
                </a:lnTo>
                <a:lnTo>
                  <a:pt x="795" y="322"/>
                </a:lnTo>
                <a:lnTo>
                  <a:pt x="802" y="330"/>
                </a:lnTo>
                <a:lnTo>
                  <a:pt x="808" y="333"/>
                </a:lnTo>
                <a:lnTo>
                  <a:pt x="816" y="333"/>
                </a:lnTo>
                <a:lnTo>
                  <a:pt x="822" y="330"/>
                </a:lnTo>
                <a:lnTo>
                  <a:pt x="829" y="326"/>
                </a:lnTo>
                <a:lnTo>
                  <a:pt x="837" y="320"/>
                </a:lnTo>
                <a:lnTo>
                  <a:pt x="843" y="314"/>
                </a:lnTo>
                <a:lnTo>
                  <a:pt x="850" y="310"/>
                </a:lnTo>
                <a:lnTo>
                  <a:pt x="856" y="309"/>
                </a:lnTo>
                <a:lnTo>
                  <a:pt x="864" y="310"/>
                </a:lnTo>
                <a:lnTo>
                  <a:pt x="872" y="314"/>
                </a:lnTo>
                <a:lnTo>
                  <a:pt x="877" y="320"/>
                </a:lnTo>
                <a:lnTo>
                  <a:pt x="885" y="328"/>
                </a:lnTo>
                <a:lnTo>
                  <a:pt x="891" y="333"/>
                </a:lnTo>
                <a:lnTo>
                  <a:pt x="898" y="341"/>
                </a:lnTo>
                <a:lnTo>
                  <a:pt x="904" y="349"/>
                </a:lnTo>
                <a:lnTo>
                  <a:pt x="912" y="355"/>
                </a:lnTo>
                <a:lnTo>
                  <a:pt x="920" y="360"/>
                </a:lnTo>
                <a:lnTo>
                  <a:pt x="925" y="366"/>
                </a:lnTo>
                <a:lnTo>
                  <a:pt x="933" y="372"/>
                </a:lnTo>
                <a:lnTo>
                  <a:pt x="939" y="374"/>
                </a:lnTo>
                <a:lnTo>
                  <a:pt x="946" y="376"/>
                </a:lnTo>
                <a:lnTo>
                  <a:pt x="954" y="374"/>
                </a:lnTo>
                <a:lnTo>
                  <a:pt x="960" y="374"/>
                </a:lnTo>
                <a:lnTo>
                  <a:pt x="968" y="374"/>
                </a:lnTo>
                <a:lnTo>
                  <a:pt x="973" y="374"/>
                </a:lnTo>
                <a:lnTo>
                  <a:pt x="981" y="376"/>
                </a:lnTo>
                <a:lnTo>
                  <a:pt x="989" y="380"/>
                </a:lnTo>
                <a:lnTo>
                  <a:pt x="994" y="381"/>
                </a:lnTo>
                <a:lnTo>
                  <a:pt x="1002" y="383"/>
                </a:lnTo>
                <a:lnTo>
                  <a:pt x="1008" y="385"/>
                </a:lnTo>
                <a:lnTo>
                  <a:pt x="1016" y="385"/>
                </a:lnTo>
                <a:lnTo>
                  <a:pt x="1021" y="383"/>
                </a:lnTo>
                <a:lnTo>
                  <a:pt x="1029" y="381"/>
                </a:lnTo>
                <a:lnTo>
                  <a:pt x="1037" y="380"/>
                </a:lnTo>
                <a:lnTo>
                  <a:pt x="1042" y="380"/>
                </a:lnTo>
                <a:lnTo>
                  <a:pt x="1050" y="380"/>
                </a:lnTo>
                <a:lnTo>
                  <a:pt x="1056" y="380"/>
                </a:lnTo>
                <a:lnTo>
                  <a:pt x="1064" y="383"/>
                </a:lnTo>
                <a:lnTo>
                  <a:pt x="1071" y="385"/>
                </a:lnTo>
                <a:lnTo>
                  <a:pt x="1077" y="389"/>
                </a:lnTo>
                <a:lnTo>
                  <a:pt x="1085" y="393"/>
                </a:lnTo>
                <a:lnTo>
                  <a:pt x="1090" y="397"/>
                </a:lnTo>
                <a:lnTo>
                  <a:pt x="1098" y="401"/>
                </a:lnTo>
                <a:lnTo>
                  <a:pt x="1106" y="404"/>
                </a:lnTo>
                <a:lnTo>
                  <a:pt x="1112" y="406"/>
                </a:lnTo>
                <a:lnTo>
                  <a:pt x="1119" y="408"/>
                </a:lnTo>
                <a:lnTo>
                  <a:pt x="1125" y="410"/>
                </a:lnTo>
                <a:lnTo>
                  <a:pt x="1133" y="408"/>
                </a:lnTo>
                <a:lnTo>
                  <a:pt x="1140" y="408"/>
                </a:lnTo>
                <a:lnTo>
                  <a:pt x="1146" y="406"/>
                </a:lnTo>
                <a:lnTo>
                  <a:pt x="1154" y="404"/>
                </a:lnTo>
                <a:lnTo>
                  <a:pt x="1160" y="404"/>
                </a:lnTo>
                <a:lnTo>
                  <a:pt x="1167" y="403"/>
                </a:lnTo>
                <a:lnTo>
                  <a:pt x="1173" y="403"/>
                </a:lnTo>
                <a:lnTo>
                  <a:pt x="1181" y="403"/>
                </a:lnTo>
                <a:lnTo>
                  <a:pt x="1188" y="401"/>
                </a:lnTo>
                <a:lnTo>
                  <a:pt x="1194" y="399"/>
                </a:lnTo>
                <a:lnTo>
                  <a:pt x="1202" y="397"/>
                </a:lnTo>
                <a:lnTo>
                  <a:pt x="1208" y="393"/>
                </a:lnTo>
                <a:lnTo>
                  <a:pt x="1215" y="387"/>
                </a:lnTo>
                <a:lnTo>
                  <a:pt x="1223" y="383"/>
                </a:lnTo>
                <a:lnTo>
                  <a:pt x="1229" y="378"/>
                </a:lnTo>
                <a:lnTo>
                  <a:pt x="1236" y="374"/>
                </a:lnTo>
                <a:lnTo>
                  <a:pt x="1242" y="372"/>
                </a:lnTo>
                <a:lnTo>
                  <a:pt x="1250" y="370"/>
                </a:lnTo>
                <a:lnTo>
                  <a:pt x="1258" y="370"/>
                </a:lnTo>
                <a:lnTo>
                  <a:pt x="1263" y="372"/>
                </a:lnTo>
                <a:lnTo>
                  <a:pt x="1271" y="374"/>
                </a:lnTo>
                <a:lnTo>
                  <a:pt x="1277" y="374"/>
                </a:lnTo>
                <a:lnTo>
                  <a:pt x="1284" y="374"/>
                </a:lnTo>
                <a:lnTo>
                  <a:pt x="1290" y="374"/>
                </a:lnTo>
                <a:lnTo>
                  <a:pt x="1298" y="372"/>
                </a:lnTo>
                <a:lnTo>
                  <a:pt x="1306" y="368"/>
                </a:lnTo>
                <a:lnTo>
                  <a:pt x="1311" y="364"/>
                </a:lnTo>
                <a:lnTo>
                  <a:pt x="1319" y="360"/>
                </a:lnTo>
                <a:lnTo>
                  <a:pt x="1325" y="355"/>
                </a:lnTo>
                <a:lnTo>
                  <a:pt x="1332" y="347"/>
                </a:lnTo>
                <a:lnTo>
                  <a:pt x="1340" y="341"/>
                </a:lnTo>
                <a:lnTo>
                  <a:pt x="1346" y="333"/>
                </a:lnTo>
                <a:lnTo>
                  <a:pt x="1354" y="326"/>
                </a:lnTo>
                <a:lnTo>
                  <a:pt x="1359" y="322"/>
                </a:lnTo>
                <a:lnTo>
                  <a:pt x="1367" y="320"/>
                </a:lnTo>
                <a:lnTo>
                  <a:pt x="1375" y="320"/>
                </a:lnTo>
                <a:lnTo>
                  <a:pt x="1380" y="322"/>
                </a:lnTo>
                <a:lnTo>
                  <a:pt x="1388" y="324"/>
                </a:lnTo>
                <a:lnTo>
                  <a:pt x="1394" y="326"/>
                </a:lnTo>
                <a:lnTo>
                  <a:pt x="1402" y="326"/>
                </a:lnTo>
                <a:lnTo>
                  <a:pt x="1409" y="324"/>
                </a:lnTo>
                <a:lnTo>
                  <a:pt x="1415" y="324"/>
                </a:lnTo>
                <a:lnTo>
                  <a:pt x="1423" y="324"/>
                </a:lnTo>
                <a:lnTo>
                  <a:pt x="1428" y="328"/>
                </a:lnTo>
                <a:lnTo>
                  <a:pt x="1436" y="332"/>
                </a:lnTo>
                <a:lnTo>
                  <a:pt x="1442" y="339"/>
                </a:lnTo>
                <a:lnTo>
                  <a:pt x="1450" y="347"/>
                </a:lnTo>
                <a:lnTo>
                  <a:pt x="1457" y="355"/>
                </a:lnTo>
                <a:lnTo>
                  <a:pt x="1463" y="360"/>
                </a:lnTo>
                <a:lnTo>
                  <a:pt x="1471" y="364"/>
                </a:lnTo>
                <a:lnTo>
                  <a:pt x="1476" y="366"/>
                </a:lnTo>
                <a:lnTo>
                  <a:pt x="1484" y="364"/>
                </a:lnTo>
                <a:lnTo>
                  <a:pt x="1492" y="358"/>
                </a:lnTo>
                <a:lnTo>
                  <a:pt x="1498" y="353"/>
                </a:lnTo>
                <a:lnTo>
                  <a:pt x="1505" y="343"/>
                </a:lnTo>
                <a:lnTo>
                  <a:pt x="1511" y="333"/>
                </a:lnTo>
                <a:lnTo>
                  <a:pt x="1519" y="324"/>
                </a:lnTo>
                <a:lnTo>
                  <a:pt x="1526" y="318"/>
                </a:lnTo>
                <a:lnTo>
                  <a:pt x="1532" y="314"/>
                </a:lnTo>
                <a:lnTo>
                  <a:pt x="1540" y="316"/>
                </a:lnTo>
                <a:lnTo>
                  <a:pt x="1546" y="320"/>
                </a:lnTo>
                <a:lnTo>
                  <a:pt x="1553" y="326"/>
                </a:lnTo>
                <a:lnTo>
                  <a:pt x="1559" y="333"/>
                </a:lnTo>
                <a:lnTo>
                  <a:pt x="1567" y="339"/>
                </a:lnTo>
                <a:lnTo>
                  <a:pt x="1574" y="343"/>
                </a:lnTo>
                <a:lnTo>
                  <a:pt x="1580" y="347"/>
                </a:lnTo>
                <a:lnTo>
                  <a:pt x="1588" y="347"/>
                </a:lnTo>
                <a:lnTo>
                  <a:pt x="1594" y="347"/>
                </a:lnTo>
                <a:lnTo>
                  <a:pt x="1601" y="343"/>
                </a:lnTo>
                <a:lnTo>
                  <a:pt x="1609" y="337"/>
                </a:lnTo>
                <a:lnTo>
                  <a:pt x="1615" y="333"/>
                </a:lnTo>
                <a:lnTo>
                  <a:pt x="1622" y="333"/>
                </a:lnTo>
                <a:lnTo>
                  <a:pt x="1628" y="335"/>
                </a:lnTo>
                <a:lnTo>
                  <a:pt x="1636" y="341"/>
                </a:lnTo>
                <a:lnTo>
                  <a:pt x="1643" y="347"/>
                </a:lnTo>
                <a:lnTo>
                  <a:pt x="1649" y="353"/>
                </a:lnTo>
                <a:lnTo>
                  <a:pt x="1657" y="356"/>
                </a:lnTo>
                <a:lnTo>
                  <a:pt x="1663" y="360"/>
                </a:lnTo>
                <a:lnTo>
                  <a:pt x="1670" y="362"/>
                </a:lnTo>
                <a:lnTo>
                  <a:pt x="1676" y="364"/>
                </a:lnTo>
                <a:lnTo>
                  <a:pt x="1684" y="366"/>
                </a:lnTo>
                <a:lnTo>
                  <a:pt x="1691" y="368"/>
                </a:lnTo>
                <a:lnTo>
                  <a:pt x="1697" y="368"/>
                </a:lnTo>
                <a:lnTo>
                  <a:pt x="1705" y="368"/>
                </a:lnTo>
                <a:lnTo>
                  <a:pt x="1711" y="370"/>
                </a:lnTo>
                <a:lnTo>
                  <a:pt x="1718" y="370"/>
                </a:lnTo>
                <a:lnTo>
                  <a:pt x="1726" y="370"/>
                </a:lnTo>
                <a:lnTo>
                  <a:pt x="1732" y="370"/>
                </a:lnTo>
                <a:lnTo>
                  <a:pt x="1739" y="372"/>
                </a:lnTo>
                <a:lnTo>
                  <a:pt x="1745" y="372"/>
                </a:lnTo>
                <a:lnTo>
                  <a:pt x="1753" y="372"/>
                </a:lnTo>
                <a:lnTo>
                  <a:pt x="1761" y="374"/>
                </a:lnTo>
                <a:lnTo>
                  <a:pt x="1766" y="374"/>
                </a:lnTo>
                <a:lnTo>
                  <a:pt x="1774" y="374"/>
                </a:lnTo>
                <a:lnTo>
                  <a:pt x="1780" y="374"/>
                </a:lnTo>
                <a:lnTo>
                  <a:pt x="1787" y="374"/>
                </a:lnTo>
                <a:lnTo>
                  <a:pt x="1795" y="374"/>
                </a:lnTo>
                <a:lnTo>
                  <a:pt x="1801" y="372"/>
                </a:lnTo>
                <a:lnTo>
                  <a:pt x="1809" y="370"/>
                </a:lnTo>
                <a:lnTo>
                  <a:pt x="1814" y="366"/>
                </a:lnTo>
                <a:lnTo>
                  <a:pt x="1822" y="360"/>
                </a:lnTo>
                <a:lnTo>
                  <a:pt x="1828" y="353"/>
                </a:lnTo>
                <a:lnTo>
                  <a:pt x="1835" y="341"/>
                </a:lnTo>
                <a:lnTo>
                  <a:pt x="1843" y="326"/>
                </a:lnTo>
                <a:lnTo>
                  <a:pt x="1849" y="305"/>
                </a:lnTo>
                <a:lnTo>
                  <a:pt x="1857" y="270"/>
                </a:lnTo>
                <a:lnTo>
                  <a:pt x="1862" y="216"/>
                </a:lnTo>
                <a:lnTo>
                  <a:pt x="1870" y="126"/>
                </a:lnTo>
                <a:lnTo>
                  <a:pt x="1878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26" name="Rectangle 804">
            <a:extLst>
              <a:ext uri="{FF2B5EF4-FFF2-40B4-BE49-F238E27FC236}">
                <a16:creationId xmlns:a16="http://schemas.microsoft.com/office/drawing/2014/main" id="{7DA3403E-9A27-0EF0-4EF9-CD41BF28BD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9698" y="3806714"/>
            <a:ext cx="1699810" cy="722581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700"/>
          </a:p>
        </p:txBody>
      </p: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762DA9DA-8717-9473-4688-2DEFB7D83074}"/>
              </a:ext>
            </a:extLst>
          </p:cNvPr>
          <p:cNvGrpSpPr/>
          <p:nvPr/>
        </p:nvGrpSpPr>
        <p:grpSpPr>
          <a:xfrm>
            <a:off x="4761123" y="2789354"/>
            <a:ext cx="1862382" cy="780361"/>
            <a:chOff x="-1138164" y="3738720"/>
            <a:chExt cx="2801263" cy="1043661"/>
          </a:xfrm>
        </p:grpSpPr>
        <p:sp>
          <p:nvSpPr>
            <p:cNvPr id="28" name="Freeform 601">
              <a:extLst>
                <a:ext uri="{FF2B5EF4-FFF2-40B4-BE49-F238E27FC236}">
                  <a16:creationId xmlns:a16="http://schemas.microsoft.com/office/drawing/2014/main" id="{58203175-A7A5-99B8-BC06-C50611D624D9}"/>
                </a:ext>
              </a:extLst>
            </p:cNvPr>
            <p:cNvSpPr>
              <a:spLocks/>
            </p:cNvSpPr>
            <p:nvPr/>
          </p:nvSpPr>
          <p:spPr bwMode="auto">
            <a:xfrm>
              <a:off x="-902147" y="3790273"/>
              <a:ext cx="2378057" cy="931083"/>
            </a:xfrm>
            <a:custGeom>
              <a:avLst/>
              <a:gdLst>
                <a:gd name="T0" fmla="*/ 0 w 6354"/>
                <a:gd name="T1" fmla="*/ 9 h 1088"/>
                <a:gd name="T2" fmla="*/ 1 w 6354"/>
                <a:gd name="T3" fmla="*/ 5 h 1088"/>
                <a:gd name="T4" fmla="*/ 2 w 6354"/>
                <a:gd name="T5" fmla="*/ 8 h 1088"/>
                <a:gd name="T6" fmla="*/ 3 w 6354"/>
                <a:gd name="T7" fmla="*/ 9 h 1088"/>
                <a:gd name="T8" fmla="*/ 3 w 6354"/>
                <a:gd name="T9" fmla="*/ 9 h 1088"/>
                <a:gd name="T10" fmla="*/ 4 w 6354"/>
                <a:gd name="T11" fmla="*/ 9 h 1088"/>
                <a:gd name="T12" fmla="*/ 5 w 6354"/>
                <a:gd name="T13" fmla="*/ 9 h 1088"/>
                <a:gd name="T14" fmla="*/ 6 w 6354"/>
                <a:gd name="T15" fmla="*/ 9 h 1088"/>
                <a:gd name="T16" fmla="*/ 7 w 6354"/>
                <a:gd name="T17" fmla="*/ 9 h 1088"/>
                <a:gd name="T18" fmla="*/ 7 w 6354"/>
                <a:gd name="T19" fmla="*/ 9 h 1088"/>
                <a:gd name="T20" fmla="*/ 8 w 6354"/>
                <a:gd name="T21" fmla="*/ 9 h 1088"/>
                <a:gd name="T22" fmla="*/ 9 w 6354"/>
                <a:gd name="T23" fmla="*/ 9 h 1088"/>
                <a:gd name="T24" fmla="*/ 10 w 6354"/>
                <a:gd name="T25" fmla="*/ 8 h 1088"/>
                <a:gd name="T26" fmla="*/ 11 w 6354"/>
                <a:gd name="T27" fmla="*/ 8 h 1088"/>
                <a:gd name="T28" fmla="*/ 12 w 6354"/>
                <a:gd name="T29" fmla="*/ 8 h 1088"/>
                <a:gd name="T30" fmla="*/ 12 w 6354"/>
                <a:gd name="T31" fmla="*/ 7 h 1088"/>
                <a:gd name="T32" fmla="*/ 13 w 6354"/>
                <a:gd name="T33" fmla="*/ 7 h 1088"/>
                <a:gd name="T34" fmla="*/ 14 w 6354"/>
                <a:gd name="T35" fmla="*/ 5 h 1088"/>
                <a:gd name="T36" fmla="*/ 15 w 6354"/>
                <a:gd name="T37" fmla="*/ 7 h 1088"/>
                <a:gd name="T38" fmla="*/ 16 w 6354"/>
                <a:gd name="T39" fmla="*/ 7 h 1088"/>
                <a:gd name="T40" fmla="*/ 16 w 6354"/>
                <a:gd name="T41" fmla="*/ 7 h 1088"/>
                <a:gd name="T42" fmla="*/ 17 w 6354"/>
                <a:gd name="T43" fmla="*/ 7 h 1088"/>
                <a:gd name="T44" fmla="*/ 18 w 6354"/>
                <a:gd name="T45" fmla="*/ 7 h 1088"/>
                <a:gd name="T46" fmla="*/ 19 w 6354"/>
                <a:gd name="T47" fmla="*/ 6 h 1088"/>
                <a:gd name="T48" fmla="*/ 20 w 6354"/>
                <a:gd name="T49" fmla="*/ 7 h 1088"/>
                <a:gd name="T50" fmla="*/ 20 w 6354"/>
                <a:gd name="T51" fmla="*/ 7 h 1088"/>
                <a:gd name="T52" fmla="*/ 21 w 6354"/>
                <a:gd name="T53" fmla="*/ 7 h 1088"/>
                <a:gd name="T54" fmla="*/ 22 w 6354"/>
                <a:gd name="T55" fmla="*/ 7 h 1088"/>
                <a:gd name="T56" fmla="*/ 23 w 6354"/>
                <a:gd name="T57" fmla="*/ 7 h 1088"/>
                <a:gd name="T58" fmla="*/ 24 w 6354"/>
                <a:gd name="T59" fmla="*/ 7 h 1088"/>
                <a:gd name="T60" fmla="*/ 24 w 6354"/>
                <a:gd name="T61" fmla="*/ 6 h 1088"/>
                <a:gd name="T62" fmla="*/ 25 w 6354"/>
                <a:gd name="T63" fmla="*/ 7 h 1088"/>
                <a:gd name="T64" fmla="*/ 26 w 6354"/>
                <a:gd name="T65" fmla="*/ 7 h 1088"/>
                <a:gd name="T66" fmla="*/ 27 w 6354"/>
                <a:gd name="T67" fmla="*/ 6 h 1088"/>
                <a:gd name="T68" fmla="*/ 28 w 6354"/>
                <a:gd name="T69" fmla="*/ 6 h 1088"/>
                <a:gd name="T70" fmla="*/ 28 w 6354"/>
                <a:gd name="T71" fmla="*/ 6 h 1088"/>
                <a:gd name="T72" fmla="*/ 29 w 6354"/>
                <a:gd name="T73" fmla="*/ 5 h 1088"/>
                <a:gd name="T74" fmla="*/ 30 w 6354"/>
                <a:gd name="T75" fmla="*/ 6 h 1088"/>
                <a:gd name="T76" fmla="*/ 31 w 6354"/>
                <a:gd name="T77" fmla="*/ 6 h 1088"/>
                <a:gd name="T78" fmla="*/ 32 w 6354"/>
                <a:gd name="T79" fmla="*/ 5 h 1088"/>
                <a:gd name="T80" fmla="*/ 33 w 6354"/>
                <a:gd name="T81" fmla="*/ 6 h 1088"/>
                <a:gd name="T82" fmla="*/ 33 w 6354"/>
                <a:gd name="T83" fmla="*/ 4 h 1088"/>
                <a:gd name="T84" fmla="*/ 34 w 6354"/>
                <a:gd name="T85" fmla="*/ 3 h 1088"/>
                <a:gd name="T86" fmla="*/ 35 w 6354"/>
                <a:gd name="T87" fmla="*/ 5 h 1088"/>
                <a:gd name="T88" fmla="*/ 36 w 6354"/>
                <a:gd name="T89" fmla="*/ 5 h 1088"/>
                <a:gd name="T90" fmla="*/ 37 w 6354"/>
                <a:gd name="T91" fmla="*/ 5 h 1088"/>
                <a:gd name="T92" fmla="*/ 37 w 6354"/>
                <a:gd name="T93" fmla="*/ 5 h 1088"/>
                <a:gd name="T94" fmla="*/ 38 w 6354"/>
                <a:gd name="T95" fmla="*/ 5 h 1088"/>
                <a:gd name="T96" fmla="*/ 39 w 6354"/>
                <a:gd name="T97" fmla="*/ 5 h 1088"/>
                <a:gd name="T98" fmla="*/ 40 w 6354"/>
                <a:gd name="T99" fmla="*/ 5 h 1088"/>
                <a:gd name="T100" fmla="*/ 41 w 6354"/>
                <a:gd name="T101" fmla="*/ 5 h 1088"/>
                <a:gd name="T102" fmla="*/ 41 w 6354"/>
                <a:gd name="T103" fmla="*/ 5 h 1088"/>
                <a:gd name="T104" fmla="*/ 42 w 6354"/>
                <a:gd name="T105" fmla="*/ 5 h 1088"/>
                <a:gd name="T106" fmla="*/ 43 w 6354"/>
                <a:gd name="T107" fmla="*/ 5 h 1088"/>
                <a:gd name="T108" fmla="*/ 44 w 6354"/>
                <a:gd name="T109" fmla="*/ 5 h 1088"/>
                <a:gd name="T110" fmla="*/ 45 w 6354"/>
                <a:gd name="T111" fmla="*/ 5 h 1088"/>
                <a:gd name="T112" fmla="*/ 45 w 6354"/>
                <a:gd name="T113" fmla="*/ 4 h 1088"/>
                <a:gd name="T114" fmla="*/ 46 w 6354"/>
                <a:gd name="T115" fmla="*/ 4 h 1088"/>
                <a:gd name="T116" fmla="*/ 47 w 6354"/>
                <a:gd name="T117" fmla="*/ 4 h 1088"/>
                <a:gd name="T118" fmla="*/ 48 w 6354"/>
                <a:gd name="T119" fmla="*/ 4 h 1088"/>
                <a:gd name="T120" fmla="*/ 49 w 6354"/>
                <a:gd name="T121" fmla="*/ 4 h 1088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60000 65536"/>
                <a:gd name="T181" fmla="*/ 0 60000 65536"/>
                <a:gd name="T182" fmla="*/ 0 60000 65536"/>
              </a:gdLst>
              <a:ahLst/>
              <a:cxnLst>
                <a:cxn ang="T122">
                  <a:pos x="T0" y="T1"/>
                </a:cxn>
                <a:cxn ang="T123">
                  <a:pos x="T2" y="T3"/>
                </a:cxn>
                <a:cxn ang="T124">
                  <a:pos x="T4" y="T5"/>
                </a:cxn>
                <a:cxn ang="T125">
                  <a:pos x="T6" y="T7"/>
                </a:cxn>
                <a:cxn ang="T126">
                  <a:pos x="T8" y="T9"/>
                </a:cxn>
                <a:cxn ang="T127">
                  <a:pos x="T10" y="T11"/>
                </a:cxn>
                <a:cxn ang="T128">
                  <a:pos x="T12" y="T13"/>
                </a:cxn>
                <a:cxn ang="T129">
                  <a:pos x="T14" y="T15"/>
                </a:cxn>
                <a:cxn ang="T130">
                  <a:pos x="T16" y="T17"/>
                </a:cxn>
                <a:cxn ang="T131">
                  <a:pos x="T18" y="T19"/>
                </a:cxn>
                <a:cxn ang="T132">
                  <a:pos x="T20" y="T21"/>
                </a:cxn>
                <a:cxn ang="T133">
                  <a:pos x="T22" y="T23"/>
                </a:cxn>
                <a:cxn ang="T134">
                  <a:pos x="T24" y="T25"/>
                </a:cxn>
                <a:cxn ang="T135">
                  <a:pos x="T26" y="T27"/>
                </a:cxn>
                <a:cxn ang="T136">
                  <a:pos x="T28" y="T29"/>
                </a:cxn>
                <a:cxn ang="T137">
                  <a:pos x="T30" y="T31"/>
                </a:cxn>
                <a:cxn ang="T138">
                  <a:pos x="T32" y="T33"/>
                </a:cxn>
                <a:cxn ang="T139">
                  <a:pos x="T34" y="T35"/>
                </a:cxn>
                <a:cxn ang="T140">
                  <a:pos x="T36" y="T37"/>
                </a:cxn>
                <a:cxn ang="T141">
                  <a:pos x="T38" y="T39"/>
                </a:cxn>
                <a:cxn ang="T142">
                  <a:pos x="T40" y="T41"/>
                </a:cxn>
                <a:cxn ang="T143">
                  <a:pos x="T42" y="T43"/>
                </a:cxn>
                <a:cxn ang="T144">
                  <a:pos x="T44" y="T45"/>
                </a:cxn>
                <a:cxn ang="T145">
                  <a:pos x="T46" y="T47"/>
                </a:cxn>
                <a:cxn ang="T146">
                  <a:pos x="T48" y="T49"/>
                </a:cxn>
                <a:cxn ang="T147">
                  <a:pos x="T50" y="T51"/>
                </a:cxn>
                <a:cxn ang="T148">
                  <a:pos x="T52" y="T53"/>
                </a:cxn>
                <a:cxn ang="T149">
                  <a:pos x="T54" y="T55"/>
                </a:cxn>
                <a:cxn ang="T150">
                  <a:pos x="T56" y="T57"/>
                </a:cxn>
                <a:cxn ang="T151">
                  <a:pos x="T58" y="T59"/>
                </a:cxn>
                <a:cxn ang="T152">
                  <a:pos x="T60" y="T61"/>
                </a:cxn>
                <a:cxn ang="T153">
                  <a:pos x="T62" y="T63"/>
                </a:cxn>
                <a:cxn ang="T154">
                  <a:pos x="T64" y="T65"/>
                </a:cxn>
                <a:cxn ang="T155">
                  <a:pos x="T66" y="T67"/>
                </a:cxn>
                <a:cxn ang="T156">
                  <a:pos x="T68" y="T69"/>
                </a:cxn>
                <a:cxn ang="T157">
                  <a:pos x="T70" y="T71"/>
                </a:cxn>
                <a:cxn ang="T158">
                  <a:pos x="T72" y="T73"/>
                </a:cxn>
                <a:cxn ang="T159">
                  <a:pos x="T74" y="T75"/>
                </a:cxn>
                <a:cxn ang="T160">
                  <a:pos x="T76" y="T77"/>
                </a:cxn>
                <a:cxn ang="T161">
                  <a:pos x="T78" y="T79"/>
                </a:cxn>
                <a:cxn ang="T162">
                  <a:pos x="T80" y="T81"/>
                </a:cxn>
                <a:cxn ang="T163">
                  <a:pos x="T82" y="T83"/>
                </a:cxn>
                <a:cxn ang="T164">
                  <a:pos x="T84" y="T85"/>
                </a:cxn>
                <a:cxn ang="T165">
                  <a:pos x="T86" y="T87"/>
                </a:cxn>
                <a:cxn ang="T166">
                  <a:pos x="T88" y="T89"/>
                </a:cxn>
                <a:cxn ang="T167">
                  <a:pos x="T90" y="T91"/>
                </a:cxn>
                <a:cxn ang="T168">
                  <a:pos x="T92" y="T93"/>
                </a:cxn>
                <a:cxn ang="T169">
                  <a:pos x="T94" y="T95"/>
                </a:cxn>
                <a:cxn ang="T170">
                  <a:pos x="T96" y="T97"/>
                </a:cxn>
                <a:cxn ang="T171">
                  <a:pos x="T98" y="T99"/>
                </a:cxn>
                <a:cxn ang="T172">
                  <a:pos x="T100" y="T101"/>
                </a:cxn>
                <a:cxn ang="T173">
                  <a:pos x="T102" y="T103"/>
                </a:cxn>
                <a:cxn ang="T174">
                  <a:pos x="T104" y="T105"/>
                </a:cxn>
                <a:cxn ang="T175">
                  <a:pos x="T106" y="T107"/>
                </a:cxn>
                <a:cxn ang="T176">
                  <a:pos x="T108" y="T109"/>
                </a:cxn>
                <a:cxn ang="T177">
                  <a:pos x="T110" y="T111"/>
                </a:cxn>
                <a:cxn ang="T178">
                  <a:pos x="T112" y="T113"/>
                </a:cxn>
                <a:cxn ang="T179">
                  <a:pos x="T114" y="T115"/>
                </a:cxn>
                <a:cxn ang="T180">
                  <a:pos x="T116" y="T117"/>
                </a:cxn>
                <a:cxn ang="T181">
                  <a:pos x="T118" y="T119"/>
                </a:cxn>
                <a:cxn ang="T182">
                  <a:pos x="T120" y="T121"/>
                </a:cxn>
              </a:cxnLst>
              <a:rect l="0" t="0" r="r" b="b"/>
              <a:pathLst>
                <a:path w="6354" h="1088">
                  <a:moveTo>
                    <a:pt x="0" y="1086"/>
                  </a:moveTo>
                  <a:lnTo>
                    <a:pt x="2" y="1088"/>
                  </a:lnTo>
                  <a:lnTo>
                    <a:pt x="8" y="1088"/>
                  </a:lnTo>
                  <a:lnTo>
                    <a:pt x="16" y="1088"/>
                  </a:lnTo>
                  <a:lnTo>
                    <a:pt x="23" y="1088"/>
                  </a:lnTo>
                  <a:lnTo>
                    <a:pt x="29" y="1088"/>
                  </a:lnTo>
                  <a:lnTo>
                    <a:pt x="37" y="1088"/>
                  </a:lnTo>
                  <a:lnTo>
                    <a:pt x="43" y="1088"/>
                  </a:lnTo>
                  <a:lnTo>
                    <a:pt x="50" y="1086"/>
                  </a:lnTo>
                  <a:lnTo>
                    <a:pt x="58" y="1084"/>
                  </a:lnTo>
                  <a:lnTo>
                    <a:pt x="64" y="1080"/>
                  </a:lnTo>
                  <a:lnTo>
                    <a:pt x="71" y="1074"/>
                  </a:lnTo>
                  <a:lnTo>
                    <a:pt x="77" y="1065"/>
                  </a:lnTo>
                  <a:lnTo>
                    <a:pt x="85" y="1053"/>
                  </a:lnTo>
                  <a:lnTo>
                    <a:pt x="92" y="1038"/>
                  </a:lnTo>
                  <a:lnTo>
                    <a:pt x="98" y="1019"/>
                  </a:lnTo>
                  <a:lnTo>
                    <a:pt x="106" y="994"/>
                  </a:lnTo>
                  <a:lnTo>
                    <a:pt x="112" y="963"/>
                  </a:lnTo>
                  <a:lnTo>
                    <a:pt x="119" y="928"/>
                  </a:lnTo>
                  <a:lnTo>
                    <a:pt x="127" y="890"/>
                  </a:lnTo>
                  <a:lnTo>
                    <a:pt x="133" y="848"/>
                  </a:lnTo>
                  <a:lnTo>
                    <a:pt x="140" y="804"/>
                  </a:lnTo>
                  <a:lnTo>
                    <a:pt x="146" y="761"/>
                  </a:lnTo>
                  <a:lnTo>
                    <a:pt x="154" y="723"/>
                  </a:lnTo>
                  <a:lnTo>
                    <a:pt x="160" y="687"/>
                  </a:lnTo>
                  <a:lnTo>
                    <a:pt x="167" y="658"/>
                  </a:lnTo>
                  <a:lnTo>
                    <a:pt x="175" y="635"/>
                  </a:lnTo>
                  <a:lnTo>
                    <a:pt x="181" y="619"/>
                  </a:lnTo>
                  <a:lnTo>
                    <a:pt x="188" y="612"/>
                  </a:lnTo>
                  <a:lnTo>
                    <a:pt x="194" y="610"/>
                  </a:lnTo>
                  <a:lnTo>
                    <a:pt x="202" y="614"/>
                  </a:lnTo>
                  <a:lnTo>
                    <a:pt x="210" y="623"/>
                  </a:lnTo>
                  <a:lnTo>
                    <a:pt x="215" y="637"/>
                  </a:lnTo>
                  <a:lnTo>
                    <a:pt x="223" y="654"/>
                  </a:lnTo>
                  <a:lnTo>
                    <a:pt x="229" y="673"/>
                  </a:lnTo>
                  <a:lnTo>
                    <a:pt x="236" y="696"/>
                  </a:lnTo>
                  <a:lnTo>
                    <a:pt x="244" y="719"/>
                  </a:lnTo>
                  <a:lnTo>
                    <a:pt x="250" y="742"/>
                  </a:lnTo>
                  <a:lnTo>
                    <a:pt x="258" y="767"/>
                  </a:lnTo>
                  <a:lnTo>
                    <a:pt x="263" y="790"/>
                  </a:lnTo>
                  <a:lnTo>
                    <a:pt x="271" y="815"/>
                  </a:lnTo>
                  <a:lnTo>
                    <a:pt x="277" y="838"/>
                  </a:lnTo>
                  <a:lnTo>
                    <a:pt x="284" y="859"/>
                  </a:lnTo>
                  <a:lnTo>
                    <a:pt x="292" y="880"/>
                  </a:lnTo>
                  <a:lnTo>
                    <a:pt x="298" y="900"/>
                  </a:lnTo>
                  <a:lnTo>
                    <a:pt x="306" y="919"/>
                  </a:lnTo>
                  <a:lnTo>
                    <a:pt x="311" y="936"/>
                  </a:lnTo>
                  <a:lnTo>
                    <a:pt x="319" y="951"/>
                  </a:lnTo>
                  <a:lnTo>
                    <a:pt x="327" y="967"/>
                  </a:lnTo>
                  <a:lnTo>
                    <a:pt x="332" y="980"/>
                  </a:lnTo>
                  <a:lnTo>
                    <a:pt x="340" y="994"/>
                  </a:lnTo>
                  <a:lnTo>
                    <a:pt x="346" y="1005"/>
                  </a:lnTo>
                  <a:lnTo>
                    <a:pt x="354" y="1015"/>
                  </a:lnTo>
                  <a:lnTo>
                    <a:pt x="361" y="1024"/>
                  </a:lnTo>
                  <a:lnTo>
                    <a:pt x="367" y="1032"/>
                  </a:lnTo>
                  <a:lnTo>
                    <a:pt x="375" y="1040"/>
                  </a:lnTo>
                  <a:lnTo>
                    <a:pt x="380" y="1047"/>
                  </a:lnTo>
                  <a:lnTo>
                    <a:pt x="388" y="1053"/>
                  </a:lnTo>
                  <a:lnTo>
                    <a:pt x="394" y="1059"/>
                  </a:lnTo>
                  <a:lnTo>
                    <a:pt x="402" y="1063"/>
                  </a:lnTo>
                  <a:lnTo>
                    <a:pt x="409" y="1067"/>
                  </a:lnTo>
                  <a:lnTo>
                    <a:pt x="415" y="1070"/>
                  </a:lnTo>
                  <a:lnTo>
                    <a:pt x="423" y="1072"/>
                  </a:lnTo>
                  <a:lnTo>
                    <a:pt x="429" y="1074"/>
                  </a:lnTo>
                  <a:lnTo>
                    <a:pt x="436" y="1076"/>
                  </a:lnTo>
                  <a:lnTo>
                    <a:pt x="444" y="1078"/>
                  </a:lnTo>
                  <a:lnTo>
                    <a:pt x="450" y="1078"/>
                  </a:lnTo>
                  <a:lnTo>
                    <a:pt x="457" y="1080"/>
                  </a:lnTo>
                  <a:lnTo>
                    <a:pt x="463" y="1080"/>
                  </a:lnTo>
                  <a:lnTo>
                    <a:pt x="471" y="1080"/>
                  </a:lnTo>
                  <a:lnTo>
                    <a:pt x="478" y="1080"/>
                  </a:lnTo>
                  <a:lnTo>
                    <a:pt x="484" y="1080"/>
                  </a:lnTo>
                  <a:lnTo>
                    <a:pt x="492" y="1078"/>
                  </a:lnTo>
                  <a:lnTo>
                    <a:pt x="498" y="1078"/>
                  </a:lnTo>
                  <a:lnTo>
                    <a:pt x="505" y="1078"/>
                  </a:lnTo>
                  <a:lnTo>
                    <a:pt x="513" y="1076"/>
                  </a:lnTo>
                  <a:lnTo>
                    <a:pt x="519" y="1076"/>
                  </a:lnTo>
                  <a:lnTo>
                    <a:pt x="526" y="1074"/>
                  </a:lnTo>
                  <a:lnTo>
                    <a:pt x="532" y="1072"/>
                  </a:lnTo>
                  <a:lnTo>
                    <a:pt x="540" y="1072"/>
                  </a:lnTo>
                  <a:lnTo>
                    <a:pt x="546" y="1070"/>
                  </a:lnTo>
                  <a:lnTo>
                    <a:pt x="553" y="1070"/>
                  </a:lnTo>
                  <a:lnTo>
                    <a:pt x="561" y="1068"/>
                  </a:lnTo>
                  <a:lnTo>
                    <a:pt x="567" y="1068"/>
                  </a:lnTo>
                  <a:lnTo>
                    <a:pt x="574" y="1068"/>
                  </a:lnTo>
                  <a:lnTo>
                    <a:pt x="580" y="1068"/>
                  </a:lnTo>
                  <a:lnTo>
                    <a:pt x="588" y="1068"/>
                  </a:lnTo>
                  <a:lnTo>
                    <a:pt x="596" y="1068"/>
                  </a:lnTo>
                  <a:lnTo>
                    <a:pt x="601" y="1068"/>
                  </a:lnTo>
                  <a:lnTo>
                    <a:pt x="609" y="1068"/>
                  </a:lnTo>
                  <a:lnTo>
                    <a:pt x="615" y="1070"/>
                  </a:lnTo>
                  <a:lnTo>
                    <a:pt x="622" y="1070"/>
                  </a:lnTo>
                  <a:lnTo>
                    <a:pt x="630" y="1070"/>
                  </a:lnTo>
                  <a:lnTo>
                    <a:pt x="636" y="1072"/>
                  </a:lnTo>
                  <a:lnTo>
                    <a:pt x="644" y="1072"/>
                  </a:lnTo>
                  <a:lnTo>
                    <a:pt x="649" y="1074"/>
                  </a:lnTo>
                  <a:lnTo>
                    <a:pt x="657" y="1074"/>
                  </a:lnTo>
                  <a:lnTo>
                    <a:pt x="663" y="1074"/>
                  </a:lnTo>
                  <a:lnTo>
                    <a:pt x="670" y="1076"/>
                  </a:lnTo>
                  <a:lnTo>
                    <a:pt x="678" y="1076"/>
                  </a:lnTo>
                  <a:lnTo>
                    <a:pt x="684" y="1076"/>
                  </a:lnTo>
                  <a:lnTo>
                    <a:pt x="692" y="1078"/>
                  </a:lnTo>
                  <a:lnTo>
                    <a:pt x="697" y="1078"/>
                  </a:lnTo>
                  <a:lnTo>
                    <a:pt x="705" y="1078"/>
                  </a:lnTo>
                  <a:lnTo>
                    <a:pt x="713" y="1078"/>
                  </a:lnTo>
                  <a:lnTo>
                    <a:pt x="718" y="1078"/>
                  </a:lnTo>
                  <a:lnTo>
                    <a:pt x="726" y="1078"/>
                  </a:lnTo>
                  <a:lnTo>
                    <a:pt x="732" y="1078"/>
                  </a:lnTo>
                  <a:lnTo>
                    <a:pt x="740" y="1078"/>
                  </a:lnTo>
                  <a:lnTo>
                    <a:pt x="747" y="1080"/>
                  </a:lnTo>
                  <a:lnTo>
                    <a:pt x="753" y="1080"/>
                  </a:lnTo>
                  <a:lnTo>
                    <a:pt x="761" y="1080"/>
                  </a:lnTo>
                  <a:lnTo>
                    <a:pt x="766" y="1080"/>
                  </a:lnTo>
                  <a:lnTo>
                    <a:pt x="774" y="1080"/>
                  </a:lnTo>
                  <a:lnTo>
                    <a:pt x="782" y="1080"/>
                  </a:lnTo>
                  <a:lnTo>
                    <a:pt x="788" y="1080"/>
                  </a:lnTo>
                  <a:lnTo>
                    <a:pt x="795" y="1080"/>
                  </a:lnTo>
                  <a:lnTo>
                    <a:pt x="801" y="1082"/>
                  </a:lnTo>
                  <a:lnTo>
                    <a:pt x="809" y="1082"/>
                  </a:lnTo>
                  <a:lnTo>
                    <a:pt x="814" y="1082"/>
                  </a:lnTo>
                  <a:lnTo>
                    <a:pt x="822" y="1082"/>
                  </a:lnTo>
                  <a:lnTo>
                    <a:pt x="830" y="1082"/>
                  </a:lnTo>
                  <a:lnTo>
                    <a:pt x="836" y="1082"/>
                  </a:lnTo>
                  <a:lnTo>
                    <a:pt x="843" y="1084"/>
                  </a:lnTo>
                  <a:lnTo>
                    <a:pt x="849" y="1084"/>
                  </a:lnTo>
                  <a:lnTo>
                    <a:pt x="857" y="1084"/>
                  </a:lnTo>
                  <a:lnTo>
                    <a:pt x="864" y="1084"/>
                  </a:lnTo>
                  <a:lnTo>
                    <a:pt x="870" y="1084"/>
                  </a:lnTo>
                  <a:lnTo>
                    <a:pt x="878" y="1084"/>
                  </a:lnTo>
                  <a:lnTo>
                    <a:pt x="884" y="1084"/>
                  </a:lnTo>
                  <a:lnTo>
                    <a:pt x="891" y="1084"/>
                  </a:lnTo>
                  <a:lnTo>
                    <a:pt x="899" y="1084"/>
                  </a:lnTo>
                  <a:lnTo>
                    <a:pt x="905" y="1084"/>
                  </a:lnTo>
                  <a:lnTo>
                    <a:pt x="912" y="1082"/>
                  </a:lnTo>
                  <a:lnTo>
                    <a:pt x="918" y="1082"/>
                  </a:lnTo>
                  <a:lnTo>
                    <a:pt x="926" y="1080"/>
                  </a:lnTo>
                  <a:lnTo>
                    <a:pt x="932" y="1080"/>
                  </a:lnTo>
                  <a:lnTo>
                    <a:pt x="939" y="1078"/>
                  </a:lnTo>
                  <a:lnTo>
                    <a:pt x="947" y="1078"/>
                  </a:lnTo>
                  <a:lnTo>
                    <a:pt x="953" y="1076"/>
                  </a:lnTo>
                  <a:lnTo>
                    <a:pt x="960" y="1074"/>
                  </a:lnTo>
                  <a:lnTo>
                    <a:pt x="966" y="1074"/>
                  </a:lnTo>
                  <a:lnTo>
                    <a:pt x="974" y="1072"/>
                  </a:lnTo>
                  <a:lnTo>
                    <a:pt x="981" y="1070"/>
                  </a:lnTo>
                  <a:lnTo>
                    <a:pt x="987" y="1070"/>
                  </a:lnTo>
                  <a:lnTo>
                    <a:pt x="995" y="1068"/>
                  </a:lnTo>
                  <a:lnTo>
                    <a:pt x="1001" y="1068"/>
                  </a:lnTo>
                  <a:lnTo>
                    <a:pt x="1008" y="1068"/>
                  </a:lnTo>
                  <a:lnTo>
                    <a:pt x="1016" y="1068"/>
                  </a:lnTo>
                  <a:lnTo>
                    <a:pt x="1022" y="1068"/>
                  </a:lnTo>
                  <a:lnTo>
                    <a:pt x="1029" y="1068"/>
                  </a:lnTo>
                  <a:lnTo>
                    <a:pt x="1035" y="1068"/>
                  </a:lnTo>
                  <a:lnTo>
                    <a:pt x="1043" y="1068"/>
                  </a:lnTo>
                  <a:lnTo>
                    <a:pt x="1049" y="1068"/>
                  </a:lnTo>
                  <a:lnTo>
                    <a:pt x="1056" y="1068"/>
                  </a:lnTo>
                  <a:lnTo>
                    <a:pt x="1064" y="1068"/>
                  </a:lnTo>
                  <a:lnTo>
                    <a:pt x="1070" y="1068"/>
                  </a:lnTo>
                  <a:lnTo>
                    <a:pt x="1078" y="1070"/>
                  </a:lnTo>
                  <a:lnTo>
                    <a:pt x="1083" y="1070"/>
                  </a:lnTo>
                  <a:lnTo>
                    <a:pt x="1091" y="1070"/>
                  </a:lnTo>
                  <a:lnTo>
                    <a:pt x="1099" y="1070"/>
                  </a:lnTo>
                  <a:lnTo>
                    <a:pt x="1104" y="1070"/>
                  </a:lnTo>
                  <a:lnTo>
                    <a:pt x="1112" y="1070"/>
                  </a:lnTo>
                  <a:lnTo>
                    <a:pt x="1118" y="1070"/>
                  </a:lnTo>
                  <a:lnTo>
                    <a:pt x="1126" y="1068"/>
                  </a:lnTo>
                  <a:lnTo>
                    <a:pt x="1133" y="1068"/>
                  </a:lnTo>
                  <a:lnTo>
                    <a:pt x="1139" y="1068"/>
                  </a:lnTo>
                  <a:lnTo>
                    <a:pt x="1147" y="1067"/>
                  </a:lnTo>
                  <a:lnTo>
                    <a:pt x="1152" y="1067"/>
                  </a:lnTo>
                  <a:lnTo>
                    <a:pt x="1160" y="1065"/>
                  </a:lnTo>
                  <a:lnTo>
                    <a:pt x="1168" y="1065"/>
                  </a:lnTo>
                  <a:lnTo>
                    <a:pt x="1174" y="1063"/>
                  </a:lnTo>
                  <a:lnTo>
                    <a:pt x="1181" y="1061"/>
                  </a:lnTo>
                  <a:lnTo>
                    <a:pt x="1187" y="1059"/>
                  </a:lnTo>
                  <a:lnTo>
                    <a:pt x="1195" y="1057"/>
                  </a:lnTo>
                  <a:lnTo>
                    <a:pt x="1200" y="1057"/>
                  </a:lnTo>
                  <a:lnTo>
                    <a:pt x="1208" y="1055"/>
                  </a:lnTo>
                  <a:lnTo>
                    <a:pt x="1216" y="1051"/>
                  </a:lnTo>
                  <a:lnTo>
                    <a:pt x="1222" y="1049"/>
                  </a:lnTo>
                  <a:lnTo>
                    <a:pt x="1229" y="1047"/>
                  </a:lnTo>
                  <a:lnTo>
                    <a:pt x="1235" y="1043"/>
                  </a:lnTo>
                  <a:lnTo>
                    <a:pt x="1243" y="1042"/>
                  </a:lnTo>
                  <a:lnTo>
                    <a:pt x="1250" y="1038"/>
                  </a:lnTo>
                  <a:lnTo>
                    <a:pt x="1256" y="1034"/>
                  </a:lnTo>
                  <a:lnTo>
                    <a:pt x="1264" y="1030"/>
                  </a:lnTo>
                  <a:lnTo>
                    <a:pt x="1270" y="1028"/>
                  </a:lnTo>
                  <a:lnTo>
                    <a:pt x="1277" y="1024"/>
                  </a:lnTo>
                  <a:lnTo>
                    <a:pt x="1285" y="1019"/>
                  </a:lnTo>
                  <a:lnTo>
                    <a:pt x="1291" y="1015"/>
                  </a:lnTo>
                  <a:lnTo>
                    <a:pt x="1298" y="1011"/>
                  </a:lnTo>
                  <a:lnTo>
                    <a:pt x="1304" y="1007"/>
                  </a:lnTo>
                  <a:lnTo>
                    <a:pt x="1312" y="1003"/>
                  </a:lnTo>
                  <a:lnTo>
                    <a:pt x="1318" y="999"/>
                  </a:lnTo>
                  <a:lnTo>
                    <a:pt x="1325" y="996"/>
                  </a:lnTo>
                  <a:lnTo>
                    <a:pt x="1333" y="992"/>
                  </a:lnTo>
                  <a:lnTo>
                    <a:pt x="1339" y="988"/>
                  </a:lnTo>
                  <a:lnTo>
                    <a:pt x="1346" y="986"/>
                  </a:lnTo>
                  <a:lnTo>
                    <a:pt x="1352" y="982"/>
                  </a:lnTo>
                  <a:lnTo>
                    <a:pt x="1360" y="980"/>
                  </a:lnTo>
                  <a:lnTo>
                    <a:pt x="1367" y="978"/>
                  </a:lnTo>
                  <a:lnTo>
                    <a:pt x="1373" y="976"/>
                  </a:lnTo>
                  <a:lnTo>
                    <a:pt x="1381" y="974"/>
                  </a:lnTo>
                  <a:lnTo>
                    <a:pt x="1387" y="972"/>
                  </a:lnTo>
                  <a:lnTo>
                    <a:pt x="1394" y="971"/>
                  </a:lnTo>
                  <a:lnTo>
                    <a:pt x="1402" y="969"/>
                  </a:lnTo>
                  <a:lnTo>
                    <a:pt x="1408" y="967"/>
                  </a:lnTo>
                  <a:lnTo>
                    <a:pt x="1415" y="965"/>
                  </a:lnTo>
                  <a:lnTo>
                    <a:pt x="1421" y="961"/>
                  </a:lnTo>
                  <a:lnTo>
                    <a:pt x="1429" y="959"/>
                  </a:lnTo>
                  <a:lnTo>
                    <a:pt x="1435" y="957"/>
                  </a:lnTo>
                  <a:lnTo>
                    <a:pt x="1442" y="955"/>
                  </a:lnTo>
                  <a:lnTo>
                    <a:pt x="1450" y="951"/>
                  </a:lnTo>
                  <a:lnTo>
                    <a:pt x="1456" y="948"/>
                  </a:lnTo>
                  <a:lnTo>
                    <a:pt x="1463" y="946"/>
                  </a:lnTo>
                  <a:lnTo>
                    <a:pt x="1469" y="942"/>
                  </a:lnTo>
                  <a:lnTo>
                    <a:pt x="1477" y="938"/>
                  </a:lnTo>
                  <a:lnTo>
                    <a:pt x="1485" y="934"/>
                  </a:lnTo>
                  <a:lnTo>
                    <a:pt x="1490" y="930"/>
                  </a:lnTo>
                  <a:lnTo>
                    <a:pt x="1498" y="928"/>
                  </a:lnTo>
                  <a:lnTo>
                    <a:pt x="1504" y="925"/>
                  </a:lnTo>
                  <a:lnTo>
                    <a:pt x="1511" y="921"/>
                  </a:lnTo>
                  <a:lnTo>
                    <a:pt x="1519" y="917"/>
                  </a:lnTo>
                  <a:lnTo>
                    <a:pt x="1525" y="913"/>
                  </a:lnTo>
                  <a:lnTo>
                    <a:pt x="1533" y="909"/>
                  </a:lnTo>
                  <a:lnTo>
                    <a:pt x="1538" y="907"/>
                  </a:lnTo>
                  <a:lnTo>
                    <a:pt x="1546" y="903"/>
                  </a:lnTo>
                  <a:lnTo>
                    <a:pt x="1554" y="901"/>
                  </a:lnTo>
                  <a:lnTo>
                    <a:pt x="1559" y="898"/>
                  </a:lnTo>
                  <a:lnTo>
                    <a:pt x="1567" y="896"/>
                  </a:lnTo>
                  <a:lnTo>
                    <a:pt x="1573" y="892"/>
                  </a:lnTo>
                  <a:lnTo>
                    <a:pt x="1581" y="890"/>
                  </a:lnTo>
                  <a:lnTo>
                    <a:pt x="1586" y="886"/>
                  </a:lnTo>
                  <a:lnTo>
                    <a:pt x="1594" y="884"/>
                  </a:lnTo>
                  <a:lnTo>
                    <a:pt x="1602" y="882"/>
                  </a:lnTo>
                  <a:lnTo>
                    <a:pt x="1607" y="878"/>
                  </a:lnTo>
                  <a:lnTo>
                    <a:pt x="1615" y="877"/>
                  </a:lnTo>
                  <a:lnTo>
                    <a:pt x="1621" y="875"/>
                  </a:lnTo>
                  <a:lnTo>
                    <a:pt x="1629" y="873"/>
                  </a:lnTo>
                  <a:lnTo>
                    <a:pt x="1636" y="871"/>
                  </a:lnTo>
                  <a:lnTo>
                    <a:pt x="1642" y="869"/>
                  </a:lnTo>
                  <a:lnTo>
                    <a:pt x="1650" y="867"/>
                  </a:lnTo>
                  <a:lnTo>
                    <a:pt x="1655" y="865"/>
                  </a:lnTo>
                  <a:lnTo>
                    <a:pt x="1663" y="865"/>
                  </a:lnTo>
                  <a:lnTo>
                    <a:pt x="1671" y="865"/>
                  </a:lnTo>
                  <a:lnTo>
                    <a:pt x="1677" y="863"/>
                  </a:lnTo>
                  <a:lnTo>
                    <a:pt x="1684" y="863"/>
                  </a:lnTo>
                  <a:lnTo>
                    <a:pt x="1690" y="861"/>
                  </a:lnTo>
                  <a:lnTo>
                    <a:pt x="1698" y="859"/>
                  </a:lnTo>
                  <a:lnTo>
                    <a:pt x="1703" y="857"/>
                  </a:lnTo>
                  <a:lnTo>
                    <a:pt x="1711" y="855"/>
                  </a:lnTo>
                  <a:lnTo>
                    <a:pt x="1719" y="855"/>
                  </a:lnTo>
                  <a:lnTo>
                    <a:pt x="1725" y="854"/>
                  </a:lnTo>
                  <a:lnTo>
                    <a:pt x="1732" y="852"/>
                  </a:lnTo>
                  <a:lnTo>
                    <a:pt x="1738" y="850"/>
                  </a:lnTo>
                  <a:lnTo>
                    <a:pt x="1746" y="850"/>
                  </a:lnTo>
                  <a:lnTo>
                    <a:pt x="1753" y="848"/>
                  </a:lnTo>
                  <a:lnTo>
                    <a:pt x="1759" y="846"/>
                  </a:lnTo>
                  <a:lnTo>
                    <a:pt x="1767" y="842"/>
                  </a:lnTo>
                  <a:lnTo>
                    <a:pt x="1773" y="838"/>
                  </a:lnTo>
                  <a:lnTo>
                    <a:pt x="1780" y="829"/>
                  </a:lnTo>
                  <a:lnTo>
                    <a:pt x="1788" y="811"/>
                  </a:lnTo>
                  <a:lnTo>
                    <a:pt x="1794" y="790"/>
                  </a:lnTo>
                  <a:lnTo>
                    <a:pt x="1801" y="761"/>
                  </a:lnTo>
                  <a:lnTo>
                    <a:pt x="1807" y="725"/>
                  </a:lnTo>
                  <a:lnTo>
                    <a:pt x="1815" y="683"/>
                  </a:lnTo>
                  <a:lnTo>
                    <a:pt x="1823" y="640"/>
                  </a:lnTo>
                  <a:lnTo>
                    <a:pt x="1828" y="600"/>
                  </a:lnTo>
                  <a:lnTo>
                    <a:pt x="1836" y="566"/>
                  </a:lnTo>
                  <a:lnTo>
                    <a:pt x="1842" y="541"/>
                  </a:lnTo>
                  <a:lnTo>
                    <a:pt x="1849" y="527"/>
                  </a:lnTo>
                  <a:lnTo>
                    <a:pt x="1855" y="525"/>
                  </a:lnTo>
                  <a:lnTo>
                    <a:pt x="1863" y="533"/>
                  </a:lnTo>
                  <a:lnTo>
                    <a:pt x="1871" y="550"/>
                  </a:lnTo>
                  <a:lnTo>
                    <a:pt x="1876" y="573"/>
                  </a:lnTo>
                  <a:lnTo>
                    <a:pt x="1884" y="600"/>
                  </a:lnTo>
                  <a:lnTo>
                    <a:pt x="1890" y="631"/>
                  </a:lnTo>
                  <a:lnTo>
                    <a:pt x="1897" y="662"/>
                  </a:lnTo>
                  <a:lnTo>
                    <a:pt x="1905" y="690"/>
                  </a:lnTo>
                  <a:lnTo>
                    <a:pt x="1911" y="713"/>
                  </a:lnTo>
                  <a:lnTo>
                    <a:pt x="1919" y="735"/>
                  </a:lnTo>
                  <a:lnTo>
                    <a:pt x="1924" y="752"/>
                  </a:lnTo>
                  <a:lnTo>
                    <a:pt x="1932" y="765"/>
                  </a:lnTo>
                  <a:lnTo>
                    <a:pt x="1940" y="775"/>
                  </a:lnTo>
                  <a:lnTo>
                    <a:pt x="1945" y="783"/>
                  </a:lnTo>
                  <a:lnTo>
                    <a:pt x="1953" y="786"/>
                  </a:lnTo>
                  <a:lnTo>
                    <a:pt x="1959" y="788"/>
                  </a:lnTo>
                  <a:lnTo>
                    <a:pt x="1967" y="788"/>
                  </a:lnTo>
                  <a:lnTo>
                    <a:pt x="1972" y="788"/>
                  </a:lnTo>
                  <a:lnTo>
                    <a:pt x="1980" y="788"/>
                  </a:lnTo>
                  <a:lnTo>
                    <a:pt x="1988" y="788"/>
                  </a:lnTo>
                  <a:lnTo>
                    <a:pt x="1993" y="788"/>
                  </a:lnTo>
                  <a:lnTo>
                    <a:pt x="2001" y="788"/>
                  </a:lnTo>
                  <a:lnTo>
                    <a:pt x="2007" y="788"/>
                  </a:lnTo>
                  <a:lnTo>
                    <a:pt x="2015" y="790"/>
                  </a:lnTo>
                  <a:lnTo>
                    <a:pt x="2022" y="794"/>
                  </a:lnTo>
                  <a:lnTo>
                    <a:pt x="2028" y="796"/>
                  </a:lnTo>
                  <a:lnTo>
                    <a:pt x="2036" y="798"/>
                  </a:lnTo>
                  <a:lnTo>
                    <a:pt x="2041" y="800"/>
                  </a:lnTo>
                  <a:lnTo>
                    <a:pt x="2049" y="802"/>
                  </a:lnTo>
                  <a:lnTo>
                    <a:pt x="2057" y="804"/>
                  </a:lnTo>
                  <a:lnTo>
                    <a:pt x="2063" y="806"/>
                  </a:lnTo>
                  <a:lnTo>
                    <a:pt x="2070" y="806"/>
                  </a:lnTo>
                  <a:lnTo>
                    <a:pt x="2076" y="807"/>
                  </a:lnTo>
                  <a:lnTo>
                    <a:pt x="2084" y="807"/>
                  </a:lnTo>
                  <a:lnTo>
                    <a:pt x="2089" y="806"/>
                  </a:lnTo>
                  <a:lnTo>
                    <a:pt x="2097" y="804"/>
                  </a:lnTo>
                  <a:lnTo>
                    <a:pt x="2105" y="804"/>
                  </a:lnTo>
                  <a:lnTo>
                    <a:pt x="2111" y="800"/>
                  </a:lnTo>
                  <a:lnTo>
                    <a:pt x="2118" y="798"/>
                  </a:lnTo>
                  <a:lnTo>
                    <a:pt x="2124" y="794"/>
                  </a:lnTo>
                  <a:lnTo>
                    <a:pt x="2132" y="792"/>
                  </a:lnTo>
                  <a:lnTo>
                    <a:pt x="2139" y="788"/>
                  </a:lnTo>
                  <a:lnTo>
                    <a:pt x="2145" y="788"/>
                  </a:lnTo>
                  <a:lnTo>
                    <a:pt x="2153" y="788"/>
                  </a:lnTo>
                  <a:lnTo>
                    <a:pt x="2159" y="788"/>
                  </a:lnTo>
                  <a:lnTo>
                    <a:pt x="2166" y="788"/>
                  </a:lnTo>
                  <a:lnTo>
                    <a:pt x="2174" y="786"/>
                  </a:lnTo>
                  <a:lnTo>
                    <a:pt x="2180" y="783"/>
                  </a:lnTo>
                  <a:lnTo>
                    <a:pt x="2187" y="779"/>
                  </a:lnTo>
                  <a:lnTo>
                    <a:pt x="2193" y="771"/>
                  </a:lnTo>
                  <a:lnTo>
                    <a:pt x="2201" y="763"/>
                  </a:lnTo>
                  <a:lnTo>
                    <a:pt x="2208" y="758"/>
                  </a:lnTo>
                  <a:lnTo>
                    <a:pt x="2214" y="756"/>
                  </a:lnTo>
                  <a:lnTo>
                    <a:pt x="2222" y="758"/>
                  </a:lnTo>
                  <a:lnTo>
                    <a:pt x="2228" y="763"/>
                  </a:lnTo>
                  <a:lnTo>
                    <a:pt x="2235" y="769"/>
                  </a:lnTo>
                  <a:lnTo>
                    <a:pt x="2241" y="775"/>
                  </a:lnTo>
                  <a:lnTo>
                    <a:pt x="2249" y="779"/>
                  </a:lnTo>
                  <a:lnTo>
                    <a:pt x="2256" y="783"/>
                  </a:lnTo>
                  <a:lnTo>
                    <a:pt x="2262" y="784"/>
                  </a:lnTo>
                  <a:lnTo>
                    <a:pt x="2270" y="784"/>
                  </a:lnTo>
                  <a:lnTo>
                    <a:pt x="2276" y="783"/>
                  </a:lnTo>
                  <a:lnTo>
                    <a:pt x="2283" y="781"/>
                  </a:lnTo>
                  <a:lnTo>
                    <a:pt x="2291" y="775"/>
                  </a:lnTo>
                  <a:lnTo>
                    <a:pt x="2297" y="771"/>
                  </a:lnTo>
                  <a:lnTo>
                    <a:pt x="2304" y="765"/>
                  </a:lnTo>
                  <a:lnTo>
                    <a:pt x="2310" y="761"/>
                  </a:lnTo>
                  <a:lnTo>
                    <a:pt x="2318" y="759"/>
                  </a:lnTo>
                  <a:lnTo>
                    <a:pt x="2326" y="759"/>
                  </a:lnTo>
                  <a:lnTo>
                    <a:pt x="2331" y="759"/>
                  </a:lnTo>
                  <a:lnTo>
                    <a:pt x="2339" y="763"/>
                  </a:lnTo>
                  <a:lnTo>
                    <a:pt x="2345" y="767"/>
                  </a:lnTo>
                  <a:lnTo>
                    <a:pt x="2352" y="771"/>
                  </a:lnTo>
                  <a:lnTo>
                    <a:pt x="2358" y="775"/>
                  </a:lnTo>
                  <a:lnTo>
                    <a:pt x="2366" y="779"/>
                  </a:lnTo>
                  <a:lnTo>
                    <a:pt x="2374" y="783"/>
                  </a:lnTo>
                  <a:lnTo>
                    <a:pt x="2379" y="786"/>
                  </a:lnTo>
                  <a:lnTo>
                    <a:pt x="2387" y="788"/>
                  </a:lnTo>
                  <a:lnTo>
                    <a:pt x="2393" y="790"/>
                  </a:lnTo>
                  <a:lnTo>
                    <a:pt x="2400" y="790"/>
                  </a:lnTo>
                  <a:lnTo>
                    <a:pt x="2408" y="792"/>
                  </a:lnTo>
                  <a:lnTo>
                    <a:pt x="2414" y="792"/>
                  </a:lnTo>
                  <a:lnTo>
                    <a:pt x="2422" y="790"/>
                  </a:lnTo>
                  <a:lnTo>
                    <a:pt x="2427" y="784"/>
                  </a:lnTo>
                  <a:lnTo>
                    <a:pt x="2435" y="777"/>
                  </a:lnTo>
                  <a:lnTo>
                    <a:pt x="2443" y="761"/>
                  </a:lnTo>
                  <a:lnTo>
                    <a:pt x="2448" y="742"/>
                  </a:lnTo>
                  <a:lnTo>
                    <a:pt x="2456" y="723"/>
                  </a:lnTo>
                  <a:lnTo>
                    <a:pt x="2462" y="706"/>
                  </a:lnTo>
                  <a:lnTo>
                    <a:pt x="2470" y="694"/>
                  </a:lnTo>
                  <a:lnTo>
                    <a:pt x="2477" y="692"/>
                  </a:lnTo>
                  <a:lnTo>
                    <a:pt x="2483" y="698"/>
                  </a:lnTo>
                  <a:lnTo>
                    <a:pt x="2491" y="708"/>
                  </a:lnTo>
                  <a:lnTo>
                    <a:pt x="2496" y="717"/>
                  </a:lnTo>
                  <a:lnTo>
                    <a:pt x="2504" y="727"/>
                  </a:lnTo>
                  <a:lnTo>
                    <a:pt x="2510" y="736"/>
                  </a:lnTo>
                  <a:lnTo>
                    <a:pt x="2518" y="744"/>
                  </a:lnTo>
                  <a:lnTo>
                    <a:pt x="2525" y="750"/>
                  </a:lnTo>
                  <a:lnTo>
                    <a:pt x="2531" y="758"/>
                  </a:lnTo>
                  <a:lnTo>
                    <a:pt x="2539" y="763"/>
                  </a:lnTo>
                  <a:lnTo>
                    <a:pt x="2544" y="769"/>
                  </a:lnTo>
                  <a:lnTo>
                    <a:pt x="2552" y="775"/>
                  </a:lnTo>
                  <a:lnTo>
                    <a:pt x="2560" y="779"/>
                  </a:lnTo>
                  <a:lnTo>
                    <a:pt x="2566" y="781"/>
                  </a:lnTo>
                  <a:lnTo>
                    <a:pt x="2573" y="783"/>
                  </a:lnTo>
                  <a:lnTo>
                    <a:pt x="2579" y="786"/>
                  </a:lnTo>
                  <a:lnTo>
                    <a:pt x="2587" y="786"/>
                  </a:lnTo>
                  <a:lnTo>
                    <a:pt x="2594" y="788"/>
                  </a:lnTo>
                  <a:lnTo>
                    <a:pt x="2600" y="790"/>
                  </a:lnTo>
                  <a:lnTo>
                    <a:pt x="2608" y="790"/>
                  </a:lnTo>
                  <a:lnTo>
                    <a:pt x="2614" y="792"/>
                  </a:lnTo>
                  <a:lnTo>
                    <a:pt x="2621" y="792"/>
                  </a:lnTo>
                  <a:lnTo>
                    <a:pt x="2627" y="794"/>
                  </a:lnTo>
                  <a:lnTo>
                    <a:pt x="2635" y="794"/>
                  </a:lnTo>
                  <a:lnTo>
                    <a:pt x="2642" y="794"/>
                  </a:lnTo>
                  <a:lnTo>
                    <a:pt x="2648" y="794"/>
                  </a:lnTo>
                  <a:lnTo>
                    <a:pt x="2656" y="796"/>
                  </a:lnTo>
                  <a:lnTo>
                    <a:pt x="2662" y="796"/>
                  </a:lnTo>
                  <a:lnTo>
                    <a:pt x="2669" y="796"/>
                  </a:lnTo>
                  <a:lnTo>
                    <a:pt x="2677" y="796"/>
                  </a:lnTo>
                  <a:lnTo>
                    <a:pt x="2683" y="796"/>
                  </a:lnTo>
                  <a:lnTo>
                    <a:pt x="2690" y="796"/>
                  </a:lnTo>
                  <a:lnTo>
                    <a:pt x="2696" y="796"/>
                  </a:lnTo>
                  <a:lnTo>
                    <a:pt x="2704" y="796"/>
                  </a:lnTo>
                  <a:lnTo>
                    <a:pt x="2712" y="796"/>
                  </a:lnTo>
                  <a:lnTo>
                    <a:pt x="2717" y="796"/>
                  </a:lnTo>
                  <a:lnTo>
                    <a:pt x="2725" y="796"/>
                  </a:lnTo>
                  <a:lnTo>
                    <a:pt x="2731" y="796"/>
                  </a:lnTo>
                  <a:lnTo>
                    <a:pt x="2738" y="796"/>
                  </a:lnTo>
                  <a:lnTo>
                    <a:pt x="2744" y="796"/>
                  </a:lnTo>
                  <a:lnTo>
                    <a:pt x="2752" y="796"/>
                  </a:lnTo>
                  <a:lnTo>
                    <a:pt x="2760" y="796"/>
                  </a:lnTo>
                  <a:lnTo>
                    <a:pt x="2765" y="794"/>
                  </a:lnTo>
                  <a:lnTo>
                    <a:pt x="2773" y="794"/>
                  </a:lnTo>
                  <a:lnTo>
                    <a:pt x="2779" y="794"/>
                  </a:lnTo>
                  <a:lnTo>
                    <a:pt x="2786" y="792"/>
                  </a:lnTo>
                  <a:lnTo>
                    <a:pt x="2794" y="792"/>
                  </a:lnTo>
                  <a:lnTo>
                    <a:pt x="2800" y="792"/>
                  </a:lnTo>
                  <a:lnTo>
                    <a:pt x="2808" y="792"/>
                  </a:lnTo>
                  <a:lnTo>
                    <a:pt x="2813" y="792"/>
                  </a:lnTo>
                  <a:lnTo>
                    <a:pt x="2821" y="792"/>
                  </a:lnTo>
                  <a:lnTo>
                    <a:pt x="2829" y="790"/>
                  </a:lnTo>
                  <a:lnTo>
                    <a:pt x="2834" y="790"/>
                  </a:lnTo>
                  <a:lnTo>
                    <a:pt x="2842" y="788"/>
                  </a:lnTo>
                  <a:lnTo>
                    <a:pt x="2848" y="788"/>
                  </a:lnTo>
                  <a:lnTo>
                    <a:pt x="2856" y="786"/>
                  </a:lnTo>
                  <a:lnTo>
                    <a:pt x="2863" y="786"/>
                  </a:lnTo>
                  <a:lnTo>
                    <a:pt x="2869" y="786"/>
                  </a:lnTo>
                  <a:lnTo>
                    <a:pt x="2877" y="786"/>
                  </a:lnTo>
                  <a:lnTo>
                    <a:pt x="2882" y="786"/>
                  </a:lnTo>
                  <a:lnTo>
                    <a:pt x="2890" y="786"/>
                  </a:lnTo>
                  <a:lnTo>
                    <a:pt x="2896" y="786"/>
                  </a:lnTo>
                  <a:lnTo>
                    <a:pt x="2904" y="786"/>
                  </a:lnTo>
                  <a:lnTo>
                    <a:pt x="2911" y="786"/>
                  </a:lnTo>
                  <a:lnTo>
                    <a:pt x="2917" y="786"/>
                  </a:lnTo>
                  <a:lnTo>
                    <a:pt x="2925" y="786"/>
                  </a:lnTo>
                  <a:lnTo>
                    <a:pt x="2930" y="786"/>
                  </a:lnTo>
                  <a:lnTo>
                    <a:pt x="2938" y="786"/>
                  </a:lnTo>
                  <a:lnTo>
                    <a:pt x="2946" y="786"/>
                  </a:lnTo>
                  <a:lnTo>
                    <a:pt x="2952" y="786"/>
                  </a:lnTo>
                  <a:lnTo>
                    <a:pt x="2959" y="786"/>
                  </a:lnTo>
                  <a:lnTo>
                    <a:pt x="2965" y="786"/>
                  </a:lnTo>
                  <a:lnTo>
                    <a:pt x="2973" y="786"/>
                  </a:lnTo>
                  <a:lnTo>
                    <a:pt x="2980" y="786"/>
                  </a:lnTo>
                  <a:lnTo>
                    <a:pt x="2986" y="786"/>
                  </a:lnTo>
                  <a:lnTo>
                    <a:pt x="2994" y="784"/>
                  </a:lnTo>
                  <a:lnTo>
                    <a:pt x="3000" y="783"/>
                  </a:lnTo>
                  <a:lnTo>
                    <a:pt x="3007" y="779"/>
                  </a:lnTo>
                  <a:lnTo>
                    <a:pt x="3013" y="775"/>
                  </a:lnTo>
                  <a:lnTo>
                    <a:pt x="3021" y="773"/>
                  </a:lnTo>
                  <a:lnTo>
                    <a:pt x="3028" y="769"/>
                  </a:lnTo>
                  <a:lnTo>
                    <a:pt x="3034" y="769"/>
                  </a:lnTo>
                  <a:lnTo>
                    <a:pt x="3042" y="769"/>
                  </a:lnTo>
                  <a:lnTo>
                    <a:pt x="3048" y="769"/>
                  </a:lnTo>
                  <a:lnTo>
                    <a:pt x="3055" y="771"/>
                  </a:lnTo>
                  <a:lnTo>
                    <a:pt x="3063" y="771"/>
                  </a:lnTo>
                  <a:lnTo>
                    <a:pt x="3069" y="773"/>
                  </a:lnTo>
                  <a:lnTo>
                    <a:pt x="3076" y="773"/>
                  </a:lnTo>
                  <a:lnTo>
                    <a:pt x="3082" y="775"/>
                  </a:lnTo>
                  <a:lnTo>
                    <a:pt x="3090" y="775"/>
                  </a:lnTo>
                  <a:lnTo>
                    <a:pt x="3097" y="775"/>
                  </a:lnTo>
                  <a:lnTo>
                    <a:pt x="3103" y="775"/>
                  </a:lnTo>
                  <a:lnTo>
                    <a:pt x="3111" y="773"/>
                  </a:lnTo>
                  <a:lnTo>
                    <a:pt x="3117" y="771"/>
                  </a:lnTo>
                  <a:lnTo>
                    <a:pt x="3124" y="767"/>
                  </a:lnTo>
                  <a:lnTo>
                    <a:pt x="3132" y="761"/>
                  </a:lnTo>
                  <a:lnTo>
                    <a:pt x="3138" y="754"/>
                  </a:lnTo>
                  <a:lnTo>
                    <a:pt x="3145" y="746"/>
                  </a:lnTo>
                  <a:lnTo>
                    <a:pt x="3151" y="738"/>
                  </a:lnTo>
                  <a:lnTo>
                    <a:pt x="3159" y="735"/>
                  </a:lnTo>
                  <a:lnTo>
                    <a:pt x="3165" y="733"/>
                  </a:lnTo>
                  <a:lnTo>
                    <a:pt x="3172" y="735"/>
                  </a:lnTo>
                  <a:lnTo>
                    <a:pt x="3180" y="738"/>
                  </a:lnTo>
                  <a:lnTo>
                    <a:pt x="3186" y="742"/>
                  </a:lnTo>
                  <a:lnTo>
                    <a:pt x="3193" y="748"/>
                  </a:lnTo>
                  <a:lnTo>
                    <a:pt x="3199" y="750"/>
                  </a:lnTo>
                  <a:lnTo>
                    <a:pt x="3207" y="754"/>
                  </a:lnTo>
                  <a:lnTo>
                    <a:pt x="3215" y="754"/>
                  </a:lnTo>
                  <a:lnTo>
                    <a:pt x="3220" y="756"/>
                  </a:lnTo>
                  <a:lnTo>
                    <a:pt x="3228" y="756"/>
                  </a:lnTo>
                  <a:lnTo>
                    <a:pt x="3234" y="756"/>
                  </a:lnTo>
                  <a:lnTo>
                    <a:pt x="3241" y="758"/>
                  </a:lnTo>
                  <a:lnTo>
                    <a:pt x="3249" y="759"/>
                  </a:lnTo>
                  <a:lnTo>
                    <a:pt x="3255" y="761"/>
                  </a:lnTo>
                  <a:lnTo>
                    <a:pt x="3263" y="763"/>
                  </a:lnTo>
                  <a:lnTo>
                    <a:pt x="3268" y="765"/>
                  </a:lnTo>
                  <a:lnTo>
                    <a:pt x="3276" y="767"/>
                  </a:lnTo>
                  <a:lnTo>
                    <a:pt x="3282" y="769"/>
                  </a:lnTo>
                  <a:lnTo>
                    <a:pt x="3289" y="769"/>
                  </a:lnTo>
                  <a:lnTo>
                    <a:pt x="3297" y="771"/>
                  </a:lnTo>
                  <a:lnTo>
                    <a:pt x="3303" y="771"/>
                  </a:lnTo>
                  <a:lnTo>
                    <a:pt x="3311" y="773"/>
                  </a:lnTo>
                  <a:lnTo>
                    <a:pt x="3316" y="773"/>
                  </a:lnTo>
                  <a:lnTo>
                    <a:pt x="3324" y="773"/>
                  </a:lnTo>
                  <a:lnTo>
                    <a:pt x="3332" y="773"/>
                  </a:lnTo>
                  <a:lnTo>
                    <a:pt x="3337" y="775"/>
                  </a:lnTo>
                  <a:lnTo>
                    <a:pt x="3345" y="775"/>
                  </a:lnTo>
                  <a:lnTo>
                    <a:pt x="3351" y="775"/>
                  </a:lnTo>
                  <a:lnTo>
                    <a:pt x="3359" y="775"/>
                  </a:lnTo>
                  <a:lnTo>
                    <a:pt x="3366" y="775"/>
                  </a:lnTo>
                  <a:lnTo>
                    <a:pt x="3372" y="775"/>
                  </a:lnTo>
                  <a:lnTo>
                    <a:pt x="3380" y="775"/>
                  </a:lnTo>
                  <a:lnTo>
                    <a:pt x="3385" y="775"/>
                  </a:lnTo>
                  <a:lnTo>
                    <a:pt x="3393" y="775"/>
                  </a:lnTo>
                  <a:lnTo>
                    <a:pt x="3399" y="775"/>
                  </a:lnTo>
                  <a:lnTo>
                    <a:pt x="3407" y="773"/>
                  </a:lnTo>
                  <a:lnTo>
                    <a:pt x="3414" y="773"/>
                  </a:lnTo>
                  <a:lnTo>
                    <a:pt x="3420" y="773"/>
                  </a:lnTo>
                  <a:lnTo>
                    <a:pt x="3428" y="773"/>
                  </a:lnTo>
                  <a:lnTo>
                    <a:pt x="3433" y="773"/>
                  </a:lnTo>
                  <a:lnTo>
                    <a:pt x="3441" y="771"/>
                  </a:lnTo>
                  <a:lnTo>
                    <a:pt x="3449" y="771"/>
                  </a:lnTo>
                  <a:lnTo>
                    <a:pt x="3455" y="769"/>
                  </a:lnTo>
                  <a:lnTo>
                    <a:pt x="3462" y="769"/>
                  </a:lnTo>
                  <a:lnTo>
                    <a:pt x="3468" y="769"/>
                  </a:lnTo>
                  <a:lnTo>
                    <a:pt x="3476" y="767"/>
                  </a:lnTo>
                  <a:lnTo>
                    <a:pt x="3483" y="767"/>
                  </a:lnTo>
                  <a:lnTo>
                    <a:pt x="3489" y="767"/>
                  </a:lnTo>
                  <a:lnTo>
                    <a:pt x="3497" y="765"/>
                  </a:lnTo>
                  <a:lnTo>
                    <a:pt x="3503" y="765"/>
                  </a:lnTo>
                  <a:lnTo>
                    <a:pt x="3510" y="763"/>
                  </a:lnTo>
                  <a:lnTo>
                    <a:pt x="3518" y="763"/>
                  </a:lnTo>
                  <a:lnTo>
                    <a:pt x="3524" y="761"/>
                  </a:lnTo>
                  <a:lnTo>
                    <a:pt x="3531" y="761"/>
                  </a:lnTo>
                  <a:lnTo>
                    <a:pt x="3537" y="759"/>
                  </a:lnTo>
                  <a:lnTo>
                    <a:pt x="3545" y="758"/>
                  </a:lnTo>
                  <a:lnTo>
                    <a:pt x="3551" y="758"/>
                  </a:lnTo>
                  <a:lnTo>
                    <a:pt x="3558" y="756"/>
                  </a:lnTo>
                  <a:lnTo>
                    <a:pt x="3566" y="754"/>
                  </a:lnTo>
                  <a:lnTo>
                    <a:pt x="3572" y="752"/>
                  </a:lnTo>
                  <a:lnTo>
                    <a:pt x="3579" y="752"/>
                  </a:lnTo>
                  <a:lnTo>
                    <a:pt x="3585" y="750"/>
                  </a:lnTo>
                  <a:lnTo>
                    <a:pt x="3593" y="750"/>
                  </a:lnTo>
                  <a:lnTo>
                    <a:pt x="3601" y="750"/>
                  </a:lnTo>
                  <a:lnTo>
                    <a:pt x="3606" y="750"/>
                  </a:lnTo>
                  <a:lnTo>
                    <a:pt x="3614" y="750"/>
                  </a:lnTo>
                  <a:lnTo>
                    <a:pt x="3620" y="750"/>
                  </a:lnTo>
                  <a:lnTo>
                    <a:pt x="3627" y="752"/>
                  </a:lnTo>
                  <a:lnTo>
                    <a:pt x="3635" y="752"/>
                  </a:lnTo>
                  <a:lnTo>
                    <a:pt x="3641" y="752"/>
                  </a:lnTo>
                  <a:lnTo>
                    <a:pt x="3649" y="754"/>
                  </a:lnTo>
                  <a:lnTo>
                    <a:pt x="3654" y="754"/>
                  </a:lnTo>
                  <a:lnTo>
                    <a:pt x="3662" y="754"/>
                  </a:lnTo>
                  <a:lnTo>
                    <a:pt x="3668" y="756"/>
                  </a:lnTo>
                  <a:lnTo>
                    <a:pt x="3675" y="756"/>
                  </a:lnTo>
                  <a:lnTo>
                    <a:pt x="3683" y="756"/>
                  </a:lnTo>
                  <a:lnTo>
                    <a:pt x="3689" y="756"/>
                  </a:lnTo>
                  <a:lnTo>
                    <a:pt x="3697" y="756"/>
                  </a:lnTo>
                  <a:lnTo>
                    <a:pt x="3702" y="756"/>
                  </a:lnTo>
                  <a:lnTo>
                    <a:pt x="3710" y="754"/>
                  </a:lnTo>
                  <a:lnTo>
                    <a:pt x="3718" y="754"/>
                  </a:lnTo>
                  <a:lnTo>
                    <a:pt x="3723" y="754"/>
                  </a:lnTo>
                  <a:lnTo>
                    <a:pt x="3731" y="752"/>
                  </a:lnTo>
                  <a:lnTo>
                    <a:pt x="3737" y="752"/>
                  </a:lnTo>
                  <a:lnTo>
                    <a:pt x="3745" y="752"/>
                  </a:lnTo>
                  <a:lnTo>
                    <a:pt x="3752" y="750"/>
                  </a:lnTo>
                  <a:lnTo>
                    <a:pt x="3758" y="748"/>
                  </a:lnTo>
                  <a:lnTo>
                    <a:pt x="3766" y="744"/>
                  </a:lnTo>
                  <a:lnTo>
                    <a:pt x="3771" y="740"/>
                  </a:lnTo>
                  <a:lnTo>
                    <a:pt x="3779" y="731"/>
                  </a:lnTo>
                  <a:lnTo>
                    <a:pt x="3785" y="715"/>
                  </a:lnTo>
                  <a:lnTo>
                    <a:pt x="3793" y="696"/>
                  </a:lnTo>
                  <a:lnTo>
                    <a:pt x="3800" y="671"/>
                  </a:lnTo>
                  <a:lnTo>
                    <a:pt x="3806" y="640"/>
                  </a:lnTo>
                  <a:lnTo>
                    <a:pt x="3814" y="610"/>
                  </a:lnTo>
                  <a:lnTo>
                    <a:pt x="3819" y="583"/>
                  </a:lnTo>
                  <a:lnTo>
                    <a:pt x="3827" y="560"/>
                  </a:lnTo>
                  <a:lnTo>
                    <a:pt x="3835" y="546"/>
                  </a:lnTo>
                  <a:lnTo>
                    <a:pt x="3841" y="545"/>
                  </a:lnTo>
                  <a:lnTo>
                    <a:pt x="3848" y="550"/>
                  </a:lnTo>
                  <a:lnTo>
                    <a:pt x="3854" y="564"/>
                  </a:lnTo>
                  <a:lnTo>
                    <a:pt x="3862" y="579"/>
                  </a:lnTo>
                  <a:lnTo>
                    <a:pt x="3869" y="596"/>
                  </a:lnTo>
                  <a:lnTo>
                    <a:pt x="3875" y="612"/>
                  </a:lnTo>
                  <a:lnTo>
                    <a:pt x="3883" y="625"/>
                  </a:lnTo>
                  <a:lnTo>
                    <a:pt x="3889" y="637"/>
                  </a:lnTo>
                  <a:lnTo>
                    <a:pt x="3896" y="650"/>
                  </a:lnTo>
                  <a:lnTo>
                    <a:pt x="3904" y="662"/>
                  </a:lnTo>
                  <a:lnTo>
                    <a:pt x="3910" y="673"/>
                  </a:lnTo>
                  <a:lnTo>
                    <a:pt x="3917" y="685"/>
                  </a:lnTo>
                  <a:lnTo>
                    <a:pt x="3923" y="694"/>
                  </a:lnTo>
                  <a:lnTo>
                    <a:pt x="3931" y="704"/>
                  </a:lnTo>
                  <a:lnTo>
                    <a:pt x="3937" y="711"/>
                  </a:lnTo>
                  <a:lnTo>
                    <a:pt x="3944" y="717"/>
                  </a:lnTo>
                  <a:lnTo>
                    <a:pt x="3952" y="721"/>
                  </a:lnTo>
                  <a:lnTo>
                    <a:pt x="3958" y="725"/>
                  </a:lnTo>
                  <a:lnTo>
                    <a:pt x="3965" y="729"/>
                  </a:lnTo>
                  <a:lnTo>
                    <a:pt x="3971" y="733"/>
                  </a:lnTo>
                  <a:lnTo>
                    <a:pt x="3979" y="735"/>
                  </a:lnTo>
                  <a:lnTo>
                    <a:pt x="3986" y="735"/>
                  </a:lnTo>
                  <a:lnTo>
                    <a:pt x="3992" y="736"/>
                  </a:lnTo>
                  <a:lnTo>
                    <a:pt x="4000" y="736"/>
                  </a:lnTo>
                  <a:lnTo>
                    <a:pt x="4006" y="736"/>
                  </a:lnTo>
                  <a:lnTo>
                    <a:pt x="4013" y="736"/>
                  </a:lnTo>
                  <a:lnTo>
                    <a:pt x="4021" y="735"/>
                  </a:lnTo>
                  <a:lnTo>
                    <a:pt x="4027" y="733"/>
                  </a:lnTo>
                  <a:lnTo>
                    <a:pt x="4034" y="729"/>
                  </a:lnTo>
                  <a:lnTo>
                    <a:pt x="4040" y="727"/>
                  </a:lnTo>
                  <a:lnTo>
                    <a:pt x="4048" y="723"/>
                  </a:lnTo>
                  <a:lnTo>
                    <a:pt x="4054" y="719"/>
                  </a:lnTo>
                  <a:lnTo>
                    <a:pt x="4061" y="715"/>
                  </a:lnTo>
                  <a:lnTo>
                    <a:pt x="4069" y="711"/>
                  </a:lnTo>
                  <a:lnTo>
                    <a:pt x="4075" y="710"/>
                  </a:lnTo>
                  <a:lnTo>
                    <a:pt x="4082" y="704"/>
                  </a:lnTo>
                  <a:lnTo>
                    <a:pt x="4088" y="696"/>
                  </a:lnTo>
                  <a:lnTo>
                    <a:pt x="4096" y="683"/>
                  </a:lnTo>
                  <a:lnTo>
                    <a:pt x="4104" y="664"/>
                  </a:lnTo>
                  <a:lnTo>
                    <a:pt x="4109" y="635"/>
                  </a:lnTo>
                  <a:lnTo>
                    <a:pt x="4117" y="598"/>
                  </a:lnTo>
                  <a:lnTo>
                    <a:pt x="4123" y="562"/>
                  </a:lnTo>
                  <a:lnTo>
                    <a:pt x="4130" y="531"/>
                  </a:lnTo>
                  <a:lnTo>
                    <a:pt x="4138" y="514"/>
                  </a:lnTo>
                  <a:lnTo>
                    <a:pt x="4144" y="512"/>
                  </a:lnTo>
                  <a:lnTo>
                    <a:pt x="4152" y="525"/>
                  </a:lnTo>
                  <a:lnTo>
                    <a:pt x="4157" y="545"/>
                  </a:lnTo>
                  <a:lnTo>
                    <a:pt x="4165" y="569"/>
                  </a:lnTo>
                  <a:lnTo>
                    <a:pt x="4173" y="591"/>
                  </a:lnTo>
                  <a:lnTo>
                    <a:pt x="4178" y="612"/>
                  </a:lnTo>
                  <a:lnTo>
                    <a:pt x="4186" y="629"/>
                  </a:lnTo>
                  <a:lnTo>
                    <a:pt x="4192" y="642"/>
                  </a:lnTo>
                  <a:lnTo>
                    <a:pt x="4200" y="654"/>
                  </a:lnTo>
                  <a:lnTo>
                    <a:pt x="4205" y="662"/>
                  </a:lnTo>
                  <a:lnTo>
                    <a:pt x="4213" y="669"/>
                  </a:lnTo>
                  <a:lnTo>
                    <a:pt x="4221" y="677"/>
                  </a:lnTo>
                  <a:lnTo>
                    <a:pt x="4226" y="681"/>
                  </a:lnTo>
                  <a:lnTo>
                    <a:pt x="4234" y="685"/>
                  </a:lnTo>
                  <a:lnTo>
                    <a:pt x="4240" y="688"/>
                  </a:lnTo>
                  <a:lnTo>
                    <a:pt x="4248" y="690"/>
                  </a:lnTo>
                  <a:lnTo>
                    <a:pt x="4255" y="690"/>
                  </a:lnTo>
                  <a:lnTo>
                    <a:pt x="4261" y="690"/>
                  </a:lnTo>
                  <a:lnTo>
                    <a:pt x="4269" y="687"/>
                  </a:lnTo>
                  <a:lnTo>
                    <a:pt x="4275" y="681"/>
                  </a:lnTo>
                  <a:lnTo>
                    <a:pt x="4282" y="671"/>
                  </a:lnTo>
                  <a:lnTo>
                    <a:pt x="4290" y="658"/>
                  </a:lnTo>
                  <a:lnTo>
                    <a:pt x="4296" y="640"/>
                  </a:lnTo>
                  <a:lnTo>
                    <a:pt x="4303" y="617"/>
                  </a:lnTo>
                  <a:lnTo>
                    <a:pt x="4309" y="591"/>
                  </a:lnTo>
                  <a:lnTo>
                    <a:pt x="4317" y="562"/>
                  </a:lnTo>
                  <a:lnTo>
                    <a:pt x="4323" y="535"/>
                  </a:lnTo>
                  <a:lnTo>
                    <a:pt x="4330" y="508"/>
                  </a:lnTo>
                  <a:lnTo>
                    <a:pt x="4338" y="487"/>
                  </a:lnTo>
                  <a:lnTo>
                    <a:pt x="4344" y="472"/>
                  </a:lnTo>
                  <a:lnTo>
                    <a:pt x="4351" y="458"/>
                  </a:lnTo>
                  <a:lnTo>
                    <a:pt x="4357" y="451"/>
                  </a:lnTo>
                  <a:lnTo>
                    <a:pt x="4365" y="447"/>
                  </a:lnTo>
                  <a:lnTo>
                    <a:pt x="4372" y="449"/>
                  </a:lnTo>
                  <a:lnTo>
                    <a:pt x="4378" y="454"/>
                  </a:lnTo>
                  <a:lnTo>
                    <a:pt x="4386" y="462"/>
                  </a:lnTo>
                  <a:lnTo>
                    <a:pt x="4392" y="470"/>
                  </a:lnTo>
                  <a:lnTo>
                    <a:pt x="4399" y="474"/>
                  </a:lnTo>
                  <a:lnTo>
                    <a:pt x="4407" y="468"/>
                  </a:lnTo>
                  <a:lnTo>
                    <a:pt x="4413" y="445"/>
                  </a:lnTo>
                  <a:lnTo>
                    <a:pt x="4420" y="404"/>
                  </a:lnTo>
                  <a:lnTo>
                    <a:pt x="4426" y="349"/>
                  </a:lnTo>
                  <a:lnTo>
                    <a:pt x="4434" y="291"/>
                  </a:lnTo>
                  <a:lnTo>
                    <a:pt x="4440" y="249"/>
                  </a:lnTo>
                  <a:lnTo>
                    <a:pt x="4447" y="236"/>
                  </a:lnTo>
                  <a:lnTo>
                    <a:pt x="4455" y="253"/>
                  </a:lnTo>
                  <a:lnTo>
                    <a:pt x="4461" y="289"/>
                  </a:lnTo>
                  <a:lnTo>
                    <a:pt x="4468" y="337"/>
                  </a:lnTo>
                  <a:lnTo>
                    <a:pt x="4474" y="383"/>
                  </a:lnTo>
                  <a:lnTo>
                    <a:pt x="4482" y="422"/>
                  </a:lnTo>
                  <a:lnTo>
                    <a:pt x="4490" y="447"/>
                  </a:lnTo>
                  <a:lnTo>
                    <a:pt x="4495" y="464"/>
                  </a:lnTo>
                  <a:lnTo>
                    <a:pt x="4503" y="475"/>
                  </a:lnTo>
                  <a:lnTo>
                    <a:pt x="4509" y="485"/>
                  </a:lnTo>
                  <a:lnTo>
                    <a:pt x="4516" y="497"/>
                  </a:lnTo>
                  <a:lnTo>
                    <a:pt x="4524" y="510"/>
                  </a:lnTo>
                  <a:lnTo>
                    <a:pt x="4530" y="523"/>
                  </a:lnTo>
                  <a:lnTo>
                    <a:pt x="4538" y="531"/>
                  </a:lnTo>
                  <a:lnTo>
                    <a:pt x="4543" y="533"/>
                  </a:lnTo>
                  <a:lnTo>
                    <a:pt x="4551" y="523"/>
                  </a:lnTo>
                  <a:lnTo>
                    <a:pt x="4559" y="510"/>
                  </a:lnTo>
                  <a:lnTo>
                    <a:pt x="4564" y="498"/>
                  </a:lnTo>
                  <a:lnTo>
                    <a:pt x="4572" y="493"/>
                  </a:lnTo>
                  <a:lnTo>
                    <a:pt x="4578" y="495"/>
                  </a:lnTo>
                  <a:lnTo>
                    <a:pt x="4586" y="504"/>
                  </a:lnTo>
                  <a:lnTo>
                    <a:pt x="4591" y="518"/>
                  </a:lnTo>
                  <a:lnTo>
                    <a:pt x="4599" y="529"/>
                  </a:lnTo>
                  <a:lnTo>
                    <a:pt x="4607" y="541"/>
                  </a:lnTo>
                  <a:lnTo>
                    <a:pt x="4612" y="548"/>
                  </a:lnTo>
                  <a:lnTo>
                    <a:pt x="4620" y="552"/>
                  </a:lnTo>
                  <a:lnTo>
                    <a:pt x="4626" y="556"/>
                  </a:lnTo>
                  <a:lnTo>
                    <a:pt x="4634" y="558"/>
                  </a:lnTo>
                  <a:lnTo>
                    <a:pt x="4641" y="560"/>
                  </a:lnTo>
                  <a:lnTo>
                    <a:pt x="4647" y="562"/>
                  </a:lnTo>
                  <a:lnTo>
                    <a:pt x="4655" y="568"/>
                  </a:lnTo>
                  <a:lnTo>
                    <a:pt x="4660" y="575"/>
                  </a:lnTo>
                  <a:lnTo>
                    <a:pt x="4668" y="585"/>
                  </a:lnTo>
                  <a:lnTo>
                    <a:pt x="4676" y="596"/>
                  </a:lnTo>
                  <a:lnTo>
                    <a:pt x="4682" y="606"/>
                  </a:lnTo>
                  <a:lnTo>
                    <a:pt x="4689" y="616"/>
                  </a:lnTo>
                  <a:lnTo>
                    <a:pt x="4695" y="623"/>
                  </a:lnTo>
                  <a:lnTo>
                    <a:pt x="4703" y="629"/>
                  </a:lnTo>
                  <a:lnTo>
                    <a:pt x="4708" y="635"/>
                  </a:lnTo>
                  <a:lnTo>
                    <a:pt x="4716" y="637"/>
                  </a:lnTo>
                  <a:lnTo>
                    <a:pt x="4724" y="639"/>
                  </a:lnTo>
                  <a:lnTo>
                    <a:pt x="4730" y="639"/>
                  </a:lnTo>
                  <a:lnTo>
                    <a:pt x="4737" y="633"/>
                  </a:lnTo>
                  <a:lnTo>
                    <a:pt x="4743" y="623"/>
                  </a:lnTo>
                  <a:lnTo>
                    <a:pt x="4751" y="608"/>
                  </a:lnTo>
                  <a:lnTo>
                    <a:pt x="4758" y="587"/>
                  </a:lnTo>
                  <a:lnTo>
                    <a:pt x="4764" y="564"/>
                  </a:lnTo>
                  <a:lnTo>
                    <a:pt x="4772" y="546"/>
                  </a:lnTo>
                  <a:lnTo>
                    <a:pt x="4778" y="537"/>
                  </a:lnTo>
                  <a:lnTo>
                    <a:pt x="4785" y="535"/>
                  </a:lnTo>
                  <a:lnTo>
                    <a:pt x="4793" y="543"/>
                  </a:lnTo>
                  <a:lnTo>
                    <a:pt x="4799" y="554"/>
                  </a:lnTo>
                  <a:lnTo>
                    <a:pt x="4806" y="569"/>
                  </a:lnTo>
                  <a:lnTo>
                    <a:pt x="4812" y="583"/>
                  </a:lnTo>
                  <a:lnTo>
                    <a:pt x="4820" y="596"/>
                  </a:lnTo>
                  <a:lnTo>
                    <a:pt x="4827" y="608"/>
                  </a:lnTo>
                  <a:lnTo>
                    <a:pt x="4833" y="616"/>
                  </a:lnTo>
                  <a:lnTo>
                    <a:pt x="4841" y="623"/>
                  </a:lnTo>
                  <a:lnTo>
                    <a:pt x="4847" y="629"/>
                  </a:lnTo>
                  <a:lnTo>
                    <a:pt x="4854" y="633"/>
                  </a:lnTo>
                  <a:lnTo>
                    <a:pt x="4860" y="637"/>
                  </a:lnTo>
                  <a:lnTo>
                    <a:pt x="4868" y="639"/>
                  </a:lnTo>
                  <a:lnTo>
                    <a:pt x="4875" y="640"/>
                  </a:lnTo>
                  <a:lnTo>
                    <a:pt x="4881" y="639"/>
                  </a:lnTo>
                  <a:lnTo>
                    <a:pt x="4889" y="637"/>
                  </a:lnTo>
                  <a:lnTo>
                    <a:pt x="4895" y="633"/>
                  </a:lnTo>
                  <a:lnTo>
                    <a:pt x="4902" y="627"/>
                  </a:lnTo>
                  <a:lnTo>
                    <a:pt x="4910" y="619"/>
                  </a:lnTo>
                  <a:lnTo>
                    <a:pt x="4916" y="614"/>
                  </a:lnTo>
                  <a:lnTo>
                    <a:pt x="4924" y="610"/>
                  </a:lnTo>
                  <a:lnTo>
                    <a:pt x="4929" y="610"/>
                  </a:lnTo>
                  <a:lnTo>
                    <a:pt x="4937" y="610"/>
                  </a:lnTo>
                  <a:lnTo>
                    <a:pt x="4945" y="612"/>
                  </a:lnTo>
                  <a:lnTo>
                    <a:pt x="4950" y="614"/>
                  </a:lnTo>
                  <a:lnTo>
                    <a:pt x="4958" y="616"/>
                  </a:lnTo>
                  <a:lnTo>
                    <a:pt x="4964" y="617"/>
                  </a:lnTo>
                  <a:lnTo>
                    <a:pt x="4972" y="619"/>
                  </a:lnTo>
                  <a:lnTo>
                    <a:pt x="4977" y="621"/>
                  </a:lnTo>
                  <a:lnTo>
                    <a:pt x="4985" y="623"/>
                  </a:lnTo>
                  <a:lnTo>
                    <a:pt x="4993" y="623"/>
                  </a:lnTo>
                  <a:lnTo>
                    <a:pt x="4998" y="623"/>
                  </a:lnTo>
                  <a:lnTo>
                    <a:pt x="5006" y="621"/>
                  </a:lnTo>
                  <a:lnTo>
                    <a:pt x="5012" y="621"/>
                  </a:lnTo>
                  <a:lnTo>
                    <a:pt x="5020" y="619"/>
                  </a:lnTo>
                  <a:lnTo>
                    <a:pt x="5027" y="617"/>
                  </a:lnTo>
                  <a:lnTo>
                    <a:pt x="5033" y="617"/>
                  </a:lnTo>
                  <a:lnTo>
                    <a:pt x="5041" y="617"/>
                  </a:lnTo>
                  <a:lnTo>
                    <a:pt x="5046" y="616"/>
                  </a:lnTo>
                  <a:lnTo>
                    <a:pt x="5054" y="616"/>
                  </a:lnTo>
                  <a:lnTo>
                    <a:pt x="5062" y="614"/>
                  </a:lnTo>
                  <a:lnTo>
                    <a:pt x="5068" y="610"/>
                  </a:lnTo>
                  <a:lnTo>
                    <a:pt x="5075" y="604"/>
                  </a:lnTo>
                  <a:lnTo>
                    <a:pt x="5081" y="594"/>
                  </a:lnTo>
                  <a:lnTo>
                    <a:pt x="5089" y="585"/>
                  </a:lnTo>
                  <a:lnTo>
                    <a:pt x="5094" y="571"/>
                  </a:lnTo>
                  <a:lnTo>
                    <a:pt x="5102" y="558"/>
                  </a:lnTo>
                  <a:lnTo>
                    <a:pt x="5110" y="545"/>
                  </a:lnTo>
                  <a:lnTo>
                    <a:pt x="5116" y="535"/>
                  </a:lnTo>
                  <a:lnTo>
                    <a:pt x="5123" y="527"/>
                  </a:lnTo>
                  <a:lnTo>
                    <a:pt x="5129" y="525"/>
                  </a:lnTo>
                  <a:lnTo>
                    <a:pt x="5137" y="529"/>
                  </a:lnTo>
                  <a:lnTo>
                    <a:pt x="5144" y="535"/>
                  </a:lnTo>
                  <a:lnTo>
                    <a:pt x="5150" y="543"/>
                  </a:lnTo>
                  <a:lnTo>
                    <a:pt x="5158" y="548"/>
                  </a:lnTo>
                  <a:lnTo>
                    <a:pt x="5164" y="554"/>
                  </a:lnTo>
                  <a:lnTo>
                    <a:pt x="5171" y="558"/>
                  </a:lnTo>
                  <a:lnTo>
                    <a:pt x="5179" y="558"/>
                  </a:lnTo>
                  <a:lnTo>
                    <a:pt x="5185" y="558"/>
                  </a:lnTo>
                  <a:lnTo>
                    <a:pt x="5192" y="556"/>
                  </a:lnTo>
                  <a:lnTo>
                    <a:pt x="5198" y="552"/>
                  </a:lnTo>
                  <a:lnTo>
                    <a:pt x="5206" y="548"/>
                  </a:lnTo>
                  <a:lnTo>
                    <a:pt x="5213" y="545"/>
                  </a:lnTo>
                  <a:lnTo>
                    <a:pt x="5219" y="543"/>
                  </a:lnTo>
                  <a:lnTo>
                    <a:pt x="5227" y="545"/>
                  </a:lnTo>
                  <a:lnTo>
                    <a:pt x="5233" y="546"/>
                  </a:lnTo>
                  <a:lnTo>
                    <a:pt x="5240" y="552"/>
                  </a:lnTo>
                  <a:lnTo>
                    <a:pt x="5246" y="558"/>
                  </a:lnTo>
                  <a:lnTo>
                    <a:pt x="5254" y="564"/>
                  </a:lnTo>
                  <a:lnTo>
                    <a:pt x="5261" y="568"/>
                  </a:lnTo>
                  <a:lnTo>
                    <a:pt x="5267" y="571"/>
                  </a:lnTo>
                  <a:lnTo>
                    <a:pt x="5275" y="571"/>
                  </a:lnTo>
                  <a:lnTo>
                    <a:pt x="5281" y="571"/>
                  </a:lnTo>
                  <a:lnTo>
                    <a:pt x="5288" y="569"/>
                  </a:lnTo>
                  <a:lnTo>
                    <a:pt x="5296" y="566"/>
                  </a:lnTo>
                  <a:lnTo>
                    <a:pt x="5302" y="562"/>
                  </a:lnTo>
                  <a:lnTo>
                    <a:pt x="5309" y="558"/>
                  </a:lnTo>
                  <a:lnTo>
                    <a:pt x="5315" y="554"/>
                  </a:lnTo>
                  <a:lnTo>
                    <a:pt x="5323" y="552"/>
                  </a:lnTo>
                  <a:lnTo>
                    <a:pt x="5331" y="554"/>
                  </a:lnTo>
                  <a:lnTo>
                    <a:pt x="5336" y="556"/>
                  </a:lnTo>
                  <a:lnTo>
                    <a:pt x="5344" y="558"/>
                  </a:lnTo>
                  <a:lnTo>
                    <a:pt x="5350" y="562"/>
                  </a:lnTo>
                  <a:lnTo>
                    <a:pt x="5357" y="566"/>
                  </a:lnTo>
                  <a:lnTo>
                    <a:pt x="5363" y="569"/>
                  </a:lnTo>
                  <a:lnTo>
                    <a:pt x="5371" y="571"/>
                  </a:lnTo>
                  <a:lnTo>
                    <a:pt x="5379" y="575"/>
                  </a:lnTo>
                  <a:lnTo>
                    <a:pt x="5384" y="577"/>
                  </a:lnTo>
                  <a:lnTo>
                    <a:pt x="5392" y="579"/>
                  </a:lnTo>
                  <a:lnTo>
                    <a:pt x="5398" y="579"/>
                  </a:lnTo>
                  <a:lnTo>
                    <a:pt x="5405" y="581"/>
                  </a:lnTo>
                  <a:lnTo>
                    <a:pt x="5413" y="579"/>
                  </a:lnTo>
                  <a:lnTo>
                    <a:pt x="5419" y="579"/>
                  </a:lnTo>
                  <a:lnTo>
                    <a:pt x="5427" y="579"/>
                  </a:lnTo>
                  <a:lnTo>
                    <a:pt x="5432" y="579"/>
                  </a:lnTo>
                  <a:lnTo>
                    <a:pt x="5440" y="579"/>
                  </a:lnTo>
                  <a:lnTo>
                    <a:pt x="5448" y="581"/>
                  </a:lnTo>
                  <a:lnTo>
                    <a:pt x="5453" y="581"/>
                  </a:lnTo>
                  <a:lnTo>
                    <a:pt x="5461" y="581"/>
                  </a:lnTo>
                  <a:lnTo>
                    <a:pt x="5467" y="581"/>
                  </a:lnTo>
                  <a:lnTo>
                    <a:pt x="5475" y="581"/>
                  </a:lnTo>
                  <a:lnTo>
                    <a:pt x="5480" y="579"/>
                  </a:lnTo>
                  <a:lnTo>
                    <a:pt x="5488" y="577"/>
                  </a:lnTo>
                  <a:lnTo>
                    <a:pt x="5496" y="577"/>
                  </a:lnTo>
                  <a:lnTo>
                    <a:pt x="5501" y="575"/>
                  </a:lnTo>
                  <a:lnTo>
                    <a:pt x="5509" y="575"/>
                  </a:lnTo>
                  <a:lnTo>
                    <a:pt x="5515" y="573"/>
                  </a:lnTo>
                  <a:lnTo>
                    <a:pt x="5523" y="573"/>
                  </a:lnTo>
                  <a:lnTo>
                    <a:pt x="5530" y="573"/>
                  </a:lnTo>
                  <a:lnTo>
                    <a:pt x="5536" y="575"/>
                  </a:lnTo>
                  <a:lnTo>
                    <a:pt x="5544" y="575"/>
                  </a:lnTo>
                  <a:lnTo>
                    <a:pt x="5549" y="577"/>
                  </a:lnTo>
                  <a:lnTo>
                    <a:pt x="5557" y="577"/>
                  </a:lnTo>
                  <a:lnTo>
                    <a:pt x="5565" y="579"/>
                  </a:lnTo>
                  <a:lnTo>
                    <a:pt x="5571" y="581"/>
                  </a:lnTo>
                  <a:lnTo>
                    <a:pt x="5578" y="581"/>
                  </a:lnTo>
                  <a:lnTo>
                    <a:pt x="5584" y="581"/>
                  </a:lnTo>
                  <a:lnTo>
                    <a:pt x="5592" y="579"/>
                  </a:lnTo>
                  <a:lnTo>
                    <a:pt x="5599" y="579"/>
                  </a:lnTo>
                  <a:lnTo>
                    <a:pt x="5605" y="577"/>
                  </a:lnTo>
                  <a:lnTo>
                    <a:pt x="5613" y="575"/>
                  </a:lnTo>
                  <a:lnTo>
                    <a:pt x="5619" y="573"/>
                  </a:lnTo>
                  <a:lnTo>
                    <a:pt x="5626" y="573"/>
                  </a:lnTo>
                  <a:lnTo>
                    <a:pt x="5632" y="573"/>
                  </a:lnTo>
                  <a:lnTo>
                    <a:pt x="5640" y="571"/>
                  </a:lnTo>
                  <a:lnTo>
                    <a:pt x="5647" y="571"/>
                  </a:lnTo>
                  <a:lnTo>
                    <a:pt x="5653" y="569"/>
                  </a:lnTo>
                  <a:lnTo>
                    <a:pt x="5661" y="568"/>
                  </a:lnTo>
                  <a:lnTo>
                    <a:pt x="5667" y="564"/>
                  </a:lnTo>
                  <a:lnTo>
                    <a:pt x="5674" y="562"/>
                  </a:lnTo>
                  <a:lnTo>
                    <a:pt x="5682" y="558"/>
                  </a:lnTo>
                  <a:lnTo>
                    <a:pt x="5688" y="554"/>
                  </a:lnTo>
                  <a:lnTo>
                    <a:pt x="5695" y="550"/>
                  </a:lnTo>
                  <a:lnTo>
                    <a:pt x="5701" y="548"/>
                  </a:lnTo>
                  <a:lnTo>
                    <a:pt x="5709" y="546"/>
                  </a:lnTo>
                  <a:lnTo>
                    <a:pt x="5717" y="545"/>
                  </a:lnTo>
                  <a:lnTo>
                    <a:pt x="5722" y="545"/>
                  </a:lnTo>
                  <a:lnTo>
                    <a:pt x="5730" y="545"/>
                  </a:lnTo>
                  <a:lnTo>
                    <a:pt x="5736" y="545"/>
                  </a:lnTo>
                  <a:lnTo>
                    <a:pt x="5743" y="545"/>
                  </a:lnTo>
                  <a:lnTo>
                    <a:pt x="5749" y="543"/>
                  </a:lnTo>
                  <a:lnTo>
                    <a:pt x="5757" y="541"/>
                  </a:lnTo>
                  <a:lnTo>
                    <a:pt x="5765" y="537"/>
                  </a:lnTo>
                  <a:lnTo>
                    <a:pt x="5770" y="533"/>
                  </a:lnTo>
                  <a:lnTo>
                    <a:pt x="5778" y="529"/>
                  </a:lnTo>
                  <a:lnTo>
                    <a:pt x="5784" y="525"/>
                  </a:lnTo>
                  <a:lnTo>
                    <a:pt x="5791" y="518"/>
                  </a:lnTo>
                  <a:lnTo>
                    <a:pt x="5799" y="512"/>
                  </a:lnTo>
                  <a:lnTo>
                    <a:pt x="5805" y="504"/>
                  </a:lnTo>
                  <a:lnTo>
                    <a:pt x="5813" y="497"/>
                  </a:lnTo>
                  <a:lnTo>
                    <a:pt x="5818" y="491"/>
                  </a:lnTo>
                  <a:lnTo>
                    <a:pt x="5826" y="487"/>
                  </a:lnTo>
                  <a:lnTo>
                    <a:pt x="5834" y="485"/>
                  </a:lnTo>
                  <a:lnTo>
                    <a:pt x="5839" y="485"/>
                  </a:lnTo>
                  <a:lnTo>
                    <a:pt x="5847" y="485"/>
                  </a:lnTo>
                  <a:lnTo>
                    <a:pt x="5853" y="487"/>
                  </a:lnTo>
                  <a:lnTo>
                    <a:pt x="5861" y="487"/>
                  </a:lnTo>
                  <a:lnTo>
                    <a:pt x="5868" y="487"/>
                  </a:lnTo>
                  <a:lnTo>
                    <a:pt x="5874" y="487"/>
                  </a:lnTo>
                  <a:lnTo>
                    <a:pt x="5882" y="489"/>
                  </a:lnTo>
                  <a:lnTo>
                    <a:pt x="5887" y="491"/>
                  </a:lnTo>
                  <a:lnTo>
                    <a:pt x="5895" y="495"/>
                  </a:lnTo>
                  <a:lnTo>
                    <a:pt x="5901" y="498"/>
                  </a:lnTo>
                  <a:lnTo>
                    <a:pt x="5909" y="502"/>
                  </a:lnTo>
                  <a:lnTo>
                    <a:pt x="5916" y="506"/>
                  </a:lnTo>
                  <a:lnTo>
                    <a:pt x="5922" y="510"/>
                  </a:lnTo>
                  <a:lnTo>
                    <a:pt x="5930" y="512"/>
                  </a:lnTo>
                  <a:lnTo>
                    <a:pt x="5935" y="512"/>
                  </a:lnTo>
                  <a:lnTo>
                    <a:pt x="5943" y="510"/>
                  </a:lnTo>
                  <a:lnTo>
                    <a:pt x="5951" y="506"/>
                  </a:lnTo>
                  <a:lnTo>
                    <a:pt x="5957" y="500"/>
                  </a:lnTo>
                  <a:lnTo>
                    <a:pt x="5964" y="493"/>
                  </a:lnTo>
                  <a:lnTo>
                    <a:pt x="5970" y="487"/>
                  </a:lnTo>
                  <a:lnTo>
                    <a:pt x="5978" y="481"/>
                  </a:lnTo>
                  <a:lnTo>
                    <a:pt x="5985" y="479"/>
                  </a:lnTo>
                  <a:lnTo>
                    <a:pt x="5991" y="477"/>
                  </a:lnTo>
                  <a:lnTo>
                    <a:pt x="5999" y="479"/>
                  </a:lnTo>
                  <a:lnTo>
                    <a:pt x="6005" y="481"/>
                  </a:lnTo>
                  <a:lnTo>
                    <a:pt x="6012" y="485"/>
                  </a:lnTo>
                  <a:lnTo>
                    <a:pt x="6018" y="489"/>
                  </a:lnTo>
                  <a:lnTo>
                    <a:pt x="6026" y="493"/>
                  </a:lnTo>
                  <a:lnTo>
                    <a:pt x="6033" y="495"/>
                  </a:lnTo>
                  <a:lnTo>
                    <a:pt x="6039" y="497"/>
                  </a:lnTo>
                  <a:lnTo>
                    <a:pt x="6047" y="497"/>
                  </a:lnTo>
                  <a:lnTo>
                    <a:pt x="6053" y="497"/>
                  </a:lnTo>
                  <a:lnTo>
                    <a:pt x="6060" y="493"/>
                  </a:lnTo>
                  <a:lnTo>
                    <a:pt x="6068" y="491"/>
                  </a:lnTo>
                  <a:lnTo>
                    <a:pt x="6074" y="489"/>
                  </a:lnTo>
                  <a:lnTo>
                    <a:pt x="6081" y="487"/>
                  </a:lnTo>
                  <a:lnTo>
                    <a:pt x="6087" y="487"/>
                  </a:lnTo>
                  <a:lnTo>
                    <a:pt x="6095" y="489"/>
                  </a:lnTo>
                  <a:lnTo>
                    <a:pt x="6102" y="491"/>
                  </a:lnTo>
                  <a:lnTo>
                    <a:pt x="6108" y="493"/>
                  </a:lnTo>
                  <a:lnTo>
                    <a:pt x="6116" y="493"/>
                  </a:lnTo>
                  <a:lnTo>
                    <a:pt x="6122" y="495"/>
                  </a:lnTo>
                  <a:lnTo>
                    <a:pt x="6129" y="495"/>
                  </a:lnTo>
                  <a:lnTo>
                    <a:pt x="6135" y="495"/>
                  </a:lnTo>
                  <a:lnTo>
                    <a:pt x="6143" y="493"/>
                  </a:lnTo>
                  <a:lnTo>
                    <a:pt x="6150" y="493"/>
                  </a:lnTo>
                  <a:lnTo>
                    <a:pt x="6156" y="491"/>
                  </a:lnTo>
                  <a:lnTo>
                    <a:pt x="6164" y="491"/>
                  </a:lnTo>
                  <a:lnTo>
                    <a:pt x="6170" y="491"/>
                  </a:lnTo>
                  <a:lnTo>
                    <a:pt x="6177" y="489"/>
                  </a:lnTo>
                  <a:lnTo>
                    <a:pt x="6185" y="489"/>
                  </a:lnTo>
                  <a:lnTo>
                    <a:pt x="6191" y="489"/>
                  </a:lnTo>
                  <a:lnTo>
                    <a:pt x="6198" y="489"/>
                  </a:lnTo>
                  <a:lnTo>
                    <a:pt x="6204" y="489"/>
                  </a:lnTo>
                  <a:lnTo>
                    <a:pt x="6212" y="487"/>
                  </a:lnTo>
                  <a:lnTo>
                    <a:pt x="6220" y="487"/>
                  </a:lnTo>
                  <a:lnTo>
                    <a:pt x="6225" y="487"/>
                  </a:lnTo>
                  <a:lnTo>
                    <a:pt x="6233" y="487"/>
                  </a:lnTo>
                  <a:lnTo>
                    <a:pt x="6239" y="485"/>
                  </a:lnTo>
                  <a:lnTo>
                    <a:pt x="6246" y="485"/>
                  </a:lnTo>
                  <a:lnTo>
                    <a:pt x="6254" y="483"/>
                  </a:lnTo>
                  <a:lnTo>
                    <a:pt x="6260" y="483"/>
                  </a:lnTo>
                  <a:lnTo>
                    <a:pt x="6268" y="481"/>
                  </a:lnTo>
                  <a:lnTo>
                    <a:pt x="6273" y="479"/>
                  </a:lnTo>
                  <a:lnTo>
                    <a:pt x="6281" y="475"/>
                  </a:lnTo>
                  <a:lnTo>
                    <a:pt x="6287" y="470"/>
                  </a:lnTo>
                  <a:lnTo>
                    <a:pt x="6294" y="464"/>
                  </a:lnTo>
                  <a:lnTo>
                    <a:pt x="6302" y="454"/>
                  </a:lnTo>
                  <a:lnTo>
                    <a:pt x="6308" y="443"/>
                  </a:lnTo>
                  <a:lnTo>
                    <a:pt x="6316" y="426"/>
                  </a:lnTo>
                  <a:lnTo>
                    <a:pt x="6321" y="401"/>
                  </a:lnTo>
                  <a:lnTo>
                    <a:pt x="6329" y="362"/>
                  </a:lnTo>
                  <a:lnTo>
                    <a:pt x="6337" y="301"/>
                  </a:lnTo>
                  <a:lnTo>
                    <a:pt x="6342" y="209"/>
                  </a:lnTo>
                  <a:lnTo>
                    <a:pt x="6350" y="76"/>
                  </a:lnTo>
                  <a:lnTo>
                    <a:pt x="6354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29" name="Rectangle 603">
              <a:extLst>
                <a:ext uri="{FF2B5EF4-FFF2-40B4-BE49-F238E27FC236}">
                  <a16:creationId xmlns:a16="http://schemas.microsoft.com/office/drawing/2014/main" id="{186FD3F4-E2C6-F375-5E2E-C027124290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902896" y="3788561"/>
              <a:ext cx="2565995" cy="955044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700"/>
            </a:p>
          </p:txBody>
        </p:sp>
        <p:grpSp>
          <p:nvGrpSpPr>
            <p:cNvPr id="30" name="グループ化 29">
              <a:extLst>
                <a:ext uri="{FF2B5EF4-FFF2-40B4-BE49-F238E27FC236}">
                  <a16:creationId xmlns:a16="http://schemas.microsoft.com/office/drawing/2014/main" id="{922AF629-3193-EBA2-8D91-BC13D9139584}"/>
                </a:ext>
              </a:extLst>
            </p:cNvPr>
            <p:cNvGrpSpPr/>
            <p:nvPr/>
          </p:nvGrpSpPr>
          <p:grpSpPr>
            <a:xfrm>
              <a:off x="-1138164" y="3738720"/>
              <a:ext cx="229914" cy="1043661"/>
              <a:chOff x="1210912" y="5047853"/>
              <a:chExt cx="229914" cy="1043661"/>
            </a:xfrm>
          </p:grpSpPr>
          <p:sp>
            <p:nvSpPr>
              <p:cNvPr id="31" name="Line 783">
                <a:extLst>
                  <a:ext uri="{FF2B5EF4-FFF2-40B4-BE49-F238E27FC236}">
                    <a16:creationId xmlns:a16="http://schemas.microsoft.com/office/drawing/2014/main" id="{010B4C9A-137F-08B4-4B75-C072FD6202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6600" y="6034283"/>
                <a:ext cx="14226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Line 788">
                <a:extLst>
                  <a:ext uri="{FF2B5EF4-FFF2-40B4-BE49-F238E27FC236}">
                    <a16:creationId xmlns:a16="http://schemas.microsoft.com/office/drawing/2014/main" id="{4E7E102A-3B8B-984F-0C40-38C85BE185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6600" y="5589715"/>
                <a:ext cx="14226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Line 793">
                <a:extLst>
                  <a:ext uri="{FF2B5EF4-FFF2-40B4-BE49-F238E27FC236}">
                    <a16:creationId xmlns:a16="http://schemas.microsoft.com/office/drawing/2014/main" id="{4059D9A1-5B27-CAB8-2C02-0E219EE9DE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6600" y="5145148"/>
                <a:ext cx="14226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Line 794">
                <a:extLst>
                  <a:ext uri="{FF2B5EF4-FFF2-40B4-BE49-F238E27FC236}">
                    <a16:creationId xmlns:a16="http://schemas.microsoft.com/office/drawing/2014/main" id="{B256C7C6-6141-6998-6E29-3A35B1F878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13871" y="6034283"/>
                <a:ext cx="26955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Rectangle 795">
                <a:extLst>
                  <a:ext uri="{FF2B5EF4-FFF2-40B4-BE49-F238E27FC236}">
                    <a16:creationId xmlns:a16="http://schemas.microsoft.com/office/drawing/2014/main" id="{661C634A-955E-F407-2208-DA9F4D6478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4192" y="5947446"/>
                <a:ext cx="74746" cy="1440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0</a:t>
                </a:r>
                <a:endParaRPr lang="en-US" altLang="ja-JP" sz="700" dirty="0">
                  <a:cs typeface="Arial" panose="020B0604020202020204" pitchFamily="34" charset="0"/>
                </a:endParaRPr>
              </a:p>
            </p:txBody>
          </p:sp>
          <p:sp>
            <p:nvSpPr>
              <p:cNvPr id="90" name="Line 796">
                <a:extLst>
                  <a:ext uri="{FF2B5EF4-FFF2-40B4-BE49-F238E27FC236}">
                    <a16:creationId xmlns:a16="http://schemas.microsoft.com/office/drawing/2014/main" id="{A886D76B-9A0B-CFA4-BEFB-D07B3364FD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13871" y="5589715"/>
                <a:ext cx="26955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Rectangle 797">
                <a:extLst>
                  <a:ext uri="{FF2B5EF4-FFF2-40B4-BE49-F238E27FC236}">
                    <a16:creationId xmlns:a16="http://schemas.microsoft.com/office/drawing/2014/main" id="{46E296B3-D4E4-EE11-F0A7-CCC13288E1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0912" y="5501522"/>
                <a:ext cx="149490" cy="1440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25</a:t>
                </a:r>
                <a:endParaRPr lang="en-US" altLang="ja-JP" sz="700" dirty="0">
                  <a:cs typeface="Arial" panose="020B0604020202020204" pitchFamily="34" charset="0"/>
                </a:endParaRPr>
              </a:p>
            </p:txBody>
          </p:sp>
          <p:sp>
            <p:nvSpPr>
              <p:cNvPr id="92" name="Line 798">
                <a:extLst>
                  <a:ext uri="{FF2B5EF4-FFF2-40B4-BE49-F238E27FC236}">
                    <a16:creationId xmlns:a16="http://schemas.microsoft.com/office/drawing/2014/main" id="{06BF15AC-5398-9A69-43F5-4183E58586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13871" y="5145148"/>
                <a:ext cx="26955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Rectangle 799">
                <a:extLst>
                  <a:ext uri="{FF2B5EF4-FFF2-40B4-BE49-F238E27FC236}">
                    <a16:creationId xmlns:a16="http://schemas.microsoft.com/office/drawing/2014/main" id="{9CECD7CD-7BF6-3E11-43CC-13861AA5D5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9777" y="5047853"/>
                <a:ext cx="149490" cy="1440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50</a:t>
                </a:r>
                <a:endParaRPr lang="en-US" altLang="ja-JP" sz="700" dirty="0"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B467DE24-B3F5-071F-665F-AF503EC902AF}"/>
              </a:ext>
            </a:extLst>
          </p:cNvPr>
          <p:cNvGrpSpPr/>
          <p:nvPr/>
        </p:nvGrpSpPr>
        <p:grpSpPr>
          <a:xfrm>
            <a:off x="4762474" y="1818594"/>
            <a:ext cx="1861348" cy="792393"/>
            <a:chOff x="-1148770" y="2605477"/>
            <a:chExt cx="2811869" cy="1056152"/>
          </a:xfrm>
        </p:grpSpPr>
        <p:sp>
          <p:nvSpPr>
            <p:cNvPr id="104" name="Freeform 301">
              <a:extLst>
                <a:ext uri="{FF2B5EF4-FFF2-40B4-BE49-F238E27FC236}">
                  <a16:creationId xmlns:a16="http://schemas.microsoft.com/office/drawing/2014/main" id="{99DBA649-AA71-AB60-FB07-E7B941324A72}"/>
                </a:ext>
              </a:extLst>
            </p:cNvPr>
            <p:cNvSpPr>
              <a:spLocks/>
            </p:cNvSpPr>
            <p:nvPr/>
          </p:nvSpPr>
          <p:spPr bwMode="auto">
            <a:xfrm>
              <a:off x="-902147" y="2656630"/>
              <a:ext cx="2381052" cy="919912"/>
            </a:xfrm>
            <a:custGeom>
              <a:avLst/>
              <a:gdLst>
                <a:gd name="T0" fmla="*/ 0 w 6362"/>
                <a:gd name="T1" fmla="*/ 9 h 1076"/>
                <a:gd name="T2" fmla="*/ 1 w 6362"/>
                <a:gd name="T3" fmla="*/ 6 h 1076"/>
                <a:gd name="T4" fmla="*/ 2 w 6362"/>
                <a:gd name="T5" fmla="*/ 6 h 1076"/>
                <a:gd name="T6" fmla="*/ 3 w 6362"/>
                <a:gd name="T7" fmla="*/ 8 h 1076"/>
                <a:gd name="T8" fmla="*/ 3 w 6362"/>
                <a:gd name="T9" fmla="*/ 9 h 1076"/>
                <a:gd name="T10" fmla="*/ 4 w 6362"/>
                <a:gd name="T11" fmla="*/ 9 h 1076"/>
                <a:gd name="T12" fmla="*/ 5 w 6362"/>
                <a:gd name="T13" fmla="*/ 9 h 1076"/>
                <a:gd name="T14" fmla="*/ 6 w 6362"/>
                <a:gd name="T15" fmla="*/ 9 h 1076"/>
                <a:gd name="T16" fmla="*/ 7 w 6362"/>
                <a:gd name="T17" fmla="*/ 9 h 1076"/>
                <a:gd name="T18" fmla="*/ 7 w 6362"/>
                <a:gd name="T19" fmla="*/ 9 h 1076"/>
                <a:gd name="T20" fmla="*/ 8 w 6362"/>
                <a:gd name="T21" fmla="*/ 9 h 1076"/>
                <a:gd name="T22" fmla="*/ 9 w 6362"/>
                <a:gd name="T23" fmla="*/ 9 h 1076"/>
                <a:gd name="T24" fmla="*/ 10 w 6362"/>
                <a:gd name="T25" fmla="*/ 8 h 1076"/>
                <a:gd name="T26" fmla="*/ 11 w 6362"/>
                <a:gd name="T27" fmla="*/ 8 h 1076"/>
                <a:gd name="T28" fmla="*/ 12 w 6362"/>
                <a:gd name="T29" fmla="*/ 8 h 1076"/>
                <a:gd name="T30" fmla="*/ 12 w 6362"/>
                <a:gd name="T31" fmla="*/ 7 h 1076"/>
                <a:gd name="T32" fmla="*/ 13 w 6362"/>
                <a:gd name="T33" fmla="*/ 7 h 1076"/>
                <a:gd name="T34" fmla="*/ 14 w 6362"/>
                <a:gd name="T35" fmla="*/ 6 h 1076"/>
                <a:gd name="T36" fmla="*/ 15 w 6362"/>
                <a:gd name="T37" fmla="*/ 6 h 1076"/>
                <a:gd name="T38" fmla="*/ 16 w 6362"/>
                <a:gd name="T39" fmla="*/ 7 h 1076"/>
                <a:gd name="T40" fmla="*/ 16 w 6362"/>
                <a:gd name="T41" fmla="*/ 7 h 1076"/>
                <a:gd name="T42" fmla="*/ 17 w 6362"/>
                <a:gd name="T43" fmla="*/ 6 h 1076"/>
                <a:gd name="T44" fmla="*/ 18 w 6362"/>
                <a:gd name="T45" fmla="*/ 7 h 1076"/>
                <a:gd name="T46" fmla="*/ 19 w 6362"/>
                <a:gd name="T47" fmla="*/ 6 h 1076"/>
                <a:gd name="T48" fmla="*/ 20 w 6362"/>
                <a:gd name="T49" fmla="*/ 6 h 1076"/>
                <a:gd name="T50" fmla="*/ 20 w 6362"/>
                <a:gd name="T51" fmla="*/ 7 h 1076"/>
                <a:gd name="T52" fmla="*/ 21 w 6362"/>
                <a:gd name="T53" fmla="*/ 7 h 1076"/>
                <a:gd name="T54" fmla="*/ 22 w 6362"/>
                <a:gd name="T55" fmla="*/ 7 h 1076"/>
                <a:gd name="T56" fmla="*/ 23 w 6362"/>
                <a:gd name="T57" fmla="*/ 7 h 1076"/>
                <a:gd name="T58" fmla="*/ 24 w 6362"/>
                <a:gd name="T59" fmla="*/ 6 h 1076"/>
                <a:gd name="T60" fmla="*/ 24 w 6362"/>
                <a:gd name="T61" fmla="*/ 6 h 1076"/>
                <a:gd name="T62" fmla="*/ 25 w 6362"/>
                <a:gd name="T63" fmla="*/ 6 h 1076"/>
                <a:gd name="T64" fmla="*/ 26 w 6362"/>
                <a:gd name="T65" fmla="*/ 6 h 1076"/>
                <a:gd name="T66" fmla="*/ 27 w 6362"/>
                <a:gd name="T67" fmla="*/ 6 h 1076"/>
                <a:gd name="T68" fmla="*/ 28 w 6362"/>
                <a:gd name="T69" fmla="*/ 6 h 1076"/>
                <a:gd name="T70" fmla="*/ 28 w 6362"/>
                <a:gd name="T71" fmla="*/ 6 h 1076"/>
                <a:gd name="T72" fmla="*/ 29 w 6362"/>
                <a:gd name="T73" fmla="*/ 6 h 1076"/>
                <a:gd name="T74" fmla="*/ 30 w 6362"/>
                <a:gd name="T75" fmla="*/ 6 h 1076"/>
                <a:gd name="T76" fmla="*/ 31 w 6362"/>
                <a:gd name="T77" fmla="*/ 6 h 1076"/>
                <a:gd name="T78" fmla="*/ 32 w 6362"/>
                <a:gd name="T79" fmla="*/ 5 h 1076"/>
                <a:gd name="T80" fmla="*/ 33 w 6362"/>
                <a:gd name="T81" fmla="*/ 5 h 1076"/>
                <a:gd name="T82" fmla="*/ 33 w 6362"/>
                <a:gd name="T83" fmla="*/ 5 h 1076"/>
                <a:gd name="T84" fmla="*/ 34 w 6362"/>
                <a:gd name="T85" fmla="*/ 3 h 1076"/>
                <a:gd name="T86" fmla="*/ 35 w 6362"/>
                <a:gd name="T87" fmla="*/ 5 h 1076"/>
                <a:gd name="T88" fmla="*/ 36 w 6362"/>
                <a:gd name="T89" fmla="*/ 5 h 1076"/>
                <a:gd name="T90" fmla="*/ 37 w 6362"/>
                <a:gd name="T91" fmla="*/ 5 h 1076"/>
                <a:gd name="T92" fmla="*/ 37 w 6362"/>
                <a:gd name="T93" fmla="*/ 5 h 1076"/>
                <a:gd name="T94" fmla="*/ 38 w 6362"/>
                <a:gd name="T95" fmla="*/ 5 h 1076"/>
                <a:gd name="T96" fmla="*/ 39 w 6362"/>
                <a:gd name="T97" fmla="*/ 5 h 1076"/>
                <a:gd name="T98" fmla="*/ 40 w 6362"/>
                <a:gd name="T99" fmla="*/ 5 h 1076"/>
                <a:gd name="T100" fmla="*/ 41 w 6362"/>
                <a:gd name="T101" fmla="*/ 5 h 1076"/>
                <a:gd name="T102" fmla="*/ 41 w 6362"/>
                <a:gd name="T103" fmla="*/ 5 h 1076"/>
                <a:gd name="T104" fmla="*/ 42 w 6362"/>
                <a:gd name="T105" fmla="*/ 5 h 1076"/>
                <a:gd name="T106" fmla="*/ 43 w 6362"/>
                <a:gd name="T107" fmla="*/ 5 h 1076"/>
                <a:gd name="T108" fmla="*/ 44 w 6362"/>
                <a:gd name="T109" fmla="*/ 5 h 1076"/>
                <a:gd name="T110" fmla="*/ 45 w 6362"/>
                <a:gd name="T111" fmla="*/ 5 h 1076"/>
                <a:gd name="T112" fmla="*/ 45 w 6362"/>
                <a:gd name="T113" fmla="*/ 5 h 1076"/>
                <a:gd name="T114" fmla="*/ 46 w 6362"/>
                <a:gd name="T115" fmla="*/ 5 h 1076"/>
                <a:gd name="T116" fmla="*/ 47 w 6362"/>
                <a:gd name="T117" fmla="*/ 5 h 1076"/>
                <a:gd name="T118" fmla="*/ 48 w 6362"/>
                <a:gd name="T119" fmla="*/ 5 h 1076"/>
                <a:gd name="T120" fmla="*/ 49 w 6362"/>
                <a:gd name="T121" fmla="*/ 4 h 107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60000 65536"/>
                <a:gd name="T181" fmla="*/ 0 60000 65536"/>
                <a:gd name="T182" fmla="*/ 0 60000 65536"/>
              </a:gdLst>
              <a:ahLst/>
              <a:cxnLst>
                <a:cxn ang="T122">
                  <a:pos x="T0" y="T1"/>
                </a:cxn>
                <a:cxn ang="T123">
                  <a:pos x="T2" y="T3"/>
                </a:cxn>
                <a:cxn ang="T124">
                  <a:pos x="T4" y="T5"/>
                </a:cxn>
                <a:cxn ang="T125">
                  <a:pos x="T6" y="T7"/>
                </a:cxn>
                <a:cxn ang="T126">
                  <a:pos x="T8" y="T9"/>
                </a:cxn>
                <a:cxn ang="T127">
                  <a:pos x="T10" y="T11"/>
                </a:cxn>
                <a:cxn ang="T128">
                  <a:pos x="T12" y="T13"/>
                </a:cxn>
                <a:cxn ang="T129">
                  <a:pos x="T14" y="T15"/>
                </a:cxn>
                <a:cxn ang="T130">
                  <a:pos x="T16" y="T17"/>
                </a:cxn>
                <a:cxn ang="T131">
                  <a:pos x="T18" y="T19"/>
                </a:cxn>
                <a:cxn ang="T132">
                  <a:pos x="T20" y="T21"/>
                </a:cxn>
                <a:cxn ang="T133">
                  <a:pos x="T22" y="T23"/>
                </a:cxn>
                <a:cxn ang="T134">
                  <a:pos x="T24" y="T25"/>
                </a:cxn>
                <a:cxn ang="T135">
                  <a:pos x="T26" y="T27"/>
                </a:cxn>
                <a:cxn ang="T136">
                  <a:pos x="T28" y="T29"/>
                </a:cxn>
                <a:cxn ang="T137">
                  <a:pos x="T30" y="T31"/>
                </a:cxn>
                <a:cxn ang="T138">
                  <a:pos x="T32" y="T33"/>
                </a:cxn>
                <a:cxn ang="T139">
                  <a:pos x="T34" y="T35"/>
                </a:cxn>
                <a:cxn ang="T140">
                  <a:pos x="T36" y="T37"/>
                </a:cxn>
                <a:cxn ang="T141">
                  <a:pos x="T38" y="T39"/>
                </a:cxn>
                <a:cxn ang="T142">
                  <a:pos x="T40" y="T41"/>
                </a:cxn>
                <a:cxn ang="T143">
                  <a:pos x="T42" y="T43"/>
                </a:cxn>
                <a:cxn ang="T144">
                  <a:pos x="T44" y="T45"/>
                </a:cxn>
                <a:cxn ang="T145">
                  <a:pos x="T46" y="T47"/>
                </a:cxn>
                <a:cxn ang="T146">
                  <a:pos x="T48" y="T49"/>
                </a:cxn>
                <a:cxn ang="T147">
                  <a:pos x="T50" y="T51"/>
                </a:cxn>
                <a:cxn ang="T148">
                  <a:pos x="T52" y="T53"/>
                </a:cxn>
                <a:cxn ang="T149">
                  <a:pos x="T54" y="T55"/>
                </a:cxn>
                <a:cxn ang="T150">
                  <a:pos x="T56" y="T57"/>
                </a:cxn>
                <a:cxn ang="T151">
                  <a:pos x="T58" y="T59"/>
                </a:cxn>
                <a:cxn ang="T152">
                  <a:pos x="T60" y="T61"/>
                </a:cxn>
                <a:cxn ang="T153">
                  <a:pos x="T62" y="T63"/>
                </a:cxn>
                <a:cxn ang="T154">
                  <a:pos x="T64" y="T65"/>
                </a:cxn>
                <a:cxn ang="T155">
                  <a:pos x="T66" y="T67"/>
                </a:cxn>
                <a:cxn ang="T156">
                  <a:pos x="T68" y="T69"/>
                </a:cxn>
                <a:cxn ang="T157">
                  <a:pos x="T70" y="T71"/>
                </a:cxn>
                <a:cxn ang="T158">
                  <a:pos x="T72" y="T73"/>
                </a:cxn>
                <a:cxn ang="T159">
                  <a:pos x="T74" y="T75"/>
                </a:cxn>
                <a:cxn ang="T160">
                  <a:pos x="T76" y="T77"/>
                </a:cxn>
                <a:cxn ang="T161">
                  <a:pos x="T78" y="T79"/>
                </a:cxn>
                <a:cxn ang="T162">
                  <a:pos x="T80" y="T81"/>
                </a:cxn>
                <a:cxn ang="T163">
                  <a:pos x="T82" y="T83"/>
                </a:cxn>
                <a:cxn ang="T164">
                  <a:pos x="T84" y="T85"/>
                </a:cxn>
                <a:cxn ang="T165">
                  <a:pos x="T86" y="T87"/>
                </a:cxn>
                <a:cxn ang="T166">
                  <a:pos x="T88" y="T89"/>
                </a:cxn>
                <a:cxn ang="T167">
                  <a:pos x="T90" y="T91"/>
                </a:cxn>
                <a:cxn ang="T168">
                  <a:pos x="T92" y="T93"/>
                </a:cxn>
                <a:cxn ang="T169">
                  <a:pos x="T94" y="T95"/>
                </a:cxn>
                <a:cxn ang="T170">
                  <a:pos x="T96" y="T97"/>
                </a:cxn>
                <a:cxn ang="T171">
                  <a:pos x="T98" y="T99"/>
                </a:cxn>
                <a:cxn ang="T172">
                  <a:pos x="T100" y="T101"/>
                </a:cxn>
                <a:cxn ang="T173">
                  <a:pos x="T102" y="T103"/>
                </a:cxn>
                <a:cxn ang="T174">
                  <a:pos x="T104" y="T105"/>
                </a:cxn>
                <a:cxn ang="T175">
                  <a:pos x="T106" y="T107"/>
                </a:cxn>
                <a:cxn ang="T176">
                  <a:pos x="T108" y="T109"/>
                </a:cxn>
                <a:cxn ang="T177">
                  <a:pos x="T110" y="T111"/>
                </a:cxn>
                <a:cxn ang="T178">
                  <a:pos x="T112" y="T113"/>
                </a:cxn>
                <a:cxn ang="T179">
                  <a:pos x="T114" y="T115"/>
                </a:cxn>
                <a:cxn ang="T180">
                  <a:pos x="T116" y="T117"/>
                </a:cxn>
                <a:cxn ang="T181">
                  <a:pos x="T118" y="T119"/>
                </a:cxn>
                <a:cxn ang="T182">
                  <a:pos x="T120" y="T121"/>
                </a:cxn>
              </a:cxnLst>
              <a:rect l="0" t="0" r="r" b="b"/>
              <a:pathLst>
                <a:path w="6362" h="1076">
                  <a:moveTo>
                    <a:pt x="0" y="1074"/>
                  </a:moveTo>
                  <a:lnTo>
                    <a:pt x="2" y="1074"/>
                  </a:lnTo>
                  <a:lnTo>
                    <a:pt x="8" y="1074"/>
                  </a:lnTo>
                  <a:lnTo>
                    <a:pt x="16" y="1074"/>
                  </a:lnTo>
                  <a:lnTo>
                    <a:pt x="23" y="1076"/>
                  </a:lnTo>
                  <a:lnTo>
                    <a:pt x="29" y="1076"/>
                  </a:lnTo>
                  <a:lnTo>
                    <a:pt x="37" y="1076"/>
                  </a:lnTo>
                  <a:lnTo>
                    <a:pt x="43" y="1076"/>
                  </a:lnTo>
                  <a:lnTo>
                    <a:pt x="50" y="1076"/>
                  </a:lnTo>
                  <a:lnTo>
                    <a:pt x="58" y="1076"/>
                  </a:lnTo>
                  <a:lnTo>
                    <a:pt x="64" y="1074"/>
                  </a:lnTo>
                  <a:lnTo>
                    <a:pt x="71" y="1074"/>
                  </a:lnTo>
                  <a:lnTo>
                    <a:pt x="77" y="1074"/>
                  </a:lnTo>
                  <a:lnTo>
                    <a:pt x="85" y="1072"/>
                  </a:lnTo>
                  <a:lnTo>
                    <a:pt x="92" y="1070"/>
                  </a:lnTo>
                  <a:lnTo>
                    <a:pt x="98" y="1068"/>
                  </a:lnTo>
                  <a:lnTo>
                    <a:pt x="106" y="1065"/>
                  </a:lnTo>
                  <a:lnTo>
                    <a:pt x="112" y="1061"/>
                  </a:lnTo>
                  <a:lnTo>
                    <a:pt x="119" y="1053"/>
                  </a:lnTo>
                  <a:lnTo>
                    <a:pt x="127" y="1043"/>
                  </a:lnTo>
                  <a:lnTo>
                    <a:pt x="133" y="1032"/>
                  </a:lnTo>
                  <a:lnTo>
                    <a:pt x="140" y="1017"/>
                  </a:lnTo>
                  <a:lnTo>
                    <a:pt x="146" y="997"/>
                  </a:lnTo>
                  <a:lnTo>
                    <a:pt x="154" y="972"/>
                  </a:lnTo>
                  <a:lnTo>
                    <a:pt x="160" y="944"/>
                  </a:lnTo>
                  <a:lnTo>
                    <a:pt x="167" y="911"/>
                  </a:lnTo>
                  <a:lnTo>
                    <a:pt x="175" y="875"/>
                  </a:lnTo>
                  <a:lnTo>
                    <a:pt x="181" y="834"/>
                  </a:lnTo>
                  <a:lnTo>
                    <a:pt x="188" y="796"/>
                  </a:lnTo>
                  <a:lnTo>
                    <a:pt x="194" y="756"/>
                  </a:lnTo>
                  <a:lnTo>
                    <a:pt x="202" y="721"/>
                  </a:lnTo>
                  <a:lnTo>
                    <a:pt x="210" y="688"/>
                  </a:lnTo>
                  <a:lnTo>
                    <a:pt x="215" y="662"/>
                  </a:lnTo>
                  <a:lnTo>
                    <a:pt x="223" y="642"/>
                  </a:lnTo>
                  <a:lnTo>
                    <a:pt x="229" y="629"/>
                  </a:lnTo>
                  <a:lnTo>
                    <a:pt x="236" y="621"/>
                  </a:lnTo>
                  <a:lnTo>
                    <a:pt x="244" y="621"/>
                  </a:lnTo>
                  <a:lnTo>
                    <a:pt x="250" y="627"/>
                  </a:lnTo>
                  <a:lnTo>
                    <a:pt x="258" y="639"/>
                  </a:lnTo>
                  <a:lnTo>
                    <a:pt x="263" y="654"/>
                  </a:lnTo>
                  <a:lnTo>
                    <a:pt x="271" y="671"/>
                  </a:lnTo>
                  <a:lnTo>
                    <a:pt x="277" y="692"/>
                  </a:lnTo>
                  <a:lnTo>
                    <a:pt x="284" y="713"/>
                  </a:lnTo>
                  <a:lnTo>
                    <a:pt x="292" y="736"/>
                  </a:lnTo>
                  <a:lnTo>
                    <a:pt x="298" y="759"/>
                  </a:lnTo>
                  <a:lnTo>
                    <a:pt x="306" y="783"/>
                  </a:lnTo>
                  <a:lnTo>
                    <a:pt x="311" y="806"/>
                  </a:lnTo>
                  <a:lnTo>
                    <a:pt x="319" y="827"/>
                  </a:lnTo>
                  <a:lnTo>
                    <a:pt x="327" y="848"/>
                  </a:lnTo>
                  <a:lnTo>
                    <a:pt x="332" y="869"/>
                  </a:lnTo>
                  <a:lnTo>
                    <a:pt x="340" y="888"/>
                  </a:lnTo>
                  <a:lnTo>
                    <a:pt x="346" y="905"/>
                  </a:lnTo>
                  <a:lnTo>
                    <a:pt x="354" y="923"/>
                  </a:lnTo>
                  <a:lnTo>
                    <a:pt x="361" y="938"/>
                  </a:lnTo>
                  <a:lnTo>
                    <a:pt x="367" y="951"/>
                  </a:lnTo>
                  <a:lnTo>
                    <a:pt x="375" y="965"/>
                  </a:lnTo>
                  <a:lnTo>
                    <a:pt x="380" y="978"/>
                  </a:lnTo>
                  <a:lnTo>
                    <a:pt x="388" y="988"/>
                  </a:lnTo>
                  <a:lnTo>
                    <a:pt x="394" y="999"/>
                  </a:lnTo>
                  <a:lnTo>
                    <a:pt x="402" y="1007"/>
                  </a:lnTo>
                  <a:lnTo>
                    <a:pt x="409" y="1015"/>
                  </a:lnTo>
                  <a:lnTo>
                    <a:pt x="415" y="1022"/>
                  </a:lnTo>
                  <a:lnTo>
                    <a:pt x="423" y="1028"/>
                  </a:lnTo>
                  <a:lnTo>
                    <a:pt x="429" y="1034"/>
                  </a:lnTo>
                  <a:lnTo>
                    <a:pt x="436" y="1040"/>
                  </a:lnTo>
                  <a:lnTo>
                    <a:pt x="444" y="1043"/>
                  </a:lnTo>
                  <a:lnTo>
                    <a:pt x="450" y="1047"/>
                  </a:lnTo>
                  <a:lnTo>
                    <a:pt x="457" y="1051"/>
                  </a:lnTo>
                  <a:lnTo>
                    <a:pt x="463" y="1053"/>
                  </a:lnTo>
                  <a:lnTo>
                    <a:pt x="471" y="1055"/>
                  </a:lnTo>
                  <a:lnTo>
                    <a:pt x="478" y="1057"/>
                  </a:lnTo>
                  <a:lnTo>
                    <a:pt x="484" y="1059"/>
                  </a:lnTo>
                  <a:lnTo>
                    <a:pt x="492" y="1061"/>
                  </a:lnTo>
                  <a:lnTo>
                    <a:pt x="498" y="1063"/>
                  </a:lnTo>
                  <a:lnTo>
                    <a:pt x="505" y="1063"/>
                  </a:lnTo>
                  <a:lnTo>
                    <a:pt x="513" y="1063"/>
                  </a:lnTo>
                  <a:lnTo>
                    <a:pt x="519" y="1065"/>
                  </a:lnTo>
                  <a:lnTo>
                    <a:pt x="526" y="1065"/>
                  </a:lnTo>
                  <a:lnTo>
                    <a:pt x="532" y="1065"/>
                  </a:lnTo>
                  <a:lnTo>
                    <a:pt x="540" y="1065"/>
                  </a:lnTo>
                  <a:lnTo>
                    <a:pt x="546" y="1065"/>
                  </a:lnTo>
                  <a:lnTo>
                    <a:pt x="553" y="1065"/>
                  </a:lnTo>
                  <a:lnTo>
                    <a:pt x="561" y="1063"/>
                  </a:lnTo>
                  <a:lnTo>
                    <a:pt x="567" y="1063"/>
                  </a:lnTo>
                  <a:lnTo>
                    <a:pt x="574" y="1063"/>
                  </a:lnTo>
                  <a:lnTo>
                    <a:pt x="580" y="1063"/>
                  </a:lnTo>
                  <a:lnTo>
                    <a:pt x="588" y="1063"/>
                  </a:lnTo>
                  <a:lnTo>
                    <a:pt x="596" y="1063"/>
                  </a:lnTo>
                  <a:lnTo>
                    <a:pt x="601" y="1061"/>
                  </a:lnTo>
                  <a:lnTo>
                    <a:pt x="609" y="1061"/>
                  </a:lnTo>
                  <a:lnTo>
                    <a:pt x="615" y="1061"/>
                  </a:lnTo>
                  <a:lnTo>
                    <a:pt x="622" y="1061"/>
                  </a:lnTo>
                  <a:lnTo>
                    <a:pt x="630" y="1061"/>
                  </a:lnTo>
                  <a:lnTo>
                    <a:pt x="636" y="1061"/>
                  </a:lnTo>
                  <a:lnTo>
                    <a:pt x="644" y="1061"/>
                  </a:lnTo>
                  <a:lnTo>
                    <a:pt x="649" y="1061"/>
                  </a:lnTo>
                  <a:lnTo>
                    <a:pt x="657" y="1061"/>
                  </a:lnTo>
                  <a:lnTo>
                    <a:pt x="663" y="1061"/>
                  </a:lnTo>
                  <a:lnTo>
                    <a:pt x="670" y="1061"/>
                  </a:lnTo>
                  <a:lnTo>
                    <a:pt x="678" y="1061"/>
                  </a:lnTo>
                  <a:lnTo>
                    <a:pt x="684" y="1063"/>
                  </a:lnTo>
                  <a:lnTo>
                    <a:pt x="692" y="1063"/>
                  </a:lnTo>
                  <a:lnTo>
                    <a:pt x="697" y="1063"/>
                  </a:lnTo>
                  <a:lnTo>
                    <a:pt x="705" y="1063"/>
                  </a:lnTo>
                  <a:lnTo>
                    <a:pt x="713" y="1063"/>
                  </a:lnTo>
                  <a:lnTo>
                    <a:pt x="718" y="1065"/>
                  </a:lnTo>
                  <a:lnTo>
                    <a:pt x="726" y="1065"/>
                  </a:lnTo>
                  <a:lnTo>
                    <a:pt x="732" y="1065"/>
                  </a:lnTo>
                  <a:lnTo>
                    <a:pt x="740" y="1065"/>
                  </a:lnTo>
                  <a:lnTo>
                    <a:pt x="747" y="1065"/>
                  </a:lnTo>
                  <a:lnTo>
                    <a:pt x="753" y="1065"/>
                  </a:lnTo>
                  <a:lnTo>
                    <a:pt x="761" y="1065"/>
                  </a:lnTo>
                  <a:lnTo>
                    <a:pt x="766" y="1065"/>
                  </a:lnTo>
                  <a:lnTo>
                    <a:pt x="774" y="1065"/>
                  </a:lnTo>
                  <a:lnTo>
                    <a:pt x="782" y="1065"/>
                  </a:lnTo>
                  <a:lnTo>
                    <a:pt x="788" y="1065"/>
                  </a:lnTo>
                  <a:lnTo>
                    <a:pt x="795" y="1065"/>
                  </a:lnTo>
                  <a:lnTo>
                    <a:pt x="801" y="1065"/>
                  </a:lnTo>
                  <a:lnTo>
                    <a:pt x="809" y="1065"/>
                  </a:lnTo>
                  <a:lnTo>
                    <a:pt x="814" y="1065"/>
                  </a:lnTo>
                  <a:lnTo>
                    <a:pt x="822" y="1065"/>
                  </a:lnTo>
                  <a:lnTo>
                    <a:pt x="830" y="1065"/>
                  </a:lnTo>
                  <a:lnTo>
                    <a:pt x="836" y="1065"/>
                  </a:lnTo>
                  <a:lnTo>
                    <a:pt x="843" y="1065"/>
                  </a:lnTo>
                  <a:lnTo>
                    <a:pt x="849" y="1065"/>
                  </a:lnTo>
                  <a:lnTo>
                    <a:pt x="857" y="1065"/>
                  </a:lnTo>
                  <a:lnTo>
                    <a:pt x="864" y="1065"/>
                  </a:lnTo>
                  <a:lnTo>
                    <a:pt x="870" y="1065"/>
                  </a:lnTo>
                  <a:lnTo>
                    <a:pt x="878" y="1065"/>
                  </a:lnTo>
                  <a:lnTo>
                    <a:pt x="884" y="1065"/>
                  </a:lnTo>
                  <a:lnTo>
                    <a:pt x="891" y="1065"/>
                  </a:lnTo>
                  <a:lnTo>
                    <a:pt x="899" y="1065"/>
                  </a:lnTo>
                  <a:lnTo>
                    <a:pt x="905" y="1067"/>
                  </a:lnTo>
                  <a:lnTo>
                    <a:pt x="912" y="1067"/>
                  </a:lnTo>
                  <a:lnTo>
                    <a:pt x="918" y="1067"/>
                  </a:lnTo>
                  <a:lnTo>
                    <a:pt x="926" y="1067"/>
                  </a:lnTo>
                  <a:lnTo>
                    <a:pt x="932" y="1067"/>
                  </a:lnTo>
                  <a:lnTo>
                    <a:pt x="939" y="1065"/>
                  </a:lnTo>
                  <a:lnTo>
                    <a:pt x="947" y="1065"/>
                  </a:lnTo>
                  <a:lnTo>
                    <a:pt x="953" y="1065"/>
                  </a:lnTo>
                  <a:lnTo>
                    <a:pt x="960" y="1065"/>
                  </a:lnTo>
                  <a:lnTo>
                    <a:pt x="966" y="1065"/>
                  </a:lnTo>
                  <a:lnTo>
                    <a:pt x="974" y="1065"/>
                  </a:lnTo>
                  <a:lnTo>
                    <a:pt x="981" y="1063"/>
                  </a:lnTo>
                  <a:lnTo>
                    <a:pt x="987" y="1063"/>
                  </a:lnTo>
                  <a:lnTo>
                    <a:pt x="995" y="1063"/>
                  </a:lnTo>
                  <a:lnTo>
                    <a:pt x="1001" y="1063"/>
                  </a:lnTo>
                  <a:lnTo>
                    <a:pt x="1008" y="1061"/>
                  </a:lnTo>
                  <a:lnTo>
                    <a:pt x="1016" y="1061"/>
                  </a:lnTo>
                  <a:lnTo>
                    <a:pt x="1022" y="1061"/>
                  </a:lnTo>
                  <a:lnTo>
                    <a:pt x="1029" y="1059"/>
                  </a:lnTo>
                  <a:lnTo>
                    <a:pt x="1035" y="1059"/>
                  </a:lnTo>
                  <a:lnTo>
                    <a:pt x="1043" y="1059"/>
                  </a:lnTo>
                  <a:lnTo>
                    <a:pt x="1049" y="1057"/>
                  </a:lnTo>
                  <a:lnTo>
                    <a:pt x="1056" y="1057"/>
                  </a:lnTo>
                  <a:lnTo>
                    <a:pt x="1064" y="1057"/>
                  </a:lnTo>
                  <a:lnTo>
                    <a:pt x="1070" y="1057"/>
                  </a:lnTo>
                  <a:lnTo>
                    <a:pt x="1078" y="1055"/>
                  </a:lnTo>
                  <a:lnTo>
                    <a:pt x="1083" y="1055"/>
                  </a:lnTo>
                  <a:lnTo>
                    <a:pt x="1091" y="1055"/>
                  </a:lnTo>
                  <a:lnTo>
                    <a:pt x="1099" y="1053"/>
                  </a:lnTo>
                  <a:lnTo>
                    <a:pt x="1104" y="1053"/>
                  </a:lnTo>
                  <a:lnTo>
                    <a:pt x="1112" y="1053"/>
                  </a:lnTo>
                  <a:lnTo>
                    <a:pt x="1118" y="1051"/>
                  </a:lnTo>
                  <a:lnTo>
                    <a:pt x="1126" y="1051"/>
                  </a:lnTo>
                  <a:lnTo>
                    <a:pt x="1133" y="1051"/>
                  </a:lnTo>
                  <a:lnTo>
                    <a:pt x="1139" y="1049"/>
                  </a:lnTo>
                  <a:lnTo>
                    <a:pt x="1147" y="1049"/>
                  </a:lnTo>
                  <a:lnTo>
                    <a:pt x="1152" y="1049"/>
                  </a:lnTo>
                  <a:lnTo>
                    <a:pt x="1160" y="1047"/>
                  </a:lnTo>
                  <a:lnTo>
                    <a:pt x="1168" y="1045"/>
                  </a:lnTo>
                  <a:lnTo>
                    <a:pt x="1174" y="1045"/>
                  </a:lnTo>
                  <a:lnTo>
                    <a:pt x="1181" y="1043"/>
                  </a:lnTo>
                  <a:lnTo>
                    <a:pt x="1187" y="1042"/>
                  </a:lnTo>
                  <a:lnTo>
                    <a:pt x="1195" y="1040"/>
                  </a:lnTo>
                  <a:lnTo>
                    <a:pt x="1200" y="1040"/>
                  </a:lnTo>
                  <a:lnTo>
                    <a:pt x="1208" y="1038"/>
                  </a:lnTo>
                  <a:lnTo>
                    <a:pt x="1216" y="1036"/>
                  </a:lnTo>
                  <a:lnTo>
                    <a:pt x="1222" y="1034"/>
                  </a:lnTo>
                  <a:lnTo>
                    <a:pt x="1229" y="1032"/>
                  </a:lnTo>
                  <a:lnTo>
                    <a:pt x="1235" y="1030"/>
                  </a:lnTo>
                  <a:lnTo>
                    <a:pt x="1243" y="1028"/>
                  </a:lnTo>
                  <a:lnTo>
                    <a:pt x="1250" y="1026"/>
                  </a:lnTo>
                  <a:lnTo>
                    <a:pt x="1256" y="1024"/>
                  </a:lnTo>
                  <a:lnTo>
                    <a:pt x="1264" y="1022"/>
                  </a:lnTo>
                  <a:lnTo>
                    <a:pt x="1270" y="1020"/>
                  </a:lnTo>
                  <a:lnTo>
                    <a:pt x="1277" y="1017"/>
                  </a:lnTo>
                  <a:lnTo>
                    <a:pt x="1285" y="1015"/>
                  </a:lnTo>
                  <a:lnTo>
                    <a:pt x="1291" y="1013"/>
                  </a:lnTo>
                  <a:lnTo>
                    <a:pt x="1298" y="1009"/>
                  </a:lnTo>
                  <a:lnTo>
                    <a:pt x="1304" y="1007"/>
                  </a:lnTo>
                  <a:lnTo>
                    <a:pt x="1312" y="1003"/>
                  </a:lnTo>
                  <a:lnTo>
                    <a:pt x="1318" y="1001"/>
                  </a:lnTo>
                  <a:lnTo>
                    <a:pt x="1325" y="997"/>
                  </a:lnTo>
                  <a:lnTo>
                    <a:pt x="1333" y="996"/>
                  </a:lnTo>
                  <a:lnTo>
                    <a:pt x="1339" y="992"/>
                  </a:lnTo>
                  <a:lnTo>
                    <a:pt x="1346" y="988"/>
                  </a:lnTo>
                  <a:lnTo>
                    <a:pt x="1352" y="986"/>
                  </a:lnTo>
                  <a:lnTo>
                    <a:pt x="1360" y="982"/>
                  </a:lnTo>
                  <a:lnTo>
                    <a:pt x="1367" y="978"/>
                  </a:lnTo>
                  <a:lnTo>
                    <a:pt x="1373" y="976"/>
                  </a:lnTo>
                  <a:lnTo>
                    <a:pt x="1381" y="972"/>
                  </a:lnTo>
                  <a:lnTo>
                    <a:pt x="1387" y="969"/>
                  </a:lnTo>
                  <a:lnTo>
                    <a:pt x="1394" y="967"/>
                  </a:lnTo>
                  <a:lnTo>
                    <a:pt x="1402" y="963"/>
                  </a:lnTo>
                  <a:lnTo>
                    <a:pt x="1408" y="959"/>
                  </a:lnTo>
                  <a:lnTo>
                    <a:pt x="1415" y="957"/>
                  </a:lnTo>
                  <a:lnTo>
                    <a:pt x="1421" y="953"/>
                  </a:lnTo>
                  <a:lnTo>
                    <a:pt x="1429" y="949"/>
                  </a:lnTo>
                  <a:lnTo>
                    <a:pt x="1435" y="948"/>
                  </a:lnTo>
                  <a:lnTo>
                    <a:pt x="1442" y="944"/>
                  </a:lnTo>
                  <a:lnTo>
                    <a:pt x="1450" y="942"/>
                  </a:lnTo>
                  <a:lnTo>
                    <a:pt x="1456" y="938"/>
                  </a:lnTo>
                  <a:lnTo>
                    <a:pt x="1463" y="936"/>
                  </a:lnTo>
                  <a:lnTo>
                    <a:pt x="1469" y="932"/>
                  </a:lnTo>
                  <a:lnTo>
                    <a:pt x="1477" y="930"/>
                  </a:lnTo>
                  <a:lnTo>
                    <a:pt x="1485" y="926"/>
                  </a:lnTo>
                  <a:lnTo>
                    <a:pt x="1490" y="923"/>
                  </a:lnTo>
                  <a:lnTo>
                    <a:pt x="1498" y="921"/>
                  </a:lnTo>
                  <a:lnTo>
                    <a:pt x="1504" y="917"/>
                  </a:lnTo>
                  <a:lnTo>
                    <a:pt x="1511" y="913"/>
                  </a:lnTo>
                  <a:lnTo>
                    <a:pt x="1519" y="909"/>
                  </a:lnTo>
                  <a:lnTo>
                    <a:pt x="1525" y="907"/>
                  </a:lnTo>
                  <a:lnTo>
                    <a:pt x="1533" y="903"/>
                  </a:lnTo>
                  <a:lnTo>
                    <a:pt x="1538" y="900"/>
                  </a:lnTo>
                  <a:lnTo>
                    <a:pt x="1546" y="898"/>
                  </a:lnTo>
                  <a:lnTo>
                    <a:pt x="1554" y="894"/>
                  </a:lnTo>
                  <a:lnTo>
                    <a:pt x="1559" y="890"/>
                  </a:lnTo>
                  <a:lnTo>
                    <a:pt x="1567" y="886"/>
                  </a:lnTo>
                  <a:lnTo>
                    <a:pt x="1573" y="884"/>
                  </a:lnTo>
                  <a:lnTo>
                    <a:pt x="1581" y="882"/>
                  </a:lnTo>
                  <a:lnTo>
                    <a:pt x="1586" y="878"/>
                  </a:lnTo>
                  <a:lnTo>
                    <a:pt x="1594" y="877"/>
                  </a:lnTo>
                  <a:lnTo>
                    <a:pt x="1602" y="875"/>
                  </a:lnTo>
                  <a:lnTo>
                    <a:pt x="1607" y="873"/>
                  </a:lnTo>
                  <a:lnTo>
                    <a:pt x="1615" y="871"/>
                  </a:lnTo>
                  <a:lnTo>
                    <a:pt x="1621" y="869"/>
                  </a:lnTo>
                  <a:lnTo>
                    <a:pt x="1629" y="867"/>
                  </a:lnTo>
                  <a:lnTo>
                    <a:pt x="1636" y="863"/>
                  </a:lnTo>
                  <a:lnTo>
                    <a:pt x="1642" y="861"/>
                  </a:lnTo>
                  <a:lnTo>
                    <a:pt x="1650" y="859"/>
                  </a:lnTo>
                  <a:lnTo>
                    <a:pt x="1655" y="857"/>
                  </a:lnTo>
                  <a:lnTo>
                    <a:pt x="1663" y="855"/>
                  </a:lnTo>
                  <a:lnTo>
                    <a:pt x="1671" y="854"/>
                  </a:lnTo>
                  <a:lnTo>
                    <a:pt x="1677" y="854"/>
                  </a:lnTo>
                  <a:lnTo>
                    <a:pt x="1684" y="852"/>
                  </a:lnTo>
                  <a:lnTo>
                    <a:pt x="1690" y="852"/>
                  </a:lnTo>
                  <a:lnTo>
                    <a:pt x="1698" y="850"/>
                  </a:lnTo>
                  <a:lnTo>
                    <a:pt x="1703" y="850"/>
                  </a:lnTo>
                  <a:lnTo>
                    <a:pt x="1711" y="848"/>
                  </a:lnTo>
                  <a:lnTo>
                    <a:pt x="1719" y="848"/>
                  </a:lnTo>
                  <a:lnTo>
                    <a:pt x="1725" y="846"/>
                  </a:lnTo>
                  <a:lnTo>
                    <a:pt x="1732" y="844"/>
                  </a:lnTo>
                  <a:lnTo>
                    <a:pt x="1738" y="844"/>
                  </a:lnTo>
                  <a:lnTo>
                    <a:pt x="1746" y="842"/>
                  </a:lnTo>
                  <a:lnTo>
                    <a:pt x="1753" y="840"/>
                  </a:lnTo>
                  <a:lnTo>
                    <a:pt x="1759" y="840"/>
                  </a:lnTo>
                  <a:lnTo>
                    <a:pt x="1767" y="838"/>
                  </a:lnTo>
                  <a:lnTo>
                    <a:pt x="1773" y="836"/>
                  </a:lnTo>
                  <a:lnTo>
                    <a:pt x="1780" y="834"/>
                  </a:lnTo>
                  <a:lnTo>
                    <a:pt x="1788" y="832"/>
                  </a:lnTo>
                  <a:lnTo>
                    <a:pt x="1794" y="830"/>
                  </a:lnTo>
                  <a:lnTo>
                    <a:pt x="1801" y="827"/>
                  </a:lnTo>
                  <a:lnTo>
                    <a:pt x="1807" y="821"/>
                  </a:lnTo>
                  <a:lnTo>
                    <a:pt x="1815" y="811"/>
                  </a:lnTo>
                  <a:lnTo>
                    <a:pt x="1823" y="796"/>
                  </a:lnTo>
                  <a:lnTo>
                    <a:pt x="1828" y="777"/>
                  </a:lnTo>
                  <a:lnTo>
                    <a:pt x="1836" y="754"/>
                  </a:lnTo>
                  <a:lnTo>
                    <a:pt x="1842" y="727"/>
                  </a:lnTo>
                  <a:lnTo>
                    <a:pt x="1849" y="698"/>
                  </a:lnTo>
                  <a:lnTo>
                    <a:pt x="1855" y="667"/>
                  </a:lnTo>
                  <a:lnTo>
                    <a:pt x="1863" y="640"/>
                  </a:lnTo>
                  <a:lnTo>
                    <a:pt x="1871" y="617"/>
                  </a:lnTo>
                  <a:lnTo>
                    <a:pt x="1876" y="602"/>
                  </a:lnTo>
                  <a:lnTo>
                    <a:pt x="1884" y="596"/>
                  </a:lnTo>
                  <a:lnTo>
                    <a:pt x="1890" y="598"/>
                  </a:lnTo>
                  <a:lnTo>
                    <a:pt x="1897" y="608"/>
                  </a:lnTo>
                  <a:lnTo>
                    <a:pt x="1905" y="623"/>
                  </a:lnTo>
                  <a:lnTo>
                    <a:pt x="1911" y="644"/>
                  </a:lnTo>
                  <a:lnTo>
                    <a:pt x="1919" y="665"/>
                  </a:lnTo>
                  <a:lnTo>
                    <a:pt x="1924" y="687"/>
                  </a:lnTo>
                  <a:lnTo>
                    <a:pt x="1932" y="708"/>
                  </a:lnTo>
                  <a:lnTo>
                    <a:pt x="1940" y="725"/>
                  </a:lnTo>
                  <a:lnTo>
                    <a:pt x="1945" y="740"/>
                  </a:lnTo>
                  <a:lnTo>
                    <a:pt x="1953" y="754"/>
                  </a:lnTo>
                  <a:lnTo>
                    <a:pt x="1959" y="763"/>
                  </a:lnTo>
                  <a:lnTo>
                    <a:pt x="1967" y="771"/>
                  </a:lnTo>
                  <a:lnTo>
                    <a:pt x="1972" y="777"/>
                  </a:lnTo>
                  <a:lnTo>
                    <a:pt x="1980" y="781"/>
                  </a:lnTo>
                  <a:lnTo>
                    <a:pt x="1988" y="783"/>
                  </a:lnTo>
                  <a:lnTo>
                    <a:pt x="1993" y="783"/>
                  </a:lnTo>
                  <a:lnTo>
                    <a:pt x="2001" y="783"/>
                  </a:lnTo>
                  <a:lnTo>
                    <a:pt x="2007" y="783"/>
                  </a:lnTo>
                  <a:lnTo>
                    <a:pt x="2015" y="784"/>
                  </a:lnTo>
                  <a:lnTo>
                    <a:pt x="2022" y="784"/>
                  </a:lnTo>
                  <a:lnTo>
                    <a:pt x="2028" y="786"/>
                  </a:lnTo>
                  <a:lnTo>
                    <a:pt x="2036" y="786"/>
                  </a:lnTo>
                  <a:lnTo>
                    <a:pt x="2041" y="788"/>
                  </a:lnTo>
                  <a:lnTo>
                    <a:pt x="2049" y="790"/>
                  </a:lnTo>
                  <a:lnTo>
                    <a:pt x="2057" y="792"/>
                  </a:lnTo>
                  <a:lnTo>
                    <a:pt x="2063" y="794"/>
                  </a:lnTo>
                  <a:lnTo>
                    <a:pt x="2070" y="796"/>
                  </a:lnTo>
                  <a:lnTo>
                    <a:pt x="2076" y="796"/>
                  </a:lnTo>
                  <a:lnTo>
                    <a:pt x="2084" y="798"/>
                  </a:lnTo>
                  <a:lnTo>
                    <a:pt x="2089" y="798"/>
                  </a:lnTo>
                  <a:lnTo>
                    <a:pt x="2097" y="798"/>
                  </a:lnTo>
                  <a:lnTo>
                    <a:pt x="2105" y="798"/>
                  </a:lnTo>
                  <a:lnTo>
                    <a:pt x="2111" y="798"/>
                  </a:lnTo>
                  <a:lnTo>
                    <a:pt x="2118" y="798"/>
                  </a:lnTo>
                  <a:lnTo>
                    <a:pt x="2124" y="796"/>
                  </a:lnTo>
                  <a:lnTo>
                    <a:pt x="2132" y="794"/>
                  </a:lnTo>
                  <a:lnTo>
                    <a:pt x="2139" y="792"/>
                  </a:lnTo>
                  <a:lnTo>
                    <a:pt x="2145" y="790"/>
                  </a:lnTo>
                  <a:lnTo>
                    <a:pt x="2153" y="786"/>
                  </a:lnTo>
                  <a:lnTo>
                    <a:pt x="2159" y="786"/>
                  </a:lnTo>
                  <a:lnTo>
                    <a:pt x="2166" y="784"/>
                  </a:lnTo>
                  <a:lnTo>
                    <a:pt x="2174" y="783"/>
                  </a:lnTo>
                  <a:lnTo>
                    <a:pt x="2180" y="783"/>
                  </a:lnTo>
                  <a:lnTo>
                    <a:pt x="2187" y="781"/>
                  </a:lnTo>
                  <a:lnTo>
                    <a:pt x="2193" y="777"/>
                  </a:lnTo>
                  <a:lnTo>
                    <a:pt x="2201" y="771"/>
                  </a:lnTo>
                  <a:lnTo>
                    <a:pt x="2208" y="763"/>
                  </a:lnTo>
                  <a:lnTo>
                    <a:pt x="2214" y="756"/>
                  </a:lnTo>
                  <a:lnTo>
                    <a:pt x="2222" y="750"/>
                  </a:lnTo>
                  <a:lnTo>
                    <a:pt x="2228" y="746"/>
                  </a:lnTo>
                  <a:lnTo>
                    <a:pt x="2235" y="748"/>
                  </a:lnTo>
                  <a:lnTo>
                    <a:pt x="2241" y="752"/>
                  </a:lnTo>
                  <a:lnTo>
                    <a:pt x="2249" y="758"/>
                  </a:lnTo>
                  <a:lnTo>
                    <a:pt x="2256" y="763"/>
                  </a:lnTo>
                  <a:lnTo>
                    <a:pt x="2262" y="767"/>
                  </a:lnTo>
                  <a:lnTo>
                    <a:pt x="2270" y="771"/>
                  </a:lnTo>
                  <a:lnTo>
                    <a:pt x="2276" y="775"/>
                  </a:lnTo>
                  <a:lnTo>
                    <a:pt x="2283" y="779"/>
                  </a:lnTo>
                  <a:lnTo>
                    <a:pt x="2291" y="779"/>
                  </a:lnTo>
                  <a:lnTo>
                    <a:pt x="2297" y="779"/>
                  </a:lnTo>
                  <a:lnTo>
                    <a:pt x="2304" y="779"/>
                  </a:lnTo>
                  <a:lnTo>
                    <a:pt x="2310" y="777"/>
                  </a:lnTo>
                  <a:lnTo>
                    <a:pt x="2318" y="775"/>
                  </a:lnTo>
                  <a:lnTo>
                    <a:pt x="2326" y="773"/>
                  </a:lnTo>
                  <a:lnTo>
                    <a:pt x="2331" y="773"/>
                  </a:lnTo>
                  <a:lnTo>
                    <a:pt x="2339" y="773"/>
                  </a:lnTo>
                  <a:lnTo>
                    <a:pt x="2345" y="773"/>
                  </a:lnTo>
                  <a:lnTo>
                    <a:pt x="2352" y="775"/>
                  </a:lnTo>
                  <a:lnTo>
                    <a:pt x="2358" y="777"/>
                  </a:lnTo>
                  <a:lnTo>
                    <a:pt x="2366" y="777"/>
                  </a:lnTo>
                  <a:lnTo>
                    <a:pt x="2374" y="779"/>
                  </a:lnTo>
                  <a:lnTo>
                    <a:pt x="2379" y="781"/>
                  </a:lnTo>
                  <a:lnTo>
                    <a:pt x="2387" y="783"/>
                  </a:lnTo>
                  <a:lnTo>
                    <a:pt x="2393" y="784"/>
                  </a:lnTo>
                  <a:lnTo>
                    <a:pt x="2400" y="784"/>
                  </a:lnTo>
                  <a:lnTo>
                    <a:pt x="2408" y="786"/>
                  </a:lnTo>
                  <a:lnTo>
                    <a:pt x="2414" y="786"/>
                  </a:lnTo>
                  <a:lnTo>
                    <a:pt x="2422" y="786"/>
                  </a:lnTo>
                  <a:lnTo>
                    <a:pt x="2427" y="786"/>
                  </a:lnTo>
                  <a:lnTo>
                    <a:pt x="2435" y="784"/>
                  </a:lnTo>
                  <a:lnTo>
                    <a:pt x="2443" y="783"/>
                  </a:lnTo>
                  <a:lnTo>
                    <a:pt x="2448" y="777"/>
                  </a:lnTo>
                  <a:lnTo>
                    <a:pt x="2456" y="767"/>
                  </a:lnTo>
                  <a:lnTo>
                    <a:pt x="2462" y="756"/>
                  </a:lnTo>
                  <a:lnTo>
                    <a:pt x="2470" y="742"/>
                  </a:lnTo>
                  <a:lnTo>
                    <a:pt x="2477" y="727"/>
                  </a:lnTo>
                  <a:lnTo>
                    <a:pt x="2483" y="717"/>
                  </a:lnTo>
                  <a:lnTo>
                    <a:pt x="2491" y="713"/>
                  </a:lnTo>
                  <a:lnTo>
                    <a:pt x="2496" y="713"/>
                  </a:lnTo>
                  <a:lnTo>
                    <a:pt x="2504" y="719"/>
                  </a:lnTo>
                  <a:lnTo>
                    <a:pt x="2510" y="725"/>
                  </a:lnTo>
                  <a:lnTo>
                    <a:pt x="2518" y="731"/>
                  </a:lnTo>
                  <a:lnTo>
                    <a:pt x="2525" y="736"/>
                  </a:lnTo>
                  <a:lnTo>
                    <a:pt x="2531" y="742"/>
                  </a:lnTo>
                  <a:lnTo>
                    <a:pt x="2539" y="746"/>
                  </a:lnTo>
                  <a:lnTo>
                    <a:pt x="2544" y="750"/>
                  </a:lnTo>
                  <a:lnTo>
                    <a:pt x="2552" y="754"/>
                  </a:lnTo>
                  <a:lnTo>
                    <a:pt x="2560" y="758"/>
                  </a:lnTo>
                  <a:lnTo>
                    <a:pt x="2566" y="759"/>
                  </a:lnTo>
                  <a:lnTo>
                    <a:pt x="2573" y="763"/>
                  </a:lnTo>
                  <a:lnTo>
                    <a:pt x="2579" y="765"/>
                  </a:lnTo>
                  <a:lnTo>
                    <a:pt x="2587" y="769"/>
                  </a:lnTo>
                  <a:lnTo>
                    <a:pt x="2594" y="771"/>
                  </a:lnTo>
                  <a:lnTo>
                    <a:pt x="2600" y="775"/>
                  </a:lnTo>
                  <a:lnTo>
                    <a:pt x="2608" y="777"/>
                  </a:lnTo>
                  <a:lnTo>
                    <a:pt x="2614" y="777"/>
                  </a:lnTo>
                  <a:lnTo>
                    <a:pt x="2621" y="779"/>
                  </a:lnTo>
                  <a:lnTo>
                    <a:pt x="2627" y="781"/>
                  </a:lnTo>
                  <a:lnTo>
                    <a:pt x="2635" y="783"/>
                  </a:lnTo>
                  <a:lnTo>
                    <a:pt x="2642" y="783"/>
                  </a:lnTo>
                  <a:lnTo>
                    <a:pt x="2648" y="783"/>
                  </a:lnTo>
                  <a:lnTo>
                    <a:pt x="2656" y="784"/>
                  </a:lnTo>
                  <a:lnTo>
                    <a:pt x="2662" y="784"/>
                  </a:lnTo>
                  <a:lnTo>
                    <a:pt x="2669" y="784"/>
                  </a:lnTo>
                  <a:lnTo>
                    <a:pt x="2677" y="784"/>
                  </a:lnTo>
                  <a:lnTo>
                    <a:pt x="2683" y="784"/>
                  </a:lnTo>
                  <a:lnTo>
                    <a:pt x="2690" y="786"/>
                  </a:lnTo>
                  <a:lnTo>
                    <a:pt x="2696" y="786"/>
                  </a:lnTo>
                  <a:lnTo>
                    <a:pt x="2704" y="786"/>
                  </a:lnTo>
                  <a:lnTo>
                    <a:pt x="2712" y="786"/>
                  </a:lnTo>
                  <a:lnTo>
                    <a:pt x="2717" y="786"/>
                  </a:lnTo>
                  <a:lnTo>
                    <a:pt x="2725" y="786"/>
                  </a:lnTo>
                  <a:lnTo>
                    <a:pt x="2731" y="786"/>
                  </a:lnTo>
                  <a:lnTo>
                    <a:pt x="2738" y="786"/>
                  </a:lnTo>
                  <a:lnTo>
                    <a:pt x="2744" y="786"/>
                  </a:lnTo>
                  <a:lnTo>
                    <a:pt x="2752" y="786"/>
                  </a:lnTo>
                  <a:lnTo>
                    <a:pt x="2760" y="784"/>
                  </a:lnTo>
                  <a:lnTo>
                    <a:pt x="2765" y="784"/>
                  </a:lnTo>
                  <a:lnTo>
                    <a:pt x="2773" y="784"/>
                  </a:lnTo>
                  <a:lnTo>
                    <a:pt x="2779" y="784"/>
                  </a:lnTo>
                  <a:lnTo>
                    <a:pt x="2786" y="784"/>
                  </a:lnTo>
                  <a:lnTo>
                    <a:pt x="2794" y="783"/>
                  </a:lnTo>
                  <a:lnTo>
                    <a:pt x="2800" y="783"/>
                  </a:lnTo>
                  <a:lnTo>
                    <a:pt x="2808" y="783"/>
                  </a:lnTo>
                  <a:lnTo>
                    <a:pt x="2813" y="783"/>
                  </a:lnTo>
                  <a:lnTo>
                    <a:pt x="2821" y="783"/>
                  </a:lnTo>
                  <a:lnTo>
                    <a:pt x="2829" y="781"/>
                  </a:lnTo>
                  <a:lnTo>
                    <a:pt x="2834" y="781"/>
                  </a:lnTo>
                  <a:lnTo>
                    <a:pt x="2842" y="781"/>
                  </a:lnTo>
                  <a:lnTo>
                    <a:pt x="2848" y="779"/>
                  </a:lnTo>
                  <a:lnTo>
                    <a:pt x="2856" y="779"/>
                  </a:lnTo>
                  <a:lnTo>
                    <a:pt x="2863" y="779"/>
                  </a:lnTo>
                  <a:lnTo>
                    <a:pt x="2869" y="779"/>
                  </a:lnTo>
                  <a:lnTo>
                    <a:pt x="2877" y="779"/>
                  </a:lnTo>
                  <a:lnTo>
                    <a:pt x="2882" y="779"/>
                  </a:lnTo>
                  <a:lnTo>
                    <a:pt x="2890" y="779"/>
                  </a:lnTo>
                  <a:lnTo>
                    <a:pt x="2896" y="779"/>
                  </a:lnTo>
                  <a:lnTo>
                    <a:pt x="2904" y="779"/>
                  </a:lnTo>
                  <a:lnTo>
                    <a:pt x="2911" y="779"/>
                  </a:lnTo>
                  <a:lnTo>
                    <a:pt x="2917" y="779"/>
                  </a:lnTo>
                  <a:lnTo>
                    <a:pt x="2925" y="779"/>
                  </a:lnTo>
                  <a:lnTo>
                    <a:pt x="2930" y="779"/>
                  </a:lnTo>
                  <a:lnTo>
                    <a:pt x="2938" y="779"/>
                  </a:lnTo>
                  <a:lnTo>
                    <a:pt x="2946" y="777"/>
                  </a:lnTo>
                  <a:lnTo>
                    <a:pt x="2952" y="777"/>
                  </a:lnTo>
                  <a:lnTo>
                    <a:pt x="2959" y="777"/>
                  </a:lnTo>
                  <a:lnTo>
                    <a:pt x="2965" y="777"/>
                  </a:lnTo>
                  <a:lnTo>
                    <a:pt x="2973" y="777"/>
                  </a:lnTo>
                  <a:lnTo>
                    <a:pt x="2980" y="777"/>
                  </a:lnTo>
                  <a:lnTo>
                    <a:pt x="2986" y="777"/>
                  </a:lnTo>
                  <a:lnTo>
                    <a:pt x="2994" y="775"/>
                  </a:lnTo>
                  <a:lnTo>
                    <a:pt x="3000" y="775"/>
                  </a:lnTo>
                  <a:lnTo>
                    <a:pt x="3007" y="773"/>
                  </a:lnTo>
                  <a:lnTo>
                    <a:pt x="3013" y="771"/>
                  </a:lnTo>
                  <a:lnTo>
                    <a:pt x="3021" y="769"/>
                  </a:lnTo>
                  <a:lnTo>
                    <a:pt x="3028" y="767"/>
                  </a:lnTo>
                  <a:lnTo>
                    <a:pt x="3034" y="767"/>
                  </a:lnTo>
                  <a:lnTo>
                    <a:pt x="3042" y="765"/>
                  </a:lnTo>
                  <a:lnTo>
                    <a:pt x="3048" y="765"/>
                  </a:lnTo>
                  <a:lnTo>
                    <a:pt x="3055" y="765"/>
                  </a:lnTo>
                  <a:lnTo>
                    <a:pt x="3063" y="765"/>
                  </a:lnTo>
                  <a:lnTo>
                    <a:pt x="3069" y="767"/>
                  </a:lnTo>
                  <a:lnTo>
                    <a:pt x="3076" y="767"/>
                  </a:lnTo>
                  <a:lnTo>
                    <a:pt x="3082" y="767"/>
                  </a:lnTo>
                  <a:lnTo>
                    <a:pt x="3090" y="767"/>
                  </a:lnTo>
                  <a:lnTo>
                    <a:pt x="3097" y="767"/>
                  </a:lnTo>
                  <a:lnTo>
                    <a:pt x="3103" y="767"/>
                  </a:lnTo>
                  <a:lnTo>
                    <a:pt x="3111" y="767"/>
                  </a:lnTo>
                  <a:lnTo>
                    <a:pt x="3117" y="765"/>
                  </a:lnTo>
                  <a:lnTo>
                    <a:pt x="3124" y="765"/>
                  </a:lnTo>
                  <a:lnTo>
                    <a:pt x="3132" y="761"/>
                  </a:lnTo>
                  <a:lnTo>
                    <a:pt x="3138" y="758"/>
                  </a:lnTo>
                  <a:lnTo>
                    <a:pt x="3145" y="754"/>
                  </a:lnTo>
                  <a:lnTo>
                    <a:pt x="3151" y="748"/>
                  </a:lnTo>
                  <a:lnTo>
                    <a:pt x="3159" y="742"/>
                  </a:lnTo>
                  <a:lnTo>
                    <a:pt x="3165" y="738"/>
                  </a:lnTo>
                  <a:lnTo>
                    <a:pt x="3172" y="736"/>
                  </a:lnTo>
                  <a:lnTo>
                    <a:pt x="3180" y="735"/>
                  </a:lnTo>
                  <a:lnTo>
                    <a:pt x="3186" y="736"/>
                  </a:lnTo>
                  <a:lnTo>
                    <a:pt x="3193" y="738"/>
                  </a:lnTo>
                  <a:lnTo>
                    <a:pt x="3199" y="742"/>
                  </a:lnTo>
                  <a:lnTo>
                    <a:pt x="3207" y="744"/>
                  </a:lnTo>
                  <a:lnTo>
                    <a:pt x="3215" y="746"/>
                  </a:lnTo>
                  <a:lnTo>
                    <a:pt x="3220" y="748"/>
                  </a:lnTo>
                  <a:lnTo>
                    <a:pt x="3228" y="748"/>
                  </a:lnTo>
                  <a:lnTo>
                    <a:pt x="3234" y="748"/>
                  </a:lnTo>
                  <a:lnTo>
                    <a:pt x="3241" y="750"/>
                  </a:lnTo>
                  <a:lnTo>
                    <a:pt x="3249" y="750"/>
                  </a:lnTo>
                  <a:lnTo>
                    <a:pt x="3255" y="750"/>
                  </a:lnTo>
                  <a:lnTo>
                    <a:pt x="3263" y="752"/>
                  </a:lnTo>
                  <a:lnTo>
                    <a:pt x="3268" y="754"/>
                  </a:lnTo>
                  <a:lnTo>
                    <a:pt x="3276" y="754"/>
                  </a:lnTo>
                  <a:lnTo>
                    <a:pt x="3282" y="756"/>
                  </a:lnTo>
                  <a:lnTo>
                    <a:pt x="3289" y="758"/>
                  </a:lnTo>
                  <a:lnTo>
                    <a:pt x="3297" y="758"/>
                  </a:lnTo>
                  <a:lnTo>
                    <a:pt x="3303" y="758"/>
                  </a:lnTo>
                  <a:lnTo>
                    <a:pt x="3311" y="759"/>
                  </a:lnTo>
                  <a:lnTo>
                    <a:pt x="3316" y="759"/>
                  </a:lnTo>
                  <a:lnTo>
                    <a:pt x="3324" y="759"/>
                  </a:lnTo>
                  <a:lnTo>
                    <a:pt x="3332" y="759"/>
                  </a:lnTo>
                  <a:lnTo>
                    <a:pt x="3337" y="759"/>
                  </a:lnTo>
                  <a:lnTo>
                    <a:pt x="3345" y="761"/>
                  </a:lnTo>
                  <a:lnTo>
                    <a:pt x="3351" y="761"/>
                  </a:lnTo>
                  <a:lnTo>
                    <a:pt x="3359" y="761"/>
                  </a:lnTo>
                  <a:lnTo>
                    <a:pt x="3366" y="761"/>
                  </a:lnTo>
                  <a:lnTo>
                    <a:pt x="3372" y="761"/>
                  </a:lnTo>
                  <a:lnTo>
                    <a:pt x="3380" y="761"/>
                  </a:lnTo>
                  <a:lnTo>
                    <a:pt x="3385" y="761"/>
                  </a:lnTo>
                  <a:lnTo>
                    <a:pt x="3393" y="761"/>
                  </a:lnTo>
                  <a:lnTo>
                    <a:pt x="3399" y="761"/>
                  </a:lnTo>
                  <a:lnTo>
                    <a:pt x="3407" y="761"/>
                  </a:lnTo>
                  <a:lnTo>
                    <a:pt x="3414" y="761"/>
                  </a:lnTo>
                  <a:lnTo>
                    <a:pt x="3420" y="761"/>
                  </a:lnTo>
                  <a:lnTo>
                    <a:pt x="3428" y="759"/>
                  </a:lnTo>
                  <a:lnTo>
                    <a:pt x="3433" y="759"/>
                  </a:lnTo>
                  <a:lnTo>
                    <a:pt x="3441" y="759"/>
                  </a:lnTo>
                  <a:lnTo>
                    <a:pt x="3449" y="759"/>
                  </a:lnTo>
                  <a:lnTo>
                    <a:pt x="3455" y="758"/>
                  </a:lnTo>
                  <a:lnTo>
                    <a:pt x="3462" y="758"/>
                  </a:lnTo>
                  <a:lnTo>
                    <a:pt x="3468" y="756"/>
                  </a:lnTo>
                  <a:lnTo>
                    <a:pt x="3476" y="754"/>
                  </a:lnTo>
                  <a:lnTo>
                    <a:pt x="3483" y="754"/>
                  </a:lnTo>
                  <a:lnTo>
                    <a:pt x="3489" y="752"/>
                  </a:lnTo>
                  <a:lnTo>
                    <a:pt x="3497" y="750"/>
                  </a:lnTo>
                  <a:lnTo>
                    <a:pt x="3503" y="750"/>
                  </a:lnTo>
                  <a:lnTo>
                    <a:pt x="3510" y="748"/>
                  </a:lnTo>
                  <a:lnTo>
                    <a:pt x="3518" y="748"/>
                  </a:lnTo>
                  <a:lnTo>
                    <a:pt x="3524" y="748"/>
                  </a:lnTo>
                  <a:lnTo>
                    <a:pt x="3531" y="748"/>
                  </a:lnTo>
                  <a:lnTo>
                    <a:pt x="3537" y="748"/>
                  </a:lnTo>
                  <a:lnTo>
                    <a:pt x="3545" y="748"/>
                  </a:lnTo>
                  <a:lnTo>
                    <a:pt x="3551" y="748"/>
                  </a:lnTo>
                  <a:lnTo>
                    <a:pt x="3558" y="748"/>
                  </a:lnTo>
                  <a:lnTo>
                    <a:pt x="3566" y="748"/>
                  </a:lnTo>
                  <a:lnTo>
                    <a:pt x="3572" y="746"/>
                  </a:lnTo>
                  <a:lnTo>
                    <a:pt x="3579" y="744"/>
                  </a:lnTo>
                  <a:lnTo>
                    <a:pt x="3585" y="742"/>
                  </a:lnTo>
                  <a:lnTo>
                    <a:pt x="3593" y="738"/>
                  </a:lnTo>
                  <a:lnTo>
                    <a:pt x="3601" y="738"/>
                  </a:lnTo>
                  <a:lnTo>
                    <a:pt x="3606" y="736"/>
                  </a:lnTo>
                  <a:lnTo>
                    <a:pt x="3614" y="736"/>
                  </a:lnTo>
                  <a:lnTo>
                    <a:pt x="3620" y="738"/>
                  </a:lnTo>
                  <a:lnTo>
                    <a:pt x="3627" y="738"/>
                  </a:lnTo>
                  <a:lnTo>
                    <a:pt x="3635" y="740"/>
                  </a:lnTo>
                  <a:lnTo>
                    <a:pt x="3641" y="740"/>
                  </a:lnTo>
                  <a:lnTo>
                    <a:pt x="3649" y="740"/>
                  </a:lnTo>
                  <a:lnTo>
                    <a:pt x="3654" y="742"/>
                  </a:lnTo>
                  <a:lnTo>
                    <a:pt x="3662" y="742"/>
                  </a:lnTo>
                  <a:lnTo>
                    <a:pt x="3668" y="744"/>
                  </a:lnTo>
                  <a:lnTo>
                    <a:pt x="3675" y="744"/>
                  </a:lnTo>
                  <a:lnTo>
                    <a:pt x="3683" y="744"/>
                  </a:lnTo>
                  <a:lnTo>
                    <a:pt x="3689" y="746"/>
                  </a:lnTo>
                  <a:lnTo>
                    <a:pt x="3697" y="746"/>
                  </a:lnTo>
                  <a:lnTo>
                    <a:pt x="3702" y="746"/>
                  </a:lnTo>
                  <a:lnTo>
                    <a:pt x="3710" y="746"/>
                  </a:lnTo>
                  <a:lnTo>
                    <a:pt x="3718" y="746"/>
                  </a:lnTo>
                  <a:lnTo>
                    <a:pt x="3723" y="746"/>
                  </a:lnTo>
                  <a:lnTo>
                    <a:pt x="3731" y="744"/>
                  </a:lnTo>
                  <a:lnTo>
                    <a:pt x="3737" y="744"/>
                  </a:lnTo>
                  <a:lnTo>
                    <a:pt x="3745" y="744"/>
                  </a:lnTo>
                  <a:lnTo>
                    <a:pt x="3752" y="744"/>
                  </a:lnTo>
                  <a:lnTo>
                    <a:pt x="3758" y="742"/>
                  </a:lnTo>
                  <a:lnTo>
                    <a:pt x="3766" y="742"/>
                  </a:lnTo>
                  <a:lnTo>
                    <a:pt x="3771" y="740"/>
                  </a:lnTo>
                  <a:lnTo>
                    <a:pt x="3779" y="738"/>
                  </a:lnTo>
                  <a:lnTo>
                    <a:pt x="3785" y="735"/>
                  </a:lnTo>
                  <a:lnTo>
                    <a:pt x="3793" y="729"/>
                  </a:lnTo>
                  <a:lnTo>
                    <a:pt x="3800" y="719"/>
                  </a:lnTo>
                  <a:lnTo>
                    <a:pt x="3806" y="708"/>
                  </a:lnTo>
                  <a:lnTo>
                    <a:pt x="3814" y="692"/>
                  </a:lnTo>
                  <a:lnTo>
                    <a:pt x="3819" y="673"/>
                  </a:lnTo>
                  <a:lnTo>
                    <a:pt x="3827" y="652"/>
                  </a:lnTo>
                  <a:lnTo>
                    <a:pt x="3835" y="631"/>
                  </a:lnTo>
                  <a:lnTo>
                    <a:pt x="3841" y="612"/>
                  </a:lnTo>
                  <a:lnTo>
                    <a:pt x="3848" y="596"/>
                  </a:lnTo>
                  <a:lnTo>
                    <a:pt x="3854" y="589"/>
                  </a:lnTo>
                  <a:lnTo>
                    <a:pt x="3862" y="585"/>
                  </a:lnTo>
                  <a:lnTo>
                    <a:pt x="3869" y="589"/>
                  </a:lnTo>
                  <a:lnTo>
                    <a:pt x="3875" y="596"/>
                  </a:lnTo>
                  <a:lnTo>
                    <a:pt x="3883" y="606"/>
                  </a:lnTo>
                  <a:lnTo>
                    <a:pt x="3889" y="617"/>
                  </a:lnTo>
                  <a:lnTo>
                    <a:pt x="3896" y="631"/>
                  </a:lnTo>
                  <a:lnTo>
                    <a:pt x="3904" y="644"/>
                  </a:lnTo>
                  <a:lnTo>
                    <a:pt x="3910" y="660"/>
                  </a:lnTo>
                  <a:lnTo>
                    <a:pt x="3917" y="673"/>
                  </a:lnTo>
                  <a:lnTo>
                    <a:pt x="3923" y="685"/>
                  </a:lnTo>
                  <a:lnTo>
                    <a:pt x="3931" y="696"/>
                  </a:lnTo>
                  <a:lnTo>
                    <a:pt x="3937" y="704"/>
                  </a:lnTo>
                  <a:lnTo>
                    <a:pt x="3944" y="711"/>
                  </a:lnTo>
                  <a:lnTo>
                    <a:pt x="3952" y="717"/>
                  </a:lnTo>
                  <a:lnTo>
                    <a:pt x="3958" y="721"/>
                  </a:lnTo>
                  <a:lnTo>
                    <a:pt x="3965" y="725"/>
                  </a:lnTo>
                  <a:lnTo>
                    <a:pt x="3971" y="727"/>
                  </a:lnTo>
                  <a:lnTo>
                    <a:pt x="3979" y="729"/>
                  </a:lnTo>
                  <a:lnTo>
                    <a:pt x="3986" y="731"/>
                  </a:lnTo>
                  <a:lnTo>
                    <a:pt x="3992" y="731"/>
                  </a:lnTo>
                  <a:lnTo>
                    <a:pt x="4000" y="733"/>
                  </a:lnTo>
                  <a:lnTo>
                    <a:pt x="4006" y="733"/>
                  </a:lnTo>
                  <a:lnTo>
                    <a:pt x="4013" y="733"/>
                  </a:lnTo>
                  <a:lnTo>
                    <a:pt x="4021" y="733"/>
                  </a:lnTo>
                  <a:lnTo>
                    <a:pt x="4027" y="733"/>
                  </a:lnTo>
                  <a:lnTo>
                    <a:pt x="4034" y="733"/>
                  </a:lnTo>
                  <a:lnTo>
                    <a:pt x="4040" y="731"/>
                  </a:lnTo>
                  <a:lnTo>
                    <a:pt x="4048" y="729"/>
                  </a:lnTo>
                  <a:lnTo>
                    <a:pt x="4054" y="727"/>
                  </a:lnTo>
                  <a:lnTo>
                    <a:pt x="4061" y="725"/>
                  </a:lnTo>
                  <a:lnTo>
                    <a:pt x="4069" y="721"/>
                  </a:lnTo>
                  <a:lnTo>
                    <a:pt x="4075" y="717"/>
                  </a:lnTo>
                  <a:lnTo>
                    <a:pt x="4082" y="711"/>
                  </a:lnTo>
                  <a:lnTo>
                    <a:pt x="4088" y="704"/>
                  </a:lnTo>
                  <a:lnTo>
                    <a:pt x="4096" y="692"/>
                  </a:lnTo>
                  <a:lnTo>
                    <a:pt x="4104" y="675"/>
                  </a:lnTo>
                  <a:lnTo>
                    <a:pt x="4109" y="654"/>
                  </a:lnTo>
                  <a:lnTo>
                    <a:pt x="4117" y="631"/>
                  </a:lnTo>
                  <a:lnTo>
                    <a:pt x="4123" y="606"/>
                  </a:lnTo>
                  <a:lnTo>
                    <a:pt x="4130" y="589"/>
                  </a:lnTo>
                  <a:lnTo>
                    <a:pt x="4138" y="579"/>
                  </a:lnTo>
                  <a:lnTo>
                    <a:pt x="4144" y="579"/>
                  </a:lnTo>
                  <a:lnTo>
                    <a:pt x="4152" y="589"/>
                  </a:lnTo>
                  <a:lnTo>
                    <a:pt x="4157" y="600"/>
                  </a:lnTo>
                  <a:lnTo>
                    <a:pt x="4165" y="614"/>
                  </a:lnTo>
                  <a:lnTo>
                    <a:pt x="4173" y="625"/>
                  </a:lnTo>
                  <a:lnTo>
                    <a:pt x="4178" y="633"/>
                  </a:lnTo>
                  <a:lnTo>
                    <a:pt x="4186" y="633"/>
                  </a:lnTo>
                  <a:lnTo>
                    <a:pt x="4192" y="625"/>
                  </a:lnTo>
                  <a:lnTo>
                    <a:pt x="4200" y="610"/>
                  </a:lnTo>
                  <a:lnTo>
                    <a:pt x="4205" y="593"/>
                  </a:lnTo>
                  <a:lnTo>
                    <a:pt x="4213" y="577"/>
                  </a:lnTo>
                  <a:lnTo>
                    <a:pt x="4221" y="566"/>
                  </a:lnTo>
                  <a:lnTo>
                    <a:pt x="4226" y="566"/>
                  </a:lnTo>
                  <a:lnTo>
                    <a:pt x="4234" y="571"/>
                  </a:lnTo>
                  <a:lnTo>
                    <a:pt x="4240" y="585"/>
                  </a:lnTo>
                  <a:lnTo>
                    <a:pt x="4248" y="600"/>
                  </a:lnTo>
                  <a:lnTo>
                    <a:pt x="4255" y="616"/>
                  </a:lnTo>
                  <a:lnTo>
                    <a:pt x="4261" y="631"/>
                  </a:lnTo>
                  <a:lnTo>
                    <a:pt x="4269" y="640"/>
                  </a:lnTo>
                  <a:lnTo>
                    <a:pt x="4275" y="650"/>
                  </a:lnTo>
                  <a:lnTo>
                    <a:pt x="4282" y="656"/>
                  </a:lnTo>
                  <a:lnTo>
                    <a:pt x="4290" y="660"/>
                  </a:lnTo>
                  <a:lnTo>
                    <a:pt x="4296" y="660"/>
                  </a:lnTo>
                  <a:lnTo>
                    <a:pt x="4303" y="660"/>
                  </a:lnTo>
                  <a:lnTo>
                    <a:pt x="4309" y="656"/>
                  </a:lnTo>
                  <a:lnTo>
                    <a:pt x="4317" y="652"/>
                  </a:lnTo>
                  <a:lnTo>
                    <a:pt x="4323" y="646"/>
                  </a:lnTo>
                  <a:lnTo>
                    <a:pt x="4330" y="639"/>
                  </a:lnTo>
                  <a:lnTo>
                    <a:pt x="4338" y="629"/>
                  </a:lnTo>
                  <a:lnTo>
                    <a:pt x="4344" y="617"/>
                  </a:lnTo>
                  <a:lnTo>
                    <a:pt x="4351" y="602"/>
                  </a:lnTo>
                  <a:lnTo>
                    <a:pt x="4357" y="585"/>
                  </a:lnTo>
                  <a:lnTo>
                    <a:pt x="4365" y="566"/>
                  </a:lnTo>
                  <a:lnTo>
                    <a:pt x="4372" y="546"/>
                  </a:lnTo>
                  <a:lnTo>
                    <a:pt x="4378" y="525"/>
                  </a:lnTo>
                  <a:lnTo>
                    <a:pt x="4386" y="504"/>
                  </a:lnTo>
                  <a:lnTo>
                    <a:pt x="4392" y="481"/>
                  </a:lnTo>
                  <a:lnTo>
                    <a:pt x="4399" y="458"/>
                  </a:lnTo>
                  <a:lnTo>
                    <a:pt x="4407" y="431"/>
                  </a:lnTo>
                  <a:lnTo>
                    <a:pt x="4413" y="397"/>
                  </a:lnTo>
                  <a:lnTo>
                    <a:pt x="4420" y="358"/>
                  </a:lnTo>
                  <a:lnTo>
                    <a:pt x="4426" y="318"/>
                  </a:lnTo>
                  <a:lnTo>
                    <a:pt x="4434" y="285"/>
                  </a:lnTo>
                  <a:lnTo>
                    <a:pt x="4440" y="272"/>
                  </a:lnTo>
                  <a:lnTo>
                    <a:pt x="4447" y="282"/>
                  </a:lnTo>
                  <a:lnTo>
                    <a:pt x="4455" y="310"/>
                  </a:lnTo>
                  <a:lnTo>
                    <a:pt x="4461" y="353"/>
                  </a:lnTo>
                  <a:lnTo>
                    <a:pt x="4468" y="397"/>
                  </a:lnTo>
                  <a:lnTo>
                    <a:pt x="4474" y="439"/>
                  </a:lnTo>
                  <a:lnTo>
                    <a:pt x="4482" y="474"/>
                  </a:lnTo>
                  <a:lnTo>
                    <a:pt x="4490" y="498"/>
                  </a:lnTo>
                  <a:lnTo>
                    <a:pt x="4495" y="520"/>
                  </a:lnTo>
                  <a:lnTo>
                    <a:pt x="4503" y="535"/>
                  </a:lnTo>
                  <a:lnTo>
                    <a:pt x="4509" y="546"/>
                  </a:lnTo>
                  <a:lnTo>
                    <a:pt x="4516" y="560"/>
                  </a:lnTo>
                  <a:lnTo>
                    <a:pt x="4524" y="571"/>
                  </a:lnTo>
                  <a:lnTo>
                    <a:pt x="4530" y="579"/>
                  </a:lnTo>
                  <a:lnTo>
                    <a:pt x="4538" y="583"/>
                  </a:lnTo>
                  <a:lnTo>
                    <a:pt x="4543" y="583"/>
                  </a:lnTo>
                  <a:lnTo>
                    <a:pt x="4551" y="575"/>
                  </a:lnTo>
                  <a:lnTo>
                    <a:pt x="4559" y="568"/>
                  </a:lnTo>
                  <a:lnTo>
                    <a:pt x="4564" y="562"/>
                  </a:lnTo>
                  <a:lnTo>
                    <a:pt x="4572" y="558"/>
                  </a:lnTo>
                  <a:lnTo>
                    <a:pt x="4578" y="562"/>
                  </a:lnTo>
                  <a:lnTo>
                    <a:pt x="4586" y="569"/>
                  </a:lnTo>
                  <a:lnTo>
                    <a:pt x="4591" y="579"/>
                  </a:lnTo>
                  <a:lnTo>
                    <a:pt x="4599" y="585"/>
                  </a:lnTo>
                  <a:lnTo>
                    <a:pt x="4607" y="591"/>
                  </a:lnTo>
                  <a:lnTo>
                    <a:pt x="4612" y="594"/>
                  </a:lnTo>
                  <a:lnTo>
                    <a:pt x="4620" y="596"/>
                  </a:lnTo>
                  <a:lnTo>
                    <a:pt x="4626" y="598"/>
                  </a:lnTo>
                  <a:lnTo>
                    <a:pt x="4634" y="598"/>
                  </a:lnTo>
                  <a:lnTo>
                    <a:pt x="4641" y="598"/>
                  </a:lnTo>
                  <a:lnTo>
                    <a:pt x="4647" y="600"/>
                  </a:lnTo>
                  <a:lnTo>
                    <a:pt x="4655" y="604"/>
                  </a:lnTo>
                  <a:lnTo>
                    <a:pt x="4660" y="610"/>
                  </a:lnTo>
                  <a:lnTo>
                    <a:pt x="4668" y="616"/>
                  </a:lnTo>
                  <a:lnTo>
                    <a:pt x="4676" y="623"/>
                  </a:lnTo>
                  <a:lnTo>
                    <a:pt x="4682" y="629"/>
                  </a:lnTo>
                  <a:lnTo>
                    <a:pt x="4689" y="635"/>
                  </a:lnTo>
                  <a:lnTo>
                    <a:pt x="4695" y="640"/>
                  </a:lnTo>
                  <a:lnTo>
                    <a:pt x="4703" y="644"/>
                  </a:lnTo>
                  <a:lnTo>
                    <a:pt x="4708" y="646"/>
                  </a:lnTo>
                  <a:lnTo>
                    <a:pt x="4716" y="648"/>
                  </a:lnTo>
                  <a:lnTo>
                    <a:pt x="4724" y="646"/>
                  </a:lnTo>
                  <a:lnTo>
                    <a:pt x="4730" y="644"/>
                  </a:lnTo>
                  <a:lnTo>
                    <a:pt x="4737" y="639"/>
                  </a:lnTo>
                  <a:lnTo>
                    <a:pt x="4743" y="627"/>
                  </a:lnTo>
                  <a:lnTo>
                    <a:pt x="4751" y="614"/>
                  </a:lnTo>
                  <a:lnTo>
                    <a:pt x="4758" y="596"/>
                  </a:lnTo>
                  <a:lnTo>
                    <a:pt x="4764" y="581"/>
                  </a:lnTo>
                  <a:lnTo>
                    <a:pt x="4772" y="568"/>
                  </a:lnTo>
                  <a:lnTo>
                    <a:pt x="4778" y="562"/>
                  </a:lnTo>
                  <a:lnTo>
                    <a:pt x="4785" y="562"/>
                  </a:lnTo>
                  <a:lnTo>
                    <a:pt x="4793" y="566"/>
                  </a:lnTo>
                  <a:lnTo>
                    <a:pt x="4799" y="575"/>
                  </a:lnTo>
                  <a:lnTo>
                    <a:pt x="4806" y="585"/>
                  </a:lnTo>
                  <a:lnTo>
                    <a:pt x="4812" y="596"/>
                  </a:lnTo>
                  <a:lnTo>
                    <a:pt x="4820" y="606"/>
                  </a:lnTo>
                  <a:lnTo>
                    <a:pt x="4827" y="614"/>
                  </a:lnTo>
                  <a:lnTo>
                    <a:pt x="4833" y="621"/>
                  </a:lnTo>
                  <a:lnTo>
                    <a:pt x="4841" y="627"/>
                  </a:lnTo>
                  <a:lnTo>
                    <a:pt x="4847" y="633"/>
                  </a:lnTo>
                  <a:lnTo>
                    <a:pt x="4854" y="637"/>
                  </a:lnTo>
                  <a:lnTo>
                    <a:pt x="4860" y="640"/>
                  </a:lnTo>
                  <a:lnTo>
                    <a:pt x="4868" y="642"/>
                  </a:lnTo>
                  <a:lnTo>
                    <a:pt x="4875" y="642"/>
                  </a:lnTo>
                  <a:lnTo>
                    <a:pt x="4881" y="642"/>
                  </a:lnTo>
                  <a:lnTo>
                    <a:pt x="4889" y="640"/>
                  </a:lnTo>
                  <a:lnTo>
                    <a:pt x="4895" y="637"/>
                  </a:lnTo>
                  <a:lnTo>
                    <a:pt x="4902" y="633"/>
                  </a:lnTo>
                  <a:lnTo>
                    <a:pt x="4910" y="629"/>
                  </a:lnTo>
                  <a:lnTo>
                    <a:pt x="4916" y="625"/>
                  </a:lnTo>
                  <a:lnTo>
                    <a:pt x="4924" y="623"/>
                  </a:lnTo>
                  <a:lnTo>
                    <a:pt x="4929" y="623"/>
                  </a:lnTo>
                  <a:lnTo>
                    <a:pt x="4937" y="623"/>
                  </a:lnTo>
                  <a:lnTo>
                    <a:pt x="4945" y="625"/>
                  </a:lnTo>
                  <a:lnTo>
                    <a:pt x="4950" y="627"/>
                  </a:lnTo>
                  <a:lnTo>
                    <a:pt x="4958" y="627"/>
                  </a:lnTo>
                  <a:lnTo>
                    <a:pt x="4964" y="629"/>
                  </a:lnTo>
                  <a:lnTo>
                    <a:pt x="4972" y="631"/>
                  </a:lnTo>
                  <a:lnTo>
                    <a:pt x="4977" y="631"/>
                  </a:lnTo>
                  <a:lnTo>
                    <a:pt x="4985" y="631"/>
                  </a:lnTo>
                  <a:lnTo>
                    <a:pt x="4993" y="633"/>
                  </a:lnTo>
                  <a:lnTo>
                    <a:pt x="4998" y="631"/>
                  </a:lnTo>
                  <a:lnTo>
                    <a:pt x="5006" y="631"/>
                  </a:lnTo>
                  <a:lnTo>
                    <a:pt x="5012" y="629"/>
                  </a:lnTo>
                  <a:lnTo>
                    <a:pt x="5020" y="627"/>
                  </a:lnTo>
                  <a:lnTo>
                    <a:pt x="5027" y="627"/>
                  </a:lnTo>
                  <a:lnTo>
                    <a:pt x="5033" y="627"/>
                  </a:lnTo>
                  <a:lnTo>
                    <a:pt x="5041" y="625"/>
                  </a:lnTo>
                  <a:lnTo>
                    <a:pt x="5046" y="625"/>
                  </a:lnTo>
                  <a:lnTo>
                    <a:pt x="5054" y="623"/>
                  </a:lnTo>
                  <a:lnTo>
                    <a:pt x="5062" y="621"/>
                  </a:lnTo>
                  <a:lnTo>
                    <a:pt x="5068" y="617"/>
                  </a:lnTo>
                  <a:lnTo>
                    <a:pt x="5075" y="614"/>
                  </a:lnTo>
                  <a:lnTo>
                    <a:pt x="5081" y="608"/>
                  </a:lnTo>
                  <a:lnTo>
                    <a:pt x="5089" y="600"/>
                  </a:lnTo>
                  <a:lnTo>
                    <a:pt x="5094" y="593"/>
                  </a:lnTo>
                  <a:lnTo>
                    <a:pt x="5102" y="583"/>
                  </a:lnTo>
                  <a:lnTo>
                    <a:pt x="5110" y="575"/>
                  </a:lnTo>
                  <a:lnTo>
                    <a:pt x="5116" y="569"/>
                  </a:lnTo>
                  <a:lnTo>
                    <a:pt x="5123" y="566"/>
                  </a:lnTo>
                  <a:lnTo>
                    <a:pt x="5129" y="566"/>
                  </a:lnTo>
                  <a:lnTo>
                    <a:pt x="5137" y="568"/>
                  </a:lnTo>
                  <a:lnTo>
                    <a:pt x="5144" y="571"/>
                  </a:lnTo>
                  <a:lnTo>
                    <a:pt x="5150" y="577"/>
                  </a:lnTo>
                  <a:lnTo>
                    <a:pt x="5158" y="581"/>
                  </a:lnTo>
                  <a:lnTo>
                    <a:pt x="5164" y="585"/>
                  </a:lnTo>
                  <a:lnTo>
                    <a:pt x="5171" y="587"/>
                  </a:lnTo>
                  <a:lnTo>
                    <a:pt x="5179" y="587"/>
                  </a:lnTo>
                  <a:lnTo>
                    <a:pt x="5185" y="587"/>
                  </a:lnTo>
                  <a:lnTo>
                    <a:pt x="5192" y="587"/>
                  </a:lnTo>
                  <a:lnTo>
                    <a:pt x="5198" y="585"/>
                  </a:lnTo>
                  <a:lnTo>
                    <a:pt x="5206" y="583"/>
                  </a:lnTo>
                  <a:lnTo>
                    <a:pt x="5213" y="581"/>
                  </a:lnTo>
                  <a:lnTo>
                    <a:pt x="5219" y="581"/>
                  </a:lnTo>
                  <a:lnTo>
                    <a:pt x="5227" y="581"/>
                  </a:lnTo>
                  <a:lnTo>
                    <a:pt x="5233" y="581"/>
                  </a:lnTo>
                  <a:lnTo>
                    <a:pt x="5240" y="583"/>
                  </a:lnTo>
                  <a:lnTo>
                    <a:pt x="5246" y="585"/>
                  </a:lnTo>
                  <a:lnTo>
                    <a:pt x="5254" y="589"/>
                  </a:lnTo>
                  <a:lnTo>
                    <a:pt x="5261" y="589"/>
                  </a:lnTo>
                  <a:lnTo>
                    <a:pt x="5267" y="589"/>
                  </a:lnTo>
                  <a:lnTo>
                    <a:pt x="5275" y="589"/>
                  </a:lnTo>
                  <a:lnTo>
                    <a:pt x="5281" y="587"/>
                  </a:lnTo>
                  <a:lnTo>
                    <a:pt x="5288" y="585"/>
                  </a:lnTo>
                  <a:lnTo>
                    <a:pt x="5296" y="581"/>
                  </a:lnTo>
                  <a:lnTo>
                    <a:pt x="5302" y="579"/>
                  </a:lnTo>
                  <a:lnTo>
                    <a:pt x="5309" y="577"/>
                  </a:lnTo>
                  <a:lnTo>
                    <a:pt x="5315" y="577"/>
                  </a:lnTo>
                  <a:lnTo>
                    <a:pt x="5323" y="577"/>
                  </a:lnTo>
                  <a:lnTo>
                    <a:pt x="5331" y="579"/>
                  </a:lnTo>
                  <a:lnTo>
                    <a:pt x="5336" y="581"/>
                  </a:lnTo>
                  <a:lnTo>
                    <a:pt x="5344" y="583"/>
                  </a:lnTo>
                  <a:lnTo>
                    <a:pt x="5350" y="585"/>
                  </a:lnTo>
                  <a:lnTo>
                    <a:pt x="5357" y="587"/>
                  </a:lnTo>
                  <a:lnTo>
                    <a:pt x="5363" y="589"/>
                  </a:lnTo>
                  <a:lnTo>
                    <a:pt x="5371" y="591"/>
                  </a:lnTo>
                  <a:lnTo>
                    <a:pt x="5379" y="591"/>
                  </a:lnTo>
                  <a:lnTo>
                    <a:pt x="5384" y="593"/>
                  </a:lnTo>
                  <a:lnTo>
                    <a:pt x="5392" y="594"/>
                  </a:lnTo>
                  <a:lnTo>
                    <a:pt x="5398" y="594"/>
                  </a:lnTo>
                  <a:lnTo>
                    <a:pt x="5405" y="594"/>
                  </a:lnTo>
                  <a:lnTo>
                    <a:pt x="5413" y="594"/>
                  </a:lnTo>
                  <a:lnTo>
                    <a:pt x="5419" y="594"/>
                  </a:lnTo>
                  <a:lnTo>
                    <a:pt x="5427" y="594"/>
                  </a:lnTo>
                  <a:lnTo>
                    <a:pt x="5432" y="593"/>
                  </a:lnTo>
                  <a:lnTo>
                    <a:pt x="5440" y="593"/>
                  </a:lnTo>
                  <a:lnTo>
                    <a:pt x="5448" y="593"/>
                  </a:lnTo>
                  <a:lnTo>
                    <a:pt x="5453" y="593"/>
                  </a:lnTo>
                  <a:lnTo>
                    <a:pt x="5461" y="593"/>
                  </a:lnTo>
                  <a:lnTo>
                    <a:pt x="5467" y="593"/>
                  </a:lnTo>
                  <a:lnTo>
                    <a:pt x="5475" y="593"/>
                  </a:lnTo>
                  <a:lnTo>
                    <a:pt x="5480" y="593"/>
                  </a:lnTo>
                  <a:lnTo>
                    <a:pt x="5488" y="591"/>
                  </a:lnTo>
                  <a:lnTo>
                    <a:pt x="5496" y="591"/>
                  </a:lnTo>
                  <a:lnTo>
                    <a:pt x="5501" y="589"/>
                  </a:lnTo>
                  <a:lnTo>
                    <a:pt x="5509" y="589"/>
                  </a:lnTo>
                  <a:lnTo>
                    <a:pt x="5515" y="589"/>
                  </a:lnTo>
                  <a:lnTo>
                    <a:pt x="5523" y="587"/>
                  </a:lnTo>
                  <a:lnTo>
                    <a:pt x="5530" y="587"/>
                  </a:lnTo>
                  <a:lnTo>
                    <a:pt x="5536" y="587"/>
                  </a:lnTo>
                  <a:lnTo>
                    <a:pt x="5544" y="587"/>
                  </a:lnTo>
                  <a:lnTo>
                    <a:pt x="5549" y="587"/>
                  </a:lnTo>
                  <a:lnTo>
                    <a:pt x="5557" y="589"/>
                  </a:lnTo>
                  <a:lnTo>
                    <a:pt x="5565" y="589"/>
                  </a:lnTo>
                  <a:lnTo>
                    <a:pt x="5571" y="589"/>
                  </a:lnTo>
                  <a:lnTo>
                    <a:pt x="5578" y="589"/>
                  </a:lnTo>
                  <a:lnTo>
                    <a:pt x="5584" y="589"/>
                  </a:lnTo>
                  <a:lnTo>
                    <a:pt x="5592" y="589"/>
                  </a:lnTo>
                  <a:lnTo>
                    <a:pt x="5599" y="589"/>
                  </a:lnTo>
                  <a:lnTo>
                    <a:pt x="5605" y="587"/>
                  </a:lnTo>
                  <a:lnTo>
                    <a:pt x="5613" y="587"/>
                  </a:lnTo>
                  <a:lnTo>
                    <a:pt x="5619" y="585"/>
                  </a:lnTo>
                  <a:lnTo>
                    <a:pt x="5626" y="585"/>
                  </a:lnTo>
                  <a:lnTo>
                    <a:pt x="5632" y="583"/>
                  </a:lnTo>
                  <a:lnTo>
                    <a:pt x="5640" y="583"/>
                  </a:lnTo>
                  <a:lnTo>
                    <a:pt x="5647" y="581"/>
                  </a:lnTo>
                  <a:lnTo>
                    <a:pt x="5653" y="579"/>
                  </a:lnTo>
                  <a:lnTo>
                    <a:pt x="5661" y="577"/>
                  </a:lnTo>
                  <a:lnTo>
                    <a:pt x="5667" y="575"/>
                  </a:lnTo>
                  <a:lnTo>
                    <a:pt x="5674" y="573"/>
                  </a:lnTo>
                  <a:lnTo>
                    <a:pt x="5682" y="571"/>
                  </a:lnTo>
                  <a:lnTo>
                    <a:pt x="5688" y="569"/>
                  </a:lnTo>
                  <a:lnTo>
                    <a:pt x="5695" y="568"/>
                  </a:lnTo>
                  <a:lnTo>
                    <a:pt x="5701" y="566"/>
                  </a:lnTo>
                  <a:lnTo>
                    <a:pt x="5709" y="566"/>
                  </a:lnTo>
                  <a:lnTo>
                    <a:pt x="5717" y="566"/>
                  </a:lnTo>
                  <a:lnTo>
                    <a:pt x="5722" y="564"/>
                  </a:lnTo>
                  <a:lnTo>
                    <a:pt x="5730" y="564"/>
                  </a:lnTo>
                  <a:lnTo>
                    <a:pt x="5736" y="562"/>
                  </a:lnTo>
                  <a:lnTo>
                    <a:pt x="5743" y="562"/>
                  </a:lnTo>
                  <a:lnTo>
                    <a:pt x="5749" y="560"/>
                  </a:lnTo>
                  <a:lnTo>
                    <a:pt x="5757" y="558"/>
                  </a:lnTo>
                  <a:lnTo>
                    <a:pt x="5765" y="558"/>
                  </a:lnTo>
                  <a:lnTo>
                    <a:pt x="5770" y="556"/>
                  </a:lnTo>
                  <a:lnTo>
                    <a:pt x="5778" y="552"/>
                  </a:lnTo>
                  <a:lnTo>
                    <a:pt x="5784" y="550"/>
                  </a:lnTo>
                  <a:lnTo>
                    <a:pt x="5791" y="546"/>
                  </a:lnTo>
                  <a:lnTo>
                    <a:pt x="5799" y="545"/>
                  </a:lnTo>
                  <a:lnTo>
                    <a:pt x="5805" y="541"/>
                  </a:lnTo>
                  <a:lnTo>
                    <a:pt x="5813" y="537"/>
                  </a:lnTo>
                  <a:lnTo>
                    <a:pt x="5818" y="535"/>
                  </a:lnTo>
                  <a:lnTo>
                    <a:pt x="5826" y="533"/>
                  </a:lnTo>
                  <a:lnTo>
                    <a:pt x="5834" y="531"/>
                  </a:lnTo>
                  <a:lnTo>
                    <a:pt x="5839" y="529"/>
                  </a:lnTo>
                  <a:lnTo>
                    <a:pt x="5847" y="527"/>
                  </a:lnTo>
                  <a:lnTo>
                    <a:pt x="5853" y="527"/>
                  </a:lnTo>
                  <a:lnTo>
                    <a:pt x="5861" y="525"/>
                  </a:lnTo>
                  <a:lnTo>
                    <a:pt x="5868" y="523"/>
                  </a:lnTo>
                  <a:lnTo>
                    <a:pt x="5874" y="523"/>
                  </a:lnTo>
                  <a:lnTo>
                    <a:pt x="5882" y="522"/>
                  </a:lnTo>
                  <a:lnTo>
                    <a:pt x="5887" y="522"/>
                  </a:lnTo>
                  <a:lnTo>
                    <a:pt x="5895" y="523"/>
                  </a:lnTo>
                  <a:lnTo>
                    <a:pt x="5901" y="525"/>
                  </a:lnTo>
                  <a:lnTo>
                    <a:pt x="5909" y="527"/>
                  </a:lnTo>
                  <a:lnTo>
                    <a:pt x="5916" y="529"/>
                  </a:lnTo>
                  <a:lnTo>
                    <a:pt x="5922" y="531"/>
                  </a:lnTo>
                  <a:lnTo>
                    <a:pt x="5930" y="533"/>
                  </a:lnTo>
                  <a:lnTo>
                    <a:pt x="5935" y="535"/>
                  </a:lnTo>
                  <a:lnTo>
                    <a:pt x="5943" y="537"/>
                  </a:lnTo>
                  <a:lnTo>
                    <a:pt x="5951" y="535"/>
                  </a:lnTo>
                  <a:lnTo>
                    <a:pt x="5957" y="535"/>
                  </a:lnTo>
                  <a:lnTo>
                    <a:pt x="5964" y="531"/>
                  </a:lnTo>
                  <a:lnTo>
                    <a:pt x="5970" y="529"/>
                  </a:lnTo>
                  <a:lnTo>
                    <a:pt x="5978" y="523"/>
                  </a:lnTo>
                  <a:lnTo>
                    <a:pt x="5985" y="520"/>
                  </a:lnTo>
                  <a:lnTo>
                    <a:pt x="5991" y="514"/>
                  </a:lnTo>
                  <a:lnTo>
                    <a:pt x="5999" y="510"/>
                  </a:lnTo>
                  <a:lnTo>
                    <a:pt x="6005" y="506"/>
                  </a:lnTo>
                  <a:lnTo>
                    <a:pt x="6012" y="504"/>
                  </a:lnTo>
                  <a:lnTo>
                    <a:pt x="6018" y="504"/>
                  </a:lnTo>
                  <a:lnTo>
                    <a:pt x="6026" y="506"/>
                  </a:lnTo>
                  <a:lnTo>
                    <a:pt x="6033" y="506"/>
                  </a:lnTo>
                  <a:lnTo>
                    <a:pt x="6039" y="508"/>
                  </a:lnTo>
                  <a:lnTo>
                    <a:pt x="6047" y="510"/>
                  </a:lnTo>
                  <a:lnTo>
                    <a:pt x="6053" y="512"/>
                  </a:lnTo>
                  <a:lnTo>
                    <a:pt x="6060" y="512"/>
                  </a:lnTo>
                  <a:lnTo>
                    <a:pt x="6068" y="512"/>
                  </a:lnTo>
                  <a:lnTo>
                    <a:pt x="6074" y="512"/>
                  </a:lnTo>
                  <a:lnTo>
                    <a:pt x="6081" y="512"/>
                  </a:lnTo>
                  <a:lnTo>
                    <a:pt x="6087" y="514"/>
                  </a:lnTo>
                  <a:lnTo>
                    <a:pt x="6095" y="514"/>
                  </a:lnTo>
                  <a:lnTo>
                    <a:pt x="6102" y="516"/>
                  </a:lnTo>
                  <a:lnTo>
                    <a:pt x="6108" y="516"/>
                  </a:lnTo>
                  <a:lnTo>
                    <a:pt x="6116" y="518"/>
                  </a:lnTo>
                  <a:lnTo>
                    <a:pt x="6122" y="518"/>
                  </a:lnTo>
                  <a:lnTo>
                    <a:pt x="6129" y="518"/>
                  </a:lnTo>
                  <a:lnTo>
                    <a:pt x="6135" y="516"/>
                  </a:lnTo>
                  <a:lnTo>
                    <a:pt x="6143" y="516"/>
                  </a:lnTo>
                  <a:lnTo>
                    <a:pt x="6150" y="516"/>
                  </a:lnTo>
                  <a:lnTo>
                    <a:pt x="6156" y="516"/>
                  </a:lnTo>
                  <a:lnTo>
                    <a:pt x="6164" y="514"/>
                  </a:lnTo>
                  <a:lnTo>
                    <a:pt x="6170" y="514"/>
                  </a:lnTo>
                  <a:lnTo>
                    <a:pt x="6177" y="514"/>
                  </a:lnTo>
                  <a:lnTo>
                    <a:pt x="6185" y="514"/>
                  </a:lnTo>
                  <a:lnTo>
                    <a:pt x="6191" y="514"/>
                  </a:lnTo>
                  <a:lnTo>
                    <a:pt x="6198" y="512"/>
                  </a:lnTo>
                  <a:lnTo>
                    <a:pt x="6204" y="512"/>
                  </a:lnTo>
                  <a:lnTo>
                    <a:pt x="6212" y="512"/>
                  </a:lnTo>
                  <a:lnTo>
                    <a:pt x="6220" y="512"/>
                  </a:lnTo>
                  <a:lnTo>
                    <a:pt x="6225" y="512"/>
                  </a:lnTo>
                  <a:lnTo>
                    <a:pt x="6233" y="512"/>
                  </a:lnTo>
                  <a:lnTo>
                    <a:pt x="6239" y="512"/>
                  </a:lnTo>
                  <a:lnTo>
                    <a:pt x="6246" y="512"/>
                  </a:lnTo>
                  <a:lnTo>
                    <a:pt x="6254" y="512"/>
                  </a:lnTo>
                  <a:lnTo>
                    <a:pt x="6260" y="510"/>
                  </a:lnTo>
                  <a:lnTo>
                    <a:pt x="6268" y="510"/>
                  </a:lnTo>
                  <a:lnTo>
                    <a:pt x="6273" y="508"/>
                  </a:lnTo>
                  <a:lnTo>
                    <a:pt x="6281" y="504"/>
                  </a:lnTo>
                  <a:lnTo>
                    <a:pt x="6287" y="500"/>
                  </a:lnTo>
                  <a:lnTo>
                    <a:pt x="6294" y="497"/>
                  </a:lnTo>
                  <a:lnTo>
                    <a:pt x="6302" y="489"/>
                  </a:lnTo>
                  <a:lnTo>
                    <a:pt x="6308" y="479"/>
                  </a:lnTo>
                  <a:lnTo>
                    <a:pt x="6316" y="468"/>
                  </a:lnTo>
                  <a:lnTo>
                    <a:pt x="6321" y="449"/>
                  </a:lnTo>
                  <a:lnTo>
                    <a:pt x="6329" y="422"/>
                  </a:lnTo>
                  <a:lnTo>
                    <a:pt x="6337" y="378"/>
                  </a:lnTo>
                  <a:lnTo>
                    <a:pt x="6342" y="312"/>
                  </a:lnTo>
                  <a:lnTo>
                    <a:pt x="6350" y="216"/>
                  </a:lnTo>
                  <a:lnTo>
                    <a:pt x="6356" y="86"/>
                  </a:lnTo>
                  <a:lnTo>
                    <a:pt x="6362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 sz="700"/>
            </a:p>
          </p:txBody>
        </p:sp>
        <p:sp>
          <p:nvSpPr>
            <p:cNvPr id="105" name="Rectangle 303">
              <a:extLst>
                <a:ext uri="{FF2B5EF4-FFF2-40B4-BE49-F238E27FC236}">
                  <a16:creationId xmlns:a16="http://schemas.microsoft.com/office/drawing/2014/main" id="{267A5632-AE1E-34FD-7A30-B085F38E3B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902896" y="2654920"/>
              <a:ext cx="2565995" cy="954109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700"/>
            </a:p>
          </p:txBody>
        </p:sp>
        <p:grpSp>
          <p:nvGrpSpPr>
            <p:cNvPr id="106" name="グループ化 105">
              <a:extLst>
                <a:ext uri="{FF2B5EF4-FFF2-40B4-BE49-F238E27FC236}">
                  <a16:creationId xmlns:a16="http://schemas.microsoft.com/office/drawing/2014/main" id="{D62FB299-A105-2AD5-47EB-5B0BB8116DA0}"/>
                </a:ext>
              </a:extLst>
            </p:cNvPr>
            <p:cNvGrpSpPr/>
            <p:nvPr/>
          </p:nvGrpSpPr>
          <p:grpSpPr>
            <a:xfrm>
              <a:off x="-1148770" y="2605477"/>
              <a:ext cx="237640" cy="1056152"/>
              <a:chOff x="1203186" y="5054789"/>
              <a:chExt cx="237640" cy="1056152"/>
            </a:xfrm>
          </p:grpSpPr>
          <p:sp>
            <p:nvSpPr>
              <p:cNvPr id="107" name="Line 783">
                <a:extLst>
                  <a:ext uri="{FF2B5EF4-FFF2-40B4-BE49-F238E27FC236}">
                    <a16:creationId xmlns:a16="http://schemas.microsoft.com/office/drawing/2014/main" id="{665CEF51-1CCA-4E12-E083-D51F9FECCD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6600" y="6034283"/>
                <a:ext cx="14226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Line 788">
                <a:extLst>
                  <a:ext uri="{FF2B5EF4-FFF2-40B4-BE49-F238E27FC236}">
                    <a16:creationId xmlns:a16="http://schemas.microsoft.com/office/drawing/2014/main" id="{0900E7A0-7144-1338-023E-D61C62D0B2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6600" y="5589715"/>
                <a:ext cx="14226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Line 793">
                <a:extLst>
                  <a:ext uri="{FF2B5EF4-FFF2-40B4-BE49-F238E27FC236}">
                    <a16:creationId xmlns:a16="http://schemas.microsoft.com/office/drawing/2014/main" id="{FED00A30-A4D3-0E28-6BD0-41CE81BE29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6600" y="5145148"/>
                <a:ext cx="14226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Line 794">
                <a:extLst>
                  <a:ext uri="{FF2B5EF4-FFF2-40B4-BE49-F238E27FC236}">
                    <a16:creationId xmlns:a16="http://schemas.microsoft.com/office/drawing/2014/main" id="{7563AF6E-6346-F0B4-00EC-821F54C8F7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13871" y="6034283"/>
                <a:ext cx="26955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Rectangle 795">
                <a:extLst>
                  <a:ext uri="{FF2B5EF4-FFF2-40B4-BE49-F238E27FC236}">
                    <a16:creationId xmlns:a16="http://schemas.microsoft.com/office/drawing/2014/main" id="{A66A71EF-71F2-BD97-7222-4B60CF3FBB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0537" y="5967362"/>
                <a:ext cx="75071" cy="1435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0</a:t>
                </a:r>
                <a:endParaRPr lang="en-US" altLang="ja-JP" sz="7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12" name="Line 796">
                <a:extLst>
                  <a:ext uri="{FF2B5EF4-FFF2-40B4-BE49-F238E27FC236}">
                    <a16:creationId xmlns:a16="http://schemas.microsoft.com/office/drawing/2014/main" id="{46F55BF4-235C-25AE-7DFF-987451B59F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13871" y="5589715"/>
                <a:ext cx="26955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Rectangle 797">
                <a:extLst>
                  <a:ext uri="{FF2B5EF4-FFF2-40B4-BE49-F238E27FC236}">
                    <a16:creationId xmlns:a16="http://schemas.microsoft.com/office/drawing/2014/main" id="{A9C8A274-CD98-9FE6-8BC0-2E76FD1D20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3186" y="5532081"/>
                <a:ext cx="150139" cy="1435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25</a:t>
                </a:r>
                <a:endParaRPr lang="en-US" altLang="ja-JP" sz="7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14" name="Line 798">
                <a:extLst>
                  <a:ext uri="{FF2B5EF4-FFF2-40B4-BE49-F238E27FC236}">
                    <a16:creationId xmlns:a16="http://schemas.microsoft.com/office/drawing/2014/main" id="{D1644A77-8BDC-0362-B7E7-3DC0A7797E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13871" y="5145148"/>
                <a:ext cx="26955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Rectangle 799">
                <a:extLst>
                  <a:ext uri="{FF2B5EF4-FFF2-40B4-BE49-F238E27FC236}">
                    <a16:creationId xmlns:a16="http://schemas.microsoft.com/office/drawing/2014/main" id="{5EA913BF-4F8E-4C2C-42C9-9F5DCF017B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9090" y="5054789"/>
                <a:ext cx="150139" cy="1435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50</a:t>
                </a:r>
                <a:endParaRPr lang="en-US" altLang="ja-JP" sz="700" dirty="0"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16" name="グループ化 115">
            <a:extLst>
              <a:ext uri="{FF2B5EF4-FFF2-40B4-BE49-F238E27FC236}">
                <a16:creationId xmlns:a16="http://schemas.microsoft.com/office/drawing/2014/main" id="{93CC61E1-7C9A-0AC2-E75B-EAD95CF26484}"/>
              </a:ext>
            </a:extLst>
          </p:cNvPr>
          <p:cNvGrpSpPr/>
          <p:nvPr/>
        </p:nvGrpSpPr>
        <p:grpSpPr>
          <a:xfrm>
            <a:off x="4751721" y="830253"/>
            <a:ext cx="1873232" cy="755980"/>
            <a:chOff x="-336254" y="1256175"/>
            <a:chExt cx="2836340" cy="996775"/>
          </a:xfrm>
        </p:grpSpPr>
        <p:grpSp>
          <p:nvGrpSpPr>
            <p:cNvPr id="117" name="グループ化 116">
              <a:extLst>
                <a:ext uri="{FF2B5EF4-FFF2-40B4-BE49-F238E27FC236}">
                  <a16:creationId xmlns:a16="http://schemas.microsoft.com/office/drawing/2014/main" id="{EC2E59B4-85CC-6AF0-C3D6-ED8C8C20C26E}"/>
                </a:ext>
              </a:extLst>
            </p:cNvPr>
            <p:cNvGrpSpPr/>
            <p:nvPr/>
          </p:nvGrpSpPr>
          <p:grpSpPr>
            <a:xfrm>
              <a:off x="-336254" y="1256175"/>
              <a:ext cx="2836340" cy="996775"/>
              <a:chOff x="-1173241" y="1388291"/>
              <a:chExt cx="2836340" cy="996775"/>
            </a:xfrm>
          </p:grpSpPr>
          <p:sp>
            <p:nvSpPr>
              <p:cNvPr id="119" name="Line 183">
                <a:extLst>
                  <a:ext uri="{FF2B5EF4-FFF2-40B4-BE49-F238E27FC236}">
                    <a16:creationId xmlns:a16="http://schemas.microsoft.com/office/drawing/2014/main" id="{59569273-00CE-1A38-B371-BF5510B5BE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917122" y="2345740"/>
                <a:ext cx="14226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/>
              </a:p>
            </p:txBody>
          </p:sp>
          <p:sp>
            <p:nvSpPr>
              <p:cNvPr id="120" name="Line 188">
                <a:extLst>
                  <a:ext uri="{FF2B5EF4-FFF2-40B4-BE49-F238E27FC236}">
                    <a16:creationId xmlns:a16="http://schemas.microsoft.com/office/drawing/2014/main" id="{8C5048A7-62DF-B03B-7B71-EF3C44F327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917122" y="1899463"/>
                <a:ext cx="14226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/>
              </a:p>
            </p:txBody>
          </p:sp>
          <p:sp>
            <p:nvSpPr>
              <p:cNvPr id="121" name="Line 193">
                <a:extLst>
                  <a:ext uri="{FF2B5EF4-FFF2-40B4-BE49-F238E27FC236}">
                    <a16:creationId xmlns:a16="http://schemas.microsoft.com/office/drawing/2014/main" id="{9D6010D2-169A-6C9E-E22F-3EDB74CC7E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917122" y="1451476"/>
                <a:ext cx="14226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/>
              </a:p>
            </p:txBody>
          </p:sp>
          <p:sp>
            <p:nvSpPr>
              <p:cNvPr id="122" name="Line 194">
                <a:extLst>
                  <a:ext uri="{FF2B5EF4-FFF2-40B4-BE49-F238E27FC236}">
                    <a16:creationId xmlns:a16="http://schemas.microsoft.com/office/drawing/2014/main" id="{A7655969-61F8-7CE8-AC8B-755C81D28E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929851" y="2345740"/>
                <a:ext cx="26955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/>
              </a:p>
            </p:txBody>
          </p:sp>
          <p:sp>
            <p:nvSpPr>
              <p:cNvPr id="123" name="Rectangle 195">
                <a:extLst>
                  <a:ext uri="{FF2B5EF4-FFF2-40B4-BE49-F238E27FC236}">
                    <a16:creationId xmlns:a16="http://schemas.microsoft.com/office/drawing/2014/main" id="{20224105-812E-8EEF-7B80-9B811ED6A6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026289" y="2270531"/>
                <a:ext cx="496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0</a:t>
                </a:r>
                <a:endParaRPr lang="en-US" altLang="ja-JP" sz="7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24" name="Line 196">
                <a:extLst>
                  <a:ext uri="{FF2B5EF4-FFF2-40B4-BE49-F238E27FC236}">
                    <a16:creationId xmlns:a16="http://schemas.microsoft.com/office/drawing/2014/main" id="{893A36C7-B763-F96E-1BDF-952C7A5897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929851" y="1899463"/>
                <a:ext cx="26955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/>
              </a:p>
            </p:txBody>
          </p:sp>
          <p:sp>
            <p:nvSpPr>
              <p:cNvPr id="125" name="Rectangle 197">
                <a:extLst>
                  <a:ext uri="{FF2B5EF4-FFF2-40B4-BE49-F238E27FC236}">
                    <a16:creationId xmlns:a16="http://schemas.microsoft.com/office/drawing/2014/main" id="{36A4D422-4D65-6125-F912-26C82F0B64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66529" y="1837587"/>
                <a:ext cx="14907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100</a:t>
                </a:r>
                <a:endParaRPr lang="en-US" altLang="ja-JP" sz="7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26" name="Line 198">
                <a:extLst>
                  <a:ext uri="{FF2B5EF4-FFF2-40B4-BE49-F238E27FC236}">
                    <a16:creationId xmlns:a16="http://schemas.microsoft.com/office/drawing/2014/main" id="{78F573E5-5BB5-C16E-D523-F370CBF188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929851" y="1451476"/>
                <a:ext cx="26955" cy="17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700"/>
              </a:p>
            </p:txBody>
          </p:sp>
          <p:sp>
            <p:nvSpPr>
              <p:cNvPr id="127" name="Rectangle 199">
                <a:extLst>
                  <a:ext uri="{FF2B5EF4-FFF2-40B4-BE49-F238E27FC236}">
                    <a16:creationId xmlns:a16="http://schemas.microsoft.com/office/drawing/2014/main" id="{A9070A86-F938-9D55-EA63-5F5CC25B6A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3241" y="1388291"/>
                <a:ext cx="14907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>
                    <a:solidFill>
                      <a:srgbClr val="000000"/>
                    </a:solidFill>
                    <a:ea typeface="ＭＳ ゴシック" panose="020B0609070205080204" pitchFamily="49" charset="-128"/>
                    <a:cs typeface="Arial" panose="020B0604020202020204" pitchFamily="34" charset="0"/>
                  </a:rPr>
                  <a:t>200</a:t>
                </a:r>
                <a:endParaRPr lang="en-US" altLang="ja-JP" sz="7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92" name="Freeform 201">
                <a:extLst>
                  <a:ext uri="{FF2B5EF4-FFF2-40B4-BE49-F238E27FC236}">
                    <a16:creationId xmlns:a16="http://schemas.microsoft.com/office/drawing/2014/main" id="{3071FE0A-E7AA-5B35-B321-59872C2610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902147" y="1547229"/>
                <a:ext cx="2564498" cy="798511"/>
              </a:xfrm>
              <a:custGeom>
                <a:avLst/>
                <a:gdLst>
                  <a:gd name="T0" fmla="*/ 0 w 6851"/>
                  <a:gd name="T1" fmla="*/ 7 h 934"/>
                  <a:gd name="T2" fmla="*/ 1 w 6851"/>
                  <a:gd name="T3" fmla="*/ 7 h 934"/>
                  <a:gd name="T4" fmla="*/ 2 w 6851"/>
                  <a:gd name="T5" fmla="*/ 8 h 934"/>
                  <a:gd name="T6" fmla="*/ 3 w 6851"/>
                  <a:gd name="T7" fmla="*/ 8 h 934"/>
                  <a:gd name="T8" fmla="*/ 4 w 6851"/>
                  <a:gd name="T9" fmla="*/ 8 h 934"/>
                  <a:gd name="T10" fmla="*/ 5 w 6851"/>
                  <a:gd name="T11" fmla="*/ 8 h 934"/>
                  <a:gd name="T12" fmla="*/ 5 w 6851"/>
                  <a:gd name="T13" fmla="*/ 8 h 934"/>
                  <a:gd name="T14" fmla="*/ 6 w 6851"/>
                  <a:gd name="T15" fmla="*/ 8 h 934"/>
                  <a:gd name="T16" fmla="*/ 7 w 6851"/>
                  <a:gd name="T17" fmla="*/ 8 h 934"/>
                  <a:gd name="T18" fmla="*/ 8 w 6851"/>
                  <a:gd name="T19" fmla="*/ 8 h 934"/>
                  <a:gd name="T20" fmla="*/ 9 w 6851"/>
                  <a:gd name="T21" fmla="*/ 8 h 934"/>
                  <a:gd name="T22" fmla="*/ 10 w 6851"/>
                  <a:gd name="T23" fmla="*/ 8 h 934"/>
                  <a:gd name="T24" fmla="*/ 11 w 6851"/>
                  <a:gd name="T25" fmla="*/ 8 h 934"/>
                  <a:gd name="T26" fmla="*/ 11 w 6851"/>
                  <a:gd name="T27" fmla="*/ 7 h 934"/>
                  <a:gd name="T28" fmla="*/ 12 w 6851"/>
                  <a:gd name="T29" fmla="*/ 7 h 934"/>
                  <a:gd name="T30" fmla="*/ 13 w 6851"/>
                  <a:gd name="T31" fmla="*/ 7 h 934"/>
                  <a:gd name="T32" fmla="*/ 14 w 6851"/>
                  <a:gd name="T33" fmla="*/ 7 h 934"/>
                  <a:gd name="T34" fmla="*/ 15 w 6851"/>
                  <a:gd name="T35" fmla="*/ 7 h 934"/>
                  <a:gd name="T36" fmla="*/ 16 w 6851"/>
                  <a:gd name="T37" fmla="*/ 7 h 934"/>
                  <a:gd name="T38" fmla="*/ 17 w 6851"/>
                  <a:gd name="T39" fmla="*/ 7 h 934"/>
                  <a:gd name="T40" fmla="*/ 18 w 6851"/>
                  <a:gd name="T41" fmla="*/ 7 h 934"/>
                  <a:gd name="T42" fmla="*/ 18 w 6851"/>
                  <a:gd name="T43" fmla="*/ 7 h 934"/>
                  <a:gd name="T44" fmla="*/ 19 w 6851"/>
                  <a:gd name="T45" fmla="*/ 7 h 934"/>
                  <a:gd name="T46" fmla="*/ 20 w 6851"/>
                  <a:gd name="T47" fmla="*/ 7 h 934"/>
                  <a:gd name="T48" fmla="*/ 21 w 6851"/>
                  <a:gd name="T49" fmla="*/ 7 h 934"/>
                  <a:gd name="T50" fmla="*/ 22 w 6851"/>
                  <a:gd name="T51" fmla="*/ 7 h 934"/>
                  <a:gd name="T52" fmla="*/ 23 w 6851"/>
                  <a:gd name="T53" fmla="*/ 7 h 934"/>
                  <a:gd name="T54" fmla="*/ 24 w 6851"/>
                  <a:gd name="T55" fmla="*/ 7 h 934"/>
                  <a:gd name="T56" fmla="*/ 24 w 6851"/>
                  <a:gd name="T57" fmla="*/ 7 h 934"/>
                  <a:gd name="T58" fmla="*/ 25 w 6851"/>
                  <a:gd name="T59" fmla="*/ 7 h 934"/>
                  <a:gd name="T60" fmla="*/ 26 w 6851"/>
                  <a:gd name="T61" fmla="*/ 7 h 934"/>
                  <a:gd name="T62" fmla="*/ 27 w 6851"/>
                  <a:gd name="T63" fmla="*/ 7 h 934"/>
                  <a:gd name="T64" fmla="*/ 28 w 6851"/>
                  <a:gd name="T65" fmla="*/ 7 h 934"/>
                  <a:gd name="T66" fmla="*/ 29 w 6851"/>
                  <a:gd name="T67" fmla="*/ 7 h 934"/>
                  <a:gd name="T68" fmla="*/ 30 w 6851"/>
                  <a:gd name="T69" fmla="*/ 7 h 934"/>
                  <a:gd name="T70" fmla="*/ 30 w 6851"/>
                  <a:gd name="T71" fmla="*/ 7 h 934"/>
                  <a:gd name="T72" fmla="*/ 31 w 6851"/>
                  <a:gd name="T73" fmla="*/ 7 h 934"/>
                  <a:gd name="T74" fmla="*/ 32 w 6851"/>
                  <a:gd name="T75" fmla="*/ 7 h 934"/>
                  <a:gd name="T76" fmla="*/ 33 w 6851"/>
                  <a:gd name="T77" fmla="*/ 7 h 934"/>
                  <a:gd name="T78" fmla="*/ 34 w 6851"/>
                  <a:gd name="T79" fmla="*/ 7 h 934"/>
                  <a:gd name="T80" fmla="*/ 35 w 6851"/>
                  <a:gd name="T81" fmla="*/ 7 h 934"/>
                  <a:gd name="T82" fmla="*/ 36 w 6851"/>
                  <a:gd name="T83" fmla="*/ 7 h 934"/>
                  <a:gd name="T84" fmla="*/ 36 w 6851"/>
                  <a:gd name="T85" fmla="*/ 7 h 934"/>
                  <a:gd name="T86" fmla="*/ 37 w 6851"/>
                  <a:gd name="T87" fmla="*/ 7 h 934"/>
                  <a:gd name="T88" fmla="*/ 38 w 6851"/>
                  <a:gd name="T89" fmla="*/ 7 h 934"/>
                  <a:gd name="T90" fmla="*/ 39 w 6851"/>
                  <a:gd name="T91" fmla="*/ 7 h 934"/>
                  <a:gd name="T92" fmla="*/ 40 w 6851"/>
                  <a:gd name="T93" fmla="*/ 7 h 934"/>
                  <a:gd name="T94" fmla="*/ 41 w 6851"/>
                  <a:gd name="T95" fmla="*/ 7 h 934"/>
                  <a:gd name="T96" fmla="*/ 42 w 6851"/>
                  <a:gd name="T97" fmla="*/ 7 h 934"/>
                  <a:gd name="T98" fmla="*/ 42 w 6851"/>
                  <a:gd name="T99" fmla="*/ 7 h 934"/>
                  <a:gd name="T100" fmla="*/ 43 w 6851"/>
                  <a:gd name="T101" fmla="*/ 7 h 934"/>
                  <a:gd name="T102" fmla="*/ 44 w 6851"/>
                  <a:gd name="T103" fmla="*/ 7 h 934"/>
                  <a:gd name="T104" fmla="*/ 45 w 6851"/>
                  <a:gd name="T105" fmla="*/ 7 h 934"/>
                  <a:gd name="T106" fmla="*/ 46 w 6851"/>
                  <a:gd name="T107" fmla="*/ 7 h 934"/>
                  <a:gd name="T108" fmla="*/ 47 w 6851"/>
                  <a:gd name="T109" fmla="*/ 7 h 934"/>
                  <a:gd name="T110" fmla="*/ 48 w 6851"/>
                  <a:gd name="T111" fmla="*/ 7 h 934"/>
                  <a:gd name="T112" fmla="*/ 49 w 6851"/>
                  <a:gd name="T113" fmla="*/ 7 h 934"/>
                  <a:gd name="T114" fmla="*/ 49 w 6851"/>
                  <a:gd name="T115" fmla="*/ 3 h 934"/>
                  <a:gd name="T116" fmla="*/ 50 w 6851"/>
                  <a:gd name="T117" fmla="*/ 2 h 934"/>
                  <a:gd name="T118" fmla="*/ 51 w 6851"/>
                  <a:gd name="T119" fmla="*/ 4 h 934"/>
                  <a:gd name="T120" fmla="*/ 52 w 6851"/>
                  <a:gd name="T121" fmla="*/ 5 h 934"/>
                  <a:gd name="T122" fmla="*/ 53 w 6851"/>
                  <a:gd name="T123" fmla="*/ 5 h 934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60000 65536"/>
                  <a:gd name="T145" fmla="*/ 0 60000 65536"/>
                  <a:gd name="T146" fmla="*/ 0 60000 65536"/>
                  <a:gd name="T147" fmla="*/ 0 60000 65536"/>
                  <a:gd name="T148" fmla="*/ 0 60000 65536"/>
                  <a:gd name="T149" fmla="*/ 0 60000 65536"/>
                  <a:gd name="T150" fmla="*/ 0 60000 65536"/>
                  <a:gd name="T151" fmla="*/ 0 60000 65536"/>
                  <a:gd name="T152" fmla="*/ 0 60000 65536"/>
                  <a:gd name="T153" fmla="*/ 0 60000 65536"/>
                  <a:gd name="T154" fmla="*/ 0 60000 65536"/>
                  <a:gd name="T155" fmla="*/ 0 60000 65536"/>
                  <a:gd name="T156" fmla="*/ 0 60000 65536"/>
                  <a:gd name="T157" fmla="*/ 0 60000 65536"/>
                  <a:gd name="T158" fmla="*/ 0 60000 65536"/>
                  <a:gd name="T159" fmla="*/ 0 60000 65536"/>
                  <a:gd name="T160" fmla="*/ 0 60000 65536"/>
                  <a:gd name="T161" fmla="*/ 0 60000 65536"/>
                  <a:gd name="T162" fmla="*/ 0 60000 65536"/>
                  <a:gd name="T163" fmla="*/ 0 60000 65536"/>
                  <a:gd name="T164" fmla="*/ 0 60000 65536"/>
                  <a:gd name="T165" fmla="*/ 0 60000 65536"/>
                  <a:gd name="T166" fmla="*/ 0 60000 65536"/>
                  <a:gd name="T167" fmla="*/ 0 60000 65536"/>
                  <a:gd name="T168" fmla="*/ 0 60000 65536"/>
                  <a:gd name="T169" fmla="*/ 0 60000 65536"/>
                  <a:gd name="T170" fmla="*/ 0 60000 65536"/>
                  <a:gd name="T171" fmla="*/ 0 60000 65536"/>
                  <a:gd name="T172" fmla="*/ 0 60000 65536"/>
                  <a:gd name="T173" fmla="*/ 0 60000 65536"/>
                  <a:gd name="T174" fmla="*/ 0 60000 65536"/>
                  <a:gd name="T175" fmla="*/ 0 60000 65536"/>
                  <a:gd name="T176" fmla="*/ 0 60000 65536"/>
                  <a:gd name="T177" fmla="*/ 0 60000 65536"/>
                  <a:gd name="T178" fmla="*/ 0 60000 65536"/>
                  <a:gd name="T179" fmla="*/ 0 60000 65536"/>
                  <a:gd name="T180" fmla="*/ 0 60000 65536"/>
                  <a:gd name="T181" fmla="*/ 0 60000 65536"/>
                  <a:gd name="T182" fmla="*/ 0 60000 65536"/>
                  <a:gd name="T183" fmla="*/ 0 60000 65536"/>
                  <a:gd name="T184" fmla="*/ 0 60000 65536"/>
                  <a:gd name="T185" fmla="*/ 0 60000 65536"/>
                </a:gdLst>
                <a:ahLst/>
                <a:cxnLst>
                  <a:cxn ang="T124">
                    <a:pos x="T0" y="T1"/>
                  </a:cxn>
                  <a:cxn ang="T125">
                    <a:pos x="T2" y="T3"/>
                  </a:cxn>
                  <a:cxn ang="T126">
                    <a:pos x="T4" y="T5"/>
                  </a:cxn>
                  <a:cxn ang="T127">
                    <a:pos x="T6" y="T7"/>
                  </a:cxn>
                  <a:cxn ang="T128">
                    <a:pos x="T8" y="T9"/>
                  </a:cxn>
                  <a:cxn ang="T129">
                    <a:pos x="T10" y="T11"/>
                  </a:cxn>
                  <a:cxn ang="T130">
                    <a:pos x="T12" y="T13"/>
                  </a:cxn>
                  <a:cxn ang="T131">
                    <a:pos x="T14" y="T15"/>
                  </a:cxn>
                  <a:cxn ang="T132">
                    <a:pos x="T16" y="T17"/>
                  </a:cxn>
                  <a:cxn ang="T133">
                    <a:pos x="T18" y="T19"/>
                  </a:cxn>
                  <a:cxn ang="T134">
                    <a:pos x="T20" y="T21"/>
                  </a:cxn>
                  <a:cxn ang="T135">
                    <a:pos x="T22" y="T23"/>
                  </a:cxn>
                  <a:cxn ang="T136">
                    <a:pos x="T24" y="T25"/>
                  </a:cxn>
                  <a:cxn ang="T137">
                    <a:pos x="T26" y="T27"/>
                  </a:cxn>
                  <a:cxn ang="T138">
                    <a:pos x="T28" y="T29"/>
                  </a:cxn>
                  <a:cxn ang="T139">
                    <a:pos x="T30" y="T31"/>
                  </a:cxn>
                  <a:cxn ang="T140">
                    <a:pos x="T32" y="T33"/>
                  </a:cxn>
                  <a:cxn ang="T141">
                    <a:pos x="T34" y="T35"/>
                  </a:cxn>
                  <a:cxn ang="T142">
                    <a:pos x="T36" y="T37"/>
                  </a:cxn>
                  <a:cxn ang="T143">
                    <a:pos x="T38" y="T39"/>
                  </a:cxn>
                  <a:cxn ang="T144">
                    <a:pos x="T40" y="T41"/>
                  </a:cxn>
                  <a:cxn ang="T145">
                    <a:pos x="T42" y="T43"/>
                  </a:cxn>
                  <a:cxn ang="T146">
                    <a:pos x="T44" y="T45"/>
                  </a:cxn>
                  <a:cxn ang="T147">
                    <a:pos x="T46" y="T47"/>
                  </a:cxn>
                  <a:cxn ang="T148">
                    <a:pos x="T48" y="T49"/>
                  </a:cxn>
                  <a:cxn ang="T149">
                    <a:pos x="T50" y="T51"/>
                  </a:cxn>
                  <a:cxn ang="T150">
                    <a:pos x="T52" y="T53"/>
                  </a:cxn>
                  <a:cxn ang="T151">
                    <a:pos x="T54" y="T55"/>
                  </a:cxn>
                  <a:cxn ang="T152">
                    <a:pos x="T56" y="T57"/>
                  </a:cxn>
                  <a:cxn ang="T153">
                    <a:pos x="T58" y="T59"/>
                  </a:cxn>
                  <a:cxn ang="T154">
                    <a:pos x="T60" y="T61"/>
                  </a:cxn>
                  <a:cxn ang="T155">
                    <a:pos x="T62" y="T63"/>
                  </a:cxn>
                  <a:cxn ang="T156">
                    <a:pos x="T64" y="T65"/>
                  </a:cxn>
                  <a:cxn ang="T157">
                    <a:pos x="T66" y="T67"/>
                  </a:cxn>
                  <a:cxn ang="T158">
                    <a:pos x="T68" y="T69"/>
                  </a:cxn>
                  <a:cxn ang="T159">
                    <a:pos x="T70" y="T71"/>
                  </a:cxn>
                  <a:cxn ang="T160">
                    <a:pos x="T72" y="T73"/>
                  </a:cxn>
                  <a:cxn ang="T161">
                    <a:pos x="T74" y="T75"/>
                  </a:cxn>
                  <a:cxn ang="T162">
                    <a:pos x="T76" y="T77"/>
                  </a:cxn>
                  <a:cxn ang="T163">
                    <a:pos x="T78" y="T79"/>
                  </a:cxn>
                  <a:cxn ang="T164">
                    <a:pos x="T80" y="T81"/>
                  </a:cxn>
                  <a:cxn ang="T165">
                    <a:pos x="T82" y="T83"/>
                  </a:cxn>
                  <a:cxn ang="T166">
                    <a:pos x="T84" y="T85"/>
                  </a:cxn>
                  <a:cxn ang="T167">
                    <a:pos x="T86" y="T87"/>
                  </a:cxn>
                  <a:cxn ang="T168">
                    <a:pos x="T88" y="T89"/>
                  </a:cxn>
                  <a:cxn ang="T169">
                    <a:pos x="T90" y="T91"/>
                  </a:cxn>
                  <a:cxn ang="T170">
                    <a:pos x="T92" y="T93"/>
                  </a:cxn>
                  <a:cxn ang="T171">
                    <a:pos x="T94" y="T95"/>
                  </a:cxn>
                  <a:cxn ang="T172">
                    <a:pos x="T96" y="T97"/>
                  </a:cxn>
                  <a:cxn ang="T173">
                    <a:pos x="T98" y="T99"/>
                  </a:cxn>
                  <a:cxn ang="T174">
                    <a:pos x="T100" y="T101"/>
                  </a:cxn>
                  <a:cxn ang="T175">
                    <a:pos x="T102" y="T103"/>
                  </a:cxn>
                  <a:cxn ang="T176">
                    <a:pos x="T104" y="T105"/>
                  </a:cxn>
                  <a:cxn ang="T177">
                    <a:pos x="T106" y="T107"/>
                  </a:cxn>
                  <a:cxn ang="T178">
                    <a:pos x="T108" y="T109"/>
                  </a:cxn>
                  <a:cxn ang="T179">
                    <a:pos x="T110" y="T111"/>
                  </a:cxn>
                  <a:cxn ang="T180">
                    <a:pos x="T112" y="T113"/>
                  </a:cxn>
                  <a:cxn ang="T181">
                    <a:pos x="T114" y="T115"/>
                  </a:cxn>
                  <a:cxn ang="T182">
                    <a:pos x="T116" y="T117"/>
                  </a:cxn>
                  <a:cxn ang="T183">
                    <a:pos x="T118" y="T119"/>
                  </a:cxn>
                  <a:cxn ang="T184">
                    <a:pos x="T120" y="T121"/>
                  </a:cxn>
                  <a:cxn ang="T185">
                    <a:pos x="T122" y="T123"/>
                  </a:cxn>
                </a:cxnLst>
                <a:rect l="0" t="0" r="r" b="b"/>
                <a:pathLst>
                  <a:path w="6851" h="934">
                    <a:moveTo>
                      <a:pt x="0" y="933"/>
                    </a:moveTo>
                    <a:lnTo>
                      <a:pt x="2" y="933"/>
                    </a:lnTo>
                    <a:lnTo>
                      <a:pt x="8" y="931"/>
                    </a:lnTo>
                    <a:lnTo>
                      <a:pt x="16" y="931"/>
                    </a:lnTo>
                    <a:lnTo>
                      <a:pt x="23" y="929"/>
                    </a:lnTo>
                    <a:lnTo>
                      <a:pt x="29" y="929"/>
                    </a:lnTo>
                    <a:lnTo>
                      <a:pt x="37" y="927"/>
                    </a:lnTo>
                    <a:lnTo>
                      <a:pt x="43" y="925"/>
                    </a:lnTo>
                    <a:lnTo>
                      <a:pt x="50" y="923"/>
                    </a:lnTo>
                    <a:lnTo>
                      <a:pt x="58" y="919"/>
                    </a:lnTo>
                    <a:lnTo>
                      <a:pt x="64" y="915"/>
                    </a:lnTo>
                    <a:lnTo>
                      <a:pt x="71" y="911"/>
                    </a:lnTo>
                    <a:lnTo>
                      <a:pt x="77" y="906"/>
                    </a:lnTo>
                    <a:lnTo>
                      <a:pt x="85" y="898"/>
                    </a:lnTo>
                    <a:lnTo>
                      <a:pt x="92" y="888"/>
                    </a:lnTo>
                    <a:lnTo>
                      <a:pt x="98" y="881"/>
                    </a:lnTo>
                    <a:lnTo>
                      <a:pt x="106" y="871"/>
                    </a:lnTo>
                    <a:lnTo>
                      <a:pt x="112" y="862"/>
                    </a:lnTo>
                    <a:lnTo>
                      <a:pt x="119" y="852"/>
                    </a:lnTo>
                    <a:lnTo>
                      <a:pt x="127" y="844"/>
                    </a:lnTo>
                    <a:lnTo>
                      <a:pt x="133" y="837"/>
                    </a:lnTo>
                    <a:lnTo>
                      <a:pt x="140" y="831"/>
                    </a:lnTo>
                    <a:lnTo>
                      <a:pt x="146" y="827"/>
                    </a:lnTo>
                    <a:lnTo>
                      <a:pt x="154" y="825"/>
                    </a:lnTo>
                    <a:lnTo>
                      <a:pt x="160" y="825"/>
                    </a:lnTo>
                    <a:lnTo>
                      <a:pt x="167" y="825"/>
                    </a:lnTo>
                    <a:lnTo>
                      <a:pt x="175" y="827"/>
                    </a:lnTo>
                    <a:lnTo>
                      <a:pt x="181" y="829"/>
                    </a:lnTo>
                    <a:lnTo>
                      <a:pt x="188" y="833"/>
                    </a:lnTo>
                    <a:lnTo>
                      <a:pt x="194" y="838"/>
                    </a:lnTo>
                    <a:lnTo>
                      <a:pt x="202" y="842"/>
                    </a:lnTo>
                    <a:lnTo>
                      <a:pt x="210" y="848"/>
                    </a:lnTo>
                    <a:lnTo>
                      <a:pt x="215" y="854"/>
                    </a:lnTo>
                    <a:lnTo>
                      <a:pt x="223" y="860"/>
                    </a:lnTo>
                    <a:lnTo>
                      <a:pt x="229" y="863"/>
                    </a:lnTo>
                    <a:lnTo>
                      <a:pt x="236" y="869"/>
                    </a:lnTo>
                    <a:lnTo>
                      <a:pt x="244" y="875"/>
                    </a:lnTo>
                    <a:lnTo>
                      <a:pt x="250" y="881"/>
                    </a:lnTo>
                    <a:lnTo>
                      <a:pt x="258" y="885"/>
                    </a:lnTo>
                    <a:lnTo>
                      <a:pt x="263" y="888"/>
                    </a:lnTo>
                    <a:lnTo>
                      <a:pt x="271" y="894"/>
                    </a:lnTo>
                    <a:lnTo>
                      <a:pt x="277" y="898"/>
                    </a:lnTo>
                    <a:lnTo>
                      <a:pt x="284" y="902"/>
                    </a:lnTo>
                    <a:lnTo>
                      <a:pt x="292" y="906"/>
                    </a:lnTo>
                    <a:lnTo>
                      <a:pt x="298" y="908"/>
                    </a:lnTo>
                    <a:lnTo>
                      <a:pt x="306" y="911"/>
                    </a:lnTo>
                    <a:lnTo>
                      <a:pt x="311" y="913"/>
                    </a:lnTo>
                    <a:lnTo>
                      <a:pt x="319" y="915"/>
                    </a:lnTo>
                    <a:lnTo>
                      <a:pt x="327" y="919"/>
                    </a:lnTo>
                    <a:lnTo>
                      <a:pt x="332" y="921"/>
                    </a:lnTo>
                    <a:lnTo>
                      <a:pt x="340" y="923"/>
                    </a:lnTo>
                    <a:lnTo>
                      <a:pt x="346" y="923"/>
                    </a:lnTo>
                    <a:lnTo>
                      <a:pt x="354" y="925"/>
                    </a:lnTo>
                    <a:lnTo>
                      <a:pt x="361" y="927"/>
                    </a:lnTo>
                    <a:lnTo>
                      <a:pt x="367" y="927"/>
                    </a:lnTo>
                    <a:lnTo>
                      <a:pt x="375" y="929"/>
                    </a:lnTo>
                    <a:lnTo>
                      <a:pt x="380" y="929"/>
                    </a:lnTo>
                    <a:lnTo>
                      <a:pt x="388" y="931"/>
                    </a:lnTo>
                    <a:lnTo>
                      <a:pt x="394" y="931"/>
                    </a:lnTo>
                    <a:lnTo>
                      <a:pt x="402" y="931"/>
                    </a:lnTo>
                    <a:lnTo>
                      <a:pt x="409" y="931"/>
                    </a:lnTo>
                    <a:lnTo>
                      <a:pt x="415" y="933"/>
                    </a:lnTo>
                    <a:lnTo>
                      <a:pt x="423" y="933"/>
                    </a:lnTo>
                    <a:lnTo>
                      <a:pt x="429" y="933"/>
                    </a:lnTo>
                    <a:lnTo>
                      <a:pt x="436" y="933"/>
                    </a:lnTo>
                    <a:lnTo>
                      <a:pt x="444" y="933"/>
                    </a:lnTo>
                    <a:lnTo>
                      <a:pt x="450" y="933"/>
                    </a:lnTo>
                    <a:lnTo>
                      <a:pt x="457" y="933"/>
                    </a:lnTo>
                    <a:lnTo>
                      <a:pt x="463" y="933"/>
                    </a:lnTo>
                    <a:lnTo>
                      <a:pt x="471" y="933"/>
                    </a:lnTo>
                    <a:lnTo>
                      <a:pt x="478" y="933"/>
                    </a:lnTo>
                    <a:lnTo>
                      <a:pt x="484" y="933"/>
                    </a:lnTo>
                    <a:lnTo>
                      <a:pt x="492" y="933"/>
                    </a:lnTo>
                    <a:lnTo>
                      <a:pt x="498" y="933"/>
                    </a:lnTo>
                    <a:lnTo>
                      <a:pt x="505" y="933"/>
                    </a:lnTo>
                    <a:lnTo>
                      <a:pt x="513" y="933"/>
                    </a:lnTo>
                    <a:lnTo>
                      <a:pt x="519" y="933"/>
                    </a:lnTo>
                    <a:lnTo>
                      <a:pt x="526" y="933"/>
                    </a:lnTo>
                    <a:lnTo>
                      <a:pt x="532" y="933"/>
                    </a:lnTo>
                    <a:lnTo>
                      <a:pt x="540" y="933"/>
                    </a:lnTo>
                    <a:lnTo>
                      <a:pt x="546" y="933"/>
                    </a:lnTo>
                    <a:lnTo>
                      <a:pt x="553" y="933"/>
                    </a:lnTo>
                    <a:lnTo>
                      <a:pt x="561" y="933"/>
                    </a:lnTo>
                    <a:lnTo>
                      <a:pt x="567" y="933"/>
                    </a:lnTo>
                    <a:lnTo>
                      <a:pt x="574" y="933"/>
                    </a:lnTo>
                    <a:lnTo>
                      <a:pt x="580" y="933"/>
                    </a:lnTo>
                    <a:lnTo>
                      <a:pt x="588" y="933"/>
                    </a:lnTo>
                    <a:lnTo>
                      <a:pt x="596" y="933"/>
                    </a:lnTo>
                    <a:lnTo>
                      <a:pt x="601" y="933"/>
                    </a:lnTo>
                    <a:lnTo>
                      <a:pt x="609" y="933"/>
                    </a:lnTo>
                    <a:lnTo>
                      <a:pt x="615" y="933"/>
                    </a:lnTo>
                    <a:lnTo>
                      <a:pt x="622" y="933"/>
                    </a:lnTo>
                    <a:lnTo>
                      <a:pt x="630" y="933"/>
                    </a:lnTo>
                    <a:lnTo>
                      <a:pt x="636" y="933"/>
                    </a:lnTo>
                    <a:lnTo>
                      <a:pt x="644" y="933"/>
                    </a:lnTo>
                    <a:lnTo>
                      <a:pt x="649" y="933"/>
                    </a:lnTo>
                    <a:lnTo>
                      <a:pt x="657" y="933"/>
                    </a:lnTo>
                    <a:lnTo>
                      <a:pt x="663" y="933"/>
                    </a:lnTo>
                    <a:lnTo>
                      <a:pt x="670" y="933"/>
                    </a:lnTo>
                    <a:lnTo>
                      <a:pt x="678" y="934"/>
                    </a:lnTo>
                    <a:lnTo>
                      <a:pt x="684" y="933"/>
                    </a:lnTo>
                    <a:lnTo>
                      <a:pt x="692" y="934"/>
                    </a:lnTo>
                    <a:lnTo>
                      <a:pt x="697" y="934"/>
                    </a:lnTo>
                    <a:lnTo>
                      <a:pt x="705" y="934"/>
                    </a:lnTo>
                    <a:lnTo>
                      <a:pt x="713" y="934"/>
                    </a:lnTo>
                    <a:lnTo>
                      <a:pt x="718" y="934"/>
                    </a:lnTo>
                    <a:lnTo>
                      <a:pt x="726" y="934"/>
                    </a:lnTo>
                    <a:lnTo>
                      <a:pt x="732" y="934"/>
                    </a:lnTo>
                    <a:lnTo>
                      <a:pt x="740" y="934"/>
                    </a:lnTo>
                    <a:lnTo>
                      <a:pt x="747" y="934"/>
                    </a:lnTo>
                    <a:lnTo>
                      <a:pt x="753" y="934"/>
                    </a:lnTo>
                    <a:lnTo>
                      <a:pt x="761" y="934"/>
                    </a:lnTo>
                    <a:lnTo>
                      <a:pt x="766" y="934"/>
                    </a:lnTo>
                    <a:lnTo>
                      <a:pt x="774" y="934"/>
                    </a:lnTo>
                    <a:lnTo>
                      <a:pt x="782" y="934"/>
                    </a:lnTo>
                    <a:lnTo>
                      <a:pt x="788" y="934"/>
                    </a:lnTo>
                    <a:lnTo>
                      <a:pt x="795" y="934"/>
                    </a:lnTo>
                    <a:lnTo>
                      <a:pt x="801" y="934"/>
                    </a:lnTo>
                    <a:lnTo>
                      <a:pt x="809" y="934"/>
                    </a:lnTo>
                    <a:lnTo>
                      <a:pt x="814" y="934"/>
                    </a:lnTo>
                    <a:lnTo>
                      <a:pt x="822" y="934"/>
                    </a:lnTo>
                    <a:lnTo>
                      <a:pt x="830" y="934"/>
                    </a:lnTo>
                    <a:lnTo>
                      <a:pt x="836" y="934"/>
                    </a:lnTo>
                    <a:lnTo>
                      <a:pt x="843" y="934"/>
                    </a:lnTo>
                    <a:lnTo>
                      <a:pt x="849" y="934"/>
                    </a:lnTo>
                    <a:lnTo>
                      <a:pt x="857" y="934"/>
                    </a:lnTo>
                    <a:lnTo>
                      <a:pt x="864" y="934"/>
                    </a:lnTo>
                    <a:lnTo>
                      <a:pt x="870" y="934"/>
                    </a:lnTo>
                    <a:lnTo>
                      <a:pt x="878" y="934"/>
                    </a:lnTo>
                    <a:lnTo>
                      <a:pt x="884" y="934"/>
                    </a:lnTo>
                    <a:lnTo>
                      <a:pt x="891" y="934"/>
                    </a:lnTo>
                    <a:lnTo>
                      <a:pt x="899" y="934"/>
                    </a:lnTo>
                    <a:lnTo>
                      <a:pt x="905" y="934"/>
                    </a:lnTo>
                    <a:lnTo>
                      <a:pt x="912" y="934"/>
                    </a:lnTo>
                    <a:lnTo>
                      <a:pt x="918" y="934"/>
                    </a:lnTo>
                    <a:lnTo>
                      <a:pt x="926" y="934"/>
                    </a:lnTo>
                    <a:lnTo>
                      <a:pt x="932" y="934"/>
                    </a:lnTo>
                    <a:lnTo>
                      <a:pt x="939" y="934"/>
                    </a:lnTo>
                    <a:lnTo>
                      <a:pt x="947" y="933"/>
                    </a:lnTo>
                    <a:lnTo>
                      <a:pt x="953" y="933"/>
                    </a:lnTo>
                    <a:lnTo>
                      <a:pt x="960" y="933"/>
                    </a:lnTo>
                    <a:lnTo>
                      <a:pt x="966" y="933"/>
                    </a:lnTo>
                    <a:lnTo>
                      <a:pt x="974" y="933"/>
                    </a:lnTo>
                    <a:lnTo>
                      <a:pt x="981" y="933"/>
                    </a:lnTo>
                    <a:lnTo>
                      <a:pt x="987" y="933"/>
                    </a:lnTo>
                    <a:lnTo>
                      <a:pt x="995" y="933"/>
                    </a:lnTo>
                    <a:lnTo>
                      <a:pt x="1001" y="933"/>
                    </a:lnTo>
                    <a:lnTo>
                      <a:pt x="1008" y="933"/>
                    </a:lnTo>
                    <a:lnTo>
                      <a:pt x="1016" y="933"/>
                    </a:lnTo>
                    <a:lnTo>
                      <a:pt x="1022" y="933"/>
                    </a:lnTo>
                    <a:lnTo>
                      <a:pt x="1029" y="933"/>
                    </a:lnTo>
                    <a:lnTo>
                      <a:pt x="1035" y="933"/>
                    </a:lnTo>
                    <a:lnTo>
                      <a:pt x="1043" y="933"/>
                    </a:lnTo>
                    <a:lnTo>
                      <a:pt x="1049" y="933"/>
                    </a:lnTo>
                    <a:lnTo>
                      <a:pt x="1056" y="933"/>
                    </a:lnTo>
                    <a:lnTo>
                      <a:pt x="1064" y="931"/>
                    </a:lnTo>
                    <a:lnTo>
                      <a:pt x="1070" y="931"/>
                    </a:lnTo>
                    <a:lnTo>
                      <a:pt x="1078" y="931"/>
                    </a:lnTo>
                    <a:lnTo>
                      <a:pt x="1083" y="931"/>
                    </a:lnTo>
                    <a:lnTo>
                      <a:pt x="1091" y="931"/>
                    </a:lnTo>
                    <a:lnTo>
                      <a:pt x="1099" y="931"/>
                    </a:lnTo>
                    <a:lnTo>
                      <a:pt x="1104" y="931"/>
                    </a:lnTo>
                    <a:lnTo>
                      <a:pt x="1112" y="931"/>
                    </a:lnTo>
                    <a:lnTo>
                      <a:pt x="1118" y="931"/>
                    </a:lnTo>
                    <a:lnTo>
                      <a:pt x="1126" y="929"/>
                    </a:lnTo>
                    <a:lnTo>
                      <a:pt x="1133" y="929"/>
                    </a:lnTo>
                    <a:lnTo>
                      <a:pt x="1139" y="929"/>
                    </a:lnTo>
                    <a:lnTo>
                      <a:pt x="1147" y="929"/>
                    </a:lnTo>
                    <a:lnTo>
                      <a:pt x="1152" y="929"/>
                    </a:lnTo>
                    <a:lnTo>
                      <a:pt x="1160" y="929"/>
                    </a:lnTo>
                    <a:lnTo>
                      <a:pt x="1168" y="927"/>
                    </a:lnTo>
                    <a:lnTo>
                      <a:pt x="1174" y="927"/>
                    </a:lnTo>
                    <a:lnTo>
                      <a:pt x="1181" y="927"/>
                    </a:lnTo>
                    <a:lnTo>
                      <a:pt x="1187" y="927"/>
                    </a:lnTo>
                    <a:lnTo>
                      <a:pt x="1195" y="927"/>
                    </a:lnTo>
                    <a:lnTo>
                      <a:pt x="1200" y="925"/>
                    </a:lnTo>
                    <a:lnTo>
                      <a:pt x="1208" y="925"/>
                    </a:lnTo>
                    <a:lnTo>
                      <a:pt x="1216" y="925"/>
                    </a:lnTo>
                    <a:lnTo>
                      <a:pt x="1222" y="925"/>
                    </a:lnTo>
                    <a:lnTo>
                      <a:pt x="1229" y="925"/>
                    </a:lnTo>
                    <a:lnTo>
                      <a:pt x="1235" y="923"/>
                    </a:lnTo>
                    <a:lnTo>
                      <a:pt x="1243" y="923"/>
                    </a:lnTo>
                    <a:lnTo>
                      <a:pt x="1250" y="923"/>
                    </a:lnTo>
                    <a:lnTo>
                      <a:pt x="1256" y="923"/>
                    </a:lnTo>
                    <a:lnTo>
                      <a:pt x="1264" y="921"/>
                    </a:lnTo>
                    <a:lnTo>
                      <a:pt x="1270" y="921"/>
                    </a:lnTo>
                    <a:lnTo>
                      <a:pt x="1277" y="921"/>
                    </a:lnTo>
                    <a:lnTo>
                      <a:pt x="1285" y="919"/>
                    </a:lnTo>
                    <a:lnTo>
                      <a:pt x="1291" y="919"/>
                    </a:lnTo>
                    <a:lnTo>
                      <a:pt x="1298" y="919"/>
                    </a:lnTo>
                    <a:lnTo>
                      <a:pt x="1304" y="917"/>
                    </a:lnTo>
                    <a:lnTo>
                      <a:pt x="1312" y="917"/>
                    </a:lnTo>
                    <a:lnTo>
                      <a:pt x="1318" y="917"/>
                    </a:lnTo>
                    <a:lnTo>
                      <a:pt x="1325" y="915"/>
                    </a:lnTo>
                    <a:lnTo>
                      <a:pt x="1333" y="915"/>
                    </a:lnTo>
                    <a:lnTo>
                      <a:pt x="1339" y="915"/>
                    </a:lnTo>
                    <a:lnTo>
                      <a:pt x="1346" y="913"/>
                    </a:lnTo>
                    <a:lnTo>
                      <a:pt x="1352" y="913"/>
                    </a:lnTo>
                    <a:lnTo>
                      <a:pt x="1360" y="913"/>
                    </a:lnTo>
                    <a:lnTo>
                      <a:pt x="1367" y="911"/>
                    </a:lnTo>
                    <a:lnTo>
                      <a:pt x="1373" y="911"/>
                    </a:lnTo>
                    <a:lnTo>
                      <a:pt x="1381" y="909"/>
                    </a:lnTo>
                    <a:lnTo>
                      <a:pt x="1387" y="909"/>
                    </a:lnTo>
                    <a:lnTo>
                      <a:pt x="1394" y="909"/>
                    </a:lnTo>
                    <a:lnTo>
                      <a:pt x="1402" y="908"/>
                    </a:lnTo>
                    <a:lnTo>
                      <a:pt x="1408" y="908"/>
                    </a:lnTo>
                    <a:lnTo>
                      <a:pt x="1415" y="906"/>
                    </a:lnTo>
                    <a:lnTo>
                      <a:pt x="1421" y="906"/>
                    </a:lnTo>
                    <a:lnTo>
                      <a:pt x="1429" y="904"/>
                    </a:lnTo>
                    <a:lnTo>
                      <a:pt x="1435" y="904"/>
                    </a:lnTo>
                    <a:lnTo>
                      <a:pt x="1442" y="902"/>
                    </a:lnTo>
                    <a:lnTo>
                      <a:pt x="1450" y="902"/>
                    </a:lnTo>
                    <a:lnTo>
                      <a:pt x="1456" y="902"/>
                    </a:lnTo>
                    <a:lnTo>
                      <a:pt x="1463" y="900"/>
                    </a:lnTo>
                    <a:lnTo>
                      <a:pt x="1469" y="900"/>
                    </a:lnTo>
                    <a:lnTo>
                      <a:pt x="1477" y="898"/>
                    </a:lnTo>
                    <a:lnTo>
                      <a:pt x="1485" y="898"/>
                    </a:lnTo>
                    <a:lnTo>
                      <a:pt x="1490" y="896"/>
                    </a:lnTo>
                    <a:lnTo>
                      <a:pt x="1498" y="896"/>
                    </a:lnTo>
                    <a:lnTo>
                      <a:pt x="1504" y="894"/>
                    </a:lnTo>
                    <a:lnTo>
                      <a:pt x="1511" y="894"/>
                    </a:lnTo>
                    <a:lnTo>
                      <a:pt x="1519" y="894"/>
                    </a:lnTo>
                    <a:lnTo>
                      <a:pt x="1525" y="892"/>
                    </a:lnTo>
                    <a:lnTo>
                      <a:pt x="1533" y="892"/>
                    </a:lnTo>
                    <a:lnTo>
                      <a:pt x="1538" y="892"/>
                    </a:lnTo>
                    <a:lnTo>
                      <a:pt x="1546" y="890"/>
                    </a:lnTo>
                    <a:lnTo>
                      <a:pt x="1554" y="890"/>
                    </a:lnTo>
                    <a:lnTo>
                      <a:pt x="1559" y="888"/>
                    </a:lnTo>
                    <a:lnTo>
                      <a:pt x="1567" y="888"/>
                    </a:lnTo>
                    <a:lnTo>
                      <a:pt x="1573" y="888"/>
                    </a:lnTo>
                    <a:lnTo>
                      <a:pt x="1581" y="886"/>
                    </a:lnTo>
                    <a:lnTo>
                      <a:pt x="1586" y="886"/>
                    </a:lnTo>
                    <a:lnTo>
                      <a:pt x="1594" y="886"/>
                    </a:lnTo>
                    <a:lnTo>
                      <a:pt x="1602" y="885"/>
                    </a:lnTo>
                    <a:lnTo>
                      <a:pt x="1607" y="885"/>
                    </a:lnTo>
                    <a:lnTo>
                      <a:pt x="1615" y="885"/>
                    </a:lnTo>
                    <a:lnTo>
                      <a:pt x="1621" y="885"/>
                    </a:lnTo>
                    <a:lnTo>
                      <a:pt x="1629" y="883"/>
                    </a:lnTo>
                    <a:lnTo>
                      <a:pt x="1636" y="883"/>
                    </a:lnTo>
                    <a:lnTo>
                      <a:pt x="1642" y="883"/>
                    </a:lnTo>
                    <a:lnTo>
                      <a:pt x="1650" y="883"/>
                    </a:lnTo>
                    <a:lnTo>
                      <a:pt x="1655" y="881"/>
                    </a:lnTo>
                    <a:lnTo>
                      <a:pt x="1663" y="881"/>
                    </a:lnTo>
                    <a:lnTo>
                      <a:pt x="1671" y="881"/>
                    </a:lnTo>
                    <a:lnTo>
                      <a:pt x="1677" y="881"/>
                    </a:lnTo>
                    <a:lnTo>
                      <a:pt x="1684" y="879"/>
                    </a:lnTo>
                    <a:lnTo>
                      <a:pt x="1690" y="879"/>
                    </a:lnTo>
                    <a:lnTo>
                      <a:pt x="1698" y="879"/>
                    </a:lnTo>
                    <a:lnTo>
                      <a:pt x="1703" y="879"/>
                    </a:lnTo>
                    <a:lnTo>
                      <a:pt x="1711" y="877"/>
                    </a:lnTo>
                    <a:lnTo>
                      <a:pt x="1719" y="877"/>
                    </a:lnTo>
                    <a:lnTo>
                      <a:pt x="1725" y="877"/>
                    </a:lnTo>
                    <a:lnTo>
                      <a:pt x="1732" y="877"/>
                    </a:lnTo>
                    <a:lnTo>
                      <a:pt x="1738" y="877"/>
                    </a:lnTo>
                    <a:lnTo>
                      <a:pt x="1746" y="877"/>
                    </a:lnTo>
                    <a:lnTo>
                      <a:pt x="1753" y="877"/>
                    </a:lnTo>
                    <a:lnTo>
                      <a:pt x="1759" y="875"/>
                    </a:lnTo>
                    <a:lnTo>
                      <a:pt x="1767" y="875"/>
                    </a:lnTo>
                    <a:lnTo>
                      <a:pt x="1773" y="875"/>
                    </a:lnTo>
                    <a:lnTo>
                      <a:pt x="1780" y="875"/>
                    </a:lnTo>
                    <a:lnTo>
                      <a:pt x="1788" y="873"/>
                    </a:lnTo>
                    <a:lnTo>
                      <a:pt x="1794" y="873"/>
                    </a:lnTo>
                    <a:lnTo>
                      <a:pt x="1801" y="871"/>
                    </a:lnTo>
                    <a:lnTo>
                      <a:pt x="1807" y="871"/>
                    </a:lnTo>
                    <a:lnTo>
                      <a:pt x="1815" y="869"/>
                    </a:lnTo>
                    <a:lnTo>
                      <a:pt x="1823" y="867"/>
                    </a:lnTo>
                    <a:lnTo>
                      <a:pt x="1828" y="865"/>
                    </a:lnTo>
                    <a:lnTo>
                      <a:pt x="1836" y="863"/>
                    </a:lnTo>
                    <a:lnTo>
                      <a:pt x="1842" y="862"/>
                    </a:lnTo>
                    <a:lnTo>
                      <a:pt x="1849" y="862"/>
                    </a:lnTo>
                    <a:lnTo>
                      <a:pt x="1855" y="860"/>
                    </a:lnTo>
                    <a:lnTo>
                      <a:pt x="1863" y="858"/>
                    </a:lnTo>
                    <a:lnTo>
                      <a:pt x="1871" y="858"/>
                    </a:lnTo>
                    <a:lnTo>
                      <a:pt x="1876" y="858"/>
                    </a:lnTo>
                    <a:lnTo>
                      <a:pt x="1884" y="860"/>
                    </a:lnTo>
                    <a:lnTo>
                      <a:pt x="1890" y="860"/>
                    </a:lnTo>
                    <a:lnTo>
                      <a:pt x="1897" y="862"/>
                    </a:lnTo>
                    <a:lnTo>
                      <a:pt x="1905" y="862"/>
                    </a:lnTo>
                    <a:lnTo>
                      <a:pt x="1911" y="863"/>
                    </a:lnTo>
                    <a:lnTo>
                      <a:pt x="1919" y="863"/>
                    </a:lnTo>
                    <a:lnTo>
                      <a:pt x="1924" y="865"/>
                    </a:lnTo>
                    <a:lnTo>
                      <a:pt x="1932" y="865"/>
                    </a:lnTo>
                    <a:lnTo>
                      <a:pt x="1940" y="865"/>
                    </a:lnTo>
                    <a:lnTo>
                      <a:pt x="1945" y="867"/>
                    </a:lnTo>
                    <a:lnTo>
                      <a:pt x="1953" y="867"/>
                    </a:lnTo>
                    <a:lnTo>
                      <a:pt x="1959" y="867"/>
                    </a:lnTo>
                    <a:lnTo>
                      <a:pt x="1967" y="867"/>
                    </a:lnTo>
                    <a:lnTo>
                      <a:pt x="1972" y="867"/>
                    </a:lnTo>
                    <a:lnTo>
                      <a:pt x="1980" y="867"/>
                    </a:lnTo>
                    <a:lnTo>
                      <a:pt x="1988" y="867"/>
                    </a:lnTo>
                    <a:lnTo>
                      <a:pt x="1993" y="867"/>
                    </a:lnTo>
                    <a:lnTo>
                      <a:pt x="2001" y="867"/>
                    </a:lnTo>
                    <a:lnTo>
                      <a:pt x="2007" y="867"/>
                    </a:lnTo>
                    <a:lnTo>
                      <a:pt x="2015" y="867"/>
                    </a:lnTo>
                    <a:lnTo>
                      <a:pt x="2022" y="867"/>
                    </a:lnTo>
                    <a:lnTo>
                      <a:pt x="2028" y="867"/>
                    </a:lnTo>
                    <a:lnTo>
                      <a:pt x="2036" y="867"/>
                    </a:lnTo>
                    <a:lnTo>
                      <a:pt x="2041" y="867"/>
                    </a:lnTo>
                    <a:lnTo>
                      <a:pt x="2049" y="867"/>
                    </a:lnTo>
                    <a:lnTo>
                      <a:pt x="2057" y="867"/>
                    </a:lnTo>
                    <a:lnTo>
                      <a:pt x="2063" y="867"/>
                    </a:lnTo>
                    <a:lnTo>
                      <a:pt x="2070" y="867"/>
                    </a:lnTo>
                    <a:lnTo>
                      <a:pt x="2076" y="867"/>
                    </a:lnTo>
                    <a:lnTo>
                      <a:pt x="2084" y="867"/>
                    </a:lnTo>
                    <a:lnTo>
                      <a:pt x="2089" y="867"/>
                    </a:lnTo>
                    <a:lnTo>
                      <a:pt x="2097" y="865"/>
                    </a:lnTo>
                    <a:lnTo>
                      <a:pt x="2105" y="865"/>
                    </a:lnTo>
                    <a:lnTo>
                      <a:pt x="2111" y="865"/>
                    </a:lnTo>
                    <a:lnTo>
                      <a:pt x="2118" y="865"/>
                    </a:lnTo>
                    <a:lnTo>
                      <a:pt x="2124" y="865"/>
                    </a:lnTo>
                    <a:lnTo>
                      <a:pt x="2132" y="865"/>
                    </a:lnTo>
                    <a:lnTo>
                      <a:pt x="2139" y="865"/>
                    </a:lnTo>
                    <a:lnTo>
                      <a:pt x="2145" y="865"/>
                    </a:lnTo>
                    <a:lnTo>
                      <a:pt x="2153" y="865"/>
                    </a:lnTo>
                    <a:lnTo>
                      <a:pt x="2159" y="863"/>
                    </a:lnTo>
                    <a:lnTo>
                      <a:pt x="2166" y="863"/>
                    </a:lnTo>
                    <a:lnTo>
                      <a:pt x="2174" y="862"/>
                    </a:lnTo>
                    <a:lnTo>
                      <a:pt x="2180" y="860"/>
                    </a:lnTo>
                    <a:lnTo>
                      <a:pt x="2187" y="856"/>
                    </a:lnTo>
                    <a:lnTo>
                      <a:pt x="2193" y="854"/>
                    </a:lnTo>
                    <a:lnTo>
                      <a:pt x="2201" y="852"/>
                    </a:lnTo>
                    <a:lnTo>
                      <a:pt x="2208" y="852"/>
                    </a:lnTo>
                    <a:lnTo>
                      <a:pt x="2214" y="852"/>
                    </a:lnTo>
                    <a:lnTo>
                      <a:pt x="2222" y="852"/>
                    </a:lnTo>
                    <a:lnTo>
                      <a:pt x="2228" y="854"/>
                    </a:lnTo>
                    <a:lnTo>
                      <a:pt x="2235" y="856"/>
                    </a:lnTo>
                    <a:lnTo>
                      <a:pt x="2241" y="858"/>
                    </a:lnTo>
                    <a:lnTo>
                      <a:pt x="2249" y="858"/>
                    </a:lnTo>
                    <a:lnTo>
                      <a:pt x="2256" y="860"/>
                    </a:lnTo>
                    <a:lnTo>
                      <a:pt x="2262" y="860"/>
                    </a:lnTo>
                    <a:lnTo>
                      <a:pt x="2270" y="860"/>
                    </a:lnTo>
                    <a:lnTo>
                      <a:pt x="2276" y="860"/>
                    </a:lnTo>
                    <a:lnTo>
                      <a:pt x="2283" y="860"/>
                    </a:lnTo>
                    <a:lnTo>
                      <a:pt x="2291" y="860"/>
                    </a:lnTo>
                    <a:lnTo>
                      <a:pt x="2297" y="858"/>
                    </a:lnTo>
                    <a:lnTo>
                      <a:pt x="2304" y="858"/>
                    </a:lnTo>
                    <a:lnTo>
                      <a:pt x="2310" y="856"/>
                    </a:lnTo>
                    <a:lnTo>
                      <a:pt x="2318" y="856"/>
                    </a:lnTo>
                    <a:lnTo>
                      <a:pt x="2326" y="856"/>
                    </a:lnTo>
                    <a:lnTo>
                      <a:pt x="2331" y="856"/>
                    </a:lnTo>
                    <a:lnTo>
                      <a:pt x="2339" y="856"/>
                    </a:lnTo>
                    <a:lnTo>
                      <a:pt x="2345" y="858"/>
                    </a:lnTo>
                    <a:lnTo>
                      <a:pt x="2352" y="858"/>
                    </a:lnTo>
                    <a:lnTo>
                      <a:pt x="2358" y="858"/>
                    </a:lnTo>
                    <a:lnTo>
                      <a:pt x="2366" y="860"/>
                    </a:lnTo>
                    <a:lnTo>
                      <a:pt x="2374" y="860"/>
                    </a:lnTo>
                    <a:lnTo>
                      <a:pt x="2379" y="860"/>
                    </a:lnTo>
                    <a:lnTo>
                      <a:pt x="2387" y="860"/>
                    </a:lnTo>
                    <a:lnTo>
                      <a:pt x="2393" y="860"/>
                    </a:lnTo>
                    <a:lnTo>
                      <a:pt x="2400" y="860"/>
                    </a:lnTo>
                    <a:lnTo>
                      <a:pt x="2408" y="860"/>
                    </a:lnTo>
                    <a:lnTo>
                      <a:pt x="2414" y="860"/>
                    </a:lnTo>
                    <a:lnTo>
                      <a:pt x="2422" y="860"/>
                    </a:lnTo>
                    <a:lnTo>
                      <a:pt x="2427" y="860"/>
                    </a:lnTo>
                    <a:lnTo>
                      <a:pt x="2435" y="858"/>
                    </a:lnTo>
                    <a:lnTo>
                      <a:pt x="2443" y="856"/>
                    </a:lnTo>
                    <a:lnTo>
                      <a:pt x="2448" y="852"/>
                    </a:lnTo>
                    <a:lnTo>
                      <a:pt x="2456" y="848"/>
                    </a:lnTo>
                    <a:lnTo>
                      <a:pt x="2462" y="846"/>
                    </a:lnTo>
                    <a:lnTo>
                      <a:pt x="2470" y="844"/>
                    </a:lnTo>
                    <a:lnTo>
                      <a:pt x="2477" y="844"/>
                    </a:lnTo>
                    <a:lnTo>
                      <a:pt x="2483" y="844"/>
                    </a:lnTo>
                    <a:lnTo>
                      <a:pt x="2491" y="846"/>
                    </a:lnTo>
                    <a:lnTo>
                      <a:pt x="2496" y="848"/>
                    </a:lnTo>
                    <a:lnTo>
                      <a:pt x="2504" y="850"/>
                    </a:lnTo>
                    <a:lnTo>
                      <a:pt x="2510" y="850"/>
                    </a:lnTo>
                    <a:lnTo>
                      <a:pt x="2518" y="850"/>
                    </a:lnTo>
                    <a:lnTo>
                      <a:pt x="2525" y="850"/>
                    </a:lnTo>
                    <a:lnTo>
                      <a:pt x="2531" y="850"/>
                    </a:lnTo>
                    <a:lnTo>
                      <a:pt x="2539" y="850"/>
                    </a:lnTo>
                    <a:lnTo>
                      <a:pt x="2544" y="850"/>
                    </a:lnTo>
                    <a:lnTo>
                      <a:pt x="2552" y="850"/>
                    </a:lnTo>
                    <a:lnTo>
                      <a:pt x="2560" y="850"/>
                    </a:lnTo>
                    <a:lnTo>
                      <a:pt x="2566" y="852"/>
                    </a:lnTo>
                    <a:lnTo>
                      <a:pt x="2573" y="852"/>
                    </a:lnTo>
                    <a:lnTo>
                      <a:pt x="2579" y="854"/>
                    </a:lnTo>
                    <a:lnTo>
                      <a:pt x="2587" y="854"/>
                    </a:lnTo>
                    <a:lnTo>
                      <a:pt x="2594" y="856"/>
                    </a:lnTo>
                    <a:lnTo>
                      <a:pt x="2600" y="856"/>
                    </a:lnTo>
                    <a:lnTo>
                      <a:pt x="2608" y="858"/>
                    </a:lnTo>
                    <a:lnTo>
                      <a:pt x="2614" y="858"/>
                    </a:lnTo>
                    <a:lnTo>
                      <a:pt x="2621" y="858"/>
                    </a:lnTo>
                    <a:lnTo>
                      <a:pt x="2627" y="858"/>
                    </a:lnTo>
                    <a:lnTo>
                      <a:pt x="2635" y="858"/>
                    </a:lnTo>
                    <a:lnTo>
                      <a:pt x="2642" y="860"/>
                    </a:lnTo>
                    <a:lnTo>
                      <a:pt x="2648" y="860"/>
                    </a:lnTo>
                    <a:lnTo>
                      <a:pt x="2656" y="860"/>
                    </a:lnTo>
                    <a:lnTo>
                      <a:pt x="2662" y="860"/>
                    </a:lnTo>
                    <a:lnTo>
                      <a:pt x="2669" y="860"/>
                    </a:lnTo>
                    <a:lnTo>
                      <a:pt x="2677" y="860"/>
                    </a:lnTo>
                    <a:lnTo>
                      <a:pt x="2683" y="860"/>
                    </a:lnTo>
                    <a:lnTo>
                      <a:pt x="2690" y="860"/>
                    </a:lnTo>
                    <a:lnTo>
                      <a:pt x="2696" y="860"/>
                    </a:lnTo>
                    <a:lnTo>
                      <a:pt x="2704" y="860"/>
                    </a:lnTo>
                    <a:lnTo>
                      <a:pt x="2712" y="860"/>
                    </a:lnTo>
                    <a:lnTo>
                      <a:pt x="2717" y="860"/>
                    </a:lnTo>
                    <a:lnTo>
                      <a:pt x="2725" y="860"/>
                    </a:lnTo>
                    <a:lnTo>
                      <a:pt x="2731" y="860"/>
                    </a:lnTo>
                    <a:lnTo>
                      <a:pt x="2738" y="860"/>
                    </a:lnTo>
                    <a:lnTo>
                      <a:pt x="2744" y="860"/>
                    </a:lnTo>
                    <a:lnTo>
                      <a:pt x="2752" y="860"/>
                    </a:lnTo>
                    <a:lnTo>
                      <a:pt x="2760" y="858"/>
                    </a:lnTo>
                    <a:lnTo>
                      <a:pt x="2765" y="858"/>
                    </a:lnTo>
                    <a:lnTo>
                      <a:pt x="2773" y="858"/>
                    </a:lnTo>
                    <a:lnTo>
                      <a:pt x="2779" y="858"/>
                    </a:lnTo>
                    <a:lnTo>
                      <a:pt x="2786" y="858"/>
                    </a:lnTo>
                    <a:lnTo>
                      <a:pt x="2794" y="858"/>
                    </a:lnTo>
                    <a:lnTo>
                      <a:pt x="2800" y="858"/>
                    </a:lnTo>
                    <a:lnTo>
                      <a:pt x="2808" y="858"/>
                    </a:lnTo>
                    <a:lnTo>
                      <a:pt x="2813" y="858"/>
                    </a:lnTo>
                    <a:lnTo>
                      <a:pt x="2821" y="858"/>
                    </a:lnTo>
                    <a:lnTo>
                      <a:pt x="2829" y="858"/>
                    </a:lnTo>
                    <a:lnTo>
                      <a:pt x="2834" y="858"/>
                    </a:lnTo>
                    <a:lnTo>
                      <a:pt x="2842" y="858"/>
                    </a:lnTo>
                    <a:lnTo>
                      <a:pt x="2848" y="858"/>
                    </a:lnTo>
                    <a:lnTo>
                      <a:pt x="2856" y="858"/>
                    </a:lnTo>
                    <a:lnTo>
                      <a:pt x="2863" y="858"/>
                    </a:lnTo>
                    <a:lnTo>
                      <a:pt x="2869" y="858"/>
                    </a:lnTo>
                    <a:lnTo>
                      <a:pt x="2877" y="858"/>
                    </a:lnTo>
                    <a:lnTo>
                      <a:pt x="2882" y="858"/>
                    </a:lnTo>
                    <a:lnTo>
                      <a:pt x="2890" y="858"/>
                    </a:lnTo>
                    <a:lnTo>
                      <a:pt x="2896" y="858"/>
                    </a:lnTo>
                    <a:lnTo>
                      <a:pt x="2904" y="858"/>
                    </a:lnTo>
                    <a:lnTo>
                      <a:pt x="2911" y="858"/>
                    </a:lnTo>
                    <a:lnTo>
                      <a:pt x="2917" y="858"/>
                    </a:lnTo>
                    <a:lnTo>
                      <a:pt x="2925" y="858"/>
                    </a:lnTo>
                    <a:lnTo>
                      <a:pt x="2930" y="858"/>
                    </a:lnTo>
                    <a:lnTo>
                      <a:pt x="2938" y="856"/>
                    </a:lnTo>
                    <a:lnTo>
                      <a:pt x="2946" y="856"/>
                    </a:lnTo>
                    <a:lnTo>
                      <a:pt x="2952" y="856"/>
                    </a:lnTo>
                    <a:lnTo>
                      <a:pt x="2959" y="856"/>
                    </a:lnTo>
                    <a:lnTo>
                      <a:pt x="2965" y="856"/>
                    </a:lnTo>
                    <a:lnTo>
                      <a:pt x="2973" y="856"/>
                    </a:lnTo>
                    <a:lnTo>
                      <a:pt x="2980" y="856"/>
                    </a:lnTo>
                    <a:lnTo>
                      <a:pt x="2986" y="856"/>
                    </a:lnTo>
                    <a:lnTo>
                      <a:pt x="2994" y="856"/>
                    </a:lnTo>
                    <a:lnTo>
                      <a:pt x="3000" y="856"/>
                    </a:lnTo>
                    <a:lnTo>
                      <a:pt x="3007" y="856"/>
                    </a:lnTo>
                    <a:lnTo>
                      <a:pt x="3013" y="856"/>
                    </a:lnTo>
                    <a:lnTo>
                      <a:pt x="3021" y="856"/>
                    </a:lnTo>
                    <a:lnTo>
                      <a:pt x="3028" y="856"/>
                    </a:lnTo>
                    <a:lnTo>
                      <a:pt x="3034" y="856"/>
                    </a:lnTo>
                    <a:lnTo>
                      <a:pt x="3042" y="856"/>
                    </a:lnTo>
                    <a:lnTo>
                      <a:pt x="3048" y="856"/>
                    </a:lnTo>
                    <a:lnTo>
                      <a:pt x="3055" y="856"/>
                    </a:lnTo>
                    <a:lnTo>
                      <a:pt x="3063" y="856"/>
                    </a:lnTo>
                    <a:lnTo>
                      <a:pt x="3069" y="856"/>
                    </a:lnTo>
                    <a:lnTo>
                      <a:pt x="3076" y="856"/>
                    </a:lnTo>
                    <a:lnTo>
                      <a:pt x="3082" y="854"/>
                    </a:lnTo>
                    <a:lnTo>
                      <a:pt x="3090" y="854"/>
                    </a:lnTo>
                    <a:lnTo>
                      <a:pt x="3097" y="854"/>
                    </a:lnTo>
                    <a:lnTo>
                      <a:pt x="3103" y="854"/>
                    </a:lnTo>
                    <a:lnTo>
                      <a:pt x="3111" y="854"/>
                    </a:lnTo>
                    <a:lnTo>
                      <a:pt x="3117" y="854"/>
                    </a:lnTo>
                    <a:lnTo>
                      <a:pt x="3124" y="854"/>
                    </a:lnTo>
                    <a:lnTo>
                      <a:pt x="3132" y="854"/>
                    </a:lnTo>
                    <a:lnTo>
                      <a:pt x="3138" y="854"/>
                    </a:lnTo>
                    <a:lnTo>
                      <a:pt x="3145" y="854"/>
                    </a:lnTo>
                    <a:lnTo>
                      <a:pt x="3151" y="854"/>
                    </a:lnTo>
                    <a:lnTo>
                      <a:pt x="3159" y="854"/>
                    </a:lnTo>
                    <a:lnTo>
                      <a:pt x="3165" y="854"/>
                    </a:lnTo>
                    <a:lnTo>
                      <a:pt x="3172" y="854"/>
                    </a:lnTo>
                    <a:lnTo>
                      <a:pt x="3180" y="854"/>
                    </a:lnTo>
                    <a:lnTo>
                      <a:pt x="3186" y="852"/>
                    </a:lnTo>
                    <a:lnTo>
                      <a:pt x="3193" y="852"/>
                    </a:lnTo>
                    <a:lnTo>
                      <a:pt x="3199" y="852"/>
                    </a:lnTo>
                    <a:lnTo>
                      <a:pt x="3207" y="852"/>
                    </a:lnTo>
                    <a:lnTo>
                      <a:pt x="3215" y="852"/>
                    </a:lnTo>
                    <a:lnTo>
                      <a:pt x="3220" y="852"/>
                    </a:lnTo>
                    <a:lnTo>
                      <a:pt x="3228" y="852"/>
                    </a:lnTo>
                    <a:lnTo>
                      <a:pt x="3234" y="852"/>
                    </a:lnTo>
                    <a:lnTo>
                      <a:pt x="3241" y="852"/>
                    </a:lnTo>
                    <a:lnTo>
                      <a:pt x="3249" y="852"/>
                    </a:lnTo>
                    <a:lnTo>
                      <a:pt x="3255" y="852"/>
                    </a:lnTo>
                    <a:lnTo>
                      <a:pt x="3263" y="852"/>
                    </a:lnTo>
                    <a:lnTo>
                      <a:pt x="3268" y="852"/>
                    </a:lnTo>
                    <a:lnTo>
                      <a:pt x="3276" y="852"/>
                    </a:lnTo>
                    <a:lnTo>
                      <a:pt x="3282" y="852"/>
                    </a:lnTo>
                    <a:lnTo>
                      <a:pt x="3289" y="852"/>
                    </a:lnTo>
                    <a:lnTo>
                      <a:pt x="3297" y="852"/>
                    </a:lnTo>
                    <a:lnTo>
                      <a:pt x="3303" y="852"/>
                    </a:lnTo>
                    <a:lnTo>
                      <a:pt x="3311" y="852"/>
                    </a:lnTo>
                    <a:lnTo>
                      <a:pt x="3316" y="852"/>
                    </a:lnTo>
                    <a:lnTo>
                      <a:pt x="3324" y="852"/>
                    </a:lnTo>
                    <a:lnTo>
                      <a:pt x="3332" y="850"/>
                    </a:lnTo>
                    <a:lnTo>
                      <a:pt x="3337" y="850"/>
                    </a:lnTo>
                    <a:lnTo>
                      <a:pt x="3345" y="850"/>
                    </a:lnTo>
                    <a:lnTo>
                      <a:pt x="3351" y="850"/>
                    </a:lnTo>
                    <a:lnTo>
                      <a:pt x="3359" y="850"/>
                    </a:lnTo>
                    <a:lnTo>
                      <a:pt x="3366" y="850"/>
                    </a:lnTo>
                    <a:lnTo>
                      <a:pt x="3372" y="850"/>
                    </a:lnTo>
                    <a:lnTo>
                      <a:pt x="3380" y="850"/>
                    </a:lnTo>
                    <a:lnTo>
                      <a:pt x="3385" y="850"/>
                    </a:lnTo>
                    <a:lnTo>
                      <a:pt x="3393" y="850"/>
                    </a:lnTo>
                    <a:lnTo>
                      <a:pt x="3399" y="850"/>
                    </a:lnTo>
                    <a:lnTo>
                      <a:pt x="3407" y="850"/>
                    </a:lnTo>
                    <a:lnTo>
                      <a:pt x="3414" y="850"/>
                    </a:lnTo>
                    <a:lnTo>
                      <a:pt x="3420" y="850"/>
                    </a:lnTo>
                    <a:lnTo>
                      <a:pt x="3428" y="850"/>
                    </a:lnTo>
                    <a:lnTo>
                      <a:pt x="3433" y="850"/>
                    </a:lnTo>
                    <a:lnTo>
                      <a:pt x="3441" y="850"/>
                    </a:lnTo>
                    <a:lnTo>
                      <a:pt x="3449" y="848"/>
                    </a:lnTo>
                    <a:lnTo>
                      <a:pt x="3455" y="848"/>
                    </a:lnTo>
                    <a:lnTo>
                      <a:pt x="3462" y="848"/>
                    </a:lnTo>
                    <a:lnTo>
                      <a:pt x="3468" y="848"/>
                    </a:lnTo>
                    <a:lnTo>
                      <a:pt x="3476" y="848"/>
                    </a:lnTo>
                    <a:lnTo>
                      <a:pt x="3483" y="848"/>
                    </a:lnTo>
                    <a:lnTo>
                      <a:pt x="3489" y="848"/>
                    </a:lnTo>
                    <a:lnTo>
                      <a:pt x="3497" y="848"/>
                    </a:lnTo>
                    <a:lnTo>
                      <a:pt x="3503" y="848"/>
                    </a:lnTo>
                    <a:lnTo>
                      <a:pt x="3510" y="848"/>
                    </a:lnTo>
                    <a:lnTo>
                      <a:pt x="3518" y="848"/>
                    </a:lnTo>
                    <a:lnTo>
                      <a:pt x="3524" y="848"/>
                    </a:lnTo>
                    <a:lnTo>
                      <a:pt x="3531" y="848"/>
                    </a:lnTo>
                    <a:lnTo>
                      <a:pt x="3537" y="848"/>
                    </a:lnTo>
                    <a:lnTo>
                      <a:pt x="3545" y="848"/>
                    </a:lnTo>
                    <a:lnTo>
                      <a:pt x="3551" y="848"/>
                    </a:lnTo>
                    <a:lnTo>
                      <a:pt x="3558" y="846"/>
                    </a:lnTo>
                    <a:lnTo>
                      <a:pt x="3566" y="846"/>
                    </a:lnTo>
                    <a:lnTo>
                      <a:pt x="3572" y="846"/>
                    </a:lnTo>
                    <a:lnTo>
                      <a:pt x="3579" y="846"/>
                    </a:lnTo>
                    <a:lnTo>
                      <a:pt x="3585" y="846"/>
                    </a:lnTo>
                    <a:lnTo>
                      <a:pt x="3593" y="846"/>
                    </a:lnTo>
                    <a:lnTo>
                      <a:pt x="3601" y="846"/>
                    </a:lnTo>
                    <a:lnTo>
                      <a:pt x="3606" y="846"/>
                    </a:lnTo>
                    <a:lnTo>
                      <a:pt x="3614" y="846"/>
                    </a:lnTo>
                    <a:lnTo>
                      <a:pt x="3620" y="846"/>
                    </a:lnTo>
                    <a:lnTo>
                      <a:pt x="3627" y="846"/>
                    </a:lnTo>
                    <a:lnTo>
                      <a:pt x="3635" y="846"/>
                    </a:lnTo>
                    <a:lnTo>
                      <a:pt x="3641" y="846"/>
                    </a:lnTo>
                    <a:lnTo>
                      <a:pt x="3649" y="846"/>
                    </a:lnTo>
                    <a:lnTo>
                      <a:pt x="3654" y="846"/>
                    </a:lnTo>
                    <a:lnTo>
                      <a:pt x="3662" y="846"/>
                    </a:lnTo>
                    <a:lnTo>
                      <a:pt x="3668" y="846"/>
                    </a:lnTo>
                    <a:lnTo>
                      <a:pt x="3675" y="846"/>
                    </a:lnTo>
                    <a:lnTo>
                      <a:pt x="3683" y="846"/>
                    </a:lnTo>
                    <a:lnTo>
                      <a:pt x="3689" y="844"/>
                    </a:lnTo>
                    <a:lnTo>
                      <a:pt x="3697" y="844"/>
                    </a:lnTo>
                    <a:lnTo>
                      <a:pt x="3702" y="844"/>
                    </a:lnTo>
                    <a:lnTo>
                      <a:pt x="3710" y="844"/>
                    </a:lnTo>
                    <a:lnTo>
                      <a:pt x="3718" y="844"/>
                    </a:lnTo>
                    <a:lnTo>
                      <a:pt x="3723" y="844"/>
                    </a:lnTo>
                    <a:lnTo>
                      <a:pt x="3731" y="844"/>
                    </a:lnTo>
                    <a:lnTo>
                      <a:pt x="3737" y="844"/>
                    </a:lnTo>
                    <a:lnTo>
                      <a:pt x="3745" y="844"/>
                    </a:lnTo>
                    <a:lnTo>
                      <a:pt x="3752" y="844"/>
                    </a:lnTo>
                    <a:lnTo>
                      <a:pt x="3758" y="844"/>
                    </a:lnTo>
                    <a:lnTo>
                      <a:pt x="3766" y="842"/>
                    </a:lnTo>
                    <a:lnTo>
                      <a:pt x="3771" y="842"/>
                    </a:lnTo>
                    <a:lnTo>
                      <a:pt x="3779" y="842"/>
                    </a:lnTo>
                    <a:lnTo>
                      <a:pt x="3785" y="842"/>
                    </a:lnTo>
                    <a:lnTo>
                      <a:pt x="3793" y="842"/>
                    </a:lnTo>
                    <a:lnTo>
                      <a:pt x="3800" y="842"/>
                    </a:lnTo>
                    <a:lnTo>
                      <a:pt x="3806" y="840"/>
                    </a:lnTo>
                    <a:lnTo>
                      <a:pt x="3814" y="840"/>
                    </a:lnTo>
                    <a:lnTo>
                      <a:pt x="3819" y="840"/>
                    </a:lnTo>
                    <a:lnTo>
                      <a:pt x="3827" y="840"/>
                    </a:lnTo>
                    <a:lnTo>
                      <a:pt x="3835" y="838"/>
                    </a:lnTo>
                    <a:lnTo>
                      <a:pt x="3841" y="838"/>
                    </a:lnTo>
                    <a:lnTo>
                      <a:pt x="3848" y="838"/>
                    </a:lnTo>
                    <a:lnTo>
                      <a:pt x="3854" y="838"/>
                    </a:lnTo>
                    <a:lnTo>
                      <a:pt x="3862" y="838"/>
                    </a:lnTo>
                    <a:lnTo>
                      <a:pt x="3869" y="838"/>
                    </a:lnTo>
                    <a:lnTo>
                      <a:pt x="3875" y="838"/>
                    </a:lnTo>
                    <a:lnTo>
                      <a:pt x="3883" y="840"/>
                    </a:lnTo>
                    <a:lnTo>
                      <a:pt x="3889" y="840"/>
                    </a:lnTo>
                    <a:lnTo>
                      <a:pt x="3896" y="840"/>
                    </a:lnTo>
                    <a:lnTo>
                      <a:pt x="3904" y="840"/>
                    </a:lnTo>
                    <a:lnTo>
                      <a:pt x="3910" y="840"/>
                    </a:lnTo>
                    <a:lnTo>
                      <a:pt x="3917" y="840"/>
                    </a:lnTo>
                    <a:lnTo>
                      <a:pt x="3923" y="840"/>
                    </a:lnTo>
                    <a:lnTo>
                      <a:pt x="3931" y="840"/>
                    </a:lnTo>
                    <a:lnTo>
                      <a:pt x="3937" y="840"/>
                    </a:lnTo>
                    <a:lnTo>
                      <a:pt x="3944" y="840"/>
                    </a:lnTo>
                    <a:lnTo>
                      <a:pt x="3952" y="840"/>
                    </a:lnTo>
                    <a:lnTo>
                      <a:pt x="3958" y="840"/>
                    </a:lnTo>
                    <a:lnTo>
                      <a:pt x="3965" y="840"/>
                    </a:lnTo>
                    <a:lnTo>
                      <a:pt x="3971" y="840"/>
                    </a:lnTo>
                    <a:lnTo>
                      <a:pt x="3979" y="840"/>
                    </a:lnTo>
                    <a:lnTo>
                      <a:pt x="3986" y="840"/>
                    </a:lnTo>
                    <a:lnTo>
                      <a:pt x="3992" y="840"/>
                    </a:lnTo>
                    <a:lnTo>
                      <a:pt x="4000" y="840"/>
                    </a:lnTo>
                    <a:lnTo>
                      <a:pt x="4006" y="840"/>
                    </a:lnTo>
                    <a:lnTo>
                      <a:pt x="4013" y="840"/>
                    </a:lnTo>
                    <a:lnTo>
                      <a:pt x="4021" y="840"/>
                    </a:lnTo>
                    <a:lnTo>
                      <a:pt x="4027" y="840"/>
                    </a:lnTo>
                    <a:lnTo>
                      <a:pt x="4034" y="840"/>
                    </a:lnTo>
                    <a:lnTo>
                      <a:pt x="4040" y="840"/>
                    </a:lnTo>
                    <a:lnTo>
                      <a:pt x="4048" y="840"/>
                    </a:lnTo>
                    <a:lnTo>
                      <a:pt x="4054" y="840"/>
                    </a:lnTo>
                    <a:lnTo>
                      <a:pt x="4061" y="838"/>
                    </a:lnTo>
                    <a:lnTo>
                      <a:pt x="4069" y="838"/>
                    </a:lnTo>
                    <a:lnTo>
                      <a:pt x="4075" y="838"/>
                    </a:lnTo>
                    <a:lnTo>
                      <a:pt x="4082" y="838"/>
                    </a:lnTo>
                    <a:lnTo>
                      <a:pt x="4088" y="838"/>
                    </a:lnTo>
                    <a:lnTo>
                      <a:pt x="4096" y="838"/>
                    </a:lnTo>
                    <a:lnTo>
                      <a:pt x="4104" y="838"/>
                    </a:lnTo>
                    <a:lnTo>
                      <a:pt x="4109" y="837"/>
                    </a:lnTo>
                    <a:lnTo>
                      <a:pt x="4117" y="837"/>
                    </a:lnTo>
                    <a:lnTo>
                      <a:pt x="4123" y="837"/>
                    </a:lnTo>
                    <a:lnTo>
                      <a:pt x="4130" y="837"/>
                    </a:lnTo>
                    <a:lnTo>
                      <a:pt x="4138" y="837"/>
                    </a:lnTo>
                    <a:lnTo>
                      <a:pt x="4144" y="835"/>
                    </a:lnTo>
                    <a:lnTo>
                      <a:pt x="4152" y="835"/>
                    </a:lnTo>
                    <a:lnTo>
                      <a:pt x="4157" y="835"/>
                    </a:lnTo>
                    <a:lnTo>
                      <a:pt x="4165" y="835"/>
                    </a:lnTo>
                    <a:lnTo>
                      <a:pt x="4173" y="835"/>
                    </a:lnTo>
                    <a:lnTo>
                      <a:pt x="4178" y="835"/>
                    </a:lnTo>
                    <a:lnTo>
                      <a:pt x="4186" y="835"/>
                    </a:lnTo>
                    <a:lnTo>
                      <a:pt x="4192" y="835"/>
                    </a:lnTo>
                    <a:lnTo>
                      <a:pt x="4200" y="835"/>
                    </a:lnTo>
                    <a:lnTo>
                      <a:pt x="4205" y="835"/>
                    </a:lnTo>
                    <a:lnTo>
                      <a:pt x="4213" y="833"/>
                    </a:lnTo>
                    <a:lnTo>
                      <a:pt x="4221" y="833"/>
                    </a:lnTo>
                    <a:lnTo>
                      <a:pt x="4226" y="833"/>
                    </a:lnTo>
                    <a:lnTo>
                      <a:pt x="4234" y="833"/>
                    </a:lnTo>
                    <a:lnTo>
                      <a:pt x="4240" y="833"/>
                    </a:lnTo>
                    <a:lnTo>
                      <a:pt x="4248" y="833"/>
                    </a:lnTo>
                    <a:lnTo>
                      <a:pt x="4255" y="833"/>
                    </a:lnTo>
                    <a:lnTo>
                      <a:pt x="4261" y="833"/>
                    </a:lnTo>
                    <a:lnTo>
                      <a:pt x="4269" y="833"/>
                    </a:lnTo>
                    <a:lnTo>
                      <a:pt x="4275" y="833"/>
                    </a:lnTo>
                    <a:lnTo>
                      <a:pt x="4282" y="833"/>
                    </a:lnTo>
                    <a:lnTo>
                      <a:pt x="4290" y="833"/>
                    </a:lnTo>
                    <a:lnTo>
                      <a:pt x="4296" y="833"/>
                    </a:lnTo>
                    <a:lnTo>
                      <a:pt x="4303" y="833"/>
                    </a:lnTo>
                    <a:lnTo>
                      <a:pt x="4309" y="831"/>
                    </a:lnTo>
                    <a:lnTo>
                      <a:pt x="4317" y="831"/>
                    </a:lnTo>
                    <a:lnTo>
                      <a:pt x="4323" y="831"/>
                    </a:lnTo>
                    <a:lnTo>
                      <a:pt x="4330" y="829"/>
                    </a:lnTo>
                    <a:lnTo>
                      <a:pt x="4338" y="829"/>
                    </a:lnTo>
                    <a:lnTo>
                      <a:pt x="4344" y="829"/>
                    </a:lnTo>
                    <a:lnTo>
                      <a:pt x="4351" y="827"/>
                    </a:lnTo>
                    <a:lnTo>
                      <a:pt x="4357" y="827"/>
                    </a:lnTo>
                    <a:lnTo>
                      <a:pt x="4365" y="825"/>
                    </a:lnTo>
                    <a:lnTo>
                      <a:pt x="4372" y="825"/>
                    </a:lnTo>
                    <a:lnTo>
                      <a:pt x="4378" y="825"/>
                    </a:lnTo>
                    <a:lnTo>
                      <a:pt x="4386" y="825"/>
                    </a:lnTo>
                    <a:lnTo>
                      <a:pt x="4392" y="825"/>
                    </a:lnTo>
                    <a:lnTo>
                      <a:pt x="4399" y="825"/>
                    </a:lnTo>
                    <a:lnTo>
                      <a:pt x="4407" y="825"/>
                    </a:lnTo>
                    <a:lnTo>
                      <a:pt x="4413" y="825"/>
                    </a:lnTo>
                    <a:lnTo>
                      <a:pt x="4420" y="827"/>
                    </a:lnTo>
                    <a:lnTo>
                      <a:pt x="4426" y="827"/>
                    </a:lnTo>
                    <a:lnTo>
                      <a:pt x="4434" y="827"/>
                    </a:lnTo>
                    <a:lnTo>
                      <a:pt x="4440" y="827"/>
                    </a:lnTo>
                    <a:lnTo>
                      <a:pt x="4447" y="827"/>
                    </a:lnTo>
                    <a:lnTo>
                      <a:pt x="4455" y="829"/>
                    </a:lnTo>
                    <a:lnTo>
                      <a:pt x="4461" y="829"/>
                    </a:lnTo>
                    <a:lnTo>
                      <a:pt x="4468" y="829"/>
                    </a:lnTo>
                    <a:lnTo>
                      <a:pt x="4474" y="829"/>
                    </a:lnTo>
                    <a:lnTo>
                      <a:pt x="4482" y="829"/>
                    </a:lnTo>
                    <a:lnTo>
                      <a:pt x="4490" y="829"/>
                    </a:lnTo>
                    <a:lnTo>
                      <a:pt x="4495" y="829"/>
                    </a:lnTo>
                    <a:lnTo>
                      <a:pt x="4503" y="831"/>
                    </a:lnTo>
                    <a:lnTo>
                      <a:pt x="4509" y="831"/>
                    </a:lnTo>
                    <a:lnTo>
                      <a:pt x="4516" y="829"/>
                    </a:lnTo>
                    <a:lnTo>
                      <a:pt x="4524" y="829"/>
                    </a:lnTo>
                    <a:lnTo>
                      <a:pt x="4530" y="829"/>
                    </a:lnTo>
                    <a:lnTo>
                      <a:pt x="4538" y="829"/>
                    </a:lnTo>
                    <a:lnTo>
                      <a:pt x="4543" y="829"/>
                    </a:lnTo>
                    <a:lnTo>
                      <a:pt x="4551" y="829"/>
                    </a:lnTo>
                    <a:lnTo>
                      <a:pt x="4559" y="829"/>
                    </a:lnTo>
                    <a:lnTo>
                      <a:pt x="4564" y="829"/>
                    </a:lnTo>
                    <a:lnTo>
                      <a:pt x="4572" y="829"/>
                    </a:lnTo>
                    <a:lnTo>
                      <a:pt x="4578" y="829"/>
                    </a:lnTo>
                    <a:lnTo>
                      <a:pt x="4586" y="829"/>
                    </a:lnTo>
                    <a:lnTo>
                      <a:pt x="4591" y="829"/>
                    </a:lnTo>
                    <a:lnTo>
                      <a:pt x="4599" y="829"/>
                    </a:lnTo>
                    <a:lnTo>
                      <a:pt x="4607" y="829"/>
                    </a:lnTo>
                    <a:lnTo>
                      <a:pt x="4612" y="829"/>
                    </a:lnTo>
                    <a:lnTo>
                      <a:pt x="4620" y="829"/>
                    </a:lnTo>
                    <a:lnTo>
                      <a:pt x="4626" y="827"/>
                    </a:lnTo>
                    <a:lnTo>
                      <a:pt x="4634" y="827"/>
                    </a:lnTo>
                    <a:lnTo>
                      <a:pt x="4641" y="827"/>
                    </a:lnTo>
                    <a:lnTo>
                      <a:pt x="4647" y="827"/>
                    </a:lnTo>
                    <a:lnTo>
                      <a:pt x="4655" y="827"/>
                    </a:lnTo>
                    <a:lnTo>
                      <a:pt x="4660" y="827"/>
                    </a:lnTo>
                    <a:lnTo>
                      <a:pt x="4668" y="827"/>
                    </a:lnTo>
                    <a:lnTo>
                      <a:pt x="4676" y="827"/>
                    </a:lnTo>
                    <a:lnTo>
                      <a:pt x="4682" y="827"/>
                    </a:lnTo>
                    <a:lnTo>
                      <a:pt x="4689" y="827"/>
                    </a:lnTo>
                    <a:lnTo>
                      <a:pt x="4695" y="827"/>
                    </a:lnTo>
                    <a:lnTo>
                      <a:pt x="4703" y="827"/>
                    </a:lnTo>
                    <a:lnTo>
                      <a:pt x="4708" y="827"/>
                    </a:lnTo>
                    <a:lnTo>
                      <a:pt x="4716" y="827"/>
                    </a:lnTo>
                    <a:lnTo>
                      <a:pt x="4724" y="827"/>
                    </a:lnTo>
                    <a:lnTo>
                      <a:pt x="4730" y="827"/>
                    </a:lnTo>
                    <a:lnTo>
                      <a:pt x="4737" y="825"/>
                    </a:lnTo>
                    <a:lnTo>
                      <a:pt x="4743" y="825"/>
                    </a:lnTo>
                    <a:lnTo>
                      <a:pt x="4751" y="825"/>
                    </a:lnTo>
                    <a:lnTo>
                      <a:pt x="4758" y="823"/>
                    </a:lnTo>
                    <a:lnTo>
                      <a:pt x="4764" y="821"/>
                    </a:lnTo>
                    <a:lnTo>
                      <a:pt x="4772" y="821"/>
                    </a:lnTo>
                    <a:lnTo>
                      <a:pt x="4778" y="821"/>
                    </a:lnTo>
                    <a:lnTo>
                      <a:pt x="4785" y="821"/>
                    </a:lnTo>
                    <a:lnTo>
                      <a:pt x="4793" y="821"/>
                    </a:lnTo>
                    <a:lnTo>
                      <a:pt x="4799" y="821"/>
                    </a:lnTo>
                    <a:lnTo>
                      <a:pt x="4806" y="821"/>
                    </a:lnTo>
                    <a:lnTo>
                      <a:pt x="4812" y="823"/>
                    </a:lnTo>
                    <a:lnTo>
                      <a:pt x="4820" y="823"/>
                    </a:lnTo>
                    <a:lnTo>
                      <a:pt x="4827" y="823"/>
                    </a:lnTo>
                    <a:lnTo>
                      <a:pt x="4833" y="823"/>
                    </a:lnTo>
                    <a:lnTo>
                      <a:pt x="4841" y="823"/>
                    </a:lnTo>
                    <a:lnTo>
                      <a:pt x="4847" y="823"/>
                    </a:lnTo>
                    <a:lnTo>
                      <a:pt x="4854" y="823"/>
                    </a:lnTo>
                    <a:lnTo>
                      <a:pt x="4860" y="825"/>
                    </a:lnTo>
                    <a:lnTo>
                      <a:pt x="4868" y="825"/>
                    </a:lnTo>
                    <a:lnTo>
                      <a:pt x="4875" y="825"/>
                    </a:lnTo>
                    <a:lnTo>
                      <a:pt x="4881" y="825"/>
                    </a:lnTo>
                    <a:lnTo>
                      <a:pt x="4889" y="825"/>
                    </a:lnTo>
                    <a:lnTo>
                      <a:pt x="4895" y="823"/>
                    </a:lnTo>
                    <a:lnTo>
                      <a:pt x="4902" y="823"/>
                    </a:lnTo>
                    <a:lnTo>
                      <a:pt x="4910" y="823"/>
                    </a:lnTo>
                    <a:lnTo>
                      <a:pt x="4916" y="823"/>
                    </a:lnTo>
                    <a:lnTo>
                      <a:pt x="4924" y="823"/>
                    </a:lnTo>
                    <a:lnTo>
                      <a:pt x="4929" y="823"/>
                    </a:lnTo>
                    <a:lnTo>
                      <a:pt x="4937" y="823"/>
                    </a:lnTo>
                    <a:lnTo>
                      <a:pt x="4945" y="823"/>
                    </a:lnTo>
                    <a:lnTo>
                      <a:pt x="4950" y="823"/>
                    </a:lnTo>
                    <a:lnTo>
                      <a:pt x="4958" y="823"/>
                    </a:lnTo>
                    <a:lnTo>
                      <a:pt x="4964" y="823"/>
                    </a:lnTo>
                    <a:lnTo>
                      <a:pt x="4972" y="823"/>
                    </a:lnTo>
                    <a:lnTo>
                      <a:pt x="4977" y="823"/>
                    </a:lnTo>
                    <a:lnTo>
                      <a:pt x="4985" y="823"/>
                    </a:lnTo>
                    <a:lnTo>
                      <a:pt x="4993" y="823"/>
                    </a:lnTo>
                    <a:lnTo>
                      <a:pt x="4998" y="823"/>
                    </a:lnTo>
                    <a:lnTo>
                      <a:pt x="5006" y="823"/>
                    </a:lnTo>
                    <a:lnTo>
                      <a:pt x="5012" y="821"/>
                    </a:lnTo>
                    <a:lnTo>
                      <a:pt x="5020" y="821"/>
                    </a:lnTo>
                    <a:lnTo>
                      <a:pt x="5027" y="821"/>
                    </a:lnTo>
                    <a:lnTo>
                      <a:pt x="5033" y="821"/>
                    </a:lnTo>
                    <a:lnTo>
                      <a:pt x="5041" y="821"/>
                    </a:lnTo>
                    <a:lnTo>
                      <a:pt x="5046" y="821"/>
                    </a:lnTo>
                    <a:lnTo>
                      <a:pt x="5054" y="821"/>
                    </a:lnTo>
                    <a:lnTo>
                      <a:pt x="5062" y="821"/>
                    </a:lnTo>
                    <a:lnTo>
                      <a:pt x="5068" y="821"/>
                    </a:lnTo>
                    <a:lnTo>
                      <a:pt x="5075" y="821"/>
                    </a:lnTo>
                    <a:lnTo>
                      <a:pt x="5081" y="821"/>
                    </a:lnTo>
                    <a:lnTo>
                      <a:pt x="5089" y="819"/>
                    </a:lnTo>
                    <a:lnTo>
                      <a:pt x="5094" y="819"/>
                    </a:lnTo>
                    <a:lnTo>
                      <a:pt x="5102" y="819"/>
                    </a:lnTo>
                    <a:lnTo>
                      <a:pt x="5110" y="819"/>
                    </a:lnTo>
                    <a:lnTo>
                      <a:pt x="5116" y="819"/>
                    </a:lnTo>
                    <a:lnTo>
                      <a:pt x="5123" y="819"/>
                    </a:lnTo>
                    <a:lnTo>
                      <a:pt x="5129" y="819"/>
                    </a:lnTo>
                    <a:lnTo>
                      <a:pt x="5137" y="819"/>
                    </a:lnTo>
                    <a:lnTo>
                      <a:pt x="5144" y="819"/>
                    </a:lnTo>
                    <a:lnTo>
                      <a:pt x="5150" y="819"/>
                    </a:lnTo>
                    <a:lnTo>
                      <a:pt x="5158" y="819"/>
                    </a:lnTo>
                    <a:lnTo>
                      <a:pt x="5164" y="817"/>
                    </a:lnTo>
                    <a:lnTo>
                      <a:pt x="5171" y="817"/>
                    </a:lnTo>
                    <a:lnTo>
                      <a:pt x="5179" y="817"/>
                    </a:lnTo>
                    <a:lnTo>
                      <a:pt x="5185" y="817"/>
                    </a:lnTo>
                    <a:lnTo>
                      <a:pt x="5192" y="817"/>
                    </a:lnTo>
                    <a:lnTo>
                      <a:pt x="5198" y="817"/>
                    </a:lnTo>
                    <a:lnTo>
                      <a:pt x="5206" y="817"/>
                    </a:lnTo>
                    <a:lnTo>
                      <a:pt x="5213" y="817"/>
                    </a:lnTo>
                    <a:lnTo>
                      <a:pt x="5219" y="817"/>
                    </a:lnTo>
                    <a:lnTo>
                      <a:pt x="5227" y="817"/>
                    </a:lnTo>
                    <a:lnTo>
                      <a:pt x="5233" y="815"/>
                    </a:lnTo>
                    <a:lnTo>
                      <a:pt x="5240" y="815"/>
                    </a:lnTo>
                    <a:lnTo>
                      <a:pt x="5246" y="815"/>
                    </a:lnTo>
                    <a:lnTo>
                      <a:pt x="5254" y="815"/>
                    </a:lnTo>
                    <a:lnTo>
                      <a:pt x="5261" y="815"/>
                    </a:lnTo>
                    <a:lnTo>
                      <a:pt x="5267" y="815"/>
                    </a:lnTo>
                    <a:lnTo>
                      <a:pt x="5275" y="815"/>
                    </a:lnTo>
                    <a:lnTo>
                      <a:pt x="5281" y="815"/>
                    </a:lnTo>
                    <a:lnTo>
                      <a:pt x="5288" y="815"/>
                    </a:lnTo>
                    <a:lnTo>
                      <a:pt x="5296" y="815"/>
                    </a:lnTo>
                    <a:lnTo>
                      <a:pt x="5302" y="815"/>
                    </a:lnTo>
                    <a:lnTo>
                      <a:pt x="5309" y="815"/>
                    </a:lnTo>
                    <a:lnTo>
                      <a:pt x="5315" y="815"/>
                    </a:lnTo>
                    <a:lnTo>
                      <a:pt x="5323" y="815"/>
                    </a:lnTo>
                    <a:lnTo>
                      <a:pt x="5331" y="815"/>
                    </a:lnTo>
                    <a:lnTo>
                      <a:pt x="5336" y="814"/>
                    </a:lnTo>
                    <a:lnTo>
                      <a:pt x="5344" y="814"/>
                    </a:lnTo>
                    <a:lnTo>
                      <a:pt x="5350" y="814"/>
                    </a:lnTo>
                    <a:lnTo>
                      <a:pt x="5357" y="814"/>
                    </a:lnTo>
                    <a:lnTo>
                      <a:pt x="5363" y="814"/>
                    </a:lnTo>
                    <a:lnTo>
                      <a:pt x="5371" y="814"/>
                    </a:lnTo>
                    <a:lnTo>
                      <a:pt x="5379" y="814"/>
                    </a:lnTo>
                    <a:lnTo>
                      <a:pt x="5384" y="814"/>
                    </a:lnTo>
                    <a:lnTo>
                      <a:pt x="5392" y="814"/>
                    </a:lnTo>
                    <a:lnTo>
                      <a:pt x="5398" y="814"/>
                    </a:lnTo>
                    <a:lnTo>
                      <a:pt x="5405" y="814"/>
                    </a:lnTo>
                    <a:lnTo>
                      <a:pt x="5413" y="814"/>
                    </a:lnTo>
                    <a:lnTo>
                      <a:pt x="5419" y="812"/>
                    </a:lnTo>
                    <a:lnTo>
                      <a:pt x="5427" y="812"/>
                    </a:lnTo>
                    <a:lnTo>
                      <a:pt x="5432" y="812"/>
                    </a:lnTo>
                    <a:lnTo>
                      <a:pt x="5440" y="812"/>
                    </a:lnTo>
                    <a:lnTo>
                      <a:pt x="5448" y="812"/>
                    </a:lnTo>
                    <a:lnTo>
                      <a:pt x="5453" y="812"/>
                    </a:lnTo>
                    <a:lnTo>
                      <a:pt x="5461" y="812"/>
                    </a:lnTo>
                    <a:lnTo>
                      <a:pt x="5467" y="812"/>
                    </a:lnTo>
                    <a:lnTo>
                      <a:pt x="5475" y="812"/>
                    </a:lnTo>
                    <a:lnTo>
                      <a:pt x="5480" y="812"/>
                    </a:lnTo>
                    <a:lnTo>
                      <a:pt x="5488" y="810"/>
                    </a:lnTo>
                    <a:lnTo>
                      <a:pt x="5496" y="810"/>
                    </a:lnTo>
                    <a:lnTo>
                      <a:pt x="5501" y="810"/>
                    </a:lnTo>
                    <a:lnTo>
                      <a:pt x="5509" y="810"/>
                    </a:lnTo>
                    <a:lnTo>
                      <a:pt x="5515" y="810"/>
                    </a:lnTo>
                    <a:lnTo>
                      <a:pt x="5523" y="810"/>
                    </a:lnTo>
                    <a:lnTo>
                      <a:pt x="5530" y="810"/>
                    </a:lnTo>
                    <a:lnTo>
                      <a:pt x="5536" y="810"/>
                    </a:lnTo>
                    <a:lnTo>
                      <a:pt x="5544" y="810"/>
                    </a:lnTo>
                    <a:lnTo>
                      <a:pt x="5549" y="810"/>
                    </a:lnTo>
                    <a:lnTo>
                      <a:pt x="5557" y="810"/>
                    </a:lnTo>
                    <a:lnTo>
                      <a:pt x="5565" y="808"/>
                    </a:lnTo>
                    <a:lnTo>
                      <a:pt x="5571" y="808"/>
                    </a:lnTo>
                    <a:lnTo>
                      <a:pt x="5578" y="808"/>
                    </a:lnTo>
                    <a:lnTo>
                      <a:pt x="5584" y="808"/>
                    </a:lnTo>
                    <a:lnTo>
                      <a:pt x="5592" y="808"/>
                    </a:lnTo>
                    <a:lnTo>
                      <a:pt x="5599" y="808"/>
                    </a:lnTo>
                    <a:lnTo>
                      <a:pt x="5605" y="808"/>
                    </a:lnTo>
                    <a:lnTo>
                      <a:pt x="5613" y="808"/>
                    </a:lnTo>
                    <a:lnTo>
                      <a:pt x="5619" y="808"/>
                    </a:lnTo>
                    <a:lnTo>
                      <a:pt x="5626" y="806"/>
                    </a:lnTo>
                    <a:lnTo>
                      <a:pt x="5632" y="806"/>
                    </a:lnTo>
                    <a:lnTo>
                      <a:pt x="5640" y="806"/>
                    </a:lnTo>
                    <a:lnTo>
                      <a:pt x="5647" y="806"/>
                    </a:lnTo>
                    <a:lnTo>
                      <a:pt x="5653" y="806"/>
                    </a:lnTo>
                    <a:lnTo>
                      <a:pt x="5661" y="806"/>
                    </a:lnTo>
                    <a:lnTo>
                      <a:pt x="5667" y="806"/>
                    </a:lnTo>
                    <a:lnTo>
                      <a:pt x="5674" y="806"/>
                    </a:lnTo>
                    <a:lnTo>
                      <a:pt x="5682" y="806"/>
                    </a:lnTo>
                    <a:lnTo>
                      <a:pt x="5688" y="804"/>
                    </a:lnTo>
                    <a:lnTo>
                      <a:pt x="5695" y="804"/>
                    </a:lnTo>
                    <a:lnTo>
                      <a:pt x="5701" y="804"/>
                    </a:lnTo>
                    <a:lnTo>
                      <a:pt x="5709" y="804"/>
                    </a:lnTo>
                    <a:lnTo>
                      <a:pt x="5717" y="804"/>
                    </a:lnTo>
                    <a:lnTo>
                      <a:pt x="5722" y="804"/>
                    </a:lnTo>
                    <a:lnTo>
                      <a:pt x="5730" y="804"/>
                    </a:lnTo>
                    <a:lnTo>
                      <a:pt x="5736" y="804"/>
                    </a:lnTo>
                    <a:lnTo>
                      <a:pt x="5743" y="804"/>
                    </a:lnTo>
                    <a:lnTo>
                      <a:pt x="5749" y="804"/>
                    </a:lnTo>
                    <a:lnTo>
                      <a:pt x="5757" y="804"/>
                    </a:lnTo>
                    <a:lnTo>
                      <a:pt x="5765" y="802"/>
                    </a:lnTo>
                    <a:lnTo>
                      <a:pt x="5770" y="802"/>
                    </a:lnTo>
                    <a:lnTo>
                      <a:pt x="5778" y="802"/>
                    </a:lnTo>
                    <a:lnTo>
                      <a:pt x="5784" y="802"/>
                    </a:lnTo>
                    <a:lnTo>
                      <a:pt x="5791" y="802"/>
                    </a:lnTo>
                    <a:lnTo>
                      <a:pt x="5799" y="802"/>
                    </a:lnTo>
                    <a:lnTo>
                      <a:pt x="5805" y="800"/>
                    </a:lnTo>
                    <a:lnTo>
                      <a:pt x="5813" y="800"/>
                    </a:lnTo>
                    <a:lnTo>
                      <a:pt x="5818" y="798"/>
                    </a:lnTo>
                    <a:lnTo>
                      <a:pt x="5826" y="798"/>
                    </a:lnTo>
                    <a:lnTo>
                      <a:pt x="5834" y="798"/>
                    </a:lnTo>
                    <a:lnTo>
                      <a:pt x="5839" y="796"/>
                    </a:lnTo>
                    <a:lnTo>
                      <a:pt x="5847" y="796"/>
                    </a:lnTo>
                    <a:lnTo>
                      <a:pt x="5853" y="794"/>
                    </a:lnTo>
                    <a:lnTo>
                      <a:pt x="5861" y="794"/>
                    </a:lnTo>
                    <a:lnTo>
                      <a:pt x="5868" y="794"/>
                    </a:lnTo>
                    <a:lnTo>
                      <a:pt x="5874" y="794"/>
                    </a:lnTo>
                    <a:lnTo>
                      <a:pt x="5882" y="794"/>
                    </a:lnTo>
                    <a:lnTo>
                      <a:pt x="5887" y="794"/>
                    </a:lnTo>
                    <a:lnTo>
                      <a:pt x="5895" y="794"/>
                    </a:lnTo>
                    <a:lnTo>
                      <a:pt x="5901" y="794"/>
                    </a:lnTo>
                    <a:lnTo>
                      <a:pt x="5909" y="794"/>
                    </a:lnTo>
                    <a:lnTo>
                      <a:pt x="5916" y="794"/>
                    </a:lnTo>
                    <a:lnTo>
                      <a:pt x="5922" y="794"/>
                    </a:lnTo>
                    <a:lnTo>
                      <a:pt x="5930" y="794"/>
                    </a:lnTo>
                    <a:lnTo>
                      <a:pt x="5935" y="794"/>
                    </a:lnTo>
                    <a:lnTo>
                      <a:pt x="5943" y="794"/>
                    </a:lnTo>
                    <a:lnTo>
                      <a:pt x="5951" y="794"/>
                    </a:lnTo>
                    <a:lnTo>
                      <a:pt x="5957" y="794"/>
                    </a:lnTo>
                    <a:lnTo>
                      <a:pt x="5964" y="794"/>
                    </a:lnTo>
                    <a:lnTo>
                      <a:pt x="5970" y="794"/>
                    </a:lnTo>
                    <a:lnTo>
                      <a:pt x="5978" y="792"/>
                    </a:lnTo>
                    <a:lnTo>
                      <a:pt x="5985" y="792"/>
                    </a:lnTo>
                    <a:lnTo>
                      <a:pt x="5991" y="792"/>
                    </a:lnTo>
                    <a:lnTo>
                      <a:pt x="5999" y="792"/>
                    </a:lnTo>
                    <a:lnTo>
                      <a:pt x="6005" y="792"/>
                    </a:lnTo>
                    <a:lnTo>
                      <a:pt x="6012" y="792"/>
                    </a:lnTo>
                    <a:lnTo>
                      <a:pt x="6018" y="792"/>
                    </a:lnTo>
                    <a:lnTo>
                      <a:pt x="6026" y="791"/>
                    </a:lnTo>
                    <a:lnTo>
                      <a:pt x="6033" y="791"/>
                    </a:lnTo>
                    <a:lnTo>
                      <a:pt x="6039" y="791"/>
                    </a:lnTo>
                    <a:lnTo>
                      <a:pt x="6047" y="791"/>
                    </a:lnTo>
                    <a:lnTo>
                      <a:pt x="6053" y="791"/>
                    </a:lnTo>
                    <a:lnTo>
                      <a:pt x="6060" y="791"/>
                    </a:lnTo>
                    <a:lnTo>
                      <a:pt x="6068" y="791"/>
                    </a:lnTo>
                    <a:lnTo>
                      <a:pt x="6074" y="791"/>
                    </a:lnTo>
                    <a:lnTo>
                      <a:pt x="6081" y="791"/>
                    </a:lnTo>
                    <a:lnTo>
                      <a:pt x="6087" y="791"/>
                    </a:lnTo>
                    <a:lnTo>
                      <a:pt x="6095" y="791"/>
                    </a:lnTo>
                    <a:lnTo>
                      <a:pt x="6102" y="791"/>
                    </a:lnTo>
                    <a:lnTo>
                      <a:pt x="6108" y="791"/>
                    </a:lnTo>
                    <a:lnTo>
                      <a:pt x="6116" y="791"/>
                    </a:lnTo>
                    <a:lnTo>
                      <a:pt x="6122" y="789"/>
                    </a:lnTo>
                    <a:lnTo>
                      <a:pt x="6129" y="789"/>
                    </a:lnTo>
                    <a:lnTo>
                      <a:pt x="6135" y="789"/>
                    </a:lnTo>
                    <a:lnTo>
                      <a:pt x="6143" y="789"/>
                    </a:lnTo>
                    <a:lnTo>
                      <a:pt x="6150" y="789"/>
                    </a:lnTo>
                    <a:lnTo>
                      <a:pt x="6156" y="789"/>
                    </a:lnTo>
                    <a:lnTo>
                      <a:pt x="6164" y="789"/>
                    </a:lnTo>
                    <a:lnTo>
                      <a:pt x="6170" y="789"/>
                    </a:lnTo>
                    <a:lnTo>
                      <a:pt x="6177" y="789"/>
                    </a:lnTo>
                    <a:lnTo>
                      <a:pt x="6185" y="789"/>
                    </a:lnTo>
                    <a:lnTo>
                      <a:pt x="6191" y="789"/>
                    </a:lnTo>
                    <a:lnTo>
                      <a:pt x="6198" y="789"/>
                    </a:lnTo>
                    <a:lnTo>
                      <a:pt x="6204" y="787"/>
                    </a:lnTo>
                    <a:lnTo>
                      <a:pt x="6212" y="787"/>
                    </a:lnTo>
                    <a:lnTo>
                      <a:pt x="6220" y="787"/>
                    </a:lnTo>
                    <a:lnTo>
                      <a:pt x="6225" y="787"/>
                    </a:lnTo>
                    <a:lnTo>
                      <a:pt x="6233" y="787"/>
                    </a:lnTo>
                    <a:lnTo>
                      <a:pt x="6239" y="787"/>
                    </a:lnTo>
                    <a:lnTo>
                      <a:pt x="6246" y="787"/>
                    </a:lnTo>
                    <a:lnTo>
                      <a:pt x="6254" y="785"/>
                    </a:lnTo>
                    <a:lnTo>
                      <a:pt x="6260" y="785"/>
                    </a:lnTo>
                    <a:lnTo>
                      <a:pt x="6268" y="785"/>
                    </a:lnTo>
                    <a:lnTo>
                      <a:pt x="6273" y="783"/>
                    </a:lnTo>
                    <a:lnTo>
                      <a:pt x="6281" y="781"/>
                    </a:lnTo>
                    <a:lnTo>
                      <a:pt x="6287" y="781"/>
                    </a:lnTo>
                    <a:lnTo>
                      <a:pt x="6294" y="779"/>
                    </a:lnTo>
                    <a:lnTo>
                      <a:pt x="6302" y="775"/>
                    </a:lnTo>
                    <a:lnTo>
                      <a:pt x="6308" y="773"/>
                    </a:lnTo>
                    <a:lnTo>
                      <a:pt x="6316" y="767"/>
                    </a:lnTo>
                    <a:lnTo>
                      <a:pt x="6321" y="760"/>
                    </a:lnTo>
                    <a:lnTo>
                      <a:pt x="6329" y="746"/>
                    </a:lnTo>
                    <a:lnTo>
                      <a:pt x="6337" y="727"/>
                    </a:lnTo>
                    <a:lnTo>
                      <a:pt x="6342" y="700"/>
                    </a:lnTo>
                    <a:lnTo>
                      <a:pt x="6350" y="662"/>
                    </a:lnTo>
                    <a:lnTo>
                      <a:pt x="6356" y="618"/>
                    </a:lnTo>
                    <a:lnTo>
                      <a:pt x="6364" y="564"/>
                    </a:lnTo>
                    <a:lnTo>
                      <a:pt x="6371" y="505"/>
                    </a:lnTo>
                    <a:lnTo>
                      <a:pt x="6377" y="441"/>
                    </a:lnTo>
                    <a:lnTo>
                      <a:pt x="6385" y="372"/>
                    </a:lnTo>
                    <a:lnTo>
                      <a:pt x="6390" y="301"/>
                    </a:lnTo>
                    <a:lnTo>
                      <a:pt x="6398" y="232"/>
                    </a:lnTo>
                    <a:lnTo>
                      <a:pt x="6404" y="167"/>
                    </a:lnTo>
                    <a:lnTo>
                      <a:pt x="6412" y="109"/>
                    </a:lnTo>
                    <a:lnTo>
                      <a:pt x="6419" y="63"/>
                    </a:lnTo>
                    <a:lnTo>
                      <a:pt x="6425" y="29"/>
                    </a:lnTo>
                    <a:lnTo>
                      <a:pt x="6433" y="9"/>
                    </a:lnTo>
                    <a:lnTo>
                      <a:pt x="6438" y="0"/>
                    </a:lnTo>
                    <a:lnTo>
                      <a:pt x="6446" y="2"/>
                    </a:lnTo>
                    <a:lnTo>
                      <a:pt x="6454" y="11"/>
                    </a:lnTo>
                    <a:lnTo>
                      <a:pt x="6460" y="27"/>
                    </a:lnTo>
                    <a:lnTo>
                      <a:pt x="6467" y="46"/>
                    </a:lnTo>
                    <a:lnTo>
                      <a:pt x="6473" y="71"/>
                    </a:lnTo>
                    <a:lnTo>
                      <a:pt x="6481" y="96"/>
                    </a:lnTo>
                    <a:lnTo>
                      <a:pt x="6488" y="123"/>
                    </a:lnTo>
                    <a:lnTo>
                      <a:pt x="6494" y="151"/>
                    </a:lnTo>
                    <a:lnTo>
                      <a:pt x="6502" y="178"/>
                    </a:lnTo>
                    <a:lnTo>
                      <a:pt x="6508" y="203"/>
                    </a:lnTo>
                    <a:lnTo>
                      <a:pt x="6515" y="228"/>
                    </a:lnTo>
                    <a:lnTo>
                      <a:pt x="6523" y="251"/>
                    </a:lnTo>
                    <a:lnTo>
                      <a:pt x="6529" y="274"/>
                    </a:lnTo>
                    <a:lnTo>
                      <a:pt x="6536" y="295"/>
                    </a:lnTo>
                    <a:lnTo>
                      <a:pt x="6542" y="313"/>
                    </a:lnTo>
                    <a:lnTo>
                      <a:pt x="6550" y="330"/>
                    </a:lnTo>
                    <a:lnTo>
                      <a:pt x="6556" y="347"/>
                    </a:lnTo>
                    <a:lnTo>
                      <a:pt x="6563" y="361"/>
                    </a:lnTo>
                    <a:lnTo>
                      <a:pt x="6571" y="376"/>
                    </a:lnTo>
                    <a:lnTo>
                      <a:pt x="6577" y="388"/>
                    </a:lnTo>
                    <a:lnTo>
                      <a:pt x="6584" y="399"/>
                    </a:lnTo>
                    <a:lnTo>
                      <a:pt x="6590" y="411"/>
                    </a:lnTo>
                    <a:lnTo>
                      <a:pt x="6598" y="422"/>
                    </a:lnTo>
                    <a:lnTo>
                      <a:pt x="6606" y="432"/>
                    </a:lnTo>
                    <a:lnTo>
                      <a:pt x="6611" y="441"/>
                    </a:lnTo>
                    <a:lnTo>
                      <a:pt x="6619" y="449"/>
                    </a:lnTo>
                    <a:lnTo>
                      <a:pt x="6625" y="459"/>
                    </a:lnTo>
                    <a:lnTo>
                      <a:pt x="6632" y="466"/>
                    </a:lnTo>
                    <a:lnTo>
                      <a:pt x="6640" y="474"/>
                    </a:lnTo>
                    <a:lnTo>
                      <a:pt x="6646" y="480"/>
                    </a:lnTo>
                    <a:lnTo>
                      <a:pt x="6654" y="487"/>
                    </a:lnTo>
                    <a:lnTo>
                      <a:pt x="6659" y="495"/>
                    </a:lnTo>
                    <a:lnTo>
                      <a:pt x="6667" y="501"/>
                    </a:lnTo>
                    <a:lnTo>
                      <a:pt x="6673" y="506"/>
                    </a:lnTo>
                    <a:lnTo>
                      <a:pt x="6680" y="512"/>
                    </a:lnTo>
                    <a:lnTo>
                      <a:pt x="6688" y="518"/>
                    </a:lnTo>
                    <a:lnTo>
                      <a:pt x="6694" y="524"/>
                    </a:lnTo>
                    <a:lnTo>
                      <a:pt x="6702" y="530"/>
                    </a:lnTo>
                    <a:lnTo>
                      <a:pt x="6707" y="535"/>
                    </a:lnTo>
                    <a:lnTo>
                      <a:pt x="6715" y="541"/>
                    </a:lnTo>
                    <a:lnTo>
                      <a:pt x="6723" y="545"/>
                    </a:lnTo>
                    <a:lnTo>
                      <a:pt x="6728" y="551"/>
                    </a:lnTo>
                    <a:lnTo>
                      <a:pt x="6736" y="554"/>
                    </a:lnTo>
                    <a:lnTo>
                      <a:pt x="6742" y="558"/>
                    </a:lnTo>
                    <a:lnTo>
                      <a:pt x="6750" y="564"/>
                    </a:lnTo>
                    <a:lnTo>
                      <a:pt x="6757" y="568"/>
                    </a:lnTo>
                    <a:lnTo>
                      <a:pt x="6763" y="572"/>
                    </a:lnTo>
                    <a:lnTo>
                      <a:pt x="6771" y="576"/>
                    </a:lnTo>
                    <a:lnTo>
                      <a:pt x="6776" y="579"/>
                    </a:lnTo>
                    <a:lnTo>
                      <a:pt x="6784" y="583"/>
                    </a:lnTo>
                    <a:lnTo>
                      <a:pt x="6790" y="587"/>
                    </a:lnTo>
                    <a:lnTo>
                      <a:pt x="6798" y="591"/>
                    </a:lnTo>
                    <a:lnTo>
                      <a:pt x="6805" y="595"/>
                    </a:lnTo>
                    <a:lnTo>
                      <a:pt x="6811" y="599"/>
                    </a:lnTo>
                    <a:lnTo>
                      <a:pt x="6819" y="602"/>
                    </a:lnTo>
                    <a:lnTo>
                      <a:pt x="6824" y="604"/>
                    </a:lnTo>
                    <a:lnTo>
                      <a:pt x="6832" y="608"/>
                    </a:lnTo>
                    <a:lnTo>
                      <a:pt x="6840" y="612"/>
                    </a:lnTo>
                    <a:lnTo>
                      <a:pt x="6846" y="614"/>
                    </a:lnTo>
                    <a:lnTo>
                      <a:pt x="6851" y="618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ja-JP" altLang="en-US" sz="700"/>
              </a:p>
            </p:txBody>
          </p:sp>
          <p:sp>
            <p:nvSpPr>
              <p:cNvPr id="193" name="Rectangle 203">
                <a:extLst>
                  <a:ext uri="{FF2B5EF4-FFF2-40B4-BE49-F238E27FC236}">
                    <a16:creationId xmlns:a16="http://schemas.microsoft.com/office/drawing/2014/main" id="{5D7AEBA1-BABF-6582-4B8F-500224179C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02896" y="1430957"/>
                <a:ext cx="2565995" cy="954109"/>
              </a:xfrm>
              <a:prstGeom prst="rect">
                <a:avLst/>
              </a:prstGeom>
              <a:noFill/>
              <a:ln w="12700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ja-JP" altLang="en-US" sz="700"/>
              </a:p>
            </p:txBody>
          </p:sp>
          <p:sp>
            <p:nvSpPr>
              <p:cNvPr id="194" name="テキスト ボックス 1003">
                <a:extLst>
                  <a:ext uri="{FF2B5EF4-FFF2-40B4-BE49-F238E27FC236}">
                    <a16:creationId xmlns:a16="http://schemas.microsoft.com/office/drawing/2014/main" id="{F62DAF29-C6AE-E3B2-6DD5-E82840E6E7A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984349" y="2029738"/>
                <a:ext cx="352981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ja-JP" sz="700" dirty="0"/>
                  <a:t>SA5</a:t>
                </a:r>
                <a:endParaRPr lang="ja-JP" altLang="en-US" sz="700" dirty="0"/>
              </a:p>
            </p:txBody>
          </p:sp>
        </p:grpSp>
        <p:sp>
          <p:nvSpPr>
            <p:cNvPr id="118" name="テキスト ボックス 1003">
              <a:extLst>
                <a:ext uri="{FF2B5EF4-FFF2-40B4-BE49-F238E27FC236}">
                  <a16:creationId xmlns:a16="http://schemas.microsoft.com/office/drawing/2014/main" id="{63762640-B952-852C-54E8-9035B947A4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17586" y="1370442"/>
              <a:ext cx="367408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ja-JP" sz="700" dirty="0"/>
                <a:t>HSA</a:t>
              </a:r>
              <a:endParaRPr lang="ja-JP" altLang="en-US" sz="700" dirty="0"/>
            </a:p>
          </p:txBody>
        </p:sp>
      </p:grp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EF25B0E3-9DDB-AF74-630A-D3D94725D877}"/>
              </a:ext>
            </a:extLst>
          </p:cNvPr>
          <p:cNvSpPr txBox="1"/>
          <p:nvPr/>
        </p:nvSpPr>
        <p:spPr>
          <a:xfrm rot="16200000">
            <a:off x="1691786" y="4221975"/>
            <a:ext cx="506377" cy="131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mAU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(220 nm)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D6864A79-461F-E917-174A-6976E356139A}"/>
              </a:ext>
            </a:extLst>
          </p:cNvPr>
          <p:cNvSpPr txBox="1"/>
          <p:nvPr/>
        </p:nvSpPr>
        <p:spPr>
          <a:xfrm>
            <a:off x="4405543" y="817922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0) 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DEB81540-347E-D487-428D-169F7E1B129E}"/>
              </a:ext>
            </a:extLst>
          </p:cNvPr>
          <p:cNvSpPr txBox="1"/>
          <p:nvPr/>
        </p:nvSpPr>
        <p:spPr>
          <a:xfrm>
            <a:off x="4397076" y="1798938"/>
            <a:ext cx="3037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1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B599932F-7A9F-64AC-3F99-8E6A27E65713}"/>
              </a:ext>
            </a:extLst>
          </p:cNvPr>
          <p:cNvSpPr txBox="1"/>
          <p:nvPr/>
        </p:nvSpPr>
        <p:spPr>
          <a:xfrm>
            <a:off x="4352504" y="624085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day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8A56250A-C53B-FAC6-87DB-EB40DC834FCE}"/>
              </a:ext>
            </a:extLst>
          </p:cNvPr>
          <p:cNvSpPr txBox="1"/>
          <p:nvPr/>
        </p:nvSpPr>
        <p:spPr>
          <a:xfrm>
            <a:off x="4411616" y="2789377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3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533" name="グループ化 56">
            <a:extLst>
              <a:ext uri="{FF2B5EF4-FFF2-40B4-BE49-F238E27FC236}">
                <a16:creationId xmlns:a16="http://schemas.microsoft.com/office/drawing/2014/main" id="{12EBAB72-1E41-DCD1-796E-9890F9E317DC}"/>
              </a:ext>
            </a:extLst>
          </p:cNvPr>
          <p:cNvGrpSpPr/>
          <p:nvPr/>
        </p:nvGrpSpPr>
        <p:grpSpPr>
          <a:xfrm>
            <a:off x="2079818" y="3783427"/>
            <a:ext cx="1805776" cy="773999"/>
            <a:chOff x="3107535" y="7319600"/>
            <a:chExt cx="1816626" cy="843693"/>
          </a:xfrm>
        </p:grpSpPr>
        <p:sp>
          <p:nvSpPr>
            <p:cNvPr id="534" name="Line 574">
              <a:extLst>
                <a:ext uri="{FF2B5EF4-FFF2-40B4-BE49-F238E27FC236}">
                  <a16:creationId xmlns:a16="http://schemas.microsoft.com/office/drawing/2014/main" id="{C2F7BE50-8146-C85E-A413-798E94261B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5913" y="8109789"/>
              <a:ext cx="12172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5" name="Line 579">
              <a:extLst>
                <a:ext uri="{FF2B5EF4-FFF2-40B4-BE49-F238E27FC236}">
                  <a16:creationId xmlns:a16="http://schemas.microsoft.com/office/drawing/2014/main" id="{4E139DE9-7DE7-BC64-1DF9-11CC43255E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5913" y="7741489"/>
              <a:ext cx="12172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6" name="Line 584">
              <a:extLst>
                <a:ext uri="{FF2B5EF4-FFF2-40B4-BE49-F238E27FC236}">
                  <a16:creationId xmlns:a16="http://schemas.microsoft.com/office/drawing/2014/main" id="{A0F98626-55B8-3A54-6FF4-CEF89135E9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5913" y="7374776"/>
              <a:ext cx="12172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7" name="Line 585">
              <a:extLst>
                <a:ext uri="{FF2B5EF4-FFF2-40B4-BE49-F238E27FC236}">
                  <a16:creationId xmlns:a16="http://schemas.microsoft.com/office/drawing/2014/main" id="{1DE2AE7B-1A32-BC95-ED25-0EB6C2E7AD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4418" y="8109789"/>
              <a:ext cx="2366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8" name="Line 587">
              <a:extLst>
                <a:ext uri="{FF2B5EF4-FFF2-40B4-BE49-F238E27FC236}">
                  <a16:creationId xmlns:a16="http://schemas.microsoft.com/office/drawing/2014/main" id="{846543F9-9989-0A86-C6BF-52C3F8A174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4418" y="7741489"/>
              <a:ext cx="2366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9" name="Line 589">
              <a:extLst>
                <a:ext uri="{FF2B5EF4-FFF2-40B4-BE49-F238E27FC236}">
                  <a16:creationId xmlns:a16="http://schemas.microsoft.com/office/drawing/2014/main" id="{4699F012-7614-1F8B-E268-BAC1013149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4418" y="7374776"/>
              <a:ext cx="2366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0" name="Freeform 592">
              <a:extLst>
                <a:ext uri="{FF2B5EF4-FFF2-40B4-BE49-F238E27FC236}">
                  <a16:creationId xmlns:a16="http://schemas.microsoft.com/office/drawing/2014/main" id="{C90621B7-A585-C24D-FB95-935A1D18007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18761" y="7350964"/>
              <a:ext cx="1557986" cy="628650"/>
            </a:xfrm>
            <a:custGeom>
              <a:avLst/>
              <a:gdLst>
                <a:gd name="T0" fmla="*/ 32 w 2304"/>
                <a:gd name="T1" fmla="*/ 363 h 396"/>
                <a:gd name="T2" fmla="*/ 69 w 2304"/>
                <a:gd name="T3" fmla="*/ 328 h 396"/>
                <a:gd name="T4" fmla="*/ 106 w 2304"/>
                <a:gd name="T5" fmla="*/ 373 h 396"/>
                <a:gd name="T6" fmla="*/ 143 w 2304"/>
                <a:gd name="T7" fmla="*/ 374 h 396"/>
                <a:gd name="T8" fmla="*/ 181 w 2304"/>
                <a:gd name="T9" fmla="*/ 373 h 396"/>
                <a:gd name="T10" fmla="*/ 217 w 2304"/>
                <a:gd name="T11" fmla="*/ 371 h 396"/>
                <a:gd name="T12" fmla="*/ 255 w 2304"/>
                <a:gd name="T13" fmla="*/ 371 h 396"/>
                <a:gd name="T14" fmla="*/ 292 w 2304"/>
                <a:gd name="T15" fmla="*/ 366 h 396"/>
                <a:gd name="T16" fmla="*/ 329 w 2304"/>
                <a:gd name="T17" fmla="*/ 367 h 396"/>
                <a:gd name="T18" fmla="*/ 366 w 2304"/>
                <a:gd name="T19" fmla="*/ 369 h 396"/>
                <a:gd name="T20" fmla="*/ 403 w 2304"/>
                <a:gd name="T21" fmla="*/ 363 h 396"/>
                <a:gd name="T22" fmla="*/ 440 w 2304"/>
                <a:gd name="T23" fmla="*/ 368 h 396"/>
                <a:gd name="T24" fmla="*/ 477 w 2304"/>
                <a:gd name="T25" fmla="*/ 369 h 396"/>
                <a:gd name="T26" fmla="*/ 515 w 2304"/>
                <a:gd name="T27" fmla="*/ 366 h 396"/>
                <a:gd name="T28" fmla="*/ 551 w 2304"/>
                <a:gd name="T29" fmla="*/ 359 h 396"/>
                <a:gd name="T30" fmla="*/ 589 w 2304"/>
                <a:gd name="T31" fmla="*/ 363 h 396"/>
                <a:gd name="T32" fmla="*/ 625 w 2304"/>
                <a:gd name="T33" fmla="*/ 358 h 396"/>
                <a:gd name="T34" fmla="*/ 663 w 2304"/>
                <a:gd name="T35" fmla="*/ 358 h 396"/>
                <a:gd name="T36" fmla="*/ 699 w 2304"/>
                <a:gd name="T37" fmla="*/ 340 h 396"/>
                <a:gd name="T38" fmla="*/ 737 w 2304"/>
                <a:gd name="T39" fmla="*/ 319 h 396"/>
                <a:gd name="T40" fmla="*/ 773 w 2304"/>
                <a:gd name="T41" fmla="*/ 357 h 396"/>
                <a:gd name="T42" fmla="*/ 811 w 2304"/>
                <a:gd name="T43" fmla="*/ 359 h 396"/>
                <a:gd name="T44" fmla="*/ 848 w 2304"/>
                <a:gd name="T45" fmla="*/ 352 h 396"/>
                <a:gd name="T46" fmla="*/ 885 w 2304"/>
                <a:gd name="T47" fmla="*/ 354 h 396"/>
                <a:gd name="T48" fmla="*/ 922 w 2304"/>
                <a:gd name="T49" fmla="*/ 348 h 396"/>
                <a:gd name="T50" fmla="*/ 959 w 2304"/>
                <a:gd name="T51" fmla="*/ 342 h 396"/>
                <a:gd name="T52" fmla="*/ 997 w 2304"/>
                <a:gd name="T53" fmla="*/ 345 h 396"/>
                <a:gd name="T54" fmla="*/ 1033 w 2304"/>
                <a:gd name="T55" fmla="*/ 307 h 396"/>
                <a:gd name="T56" fmla="*/ 1071 w 2304"/>
                <a:gd name="T57" fmla="*/ 341 h 396"/>
                <a:gd name="T58" fmla="*/ 1108 w 2304"/>
                <a:gd name="T59" fmla="*/ 340 h 396"/>
                <a:gd name="T60" fmla="*/ 1145 w 2304"/>
                <a:gd name="T61" fmla="*/ 345 h 396"/>
                <a:gd name="T62" fmla="*/ 1182 w 2304"/>
                <a:gd name="T63" fmla="*/ 257 h 396"/>
                <a:gd name="T64" fmla="*/ 1219 w 2304"/>
                <a:gd name="T65" fmla="*/ 203 h 396"/>
                <a:gd name="T66" fmla="*/ 1256 w 2304"/>
                <a:gd name="T67" fmla="*/ 288 h 396"/>
                <a:gd name="T68" fmla="*/ 1293 w 2304"/>
                <a:gd name="T69" fmla="*/ 311 h 396"/>
                <a:gd name="T70" fmla="*/ 1330 w 2304"/>
                <a:gd name="T71" fmla="*/ 282 h 396"/>
                <a:gd name="T72" fmla="*/ 1367 w 2304"/>
                <a:gd name="T73" fmla="*/ 278 h 396"/>
                <a:gd name="T74" fmla="*/ 1404 w 2304"/>
                <a:gd name="T75" fmla="*/ 275 h 396"/>
                <a:gd name="T76" fmla="*/ 1442 w 2304"/>
                <a:gd name="T77" fmla="*/ 301 h 396"/>
                <a:gd name="T78" fmla="*/ 1478 w 2304"/>
                <a:gd name="T79" fmla="*/ 321 h 396"/>
                <a:gd name="T80" fmla="*/ 1516 w 2304"/>
                <a:gd name="T81" fmla="*/ 306 h 396"/>
                <a:gd name="T82" fmla="*/ 1552 w 2304"/>
                <a:gd name="T83" fmla="*/ 318 h 396"/>
                <a:gd name="T84" fmla="*/ 1590 w 2304"/>
                <a:gd name="T85" fmla="*/ 311 h 396"/>
                <a:gd name="T86" fmla="*/ 1626 w 2304"/>
                <a:gd name="T87" fmla="*/ 321 h 396"/>
                <a:gd name="T88" fmla="*/ 1664 w 2304"/>
                <a:gd name="T89" fmla="*/ 298 h 396"/>
                <a:gd name="T90" fmla="*/ 1701 w 2304"/>
                <a:gd name="T91" fmla="*/ 302 h 396"/>
                <a:gd name="T92" fmla="*/ 1738 w 2304"/>
                <a:gd name="T93" fmla="*/ 302 h 396"/>
                <a:gd name="T94" fmla="*/ 1776 w 2304"/>
                <a:gd name="T95" fmla="*/ 306 h 396"/>
                <a:gd name="T96" fmla="*/ 1812 w 2304"/>
                <a:gd name="T97" fmla="*/ 310 h 396"/>
                <a:gd name="T98" fmla="*/ 1850 w 2304"/>
                <a:gd name="T99" fmla="*/ 310 h 396"/>
                <a:gd name="T100" fmla="*/ 1886 w 2304"/>
                <a:gd name="T101" fmla="*/ 309 h 396"/>
                <a:gd name="T102" fmla="*/ 1924 w 2304"/>
                <a:gd name="T103" fmla="*/ 299 h 396"/>
                <a:gd name="T104" fmla="*/ 1960 w 2304"/>
                <a:gd name="T105" fmla="*/ 300 h 396"/>
                <a:gd name="T106" fmla="*/ 1998 w 2304"/>
                <a:gd name="T107" fmla="*/ 293 h 396"/>
                <a:gd name="T108" fmla="*/ 2034 w 2304"/>
                <a:gd name="T109" fmla="*/ 290 h 396"/>
                <a:gd name="T110" fmla="*/ 2072 w 2304"/>
                <a:gd name="T111" fmla="*/ 272 h 396"/>
                <a:gd name="T112" fmla="*/ 2109 w 2304"/>
                <a:gd name="T113" fmla="*/ 290 h 396"/>
                <a:gd name="T114" fmla="*/ 2146 w 2304"/>
                <a:gd name="T115" fmla="*/ 295 h 396"/>
                <a:gd name="T116" fmla="*/ 2183 w 2304"/>
                <a:gd name="T117" fmla="*/ 296 h 396"/>
                <a:gd name="T118" fmla="*/ 2220 w 2304"/>
                <a:gd name="T119" fmla="*/ 289 h 396"/>
                <a:gd name="T120" fmla="*/ 2257 w 2304"/>
                <a:gd name="T121" fmla="*/ 275 h 396"/>
                <a:gd name="T122" fmla="*/ 2294 w 2304"/>
                <a:gd name="T123" fmla="*/ 149 h 3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304" h="396">
                  <a:moveTo>
                    <a:pt x="0" y="396"/>
                  </a:moveTo>
                  <a:lnTo>
                    <a:pt x="2" y="395"/>
                  </a:lnTo>
                  <a:lnTo>
                    <a:pt x="5" y="394"/>
                  </a:lnTo>
                  <a:lnTo>
                    <a:pt x="9" y="393"/>
                  </a:lnTo>
                  <a:lnTo>
                    <a:pt x="12" y="392"/>
                  </a:lnTo>
                  <a:lnTo>
                    <a:pt x="16" y="391"/>
                  </a:lnTo>
                  <a:lnTo>
                    <a:pt x="18" y="388"/>
                  </a:lnTo>
                  <a:lnTo>
                    <a:pt x="22" y="385"/>
                  </a:lnTo>
                  <a:lnTo>
                    <a:pt x="25" y="379"/>
                  </a:lnTo>
                  <a:lnTo>
                    <a:pt x="29" y="373"/>
                  </a:lnTo>
                  <a:lnTo>
                    <a:pt x="32" y="363"/>
                  </a:lnTo>
                  <a:lnTo>
                    <a:pt x="36" y="353"/>
                  </a:lnTo>
                  <a:lnTo>
                    <a:pt x="39" y="341"/>
                  </a:lnTo>
                  <a:lnTo>
                    <a:pt x="42" y="330"/>
                  </a:lnTo>
                  <a:lnTo>
                    <a:pt x="45" y="320"/>
                  </a:lnTo>
                  <a:lnTo>
                    <a:pt x="49" y="312"/>
                  </a:lnTo>
                  <a:lnTo>
                    <a:pt x="52" y="308"/>
                  </a:lnTo>
                  <a:lnTo>
                    <a:pt x="56" y="307"/>
                  </a:lnTo>
                  <a:lnTo>
                    <a:pt x="59" y="310"/>
                  </a:lnTo>
                  <a:lnTo>
                    <a:pt x="63" y="314"/>
                  </a:lnTo>
                  <a:lnTo>
                    <a:pt x="66" y="320"/>
                  </a:lnTo>
                  <a:lnTo>
                    <a:pt x="69" y="328"/>
                  </a:lnTo>
                  <a:lnTo>
                    <a:pt x="72" y="335"/>
                  </a:lnTo>
                  <a:lnTo>
                    <a:pt x="76" y="342"/>
                  </a:lnTo>
                  <a:lnTo>
                    <a:pt x="79" y="349"/>
                  </a:lnTo>
                  <a:lnTo>
                    <a:pt x="83" y="355"/>
                  </a:lnTo>
                  <a:lnTo>
                    <a:pt x="86" y="360"/>
                  </a:lnTo>
                  <a:lnTo>
                    <a:pt x="90" y="364"/>
                  </a:lnTo>
                  <a:lnTo>
                    <a:pt x="92" y="367"/>
                  </a:lnTo>
                  <a:lnTo>
                    <a:pt x="96" y="370"/>
                  </a:lnTo>
                  <a:lnTo>
                    <a:pt x="99" y="372"/>
                  </a:lnTo>
                  <a:lnTo>
                    <a:pt x="103" y="372"/>
                  </a:lnTo>
                  <a:lnTo>
                    <a:pt x="106" y="373"/>
                  </a:lnTo>
                  <a:lnTo>
                    <a:pt x="110" y="373"/>
                  </a:lnTo>
                  <a:lnTo>
                    <a:pt x="113" y="373"/>
                  </a:lnTo>
                  <a:lnTo>
                    <a:pt x="117" y="373"/>
                  </a:lnTo>
                  <a:lnTo>
                    <a:pt x="119" y="373"/>
                  </a:lnTo>
                  <a:lnTo>
                    <a:pt x="123" y="373"/>
                  </a:lnTo>
                  <a:lnTo>
                    <a:pt x="126" y="374"/>
                  </a:lnTo>
                  <a:lnTo>
                    <a:pt x="130" y="374"/>
                  </a:lnTo>
                  <a:lnTo>
                    <a:pt x="133" y="374"/>
                  </a:lnTo>
                  <a:lnTo>
                    <a:pt x="137" y="374"/>
                  </a:lnTo>
                  <a:lnTo>
                    <a:pt x="140" y="374"/>
                  </a:lnTo>
                  <a:lnTo>
                    <a:pt x="143" y="374"/>
                  </a:lnTo>
                  <a:lnTo>
                    <a:pt x="146" y="374"/>
                  </a:lnTo>
                  <a:lnTo>
                    <a:pt x="150" y="374"/>
                  </a:lnTo>
                  <a:lnTo>
                    <a:pt x="153" y="373"/>
                  </a:lnTo>
                  <a:lnTo>
                    <a:pt x="157" y="373"/>
                  </a:lnTo>
                  <a:lnTo>
                    <a:pt x="161" y="373"/>
                  </a:lnTo>
                  <a:lnTo>
                    <a:pt x="164" y="373"/>
                  </a:lnTo>
                  <a:lnTo>
                    <a:pt x="167" y="373"/>
                  </a:lnTo>
                  <a:lnTo>
                    <a:pt x="170" y="373"/>
                  </a:lnTo>
                  <a:lnTo>
                    <a:pt x="174" y="373"/>
                  </a:lnTo>
                  <a:lnTo>
                    <a:pt x="177" y="373"/>
                  </a:lnTo>
                  <a:lnTo>
                    <a:pt x="181" y="373"/>
                  </a:lnTo>
                  <a:lnTo>
                    <a:pt x="184" y="372"/>
                  </a:lnTo>
                  <a:lnTo>
                    <a:pt x="188" y="371"/>
                  </a:lnTo>
                  <a:lnTo>
                    <a:pt x="191" y="370"/>
                  </a:lnTo>
                  <a:lnTo>
                    <a:pt x="194" y="369"/>
                  </a:lnTo>
                  <a:lnTo>
                    <a:pt x="197" y="369"/>
                  </a:lnTo>
                  <a:lnTo>
                    <a:pt x="201" y="368"/>
                  </a:lnTo>
                  <a:lnTo>
                    <a:pt x="204" y="369"/>
                  </a:lnTo>
                  <a:lnTo>
                    <a:pt x="208" y="369"/>
                  </a:lnTo>
                  <a:lnTo>
                    <a:pt x="211" y="370"/>
                  </a:lnTo>
                  <a:lnTo>
                    <a:pt x="215" y="371"/>
                  </a:lnTo>
                  <a:lnTo>
                    <a:pt x="217" y="371"/>
                  </a:lnTo>
                  <a:lnTo>
                    <a:pt x="221" y="372"/>
                  </a:lnTo>
                  <a:lnTo>
                    <a:pt x="224" y="372"/>
                  </a:lnTo>
                  <a:lnTo>
                    <a:pt x="228" y="372"/>
                  </a:lnTo>
                  <a:lnTo>
                    <a:pt x="231" y="373"/>
                  </a:lnTo>
                  <a:lnTo>
                    <a:pt x="235" y="373"/>
                  </a:lnTo>
                  <a:lnTo>
                    <a:pt x="238" y="373"/>
                  </a:lnTo>
                  <a:lnTo>
                    <a:pt x="242" y="373"/>
                  </a:lnTo>
                  <a:lnTo>
                    <a:pt x="244" y="373"/>
                  </a:lnTo>
                  <a:lnTo>
                    <a:pt x="248" y="372"/>
                  </a:lnTo>
                  <a:lnTo>
                    <a:pt x="251" y="372"/>
                  </a:lnTo>
                  <a:lnTo>
                    <a:pt x="255" y="371"/>
                  </a:lnTo>
                  <a:lnTo>
                    <a:pt x="258" y="370"/>
                  </a:lnTo>
                  <a:lnTo>
                    <a:pt x="262" y="369"/>
                  </a:lnTo>
                  <a:lnTo>
                    <a:pt x="265" y="369"/>
                  </a:lnTo>
                  <a:lnTo>
                    <a:pt x="268" y="368"/>
                  </a:lnTo>
                  <a:lnTo>
                    <a:pt x="271" y="367"/>
                  </a:lnTo>
                  <a:lnTo>
                    <a:pt x="275" y="367"/>
                  </a:lnTo>
                  <a:lnTo>
                    <a:pt x="278" y="367"/>
                  </a:lnTo>
                  <a:lnTo>
                    <a:pt x="282" y="367"/>
                  </a:lnTo>
                  <a:lnTo>
                    <a:pt x="285" y="366"/>
                  </a:lnTo>
                  <a:lnTo>
                    <a:pt x="289" y="366"/>
                  </a:lnTo>
                  <a:lnTo>
                    <a:pt x="292" y="366"/>
                  </a:lnTo>
                  <a:lnTo>
                    <a:pt x="295" y="366"/>
                  </a:lnTo>
                  <a:lnTo>
                    <a:pt x="298" y="365"/>
                  </a:lnTo>
                  <a:lnTo>
                    <a:pt x="302" y="365"/>
                  </a:lnTo>
                  <a:lnTo>
                    <a:pt x="305" y="365"/>
                  </a:lnTo>
                  <a:lnTo>
                    <a:pt x="309" y="365"/>
                  </a:lnTo>
                  <a:lnTo>
                    <a:pt x="312" y="365"/>
                  </a:lnTo>
                  <a:lnTo>
                    <a:pt x="316" y="366"/>
                  </a:lnTo>
                  <a:lnTo>
                    <a:pt x="318" y="366"/>
                  </a:lnTo>
                  <a:lnTo>
                    <a:pt x="322" y="366"/>
                  </a:lnTo>
                  <a:lnTo>
                    <a:pt x="325" y="367"/>
                  </a:lnTo>
                  <a:lnTo>
                    <a:pt x="329" y="367"/>
                  </a:lnTo>
                  <a:lnTo>
                    <a:pt x="332" y="368"/>
                  </a:lnTo>
                  <a:lnTo>
                    <a:pt x="336" y="368"/>
                  </a:lnTo>
                  <a:lnTo>
                    <a:pt x="339" y="368"/>
                  </a:lnTo>
                  <a:lnTo>
                    <a:pt x="343" y="369"/>
                  </a:lnTo>
                  <a:lnTo>
                    <a:pt x="345" y="369"/>
                  </a:lnTo>
                  <a:lnTo>
                    <a:pt x="349" y="369"/>
                  </a:lnTo>
                  <a:lnTo>
                    <a:pt x="352" y="369"/>
                  </a:lnTo>
                  <a:lnTo>
                    <a:pt x="356" y="369"/>
                  </a:lnTo>
                  <a:lnTo>
                    <a:pt x="359" y="369"/>
                  </a:lnTo>
                  <a:lnTo>
                    <a:pt x="363" y="369"/>
                  </a:lnTo>
                  <a:lnTo>
                    <a:pt x="366" y="369"/>
                  </a:lnTo>
                  <a:lnTo>
                    <a:pt x="369" y="368"/>
                  </a:lnTo>
                  <a:lnTo>
                    <a:pt x="372" y="368"/>
                  </a:lnTo>
                  <a:lnTo>
                    <a:pt x="376" y="368"/>
                  </a:lnTo>
                  <a:lnTo>
                    <a:pt x="379" y="367"/>
                  </a:lnTo>
                  <a:lnTo>
                    <a:pt x="383" y="367"/>
                  </a:lnTo>
                  <a:lnTo>
                    <a:pt x="386" y="366"/>
                  </a:lnTo>
                  <a:lnTo>
                    <a:pt x="390" y="365"/>
                  </a:lnTo>
                  <a:lnTo>
                    <a:pt x="393" y="365"/>
                  </a:lnTo>
                  <a:lnTo>
                    <a:pt x="396" y="364"/>
                  </a:lnTo>
                  <a:lnTo>
                    <a:pt x="399" y="363"/>
                  </a:lnTo>
                  <a:lnTo>
                    <a:pt x="403" y="363"/>
                  </a:lnTo>
                  <a:lnTo>
                    <a:pt x="406" y="363"/>
                  </a:lnTo>
                  <a:lnTo>
                    <a:pt x="410" y="364"/>
                  </a:lnTo>
                  <a:lnTo>
                    <a:pt x="413" y="364"/>
                  </a:lnTo>
                  <a:lnTo>
                    <a:pt x="417" y="365"/>
                  </a:lnTo>
                  <a:lnTo>
                    <a:pt x="419" y="365"/>
                  </a:lnTo>
                  <a:lnTo>
                    <a:pt x="423" y="366"/>
                  </a:lnTo>
                  <a:lnTo>
                    <a:pt x="426" y="366"/>
                  </a:lnTo>
                  <a:lnTo>
                    <a:pt x="430" y="367"/>
                  </a:lnTo>
                  <a:lnTo>
                    <a:pt x="433" y="367"/>
                  </a:lnTo>
                  <a:lnTo>
                    <a:pt x="437" y="367"/>
                  </a:lnTo>
                  <a:lnTo>
                    <a:pt x="440" y="368"/>
                  </a:lnTo>
                  <a:lnTo>
                    <a:pt x="444" y="368"/>
                  </a:lnTo>
                  <a:lnTo>
                    <a:pt x="446" y="368"/>
                  </a:lnTo>
                  <a:lnTo>
                    <a:pt x="450" y="368"/>
                  </a:lnTo>
                  <a:lnTo>
                    <a:pt x="453" y="368"/>
                  </a:lnTo>
                  <a:lnTo>
                    <a:pt x="457" y="369"/>
                  </a:lnTo>
                  <a:lnTo>
                    <a:pt x="460" y="369"/>
                  </a:lnTo>
                  <a:lnTo>
                    <a:pt x="464" y="369"/>
                  </a:lnTo>
                  <a:lnTo>
                    <a:pt x="467" y="369"/>
                  </a:lnTo>
                  <a:lnTo>
                    <a:pt x="470" y="369"/>
                  </a:lnTo>
                  <a:lnTo>
                    <a:pt x="473" y="369"/>
                  </a:lnTo>
                  <a:lnTo>
                    <a:pt x="477" y="369"/>
                  </a:lnTo>
                  <a:lnTo>
                    <a:pt x="481" y="369"/>
                  </a:lnTo>
                  <a:lnTo>
                    <a:pt x="484" y="369"/>
                  </a:lnTo>
                  <a:lnTo>
                    <a:pt x="488" y="369"/>
                  </a:lnTo>
                  <a:lnTo>
                    <a:pt x="491" y="369"/>
                  </a:lnTo>
                  <a:lnTo>
                    <a:pt x="494" y="369"/>
                  </a:lnTo>
                  <a:lnTo>
                    <a:pt x="497" y="368"/>
                  </a:lnTo>
                  <a:lnTo>
                    <a:pt x="501" y="368"/>
                  </a:lnTo>
                  <a:lnTo>
                    <a:pt x="504" y="368"/>
                  </a:lnTo>
                  <a:lnTo>
                    <a:pt x="508" y="367"/>
                  </a:lnTo>
                  <a:lnTo>
                    <a:pt x="511" y="366"/>
                  </a:lnTo>
                  <a:lnTo>
                    <a:pt x="515" y="366"/>
                  </a:lnTo>
                  <a:lnTo>
                    <a:pt x="518" y="365"/>
                  </a:lnTo>
                  <a:lnTo>
                    <a:pt x="521" y="364"/>
                  </a:lnTo>
                  <a:lnTo>
                    <a:pt x="524" y="363"/>
                  </a:lnTo>
                  <a:lnTo>
                    <a:pt x="528" y="362"/>
                  </a:lnTo>
                  <a:lnTo>
                    <a:pt x="531" y="361"/>
                  </a:lnTo>
                  <a:lnTo>
                    <a:pt x="535" y="360"/>
                  </a:lnTo>
                  <a:lnTo>
                    <a:pt x="538" y="359"/>
                  </a:lnTo>
                  <a:lnTo>
                    <a:pt x="542" y="358"/>
                  </a:lnTo>
                  <a:lnTo>
                    <a:pt x="544" y="358"/>
                  </a:lnTo>
                  <a:lnTo>
                    <a:pt x="548" y="358"/>
                  </a:lnTo>
                  <a:lnTo>
                    <a:pt x="551" y="359"/>
                  </a:lnTo>
                  <a:lnTo>
                    <a:pt x="555" y="359"/>
                  </a:lnTo>
                  <a:lnTo>
                    <a:pt x="558" y="360"/>
                  </a:lnTo>
                  <a:lnTo>
                    <a:pt x="562" y="361"/>
                  </a:lnTo>
                  <a:lnTo>
                    <a:pt x="565" y="362"/>
                  </a:lnTo>
                  <a:lnTo>
                    <a:pt x="569" y="362"/>
                  </a:lnTo>
                  <a:lnTo>
                    <a:pt x="571" y="363"/>
                  </a:lnTo>
                  <a:lnTo>
                    <a:pt x="575" y="363"/>
                  </a:lnTo>
                  <a:lnTo>
                    <a:pt x="578" y="363"/>
                  </a:lnTo>
                  <a:lnTo>
                    <a:pt x="582" y="363"/>
                  </a:lnTo>
                  <a:lnTo>
                    <a:pt x="585" y="363"/>
                  </a:lnTo>
                  <a:lnTo>
                    <a:pt x="589" y="363"/>
                  </a:lnTo>
                  <a:lnTo>
                    <a:pt x="592" y="363"/>
                  </a:lnTo>
                  <a:lnTo>
                    <a:pt x="595" y="364"/>
                  </a:lnTo>
                  <a:lnTo>
                    <a:pt x="598" y="364"/>
                  </a:lnTo>
                  <a:lnTo>
                    <a:pt x="602" y="364"/>
                  </a:lnTo>
                  <a:lnTo>
                    <a:pt x="605" y="364"/>
                  </a:lnTo>
                  <a:lnTo>
                    <a:pt x="609" y="364"/>
                  </a:lnTo>
                  <a:lnTo>
                    <a:pt x="612" y="363"/>
                  </a:lnTo>
                  <a:lnTo>
                    <a:pt x="616" y="362"/>
                  </a:lnTo>
                  <a:lnTo>
                    <a:pt x="619" y="361"/>
                  </a:lnTo>
                  <a:lnTo>
                    <a:pt x="622" y="360"/>
                  </a:lnTo>
                  <a:lnTo>
                    <a:pt x="625" y="358"/>
                  </a:lnTo>
                  <a:lnTo>
                    <a:pt x="629" y="357"/>
                  </a:lnTo>
                  <a:lnTo>
                    <a:pt x="632" y="357"/>
                  </a:lnTo>
                  <a:lnTo>
                    <a:pt x="636" y="356"/>
                  </a:lnTo>
                  <a:lnTo>
                    <a:pt x="639" y="356"/>
                  </a:lnTo>
                  <a:lnTo>
                    <a:pt x="643" y="356"/>
                  </a:lnTo>
                  <a:lnTo>
                    <a:pt x="645" y="357"/>
                  </a:lnTo>
                  <a:lnTo>
                    <a:pt x="649" y="357"/>
                  </a:lnTo>
                  <a:lnTo>
                    <a:pt x="652" y="357"/>
                  </a:lnTo>
                  <a:lnTo>
                    <a:pt x="656" y="357"/>
                  </a:lnTo>
                  <a:lnTo>
                    <a:pt x="659" y="358"/>
                  </a:lnTo>
                  <a:lnTo>
                    <a:pt x="663" y="358"/>
                  </a:lnTo>
                  <a:lnTo>
                    <a:pt x="666" y="358"/>
                  </a:lnTo>
                  <a:lnTo>
                    <a:pt x="670" y="359"/>
                  </a:lnTo>
                  <a:lnTo>
                    <a:pt x="672" y="359"/>
                  </a:lnTo>
                  <a:lnTo>
                    <a:pt x="676" y="360"/>
                  </a:lnTo>
                  <a:lnTo>
                    <a:pt x="679" y="360"/>
                  </a:lnTo>
                  <a:lnTo>
                    <a:pt x="683" y="359"/>
                  </a:lnTo>
                  <a:lnTo>
                    <a:pt x="686" y="357"/>
                  </a:lnTo>
                  <a:lnTo>
                    <a:pt x="690" y="354"/>
                  </a:lnTo>
                  <a:lnTo>
                    <a:pt x="693" y="350"/>
                  </a:lnTo>
                  <a:lnTo>
                    <a:pt x="696" y="345"/>
                  </a:lnTo>
                  <a:lnTo>
                    <a:pt x="699" y="340"/>
                  </a:lnTo>
                  <a:lnTo>
                    <a:pt x="703" y="335"/>
                  </a:lnTo>
                  <a:lnTo>
                    <a:pt x="706" y="329"/>
                  </a:lnTo>
                  <a:lnTo>
                    <a:pt x="710" y="324"/>
                  </a:lnTo>
                  <a:lnTo>
                    <a:pt x="713" y="320"/>
                  </a:lnTo>
                  <a:lnTo>
                    <a:pt x="717" y="316"/>
                  </a:lnTo>
                  <a:lnTo>
                    <a:pt x="720" y="314"/>
                  </a:lnTo>
                  <a:lnTo>
                    <a:pt x="723" y="312"/>
                  </a:lnTo>
                  <a:lnTo>
                    <a:pt x="726" y="311"/>
                  </a:lnTo>
                  <a:lnTo>
                    <a:pt x="730" y="312"/>
                  </a:lnTo>
                  <a:lnTo>
                    <a:pt x="733" y="315"/>
                  </a:lnTo>
                  <a:lnTo>
                    <a:pt x="737" y="319"/>
                  </a:lnTo>
                  <a:lnTo>
                    <a:pt x="740" y="324"/>
                  </a:lnTo>
                  <a:lnTo>
                    <a:pt x="744" y="329"/>
                  </a:lnTo>
                  <a:lnTo>
                    <a:pt x="746" y="335"/>
                  </a:lnTo>
                  <a:lnTo>
                    <a:pt x="750" y="339"/>
                  </a:lnTo>
                  <a:lnTo>
                    <a:pt x="753" y="344"/>
                  </a:lnTo>
                  <a:lnTo>
                    <a:pt x="757" y="348"/>
                  </a:lnTo>
                  <a:lnTo>
                    <a:pt x="760" y="351"/>
                  </a:lnTo>
                  <a:lnTo>
                    <a:pt x="764" y="353"/>
                  </a:lnTo>
                  <a:lnTo>
                    <a:pt x="767" y="355"/>
                  </a:lnTo>
                  <a:lnTo>
                    <a:pt x="771" y="356"/>
                  </a:lnTo>
                  <a:lnTo>
                    <a:pt x="773" y="357"/>
                  </a:lnTo>
                  <a:lnTo>
                    <a:pt x="777" y="357"/>
                  </a:lnTo>
                  <a:lnTo>
                    <a:pt x="780" y="357"/>
                  </a:lnTo>
                  <a:lnTo>
                    <a:pt x="784" y="358"/>
                  </a:lnTo>
                  <a:lnTo>
                    <a:pt x="787" y="358"/>
                  </a:lnTo>
                  <a:lnTo>
                    <a:pt x="791" y="359"/>
                  </a:lnTo>
                  <a:lnTo>
                    <a:pt x="795" y="359"/>
                  </a:lnTo>
                  <a:lnTo>
                    <a:pt x="797" y="360"/>
                  </a:lnTo>
                  <a:lnTo>
                    <a:pt x="801" y="360"/>
                  </a:lnTo>
                  <a:lnTo>
                    <a:pt x="804" y="360"/>
                  </a:lnTo>
                  <a:lnTo>
                    <a:pt x="808" y="360"/>
                  </a:lnTo>
                  <a:lnTo>
                    <a:pt x="811" y="359"/>
                  </a:lnTo>
                  <a:lnTo>
                    <a:pt x="815" y="358"/>
                  </a:lnTo>
                  <a:lnTo>
                    <a:pt x="818" y="356"/>
                  </a:lnTo>
                  <a:lnTo>
                    <a:pt x="821" y="354"/>
                  </a:lnTo>
                  <a:lnTo>
                    <a:pt x="824" y="352"/>
                  </a:lnTo>
                  <a:lnTo>
                    <a:pt x="828" y="350"/>
                  </a:lnTo>
                  <a:lnTo>
                    <a:pt x="831" y="349"/>
                  </a:lnTo>
                  <a:lnTo>
                    <a:pt x="835" y="349"/>
                  </a:lnTo>
                  <a:lnTo>
                    <a:pt x="838" y="350"/>
                  </a:lnTo>
                  <a:lnTo>
                    <a:pt x="842" y="350"/>
                  </a:lnTo>
                  <a:lnTo>
                    <a:pt x="845" y="351"/>
                  </a:lnTo>
                  <a:lnTo>
                    <a:pt x="848" y="352"/>
                  </a:lnTo>
                  <a:lnTo>
                    <a:pt x="851" y="353"/>
                  </a:lnTo>
                  <a:lnTo>
                    <a:pt x="855" y="354"/>
                  </a:lnTo>
                  <a:lnTo>
                    <a:pt x="858" y="354"/>
                  </a:lnTo>
                  <a:lnTo>
                    <a:pt x="862" y="354"/>
                  </a:lnTo>
                  <a:lnTo>
                    <a:pt x="865" y="354"/>
                  </a:lnTo>
                  <a:lnTo>
                    <a:pt x="869" y="353"/>
                  </a:lnTo>
                  <a:lnTo>
                    <a:pt x="871" y="353"/>
                  </a:lnTo>
                  <a:lnTo>
                    <a:pt x="875" y="353"/>
                  </a:lnTo>
                  <a:lnTo>
                    <a:pt x="878" y="354"/>
                  </a:lnTo>
                  <a:lnTo>
                    <a:pt x="882" y="354"/>
                  </a:lnTo>
                  <a:lnTo>
                    <a:pt x="885" y="354"/>
                  </a:lnTo>
                  <a:lnTo>
                    <a:pt x="889" y="355"/>
                  </a:lnTo>
                  <a:lnTo>
                    <a:pt x="892" y="355"/>
                  </a:lnTo>
                  <a:lnTo>
                    <a:pt x="896" y="354"/>
                  </a:lnTo>
                  <a:lnTo>
                    <a:pt x="898" y="353"/>
                  </a:lnTo>
                  <a:lnTo>
                    <a:pt x="902" y="352"/>
                  </a:lnTo>
                  <a:lnTo>
                    <a:pt x="905" y="351"/>
                  </a:lnTo>
                  <a:lnTo>
                    <a:pt x="909" y="349"/>
                  </a:lnTo>
                  <a:lnTo>
                    <a:pt x="912" y="348"/>
                  </a:lnTo>
                  <a:lnTo>
                    <a:pt x="916" y="348"/>
                  </a:lnTo>
                  <a:lnTo>
                    <a:pt x="919" y="348"/>
                  </a:lnTo>
                  <a:lnTo>
                    <a:pt x="922" y="348"/>
                  </a:lnTo>
                  <a:lnTo>
                    <a:pt x="925" y="349"/>
                  </a:lnTo>
                  <a:lnTo>
                    <a:pt x="929" y="350"/>
                  </a:lnTo>
                  <a:lnTo>
                    <a:pt x="932" y="350"/>
                  </a:lnTo>
                  <a:lnTo>
                    <a:pt x="936" y="350"/>
                  </a:lnTo>
                  <a:lnTo>
                    <a:pt x="939" y="349"/>
                  </a:lnTo>
                  <a:lnTo>
                    <a:pt x="943" y="348"/>
                  </a:lnTo>
                  <a:lnTo>
                    <a:pt x="946" y="347"/>
                  </a:lnTo>
                  <a:lnTo>
                    <a:pt x="949" y="345"/>
                  </a:lnTo>
                  <a:lnTo>
                    <a:pt x="952" y="343"/>
                  </a:lnTo>
                  <a:lnTo>
                    <a:pt x="956" y="343"/>
                  </a:lnTo>
                  <a:lnTo>
                    <a:pt x="959" y="342"/>
                  </a:lnTo>
                  <a:lnTo>
                    <a:pt x="963" y="343"/>
                  </a:lnTo>
                  <a:lnTo>
                    <a:pt x="966" y="344"/>
                  </a:lnTo>
                  <a:lnTo>
                    <a:pt x="970" y="346"/>
                  </a:lnTo>
                  <a:lnTo>
                    <a:pt x="972" y="348"/>
                  </a:lnTo>
                  <a:lnTo>
                    <a:pt x="976" y="349"/>
                  </a:lnTo>
                  <a:lnTo>
                    <a:pt x="979" y="350"/>
                  </a:lnTo>
                  <a:lnTo>
                    <a:pt x="983" y="350"/>
                  </a:lnTo>
                  <a:lnTo>
                    <a:pt x="986" y="350"/>
                  </a:lnTo>
                  <a:lnTo>
                    <a:pt x="990" y="350"/>
                  </a:lnTo>
                  <a:lnTo>
                    <a:pt x="993" y="348"/>
                  </a:lnTo>
                  <a:lnTo>
                    <a:pt x="997" y="345"/>
                  </a:lnTo>
                  <a:lnTo>
                    <a:pt x="999" y="340"/>
                  </a:lnTo>
                  <a:lnTo>
                    <a:pt x="1003" y="335"/>
                  </a:lnTo>
                  <a:lnTo>
                    <a:pt x="1006" y="327"/>
                  </a:lnTo>
                  <a:lnTo>
                    <a:pt x="1010" y="318"/>
                  </a:lnTo>
                  <a:lnTo>
                    <a:pt x="1013" y="309"/>
                  </a:lnTo>
                  <a:lnTo>
                    <a:pt x="1017" y="303"/>
                  </a:lnTo>
                  <a:lnTo>
                    <a:pt x="1020" y="299"/>
                  </a:lnTo>
                  <a:lnTo>
                    <a:pt x="1023" y="297"/>
                  </a:lnTo>
                  <a:lnTo>
                    <a:pt x="1026" y="299"/>
                  </a:lnTo>
                  <a:lnTo>
                    <a:pt x="1030" y="303"/>
                  </a:lnTo>
                  <a:lnTo>
                    <a:pt x="1033" y="307"/>
                  </a:lnTo>
                  <a:lnTo>
                    <a:pt x="1037" y="313"/>
                  </a:lnTo>
                  <a:lnTo>
                    <a:pt x="1040" y="320"/>
                  </a:lnTo>
                  <a:lnTo>
                    <a:pt x="1044" y="325"/>
                  </a:lnTo>
                  <a:lnTo>
                    <a:pt x="1047" y="330"/>
                  </a:lnTo>
                  <a:lnTo>
                    <a:pt x="1050" y="334"/>
                  </a:lnTo>
                  <a:lnTo>
                    <a:pt x="1053" y="336"/>
                  </a:lnTo>
                  <a:lnTo>
                    <a:pt x="1057" y="338"/>
                  </a:lnTo>
                  <a:lnTo>
                    <a:pt x="1060" y="338"/>
                  </a:lnTo>
                  <a:lnTo>
                    <a:pt x="1064" y="339"/>
                  </a:lnTo>
                  <a:lnTo>
                    <a:pt x="1067" y="340"/>
                  </a:lnTo>
                  <a:lnTo>
                    <a:pt x="1071" y="341"/>
                  </a:lnTo>
                  <a:lnTo>
                    <a:pt x="1073" y="341"/>
                  </a:lnTo>
                  <a:lnTo>
                    <a:pt x="1077" y="341"/>
                  </a:lnTo>
                  <a:lnTo>
                    <a:pt x="1080" y="340"/>
                  </a:lnTo>
                  <a:lnTo>
                    <a:pt x="1084" y="340"/>
                  </a:lnTo>
                  <a:lnTo>
                    <a:pt x="1087" y="339"/>
                  </a:lnTo>
                  <a:lnTo>
                    <a:pt x="1091" y="339"/>
                  </a:lnTo>
                  <a:lnTo>
                    <a:pt x="1094" y="339"/>
                  </a:lnTo>
                  <a:lnTo>
                    <a:pt x="1098" y="339"/>
                  </a:lnTo>
                  <a:lnTo>
                    <a:pt x="1100" y="340"/>
                  </a:lnTo>
                  <a:lnTo>
                    <a:pt x="1104" y="340"/>
                  </a:lnTo>
                  <a:lnTo>
                    <a:pt x="1108" y="340"/>
                  </a:lnTo>
                  <a:lnTo>
                    <a:pt x="1111" y="341"/>
                  </a:lnTo>
                  <a:lnTo>
                    <a:pt x="1115" y="341"/>
                  </a:lnTo>
                  <a:lnTo>
                    <a:pt x="1118" y="342"/>
                  </a:lnTo>
                  <a:lnTo>
                    <a:pt x="1122" y="342"/>
                  </a:lnTo>
                  <a:lnTo>
                    <a:pt x="1124" y="343"/>
                  </a:lnTo>
                  <a:lnTo>
                    <a:pt x="1128" y="343"/>
                  </a:lnTo>
                  <a:lnTo>
                    <a:pt x="1131" y="344"/>
                  </a:lnTo>
                  <a:lnTo>
                    <a:pt x="1135" y="344"/>
                  </a:lnTo>
                  <a:lnTo>
                    <a:pt x="1138" y="345"/>
                  </a:lnTo>
                  <a:lnTo>
                    <a:pt x="1142" y="345"/>
                  </a:lnTo>
                  <a:lnTo>
                    <a:pt x="1145" y="345"/>
                  </a:lnTo>
                  <a:lnTo>
                    <a:pt x="1148" y="344"/>
                  </a:lnTo>
                  <a:lnTo>
                    <a:pt x="1151" y="344"/>
                  </a:lnTo>
                  <a:lnTo>
                    <a:pt x="1155" y="342"/>
                  </a:lnTo>
                  <a:lnTo>
                    <a:pt x="1158" y="340"/>
                  </a:lnTo>
                  <a:lnTo>
                    <a:pt x="1162" y="336"/>
                  </a:lnTo>
                  <a:lnTo>
                    <a:pt x="1165" y="328"/>
                  </a:lnTo>
                  <a:lnTo>
                    <a:pt x="1169" y="316"/>
                  </a:lnTo>
                  <a:lnTo>
                    <a:pt x="1172" y="302"/>
                  </a:lnTo>
                  <a:lnTo>
                    <a:pt x="1175" y="285"/>
                  </a:lnTo>
                  <a:lnTo>
                    <a:pt x="1178" y="269"/>
                  </a:lnTo>
                  <a:lnTo>
                    <a:pt x="1182" y="257"/>
                  </a:lnTo>
                  <a:lnTo>
                    <a:pt x="1185" y="250"/>
                  </a:lnTo>
                  <a:lnTo>
                    <a:pt x="1189" y="249"/>
                  </a:lnTo>
                  <a:lnTo>
                    <a:pt x="1192" y="250"/>
                  </a:lnTo>
                  <a:lnTo>
                    <a:pt x="1196" y="251"/>
                  </a:lnTo>
                  <a:lnTo>
                    <a:pt x="1198" y="251"/>
                  </a:lnTo>
                  <a:lnTo>
                    <a:pt x="1202" y="247"/>
                  </a:lnTo>
                  <a:lnTo>
                    <a:pt x="1205" y="241"/>
                  </a:lnTo>
                  <a:lnTo>
                    <a:pt x="1209" y="232"/>
                  </a:lnTo>
                  <a:lnTo>
                    <a:pt x="1212" y="223"/>
                  </a:lnTo>
                  <a:lnTo>
                    <a:pt x="1216" y="213"/>
                  </a:lnTo>
                  <a:lnTo>
                    <a:pt x="1219" y="203"/>
                  </a:lnTo>
                  <a:lnTo>
                    <a:pt x="1223" y="197"/>
                  </a:lnTo>
                  <a:lnTo>
                    <a:pt x="1225" y="194"/>
                  </a:lnTo>
                  <a:lnTo>
                    <a:pt x="1229" y="194"/>
                  </a:lnTo>
                  <a:lnTo>
                    <a:pt x="1232" y="199"/>
                  </a:lnTo>
                  <a:lnTo>
                    <a:pt x="1236" y="208"/>
                  </a:lnTo>
                  <a:lnTo>
                    <a:pt x="1239" y="221"/>
                  </a:lnTo>
                  <a:lnTo>
                    <a:pt x="1243" y="235"/>
                  </a:lnTo>
                  <a:lnTo>
                    <a:pt x="1246" y="250"/>
                  </a:lnTo>
                  <a:lnTo>
                    <a:pt x="1249" y="265"/>
                  </a:lnTo>
                  <a:lnTo>
                    <a:pt x="1252" y="277"/>
                  </a:lnTo>
                  <a:lnTo>
                    <a:pt x="1256" y="288"/>
                  </a:lnTo>
                  <a:lnTo>
                    <a:pt x="1259" y="296"/>
                  </a:lnTo>
                  <a:lnTo>
                    <a:pt x="1263" y="302"/>
                  </a:lnTo>
                  <a:lnTo>
                    <a:pt x="1266" y="305"/>
                  </a:lnTo>
                  <a:lnTo>
                    <a:pt x="1270" y="307"/>
                  </a:lnTo>
                  <a:lnTo>
                    <a:pt x="1273" y="307"/>
                  </a:lnTo>
                  <a:lnTo>
                    <a:pt x="1276" y="307"/>
                  </a:lnTo>
                  <a:lnTo>
                    <a:pt x="1279" y="307"/>
                  </a:lnTo>
                  <a:lnTo>
                    <a:pt x="1283" y="307"/>
                  </a:lnTo>
                  <a:lnTo>
                    <a:pt x="1286" y="307"/>
                  </a:lnTo>
                  <a:lnTo>
                    <a:pt x="1290" y="309"/>
                  </a:lnTo>
                  <a:lnTo>
                    <a:pt x="1293" y="311"/>
                  </a:lnTo>
                  <a:lnTo>
                    <a:pt x="1297" y="314"/>
                  </a:lnTo>
                  <a:lnTo>
                    <a:pt x="1299" y="318"/>
                  </a:lnTo>
                  <a:lnTo>
                    <a:pt x="1303" y="321"/>
                  </a:lnTo>
                  <a:lnTo>
                    <a:pt x="1306" y="323"/>
                  </a:lnTo>
                  <a:lnTo>
                    <a:pt x="1310" y="325"/>
                  </a:lnTo>
                  <a:lnTo>
                    <a:pt x="1313" y="326"/>
                  </a:lnTo>
                  <a:lnTo>
                    <a:pt x="1317" y="324"/>
                  </a:lnTo>
                  <a:lnTo>
                    <a:pt x="1320" y="320"/>
                  </a:lnTo>
                  <a:lnTo>
                    <a:pt x="1324" y="311"/>
                  </a:lnTo>
                  <a:lnTo>
                    <a:pt x="1326" y="299"/>
                  </a:lnTo>
                  <a:lnTo>
                    <a:pt x="1330" y="282"/>
                  </a:lnTo>
                  <a:lnTo>
                    <a:pt x="1333" y="265"/>
                  </a:lnTo>
                  <a:lnTo>
                    <a:pt x="1337" y="250"/>
                  </a:lnTo>
                  <a:lnTo>
                    <a:pt x="1340" y="242"/>
                  </a:lnTo>
                  <a:lnTo>
                    <a:pt x="1344" y="241"/>
                  </a:lnTo>
                  <a:lnTo>
                    <a:pt x="1347" y="246"/>
                  </a:lnTo>
                  <a:lnTo>
                    <a:pt x="1350" y="255"/>
                  </a:lnTo>
                  <a:lnTo>
                    <a:pt x="1353" y="265"/>
                  </a:lnTo>
                  <a:lnTo>
                    <a:pt x="1357" y="272"/>
                  </a:lnTo>
                  <a:lnTo>
                    <a:pt x="1360" y="277"/>
                  </a:lnTo>
                  <a:lnTo>
                    <a:pt x="1364" y="279"/>
                  </a:lnTo>
                  <a:lnTo>
                    <a:pt x="1367" y="278"/>
                  </a:lnTo>
                  <a:lnTo>
                    <a:pt x="1371" y="275"/>
                  </a:lnTo>
                  <a:lnTo>
                    <a:pt x="1374" y="272"/>
                  </a:lnTo>
                  <a:lnTo>
                    <a:pt x="1377" y="270"/>
                  </a:lnTo>
                  <a:lnTo>
                    <a:pt x="1380" y="271"/>
                  </a:lnTo>
                  <a:lnTo>
                    <a:pt x="1384" y="273"/>
                  </a:lnTo>
                  <a:lnTo>
                    <a:pt x="1387" y="276"/>
                  </a:lnTo>
                  <a:lnTo>
                    <a:pt x="1391" y="278"/>
                  </a:lnTo>
                  <a:lnTo>
                    <a:pt x="1394" y="278"/>
                  </a:lnTo>
                  <a:lnTo>
                    <a:pt x="1398" y="277"/>
                  </a:lnTo>
                  <a:lnTo>
                    <a:pt x="1400" y="275"/>
                  </a:lnTo>
                  <a:lnTo>
                    <a:pt x="1404" y="275"/>
                  </a:lnTo>
                  <a:lnTo>
                    <a:pt x="1407" y="276"/>
                  </a:lnTo>
                  <a:lnTo>
                    <a:pt x="1411" y="279"/>
                  </a:lnTo>
                  <a:lnTo>
                    <a:pt x="1414" y="282"/>
                  </a:lnTo>
                  <a:lnTo>
                    <a:pt x="1418" y="285"/>
                  </a:lnTo>
                  <a:lnTo>
                    <a:pt x="1421" y="289"/>
                  </a:lnTo>
                  <a:lnTo>
                    <a:pt x="1425" y="292"/>
                  </a:lnTo>
                  <a:lnTo>
                    <a:pt x="1428" y="295"/>
                  </a:lnTo>
                  <a:lnTo>
                    <a:pt x="1431" y="297"/>
                  </a:lnTo>
                  <a:lnTo>
                    <a:pt x="1435" y="298"/>
                  </a:lnTo>
                  <a:lnTo>
                    <a:pt x="1438" y="300"/>
                  </a:lnTo>
                  <a:lnTo>
                    <a:pt x="1442" y="301"/>
                  </a:lnTo>
                  <a:lnTo>
                    <a:pt x="1445" y="303"/>
                  </a:lnTo>
                  <a:lnTo>
                    <a:pt x="1449" y="304"/>
                  </a:lnTo>
                  <a:lnTo>
                    <a:pt x="1451" y="306"/>
                  </a:lnTo>
                  <a:lnTo>
                    <a:pt x="1455" y="309"/>
                  </a:lnTo>
                  <a:lnTo>
                    <a:pt x="1458" y="311"/>
                  </a:lnTo>
                  <a:lnTo>
                    <a:pt x="1462" y="313"/>
                  </a:lnTo>
                  <a:lnTo>
                    <a:pt x="1465" y="315"/>
                  </a:lnTo>
                  <a:lnTo>
                    <a:pt x="1469" y="317"/>
                  </a:lnTo>
                  <a:lnTo>
                    <a:pt x="1472" y="319"/>
                  </a:lnTo>
                  <a:lnTo>
                    <a:pt x="1475" y="320"/>
                  </a:lnTo>
                  <a:lnTo>
                    <a:pt x="1478" y="321"/>
                  </a:lnTo>
                  <a:lnTo>
                    <a:pt x="1482" y="322"/>
                  </a:lnTo>
                  <a:lnTo>
                    <a:pt x="1485" y="322"/>
                  </a:lnTo>
                  <a:lnTo>
                    <a:pt x="1489" y="320"/>
                  </a:lnTo>
                  <a:lnTo>
                    <a:pt x="1492" y="318"/>
                  </a:lnTo>
                  <a:lnTo>
                    <a:pt x="1496" y="315"/>
                  </a:lnTo>
                  <a:lnTo>
                    <a:pt x="1499" y="311"/>
                  </a:lnTo>
                  <a:lnTo>
                    <a:pt x="1502" y="307"/>
                  </a:lnTo>
                  <a:lnTo>
                    <a:pt x="1505" y="305"/>
                  </a:lnTo>
                  <a:lnTo>
                    <a:pt x="1509" y="304"/>
                  </a:lnTo>
                  <a:lnTo>
                    <a:pt x="1512" y="304"/>
                  </a:lnTo>
                  <a:lnTo>
                    <a:pt x="1516" y="306"/>
                  </a:lnTo>
                  <a:lnTo>
                    <a:pt x="1519" y="308"/>
                  </a:lnTo>
                  <a:lnTo>
                    <a:pt x="1523" y="310"/>
                  </a:lnTo>
                  <a:lnTo>
                    <a:pt x="1525" y="312"/>
                  </a:lnTo>
                  <a:lnTo>
                    <a:pt x="1529" y="314"/>
                  </a:lnTo>
                  <a:lnTo>
                    <a:pt x="1532" y="316"/>
                  </a:lnTo>
                  <a:lnTo>
                    <a:pt x="1536" y="317"/>
                  </a:lnTo>
                  <a:lnTo>
                    <a:pt x="1539" y="318"/>
                  </a:lnTo>
                  <a:lnTo>
                    <a:pt x="1543" y="319"/>
                  </a:lnTo>
                  <a:lnTo>
                    <a:pt x="1546" y="319"/>
                  </a:lnTo>
                  <a:lnTo>
                    <a:pt x="1550" y="319"/>
                  </a:lnTo>
                  <a:lnTo>
                    <a:pt x="1552" y="318"/>
                  </a:lnTo>
                  <a:lnTo>
                    <a:pt x="1556" y="316"/>
                  </a:lnTo>
                  <a:lnTo>
                    <a:pt x="1559" y="314"/>
                  </a:lnTo>
                  <a:lnTo>
                    <a:pt x="1563" y="310"/>
                  </a:lnTo>
                  <a:lnTo>
                    <a:pt x="1566" y="307"/>
                  </a:lnTo>
                  <a:lnTo>
                    <a:pt x="1570" y="305"/>
                  </a:lnTo>
                  <a:lnTo>
                    <a:pt x="1573" y="303"/>
                  </a:lnTo>
                  <a:lnTo>
                    <a:pt x="1576" y="304"/>
                  </a:lnTo>
                  <a:lnTo>
                    <a:pt x="1579" y="305"/>
                  </a:lnTo>
                  <a:lnTo>
                    <a:pt x="1583" y="307"/>
                  </a:lnTo>
                  <a:lnTo>
                    <a:pt x="1586" y="309"/>
                  </a:lnTo>
                  <a:lnTo>
                    <a:pt x="1590" y="311"/>
                  </a:lnTo>
                  <a:lnTo>
                    <a:pt x="1593" y="313"/>
                  </a:lnTo>
                  <a:lnTo>
                    <a:pt x="1597" y="315"/>
                  </a:lnTo>
                  <a:lnTo>
                    <a:pt x="1600" y="317"/>
                  </a:lnTo>
                  <a:lnTo>
                    <a:pt x="1603" y="318"/>
                  </a:lnTo>
                  <a:lnTo>
                    <a:pt x="1606" y="319"/>
                  </a:lnTo>
                  <a:lnTo>
                    <a:pt x="1610" y="321"/>
                  </a:lnTo>
                  <a:lnTo>
                    <a:pt x="1613" y="321"/>
                  </a:lnTo>
                  <a:lnTo>
                    <a:pt x="1617" y="321"/>
                  </a:lnTo>
                  <a:lnTo>
                    <a:pt x="1620" y="321"/>
                  </a:lnTo>
                  <a:lnTo>
                    <a:pt x="1624" y="321"/>
                  </a:lnTo>
                  <a:lnTo>
                    <a:pt x="1626" y="321"/>
                  </a:lnTo>
                  <a:lnTo>
                    <a:pt x="1630" y="321"/>
                  </a:lnTo>
                  <a:lnTo>
                    <a:pt x="1633" y="321"/>
                  </a:lnTo>
                  <a:lnTo>
                    <a:pt x="1637" y="320"/>
                  </a:lnTo>
                  <a:lnTo>
                    <a:pt x="1640" y="319"/>
                  </a:lnTo>
                  <a:lnTo>
                    <a:pt x="1644" y="317"/>
                  </a:lnTo>
                  <a:lnTo>
                    <a:pt x="1647" y="314"/>
                  </a:lnTo>
                  <a:lnTo>
                    <a:pt x="1651" y="311"/>
                  </a:lnTo>
                  <a:lnTo>
                    <a:pt x="1653" y="307"/>
                  </a:lnTo>
                  <a:lnTo>
                    <a:pt x="1657" y="304"/>
                  </a:lnTo>
                  <a:lnTo>
                    <a:pt x="1660" y="301"/>
                  </a:lnTo>
                  <a:lnTo>
                    <a:pt x="1664" y="298"/>
                  </a:lnTo>
                  <a:lnTo>
                    <a:pt x="1667" y="295"/>
                  </a:lnTo>
                  <a:lnTo>
                    <a:pt x="1671" y="292"/>
                  </a:lnTo>
                  <a:lnTo>
                    <a:pt x="1674" y="291"/>
                  </a:lnTo>
                  <a:lnTo>
                    <a:pt x="1677" y="290"/>
                  </a:lnTo>
                  <a:lnTo>
                    <a:pt x="1680" y="290"/>
                  </a:lnTo>
                  <a:lnTo>
                    <a:pt x="1684" y="292"/>
                  </a:lnTo>
                  <a:lnTo>
                    <a:pt x="1687" y="294"/>
                  </a:lnTo>
                  <a:lnTo>
                    <a:pt x="1691" y="296"/>
                  </a:lnTo>
                  <a:lnTo>
                    <a:pt x="1694" y="298"/>
                  </a:lnTo>
                  <a:lnTo>
                    <a:pt x="1698" y="300"/>
                  </a:lnTo>
                  <a:lnTo>
                    <a:pt x="1701" y="302"/>
                  </a:lnTo>
                  <a:lnTo>
                    <a:pt x="1704" y="303"/>
                  </a:lnTo>
                  <a:lnTo>
                    <a:pt x="1707" y="303"/>
                  </a:lnTo>
                  <a:lnTo>
                    <a:pt x="1711" y="303"/>
                  </a:lnTo>
                  <a:lnTo>
                    <a:pt x="1714" y="303"/>
                  </a:lnTo>
                  <a:lnTo>
                    <a:pt x="1718" y="303"/>
                  </a:lnTo>
                  <a:lnTo>
                    <a:pt x="1721" y="302"/>
                  </a:lnTo>
                  <a:lnTo>
                    <a:pt x="1725" y="301"/>
                  </a:lnTo>
                  <a:lnTo>
                    <a:pt x="1727" y="300"/>
                  </a:lnTo>
                  <a:lnTo>
                    <a:pt x="1731" y="300"/>
                  </a:lnTo>
                  <a:lnTo>
                    <a:pt x="1734" y="301"/>
                  </a:lnTo>
                  <a:lnTo>
                    <a:pt x="1738" y="302"/>
                  </a:lnTo>
                  <a:lnTo>
                    <a:pt x="1742" y="303"/>
                  </a:lnTo>
                  <a:lnTo>
                    <a:pt x="1745" y="303"/>
                  </a:lnTo>
                  <a:lnTo>
                    <a:pt x="1749" y="305"/>
                  </a:lnTo>
                  <a:lnTo>
                    <a:pt x="1752" y="306"/>
                  </a:lnTo>
                  <a:lnTo>
                    <a:pt x="1755" y="307"/>
                  </a:lnTo>
                  <a:lnTo>
                    <a:pt x="1758" y="308"/>
                  </a:lnTo>
                  <a:lnTo>
                    <a:pt x="1762" y="308"/>
                  </a:lnTo>
                  <a:lnTo>
                    <a:pt x="1765" y="308"/>
                  </a:lnTo>
                  <a:lnTo>
                    <a:pt x="1769" y="308"/>
                  </a:lnTo>
                  <a:lnTo>
                    <a:pt x="1772" y="307"/>
                  </a:lnTo>
                  <a:lnTo>
                    <a:pt x="1776" y="306"/>
                  </a:lnTo>
                  <a:lnTo>
                    <a:pt x="1778" y="305"/>
                  </a:lnTo>
                  <a:lnTo>
                    <a:pt x="1782" y="305"/>
                  </a:lnTo>
                  <a:lnTo>
                    <a:pt x="1785" y="305"/>
                  </a:lnTo>
                  <a:lnTo>
                    <a:pt x="1789" y="305"/>
                  </a:lnTo>
                  <a:lnTo>
                    <a:pt x="1792" y="306"/>
                  </a:lnTo>
                  <a:lnTo>
                    <a:pt x="1796" y="307"/>
                  </a:lnTo>
                  <a:lnTo>
                    <a:pt x="1799" y="308"/>
                  </a:lnTo>
                  <a:lnTo>
                    <a:pt x="1802" y="309"/>
                  </a:lnTo>
                  <a:lnTo>
                    <a:pt x="1805" y="309"/>
                  </a:lnTo>
                  <a:lnTo>
                    <a:pt x="1809" y="310"/>
                  </a:lnTo>
                  <a:lnTo>
                    <a:pt x="1812" y="310"/>
                  </a:lnTo>
                  <a:lnTo>
                    <a:pt x="1816" y="310"/>
                  </a:lnTo>
                  <a:lnTo>
                    <a:pt x="1819" y="310"/>
                  </a:lnTo>
                  <a:lnTo>
                    <a:pt x="1823" y="310"/>
                  </a:lnTo>
                  <a:lnTo>
                    <a:pt x="1826" y="310"/>
                  </a:lnTo>
                  <a:lnTo>
                    <a:pt x="1829" y="310"/>
                  </a:lnTo>
                  <a:lnTo>
                    <a:pt x="1832" y="310"/>
                  </a:lnTo>
                  <a:lnTo>
                    <a:pt x="1836" y="310"/>
                  </a:lnTo>
                  <a:lnTo>
                    <a:pt x="1839" y="311"/>
                  </a:lnTo>
                  <a:lnTo>
                    <a:pt x="1843" y="310"/>
                  </a:lnTo>
                  <a:lnTo>
                    <a:pt x="1846" y="310"/>
                  </a:lnTo>
                  <a:lnTo>
                    <a:pt x="1850" y="310"/>
                  </a:lnTo>
                  <a:lnTo>
                    <a:pt x="1852" y="310"/>
                  </a:lnTo>
                  <a:lnTo>
                    <a:pt x="1856" y="309"/>
                  </a:lnTo>
                  <a:lnTo>
                    <a:pt x="1859" y="309"/>
                  </a:lnTo>
                  <a:lnTo>
                    <a:pt x="1863" y="309"/>
                  </a:lnTo>
                  <a:lnTo>
                    <a:pt x="1866" y="309"/>
                  </a:lnTo>
                  <a:lnTo>
                    <a:pt x="1870" y="309"/>
                  </a:lnTo>
                  <a:lnTo>
                    <a:pt x="1873" y="309"/>
                  </a:lnTo>
                  <a:lnTo>
                    <a:pt x="1877" y="309"/>
                  </a:lnTo>
                  <a:lnTo>
                    <a:pt x="1879" y="309"/>
                  </a:lnTo>
                  <a:lnTo>
                    <a:pt x="1883" y="309"/>
                  </a:lnTo>
                  <a:lnTo>
                    <a:pt x="1886" y="309"/>
                  </a:lnTo>
                  <a:lnTo>
                    <a:pt x="1890" y="308"/>
                  </a:lnTo>
                  <a:lnTo>
                    <a:pt x="1893" y="307"/>
                  </a:lnTo>
                  <a:lnTo>
                    <a:pt x="1897" y="306"/>
                  </a:lnTo>
                  <a:lnTo>
                    <a:pt x="1900" y="305"/>
                  </a:lnTo>
                  <a:lnTo>
                    <a:pt x="1903" y="303"/>
                  </a:lnTo>
                  <a:lnTo>
                    <a:pt x="1906" y="303"/>
                  </a:lnTo>
                  <a:lnTo>
                    <a:pt x="1910" y="301"/>
                  </a:lnTo>
                  <a:lnTo>
                    <a:pt x="1913" y="300"/>
                  </a:lnTo>
                  <a:lnTo>
                    <a:pt x="1917" y="299"/>
                  </a:lnTo>
                  <a:lnTo>
                    <a:pt x="1920" y="298"/>
                  </a:lnTo>
                  <a:lnTo>
                    <a:pt x="1924" y="299"/>
                  </a:lnTo>
                  <a:lnTo>
                    <a:pt x="1927" y="299"/>
                  </a:lnTo>
                  <a:lnTo>
                    <a:pt x="1930" y="300"/>
                  </a:lnTo>
                  <a:lnTo>
                    <a:pt x="1933" y="301"/>
                  </a:lnTo>
                  <a:lnTo>
                    <a:pt x="1937" y="302"/>
                  </a:lnTo>
                  <a:lnTo>
                    <a:pt x="1940" y="302"/>
                  </a:lnTo>
                  <a:lnTo>
                    <a:pt x="1944" y="303"/>
                  </a:lnTo>
                  <a:lnTo>
                    <a:pt x="1947" y="303"/>
                  </a:lnTo>
                  <a:lnTo>
                    <a:pt x="1951" y="302"/>
                  </a:lnTo>
                  <a:lnTo>
                    <a:pt x="1953" y="302"/>
                  </a:lnTo>
                  <a:lnTo>
                    <a:pt x="1957" y="301"/>
                  </a:lnTo>
                  <a:lnTo>
                    <a:pt x="1960" y="300"/>
                  </a:lnTo>
                  <a:lnTo>
                    <a:pt x="1964" y="299"/>
                  </a:lnTo>
                  <a:lnTo>
                    <a:pt x="1967" y="298"/>
                  </a:lnTo>
                  <a:lnTo>
                    <a:pt x="1971" y="297"/>
                  </a:lnTo>
                  <a:lnTo>
                    <a:pt x="1974" y="296"/>
                  </a:lnTo>
                  <a:lnTo>
                    <a:pt x="1978" y="295"/>
                  </a:lnTo>
                  <a:lnTo>
                    <a:pt x="1980" y="295"/>
                  </a:lnTo>
                  <a:lnTo>
                    <a:pt x="1984" y="294"/>
                  </a:lnTo>
                  <a:lnTo>
                    <a:pt x="1987" y="294"/>
                  </a:lnTo>
                  <a:lnTo>
                    <a:pt x="1991" y="294"/>
                  </a:lnTo>
                  <a:lnTo>
                    <a:pt x="1994" y="293"/>
                  </a:lnTo>
                  <a:lnTo>
                    <a:pt x="1998" y="293"/>
                  </a:lnTo>
                  <a:lnTo>
                    <a:pt x="2001" y="293"/>
                  </a:lnTo>
                  <a:lnTo>
                    <a:pt x="2004" y="292"/>
                  </a:lnTo>
                  <a:lnTo>
                    <a:pt x="2007" y="291"/>
                  </a:lnTo>
                  <a:lnTo>
                    <a:pt x="2011" y="290"/>
                  </a:lnTo>
                  <a:lnTo>
                    <a:pt x="2014" y="289"/>
                  </a:lnTo>
                  <a:lnTo>
                    <a:pt x="2018" y="288"/>
                  </a:lnTo>
                  <a:lnTo>
                    <a:pt x="2021" y="288"/>
                  </a:lnTo>
                  <a:lnTo>
                    <a:pt x="2025" y="288"/>
                  </a:lnTo>
                  <a:lnTo>
                    <a:pt x="2028" y="288"/>
                  </a:lnTo>
                  <a:lnTo>
                    <a:pt x="2031" y="289"/>
                  </a:lnTo>
                  <a:lnTo>
                    <a:pt x="2034" y="290"/>
                  </a:lnTo>
                  <a:lnTo>
                    <a:pt x="2038" y="290"/>
                  </a:lnTo>
                  <a:lnTo>
                    <a:pt x="2041" y="291"/>
                  </a:lnTo>
                  <a:lnTo>
                    <a:pt x="2045" y="290"/>
                  </a:lnTo>
                  <a:lnTo>
                    <a:pt x="2048" y="290"/>
                  </a:lnTo>
                  <a:lnTo>
                    <a:pt x="2052" y="288"/>
                  </a:lnTo>
                  <a:lnTo>
                    <a:pt x="2055" y="286"/>
                  </a:lnTo>
                  <a:lnTo>
                    <a:pt x="2058" y="283"/>
                  </a:lnTo>
                  <a:lnTo>
                    <a:pt x="2062" y="281"/>
                  </a:lnTo>
                  <a:lnTo>
                    <a:pt x="2065" y="278"/>
                  </a:lnTo>
                  <a:lnTo>
                    <a:pt x="2069" y="275"/>
                  </a:lnTo>
                  <a:lnTo>
                    <a:pt x="2072" y="272"/>
                  </a:lnTo>
                  <a:lnTo>
                    <a:pt x="2076" y="270"/>
                  </a:lnTo>
                  <a:lnTo>
                    <a:pt x="2079" y="269"/>
                  </a:lnTo>
                  <a:lnTo>
                    <a:pt x="2082" y="268"/>
                  </a:lnTo>
                  <a:lnTo>
                    <a:pt x="2085" y="269"/>
                  </a:lnTo>
                  <a:lnTo>
                    <a:pt x="2089" y="270"/>
                  </a:lnTo>
                  <a:lnTo>
                    <a:pt x="2092" y="273"/>
                  </a:lnTo>
                  <a:lnTo>
                    <a:pt x="2096" y="276"/>
                  </a:lnTo>
                  <a:lnTo>
                    <a:pt x="2099" y="280"/>
                  </a:lnTo>
                  <a:lnTo>
                    <a:pt x="2103" y="283"/>
                  </a:lnTo>
                  <a:lnTo>
                    <a:pt x="2105" y="287"/>
                  </a:lnTo>
                  <a:lnTo>
                    <a:pt x="2109" y="290"/>
                  </a:lnTo>
                  <a:lnTo>
                    <a:pt x="2112" y="292"/>
                  </a:lnTo>
                  <a:lnTo>
                    <a:pt x="2116" y="294"/>
                  </a:lnTo>
                  <a:lnTo>
                    <a:pt x="2119" y="296"/>
                  </a:lnTo>
                  <a:lnTo>
                    <a:pt x="2123" y="297"/>
                  </a:lnTo>
                  <a:lnTo>
                    <a:pt x="2126" y="298"/>
                  </a:lnTo>
                  <a:lnTo>
                    <a:pt x="2129" y="298"/>
                  </a:lnTo>
                  <a:lnTo>
                    <a:pt x="2132" y="298"/>
                  </a:lnTo>
                  <a:lnTo>
                    <a:pt x="2136" y="297"/>
                  </a:lnTo>
                  <a:lnTo>
                    <a:pt x="2139" y="297"/>
                  </a:lnTo>
                  <a:lnTo>
                    <a:pt x="2143" y="296"/>
                  </a:lnTo>
                  <a:lnTo>
                    <a:pt x="2146" y="295"/>
                  </a:lnTo>
                  <a:lnTo>
                    <a:pt x="2150" y="294"/>
                  </a:lnTo>
                  <a:lnTo>
                    <a:pt x="2153" y="294"/>
                  </a:lnTo>
                  <a:lnTo>
                    <a:pt x="2156" y="294"/>
                  </a:lnTo>
                  <a:lnTo>
                    <a:pt x="2159" y="294"/>
                  </a:lnTo>
                  <a:lnTo>
                    <a:pt x="2163" y="295"/>
                  </a:lnTo>
                  <a:lnTo>
                    <a:pt x="2166" y="295"/>
                  </a:lnTo>
                  <a:lnTo>
                    <a:pt x="2170" y="296"/>
                  </a:lnTo>
                  <a:lnTo>
                    <a:pt x="2173" y="296"/>
                  </a:lnTo>
                  <a:lnTo>
                    <a:pt x="2177" y="296"/>
                  </a:lnTo>
                  <a:lnTo>
                    <a:pt x="2179" y="296"/>
                  </a:lnTo>
                  <a:lnTo>
                    <a:pt x="2183" y="296"/>
                  </a:lnTo>
                  <a:lnTo>
                    <a:pt x="2186" y="296"/>
                  </a:lnTo>
                  <a:lnTo>
                    <a:pt x="2190" y="295"/>
                  </a:lnTo>
                  <a:lnTo>
                    <a:pt x="2193" y="295"/>
                  </a:lnTo>
                  <a:lnTo>
                    <a:pt x="2197" y="294"/>
                  </a:lnTo>
                  <a:lnTo>
                    <a:pt x="2200" y="294"/>
                  </a:lnTo>
                  <a:lnTo>
                    <a:pt x="2204" y="293"/>
                  </a:lnTo>
                  <a:lnTo>
                    <a:pt x="2206" y="292"/>
                  </a:lnTo>
                  <a:lnTo>
                    <a:pt x="2210" y="291"/>
                  </a:lnTo>
                  <a:lnTo>
                    <a:pt x="2213" y="291"/>
                  </a:lnTo>
                  <a:lnTo>
                    <a:pt x="2217" y="290"/>
                  </a:lnTo>
                  <a:lnTo>
                    <a:pt x="2220" y="289"/>
                  </a:lnTo>
                  <a:lnTo>
                    <a:pt x="2224" y="288"/>
                  </a:lnTo>
                  <a:lnTo>
                    <a:pt x="2227" y="288"/>
                  </a:lnTo>
                  <a:lnTo>
                    <a:pt x="2230" y="287"/>
                  </a:lnTo>
                  <a:lnTo>
                    <a:pt x="2233" y="286"/>
                  </a:lnTo>
                  <a:lnTo>
                    <a:pt x="2237" y="286"/>
                  </a:lnTo>
                  <a:lnTo>
                    <a:pt x="2240" y="285"/>
                  </a:lnTo>
                  <a:lnTo>
                    <a:pt x="2244" y="283"/>
                  </a:lnTo>
                  <a:lnTo>
                    <a:pt x="2247" y="282"/>
                  </a:lnTo>
                  <a:lnTo>
                    <a:pt x="2251" y="280"/>
                  </a:lnTo>
                  <a:lnTo>
                    <a:pt x="2254" y="277"/>
                  </a:lnTo>
                  <a:lnTo>
                    <a:pt x="2257" y="275"/>
                  </a:lnTo>
                  <a:lnTo>
                    <a:pt x="2260" y="272"/>
                  </a:lnTo>
                  <a:lnTo>
                    <a:pt x="2264" y="268"/>
                  </a:lnTo>
                  <a:lnTo>
                    <a:pt x="2267" y="266"/>
                  </a:lnTo>
                  <a:lnTo>
                    <a:pt x="2271" y="262"/>
                  </a:lnTo>
                  <a:lnTo>
                    <a:pt x="2274" y="257"/>
                  </a:lnTo>
                  <a:lnTo>
                    <a:pt x="2278" y="250"/>
                  </a:lnTo>
                  <a:lnTo>
                    <a:pt x="2280" y="242"/>
                  </a:lnTo>
                  <a:lnTo>
                    <a:pt x="2284" y="230"/>
                  </a:lnTo>
                  <a:lnTo>
                    <a:pt x="2287" y="212"/>
                  </a:lnTo>
                  <a:lnTo>
                    <a:pt x="2291" y="186"/>
                  </a:lnTo>
                  <a:lnTo>
                    <a:pt x="2294" y="149"/>
                  </a:lnTo>
                  <a:lnTo>
                    <a:pt x="2298" y="100"/>
                  </a:lnTo>
                  <a:lnTo>
                    <a:pt x="2301" y="38"/>
                  </a:lnTo>
                  <a:lnTo>
                    <a:pt x="2304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1" name="Rectangle 594">
              <a:extLst>
                <a:ext uri="{FF2B5EF4-FFF2-40B4-BE49-F238E27FC236}">
                  <a16:creationId xmlns:a16="http://schemas.microsoft.com/office/drawing/2014/main" id="{D1EB551A-1694-5E83-14FE-8480DA98F4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8085" y="7349376"/>
              <a:ext cx="1706076" cy="788988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2" name="Rectangle 341">
              <a:extLst>
                <a:ext uri="{FF2B5EF4-FFF2-40B4-BE49-F238E27FC236}">
                  <a16:creationId xmlns:a16="http://schemas.microsoft.com/office/drawing/2014/main" id="{D8734DAE-E4B2-3602-BD1D-9E46CB0C4E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2432" y="7687984"/>
              <a:ext cx="46598" cy="1070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25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3" name="Rectangle 343">
              <a:extLst>
                <a:ext uri="{FF2B5EF4-FFF2-40B4-BE49-F238E27FC236}">
                  <a16:creationId xmlns:a16="http://schemas.microsoft.com/office/drawing/2014/main" id="{B3E47FE1-274F-EC6E-282B-8330C7B289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7535" y="7319600"/>
              <a:ext cx="113700" cy="110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44" name="Rectangle 341">
              <a:extLst>
                <a:ext uri="{FF2B5EF4-FFF2-40B4-BE49-F238E27FC236}">
                  <a16:creationId xmlns:a16="http://schemas.microsoft.com/office/drawing/2014/main" id="{52BEB4C2-AF32-1C85-3875-5EFC05ED1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1885" y="8056284"/>
              <a:ext cx="23299" cy="1070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700" dirty="0">
                  <a:solidFill>
                    <a:srgbClr val="000000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0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1" name="Line 761">
            <a:extLst>
              <a:ext uri="{FF2B5EF4-FFF2-40B4-BE49-F238E27FC236}">
                <a16:creationId xmlns:a16="http://schemas.microsoft.com/office/drawing/2014/main" id="{502F42A7-A970-C012-0052-9EE8C68B5E91}"/>
              </a:ext>
            </a:extLst>
          </p:cNvPr>
          <p:cNvSpPr>
            <a:spLocks noChangeShapeType="1"/>
          </p:cNvSpPr>
          <p:nvPr/>
        </p:nvSpPr>
        <p:spPr bwMode="auto">
          <a:xfrm>
            <a:off x="2195121" y="4530183"/>
            <a:ext cx="496" cy="453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2" name="Rectangle 762">
            <a:extLst>
              <a:ext uri="{FF2B5EF4-FFF2-40B4-BE49-F238E27FC236}">
                <a16:creationId xmlns:a16="http://schemas.microsoft.com/office/drawing/2014/main" id="{AACFE958-07F2-8CCC-3EC6-E5BAB533DE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82353" y="4576801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6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53" name="Line 769">
            <a:extLst>
              <a:ext uri="{FF2B5EF4-FFF2-40B4-BE49-F238E27FC236}">
                <a16:creationId xmlns:a16="http://schemas.microsoft.com/office/drawing/2014/main" id="{49249766-4A66-3266-F3E1-55229E4BF319}"/>
              </a:ext>
            </a:extLst>
          </p:cNvPr>
          <p:cNvSpPr>
            <a:spLocks noChangeShapeType="1"/>
          </p:cNvSpPr>
          <p:nvPr/>
        </p:nvSpPr>
        <p:spPr bwMode="auto">
          <a:xfrm>
            <a:off x="3039032" y="4530183"/>
            <a:ext cx="496" cy="453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4" name="Rectangle 770">
            <a:extLst>
              <a:ext uri="{FF2B5EF4-FFF2-40B4-BE49-F238E27FC236}">
                <a16:creationId xmlns:a16="http://schemas.microsoft.com/office/drawing/2014/main" id="{C548A03D-42CA-D40A-6E3B-EC6E058F47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931" y="4576427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10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55" name="Rectangle 780">
            <a:extLst>
              <a:ext uri="{FF2B5EF4-FFF2-40B4-BE49-F238E27FC236}">
                <a16:creationId xmlns:a16="http://schemas.microsoft.com/office/drawing/2014/main" id="{23181E85-11CA-2B5B-4050-3B7AA25EC7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43722" y="4577314"/>
            <a:ext cx="65837" cy="81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14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56" name="Line 781">
            <a:extLst>
              <a:ext uri="{FF2B5EF4-FFF2-40B4-BE49-F238E27FC236}">
                <a16:creationId xmlns:a16="http://schemas.microsoft.com/office/drawing/2014/main" id="{70279D9F-8FDF-6E1C-C35B-258BC0A8B9C1}"/>
              </a:ext>
            </a:extLst>
          </p:cNvPr>
          <p:cNvSpPr>
            <a:spLocks noChangeShapeType="1"/>
          </p:cNvSpPr>
          <p:nvPr/>
        </p:nvSpPr>
        <p:spPr bwMode="auto">
          <a:xfrm>
            <a:off x="3882942" y="4530183"/>
            <a:ext cx="496" cy="453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FEDB005B-609C-1860-7721-7E0FD1BB5634}"/>
              </a:ext>
            </a:extLst>
          </p:cNvPr>
          <p:cNvSpPr txBox="1"/>
          <p:nvPr/>
        </p:nvSpPr>
        <p:spPr>
          <a:xfrm>
            <a:off x="4411616" y="3783427"/>
            <a:ext cx="294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(5)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E7905BC-FCD6-03D8-F0E2-9D3CBCE4BB55}"/>
              </a:ext>
            </a:extLst>
          </p:cNvPr>
          <p:cNvSpPr txBox="1"/>
          <p:nvPr/>
        </p:nvSpPr>
        <p:spPr>
          <a:xfrm rot="16200000">
            <a:off x="4427132" y="4223731"/>
            <a:ext cx="506377" cy="131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mAU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(220 nm)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Line 524">
            <a:extLst>
              <a:ext uri="{FF2B5EF4-FFF2-40B4-BE49-F238E27FC236}">
                <a16:creationId xmlns:a16="http://schemas.microsoft.com/office/drawing/2014/main" id="{CBAABCA3-FEA1-71E7-76C3-16020B7C8395}"/>
              </a:ext>
            </a:extLst>
          </p:cNvPr>
          <p:cNvSpPr>
            <a:spLocks noChangeShapeType="1"/>
          </p:cNvSpPr>
          <p:nvPr/>
        </p:nvSpPr>
        <p:spPr bwMode="auto">
          <a:xfrm>
            <a:off x="5826758" y="4536058"/>
            <a:ext cx="498" cy="2287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62" name="Line 560">
            <a:extLst>
              <a:ext uri="{FF2B5EF4-FFF2-40B4-BE49-F238E27FC236}">
                <a16:creationId xmlns:a16="http://schemas.microsoft.com/office/drawing/2014/main" id="{A11DB900-023B-63F9-A45D-5F2B65AF1954}"/>
              </a:ext>
            </a:extLst>
          </p:cNvPr>
          <p:cNvSpPr>
            <a:spLocks noChangeShapeType="1"/>
          </p:cNvSpPr>
          <p:nvPr/>
        </p:nvSpPr>
        <p:spPr bwMode="auto">
          <a:xfrm>
            <a:off x="5826758" y="4536058"/>
            <a:ext cx="498" cy="4447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700"/>
          </a:p>
        </p:txBody>
      </p:sp>
      <p:sp>
        <p:nvSpPr>
          <p:cNvPr id="63" name="Rectangle 561">
            <a:extLst>
              <a:ext uri="{FF2B5EF4-FFF2-40B4-BE49-F238E27FC236}">
                <a16:creationId xmlns:a16="http://schemas.microsoft.com/office/drawing/2014/main" id="{55E21CFF-CFA6-E1FC-1EE9-502D163CC7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1858" y="4581806"/>
            <a:ext cx="35248" cy="799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9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8" name="Rectangle 770">
            <a:extLst>
              <a:ext uri="{FF2B5EF4-FFF2-40B4-BE49-F238E27FC236}">
                <a16:creationId xmlns:a16="http://schemas.microsoft.com/office/drawing/2014/main" id="{851DB607-6668-D07B-92AA-6E51A1EF9A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8821" y="4691636"/>
            <a:ext cx="4296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Time (min)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449" name="Rectangle 770">
            <a:extLst>
              <a:ext uri="{FF2B5EF4-FFF2-40B4-BE49-F238E27FC236}">
                <a16:creationId xmlns:a16="http://schemas.microsoft.com/office/drawing/2014/main" id="{98DC8114-B194-CF97-D732-B27AFCB689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30304" y="4691636"/>
            <a:ext cx="4296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>
                <a:solidFill>
                  <a:srgbClr val="000000"/>
                </a:solidFill>
                <a:ea typeface="ＭＳ ゴシック" panose="020B0609070205080204" pitchFamily="49" charset="-128"/>
                <a:cs typeface="Arial" panose="020B0604020202020204" pitchFamily="34" charset="0"/>
              </a:rPr>
              <a:t>Time (min)</a:t>
            </a:r>
            <a:endParaRPr lang="en-US" altLang="ja-JP" sz="700" dirty="0"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EEF5742-52C0-778B-082D-B29B25027633}"/>
              </a:ext>
            </a:extLst>
          </p:cNvPr>
          <p:cNvSpPr txBox="1"/>
          <p:nvPr/>
        </p:nvSpPr>
        <p:spPr>
          <a:xfrm>
            <a:off x="946150" y="5032110"/>
            <a:ext cx="695325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3: Time course analysis of the cleavage activity of ANA-SA5 against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β42 using HPLC. </a:t>
            </a:r>
          </a:p>
          <a:p>
            <a:r>
              <a:rPr lang="en-US" altLang="ja-JP" sz="1200" dirty="0">
                <a:latin typeface="Palatino Linotype" panose="02040502050505030304" pitchFamily="18" charset="0"/>
              </a:rPr>
              <a:t>Ten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μL</a:t>
            </a:r>
            <a:r>
              <a:rPr lang="en-US" altLang="ja-JP" sz="1200" dirty="0">
                <a:latin typeface="Palatino Linotype" panose="02040502050505030304" pitchFamily="18" charset="0"/>
              </a:rPr>
              <a:t> of the reaction mixture was analyzed using an analytical HPLC. (a) </a:t>
            </a:r>
            <a:r>
              <a:rPr lang="en-US" altLang="ja-JP" sz="1200" i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β42  alone, (b) </a:t>
            </a:r>
            <a:r>
              <a:rPr lang="en-US" altLang="ja-JP" sz="1200" i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β42 co-incubated with ANA-SA5.</a:t>
            </a:r>
            <a:endParaRPr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E58B2BD-E3BE-B72A-76D3-D4860105F86E}"/>
              </a:ext>
            </a:extLst>
          </p:cNvPr>
          <p:cNvSpPr txBox="1"/>
          <p:nvPr/>
        </p:nvSpPr>
        <p:spPr>
          <a:xfrm>
            <a:off x="1618478" y="41499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3226B84-BBA4-5022-2840-2EA8EFCFF307}"/>
              </a:ext>
            </a:extLst>
          </p:cNvPr>
          <p:cNvSpPr txBox="1"/>
          <p:nvPr/>
        </p:nvSpPr>
        <p:spPr>
          <a:xfrm>
            <a:off x="4364890" y="41499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7277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57</TotalTime>
  <Words>428</Words>
  <Application>Microsoft Office PowerPoint</Application>
  <PresentationFormat>画面に合わせる (4:3)</PresentationFormat>
  <Paragraphs>15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ＭＳ ゴシック</vt:lpstr>
      <vt:lpstr>游ゴシック</vt:lpstr>
      <vt:lpstr>Arial</vt:lpstr>
      <vt:lpstr>Calibri</vt:lpstr>
      <vt:lpstr>Calibri Light</vt:lpstr>
      <vt:lpstr>Palatino Linotype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村　里菜</dc:creator>
  <cp:lastModifiedBy>Rina</cp:lastModifiedBy>
  <cp:revision>5</cp:revision>
  <dcterms:created xsi:type="dcterms:W3CDTF">2023-11-17T09:31:30Z</dcterms:created>
  <dcterms:modified xsi:type="dcterms:W3CDTF">2024-04-17T07:53:44Z</dcterms:modified>
</cp:coreProperties>
</file>